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wdp" ContentType="image/vnd.ms-photo"/>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chart4.xml" ContentType="application/vnd.openxmlformats-officedocument.drawingml.chart+xml"/>
  <Override PartName="/ppt/charts/chart5.xml" ContentType="application/vnd.openxmlformats-officedocument.drawingml.chart+xml"/>
  <Override PartName="/ppt/charts/chart6.xml" ContentType="application/vnd.openxmlformats-officedocument.drawingml.chart+xml"/>
  <Override PartName="/ppt/charts/chart7.xml" ContentType="application/vnd.openxmlformats-officedocument.drawingml.chart+xml"/>
  <Override PartName="/ppt/charts/style3.xml" ContentType="application/vnd.ms-office.chartstyle+xml"/>
  <Override PartName="/ppt/charts/colors3.xml" ContentType="application/vnd.ms-office.chartcolorstyle+xml"/>
  <Override PartName="/ppt/charts/chart8.xml" ContentType="application/vnd.openxmlformats-officedocument.drawingml.chart+xml"/>
  <Override PartName="/ppt/charts/style4.xml" ContentType="application/vnd.ms-office.chartstyle+xml"/>
  <Override PartName="/ppt/charts/colors4.xml" ContentType="application/vnd.ms-office.chartcolorstyle+xml"/>
  <Override PartName="/ppt/charts/chart9.xml" ContentType="application/vnd.openxmlformats-officedocument.drawingml.chart+xml"/>
  <Override PartName="/ppt/charts/style5.xml" ContentType="application/vnd.ms-office.chartstyle+xml"/>
  <Override PartName="/ppt/charts/colors5.xml" ContentType="application/vnd.ms-office.chartcolorstyle+xml"/>
  <Override PartName="/ppt/charts/chart10.xml" ContentType="application/vnd.openxmlformats-officedocument.drawingml.chart+xml"/>
  <Override PartName="/ppt/charts/style6.xml" ContentType="application/vnd.ms-office.chartstyle+xml"/>
  <Override PartName="/ppt/charts/colors6.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7" r:id="rId3"/>
    <p:sldId id="258" r:id="rId4"/>
  </p:sldIdLst>
  <p:sldSz cx="7772400" cy="100584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68" userDrawn="1">
          <p15:clr>
            <a:srgbClr val="A4A3A4"/>
          </p15:clr>
        </p15:guide>
        <p15:guide id="2" pos="2448"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366" autoAdjust="0"/>
  </p:normalViewPr>
  <p:slideViewPr>
    <p:cSldViewPr>
      <p:cViewPr varScale="1">
        <p:scale>
          <a:sx n="59" d="100"/>
          <a:sy n="59" d="100"/>
        </p:scale>
        <p:origin x="1404" y="90"/>
      </p:cViewPr>
      <p:guideLst>
        <p:guide orient="horz" pos="3168"/>
        <p:guide pos="2448"/>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charts/_rels/chart1.xml.rels><?xml version="1.0" encoding="UTF-8" standalone="yes"?>
<Relationships xmlns="http://schemas.openxmlformats.org/package/2006/relationships"><Relationship Id="rId3" Type="http://schemas.openxmlformats.org/officeDocument/2006/relationships/oleObject" Target="file:///G:\Dropbox\miRNA%20Paper%20Outline\Charts.xlsx" TargetMode="External"/><Relationship Id="rId2" Type="http://schemas.microsoft.com/office/2011/relationships/chartColorStyle" Target="colors1.xml"/><Relationship Id="rId1" Type="http://schemas.microsoft.com/office/2011/relationships/chartStyle" Target="style1.xml"/></Relationships>
</file>

<file path=ppt/charts/_rels/chart10.xml.rels><?xml version="1.0" encoding="UTF-8" standalone="yes"?>
<Relationships xmlns="http://schemas.openxmlformats.org/package/2006/relationships"><Relationship Id="rId3" Type="http://schemas.openxmlformats.org/officeDocument/2006/relationships/oleObject" Target="file:///J:\Dropbox\miRNA%20Paper%20Outline\Charts.xlsx" TargetMode="External"/><Relationship Id="rId2" Type="http://schemas.microsoft.com/office/2011/relationships/chartColorStyle" Target="colors6.xml"/><Relationship Id="rId1" Type="http://schemas.microsoft.com/office/2011/relationships/chartStyle" Target="style6.xml"/></Relationships>
</file>

<file path=ppt/charts/_rels/chart2.xml.rels><?xml version="1.0" encoding="UTF-8" standalone="yes"?>
<Relationships xmlns="http://schemas.openxmlformats.org/package/2006/relationships"><Relationship Id="rId3" Type="http://schemas.openxmlformats.org/officeDocument/2006/relationships/oleObject" Target="file:///G:\Dropbox\miRNA%20Paper%20Outline\Charts.xlsx"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1" Type="http://schemas.openxmlformats.org/officeDocument/2006/relationships/oleObject" Target="file:///G:\Dropbox\miRNA%20Paper%20Outline\Charts.xlsx" TargetMode="External"/></Relationships>
</file>

<file path=ppt/charts/_rels/chart4.xml.rels><?xml version="1.0" encoding="UTF-8" standalone="yes"?>
<Relationships xmlns="http://schemas.openxmlformats.org/package/2006/relationships"><Relationship Id="rId1" Type="http://schemas.openxmlformats.org/officeDocument/2006/relationships/oleObject" Target="file:///G:\Dropbox\miRNA%20Paper%20Outline\Charts.xlsx" TargetMode="External"/></Relationships>
</file>

<file path=ppt/charts/_rels/chart5.xml.rels><?xml version="1.0" encoding="UTF-8" standalone="yes"?>
<Relationships xmlns="http://schemas.openxmlformats.org/package/2006/relationships"><Relationship Id="rId1" Type="http://schemas.openxmlformats.org/officeDocument/2006/relationships/oleObject" Target="file:///G:\Dropbox\miRNA%20Paper%20Outline\Charts.xlsx" TargetMode="External"/></Relationships>
</file>

<file path=ppt/charts/_rels/chart6.xml.rels><?xml version="1.0" encoding="UTF-8" standalone="yes"?>
<Relationships xmlns="http://schemas.openxmlformats.org/package/2006/relationships"><Relationship Id="rId1" Type="http://schemas.openxmlformats.org/officeDocument/2006/relationships/oleObject" Target="file:///G:\Dropbox\miRNA%20Paper%20Outline\Charts.xlsx" TargetMode="External"/></Relationships>
</file>

<file path=ppt/charts/_rels/chart7.xml.rels><?xml version="1.0" encoding="UTF-8" standalone="yes"?>
<Relationships xmlns="http://schemas.openxmlformats.org/package/2006/relationships"><Relationship Id="rId3" Type="http://schemas.openxmlformats.org/officeDocument/2006/relationships/oleObject" Target="file:///G:\Dropbox\miRNA%20Paper%20Outline\qRT\KF_2016-10-10%2010-05-44_CT009744_169_NFYB_Bio2%20-%20%20Gene%20Expression%20Results%20-%20Bar%20Chart.xlsx" TargetMode="External"/><Relationship Id="rId2" Type="http://schemas.microsoft.com/office/2011/relationships/chartColorStyle" Target="colors3.xml"/><Relationship Id="rId1" Type="http://schemas.microsoft.com/office/2011/relationships/chartStyle" Target="style3.xml"/></Relationships>
</file>

<file path=ppt/charts/_rels/chart8.xml.rels><?xml version="1.0" encoding="UTF-8" standalone="yes"?>
<Relationships xmlns="http://schemas.openxmlformats.org/package/2006/relationships"><Relationship Id="rId3" Type="http://schemas.openxmlformats.org/officeDocument/2006/relationships/oleObject" Target="file:///G:\Dropbox\miRNA%20Paper%20Outline\qRT\393_2_template.xlsx" TargetMode="External"/><Relationship Id="rId2" Type="http://schemas.microsoft.com/office/2011/relationships/chartColorStyle" Target="colors4.xml"/><Relationship Id="rId1" Type="http://schemas.microsoft.com/office/2011/relationships/chartStyle" Target="style4.xml"/></Relationships>
</file>

<file path=ppt/charts/_rels/chart9.xml.rels><?xml version="1.0" encoding="UTF-8" standalone="yes"?>
<Relationships xmlns="http://schemas.openxmlformats.org/package/2006/relationships"><Relationship Id="rId3" Type="http://schemas.openxmlformats.org/officeDocument/2006/relationships/oleObject" Target="file:///G:\Dropbox\miRNA%20Paper%20Outline\qRT\KF_2016-10-08%2019-17-56_CT009744_394_FBX32_bio2_Gene%20Expression%20Results%20-%20Bar%20Chart.xlsx" TargetMode="External"/><Relationship Id="rId2" Type="http://schemas.microsoft.com/office/2011/relationships/chartColorStyle" Target="colors5.xml"/><Relationship Id="rId1" Type="http://schemas.microsoft.com/office/2011/relationships/chartStyle" Target="style5.xm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200" b="1" i="0" u="none" strike="noStrike" kern="1200" spc="0" baseline="0">
                <a:solidFill>
                  <a:schemeClr val="tx1"/>
                </a:solidFill>
                <a:latin typeface="+mn-lt"/>
                <a:ea typeface="+mn-ea"/>
                <a:cs typeface="+mn-cs"/>
              </a:defRPr>
            </a:pPr>
            <a:r>
              <a:rPr lang="en-US" sz="1200" b="1" dirty="0" smtClean="0">
                <a:solidFill>
                  <a:schemeClr val="tx1"/>
                </a:solidFill>
                <a:effectLst/>
              </a:rPr>
              <a:t>Control</a:t>
            </a:r>
          </a:p>
        </c:rich>
      </c:tx>
      <c:layout/>
      <c:overlay val="0"/>
      <c:spPr>
        <a:noFill/>
        <a:ln>
          <a:noFill/>
        </a:ln>
        <a:effectLst/>
      </c:spPr>
      <c:txPr>
        <a:bodyPr rot="0" spcFirstLastPara="1" vertOverflow="ellipsis" vert="horz" wrap="square" anchor="ctr" anchorCtr="1"/>
        <a:lstStyle/>
        <a:p>
          <a:pPr>
            <a:defRPr sz="1200" b="1" i="0" u="none" strike="noStrike" kern="1200" spc="0" baseline="0">
              <a:solidFill>
                <a:schemeClr val="tx1"/>
              </a:solidFill>
              <a:latin typeface="+mn-lt"/>
              <a:ea typeface="+mn-ea"/>
              <a:cs typeface="+mn-cs"/>
            </a:defRPr>
          </a:pPr>
          <a:endParaRPr lang="en-US"/>
        </a:p>
      </c:txPr>
    </c:title>
    <c:autoTitleDeleted val="0"/>
    <c:plotArea>
      <c:layout>
        <c:manualLayout>
          <c:layoutTarget val="inner"/>
          <c:xMode val="edge"/>
          <c:yMode val="edge"/>
          <c:x val="0.1812679012345679"/>
          <c:y val="0.17171296296296296"/>
          <c:w val="0.70538024691358014"/>
          <c:h val="0.59860717410323705"/>
        </c:manualLayout>
      </c:layout>
      <c:scatterChart>
        <c:scatterStyle val="lineMarker"/>
        <c:varyColors val="0"/>
        <c:ser>
          <c:idx val="0"/>
          <c:order val="0"/>
          <c:tx>
            <c:strRef>
              <c:f>'Brachy NFY'!$C$2</c:f>
              <c:strCache>
                <c:ptCount val="1"/>
                <c:pt idx="0">
                  <c:v>Control1</c:v>
                </c:pt>
              </c:strCache>
              <c:extLst xmlns:c15="http://schemas.microsoft.com/office/drawing/2012/chart"/>
            </c:strRef>
          </c:tx>
          <c:spPr>
            <a:ln w="19050" cap="rnd">
              <a:noFill/>
              <a:round/>
            </a:ln>
            <a:effectLst/>
          </c:spPr>
          <c:marker>
            <c:symbol val="circle"/>
            <c:size val="5"/>
            <c:spPr>
              <a:solidFill>
                <a:schemeClr val="tx1"/>
              </a:solidFill>
              <a:ln w="9525">
                <a:solidFill>
                  <a:schemeClr val="tx1"/>
                </a:solidFill>
              </a:ln>
              <a:effectLst/>
            </c:spPr>
          </c:marker>
          <c:dPt>
            <c:idx val="806"/>
            <c:marker>
              <c:symbol val="circle"/>
              <c:size val="5"/>
              <c:spPr>
                <a:solidFill>
                  <a:srgbClr val="FF0000"/>
                </a:solidFill>
                <a:ln w="9525">
                  <a:solidFill>
                    <a:srgbClr val="FF0000"/>
                  </a:solidFill>
                </a:ln>
                <a:effectLst/>
              </c:spPr>
            </c:marker>
            <c:bubble3D val="0"/>
          </c:dPt>
          <c:xVal>
            <c:numRef>
              <c:f>'Brachy NFY'!$B$3:$B$1060</c:f>
              <c:numCache>
                <c:formatCode>General</c:formatCode>
                <c:ptCount val="1058"/>
                <c:pt idx="0">
                  <c:v>52</c:v>
                </c:pt>
                <c:pt idx="1">
                  <c:v>62</c:v>
                </c:pt>
                <c:pt idx="2">
                  <c:v>69</c:v>
                </c:pt>
                <c:pt idx="3">
                  <c:v>77</c:v>
                </c:pt>
                <c:pt idx="4">
                  <c:v>89</c:v>
                </c:pt>
                <c:pt idx="5">
                  <c:v>92</c:v>
                </c:pt>
                <c:pt idx="6">
                  <c:v>95</c:v>
                </c:pt>
                <c:pt idx="7">
                  <c:v>100</c:v>
                </c:pt>
                <c:pt idx="8">
                  <c:v>116</c:v>
                </c:pt>
                <c:pt idx="9">
                  <c:v>123</c:v>
                </c:pt>
                <c:pt idx="10">
                  <c:v>125</c:v>
                </c:pt>
                <c:pt idx="11">
                  <c:v>129</c:v>
                </c:pt>
                <c:pt idx="12">
                  <c:v>135</c:v>
                </c:pt>
                <c:pt idx="13">
                  <c:v>146</c:v>
                </c:pt>
                <c:pt idx="14">
                  <c:v>147</c:v>
                </c:pt>
                <c:pt idx="15">
                  <c:v>148</c:v>
                </c:pt>
                <c:pt idx="16">
                  <c:v>149</c:v>
                </c:pt>
                <c:pt idx="17">
                  <c:v>150</c:v>
                </c:pt>
                <c:pt idx="18">
                  <c:v>152</c:v>
                </c:pt>
                <c:pt idx="19">
                  <c:v>153</c:v>
                </c:pt>
                <c:pt idx="20">
                  <c:v>155</c:v>
                </c:pt>
                <c:pt idx="21">
                  <c:v>157</c:v>
                </c:pt>
                <c:pt idx="22">
                  <c:v>158</c:v>
                </c:pt>
                <c:pt idx="23">
                  <c:v>159</c:v>
                </c:pt>
                <c:pt idx="24">
                  <c:v>160</c:v>
                </c:pt>
                <c:pt idx="25">
                  <c:v>162</c:v>
                </c:pt>
                <c:pt idx="26">
                  <c:v>164</c:v>
                </c:pt>
                <c:pt idx="27">
                  <c:v>169</c:v>
                </c:pt>
                <c:pt idx="28">
                  <c:v>171</c:v>
                </c:pt>
                <c:pt idx="29">
                  <c:v>173</c:v>
                </c:pt>
                <c:pt idx="30">
                  <c:v>174</c:v>
                </c:pt>
                <c:pt idx="31">
                  <c:v>181</c:v>
                </c:pt>
                <c:pt idx="32">
                  <c:v>186</c:v>
                </c:pt>
                <c:pt idx="33">
                  <c:v>187</c:v>
                </c:pt>
                <c:pt idx="34">
                  <c:v>190</c:v>
                </c:pt>
                <c:pt idx="35">
                  <c:v>192</c:v>
                </c:pt>
                <c:pt idx="36">
                  <c:v>197</c:v>
                </c:pt>
                <c:pt idx="37">
                  <c:v>202</c:v>
                </c:pt>
                <c:pt idx="38">
                  <c:v>204</c:v>
                </c:pt>
                <c:pt idx="39">
                  <c:v>206</c:v>
                </c:pt>
                <c:pt idx="40">
                  <c:v>208</c:v>
                </c:pt>
                <c:pt idx="41">
                  <c:v>209</c:v>
                </c:pt>
                <c:pt idx="42">
                  <c:v>210</c:v>
                </c:pt>
                <c:pt idx="43">
                  <c:v>217</c:v>
                </c:pt>
                <c:pt idx="44">
                  <c:v>219</c:v>
                </c:pt>
                <c:pt idx="45">
                  <c:v>220</c:v>
                </c:pt>
                <c:pt idx="46">
                  <c:v>222</c:v>
                </c:pt>
                <c:pt idx="47">
                  <c:v>226</c:v>
                </c:pt>
                <c:pt idx="48">
                  <c:v>227</c:v>
                </c:pt>
                <c:pt idx="49">
                  <c:v>230</c:v>
                </c:pt>
                <c:pt idx="50">
                  <c:v>231</c:v>
                </c:pt>
                <c:pt idx="51">
                  <c:v>232</c:v>
                </c:pt>
                <c:pt idx="52">
                  <c:v>235</c:v>
                </c:pt>
                <c:pt idx="53">
                  <c:v>236</c:v>
                </c:pt>
                <c:pt idx="54">
                  <c:v>240</c:v>
                </c:pt>
                <c:pt idx="55">
                  <c:v>241</c:v>
                </c:pt>
                <c:pt idx="56">
                  <c:v>244</c:v>
                </c:pt>
                <c:pt idx="57">
                  <c:v>245</c:v>
                </c:pt>
                <c:pt idx="58">
                  <c:v>247</c:v>
                </c:pt>
                <c:pt idx="59">
                  <c:v>248</c:v>
                </c:pt>
                <c:pt idx="60">
                  <c:v>251</c:v>
                </c:pt>
                <c:pt idx="61">
                  <c:v>254</c:v>
                </c:pt>
                <c:pt idx="62">
                  <c:v>255</c:v>
                </c:pt>
                <c:pt idx="63">
                  <c:v>258</c:v>
                </c:pt>
                <c:pt idx="64">
                  <c:v>260</c:v>
                </c:pt>
                <c:pt idx="65">
                  <c:v>261</c:v>
                </c:pt>
                <c:pt idx="66">
                  <c:v>262</c:v>
                </c:pt>
                <c:pt idx="67">
                  <c:v>263</c:v>
                </c:pt>
                <c:pt idx="68">
                  <c:v>264</c:v>
                </c:pt>
                <c:pt idx="69">
                  <c:v>265</c:v>
                </c:pt>
                <c:pt idx="70">
                  <c:v>266</c:v>
                </c:pt>
                <c:pt idx="71">
                  <c:v>267</c:v>
                </c:pt>
                <c:pt idx="72">
                  <c:v>268</c:v>
                </c:pt>
                <c:pt idx="73">
                  <c:v>270</c:v>
                </c:pt>
                <c:pt idx="74">
                  <c:v>273</c:v>
                </c:pt>
                <c:pt idx="75">
                  <c:v>286</c:v>
                </c:pt>
                <c:pt idx="76">
                  <c:v>289</c:v>
                </c:pt>
                <c:pt idx="77">
                  <c:v>290</c:v>
                </c:pt>
                <c:pt idx="78">
                  <c:v>292</c:v>
                </c:pt>
                <c:pt idx="79">
                  <c:v>294</c:v>
                </c:pt>
                <c:pt idx="80">
                  <c:v>295</c:v>
                </c:pt>
                <c:pt idx="81">
                  <c:v>297</c:v>
                </c:pt>
                <c:pt idx="82">
                  <c:v>302</c:v>
                </c:pt>
                <c:pt idx="83">
                  <c:v>303</c:v>
                </c:pt>
                <c:pt idx="84">
                  <c:v>307</c:v>
                </c:pt>
                <c:pt idx="85">
                  <c:v>309</c:v>
                </c:pt>
                <c:pt idx="86">
                  <c:v>310</c:v>
                </c:pt>
                <c:pt idx="87">
                  <c:v>312</c:v>
                </c:pt>
                <c:pt idx="88">
                  <c:v>313</c:v>
                </c:pt>
                <c:pt idx="89">
                  <c:v>314</c:v>
                </c:pt>
                <c:pt idx="90">
                  <c:v>315</c:v>
                </c:pt>
                <c:pt idx="91">
                  <c:v>316</c:v>
                </c:pt>
                <c:pt idx="92">
                  <c:v>326</c:v>
                </c:pt>
                <c:pt idx="93">
                  <c:v>330</c:v>
                </c:pt>
                <c:pt idx="94">
                  <c:v>335</c:v>
                </c:pt>
                <c:pt idx="95">
                  <c:v>338</c:v>
                </c:pt>
                <c:pt idx="96">
                  <c:v>339</c:v>
                </c:pt>
                <c:pt idx="97">
                  <c:v>344</c:v>
                </c:pt>
                <c:pt idx="98">
                  <c:v>349</c:v>
                </c:pt>
                <c:pt idx="99">
                  <c:v>351</c:v>
                </c:pt>
                <c:pt idx="100">
                  <c:v>354</c:v>
                </c:pt>
                <c:pt idx="101">
                  <c:v>357</c:v>
                </c:pt>
                <c:pt idx="102">
                  <c:v>361</c:v>
                </c:pt>
                <c:pt idx="103">
                  <c:v>364</c:v>
                </c:pt>
                <c:pt idx="104">
                  <c:v>373</c:v>
                </c:pt>
                <c:pt idx="105">
                  <c:v>377</c:v>
                </c:pt>
                <c:pt idx="106">
                  <c:v>378</c:v>
                </c:pt>
                <c:pt idx="107">
                  <c:v>379</c:v>
                </c:pt>
                <c:pt idx="108">
                  <c:v>382</c:v>
                </c:pt>
                <c:pt idx="109">
                  <c:v>390</c:v>
                </c:pt>
                <c:pt idx="110">
                  <c:v>394</c:v>
                </c:pt>
                <c:pt idx="111">
                  <c:v>396</c:v>
                </c:pt>
                <c:pt idx="112">
                  <c:v>397</c:v>
                </c:pt>
                <c:pt idx="113">
                  <c:v>400</c:v>
                </c:pt>
                <c:pt idx="114">
                  <c:v>403</c:v>
                </c:pt>
                <c:pt idx="115">
                  <c:v>405</c:v>
                </c:pt>
                <c:pt idx="116">
                  <c:v>406</c:v>
                </c:pt>
                <c:pt idx="117">
                  <c:v>407</c:v>
                </c:pt>
                <c:pt idx="118">
                  <c:v>408</c:v>
                </c:pt>
                <c:pt idx="119">
                  <c:v>409</c:v>
                </c:pt>
                <c:pt idx="120">
                  <c:v>410</c:v>
                </c:pt>
                <c:pt idx="121">
                  <c:v>416</c:v>
                </c:pt>
                <c:pt idx="122">
                  <c:v>418</c:v>
                </c:pt>
                <c:pt idx="123">
                  <c:v>423</c:v>
                </c:pt>
                <c:pt idx="124">
                  <c:v>424</c:v>
                </c:pt>
                <c:pt idx="125">
                  <c:v>426</c:v>
                </c:pt>
                <c:pt idx="126">
                  <c:v>428</c:v>
                </c:pt>
                <c:pt idx="127">
                  <c:v>429</c:v>
                </c:pt>
                <c:pt idx="128">
                  <c:v>430</c:v>
                </c:pt>
                <c:pt idx="129">
                  <c:v>433</c:v>
                </c:pt>
                <c:pt idx="130">
                  <c:v>438</c:v>
                </c:pt>
                <c:pt idx="131">
                  <c:v>440</c:v>
                </c:pt>
                <c:pt idx="132">
                  <c:v>450</c:v>
                </c:pt>
                <c:pt idx="133">
                  <c:v>453</c:v>
                </c:pt>
                <c:pt idx="134">
                  <c:v>460</c:v>
                </c:pt>
                <c:pt idx="135">
                  <c:v>461</c:v>
                </c:pt>
                <c:pt idx="136">
                  <c:v>464</c:v>
                </c:pt>
                <c:pt idx="137">
                  <c:v>465</c:v>
                </c:pt>
                <c:pt idx="138">
                  <c:v>466</c:v>
                </c:pt>
                <c:pt idx="139">
                  <c:v>467</c:v>
                </c:pt>
                <c:pt idx="140">
                  <c:v>468</c:v>
                </c:pt>
                <c:pt idx="141">
                  <c:v>469</c:v>
                </c:pt>
                <c:pt idx="142">
                  <c:v>470</c:v>
                </c:pt>
                <c:pt idx="143">
                  <c:v>471</c:v>
                </c:pt>
                <c:pt idx="144">
                  <c:v>472</c:v>
                </c:pt>
                <c:pt idx="145">
                  <c:v>473</c:v>
                </c:pt>
                <c:pt idx="146">
                  <c:v>474</c:v>
                </c:pt>
                <c:pt idx="147">
                  <c:v>475</c:v>
                </c:pt>
                <c:pt idx="148">
                  <c:v>477</c:v>
                </c:pt>
                <c:pt idx="149">
                  <c:v>478</c:v>
                </c:pt>
                <c:pt idx="150">
                  <c:v>479</c:v>
                </c:pt>
                <c:pt idx="151">
                  <c:v>480</c:v>
                </c:pt>
                <c:pt idx="152">
                  <c:v>485</c:v>
                </c:pt>
                <c:pt idx="153">
                  <c:v>488</c:v>
                </c:pt>
                <c:pt idx="154">
                  <c:v>489</c:v>
                </c:pt>
                <c:pt idx="155">
                  <c:v>491</c:v>
                </c:pt>
                <c:pt idx="156">
                  <c:v>492</c:v>
                </c:pt>
                <c:pt idx="157">
                  <c:v>494</c:v>
                </c:pt>
                <c:pt idx="158">
                  <c:v>495</c:v>
                </c:pt>
                <c:pt idx="159">
                  <c:v>497</c:v>
                </c:pt>
                <c:pt idx="160">
                  <c:v>498</c:v>
                </c:pt>
                <c:pt idx="161">
                  <c:v>499</c:v>
                </c:pt>
                <c:pt idx="162">
                  <c:v>500</c:v>
                </c:pt>
                <c:pt idx="163">
                  <c:v>501</c:v>
                </c:pt>
                <c:pt idx="164">
                  <c:v>502</c:v>
                </c:pt>
                <c:pt idx="165">
                  <c:v>503</c:v>
                </c:pt>
                <c:pt idx="166">
                  <c:v>504</c:v>
                </c:pt>
                <c:pt idx="167">
                  <c:v>505</c:v>
                </c:pt>
                <c:pt idx="168">
                  <c:v>508</c:v>
                </c:pt>
                <c:pt idx="169">
                  <c:v>510</c:v>
                </c:pt>
                <c:pt idx="170">
                  <c:v>511</c:v>
                </c:pt>
                <c:pt idx="171">
                  <c:v>513</c:v>
                </c:pt>
                <c:pt idx="172">
                  <c:v>516</c:v>
                </c:pt>
                <c:pt idx="173">
                  <c:v>518</c:v>
                </c:pt>
                <c:pt idx="174">
                  <c:v>519</c:v>
                </c:pt>
                <c:pt idx="175">
                  <c:v>520</c:v>
                </c:pt>
                <c:pt idx="176">
                  <c:v>521</c:v>
                </c:pt>
                <c:pt idx="177">
                  <c:v>522</c:v>
                </c:pt>
                <c:pt idx="178">
                  <c:v>523</c:v>
                </c:pt>
                <c:pt idx="179">
                  <c:v>524</c:v>
                </c:pt>
                <c:pt idx="180">
                  <c:v>525</c:v>
                </c:pt>
                <c:pt idx="181">
                  <c:v>527</c:v>
                </c:pt>
                <c:pt idx="182">
                  <c:v>530</c:v>
                </c:pt>
                <c:pt idx="183">
                  <c:v>531</c:v>
                </c:pt>
                <c:pt idx="184">
                  <c:v>532</c:v>
                </c:pt>
                <c:pt idx="185">
                  <c:v>533</c:v>
                </c:pt>
                <c:pt idx="186">
                  <c:v>537</c:v>
                </c:pt>
                <c:pt idx="187">
                  <c:v>538</c:v>
                </c:pt>
                <c:pt idx="188">
                  <c:v>539</c:v>
                </c:pt>
                <c:pt idx="189">
                  <c:v>541</c:v>
                </c:pt>
                <c:pt idx="190">
                  <c:v>542</c:v>
                </c:pt>
                <c:pt idx="191">
                  <c:v>543</c:v>
                </c:pt>
                <c:pt idx="192">
                  <c:v>544</c:v>
                </c:pt>
                <c:pt idx="193">
                  <c:v>545</c:v>
                </c:pt>
                <c:pt idx="194">
                  <c:v>549</c:v>
                </c:pt>
                <c:pt idx="195">
                  <c:v>550</c:v>
                </c:pt>
                <c:pt idx="196">
                  <c:v>551</c:v>
                </c:pt>
                <c:pt idx="197">
                  <c:v>552</c:v>
                </c:pt>
                <c:pt idx="198">
                  <c:v>553</c:v>
                </c:pt>
                <c:pt idx="199">
                  <c:v>554</c:v>
                </c:pt>
                <c:pt idx="200">
                  <c:v>555</c:v>
                </c:pt>
                <c:pt idx="201">
                  <c:v>556</c:v>
                </c:pt>
                <c:pt idx="202">
                  <c:v>557</c:v>
                </c:pt>
                <c:pt idx="203">
                  <c:v>558</c:v>
                </c:pt>
                <c:pt idx="204">
                  <c:v>561</c:v>
                </c:pt>
                <c:pt idx="205">
                  <c:v>562</c:v>
                </c:pt>
                <c:pt idx="206">
                  <c:v>564</c:v>
                </c:pt>
                <c:pt idx="207">
                  <c:v>565</c:v>
                </c:pt>
                <c:pt idx="208">
                  <c:v>568</c:v>
                </c:pt>
                <c:pt idx="209">
                  <c:v>570</c:v>
                </c:pt>
                <c:pt idx="210">
                  <c:v>571</c:v>
                </c:pt>
                <c:pt idx="211">
                  <c:v>573</c:v>
                </c:pt>
                <c:pt idx="212">
                  <c:v>574</c:v>
                </c:pt>
                <c:pt idx="213">
                  <c:v>575</c:v>
                </c:pt>
                <c:pt idx="214">
                  <c:v>582</c:v>
                </c:pt>
                <c:pt idx="215">
                  <c:v>586</c:v>
                </c:pt>
                <c:pt idx="216">
                  <c:v>587</c:v>
                </c:pt>
                <c:pt idx="217">
                  <c:v>589</c:v>
                </c:pt>
                <c:pt idx="218">
                  <c:v>590</c:v>
                </c:pt>
                <c:pt idx="219">
                  <c:v>591</c:v>
                </c:pt>
                <c:pt idx="220">
                  <c:v>592</c:v>
                </c:pt>
                <c:pt idx="221">
                  <c:v>595</c:v>
                </c:pt>
                <c:pt idx="222">
                  <c:v>596</c:v>
                </c:pt>
                <c:pt idx="223">
                  <c:v>597</c:v>
                </c:pt>
                <c:pt idx="224">
                  <c:v>598</c:v>
                </c:pt>
                <c:pt idx="225">
                  <c:v>604</c:v>
                </c:pt>
                <c:pt idx="226">
                  <c:v>605</c:v>
                </c:pt>
                <c:pt idx="227">
                  <c:v>608</c:v>
                </c:pt>
                <c:pt idx="228">
                  <c:v>609</c:v>
                </c:pt>
                <c:pt idx="229">
                  <c:v>610</c:v>
                </c:pt>
                <c:pt idx="230">
                  <c:v>611</c:v>
                </c:pt>
                <c:pt idx="231">
                  <c:v>612</c:v>
                </c:pt>
                <c:pt idx="232">
                  <c:v>613</c:v>
                </c:pt>
                <c:pt idx="233">
                  <c:v>623</c:v>
                </c:pt>
                <c:pt idx="234">
                  <c:v>624</c:v>
                </c:pt>
                <c:pt idx="235">
                  <c:v>625</c:v>
                </c:pt>
                <c:pt idx="236">
                  <c:v>627</c:v>
                </c:pt>
                <c:pt idx="237">
                  <c:v>628</c:v>
                </c:pt>
                <c:pt idx="238">
                  <c:v>629</c:v>
                </c:pt>
                <c:pt idx="239">
                  <c:v>631</c:v>
                </c:pt>
                <c:pt idx="240">
                  <c:v>634</c:v>
                </c:pt>
                <c:pt idx="241">
                  <c:v>636</c:v>
                </c:pt>
                <c:pt idx="242">
                  <c:v>638</c:v>
                </c:pt>
                <c:pt idx="243">
                  <c:v>639</c:v>
                </c:pt>
                <c:pt idx="244">
                  <c:v>642</c:v>
                </c:pt>
                <c:pt idx="245">
                  <c:v>643</c:v>
                </c:pt>
                <c:pt idx="246">
                  <c:v>644</c:v>
                </c:pt>
                <c:pt idx="247">
                  <c:v>646</c:v>
                </c:pt>
                <c:pt idx="248">
                  <c:v>647</c:v>
                </c:pt>
                <c:pt idx="249">
                  <c:v>649</c:v>
                </c:pt>
                <c:pt idx="250">
                  <c:v>650</c:v>
                </c:pt>
                <c:pt idx="251">
                  <c:v>652</c:v>
                </c:pt>
                <c:pt idx="252">
                  <c:v>653</c:v>
                </c:pt>
                <c:pt idx="253">
                  <c:v>654</c:v>
                </c:pt>
                <c:pt idx="254">
                  <c:v>656</c:v>
                </c:pt>
                <c:pt idx="255">
                  <c:v>657</c:v>
                </c:pt>
                <c:pt idx="256">
                  <c:v>659</c:v>
                </c:pt>
                <c:pt idx="257">
                  <c:v>661</c:v>
                </c:pt>
                <c:pt idx="258">
                  <c:v>665</c:v>
                </c:pt>
                <c:pt idx="259">
                  <c:v>667</c:v>
                </c:pt>
                <c:pt idx="260">
                  <c:v>668</c:v>
                </c:pt>
                <c:pt idx="261">
                  <c:v>669</c:v>
                </c:pt>
                <c:pt idx="262">
                  <c:v>670</c:v>
                </c:pt>
                <c:pt idx="263">
                  <c:v>671</c:v>
                </c:pt>
                <c:pt idx="264">
                  <c:v>672</c:v>
                </c:pt>
                <c:pt idx="265">
                  <c:v>673</c:v>
                </c:pt>
                <c:pt idx="266">
                  <c:v>674</c:v>
                </c:pt>
                <c:pt idx="267">
                  <c:v>675</c:v>
                </c:pt>
                <c:pt idx="268">
                  <c:v>676</c:v>
                </c:pt>
                <c:pt idx="269">
                  <c:v>677</c:v>
                </c:pt>
                <c:pt idx="270">
                  <c:v>678</c:v>
                </c:pt>
                <c:pt idx="271">
                  <c:v>681</c:v>
                </c:pt>
                <c:pt idx="272">
                  <c:v>682</c:v>
                </c:pt>
                <c:pt idx="273">
                  <c:v>683</c:v>
                </c:pt>
                <c:pt idx="274">
                  <c:v>684</c:v>
                </c:pt>
                <c:pt idx="275">
                  <c:v>685</c:v>
                </c:pt>
                <c:pt idx="276">
                  <c:v>686</c:v>
                </c:pt>
                <c:pt idx="277">
                  <c:v>687</c:v>
                </c:pt>
                <c:pt idx="278">
                  <c:v>688</c:v>
                </c:pt>
                <c:pt idx="279">
                  <c:v>689</c:v>
                </c:pt>
                <c:pt idx="280">
                  <c:v>693</c:v>
                </c:pt>
                <c:pt idx="281">
                  <c:v>694</c:v>
                </c:pt>
                <c:pt idx="282">
                  <c:v>698</c:v>
                </c:pt>
                <c:pt idx="283">
                  <c:v>701</c:v>
                </c:pt>
                <c:pt idx="284">
                  <c:v>702</c:v>
                </c:pt>
                <c:pt idx="285">
                  <c:v>703</c:v>
                </c:pt>
                <c:pt idx="286">
                  <c:v>707</c:v>
                </c:pt>
                <c:pt idx="287">
                  <c:v>708</c:v>
                </c:pt>
                <c:pt idx="288">
                  <c:v>712</c:v>
                </c:pt>
                <c:pt idx="289">
                  <c:v>713</c:v>
                </c:pt>
                <c:pt idx="290">
                  <c:v>714</c:v>
                </c:pt>
                <c:pt idx="291">
                  <c:v>719</c:v>
                </c:pt>
                <c:pt idx="292">
                  <c:v>720</c:v>
                </c:pt>
                <c:pt idx="293">
                  <c:v>721</c:v>
                </c:pt>
                <c:pt idx="294">
                  <c:v>723</c:v>
                </c:pt>
                <c:pt idx="295">
                  <c:v>724</c:v>
                </c:pt>
                <c:pt idx="296">
                  <c:v>725</c:v>
                </c:pt>
                <c:pt idx="297">
                  <c:v>726</c:v>
                </c:pt>
                <c:pt idx="298">
                  <c:v>727</c:v>
                </c:pt>
                <c:pt idx="299">
                  <c:v>728</c:v>
                </c:pt>
                <c:pt idx="300">
                  <c:v>729</c:v>
                </c:pt>
                <c:pt idx="301">
                  <c:v>730</c:v>
                </c:pt>
                <c:pt idx="302">
                  <c:v>732</c:v>
                </c:pt>
                <c:pt idx="303">
                  <c:v>734</c:v>
                </c:pt>
                <c:pt idx="304">
                  <c:v>735</c:v>
                </c:pt>
                <c:pt idx="305">
                  <c:v>736</c:v>
                </c:pt>
                <c:pt idx="306">
                  <c:v>737</c:v>
                </c:pt>
                <c:pt idx="307">
                  <c:v>738</c:v>
                </c:pt>
                <c:pt idx="308">
                  <c:v>739</c:v>
                </c:pt>
                <c:pt idx="309">
                  <c:v>740</c:v>
                </c:pt>
                <c:pt idx="310">
                  <c:v>741</c:v>
                </c:pt>
                <c:pt idx="311">
                  <c:v>742</c:v>
                </c:pt>
                <c:pt idx="312">
                  <c:v>743</c:v>
                </c:pt>
                <c:pt idx="313">
                  <c:v>744</c:v>
                </c:pt>
                <c:pt idx="314">
                  <c:v>745</c:v>
                </c:pt>
                <c:pt idx="315">
                  <c:v>746</c:v>
                </c:pt>
                <c:pt idx="316">
                  <c:v>747</c:v>
                </c:pt>
                <c:pt idx="317">
                  <c:v>748</c:v>
                </c:pt>
                <c:pt idx="318">
                  <c:v>749</c:v>
                </c:pt>
                <c:pt idx="319">
                  <c:v>750</c:v>
                </c:pt>
                <c:pt idx="320">
                  <c:v>751</c:v>
                </c:pt>
                <c:pt idx="321">
                  <c:v>757</c:v>
                </c:pt>
                <c:pt idx="322">
                  <c:v>758</c:v>
                </c:pt>
                <c:pt idx="323">
                  <c:v>759</c:v>
                </c:pt>
                <c:pt idx="324">
                  <c:v>760</c:v>
                </c:pt>
                <c:pt idx="325">
                  <c:v>761</c:v>
                </c:pt>
                <c:pt idx="326">
                  <c:v>762</c:v>
                </c:pt>
                <c:pt idx="327">
                  <c:v>765</c:v>
                </c:pt>
                <c:pt idx="328">
                  <c:v>766</c:v>
                </c:pt>
                <c:pt idx="329">
                  <c:v>767</c:v>
                </c:pt>
                <c:pt idx="330">
                  <c:v>769</c:v>
                </c:pt>
                <c:pt idx="331">
                  <c:v>770</c:v>
                </c:pt>
                <c:pt idx="332">
                  <c:v>772</c:v>
                </c:pt>
                <c:pt idx="333">
                  <c:v>773</c:v>
                </c:pt>
                <c:pt idx="334">
                  <c:v>774</c:v>
                </c:pt>
                <c:pt idx="335">
                  <c:v>775</c:v>
                </c:pt>
                <c:pt idx="336">
                  <c:v>776</c:v>
                </c:pt>
                <c:pt idx="337">
                  <c:v>777</c:v>
                </c:pt>
                <c:pt idx="338">
                  <c:v>778</c:v>
                </c:pt>
                <c:pt idx="339">
                  <c:v>779</c:v>
                </c:pt>
                <c:pt idx="340">
                  <c:v>781</c:v>
                </c:pt>
                <c:pt idx="341">
                  <c:v>782</c:v>
                </c:pt>
                <c:pt idx="342">
                  <c:v>783</c:v>
                </c:pt>
                <c:pt idx="343">
                  <c:v>784</c:v>
                </c:pt>
                <c:pt idx="344">
                  <c:v>786</c:v>
                </c:pt>
                <c:pt idx="345">
                  <c:v>787</c:v>
                </c:pt>
                <c:pt idx="346">
                  <c:v>788</c:v>
                </c:pt>
                <c:pt idx="347">
                  <c:v>789</c:v>
                </c:pt>
                <c:pt idx="348">
                  <c:v>790</c:v>
                </c:pt>
                <c:pt idx="349">
                  <c:v>794</c:v>
                </c:pt>
                <c:pt idx="350">
                  <c:v>795</c:v>
                </c:pt>
                <c:pt idx="351">
                  <c:v>796</c:v>
                </c:pt>
                <c:pt idx="352">
                  <c:v>797</c:v>
                </c:pt>
                <c:pt idx="353">
                  <c:v>798</c:v>
                </c:pt>
                <c:pt idx="354">
                  <c:v>800</c:v>
                </c:pt>
                <c:pt idx="355">
                  <c:v>801</c:v>
                </c:pt>
                <c:pt idx="356">
                  <c:v>802</c:v>
                </c:pt>
                <c:pt idx="357">
                  <c:v>803</c:v>
                </c:pt>
                <c:pt idx="358">
                  <c:v>804</c:v>
                </c:pt>
                <c:pt idx="359">
                  <c:v>805</c:v>
                </c:pt>
                <c:pt idx="360">
                  <c:v>806</c:v>
                </c:pt>
                <c:pt idx="361">
                  <c:v>807</c:v>
                </c:pt>
                <c:pt idx="362">
                  <c:v>808</c:v>
                </c:pt>
                <c:pt idx="363">
                  <c:v>811</c:v>
                </c:pt>
                <c:pt idx="364">
                  <c:v>812</c:v>
                </c:pt>
                <c:pt idx="365">
                  <c:v>813</c:v>
                </c:pt>
                <c:pt idx="366">
                  <c:v>814</c:v>
                </c:pt>
                <c:pt idx="367">
                  <c:v>815</c:v>
                </c:pt>
                <c:pt idx="368">
                  <c:v>816</c:v>
                </c:pt>
                <c:pt idx="369">
                  <c:v>817</c:v>
                </c:pt>
                <c:pt idx="370">
                  <c:v>818</c:v>
                </c:pt>
                <c:pt idx="371">
                  <c:v>819</c:v>
                </c:pt>
                <c:pt idx="372">
                  <c:v>820</c:v>
                </c:pt>
                <c:pt idx="373">
                  <c:v>821</c:v>
                </c:pt>
                <c:pt idx="374">
                  <c:v>822</c:v>
                </c:pt>
                <c:pt idx="375">
                  <c:v>823</c:v>
                </c:pt>
                <c:pt idx="376">
                  <c:v>825</c:v>
                </c:pt>
                <c:pt idx="377">
                  <c:v>826</c:v>
                </c:pt>
                <c:pt idx="378">
                  <c:v>827</c:v>
                </c:pt>
                <c:pt idx="379">
                  <c:v>828</c:v>
                </c:pt>
                <c:pt idx="380">
                  <c:v>829</c:v>
                </c:pt>
                <c:pt idx="381">
                  <c:v>830</c:v>
                </c:pt>
                <c:pt idx="382">
                  <c:v>831</c:v>
                </c:pt>
                <c:pt idx="383">
                  <c:v>832</c:v>
                </c:pt>
                <c:pt idx="384">
                  <c:v>834</c:v>
                </c:pt>
                <c:pt idx="385">
                  <c:v>836</c:v>
                </c:pt>
                <c:pt idx="386">
                  <c:v>837</c:v>
                </c:pt>
                <c:pt idx="387">
                  <c:v>838</c:v>
                </c:pt>
                <c:pt idx="388">
                  <c:v>839</c:v>
                </c:pt>
                <c:pt idx="389">
                  <c:v>840</c:v>
                </c:pt>
                <c:pt idx="390">
                  <c:v>842</c:v>
                </c:pt>
                <c:pt idx="391">
                  <c:v>843</c:v>
                </c:pt>
                <c:pt idx="392">
                  <c:v>844</c:v>
                </c:pt>
                <c:pt idx="393">
                  <c:v>845</c:v>
                </c:pt>
                <c:pt idx="394">
                  <c:v>846</c:v>
                </c:pt>
                <c:pt idx="395">
                  <c:v>847</c:v>
                </c:pt>
                <c:pt idx="396">
                  <c:v>848</c:v>
                </c:pt>
                <c:pt idx="397">
                  <c:v>849</c:v>
                </c:pt>
                <c:pt idx="398">
                  <c:v>850</c:v>
                </c:pt>
                <c:pt idx="399">
                  <c:v>851</c:v>
                </c:pt>
                <c:pt idx="400">
                  <c:v>853</c:v>
                </c:pt>
                <c:pt idx="401">
                  <c:v>854</c:v>
                </c:pt>
                <c:pt idx="402">
                  <c:v>855</c:v>
                </c:pt>
                <c:pt idx="403">
                  <c:v>856</c:v>
                </c:pt>
                <c:pt idx="404">
                  <c:v>857</c:v>
                </c:pt>
                <c:pt idx="405">
                  <c:v>859</c:v>
                </c:pt>
                <c:pt idx="406">
                  <c:v>860</c:v>
                </c:pt>
                <c:pt idx="407">
                  <c:v>861</c:v>
                </c:pt>
                <c:pt idx="408">
                  <c:v>862</c:v>
                </c:pt>
                <c:pt idx="409">
                  <c:v>863</c:v>
                </c:pt>
                <c:pt idx="410">
                  <c:v>865</c:v>
                </c:pt>
                <c:pt idx="411">
                  <c:v>867</c:v>
                </c:pt>
                <c:pt idx="412">
                  <c:v>868</c:v>
                </c:pt>
                <c:pt idx="413">
                  <c:v>869</c:v>
                </c:pt>
                <c:pt idx="414">
                  <c:v>876</c:v>
                </c:pt>
                <c:pt idx="415">
                  <c:v>877</c:v>
                </c:pt>
                <c:pt idx="416">
                  <c:v>882</c:v>
                </c:pt>
                <c:pt idx="417">
                  <c:v>883</c:v>
                </c:pt>
                <c:pt idx="418">
                  <c:v>885</c:v>
                </c:pt>
                <c:pt idx="419">
                  <c:v>886</c:v>
                </c:pt>
                <c:pt idx="420">
                  <c:v>887</c:v>
                </c:pt>
                <c:pt idx="421">
                  <c:v>888</c:v>
                </c:pt>
                <c:pt idx="422">
                  <c:v>889</c:v>
                </c:pt>
                <c:pt idx="423">
                  <c:v>890</c:v>
                </c:pt>
                <c:pt idx="424">
                  <c:v>891</c:v>
                </c:pt>
                <c:pt idx="425">
                  <c:v>892</c:v>
                </c:pt>
                <c:pt idx="426">
                  <c:v>893</c:v>
                </c:pt>
                <c:pt idx="427">
                  <c:v>895</c:v>
                </c:pt>
                <c:pt idx="428">
                  <c:v>896</c:v>
                </c:pt>
                <c:pt idx="429">
                  <c:v>897</c:v>
                </c:pt>
                <c:pt idx="430">
                  <c:v>898</c:v>
                </c:pt>
                <c:pt idx="431">
                  <c:v>900</c:v>
                </c:pt>
                <c:pt idx="432">
                  <c:v>901</c:v>
                </c:pt>
                <c:pt idx="433">
                  <c:v>902</c:v>
                </c:pt>
                <c:pt idx="434">
                  <c:v>903</c:v>
                </c:pt>
                <c:pt idx="435">
                  <c:v>904</c:v>
                </c:pt>
                <c:pt idx="436">
                  <c:v>905</c:v>
                </c:pt>
                <c:pt idx="437">
                  <c:v>907</c:v>
                </c:pt>
                <c:pt idx="438">
                  <c:v>908</c:v>
                </c:pt>
                <c:pt idx="439">
                  <c:v>909</c:v>
                </c:pt>
                <c:pt idx="440">
                  <c:v>910</c:v>
                </c:pt>
                <c:pt idx="441">
                  <c:v>911</c:v>
                </c:pt>
                <c:pt idx="442">
                  <c:v>912</c:v>
                </c:pt>
                <c:pt idx="443">
                  <c:v>913</c:v>
                </c:pt>
                <c:pt idx="444">
                  <c:v>918</c:v>
                </c:pt>
                <c:pt idx="445">
                  <c:v>919</c:v>
                </c:pt>
                <c:pt idx="446">
                  <c:v>920</c:v>
                </c:pt>
                <c:pt idx="447">
                  <c:v>922</c:v>
                </c:pt>
                <c:pt idx="448">
                  <c:v>923</c:v>
                </c:pt>
                <c:pt idx="449">
                  <c:v>924</c:v>
                </c:pt>
                <c:pt idx="450">
                  <c:v>925</c:v>
                </c:pt>
                <c:pt idx="451">
                  <c:v>926</c:v>
                </c:pt>
                <c:pt idx="452">
                  <c:v>927</c:v>
                </c:pt>
                <c:pt idx="453">
                  <c:v>928</c:v>
                </c:pt>
                <c:pt idx="454">
                  <c:v>929</c:v>
                </c:pt>
                <c:pt idx="455">
                  <c:v>930</c:v>
                </c:pt>
                <c:pt idx="456">
                  <c:v>931</c:v>
                </c:pt>
                <c:pt idx="457">
                  <c:v>934</c:v>
                </c:pt>
                <c:pt idx="458">
                  <c:v>935</c:v>
                </c:pt>
                <c:pt idx="459">
                  <c:v>940</c:v>
                </c:pt>
                <c:pt idx="460">
                  <c:v>941</c:v>
                </c:pt>
                <c:pt idx="461">
                  <c:v>942</c:v>
                </c:pt>
                <c:pt idx="462">
                  <c:v>943</c:v>
                </c:pt>
                <c:pt idx="463">
                  <c:v>944</c:v>
                </c:pt>
                <c:pt idx="464">
                  <c:v>945</c:v>
                </c:pt>
                <c:pt idx="465">
                  <c:v>946</c:v>
                </c:pt>
                <c:pt idx="466">
                  <c:v>947</c:v>
                </c:pt>
                <c:pt idx="467">
                  <c:v>948</c:v>
                </c:pt>
                <c:pt idx="468">
                  <c:v>949</c:v>
                </c:pt>
                <c:pt idx="469">
                  <c:v>950</c:v>
                </c:pt>
                <c:pt idx="470">
                  <c:v>951</c:v>
                </c:pt>
                <c:pt idx="471">
                  <c:v>952</c:v>
                </c:pt>
                <c:pt idx="472">
                  <c:v>954</c:v>
                </c:pt>
                <c:pt idx="473">
                  <c:v>955</c:v>
                </c:pt>
                <c:pt idx="474">
                  <c:v>956</c:v>
                </c:pt>
                <c:pt idx="475">
                  <c:v>961</c:v>
                </c:pt>
                <c:pt idx="476">
                  <c:v>964</c:v>
                </c:pt>
                <c:pt idx="477">
                  <c:v>965</c:v>
                </c:pt>
                <c:pt idx="478">
                  <c:v>966</c:v>
                </c:pt>
                <c:pt idx="479">
                  <c:v>969</c:v>
                </c:pt>
                <c:pt idx="480">
                  <c:v>970</c:v>
                </c:pt>
                <c:pt idx="481">
                  <c:v>973</c:v>
                </c:pt>
                <c:pt idx="482">
                  <c:v>974</c:v>
                </c:pt>
                <c:pt idx="483">
                  <c:v>975</c:v>
                </c:pt>
                <c:pt idx="484">
                  <c:v>977</c:v>
                </c:pt>
                <c:pt idx="485">
                  <c:v>978</c:v>
                </c:pt>
                <c:pt idx="486">
                  <c:v>979</c:v>
                </c:pt>
                <c:pt idx="487">
                  <c:v>980</c:v>
                </c:pt>
                <c:pt idx="488">
                  <c:v>983</c:v>
                </c:pt>
                <c:pt idx="489">
                  <c:v>984</c:v>
                </c:pt>
                <c:pt idx="490">
                  <c:v>986</c:v>
                </c:pt>
                <c:pt idx="491">
                  <c:v>987</c:v>
                </c:pt>
                <c:pt idx="492">
                  <c:v>988</c:v>
                </c:pt>
                <c:pt idx="493">
                  <c:v>989</c:v>
                </c:pt>
                <c:pt idx="494">
                  <c:v>990</c:v>
                </c:pt>
                <c:pt idx="495">
                  <c:v>991</c:v>
                </c:pt>
                <c:pt idx="496">
                  <c:v>992</c:v>
                </c:pt>
                <c:pt idx="497">
                  <c:v>994</c:v>
                </c:pt>
                <c:pt idx="498">
                  <c:v>995</c:v>
                </c:pt>
                <c:pt idx="499">
                  <c:v>996</c:v>
                </c:pt>
                <c:pt idx="500">
                  <c:v>997</c:v>
                </c:pt>
                <c:pt idx="501">
                  <c:v>998</c:v>
                </c:pt>
                <c:pt idx="502">
                  <c:v>999</c:v>
                </c:pt>
                <c:pt idx="503">
                  <c:v>1000</c:v>
                </c:pt>
                <c:pt idx="504">
                  <c:v>1001</c:v>
                </c:pt>
                <c:pt idx="505">
                  <c:v>1002</c:v>
                </c:pt>
                <c:pt idx="506">
                  <c:v>1003</c:v>
                </c:pt>
                <c:pt idx="507">
                  <c:v>1004</c:v>
                </c:pt>
                <c:pt idx="508">
                  <c:v>1005</c:v>
                </c:pt>
                <c:pt idx="509">
                  <c:v>1006</c:v>
                </c:pt>
                <c:pt idx="510">
                  <c:v>1008</c:v>
                </c:pt>
                <c:pt idx="511">
                  <c:v>1009</c:v>
                </c:pt>
                <c:pt idx="512">
                  <c:v>1010</c:v>
                </c:pt>
                <c:pt idx="513">
                  <c:v>1011</c:v>
                </c:pt>
                <c:pt idx="514">
                  <c:v>1012</c:v>
                </c:pt>
                <c:pt idx="515">
                  <c:v>1013</c:v>
                </c:pt>
                <c:pt idx="516">
                  <c:v>1015</c:v>
                </c:pt>
                <c:pt idx="517">
                  <c:v>1020</c:v>
                </c:pt>
                <c:pt idx="518">
                  <c:v>1021</c:v>
                </c:pt>
                <c:pt idx="519">
                  <c:v>1022</c:v>
                </c:pt>
                <c:pt idx="520">
                  <c:v>1023</c:v>
                </c:pt>
                <c:pt idx="521">
                  <c:v>1024</c:v>
                </c:pt>
                <c:pt idx="522">
                  <c:v>1025</c:v>
                </c:pt>
                <c:pt idx="523">
                  <c:v>1027</c:v>
                </c:pt>
                <c:pt idx="524">
                  <c:v>1031</c:v>
                </c:pt>
                <c:pt idx="525">
                  <c:v>1032</c:v>
                </c:pt>
                <c:pt idx="526">
                  <c:v>1033</c:v>
                </c:pt>
                <c:pt idx="527">
                  <c:v>1034</c:v>
                </c:pt>
                <c:pt idx="528">
                  <c:v>1035</c:v>
                </c:pt>
                <c:pt idx="529">
                  <c:v>1037</c:v>
                </c:pt>
                <c:pt idx="530">
                  <c:v>1039</c:v>
                </c:pt>
                <c:pt idx="531">
                  <c:v>1040</c:v>
                </c:pt>
                <c:pt idx="532">
                  <c:v>1041</c:v>
                </c:pt>
                <c:pt idx="533">
                  <c:v>1043</c:v>
                </c:pt>
                <c:pt idx="534">
                  <c:v>1044</c:v>
                </c:pt>
                <c:pt idx="535">
                  <c:v>1045</c:v>
                </c:pt>
                <c:pt idx="536">
                  <c:v>1046</c:v>
                </c:pt>
                <c:pt idx="537">
                  <c:v>1047</c:v>
                </c:pt>
                <c:pt idx="538">
                  <c:v>1048</c:v>
                </c:pt>
                <c:pt idx="539">
                  <c:v>1049</c:v>
                </c:pt>
                <c:pt idx="540">
                  <c:v>1050</c:v>
                </c:pt>
                <c:pt idx="541">
                  <c:v>1051</c:v>
                </c:pt>
                <c:pt idx="542">
                  <c:v>1052</c:v>
                </c:pt>
                <c:pt idx="543">
                  <c:v>1053</c:v>
                </c:pt>
                <c:pt idx="544">
                  <c:v>1054</c:v>
                </c:pt>
                <c:pt idx="545">
                  <c:v>1055</c:v>
                </c:pt>
                <c:pt idx="546">
                  <c:v>1057</c:v>
                </c:pt>
                <c:pt idx="547">
                  <c:v>1059</c:v>
                </c:pt>
                <c:pt idx="548">
                  <c:v>1060</c:v>
                </c:pt>
                <c:pt idx="549">
                  <c:v>1061</c:v>
                </c:pt>
                <c:pt idx="550">
                  <c:v>1062</c:v>
                </c:pt>
                <c:pt idx="551">
                  <c:v>1063</c:v>
                </c:pt>
                <c:pt idx="552">
                  <c:v>1064</c:v>
                </c:pt>
                <c:pt idx="553">
                  <c:v>1065</c:v>
                </c:pt>
                <c:pt idx="554">
                  <c:v>1066</c:v>
                </c:pt>
                <c:pt idx="555">
                  <c:v>1067</c:v>
                </c:pt>
                <c:pt idx="556">
                  <c:v>1068</c:v>
                </c:pt>
                <c:pt idx="557">
                  <c:v>1069</c:v>
                </c:pt>
                <c:pt idx="558">
                  <c:v>1070</c:v>
                </c:pt>
                <c:pt idx="559">
                  <c:v>1072</c:v>
                </c:pt>
                <c:pt idx="560">
                  <c:v>1073</c:v>
                </c:pt>
                <c:pt idx="561">
                  <c:v>1074</c:v>
                </c:pt>
                <c:pt idx="562">
                  <c:v>1077</c:v>
                </c:pt>
                <c:pt idx="563">
                  <c:v>1080</c:v>
                </c:pt>
                <c:pt idx="564">
                  <c:v>1081</c:v>
                </c:pt>
                <c:pt idx="565">
                  <c:v>1082</c:v>
                </c:pt>
                <c:pt idx="566">
                  <c:v>1083</c:v>
                </c:pt>
                <c:pt idx="567">
                  <c:v>1084</c:v>
                </c:pt>
                <c:pt idx="568">
                  <c:v>1085</c:v>
                </c:pt>
                <c:pt idx="569">
                  <c:v>1090</c:v>
                </c:pt>
                <c:pt idx="570">
                  <c:v>1091</c:v>
                </c:pt>
                <c:pt idx="571">
                  <c:v>1092</c:v>
                </c:pt>
                <c:pt idx="572">
                  <c:v>1093</c:v>
                </c:pt>
                <c:pt idx="573">
                  <c:v>1094</c:v>
                </c:pt>
                <c:pt idx="574">
                  <c:v>1099</c:v>
                </c:pt>
                <c:pt idx="575">
                  <c:v>1100</c:v>
                </c:pt>
                <c:pt idx="576">
                  <c:v>1101</c:v>
                </c:pt>
                <c:pt idx="577">
                  <c:v>1102</c:v>
                </c:pt>
                <c:pt idx="578">
                  <c:v>1103</c:v>
                </c:pt>
                <c:pt idx="579">
                  <c:v>1104</c:v>
                </c:pt>
                <c:pt idx="580">
                  <c:v>1105</c:v>
                </c:pt>
                <c:pt idx="581">
                  <c:v>1106</c:v>
                </c:pt>
                <c:pt idx="582">
                  <c:v>1107</c:v>
                </c:pt>
                <c:pt idx="583">
                  <c:v>1108</c:v>
                </c:pt>
                <c:pt idx="584">
                  <c:v>1110</c:v>
                </c:pt>
                <c:pt idx="585">
                  <c:v>1111</c:v>
                </c:pt>
                <c:pt idx="586">
                  <c:v>1112</c:v>
                </c:pt>
                <c:pt idx="587">
                  <c:v>1113</c:v>
                </c:pt>
                <c:pt idx="588">
                  <c:v>1114</c:v>
                </c:pt>
                <c:pt idx="589">
                  <c:v>1115</c:v>
                </c:pt>
                <c:pt idx="590">
                  <c:v>1116</c:v>
                </c:pt>
                <c:pt idx="591">
                  <c:v>1118</c:v>
                </c:pt>
                <c:pt idx="592">
                  <c:v>1119</c:v>
                </c:pt>
                <c:pt idx="593">
                  <c:v>1120</c:v>
                </c:pt>
                <c:pt idx="594">
                  <c:v>1121</c:v>
                </c:pt>
                <c:pt idx="595">
                  <c:v>1122</c:v>
                </c:pt>
                <c:pt idx="596">
                  <c:v>1123</c:v>
                </c:pt>
                <c:pt idx="597">
                  <c:v>1124</c:v>
                </c:pt>
                <c:pt idx="598">
                  <c:v>1130</c:v>
                </c:pt>
                <c:pt idx="599">
                  <c:v>1131</c:v>
                </c:pt>
                <c:pt idx="600">
                  <c:v>1132</c:v>
                </c:pt>
                <c:pt idx="601">
                  <c:v>1133</c:v>
                </c:pt>
                <c:pt idx="602">
                  <c:v>1134</c:v>
                </c:pt>
                <c:pt idx="603">
                  <c:v>1135</c:v>
                </c:pt>
                <c:pt idx="604">
                  <c:v>1136</c:v>
                </c:pt>
                <c:pt idx="605">
                  <c:v>1137</c:v>
                </c:pt>
                <c:pt idx="606">
                  <c:v>1138</c:v>
                </c:pt>
                <c:pt idx="607">
                  <c:v>1139</c:v>
                </c:pt>
                <c:pt idx="608">
                  <c:v>1140</c:v>
                </c:pt>
                <c:pt idx="609">
                  <c:v>1141</c:v>
                </c:pt>
                <c:pt idx="610">
                  <c:v>1142</c:v>
                </c:pt>
                <c:pt idx="611">
                  <c:v>1143</c:v>
                </c:pt>
                <c:pt idx="612">
                  <c:v>1145</c:v>
                </c:pt>
                <c:pt idx="613">
                  <c:v>1146</c:v>
                </c:pt>
                <c:pt idx="614">
                  <c:v>1147</c:v>
                </c:pt>
                <c:pt idx="615">
                  <c:v>1148</c:v>
                </c:pt>
                <c:pt idx="616">
                  <c:v>1149</c:v>
                </c:pt>
                <c:pt idx="617">
                  <c:v>1150</c:v>
                </c:pt>
                <c:pt idx="618">
                  <c:v>1151</c:v>
                </c:pt>
                <c:pt idx="619">
                  <c:v>1153</c:v>
                </c:pt>
                <c:pt idx="620">
                  <c:v>1154</c:v>
                </c:pt>
                <c:pt idx="621">
                  <c:v>1155</c:v>
                </c:pt>
                <c:pt idx="622">
                  <c:v>1156</c:v>
                </c:pt>
                <c:pt idx="623">
                  <c:v>1157</c:v>
                </c:pt>
                <c:pt idx="624">
                  <c:v>1158</c:v>
                </c:pt>
                <c:pt idx="625">
                  <c:v>1159</c:v>
                </c:pt>
                <c:pt idx="626">
                  <c:v>1160</c:v>
                </c:pt>
                <c:pt idx="627">
                  <c:v>1161</c:v>
                </c:pt>
                <c:pt idx="628">
                  <c:v>1162</c:v>
                </c:pt>
                <c:pt idx="629">
                  <c:v>1165</c:v>
                </c:pt>
                <c:pt idx="630">
                  <c:v>1166</c:v>
                </c:pt>
                <c:pt idx="631">
                  <c:v>1167</c:v>
                </c:pt>
                <c:pt idx="632">
                  <c:v>1168</c:v>
                </c:pt>
                <c:pt idx="633">
                  <c:v>1169</c:v>
                </c:pt>
                <c:pt idx="634">
                  <c:v>1170</c:v>
                </c:pt>
                <c:pt idx="635">
                  <c:v>1173</c:v>
                </c:pt>
                <c:pt idx="636">
                  <c:v>1174</c:v>
                </c:pt>
                <c:pt idx="637">
                  <c:v>1175</c:v>
                </c:pt>
                <c:pt idx="638">
                  <c:v>1180</c:v>
                </c:pt>
                <c:pt idx="639">
                  <c:v>1181</c:v>
                </c:pt>
                <c:pt idx="640">
                  <c:v>1182</c:v>
                </c:pt>
                <c:pt idx="641">
                  <c:v>1183</c:v>
                </c:pt>
                <c:pt idx="642">
                  <c:v>1184</c:v>
                </c:pt>
                <c:pt idx="643">
                  <c:v>1185</c:v>
                </c:pt>
                <c:pt idx="644">
                  <c:v>1186</c:v>
                </c:pt>
                <c:pt idx="645">
                  <c:v>1187</c:v>
                </c:pt>
                <c:pt idx="646">
                  <c:v>1188</c:v>
                </c:pt>
                <c:pt idx="647">
                  <c:v>1189</c:v>
                </c:pt>
                <c:pt idx="648">
                  <c:v>1190</c:v>
                </c:pt>
                <c:pt idx="649">
                  <c:v>1192</c:v>
                </c:pt>
                <c:pt idx="650">
                  <c:v>1193</c:v>
                </c:pt>
                <c:pt idx="651">
                  <c:v>1194</c:v>
                </c:pt>
                <c:pt idx="652">
                  <c:v>1195</c:v>
                </c:pt>
                <c:pt idx="653">
                  <c:v>1197</c:v>
                </c:pt>
                <c:pt idx="654">
                  <c:v>1198</c:v>
                </c:pt>
                <c:pt idx="655">
                  <c:v>1199</c:v>
                </c:pt>
                <c:pt idx="656">
                  <c:v>1200</c:v>
                </c:pt>
                <c:pt idx="657">
                  <c:v>1201</c:v>
                </c:pt>
                <c:pt idx="658">
                  <c:v>1203</c:v>
                </c:pt>
                <c:pt idx="659">
                  <c:v>1204</c:v>
                </c:pt>
                <c:pt idx="660">
                  <c:v>1205</c:v>
                </c:pt>
                <c:pt idx="661">
                  <c:v>1208</c:v>
                </c:pt>
                <c:pt idx="662">
                  <c:v>1209</c:v>
                </c:pt>
                <c:pt idx="663">
                  <c:v>1210</c:v>
                </c:pt>
                <c:pt idx="664">
                  <c:v>1214</c:v>
                </c:pt>
                <c:pt idx="665">
                  <c:v>1215</c:v>
                </c:pt>
                <c:pt idx="666">
                  <c:v>1216</c:v>
                </c:pt>
                <c:pt idx="667">
                  <c:v>1217</c:v>
                </c:pt>
                <c:pt idx="668">
                  <c:v>1220</c:v>
                </c:pt>
                <c:pt idx="669">
                  <c:v>1221</c:v>
                </c:pt>
                <c:pt idx="670">
                  <c:v>1225</c:v>
                </c:pt>
                <c:pt idx="671">
                  <c:v>1229</c:v>
                </c:pt>
                <c:pt idx="672">
                  <c:v>1231</c:v>
                </c:pt>
                <c:pt idx="673">
                  <c:v>1232</c:v>
                </c:pt>
                <c:pt idx="674">
                  <c:v>1242</c:v>
                </c:pt>
                <c:pt idx="675">
                  <c:v>1253</c:v>
                </c:pt>
                <c:pt idx="676">
                  <c:v>1255</c:v>
                </c:pt>
                <c:pt idx="677">
                  <c:v>1256</c:v>
                </c:pt>
                <c:pt idx="678">
                  <c:v>1258</c:v>
                </c:pt>
                <c:pt idx="679">
                  <c:v>1259</c:v>
                </c:pt>
                <c:pt idx="680">
                  <c:v>1260</c:v>
                </c:pt>
                <c:pt idx="681">
                  <c:v>1261</c:v>
                </c:pt>
                <c:pt idx="682">
                  <c:v>1262</c:v>
                </c:pt>
                <c:pt idx="683">
                  <c:v>1263</c:v>
                </c:pt>
                <c:pt idx="684">
                  <c:v>1264</c:v>
                </c:pt>
                <c:pt idx="685">
                  <c:v>1266</c:v>
                </c:pt>
                <c:pt idx="686">
                  <c:v>1269</c:v>
                </c:pt>
                <c:pt idx="687">
                  <c:v>1279</c:v>
                </c:pt>
                <c:pt idx="688">
                  <c:v>1280</c:v>
                </c:pt>
                <c:pt idx="689">
                  <c:v>1290</c:v>
                </c:pt>
                <c:pt idx="690">
                  <c:v>1291</c:v>
                </c:pt>
                <c:pt idx="691">
                  <c:v>1292</c:v>
                </c:pt>
                <c:pt idx="692">
                  <c:v>1293</c:v>
                </c:pt>
                <c:pt idx="693">
                  <c:v>1294</c:v>
                </c:pt>
                <c:pt idx="694">
                  <c:v>1295</c:v>
                </c:pt>
                <c:pt idx="695">
                  <c:v>1300</c:v>
                </c:pt>
                <c:pt idx="696">
                  <c:v>1301</c:v>
                </c:pt>
                <c:pt idx="697">
                  <c:v>1302</c:v>
                </c:pt>
                <c:pt idx="698">
                  <c:v>1303</c:v>
                </c:pt>
                <c:pt idx="699">
                  <c:v>1305</c:v>
                </c:pt>
                <c:pt idx="700">
                  <c:v>1306</c:v>
                </c:pt>
                <c:pt idx="701">
                  <c:v>1307</c:v>
                </c:pt>
                <c:pt idx="702">
                  <c:v>1308</c:v>
                </c:pt>
                <c:pt idx="703">
                  <c:v>1310</c:v>
                </c:pt>
                <c:pt idx="704">
                  <c:v>1311</c:v>
                </c:pt>
                <c:pt idx="705">
                  <c:v>1312</c:v>
                </c:pt>
                <c:pt idx="706">
                  <c:v>1313</c:v>
                </c:pt>
                <c:pt idx="707">
                  <c:v>1314</c:v>
                </c:pt>
                <c:pt idx="708">
                  <c:v>1315</c:v>
                </c:pt>
                <c:pt idx="709">
                  <c:v>1316</c:v>
                </c:pt>
                <c:pt idx="710">
                  <c:v>1317</c:v>
                </c:pt>
                <c:pt idx="711">
                  <c:v>1318</c:v>
                </c:pt>
                <c:pt idx="712">
                  <c:v>1319</c:v>
                </c:pt>
                <c:pt idx="713">
                  <c:v>1320</c:v>
                </c:pt>
                <c:pt idx="714">
                  <c:v>1322</c:v>
                </c:pt>
                <c:pt idx="715">
                  <c:v>1323</c:v>
                </c:pt>
                <c:pt idx="716">
                  <c:v>1324</c:v>
                </c:pt>
                <c:pt idx="717">
                  <c:v>1325</c:v>
                </c:pt>
                <c:pt idx="718">
                  <c:v>1326</c:v>
                </c:pt>
                <c:pt idx="719">
                  <c:v>1327</c:v>
                </c:pt>
                <c:pt idx="720">
                  <c:v>1328</c:v>
                </c:pt>
                <c:pt idx="721">
                  <c:v>1329</c:v>
                </c:pt>
                <c:pt idx="722">
                  <c:v>1331</c:v>
                </c:pt>
                <c:pt idx="723">
                  <c:v>1333</c:v>
                </c:pt>
                <c:pt idx="724">
                  <c:v>1337</c:v>
                </c:pt>
                <c:pt idx="725">
                  <c:v>1338</c:v>
                </c:pt>
                <c:pt idx="726">
                  <c:v>1339</c:v>
                </c:pt>
                <c:pt idx="727">
                  <c:v>1342</c:v>
                </c:pt>
                <c:pt idx="728">
                  <c:v>1343</c:v>
                </c:pt>
                <c:pt idx="729">
                  <c:v>1344</c:v>
                </c:pt>
                <c:pt idx="730">
                  <c:v>1345</c:v>
                </c:pt>
                <c:pt idx="731">
                  <c:v>1346</c:v>
                </c:pt>
                <c:pt idx="732">
                  <c:v>1348</c:v>
                </c:pt>
                <c:pt idx="733">
                  <c:v>1349</c:v>
                </c:pt>
                <c:pt idx="734">
                  <c:v>1353</c:v>
                </c:pt>
                <c:pt idx="735">
                  <c:v>1355</c:v>
                </c:pt>
                <c:pt idx="736">
                  <c:v>1360</c:v>
                </c:pt>
                <c:pt idx="737">
                  <c:v>1361</c:v>
                </c:pt>
                <c:pt idx="738">
                  <c:v>1363</c:v>
                </c:pt>
                <c:pt idx="739">
                  <c:v>1364</c:v>
                </c:pt>
                <c:pt idx="740">
                  <c:v>1365</c:v>
                </c:pt>
                <c:pt idx="741">
                  <c:v>1366</c:v>
                </c:pt>
                <c:pt idx="742">
                  <c:v>1367</c:v>
                </c:pt>
                <c:pt idx="743">
                  <c:v>1369</c:v>
                </c:pt>
                <c:pt idx="744">
                  <c:v>1372</c:v>
                </c:pt>
                <c:pt idx="745">
                  <c:v>1373</c:v>
                </c:pt>
                <c:pt idx="746">
                  <c:v>1374</c:v>
                </c:pt>
                <c:pt idx="747">
                  <c:v>1375</c:v>
                </c:pt>
                <c:pt idx="748">
                  <c:v>1376</c:v>
                </c:pt>
                <c:pt idx="749">
                  <c:v>1377</c:v>
                </c:pt>
                <c:pt idx="750">
                  <c:v>1378</c:v>
                </c:pt>
                <c:pt idx="751">
                  <c:v>1379</c:v>
                </c:pt>
                <c:pt idx="752">
                  <c:v>1380</c:v>
                </c:pt>
                <c:pt idx="753">
                  <c:v>1381</c:v>
                </c:pt>
                <c:pt idx="754">
                  <c:v>1383</c:v>
                </c:pt>
                <c:pt idx="755">
                  <c:v>1384</c:v>
                </c:pt>
                <c:pt idx="756">
                  <c:v>1385</c:v>
                </c:pt>
                <c:pt idx="757">
                  <c:v>1386</c:v>
                </c:pt>
                <c:pt idx="758">
                  <c:v>1390</c:v>
                </c:pt>
                <c:pt idx="759">
                  <c:v>1391</c:v>
                </c:pt>
                <c:pt idx="760">
                  <c:v>1392</c:v>
                </c:pt>
                <c:pt idx="761">
                  <c:v>1393</c:v>
                </c:pt>
                <c:pt idx="762">
                  <c:v>1394</c:v>
                </c:pt>
                <c:pt idx="763">
                  <c:v>1395</c:v>
                </c:pt>
                <c:pt idx="764">
                  <c:v>1396</c:v>
                </c:pt>
                <c:pt idx="765">
                  <c:v>1397</c:v>
                </c:pt>
                <c:pt idx="766">
                  <c:v>1398</c:v>
                </c:pt>
                <c:pt idx="767">
                  <c:v>1400</c:v>
                </c:pt>
                <c:pt idx="768">
                  <c:v>1401</c:v>
                </c:pt>
                <c:pt idx="769">
                  <c:v>1402</c:v>
                </c:pt>
                <c:pt idx="770">
                  <c:v>1403</c:v>
                </c:pt>
                <c:pt idx="771">
                  <c:v>1405</c:v>
                </c:pt>
                <c:pt idx="772">
                  <c:v>1407</c:v>
                </c:pt>
                <c:pt idx="773">
                  <c:v>1408</c:v>
                </c:pt>
                <c:pt idx="774">
                  <c:v>1410</c:v>
                </c:pt>
                <c:pt idx="775">
                  <c:v>1411</c:v>
                </c:pt>
                <c:pt idx="776">
                  <c:v>1412</c:v>
                </c:pt>
                <c:pt idx="777">
                  <c:v>1413</c:v>
                </c:pt>
                <c:pt idx="778">
                  <c:v>1414</c:v>
                </c:pt>
                <c:pt idx="779">
                  <c:v>1415</c:v>
                </c:pt>
                <c:pt idx="780">
                  <c:v>1416</c:v>
                </c:pt>
                <c:pt idx="781">
                  <c:v>1417</c:v>
                </c:pt>
                <c:pt idx="782">
                  <c:v>1418</c:v>
                </c:pt>
                <c:pt idx="783">
                  <c:v>1419</c:v>
                </c:pt>
                <c:pt idx="784">
                  <c:v>1420</c:v>
                </c:pt>
                <c:pt idx="785">
                  <c:v>1421</c:v>
                </c:pt>
                <c:pt idx="786">
                  <c:v>1423</c:v>
                </c:pt>
                <c:pt idx="787">
                  <c:v>1424</c:v>
                </c:pt>
                <c:pt idx="788">
                  <c:v>1425</c:v>
                </c:pt>
                <c:pt idx="789">
                  <c:v>1426</c:v>
                </c:pt>
                <c:pt idx="790">
                  <c:v>1427</c:v>
                </c:pt>
                <c:pt idx="791">
                  <c:v>1428</c:v>
                </c:pt>
                <c:pt idx="792">
                  <c:v>1429</c:v>
                </c:pt>
                <c:pt idx="793">
                  <c:v>1430</c:v>
                </c:pt>
                <c:pt idx="794">
                  <c:v>1432</c:v>
                </c:pt>
                <c:pt idx="795">
                  <c:v>1434</c:v>
                </c:pt>
                <c:pt idx="796">
                  <c:v>1435</c:v>
                </c:pt>
                <c:pt idx="797">
                  <c:v>1436</c:v>
                </c:pt>
                <c:pt idx="798">
                  <c:v>1437</c:v>
                </c:pt>
                <c:pt idx="799">
                  <c:v>1439</c:v>
                </c:pt>
                <c:pt idx="800">
                  <c:v>1440</c:v>
                </c:pt>
                <c:pt idx="801">
                  <c:v>1442</c:v>
                </c:pt>
                <c:pt idx="802">
                  <c:v>1443</c:v>
                </c:pt>
                <c:pt idx="803">
                  <c:v>1444</c:v>
                </c:pt>
                <c:pt idx="804">
                  <c:v>1445</c:v>
                </c:pt>
                <c:pt idx="805">
                  <c:v>1446</c:v>
                </c:pt>
                <c:pt idx="806">
                  <c:v>1447</c:v>
                </c:pt>
                <c:pt idx="807">
                  <c:v>1448</c:v>
                </c:pt>
                <c:pt idx="808">
                  <c:v>1449</c:v>
                </c:pt>
                <c:pt idx="809">
                  <c:v>1450</c:v>
                </c:pt>
                <c:pt idx="810">
                  <c:v>1451</c:v>
                </c:pt>
                <c:pt idx="811">
                  <c:v>1453</c:v>
                </c:pt>
                <c:pt idx="812">
                  <c:v>1454</c:v>
                </c:pt>
                <c:pt idx="813">
                  <c:v>1455</c:v>
                </c:pt>
                <c:pt idx="814">
                  <c:v>1456</c:v>
                </c:pt>
                <c:pt idx="815">
                  <c:v>1457</c:v>
                </c:pt>
                <c:pt idx="816">
                  <c:v>1458</c:v>
                </c:pt>
                <c:pt idx="817">
                  <c:v>1459</c:v>
                </c:pt>
                <c:pt idx="818">
                  <c:v>1460</c:v>
                </c:pt>
                <c:pt idx="819">
                  <c:v>1461</c:v>
                </c:pt>
                <c:pt idx="820">
                  <c:v>1462</c:v>
                </c:pt>
                <c:pt idx="821">
                  <c:v>1463</c:v>
                </c:pt>
                <c:pt idx="822">
                  <c:v>1464</c:v>
                </c:pt>
                <c:pt idx="823">
                  <c:v>1465</c:v>
                </c:pt>
                <c:pt idx="824">
                  <c:v>1466</c:v>
                </c:pt>
                <c:pt idx="825">
                  <c:v>1467</c:v>
                </c:pt>
                <c:pt idx="826">
                  <c:v>1468</c:v>
                </c:pt>
                <c:pt idx="827">
                  <c:v>1469</c:v>
                </c:pt>
                <c:pt idx="828">
                  <c:v>1470</c:v>
                </c:pt>
                <c:pt idx="829">
                  <c:v>1471</c:v>
                </c:pt>
                <c:pt idx="830">
                  <c:v>1472</c:v>
                </c:pt>
                <c:pt idx="831">
                  <c:v>1473</c:v>
                </c:pt>
                <c:pt idx="832">
                  <c:v>1474</c:v>
                </c:pt>
                <c:pt idx="833">
                  <c:v>1475</c:v>
                </c:pt>
                <c:pt idx="834">
                  <c:v>1476</c:v>
                </c:pt>
                <c:pt idx="835">
                  <c:v>1477</c:v>
                </c:pt>
                <c:pt idx="836">
                  <c:v>1478</c:v>
                </c:pt>
                <c:pt idx="837">
                  <c:v>1479</c:v>
                </c:pt>
                <c:pt idx="838">
                  <c:v>1480</c:v>
                </c:pt>
                <c:pt idx="839">
                  <c:v>1481</c:v>
                </c:pt>
                <c:pt idx="840">
                  <c:v>1482</c:v>
                </c:pt>
                <c:pt idx="841">
                  <c:v>1483</c:v>
                </c:pt>
                <c:pt idx="842">
                  <c:v>1484</c:v>
                </c:pt>
                <c:pt idx="843">
                  <c:v>1485</c:v>
                </c:pt>
                <c:pt idx="844">
                  <c:v>1486</c:v>
                </c:pt>
                <c:pt idx="845">
                  <c:v>1487</c:v>
                </c:pt>
                <c:pt idx="846">
                  <c:v>1488</c:v>
                </c:pt>
                <c:pt idx="847">
                  <c:v>1489</c:v>
                </c:pt>
                <c:pt idx="848">
                  <c:v>1490</c:v>
                </c:pt>
                <c:pt idx="849">
                  <c:v>1491</c:v>
                </c:pt>
                <c:pt idx="850">
                  <c:v>1492</c:v>
                </c:pt>
                <c:pt idx="851">
                  <c:v>1493</c:v>
                </c:pt>
                <c:pt idx="852">
                  <c:v>1494</c:v>
                </c:pt>
                <c:pt idx="853">
                  <c:v>1495</c:v>
                </c:pt>
                <c:pt idx="854">
                  <c:v>1496</c:v>
                </c:pt>
                <c:pt idx="855">
                  <c:v>1497</c:v>
                </c:pt>
                <c:pt idx="856">
                  <c:v>1498</c:v>
                </c:pt>
                <c:pt idx="857">
                  <c:v>1499</c:v>
                </c:pt>
                <c:pt idx="858">
                  <c:v>1500</c:v>
                </c:pt>
                <c:pt idx="859">
                  <c:v>1501</c:v>
                </c:pt>
                <c:pt idx="860">
                  <c:v>1502</c:v>
                </c:pt>
                <c:pt idx="861">
                  <c:v>1503</c:v>
                </c:pt>
                <c:pt idx="862">
                  <c:v>1504</c:v>
                </c:pt>
                <c:pt idx="863">
                  <c:v>1505</c:v>
                </c:pt>
                <c:pt idx="864">
                  <c:v>1506</c:v>
                </c:pt>
                <c:pt idx="865">
                  <c:v>1507</c:v>
                </c:pt>
                <c:pt idx="866">
                  <c:v>1509</c:v>
                </c:pt>
                <c:pt idx="867">
                  <c:v>1510</c:v>
                </c:pt>
                <c:pt idx="868">
                  <c:v>1511</c:v>
                </c:pt>
                <c:pt idx="869">
                  <c:v>1512</c:v>
                </c:pt>
                <c:pt idx="870">
                  <c:v>1514</c:v>
                </c:pt>
                <c:pt idx="871">
                  <c:v>1515</c:v>
                </c:pt>
                <c:pt idx="872">
                  <c:v>1516</c:v>
                </c:pt>
                <c:pt idx="873">
                  <c:v>1517</c:v>
                </c:pt>
                <c:pt idx="874">
                  <c:v>1518</c:v>
                </c:pt>
                <c:pt idx="875">
                  <c:v>1519</c:v>
                </c:pt>
                <c:pt idx="876">
                  <c:v>1520</c:v>
                </c:pt>
                <c:pt idx="877">
                  <c:v>1521</c:v>
                </c:pt>
                <c:pt idx="878">
                  <c:v>1522</c:v>
                </c:pt>
                <c:pt idx="879">
                  <c:v>1523</c:v>
                </c:pt>
                <c:pt idx="880">
                  <c:v>1524</c:v>
                </c:pt>
                <c:pt idx="881">
                  <c:v>1525</c:v>
                </c:pt>
                <c:pt idx="882">
                  <c:v>1526</c:v>
                </c:pt>
                <c:pt idx="883">
                  <c:v>1527</c:v>
                </c:pt>
                <c:pt idx="884">
                  <c:v>1528</c:v>
                </c:pt>
                <c:pt idx="885">
                  <c:v>1529</c:v>
                </c:pt>
                <c:pt idx="886">
                  <c:v>1530</c:v>
                </c:pt>
                <c:pt idx="887">
                  <c:v>1531</c:v>
                </c:pt>
                <c:pt idx="888">
                  <c:v>1532</c:v>
                </c:pt>
                <c:pt idx="889">
                  <c:v>1533</c:v>
                </c:pt>
                <c:pt idx="890">
                  <c:v>1534</c:v>
                </c:pt>
                <c:pt idx="891">
                  <c:v>1535</c:v>
                </c:pt>
                <c:pt idx="892">
                  <c:v>1536</c:v>
                </c:pt>
                <c:pt idx="893">
                  <c:v>1537</c:v>
                </c:pt>
                <c:pt idx="894">
                  <c:v>1538</c:v>
                </c:pt>
                <c:pt idx="895">
                  <c:v>1539</c:v>
                </c:pt>
                <c:pt idx="896">
                  <c:v>1540</c:v>
                </c:pt>
                <c:pt idx="897">
                  <c:v>1541</c:v>
                </c:pt>
                <c:pt idx="898">
                  <c:v>1542</c:v>
                </c:pt>
                <c:pt idx="899">
                  <c:v>1543</c:v>
                </c:pt>
                <c:pt idx="900">
                  <c:v>1544</c:v>
                </c:pt>
                <c:pt idx="901">
                  <c:v>1545</c:v>
                </c:pt>
                <c:pt idx="902">
                  <c:v>1546</c:v>
                </c:pt>
                <c:pt idx="903">
                  <c:v>1547</c:v>
                </c:pt>
                <c:pt idx="904">
                  <c:v>1548</c:v>
                </c:pt>
                <c:pt idx="905">
                  <c:v>1549</c:v>
                </c:pt>
                <c:pt idx="906">
                  <c:v>1550</c:v>
                </c:pt>
                <c:pt idx="907">
                  <c:v>1551</c:v>
                </c:pt>
                <c:pt idx="908">
                  <c:v>1552</c:v>
                </c:pt>
                <c:pt idx="909">
                  <c:v>1553</c:v>
                </c:pt>
                <c:pt idx="910">
                  <c:v>1554</c:v>
                </c:pt>
                <c:pt idx="911">
                  <c:v>1555</c:v>
                </c:pt>
                <c:pt idx="912">
                  <c:v>1556</c:v>
                </c:pt>
                <c:pt idx="913">
                  <c:v>1557</c:v>
                </c:pt>
                <c:pt idx="914">
                  <c:v>1558</c:v>
                </c:pt>
                <c:pt idx="915">
                  <c:v>1559</c:v>
                </c:pt>
                <c:pt idx="916">
                  <c:v>1560</c:v>
                </c:pt>
                <c:pt idx="917">
                  <c:v>1561</c:v>
                </c:pt>
                <c:pt idx="918">
                  <c:v>1562</c:v>
                </c:pt>
                <c:pt idx="919">
                  <c:v>1563</c:v>
                </c:pt>
                <c:pt idx="920">
                  <c:v>1564</c:v>
                </c:pt>
                <c:pt idx="921">
                  <c:v>1565</c:v>
                </c:pt>
                <c:pt idx="922">
                  <c:v>1566</c:v>
                </c:pt>
                <c:pt idx="923">
                  <c:v>1567</c:v>
                </c:pt>
                <c:pt idx="924">
                  <c:v>1568</c:v>
                </c:pt>
                <c:pt idx="925">
                  <c:v>1569</c:v>
                </c:pt>
                <c:pt idx="926">
                  <c:v>1570</c:v>
                </c:pt>
                <c:pt idx="927">
                  <c:v>1571</c:v>
                </c:pt>
                <c:pt idx="928">
                  <c:v>1572</c:v>
                </c:pt>
                <c:pt idx="929">
                  <c:v>1573</c:v>
                </c:pt>
                <c:pt idx="930">
                  <c:v>1574</c:v>
                </c:pt>
                <c:pt idx="931">
                  <c:v>1575</c:v>
                </c:pt>
                <c:pt idx="932">
                  <c:v>1576</c:v>
                </c:pt>
                <c:pt idx="933">
                  <c:v>1577</c:v>
                </c:pt>
                <c:pt idx="934">
                  <c:v>1578</c:v>
                </c:pt>
                <c:pt idx="935">
                  <c:v>1579</c:v>
                </c:pt>
                <c:pt idx="936">
                  <c:v>1580</c:v>
                </c:pt>
                <c:pt idx="937">
                  <c:v>1582</c:v>
                </c:pt>
                <c:pt idx="938">
                  <c:v>1583</c:v>
                </c:pt>
                <c:pt idx="939">
                  <c:v>1584</c:v>
                </c:pt>
                <c:pt idx="940">
                  <c:v>1585</c:v>
                </c:pt>
                <c:pt idx="941">
                  <c:v>1586</c:v>
                </c:pt>
                <c:pt idx="942">
                  <c:v>1587</c:v>
                </c:pt>
                <c:pt idx="943">
                  <c:v>1588</c:v>
                </c:pt>
                <c:pt idx="944">
                  <c:v>1589</c:v>
                </c:pt>
                <c:pt idx="945">
                  <c:v>1591</c:v>
                </c:pt>
                <c:pt idx="946">
                  <c:v>1592</c:v>
                </c:pt>
                <c:pt idx="947">
                  <c:v>1593</c:v>
                </c:pt>
                <c:pt idx="948">
                  <c:v>1594</c:v>
                </c:pt>
                <c:pt idx="949">
                  <c:v>1595</c:v>
                </c:pt>
                <c:pt idx="950">
                  <c:v>1596</c:v>
                </c:pt>
                <c:pt idx="951">
                  <c:v>1597</c:v>
                </c:pt>
                <c:pt idx="952">
                  <c:v>1598</c:v>
                </c:pt>
                <c:pt idx="953">
                  <c:v>1599</c:v>
                </c:pt>
                <c:pt idx="954">
                  <c:v>1600</c:v>
                </c:pt>
                <c:pt idx="955">
                  <c:v>1601</c:v>
                </c:pt>
                <c:pt idx="956">
                  <c:v>1602</c:v>
                </c:pt>
                <c:pt idx="957">
                  <c:v>1603</c:v>
                </c:pt>
                <c:pt idx="958">
                  <c:v>1604</c:v>
                </c:pt>
                <c:pt idx="959">
                  <c:v>1605</c:v>
                </c:pt>
                <c:pt idx="960">
                  <c:v>1606</c:v>
                </c:pt>
                <c:pt idx="961">
                  <c:v>1607</c:v>
                </c:pt>
                <c:pt idx="962">
                  <c:v>1608</c:v>
                </c:pt>
                <c:pt idx="963">
                  <c:v>1609</c:v>
                </c:pt>
                <c:pt idx="964">
                  <c:v>1610</c:v>
                </c:pt>
                <c:pt idx="965">
                  <c:v>1611</c:v>
                </c:pt>
                <c:pt idx="966">
                  <c:v>1612</c:v>
                </c:pt>
                <c:pt idx="967">
                  <c:v>1613</c:v>
                </c:pt>
                <c:pt idx="968">
                  <c:v>1614</c:v>
                </c:pt>
                <c:pt idx="969">
                  <c:v>1615</c:v>
                </c:pt>
                <c:pt idx="970">
                  <c:v>1616</c:v>
                </c:pt>
                <c:pt idx="971">
                  <c:v>1617</c:v>
                </c:pt>
                <c:pt idx="972">
                  <c:v>1618</c:v>
                </c:pt>
                <c:pt idx="973">
                  <c:v>1619</c:v>
                </c:pt>
                <c:pt idx="974">
                  <c:v>1620</c:v>
                </c:pt>
                <c:pt idx="975">
                  <c:v>1621</c:v>
                </c:pt>
                <c:pt idx="976">
                  <c:v>1622</c:v>
                </c:pt>
                <c:pt idx="977">
                  <c:v>1623</c:v>
                </c:pt>
                <c:pt idx="978">
                  <c:v>1624</c:v>
                </c:pt>
                <c:pt idx="979">
                  <c:v>1625</c:v>
                </c:pt>
                <c:pt idx="980">
                  <c:v>1626</c:v>
                </c:pt>
                <c:pt idx="981">
                  <c:v>1627</c:v>
                </c:pt>
                <c:pt idx="982">
                  <c:v>1628</c:v>
                </c:pt>
                <c:pt idx="983">
                  <c:v>1629</c:v>
                </c:pt>
                <c:pt idx="984">
                  <c:v>1630</c:v>
                </c:pt>
                <c:pt idx="985">
                  <c:v>1631</c:v>
                </c:pt>
                <c:pt idx="986">
                  <c:v>1632</c:v>
                </c:pt>
                <c:pt idx="987">
                  <c:v>1633</c:v>
                </c:pt>
                <c:pt idx="988">
                  <c:v>1634</c:v>
                </c:pt>
                <c:pt idx="989">
                  <c:v>1635</c:v>
                </c:pt>
                <c:pt idx="990">
                  <c:v>1636</c:v>
                </c:pt>
                <c:pt idx="991">
                  <c:v>1637</c:v>
                </c:pt>
                <c:pt idx="992">
                  <c:v>1638</c:v>
                </c:pt>
                <c:pt idx="993">
                  <c:v>1639</c:v>
                </c:pt>
                <c:pt idx="994">
                  <c:v>1640</c:v>
                </c:pt>
                <c:pt idx="995">
                  <c:v>1641</c:v>
                </c:pt>
                <c:pt idx="996">
                  <c:v>1642</c:v>
                </c:pt>
                <c:pt idx="997">
                  <c:v>1643</c:v>
                </c:pt>
                <c:pt idx="998">
                  <c:v>1644</c:v>
                </c:pt>
                <c:pt idx="999">
                  <c:v>1645</c:v>
                </c:pt>
                <c:pt idx="1000">
                  <c:v>1646</c:v>
                </c:pt>
                <c:pt idx="1001">
                  <c:v>1647</c:v>
                </c:pt>
                <c:pt idx="1002">
                  <c:v>1648</c:v>
                </c:pt>
                <c:pt idx="1003">
                  <c:v>1649</c:v>
                </c:pt>
                <c:pt idx="1004">
                  <c:v>1650</c:v>
                </c:pt>
                <c:pt idx="1005">
                  <c:v>1651</c:v>
                </c:pt>
                <c:pt idx="1006">
                  <c:v>1652</c:v>
                </c:pt>
                <c:pt idx="1007">
                  <c:v>1653</c:v>
                </c:pt>
                <c:pt idx="1008">
                  <c:v>1654</c:v>
                </c:pt>
                <c:pt idx="1009">
                  <c:v>1655</c:v>
                </c:pt>
                <c:pt idx="1010">
                  <c:v>1656</c:v>
                </c:pt>
                <c:pt idx="1011">
                  <c:v>1657</c:v>
                </c:pt>
                <c:pt idx="1012">
                  <c:v>1658</c:v>
                </c:pt>
                <c:pt idx="1013">
                  <c:v>1659</c:v>
                </c:pt>
                <c:pt idx="1014">
                  <c:v>1660</c:v>
                </c:pt>
                <c:pt idx="1015">
                  <c:v>1661</c:v>
                </c:pt>
                <c:pt idx="1016">
                  <c:v>1663</c:v>
                </c:pt>
                <c:pt idx="1017">
                  <c:v>1664</c:v>
                </c:pt>
                <c:pt idx="1018">
                  <c:v>1668</c:v>
                </c:pt>
                <c:pt idx="1019">
                  <c:v>1669</c:v>
                </c:pt>
                <c:pt idx="1020">
                  <c:v>1672</c:v>
                </c:pt>
                <c:pt idx="1021">
                  <c:v>1673</c:v>
                </c:pt>
                <c:pt idx="1022">
                  <c:v>1674</c:v>
                </c:pt>
                <c:pt idx="1023">
                  <c:v>1675</c:v>
                </c:pt>
                <c:pt idx="1024">
                  <c:v>1676</c:v>
                </c:pt>
                <c:pt idx="1025">
                  <c:v>1677</c:v>
                </c:pt>
                <c:pt idx="1026">
                  <c:v>1678</c:v>
                </c:pt>
                <c:pt idx="1027">
                  <c:v>1679</c:v>
                </c:pt>
                <c:pt idx="1028">
                  <c:v>1680</c:v>
                </c:pt>
                <c:pt idx="1029">
                  <c:v>1681</c:v>
                </c:pt>
                <c:pt idx="1030">
                  <c:v>1682</c:v>
                </c:pt>
                <c:pt idx="1031">
                  <c:v>1683</c:v>
                </c:pt>
                <c:pt idx="1032">
                  <c:v>1684</c:v>
                </c:pt>
                <c:pt idx="1033">
                  <c:v>1685</c:v>
                </c:pt>
                <c:pt idx="1034">
                  <c:v>1686</c:v>
                </c:pt>
                <c:pt idx="1035">
                  <c:v>1687</c:v>
                </c:pt>
                <c:pt idx="1036">
                  <c:v>1688</c:v>
                </c:pt>
                <c:pt idx="1037">
                  <c:v>1689</c:v>
                </c:pt>
                <c:pt idx="1038">
                  <c:v>1690</c:v>
                </c:pt>
                <c:pt idx="1039">
                  <c:v>1701</c:v>
                </c:pt>
                <c:pt idx="1040">
                  <c:v>1704</c:v>
                </c:pt>
                <c:pt idx="1041">
                  <c:v>1708</c:v>
                </c:pt>
                <c:pt idx="1042">
                  <c:v>1709</c:v>
                </c:pt>
                <c:pt idx="1043">
                  <c:v>1710</c:v>
                </c:pt>
                <c:pt idx="1044">
                  <c:v>1712</c:v>
                </c:pt>
                <c:pt idx="1045">
                  <c:v>1713</c:v>
                </c:pt>
                <c:pt idx="1046">
                  <c:v>1714</c:v>
                </c:pt>
                <c:pt idx="1047">
                  <c:v>1715</c:v>
                </c:pt>
                <c:pt idx="1048">
                  <c:v>1716</c:v>
                </c:pt>
                <c:pt idx="1049">
                  <c:v>1717</c:v>
                </c:pt>
                <c:pt idx="1050">
                  <c:v>1718</c:v>
                </c:pt>
                <c:pt idx="1051">
                  <c:v>1721</c:v>
                </c:pt>
                <c:pt idx="1052">
                  <c:v>1722</c:v>
                </c:pt>
                <c:pt idx="1053">
                  <c:v>1725</c:v>
                </c:pt>
                <c:pt idx="1054">
                  <c:v>1726</c:v>
                </c:pt>
                <c:pt idx="1055">
                  <c:v>1732</c:v>
                </c:pt>
                <c:pt idx="1056">
                  <c:v>1746</c:v>
                </c:pt>
                <c:pt idx="1057">
                  <c:v>1951</c:v>
                </c:pt>
              </c:numCache>
              <c:extLst xmlns:c15="http://schemas.microsoft.com/office/drawing/2012/chart"/>
            </c:numRef>
          </c:xVal>
          <c:yVal>
            <c:numRef>
              <c:f>'Brachy NFY'!$C$3:$C$1060</c:f>
              <c:numCache>
                <c:formatCode>General</c:formatCode>
                <c:ptCount val="1058"/>
                <c:pt idx="11">
                  <c:v>1</c:v>
                </c:pt>
                <c:pt idx="28">
                  <c:v>1</c:v>
                </c:pt>
                <c:pt idx="31">
                  <c:v>1</c:v>
                </c:pt>
                <c:pt idx="38">
                  <c:v>1</c:v>
                </c:pt>
                <c:pt idx="42">
                  <c:v>1</c:v>
                </c:pt>
                <c:pt idx="43">
                  <c:v>1</c:v>
                </c:pt>
                <c:pt idx="52">
                  <c:v>1</c:v>
                </c:pt>
                <c:pt idx="55">
                  <c:v>1</c:v>
                </c:pt>
                <c:pt idx="67">
                  <c:v>1</c:v>
                </c:pt>
                <c:pt idx="73">
                  <c:v>1</c:v>
                </c:pt>
                <c:pt idx="95">
                  <c:v>1</c:v>
                </c:pt>
                <c:pt idx="96">
                  <c:v>1</c:v>
                </c:pt>
                <c:pt idx="97">
                  <c:v>1</c:v>
                </c:pt>
                <c:pt idx="99">
                  <c:v>1</c:v>
                </c:pt>
                <c:pt idx="101">
                  <c:v>1</c:v>
                </c:pt>
                <c:pt idx="106">
                  <c:v>1</c:v>
                </c:pt>
                <c:pt idx="109">
                  <c:v>1</c:v>
                </c:pt>
                <c:pt idx="116">
                  <c:v>1</c:v>
                </c:pt>
                <c:pt idx="117">
                  <c:v>1</c:v>
                </c:pt>
                <c:pt idx="118">
                  <c:v>1</c:v>
                </c:pt>
                <c:pt idx="120">
                  <c:v>1</c:v>
                </c:pt>
                <c:pt idx="124">
                  <c:v>1</c:v>
                </c:pt>
                <c:pt idx="125">
                  <c:v>1</c:v>
                </c:pt>
                <c:pt idx="130">
                  <c:v>1</c:v>
                </c:pt>
                <c:pt idx="141">
                  <c:v>1</c:v>
                </c:pt>
                <c:pt idx="144">
                  <c:v>1</c:v>
                </c:pt>
                <c:pt idx="147">
                  <c:v>1</c:v>
                </c:pt>
                <c:pt idx="148">
                  <c:v>1</c:v>
                </c:pt>
                <c:pt idx="150">
                  <c:v>1</c:v>
                </c:pt>
                <c:pt idx="151">
                  <c:v>1</c:v>
                </c:pt>
                <c:pt idx="160">
                  <c:v>1</c:v>
                </c:pt>
                <c:pt idx="162">
                  <c:v>1</c:v>
                </c:pt>
                <c:pt idx="163">
                  <c:v>1</c:v>
                </c:pt>
                <c:pt idx="175">
                  <c:v>1</c:v>
                </c:pt>
                <c:pt idx="178">
                  <c:v>1</c:v>
                </c:pt>
                <c:pt idx="179">
                  <c:v>1</c:v>
                </c:pt>
                <c:pt idx="190">
                  <c:v>1</c:v>
                </c:pt>
                <c:pt idx="204">
                  <c:v>1</c:v>
                </c:pt>
                <c:pt idx="210">
                  <c:v>1</c:v>
                </c:pt>
                <c:pt idx="212">
                  <c:v>1</c:v>
                </c:pt>
                <c:pt idx="220">
                  <c:v>1</c:v>
                </c:pt>
                <c:pt idx="222">
                  <c:v>1</c:v>
                </c:pt>
                <c:pt idx="229">
                  <c:v>1</c:v>
                </c:pt>
                <c:pt idx="244">
                  <c:v>1</c:v>
                </c:pt>
                <c:pt idx="247">
                  <c:v>1</c:v>
                </c:pt>
                <c:pt idx="257">
                  <c:v>1</c:v>
                </c:pt>
                <c:pt idx="259">
                  <c:v>1</c:v>
                </c:pt>
                <c:pt idx="262">
                  <c:v>1</c:v>
                </c:pt>
                <c:pt idx="264">
                  <c:v>1</c:v>
                </c:pt>
                <c:pt idx="265">
                  <c:v>1</c:v>
                </c:pt>
                <c:pt idx="266">
                  <c:v>1</c:v>
                </c:pt>
                <c:pt idx="267">
                  <c:v>1</c:v>
                </c:pt>
                <c:pt idx="280">
                  <c:v>1</c:v>
                </c:pt>
                <c:pt idx="294">
                  <c:v>1</c:v>
                </c:pt>
                <c:pt idx="299">
                  <c:v>1</c:v>
                </c:pt>
                <c:pt idx="300">
                  <c:v>1</c:v>
                </c:pt>
                <c:pt idx="301">
                  <c:v>1</c:v>
                </c:pt>
                <c:pt idx="303">
                  <c:v>1</c:v>
                </c:pt>
                <c:pt idx="305">
                  <c:v>1</c:v>
                </c:pt>
                <c:pt idx="313">
                  <c:v>1</c:v>
                </c:pt>
                <c:pt idx="315">
                  <c:v>1</c:v>
                </c:pt>
                <c:pt idx="324">
                  <c:v>1</c:v>
                </c:pt>
                <c:pt idx="330">
                  <c:v>1</c:v>
                </c:pt>
                <c:pt idx="331">
                  <c:v>1</c:v>
                </c:pt>
                <c:pt idx="332">
                  <c:v>1</c:v>
                </c:pt>
                <c:pt idx="334">
                  <c:v>1</c:v>
                </c:pt>
                <c:pt idx="336">
                  <c:v>1</c:v>
                </c:pt>
                <c:pt idx="337">
                  <c:v>1</c:v>
                </c:pt>
                <c:pt idx="342">
                  <c:v>1</c:v>
                </c:pt>
                <c:pt idx="343">
                  <c:v>1</c:v>
                </c:pt>
                <c:pt idx="344">
                  <c:v>1</c:v>
                </c:pt>
                <c:pt idx="345">
                  <c:v>1</c:v>
                </c:pt>
                <c:pt idx="346">
                  <c:v>1</c:v>
                </c:pt>
                <c:pt idx="348">
                  <c:v>1</c:v>
                </c:pt>
                <c:pt idx="354">
                  <c:v>1</c:v>
                </c:pt>
                <c:pt idx="361">
                  <c:v>1</c:v>
                </c:pt>
                <c:pt idx="364">
                  <c:v>1</c:v>
                </c:pt>
                <c:pt idx="366">
                  <c:v>1</c:v>
                </c:pt>
                <c:pt idx="367">
                  <c:v>1</c:v>
                </c:pt>
                <c:pt idx="370">
                  <c:v>1</c:v>
                </c:pt>
                <c:pt idx="373">
                  <c:v>1</c:v>
                </c:pt>
                <c:pt idx="374">
                  <c:v>1</c:v>
                </c:pt>
                <c:pt idx="377">
                  <c:v>1</c:v>
                </c:pt>
                <c:pt idx="383">
                  <c:v>1</c:v>
                </c:pt>
                <c:pt idx="386">
                  <c:v>1</c:v>
                </c:pt>
                <c:pt idx="388">
                  <c:v>1</c:v>
                </c:pt>
                <c:pt idx="392">
                  <c:v>1</c:v>
                </c:pt>
                <c:pt idx="393">
                  <c:v>1</c:v>
                </c:pt>
                <c:pt idx="395">
                  <c:v>1</c:v>
                </c:pt>
                <c:pt idx="401">
                  <c:v>1</c:v>
                </c:pt>
                <c:pt idx="405">
                  <c:v>1</c:v>
                </c:pt>
                <c:pt idx="406">
                  <c:v>1</c:v>
                </c:pt>
                <c:pt idx="414">
                  <c:v>1</c:v>
                </c:pt>
                <c:pt idx="420">
                  <c:v>1</c:v>
                </c:pt>
                <c:pt idx="422">
                  <c:v>1</c:v>
                </c:pt>
                <c:pt idx="423">
                  <c:v>1</c:v>
                </c:pt>
                <c:pt idx="424">
                  <c:v>1</c:v>
                </c:pt>
                <c:pt idx="425">
                  <c:v>1</c:v>
                </c:pt>
                <c:pt idx="428">
                  <c:v>1</c:v>
                </c:pt>
                <c:pt idx="429">
                  <c:v>1</c:v>
                </c:pt>
                <c:pt idx="432">
                  <c:v>1</c:v>
                </c:pt>
                <c:pt idx="433">
                  <c:v>1</c:v>
                </c:pt>
                <c:pt idx="436">
                  <c:v>1</c:v>
                </c:pt>
                <c:pt idx="437">
                  <c:v>1</c:v>
                </c:pt>
                <c:pt idx="443">
                  <c:v>1</c:v>
                </c:pt>
                <c:pt idx="445">
                  <c:v>1</c:v>
                </c:pt>
                <c:pt idx="450">
                  <c:v>1</c:v>
                </c:pt>
                <c:pt idx="453">
                  <c:v>1</c:v>
                </c:pt>
                <c:pt idx="454">
                  <c:v>1</c:v>
                </c:pt>
                <c:pt idx="461">
                  <c:v>1</c:v>
                </c:pt>
                <c:pt idx="467">
                  <c:v>1</c:v>
                </c:pt>
                <c:pt idx="474">
                  <c:v>1</c:v>
                </c:pt>
                <c:pt idx="477">
                  <c:v>1</c:v>
                </c:pt>
                <c:pt idx="480">
                  <c:v>1</c:v>
                </c:pt>
                <c:pt idx="481">
                  <c:v>1</c:v>
                </c:pt>
                <c:pt idx="483">
                  <c:v>1</c:v>
                </c:pt>
                <c:pt idx="491">
                  <c:v>1</c:v>
                </c:pt>
                <c:pt idx="499">
                  <c:v>1</c:v>
                </c:pt>
                <c:pt idx="501">
                  <c:v>1</c:v>
                </c:pt>
                <c:pt idx="503">
                  <c:v>1</c:v>
                </c:pt>
                <c:pt idx="504">
                  <c:v>1</c:v>
                </c:pt>
                <c:pt idx="509">
                  <c:v>1</c:v>
                </c:pt>
                <c:pt idx="510">
                  <c:v>1</c:v>
                </c:pt>
                <c:pt idx="515">
                  <c:v>1</c:v>
                </c:pt>
                <c:pt idx="518">
                  <c:v>1</c:v>
                </c:pt>
                <c:pt idx="522">
                  <c:v>1</c:v>
                </c:pt>
                <c:pt idx="526">
                  <c:v>1</c:v>
                </c:pt>
                <c:pt idx="530">
                  <c:v>1</c:v>
                </c:pt>
                <c:pt idx="534">
                  <c:v>1</c:v>
                </c:pt>
                <c:pt idx="535">
                  <c:v>1</c:v>
                </c:pt>
                <c:pt idx="536">
                  <c:v>1</c:v>
                </c:pt>
                <c:pt idx="538">
                  <c:v>1</c:v>
                </c:pt>
                <c:pt idx="542">
                  <c:v>1</c:v>
                </c:pt>
                <c:pt idx="544">
                  <c:v>1</c:v>
                </c:pt>
                <c:pt idx="549">
                  <c:v>1</c:v>
                </c:pt>
                <c:pt idx="551">
                  <c:v>1</c:v>
                </c:pt>
                <c:pt idx="557">
                  <c:v>1</c:v>
                </c:pt>
                <c:pt idx="560">
                  <c:v>1</c:v>
                </c:pt>
                <c:pt idx="561">
                  <c:v>1</c:v>
                </c:pt>
                <c:pt idx="563">
                  <c:v>1</c:v>
                </c:pt>
                <c:pt idx="564">
                  <c:v>1</c:v>
                </c:pt>
                <c:pt idx="565">
                  <c:v>1</c:v>
                </c:pt>
                <c:pt idx="566">
                  <c:v>1</c:v>
                </c:pt>
                <c:pt idx="567">
                  <c:v>1</c:v>
                </c:pt>
                <c:pt idx="568">
                  <c:v>1</c:v>
                </c:pt>
                <c:pt idx="570">
                  <c:v>1</c:v>
                </c:pt>
                <c:pt idx="572">
                  <c:v>1</c:v>
                </c:pt>
                <c:pt idx="577">
                  <c:v>1</c:v>
                </c:pt>
                <c:pt idx="579">
                  <c:v>1</c:v>
                </c:pt>
                <c:pt idx="580">
                  <c:v>1</c:v>
                </c:pt>
                <c:pt idx="581">
                  <c:v>1</c:v>
                </c:pt>
                <c:pt idx="582">
                  <c:v>1</c:v>
                </c:pt>
                <c:pt idx="585">
                  <c:v>1</c:v>
                </c:pt>
                <c:pt idx="586">
                  <c:v>1</c:v>
                </c:pt>
                <c:pt idx="588">
                  <c:v>1</c:v>
                </c:pt>
                <c:pt idx="589">
                  <c:v>1</c:v>
                </c:pt>
                <c:pt idx="594">
                  <c:v>1</c:v>
                </c:pt>
                <c:pt idx="598">
                  <c:v>1</c:v>
                </c:pt>
                <c:pt idx="600">
                  <c:v>1</c:v>
                </c:pt>
                <c:pt idx="601">
                  <c:v>1</c:v>
                </c:pt>
                <c:pt idx="603">
                  <c:v>2</c:v>
                </c:pt>
                <c:pt idx="604">
                  <c:v>5</c:v>
                </c:pt>
                <c:pt idx="605">
                  <c:v>7</c:v>
                </c:pt>
                <c:pt idx="606">
                  <c:v>2</c:v>
                </c:pt>
                <c:pt idx="613">
                  <c:v>1</c:v>
                </c:pt>
                <c:pt idx="614">
                  <c:v>1</c:v>
                </c:pt>
                <c:pt idx="615">
                  <c:v>1</c:v>
                </c:pt>
                <c:pt idx="617">
                  <c:v>1</c:v>
                </c:pt>
                <c:pt idx="620">
                  <c:v>1</c:v>
                </c:pt>
                <c:pt idx="621">
                  <c:v>1</c:v>
                </c:pt>
                <c:pt idx="626">
                  <c:v>1</c:v>
                </c:pt>
                <c:pt idx="630">
                  <c:v>1</c:v>
                </c:pt>
                <c:pt idx="631">
                  <c:v>1</c:v>
                </c:pt>
                <c:pt idx="632">
                  <c:v>1</c:v>
                </c:pt>
                <c:pt idx="633">
                  <c:v>1</c:v>
                </c:pt>
                <c:pt idx="634">
                  <c:v>1</c:v>
                </c:pt>
                <c:pt idx="635">
                  <c:v>1</c:v>
                </c:pt>
                <c:pt idx="637">
                  <c:v>1</c:v>
                </c:pt>
                <c:pt idx="638">
                  <c:v>1</c:v>
                </c:pt>
                <c:pt idx="641">
                  <c:v>1</c:v>
                </c:pt>
                <c:pt idx="642">
                  <c:v>1</c:v>
                </c:pt>
                <c:pt idx="643">
                  <c:v>1</c:v>
                </c:pt>
                <c:pt idx="645">
                  <c:v>1</c:v>
                </c:pt>
                <c:pt idx="646">
                  <c:v>1</c:v>
                </c:pt>
                <c:pt idx="649">
                  <c:v>1</c:v>
                </c:pt>
                <c:pt idx="650">
                  <c:v>1</c:v>
                </c:pt>
                <c:pt idx="652">
                  <c:v>1</c:v>
                </c:pt>
                <c:pt idx="653">
                  <c:v>1</c:v>
                </c:pt>
                <c:pt idx="655">
                  <c:v>1</c:v>
                </c:pt>
                <c:pt idx="657">
                  <c:v>1</c:v>
                </c:pt>
                <c:pt idx="660">
                  <c:v>1</c:v>
                </c:pt>
                <c:pt idx="663">
                  <c:v>1</c:v>
                </c:pt>
                <c:pt idx="664">
                  <c:v>1</c:v>
                </c:pt>
                <c:pt idx="665">
                  <c:v>1</c:v>
                </c:pt>
                <c:pt idx="666">
                  <c:v>1</c:v>
                </c:pt>
                <c:pt idx="670">
                  <c:v>1</c:v>
                </c:pt>
                <c:pt idx="672">
                  <c:v>1</c:v>
                </c:pt>
                <c:pt idx="673">
                  <c:v>1</c:v>
                </c:pt>
                <c:pt idx="676">
                  <c:v>1</c:v>
                </c:pt>
                <c:pt idx="677">
                  <c:v>1</c:v>
                </c:pt>
                <c:pt idx="680">
                  <c:v>1</c:v>
                </c:pt>
                <c:pt idx="681">
                  <c:v>1</c:v>
                </c:pt>
                <c:pt idx="682">
                  <c:v>1</c:v>
                </c:pt>
                <c:pt idx="691">
                  <c:v>1</c:v>
                </c:pt>
                <c:pt idx="696">
                  <c:v>1</c:v>
                </c:pt>
                <c:pt idx="704">
                  <c:v>1</c:v>
                </c:pt>
                <c:pt idx="705">
                  <c:v>1</c:v>
                </c:pt>
                <c:pt idx="706">
                  <c:v>1</c:v>
                </c:pt>
                <c:pt idx="707">
                  <c:v>1</c:v>
                </c:pt>
                <c:pt idx="709">
                  <c:v>1</c:v>
                </c:pt>
                <c:pt idx="711">
                  <c:v>1</c:v>
                </c:pt>
                <c:pt idx="712">
                  <c:v>1</c:v>
                </c:pt>
                <c:pt idx="721">
                  <c:v>1</c:v>
                </c:pt>
                <c:pt idx="727">
                  <c:v>1</c:v>
                </c:pt>
                <c:pt idx="728">
                  <c:v>1</c:v>
                </c:pt>
                <c:pt idx="729">
                  <c:v>1</c:v>
                </c:pt>
                <c:pt idx="733">
                  <c:v>1</c:v>
                </c:pt>
                <c:pt idx="734">
                  <c:v>1</c:v>
                </c:pt>
                <c:pt idx="736">
                  <c:v>1</c:v>
                </c:pt>
                <c:pt idx="737">
                  <c:v>1</c:v>
                </c:pt>
                <c:pt idx="739">
                  <c:v>1</c:v>
                </c:pt>
                <c:pt idx="742">
                  <c:v>1</c:v>
                </c:pt>
                <c:pt idx="744">
                  <c:v>1</c:v>
                </c:pt>
                <c:pt idx="745">
                  <c:v>1</c:v>
                </c:pt>
                <c:pt idx="746">
                  <c:v>1</c:v>
                </c:pt>
                <c:pt idx="747">
                  <c:v>1</c:v>
                </c:pt>
                <c:pt idx="751">
                  <c:v>1</c:v>
                </c:pt>
                <c:pt idx="752">
                  <c:v>1</c:v>
                </c:pt>
                <c:pt idx="758">
                  <c:v>1</c:v>
                </c:pt>
                <c:pt idx="760">
                  <c:v>1</c:v>
                </c:pt>
                <c:pt idx="761">
                  <c:v>1</c:v>
                </c:pt>
                <c:pt idx="765">
                  <c:v>1</c:v>
                </c:pt>
                <c:pt idx="768">
                  <c:v>1</c:v>
                </c:pt>
                <c:pt idx="769">
                  <c:v>1</c:v>
                </c:pt>
                <c:pt idx="771">
                  <c:v>1</c:v>
                </c:pt>
                <c:pt idx="775">
                  <c:v>1</c:v>
                </c:pt>
                <c:pt idx="776">
                  <c:v>1</c:v>
                </c:pt>
                <c:pt idx="778">
                  <c:v>1</c:v>
                </c:pt>
                <c:pt idx="780">
                  <c:v>1</c:v>
                </c:pt>
                <c:pt idx="787">
                  <c:v>1</c:v>
                </c:pt>
                <c:pt idx="791">
                  <c:v>1</c:v>
                </c:pt>
                <c:pt idx="792">
                  <c:v>1</c:v>
                </c:pt>
                <c:pt idx="794">
                  <c:v>1</c:v>
                </c:pt>
                <c:pt idx="795">
                  <c:v>1</c:v>
                </c:pt>
                <c:pt idx="796">
                  <c:v>2</c:v>
                </c:pt>
                <c:pt idx="797">
                  <c:v>1</c:v>
                </c:pt>
                <c:pt idx="798">
                  <c:v>1</c:v>
                </c:pt>
                <c:pt idx="800">
                  <c:v>1</c:v>
                </c:pt>
                <c:pt idx="801">
                  <c:v>1</c:v>
                </c:pt>
                <c:pt idx="802">
                  <c:v>1</c:v>
                </c:pt>
                <c:pt idx="804">
                  <c:v>1</c:v>
                </c:pt>
                <c:pt idx="806">
                  <c:v>95</c:v>
                </c:pt>
                <c:pt idx="807">
                  <c:v>1</c:v>
                </c:pt>
                <c:pt idx="808">
                  <c:v>1</c:v>
                </c:pt>
                <c:pt idx="809">
                  <c:v>1</c:v>
                </c:pt>
                <c:pt idx="810">
                  <c:v>1</c:v>
                </c:pt>
                <c:pt idx="812">
                  <c:v>1</c:v>
                </c:pt>
                <c:pt idx="813">
                  <c:v>1</c:v>
                </c:pt>
                <c:pt idx="814">
                  <c:v>1</c:v>
                </c:pt>
                <c:pt idx="815">
                  <c:v>1</c:v>
                </c:pt>
                <c:pt idx="816">
                  <c:v>1</c:v>
                </c:pt>
                <c:pt idx="817">
                  <c:v>1</c:v>
                </c:pt>
                <c:pt idx="818">
                  <c:v>1</c:v>
                </c:pt>
                <c:pt idx="820">
                  <c:v>1</c:v>
                </c:pt>
                <c:pt idx="821">
                  <c:v>1</c:v>
                </c:pt>
                <c:pt idx="823">
                  <c:v>1</c:v>
                </c:pt>
                <c:pt idx="824">
                  <c:v>1</c:v>
                </c:pt>
                <c:pt idx="826">
                  <c:v>1</c:v>
                </c:pt>
                <c:pt idx="827">
                  <c:v>1</c:v>
                </c:pt>
                <c:pt idx="829">
                  <c:v>1</c:v>
                </c:pt>
                <c:pt idx="830">
                  <c:v>1</c:v>
                </c:pt>
                <c:pt idx="831">
                  <c:v>1</c:v>
                </c:pt>
                <c:pt idx="833">
                  <c:v>1</c:v>
                </c:pt>
                <c:pt idx="835">
                  <c:v>1</c:v>
                </c:pt>
                <c:pt idx="839">
                  <c:v>1</c:v>
                </c:pt>
                <c:pt idx="840">
                  <c:v>1</c:v>
                </c:pt>
                <c:pt idx="841">
                  <c:v>1</c:v>
                </c:pt>
                <c:pt idx="842">
                  <c:v>1</c:v>
                </c:pt>
                <c:pt idx="843">
                  <c:v>1</c:v>
                </c:pt>
                <c:pt idx="844">
                  <c:v>1</c:v>
                </c:pt>
                <c:pt idx="845">
                  <c:v>2</c:v>
                </c:pt>
                <c:pt idx="846">
                  <c:v>3</c:v>
                </c:pt>
                <c:pt idx="847">
                  <c:v>1</c:v>
                </c:pt>
                <c:pt idx="848">
                  <c:v>1</c:v>
                </c:pt>
                <c:pt idx="849">
                  <c:v>25</c:v>
                </c:pt>
                <c:pt idx="853">
                  <c:v>1</c:v>
                </c:pt>
                <c:pt idx="857">
                  <c:v>1</c:v>
                </c:pt>
                <c:pt idx="858">
                  <c:v>1</c:v>
                </c:pt>
                <c:pt idx="859">
                  <c:v>1</c:v>
                </c:pt>
                <c:pt idx="860">
                  <c:v>1</c:v>
                </c:pt>
                <c:pt idx="862">
                  <c:v>1</c:v>
                </c:pt>
                <c:pt idx="866">
                  <c:v>1</c:v>
                </c:pt>
                <c:pt idx="868">
                  <c:v>1</c:v>
                </c:pt>
                <c:pt idx="870">
                  <c:v>1</c:v>
                </c:pt>
                <c:pt idx="872">
                  <c:v>1</c:v>
                </c:pt>
                <c:pt idx="876">
                  <c:v>2</c:v>
                </c:pt>
                <c:pt idx="877">
                  <c:v>1</c:v>
                </c:pt>
                <c:pt idx="878">
                  <c:v>1</c:v>
                </c:pt>
                <c:pt idx="879">
                  <c:v>1</c:v>
                </c:pt>
                <c:pt idx="881">
                  <c:v>1</c:v>
                </c:pt>
                <c:pt idx="885">
                  <c:v>1</c:v>
                </c:pt>
                <c:pt idx="886">
                  <c:v>1</c:v>
                </c:pt>
                <c:pt idx="887">
                  <c:v>2</c:v>
                </c:pt>
                <c:pt idx="889">
                  <c:v>1</c:v>
                </c:pt>
                <c:pt idx="890">
                  <c:v>1</c:v>
                </c:pt>
                <c:pt idx="891">
                  <c:v>3</c:v>
                </c:pt>
                <c:pt idx="892">
                  <c:v>1</c:v>
                </c:pt>
                <c:pt idx="894">
                  <c:v>1</c:v>
                </c:pt>
                <c:pt idx="895">
                  <c:v>2</c:v>
                </c:pt>
                <c:pt idx="896">
                  <c:v>3</c:v>
                </c:pt>
                <c:pt idx="897">
                  <c:v>2</c:v>
                </c:pt>
                <c:pt idx="898">
                  <c:v>1</c:v>
                </c:pt>
                <c:pt idx="899">
                  <c:v>3</c:v>
                </c:pt>
                <c:pt idx="900">
                  <c:v>3</c:v>
                </c:pt>
                <c:pt idx="901">
                  <c:v>2</c:v>
                </c:pt>
                <c:pt idx="902">
                  <c:v>1</c:v>
                </c:pt>
                <c:pt idx="903">
                  <c:v>1</c:v>
                </c:pt>
                <c:pt idx="904">
                  <c:v>3</c:v>
                </c:pt>
                <c:pt idx="905">
                  <c:v>1</c:v>
                </c:pt>
                <c:pt idx="906">
                  <c:v>26</c:v>
                </c:pt>
                <c:pt idx="907">
                  <c:v>3</c:v>
                </c:pt>
                <c:pt idx="909">
                  <c:v>1</c:v>
                </c:pt>
                <c:pt idx="910">
                  <c:v>1</c:v>
                </c:pt>
                <c:pt idx="912">
                  <c:v>1</c:v>
                </c:pt>
                <c:pt idx="913">
                  <c:v>1</c:v>
                </c:pt>
                <c:pt idx="914">
                  <c:v>2</c:v>
                </c:pt>
                <c:pt idx="917">
                  <c:v>1</c:v>
                </c:pt>
                <c:pt idx="918">
                  <c:v>4</c:v>
                </c:pt>
                <c:pt idx="919">
                  <c:v>1</c:v>
                </c:pt>
                <c:pt idx="920">
                  <c:v>2</c:v>
                </c:pt>
                <c:pt idx="921">
                  <c:v>107</c:v>
                </c:pt>
                <c:pt idx="922">
                  <c:v>171</c:v>
                </c:pt>
                <c:pt idx="923">
                  <c:v>1</c:v>
                </c:pt>
                <c:pt idx="924">
                  <c:v>8</c:v>
                </c:pt>
                <c:pt idx="925">
                  <c:v>1</c:v>
                </c:pt>
                <c:pt idx="926">
                  <c:v>2</c:v>
                </c:pt>
                <c:pt idx="927">
                  <c:v>1</c:v>
                </c:pt>
                <c:pt idx="928">
                  <c:v>1</c:v>
                </c:pt>
                <c:pt idx="929">
                  <c:v>3</c:v>
                </c:pt>
                <c:pt idx="930">
                  <c:v>1</c:v>
                </c:pt>
                <c:pt idx="931">
                  <c:v>2</c:v>
                </c:pt>
                <c:pt idx="932">
                  <c:v>3</c:v>
                </c:pt>
                <c:pt idx="934">
                  <c:v>1</c:v>
                </c:pt>
                <c:pt idx="935">
                  <c:v>5</c:v>
                </c:pt>
                <c:pt idx="936">
                  <c:v>1</c:v>
                </c:pt>
                <c:pt idx="937">
                  <c:v>1</c:v>
                </c:pt>
                <c:pt idx="938">
                  <c:v>1</c:v>
                </c:pt>
                <c:pt idx="939">
                  <c:v>3</c:v>
                </c:pt>
                <c:pt idx="940">
                  <c:v>3</c:v>
                </c:pt>
                <c:pt idx="941">
                  <c:v>1</c:v>
                </c:pt>
                <c:pt idx="942">
                  <c:v>1</c:v>
                </c:pt>
                <c:pt idx="943">
                  <c:v>1</c:v>
                </c:pt>
                <c:pt idx="944">
                  <c:v>1</c:v>
                </c:pt>
                <c:pt idx="945">
                  <c:v>1</c:v>
                </c:pt>
                <c:pt idx="947">
                  <c:v>1</c:v>
                </c:pt>
                <c:pt idx="948">
                  <c:v>1</c:v>
                </c:pt>
                <c:pt idx="949">
                  <c:v>1</c:v>
                </c:pt>
                <c:pt idx="950">
                  <c:v>7</c:v>
                </c:pt>
                <c:pt idx="951">
                  <c:v>6</c:v>
                </c:pt>
                <c:pt idx="952">
                  <c:v>4</c:v>
                </c:pt>
                <c:pt idx="953">
                  <c:v>1</c:v>
                </c:pt>
                <c:pt idx="954">
                  <c:v>2</c:v>
                </c:pt>
                <c:pt idx="955">
                  <c:v>4</c:v>
                </c:pt>
                <c:pt idx="956">
                  <c:v>1</c:v>
                </c:pt>
                <c:pt idx="957">
                  <c:v>1</c:v>
                </c:pt>
                <c:pt idx="958">
                  <c:v>1</c:v>
                </c:pt>
                <c:pt idx="959">
                  <c:v>1</c:v>
                </c:pt>
                <c:pt idx="961">
                  <c:v>1</c:v>
                </c:pt>
                <c:pt idx="962">
                  <c:v>9</c:v>
                </c:pt>
                <c:pt idx="963">
                  <c:v>6</c:v>
                </c:pt>
                <c:pt idx="964">
                  <c:v>1</c:v>
                </c:pt>
                <c:pt idx="965">
                  <c:v>2</c:v>
                </c:pt>
                <c:pt idx="966">
                  <c:v>2</c:v>
                </c:pt>
                <c:pt idx="967">
                  <c:v>1</c:v>
                </c:pt>
                <c:pt idx="969">
                  <c:v>3</c:v>
                </c:pt>
                <c:pt idx="970">
                  <c:v>1</c:v>
                </c:pt>
                <c:pt idx="971">
                  <c:v>2</c:v>
                </c:pt>
                <c:pt idx="972">
                  <c:v>1</c:v>
                </c:pt>
                <c:pt idx="973">
                  <c:v>7</c:v>
                </c:pt>
                <c:pt idx="974">
                  <c:v>3</c:v>
                </c:pt>
                <c:pt idx="975">
                  <c:v>1</c:v>
                </c:pt>
                <c:pt idx="976">
                  <c:v>1</c:v>
                </c:pt>
                <c:pt idx="977">
                  <c:v>2</c:v>
                </c:pt>
                <c:pt idx="978">
                  <c:v>8</c:v>
                </c:pt>
                <c:pt idx="979">
                  <c:v>1</c:v>
                </c:pt>
                <c:pt idx="980">
                  <c:v>1</c:v>
                </c:pt>
                <c:pt idx="981">
                  <c:v>1</c:v>
                </c:pt>
                <c:pt idx="982">
                  <c:v>1</c:v>
                </c:pt>
                <c:pt idx="983">
                  <c:v>1</c:v>
                </c:pt>
                <c:pt idx="984">
                  <c:v>3</c:v>
                </c:pt>
                <c:pt idx="985">
                  <c:v>1</c:v>
                </c:pt>
                <c:pt idx="986">
                  <c:v>2</c:v>
                </c:pt>
                <c:pt idx="987">
                  <c:v>2</c:v>
                </c:pt>
                <c:pt idx="988">
                  <c:v>1</c:v>
                </c:pt>
                <c:pt idx="989">
                  <c:v>1</c:v>
                </c:pt>
                <c:pt idx="990">
                  <c:v>1</c:v>
                </c:pt>
                <c:pt idx="991">
                  <c:v>75</c:v>
                </c:pt>
                <c:pt idx="992">
                  <c:v>99</c:v>
                </c:pt>
                <c:pt idx="993">
                  <c:v>1</c:v>
                </c:pt>
                <c:pt idx="994">
                  <c:v>1</c:v>
                </c:pt>
                <c:pt idx="995">
                  <c:v>1</c:v>
                </c:pt>
                <c:pt idx="996">
                  <c:v>2</c:v>
                </c:pt>
                <c:pt idx="997">
                  <c:v>3</c:v>
                </c:pt>
                <c:pt idx="998">
                  <c:v>1</c:v>
                </c:pt>
                <c:pt idx="999">
                  <c:v>1</c:v>
                </c:pt>
                <c:pt idx="1000">
                  <c:v>2</c:v>
                </c:pt>
                <c:pt idx="1001">
                  <c:v>1</c:v>
                </c:pt>
                <c:pt idx="1002">
                  <c:v>3</c:v>
                </c:pt>
                <c:pt idx="1003">
                  <c:v>6</c:v>
                </c:pt>
                <c:pt idx="1004">
                  <c:v>3</c:v>
                </c:pt>
                <c:pt idx="1005">
                  <c:v>2</c:v>
                </c:pt>
                <c:pt idx="1006">
                  <c:v>1</c:v>
                </c:pt>
                <c:pt idx="1007">
                  <c:v>2</c:v>
                </c:pt>
                <c:pt idx="1008">
                  <c:v>2</c:v>
                </c:pt>
                <c:pt idx="1009">
                  <c:v>1</c:v>
                </c:pt>
                <c:pt idx="1010">
                  <c:v>2</c:v>
                </c:pt>
                <c:pt idx="1011">
                  <c:v>1</c:v>
                </c:pt>
                <c:pt idx="1012">
                  <c:v>1</c:v>
                </c:pt>
                <c:pt idx="1013">
                  <c:v>1</c:v>
                </c:pt>
                <c:pt idx="1016">
                  <c:v>1</c:v>
                </c:pt>
                <c:pt idx="1018">
                  <c:v>1</c:v>
                </c:pt>
                <c:pt idx="1019">
                  <c:v>1</c:v>
                </c:pt>
                <c:pt idx="1020">
                  <c:v>1</c:v>
                </c:pt>
                <c:pt idx="1024">
                  <c:v>1</c:v>
                </c:pt>
                <c:pt idx="1025">
                  <c:v>1</c:v>
                </c:pt>
                <c:pt idx="1026">
                  <c:v>4</c:v>
                </c:pt>
                <c:pt idx="1027">
                  <c:v>1</c:v>
                </c:pt>
                <c:pt idx="1028">
                  <c:v>1</c:v>
                </c:pt>
                <c:pt idx="1030">
                  <c:v>1</c:v>
                </c:pt>
                <c:pt idx="1031">
                  <c:v>1</c:v>
                </c:pt>
                <c:pt idx="1032">
                  <c:v>1</c:v>
                </c:pt>
                <c:pt idx="1033">
                  <c:v>1</c:v>
                </c:pt>
                <c:pt idx="1034">
                  <c:v>1</c:v>
                </c:pt>
                <c:pt idx="1036">
                  <c:v>1</c:v>
                </c:pt>
                <c:pt idx="1037">
                  <c:v>1</c:v>
                </c:pt>
                <c:pt idx="1042">
                  <c:v>1</c:v>
                </c:pt>
                <c:pt idx="1044">
                  <c:v>1</c:v>
                </c:pt>
                <c:pt idx="1045">
                  <c:v>1</c:v>
                </c:pt>
                <c:pt idx="1047">
                  <c:v>1</c:v>
                </c:pt>
                <c:pt idx="1049">
                  <c:v>1</c:v>
                </c:pt>
                <c:pt idx="1052">
                  <c:v>1</c:v>
                </c:pt>
                <c:pt idx="1053">
                  <c:v>1</c:v>
                </c:pt>
                <c:pt idx="1054">
                  <c:v>1</c:v>
                </c:pt>
                <c:pt idx="1057">
                  <c:v>1</c:v>
                </c:pt>
              </c:numCache>
              <c:extLst xmlns:c15="http://schemas.microsoft.com/office/drawing/2012/chart"/>
            </c:numRef>
          </c:yVal>
          <c:smooth val="0"/>
        </c:ser>
        <c:dLbls>
          <c:showLegendKey val="0"/>
          <c:showVal val="0"/>
          <c:showCatName val="0"/>
          <c:showSerName val="0"/>
          <c:showPercent val="0"/>
          <c:showBubbleSize val="0"/>
        </c:dLbls>
        <c:axId val="424490168"/>
        <c:axId val="241376952"/>
        <c:extLst>
          <c:ext xmlns:c15="http://schemas.microsoft.com/office/drawing/2012/chart" uri="{02D57815-91ED-43cb-92C2-25804820EDAC}">
            <c15:filteredScatterSeries>
              <c15:ser>
                <c:idx val="1"/>
                <c:order val="1"/>
                <c:tx>
                  <c:strRef>
                    <c:extLst>
                      <c:ext uri="{02D57815-91ED-43cb-92C2-25804820EDAC}">
                        <c15:formulaRef>
                          <c15:sqref>'Brachy NFY'!$D$2</c15:sqref>
                        </c15:formulaRef>
                      </c:ext>
                    </c:extLst>
                    <c:strCache>
                      <c:ptCount val="1"/>
                      <c:pt idx="0">
                        <c:v>Control2</c:v>
                      </c:pt>
                    </c:strCache>
                  </c:strRef>
                </c:tx>
                <c:spPr>
                  <a:ln w="25400" cap="rnd">
                    <a:noFill/>
                    <a:round/>
                  </a:ln>
                  <a:effectLst/>
                </c:spPr>
                <c:marker>
                  <c:symbol val="circle"/>
                  <c:size val="5"/>
                  <c:spPr>
                    <a:solidFill>
                      <a:schemeClr val="tx1"/>
                    </a:solidFill>
                    <a:ln w="9525">
                      <a:solidFill>
                        <a:schemeClr val="tx1"/>
                      </a:solidFill>
                    </a:ln>
                    <a:effectLst/>
                  </c:spPr>
                </c:marker>
                <c:xVal>
                  <c:numRef>
                    <c:extLst>
                      <c:ext uri="{02D57815-91ED-43cb-92C2-25804820EDAC}">
                        <c15:formulaRef>
                          <c15:sqref>'Brachy NFY'!$B$3:$B$1060</c15:sqref>
                        </c15:formulaRef>
                      </c:ext>
                    </c:extLst>
                    <c:numCache>
                      <c:formatCode>General</c:formatCode>
                      <c:ptCount val="1058"/>
                      <c:pt idx="0">
                        <c:v>52</c:v>
                      </c:pt>
                      <c:pt idx="1">
                        <c:v>62</c:v>
                      </c:pt>
                      <c:pt idx="2">
                        <c:v>69</c:v>
                      </c:pt>
                      <c:pt idx="3">
                        <c:v>77</c:v>
                      </c:pt>
                      <c:pt idx="4">
                        <c:v>89</c:v>
                      </c:pt>
                      <c:pt idx="5">
                        <c:v>92</c:v>
                      </c:pt>
                      <c:pt idx="6">
                        <c:v>95</c:v>
                      </c:pt>
                      <c:pt idx="7">
                        <c:v>100</c:v>
                      </c:pt>
                      <c:pt idx="8">
                        <c:v>116</c:v>
                      </c:pt>
                      <c:pt idx="9">
                        <c:v>123</c:v>
                      </c:pt>
                      <c:pt idx="10">
                        <c:v>125</c:v>
                      </c:pt>
                      <c:pt idx="11">
                        <c:v>129</c:v>
                      </c:pt>
                      <c:pt idx="12">
                        <c:v>135</c:v>
                      </c:pt>
                      <c:pt idx="13">
                        <c:v>146</c:v>
                      </c:pt>
                      <c:pt idx="14">
                        <c:v>147</c:v>
                      </c:pt>
                      <c:pt idx="15">
                        <c:v>148</c:v>
                      </c:pt>
                      <c:pt idx="16">
                        <c:v>149</c:v>
                      </c:pt>
                      <c:pt idx="17">
                        <c:v>150</c:v>
                      </c:pt>
                      <c:pt idx="18">
                        <c:v>152</c:v>
                      </c:pt>
                      <c:pt idx="19">
                        <c:v>153</c:v>
                      </c:pt>
                      <c:pt idx="20">
                        <c:v>155</c:v>
                      </c:pt>
                      <c:pt idx="21">
                        <c:v>157</c:v>
                      </c:pt>
                      <c:pt idx="22">
                        <c:v>158</c:v>
                      </c:pt>
                      <c:pt idx="23">
                        <c:v>159</c:v>
                      </c:pt>
                      <c:pt idx="24">
                        <c:v>160</c:v>
                      </c:pt>
                      <c:pt idx="25">
                        <c:v>162</c:v>
                      </c:pt>
                      <c:pt idx="26">
                        <c:v>164</c:v>
                      </c:pt>
                      <c:pt idx="27">
                        <c:v>169</c:v>
                      </c:pt>
                      <c:pt idx="28">
                        <c:v>171</c:v>
                      </c:pt>
                      <c:pt idx="29">
                        <c:v>173</c:v>
                      </c:pt>
                      <c:pt idx="30">
                        <c:v>174</c:v>
                      </c:pt>
                      <c:pt idx="31">
                        <c:v>181</c:v>
                      </c:pt>
                      <c:pt idx="32">
                        <c:v>186</c:v>
                      </c:pt>
                      <c:pt idx="33">
                        <c:v>187</c:v>
                      </c:pt>
                      <c:pt idx="34">
                        <c:v>190</c:v>
                      </c:pt>
                      <c:pt idx="35">
                        <c:v>192</c:v>
                      </c:pt>
                      <c:pt idx="36">
                        <c:v>197</c:v>
                      </c:pt>
                      <c:pt idx="37">
                        <c:v>202</c:v>
                      </c:pt>
                      <c:pt idx="38">
                        <c:v>204</c:v>
                      </c:pt>
                      <c:pt idx="39">
                        <c:v>206</c:v>
                      </c:pt>
                      <c:pt idx="40">
                        <c:v>208</c:v>
                      </c:pt>
                      <c:pt idx="41">
                        <c:v>209</c:v>
                      </c:pt>
                      <c:pt idx="42">
                        <c:v>210</c:v>
                      </c:pt>
                      <c:pt idx="43">
                        <c:v>217</c:v>
                      </c:pt>
                      <c:pt idx="44">
                        <c:v>219</c:v>
                      </c:pt>
                      <c:pt idx="45">
                        <c:v>220</c:v>
                      </c:pt>
                      <c:pt idx="46">
                        <c:v>222</c:v>
                      </c:pt>
                      <c:pt idx="47">
                        <c:v>226</c:v>
                      </c:pt>
                      <c:pt idx="48">
                        <c:v>227</c:v>
                      </c:pt>
                      <c:pt idx="49">
                        <c:v>230</c:v>
                      </c:pt>
                      <c:pt idx="50">
                        <c:v>231</c:v>
                      </c:pt>
                      <c:pt idx="51">
                        <c:v>232</c:v>
                      </c:pt>
                      <c:pt idx="52">
                        <c:v>235</c:v>
                      </c:pt>
                      <c:pt idx="53">
                        <c:v>236</c:v>
                      </c:pt>
                      <c:pt idx="54">
                        <c:v>240</c:v>
                      </c:pt>
                      <c:pt idx="55">
                        <c:v>241</c:v>
                      </c:pt>
                      <c:pt idx="56">
                        <c:v>244</c:v>
                      </c:pt>
                      <c:pt idx="57">
                        <c:v>245</c:v>
                      </c:pt>
                      <c:pt idx="58">
                        <c:v>247</c:v>
                      </c:pt>
                      <c:pt idx="59">
                        <c:v>248</c:v>
                      </c:pt>
                      <c:pt idx="60">
                        <c:v>251</c:v>
                      </c:pt>
                      <c:pt idx="61">
                        <c:v>254</c:v>
                      </c:pt>
                      <c:pt idx="62">
                        <c:v>255</c:v>
                      </c:pt>
                      <c:pt idx="63">
                        <c:v>258</c:v>
                      </c:pt>
                      <c:pt idx="64">
                        <c:v>260</c:v>
                      </c:pt>
                      <c:pt idx="65">
                        <c:v>261</c:v>
                      </c:pt>
                      <c:pt idx="66">
                        <c:v>262</c:v>
                      </c:pt>
                      <c:pt idx="67">
                        <c:v>263</c:v>
                      </c:pt>
                      <c:pt idx="68">
                        <c:v>264</c:v>
                      </c:pt>
                      <c:pt idx="69">
                        <c:v>265</c:v>
                      </c:pt>
                      <c:pt idx="70">
                        <c:v>266</c:v>
                      </c:pt>
                      <c:pt idx="71">
                        <c:v>267</c:v>
                      </c:pt>
                      <c:pt idx="72">
                        <c:v>268</c:v>
                      </c:pt>
                      <c:pt idx="73">
                        <c:v>270</c:v>
                      </c:pt>
                      <c:pt idx="74">
                        <c:v>273</c:v>
                      </c:pt>
                      <c:pt idx="75">
                        <c:v>286</c:v>
                      </c:pt>
                      <c:pt idx="76">
                        <c:v>289</c:v>
                      </c:pt>
                      <c:pt idx="77">
                        <c:v>290</c:v>
                      </c:pt>
                      <c:pt idx="78">
                        <c:v>292</c:v>
                      </c:pt>
                      <c:pt idx="79">
                        <c:v>294</c:v>
                      </c:pt>
                      <c:pt idx="80">
                        <c:v>295</c:v>
                      </c:pt>
                      <c:pt idx="81">
                        <c:v>297</c:v>
                      </c:pt>
                      <c:pt idx="82">
                        <c:v>302</c:v>
                      </c:pt>
                      <c:pt idx="83">
                        <c:v>303</c:v>
                      </c:pt>
                      <c:pt idx="84">
                        <c:v>307</c:v>
                      </c:pt>
                      <c:pt idx="85">
                        <c:v>309</c:v>
                      </c:pt>
                      <c:pt idx="86">
                        <c:v>310</c:v>
                      </c:pt>
                      <c:pt idx="87">
                        <c:v>312</c:v>
                      </c:pt>
                      <c:pt idx="88">
                        <c:v>313</c:v>
                      </c:pt>
                      <c:pt idx="89">
                        <c:v>314</c:v>
                      </c:pt>
                      <c:pt idx="90">
                        <c:v>315</c:v>
                      </c:pt>
                      <c:pt idx="91">
                        <c:v>316</c:v>
                      </c:pt>
                      <c:pt idx="92">
                        <c:v>326</c:v>
                      </c:pt>
                      <c:pt idx="93">
                        <c:v>330</c:v>
                      </c:pt>
                      <c:pt idx="94">
                        <c:v>335</c:v>
                      </c:pt>
                      <c:pt idx="95">
                        <c:v>338</c:v>
                      </c:pt>
                      <c:pt idx="96">
                        <c:v>339</c:v>
                      </c:pt>
                      <c:pt idx="97">
                        <c:v>344</c:v>
                      </c:pt>
                      <c:pt idx="98">
                        <c:v>349</c:v>
                      </c:pt>
                      <c:pt idx="99">
                        <c:v>351</c:v>
                      </c:pt>
                      <c:pt idx="100">
                        <c:v>354</c:v>
                      </c:pt>
                      <c:pt idx="101">
                        <c:v>357</c:v>
                      </c:pt>
                      <c:pt idx="102">
                        <c:v>361</c:v>
                      </c:pt>
                      <c:pt idx="103">
                        <c:v>364</c:v>
                      </c:pt>
                      <c:pt idx="104">
                        <c:v>373</c:v>
                      </c:pt>
                      <c:pt idx="105">
                        <c:v>377</c:v>
                      </c:pt>
                      <c:pt idx="106">
                        <c:v>378</c:v>
                      </c:pt>
                      <c:pt idx="107">
                        <c:v>379</c:v>
                      </c:pt>
                      <c:pt idx="108">
                        <c:v>382</c:v>
                      </c:pt>
                      <c:pt idx="109">
                        <c:v>390</c:v>
                      </c:pt>
                      <c:pt idx="110">
                        <c:v>394</c:v>
                      </c:pt>
                      <c:pt idx="111">
                        <c:v>396</c:v>
                      </c:pt>
                      <c:pt idx="112">
                        <c:v>397</c:v>
                      </c:pt>
                      <c:pt idx="113">
                        <c:v>400</c:v>
                      </c:pt>
                      <c:pt idx="114">
                        <c:v>403</c:v>
                      </c:pt>
                      <c:pt idx="115">
                        <c:v>405</c:v>
                      </c:pt>
                      <c:pt idx="116">
                        <c:v>406</c:v>
                      </c:pt>
                      <c:pt idx="117">
                        <c:v>407</c:v>
                      </c:pt>
                      <c:pt idx="118">
                        <c:v>408</c:v>
                      </c:pt>
                      <c:pt idx="119">
                        <c:v>409</c:v>
                      </c:pt>
                      <c:pt idx="120">
                        <c:v>410</c:v>
                      </c:pt>
                      <c:pt idx="121">
                        <c:v>416</c:v>
                      </c:pt>
                      <c:pt idx="122">
                        <c:v>418</c:v>
                      </c:pt>
                      <c:pt idx="123">
                        <c:v>423</c:v>
                      </c:pt>
                      <c:pt idx="124">
                        <c:v>424</c:v>
                      </c:pt>
                      <c:pt idx="125">
                        <c:v>426</c:v>
                      </c:pt>
                      <c:pt idx="126">
                        <c:v>428</c:v>
                      </c:pt>
                      <c:pt idx="127">
                        <c:v>429</c:v>
                      </c:pt>
                      <c:pt idx="128">
                        <c:v>430</c:v>
                      </c:pt>
                      <c:pt idx="129">
                        <c:v>433</c:v>
                      </c:pt>
                      <c:pt idx="130">
                        <c:v>438</c:v>
                      </c:pt>
                      <c:pt idx="131">
                        <c:v>440</c:v>
                      </c:pt>
                      <c:pt idx="132">
                        <c:v>450</c:v>
                      </c:pt>
                      <c:pt idx="133">
                        <c:v>453</c:v>
                      </c:pt>
                      <c:pt idx="134">
                        <c:v>460</c:v>
                      </c:pt>
                      <c:pt idx="135">
                        <c:v>461</c:v>
                      </c:pt>
                      <c:pt idx="136">
                        <c:v>464</c:v>
                      </c:pt>
                      <c:pt idx="137">
                        <c:v>465</c:v>
                      </c:pt>
                      <c:pt idx="138">
                        <c:v>466</c:v>
                      </c:pt>
                      <c:pt idx="139">
                        <c:v>467</c:v>
                      </c:pt>
                      <c:pt idx="140">
                        <c:v>468</c:v>
                      </c:pt>
                      <c:pt idx="141">
                        <c:v>469</c:v>
                      </c:pt>
                      <c:pt idx="142">
                        <c:v>470</c:v>
                      </c:pt>
                      <c:pt idx="143">
                        <c:v>471</c:v>
                      </c:pt>
                      <c:pt idx="144">
                        <c:v>472</c:v>
                      </c:pt>
                      <c:pt idx="145">
                        <c:v>473</c:v>
                      </c:pt>
                      <c:pt idx="146">
                        <c:v>474</c:v>
                      </c:pt>
                      <c:pt idx="147">
                        <c:v>475</c:v>
                      </c:pt>
                      <c:pt idx="148">
                        <c:v>477</c:v>
                      </c:pt>
                      <c:pt idx="149">
                        <c:v>478</c:v>
                      </c:pt>
                      <c:pt idx="150">
                        <c:v>479</c:v>
                      </c:pt>
                      <c:pt idx="151">
                        <c:v>480</c:v>
                      </c:pt>
                      <c:pt idx="152">
                        <c:v>485</c:v>
                      </c:pt>
                      <c:pt idx="153">
                        <c:v>488</c:v>
                      </c:pt>
                      <c:pt idx="154">
                        <c:v>489</c:v>
                      </c:pt>
                      <c:pt idx="155">
                        <c:v>491</c:v>
                      </c:pt>
                      <c:pt idx="156">
                        <c:v>492</c:v>
                      </c:pt>
                      <c:pt idx="157">
                        <c:v>494</c:v>
                      </c:pt>
                      <c:pt idx="158">
                        <c:v>495</c:v>
                      </c:pt>
                      <c:pt idx="159">
                        <c:v>497</c:v>
                      </c:pt>
                      <c:pt idx="160">
                        <c:v>498</c:v>
                      </c:pt>
                      <c:pt idx="161">
                        <c:v>499</c:v>
                      </c:pt>
                      <c:pt idx="162">
                        <c:v>500</c:v>
                      </c:pt>
                      <c:pt idx="163">
                        <c:v>501</c:v>
                      </c:pt>
                      <c:pt idx="164">
                        <c:v>502</c:v>
                      </c:pt>
                      <c:pt idx="165">
                        <c:v>503</c:v>
                      </c:pt>
                      <c:pt idx="166">
                        <c:v>504</c:v>
                      </c:pt>
                      <c:pt idx="167">
                        <c:v>505</c:v>
                      </c:pt>
                      <c:pt idx="168">
                        <c:v>508</c:v>
                      </c:pt>
                      <c:pt idx="169">
                        <c:v>510</c:v>
                      </c:pt>
                      <c:pt idx="170">
                        <c:v>511</c:v>
                      </c:pt>
                      <c:pt idx="171">
                        <c:v>513</c:v>
                      </c:pt>
                      <c:pt idx="172">
                        <c:v>516</c:v>
                      </c:pt>
                      <c:pt idx="173">
                        <c:v>518</c:v>
                      </c:pt>
                      <c:pt idx="174">
                        <c:v>519</c:v>
                      </c:pt>
                      <c:pt idx="175">
                        <c:v>520</c:v>
                      </c:pt>
                      <c:pt idx="176">
                        <c:v>521</c:v>
                      </c:pt>
                      <c:pt idx="177">
                        <c:v>522</c:v>
                      </c:pt>
                      <c:pt idx="178">
                        <c:v>523</c:v>
                      </c:pt>
                      <c:pt idx="179">
                        <c:v>524</c:v>
                      </c:pt>
                      <c:pt idx="180">
                        <c:v>525</c:v>
                      </c:pt>
                      <c:pt idx="181">
                        <c:v>527</c:v>
                      </c:pt>
                      <c:pt idx="182">
                        <c:v>530</c:v>
                      </c:pt>
                      <c:pt idx="183">
                        <c:v>531</c:v>
                      </c:pt>
                      <c:pt idx="184">
                        <c:v>532</c:v>
                      </c:pt>
                      <c:pt idx="185">
                        <c:v>533</c:v>
                      </c:pt>
                      <c:pt idx="186">
                        <c:v>537</c:v>
                      </c:pt>
                      <c:pt idx="187">
                        <c:v>538</c:v>
                      </c:pt>
                      <c:pt idx="188">
                        <c:v>539</c:v>
                      </c:pt>
                      <c:pt idx="189">
                        <c:v>541</c:v>
                      </c:pt>
                      <c:pt idx="190">
                        <c:v>542</c:v>
                      </c:pt>
                      <c:pt idx="191">
                        <c:v>543</c:v>
                      </c:pt>
                      <c:pt idx="192">
                        <c:v>544</c:v>
                      </c:pt>
                      <c:pt idx="193">
                        <c:v>545</c:v>
                      </c:pt>
                      <c:pt idx="194">
                        <c:v>549</c:v>
                      </c:pt>
                      <c:pt idx="195">
                        <c:v>550</c:v>
                      </c:pt>
                      <c:pt idx="196">
                        <c:v>551</c:v>
                      </c:pt>
                      <c:pt idx="197">
                        <c:v>552</c:v>
                      </c:pt>
                      <c:pt idx="198">
                        <c:v>553</c:v>
                      </c:pt>
                      <c:pt idx="199">
                        <c:v>554</c:v>
                      </c:pt>
                      <c:pt idx="200">
                        <c:v>555</c:v>
                      </c:pt>
                      <c:pt idx="201">
                        <c:v>556</c:v>
                      </c:pt>
                      <c:pt idx="202">
                        <c:v>557</c:v>
                      </c:pt>
                      <c:pt idx="203">
                        <c:v>558</c:v>
                      </c:pt>
                      <c:pt idx="204">
                        <c:v>561</c:v>
                      </c:pt>
                      <c:pt idx="205">
                        <c:v>562</c:v>
                      </c:pt>
                      <c:pt idx="206">
                        <c:v>564</c:v>
                      </c:pt>
                      <c:pt idx="207">
                        <c:v>565</c:v>
                      </c:pt>
                      <c:pt idx="208">
                        <c:v>568</c:v>
                      </c:pt>
                      <c:pt idx="209">
                        <c:v>570</c:v>
                      </c:pt>
                      <c:pt idx="210">
                        <c:v>571</c:v>
                      </c:pt>
                      <c:pt idx="211">
                        <c:v>573</c:v>
                      </c:pt>
                      <c:pt idx="212">
                        <c:v>574</c:v>
                      </c:pt>
                      <c:pt idx="213">
                        <c:v>575</c:v>
                      </c:pt>
                      <c:pt idx="214">
                        <c:v>582</c:v>
                      </c:pt>
                      <c:pt idx="215">
                        <c:v>586</c:v>
                      </c:pt>
                      <c:pt idx="216">
                        <c:v>587</c:v>
                      </c:pt>
                      <c:pt idx="217">
                        <c:v>589</c:v>
                      </c:pt>
                      <c:pt idx="218">
                        <c:v>590</c:v>
                      </c:pt>
                      <c:pt idx="219">
                        <c:v>591</c:v>
                      </c:pt>
                      <c:pt idx="220">
                        <c:v>592</c:v>
                      </c:pt>
                      <c:pt idx="221">
                        <c:v>595</c:v>
                      </c:pt>
                      <c:pt idx="222">
                        <c:v>596</c:v>
                      </c:pt>
                      <c:pt idx="223">
                        <c:v>597</c:v>
                      </c:pt>
                      <c:pt idx="224">
                        <c:v>598</c:v>
                      </c:pt>
                      <c:pt idx="225">
                        <c:v>604</c:v>
                      </c:pt>
                      <c:pt idx="226">
                        <c:v>605</c:v>
                      </c:pt>
                      <c:pt idx="227">
                        <c:v>608</c:v>
                      </c:pt>
                      <c:pt idx="228">
                        <c:v>609</c:v>
                      </c:pt>
                      <c:pt idx="229">
                        <c:v>610</c:v>
                      </c:pt>
                      <c:pt idx="230">
                        <c:v>611</c:v>
                      </c:pt>
                      <c:pt idx="231">
                        <c:v>612</c:v>
                      </c:pt>
                      <c:pt idx="232">
                        <c:v>613</c:v>
                      </c:pt>
                      <c:pt idx="233">
                        <c:v>623</c:v>
                      </c:pt>
                      <c:pt idx="234">
                        <c:v>624</c:v>
                      </c:pt>
                      <c:pt idx="235">
                        <c:v>625</c:v>
                      </c:pt>
                      <c:pt idx="236">
                        <c:v>627</c:v>
                      </c:pt>
                      <c:pt idx="237">
                        <c:v>628</c:v>
                      </c:pt>
                      <c:pt idx="238">
                        <c:v>629</c:v>
                      </c:pt>
                      <c:pt idx="239">
                        <c:v>631</c:v>
                      </c:pt>
                      <c:pt idx="240">
                        <c:v>634</c:v>
                      </c:pt>
                      <c:pt idx="241">
                        <c:v>636</c:v>
                      </c:pt>
                      <c:pt idx="242">
                        <c:v>638</c:v>
                      </c:pt>
                      <c:pt idx="243">
                        <c:v>639</c:v>
                      </c:pt>
                      <c:pt idx="244">
                        <c:v>642</c:v>
                      </c:pt>
                      <c:pt idx="245">
                        <c:v>643</c:v>
                      </c:pt>
                      <c:pt idx="246">
                        <c:v>644</c:v>
                      </c:pt>
                      <c:pt idx="247">
                        <c:v>646</c:v>
                      </c:pt>
                      <c:pt idx="248">
                        <c:v>647</c:v>
                      </c:pt>
                      <c:pt idx="249">
                        <c:v>649</c:v>
                      </c:pt>
                      <c:pt idx="250">
                        <c:v>650</c:v>
                      </c:pt>
                      <c:pt idx="251">
                        <c:v>652</c:v>
                      </c:pt>
                      <c:pt idx="252">
                        <c:v>653</c:v>
                      </c:pt>
                      <c:pt idx="253">
                        <c:v>654</c:v>
                      </c:pt>
                      <c:pt idx="254">
                        <c:v>656</c:v>
                      </c:pt>
                      <c:pt idx="255">
                        <c:v>657</c:v>
                      </c:pt>
                      <c:pt idx="256">
                        <c:v>659</c:v>
                      </c:pt>
                      <c:pt idx="257">
                        <c:v>661</c:v>
                      </c:pt>
                      <c:pt idx="258">
                        <c:v>665</c:v>
                      </c:pt>
                      <c:pt idx="259">
                        <c:v>667</c:v>
                      </c:pt>
                      <c:pt idx="260">
                        <c:v>668</c:v>
                      </c:pt>
                      <c:pt idx="261">
                        <c:v>669</c:v>
                      </c:pt>
                      <c:pt idx="262">
                        <c:v>670</c:v>
                      </c:pt>
                      <c:pt idx="263">
                        <c:v>671</c:v>
                      </c:pt>
                      <c:pt idx="264">
                        <c:v>672</c:v>
                      </c:pt>
                      <c:pt idx="265">
                        <c:v>673</c:v>
                      </c:pt>
                      <c:pt idx="266">
                        <c:v>674</c:v>
                      </c:pt>
                      <c:pt idx="267">
                        <c:v>675</c:v>
                      </c:pt>
                      <c:pt idx="268">
                        <c:v>676</c:v>
                      </c:pt>
                      <c:pt idx="269">
                        <c:v>677</c:v>
                      </c:pt>
                      <c:pt idx="270">
                        <c:v>678</c:v>
                      </c:pt>
                      <c:pt idx="271">
                        <c:v>681</c:v>
                      </c:pt>
                      <c:pt idx="272">
                        <c:v>682</c:v>
                      </c:pt>
                      <c:pt idx="273">
                        <c:v>683</c:v>
                      </c:pt>
                      <c:pt idx="274">
                        <c:v>684</c:v>
                      </c:pt>
                      <c:pt idx="275">
                        <c:v>685</c:v>
                      </c:pt>
                      <c:pt idx="276">
                        <c:v>686</c:v>
                      </c:pt>
                      <c:pt idx="277">
                        <c:v>687</c:v>
                      </c:pt>
                      <c:pt idx="278">
                        <c:v>688</c:v>
                      </c:pt>
                      <c:pt idx="279">
                        <c:v>689</c:v>
                      </c:pt>
                      <c:pt idx="280">
                        <c:v>693</c:v>
                      </c:pt>
                      <c:pt idx="281">
                        <c:v>694</c:v>
                      </c:pt>
                      <c:pt idx="282">
                        <c:v>698</c:v>
                      </c:pt>
                      <c:pt idx="283">
                        <c:v>701</c:v>
                      </c:pt>
                      <c:pt idx="284">
                        <c:v>702</c:v>
                      </c:pt>
                      <c:pt idx="285">
                        <c:v>703</c:v>
                      </c:pt>
                      <c:pt idx="286">
                        <c:v>707</c:v>
                      </c:pt>
                      <c:pt idx="287">
                        <c:v>708</c:v>
                      </c:pt>
                      <c:pt idx="288">
                        <c:v>712</c:v>
                      </c:pt>
                      <c:pt idx="289">
                        <c:v>713</c:v>
                      </c:pt>
                      <c:pt idx="290">
                        <c:v>714</c:v>
                      </c:pt>
                      <c:pt idx="291">
                        <c:v>719</c:v>
                      </c:pt>
                      <c:pt idx="292">
                        <c:v>720</c:v>
                      </c:pt>
                      <c:pt idx="293">
                        <c:v>721</c:v>
                      </c:pt>
                      <c:pt idx="294">
                        <c:v>723</c:v>
                      </c:pt>
                      <c:pt idx="295">
                        <c:v>724</c:v>
                      </c:pt>
                      <c:pt idx="296">
                        <c:v>725</c:v>
                      </c:pt>
                      <c:pt idx="297">
                        <c:v>726</c:v>
                      </c:pt>
                      <c:pt idx="298">
                        <c:v>727</c:v>
                      </c:pt>
                      <c:pt idx="299">
                        <c:v>728</c:v>
                      </c:pt>
                      <c:pt idx="300">
                        <c:v>729</c:v>
                      </c:pt>
                      <c:pt idx="301">
                        <c:v>730</c:v>
                      </c:pt>
                      <c:pt idx="302">
                        <c:v>732</c:v>
                      </c:pt>
                      <c:pt idx="303">
                        <c:v>734</c:v>
                      </c:pt>
                      <c:pt idx="304">
                        <c:v>735</c:v>
                      </c:pt>
                      <c:pt idx="305">
                        <c:v>736</c:v>
                      </c:pt>
                      <c:pt idx="306">
                        <c:v>737</c:v>
                      </c:pt>
                      <c:pt idx="307">
                        <c:v>738</c:v>
                      </c:pt>
                      <c:pt idx="308">
                        <c:v>739</c:v>
                      </c:pt>
                      <c:pt idx="309">
                        <c:v>740</c:v>
                      </c:pt>
                      <c:pt idx="310">
                        <c:v>741</c:v>
                      </c:pt>
                      <c:pt idx="311">
                        <c:v>742</c:v>
                      </c:pt>
                      <c:pt idx="312">
                        <c:v>743</c:v>
                      </c:pt>
                      <c:pt idx="313">
                        <c:v>744</c:v>
                      </c:pt>
                      <c:pt idx="314">
                        <c:v>745</c:v>
                      </c:pt>
                      <c:pt idx="315">
                        <c:v>746</c:v>
                      </c:pt>
                      <c:pt idx="316">
                        <c:v>747</c:v>
                      </c:pt>
                      <c:pt idx="317">
                        <c:v>748</c:v>
                      </c:pt>
                      <c:pt idx="318">
                        <c:v>749</c:v>
                      </c:pt>
                      <c:pt idx="319">
                        <c:v>750</c:v>
                      </c:pt>
                      <c:pt idx="320">
                        <c:v>751</c:v>
                      </c:pt>
                      <c:pt idx="321">
                        <c:v>757</c:v>
                      </c:pt>
                      <c:pt idx="322">
                        <c:v>758</c:v>
                      </c:pt>
                      <c:pt idx="323">
                        <c:v>759</c:v>
                      </c:pt>
                      <c:pt idx="324">
                        <c:v>760</c:v>
                      </c:pt>
                      <c:pt idx="325">
                        <c:v>761</c:v>
                      </c:pt>
                      <c:pt idx="326">
                        <c:v>762</c:v>
                      </c:pt>
                      <c:pt idx="327">
                        <c:v>765</c:v>
                      </c:pt>
                      <c:pt idx="328">
                        <c:v>766</c:v>
                      </c:pt>
                      <c:pt idx="329">
                        <c:v>767</c:v>
                      </c:pt>
                      <c:pt idx="330">
                        <c:v>769</c:v>
                      </c:pt>
                      <c:pt idx="331">
                        <c:v>770</c:v>
                      </c:pt>
                      <c:pt idx="332">
                        <c:v>772</c:v>
                      </c:pt>
                      <c:pt idx="333">
                        <c:v>773</c:v>
                      </c:pt>
                      <c:pt idx="334">
                        <c:v>774</c:v>
                      </c:pt>
                      <c:pt idx="335">
                        <c:v>775</c:v>
                      </c:pt>
                      <c:pt idx="336">
                        <c:v>776</c:v>
                      </c:pt>
                      <c:pt idx="337">
                        <c:v>777</c:v>
                      </c:pt>
                      <c:pt idx="338">
                        <c:v>778</c:v>
                      </c:pt>
                      <c:pt idx="339">
                        <c:v>779</c:v>
                      </c:pt>
                      <c:pt idx="340">
                        <c:v>781</c:v>
                      </c:pt>
                      <c:pt idx="341">
                        <c:v>782</c:v>
                      </c:pt>
                      <c:pt idx="342">
                        <c:v>783</c:v>
                      </c:pt>
                      <c:pt idx="343">
                        <c:v>784</c:v>
                      </c:pt>
                      <c:pt idx="344">
                        <c:v>786</c:v>
                      </c:pt>
                      <c:pt idx="345">
                        <c:v>787</c:v>
                      </c:pt>
                      <c:pt idx="346">
                        <c:v>788</c:v>
                      </c:pt>
                      <c:pt idx="347">
                        <c:v>789</c:v>
                      </c:pt>
                      <c:pt idx="348">
                        <c:v>790</c:v>
                      </c:pt>
                      <c:pt idx="349">
                        <c:v>794</c:v>
                      </c:pt>
                      <c:pt idx="350">
                        <c:v>795</c:v>
                      </c:pt>
                      <c:pt idx="351">
                        <c:v>796</c:v>
                      </c:pt>
                      <c:pt idx="352">
                        <c:v>797</c:v>
                      </c:pt>
                      <c:pt idx="353">
                        <c:v>798</c:v>
                      </c:pt>
                      <c:pt idx="354">
                        <c:v>800</c:v>
                      </c:pt>
                      <c:pt idx="355">
                        <c:v>801</c:v>
                      </c:pt>
                      <c:pt idx="356">
                        <c:v>802</c:v>
                      </c:pt>
                      <c:pt idx="357">
                        <c:v>803</c:v>
                      </c:pt>
                      <c:pt idx="358">
                        <c:v>804</c:v>
                      </c:pt>
                      <c:pt idx="359">
                        <c:v>805</c:v>
                      </c:pt>
                      <c:pt idx="360">
                        <c:v>806</c:v>
                      </c:pt>
                      <c:pt idx="361">
                        <c:v>807</c:v>
                      </c:pt>
                      <c:pt idx="362">
                        <c:v>808</c:v>
                      </c:pt>
                      <c:pt idx="363">
                        <c:v>811</c:v>
                      </c:pt>
                      <c:pt idx="364">
                        <c:v>812</c:v>
                      </c:pt>
                      <c:pt idx="365">
                        <c:v>813</c:v>
                      </c:pt>
                      <c:pt idx="366">
                        <c:v>814</c:v>
                      </c:pt>
                      <c:pt idx="367">
                        <c:v>815</c:v>
                      </c:pt>
                      <c:pt idx="368">
                        <c:v>816</c:v>
                      </c:pt>
                      <c:pt idx="369">
                        <c:v>817</c:v>
                      </c:pt>
                      <c:pt idx="370">
                        <c:v>818</c:v>
                      </c:pt>
                      <c:pt idx="371">
                        <c:v>819</c:v>
                      </c:pt>
                      <c:pt idx="372">
                        <c:v>820</c:v>
                      </c:pt>
                      <c:pt idx="373">
                        <c:v>821</c:v>
                      </c:pt>
                      <c:pt idx="374">
                        <c:v>822</c:v>
                      </c:pt>
                      <c:pt idx="375">
                        <c:v>823</c:v>
                      </c:pt>
                      <c:pt idx="376">
                        <c:v>825</c:v>
                      </c:pt>
                      <c:pt idx="377">
                        <c:v>826</c:v>
                      </c:pt>
                      <c:pt idx="378">
                        <c:v>827</c:v>
                      </c:pt>
                      <c:pt idx="379">
                        <c:v>828</c:v>
                      </c:pt>
                      <c:pt idx="380">
                        <c:v>829</c:v>
                      </c:pt>
                      <c:pt idx="381">
                        <c:v>830</c:v>
                      </c:pt>
                      <c:pt idx="382">
                        <c:v>831</c:v>
                      </c:pt>
                      <c:pt idx="383">
                        <c:v>832</c:v>
                      </c:pt>
                      <c:pt idx="384">
                        <c:v>834</c:v>
                      </c:pt>
                      <c:pt idx="385">
                        <c:v>836</c:v>
                      </c:pt>
                      <c:pt idx="386">
                        <c:v>837</c:v>
                      </c:pt>
                      <c:pt idx="387">
                        <c:v>838</c:v>
                      </c:pt>
                      <c:pt idx="388">
                        <c:v>839</c:v>
                      </c:pt>
                      <c:pt idx="389">
                        <c:v>840</c:v>
                      </c:pt>
                      <c:pt idx="390">
                        <c:v>842</c:v>
                      </c:pt>
                      <c:pt idx="391">
                        <c:v>843</c:v>
                      </c:pt>
                      <c:pt idx="392">
                        <c:v>844</c:v>
                      </c:pt>
                      <c:pt idx="393">
                        <c:v>845</c:v>
                      </c:pt>
                      <c:pt idx="394">
                        <c:v>846</c:v>
                      </c:pt>
                      <c:pt idx="395">
                        <c:v>847</c:v>
                      </c:pt>
                      <c:pt idx="396">
                        <c:v>848</c:v>
                      </c:pt>
                      <c:pt idx="397">
                        <c:v>849</c:v>
                      </c:pt>
                      <c:pt idx="398">
                        <c:v>850</c:v>
                      </c:pt>
                      <c:pt idx="399">
                        <c:v>851</c:v>
                      </c:pt>
                      <c:pt idx="400">
                        <c:v>853</c:v>
                      </c:pt>
                      <c:pt idx="401">
                        <c:v>854</c:v>
                      </c:pt>
                      <c:pt idx="402">
                        <c:v>855</c:v>
                      </c:pt>
                      <c:pt idx="403">
                        <c:v>856</c:v>
                      </c:pt>
                      <c:pt idx="404">
                        <c:v>857</c:v>
                      </c:pt>
                      <c:pt idx="405">
                        <c:v>859</c:v>
                      </c:pt>
                      <c:pt idx="406">
                        <c:v>860</c:v>
                      </c:pt>
                      <c:pt idx="407">
                        <c:v>861</c:v>
                      </c:pt>
                      <c:pt idx="408">
                        <c:v>862</c:v>
                      </c:pt>
                      <c:pt idx="409">
                        <c:v>863</c:v>
                      </c:pt>
                      <c:pt idx="410">
                        <c:v>865</c:v>
                      </c:pt>
                      <c:pt idx="411">
                        <c:v>867</c:v>
                      </c:pt>
                      <c:pt idx="412">
                        <c:v>868</c:v>
                      </c:pt>
                      <c:pt idx="413">
                        <c:v>869</c:v>
                      </c:pt>
                      <c:pt idx="414">
                        <c:v>876</c:v>
                      </c:pt>
                      <c:pt idx="415">
                        <c:v>877</c:v>
                      </c:pt>
                      <c:pt idx="416">
                        <c:v>882</c:v>
                      </c:pt>
                      <c:pt idx="417">
                        <c:v>883</c:v>
                      </c:pt>
                      <c:pt idx="418">
                        <c:v>885</c:v>
                      </c:pt>
                      <c:pt idx="419">
                        <c:v>886</c:v>
                      </c:pt>
                      <c:pt idx="420">
                        <c:v>887</c:v>
                      </c:pt>
                      <c:pt idx="421">
                        <c:v>888</c:v>
                      </c:pt>
                      <c:pt idx="422">
                        <c:v>889</c:v>
                      </c:pt>
                      <c:pt idx="423">
                        <c:v>890</c:v>
                      </c:pt>
                      <c:pt idx="424">
                        <c:v>891</c:v>
                      </c:pt>
                      <c:pt idx="425">
                        <c:v>892</c:v>
                      </c:pt>
                      <c:pt idx="426">
                        <c:v>893</c:v>
                      </c:pt>
                      <c:pt idx="427">
                        <c:v>895</c:v>
                      </c:pt>
                      <c:pt idx="428">
                        <c:v>896</c:v>
                      </c:pt>
                      <c:pt idx="429">
                        <c:v>897</c:v>
                      </c:pt>
                      <c:pt idx="430">
                        <c:v>898</c:v>
                      </c:pt>
                      <c:pt idx="431">
                        <c:v>900</c:v>
                      </c:pt>
                      <c:pt idx="432">
                        <c:v>901</c:v>
                      </c:pt>
                      <c:pt idx="433">
                        <c:v>902</c:v>
                      </c:pt>
                      <c:pt idx="434">
                        <c:v>903</c:v>
                      </c:pt>
                      <c:pt idx="435">
                        <c:v>904</c:v>
                      </c:pt>
                      <c:pt idx="436">
                        <c:v>905</c:v>
                      </c:pt>
                      <c:pt idx="437">
                        <c:v>907</c:v>
                      </c:pt>
                      <c:pt idx="438">
                        <c:v>908</c:v>
                      </c:pt>
                      <c:pt idx="439">
                        <c:v>909</c:v>
                      </c:pt>
                      <c:pt idx="440">
                        <c:v>910</c:v>
                      </c:pt>
                      <c:pt idx="441">
                        <c:v>911</c:v>
                      </c:pt>
                      <c:pt idx="442">
                        <c:v>912</c:v>
                      </c:pt>
                      <c:pt idx="443">
                        <c:v>913</c:v>
                      </c:pt>
                      <c:pt idx="444">
                        <c:v>918</c:v>
                      </c:pt>
                      <c:pt idx="445">
                        <c:v>919</c:v>
                      </c:pt>
                      <c:pt idx="446">
                        <c:v>920</c:v>
                      </c:pt>
                      <c:pt idx="447">
                        <c:v>922</c:v>
                      </c:pt>
                      <c:pt idx="448">
                        <c:v>923</c:v>
                      </c:pt>
                      <c:pt idx="449">
                        <c:v>924</c:v>
                      </c:pt>
                      <c:pt idx="450">
                        <c:v>925</c:v>
                      </c:pt>
                      <c:pt idx="451">
                        <c:v>926</c:v>
                      </c:pt>
                      <c:pt idx="452">
                        <c:v>927</c:v>
                      </c:pt>
                      <c:pt idx="453">
                        <c:v>928</c:v>
                      </c:pt>
                      <c:pt idx="454">
                        <c:v>929</c:v>
                      </c:pt>
                      <c:pt idx="455">
                        <c:v>930</c:v>
                      </c:pt>
                      <c:pt idx="456">
                        <c:v>931</c:v>
                      </c:pt>
                      <c:pt idx="457">
                        <c:v>934</c:v>
                      </c:pt>
                      <c:pt idx="458">
                        <c:v>935</c:v>
                      </c:pt>
                      <c:pt idx="459">
                        <c:v>940</c:v>
                      </c:pt>
                      <c:pt idx="460">
                        <c:v>941</c:v>
                      </c:pt>
                      <c:pt idx="461">
                        <c:v>942</c:v>
                      </c:pt>
                      <c:pt idx="462">
                        <c:v>943</c:v>
                      </c:pt>
                      <c:pt idx="463">
                        <c:v>944</c:v>
                      </c:pt>
                      <c:pt idx="464">
                        <c:v>945</c:v>
                      </c:pt>
                      <c:pt idx="465">
                        <c:v>946</c:v>
                      </c:pt>
                      <c:pt idx="466">
                        <c:v>947</c:v>
                      </c:pt>
                      <c:pt idx="467">
                        <c:v>948</c:v>
                      </c:pt>
                      <c:pt idx="468">
                        <c:v>949</c:v>
                      </c:pt>
                      <c:pt idx="469">
                        <c:v>950</c:v>
                      </c:pt>
                      <c:pt idx="470">
                        <c:v>951</c:v>
                      </c:pt>
                      <c:pt idx="471">
                        <c:v>952</c:v>
                      </c:pt>
                      <c:pt idx="472">
                        <c:v>954</c:v>
                      </c:pt>
                      <c:pt idx="473">
                        <c:v>955</c:v>
                      </c:pt>
                      <c:pt idx="474">
                        <c:v>956</c:v>
                      </c:pt>
                      <c:pt idx="475">
                        <c:v>961</c:v>
                      </c:pt>
                      <c:pt idx="476">
                        <c:v>964</c:v>
                      </c:pt>
                      <c:pt idx="477">
                        <c:v>965</c:v>
                      </c:pt>
                      <c:pt idx="478">
                        <c:v>966</c:v>
                      </c:pt>
                      <c:pt idx="479">
                        <c:v>969</c:v>
                      </c:pt>
                      <c:pt idx="480">
                        <c:v>970</c:v>
                      </c:pt>
                      <c:pt idx="481">
                        <c:v>973</c:v>
                      </c:pt>
                      <c:pt idx="482">
                        <c:v>974</c:v>
                      </c:pt>
                      <c:pt idx="483">
                        <c:v>975</c:v>
                      </c:pt>
                      <c:pt idx="484">
                        <c:v>977</c:v>
                      </c:pt>
                      <c:pt idx="485">
                        <c:v>978</c:v>
                      </c:pt>
                      <c:pt idx="486">
                        <c:v>979</c:v>
                      </c:pt>
                      <c:pt idx="487">
                        <c:v>980</c:v>
                      </c:pt>
                      <c:pt idx="488">
                        <c:v>983</c:v>
                      </c:pt>
                      <c:pt idx="489">
                        <c:v>984</c:v>
                      </c:pt>
                      <c:pt idx="490">
                        <c:v>986</c:v>
                      </c:pt>
                      <c:pt idx="491">
                        <c:v>987</c:v>
                      </c:pt>
                      <c:pt idx="492">
                        <c:v>988</c:v>
                      </c:pt>
                      <c:pt idx="493">
                        <c:v>989</c:v>
                      </c:pt>
                      <c:pt idx="494">
                        <c:v>990</c:v>
                      </c:pt>
                      <c:pt idx="495">
                        <c:v>991</c:v>
                      </c:pt>
                      <c:pt idx="496">
                        <c:v>992</c:v>
                      </c:pt>
                      <c:pt idx="497">
                        <c:v>994</c:v>
                      </c:pt>
                      <c:pt idx="498">
                        <c:v>995</c:v>
                      </c:pt>
                      <c:pt idx="499">
                        <c:v>996</c:v>
                      </c:pt>
                      <c:pt idx="500">
                        <c:v>997</c:v>
                      </c:pt>
                      <c:pt idx="501">
                        <c:v>998</c:v>
                      </c:pt>
                      <c:pt idx="502">
                        <c:v>999</c:v>
                      </c:pt>
                      <c:pt idx="503">
                        <c:v>1000</c:v>
                      </c:pt>
                      <c:pt idx="504">
                        <c:v>1001</c:v>
                      </c:pt>
                      <c:pt idx="505">
                        <c:v>1002</c:v>
                      </c:pt>
                      <c:pt idx="506">
                        <c:v>1003</c:v>
                      </c:pt>
                      <c:pt idx="507">
                        <c:v>1004</c:v>
                      </c:pt>
                      <c:pt idx="508">
                        <c:v>1005</c:v>
                      </c:pt>
                      <c:pt idx="509">
                        <c:v>1006</c:v>
                      </c:pt>
                      <c:pt idx="510">
                        <c:v>1008</c:v>
                      </c:pt>
                      <c:pt idx="511">
                        <c:v>1009</c:v>
                      </c:pt>
                      <c:pt idx="512">
                        <c:v>1010</c:v>
                      </c:pt>
                      <c:pt idx="513">
                        <c:v>1011</c:v>
                      </c:pt>
                      <c:pt idx="514">
                        <c:v>1012</c:v>
                      </c:pt>
                      <c:pt idx="515">
                        <c:v>1013</c:v>
                      </c:pt>
                      <c:pt idx="516">
                        <c:v>1015</c:v>
                      </c:pt>
                      <c:pt idx="517">
                        <c:v>1020</c:v>
                      </c:pt>
                      <c:pt idx="518">
                        <c:v>1021</c:v>
                      </c:pt>
                      <c:pt idx="519">
                        <c:v>1022</c:v>
                      </c:pt>
                      <c:pt idx="520">
                        <c:v>1023</c:v>
                      </c:pt>
                      <c:pt idx="521">
                        <c:v>1024</c:v>
                      </c:pt>
                      <c:pt idx="522">
                        <c:v>1025</c:v>
                      </c:pt>
                      <c:pt idx="523">
                        <c:v>1027</c:v>
                      </c:pt>
                      <c:pt idx="524">
                        <c:v>1031</c:v>
                      </c:pt>
                      <c:pt idx="525">
                        <c:v>1032</c:v>
                      </c:pt>
                      <c:pt idx="526">
                        <c:v>1033</c:v>
                      </c:pt>
                      <c:pt idx="527">
                        <c:v>1034</c:v>
                      </c:pt>
                      <c:pt idx="528">
                        <c:v>1035</c:v>
                      </c:pt>
                      <c:pt idx="529">
                        <c:v>1037</c:v>
                      </c:pt>
                      <c:pt idx="530">
                        <c:v>1039</c:v>
                      </c:pt>
                      <c:pt idx="531">
                        <c:v>1040</c:v>
                      </c:pt>
                      <c:pt idx="532">
                        <c:v>1041</c:v>
                      </c:pt>
                      <c:pt idx="533">
                        <c:v>1043</c:v>
                      </c:pt>
                      <c:pt idx="534">
                        <c:v>1044</c:v>
                      </c:pt>
                      <c:pt idx="535">
                        <c:v>1045</c:v>
                      </c:pt>
                      <c:pt idx="536">
                        <c:v>1046</c:v>
                      </c:pt>
                      <c:pt idx="537">
                        <c:v>1047</c:v>
                      </c:pt>
                      <c:pt idx="538">
                        <c:v>1048</c:v>
                      </c:pt>
                      <c:pt idx="539">
                        <c:v>1049</c:v>
                      </c:pt>
                      <c:pt idx="540">
                        <c:v>1050</c:v>
                      </c:pt>
                      <c:pt idx="541">
                        <c:v>1051</c:v>
                      </c:pt>
                      <c:pt idx="542">
                        <c:v>1052</c:v>
                      </c:pt>
                      <c:pt idx="543">
                        <c:v>1053</c:v>
                      </c:pt>
                      <c:pt idx="544">
                        <c:v>1054</c:v>
                      </c:pt>
                      <c:pt idx="545">
                        <c:v>1055</c:v>
                      </c:pt>
                      <c:pt idx="546">
                        <c:v>1057</c:v>
                      </c:pt>
                      <c:pt idx="547">
                        <c:v>1059</c:v>
                      </c:pt>
                      <c:pt idx="548">
                        <c:v>1060</c:v>
                      </c:pt>
                      <c:pt idx="549">
                        <c:v>1061</c:v>
                      </c:pt>
                      <c:pt idx="550">
                        <c:v>1062</c:v>
                      </c:pt>
                      <c:pt idx="551">
                        <c:v>1063</c:v>
                      </c:pt>
                      <c:pt idx="552">
                        <c:v>1064</c:v>
                      </c:pt>
                      <c:pt idx="553">
                        <c:v>1065</c:v>
                      </c:pt>
                      <c:pt idx="554">
                        <c:v>1066</c:v>
                      </c:pt>
                      <c:pt idx="555">
                        <c:v>1067</c:v>
                      </c:pt>
                      <c:pt idx="556">
                        <c:v>1068</c:v>
                      </c:pt>
                      <c:pt idx="557">
                        <c:v>1069</c:v>
                      </c:pt>
                      <c:pt idx="558">
                        <c:v>1070</c:v>
                      </c:pt>
                      <c:pt idx="559">
                        <c:v>1072</c:v>
                      </c:pt>
                      <c:pt idx="560">
                        <c:v>1073</c:v>
                      </c:pt>
                      <c:pt idx="561">
                        <c:v>1074</c:v>
                      </c:pt>
                      <c:pt idx="562">
                        <c:v>1077</c:v>
                      </c:pt>
                      <c:pt idx="563">
                        <c:v>1080</c:v>
                      </c:pt>
                      <c:pt idx="564">
                        <c:v>1081</c:v>
                      </c:pt>
                      <c:pt idx="565">
                        <c:v>1082</c:v>
                      </c:pt>
                      <c:pt idx="566">
                        <c:v>1083</c:v>
                      </c:pt>
                      <c:pt idx="567">
                        <c:v>1084</c:v>
                      </c:pt>
                      <c:pt idx="568">
                        <c:v>1085</c:v>
                      </c:pt>
                      <c:pt idx="569">
                        <c:v>1090</c:v>
                      </c:pt>
                      <c:pt idx="570">
                        <c:v>1091</c:v>
                      </c:pt>
                      <c:pt idx="571">
                        <c:v>1092</c:v>
                      </c:pt>
                      <c:pt idx="572">
                        <c:v>1093</c:v>
                      </c:pt>
                      <c:pt idx="573">
                        <c:v>1094</c:v>
                      </c:pt>
                      <c:pt idx="574">
                        <c:v>1099</c:v>
                      </c:pt>
                      <c:pt idx="575">
                        <c:v>1100</c:v>
                      </c:pt>
                      <c:pt idx="576">
                        <c:v>1101</c:v>
                      </c:pt>
                      <c:pt idx="577">
                        <c:v>1102</c:v>
                      </c:pt>
                      <c:pt idx="578">
                        <c:v>1103</c:v>
                      </c:pt>
                      <c:pt idx="579">
                        <c:v>1104</c:v>
                      </c:pt>
                      <c:pt idx="580">
                        <c:v>1105</c:v>
                      </c:pt>
                      <c:pt idx="581">
                        <c:v>1106</c:v>
                      </c:pt>
                      <c:pt idx="582">
                        <c:v>1107</c:v>
                      </c:pt>
                      <c:pt idx="583">
                        <c:v>1108</c:v>
                      </c:pt>
                      <c:pt idx="584">
                        <c:v>1110</c:v>
                      </c:pt>
                      <c:pt idx="585">
                        <c:v>1111</c:v>
                      </c:pt>
                      <c:pt idx="586">
                        <c:v>1112</c:v>
                      </c:pt>
                      <c:pt idx="587">
                        <c:v>1113</c:v>
                      </c:pt>
                      <c:pt idx="588">
                        <c:v>1114</c:v>
                      </c:pt>
                      <c:pt idx="589">
                        <c:v>1115</c:v>
                      </c:pt>
                      <c:pt idx="590">
                        <c:v>1116</c:v>
                      </c:pt>
                      <c:pt idx="591">
                        <c:v>1118</c:v>
                      </c:pt>
                      <c:pt idx="592">
                        <c:v>1119</c:v>
                      </c:pt>
                      <c:pt idx="593">
                        <c:v>1120</c:v>
                      </c:pt>
                      <c:pt idx="594">
                        <c:v>1121</c:v>
                      </c:pt>
                      <c:pt idx="595">
                        <c:v>1122</c:v>
                      </c:pt>
                      <c:pt idx="596">
                        <c:v>1123</c:v>
                      </c:pt>
                      <c:pt idx="597">
                        <c:v>1124</c:v>
                      </c:pt>
                      <c:pt idx="598">
                        <c:v>1130</c:v>
                      </c:pt>
                      <c:pt idx="599">
                        <c:v>1131</c:v>
                      </c:pt>
                      <c:pt idx="600">
                        <c:v>1132</c:v>
                      </c:pt>
                      <c:pt idx="601">
                        <c:v>1133</c:v>
                      </c:pt>
                      <c:pt idx="602">
                        <c:v>1134</c:v>
                      </c:pt>
                      <c:pt idx="603">
                        <c:v>1135</c:v>
                      </c:pt>
                      <c:pt idx="604">
                        <c:v>1136</c:v>
                      </c:pt>
                      <c:pt idx="605">
                        <c:v>1137</c:v>
                      </c:pt>
                      <c:pt idx="606">
                        <c:v>1138</c:v>
                      </c:pt>
                      <c:pt idx="607">
                        <c:v>1139</c:v>
                      </c:pt>
                      <c:pt idx="608">
                        <c:v>1140</c:v>
                      </c:pt>
                      <c:pt idx="609">
                        <c:v>1141</c:v>
                      </c:pt>
                      <c:pt idx="610">
                        <c:v>1142</c:v>
                      </c:pt>
                      <c:pt idx="611">
                        <c:v>1143</c:v>
                      </c:pt>
                      <c:pt idx="612">
                        <c:v>1145</c:v>
                      </c:pt>
                      <c:pt idx="613">
                        <c:v>1146</c:v>
                      </c:pt>
                      <c:pt idx="614">
                        <c:v>1147</c:v>
                      </c:pt>
                      <c:pt idx="615">
                        <c:v>1148</c:v>
                      </c:pt>
                      <c:pt idx="616">
                        <c:v>1149</c:v>
                      </c:pt>
                      <c:pt idx="617">
                        <c:v>1150</c:v>
                      </c:pt>
                      <c:pt idx="618">
                        <c:v>1151</c:v>
                      </c:pt>
                      <c:pt idx="619">
                        <c:v>1153</c:v>
                      </c:pt>
                      <c:pt idx="620">
                        <c:v>1154</c:v>
                      </c:pt>
                      <c:pt idx="621">
                        <c:v>1155</c:v>
                      </c:pt>
                      <c:pt idx="622">
                        <c:v>1156</c:v>
                      </c:pt>
                      <c:pt idx="623">
                        <c:v>1157</c:v>
                      </c:pt>
                      <c:pt idx="624">
                        <c:v>1158</c:v>
                      </c:pt>
                      <c:pt idx="625">
                        <c:v>1159</c:v>
                      </c:pt>
                      <c:pt idx="626">
                        <c:v>1160</c:v>
                      </c:pt>
                      <c:pt idx="627">
                        <c:v>1161</c:v>
                      </c:pt>
                      <c:pt idx="628">
                        <c:v>1162</c:v>
                      </c:pt>
                      <c:pt idx="629">
                        <c:v>1165</c:v>
                      </c:pt>
                      <c:pt idx="630">
                        <c:v>1166</c:v>
                      </c:pt>
                      <c:pt idx="631">
                        <c:v>1167</c:v>
                      </c:pt>
                      <c:pt idx="632">
                        <c:v>1168</c:v>
                      </c:pt>
                      <c:pt idx="633">
                        <c:v>1169</c:v>
                      </c:pt>
                      <c:pt idx="634">
                        <c:v>1170</c:v>
                      </c:pt>
                      <c:pt idx="635">
                        <c:v>1173</c:v>
                      </c:pt>
                      <c:pt idx="636">
                        <c:v>1174</c:v>
                      </c:pt>
                      <c:pt idx="637">
                        <c:v>1175</c:v>
                      </c:pt>
                      <c:pt idx="638">
                        <c:v>1180</c:v>
                      </c:pt>
                      <c:pt idx="639">
                        <c:v>1181</c:v>
                      </c:pt>
                      <c:pt idx="640">
                        <c:v>1182</c:v>
                      </c:pt>
                      <c:pt idx="641">
                        <c:v>1183</c:v>
                      </c:pt>
                      <c:pt idx="642">
                        <c:v>1184</c:v>
                      </c:pt>
                      <c:pt idx="643">
                        <c:v>1185</c:v>
                      </c:pt>
                      <c:pt idx="644">
                        <c:v>1186</c:v>
                      </c:pt>
                      <c:pt idx="645">
                        <c:v>1187</c:v>
                      </c:pt>
                      <c:pt idx="646">
                        <c:v>1188</c:v>
                      </c:pt>
                      <c:pt idx="647">
                        <c:v>1189</c:v>
                      </c:pt>
                      <c:pt idx="648">
                        <c:v>1190</c:v>
                      </c:pt>
                      <c:pt idx="649">
                        <c:v>1192</c:v>
                      </c:pt>
                      <c:pt idx="650">
                        <c:v>1193</c:v>
                      </c:pt>
                      <c:pt idx="651">
                        <c:v>1194</c:v>
                      </c:pt>
                      <c:pt idx="652">
                        <c:v>1195</c:v>
                      </c:pt>
                      <c:pt idx="653">
                        <c:v>1197</c:v>
                      </c:pt>
                      <c:pt idx="654">
                        <c:v>1198</c:v>
                      </c:pt>
                      <c:pt idx="655">
                        <c:v>1199</c:v>
                      </c:pt>
                      <c:pt idx="656">
                        <c:v>1200</c:v>
                      </c:pt>
                      <c:pt idx="657">
                        <c:v>1201</c:v>
                      </c:pt>
                      <c:pt idx="658">
                        <c:v>1203</c:v>
                      </c:pt>
                      <c:pt idx="659">
                        <c:v>1204</c:v>
                      </c:pt>
                      <c:pt idx="660">
                        <c:v>1205</c:v>
                      </c:pt>
                      <c:pt idx="661">
                        <c:v>1208</c:v>
                      </c:pt>
                      <c:pt idx="662">
                        <c:v>1209</c:v>
                      </c:pt>
                      <c:pt idx="663">
                        <c:v>1210</c:v>
                      </c:pt>
                      <c:pt idx="664">
                        <c:v>1214</c:v>
                      </c:pt>
                      <c:pt idx="665">
                        <c:v>1215</c:v>
                      </c:pt>
                      <c:pt idx="666">
                        <c:v>1216</c:v>
                      </c:pt>
                      <c:pt idx="667">
                        <c:v>1217</c:v>
                      </c:pt>
                      <c:pt idx="668">
                        <c:v>1220</c:v>
                      </c:pt>
                      <c:pt idx="669">
                        <c:v>1221</c:v>
                      </c:pt>
                      <c:pt idx="670">
                        <c:v>1225</c:v>
                      </c:pt>
                      <c:pt idx="671">
                        <c:v>1229</c:v>
                      </c:pt>
                      <c:pt idx="672">
                        <c:v>1231</c:v>
                      </c:pt>
                      <c:pt idx="673">
                        <c:v>1232</c:v>
                      </c:pt>
                      <c:pt idx="674">
                        <c:v>1242</c:v>
                      </c:pt>
                      <c:pt idx="675">
                        <c:v>1253</c:v>
                      </c:pt>
                      <c:pt idx="676">
                        <c:v>1255</c:v>
                      </c:pt>
                      <c:pt idx="677">
                        <c:v>1256</c:v>
                      </c:pt>
                      <c:pt idx="678">
                        <c:v>1258</c:v>
                      </c:pt>
                      <c:pt idx="679">
                        <c:v>1259</c:v>
                      </c:pt>
                      <c:pt idx="680">
                        <c:v>1260</c:v>
                      </c:pt>
                      <c:pt idx="681">
                        <c:v>1261</c:v>
                      </c:pt>
                      <c:pt idx="682">
                        <c:v>1262</c:v>
                      </c:pt>
                      <c:pt idx="683">
                        <c:v>1263</c:v>
                      </c:pt>
                      <c:pt idx="684">
                        <c:v>1264</c:v>
                      </c:pt>
                      <c:pt idx="685">
                        <c:v>1266</c:v>
                      </c:pt>
                      <c:pt idx="686">
                        <c:v>1269</c:v>
                      </c:pt>
                      <c:pt idx="687">
                        <c:v>1279</c:v>
                      </c:pt>
                      <c:pt idx="688">
                        <c:v>1280</c:v>
                      </c:pt>
                      <c:pt idx="689">
                        <c:v>1290</c:v>
                      </c:pt>
                      <c:pt idx="690">
                        <c:v>1291</c:v>
                      </c:pt>
                      <c:pt idx="691">
                        <c:v>1292</c:v>
                      </c:pt>
                      <c:pt idx="692">
                        <c:v>1293</c:v>
                      </c:pt>
                      <c:pt idx="693">
                        <c:v>1294</c:v>
                      </c:pt>
                      <c:pt idx="694">
                        <c:v>1295</c:v>
                      </c:pt>
                      <c:pt idx="695">
                        <c:v>1300</c:v>
                      </c:pt>
                      <c:pt idx="696">
                        <c:v>1301</c:v>
                      </c:pt>
                      <c:pt idx="697">
                        <c:v>1302</c:v>
                      </c:pt>
                      <c:pt idx="698">
                        <c:v>1303</c:v>
                      </c:pt>
                      <c:pt idx="699">
                        <c:v>1305</c:v>
                      </c:pt>
                      <c:pt idx="700">
                        <c:v>1306</c:v>
                      </c:pt>
                      <c:pt idx="701">
                        <c:v>1307</c:v>
                      </c:pt>
                      <c:pt idx="702">
                        <c:v>1308</c:v>
                      </c:pt>
                      <c:pt idx="703">
                        <c:v>1310</c:v>
                      </c:pt>
                      <c:pt idx="704">
                        <c:v>1311</c:v>
                      </c:pt>
                      <c:pt idx="705">
                        <c:v>1312</c:v>
                      </c:pt>
                      <c:pt idx="706">
                        <c:v>1313</c:v>
                      </c:pt>
                      <c:pt idx="707">
                        <c:v>1314</c:v>
                      </c:pt>
                      <c:pt idx="708">
                        <c:v>1315</c:v>
                      </c:pt>
                      <c:pt idx="709">
                        <c:v>1316</c:v>
                      </c:pt>
                      <c:pt idx="710">
                        <c:v>1317</c:v>
                      </c:pt>
                      <c:pt idx="711">
                        <c:v>1318</c:v>
                      </c:pt>
                      <c:pt idx="712">
                        <c:v>1319</c:v>
                      </c:pt>
                      <c:pt idx="713">
                        <c:v>1320</c:v>
                      </c:pt>
                      <c:pt idx="714">
                        <c:v>1322</c:v>
                      </c:pt>
                      <c:pt idx="715">
                        <c:v>1323</c:v>
                      </c:pt>
                      <c:pt idx="716">
                        <c:v>1324</c:v>
                      </c:pt>
                      <c:pt idx="717">
                        <c:v>1325</c:v>
                      </c:pt>
                      <c:pt idx="718">
                        <c:v>1326</c:v>
                      </c:pt>
                      <c:pt idx="719">
                        <c:v>1327</c:v>
                      </c:pt>
                      <c:pt idx="720">
                        <c:v>1328</c:v>
                      </c:pt>
                      <c:pt idx="721">
                        <c:v>1329</c:v>
                      </c:pt>
                      <c:pt idx="722">
                        <c:v>1331</c:v>
                      </c:pt>
                      <c:pt idx="723">
                        <c:v>1333</c:v>
                      </c:pt>
                      <c:pt idx="724">
                        <c:v>1337</c:v>
                      </c:pt>
                      <c:pt idx="725">
                        <c:v>1338</c:v>
                      </c:pt>
                      <c:pt idx="726">
                        <c:v>1339</c:v>
                      </c:pt>
                      <c:pt idx="727">
                        <c:v>1342</c:v>
                      </c:pt>
                      <c:pt idx="728">
                        <c:v>1343</c:v>
                      </c:pt>
                      <c:pt idx="729">
                        <c:v>1344</c:v>
                      </c:pt>
                      <c:pt idx="730">
                        <c:v>1345</c:v>
                      </c:pt>
                      <c:pt idx="731">
                        <c:v>1346</c:v>
                      </c:pt>
                      <c:pt idx="732">
                        <c:v>1348</c:v>
                      </c:pt>
                      <c:pt idx="733">
                        <c:v>1349</c:v>
                      </c:pt>
                      <c:pt idx="734">
                        <c:v>1353</c:v>
                      </c:pt>
                      <c:pt idx="735">
                        <c:v>1355</c:v>
                      </c:pt>
                      <c:pt idx="736">
                        <c:v>1360</c:v>
                      </c:pt>
                      <c:pt idx="737">
                        <c:v>1361</c:v>
                      </c:pt>
                      <c:pt idx="738">
                        <c:v>1363</c:v>
                      </c:pt>
                      <c:pt idx="739">
                        <c:v>1364</c:v>
                      </c:pt>
                      <c:pt idx="740">
                        <c:v>1365</c:v>
                      </c:pt>
                      <c:pt idx="741">
                        <c:v>1366</c:v>
                      </c:pt>
                      <c:pt idx="742">
                        <c:v>1367</c:v>
                      </c:pt>
                      <c:pt idx="743">
                        <c:v>1369</c:v>
                      </c:pt>
                      <c:pt idx="744">
                        <c:v>1372</c:v>
                      </c:pt>
                      <c:pt idx="745">
                        <c:v>1373</c:v>
                      </c:pt>
                      <c:pt idx="746">
                        <c:v>1374</c:v>
                      </c:pt>
                      <c:pt idx="747">
                        <c:v>1375</c:v>
                      </c:pt>
                      <c:pt idx="748">
                        <c:v>1376</c:v>
                      </c:pt>
                      <c:pt idx="749">
                        <c:v>1377</c:v>
                      </c:pt>
                      <c:pt idx="750">
                        <c:v>1378</c:v>
                      </c:pt>
                      <c:pt idx="751">
                        <c:v>1379</c:v>
                      </c:pt>
                      <c:pt idx="752">
                        <c:v>1380</c:v>
                      </c:pt>
                      <c:pt idx="753">
                        <c:v>1381</c:v>
                      </c:pt>
                      <c:pt idx="754">
                        <c:v>1383</c:v>
                      </c:pt>
                      <c:pt idx="755">
                        <c:v>1384</c:v>
                      </c:pt>
                      <c:pt idx="756">
                        <c:v>1385</c:v>
                      </c:pt>
                      <c:pt idx="757">
                        <c:v>1386</c:v>
                      </c:pt>
                      <c:pt idx="758">
                        <c:v>1390</c:v>
                      </c:pt>
                      <c:pt idx="759">
                        <c:v>1391</c:v>
                      </c:pt>
                      <c:pt idx="760">
                        <c:v>1392</c:v>
                      </c:pt>
                      <c:pt idx="761">
                        <c:v>1393</c:v>
                      </c:pt>
                      <c:pt idx="762">
                        <c:v>1394</c:v>
                      </c:pt>
                      <c:pt idx="763">
                        <c:v>1395</c:v>
                      </c:pt>
                      <c:pt idx="764">
                        <c:v>1396</c:v>
                      </c:pt>
                      <c:pt idx="765">
                        <c:v>1397</c:v>
                      </c:pt>
                      <c:pt idx="766">
                        <c:v>1398</c:v>
                      </c:pt>
                      <c:pt idx="767">
                        <c:v>1400</c:v>
                      </c:pt>
                      <c:pt idx="768">
                        <c:v>1401</c:v>
                      </c:pt>
                      <c:pt idx="769">
                        <c:v>1402</c:v>
                      </c:pt>
                      <c:pt idx="770">
                        <c:v>1403</c:v>
                      </c:pt>
                      <c:pt idx="771">
                        <c:v>1405</c:v>
                      </c:pt>
                      <c:pt idx="772">
                        <c:v>1407</c:v>
                      </c:pt>
                      <c:pt idx="773">
                        <c:v>1408</c:v>
                      </c:pt>
                      <c:pt idx="774">
                        <c:v>1410</c:v>
                      </c:pt>
                      <c:pt idx="775">
                        <c:v>1411</c:v>
                      </c:pt>
                      <c:pt idx="776">
                        <c:v>1412</c:v>
                      </c:pt>
                      <c:pt idx="777">
                        <c:v>1413</c:v>
                      </c:pt>
                      <c:pt idx="778">
                        <c:v>1414</c:v>
                      </c:pt>
                      <c:pt idx="779">
                        <c:v>1415</c:v>
                      </c:pt>
                      <c:pt idx="780">
                        <c:v>1416</c:v>
                      </c:pt>
                      <c:pt idx="781">
                        <c:v>1417</c:v>
                      </c:pt>
                      <c:pt idx="782">
                        <c:v>1418</c:v>
                      </c:pt>
                      <c:pt idx="783">
                        <c:v>1419</c:v>
                      </c:pt>
                      <c:pt idx="784">
                        <c:v>1420</c:v>
                      </c:pt>
                      <c:pt idx="785">
                        <c:v>1421</c:v>
                      </c:pt>
                      <c:pt idx="786">
                        <c:v>1423</c:v>
                      </c:pt>
                      <c:pt idx="787">
                        <c:v>1424</c:v>
                      </c:pt>
                      <c:pt idx="788">
                        <c:v>1425</c:v>
                      </c:pt>
                      <c:pt idx="789">
                        <c:v>1426</c:v>
                      </c:pt>
                      <c:pt idx="790">
                        <c:v>1427</c:v>
                      </c:pt>
                      <c:pt idx="791">
                        <c:v>1428</c:v>
                      </c:pt>
                      <c:pt idx="792">
                        <c:v>1429</c:v>
                      </c:pt>
                      <c:pt idx="793">
                        <c:v>1430</c:v>
                      </c:pt>
                      <c:pt idx="794">
                        <c:v>1432</c:v>
                      </c:pt>
                      <c:pt idx="795">
                        <c:v>1434</c:v>
                      </c:pt>
                      <c:pt idx="796">
                        <c:v>1435</c:v>
                      </c:pt>
                      <c:pt idx="797">
                        <c:v>1436</c:v>
                      </c:pt>
                      <c:pt idx="798">
                        <c:v>1437</c:v>
                      </c:pt>
                      <c:pt idx="799">
                        <c:v>1439</c:v>
                      </c:pt>
                      <c:pt idx="800">
                        <c:v>1440</c:v>
                      </c:pt>
                      <c:pt idx="801">
                        <c:v>1442</c:v>
                      </c:pt>
                      <c:pt idx="802">
                        <c:v>1443</c:v>
                      </c:pt>
                      <c:pt idx="803">
                        <c:v>1444</c:v>
                      </c:pt>
                      <c:pt idx="804">
                        <c:v>1445</c:v>
                      </c:pt>
                      <c:pt idx="805">
                        <c:v>1446</c:v>
                      </c:pt>
                      <c:pt idx="806">
                        <c:v>1447</c:v>
                      </c:pt>
                      <c:pt idx="807">
                        <c:v>1448</c:v>
                      </c:pt>
                      <c:pt idx="808">
                        <c:v>1449</c:v>
                      </c:pt>
                      <c:pt idx="809">
                        <c:v>1450</c:v>
                      </c:pt>
                      <c:pt idx="810">
                        <c:v>1451</c:v>
                      </c:pt>
                      <c:pt idx="811">
                        <c:v>1453</c:v>
                      </c:pt>
                      <c:pt idx="812">
                        <c:v>1454</c:v>
                      </c:pt>
                      <c:pt idx="813">
                        <c:v>1455</c:v>
                      </c:pt>
                      <c:pt idx="814">
                        <c:v>1456</c:v>
                      </c:pt>
                      <c:pt idx="815">
                        <c:v>1457</c:v>
                      </c:pt>
                      <c:pt idx="816">
                        <c:v>1458</c:v>
                      </c:pt>
                      <c:pt idx="817">
                        <c:v>1459</c:v>
                      </c:pt>
                      <c:pt idx="818">
                        <c:v>1460</c:v>
                      </c:pt>
                      <c:pt idx="819">
                        <c:v>1461</c:v>
                      </c:pt>
                      <c:pt idx="820">
                        <c:v>1462</c:v>
                      </c:pt>
                      <c:pt idx="821">
                        <c:v>1463</c:v>
                      </c:pt>
                      <c:pt idx="822">
                        <c:v>1464</c:v>
                      </c:pt>
                      <c:pt idx="823">
                        <c:v>1465</c:v>
                      </c:pt>
                      <c:pt idx="824">
                        <c:v>1466</c:v>
                      </c:pt>
                      <c:pt idx="825">
                        <c:v>1467</c:v>
                      </c:pt>
                      <c:pt idx="826">
                        <c:v>1468</c:v>
                      </c:pt>
                      <c:pt idx="827">
                        <c:v>1469</c:v>
                      </c:pt>
                      <c:pt idx="828">
                        <c:v>1470</c:v>
                      </c:pt>
                      <c:pt idx="829">
                        <c:v>1471</c:v>
                      </c:pt>
                      <c:pt idx="830">
                        <c:v>1472</c:v>
                      </c:pt>
                      <c:pt idx="831">
                        <c:v>1473</c:v>
                      </c:pt>
                      <c:pt idx="832">
                        <c:v>1474</c:v>
                      </c:pt>
                      <c:pt idx="833">
                        <c:v>1475</c:v>
                      </c:pt>
                      <c:pt idx="834">
                        <c:v>1476</c:v>
                      </c:pt>
                      <c:pt idx="835">
                        <c:v>1477</c:v>
                      </c:pt>
                      <c:pt idx="836">
                        <c:v>1478</c:v>
                      </c:pt>
                      <c:pt idx="837">
                        <c:v>1479</c:v>
                      </c:pt>
                      <c:pt idx="838">
                        <c:v>1480</c:v>
                      </c:pt>
                      <c:pt idx="839">
                        <c:v>1481</c:v>
                      </c:pt>
                      <c:pt idx="840">
                        <c:v>1482</c:v>
                      </c:pt>
                      <c:pt idx="841">
                        <c:v>1483</c:v>
                      </c:pt>
                      <c:pt idx="842">
                        <c:v>1484</c:v>
                      </c:pt>
                      <c:pt idx="843">
                        <c:v>1485</c:v>
                      </c:pt>
                      <c:pt idx="844">
                        <c:v>1486</c:v>
                      </c:pt>
                      <c:pt idx="845">
                        <c:v>1487</c:v>
                      </c:pt>
                      <c:pt idx="846">
                        <c:v>1488</c:v>
                      </c:pt>
                      <c:pt idx="847">
                        <c:v>1489</c:v>
                      </c:pt>
                      <c:pt idx="848">
                        <c:v>1490</c:v>
                      </c:pt>
                      <c:pt idx="849">
                        <c:v>1491</c:v>
                      </c:pt>
                      <c:pt idx="850">
                        <c:v>1492</c:v>
                      </c:pt>
                      <c:pt idx="851">
                        <c:v>1493</c:v>
                      </c:pt>
                      <c:pt idx="852">
                        <c:v>1494</c:v>
                      </c:pt>
                      <c:pt idx="853">
                        <c:v>1495</c:v>
                      </c:pt>
                      <c:pt idx="854">
                        <c:v>1496</c:v>
                      </c:pt>
                      <c:pt idx="855">
                        <c:v>1497</c:v>
                      </c:pt>
                      <c:pt idx="856">
                        <c:v>1498</c:v>
                      </c:pt>
                      <c:pt idx="857">
                        <c:v>1499</c:v>
                      </c:pt>
                      <c:pt idx="858">
                        <c:v>1500</c:v>
                      </c:pt>
                      <c:pt idx="859">
                        <c:v>1501</c:v>
                      </c:pt>
                      <c:pt idx="860">
                        <c:v>1502</c:v>
                      </c:pt>
                      <c:pt idx="861">
                        <c:v>1503</c:v>
                      </c:pt>
                      <c:pt idx="862">
                        <c:v>1504</c:v>
                      </c:pt>
                      <c:pt idx="863">
                        <c:v>1505</c:v>
                      </c:pt>
                      <c:pt idx="864">
                        <c:v>1506</c:v>
                      </c:pt>
                      <c:pt idx="865">
                        <c:v>1507</c:v>
                      </c:pt>
                      <c:pt idx="866">
                        <c:v>1509</c:v>
                      </c:pt>
                      <c:pt idx="867">
                        <c:v>1510</c:v>
                      </c:pt>
                      <c:pt idx="868">
                        <c:v>1511</c:v>
                      </c:pt>
                      <c:pt idx="869">
                        <c:v>1512</c:v>
                      </c:pt>
                      <c:pt idx="870">
                        <c:v>1514</c:v>
                      </c:pt>
                      <c:pt idx="871">
                        <c:v>1515</c:v>
                      </c:pt>
                      <c:pt idx="872">
                        <c:v>1516</c:v>
                      </c:pt>
                      <c:pt idx="873">
                        <c:v>1517</c:v>
                      </c:pt>
                      <c:pt idx="874">
                        <c:v>1518</c:v>
                      </c:pt>
                      <c:pt idx="875">
                        <c:v>1519</c:v>
                      </c:pt>
                      <c:pt idx="876">
                        <c:v>1520</c:v>
                      </c:pt>
                      <c:pt idx="877">
                        <c:v>1521</c:v>
                      </c:pt>
                      <c:pt idx="878">
                        <c:v>1522</c:v>
                      </c:pt>
                      <c:pt idx="879">
                        <c:v>1523</c:v>
                      </c:pt>
                      <c:pt idx="880">
                        <c:v>1524</c:v>
                      </c:pt>
                      <c:pt idx="881">
                        <c:v>1525</c:v>
                      </c:pt>
                      <c:pt idx="882">
                        <c:v>1526</c:v>
                      </c:pt>
                      <c:pt idx="883">
                        <c:v>1527</c:v>
                      </c:pt>
                      <c:pt idx="884">
                        <c:v>1528</c:v>
                      </c:pt>
                      <c:pt idx="885">
                        <c:v>1529</c:v>
                      </c:pt>
                      <c:pt idx="886">
                        <c:v>1530</c:v>
                      </c:pt>
                      <c:pt idx="887">
                        <c:v>1531</c:v>
                      </c:pt>
                      <c:pt idx="888">
                        <c:v>1532</c:v>
                      </c:pt>
                      <c:pt idx="889">
                        <c:v>1533</c:v>
                      </c:pt>
                      <c:pt idx="890">
                        <c:v>1534</c:v>
                      </c:pt>
                      <c:pt idx="891">
                        <c:v>1535</c:v>
                      </c:pt>
                      <c:pt idx="892">
                        <c:v>1536</c:v>
                      </c:pt>
                      <c:pt idx="893">
                        <c:v>1537</c:v>
                      </c:pt>
                      <c:pt idx="894">
                        <c:v>1538</c:v>
                      </c:pt>
                      <c:pt idx="895">
                        <c:v>1539</c:v>
                      </c:pt>
                      <c:pt idx="896">
                        <c:v>1540</c:v>
                      </c:pt>
                      <c:pt idx="897">
                        <c:v>1541</c:v>
                      </c:pt>
                      <c:pt idx="898">
                        <c:v>1542</c:v>
                      </c:pt>
                      <c:pt idx="899">
                        <c:v>1543</c:v>
                      </c:pt>
                      <c:pt idx="900">
                        <c:v>1544</c:v>
                      </c:pt>
                      <c:pt idx="901">
                        <c:v>1545</c:v>
                      </c:pt>
                      <c:pt idx="902">
                        <c:v>1546</c:v>
                      </c:pt>
                      <c:pt idx="903">
                        <c:v>1547</c:v>
                      </c:pt>
                      <c:pt idx="904">
                        <c:v>1548</c:v>
                      </c:pt>
                      <c:pt idx="905">
                        <c:v>1549</c:v>
                      </c:pt>
                      <c:pt idx="906">
                        <c:v>1550</c:v>
                      </c:pt>
                      <c:pt idx="907">
                        <c:v>1551</c:v>
                      </c:pt>
                      <c:pt idx="908">
                        <c:v>1552</c:v>
                      </c:pt>
                      <c:pt idx="909">
                        <c:v>1553</c:v>
                      </c:pt>
                      <c:pt idx="910">
                        <c:v>1554</c:v>
                      </c:pt>
                      <c:pt idx="911">
                        <c:v>1555</c:v>
                      </c:pt>
                      <c:pt idx="912">
                        <c:v>1556</c:v>
                      </c:pt>
                      <c:pt idx="913">
                        <c:v>1557</c:v>
                      </c:pt>
                      <c:pt idx="914">
                        <c:v>1558</c:v>
                      </c:pt>
                      <c:pt idx="915">
                        <c:v>1559</c:v>
                      </c:pt>
                      <c:pt idx="916">
                        <c:v>1560</c:v>
                      </c:pt>
                      <c:pt idx="917">
                        <c:v>1561</c:v>
                      </c:pt>
                      <c:pt idx="918">
                        <c:v>1562</c:v>
                      </c:pt>
                      <c:pt idx="919">
                        <c:v>1563</c:v>
                      </c:pt>
                      <c:pt idx="920">
                        <c:v>1564</c:v>
                      </c:pt>
                      <c:pt idx="921">
                        <c:v>1565</c:v>
                      </c:pt>
                      <c:pt idx="922">
                        <c:v>1566</c:v>
                      </c:pt>
                      <c:pt idx="923">
                        <c:v>1567</c:v>
                      </c:pt>
                      <c:pt idx="924">
                        <c:v>1568</c:v>
                      </c:pt>
                      <c:pt idx="925">
                        <c:v>1569</c:v>
                      </c:pt>
                      <c:pt idx="926">
                        <c:v>1570</c:v>
                      </c:pt>
                      <c:pt idx="927">
                        <c:v>1571</c:v>
                      </c:pt>
                      <c:pt idx="928">
                        <c:v>1572</c:v>
                      </c:pt>
                      <c:pt idx="929">
                        <c:v>1573</c:v>
                      </c:pt>
                      <c:pt idx="930">
                        <c:v>1574</c:v>
                      </c:pt>
                      <c:pt idx="931">
                        <c:v>1575</c:v>
                      </c:pt>
                      <c:pt idx="932">
                        <c:v>1576</c:v>
                      </c:pt>
                      <c:pt idx="933">
                        <c:v>1577</c:v>
                      </c:pt>
                      <c:pt idx="934">
                        <c:v>1578</c:v>
                      </c:pt>
                      <c:pt idx="935">
                        <c:v>1579</c:v>
                      </c:pt>
                      <c:pt idx="936">
                        <c:v>1580</c:v>
                      </c:pt>
                      <c:pt idx="937">
                        <c:v>1582</c:v>
                      </c:pt>
                      <c:pt idx="938">
                        <c:v>1583</c:v>
                      </c:pt>
                      <c:pt idx="939">
                        <c:v>1584</c:v>
                      </c:pt>
                      <c:pt idx="940">
                        <c:v>1585</c:v>
                      </c:pt>
                      <c:pt idx="941">
                        <c:v>1586</c:v>
                      </c:pt>
                      <c:pt idx="942">
                        <c:v>1587</c:v>
                      </c:pt>
                      <c:pt idx="943">
                        <c:v>1588</c:v>
                      </c:pt>
                      <c:pt idx="944">
                        <c:v>1589</c:v>
                      </c:pt>
                      <c:pt idx="945">
                        <c:v>1591</c:v>
                      </c:pt>
                      <c:pt idx="946">
                        <c:v>1592</c:v>
                      </c:pt>
                      <c:pt idx="947">
                        <c:v>1593</c:v>
                      </c:pt>
                      <c:pt idx="948">
                        <c:v>1594</c:v>
                      </c:pt>
                      <c:pt idx="949">
                        <c:v>1595</c:v>
                      </c:pt>
                      <c:pt idx="950">
                        <c:v>1596</c:v>
                      </c:pt>
                      <c:pt idx="951">
                        <c:v>1597</c:v>
                      </c:pt>
                      <c:pt idx="952">
                        <c:v>1598</c:v>
                      </c:pt>
                      <c:pt idx="953">
                        <c:v>1599</c:v>
                      </c:pt>
                      <c:pt idx="954">
                        <c:v>1600</c:v>
                      </c:pt>
                      <c:pt idx="955">
                        <c:v>1601</c:v>
                      </c:pt>
                      <c:pt idx="956">
                        <c:v>1602</c:v>
                      </c:pt>
                      <c:pt idx="957">
                        <c:v>1603</c:v>
                      </c:pt>
                      <c:pt idx="958">
                        <c:v>1604</c:v>
                      </c:pt>
                      <c:pt idx="959">
                        <c:v>1605</c:v>
                      </c:pt>
                      <c:pt idx="960">
                        <c:v>1606</c:v>
                      </c:pt>
                      <c:pt idx="961">
                        <c:v>1607</c:v>
                      </c:pt>
                      <c:pt idx="962">
                        <c:v>1608</c:v>
                      </c:pt>
                      <c:pt idx="963">
                        <c:v>1609</c:v>
                      </c:pt>
                      <c:pt idx="964">
                        <c:v>1610</c:v>
                      </c:pt>
                      <c:pt idx="965">
                        <c:v>1611</c:v>
                      </c:pt>
                      <c:pt idx="966">
                        <c:v>1612</c:v>
                      </c:pt>
                      <c:pt idx="967">
                        <c:v>1613</c:v>
                      </c:pt>
                      <c:pt idx="968">
                        <c:v>1614</c:v>
                      </c:pt>
                      <c:pt idx="969">
                        <c:v>1615</c:v>
                      </c:pt>
                      <c:pt idx="970">
                        <c:v>1616</c:v>
                      </c:pt>
                      <c:pt idx="971">
                        <c:v>1617</c:v>
                      </c:pt>
                      <c:pt idx="972">
                        <c:v>1618</c:v>
                      </c:pt>
                      <c:pt idx="973">
                        <c:v>1619</c:v>
                      </c:pt>
                      <c:pt idx="974">
                        <c:v>1620</c:v>
                      </c:pt>
                      <c:pt idx="975">
                        <c:v>1621</c:v>
                      </c:pt>
                      <c:pt idx="976">
                        <c:v>1622</c:v>
                      </c:pt>
                      <c:pt idx="977">
                        <c:v>1623</c:v>
                      </c:pt>
                      <c:pt idx="978">
                        <c:v>1624</c:v>
                      </c:pt>
                      <c:pt idx="979">
                        <c:v>1625</c:v>
                      </c:pt>
                      <c:pt idx="980">
                        <c:v>1626</c:v>
                      </c:pt>
                      <c:pt idx="981">
                        <c:v>1627</c:v>
                      </c:pt>
                      <c:pt idx="982">
                        <c:v>1628</c:v>
                      </c:pt>
                      <c:pt idx="983">
                        <c:v>1629</c:v>
                      </c:pt>
                      <c:pt idx="984">
                        <c:v>1630</c:v>
                      </c:pt>
                      <c:pt idx="985">
                        <c:v>1631</c:v>
                      </c:pt>
                      <c:pt idx="986">
                        <c:v>1632</c:v>
                      </c:pt>
                      <c:pt idx="987">
                        <c:v>1633</c:v>
                      </c:pt>
                      <c:pt idx="988">
                        <c:v>1634</c:v>
                      </c:pt>
                      <c:pt idx="989">
                        <c:v>1635</c:v>
                      </c:pt>
                      <c:pt idx="990">
                        <c:v>1636</c:v>
                      </c:pt>
                      <c:pt idx="991">
                        <c:v>1637</c:v>
                      </c:pt>
                      <c:pt idx="992">
                        <c:v>1638</c:v>
                      </c:pt>
                      <c:pt idx="993">
                        <c:v>1639</c:v>
                      </c:pt>
                      <c:pt idx="994">
                        <c:v>1640</c:v>
                      </c:pt>
                      <c:pt idx="995">
                        <c:v>1641</c:v>
                      </c:pt>
                      <c:pt idx="996">
                        <c:v>1642</c:v>
                      </c:pt>
                      <c:pt idx="997">
                        <c:v>1643</c:v>
                      </c:pt>
                      <c:pt idx="998">
                        <c:v>1644</c:v>
                      </c:pt>
                      <c:pt idx="999">
                        <c:v>1645</c:v>
                      </c:pt>
                      <c:pt idx="1000">
                        <c:v>1646</c:v>
                      </c:pt>
                      <c:pt idx="1001">
                        <c:v>1647</c:v>
                      </c:pt>
                      <c:pt idx="1002">
                        <c:v>1648</c:v>
                      </c:pt>
                      <c:pt idx="1003">
                        <c:v>1649</c:v>
                      </c:pt>
                      <c:pt idx="1004">
                        <c:v>1650</c:v>
                      </c:pt>
                      <c:pt idx="1005">
                        <c:v>1651</c:v>
                      </c:pt>
                      <c:pt idx="1006">
                        <c:v>1652</c:v>
                      </c:pt>
                      <c:pt idx="1007">
                        <c:v>1653</c:v>
                      </c:pt>
                      <c:pt idx="1008">
                        <c:v>1654</c:v>
                      </c:pt>
                      <c:pt idx="1009">
                        <c:v>1655</c:v>
                      </c:pt>
                      <c:pt idx="1010">
                        <c:v>1656</c:v>
                      </c:pt>
                      <c:pt idx="1011">
                        <c:v>1657</c:v>
                      </c:pt>
                      <c:pt idx="1012">
                        <c:v>1658</c:v>
                      </c:pt>
                      <c:pt idx="1013">
                        <c:v>1659</c:v>
                      </c:pt>
                      <c:pt idx="1014">
                        <c:v>1660</c:v>
                      </c:pt>
                      <c:pt idx="1015">
                        <c:v>1661</c:v>
                      </c:pt>
                      <c:pt idx="1016">
                        <c:v>1663</c:v>
                      </c:pt>
                      <c:pt idx="1017">
                        <c:v>1664</c:v>
                      </c:pt>
                      <c:pt idx="1018">
                        <c:v>1668</c:v>
                      </c:pt>
                      <c:pt idx="1019">
                        <c:v>1669</c:v>
                      </c:pt>
                      <c:pt idx="1020">
                        <c:v>1672</c:v>
                      </c:pt>
                      <c:pt idx="1021">
                        <c:v>1673</c:v>
                      </c:pt>
                      <c:pt idx="1022">
                        <c:v>1674</c:v>
                      </c:pt>
                      <c:pt idx="1023">
                        <c:v>1675</c:v>
                      </c:pt>
                      <c:pt idx="1024">
                        <c:v>1676</c:v>
                      </c:pt>
                      <c:pt idx="1025">
                        <c:v>1677</c:v>
                      </c:pt>
                      <c:pt idx="1026">
                        <c:v>1678</c:v>
                      </c:pt>
                      <c:pt idx="1027">
                        <c:v>1679</c:v>
                      </c:pt>
                      <c:pt idx="1028">
                        <c:v>1680</c:v>
                      </c:pt>
                      <c:pt idx="1029">
                        <c:v>1681</c:v>
                      </c:pt>
                      <c:pt idx="1030">
                        <c:v>1682</c:v>
                      </c:pt>
                      <c:pt idx="1031">
                        <c:v>1683</c:v>
                      </c:pt>
                      <c:pt idx="1032">
                        <c:v>1684</c:v>
                      </c:pt>
                      <c:pt idx="1033">
                        <c:v>1685</c:v>
                      </c:pt>
                      <c:pt idx="1034">
                        <c:v>1686</c:v>
                      </c:pt>
                      <c:pt idx="1035">
                        <c:v>1687</c:v>
                      </c:pt>
                      <c:pt idx="1036">
                        <c:v>1688</c:v>
                      </c:pt>
                      <c:pt idx="1037">
                        <c:v>1689</c:v>
                      </c:pt>
                      <c:pt idx="1038">
                        <c:v>1690</c:v>
                      </c:pt>
                      <c:pt idx="1039">
                        <c:v>1701</c:v>
                      </c:pt>
                      <c:pt idx="1040">
                        <c:v>1704</c:v>
                      </c:pt>
                      <c:pt idx="1041">
                        <c:v>1708</c:v>
                      </c:pt>
                      <c:pt idx="1042">
                        <c:v>1709</c:v>
                      </c:pt>
                      <c:pt idx="1043">
                        <c:v>1710</c:v>
                      </c:pt>
                      <c:pt idx="1044">
                        <c:v>1712</c:v>
                      </c:pt>
                      <c:pt idx="1045">
                        <c:v>1713</c:v>
                      </c:pt>
                      <c:pt idx="1046">
                        <c:v>1714</c:v>
                      </c:pt>
                      <c:pt idx="1047">
                        <c:v>1715</c:v>
                      </c:pt>
                      <c:pt idx="1048">
                        <c:v>1716</c:v>
                      </c:pt>
                      <c:pt idx="1049">
                        <c:v>1717</c:v>
                      </c:pt>
                      <c:pt idx="1050">
                        <c:v>1718</c:v>
                      </c:pt>
                      <c:pt idx="1051">
                        <c:v>1721</c:v>
                      </c:pt>
                      <c:pt idx="1052">
                        <c:v>1722</c:v>
                      </c:pt>
                      <c:pt idx="1053">
                        <c:v>1725</c:v>
                      </c:pt>
                      <c:pt idx="1054">
                        <c:v>1726</c:v>
                      </c:pt>
                      <c:pt idx="1055">
                        <c:v>1732</c:v>
                      </c:pt>
                      <c:pt idx="1056">
                        <c:v>1746</c:v>
                      </c:pt>
                      <c:pt idx="1057">
                        <c:v>1951</c:v>
                      </c:pt>
                    </c:numCache>
                  </c:numRef>
                </c:xVal>
                <c:yVal>
                  <c:numRef>
                    <c:extLst>
                      <c:ext uri="{02D57815-91ED-43cb-92C2-25804820EDAC}">
                        <c15:formulaRef>
                          <c15:sqref>'Brachy NFY'!$D$3:$D$1060</c15:sqref>
                        </c15:formulaRef>
                      </c:ext>
                    </c:extLst>
                    <c:numCache>
                      <c:formatCode>General</c:formatCode>
                      <c:ptCount val="1058"/>
                      <c:pt idx="13">
                        <c:v>1</c:v>
                      </c:pt>
                      <c:pt idx="14">
                        <c:v>1</c:v>
                      </c:pt>
                      <c:pt idx="19">
                        <c:v>1</c:v>
                      </c:pt>
                      <c:pt idx="25">
                        <c:v>1</c:v>
                      </c:pt>
                      <c:pt idx="40">
                        <c:v>1</c:v>
                      </c:pt>
                      <c:pt idx="55">
                        <c:v>1</c:v>
                      </c:pt>
                      <c:pt idx="59">
                        <c:v>1</c:v>
                      </c:pt>
                      <c:pt idx="65">
                        <c:v>1</c:v>
                      </c:pt>
                      <c:pt idx="74">
                        <c:v>1</c:v>
                      </c:pt>
                      <c:pt idx="81">
                        <c:v>1</c:v>
                      </c:pt>
                      <c:pt idx="94">
                        <c:v>1</c:v>
                      </c:pt>
                      <c:pt idx="99">
                        <c:v>1</c:v>
                      </c:pt>
                      <c:pt idx="104">
                        <c:v>1</c:v>
                      </c:pt>
                      <c:pt idx="107">
                        <c:v>1</c:v>
                      </c:pt>
                      <c:pt idx="108">
                        <c:v>1</c:v>
                      </c:pt>
                      <c:pt idx="110">
                        <c:v>1</c:v>
                      </c:pt>
                      <c:pt idx="112">
                        <c:v>1</c:v>
                      </c:pt>
                      <c:pt idx="113">
                        <c:v>1</c:v>
                      </c:pt>
                      <c:pt idx="115">
                        <c:v>1</c:v>
                      </c:pt>
                      <c:pt idx="117">
                        <c:v>1</c:v>
                      </c:pt>
                      <c:pt idx="119">
                        <c:v>1</c:v>
                      </c:pt>
                      <c:pt idx="130">
                        <c:v>1</c:v>
                      </c:pt>
                      <c:pt idx="136">
                        <c:v>1</c:v>
                      </c:pt>
                      <c:pt idx="137">
                        <c:v>1</c:v>
                      </c:pt>
                      <c:pt idx="138">
                        <c:v>1</c:v>
                      </c:pt>
                      <c:pt idx="140">
                        <c:v>1</c:v>
                      </c:pt>
                      <c:pt idx="144">
                        <c:v>1</c:v>
                      </c:pt>
                      <c:pt idx="148">
                        <c:v>1</c:v>
                      </c:pt>
                      <c:pt idx="159">
                        <c:v>1</c:v>
                      </c:pt>
                      <c:pt idx="161">
                        <c:v>1</c:v>
                      </c:pt>
                      <c:pt idx="163">
                        <c:v>1</c:v>
                      </c:pt>
                      <c:pt idx="170">
                        <c:v>1</c:v>
                      </c:pt>
                      <c:pt idx="171">
                        <c:v>1</c:v>
                      </c:pt>
                      <c:pt idx="176">
                        <c:v>1</c:v>
                      </c:pt>
                      <c:pt idx="185">
                        <c:v>1</c:v>
                      </c:pt>
                      <c:pt idx="187">
                        <c:v>1</c:v>
                      </c:pt>
                      <c:pt idx="192">
                        <c:v>1</c:v>
                      </c:pt>
                      <c:pt idx="197">
                        <c:v>1</c:v>
                      </c:pt>
                      <c:pt idx="198">
                        <c:v>1</c:v>
                      </c:pt>
                      <c:pt idx="200">
                        <c:v>1</c:v>
                      </c:pt>
                      <c:pt idx="204">
                        <c:v>1</c:v>
                      </c:pt>
                      <c:pt idx="205">
                        <c:v>1</c:v>
                      </c:pt>
                      <c:pt idx="211">
                        <c:v>1</c:v>
                      </c:pt>
                      <c:pt idx="217">
                        <c:v>1</c:v>
                      </c:pt>
                      <c:pt idx="221">
                        <c:v>1</c:v>
                      </c:pt>
                      <c:pt idx="227">
                        <c:v>1</c:v>
                      </c:pt>
                      <c:pt idx="233">
                        <c:v>1</c:v>
                      </c:pt>
                      <c:pt idx="237">
                        <c:v>1</c:v>
                      </c:pt>
                      <c:pt idx="245">
                        <c:v>1</c:v>
                      </c:pt>
                      <c:pt idx="247">
                        <c:v>1</c:v>
                      </c:pt>
                      <c:pt idx="248">
                        <c:v>1</c:v>
                      </c:pt>
                      <c:pt idx="250">
                        <c:v>1</c:v>
                      </c:pt>
                      <c:pt idx="251">
                        <c:v>1</c:v>
                      </c:pt>
                      <c:pt idx="252">
                        <c:v>1</c:v>
                      </c:pt>
                      <c:pt idx="253">
                        <c:v>1</c:v>
                      </c:pt>
                      <c:pt idx="254">
                        <c:v>1</c:v>
                      </c:pt>
                      <c:pt idx="259">
                        <c:v>1</c:v>
                      </c:pt>
                      <c:pt idx="260">
                        <c:v>1</c:v>
                      </c:pt>
                      <c:pt idx="263">
                        <c:v>1</c:v>
                      </c:pt>
                      <c:pt idx="264">
                        <c:v>1</c:v>
                      </c:pt>
                      <c:pt idx="265">
                        <c:v>1</c:v>
                      </c:pt>
                      <c:pt idx="267">
                        <c:v>1</c:v>
                      </c:pt>
                      <c:pt idx="269">
                        <c:v>1</c:v>
                      </c:pt>
                      <c:pt idx="270">
                        <c:v>1</c:v>
                      </c:pt>
                      <c:pt idx="273">
                        <c:v>1</c:v>
                      </c:pt>
                      <c:pt idx="274">
                        <c:v>1</c:v>
                      </c:pt>
                      <c:pt idx="275">
                        <c:v>1</c:v>
                      </c:pt>
                      <c:pt idx="280">
                        <c:v>1</c:v>
                      </c:pt>
                      <c:pt idx="281">
                        <c:v>1</c:v>
                      </c:pt>
                      <c:pt idx="286">
                        <c:v>1</c:v>
                      </c:pt>
                      <c:pt idx="287">
                        <c:v>1</c:v>
                      </c:pt>
                      <c:pt idx="288">
                        <c:v>1</c:v>
                      </c:pt>
                      <c:pt idx="297">
                        <c:v>1</c:v>
                      </c:pt>
                      <c:pt idx="300">
                        <c:v>1</c:v>
                      </c:pt>
                      <c:pt idx="302">
                        <c:v>1</c:v>
                      </c:pt>
                      <c:pt idx="303">
                        <c:v>1</c:v>
                      </c:pt>
                      <c:pt idx="304">
                        <c:v>1</c:v>
                      </c:pt>
                      <c:pt idx="309">
                        <c:v>1</c:v>
                      </c:pt>
                      <c:pt idx="311">
                        <c:v>1</c:v>
                      </c:pt>
                      <c:pt idx="312">
                        <c:v>1</c:v>
                      </c:pt>
                      <c:pt idx="317">
                        <c:v>1</c:v>
                      </c:pt>
                      <c:pt idx="318">
                        <c:v>1</c:v>
                      </c:pt>
                      <c:pt idx="323">
                        <c:v>1</c:v>
                      </c:pt>
                      <c:pt idx="330">
                        <c:v>1</c:v>
                      </c:pt>
                      <c:pt idx="334">
                        <c:v>1</c:v>
                      </c:pt>
                      <c:pt idx="335">
                        <c:v>1</c:v>
                      </c:pt>
                      <c:pt idx="336">
                        <c:v>2</c:v>
                      </c:pt>
                      <c:pt idx="337">
                        <c:v>7</c:v>
                      </c:pt>
                      <c:pt idx="338">
                        <c:v>1</c:v>
                      </c:pt>
                      <c:pt idx="339">
                        <c:v>1</c:v>
                      </c:pt>
                      <c:pt idx="346">
                        <c:v>1</c:v>
                      </c:pt>
                      <c:pt idx="349">
                        <c:v>1</c:v>
                      </c:pt>
                      <c:pt idx="353">
                        <c:v>1</c:v>
                      </c:pt>
                      <c:pt idx="358">
                        <c:v>1</c:v>
                      </c:pt>
                      <c:pt idx="361">
                        <c:v>1</c:v>
                      </c:pt>
                      <c:pt idx="365">
                        <c:v>1</c:v>
                      </c:pt>
                      <c:pt idx="366">
                        <c:v>1</c:v>
                      </c:pt>
                      <c:pt idx="367">
                        <c:v>1</c:v>
                      </c:pt>
                      <c:pt idx="371">
                        <c:v>1</c:v>
                      </c:pt>
                      <c:pt idx="372">
                        <c:v>1</c:v>
                      </c:pt>
                      <c:pt idx="373">
                        <c:v>1</c:v>
                      </c:pt>
                      <c:pt idx="374">
                        <c:v>1</c:v>
                      </c:pt>
                      <c:pt idx="376">
                        <c:v>1</c:v>
                      </c:pt>
                      <c:pt idx="377">
                        <c:v>1</c:v>
                      </c:pt>
                      <c:pt idx="378">
                        <c:v>1</c:v>
                      </c:pt>
                      <c:pt idx="379">
                        <c:v>1</c:v>
                      </c:pt>
                      <c:pt idx="380">
                        <c:v>1</c:v>
                      </c:pt>
                      <c:pt idx="381">
                        <c:v>1</c:v>
                      </c:pt>
                      <c:pt idx="383">
                        <c:v>1</c:v>
                      </c:pt>
                      <c:pt idx="385">
                        <c:v>1</c:v>
                      </c:pt>
                      <c:pt idx="391">
                        <c:v>1</c:v>
                      </c:pt>
                      <c:pt idx="392">
                        <c:v>1</c:v>
                      </c:pt>
                      <c:pt idx="393">
                        <c:v>1</c:v>
                      </c:pt>
                      <c:pt idx="394">
                        <c:v>1</c:v>
                      </c:pt>
                      <c:pt idx="395">
                        <c:v>1</c:v>
                      </c:pt>
                      <c:pt idx="396">
                        <c:v>1</c:v>
                      </c:pt>
                      <c:pt idx="397">
                        <c:v>1</c:v>
                      </c:pt>
                      <c:pt idx="398">
                        <c:v>1</c:v>
                      </c:pt>
                      <c:pt idx="401">
                        <c:v>1</c:v>
                      </c:pt>
                      <c:pt idx="405">
                        <c:v>1</c:v>
                      </c:pt>
                      <c:pt idx="406">
                        <c:v>1</c:v>
                      </c:pt>
                      <c:pt idx="407">
                        <c:v>1</c:v>
                      </c:pt>
                      <c:pt idx="408">
                        <c:v>1</c:v>
                      </c:pt>
                      <c:pt idx="409">
                        <c:v>1</c:v>
                      </c:pt>
                      <c:pt idx="410">
                        <c:v>1</c:v>
                      </c:pt>
                      <c:pt idx="415">
                        <c:v>1</c:v>
                      </c:pt>
                      <c:pt idx="418">
                        <c:v>1</c:v>
                      </c:pt>
                      <c:pt idx="419">
                        <c:v>1</c:v>
                      </c:pt>
                      <c:pt idx="420">
                        <c:v>1</c:v>
                      </c:pt>
                      <c:pt idx="423">
                        <c:v>1</c:v>
                      </c:pt>
                      <c:pt idx="429">
                        <c:v>1</c:v>
                      </c:pt>
                      <c:pt idx="431">
                        <c:v>1</c:v>
                      </c:pt>
                      <c:pt idx="432">
                        <c:v>1</c:v>
                      </c:pt>
                      <c:pt idx="433">
                        <c:v>1</c:v>
                      </c:pt>
                      <c:pt idx="439">
                        <c:v>1</c:v>
                      </c:pt>
                      <c:pt idx="440">
                        <c:v>1</c:v>
                      </c:pt>
                      <c:pt idx="448">
                        <c:v>1</c:v>
                      </c:pt>
                      <c:pt idx="452">
                        <c:v>1</c:v>
                      </c:pt>
                      <c:pt idx="455">
                        <c:v>1</c:v>
                      </c:pt>
                      <c:pt idx="456">
                        <c:v>1</c:v>
                      </c:pt>
                      <c:pt idx="457">
                        <c:v>1</c:v>
                      </c:pt>
                      <c:pt idx="460">
                        <c:v>1</c:v>
                      </c:pt>
                      <c:pt idx="462">
                        <c:v>1</c:v>
                      </c:pt>
                      <c:pt idx="466">
                        <c:v>1</c:v>
                      </c:pt>
                      <c:pt idx="471">
                        <c:v>1</c:v>
                      </c:pt>
                      <c:pt idx="474">
                        <c:v>1</c:v>
                      </c:pt>
                      <c:pt idx="479">
                        <c:v>1</c:v>
                      </c:pt>
                      <c:pt idx="485">
                        <c:v>1</c:v>
                      </c:pt>
                      <c:pt idx="486">
                        <c:v>1</c:v>
                      </c:pt>
                      <c:pt idx="487">
                        <c:v>1</c:v>
                      </c:pt>
                      <c:pt idx="488">
                        <c:v>1</c:v>
                      </c:pt>
                      <c:pt idx="489">
                        <c:v>1</c:v>
                      </c:pt>
                      <c:pt idx="490">
                        <c:v>1</c:v>
                      </c:pt>
                      <c:pt idx="493">
                        <c:v>1</c:v>
                      </c:pt>
                      <c:pt idx="501">
                        <c:v>1</c:v>
                      </c:pt>
                      <c:pt idx="503">
                        <c:v>1</c:v>
                      </c:pt>
                      <c:pt idx="505">
                        <c:v>1</c:v>
                      </c:pt>
                      <c:pt idx="508">
                        <c:v>1</c:v>
                      </c:pt>
                      <c:pt idx="509">
                        <c:v>1</c:v>
                      </c:pt>
                      <c:pt idx="511">
                        <c:v>1</c:v>
                      </c:pt>
                      <c:pt idx="514">
                        <c:v>1</c:v>
                      </c:pt>
                      <c:pt idx="515">
                        <c:v>1</c:v>
                      </c:pt>
                      <c:pt idx="519">
                        <c:v>1</c:v>
                      </c:pt>
                      <c:pt idx="521">
                        <c:v>1</c:v>
                      </c:pt>
                      <c:pt idx="524">
                        <c:v>1</c:v>
                      </c:pt>
                      <c:pt idx="530">
                        <c:v>1</c:v>
                      </c:pt>
                      <c:pt idx="537">
                        <c:v>1</c:v>
                      </c:pt>
                      <c:pt idx="538">
                        <c:v>1</c:v>
                      </c:pt>
                      <c:pt idx="539">
                        <c:v>1</c:v>
                      </c:pt>
                      <c:pt idx="547">
                        <c:v>1</c:v>
                      </c:pt>
                      <c:pt idx="549">
                        <c:v>1</c:v>
                      </c:pt>
                      <c:pt idx="550">
                        <c:v>1</c:v>
                      </c:pt>
                      <c:pt idx="551">
                        <c:v>1</c:v>
                      </c:pt>
                      <c:pt idx="553">
                        <c:v>1</c:v>
                      </c:pt>
                      <c:pt idx="555">
                        <c:v>1</c:v>
                      </c:pt>
                      <c:pt idx="556">
                        <c:v>1</c:v>
                      </c:pt>
                      <c:pt idx="560">
                        <c:v>1</c:v>
                      </c:pt>
                      <c:pt idx="562">
                        <c:v>1</c:v>
                      </c:pt>
                      <c:pt idx="563">
                        <c:v>1</c:v>
                      </c:pt>
                      <c:pt idx="565">
                        <c:v>1</c:v>
                      </c:pt>
                      <c:pt idx="569">
                        <c:v>1</c:v>
                      </c:pt>
                      <c:pt idx="571">
                        <c:v>1</c:v>
                      </c:pt>
                      <c:pt idx="572">
                        <c:v>1</c:v>
                      </c:pt>
                      <c:pt idx="575">
                        <c:v>1</c:v>
                      </c:pt>
                      <c:pt idx="577">
                        <c:v>1</c:v>
                      </c:pt>
                      <c:pt idx="581">
                        <c:v>1</c:v>
                      </c:pt>
                      <c:pt idx="582">
                        <c:v>1</c:v>
                      </c:pt>
                      <c:pt idx="583">
                        <c:v>1</c:v>
                      </c:pt>
                      <c:pt idx="585">
                        <c:v>1</c:v>
                      </c:pt>
                      <c:pt idx="588">
                        <c:v>1</c:v>
                      </c:pt>
                      <c:pt idx="591">
                        <c:v>1</c:v>
                      </c:pt>
                      <c:pt idx="592">
                        <c:v>1</c:v>
                      </c:pt>
                      <c:pt idx="595">
                        <c:v>1</c:v>
                      </c:pt>
                      <c:pt idx="596">
                        <c:v>1</c:v>
                      </c:pt>
                      <c:pt idx="598">
                        <c:v>1</c:v>
                      </c:pt>
                      <c:pt idx="600">
                        <c:v>1</c:v>
                      </c:pt>
                      <c:pt idx="601">
                        <c:v>1</c:v>
                      </c:pt>
                      <c:pt idx="602">
                        <c:v>1</c:v>
                      </c:pt>
                      <c:pt idx="603">
                        <c:v>1</c:v>
                      </c:pt>
                      <c:pt idx="604">
                        <c:v>1</c:v>
                      </c:pt>
                      <c:pt idx="605">
                        <c:v>3</c:v>
                      </c:pt>
                      <c:pt idx="606">
                        <c:v>5</c:v>
                      </c:pt>
                      <c:pt idx="607">
                        <c:v>1</c:v>
                      </c:pt>
                      <c:pt idx="611">
                        <c:v>1</c:v>
                      </c:pt>
                      <c:pt idx="615">
                        <c:v>1</c:v>
                      </c:pt>
                      <c:pt idx="617">
                        <c:v>1</c:v>
                      </c:pt>
                      <c:pt idx="618">
                        <c:v>1</c:v>
                      </c:pt>
                      <c:pt idx="619">
                        <c:v>1</c:v>
                      </c:pt>
                      <c:pt idx="620">
                        <c:v>1</c:v>
                      </c:pt>
                      <c:pt idx="621">
                        <c:v>1</c:v>
                      </c:pt>
                      <c:pt idx="622">
                        <c:v>1</c:v>
                      </c:pt>
                      <c:pt idx="623">
                        <c:v>1</c:v>
                      </c:pt>
                      <c:pt idx="624">
                        <c:v>1</c:v>
                      </c:pt>
                      <c:pt idx="625">
                        <c:v>1</c:v>
                      </c:pt>
                      <c:pt idx="626">
                        <c:v>1</c:v>
                      </c:pt>
                      <c:pt idx="627">
                        <c:v>1</c:v>
                      </c:pt>
                      <c:pt idx="629">
                        <c:v>1</c:v>
                      </c:pt>
                      <c:pt idx="630">
                        <c:v>1</c:v>
                      </c:pt>
                      <c:pt idx="631">
                        <c:v>1</c:v>
                      </c:pt>
                      <c:pt idx="632">
                        <c:v>1</c:v>
                      </c:pt>
                      <c:pt idx="633">
                        <c:v>1</c:v>
                      </c:pt>
                      <c:pt idx="637">
                        <c:v>1</c:v>
                      </c:pt>
                      <c:pt idx="639">
                        <c:v>1</c:v>
                      </c:pt>
                      <c:pt idx="640">
                        <c:v>1</c:v>
                      </c:pt>
                      <c:pt idx="641">
                        <c:v>1</c:v>
                      </c:pt>
                      <c:pt idx="642">
                        <c:v>1</c:v>
                      </c:pt>
                      <c:pt idx="643">
                        <c:v>1</c:v>
                      </c:pt>
                      <c:pt idx="644">
                        <c:v>1</c:v>
                      </c:pt>
                      <c:pt idx="645">
                        <c:v>1</c:v>
                      </c:pt>
                      <c:pt idx="646">
                        <c:v>1</c:v>
                      </c:pt>
                      <c:pt idx="647">
                        <c:v>1</c:v>
                      </c:pt>
                      <c:pt idx="649">
                        <c:v>1</c:v>
                      </c:pt>
                      <c:pt idx="653">
                        <c:v>1</c:v>
                      </c:pt>
                      <c:pt idx="654">
                        <c:v>1</c:v>
                      </c:pt>
                      <c:pt idx="655">
                        <c:v>1</c:v>
                      </c:pt>
                      <c:pt idx="656">
                        <c:v>1</c:v>
                      </c:pt>
                      <c:pt idx="659">
                        <c:v>1</c:v>
                      </c:pt>
                      <c:pt idx="663">
                        <c:v>1</c:v>
                      </c:pt>
                      <c:pt idx="667">
                        <c:v>1</c:v>
                      </c:pt>
                      <c:pt idx="675">
                        <c:v>1</c:v>
                      </c:pt>
                      <c:pt idx="682">
                        <c:v>1</c:v>
                      </c:pt>
                      <c:pt idx="683">
                        <c:v>1</c:v>
                      </c:pt>
                      <c:pt idx="685">
                        <c:v>1</c:v>
                      </c:pt>
                      <c:pt idx="692">
                        <c:v>1</c:v>
                      </c:pt>
                      <c:pt idx="698">
                        <c:v>1</c:v>
                      </c:pt>
                      <c:pt idx="699">
                        <c:v>1</c:v>
                      </c:pt>
                      <c:pt idx="701">
                        <c:v>1</c:v>
                      </c:pt>
                      <c:pt idx="704">
                        <c:v>1</c:v>
                      </c:pt>
                      <c:pt idx="710">
                        <c:v>1</c:v>
                      </c:pt>
                      <c:pt idx="713">
                        <c:v>1</c:v>
                      </c:pt>
                      <c:pt idx="720">
                        <c:v>1</c:v>
                      </c:pt>
                      <c:pt idx="722">
                        <c:v>1</c:v>
                      </c:pt>
                      <c:pt idx="729">
                        <c:v>1</c:v>
                      </c:pt>
                      <c:pt idx="731">
                        <c:v>1</c:v>
                      </c:pt>
                      <c:pt idx="739">
                        <c:v>1</c:v>
                      </c:pt>
                      <c:pt idx="746">
                        <c:v>1</c:v>
                      </c:pt>
                      <c:pt idx="747">
                        <c:v>1</c:v>
                      </c:pt>
                      <c:pt idx="748">
                        <c:v>1</c:v>
                      </c:pt>
                      <c:pt idx="750">
                        <c:v>1</c:v>
                      </c:pt>
                      <c:pt idx="751">
                        <c:v>1</c:v>
                      </c:pt>
                      <c:pt idx="752">
                        <c:v>1</c:v>
                      </c:pt>
                      <c:pt idx="757">
                        <c:v>1</c:v>
                      </c:pt>
                      <c:pt idx="760">
                        <c:v>1</c:v>
                      </c:pt>
                      <c:pt idx="761">
                        <c:v>1</c:v>
                      </c:pt>
                      <c:pt idx="764">
                        <c:v>1</c:v>
                      </c:pt>
                      <c:pt idx="765">
                        <c:v>1</c:v>
                      </c:pt>
                      <c:pt idx="766">
                        <c:v>1</c:v>
                      </c:pt>
                      <c:pt idx="767">
                        <c:v>1</c:v>
                      </c:pt>
                      <c:pt idx="768">
                        <c:v>1</c:v>
                      </c:pt>
                      <c:pt idx="769">
                        <c:v>1</c:v>
                      </c:pt>
                      <c:pt idx="770">
                        <c:v>1</c:v>
                      </c:pt>
                      <c:pt idx="778">
                        <c:v>1</c:v>
                      </c:pt>
                      <c:pt idx="785">
                        <c:v>1</c:v>
                      </c:pt>
                      <c:pt idx="786">
                        <c:v>1</c:v>
                      </c:pt>
                      <c:pt idx="795">
                        <c:v>1</c:v>
                      </c:pt>
                      <c:pt idx="796">
                        <c:v>1</c:v>
                      </c:pt>
                      <c:pt idx="797">
                        <c:v>1</c:v>
                      </c:pt>
                      <c:pt idx="802">
                        <c:v>1</c:v>
                      </c:pt>
                      <c:pt idx="805">
                        <c:v>1</c:v>
                      </c:pt>
                      <c:pt idx="806">
                        <c:v>82</c:v>
                      </c:pt>
                      <c:pt idx="807">
                        <c:v>1</c:v>
                      </c:pt>
                      <c:pt idx="810">
                        <c:v>1</c:v>
                      </c:pt>
                      <c:pt idx="811">
                        <c:v>1</c:v>
                      </c:pt>
                      <c:pt idx="815">
                        <c:v>1</c:v>
                      </c:pt>
                      <c:pt idx="820">
                        <c:v>1</c:v>
                      </c:pt>
                      <c:pt idx="821">
                        <c:v>1</c:v>
                      </c:pt>
                      <c:pt idx="822">
                        <c:v>1</c:v>
                      </c:pt>
                      <c:pt idx="824">
                        <c:v>1</c:v>
                      </c:pt>
                      <c:pt idx="825">
                        <c:v>1</c:v>
                      </c:pt>
                      <c:pt idx="826">
                        <c:v>1</c:v>
                      </c:pt>
                      <c:pt idx="828">
                        <c:v>1</c:v>
                      </c:pt>
                      <c:pt idx="830">
                        <c:v>1</c:v>
                      </c:pt>
                      <c:pt idx="832">
                        <c:v>1</c:v>
                      </c:pt>
                      <c:pt idx="833">
                        <c:v>1</c:v>
                      </c:pt>
                      <c:pt idx="837">
                        <c:v>1</c:v>
                      </c:pt>
                      <c:pt idx="839">
                        <c:v>1</c:v>
                      </c:pt>
                      <c:pt idx="841">
                        <c:v>1</c:v>
                      </c:pt>
                      <c:pt idx="842">
                        <c:v>1</c:v>
                      </c:pt>
                      <c:pt idx="843">
                        <c:v>1</c:v>
                      </c:pt>
                      <c:pt idx="844">
                        <c:v>1</c:v>
                      </c:pt>
                      <c:pt idx="845">
                        <c:v>1</c:v>
                      </c:pt>
                      <c:pt idx="846">
                        <c:v>2</c:v>
                      </c:pt>
                      <c:pt idx="848">
                        <c:v>1</c:v>
                      </c:pt>
                      <c:pt idx="849">
                        <c:v>13</c:v>
                      </c:pt>
                      <c:pt idx="850">
                        <c:v>1</c:v>
                      </c:pt>
                      <c:pt idx="851">
                        <c:v>1</c:v>
                      </c:pt>
                      <c:pt idx="853">
                        <c:v>1</c:v>
                      </c:pt>
                      <c:pt idx="855">
                        <c:v>1</c:v>
                      </c:pt>
                      <c:pt idx="860">
                        <c:v>1</c:v>
                      </c:pt>
                      <c:pt idx="863">
                        <c:v>1</c:v>
                      </c:pt>
                      <c:pt idx="865">
                        <c:v>1</c:v>
                      </c:pt>
                      <c:pt idx="867">
                        <c:v>1</c:v>
                      </c:pt>
                      <c:pt idx="868">
                        <c:v>1</c:v>
                      </c:pt>
                      <c:pt idx="869">
                        <c:v>1</c:v>
                      </c:pt>
                      <c:pt idx="873">
                        <c:v>1</c:v>
                      </c:pt>
                      <c:pt idx="874">
                        <c:v>1</c:v>
                      </c:pt>
                      <c:pt idx="875">
                        <c:v>1</c:v>
                      </c:pt>
                      <c:pt idx="876">
                        <c:v>2</c:v>
                      </c:pt>
                      <c:pt idx="877">
                        <c:v>1</c:v>
                      </c:pt>
                      <c:pt idx="878">
                        <c:v>1</c:v>
                      </c:pt>
                      <c:pt idx="884">
                        <c:v>1</c:v>
                      </c:pt>
                      <c:pt idx="885">
                        <c:v>1</c:v>
                      </c:pt>
                      <c:pt idx="886">
                        <c:v>1</c:v>
                      </c:pt>
                      <c:pt idx="887">
                        <c:v>1</c:v>
                      </c:pt>
                      <c:pt idx="888">
                        <c:v>1</c:v>
                      </c:pt>
                      <c:pt idx="890">
                        <c:v>1</c:v>
                      </c:pt>
                      <c:pt idx="891">
                        <c:v>1</c:v>
                      </c:pt>
                      <c:pt idx="892">
                        <c:v>1</c:v>
                      </c:pt>
                      <c:pt idx="893">
                        <c:v>1</c:v>
                      </c:pt>
                      <c:pt idx="895">
                        <c:v>1</c:v>
                      </c:pt>
                      <c:pt idx="897">
                        <c:v>1</c:v>
                      </c:pt>
                      <c:pt idx="898">
                        <c:v>1</c:v>
                      </c:pt>
                      <c:pt idx="899">
                        <c:v>1</c:v>
                      </c:pt>
                      <c:pt idx="900">
                        <c:v>1</c:v>
                      </c:pt>
                      <c:pt idx="901">
                        <c:v>1</c:v>
                      </c:pt>
                      <c:pt idx="903">
                        <c:v>1</c:v>
                      </c:pt>
                      <c:pt idx="904">
                        <c:v>1</c:v>
                      </c:pt>
                      <c:pt idx="905">
                        <c:v>1</c:v>
                      </c:pt>
                      <c:pt idx="906">
                        <c:v>14</c:v>
                      </c:pt>
                      <c:pt idx="907">
                        <c:v>2</c:v>
                      </c:pt>
                      <c:pt idx="910">
                        <c:v>1</c:v>
                      </c:pt>
                      <c:pt idx="911">
                        <c:v>1</c:v>
                      </c:pt>
                      <c:pt idx="912">
                        <c:v>1</c:v>
                      </c:pt>
                      <c:pt idx="913">
                        <c:v>1</c:v>
                      </c:pt>
                      <c:pt idx="914">
                        <c:v>1</c:v>
                      </c:pt>
                      <c:pt idx="916">
                        <c:v>1</c:v>
                      </c:pt>
                      <c:pt idx="917">
                        <c:v>1</c:v>
                      </c:pt>
                      <c:pt idx="918">
                        <c:v>2</c:v>
                      </c:pt>
                      <c:pt idx="919">
                        <c:v>1</c:v>
                      </c:pt>
                      <c:pt idx="920">
                        <c:v>1</c:v>
                      </c:pt>
                      <c:pt idx="921">
                        <c:v>44</c:v>
                      </c:pt>
                      <c:pt idx="922">
                        <c:v>49</c:v>
                      </c:pt>
                      <c:pt idx="923">
                        <c:v>2</c:v>
                      </c:pt>
                      <c:pt idx="924">
                        <c:v>10</c:v>
                      </c:pt>
                      <c:pt idx="925">
                        <c:v>2</c:v>
                      </c:pt>
                      <c:pt idx="926">
                        <c:v>1</c:v>
                      </c:pt>
                      <c:pt idx="927">
                        <c:v>1</c:v>
                      </c:pt>
                      <c:pt idx="928">
                        <c:v>1</c:v>
                      </c:pt>
                      <c:pt idx="929">
                        <c:v>1</c:v>
                      </c:pt>
                      <c:pt idx="930">
                        <c:v>1</c:v>
                      </c:pt>
                      <c:pt idx="931">
                        <c:v>3</c:v>
                      </c:pt>
                      <c:pt idx="932">
                        <c:v>1</c:v>
                      </c:pt>
                      <c:pt idx="934">
                        <c:v>1</c:v>
                      </c:pt>
                      <c:pt idx="935">
                        <c:v>1</c:v>
                      </c:pt>
                      <c:pt idx="938">
                        <c:v>1</c:v>
                      </c:pt>
                      <c:pt idx="939">
                        <c:v>1</c:v>
                      </c:pt>
                      <c:pt idx="940">
                        <c:v>1</c:v>
                      </c:pt>
                      <c:pt idx="945">
                        <c:v>1</c:v>
                      </c:pt>
                      <c:pt idx="946">
                        <c:v>1</c:v>
                      </c:pt>
                      <c:pt idx="947">
                        <c:v>1</c:v>
                      </c:pt>
                      <c:pt idx="948">
                        <c:v>1</c:v>
                      </c:pt>
                      <c:pt idx="950">
                        <c:v>1</c:v>
                      </c:pt>
                      <c:pt idx="951">
                        <c:v>2</c:v>
                      </c:pt>
                      <c:pt idx="952">
                        <c:v>1</c:v>
                      </c:pt>
                      <c:pt idx="954">
                        <c:v>1</c:v>
                      </c:pt>
                      <c:pt idx="955">
                        <c:v>2</c:v>
                      </c:pt>
                      <c:pt idx="956">
                        <c:v>3</c:v>
                      </c:pt>
                      <c:pt idx="957">
                        <c:v>3</c:v>
                      </c:pt>
                      <c:pt idx="958">
                        <c:v>1</c:v>
                      </c:pt>
                      <c:pt idx="959">
                        <c:v>1</c:v>
                      </c:pt>
                      <c:pt idx="960">
                        <c:v>1</c:v>
                      </c:pt>
                      <c:pt idx="961">
                        <c:v>1</c:v>
                      </c:pt>
                      <c:pt idx="962">
                        <c:v>10</c:v>
                      </c:pt>
                      <c:pt idx="963">
                        <c:v>18</c:v>
                      </c:pt>
                      <c:pt idx="964">
                        <c:v>1</c:v>
                      </c:pt>
                      <c:pt idx="965">
                        <c:v>1</c:v>
                      </c:pt>
                      <c:pt idx="966">
                        <c:v>3</c:v>
                      </c:pt>
                      <c:pt idx="967">
                        <c:v>1</c:v>
                      </c:pt>
                      <c:pt idx="968">
                        <c:v>1</c:v>
                      </c:pt>
                      <c:pt idx="969">
                        <c:v>5</c:v>
                      </c:pt>
                      <c:pt idx="970">
                        <c:v>2</c:v>
                      </c:pt>
                      <c:pt idx="971">
                        <c:v>1</c:v>
                      </c:pt>
                      <c:pt idx="972">
                        <c:v>1</c:v>
                      </c:pt>
                      <c:pt idx="973">
                        <c:v>3</c:v>
                      </c:pt>
                      <c:pt idx="974">
                        <c:v>2</c:v>
                      </c:pt>
                      <c:pt idx="976">
                        <c:v>1</c:v>
                      </c:pt>
                      <c:pt idx="977">
                        <c:v>1</c:v>
                      </c:pt>
                      <c:pt idx="978">
                        <c:v>2</c:v>
                      </c:pt>
                      <c:pt idx="979">
                        <c:v>2</c:v>
                      </c:pt>
                      <c:pt idx="980">
                        <c:v>1</c:v>
                      </c:pt>
                      <c:pt idx="981">
                        <c:v>1</c:v>
                      </c:pt>
                      <c:pt idx="983">
                        <c:v>1</c:v>
                      </c:pt>
                      <c:pt idx="984">
                        <c:v>1</c:v>
                      </c:pt>
                      <c:pt idx="985">
                        <c:v>1</c:v>
                      </c:pt>
                      <c:pt idx="986">
                        <c:v>1</c:v>
                      </c:pt>
                      <c:pt idx="987">
                        <c:v>7</c:v>
                      </c:pt>
                      <c:pt idx="988">
                        <c:v>1</c:v>
                      </c:pt>
                      <c:pt idx="989">
                        <c:v>1</c:v>
                      </c:pt>
                      <c:pt idx="990">
                        <c:v>1</c:v>
                      </c:pt>
                      <c:pt idx="991">
                        <c:v>71</c:v>
                      </c:pt>
                      <c:pt idx="992">
                        <c:v>32</c:v>
                      </c:pt>
                      <c:pt idx="993">
                        <c:v>1</c:v>
                      </c:pt>
                      <c:pt idx="994">
                        <c:v>1</c:v>
                      </c:pt>
                      <c:pt idx="995">
                        <c:v>2</c:v>
                      </c:pt>
                      <c:pt idx="996">
                        <c:v>1</c:v>
                      </c:pt>
                      <c:pt idx="997">
                        <c:v>1</c:v>
                      </c:pt>
                      <c:pt idx="998">
                        <c:v>1</c:v>
                      </c:pt>
                      <c:pt idx="999">
                        <c:v>1</c:v>
                      </c:pt>
                      <c:pt idx="1000">
                        <c:v>1</c:v>
                      </c:pt>
                      <c:pt idx="1001">
                        <c:v>1</c:v>
                      </c:pt>
                      <c:pt idx="1002">
                        <c:v>1</c:v>
                      </c:pt>
                      <c:pt idx="1003">
                        <c:v>1</c:v>
                      </c:pt>
                      <c:pt idx="1004">
                        <c:v>1</c:v>
                      </c:pt>
                      <c:pt idx="1005">
                        <c:v>1</c:v>
                      </c:pt>
                      <c:pt idx="1006">
                        <c:v>1</c:v>
                      </c:pt>
                      <c:pt idx="1007">
                        <c:v>1</c:v>
                      </c:pt>
                      <c:pt idx="1008">
                        <c:v>1</c:v>
                      </c:pt>
                      <c:pt idx="1009">
                        <c:v>1</c:v>
                      </c:pt>
                      <c:pt idx="1011">
                        <c:v>1</c:v>
                      </c:pt>
                      <c:pt idx="1014">
                        <c:v>1</c:v>
                      </c:pt>
                      <c:pt idx="1015">
                        <c:v>1</c:v>
                      </c:pt>
                      <c:pt idx="1016">
                        <c:v>1</c:v>
                      </c:pt>
                      <c:pt idx="1018">
                        <c:v>1</c:v>
                      </c:pt>
                      <c:pt idx="1020">
                        <c:v>1</c:v>
                      </c:pt>
                      <c:pt idx="1021">
                        <c:v>1</c:v>
                      </c:pt>
                      <c:pt idx="1022">
                        <c:v>1</c:v>
                      </c:pt>
                      <c:pt idx="1025">
                        <c:v>1</c:v>
                      </c:pt>
                      <c:pt idx="1026">
                        <c:v>2</c:v>
                      </c:pt>
                      <c:pt idx="1028">
                        <c:v>1</c:v>
                      </c:pt>
                      <c:pt idx="1029">
                        <c:v>1</c:v>
                      </c:pt>
                      <c:pt idx="1030">
                        <c:v>1</c:v>
                      </c:pt>
                      <c:pt idx="1039">
                        <c:v>1</c:v>
                      </c:pt>
                      <c:pt idx="1043">
                        <c:v>1</c:v>
                      </c:pt>
                      <c:pt idx="1045">
                        <c:v>1</c:v>
                      </c:pt>
                      <c:pt idx="1046">
                        <c:v>1</c:v>
                      </c:pt>
                      <c:pt idx="1048">
                        <c:v>1</c:v>
                      </c:pt>
                      <c:pt idx="1053">
                        <c:v>1</c:v>
                      </c:pt>
                    </c:numCache>
                  </c:numRef>
                </c:yVal>
                <c:smooth val="0"/>
              </c15:ser>
            </c15:filteredScatterSeries>
            <c15:filteredScatterSeries>
              <c15:ser>
                <c:idx val="2"/>
                <c:order val="2"/>
                <c:tx>
                  <c:strRef>
                    <c:extLst xmlns:c15="http://schemas.microsoft.com/office/drawing/2012/chart">
                      <c:ext xmlns:c15="http://schemas.microsoft.com/office/drawing/2012/chart" uri="{02D57815-91ED-43cb-92C2-25804820EDAC}">
                        <c15:formulaRef>
                          <c15:sqref>'Brachy NFY'!$E$2</c15:sqref>
                        </c15:formulaRef>
                      </c:ext>
                    </c:extLst>
                    <c:strCache>
                      <c:ptCount val="1"/>
                      <c:pt idx="0">
                        <c:v>Cold1</c:v>
                      </c:pt>
                    </c:strCache>
                  </c:strRef>
                </c:tx>
                <c:spPr>
                  <a:ln w="19050" cap="rnd">
                    <a:noFill/>
                    <a:round/>
                  </a:ln>
                  <a:effectLst/>
                </c:spPr>
                <c:marker>
                  <c:symbol val="circle"/>
                  <c:size val="5"/>
                  <c:spPr>
                    <a:solidFill>
                      <a:schemeClr val="tx1"/>
                    </a:solidFill>
                    <a:ln w="9525">
                      <a:solidFill>
                        <a:schemeClr val="tx1"/>
                      </a:solidFill>
                    </a:ln>
                    <a:effectLst/>
                  </c:spPr>
                </c:marker>
                <c:xVal>
                  <c:numRef>
                    <c:extLst xmlns:c15="http://schemas.microsoft.com/office/drawing/2012/chart">
                      <c:ext xmlns:c15="http://schemas.microsoft.com/office/drawing/2012/chart" uri="{02D57815-91ED-43cb-92C2-25804820EDAC}">
                        <c15:formulaRef>
                          <c15:sqref>'Brachy NFY'!$B$3:$B$1060</c15:sqref>
                        </c15:formulaRef>
                      </c:ext>
                    </c:extLst>
                    <c:numCache>
                      <c:formatCode>General</c:formatCode>
                      <c:ptCount val="1058"/>
                      <c:pt idx="0">
                        <c:v>52</c:v>
                      </c:pt>
                      <c:pt idx="1">
                        <c:v>62</c:v>
                      </c:pt>
                      <c:pt idx="2">
                        <c:v>69</c:v>
                      </c:pt>
                      <c:pt idx="3">
                        <c:v>77</c:v>
                      </c:pt>
                      <c:pt idx="4">
                        <c:v>89</c:v>
                      </c:pt>
                      <c:pt idx="5">
                        <c:v>92</c:v>
                      </c:pt>
                      <c:pt idx="6">
                        <c:v>95</c:v>
                      </c:pt>
                      <c:pt idx="7">
                        <c:v>100</c:v>
                      </c:pt>
                      <c:pt idx="8">
                        <c:v>116</c:v>
                      </c:pt>
                      <c:pt idx="9">
                        <c:v>123</c:v>
                      </c:pt>
                      <c:pt idx="10">
                        <c:v>125</c:v>
                      </c:pt>
                      <c:pt idx="11">
                        <c:v>129</c:v>
                      </c:pt>
                      <c:pt idx="12">
                        <c:v>135</c:v>
                      </c:pt>
                      <c:pt idx="13">
                        <c:v>146</c:v>
                      </c:pt>
                      <c:pt idx="14">
                        <c:v>147</c:v>
                      </c:pt>
                      <c:pt idx="15">
                        <c:v>148</c:v>
                      </c:pt>
                      <c:pt idx="16">
                        <c:v>149</c:v>
                      </c:pt>
                      <c:pt idx="17">
                        <c:v>150</c:v>
                      </c:pt>
                      <c:pt idx="18">
                        <c:v>152</c:v>
                      </c:pt>
                      <c:pt idx="19">
                        <c:v>153</c:v>
                      </c:pt>
                      <c:pt idx="20">
                        <c:v>155</c:v>
                      </c:pt>
                      <c:pt idx="21">
                        <c:v>157</c:v>
                      </c:pt>
                      <c:pt idx="22">
                        <c:v>158</c:v>
                      </c:pt>
                      <c:pt idx="23">
                        <c:v>159</c:v>
                      </c:pt>
                      <c:pt idx="24">
                        <c:v>160</c:v>
                      </c:pt>
                      <c:pt idx="25">
                        <c:v>162</c:v>
                      </c:pt>
                      <c:pt idx="26">
                        <c:v>164</c:v>
                      </c:pt>
                      <c:pt idx="27">
                        <c:v>169</c:v>
                      </c:pt>
                      <c:pt idx="28">
                        <c:v>171</c:v>
                      </c:pt>
                      <c:pt idx="29">
                        <c:v>173</c:v>
                      </c:pt>
                      <c:pt idx="30">
                        <c:v>174</c:v>
                      </c:pt>
                      <c:pt idx="31">
                        <c:v>181</c:v>
                      </c:pt>
                      <c:pt idx="32">
                        <c:v>186</c:v>
                      </c:pt>
                      <c:pt idx="33">
                        <c:v>187</c:v>
                      </c:pt>
                      <c:pt idx="34">
                        <c:v>190</c:v>
                      </c:pt>
                      <c:pt idx="35">
                        <c:v>192</c:v>
                      </c:pt>
                      <c:pt idx="36">
                        <c:v>197</c:v>
                      </c:pt>
                      <c:pt idx="37">
                        <c:v>202</c:v>
                      </c:pt>
                      <c:pt idx="38">
                        <c:v>204</c:v>
                      </c:pt>
                      <c:pt idx="39">
                        <c:v>206</c:v>
                      </c:pt>
                      <c:pt idx="40">
                        <c:v>208</c:v>
                      </c:pt>
                      <c:pt idx="41">
                        <c:v>209</c:v>
                      </c:pt>
                      <c:pt idx="42">
                        <c:v>210</c:v>
                      </c:pt>
                      <c:pt idx="43">
                        <c:v>217</c:v>
                      </c:pt>
                      <c:pt idx="44">
                        <c:v>219</c:v>
                      </c:pt>
                      <c:pt idx="45">
                        <c:v>220</c:v>
                      </c:pt>
                      <c:pt idx="46">
                        <c:v>222</c:v>
                      </c:pt>
                      <c:pt idx="47">
                        <c:v>226</c:v>
                      </c:pt>
                      <c:pt idx="48">
                        <c:v>227</c:v>
                      </c:pt>
                      <c:pt idx="49">
                        <c:v>230</c:v>
                      </c:pt>
                      <c:pt idx="50">
                        <c:v>231</c:v>
                      </c:pt>
                      <c:pt idx="51">
                        <c:v>232</c:v>
                      </c:pt>
                      <c:pt idx="52">
                        <c:v>235</c:v>
                      </c:pt>
                      <c:pt idx="53">
                        <c:v>236</c:v>
                      </c:pt>
                      <c:pt idx="54">
                        <c:v>240</c:v>
                      </c:pt>
                      <c:pt idx="55">
                        <c:v>241</c:v>
                      </c:pt>
                      <c:pt idx="56">
                        <c:v>244</c:v>
                      </c:pt>
                      <c:pt idx="57">
                        <c:v>245</c:v>
                      </c:pt>
                      <c:pt idx="58">
                        <c:v>247</c:v>
                      </c:pt>
                      <c:pt idx="59">
                        <c:v>248</c:v>
                      </c:pt>
                      <c:pt idx="60">
                        <c:v>251</c:v>
                      </c:pt>
                      <c:pt idx="61">
                        <c:v>254</c:v>
                      </c:pt>
                      <c:pt idx="62">
                        <c:v>255</c:v>
                      </c:pt>
                      <c:pt idx="63">
                        <c:v>258</c:v>
                      </c:pt>
                      <c:pt idx="64">
                        <c:v>260</c:v>
                      </c:pt>
                      <c:pt idx="65">
                        <c:v>261</c:v>
                      </c:pt>
                      <c:pt idx="66">
                        <c:v>262</c:v>
                      </c:pt>
                      <c:pt idx="67">
                        <c:v>263</c:v>
                      </c:pt>
                      <c:pt idx="68">
                        <c:v>264</c:v>
                      </c:pt>
                      <c:pt idx="69">
                        <c:v>265</c:v>
                      </c:pt>
                      <c:pt idx="70">
                        <c:v>266</c:v>
                      </c:pt>
                      <c:pt idx="71">
                        <c:v>267</c:v>
                      </c:pt>
                      <c:pt idx="72">
                        <c:v>268</c:v>
                      </c:pt>
                      <c:pt idx="73">
                        <c:v>270</c:v>
                      </c:pt>
                      <c:pt idx="74">
                        <c:v>273</c:v>
                      </c:pt>
                      <c:pt idx="75">
                        <c:v>286</c:v>
                      </c:pt>
                      <c:pt idx="76">
                        <c:v>289</c:v>
                      </c:pt>
                      <c:pt idx="77">
                        <c:v>290</c:v>
                      </c:pt>
                      <c:pt idx="78">
                        <c:v>292</c:v>
                      </c:pt>
                      <c:pt idx="79">
                        <c:v>294</c:v>
                      </c:pt>
                      <c:pt idx="80">
                        <c:v>295</c:v>
                      </c:pt>
                      <c:pt idx="81">
                        <c:v>297</c:v>
                      </c:pt>
                      <c:pt idx="82">
                        <c:v>302</c:v>
                      </c:pt>
                      <c:pt idx="83">
                        <c:v>303</c:v>
                      </c:pt>
                      <c:pt idx="84">
                        <c:v>307</c:v>
                      </c:pt>
                      <c:pt idx="85">
                        <c:v>309</c:v>
                      </c:pt>
                      <c:pt idx="86">
                        <c:v>310</c:v>
                      </c:pt>
                      <c:pt idx="87">
                        <c:v>312</c:v>
                      </c:pt>
                      <c:pt idx="88">
                        <c:v>313</c:v>
                      </c:pt>
                      <c:pt idx="89">
                        <c:v>314</c:v>
                      </c:pt>
                      <c:pt idx="90">
                        <c:v>315</c:v>
                      </c:pt>
                      <c:pt idx="91">
                        <c:v>316</c:v>
                      </c:pt>
                      <c:pt idx="92">
                        <c:v>326</c:v>
                      </c:pt>
                      <c:pt idx="93">
                        <c:v>330</c:v>
                      </c:pt>
                      <c:pt idx="94">
                        <c:v>335</c:v>
                      </c:pt>
                      <c:pt idx="95">
                        <c:v>338</c:v>
                      </c:pt>
                      <c:pt idx="96">
                        <c:v>339</c:v>
                      </c:pt>
                      <c:pt idx="97">
                        <c:v>344</c:v>
                      </c:pt>
                      <c:pt idx="98">
                        <c:v>349</c:v>
                      </c:pt>
                      <c:pt idx="99">
                        <c:v>351</c:v>
                      </c:pt>
                      <c:pt idx="100">
                        <c:v>354</c:v>
                      </c:pt>
                      <c:pt idx="101">
                        <c:v>357</c:v>
                      </c:pt>
                      <c:pt idx="102">
                        <c:v>361</c:v>
                      </c:pt>
                      <c:pt idx="103">
                        <c:v>364</c:v>
                      </c:pt>
                      <c:pt idx="104">
                        <c:v>373</c:v>
                      </c:pt>
                      <c:pt idx="105">
                        <c:v>377</c:v>
                      </c:pt>
                      <c:pt idx="106">
                        <c:v>378</c:v>
                      </c:pt>
                      <c:pt idx="107">
                        <c:v>379</c:v>
                      </c:pt>
                      <c:pt idx="108">
                        <c:v>382</c:v>
                      </c:pt>
                      <c:pt idx="109">
                        <c:v>390</c:v>
                      </c:pt>
                      <c:pt idx="110">
                        <c:v>394</c:v>
                      </c:pt>
                      <c:pt idx="111">
                        <c:v>396</c:v>
                      </c:pt>
                      <c:pt idx="112">
                        <c:v>397</c:v>
                      </c:pt>
                      <c:pt idx="113">
                        <c:v>400</c:v>
                      </c:pt>
                      <c:pt idx="114">
                        <c:v>403</c:v>
                      </c:pt>
                      <c:pt idx="115">
                        <c:v>405</c:v>
                      </c:pt>
                      <c:pt idx="116">
                        <c:v>406</c:v>
                      </c:pt>
                      <c:pt idx="117">
                        <c:v>407</c:v>
                      </c:pt>
                      <c:pt idx="118">
                        <c:v>408</c:v>
                      </c:pt>
                      <c:pt idx="119">
                        <c:v>409</c:v>
                      </c:pt>
                      <c:pt idx="120">
                        <c:v>410</c:v>
                      </c:pt>
                      <c:pt idx="121">
                        <c:v>416</c:v>
                      </c:pt>
                      <c:pt idx="122">
                        <c:v>418</c:v>
                      </c:pt>
                      <c:pt idx="123">
                        <c:v>423</c:v>
                      </c:pt>
                      <c:pt idx="124">
                        <c:v>424</c:v>
                      </c:pt>
                      <c:pt idx="125">
                        <c:v>426</c:v>
                      </c:pt>
                      <c:pt idx="126">
                        <c:v>428</c:v>
                      </c:pt>
                      <c:pt idx="127">
                        <c:v>429</c:v>
                      </c:pt>
                      <c:pt idx="128">
                        <c:v>430</c:v>
                      </c:pt>
                      <c:pt idx="129">
                        <c:v>433</c:v>
                      </c:pt>
                      <c:pt idx="130">
                        <c:v>438</c:v>
                      </c:pt>
                      <c:pt idx="131">
                        <c:v>440</c:v>
                      </c:pt>
                      <c:pt idx="132">
                        <c:v>450</c:v>
                      </c:pt>
                      <c:pt idx="133">
                        <c:v>453</c:v>
                      </c:pt>
                      <c:pt idx="134">
                        <c:v>460</c:v>
                      </c:pt>
                      <c:pt idx="135">
                        <c:v>461</c:v>
                      </c:pt>
                      <c:pt idx="136">
                        <c:v>464</c:v>
                      </c:pt>
                      <c:pt idx="137">
                        <c:v>465</c:v>
                      </c:pt>
                      <c:pt idx="138">
                        <c:v>466</c:v>
                      </c:pt>
                      <c:pt idx="139">
                        <c:v>467</c:v>
                      </c:pt>
                      <c:pt idx="140">
                        <c:v>468</c:v>
                      </c:pt>
                      <c:pt idx="141">
                        <c:v>469</c:v>
                      </c:pt>
                      <c:pt idx="142">
                        <c:v>470</c:v>
                      </c:pt>
                      <c:pt idx="143">
                        <c:v>471</c:v>
                      </c:pt>
                      <c:pt idx="144">
                        <c:v>472</c:v>
                      </c:pt>
                      <c:pt idx="145">
                        <c:v>473</c:v>
                      </c:pt>
                      <c:pt idx="146">
                        <c:v>474</c:v>
                      </c:pt>
                      <c:pt idx="147">
                        <c:v>475</c:v>
                      </c:pt>
                      <c:pt idx="148">
                        <c:v>477</c:v>
                      </c:pt>
                      <c:pt idx="149">
                        <c:v>478</c:v>
                      </c:pt>
                      <c:pt idx="150">
                        <c:v>479</c:v>
                      </c:pt>
                      <c:pt idx="151">
                        <c:v>480</c:v>
                      </c:pt>
                      <c:pt idx="152">
                        <c:v>485</c:v>
                      </c:pt>
                      <c:pt idx="153">
                        <c:v>488</c:v>
                      </c:pt>
                      <c:pt idx="154">
                        <c:v>489</c:v>
                      </c:pt>
                      <c:pt idx="155">
                        <c:v>491</c:v>
                      </c:pt>
                      <c:pt idx="156">
                        <c:v>492</c:v>
                      </c:pt>
                      <c:pt idx="157">
                        <c:v>494</c:v>
                      </c:pt>
                      <c:pt idx="158">
                        <c:v>495</c:v>
                      </c:pt>
                      <c:pt idx="159">
                        <c:v>497</c:v>
                      </c:pt>
                      <c:pt idx="160">
                        <c:v>498</c:v>
                      </c:pt>
                      <c:pt idx="161">
                        <c:v>499</c:v>
                      </c:pt>
                      <c:pt idx="162">
                        <c:v>500</c:v>
                      </c:pt>
                      <c:pt idx="163">
                        <c:v>501</c:v>
                      </c:pt>
                      <c:pt idx="164">
                        <c:v>502</c:v>
                      </c:pt>
                      <c:pt idx="165">
                        <c:v>503</c:v>
                      </c:pt>
                      <c:pt idx="166">
                        <c:v>504</c:v>
                      </c:pt>
                      <c:pt idx="167">
                        <c:v>505</c:v>
                      </c:pt>
                      <c:pt idx="168">
                        <c:v>508</c:v>
                      </c:pt>
                      <c:pt idx="169">
                        <c:v>510</c:v>
                      </c:pt>
                      <c:pt idx="170">
                        <c:v>511</c:v>
                      </c:pt>
                      <c:pt idx="171">
                        <c:v>513</c:v>
                      </c:pt>
                      <c:pt idx="172">
                        <c:v>516</c:v>
                      </c:pt>
                      <c:pt idx="173">
                        <c:v>518</c:v>
                      </c:pt>
                      <c:pt idx="174">
                        <c:v>519</c:v>
                      </c:pt>
                      <c:pt idx="175">
                        <c:v>520</c:v>
                      </c:pt>
                      <c:pt idx="176">
                        <c:v>521</c:v>
                      </c:pt>
                      <c:pt idx="177">
                        <c:v>522</c:v>
                      </c:pt>
                      <c:pt idx="178">
                        <c:v>523</c:v>
                      </c:pt>
                      <c:pt idx="179">
                        <c:v>524</c:v>
                      </c:pt>
                      <c:pt idx="180">
                        <c:v>525</c:v>
                      </c:pt>
                      <c:pt idx="181">
                        <c:v>527</c:v>
                      </c:pt>
                      <c:pt idx="182">
                        <c:v>530</c:v>
                      </c:pt>
                      <c:pt idx="183">
                        <c:v>531</c:v>
                      </c:pt>
                      <c:pt idx="184">
                        <c:v>532</c:v>
                      </c:pt>
                      <c:pt idx="185">
                        <c:v>533</c:v>
                      </c:pt>
                      <c:pt idx="186">
                        <c:v>537</c:v>
                      </c:pt>
                      <c:pt idx="187">
                        <c:v>538</c:v>
                      </c:pt>
                      <c:pt idx="188">
                        <c:v>539</c:v>
                      </c:pt>
                      <c:pt idx="189">
                        <c:v>541</c:v>
                      </c:pt>
                      <c:pt idx="190">
                        <c:v>542</c:v>
                      </c:pt>
                      <c:pt idx="191">
                        <c:v>543</c:v>
                      </c:pt>
                      <c:pt idx="192">
                        <c:v>544</c:v>
                      </c:pt>
                      <c:pt idx="193">
                        <c:v>545</c:v>
                      </c:pt>
                      <c:pt idx="194">
                        <c:v>549</c:v>
                      </c:pt>
                      <c:pt idx="195">
                        <c:v>550</c:v>
                      </c:pt>
                      <c:pt idx="196">
                        <c:v>551</c:v>
                      </c:pt>
                      <c:pt idx="197">
                        <c:v>552</c:v>
                      </c:pt>
                      <c:pt idx="198">
                        <c:v>553</c:v>
                      </c:pt>
                      <c:pt idx="199">
                        <c:v>554</c:v>
                      </c:pt>
                      <c:pt idx="200">
                        <c:v>555</c:v>
                      </c:pt>
                      <c:pt idx="201">
                        <c:v>556</c:v>
                      </c:pt>
                      <c:pt idx="202">
                        <c:v>557</c:v>
                      </c:pt>
                      <c:pt idx="203">
                        <c:v>558</c:v>
                      </c:pt>
                      <c:pt idx="204">
                        <c:v>561</c:v>
                      </c:pt>
                      <c:pt idx="205">
                        <c:v>562</c:v>
                      </c:pt>
                      <c:pt idx="206">
                        <c:v>564</c:v>
                      </c:pt>
                      <c:pt idx="207">
                        <c:v>565</c:v>
                      </c:pt>
                      <c:pt idx="208">
                        <c:v>568</c:v>
                      </c:pt>
                      <c:pt idx="209">
                        <c:v>570</c:v>
                      </c:pt>
                      <c:pt idx="210">
                        <c:v>571</c:v>
                      </c:pt>
                      <c:pt idx="211">
                        <c:v>573</c:v>
                      </c:pt>
                      <c:pt idx="212">
                        <c:v>574</c:v>
                      </c:pt>
                      <c:pt idx="213">
                        <c:v>575</c:v>
                      </c:pt>
                      <c:pt idx="214">
                        <c:v>582</c:v>
                      </c:pt>
                      <c:pt idx="215">
                        <c:v>586</c:v>
                      </c:pt>
                      <c:pt idx="216">
                        <c:v>587</c:v>
                      </c:pt>
                      <c:pt idx="217">
                        <c:v>589</c:v>
                      </c:pt>
                      <c:pt idx="218">
                        <c:v>590</c:v>
                      </c:pt>
                      <c:pt idx="219">
                        <c:v>591</c:v>
                      </c:pt>
                      <c:pt idx="220">
                        <c:v>592</c:v>
                      </c:pt>
                      <c:pt idx="221">
                        <c:v>595</c:v>
                      </c:pt>
                      <c:pt idx="222">
                        <c:v>596</c:v>
                      </c:pt>
                      <c:pt idx="223">
                        <c:v>597</c:v>
                      </c:pt>
                      <c:pt idx="224">
                        <c:v>598</c:v>
                      </c:pt>
                      <c:pt idx="225">
                        <c:v>604</c:v>
                      </c:pt>
                      <c:pt idx="226">
                        <c:v>605</c:v>
                      </c:pt>
                      <c:pt idx="227">
                        <c:v>608</c:v>
                      </c:pt>
                      <c:pt idx="228">
                        <c:v>609</c:v>
                      </c:pt>
                      <c:pt idx="229">
                        <c:v>610</c:v>
                      </c:pt>
                      <c:pt idx="230">
                        <c:v>611</c:v>
                      </c:pt>
                      <c:pt idx="231">
                        <c:v>612</c:v>
                      </c:pt>
                      <c:pt idx="232">
                        <c:v>613</c:v>
                      </c:pt>
                      <c:pt idx="233">
                        <c:v>623</c:v>
                      </c:pt>
                      <c:pt idx="234">
                        <c:v>624</c:v>
                      </c:pt>
                      <c:pt idx="235">
                        <c:v>625</c:v>
                      </c:pt>
                      <c:pt idx="236">
                        <c:v>627</c:v>
                      </c:pt>
                      <c:pt idx="237">
                        <c:v>628</c:v>
                      </c:pt>
                      <c:pt idx="238">
                        <c:v>629</c:v>
                      </c:pt>
                      <c:pt idx="239">
                        <c:v>631</c:v>
                      </c:pt>
                      <c:pt idx="240">
                        <c:v>634</c:v>
                      </c:pt>
                      <c:pt idx="241">
                        <c:v>636</c:v>
                      </c:pt>
                      <c:pt idx="242">
                        <c:v>638</c:v>
                      </c:pt>
                      <c:pt idx="243">
                        <c:v>639</c:v>
                      </c:pt>
                      <c:pt idx="244">
                        <c:v>642</c:v>
                      </c:pt>
                      <c:pt idx="245">
                        <c:v>643</c:v>
                      </c:pt>
                      <c:pt idx="246">
                        <c:v>644</c:v>
                      </c:pt>
                      <c:pt idx="247">
                        <c:v>646</c:v>
                      </c:pt>
                      <c:pt idx="248">
                        <c:v>647</c:v>
                      </c:pt>
                      <c:pt idx="249">
                        <c:v>649</c:v>
                      </c:pt>
                      <c:pt idx="250">
                        <c:v>650</c:v>
                      </c:pt>
                      <c:pt idx="251">
                        <c:v>652</c:v>
                      </c:pt>
                      <c:pt idx="252">
                        <c:v>653</c:v>
                      </c:pt>
                      <c:pt idx="253">
                        <c:v>654</c:v>
                      </c:pt>
                      <c:pt idx="254">
                        <c:v>656</c:v>
                      </c:pt>
                      <c:pt idx="255">
                        <c:v>657</c:v>
                      </c:pt>
                      <c:pt idx="256">
                        <c:v>659</c:v>
                      </c:pt>
                      <c:pt idx="257">
                        <c:v>661</c:v>
                      </c:pt>
                      <c:pt idx="258">
                        <c:v>665</c:v>
                      </c:pt>
                      <c:pt idx="259">
                        <c:v>667</c:v>
                      </c:pt>
                      <c:pt idx="260">
                        <c:v>668</c:v>
                      </c:pt>
                      <c:pt idx="261">
                        <c:v>669</c:v>
                      </c:pt>
                      <c:pt idx="262">
                        <c:v>670</c:v>
                      </c:pt>
                      <c:pt idx="263">
                        <c:v>671</c:v>
                      </c:pt>
                      <c:pt idx="264">
                        <c:v>672</c:v>
                      </c:pt>
                      <c:pt idx="265">
                        <c:v>673</c:v>
                      </c:pt>
                      <c:pt idx="266">
                        <c:v>674</c:v>
                      </c:pt>
                      <c:pt idx="267">
                        <c:v>675</c:v>
                      </c:pt>
                      <c:pt idx="268">
                        <c:v>676</c:v>
                      </c:pt>
                      <c:pt idx="269">
                        <c:v>677</c:v>
                      </c:pt>
                      <c:pt idx="270">
                        <c:v>678</c:v>
                      </c:pt>
                      <c:pt idx="271">
                        <c:v>681</c:v>
                      </c:pt>
                      <c:pt idx="272">
                        <c:v>682</c:v>
                      </c:pt>
                      <c:pt idx="273">
                        <c:v>683</c:v>
                      </c:pt>
                      <c:pt idx="274">
                        <c:v>684</c:v>
                      </c:pt>
                      <c:pt idx="275">
                        <c:v>685</c:v>
                      </c:pt>
                      <c:pt idx="276">
                        <c:v>686</c:v>
                      </c:pt>
                      <c:pt idx="277">
                        <c:v>687</c:v>
                      </c:pt>
                      <c:pt idx="278">
                        <c:v>688</c:v>
                      </c:pt>
                      <c:pt idx="279">
                        <c:v>689</c:v>
                      </c:pt>
                      <c:pt idx="280">
                        <c:v>693</c:v>
                      </c:pt>
                      <c:pt idx="281">
                        <c:v>694</c:v>
                      </c:pt>
                      <c:pt idx="282">
                        <c:v>698</c:v>
                      </c:pt>
                      <c:pt idx="283">
                        <c:v>701</c:v>
                      </c:pt>
                      <c:pt idx="284">
                        <c:v>702</c:v>
                      </c:pt>
                      <c:pt idx="285">
                        <c:v>703</c:v>
                      </c:pt>
                      <c:pt idx="286">
                        <c:v>707</c:v>
                      </c:pt>
                      <c:pt idx="287">
                        <c:v>708</c:v>
                      </c:pt>
                      <c:pt idx="288">
                        <c:v>712</c:v>
                      </c:pt>
                      <c:pt idx="289">
                        <c:v>713</c:v>
                      </c:pt>
                      <c:pt idx="290">
                        <c:v>714</c:v>
                      </c:pt>
                      <c:pt idx="291">
                        <c:v>719</c:v>
                      </c:pt>
                      <c:pt idx="292">
                        <c:v>720</c:v>
                      </c:pt>
                      <c:pt idx="293">
                        <c:v>721</c:v>
                      </c:pt>
                      <c:pt idx="294">
                        <c:v>723</c:v>
                      </c:pt>
                      <c:pt idx="295">
                        <c:v>724</c:v>
                      </c:pt>
                      <c:pt idx="296">
                        <c:v>725</c:v>
                      </c:pt>
                      <c:pt idx="297">
                        <c:v>726</c:v>
                      </c:pt>
                      <c:pt idx="298">
                        <c:v>727</c:v>
                      </c:pt>
                      <c:pt idx="299">
                        <c:v>728</c:v>
                      </c:pt>
                      <c:pt idx="300">
                        <c:v>729</c:v>
                      </c:pt>
                      <c:pt idx="301">
                        <c:v>730</c:v>
                      </c:pt>
                      <c:pt idx="302">
                        <c:v>732</c:v>
                      </c:pt>
                      <c:pt idx="303">
                        <c:v>734</c:v>
                      </c:pt>
                      <c:pt idx="304">
                        <c:v>735</c:v>
                      </c:pt>
                      <c:pt idx="305">
                        <c:v>736</c:v>
                      </c:pt>
                      <c:pt idx="306">
                        <c:v>737</c:v>
                      </c:pt>
                      <c:pt idx="307">
                        <c:v>738</c:v>
                      </c:pt>
                      <c:pt idx="308">
                        <c:v>739</c:v>
                      </c:pt>
                      <c:pt idx="309">
                        <c:v>740</c:v>
                      </c:pt>
                      <c:pt idx="310">
                        <c:v>741</c:v>
                      </c:pt>
                      <c:pt idx="311">
                        <c:v>742</c:v>
                      </c:pt>
                      <c:pt idx="312">
                        <c:v>743</c:v>
                      </c:pt>
                      <c:pt idx="313">
                        <c:v>744</c:v>
                      </c:pt>
                      <c:pt idx="314">
                        <c:v>745</c:v>
                      </c:pt>
                      <c:pt idx="315">
                        <c:v>746</c:v>
                      </c:pt>
                      <c:pt idx="316">
                        <c:v>747</c:v>
                      </c:pt>
                      <c:pt idx="317">
                        <c:v>748</c:v>
                      </c:pt>
                      <c:pt idx="318">
                        <c:v>749</c:v>
                      </c:pt>
                      <c:pt idx="319">
                        <c:v>750</c:v>
                      </c:pt>
                      <c:pt idx="320">
                        <c:v>751</c:v>
                      </c:pt>
                      <c:pt idx="321">
                        <c:v>757</c:v>
                      </c:pt>
                      <c:pt idx="322">
                        <c:v>758</c:v>
                      </c:pt>
                      <c:pt idx="323">
                        <c:v>759</c:v>
                      </c:pt>
                      <c:pt idx="324">
                        <c:v>760</c:v>
                      </c:pt>
                      <c:pt idx="325">
                        <c:v>761</c:v>
                      </c:pt>
                      <c:pt idx="326">
                        <c:v>762</c:v>
                      </c:pt>
                      <c:pt idx="327">
                        <c:v>765</c:v>
                      </c:pt>
                      <c:pt idx="328">
                        <c:v>766</c:v>
                      </c:pt>
                      <c:pt idx="329">
                        <c:v>767</c:v>
                      </c:pt>
                      <c:pt idx="330">
                        <c:v>769</c:v>
                      </c:pt>
                      <c:pt idx="331">
                        <c:v>770</c:v>
                      </c:pt>
                      <c:pt idx="332">
                        <c:v>772</c:v>
                      </c:pt>
                      <c:pt idx="333">
                        <c:v>773</c:v>
                      </c:pt>
                      <c:pt idx="334">
                        <c:v>774</c:v>
                      </c:pt>
                      <c:pt idx="335">
                        <c:v>775</c:v>
                      </c:pt>
                      <c:pt idx="336">
                        <c:v>776</c:v>
                      </c:pt>
                      <c:pt idx="337">
                        <c:v>777</c:v>
                      </c:pt>
                      <c:pt idx="338">
                        <c:v>778</c:v>
                      </c:pt>
                      <c:pt idx="339">
                        <c:v>779</c:v>
                      </c:pt>
                      <c:pt idx="340">
                        <c:v>781</c:v>
                      </c:pt>
                      <c:pt idx="341">
                        <c:v>782</c:v>
                      </c:pt>
                      <c:pt idx="342">
                        <c:v>783</c:v>
                      </c:pt>
                      <c:pt idx="343">
                        <c:v>784</c:v>
                      </c:pt>
                      <c:pt idx="344">
                        <c:v>786</c:v>
                      </c:pt>
                      <c:pt idx="345">
                        <c:v>787</c:v>
                      </c:pt>
                      <c:pt idx="346">
                        <c:v>788</c:v>
                      </c:pt>
                      <c:pt idx="347">
                        <c:v>789</c:v>
                      </c:pt>
                      <c:pt idx="348">
                        <c:v>790</c:v>
                      </c:pt>
                      <c:pt idx="349">
                        <c:v>794</c:v>
                      </c:pt>
                      <c:pt idx="350">
                        <c:v>795</c:v>
                      </c:pt>
                      <c:pt idx="351">
                        <c:v>796</c:v>
                      </c:pt>
                      <c:pt idx="352">
                        <c:v>797</c:v>
                      </c:pt>
                      <c:pt idx="353">
                        <c:v>798</c:v>
                      </c:pt>
                      <c:pt idx="354">
                        <c:v>800</c:v>
                      </c:pt>
                      <c:pt idx="355">
                        <c:v>801</c:v>
                      </c:pt>
                      <c:pt idx="356">
                        <c:v>802</c:v>
                      </c:pt>
                      <c:pt idx="357">
                        <c:v>803</c:v>
                      </c:pt>
                      <c:pt idx="358">
                        <c:v>804</c:v>
                      </c:pt>
                      <c:pt idx="359">
                        <c:v>805</c:v>
                      </c:pt>
                      <c:pt idx="360">
                        <c:v>806</c:v>
                      </c:pt>
                      <c:pt idx="361">
                        <c:v>807</c:v>
                      </c:pt>
                      <c:pt idx="362">
                        <c:v>808</c:v>
                      </c:pt>
                      <c:pt idx="363">
                        <c:v>811</c:v>
                      </c:pt>
                      <c:pt idx="364">
                        <c:v>812</c:v>
                      </c:pt>
                      <c:pt idx="365">
                        <c:v>813</c:v>
                      </c:pt>
                      <c:pt idx="366">
                        <c:v>814</c:v>
                      </c:pt>
                      <c:pt idx="367">
                        <c:v>815</c:v>
                      </c:pt>
                      <c:pt idx="368">
                        <c:v>816</c:v>
                      </c:pt>
                      <c:pt idx="369">
                        <c:v>817</c:v>
                      </c:pt>
                      <c:pt idx="370">
                        <c:v>818</c:v>
                      </c:pt>
                      <c:pt idx="371">
                        <c:v>819</c:v>
                      </c:pt>
                      <c:pt idx="372">
                        <c:v>820</c:v>
                      </c:pt>
                      <c:pt idx="373">
                        <c:v>821</c:v>
                      </c:pt>
                      <c:pt idx="374">
                        <c:v>822</c:v>
                      </c:pt>
                      <c:pt idx="375">
                        <c:v>823</c:v>
                      </c:pt>
                      <c:pt idx="376">
                        <c:v>825</c:v>
                      </c:pt>
                      <c:pt idx="377">
                        <c:v>826</c:v>
                      </c:pt>
                      <c:pt idx="378">
                        <c:v>827</c:v>
                      </c:pt>
                      <c:pt idx="379">
                        <c:v>828</c:v>
                      </c:pt>
                      <c:pt idx="380">
                        <c:v>829</c:v>
                      </c:pt>
                      <c:pt idx="381">
                        <c:v>830</c:v>
                      </c:pt>
                      <c:pt idx="382">
                        <c:v>831</c:v>
                      </c:pt>
                      <c:pt idx="383">
                        <c:v>832</c:v>
                      </c:pt>
                      <c:pt idx="384">
                        <c:v>834</c:v>
                      </c:pt>
                      <c:pt idx="385">
                        <c:v>836</c:v>
                      </c:pt>
                      <c:pt idx="386">
                        <c:v>837</c:v>
                      </c:pt>
                      <c:pt idx="387">
                        <c:v>838</c:v>
                      </c:pt>
                      <c:pt idx="388">
                        <c:v>839</c:v>
                      </c:pt>
                      <c:pt idx="389">
                        <c:v>840</c:v>
                      </c:pt>
                      <c:pt idx="390">
                        <c:v>842</c:v>
                      </c:pt>
                      <c:pt idx="391">
                        <c:v>843</c:v>
                      </c:pt>
                      <c:pt idx="392">
                        <c:v>844</c:v>
                      </c:pt>
                      <c:pt idx="393">
                        <c:v>845</c:v>
                      </c:pt>
                      <c:pt idx="394">
                        <c:v>846</c:v>
                      </c:pt>
                      <c:pt idx="395">
                        <c:v>847</c:v>
                      </c:pt>
                      <c:pt idx="396">
                        <c:v>848</c:v>
                      </c:pt>
                      <c:pt idx="397">
                        <c:v>849</c:v>
                      </c:pt>
                      <c:pt idx="398">
                        <c:v>850</c:v>
                      </c:pt>
                      <c:pt idx="399">
                        <c:v>851</c:v>
                      </c:pt>
                      <c:pt idx="400">
                        <c:v>853</c:v>
                      </c:pt>
                      <c:pt idx="401">
                        <c:v>854</c:v>
                      </c:pt>
                      <c:pt idx="402">
                        <c:v>855</c:v>
                      </c:pt>
                      <c:pt idx="403">
                        <c:v>856</c:v>
                      </c:pt>
                      <c:pt idx="404">
                        <c:v>857</c:v>
                      </c:pt>
                      <c:pt idx="405">
                        <c:v>859</c:v>
                      </c:pt>
                      <c:pt idx="406">
                        <c:v>860</c:v>
                      </c:pt>
                      <c:pt idx="407">
                        <c:v>861</c:v>
                      </c:pt>
                      <c:pt idx="408">
                        <c:v>862</c:v>
                      </c:pt>
                      <c:pt idx="409">
                        <c:v>863</c:v>
                      </c:pt>
                      <c:pt idx="410">
                        <c:v>865</c:v>
                      </c:pt>
                      <c:pt idx="411">
                        <c:v>867</c:v>
                      </c:pt>
                      <c:pt idx="412">
                        <c:v>868</c:v>
                      </c:pt>
                      <c:pt idx="413">
                        <c:v>869</c:v>
                      </c:pt>
                      <c:pt idx="414">
                        <c:v>876</c:v>
                      </c:pt>
                      <c:pt idx="415">
                        <c:v>877</c:v>
                      </c:pt>
                      <c:pt idx="416">
                        <c:v>882</c:v>
                      </c:pt>
                      <c:pt idx="417">
                        <c:v>883</c:v>
                      </c:pt>
                      <c:pt idx="418">
                        <c:v>885</c:v>
                      </c:pt>
                      <c:pt idx="419">
                        <c:v>886</c:v>
                      </c:pt>
                      <c:pt idx="420">
                        <c:v>887</c:v>
                      </c:pt>
                      <c:pt idx="421">
                        <c:v>888</c:v>
                      </c:pt>
                      <c:pt idx="422">
                        <c:v>889</c:v>
                      </c:pt>
                      <c:pt idx="423">
                        <c:v>890</c:v>
                      </c:pt>
                      <c:pt idx="424">
                        <c:v>891</c:v>
                      </c:pt>
                      <c:pt idx="425">
                        <c:v>892</c:v>
                      </c:pt>
                      <c:pt idx="426">
                        <c:v>893</c:v>
                      </c:pt>
                      <c:pt idx="427">
                        <c:v>895</c:v>
                      </c:pt>
                      <c:pt idx="428">
                        <c:v>896</c:v>
                      </c:pt>
                      <c:pt idx="429">
                        <c:v>897</c:v>
                      </c:pt>
                      <c:pt idx="430">
                        <c:v>898</c:v>
                      </c:pt>
                      <c:pt idx="431">
                        <c:v>900</c:v>
                      </c:pt>
                      <c:pt idx="432">
                        <c:v>901</c:v>
                      </c:pt>
                      <c:pt idx="433">
                        <c:v>902</c:v>
                      </c:pt>
                      <c:pt idx="434">
                        <c:v>903</c:v>
                      </c:pt>
                      <c:pt idx="435">
                        <c:v>904</c:v>
                      </c:pt>
                      <c:pt idx="436">
                        <c:v>905</c:v>
                      </c:pt>
                      <c:pt idx="437">
                        <c:v>907</c:v>
                      </c:pt>
                      <c:pt idx="438">
                        <c:v>908</c:v>
                      </c:pt>
                      <c:pt idx="439">
                        <c:v>909</c:v>
                      </c:pt>
                      <c:pt idx="440">
                        <c:v>910</c:v>
                      </c:pt>
                      <c:pt idx="441">
                        <c:v>911</c:v>
                      </c:pt>
                      <c:pt idx="442">
                        <c:v>912</c:v>
                      </c:pt>
                      <c:pt idx="443">
                        <c:v>913</c:v>
                      </c:pt>
                      <c:pt idx="444">
                        <c:v>918</c:v>
                      </c:pt>
                      <c:pt idx="445">
                        <c:v>919</c:v>
                      </c:pt>
                      <c:pt idx="446">
                        <c:v>920</c:v>
                      </c:pt>
                      <c:pt idx="447">
                        <c:v>922</c:v>
                      </c:pt>
                      <c:pt idx="448">
                        <c:v>923</c:v>
                      </c:pt>
                      <c:pt idx="449">
                        <c:v>924</c:v>
                      </c:pt>
                      <c:pt idx="450">
                        <c:v>925</c:v>
                      </c:pt>
                      <c:pt idx="451">
                        <c:v>926</c:v>
                      </c:pt>
                      <c:pt idx="452">
                        <c:v>927</c:v>
                      </c:pt>
                      <c:pt idx="453">
                        <c:v>928</c:v>
                      </c:pt>
                      <c:pt idx="454">
                        <c:v>929</c:v>
                      </c:pt>
                      <c:pt idx="455">
                        <c:v>930</c:v>
                      </c:pt>
                      <c:pt idx="456">
                        <c:v>931</c:v>
                      </c:pt>
                      <c:pt idx="457">
                        <c:v>934</c:v>
                      </c:pt>
                      <c:pt idx="458">
                        <c:v>935</c:v>
                      </c:pt>
                      <c:pt idx="459">
                        <c:v>940</c:v>
                      </c:pt>
                      <c:pt idx="460">
                        <c:v>941</c:v>
                      </c:pt>
                      <c:pt idx="461">
                        <c:v>942</c:v>
                      </c:pt>
                      <c:pt idx="462">
                        <c:v>943</c:v>
                      </c:pt>
                      <c:pt idx="463">
                        <c:v>944</c:v>
                      </c:pt>
                      <c:pt idx="464">
                        <c:v>945</c:v>
                      </c:pt>
                      <c:pt idx="465">
                        <c:v>946</c:v>
                      </c:pt>
                      <c:pt idx="466">
                        <c:v>947</c:v>
                      </c:pt>
                      <c:pt idx="467">
                        <c:v>948</c:v>
                      </c:pt>
                      <c:pt idx="468">
                        <c:v>949</c:v>
                      </c:pt>
                      <c:pt idx="469">
                        <c:v>950</c:v>
                      </c:pt>
                      <c:pt idx="470">
                        <c:v>951</c:v>
                      </c:pt>
                      <c:pt idx="471">
                        <c:v>952</c:v>
                      </c:pt>
                      <c:pt idx="472">
                        <c:v>954</c:v>
                      </c:pt>
                      <c:pt idx="473">
                        <c:v>955</c:v>
                      </c:pt>
                      <c:pt idx="474">
                        <c:v>956</c:v>
                      </c:pt>
                      <c:pt idx="475">
                        <c:v>961</c:v>
                      </c:pt>
                      <c:pt idx="476">
                        <c:v>964</c:v>
                      </c:pt>
                      <c:pt idx="477">
                        <c:v>965</c:v>
                      </c:pt>
                      <c:pt idx="478">
                        <c:v>966</c:v>
                      </c:pt>
                      <c:pt idx="479">
                        <c:v>969</c:v>
                      </c:pt>
                      <c:pt idx="480">
                        <c:v>970</c:v>
                      </c:pt>
                      <c:pt idx="481">
                        <c:v>973</c:v>
                      </c:pt>
                      <c:pt idx="482">
                        <c:v>974</c:v>
                      </c:pt>
                      <c:pt idx="483">
                        <c:v>975</c:v>
                      </c:pt>
                      <c:pt idx="484">
                        <c:v>977</c:v>
                      </c:pt>
                      <c:pt idx="485">
                        <c:v>978</c:v>
                      </c:pt>
                      <c:pt idx="486">
                        <c:v>979</c:v>
                      </c:pt>
                      <c:pt idx="487">
                        <c:v>980</c:v>
                      </c:pt>
                      <c:pt idx="488">
                        <c:v>983</c:v>
                      </c:pt>
                      <c:pt idx="489">
                        <c:v>984</c:v>
                      </c:pt>
                      <c:pt idx="490">
                        <c:v>986</c:v>
                      </c:pt>
                      <c:pt idx="491">
                        <c:v>987</c:v>
                      </c:pt>
                      <c:pt idx="492">
                        <c:v>988</c:v>
                      </c:pt>
                      <c:pt idx="493">
                        <c:v>989</c:v>
                      </c:pt>
                      <c:pt idx="494">
                        <c:v>990</c:v>
                      </c:pt>
                      <c:pt idx="495">
                        <c:v>991</c:v>
                      </c:pt>
                      <c:pt idx="496">
                        <c:v>992</c:v>
                      </c:pt>
                      <c:pt idx="497">
                        <c:v>994</c:v>
                      </c:pt>
                      <c:pt idx="498">
                        <c:v>995</c:v>
                      </c:pt>
                      <c:pt idx="499">
                        <c:v>996</c:v>
                      </c:pt>
                      <c:pt idx="500">
                        <c:v>997</c:v>
                      </c:pt>
                      <c:pt idx="501">
                        <c:v>998</c:v>
                      </c:pt>
                      <c:pt idx="502">
                        <c:v>999</c:v>
                      </c:pt>
                      <c:pt idx="503">
                        <c:v>1000</c:v>
                      </c:pt>
                      <c:pt idx="504">
                        <c:v>1001</c:v>
                      </c:pt>
                      <c:pt idx="505">
                        <c:v>1002</c:v>
                      </c:pt>
                      <c:pt idx="506">
                        <c:v>1003</c:v>
                      </c:pt>
                      <c:pt idx="507">
                        <c:v>1004</c:v>
                      </c:pt>
                      <c:pt idx="508">
                        <c:v>1005</c:v>
                      </c:pt>
                      <c:pt idx="509">
                        <c:v>1006</c:v>
                      </c:pt>
                      <c:pt idx="510">
                        <c:v>1008</c:v>
                      </c:pt>
                      <c:pt idx="511">
                        <c:v>1009</c:v>
                      </c:pt>
                      <c:pt idx="512">
                        <c:v>1010</c:v>
                      </c:pt>
                      <c:pt idx="513">
                        <c:v>1011</c:v>
                      </c:pt>
                      <c:pt idx="514">
                        <c:v>1012</c:v>
                      </c:pt>
                      <c:pt idx="515">
                        <c:v>1013</c:v>
                      </c:pt>
                      <c:pt idx="516">
                        <c:v>1015</c:v>
                      </c:pt>
                      <c:pt idx="517">
                        <c:v>1020</c:v>
                      </c:pt>
                      <c:pt idx="518">
                        <c:v>1021</c:v>
                      </c:pt>
                      <c:pt idx="519">
                        <c:v>1022</c:v>
                      </c:pt>
                      <c:pt idx="520">
                        <c:v>1023</c:v>
                      </c:pt>
                      <c:pt idx="521">
                        <c:v>1024</c:v>
                      </c:pt>
                      <c:pt idx="522">
                        <c:v>1025</c:v>
                      </c:pt>
                      <c:pt idx="523">
                        <c:v>1027</c:v>
                      </c:pt>
                      <c:pt idx="524">
                        <c:v>1031</c:v>
                      </c:pt>
                      <c:pt idx="525">
                        <c:v>1032</c:v>
                      </c:pt>
                      <c:pt idx="526">
                        <c:v>1033</c:v>
                      </c:pt>
                      <c:pt idx="527">
                        <c:v>1034</c:v>
                      </c:pt>
                      <c:pt idx="528">
                        <c:v>1035</c:v>
                      </c:pt>
                      <c:pt idx="529">
                        <c:v>1037</c:v>
                      </c:pt>
                      <c:pt idx="530">
                        <c:v>1039</c:v>
                      </c:pt>
                      <c:pt idx="531">
                        <c:v>1040</c:v>
                      </c:pt>
                      <c:pt idx="532">
                        <c:v>1041</c:v>
                      </c:pt>
                      <c:pt idx="533">
                        <c:v>1043</c:v>
                      </c:pt>
                      <c:pt idx="534">
                        <c:v>1044</c:v>
                      </c:pt>
                      <c:pt idx="535">
                        <c:v>1045</c:v>
                      </c:pt>
                      <c:pt idx="536">
                        <c:v>1046</c:v>
                      </c:pt>
                      <c:pt idx="537">
                        <c:v>1047</c:v>
                      </c:pt>
                      <c:pt idx="538">
                        <c:v>1048</c:v>
                      </c:pt>
                      <c:pt idx="539">
                        <c:v>1049</c:v>
                      </c:pt>
                      <c:pt idx="540">
                        <c:v>1050</c:v>
                      </c:pt>
                      <c:pt idx="541">
                        <c:v>1051</c:v>
                      </c:pt>
                      <c:pt idx="542">
                        <c:v>1052</c:v>
                      </c:pt>
                      <c:pt idx="543">
                        <c:v>1053</c:v>
                      </c:pt>
                      <c:pt idx="544">
                        <c:v>1054</c:v>
                      </c:pt>
                      <c:pt idx="545">
                        <c:v>1055</c:v>
                      </c:pt>
                      <c:pt idx="546">
                        <c:v>1057</c:v>
                      </c:pt>
                      <c:pt idx="547">
                        <c:v>1059</c:v>
                      </c:pt>
                      <c:pt idx="548">
                        <c:v>1060</c:v>
                      </c:pt>
                      <c:pt idx="549">
                        <c:v>1061</c:v>
                      </c:pt>
                      <c:pt idx="550">
                        <c:v>1062</c:v>
                      </c:pt>
                      <c:pt idx="551">
                        <c:v>1063</c:v>
                      </c:pt>
                      <c:pt idx="552">
                        <c:v>1064</c:v>
                      </c:pt>
                      <c:pt idx="553">
                        <c:v>1065</c:v>
                      </c:pt>
                      <c:pt idx="554">
                        <c:v>1066</c:v>
                      </c:pt>
                      <c:pt idx="555">
                        <c:v>1067</c:v>
                      </c:pt>
                      <c:pt idx="556">
                        <c:v>1068</c:v>
                      </c:pt>
                      <c:pt idx="557">
                        <c:v>1069</c:v>
                      </c:pt>
                      <c:pt idx="558">
                        <c:v>1070</c:v>
                      </c:pt>
                      <c:pt idx="559">
                        <c:v>1072</c:v>
                      </c:pt>
                      <c:pt idx="560">
                        <c:v>1073</c:v>
                      </c:pt>
                      <c:pt idx="561">
                        <c:v>1074</c:v>
                      </c:pt>
                      <c:pt idx="562">
                        <c:v>1077</c:v>
                      </c:pt>
                      <c:pt idx="563">
                        <c:v>1080</c:v>
                      </c:pt>
                      <c:pt idx="564">
                        <c:v>1081</c:v>
                      </c:pt>
                      <c:pt idx="565">
                        <c:v>1082</c:v>
                      </c:pt>
                      <c:pt idx="566">
                        <c:v>1083</c:v>
                      </c:pt>
                      <c:pt idx="567">
                        <c:v>1084</c:v>
                      </c:pt>
                      <c:pt idx="568">
                        <c:v>1085</c:v>
                      </c:pt>
                      <c:pt idx="569">
                        <c:v>1090</c:v>
                      </c:pt>
                      <c:pt idx="570">
                        <c:v>1091</c:v>
                      </c:pt>
                      <c:pt idx="571">
                        <c:v>1092</c:v>
                      </c:pt>
                      <c:pt idx="572">
                        <c:v>1093</c:v>
                      </c:pt>
                      <c:pt idx="573">
                        <c:v>1094</c:v>
                      </c:pt>
                      <c:pt idx="574">
                        <c:v>1099</c:v>
                      </c:pt>
                      <c:pt idx="575">
                        <c:v>1100</c:v>
                      </c:pt>
                      <c:pt idx="576">
                        <c:v>1101</c:v>
                      </c:pt>
                      <c:pt idx="577">
                        <c:v>1102</c:v>
                      </c:pt>
                      <c:pt idx="578">
                        <c:v>1103</c:v>
                      </c:pt>
                      <c:pt idx="579">
                        <c:v>1104</c:v>
                      </c:pt>
                      <c:pt idx="580">
                        <c:v>1105</c:v>
                      </c:pt>
                      <c:pt idx="581">
                        <c:v>1106</c:v>
                      </c:pt>
                      <c:pt idx="582">
                        <c:v>1107</c:v>
                      </c:pt>
                      <c:pt idx="583">
                        <c:v>1108</c:v>
                      </c:pt>
                      <c:pt idx="584">
                        <c:v>1110</c:v>
                      </c:pt>
                      <c:pt idx="585">
                        <c:v>1111</c:v>
                      </c:pt>
                      <c:pt idx="586">
                        <c:v>1112</c:v>
                      </c:pt>
                      <c:pt idx="587">
                        <c:v>1113</c:v>
                      </c:pt>
                      <c:pt idx="588">
                        <c:v>1114</c:v>
                      </c:pt>
                      <c:pt idx="589">
                        <c:v>1115</c:v>
                      </c:pt>
                      <c:pt idx="590">
                        <c:v>1116</c:v>
                      </c:pt>
                      <c:pt idx="591">
                        <c:v>1118</c:v>
                      </c:pt>
                      <c:pt idx="592">
                        <c:v>1119</c:v>
                      </c:pt>
                      <c:pt idx="593">
                        <c:v>1120</c:v>
                      </c:pt>
                      <c:pt idx="594">
                        <c:v>1121</c:v>
                      </c:pt>
                      <c:pt idx="595">
                        <c:v>1122</c:v>
                      </c:pt>
                      <c:pt idx="596">
                        <c:v>1123</c:v>
                      </c:pt>
                      <c:pt idx="597">
                        <c:v>1124</c:v>
                      </c:pt>
                      <c:pt idx="598">
                        <c:v>1130</c:v>
                      </c:pt>
                      <c:pt idx="599">
                        <c:v>1131</c:v>
                      </c:pt>
                      <c:pt idx="600">
                        <c:v>1132</c:v>
                      </c:pt>
                      <c:pt idx="601">
                        <c:v>1133</c:v>
                      </c:pt>
                      <c:pt idx="602">
                        <c:v>1134</c:v>
                      </c:pt>
                      <c:pt idx="603">
                        <c:v>1135</c:v>
                      </c:pt>
                      <c:pt idx="604">
                        <c:v>1136</c:v>
                      </c:pt>
                      <c:pt idx="605">
                        <c:v>1137</c:v>
                      </c:pt>
                      <c:pt idx="606">
                        <c:v>1138</c:v>
                      </c:pt>
                      <c:pt idx="607">
                        <c:v>1139</c:v>
                      </c:pt>
                      <c:pt idx="608">
                        <c:v>1140</c:v>
                      </c:pt>
                      <c:pt idx="609">
                        <c:v>1141</c:v>
                      </c:pt>
                      <c:pt idx="610">
                        <c:v>1142</c:v>
                      </c:pt>
                      <c:pt idx="611">
                        <c:v>1143</c:v>
                      </c:pt>
                      <c:pt idx="612">
                        <c:v>1145</c:v>
                      </c:pt>
                      <c:pt idx="613">
                        <c:v>1146</c:v>
                      </c:pt>
                      <c:pt idx="614">
                        <c:v>1147</c:v>
                      </c:pt>
                      <c:pt idx="615">
                        <c:v>1148</c:v>
                      </c:pt>
                      <c:pt idx="616">
                        <c:v>1149</c:v>
                      </c:pt>
                      <c:pt idx="617">
                        <c:v>1150</c:v>
                      </c:pt>
                      <c:pt idx="618">
                        <c:v>1151</c:v>
                      </c:pt>
                      <c:pt idx="619">
                        <c:v>1153</c:v>
                      </c:pt>
                      <c:pt idx="620">
                        <c:v>1154</c:v>
                      </c:pt>
                      <c:pt idx="621">
                        <c:v>1155</c:v>
                      </c:pt>
                      <c:pt idx="622">
                        <c:v>1156</c:v>
                      </c:pt>
                      <c:pt idx="623">
                        <c:v>1157</c:v>
                      </c:pt>
                      <c:pt idx="624">
                        <c:v>1158</c:v>
                      </c:pt>
                      <c:pt idx="625">
                        <c:v>1159</c:v>
                      </c:pt>
                      <c:pt idx="626">
                        <c:v>1160</c:v>
                      </c:pt>
                      <c:pt idx="627">
                        <c:v>1161</c:v>
                      </c:pt>
                      <c:pt idx="628">
                        <c:v>1162</c:v>
                      </c:pt>
                      <c:pt idx="629">
                        <c:v>1165</c:v>
                      </c:pt>
                      <c:pt idx="630">
                        <c:v>1166</c:v>
                      </c:pt>
                      <c:pt idx="631">
                        <c:v>1167</c:v>
                      </c:pt>
                      <c:pt idx="632">
                        <c:v>1168</c:v>
                      </c:pt>
                      <c:pt idx="633">
                        <c:v>1169</c:v>
                      </c:pt>
                      <c:pt idx="634">
                        <c:v>1170</c:v>
                      </c:pt>
                      <c:pt idx="635">
                        <c:v>1173</c:v>
                      </c:pt>
                      <c:pt idx="636">
                        <c:v>1174</c:v>
                      </c:pt>
                      <c:pt idx="637">
                        <c:v>1175</c:v>
                      </c:pt>
                      <c:pt idx="638">
                        <c:v>1180</c:v>
                      </c:pt>
                      <c:pt idx="639">
                        <c:v>1181</c:v>
                      </c:pt>
                      <c:pt idx="640">
                        <c:v>1182</c:v>
                      </c:pt>
                      <c:pt idx="641">
                        <c:v>1183</c:v>
                      </c:pt>
                      <c:pt idx="642">
                        <c:v>1184</c:v>
                      </c:pt>
                      <c:pt idx="643">
                        <c:v>1185</c:v>
                      </c:pt>
                      <c:pt idx="644">
                        <c:v>1186</c:v>
                      </c:pt>
                      <c:pt idx="645">
                        <c:v>1187</c:v>
                      </c:pt>
                      <c:pt idx="646">
                        <c:v>1188</c:v>
                      </c:pt>
                      <c:pt idx="647">
                        <c:v>1189</c:v>
                      </c:pt>
                      <c:pt idx="648">
                        <c:v>1190</c:v>
                      </c:pt>
                      <c:pt idx="649">
                        <c:v>1192</c:v>
                      </c:pt>
                      <c:pt idx="650">
                        <c:v>1193</c:v>
                      </c:pt>
                      <c:pt idx="651">
                        <c:v>1194</c:v>
                      </c:pt>
                      <c:pt idx="652">
                        <c:v>1195</c:v>
                      </c:pt>
                      <c:pt idx="653">
                        <c:v>1197</c:v>
                      </c:pt>
                      <c:pt idx="654">
                        <c:v>1198</c:v>
                      </c:pt>
                      <c:pt idx="655">
                        <c:v>1199</c:v>
                      </c:pt>
                      <c:pt idx="656">
                        <c:v>1200</c:v>
                      </c:pt>
                      <c:pt idx="657">
                        <c:v>1201</c:v>
                      </c:pt>
                      <c:pt idx="658">
                        <c:v>1203</c:v>
                      </c:pt>
                      <c:pt idx="659">
                        <c:v>1204</c:v>
                      </c:pt>
                      <c:pt idx="660">
                        <c:v>1205</c:v>
                      </c:pt>
                      <c:pt idx="661">
                        <c:v>1208</c:v>
                      </c:pt>
                      <c:pt idx="662">
                        <c:v>1209</c:v>
                      </c:pt>
                      <c:pt idx="663">
                        <c:v>1210</c:v>
                      </c:pt>
                      <c:pt idx="664">
                        <c:v>1214</c:v>
                      </c:pt>
                      <c:pt idx="665">
                        <c:v>1215</c:v>
                      </c:pt>
                      <c:pt idx="666">
                        <c:v>1216</c:v>
                      </c:pt>
                      <c:pt idx="667">
                        <c:v>1217</c:v>
                      </c:pt>
                      <c:pt idx="668">
                        <c:v>1220</c:v>
                      </c:pt>
                      <c:pt idx="669">
                        <c:v>1221</c:v>
                      </c:pt>
                      <c:pt idx="670">
                        <c:v>1225</c:v>
                      </c:pt>
                      <c:pt idx="671">
                        <c:v>1229</c:v>
                      </c:pt>
                      <c:pt idx="672">
                        <c:v>1231</c:v>
                      </c:pt>
                      <c:pt idx="673">
                        <c:v>1232</c:v>
                      </c:pt>
                      <c:pt idx="674">
                        <c:v>1242</c:v>
                      </c:pt>
                      <c:pt idx="675">
                        <c:v>1253</c:v>
                      </c:pt>
                      <c:pt idx="676">
                        <c:v>1255</c:v>
                      </c:pt>
                      <c:pt idx="677">
                        <c:v>1256</c:v>
                      </c:pt>
                      <c:pt idx="678">
                        <c:v>1258</c:v>
                      </c:pt>
                      <c:pt idx="679">
                        <c:v>1259</c:v>
                      </c:pt>
                      <c:pt idx="680">
                        <c:v>1260</c:v>
                      </c:pt>
                      <c:pt idx="681">
                        <c:v>1261</c:v>
                      </c:pt>
                      <c:pt idx="682">
                        <c:v>1262</c:v>
                      </c:pt>
                      <c:pt idx="683">
                        <c:v>1263</c:v>
                      </c:pt>
                      <c:pt idx="684">
                        <c:v>1264</c:v>
                      </c:pt>
                      <c:pt idx="685">
                        <c:v>1266</c:v>
                      </c:pt>
                      <c:pt idx="686">
                        <c:v>1269</c:v>
                      </c:pt>
                      <c:pt idx="687">
                        <c:v>1279</c:v>
                      </c:pt>
                      <c:pt idx="688">
                        <c:v>1280</c:v>
                      </c:pt>
                      <c:pt idx="689">
                        <c:v>1290</c:v>
                      </c:pt>
                      <c:pt idx="690">
                        <c:v>1291</c:v>
                      </c:pt>
                      <c:pt idx="691">
                        <c:v>1292</c:v>
                      </c:pt>
                      <c:pt idx="692">
                        <c:v>1293</c:v>
                      </c:pt>
                      <c:pt idx="693">
                        <c:v>1294</c:v>
                      </c:pt>
                      <c:pt idx="694">
                        <c:v>1295</c:v>
                      </c:pt>
                      <c:pt idx="695">
                        <c:v>1300</c:v>
                      </c:pt>
                      <c:pt idx="696">
                        <c:v>1301</c:v>
                      </c:pt>
                      <c:pt idx="697">
                        <c:v>1302</c:v>
                      </c:pt>
                      <c:pt idx="698">
                        <c:v>1303</c:v>
                      </c:pt>
                      <c:pt idx="699">
                        <c:v>1305</c:v>
                      </c:pt>
                      <c:pt idx="700">
                        <c:v>1306</c:v>
                      </c:pt>
                      <c:pt idx="701">
                        <c:v>1307</c:v>
                      </c:pt>
                      <c:pt idx="702">
                        <c:v>1308</c:v>
                      </c:pt>
                      <c:pt idx="703">
                        <c:v>1310</c:v>
                      </c:pt>
                      <c:pt idx="704">
                        <c:v>1311</c:v>
                      </c:pt>
                      <c:pt idx="705">
                        <c:v>1312</c:v>
                      </c:pt>
                      <c:pt idx="706">
                        <c:v>1313</c:v>
                      </c:pt>
                      <c:pt idx="707">
                        <c:v>1314</c:v>
                      </c:pt>
                      <c:pt idx="708">
                        <c:v>1315</c:v>
                      </c:pt>
                      <c:pt idx="709">
                        <c:v>1316</c:v>
                      </c:pt>
                      <c:pt idx="710">
                        <c:v>1317</c:v>
                      </c:pt>
                      <c:pt idx="711">
                        <c:v>1318</c:v>
                      </c:pt>
                      <c:pt idx="712">
                        <c:v>1319</c:v>
                      </c:pt>
                      <c:pt idx="713">
                        <c:v>1320</c:v>
                      </c:pt>
                      <c:pt idx="714">
                        <c:v>1322</c:v>
                      </c:pt>
                      <c:pt idx="715">
                        <c:v>1323</c:v>
                      </c:pt>
                      <c:pt idx="716">
                        <c:v>1324</c:v>
                      </c:pt>
                      <c:pt idx="717">
                        <c:v>1325</c:v>
                      </c:pt>
                      <c:pt idx="718">
                        <c:v>1326</c:v>
                      </c:pt>
                      <c:pt idx="719">
                        <c:v>1327</c:v>
                      </c:pt>
                      <c:pt idx="720">
                        <c:v>1328</c:v>
                      </c:pt>
                      <c:pt idx="721">
                        <c:v>1329</c:v>
                      </c:pt>
                      <c:pt idx="722">
                        <c:v>1331</c:v>
                      </c:pt>
                      <c:pt idx="723">
                        <c:v>1333</c:v>
                      </c:pt>
                      <c:pt idx="724">
                        <c:v>1337</c:v>
                      </c:pt>
                      <c:pt idx="725">
                        <c:v>1338</c:v>
                      </c:pt>
                      <c:pt idx="726">
                        <c:v>1339</c:v>
                      </c:pt>
                      <c:pt idx="727">
                        <c:v>1342</c:v>
                      </c:pt>
                      <c:pt idx="728">
                        <c:v>1343</c:v>
                      </c:pt>
                      <c:pt idx="729">
                        <c:v>1344</c:v>
                      </c:pt>
                      <c:pt idx="730">
                        <c:v>1345</c:v>
                      </c:pt>
                      <c:pt idx="731">
                        <c:v>1346</c:v>
                      </c:pt>
                      <c:pt idx="732">
                        <c:v>1348</c:v>
                      </c:pt>
                      <c:pt idx="733">
                        <c:v>1349</c:v>
                      </c:pt>
                      <c:pt idx="734">
                        <c:v>1353</c:v>
                      </c:pt>
                      <c:pt idx="735">
                        <c:v>1355</c:v>
                      </c:pt>
                      <c:pt idx="736">
                        <c:v>1360</c:v>
                      </c:pt>
                      <c:pt idx="737">
                        <c:v>1361</c:v>
                      </c:pt>
                      <c:pt idx="738">
                        <c:v>1363</c:v>
                      </c:pt>
                      <c:pt idx="739">
                        <c:v>1364</c:v>
                      </c:pt>
                      <c:pt idx="740">
                        <c:v>1365</c:v>
                      </c:pt>
                      <c:pt idx="741">
                        <c:v>1366</c:v>
                      </c:pt>
                      <c:pt idx="742">
                        <c:v>1367</c:v>
                      </c:pt>
                      <c:pt idx="743">
                        <c:v>1369</c:v>
                      </c:pt>
                      <c:pt idx="744">
                        <c:v>1372</c:v>
                      </c:pt>
                      <c:pt idx="745">
                        <c:v>1373</c:v>
                      </c:pt>
                      <c:pt idx="746">
                        <c:v>1374</c:v>
                      </c:pt>
                      <c:pt idx="747">
                        <c:v>1375</c:v>
                      </c:pt>
                      <c:pt idx="748">
                        <c:v>1376</c:v>
                      </c:pt>
                      <c:pt idx="749">
                        <c:v>1377</c:v>
                      </c:pt>
                      <c:pt idx="750">
                        <c:v>1378</c:v>
                      </c:pt>
                      <c:pt idx="751">
                        <c:v>1379</c:v>
                      </c:pt>
                      <c:pt idx="752">
                        <c:v>1380</c:v>
                      </c:pt>
                      <c:pt idx="753">
                        <c:v>1381</c:v>
                      </c:pt>
                      <c:pt idx="754">
                        <c:v>1383</c:v>
                      </c:pt>
                      <c:pt idx="755">
                        <c:v>1384</c:v>
                      </c:pt>
                      <c:pt idx="756">
                        <c:v>1385</c:v>
                      </c:pt>
                      <c:pt idx="757">
                        <c:v>1386</c:v>
                      </c:pt>
                      <c:pt idx="758">
                        <c:v>1390</c:v>
                      </c:pt>
                      <c:pt idx="759">
                        <c:v>1391</c:v>
                      </c:pt>
                      <c:pt idx="760">
                        <c:v>1392</c:v>
                      </c:pt>
                      <c:pt idx="761">
                        <c:v>1393</c:v>
                      </c:pt>
                      <c:pt idx="762">
                        <c:v>1394</c:v>
                      </c:pt>
                      <c:pt idx="763">
                        <c:v>1395</c:v>
                      </c:pt>
                      <c:pt idx="764">
                        <c:v>1396</c:v>
                      </c:pt>
                      <c:pt idx="765">
                        <c:v>1397</c:v>
                      </c:pt>
                      <c:pt idx="766">
                        <c:v>1398</c:v>
                      </c:pt>
                      <c:pt idx="767">
                        <c:v>1400</c:v>
                      </c:pt>
                      <c:pt idx="768">
                        <c:v>1401</c:v>
                      </c:pt>
                      <c:pt idx="769">
                        <c:v>1402</c:v>
                      </c:pt>
                      <c:pt idx="770">
                        <c:v>1403</c:v>
                      </c:pt>
                      <c:pt idx="771">
                        <c:v>1405</c:v>
                      </c:pt>
                      <c:pt idx="772">
                        <c:v>1407</c:v>
                      </c:pt>
                      <c:pt idx="773">
                        <c:v>1408</c:v>
                      </c:pt>
                      <c:pt idx="774">
                        <c:v>1410</c:v>
                      </c:pt>
                      <c:pt idx="775">
                        <c:v>1411</c:v>
                      </c:pt>
                      <c:pt idx="776">
                        <c:v>1412</c:v>
                      </c:pt>
                      <c:pt idx="777">
                        <c:v>1413</c:v>
                      </c:pt>
                      <c:pt idx="778">
                        <c:v>1414</c:v>
                      </c:pt>
                      <c:pt idx="779">
                        <c:v>1415</c:v>
                      </c:pt>
                      <c:pt idx="780">
                        <c:v>1416</c:v>
                      </c:pt>
                      <c:pt idx="781">
                        <c:v>1417</c:v>
                      </c:pt>
                      <c:pt idx="782">
                        <c:v>1418</c:v>
                      </c:pt>
                      <c:pt idx="783">
                        <c:v>1419</c:v>
                      </c:pt>
                      <c:pt idx="784">
                        <c:v>1420</c:v>
                      </c:pt>
                      <c:pt idx="785">
                        <c:v>1421</c:v>
                      </c:pt>
                      <c:pt idx="786">
                        <c:v>1423</c:v>
                      </c:pt>
                      <c:pt idx="787">
                        <c:v>1424</c:v>
                      </c:pt>
                      <c:pt idx="788">
                        <c:v>1425</c:v>
                      </c:pt>
                      <c:pt idx="789">
                        <c:v>1426</c:v>
                      </c:pt>
                      <c:pt idx="790">
                        <c:v>1427</c:v>
                      </c:pt>
                      <c:pt idx="791">
                        <c:v>1428</c:v>
                      </c:pt>
                      <c:pt idx="792">
                        <c:v>1429</c:v>
                      </c:pt>
                      <c:pt idx="793">
                        <c:v>1430</c:v>
                      </c:pt>
                      <c:pt idx="794">
                        <c:v>1432</c:v>
                      </c:pt>
                      <c:pt idx="795">
                        <c:v>1434</c:v>
                      </c:pt>
                      <c:pt idx="796">
                        <c:v>1435</c:v>
                      </c:pt>
                      <c:pt idx="797">
                        <c:v>1436</c:v>
                      </c:pt>
                      <c:pt idx="798">
                        <c:v>1437</c:v>
                      </c:pt>
                      <c:pt idx="799">
                        <c:v>1439</c:v>
                      </c:pt>
                      <c:pt idx="800">
                        <c:v>1440</c:v>
                      </c:pt>
                      <c:pt idx="801">
                        <c:v>1442</c:v>
                      </c:pt>
                      <c:pt idx="802">
                        <c:v>1443</c:v>
                      </c:pt>
                      <c:pt idx="803">
                        <c:v>1444</c:v>
                      </c:pt>
                      <c:pt idx="804">
                        <c:v>1445</c:v>
                      </c:pt>
                      <c:pt idx="805">
                        <c:v>1446</c:v>
                      </c:pt>
                      <c:pt idx="806">
                        <c:v>1447</c:v>
                      </c:pt>
                      <c:pt idx="807">
                        <c:v>1448</c:v>
                      </c:pt>
                      <c:pt idx="808">
                        <c:v>1449</c:v>
                      </c:pt>
                      <c:pt idx="809">
                        <c:v>1450</c:v>
                      </c:pt>
                      <c:pt idx="810">
                        <c:v>1451</c:v>
                      </c:pt>
                      <c:pt idx="811">
                        <c:v>1453</c:v>
                      </c:pt>
                      <c:pt idx="812">
                        <c:v>1454</c:v>
                      </c:pt>
                      <c:pt idx="813">
                        <c:v>1455</c:v>
                      </c:pt>
                      <c:pt idx="814">
                        <c:v>1456</c:v>
                      </c:pt>
                      <c:pt idx="815">
                        <c:v>1457</c:v>
                      </c:pt>
                      <c:pt idx="816">
                        <c:v>1458</c:v>
                      </c:pt>
                      <c:pt idx="817">
                        <c:v>1459</c:v>
                      </c:pt>
                      <c:pt idx="818">
                        <c:v>1460</c:v>
                      </c:pt>
                      <c:pt idx="819">
                        <c:v>1461</c:v>
                      </c:pt>
                      <c:pt idx="820">
                        <c:v>1462</c:v>
                      </c:pt>
                      <c:pt idx="821">
                        <c:v>1463</c:v>
                      </c:pt>
                      <c:pt idx="822">
                        <c:v>1464</c:v>
                      </c:pt>
                      <c:pt idx="823">
                        <c:v>1465</c:v>
                      </c:pt>
                      <c:pt idx="824">
                        <c:v>1466</c:v>
                      </c:pt>
                      <c:pt idx="825">
                        <c:v>1467</c:v>
                      </c:pt>
                      <c:pt idx="826">
                        <c:v>1468</c:v>
                      </c:pt>
                      <c:pt idx="827">
                        <c:v>1469</c:v>
                      </c:pt>
                      <c:pt idx="828">
                        <c:v>1470</c:v>
                      </c:pt>
                      <c:pt idx="829">
                        <c:v>1471</c:v>
                      </c:pt>
                      <c:pt idx="830">
                        <c:v>1472</c:v>
                      </c:pt>
                      <c:pt idx="831">
                        <c:v>1473</c:v>
                      </c:pt>
                      <c:pt idx="832">
                        <c:v>1474</c:v>
                      </c:pt>
                      <c:pt idx="833">
                        <c:v>1475</c:v>
                      </c:pt>
                      <c:pt idx="834">
                        <c:v>1476</c:v>
                      </c:pt>
                      <c:pt idx="835">
                        <c:v>1477</c:v>
                      </c:pt>
                      <c:pt idx="836">
                        <c:v>1478</c:v>
                      </c:pt>
                      <c:pt idx="837">
                        <c:v>1479</c:v>
                      </c:pt>
                      <c:pt idx="838">
                        <c:v>1480</c:v>
                      </c:pt>
                      <c:pt idx="839">
                        <c:v>1481</c:v>
                      </c:pt>
                      <c:pt idx="840">
                        <c:v>1482</c:v>
                      </c:pt>
                      <c:pt idx="841">
                        <c:v>1483</c:v>
                      </c:pt>
                      <c:pt idx="842">
                        <c:v>1484</c:v>
                      </c:pt>
                      <c:pt idx="843">
                        <c:v>1485</c:v>
                      </c:pt>
                      <c:pt idx="844">
                        <c:v>1486</c:v>
                      </c:pt>
                      <c:pt idx="845">
                        <c:v>1487</c:v>
                      </c:pt>
                      <c:pt idx="846">
                        <c:v>1488</c:v>
                      </c:pt>
                      <c:pt idx="847">
                        <c:v>1489</c:v>
                      </c:pt>
                      <c:pt idx="848">
                        <c:v>1490</c:v>
                      </c:pt>
                      <c:pt idx="849">
                        <c:v>1491</c:v>
                      </c:pt>
                      <c:pt idx="850">
                        <c:v>1492</c:v>
                      </c:pt>
                      <c:pt idx="851">
                        <c:v>1493</c:v>
                      </c:pt>
                      <c:pt idx="852">
                        <c:v>1494</c:v>
                      </c:pt>
                      <c:pt idx="853">
                        <c:v>1495</c:v>
                      </c:pt>
                      <c:pt idx="854">
                        <c:v>1496</c:v>
                      </c:pt>
                      <c:pt idx="855">
                        <c:v>1497</c:v>
                      </c:pt>
                      <c:pt idx="856">
                        <c:v>1498</c:v>
                      </c:pt>
                      <c:pt idx="857">
                        <c:v>1499</c:v>
                      </c:pt>
                      <c:pt idx="858">
                        <c:v>1500</c:v>
                      </c:pt>
                      <c:pt idx="859">
                        <c:v>1501</c:v>
                      </c:pt>
                      <c:pt idx="860">
                        <c:v>1502</c:v>
                      </c:pt>
                      <c:pt idx="861">
                        <c:v>1503</c:v>
                      </c:pt>
                      <c:pt idx="862">
                        <c:v>1504</c:v>
                      </c:pt>
                      <c:pt idx="863">
                        <c:v>1505</c:v>
                      </c:pt>
                      <c:pt idx="864">
                        <c:v>1506</c:v>
                      </c:pt>
                      <c:pt idx="865">
                        <c:v>1507</c:v>
                      </c:pt>
                      <c:pt idx="866">
                        <c:v>1509</c:v>
                      </c:pt>
                      <c:pt idx="867">
                        <c:v>1510</c:v>
                      </c:pt>
                      <c:pt idx="868">
                        <c:v>1511</c:v>
                      </c:pt>
                      <c:pt idx="869">
                        <c:v>1512</c:v>
                      </c:pt>
                      <c:pt idx="870">
                        <c:v>1514</c:v>
                      </c:pt>
                      <c:pt idx="871">
                        <c:v>1515</c:v>
                      </c:pt>
                      <c:pt idx="872">
                        <c:v>1516</c:v>
                      </c:pt>
                      <c:pt idx="873">
                        <c:v>1517</c:v>
                      </c:pt>
                      <c:pt idx="874">
                        <c:v>1518</c:v>
                      </c:pt>
                      <c:pt idx="875">
                        <c:v>1519</c:v>
                      </c:pt>
                      <c:pt idx="876">
                        <c:v>1520</c:v>
                      </c:pt>
                      <c:pt idx="877">
                        <c:v>1521</c:v>
                      </c:pt>
                      <c:pt idx="878">
                        <c:v>1522</c:v>
                      </c:pt>
                      <c:pt idx="879">
                        <c:v>1523</c:v>
                      </c:pt>
                      <c:pt idx="880">
                        <c:v>1524</c:v>
                      </c:pt>
                      <c:pt idx="881">
                        <c:v>1525</c:v>
                      </c:pt>
                      <c:pt idx="882">
                        <c:v>1526</c:v>
                      </c:pt>
                      <c:pt idx="883">
                        <c:v>1527</c:v>
                      </c:pt>
                      <c:pt idx="884">
                        <c:v>1528</c:v>
                      </c:pt>
                      <c:pt idx="885">
                        <c:v>1529</c:v>
                      </c:pt>
                      <c:pt idx="886">
                        <c:v>1530</c:v>
                      </c:pt>
                      <c:pt idx="887">
                        <c:v>1531</c:v>
                      </c:pt>
                      <c:pt idx="888">
                        <c:v>1532</c:v>
                      </c:pt>
                      <c:pt idx="889">
                        <c:v>1533</c:v>
                      </c:pt>
                      <c:pt idx="890">
                        <c:v>1534</c:v>
                      </c:pt>
                      <c:pt idx="891">
                        <c:v>1535</c:v>
                      </c:pt>
                      <c:pt idx="892">
                        <c:v>1536</c:v>
                      </c:pt>
                      <c:pt idx="893">
                        <c:v>1537</c:v>
                      </c:pt>
                      <c:pt idx="894">
                        <c:v>1538</c:v>
                      </c:pt>
                      <c:pt idx="895">
                        <c:v>1539</c:v>
                      </c:pt>
                      <c:pt idx="896">
                        <c:v>1540</c:v>
                      </c:pt>
                      <c:pt idx="897">
                        <c:v>1541</c:v>
                      </c:pt>
                      <c:pt idx="898">
                        <c:v>1542</c:v>
                      </c:pt>
                      <c:pt idx="899">
                        <c:v>1543</c:v>
                      </c:pt>
                      <c:pt idx="900">
                        <c:v>1544</c:v>
                      </c:pt>
                      <c:pt idx="901">
                        <c:v>1545</c:v>
                      </c:pt>
                      <c:pt idx="902">
                        <c:v>1546</c:v>
                      </c:pt>
                      <c:pt idx="903">
                        <c:v>1547</c:v>
                      </c:pt>
                      <c:pt idx="904">
                        <c:v>1548</c:v>
                      </c:pt>
                      <c:pt idx="905">
                        <c:v>1549</c:v>
                      </c:pt>
                      <c:pt idx="906">
                        <c:v>1550</c:v>
                      </c:pt>
                      <c:pt idx="907">
                        <c:v>1551</c:v>
                      </c:pt>
                      <c:pt idx="908">
                        <c:v>1552</c:v>
                      </c:pt>
                      <c:pt idx="909">
                        <c:v>1553</c:v>
                      </c:pt>
                      <c:pt idx="910">
                        <c:v>1554</c:v>
                      </c:pt>
                      <c:pt idx="911">
                        <c:v>1555</c:v>
                      </c:pt>
                      <c:pt idx="912">
                        <c:v>1556</c:v>
                      </c:pt>
                      <c:pt idx="913">
                        <c:v>1557</c:v>
                      </c:pt>
                      <c:pt idx="914">
                        <c:v>1558</c:v>
                      </c:pt>
                      <c:pt idx="915">
                        <c:v>1559</c:v>
                      </c:pt>
                      <c:pt idx="916">
                        <c:v>1560</c:v>
                      </c:pt>
                      <c:pt idx="917">
                        <c:v>1561</c:v>
                      </c:pt>
                      <c:pt idx="918">
                        <c:v>1562</c:v>
                      </c:pt>
                      <c:pt idx="919">
                        <c:v>1563</c:v>
                      </c:pt>
                      <c:pt idx="920">
                        <c:v>1564</c:v>
                      </c:pt>
                      <c:pt idx="921">
                        <c:v>1565</c:v>
                      </c:pt>
                      <c:pt idx="922">
                        <c:v>1566</c:v>
                      </c:pt>
                      <c:pt idx="923">
                        <c:v>1567</c:v>
                      </c:pt>
                      <c:pt idx="924">
                        <c:v>1568</c:v>
                      </c:pt>
                      <c:pt idx="925">
                        <c:v>1569</c:v>
                      </c:pt>
                      <c:pt idx="926">
                        <c:v>1570</c:v>
                      </c:pt>
                      <c:pt idx="927">
                        <c:v>1571</c:v>
                      </c:pt>
                      <c:pt idx="928">
                        <c:v>1572</c:v>
                      </c:pt>
                      <c:pt idx="929">
                        <c:v>1573</c:v>
                      </c:pt>
                      <c:pt idx="930">
                        <c:v>1574</c:v>
                      </c:pt>
                      <c:pt idx="931">
                        <c:v>1575</c:v>
                      </c:pt>
                      <c:pt idx="932">
                        <c:v>1576</c:v>
                      </c:pt>
                      <c:pt idx="933">
                        <c:v>1577</c:v>
                      </c:pt>
                      <c:pt idx="934">
                        <c:v>1578</c:v>
                      </c:pt>
                      <c:pt idx="935">
                        <c:v>1579</c:v>
                      </c:pt>
                      <c:pt idx="936">
                        <c:v>1580</c:v>
                      </c:pt>
                      <c:pt idx="937">
                        <c:v>1582</c:v>
                      </c:pt>
                      <c:pt idx="938">
                        <c:v>1583</c:v>
                      </c:pt>
                      <c:pt idx="939">
                        <c:v>1584</c:v>
                      </c:pt>
                      <c:pt idx="940">
                        <c:v>1585</c:v>
                      </c:pt>
                      <c:pt idx="941">
                        <c:v>1586</c:v>
                      </c:pt>
                      <c:pt idx="942">
                        <c:v>1587</c:v>
                      </c:pt>
                      <c:pt idx="943">
                        <c:v>1588</c:v>
                      </c:pt>
                      <c:pt idx="944">
                        <c:v>1589</c:v>
                      </c:pt>
                      <c:pt idx="945">
                        <c:v>1591</c:v>
                      </c:pt>
                      <c:pt idx="946">
                        <c:v>1592</c:v>
                      </c:pt>
                      <c:pt idx="947">
                        <c:v>1593</c:v>
                      </c:pt>
                      <c:pt idx="948">
                        <c:v>1594</c:v>
                      </c:pt>
                      <c:pt idx="949">
                        <c:v>1595</c:v>
                      </c:pt>
                      <c:pt idx="950">
                        <c:v>1596</c:v>
                      </c:pt>
                      <c:pt idx="951">
                        <c:v>1597</c:v>
                      </c:pt>
                      <c:pt idx="952">
                        <c:v>1598</c:v>
                      </c:pt>
                      <c:pt idx="953">
                        <c:v>1599</c:v>
                      </c:pt>
                      <c:pt idx="954">
                        <c:v>1600</c:v>
                      </c:pt>
                      <c:pt idx="955">
                        <c:v>1601</c:v>
                      </c:pt>
                      <c:pt idx="956">
                        <c:v>1602</c:v>
                      </c:pt>
                      <c:pt idx="957">
                        <c:v>1603</c:v>
                      </c:pt>
                      <c:pt idx="958">
                        <c:v>1604</c:v>
                      </c:pt>
                      <c:pt idx="959">
                        <c:v>1605</c:v>
                      </c:pt>
                      <c:pt idx="960">
                        <c:v>1606</c:v>
                      </c:pt>
                      <c:pt idx="961">
                        <c:v>1607</c:v>
                      </c:pt>
                      <c:pt idx="962">
                        <c:v>1608</c:v>
                      </c:pt>
                      <c:pt idx="963">
                        <c:v>1609</c:v>
                      </c:pt>
                      <c:pt idx="964">
                        <c:v>1610</c:v>
                      </c:pt>
                      <c:pt idx="965">
                        <c:v>1611</c:v>
                      </c:pt>
                      <c:pt idx="966">
                        <c:v>1612</c:v>
                      </c:pt>
                      <c:pt idx="967">
                        <c:v>1613</c:v>
                      </c:pt>
                      <c:pt idx="968">
                        <c:v>1614</c:v>
                      </c:pt>
                      <c:pt idx="969">
                        <c:v>1615</c:v>
                      </c:pt>
                      <c:pt idx="970">
                        <c:v>1616</c:v>
                      </c:pt>
                      <c:pt idx="971">
                        <c:v>1617</c:v>
                      </c:pt>
                      <c:pt idx="972">
                        <c:v>1618</c:v>
                      </c:pt>
                      <c:pt idx="973">
                        <c:v>1619</c:v>
                      </c:pt>
                      <c:pt idx="974">
                        <c:v>1620</c:v>
                      </c:pt>
                      <c:pt idx="975">
                        <c:v>1621</c:v>
                      </c:pt>
                      <c:pt idx="976">
                        <c:v>1622</c:v>
                      </c:pt>
                      <c:pt idx="977">
                        <c:v>1623</c:v>
                      </c:pt>
                      <c:pt idx="978">
                        <c:v>1624</c:v>
                      </c:pt>
                      <c:pt idx="979">
                        <c:v>1625</c:v>
                      </c:pt>
                      <c:pt idx="980">
                        <c:v>1626</c:v>
                      </c:pt>
                      <c:pt idx="981">
                        <c:v>1627</c:v>
                      </c:pt>
                      <c:pt idx="982">
                        <c:v>1628</c:v>
                      </c:pt>
                      <c:pt idx="983">
                        <c:v>1629</c:v>
                      </c:pt>
                      <c:pt idx="984">
                        <c:v>1630</c:v>
                      </c:pt>
                      <c:pt idx="985">
                        <c:v>1631</c:v>
                      </c:pt>
                      <c:pt idx="986">
                        <c:v>1632</c:v>
                      </c:pt>
                      <c:pt idx="987">
                        <c:v>1633</c:v>
                      </c:pt>
                      <c:pt idx="988">
                        <c:v>1634</c:v>
                      </c:pt>
                      <c:pt idx="989">
                        <c:v>1635</c:v>
                      </c:pt>
                      <c:pt idx="990">
                        <c:v>1636</c:v>
                      </c:pt>
                      <c:pt idx="991">
                        <c:v>1637</c:v>
                      </c:pt>
                      <c:pt idx="992">
                        <c:v>1638</c:v>
                      </c:pt>
                      <c:pt idx="993">
                        <c:v>1639</c:v>
                      </c:pt>
                      <c:pt idx="994">
                        <c:v>1640</c:v>
                      </c:pt>
                      <c:pt idx="995">
                        <c:v>1641</c:v>
                      </c:pt>
                      <c:pt idx="996">
                        <c:v>1642</c:v>
                      </c:pt>
                      <c:pt idx="997">
                        <c:v>1643</c:v>
                      </c:pt>
                      <c:pt idx="998">
                        <c:v>1644</c:v>
                      </c:pt>
                      <c:pt idx="999">
                        <c:v>1645</c:v>
                      </c:pt>
                      <c:pt idx="1000">
                        <c:v>1646</c:v>
                      </c:pt>
                      <c:pt idx="1001">
                        <c:v>1647</c:v>
                      </c:pt>
                      <c:pt idx="1002">
                        <c:v>1648</c:v>
                      </c:pt>
                      <c:pt idx="1003">
                        <c:v>1649</c:v>
                      </c:pt>
                      <c:pt idx="1004">
                        <c:v>1650</c:v>
                      </c:pt>
                      <c:pt idx="1005">
                        <c:v>1651</c:v>
                      </c:pt>
                      <c:pt idx="1006">
                        <c:v>1652</c:v>
                      </c:pt>
                      <c:pt idx="1007">
                        <c:v>1653</c:v>
                      </c:pt>
                      <c:pt idx="1008">
                        <c:v>1654</c:v>
                      </c:pt>
                      <c:pt idx="1009">
                        <c:v>1655</c:v>
                      </c:pt>
                      <c:pt idx="1010">
                        <c:v>1656</c:v>
                      </c:pt>
                      <c:pt idx="1011">
                        <c:v>1657</c:v>
                      </c:pt>
                      <c:pt idx="1012">
                        <c:v>1658</c:v>
                      </c:pt>
                      <c:pt idx="1013">
                        <c:v>1659</c:v>
                      </c:pt>
                      <c:pt idx="1014">
                        <c:v>1660</c:v>
                      </c:pt>
                      <c:pt idx="1015">
                        <c:v>1661</c:v>
                      </c:pt>
                      <c:pt idx="1016">
                        <c:v>1663</c:v>
                      </c:pt>
                      <c:pt idx="1017">
                        <c:v>1664</c:v>
                      </c:pt>
                      <c:pt idx="1018">
                        <c:v>1668</c:v>
                      </c:pt>
                      <c:pt idx="1019">
                        <c:v>1669</c:v>
                      </c:pt>
                      <c:pt idx="1020">
                        <c:v>1672</c:v>
                      </c:pt>
                      <c:pt idx="1021">
                        <c:v>1673</c:v>
                      </c:pt>
                      <c:pt idx="1022">
                        <c:v>1674</c:v>
                      </c:pt>
                      <c:pt idx="1023">
                        <c:v>1675</c:v>
                      </c:pt>
                      <c:pt idx="1024">
                        <c:v>1676</c:v>
                      </c:pt>
                      <c:pt idx="1025">
                        <c:v>1677</c:v>
                      </c:pt>
                      <c:pt idx="1026">
                        <c:v>1678</c:v>
                      </c:pt>
                      <c:pt idx="1027">
                        <c:v>1679</c:v>
                      </c:pt>
                      <c:pt idx="1028">
                        <c:v>1680</c:v>
                      </c:pt>
                      <c:pt idx="1029">
                        <c:v>1681</c:v>
                      </c:pt>
                      <c:pt idx="1030">
                        <c:v>1682</c:v>
                      </c:pt>
                      <c:pt idx="1031">
                        <c:v>1683</c:v>
                      </c:pt>
                      <c:pt idx="1032">
                        <c:v>1684</c:v>
                      </c:pt>
                      <c:pt idx="1033">
                        <c:v>1685</c:v>
                      </c:pt>
                      <c:pt idx="1034">
                        <c:v>1686</c:v>
                      </c:pt>
                      <c:pt idx="1035">
                        <c:v>1687</c:v>
                      </c:pt>
                      <c:pt idx="1036">
                        <c:v>1688</c:v>
                      </c:pt>
                      <c:pt idx="1037">
                        <c:v>1689</c:v>
                      </c:pt>
                      <c:pt idx="1038">
                        <c:v>1690</c:v>
                      </c:pt>
                      <c:pt idx="1039">
                        <c:v>1701</c:v>
                      </c:pt>
                      <c:pt idx="1040">
                        <c:v>1704</c:v>
                      </c:pt>
                      <c:pt idx="1041">
                        <c:v>1708</c:v>
                      </c:pt>
                      <c:pt idx="1042">
                        <c:v>1709</c:v>
                      </c:pt>
                      <c:pt idx="1043">
                        <c:v>1710</c:v>
                      </c:pt>
                      <c:pt idx="1044">
                        <c:v>1712</c:v>
                      </c:pt>
                      <c:pt idx="1045">
                        <c:v>1713</c:v>
                      </c:pt>
                      <c:pt idx="1046">
                        <c:v>1714</c:v>
                      </c:pt>
                      <c:pt idx="1047">
                        <c:v>1715</c:v>
                      </c:pt>
                      <c:pt idx="1048">
                        <c:v>1716</c:v>
                      </c:pt>
                      <c:pt idx="1049">
                        <c:v>1717</c:v>
                      </c:pt>
                      <c:pt idx="1050">
                        <c:v>1718</c:v>
                      </c:pt>
                      <c:pt idx="1051">
                        <c:v>1721</c:v>
                      </c:pt>
                      <c:pt idx="1052">
                        <c:v>1722</c:v>
                      </c:pt>
                      <c:pt idx="1053">
                        <c:v>1725</c:v>
                      </c:pt>
                      <c:pt idx="1054">
                        <c:v>1726</c:v>
                      </c:pt>
                      <c:pt idx="1055">
                        <c:v>1732</c:v>
                      </c:pt>
                      <c:pt idx="1056">
                        <c:v>1746</c:v>
                      </c:pt>
                      <c:pt idx="1057">
                        <c:v>1951</c:v>
                      </c:pt>
                    </c:numCache>
                  </c:numRef>
                </c:xVal>
                <c:yVal>
                  <c:numRef>
                    <c:extLst xmlns:c15="http://schemas.microsoft.com/office/drawing/2012/chart">
                      <c:ext xmlns:c15="http://schemas.microsoft.com/office/drawing/2012/chart" uri="{02D57815-91ED-43cb-92C2-25804820EDAC}">
                        <c15:formulaRef>
                          <c15:sqref>'Brachy NFY'!$E$3:$E$1060</c15:sqref>
                        </c15:formulaRef>
                      </c:ext>
                    </c:extLst>
                    <c:numCache>
                      <c:formatCode>General</c:formatCode>
                      <c:ptCount val="1058"/>
                      <c:pt idx="0">
                        <c:v>1</c:v>
                      </c:pt>
                      <c:pt idx="1">
                        <c:v>1</c:v>
                      </c:pt>
                      <c:pt idx="2">
                        <c:v>1</c:v>
                      </c:pt>
                      <c:pt idx="3">
                        <c:v>1</c:v>
                      </c:pt>
                      <c:pt idx="4">
                        <c:v>1</c:v>
                      </c:pt>
                      <c:pt idx="5">
                        <c:v>1</c:v>
                      </c:pt>
                      <c:pt idx="6">
                        <c:v>1</c:v>
                      </c:pt>
                      <c:pt idx="7">
                        <c:v>1</c:v>
                      </c:pt>
                      <c:pt idx="8">
                        <c:v>1</c:v>
                      </c:pt>
                      <c:pt idx="9">
                        <c:v>1</c:v>
                      </c:pt>
                      <c:pt idx="10">
                        <c:v>1</c:v>
                      </c:pt>
                      <c:pt idx="12">
                        <c:v>1</c:v>
                      </c:pt>
                      <c:pt idx="13">
                        <c:v>1</c:v>
                      </c:pt>
                      <c:pt idx="14">
                        <c:v>1</c:v>
                      </c:pt>
                      <c:pt idx="15">
                        <c:v>1</c:v>
                      </c:pt>
                      <c:pt idx="16">
                        <c:v>1</c:v>
                      </c:pt>
                      <c:pt idx="17">
                        <c:v>1</c:v>
                      </c:pt>
                      <c:pt idx="18">
                        <c:v>1</c:v>
                      </c:pt>
                      <c:pt idx="20">
                        <c:v>1</c:v>
                      </c:pt>
                      <c:pt idx="21">
                        <c:v>1</c:v>
                      </c:pt>
                      <c:pt idx="22">
                        <c:v>1</c:v>
                      </c:pt>
                      <c:pt idx="23">
                        <c:v>1</c:v>
                      </c:pt>
                      <c:pt idx="24">
                        <c:v>1</c:v>
                      </c:pt>
                      <c:pt idx="25">
                        <c:v>1</c:v>
                      </c:pt>
                      <c:pt idx="26">
                        <c:v>1</c:v>
                      </c:pt>
                      <c:pt idx="27">
                        <c:v>1</c:v>
                      </c:pt>
                      <c:pt idx="28">
                        <c:v>1</c:v>
                      </c:pt>
                      <c:pt idx="29">
                        <c:v>1</c:v>
                      </c:pt>
                      <c:pt idx="30">
                        <c:v>1</c:v>
                      </c:pt>
                      <c:pt idx="31">
                        <c:v>1</c:v>
                      </c:pt>
                      <c:pt idx="32">
                        <c:v>1</c:v>
                      </c:pt>
                      <c:pt idx="33">
                        <c:v>1</c:v>
                      </c:pt>
                      <c:pt idx="34">
                        <c:v>1</c:v>
                      </c:pt>
                      <c:pt idx="35">
                        <c:v>1</c:v>
                      </c:pt>
                      <c:pt idx="36">
                        <c:v>1</c:v>
                      </c:pt>
                      <c:pt idx="37">
                        <c:v>1</c:v>
                      </c:pt>
                      <c:pt idx="39">
                        <c:v>1</c:v>
                      </c:pt>
                      <c:pt idx="40">
                        <c:v>1</c:v>
                      </c:pt>
                      <c:pt idx="41">
                        <c:v>1</c:v>
                      </c:pt>
                      <c:pt idx="42">
                        <c:v>1</c:v>
                      </c:pt>
                      <c:pt idx="44">
                        <c:v>1</c:v>
                      </c:pt>
                      <c:pt idx="45">
                        <c:v>1</c:v>
                      </c:pt>
                      <c:pt idx="46">
                        <c:v>1</c:v>
                      </c:pt>
                      <c:pt idx="47">
                        <c:v>1</c:v>
                      </c:pt>
                      <c:pt idx="48">
                        <c:v>1</c:v>
                      </c:pt>
                      <c:pt idx="49">
                        <c:v>1</c:v>
                      </c:pt>
                      <c:pt idx="50">
                        <c:v>1</c:v>
                      </c:pt>
                      <c:pt idx="51">
                        <c:v>1</c:v>
                      </c:pt>
                      <c:pt idx="52">
                        <c:v>1</c:v>
                      </c:pt>
                      <c:pt idx="53">
                        <c:v>1</c:v>
                      </c:pt>
                      <c:pt idx="54">
                        <c:v>1</c:v>
                      </c:pt>
                      <c:pt idx="56">
                        <c:v>1</c:v>
                      </c:pt>
                      <c:pt idx="57">
                        <c:v>1</c:v>
                      </c:pt>
                      <c:pt idx="58">
                        <c:v>1</c:v>
                      </c:pt>
                      <c:pt idx="59">
                        <c:v>1</c:v>
                      </c:pt>
                      <c:pt idx="60">
                        <c:v>1</c:v>
                      </c:pt>
                      <c:pt idx="61">
                        <c:v>1</c:v>
                      </c:pt>
                      <c:pt idx="62">
                        <c:v>1</c:v>
                      </c:pt>
                      <c:pt idx="63">
                        <c:v>1</c:v>
                      </c:pt>
                      <c:pt idx="64">
                        <c:v>1</c:v>
                      </c:pt>
                      <c:pt idx="65">
                        <c:v>1</c:v>
                      </c:pt>
                      <c:pt idx="66">
                        <c:v>1</c:v>
                      </c:pt>
                      <c:pt idx="67">
                        <c:v>1</c:v>
                      </c:pt>
                      <c:pt idx="68">
                        <c:v>1</c:v>
                      </c:pt>
                      <c:pt idx="70">
                        <c:v>1</c:v>
                      </c:pt>
                      <c:pt idx="71">
                        <c:v>1</c:v>
                      </c:pt>
                      <c:pt idx="72">
                        <c:v>1</c:v>
                      </c:pt>
                      <c:pt idx="75">
                        <c:v>1</c:v>
                      </c:pt>
                      <c:pt idx="76">
                        <c:v>1</c:v>
                      </c:pt>
                      <c:pt idx="77">
                        <c:v>1</c:v>
                      </c:pt>
                      <c:pt idx="78">
                        <c:v>1</c:v>
                      </c:pt>
                      <c:pt idx="79">
                        <c:v>1</c:v>
                      </c:pt>
                      <c:pt idx="80">
                        <c:v>1</c:v>
                      </c:pt>
                      <c:pt idx="81">
                        <c:v>1</c:v>
                      </c:pt>
                      <c:pt idx="82">
                        <c:v>1</c:v>
                      </c:pt>
                      <c:pt idx="83">
                        <c:v>1</c:v>
                      </c:pt>
                      <c:pt idx="84">
                        <c:v>1</c:v>
                      </c:pt>
                      <c:pt idx="85">
                        <c:v>1</c:v>
                      </c:pt>
                      <c:pt idx="86">
                        <c:v>1</c:v>
                      </c:pt>
                      <c:pt idx="87">
                        <c:v>1</c:v>
                      </c:pt>
                      <c:pt idx="88">
                        <c:v>1</c:v>
                      </c:pt>
                      <c:pt idx="89">
                        <c:v>1</c:v>
                      </c:pt>
                      <c:pt idx="90">
                        <c:v>1</c:v>
                      </c:pt>
                      <c:pt idx="91">
                        <c:v>1</c:v>
                      </c:pt>
                      <c:pt idx="92">
                        <c:v>1</c:v>
                      </c:pt>
                      <c:pt idx="98">
                        <c:v>1</c:v>
                      </c:pt>
                      <c:pt idx="100">
                        <c:v>1</c:v>
                      </c:pt>
                      <c:pt idx="102">
                        <c:v>1</c:v>
                      </c:pt>
                      <c:pt idx="103">
                        <c:v>1</c:v>
                      </c:pt>
                      <c:pt idx="104">
                        <c:v>1</c:v>
                      </c:pt>
                      <c:pt idx="105">
                        <c:v>1</c:v>
                      </c:pt>
                      <c:pt idx="106">
                        <c:v>1</c:v>
                      </c:pt>
                      <c:pt idx="107">
                        <c:v>1</c:v>
                      </c:pt>
                      <c:pt idx="109">
                        <c:v>1</c:v>
                      </c:pt>
                      <c:pt idx="111">
                        <c:v>1</c:v>
                      </c:pt>
                      <c:pt idx="112">
                        <c:v>1</c:v>
                      </c:pt>
                      <c:pt idx="113">
                        <c:v>1</c:v>
                      </c:pt>
                      <c:pt idx="114">
                        <c:v>1</c:v>
                      </c:pt>
                      <c:pt idx="116">
                        <c:v>1</c:v>
                      </c:pt>
                      <c:pt idx="117">
                        <c:v>1</c:v>
                      </c:pt>
                      <c:pt idx="118">
                        <c:v>1</c:v>
                      </c:pt>
                      <c:pt idx="119">
                        <c:v>1</c:v>
                      </c:pt>
                      <c:pt idx="120">
                        <c:v>1</c:v>
                      </c:pt>
                      <c:pt idx="121">
                        <c:v>1</c:v>
                      </c:pt>
                      <c:pt idx="122">
                        <c:v>1</c:v>
                      </c:pt>
                      <c:pt idx="123">
                        <c:v>1</c:v>
                      </c:pt>
                      <c:pt idx="124">
                        <c:v>1</c:v>
                      </c:pt>
                      <c:pt idx="125">
                        <c:v>1</c:v>
                      </c:pt>
                      <c:pt idx="126">
                        <c:v>1</c:v>
                      </c:pt>
                      <c:pt idx="127">
                        <c:v>1</c:v>
                      </c:pt>
                      <c:pt idx="128">
                        <c:v>1</c:v>
                      </c:pt>
                      <c:pt idx="129">
                        <c:v>1</c:v>
                      </c:pt>
                      <c:pt idx="130">
                        <c:v>1</c:v>
                      </c:pt>
                      <c:pt idx="131">
                        <c:v>1</c:v>
                      </c:pt>
                      <c:pt idx="132">
                        <c:v>1</c:v>
                      </c:pt>
                      <c:pt idx="134">
                        <c:v>1</c:v>
                      </c:pt>
                      <c:pt idx="135">
                        <c:v>1</c:v>
                      </c:pt>
                      <c:pt idx="137">
                        <c:v>1</c:v>
                      </c:pt>
                      <c:pt idx="138">
                        <c:v>1</c:v>
                      </c:pt>
                      <c:pt idx="139">
                        <c:v>1</c:v>
                      </c:pt>
                      <c:pt idx="141">
                        <c:v>1</c:v>
                      </c:pt>
                      <c:pt idx="142">
                        <c:v>1</c:v>
                      </c:pt>
                      <c:pt idx="143">
                        <c:v>1</c:v>
                      </c:pt>
                      <c:pt idx="146">
                        <c:v>1</c:v>
                      </c:pt>
                      <c:pt idx="147">
                        <c:v>1</c:v>
                      </c:pt>
                      <c:pt idx="149">
                        <c:v>1</c:v>
                      </c:pt>
                      <c:pt idx="153">
                        <c:v>1</c:v>
                      </c:pt>
                      <c:pt idx="154">
                        <c:v>1</c:v>
                      </c:pt>
                      <c:pt idx="155">
                        <c:v>1</c:v>
                      </c:pt>
                      <c:pt idx="156">
                        <c:v>1</c:v>
                      </c:pt>
                      <c:pt idx="157">
                        <c:v>1</c:v>
                      </c:pt>
                      <c:pt idx="158">
                        <c:v>1</c:v>
                      </c:pt>
                      <c:pt idx="159">
                        <c:v>1</c:v>
                      </c:pt>
                      <c:pt idx="160">
                        <c:v>1</c:v>
                      </c:pt>
                      <c:pt idx="161">
                        <c:v>1</c:v>
                      </c:pt>
                      <c:pt idx="162">
                        <c:v>1</c:v>
                      </c:pt>
                      <c:pt idx="163">
                        <c:v>1</c:v>
                      </c:pt>
                      <c:pt idx="164">
                        <c:v>1</c:v>
                      </c:pt>
                      <c:pt idx="165">
                        <c:v>1</c:v>
                      </c:pt>
                      <c:pt idx="166">
                        <c:v>1</c:v>
                      </c:pt>
                      <c:pt idx="167">
                        <c:v>1</c:v>
                      </c:pt>
                      <c:pt idx="168">
                        <c:v>1</c:v>
                      </c:pt>
                      <c:pt idx="169">
                        <c:v>1</c:v>
                      </c:pt>
                      <c:pt idx="172">
                        <c:v>1</c:v>
                      </c:pt>
                      <c:pt idx="173">
                        <c:v>1</c:v>
                      </c:pt>
                      <c:pt idx="174">
                        <c:v>1</c:v>
                      </c:pt>
                      <c:pt idx="175">
                        <c:v>1</c:v>
                      </c:pt>
                      <c:pt idx="177">
                        <c:v>1</c:v>
                      </c:pt>
                      <c:pt idx="178">
                        <c:v>1</c:v>
                      </c:pt>
                      <c:pt idx="179">
                        <c:v>1</c:v>
                      </c:pt>
                      <c:pt idx="180">
                        <c:v>1</c:v>
                      </c:pt>
                      <c:pt idx="181">
                        <c:v>1</c:v>
                      </c:pt>
                      <c:pt idx="182">
                        <c:v>1</c:v>
                      </c:pt>
                      <c:pt idx="183">
                        <c:v>1</c:v>
                      </c:pt>
                      <c:pt idx="184">
                        <c:v>1</c:v>
                      </c:pt>
                      <c:pt idx="186">
                        <c:v>1</c:v>
                      </c:pt>
                      <c:pt idx="187">
                        <c:v>1</c:v>
                      </c:pt>
                      <c:pt idx="188">
                        <c:v>1</c:v>
                      </c:pt>
                      <c:pt idx="189">
                        <c:v>1</c:v>
                      </c:pt>
                      <c:pt idx="191">
                        <c:v>1</c:v>
                      </c:pt>
                      <c:pt idx="193">
                        <c:v>1</c:v>
                      </c:pt>
                      <c:pt idx="194">
                        <c:v>1</c:v>
                      </c:pt>
                      <c:pt idx="195">
                        <c:v>1</c:v>
                      </c:pt>
                      <c:pt idx="196">
                        <c:v>1</c:v>
                      </c:pt>
                      <c:pt idx="197">
                        <c:v>1</c:v>
                      </c:pt>
                      <c:pt idx="198">
                        <c:v>1</c:v>
                      </c:pt>
                      <c:pt idx="199">
                        <c:v>1</c:v>
                      </c:pt>
                      <c:pt idx="200">
                        <c:v>1</c:v>
                      </c:pt>
                      <c:pt idx="201">
                        <c:v>1</c:v>
                      </c:pt>
                      <c:pt idx="202">
                        <c:v>1</c:v>
                      </c:pt>
                      <c:pt idx="203">
                        <c:v>1</c:v>
                      </c:pt>
                      <c:pt idx="205">
                        <c:v>1</c:v>
                      </c:pt>
                      <c:pt idx="206">
                        <c:v>1</c:v>
                      </c:pt>
                      <c:pt idx="207">
                        <c:v>1</c:v>
                      </c:pt>
                      <c:pt idx="208">
                        <c:v>1</c:v>
                      </c:pt>
                      <c:pt idx="209">
                        <c:v>1</c:v>
                      </c:pt>
                      <c:pt idx="211">
                        <c:v>1</c:v>
                      </c:pt>
                      <c:pt idx="212">
                        <c:v>1</c:v>
                      </c:pt>
                      <c:pt idx="213">
                        <c:v>1</c:v>
                      </c:pt>
                      <c:pt idx="214">
                        <c:v>1</c:v>
                      </c:pt>
                      <c:pt idx="215">
                        <c:v>1</c:v>
                      </c:pt>
                      <c:pt idx="216">
                        <c:v>1</c:v>
                      </c:pt>
                      <c:pt idx="217">
                        <c:v>1</c:v>
                      </c:pt>
                      <c:pt idx="218">
                        <c:v>1</c:v>
                      </c:pt>
                      <c:pt idx="219">
                        <c:v>1</c:v>
                      </c:pt>
                      <c:pt idx="220">
                        <c:v>1</c:v>
                      </c:pt>
                      <c:pt idx="223">
                        <c:v>1</c:v>
                      </c:pt>
                      <c:pt idx="224">
                        <c:v>1</c:v>
                      </c:pt>
                      <c:pt idx="225">
                        <c:v>1</c:v>
                      </c:pt>
                      <c:pt idx="226">
                        <c:v>1</c:v>
                      </c:pt>
                      <c:pt idx="227">
                        <c:v>1</c:v>
                      </c:pt>
                      <c:pt idx="228">
                        <c:v>1</c:v>
                      </c:pt>
                      <c:pt idx="229">
                        <c:v>1</c:v>
                      </c:pt>
                      <c:pt idx="230">
                        <c:v>1</c:v>
                      </c:pt>
                      <c:pt idx="231">
                        <c:v>1</c:v>
                      </c:pt>
                      <c:pt idx="232">
                        <c:v>1</c:v>
                      </c:pt>
                      <c:pt idx="233">
                        <c:v>1</c:v>
                      </c:pt>
                      <c:pt idx="235">
                        <c:v>1</c:v>
                      </c:pt>
                      <c:pt idx="236">
                        <c:v>1</c:v>
                      </c:pt>
                      <c:pt idx="237">
                        <c:v>1</c:v>
                      </c:pt>
                      <c:pt idx="238">
                        <c:v>1</c:v>
                      </c:pt>
                      <c:pt idx="239">
                        <c:v>1</c:v>
                      </c:pt>
                      <c:pt idx="240">
                        <c:v>1</c:v>
                      </c:pt>
                      <c:pt idx="241">
                        <c:v>1</c:v>
                      </c:pt>
                      <c:pt idx="242">
                        <c:v>1</c:v>
                      </c:pt>
                      <c:pt idx="243">
                        <c:v>1</c:v>
                      </c:pt>
                      <c:pt idx="244">
                        <c:v>1</c:v>
                      </c:pt>
                      <c:pt idx="246">
                        <c:v>1</c:v>
                      </c:pt>
                      <c:pt idx="247">
                        <c:v>1</c:v>
                      </c:pt>
                      <c:pt idx="248">
                        <c:v>1</c:v>
                      </c:pt>
                      <c:pt idx="249">
                        <c:v>1</c:v>
                      </c:pt>
                      <c:pt idx="250">
                        <c:v>1</c:v>
                      </c:pt>
                      <c:pt idx="251">
                        <c:v>1</c:v>
                      </c:pt>
                      <c:pt idx="252">
                        <c:v>1</c:v>
                      </c:pt>
                      <c:pt idx="253">
                        <c:v>1</c:v>
                      </c:pt>
                      <c:pt idx="254">
                        <c:v>1</c:v>
                      </c:pt>
                      <c:pt idx="255">
                        <c:v>1</c:v>
                      </c:pt>
                      <c:pt idx="256">
                        <c:v>1</c:v>
                      </c:pt>
                      <c:pt idx="257">
                        <c:v>1</c:v>
                      </c:pt>
                      <c:pt idx="258">
                        <c:v>1</c:v>
                      </c:pt>
                      <c:pt idx="259">
                        <c:v>1</c:v>
                      </c:pt>
                      <c:pt idx="260">
                        <c:v>1</c:v>
                      </c:pt>
                      <c:pt idx="261">
                        <c:v>1</c:v>
                      </c:pt>
                      <c:pt idx="262">
                        <c:v>2</c:v>
                      </c:pt>
                      <c:pt idx="263">
                        <c:v>1</c:v>
                      </c:pt>
                      <c:pt idx="264">
                        <c:v>2</c:v>
                      </c:pt>
                      <c:pt idx="265">
                        <c:v>6</c:v>
                      </c:pt>
                      <c:pt idx="266">
                        <c:v>1</c:v>
                      </c:pt>
                      <c:pt idx="268">
                        <c:v>1</c:v>
                      </c:pt>
                      <c:pt idx="269">
                        <c:v>1</c:v>
                      </c:pt>
                      <c:pt idx="270">
                        <c:v>1</c:v>
                      </c:pt>
                      <c:pt idx="271">
                        <c:v>1</c:v>
                      </c:pt>
                      <c:pt idx="272">
                        <c:v>1</c:v>
                      </c:pt>
                      <c:pt idx="273">
                        <c:v>3</c:v>
                      </c:pt>
                      <c:pt idx="274">
                        <c:v>1</c:v>
                      </c:pt>
                      <c:pt idx="275">
                        <c:v>1</c:v>
                      </c:pt>
                      <c:pt idx="276">
                        <c:v>1</c:v>
                      </c:pt>
                      <c:pt idx="277">
                        <c:v>1</c:v>
                      </c:pt>
                      <c:pt idx="278">
                        <c:v>1</c:v>
                      </c:pt>
                      <c:pt idx="279">
                        <c:v>1</c:v>
                      </c:pt>
                      <c:pt idx="280">
                        <c:v>1</c:v>
                      </c:pt>
                      <c:pt idx="282">
                        <c:v>1</c:v>
                      </c:pt>
                      <c:pt idx="283">
                        <c:v>1</c:v>
                      </c:pt>
                      <c:pt idx="284">
                        <c:v>1</c:v>
                      </c:pt>
                      <c:pt idx="285">
                        <c:v>1</c:v>
                      </c:pt>
                      <c:pt idx="286">
                        <c:v>1</c:v>
                      </c:pt>
                      <c:pt idx="288">
                        <c:v>1</c:v>
                      </c:pt>
                      <c:pt idx="289">
                        <c:v>1</c:v>
                      </c:pt>
                      <c:pt idx="290">
                        <c:v>1</c:v>
                      </c:pt>
                      <c:pt idx="291">
                        <c:v>1</c:v>
                      </c:pt>
                      <c:pt idx="292">
                        <c:v>1</c:v>
                      </c:pt>
                      <c:pt idx="293">
                        <c:v>1</c:v>
                      </c:pt>
                      <c:pt idx="294">
                        <c:v>1</c:v>
                      </c:pt>
                      <c:pt idx="295">
                        <c:v>1</c:v>
                      </c:pt>
                      <c:pt idx="296">
                        <c:v>1</c:v>
                      </c:pt>
                      <c:pt idx="297">
                        <c:v>1</c:v>
                      </c:pt>
                      <c:pt idx="298">
                        <c:v>1</c:v>
                      </c:pt>
                      <c:pt idx="299">
                        <c:v>1</c:v>
                      </c:pt>
                      <c:pt idx="301">
                        <c:v>1</c:v>
                      </c:pt>
                      <c:pt idx="303">
                        <c:v>1</c:v>
                      </c:pt>
                      <c:pt idx="306">
                        <c:v>1</c:v>
                      </c:pt>
                      <c:pt idx="307">
                        <c:v>1</c:v>
                      </c:pt>
                      <c:pt idx="308">
                        <c:v>1</c:v>
                      </c:pt>
                      <c:pt idx="310">
                        <c:v>1</c:v>
                      </c:pt>
                      <c:pt idx="311">
                        <c:v>3</c:v>
                      </c:pt>
                      <c:pt idx="312">
                        <c:v>1</c:v>
                      </c:pt>
                      <c:pt idx="313">
                        <c:v>1</c:v>
                      </c:pt>
                      <c:pt idx="316">
                        <c:v>1</c:v>
                      </c:pt>
                      <c:pt idx="317">
                        <c:v>1</c:v>
                      </c:pt>
                      <c:pt idx="318">
                        <c:v>1</c:v>
                      </c:pt>
                      <c:pt idx="319">
                        <c:v>1</c:v>
                      </c:pt>
                      <c:pt idx="320">
                        <c:v>1</c:v>
                      </c:pt>
                      <c:pt idx="321">
                        <c:v>1</c:v>
                      </c:pt>
                      <c:pt idx="322">
                        <c:v>1</c:v>
                      </c:pt>
                      <c:pt idx="324">
                        <c:v>1</c:v>
                      </c:pt>
                      <c:pt idx="325">
                        <c:v>1</c:v>
                      </c:pt>
                      <c:pt idx="326">
                        <c:v>1</c:v>
                      </c:pt>
                      <c:pt idx="328">
                        <c:v>1</c:v>
                      </c:pt>
                      <c:pt idx="329">
                        <c:v>1</c:v>
                      </c:pt>
                      <c:pt idx="330">
                        <c:v>1</c:v>
                      </c:pt>
                      <c:pt idx="331">
                        <c:v>1</c:v>
                      </c:pt>
                      <c:pt idx="332">
                        <c:v>1</c:v>
                      </c:pt>
                      <c:pt idx="333">
                        <c:v>1</c:v>
                      </c:pt>
                      <c:pt idx="334">
                        <c:v>2</c:v>
                      </c:pt>
                      <c:pt idx="335">
                        <c:v>2</c:v>
                      </c:pt>
                      <c:pt idx="336">
                        <c:v>13</c:v>
                      </c:pt>
                      <c:pt idx="337">
                        <c:v>91</c:v>
                      </c:pt>
                      <c:pt idx="338">
                        <c:v>1</c:v>
                      </c:pt>
                      <c:pt idx="339">
                        <c:v>1</c:v>
                      </c:pt>
                      <c:pt idx="340">
                        <c:v>1</c:v>
                      </c:pt>
                      <c:pt idx="341">
                        <c:v>1</c:v>
                      </c:pt>
                      <c:pt idx="342">
                        <c:v>1</c:v>
                      </c:pt>
                      <c:pt idx="345">
                        <c:v>1</c:v>
                      </c:pt>
                      <c:pt idx="346">
                        <c:v>1</c:v>
                      </c:pt>
                      <c:pt idx="347">
                        <c:v>1</c:v>
                      </c:pt>
                      <c:pt idx="349">
                        <c:v>2</c:v>
                      </c:pt>
                      <c:pt idx="351">
                        <c:v>1</c:v>
                      </c:pt>
                      <c:pt idx="352">
                        <c:v>1</c:v>
                      </c:pt>
                      <c:pt idx="353">
                        <c:v>1</c:v>
                      </c:pt>
                      <c:pt idx="356">
                        <c:v>1</c:v>
                      </c:pt>
                      <c:pt idx="357">
                        <c:v>1</c:v>
                      </c:pt>
                      <c:pt idx="359">
                        <c:v>1</c:v>
                      </c:pt>
                      <c:pt idx="360">
                        <c:v>1</c:v>
                      </c:pt>
                      <c:pt idx="361">
                        <c:v>1</c:v>
                      </c:pt>
                      <c:pt idx="362">
                        <c:v>1</c:v>
                      </c:pt>
                      <c:pt idx="363">
                        <c:v>1</c:v>
                      </c:pt>
                      <c:pt idx="364">
                        <c:v>1</c:v>
                      </c:pt>
                      <c:pt idx="365">
                        <c:v>1</c:v>
                      </c:pt>
                      <c:pt idx="366">
                        <c:v>1</c:v>
                      </c:pt>
                      <c:pt idx="368">
                        <c:v>1</c:v>
                      </c:pt>
                      <c:pt idx="369">
                        <c:v>1</c:v>
                      </c:pt>
                      <c:pt idx="370">
                        <c:v>1</c:v>
                      </c:pt>
                      <c:pt idx="371">
                        <c:v>1</c:v>
                      </c:pt>
                      <c:pt idx="372">
                        <c:v>1</c:v>
                      </c:pt>
                      <c:pt idx="373">
                        <c:v>1</c:v>
                      </c:pt>
                      <c:pt idx="374">
                        <c:v>1</c:v>
                      </c:pt>
                      <c:pt idx="375">
                        <c:v>1</c:v>
                      </c:pt>
                      <c:pt idx="376">
                        <c:v>1</c:v>
                      </c:pt>
                      <c:pt idx="377">
                        <c:v>1</c:v>
                      </c:pt>
                      <c:pt idx="378">
                        <c:v>1</c:v>
                      </c:pt>
                      <c:pt idx="379">
                        <c:v>1</c:v>
                      </c:pt>
                      <c:pt idx="380">
                        <c:v>1</c:v>
                      </c:pt>
                      <c:pt idx="381">
                        <c:v>1</c:v>
                      </c:pt>
                      <c:pt idx="382">
                        <c:v>1</c:v>
                      </c:pt>
                      <c:pt idx="383">
                        <c:v>1</c:v>
                      </c:pt>
                      <c:pt idx="384">
                        <c:v>1</c:v>
                      </c:pt>
                      <c:pt idx="386">
                        <c:v>1</c:v>
                      </c:pt>
                      <c:pt idx="389">
                        <c:v>1</c:v>
                      </c:pt>
                      <c:pt idx="390">
                        <c:v>1</c:v>
                      </c:pt>
                      <c:pt idx="391">
                        <c:v>1</c:v>
                      </c:pt>
                      <c:pt idx="392">
                        <c:v>1</c:v>
                      </c:pt>
                      <c:pt idx="393">
                        <c:v>1</c:v>
                      </c:pt>
                      <c:pt idx="394">
                        <c:v>1</c:v>
                      </c:pt>
                      <c:pt idx="395">
                        <c:v>1</c:v>
                      </c:pt>
                      <c:pt idx="396">
                        <c:v>5</c:v>
                      </c:pt>
                      <c:pt idx="397">
                        <c:v>3</c:v>
                      </c:pt>
                      <c:pt idx="398">
                        <c:v>1</c:v>
                      </c:pt>
                      <c:pt idx="399">
                        <c:v>1</c:v>
                      </c:pt>
                      <c:pt idx="400">
                        <c:v>1</c:v>
                      </c:pt>
                      <c:pt idx="402">
                        <c:v>1</c:v>
                      </c:pt>
                      <c:pt idx="403">
                        <c:v>1</c:v>
                      </c:pt>
                      <c:pt idx="404">
                        <c:v>1</c:v>
                      </c:pt>
                      <c:pt idx="405">
                        <c:v>4</c:v>
                      </c:pt>
                      <c:pt idx="406">
                        <c:v>1</c:v>
                      </c:pt>
                      <c:pt idx="407">
                        <c:v>1</c:v>
                      </c:pt>
                      <c:pt idx="408">
                        <c:v>1</c:v>
                      </c:pt>
                      <c:pt idx="410">
                        <c:v>1</c:v>
                      </c:pt>
                      <c:pt idx="411">
                        <c:v>1</c:v>
                      </c:pt>
                      <c:pt idx="412">
                        <c:v>1</c:v>
                      </c:pt>
                      <c:pt idx="414">
                        <c:v>1</c:v>
                      </c:pt>
                      <c:pt idx="415">
                        <c:v>1</c:v>
                      </c:pt>
                      <c:pt idx="416">
                        <c:v>1</c:v>
                      </c:pt>
                      <c:pt idx="417">
                        <c:v>1</c:v>
                      </c:pt>
                      <c:pt idx="418">
                        <c:v>1</c:v>
                      </c:pt>
                      <c:pt idx="421">
                        <c:v>1</c:v>
                      </c:pt>
                      <c:pt idx="422">
                        <c:v>1</c:v>
                      </c:pt>
                      <c:pt idx="423">
                        <c:v>1</c:v>
                      </c:pt>
                      <c:pt idx="424">
                        <c:v>1</c:v>
                      </c:pt>
                      <c:pt idx="425">
                        <c:v>1</c:v>
                      </c:pt>
                      <c:pt idx="426">
                        <c:v>1</c:v>
                      </c:pt>
                      <c:pt idx="427">
                        <c:v>1</c:v>
                      </c:pt>
                      <c:pt idx="428">
                        <c:v>1</c:v>
                      </c:pt>
                      <c:pt idx="429">
                        <c:v>1</c:v>
                      </c:pt>
                      <c:pt idx="430">
                        <c:v>1</c:v>
                      </c:pt>
                      <c:pt idx="432">
                        <c:v>2</c:v>
                      </c:pt>
                      <c:pt idx="434">
                        <c:v>1</c:v>
                      </c:pt>
                      <c:pt idx="435">
                        <c:v>1</c:v>
                      </c:pt>
                      <c:pt idx="437">
                        <c:v>1</c:v>
                      </c:pt>
                      <c:pt idx="438">
                        <c:v>1</c:v>
                      </c:pt>
                      <c:pt idx="439">
                        <c:v>1</c:v>
                      </c:pt>
                      <c:pt idx="440">
                        <c:v>1</c:v>
                      </c:pt>
                      <c:pt idx="441">
                        <c:v>1</c:v>
                      </c:pt>
                      <c:pt idx="442">
                        <c:v>1</c:v>
                      </c:pt>
                      <c:pt idx="443">
                        <c:v>1</c:v>
                      </c:pt>
                      <c:pt idx="444">
                        <c:v>1</c:v>
                      </c:pt>
                      <c:pt idx="445">
                        <c:v>1</c:v>
                      </c:pt>
                      <c:pt idx="446">
                        <c:v>1</c:v>
                      </c:pt>
                      <c:pt idx="447">
                        <c:v>1</c:v>
                      </c:pt>
                      <c:pt idx="449">
                        <c:v>1</c:v>
                      </c:pt>
                      <c:pt idx="450">
                        <c:v>1</c:v>
                      </c:pt>
                      <c:pt idx="451">
                        <c:v>1</c:v>
                      </c:pt>
                      <c:pt idx="458">
                        <c:v>1</c:v>
                      </c:pt>
                      <c:pt idx="459">
                        <c:v>1</c:v>
                      </c:pt>
                      <c:pt idx="460">
                        <c:v>1</c:v>
                      </c:pt>
                      <c:pt idx="461">
                        <c:v>1</c:v>
                      </c:pt>
                      <c:pt idx="463">
                        <c:v>1</c:v>
                      </c:pt>
                      <c:pt idx="464">
                        <c:v>1</c:v>
                      </c:pt>
                      <c:pt idx="465">
                        <c:v>1</c:v>
                      </c:pt>
                      <c:pt idx="466">
                        <c:v>1</c:v>
                      </c:pt>
                      <c:pt idx="467">
                        <c:v>1</c:v>
                      </c:pt>
                      <c:pt idx="468">
                        <c:v>1</c:v>
                      </c:pt>
                      <c:pt idx="469">
                        <c:v>1</c:v>
                      </c:pt>
                      <c:pt idx="470">
                        <c:v>1</c:v>
                      </c:pt>
                      <c:pt idx="472">
                        <c:v>1</c:v>
                      </c:pt>
                      <c:pt idx="473">
                        <c:v>1</c:v>
                      </c:pt>
                      <c:pt idx="474">
                        <c:v>1</c:v>
                      </c:pt>
                      <c:pt idx="475">
                        <c:v>1</c:v>
                      </c:pt>
                      <c:pt idx="476">
                        <c:v>1</c:v>
                      </c:pt>
                      <c:pt idx="477">
                        <c:v>1</c:v>
                      </c:pt>
                      <c:pt idx="478">
                        <c:v>1</c:v>
                      </c:pt>
                      <c:pt idx="479">
                        <c:v>1</c:v>
                      </c:pt>
                      <c:pt idx="480">
                        <c:v>1</c:v>
                      </c:pt>
                      <c:pt idx="483">
                        <c:v>1</c:v>
                      </c:pt>
                      <c:pt idx="484">
                        <c:v>1</c:v>
                      </c:pt>
                      <c:pt idx="485">
                        <c:v>1</c:v>
                      </c:pt>
                      <c:pt idx="487">
                        <c:v>1</c:v>
                      </c:pt>
                      <c:pt idx="488">
                        <c:v>1</c:v>
                      </c:pt>
                      <c:pt idx="491">
                        <c:v>1</c:v>
                      </c:pt>
                      <c:pt idx="492">
                        <c:v>1</c:v>
                      </c:pt>
                      <c:pt idx="493">
                        <c:v>1</c:v>
                      </c:pt>
                      <c:pt idx="494">
                        <c:v>1</c:v>
                      </c:pt>
                      <c:pt idx="495">
                        <c:v>1</c:v>
                      </c:pt>
                      <c:pt idx="496">
                        <c:v>1</c:v>
                      </c:pt>
                      <c:pt idx="497">
                        <c:v>1</c:v>
                      </c:pt>
                      <c:pt idx="498">
                        <c:v>1</c:v>
                      </c:pt>
                      <c:pt idx="499">
                        <c:v>1</c:v>
                      </c:pt>
                      <c:pt idx="500">
                        <c:v>1</c:v>
                      </c:pt>
                      <c:pt idx="502">
                        <c:v>1</c:v>
                      </c:pt>
                      <c:pt idx="503">
                        <c:v>1</c:v>
                      </c:pt>
                      <c:pt idx="505">
                        <c:v>1</c:v>
                      </c:pt>
                      <c:pt idx="506">
                        <c:v>1</c:v>
                      </c:pt>
                      <c:pt idx="507">
                        <c:v>1</c:v>
                      </c:pt>
                      <c:pt idx="508">
                        <c:v>1</c:v>
                      </c:pt>
                      <c:pt idx="509">
                        <c:v>1</c:v>
                      </c:pt>
                      <c:pt idx="511">
                        <c:v>1</c:v>
                      </c:pt>
                      <c:pt idx="512">
                        <c:v>1</c:v>
                      </c:pt>
                      <c:pt idx="513">
                        <c:v>1</c:v>
                      </c:pt>
                      <c:pt idx="514">
                        <c:v>1</c:v>
                      </c:pt>
                      <c:pt idx="515">
                        <c:v>6</c:v>
                      </c:pt>
                      <c:pt idx="516">
                        <c:v>1</c:v>
                      </c:pt>
                      <c:pt idx="517">
                        <c:v>1</c:v>
                      </c:pt>
                      <c:pt idx="518">
                        <c:v>1</c:v>
                      </c:pt>
                      <c:pt idx="520">
                        <c:v>1</c:v>
                      </c:pt>
                      <c:pt idx="521">
                        <c:v>1</c:v>
                      </c:pt>
                      <c:pt idx="523">
                        <c:v>1</c:v>
                      </c:pt>
                      <c:pt idx="524">
                        <c:v>1</c:v>
                      </c:pt>
                      <c:pt idx="525">
                        <c:v>1</c:v>
                      </c:pt>
                      <c:pt idx="526">
                        <c:v>1</c:v>
                      </c:pt>
                      <c:pt idx="527">
                        <c:v>1</c:v>
                      </c:pt>
                      <c:pt idx="528">
                        <c:v>1</c:v>
                      </c:pt>
                      <c:pt idx="529">
                        <c:v>1</c:v>
                      </c:pt>
                      <c:pt idx="530">
                        <c:v>1</c:v>
                      </c:pt>
                      <c:pt idx="531">
                        <c:v>1</c:v>
                      </c:pt>
                      <c:pt idx="532">
                        <c:v>1</c:v>
                      </c:pt>
                      <c:pt idx="533">
                        <c:v>1</c:v>
                      </c:pt>
                      <c:pt idx="534">
                        <c:v>1</c:v>
                      </c:pt>
                      <c:pt idx="535">
                        <c:v>1</c:v>
                      </c:pt>
                      <c:pt idx="537">
                        <c:v>1</c:v>
                      </c:pt>
                      <c:pt idx="539">
                        <c:v>1</c:v>
                      </c:pt>
                      <c:pt idx="540">
                        <c:v>1</c:v>
                      </c:pt>
                      <c:pt idx="541">
                        <c:v>1</c:v>
                      </c:pt>
                      <c:pt idx="543">
                        <c:v>1</c:v>
                      </c:pt>
                      <c:pt idx="546">
                        <c:v>1</c:v>
                      </c:pt>
                      <c:pt idx="547">
                        <c:v>1</c:v>
                      </c:pt>
                      <c:pt idx="548">
                        <c:v>1</c:v>
                      </c:pt>
                      <c:pt idx="549">
                        <c:v>1</c:v>
                      </c:pt>
                      <c:pt idx="550">
                        <c:v>1</c:v>
                      </c:pt>
                      <c:pt idx="551">
                        <c:v>1</c:v>
                      </c:pt>
                      <c:pt idx="552">
                        <c:v>1</c:v>
                      </c:pt>
                      <c:pt idx="553">
                        <c:v>1</c:v>
                      </c:pt>
                      <c:pt idx="554">
                        <c:v>1</c:v>
                      </c:pt>
                      <c:pt idx="555">
                        <c:v>1</c:v>
                      </c:pt>
                      <c:pt idx="556">
                        <c:v>1</c:v>
                      </c:pt>
                      <c:pt idx="557">
                        <c:v>1</c:v>
                      </c:pt>
                      <c:pt idx="558">
                        <c:v>1</c:v>
                      </c:pt>
                      <c:pt idx="559">
                        <c:v>1</c:v>
                      </c:pt>
                      <c:pt idx="560">
                        <c:v>1</c:v>
                      </c:pt>
                      <c:pt idx="561">
                        <c:v>1</c:v>
                      </c:pt>
                      <c:pt idx="562">
                        <c:v>1</c:v>
                      </c:pt>
                      <c:pt idx="563">
                        <c:v>1</c:v>
                      </c:pt>
                      <c:pt idx="566">
                        <c:v>1</c:v>
                      </c:pt>
                      <c:pt idx="568">
                        <c:v>1</c:v>
                      </c:pt>
                      <c:pt idx="570">
                        <c:v>1</c:v>
                      </c:pt>
                      <c:pt idx="571">
                        <c:v>1</c:v>
                      </c:pt>
                      <c:pt idx="572">
                        <c:v>1</c:v>
                      </c:pt>
                      <c:pt idx="573">
                        <c:v>3</c:v>
                      </c:pt>
                      <c:pt idx="574">
                        <c:v>1</c:v>
                      </c:pt>
                      <c:pt idx="575">
                        <c:v>1</c:v>
                      </c:pt>
                      <c:pt idx="576">
                        <c:v>1</c:v>
                      </c:pt>
                      <c:pt idx="577">
                        <c:v>1</c:v>
                      </c:pt>
                      <c:pt idx="578">
                        <c:v>1</c:v>
                      </c:pt>
                      <c:pt idx="579">
                        <c:v>1</c:v>
                      </c:pt>
                      <c:pt idx="580">
                        <c:v>1</c:v>
                      </c:pt>
                      <c:pt idx="581">
                        <c:v>1</c:v>
                      </c:pt>
                      <c:pt idx="582">
                        <c:v>1</c:v>
                      </c:pt>
                      <c:pt idx="583">
                        <c:v>1</c:v>
                      </c:pt>
                      <c:pt idx="584">
                        <c:v>1</c:v>
                      </c:pt>
                      <c:pt idx="585">
                        <c:v>1</c:v>
                      </c:pt>
                      <c:pt idx="586">
                        <c:v>1</c:v>
                      </c:pt>
                      <c:pt idx="587">
                        <c:v>1</c:v>
                      </c:pt>
                      <c:pt idx="588">
                        <c:v>1</c:v>
                      </c:pt>
                      <c:pt idx="589">
                        <c:v>1</c:v>
                      </c:pt>
                      <c:pt idx="590">
                        <c:v>1</c:v>
                      </c:pt>
                      <c:pt idx="591">
                        <c:v>1</c:v>
                      </c:pt>
                      <c:pt idx="592">
                        <c:v>1</c:v>
                      </c:pt>
                      <c:pt idx="593">
                        <c:v>1</c:v>
                      </c:pt>
                      <c:pt idx="594">
                        <c:v>1</c:v>
                      </c:pt>
                      <c:pt idx="595">
                        <c:v>1</c:v>
                      </c:pt>
                      <c:pt idx="596">
                        <c:v>1</c:v>
                      </c:pt>
                      <c:pt idx="598">
                        <c:v>1</c:v>
                      </c:pt>
                      <c:pt idx="599">
                        <c:v>1</c:v>
                      </c:pt>
                      <c:pt idx="600">
                        <c:v>1</c:v>
                      </c:pt>
                      <c:pt idx="601">
                        <c:v>1</c:v>
                      </c:pt>
                      <c:pt idx="602">
                        <c:v>2</c:v>
                      </c:pt>
                      <c:pt idx="603">
                        <c:v>3</c:v>
                      </c:pt>
                      <c:pt idx="604">
                        <c:v>8</c:v>
                      </c:pt>
                      <c:pt idx="605">
                        <c:v>39</c:v>
                      </c:pt>
                      <c:pt idx="606">
                        <c:v>43</c:v>
                      </c:pt>
                      <c:pt idx="608">
                        <c:v>1</c:v>
                      </c:pt>
                      <c:pt idx="610">
                        <c:v>1</c:v>
                      </c:pt>
                      <c:pt idx="611">
                        <c:v>1</c:v>
                      </c:pt>
                      <c:pt idx="612">
                        <c:v>1</c:v>
                      </c:pt>
                      <c:pt idx="614">
                        <c:v>1</c:v>
                      </c:pt>
                      <c:pt idx="616">
                        <c:v>1</c:v>
                      </c:pt>
                      <c:pt idx="617">
                        <c:v>1</c:v>
                      </c:pt>
                      <c:pt idx="618">
                        <c:v>1</c:v>
                      </c:pt>
                      <c:pt idx="619">
                        <c:v>1</c:v>
                      </c:pt>
                      <c:pt idx="620">
                        <c:v>1</c:v>
                      </c:pt>
                      <c:pt idx="622">
                        <c:v>1</c:v>
                      </c:pt>
                      <c:pt idx="623">
                        <c:v>1</c:v>
                      </c:pt>
                      <c:pt idx="625">
                        <c:v>1</c:v>
                      </c:pt>
                      <c:pt idx="626">
                        <c:v>1</c:v>
                      </c:pt>
                      <c:pt idx="628">
                        <c:v>1</c:v>
                      </c:pt>
                      <c:pt idx="629">
                        <c:v>1</c:v>
                      </c:pt>
                      <c:pt idx="631">
                        <c:v>1</c:v>
                      </c:pt>
                      <c:pt idx="632">
                        <c:v>1</c:v>
                      </c:pt>
                      <c:pt idx="633">
                        <c:v>1</c:v>
                      </c:pt>
                      <c:pt idx="637">
                        <c:v>1</c:v>
                      </c:pt>
                      <c:pt idx="638">
                        <c:v>1</c:v>
                      </c:pt>
                      <c:pt idx="639">
                        <c:v>1</c:v>
                      </c:pt>
                      <c:pt idx="640">
                        <c:v>1</c:v>
                      </c:pt>
                      <c:pt idx="642">
                        <c:v>1</c:v>
                      </c:pt>
                      <c:pt idx="643">
                        <c:v>1</c:v>
                      </c:pt>
                      <c:pt idx="644">
                        <c:v>1</c:v>
                      </c:pt>
                      <c:pt idx="645">
                        <c:v>1</c:v>
                      </c:pt>
                      <c:pt idx="646">
                        <c:v>1</c:v>
                      </c:pt>
                      <c:pt idx="649">
                        <c:v>1</c:v>
                      </c:pt>
                      <c:pt idx="650">
                        <c:v>1</c:v>
                      </c:pt>
                      <c:pt idx="651">
                        <c:v>1</c:v>
                      </c:pt>
                      <c:pt idx="652">
                        <c:v>1</c:v>
                      </c:pt>
                      <c:pt idx="653">
                        <c:v>1</c:v>
                      </c:pt>
                      <c:pt idx="654">
                        <c:v>1</c:v>
                      </c:pt>
                      <c:pt idx="655">
                        <c:v>1</c:v>
                      </c:pt>
                      <c:pt idx="656">
                        <c:v>1</c:v>
                      </c:pt>
                      <c:pt idx="658">
                        <c:v>1</c:v>
                      </c:pt>
                      <c:pt idx="659">
                        <c:v>1</c:v>
                      </c:pt>
                      <c:pt idx="660">
                        <c:v>1</c:v>
                      </c:pt>
                      <c:pt idx="661">
                        <c:v>1</c:v>
                      </c:pt>
                      <c:pt idx="662">
                        <c:v>1</c:v>
                      </c:pt>
                      <c:pt idx="668">
                        <c:v>1</c:v>
                      </c:pt>
                      <c:pt idx="669">
                        <c:v>1</c:v>
                      </c:pt>
                      <c:pt idx="670">
                        <c:v>1</c:v>
                      </c:pt>
                      <c:pt idx="671">
                        <c:v>1</c:v>
                      </c:pt>
                      <c:pt idx="672">
                        <c:v>1</c:v>
                      </c:pt>
                      <c:pt idx="674">
                        <c:v>1</c:v>
                      </c:pt>
                      <c:pt idx="675">
                        <c:v>1</c:v>
                      </c:pt>
                      <c:pt idx="679">
                        <c:v>1</c:v>
                      </c:pt>
                      <c:pt idx="680">
                        <c:v>1</c:v>
                      </c:pt>
                      <c:pt idx="682">
                        <c:v>1</c:v>
                      </c:pt>
                      <c:pt idx="683">
                        <c:v>1</c:v>
                      </c:pt>
                      <c:pt idx="684">
                        <c:v>1</c:v>
                      </c:pt>
                      <c:pt idx="686">
                        <c:v>1</c:v>
                      </c:pt>
                      <c:pt idx="687">
                        <c:v>1</c:v>
                      </c:pt>
                      <c:pt idx="688">
                        <c:v>1</c:v>
                      </c:pt>
                      <c:pt idx="689">
                        <c:v>1</c:v>
                      </c:pt>
                      <c:pt idx="690">
                        <c:v>1</c:v>
                      </c:pt>
                      <c:pt idx="692">
                        <c:v>1</c:v>
                      </c:pt>
                      <c:pt idx="693">
                        <c:v>1</c:v>
                      </c:pt>
                      <c:pt idx="694">
                        <c:v>1</c:v>
                      </c:pt>
                      <c:pt idx="697">
                        <c:v>1</c:v>
                      </c:pt>
                      <c:pt idx="698">
                        <c:v>1</c:v>
                      </c:pt>
                      <c:pt idx="699">
                        <c:v>1</c:v>
                      </c:pt>
                      <c:pt idx="700">
                        <c:v>1</c:v>
                      </c:pt>
                      <c:pt idx="701">
                        <c:v>1</c:v>
                      </c:pt>
                      <c:pt idx="702">
                        <c:v>1</c:v>
                      </c:pt>
                      <c:pt idx="703">
                        <c:v>1</c:v>
                      </c:pt>
                      <c:pt idx="704">
                        <c:v>1</c:v>
                      </c:pt>
                      <c:pt idx="705">
                        <c:v>1</c:v>
                      </c:pt>
                      <c:pt idx="706">
                        <c:v>1</c:v>
                      </c:pt>
                      <c:pt idx="707">
                        <c:v>1</c:v>
                      </c:pt>
                      <c:pt idx="708">
                        <c:v>1</c:v>
                      </c:pt>
                      <c:pt idx="709">
                        <c:v>1</c:v>
                      </c:pt>
                      <c:pt idx="710">
                        <c:v>1</c:v>
                      </c:pt>
                      <c:pt idx="711">
                        <c:v>1</c:v>
                      </c:pt>
                      <c:pt idx="713">
                        <c:v>1</c:v>
                      </c:pt>
                      <c:pt idx="714">
                        <c:v>1</c:v>
                      </c:pt>
                      <c:pt idx="716">
                        <c:v>1</c:v>
                      </c:pt>
                      <c:pt idx="717">
                        <c:v>1</c:v>
                      </c:pt>
                      <c:pt idx="719">
                        <c:v>1</c:v>
                      </c:pt>
                      <c:pt idx="722">
                        <c:v>1</c:v>
                      </c:pt>
                      <c:pt idx="723">
                        <c:v>1</c:v>
                      </c:pt>
                      <c:pt idx="724">
                        <c:v>1</c:v>
                      </c:pt>
                      <c:pt idx="725">
                        <c:v>1</c:v>
                      </c:pt>
                      <c:pt idx="726">
                        <c:v>1</c:v>
                      </c:pt>
                      <c:pt idx="727">
                        <c:v>1</c:v>
                      </c:pt>
                      <c:pt idx="729">
                        <c:v>1</c:v>
                      </c:pt>
                      <c:pt idx="730">
                        <c:v>1</c:v>
                      </c:pt>
                      <c:pt idx="732">
                        <c:v>1</c:v>
                      </c:pt>
                      <c:pt idx="735">
                        <c:v>1</c:v>
                      </c:pt>
                      <c:pt idx="737">
                        <c:v>1</c:v>
                      </c:pt>
                      <c:pt idx="738">
                        <c:v>1</c:v>
                      </c:pt>
                      <c:pt idx="739">
                        <c:v>1</c:v>
                      </c:pt>
                      <c:pt idx="740">
                        <c:v>1</c:v>
                      </c:pt>
                      <c:pt idx="742">
                        <c:v>1</c:v>
                      </c:pt>
                      <c:pt idx="743">
                        <c:v>1</c:v>
                      </c:pt>
                      <c:pt idx="745">
                        <c:v>1</c:v>
                      </c:pt>
                      <c:pt idx="746">
                        <c:v>1</c:v>
                      </c:pt>
                      <c:pt idx="747">
                        <c:v>1</c:v>
                      </c:pt>
                      <c:pt idx="748">
                        <c:v>1</c:v>
                      </c:pt>
                      <c:pt idx="749">
                        <c:v>1</c:v>
                      </c:pt>
                      <c:pt idx="750">
                        <c:v>1</c:v>
                      </c:pt>
                      <c:pt idx="751">
                        <c:v>1</c:v>
                      </c:pt>
                      <c:pt idx="752">
                        <c:v>1</c:v>
                      </c:pt>
                      <c:pt idx="753">
                        <c:v>1</c:v>
                      </c:pt>
                      <c:pt idx="754">
                        <c:v>1</c:v>
                      </c:pt>
                      <c:pt idx="755">
                        <c:v>1</c:v>
                      </c:pt>
                      <c:pt idx="756">
                        <c:v>1</c:v>
                      </c:pt>
                      <c:pt idx="758">
                        <c:v>1</c:v>
                      </c:pt>
                      <c:pt idx="759">
                        <c:v>1</c:v>
                      </c:pt>
                      <c:pt idx="760">
                        <c:v>1</c:v>
                      </c:pt>
                      <c:pt idx="761">
                        <c:v>1</c:v>
                      </c:pt>
                      <c:pt idx="762">
                        <c:v>1</c:v>
                      </c:pt>
                      <c:pt idx="763">
                        <c:v>1</c:v>
                      </c:pt>
                      <c:pt idx="764">
                        <c:v>1</c:v>
                      </c:pt>
                      <c:pt idx="765">
                        <c:v>1</c:v>
                      </c:pt>
                      <c:pt idx="766">
                        <c:v>1</c:v>
                      </c:pt>
                      <c:pt idx="767">
                        <c:v>1</c:v>
                      </c:pt>
                      <c:pt idx="768">
                        <c:v>1</c:v>
                      </c:pt>
                      <c:pt idx="769">
                        <c:v>1</c:v>
                      </c:pt>
                      <c:pt idx="770">
                        <c:v>1</c:v>
                      </c:pt>
                      <c:pt idx="772">
                        <c:v>1</c:v>
                      </c:pt>
                      <c:pt idx="773">
                        <c:v>1</c:v>
                      </c:pt>
                      <c:pt idx="774">
                        <c:v>1</c:v>
                      </c:pt>
                      <c:pt idx="775">
                        <c:v>1</c:v>
                      </c:pt>
                      <c:pt idx="776">
                        <c:v>1</c:v>
                      </c:pt>
                      <c:pt idx="777">
                        <c:v>1</c:v>
                      </c:pt>
                      <c:pt idx="778">
                        <c:v>1</c:v>
                      </c:pt>
                      <c:pt idx="779">
                        <c:v>1</c:v>
                      </c:pt>
                      <c:pt idx="780">
                        <c:v>1</c:v>
                      </c:pt>
                      <c:pt idx="782">
                        <c:v>1</c:v>
                      </c:pt>
                      <c:pt idx="783">
                        <c:v>1</c:v>
                      </c:pt>
                      <c:pt idx="784">
                        <c:v>1</c:v>
                      </c:pt>
                      <c:pt idx="785">
                        <c:v>1</c:v>
                      </c:pt>
                      <c:pt idx="786">
                        <c:v>1</c:v>
                      </c:pt>
                      <c:pt idx="787">
                        <c:v>1</c:v>
                      </c:pt>
                      <c:pt idx="788">
                        <c:v>1</c:v>
                      </c:pt>
                      <c:pt idx="789">
                        <c:v>1</c:v>
                      </c:pt>
                      <c:pt idx="790">
                        <c:v>1</c:v>
                      </c:pt>
                      <c:pt idx="795">
                        <c:v>1</c:v>
                      </c:pt>
                      <c:pt idx="796">
                        <c:v>2</c:v>
                      </c:pt>
                      <c:pt idx="797">
                        <c:v>1</c:v>
                      </c:pt>
                      <c:pt idx="799">
                        <c:v>1</c:v>
                      </c:pt>
                      <c:pt idx="800">
                        <c:v>1</c:v>
                      </c:pt>
                      <c:pt idx="801">
                        <c:v>1</c:v>
                      </c:pt>
                      <c:pt idx="803">
                        <c:v>1</c:v>
                      </c:pt>
                      <c:pt idx="804">
                        <c:v>1</c:v>
                      </c:pt>
                      <c:pt idx="805">
                        <c:v>1</c:v>
                      </c:pt>
                      <c:pt idx="806">
                        <c:v>53</c:v>
                      </c:pt>
                      <c:pt idx="807">
                        <c:v>1</c:v>
                      </c:pt>
                      <c:pt idx="808">
                        <c:v>1</c:v>
                      </c:pt>
                      <c:pt idx="809">
                        <c:v>1</c:v>
                      </c:pt>
                      <c:pt idx="810">
                        <c:v>1</c:v>
                      </c:pt>
                      <c:pt idx="812">
                        <c:v>1</c:v>
                      </c:pt>
                      <c:pt idx="813">
                        <c:v>1</c:v>
                      </c:pt>
                      <c:pt idx="814">
                        <c:v>1</c:v>
                      </c:pt>
                      <c:pt idx="815">
                        <c:v>1</c:v>
                      </c:pt>
                      <c:pt idx="816">
                        <c:v>1</c:v>
                      </c:pt>
                      <c:pt idx="817">
                        <c:v>1</c:v>
                      </c:pt>
                      <c:pt idx="818">
                        <c:v>1</c:v>
                      </c:pt>
                      <c:pt idx="819">
                        <c:v>1</c:v>
                      </c:pt>
                      <c:pt idx="820">
                        <c:v>1</c:v>
                      </c:pt>
                      <c:pt idx="821">
                        <c:v>1</c:v>
                      </c:pt>
                      <c:pt idx="823">
                        <c:v>1</c:v>
                      </c:pt>
                      <c:pt idx="824">
                        <c:v>1</c:v>
                      </c:pt>
                      <c:pt idx="825">
                        <c:v>1</c:v>
                      </c:pt>
                      <c:pt idx="826">
                        <c:v>1</c:v>
                      </c:pt>
                      <c:pt idx="827">
                        <c:v>1</c:v>
                      </c:pt>
                      <c:pt idx="828">
                        <c:v>1</c:v>
                      </c:pt>
                      <c:pt idx="829">
                        <c:v>1</c:v>
                      </c:pt>
                      <c:pt idx="830">
                        <c:v>1</c:v>
                      </c:pt>
                      <c:pt idx="831">
                        <c:v>1</c:v>
                      </c:pt>
                      <c:pt idx="832">
                        <c:v>1</c:v>
                      </c:pt>
                      <c:pt idx="833">
                        <c:v>1</c:v>
                      </c:pt>
                      <c:pt idx="834">
                        <c:v>1</c:v>
                      </c:pt>
                      <c:pt idx="835">
                        <c:v>1</c:v>
                      </c:pt>
                      <c:pt idx="836">
                        <c:v>1</c:v>
                      </c:pt>
                      <c:pt idx="837">
                        <c:v>1</c:v>
                      </c:pt>
                      <c:pt idx="838">
                        <c:v>1</c:v>
                      </c:pt>
                      <c:pt idx="839">
                        <c:v>1</c:v>
                      </c:pt>
                      <c:pt idx="840">
                        <c:v>1</c:v>
                      </c:pt>
                      <c:pt idx="841">
                        <c:v>1</c:v>
                      </c:pt>
                      <c:pt idx="842">
                        <c:v>1</c:v>
                      </c:pt>
                      <c:pt idx="843">
                        <c:v>1</c:v>
                      </c:pt>
                      <c:pt idx="844">
                        <c:v>1</c:v>
                      </c:pt>
                      <c:pt idx="845">
                        <c:v>1</c:v>
                      </c:pt>
                      <c:pt idx="846">
                        <c:v>1</c:v>
                      </c:pt>
                      <c:pt idx="847">
                        <c:v>1</c:v>
                      </c:pt>
                      <c:pt idx="848">
                        <c:v>1</c:v>
                      </c:pt>
                      <c:pt idx="849">
                        <c:v>10</c:v>
                      </c:pt>
                      <c:pt idx="850">
                        <c:v>1</c:v>
                      </c:pt>
                      <c:pt idx="852">
                        <c:v>1</c:v>
                      </c:pt>
                      <c:pt idx="853">
                        <c:v>1</c:v>
                      </c:pt>
                      <c:pt idx="854">
                        <c:v>1</c:v>
                      </c:pt>
                      <c:pt idx="855">
                        <c:v>1</c:v>
                      </c:pt>
                      <c:pt idx="856">
                        <c:v>1</c:v>
                      </c:pt>
                      <c:pt idx="857">
                        <c:v>1</c:v>
                      </c:pt>
                      <c:pt idx="858">
                        <c:v>1</c:v>
                      </c:pt>
                      <c:pt idx="859">
                        <c:v>1</c:v>
                      </c:pt>
                      <c:pt idx="860">
                        <c:v>1</c:v>
                      </c:pt>
                      <c:pt idx="861">
                        <c:v>1</c:v>
                      </c:pt>
                      <c:pt idx="862">
                        <c:v>1</c:v>
                      </c:pt>
                      <c:pt idx="863">
                        <c:v>1</c:v>
                      </c:pt>
                      <c:pt idx="864">
                        <c:v>1</c:v>
                      </c:pt>
                      <c:pt idx="865">
                        <c:v>1</c:v>
                      </c:pt>
                      <c:pt idx="868">
                        <c:v>1</c:v>
                      </c:pt>
                      <c:pt idx="869">
                        <c:v>1</c:v>
                      </c:pt>
                      <c:pt idx="870">
                        <c:v>1</c:v>
                      </c:pt>
                      <c:pt idx="871">
                        <c:v>1</c:v>
                      </c:pt>
                      <c:pt idx="872">
                        <c:v>1</c:v>
                      </c:pt>
                      <c:pt idx="873">
                        <c:v>1</c:v>
                      </c:pt>
                      <c:pt idx="874">
                        <c:v>1</c:v>
                      </c:pt>
                      <c:pt idx="875">
                        <c:v>1</c:v>
                      </c:pt>
                      <c:pt idx="876">
                        <c:v>2</c:v>
                      </c:pt>
                      <c:pt idx="877">
                        <c:v>1</c:v>
                      </c:pt>
                      <c:pt idx="878">
                        <c:v>1</c:v>
                      </c:pt>
                      <c:pt idx="879">
                        <c:v>1</c:v>
                      </c:pt>
                      <c:pt idx="880">
                        <c:v>1</c:v>
                      </c:pt>
                      <c:pt idx="881">
                        <c:v>1</c:v>
                      </c:pt>
                      <c:pt idx="883">
                        <c:v>1</c:v>
                      </c:pt>
                      <c:pt idx="884">
                        <c:v>2</c:v>
                      </c:pt>
                      <c:pt idx="885">
                        <c:v>2</c:v>
                      </c:pt>
                      <c:pt idx="886">
                        <c:v>1</c:v>
                      </c:pt>
                      <c:pt idx="887">
                        <c:v>1</c:v>
                      </c:pt>
                      <c:pt idx="888">
                        <c:v>1</c:v>
                      </c:pt>
                      <c:pt idx="889">
                        <c:v>1</c:v>
                      </c:pt>
                      <c:pt idx="890">
                        <c:v>2</c:v>
                      </c:pt>
                      <c:pt idx="891">
                        <c:v>2</c:v>
                      </c:pt>
                      <c:pt idx="892">
                        <c:v>1</c:v>
                      </c:pt>
                      <c:pt idx="893">
                        <c:v>1</c:v>
                      </c:pt>
                      <c:pt idx="894">
                        <c:v>1</c:v>
                      </c:pt>
                      <c:pt idx="895">
                        <c:v>1</c:v>
                      </c:pt>
                      <c:pt idx="896">
                        <c:v>1</c:v>
                      </c:pt>
                      <c:pt idx="897">
                        <c:v>1</c:v>
                      </c:pt>
                      <c:pt idx="898">
                        <c:v>1</c:v>
                      </c:pt>
                      <c:pt idx="899">
                        <c:v>1</c:v>
                      </c:pt>
                      <c:pt idx="900">
                        <c:v>1</c:v>
                      </c:pt>
                      <c:pt idx="901">
                        <c:v>1</c:v>
                      </c:pt>
                      <c:pt idx="902">
                        <c:v>1</c:v>
                      </c:pt>
                      <c:pt idx="903">
                        <c:v>1</c:v>
                      </c:pt>
                      <c:pt idx="904">
                        <c:v>1</c:v>
                      </c:pt>
                      <c:pt idx="905">
                        <c:v>1</c:v>
                      </c:pt>
                      <c:pt idx="906">
                        <c:v>24</c:v>
                      </c:pt>
                      <c:pt idx="907">
                        <c:v>3</c:v>
                      </c:pt>
                      <c:pt idx="908">
                        <c:v>1</c:v>
                      </c:pt>
                      <c:pt idx="909">
                        <c:v>1</c:v>
                      </c:pt>
                      <c:pt idx="910">
                        <c:v>1</c:v>
                      </c:pt>
                      <c:pt idx="911">
                        <c:v>1</c:v>
                      </c:pt>
                      <c:pt idx="912">
                        <c:v>1</c:v>
                      </c:pt>
                      <c:pt idx="913">
                        <c:v>1</c:v>
                      </c:pt>
                      <c:pt idx="914">
                        <c:v>1</c:v>
                      </c:pt>
                      <c:pt idx="915">
                        <c:v>2</c:v>
                      </c:pt>
                      <c:pt idx="916">
                        <c:v>2</c:v>
                      </c:pt>
                      <c:pt idx="917">
                        <c:v>1</c:v>
                      </c:pt>
                      <c:pt idx="918">
                        <c:v>6</c:v>
                      </c:pt>
                      <c:pt idx="919">
                        <c:v>1</c:v>
                      </c:pt>
                      <c:pt idx="920">
                        <c:v>2</c:v>
                      </c:pt>
                      <c:pt idx="921">
                        <c:v>74</c:v>
                      </c:pt>
                      <c:pt idx="922">
                        <c:v>49</c:v>
                      </c:pt>
                      <c:pt idx="923">
                        <c:v>1</c:v>
                      </c:pt>
                      <c:pt idx="924">
                        <c:v>7</c:v>
                      </c:pt>
                      <c:pt idx="925">
                        <c:v>3</c:v>
                      </c:pt>
                      <c:pt idx="926">
                        <c:v>2</c:v>
                      </c:pt>
                      <c:pt idx="928">
                        <c:v>2</c:v>
                      </c:pt>
                      <c:pt idx="929">
                        <c:v>1</c:v>
                      </c:pt>
                      <c:pt idx="930">
                        <c:v>1</c:v>
                      </c:pt>
                      <c:pt idx="931">
                        <c:v>5</c:v>
                      </c:pt>
                      <c:pt idx="932">
                        <c:v>2</c:v>
                      </c:pt>
                      <c:pt idx="933">
                        <c:v>1</c:v>
                      </c:pt>
                      <c:pt idx="934">
                        <c:v>1</c:v>
                      </c:pt>
                      <c:pt idx="935">
                        <c:v>1</c:v>
                      </c:pt>
                      <c:pt idx="936">
                        <c:v>1</c:v>
                      </c:pt>
                      <c:pt idx="938">
                        <c:v>1</c:v>
                      </c:pt>
                      <c:pt idx="939">
                        <c:v>3</c:v>
                      </c:pt>
                      <c:pt idx="940">
                        <c:v>1</c:v>
                      </c:pt>
                      <c:pt idx="941">
                        <c:v>1</c:v>
                      </c:pt>
                      <c:pt idx="943">
                        <c:v>1</c:v>
                      </c:pt>
                      <c:pt idx="944">
                        <c:v>1</c:v>
                      </c:pt>
                      <c:pt idx="945">
                        <c:v>1</c:v>
                      </c:pt>
                      <c:pt idx="946">
                        <c:v>1</c:v>
                      </c:pt>
                      <c:pt idx="947">
                        <c:v>1</c:v>
                      </c:pt>
                      <c:pt idx="948">
                        <c:v>1</c:v>
                      </c:pt>
                      <c:pt idx="949">
                        <c:v>1</c:v>
                      </c:pt>
                      <c:pt idx="950">
                        <c:v>1</c:v>
                      </c:pt>
                      <c:pt idx="951">
                        <c:v>2</c:v>
                      </c:pt>
                      <c:pt idx="952">
                        <c:v>2</c:v>
                      </c:pt>
                      <c:pt idx="953">
                        <c:v>1</c:v>
                      </c:pt>
                      <c:pt idx="954">
                        <c:v>2</c:v>
                      </c:pt>
                      <c:pt idx="955">
                        <c:v>7</c:v>
                      </c:pt>
                      <c:pt idx="956">
                        <c:v>10</c:v>
                      </c:pt>
                      <c:pt idx="957">
                        <c:v>6</c:v>
                      </c:pt>
                      <c:pt idx="958">
                        <c:v>2</c:v>
                      </c:pt>
                      <c:pt idx="959">
                        <c:v>1</c:v>
                      </c:pt>
                      <c:pt idx="960">
                        <c:v>1</c:v>
                      </c:pt>
                      <c:pt idx="961">
                        <c:v>1</c:v>
                      </c:pt>
                      <c:pt idx="962">
                        <c:v>16</c:v>
                      </c:pt>
                      <c:pt idx="963">
                        <c:v>20</c:v>
                      </c:pt>
                      <c:pt idx="964">
                        <c:v>1</c:v>
                      </c:pt>
                      <c:pt idx="965">
                        <c:v>2</c:v>
                      </c:pt>
                      <c:pt idx="966">
                        <c:v>3</c:v>
                      </c:pt>
                      <c:pt idx="967">
                        <c:v>1</c:v>
                      </c:pt>
                      <c:pt idx="968">
                        <c:v>2</c:v>
                      </c:pt>
                      <c:pt idx="969">
                        <c:v>9</c:v>
                      </c:pt>
                      <c:pt idx="970">
                        <c:v>1</c:v>
                      </c:pt>
                      <c:pt idx="971">
                        <c:v>1</c:v>
                      </c:pt>
                      <c:pt idx="972">
                        <c:v>1</c:v>
                      </c:pt>
                      <c:pt idx="973">
                        <c:v>5</c:v>
                      </c:pt>
                      <c:pt idx="974">
                        <c:v>3</c:v>
                      </c:pt>
                      <c:pt idx="975">
                        <c:v>1</c:v>
                      </c:pt>
                      <c:pt idx="976">
                        <c:v>1</c:v>
                      </c:pt>
                      <c:pt idx="977">
                        <c:v>1</c:v>
                      </c:pt>
                      <c:pt idx="978">
                        <c:v>6</c:v>
                      </c:pt>
                      <c:pt idx="979">
                        <c:v>1</c:v>
                      </c:pt>
                      <c:pt idx="980">
                        <c:v>1</c:v>
                      </c:pt>
                      <c:pt idx="981">
                        <c:v>1</c:v>
                      </c:pt>
                      <c:pt idx="982">
                        <c:v>1</c:v>
                      </c:pt>
                      <c:pt idx="983">
                        <c:v>2</c:v>
                      </c:pt>
                      <c:pt idx="984">
                        <c:v>3</c:v>
                      </c:pt>
                      <c:pt idx="985">
                        <c:v>3</c:v>
                      </c:pt>
                      <c:pt idx="986">
                        <c:v>3</c:v>
                      </c:pt>
                      <c:pt idx="987">
                        <c:v>14</c:v>
                      </c:pt>
                      <c:pt idx="988">
                        <c:v>2</c:v>
                      </c:pt>
                      <c:pt idx="989">
                        <c:v>1</c:v>
                      </c:pt>
                      <c:pt idx="990">
                        <c:v>4</c:v>
                      </c:pt>
                      <c:pt idx="991">
                        <c:v>162</c:v>
                      </c:pt>
                      <c:pt idx="992">
                        <c:v>54</c:v>
                      </c:pt>
                      <c:pt idx="993">
                        <c:v>2</c:v>
                      </c:pt>
                      <c:pt idx="994">
                        <c:v>3</c:v>
                      </c:pt>
                      <c:pt idx="995">
                        <c:v>4</c:v>
                      </c:pt>
                      <c:pt idx="996">
                        <c:v>2</c:v>
                      </c:pt>
                      <c:pt idx="997">
                        <c:v>2</c:v>
                      </c:pt>
                      <c:pt idx="998">
                        <c:v>2</c:v>
                      </c:pt>
                      <c:pt idx="999">
                        <c:v>1</c:v>
                      </c:pt>
                      <c:pt idx="1000">
                        <c:v>8</c:v>
                      </c:pt>
                      <c:pt idx="1001">
                        <c:v>11</c:v>
                      </c:pt>
                      <c:pt idx="1002">
                        <c:v>1</c:v>
                      </c:pt>
                      <c:pt idx="1003">
                        <c:v>1</c:v>
                      </c:pt>
                      <c:pt idx="1004">
                        <c:v>1</c:v>
                      </c:pt>
                      <c:pt idx="1005">
                        <c:v>3</c:v>
                      </c:pt>
                      <c:pt idx="1006">
                        <c:v>2</c:v>
                      </c:pt>
                      <c:pt idx="1007">
                        <c:v>3</c:v>
                      </c:pt>
                      <c:pt idx="1008">
                        <c:v>1</c:v>
                      </c:pt>
                      <c:pt idx="1009">
                        <c:v>1</c:v>
                      </c:pt>
                      <c:pt idx="1010">
                        <c:v>1</c:v>
                      </c:pt>
                      <c:pt idx="1011">
                        <c:v>1</c:v>
                      </c:pt>
                      <c:pt idx="1012">
                        <c:v>1</c:v>
                      </c:pt>
                      <c:pt idx="1013">
                        <c:v>2</c:v>
                      </c:pt>
                      <c:pt idx="1014">
                        <c:v>1</c:v>
                      </c:pt>
                      <c:pt idx="1016">
                        <c:v>1</c:v>
                      </c:pt>
                      <c:pt idx="1017">
                        <c:v>1</c:v>
                      </c:pt>
                      <c:pt idx="1018">
                        <c:v>1</c:v>
                      </c:pt>
                      <c:pt idx="1019">
                        <c:v>1</c:v>
                      </c:pt>
                      <c:pt idx="1020">
                        <c:v>1</c:v>
                      </c:pt>
                      <c:pt idx="1023">
                        <c:v>1</c:v>
                      </c:pt>
                      <c:pt idx="1025">
                        <c:v>1</c:v>
                      </c:pt>
                      <c:pt idx="1026">
                        <c:v>7</c:v>
                      </c:pt>
                      <c:pt idx="1027">
                        <c:v>1</c:v>
                      </c:pt>
                      <c:pt idx="1028">
                        <c:v>1</c:v>
                      </c:pt>
                      <c:pt idx="1029">
                        <c:v>2</c:v>
                      </c:pt>
                      <c:pt idx="1030">
                        <c:v>1</c:v>
                      </c:pt>
                      <c:pt idx="1034">
                        <c:v>1</c:v>
                      </c:pt>
                      <c:pt idx="1035">
                        <c:v>1</c:v>
                      </c:pt>
                      <c:pt idx="1037">
                        <c:v>1</c:v>
                      </c:pt>
                      <c:pt idx="1038">
                        <c:v>1</c:v>
                      </c:pt>
                      <c:pt idx="1040">
                        <c:v>1</c:v>
                      </c:pt>
                      <c:pt idx="1041">
                        <c:v>1</c:v>
                      </c:pt>
                      <c:pt idx="1042">
                        <c:v>1</c:v>
                      </c:pt>
                      <c:pt idx="1044">
                        <c:v>1</c:v>
                      </c:pt>
                      <c:pt idx="1045">
                        <c:v>1</c:v>
                      </c:pt>
                      <c:pt idx="1046">
                        <c:v>1</c:v>
                      </c:pt>
                      <c:pt idx="1051">
                        <c:v>1</c:v>
                      </c:pt>
                      <c:pt idx="1053">
                        <c:v>1</c:v>
                      </c:pt>
                      <c:pt idx="1055">
                        <c:v>1</c:v>
                      </c:pt>
                    </c:numCache>
                  </c:numRef>
                </c:yVal>
                <c:smooth val="0"/>
              </c15:ser>
            </c15:filteredScatterSeries>
            <c15:filteredScatterSeries>
              <c15:ser>
                <c:idx val="3"/>
                <c:order val="3"/>
                <c:tx>
                  <c:strRef>
                    <c:extLst xmlns:c15="http://schemas.microsoft.com/office/drawing/2012/chart">
                      <c:ext xmlns:c15="http://schemas.microsoft.com/office/drawing/2012/chart" uri="{02D57815-91ED-43cb-92C2-25804820EDAC}">
                        <c15:formulaRef>
                          <c15:sqref>'Brachy NFY'!$F$2</c15:sqref>
                        </c15:formulaRef>
                      </c:ext>
                    </c:extLst>
                    <c:strCache>
                      <c:ptCount val="1"/>
                      <c:pt idx="0">
                        <c:v>Cold2</c:v>
                      </c:pt>
                    </c:strCache>
                  </c:strRef>
                </c:tx>
                <c:spPr>
                  <a:ln w="25400" cap="rnd">
                    <a:noFill/>
                    <a:round/>
                  </a:ln>
                  <a:effectLst/>
                </c:spPr>
                <c:marker>
                  <c:symbol val="circle"/>
                  <c:size val="5"/>
                  <c:spPr>
                    <a:solidFill>
                      <a:schemeClr val="accent1">
                        <a:lumMod val="75000"/>
                      </a:schemeClr>
                    </a:solidFill>
                    <a:ln w="9525">
                      <a:solidFill>
                        <a:schemeClr val="accent1">
                          <a:lumMod val="75000"/>
                        </a:schemeClr>
                      </a:solidFill>
                    </a:ln>
                    <a:effectLst/>
                  </c:spPr>
                </c:marker>
                <c:xVal>
                  <c:numRef>
                    <c:extLst xmlns:c15="http://schemas.microsoft.com/office/drawing/2012/chart">
                      <c:ext xmlns:c15="http://schemas.microsoft.com/office/drawing/2012/chart" uri="{02D57815-91ED-43cb-92C2-25804820EDAC}">
                        <c15:formulaRef>
                          <c15:sqref>'Brachy NFY'!$B$3:$B$1060</c15:sqref>
                        </c15:formulaRef>
                      </c:ext>
                    </c:extLst>
                    <c:numCache>
                      <c:formatCode>General</c:formatCode>
                      <c:ptCount val="1058"/>
                      <c:pt idx="0">
                        <c:v>52</c:v>
                      </c:pt>
                      <c:pt idx="1">
                        <c:v>62</c:v>
                      </c:pt>
                      <c:pt idx="2">
                        <c:v>69</c:v>
                      </c:pt>
                      <c:pt idx="3">
                        <c:v>77</c:v>
                      </c:pt>
                      <c:pt idx="4">
                        <c:v>89</c:v>
                      </c:pt>
                      <c:pt idx="5">
                        <c:v>92</c:v>
                      </c:pt>
                      <c:pt idx="6">
                        <c:v>95</c:v>
                      </c:pt>
                      <c:pt idx="7">
                        <c:v>100</c:v>
                      </c:pt>
                      <c:pt idx="8">
                        <c:v>116</c:v>
                      </c:pt>
                      <c:pt idx="9">
                        <c:v>123</c:v>
                      </c:pt>
                      <c:pt idx="10">
                        <c:v>125</c:v>
                      </c:pt>
                      <c:pt idx="11">
                        <c:v>129</c:v>
                      </c:pt>
                      <c:pt idx="12">
                        <c:v>135</c:v>
                      </c:pt>
                      <c:pt idx="13">
                        <c:v>146</c:v>
                      </c:pt>
                      <c:pt idx="14">
                        <c:v>147</c:v>
                      </c:pt>
                      <c:pt idx="15">
                        <c:v>148</c:v>
                      </c:pt>
                      <c:pt idx="16">
                        <c:v>149</c:v>
                      </c:pt>
                      <c:pt idx="17">
                        <c:v>150</c:v>
                      </c:pt>
                      <c:pt idx="18">
                        <c:v>152</c:v>
                      </c:pt>
                      <c:pt idx="19">
                        <c:v>153</c:v>
                      </c:pt>
                      <c:pt idx="20">
                        <c:v>155</c:v>
                      </c:pt>
                      <c:pt idx="21">
                        <c:v>157</c:v>
                      </c:pt>
                      <c:pt idx="22">
                        <c:v>158</c:v>
                      </c:pt>
                      <c:pt idx="23">
                        <c:v>159</c:v>
                      </c:pt>
                      <c:pt idx="24">
                        <c:v>160</c:v>
                      </c:pt>
                      <c:pt idx="25">
                        <c:v>162</c:v>
                      </c:pt>
                      <c:pt idx="26">
                        <c:v>164</c:v>
                      </c:pt>
                      <c:pt idx="27">
                        <c:v>169</c:v>
                      </c:pt>
                      <c:pt idx="28">
                        <c:v>171</c:v>
                      </c:pt>
                      <c:pt idx="29">
                        <c:v>173</c:v>
                      </c:pt>
                      <c:pt idx="30">
                        <c:v>174</c:v>
                      </c:pt>
                      <c:pt idx="31">
                        <c:v>181</c:v>
                      </c:pt>
                      <c:pt idx="32">
                        <c:v>186</c:v>
                      </c:pt>
                      <c:pt idx="33">
                        <c:v>187</c:v>
                      </c:pt>
                      <c:pt idx="34">
                        <c:v>190</c:v>
                      </c:pt>
                      <c:pt idx="35">
                        <c:v>192</c:v>
                      </c:pt>
                      <c:pt idx="36">
                        <c:v>197</c:v>
                      </c:pt>
                      <c:pt idx="37">
                        <c:v>202</c:v>
                      </c:pt>
                      <c:pt idx="38">
                        <c:v>204</c:v>
                      </c:pt>
                      <c:pt idx="39">
                        <c:v>206</c:v>
                      </c:pt>
                      <c:pt idx="40">
                        <c:v>208</c:v>
                      </c:pt>
                      <c:pt idx="41">
                        <c:v>209</c:v>
                      </c:pt>
                      <c:pt idx="42">
                        <c:v>210</c:v>
                      </c:pt>
                      <c:pt idx="43">
                        <c:v>217</c:v>
                      </c:pt>
                      <c:pt idx="44">
                        <c:v>219</c:v>
                      </c:pt>
                      <c:pt idx="45">
                        <c:v>220</c:v>
                      </c:pt>
                      <c:pt idx="46">
                        <c:v>222</c:v>
                      </c:pt>
                      <c:pt idx="47">
                        <c:v>226</c:v>
                      </c:pt>
                      <c:pt idx="48">
                        <c:v>227</c:v>
                      </c:pt>
                      <c:pt idx="49">
                        <c:v>230</c:v>
                      </c:pt>
                      <c:pt idx="50">
                        <c:v>231</c:v>
                      </c:pt>
                      <c:pt idx="51">
                        <c:v>232</c:v>
                      </c:pt>
                      <c:pt idx="52">
                        <c:v>235</c:v>
                      </c:pt>
                      <c:pt idx="53">
                        <c:v>236</c:v>
                      </c:pt>
                      <c:pt idx="54">
                        <c:v>240</c:v>
                      </c:pt>
                      <c:pt idx="55">
                        <c:v>241</c:v>
                      </c:pt>
                      <c:pt idx="56">
                        <c:v>244</c:v>
                      </c:pt>
                      <c:pt idx="57">
                        <c:v>245</c:v>
                      </c:pt>
                      <c:pt idx="58">
                        <c:v>247</c:v>
                      </c:pt>
                      <c:pt idx="59">
                        <c:v>248</c:v>
                      </c:pt>
                      <c:pt idx="60">
                        <c:v>251</c:v>
                      </c:pt>
                      <c:pt idx="61">
                        <c:v>254</c:v>
                      </c:pt>
                      <c:pt idx="62">
                        <c:v>255</c:v>
                      </c:pt>
                      <c:pt idx="63">
                        <c:v>258</c:v>
                      </c:pt>
                      <c:pt idx="64">
                        <c:v>260</c:v>
                      </c:pt>
                      <c:pt idx="65">
                        <c:v>261</c:v>
                      </c:pt>
                      <c:pt idx="66">
                        <c:v>262</c:v>
                      </c:pt>
                      <c:pt idx="67">
                        <c:v>263</c:v>
                      </c:pt>
                      <c:pt idx="68">
                        <c:v>264</c:v>
                      </c:pt>
                      <c:pt idx="69">
                        <c:v>265</c:v>
                      </c:pt>
                      <c:pt idx="70">
                        <c:v>266</c:v>
                      </c:pt>
                      <c:pt idx="71">
                        <c:v>267</c:v>
                      </c:pt>
                      <c:pt idx="72">
                        <c:v>268</c:v>
                      </c:pt>
                      <c:pt idx="73">
                        <c:v>270</c:v>
                      </c:pt>
                      <c:pt idx="74">
                        <c:v>273</c:v>
                      </c:pt>
                      <c:pt idx="75">
                        <c:v>286</c:v>
                      </c:pt>
                      <c:pt idx="76">
                        <c:v>289</c:v>
                      </c:pt>
                      <c:pt idx="77">
                        <c:v>290</c:v>
                      </c:pt>
                      <c:pt idx="78">
                        <c:v>292</c:v>
                      </c:pt>
                      <c:pt idx="79">
                        <c:v>294</c:v>
                      </c:pt>
                      <c:pt idx="80">
                        <c:v>295</c:v>
                      </c:pt>
                      <c:pt idx="81">
                        <c:v>297</c:v>
                      </c:pt>
                      <c:pt idx="82">
                        <c:v>302</c:v>
                      </c:pt>
                      <c:pt idx="83">
                        <c:v>303</c:v>
                      </c:pt>
                      <c:pt idx="84">
                        <c:v>307</c:v>
                      </c:pt>
                      <c:pt idx="85">
                        <c:v>309</c:v>
                      </c:pt>
                      <c:pt idx="86">
                        <c:v>310</c:v>
                      </c:pt>
                      <c:pt idx="87">
                        <c:v>312</c:v>
                      </c:pt>
                      <c:pt idx="88">
                        <c:v>313</c:v>
                      </c:pt>
                      <c:pt idx="89">
                        <c:v>314</c:v>
                      </c:pt>
                      <c:pt idx="90">
                        <c:v>315</c:v>
                      </c:pt>
                      <c:pt idx="91">
                        <c:v>316</c:v>
                      </c:pt>
                      <c:pt idx="92">
                        <c:v>326</c:v>
                      </c:pt>
                      <c:pt idx="93">
                        <c:v>330</c:v>
                      </c:pt>
                      <c:pt idx="94">
                        <c:v>335</c:v>
                      </c:pt>
                      <c:pt idx="95">
                        <c:v>338</c:v>
                      </c:pt>
                      <c:pt idx="96">
                        <c:v>339</c:v>
                      </c:pt>
                      <c:pt idx="97">
                        <c:v>344</c:v>
                      </c:pt>
                      <c:pt idx="98">
                        <c:v>349</c:v>
                      </c:pt>
                      <c:pt idx="99">
                        <c:v>351</c:v>
                      </c:pt>
                      <c:pt idx="100">
                        <c:v>354</c:v>
                      </c:pt>
                      <c:pt idx="101">
                        <c:v>357</c:v>
                      </c:pt>
                      <c:pt idx="102">
                        <c:v>361</c:v>
                      </c:pt>
                      <c:pt idx="103">
                        <c:v>364</c:v>
                      </c:pt>
                      <c:pt idx="104">
                        <c:v>373</c:v>
                      </c:pt>
                      <c:pt idx="105">
                        <c:v>377</c:v>
                      </c:pt>
                      <c:pt idx="106">
                        <c:v>378</c:v>
                      </c:pt>
                      <c:pt idx="107">
                        <c:v>379</c:v>
                      </c:pt>
                      <c:pt idx="108">
                        <c:v>382</c:v>
                      </c:pt>
                      <c:pt idx="109">
                        <c:v>390</c:v>
                      </c:pt>
                      <c:pt idx="110">
                        <c:v>394</c:v>
                      </c:pt>
                      <c:pt idx="111">
                        <c:v>396</c:v>
                      </c:pt>
                      <c:pt idx="112">
                        <c:v>397</c:v>
                      </c:pt>
                      <c:pt idx="113">
                        <c:v>400</c:v>
                      </c:pt>
                      <c:pt idx="114">
                        <c:v>403</c:v>
                      </c:pt>
                      <c:pt idx="115">
                        <c:v>405</c:v>
                      </c:pt>
                      <c:pt idx="116">
                        <c:v>406</c:v>
                      </c:pt>
                      <c:pt idx="117">
                        <c:v>407</c:v>
                      </c:pt>
                      <c:pt idx="118">
                        <c:v>408</c:v>
                      </c:pt>
                      <c:pt idx="119">
                        <c:v>409</c:v>
                      </c:pt>
                      <c:pt idx="120">
                        <c:v>410</c:v>
                      </c:pt>
                      <c:pt idx="121">
                        <c:v>416</c:v>
                      </c:pt>
                      <c:pt idx="122">
                        <c:v>418</c:v>
                      </c:pt>
                      <c:pt idx="123">
                        <c:v>423</c:v>
                      </c:pt>
                      <c:pt idx="124">
                        <c:v>424</c:v>
                      </c:pt>
                      <c:pt idx="125">
                        <c:v>426</c:v>
                      </c:pt>
                      <c:pt idx="126">
                        <c:v>428</c:v>
                      </c:pt>
                      <c:pt idx="127">
                        <c:v>429</c:v>
                      </c:pt>
                      <c:pt idx="128">
                        <c:v>430</c:v>
                      </c:pt>
                      <c:pt idx="129">
                        <c:v>433</c:v>
                      </c:pt>
                      <c:pt idx="130">
                        <c:v>438</c:v>
                      </c:pt>
                      <c:pt idx="131">
                        <c:v>440</c:v>
                      </c:pt>
                      <c:pt idx="132">
                        <c:v>450</c:v>
                      </c:pt>
                      <c:pt idx="133">
                        <c:v>453</c:v>
                      </c:pt>
                      <c:pt idx="134">
                        <c:v>460</c:v>
                      </c:pt>
                      <c:pt idx="135">
                        <c:v>461</c:v>
                      </c:pt>
                      <c:pt idx="136">
                        <c:v>464</c:v>
                      </c:pt>
                      <c:pt idx="137">
                        <c:v>465</c:v>
                      </c:pt>
                      <c:pt idx="138">
                        <c:v>466</c:v>
                      </c:pt>
                      <c:pt idx="139">
                        <c:v>467</c:v>
                      </c:pt>
                      <c:pt idx="140">
                        <c:v>468</c:v>
                      </c:pt>
                      <c:pt idx="141">
                        <c:v>469</c:v>
                      </c:pt>
                      <c:pt idx="142">
                        <c:v>470</c:v>
                      </c:pt>
                      <c:pt idx="143">
                        <c:v>471</c:v>
                      </c:pt>
                      <c:pt idx="144">
                        <c:v>472</c:v>
                      </c:pt>
                      <c:pt idx="145">
                        <c:v>473</c:v>
                      </c:pt>
                      <c:pt idx="146">
                        <c:v>474</c:v>
                      </c:pt>
                      <c:pt idx="147">
                        <c:v>475</c:v>
                      </c:pt>
                      <c:pt idx="148">
                        <c:v>477</c:v>
                      </c:pt>
                      <c:pt idx="149">
                        <c:v>478</c:v>
                      </c:pt>
                      <c:pt idx="150">
                        <c:v>479</c:v>
                      </c:pt>
                      <c:pt idx="151">
                        <c:v>480</c:v>
                      </c:pt>
                      <c:pt idx="152">
                        <c:v>485</c:v>
                      </c:pt>
                      <c:pt idx="153">
                        <c:v>488</c:v>
                      </c:pt>
                      <c:pt idx="154">
                        <c:v>489</c:v>
                      </c:pt>
                      <c:pt idx="155">
                        <c:v>491</c:v>
                      </c:pt>
                      <c:pt idx="156">
                        <c:v>492</c:v>
                      </c:pt>
                      <c:pt idx="157">
                        <c:v>494</c:v>
                      </c:pt>
                      <c:pt idx="158">
                        <c:v>495</c:v>
                      </c:pt>
                      <c:pt idx="159">
                        <c:v>497</c:v>
                      </c:pt>
                      <c:pt idx="160">
                        <c:v>498</c:v>
                      </c:pt>
                      <c:pt idx="161">
                        <c:v>499</c:v>
                      </c:pt>
                      <c:pt idx="162">
                        <c:v>500</c:v>
                      </c:pt>
                      <c:pt idx="163">
                        <c:v>501</c:v>
                      </c:pt>
                      <c:pt idx="164">
                        <c:v>502</c:v>
                      </c:pt>
                      <c:pt idx="165">
                        <c:v>503</c:v>
                      </c:pt>
                      <c:pt idx="166">
                        <c:v>504</c:v>
                      </c:pt>
                      <c:pt idx="167">
                        <c:v>505</c:v>
                      </c:pt>
                      <c:pt idx="168">
                        <c:v>508</c:v>
                      </c:pt>
                      <c:pt idx="169">
                        <c:v>510</c:v>
                      </c:pt>
                      <c:pt idx="170">
                        <c:v>511</c:v>
                      </c:pt>
                      <c:pt idx="171">
                        <c:v>513</c:v>
                      </c:pt>
                      <c:pt idx="172">
                        <c:v>516</c:v>
                      </c:pt>
                      <c:pt idx="173">
                        <c:v>518</c:v>
                      </c:pt>
                      <c:pt idx="174">
                        <c:v>519</c:v>
                      </c:pt>
                      <c:pt idx="175">
                        <c:v>520</c:v>
                      </c:pt>
                      <c:pt idx="176">
                        <c:v>521</c:v>
                      </c:pt>
                      <c:pt idx="177">
                        <c:v>522</c:v>
                      </c:pt>
                      <c:pt idx="178">
                        <c:v>523</c:v>
                      </c:pt>
                      <c:pt idx="179">
                        <c:v>524</c:v>
                      </c:pt>
                      <c:pt idx="180">
                        <c:v>525</c:v>
                      </c:pt>
                      <c:pt idx="181">
                        <c:v>527</c:v>
                      </c:pt>
                      <c:pt idx="182">
                        <c:v>530</c:v>
                      </c:pt>
                      <c:pt idx="183">
                        <c:v>531</c:v>
                      </c:pt>
                      <c:pt idx="184">
                        <c:v>532</c:v>
                      </c:pt>
                      <c:pt idx="185">
                        <c:v>533</c:v>
                      </c:pt>
                      <c:pt idx="186">
                        <c:v>537</c:v>
                      </c:pt>
                      <c:pt idx="187">
                        <c:v>538</c:v>
                      </c:pt>
                      <c:pt idx="188">
                        <c:v>539</c:v>
                      </c:pt>
                      <c:pt idx="189">
                        <c:v>541</c:v>
                      </c:pt>
                      <c:pt idx="190">
                        <c:v>542</c:v>
                      </c:pt>
                      <c:pt idx="191">
                        <c:v>543</c:v>
                      </c:pt>
                      <c:pt idx="192">
                        <c:v>544</c:v>
                      </c:pt>
                      <c:pt idx="193">
                        <c:v>545</c:v>
                      </c:pt>
                      <c:pt idx="194">
                        <c:v>549</c:v>
                      </c:pt>
                      <c:pt idx="195">
                        <c:v>550</c:v>
                      </c:pt>
                      <c:pt idx="196">
                        <c:v>551</c:v>
                      </c:pt>
                      <c:pt idx="197">
                        <c:v>552</c:v>
                      </c:pt>
                      <c:pt idx="198">
                        <c:v>553</c:v>
                      </c:pt>
                      <c:pt idx="199">
                        <c:v>554</c:v>
                      </c:pt>
                      <c:pt idx="200">
                        <c:v>555</c:v>
                      </c:pt>
                      <c:pt idx="201">
                        <c:v>556</c:v>
                      </c:pt>
                      <c:pt idx="202">
                        <c:v>557</c:v>
                      </c:pt>
                      <c:pt idx="203">
                        <c:v>558</c:v>
                      </c:pt>
                      <c:pt idx="204">
                        <c:v>561</c:v>
                      </c:pt>
                      <c:pt idx="205">
                        <c:v>562</c:v>
                      </c:pt>
                      <c:pt idx="206">
                        <c:v>564</c:v>
                      </c:pt>
                      <c:pt idx="207">
                        <c:v>565</c:v>
                      </c:pt>
                      <c:pt idx="208">
                        <c:v>568</c:v>
                      </c:pt>
                      <c:pt idx="209">
                        <c:v>570</c:v>
                      </c:pt>
                      <c:pt idx="210">
                        <c:v>571</c:v>
                      </c:pt>
                      <c:pt idx="211">
                        <c:v>573</c:v>
                      </c:pt>
                      <c:pt idx="212">
                        <c:v>574</c:v>
                      </c:pt>
                      <c:pt idx="213">
                        <c:v>575</c:v>
                      </c:pt>
                      <c:pt idx="214">
                        <c:v>582</c:v>
                      </c:pt>
                      <c:pt idx="215">
                        <c:v>586</c:v>
                      </c:pt>
                      <c:pt idx="216">
                        <c:v>587</c:v>
                      </c:pt>
                      <c:pt idx="217">
                        <c:v>589</c:v>
                      </c:pt>
                      <c:pt idx="218">
                        <c:v>590</c:v>
                      </c:pt>
                      <c:pt idx="219">
                        <c:v>591</c:v>
                      </c:pt>
                      <c:pt idx="220">
                        <c:v>592</c:v>
                      </c:pt>
                      <c:pt idx="221">
                        <c:v>595</c:v>
                      </c:pt>
                      <c:pt idx="222">
                        <c:v>596</c:v>
                      </c:pt>
                      <c:pt idx="223">
                        <c:v>597</c:v>
                      </c:pt>
                      <c:pt idx="224">
                        <c:v>598</c:v>
                      </c:pt>
                      <c:pt idx="225">
                        <c:v>604</c:v>
                      </c:pt>
                      <c:pt idx="226">
                        <c:v>605</c:v>
                      </c:pt>
                      <c:pt idx="227">
                        <c:v>608</c:v>
                      </c:pt>
                      <c:pt idx="228">
                        <c:v>609</c:v>
                      </c:pt>
                      <c:pt idx="229">
                        <c:v>610</c:v>
                      </c:pt>
                      <c:pt idx="230">
                        <c:v>611</c:v>
                      </c:pt>
                      <c:pt idx="231">
                        <c:v>612</c:v>
                      </c:pt>
                      <c:pt idx="232">
                        <c:v>613</c:v>
                      </c:pt>
                      <c:pt idx="233">
                        <c:v>623</c:v>
                      </c:pt>
                      <c:pt idx="234">
                        <c:v>624</c:v>
                      </c:pt>
                      <c:pt idx="235">
                        <c:v>625</c:v>
                      </c:pt>
                      <c:pt idx="236">
                        <c:v>627</c:v>
                      </c:pt>
                      <c:pt idx="237">
                        <c:v>628</c:v>
                      </c:pt>
                      <c:pt idx="238">
                        <c:v>629</c:v>
                      </c:pt>
                      <c:pt idx="239">
                        <c:v>631</c:v>
                      </c:pt>
                      <c:pt idx="240">
                        <c:v>634</c:v>
                      </c:pt>
                      <c:pt idx="241">
                        <c:v>636</c:v>
                      </c:pt>
                      <c:pt idx="242">
                        <c:v>638</c:v>
                      </c:pt>
                      <c:pt idx="243">
                        <c:v>639</c:v>
                      </c:pt>
                      <c:pt idx="244">
                        <c:v>642</c:v>
                      </c:pt>
                      <c:pt idx="245">
                        <c:v>643</c:v>
                      </c:pt>
                      <c:pt idx="246">
                        <c:v>644</c:v>
                      </c:pt>
                      <c:pt idx="247">
                        <c:v>646</c:v>
                      </c:pt>
                      <c:pt idx="248">
                        <c:v>647</c:v>
                      </c:pt>
                      <c:pt idx="249">
                        <c:v>649</c:v>
                      </c:pt>
                      <c:pt idx="250">
                        <c:v>650</c:v>
                      </c:pt>
                      <c:pt idx="251">
                        <c:v>652</c:v>
                      </c:pt>
                      <c:pt idx="252">
                        <c:v>653</c:v>
                      </c:pt>
                      <c:pt idx="253">
                        <c:v>654</c:v>
                      </c:pt>
                      <c:pt idx="254">
                        <c:v>656</c:v>
                      </c:pt>
                      <c:pt idx="255">
                        <c:v>657</c:v>
                      </c:pt>
                      <c:pt idx="256">
                        <c:v>659</c:v>
                      </c:pt>
                      <c:pt idx="257">
                        <c:v>661</c:v>
                      </c:pt>
                      <c:pt idx="258">
                        <c:v>665</c:v>
                      </c:pt>
                      <c:pt idx="259">
                        <c:v>667</c:v>
                      </c:pt>
                      <c:pt idx="260">
                        <c:v>668</c:v>
                      </c:pt>
                      <c:pt idx="261">
                        <c:v>669</c:v>
                      </c:pt>
                      <c:pt idx="262">
                        <c:v>670</c:v>
                      </c:pt>
                      <c:pt idx="263">
                        <c:v>671</c:v>
                      </c:pt>
                      <c:pt idx="264">
                        <c:v>672</c:v>
                      </c:pt>
                      <c:pt idx="265">
                        <c:v>673</c:v>
                      </c:pt>
                      <c:pt idx="266">
                        <c:v>674</c:v>
                      </c:pt>
                      <c:pt idx="267">
                        <c:v>675</c:v>
                      </c:pt>
                      <c:pt idx="268">
                        <c:v>676</c:v>
                      </c:pt>
                      <c:pt idx="269">
                        <c:v>677</c:v>
                      </c:pt>
                      <c:pt idx="270">
                        <c:v>678</c:v>
                      </c:pt>
                      <c:pt idx="271">
                        <c:v>681</c:v>
                      </c:pt>
                      <c:pt idx="272">
                        <c:v>682</c:v>
                      </c:pt>
                      <c:pt idx="273">
                        <c:v>683</c:v>
                      </c:pt>
                      <c:pt idx="274">
                        <c:v>684</c:v>
                      </c:pt>
                      <c:pt idx="275">
                        <c:v>685</c:v>
                      </c:pt>
                      <c:pt idx="276">
                        <c:v>686</c:v>
                      </c:pt>
                      <c:pt idx="277">
                        <c:v>687</c:v>
                      </c:pt>
                      <c:pt idx="278">
                        <c:v>688</c:v>
                      </c:pt>
                      <c:pt idx="279">
                        <c:v>689</c:v>
                      </c:pt>
                      <c:pt idx="280">
                        <c:v>693</c:v>
                      </c:pt>
                      <c:pt idx="281">
                        <c:v>694</c:v>
                      </c:pt>
                      <c:pt idx="282">
                        <c:v>698</c:v>
                      </c:pt>
                      <c:pt idx="283">
                        <c:v>701</c:v>
                      </c:pt>
                      <c:pt idx="284">
                        <c:v>702</c:v>
                      </c:pt>
                      <c:pt idx="285">
                        <c:v>703</c:v>
                      </c:pt>
                      <c:pt idx="286">
                        <c:v>707</c:v>
                      </c:pt>
                      <c:pt idx="287">
                        <c:v>708</c:v>
                      </c:pt>
                      <c:pt idx="288">
                        <c:v>712</c:v>
                      </c:pt>
                      <c:pt idx="289">
                        <c:v>713</c:v>
                      </c:pt>
                      <c:pt idx="290">
                        <c:v>714</c:v>
                      </c:pt>
                      <c:pt idx="291">
                        <c:v>719</c:v>
                      </c:pt>
                      <c:pt idx="292">
                        <c:v>720</c:v>
                      </c:pt>
                      <c:pt idx="293">
                        <c:v>721</c:v>
                      </c:pt>
                      <c:pt idx="294">
                        <c:v>723</c:v>
                      </c:pt>
                      <c:pt idx="295">
                        <c:v>724</c:v>
                      </c:pt>
                      <c:pt idx="296">
                        <c:v>725</c:v>
                      </c:pt>
                      <c:pt idx="297">
                        <c:v>726</c:v>
                      </c:pt>
                      <c:pt idx="298">
                        <c:v>727</c:v>
                      </c:pt>
                      <c:pt idx="299">
                        <c:v>728</c:v>
                      </c:pt>
                      <c:pt idx="300">
                        <c:v>729</c:v>
                      </c:pt>
                      <c:pt idx="301">
                        <c:v>730</c:v>
                      </c:pt>
                      <c:pt idx="302">
                        <c:v>732</c:v>
                      </c:pt>
                      <c:pt idx="303">
                        <c:v>734</c:v>
                      </c:pt>
                      <c:pt idx="304">
                        <c:v>735</c:v>
                      </c:pt>
                      <c:pt idx="305">
                        <c:v>736</c:v>
                      </c:pt>
                      <c:pt idx="306">
                        <c:v>737</c:v>
                      </c:pt>
                      <c:pt idx="307">
                        <c:v>738</c:v>
                      </c:pt>
                      <c:pt idx="308">
                        <c:v>739</c:v>
                      </c:pt>
                      <c:pt idx="309">
                        <c:v>740</c:v>
                      </c:pt>
                      <c:pt idx="310">
                        <c:v>741</c:v>
                      </c:pt>
                      <c:pt idx="311">
                        <c:v>742</c:v>
                      </c:pt>
                      <c:pt idx="312">
                        <c:v>743</c:v>
                      </c:pt>
                      <c:pt idx="313">
                        <c:v>744</c:v>
                      </c:pt>
                      <c:pt idx="314">
                        <c:v>745</c:v>
                      </c:pt>
                      <c:pt idx="315">
                        <c:v>746</c:v>
                      </c:pt>
                      <c:pt idx="316">
                        <c:v>747</c:v>
                      </c:pt>
                      <c:pt idx="317">
                        <c:v>748</c:v>
                      </c:pt>
                      <c:pt idx="318">
                        <c:v>749</c:v>
                      </c:pt>
                      <c:pt idx="319">
                        <c:v>750</c:v>
                      </c:pt>
                      <c:pt idx="320">
                        <c:v>751</c:v>
                      </c:pt>
                      <c:pt idx="321">
                        <c:v>757</c:v>
                      </c:pt>
                      <c:pt idx="322">
                        <c:v>758</c:v>
                      </c:pt>
                      <c:pt idx="323">
                        <c:v>759</c:v>
                      </c:pt>
                      <c:pt idx="324">
                        <c:v>760</c:v>
                      </c:pt>
                      <c:pt idx="325">
                        <c:v>761</c:v>
                      </c:pt>
                      <c:pt idx="326">
                        <c:v>762</c:v>
                      </c:pt>
                      <c:pt idx="327">
                        <c:v>765</c:v>
                      </c:pt>
                      <c:pt idx="328">
                        <c:v>766</c:v>
                      </c:pt>
                      <c:pt idx="329">
                        <c:v>767</c:v>
                      </c:pt>
                      <c:pt idx="330">
                        <c:v>769</c:v>
                      </c:pt>
                      <c:pt idx="331">
                        <c:v>770</c:v>
                      </c:pt>
                      <c:pt idx="332">
                        <c:v>772</c:v>
                      </c:pt>
                      <c:pt idx="333">
                        <c:v>773</c:v>
                      </c:pt>
                      <c:pt idx="334">
                        <c:v>774</c:v>
                      </c:pt>
                      <c:pt idx="335">
                        <c:v>775</c:v>
                      </c:pt>
                      <c:pt idx="336">
                        <c:v>776</c:v>
                      </c:pt>
                      <c:pt idx="337">
                        <c:v>777</c:v>
                      </c:pt>
                      <c:pt idx="338">
                        <c:v>778</c:v>
                      </c:pt>
                      <c:pt idx="339">
                        <c:v>779</c:v>
                      </c:pt>
                      <c:pt idx="340">
                        <c:v>781</c:v>
                      </c:pt>
                      <c:pt idx="341">
                        <c:v>782</c:v>
                      </c:pt>
                      <c:pt idx="342">
                        <c:v>783</c:v>
                      </c:pt>
                      <c:pt idx="343">
                        <c:v>784</c:v>
                      </c:pt>
                      <c:pt idx="344">
                        <c:v>786</c:v>
                      </c:pt>
                      <c:pt idx="345">
                        <c:v>787</c:v>
                      </c:pt>
                      <c:pt idx="346">
                        <c:v>788</c:v>
                      </c:pt>
                      <c:pt idx="347">
                        <c:v>789</c:v>
                      </c:pt>
                      <c:pt idx="348">
                        <c:v>790</c:v>
                      </c:pt>
                      <c:pt idx="349">
                        <c:v>794</c:v>
                      </c:pt>
                      <c:pt idx="350">
                        <c:v>795</c:v>
                      </c:pt>
                      <c:pt idx="351">
                        <c:v>796</c:v>
                      </c:pt>
                      <c:pt idx="352">
                        <c:v>797</c:v>
                      </c:pt>
                      <c:pt idx="353">
                        <c:v>798</c:v>
                      </c:pt>
                      <c:pt idx="354">
                        <c:v>800</c:v>
                      </c:pt>
                      <c:pt idx="355">
                        <c:v>801</c:v>
                      </c:pt>
                      <c:pt idx="356">
                        <c:v>802</c:v>
                      </c:pt>
                      <c:pt idx="357">
                        <c:v>803</c:v>
                      </c:pt>
                      <c:pt idx="358">
                        <c:v>804</c:v>
                      </c:pt>
                      <c:pt idx="359">
                        <c:v>805</c:v>
                      </c:pt>
                      <c:pt idx="360">
                        <c:v>806</c:v>
                      </c:pt>
                      <c:pt idx="361">
                        <c:v>807</c:v>
                      </c:pt>
                      <c:pt idx="362">
                        <c:v>808</c:v>
                      </c:pt>
                      <c:pt idx="363">
                        <c:v>811</c:v>
                      </c:pt>
                      <c:pt idx="364">
                        <c:v>812</c:v>
                      </c:pt>
                      <c:pt idx="365">
                        <c:v>813</c:v>
                      </c:pt>
                      <c:pt idx="366">
                        <c:v>814</c:v>
                      </c:pt>
                      <c:pt idx="367">
                        <c:v>815</c:v>
                      </c:pt>
                      <c:pt idx="368">
                        <c:v>816</c:v>
                      </c:pt>
                      <c:pt idx="369">
                        <c:v>817</c:v>
                      </c:pt>
                      <c:pt idx="370">
                        <c:v>818</c:v>
                      </c:pt>
                      <c:pt idx="371">
                        <c:v>819</c:v>
                      </c:pt>
                      <c:pt idx="372">
                        <c:v>820</c:v>
                      </c:pt>
                      <c:pt idx="373">
                        <c:v>821</c:v>
                      </c:pt>
                      <c:pt idx="374">
                        <c:v>822</c:v>
                      </c:pt>
                      <c:pt idx="375">
                        <c:v>823</c:v>
                      </c:pt>
                      <c:pt idx="376">
                        <c:v>825</c:v>
                      </c:pt>
                      <c:pt idx="377">
                        <c:v>826</c:v>
                      </c:pt>
                      <c:pt idx="378">
                        <c:v>827</c:v>
                      </c:pt>
                      <c:pt idx="379">
                        <c:v>828</c:v>
                      </c:pt>
                      <c:pt idx="380">
                        <c:v>829</c:v>
                      </c:pt>
                      <c:pt idx="381">
                        <c:v>830</c:v>
                      </c:pt>
                      <c:pt idx="382">
                        <c:v>831</c:v>
                      </c:pt>
                      <c:pt idx="383">
                        <c:v>832</c:v>
                      </c:pt>
                      <c:pt idx="384">
                        <c:v>834</c:v>
                      </c:pt>
                      <c:pt idx="385">
                        <c:v>836</c:v>
                      </c:pt>
                      <c:pt idx="386">
                        <c:v>837</c:v>
                      </c:pt>
                      <c:pt idx="387">
                        <c:v>838</c:v>
                      </c:pt>
                      <c:pt idx="388">
                        <c:v>839</c:v>
                      </c:pt>
                      <c:pt idx="389">
                        <c:v>840</c:v>
                      </c:pt>
                      <c:pt idx="390">
                        <c:v>842</c:v>
                      </c:pt>
                      <c:pt idx="391">
                        <c:v>843</c:v>
                      </c:pt>
                      <c:pt idx="392">
                        <c:v>844</c:v>
                      </c:pt>
                      <c:pt idx="393">
                        <c:v>845</c:v>
                      </c:pt>
                      <c:pt idx="394">
                        <c:v>846</c:v>
                      </c:pt>
                      <c:pt idx="395">
                        <c:v>847</c:v>
                      </c:pt>
                      <c:pt idx="396">
                        <c:v>848</c:v>
                      </c:pt>
                      <c:pt idx="397">
                        <c:v>849</c:v>
                      </c:pt>
                      <c:pt idx="398">
                        <c:v>850</c:v>
                      </c:pt>
                      <c:pt idx="399">
                        <c:v>851</c:v>
                      </c:pt>
                      <c:pt idx="400">
                        <c:v>853</c:v>
                      </c:pt>
                      <c:pt idx="401">
                        <c:v>854</c:v>
                      </c:pt>
                      <c:pt idx="402">
                        <c:v>855</c:v>
                      </c:pt>
                      <c:pt idx="403">
                        <c:v>856</c:v>
                      </c:pt>
                      <c:pt idx="404">
                        <c:v>857</c:v>
                      </c:pt>
                      <c:pt idx="405">
                        <c:v>859</c:v>
                      </c:pt>
                      <c:pt idx="406">
                        <c:v>860</c:v>
                      </c:pt>
                      <c:pt idx="407">
                        <c:v>861</c:v>
                      </c:pt>
                      <c:pt idx="408">
                        <c:v>862</c:v>
                      </c:pt>
                      <c:pt idx="409">
                        <c:v>863</c:v>
                      </c:pt>
                      <c:pt idx="410">
                        <c:v>865</c:v>
                      </c:pt>
                      <c:pt idx="411">
                        <c:v>867</c:v>
                      </c:pt>
                      <c:pt idx="412">
                        <c:v>868</c:v>
                      </c:pt>
                      <c:pt idx="413">
                        <c:v>869</c:v>
                      </c:pt>
                      <c:pt idx="414">
                        <c:v>876</c:v>
                      </c:pt>
                      <c:pt idx="415">
                        <c:v>877</c:v>
                      </c:pt>
                      <c:pt idx="416">
                        <c:v>882</c:v>
                      </c:pt>
                      <c:pt idx="417">
                        <c:v>883</c:v>
                      </c:pt>
                      <c:pt idx="418">
                        <c:v>885</c:v>
                      </c:pt>
                      <c:pt idx="419">
                        <c:v>886</c:v>
                      </c:pt>
                      <c:pt idx="420">
                        <c:v>887</c:v>
                      </c:pt>
                      <c:pt idx="421">
                        <c:v>888</c:v>
                      </c:pt>
                      <c:pt idx="422">
                        <c:v>889</c:v>
                      </c:pt>
                      <c:pt idx="423">
                        <c:v>890</c:v>
                      </c:pt>
                      <c:pt idx="424">
                        <c:v>891</c:v>
                      </c:pt>
                      <c:pt idx="425">
                        <c:v>892</c:v>
                      </c:pt>
                      <c:pt idx="426">
                        <c:v>893</c:v>
                      </c:pt>
                      <c:pt idx="427">
                        <c:v>895</c:v>
                      </c:pt>
                      <c:pt idx="428">
                        <c:v>896</c:v>
                      </c:pt>
                      <c:pt idx="429">
                        <c:v>897</c:v>
                      </c:pt>
                      <c:pt idx="430">
                        <c:v>898</c:v>
                      </c:pt>
                      <c:pt idx="431">
                        <c:v>900</c:v>
                      </c:pt>
                      <c:pt idx="432">
                        <c:v>901</c:v>
                      </c:pt>
                      <c:pt idx="433">
                        <c:v>902</c:v>
                      </c:pt>
                      <c:pt idx="434">
                        <c:v>903</c:v>
                      </c:pt>
                      <c:pt idx="435">
                        <c:v>904</c:v>
                      </c:pt>
                      <c:pt idx="436">
                        <c:v>905</c:v>
                      </c:pt>
                      <c:pt idx="437">
                        <c:v>907</c:v>
                      </c:pt>
                      <c:pt idx="438">
                        <c:v>908</c:v>
                      </c:pt>
                      <c:pt idx="439">
                        <c:v>909</c:v>
                      </c:pt>
                      <c:pt idx="440">
                        <c:v>910</c:v>
                      </c:pt>
                      <c:pt idx="441">
                        <c:v>911</c:v>
                      </c:pt>
                      <c:pt idx="442">
                        <c:v>912</c:v>
                      </c:pt>
                      <c:pt idx="443">
                        <c:v>913</c:v>
                      </c:pt>
                      <c:pt idx="444">
                        <c:v>918</c:v>
                      </c:pt>
                      <c:pt idx="445">
                        <c:v>919</c:v>
                      </c:pt>
                      <c:pt idx="446">
                        <c:v>920</c:v>
                      </c:pt>
                      <c:pt idx="447">
                        <c:v>922</c:v>
                      </c:pt>
                      <c:pt idx="448">
                        <c:v>923</c:v>
                      </c:pt>
                      <c:pt idx="449">
                        <c:v>924</c:v>
                      </c:pt>
                      <c:pt idx="450">
                        <c:v>925</c:v>
                      </c:pt>
                      <c:pt idx="451">
                        <c:v>926</c:v>
                      </c:pt>
                      <c:pt idx="452">
                        <c:v>927</c:v>
                      </c:pt>
                      <c:pt idx="453">
                        <c:v>928</c:v>
                      </c:pt>
                      <c:pt idx="454">
                        <c:v>929</c:v>
                      </c:pt>
                      <c:pt idx="455">
                        <c:v>930</c:v>
                      </c:pt>
                      <c:pt idx="456">
                        <c:v>931</c:v>
                      </c:pt>
                      <c:pt idx="457">
                        <c:v>934</c:v>
                      </c:pt>
                      <c:pt idx="458">
                        <c:v>935</c:v>
                      </c:pt>
                      <c:pt idx="459">
                        <c:v>940</c:v>
                      </c:pt>
                      <c:pt idx="460">
                        <c:v>941</c:v>
                      </c:pt>
                      <c:pt idx="461">
                        <c:v>942</c:v>
                      </c:pt>
                      <c:pt idx="462">
                        <c:v>943</c:v>
                      </c:pt>
                      <c:pt idx="463">
                        <c:v>944</c:v>
                      </c:pt>
                      <c:pt idx="464">
                        <c:v>945</c:v>
                      </c:pt>
                      <c:pt idx="465">
                        <c:v>946</c:v>
                      </c:pt>
                      <c:pt idx="466">
                        <c:v>947</c:v>
                      </c:pt>
                      <c:pt idx="467">
                        <c:v>948</c:v>
                      </c:pt>
                      <c:pt idx="468">
                        <c:v>949</c:v>
                      </c:pt>
                      <c:pt idx="469">
                        <c:v>950</c:v>
                      </c:pt>
                      <c:pt idx="470">
                        <c:v>951</c:v>
                      </c:pt>
                      <c:pt idx="471">
                        <c:v>952</c:v>
                      </c:pt>
                      <c:pt idx="472">
                        <c:v>954</c:v>
                      </c:pt>
                      <c:pt idx="473">
                        <c:v>955</c:v>
                      </c:pt>
                      <c:pt idx="474">
                        <c:v>956</c:v>
                      </c:pt>
                      <c:pt idx="475">
                        <c:v>961</c:v>
                      </c:pt>
                      <c:pt idx="476">
                        <c:v>964</c:v>
                      </c:pt>
                      <c:pt idx="477">
                        <c:v>965</c:v>
                      </c:pt>
                      <c:pt idx="478">
                        <c:v>966</c:v>
                      </c:pt>
                      <c:pt idx="479">
                        <c:v>969</c:v>
                      </c:pt>
                      <c:pt idx="480">
                        <c:v>970</c:v>
                      </c:pt>
                      <c:pt idx="481">
                        <c:v>973</c:v>
                      </c:pt>
                      <c:pt idx="482">
                        <c:v>974</c:v>
                      </c:pt>
                      <c:pt idx="483">
                        <c:v>975</c:v>
                      </c:pt>
                      <c:pt idx="484">
                        <c:v>977</c:v>
                      </c:pt>
                      <c:pt idx="485">
                        <c:v>978</c:v>
                      </c:pt>
                      <c:pt idx="486">
                        <c:v>979</c:v>
                      </c:pt>
                      <c:pt idx="487">
                        <c:v>980</c:v>
                      </c:pt>
                      <c:pt idx="488">
                        <c:v>983</c:v>
                      </c:pt>
                      <c:pt idx="489">
                        <c:v>984</c:v>
                      </c:pt>
                      <c:pt idx="490">
                        <c:v>986</c:v>
                      </c:pt>
                      <c:pt idx="491">
                        <c:v>987</c:v>
                      </c:pt>
                      <c:pt idx="492">
                        <c:v>988</c:v>
                      </c:pt>
                      <c:pt idx="493">
                        <c:v>989</c:v>
                      </c:pt>
                      <c:pt idx="494">
                        <c:v>990</c:v>
                      </c:pt>
                      <c:pt idx="495">
                        <c:v>991</c:v>
                      </c:pt>
                      <c:pt idx="496">
                        <c:v>992</c:v>
                      </c:pt>
                      <c:pt idx="497">
                        <c:v>994</c:v>
                      </c:pt>
                      <c:pt idx="498">
                        <c:v>995</c:v>
                      </c:pt>
                      <c:pt idx="499">
                        <c:v>996</c:v>
                      </c:pt>
                      <c:pt idx="500">
                        <c:v>997</c:v>
                      </c:pt>
                      <c:pt idx="501">
                        <c:v>998</c:v>
                      </c:pt>
                      <c:pt idx="502">
                        <c:v>999</c:v>
                      </c:pt>
                      <c:pt idx="503">
                        <c:v>1000</c:v>
                      </c:pt>
                      <c:pt idx="504">
                        <c:v>1001</c:v>
                      </c:pt>
                      <c:pt idx="505">
                        <c:v>1002</c:v>
                      </c:pt>
                      <c:pt idx="506">
                        <c:v>1003</c:v>
                      </c:pt>
                      <c:pt idx="507">
                        <c:v>1004</c:v>
                      </c:pt>
                      <c:pt idx="508">
                        <c:v>1005</c:v>
                      </c:pt>
                      <c:pt idx="509">
                        <c:v>1006</c:v>
                      </c:pt>
                      <c:pt idx="510">
                        <c:v>1008</c:v>
                      </c:pt>
                      <c:pt idx="511">
                        <c:v>1009</c:v>
                      </c:pt>
                      <c:pt idx="512">
                        <c:v>1010</c:v>
                      </c:pt>
                      <c:pt idx="513">
                        <c:v>1011</c:v>
                      </c:pt>
                      <c:pt idx="514">
                        <c:v>1012</c:v>
                      </c:pt>
                      <c:pt idx="515">
                        <c:v>1013</c:v>
                      </c:pt>
                      <c:pt idx="516">
                        <c:v>1015</c:v>
                      </c:pt>
                      <c:pt idx="517">
                        <c:v>1020</c:v>
                      </c:pt>
                      <c:pt idx="518">
                        <c:v>1021</c:v>
                      </c:pt>
                      <c:pt idx="519">
                        <c:v>1022</c:v>
                      </c:pt>
                      <c:pt idx="520">
                        <c:v>1023</c:v>
                      </c:pt>
                      <c:pt idx="521">
                        <c:v>1024</c:v>
                      </c:pt>
                      <c:pt idx="522">
                        <c:v>1025</c:v>
                      </c:pt>
                      <c:pt idx="523">
                        <c:v>1027</c:v>
                      </c:pt>
                      <c:pt idx="524">
                        <c:v>1031</c:v>
                      </c:pt>
                      <c:pt idx="525">
                        <c:v>1032</c:v>
                      </c:pt>
                      <c:pt idx="526">
                        <c:v>1033</c:v>
                      </c:pt>
                      <c:pt idx="527">
                        <c:v>1034</c:v>
                      </c:pt>
                      <c:pt idx="528">
                        <c:v>1035</c:v>
                      </c:pt>
                      <c:pt idx="529">
                        <c:v>1037</c:v>
                      </c:pt>
                      <c:pt idx="530">
                        <c:v>1039</c:v>
                      </c:pt>
                      <c:pt idx="531">
                        <c:v>1040</c:v>
                      </c:pt>
                      <c:pt idx="532">
                        <c:v>1041</c:v>
                      </c:pt>
                      <c:pt idx="533">
                        <c:v>1043</c:v>
                      </c:pt>
                      <c:pt idx="534">
                        <c:v>1044</c:v>
                      </c:pt>
                      <c:pt idx="535">
                        <c:v>1045</c:v>
                      </c:pt>
                      <c:pt idx="536">
                        <c:v>1046</c:v>
                      </c:pt>
                      <c:pt idx="537">
                        <c:v>1047</c:v>
                      </c:pt>
                      <c:pt idx="538">
                        <c:v>1048</c:v>
                      </c:pt>
                      <c:pt idx="539">
                        <c:v>1049</c:v>
                      </c:pt>
                      <c:pt idx="540">
                        <c:v>1050</c:v>
                      </c:pt>
                      <c:pt idx="541">
                        <c:v>1051</c:v>
                      </c:pt>
                      <c:pt idx="542">
                        <c:v>1052</c:v>
                      </c:pt>
                      <c:pt idx="543">
                        <c:v>1053</c:v>
                      </c:pt>
                      <c:pt idx="544">
                        <c:v>1054</c:v>
                      </c:pt>
                      <c:pt idx="545">
                        <c:v>1055</c:v>
                      </c:pt>
                      <c:pt idx="546">
                        <c:v>1057</c:v>
                      </c:pt>
                      <c:pt idx="547">
                        <c:v>1059</c:v>
                      </c:pt>
                      <c:pt idx="548">
                        <c:v>1060</c:v>
                      </c:pt>
                      <c:pt idx="549">
                        <c:v>1061</c:v>
                      </c:pt>
                      <c:pt idx="550">
                        <c:v>1062</c:v>
                      </c:pt>
                      <c:pt idx="551">
                        <c:v>1063</c:v>
                      </c:pt>
                      <c:pt idx="552">
                        <c:v>1064</c:v>
                      </c:pt>
                      <c:pt idx="553">
                        <c:v>1065</c:v>
                      </c:pt>
                      <c:pt idx="554">
                        <c:v>1066</c:v>
                      </c:pt>
                      <c:pt idx="555">
                        <c:v>1067</c:v>
                      </c:pt>
                      <c:pt idx="556">
                        <c:v>1068</c:v>
                      </c:pt>
                      <c:pt idx="557">
                        <c:v>1069</c:v>
                      </c:pt>
                      <c:pt idx="558">
                        <c:v>1070</c:v>
                      </c:pt>
                      <c:pt idx="559">
                        <c:v>1072</c:v>
                      </c:pt>
                      <c:pt idx="560">
                        <c:v>1073</c:v>
                      </c:pt>
                      <c:pt idx="561">
                        <c:v>1074</c:v>
                      </c:pt>
                      <c:pt idx="562">
                        <c:v>1077</c:v>
                      </c:pt>
                      <c:pt idx="563">
                        <c:v>1080</c:v>
                      </c:pt>
                      <c:pt idx="564">
                        <c:v>1081</c:v>
                      </c:pt>
                      <c:pt idx="565">
                        <c:v>1082</c:v>
                      </c:pt>
                      <c:pt idx="566">
                        <c:v>1083</c:v>
                      </c:pt>
                      <c:pt idx="567">
                        <c:v>1084</c:v>
                      </c:pt>
                      <c:pt idx="568">
                        <c:v>1085</c:v>
                      </c:pt>
                      <c:pt idx="569">
                        <c:v>1090</c:v>
                      </c:pt>
                      <c:pt idx="570">
                        <c:v>1091</c:v>
                      </c:pt>
                      <c:pt idx="571">
                        <c:v>1092</c:v>
                      </c:pt>
                      <c:pt idx="572">
                        <c:v>1093</c:v>
                      </c:pt>
                      <c:pt idx="573">
                        <c:v>1094</c:v>
                      </c:pt>
                      <c:pt idx="574">
                        <c:v>1099</c:v>
                      </c:pt>
                      <c:pt idx="575">
                        <c:v>1100</c:v>
                      </c:pt>
                      <c:pt idx="576">
                        <c:v>1101</c:v>
                      </c:pt>
                      <c:pt idx="577">
                        <c:v>1102</c:v>
                      </c:pt>
                      <c:pt idx="578">
                        <c:v>1103</c:v>
                      </c:pt>
                      <c:pt idx="579">
                        <c:v>1104</c:v>
                      </c:pt>
                      <c:pt idx="580">
                        <c:v>1105</c:v>
                      </c:pt>
                      <c:pt idx="581">
                        <c:v>1106</c:v>
                      </c:pt>
                      <c:pt idx="582">
                        <c:v>1107</c:v>
                      </c:pt>
                      <c:pt idx="583">
                        <c:v>1108</c:v>
                      </c:pt>
                      <c:pt idx="584">
                        <c:v>1110</c:v>
                      </c:pt>
                      <c:pt idx="585">
                        <c:v>1111</c:v>
                      </c:pt>
                      <c:pt idx="586">
                        <c:v>1112</c:v>
                      </c:pt>
                      <c:pt idx="587">
                        <c:v>1113</c:v>
                      </c:pt>
                      <c:pt idx="588">
                        <c:v>1114</c:v>
                      </c:pt>
                      <c:pt idx="589">
                        <c:v>1115</c:v>
                      </c:pt>
                      <c:pt idx="590">
                        <c:v>1116</c:v>
                      </c:pt>
                      <c:pt idx="591">
                        <c:v>1118</c:v>
                      </c:pt>
                      <c:pt idx="592">
                        <c:v>1119</c:v>
                      </c:pt>
                      <c:pt idx="593">
                        <c:v>1120</c:v>
                      </c:pt>
                      <c:pt idx="594">
                        <c:v>1121</c:v>
                      </c:pt>
                      <c:pt idx="595">
                        <c:v>1122</c:v>
                      </c:pt>
                      <c:pt idx="596">
                        <c:v>1123</c:v>
                      </c:pt>
                      <c:pt idx="597">
                        <c:v>1124</c:v>
                      </c:pt>
                      <c:pt idx="598">
                        <c:v>1130</c:v>
                      </c:pt>
                      <c:pt idx="599">
                        <c:v>1131</c:v>
                      </c:pt>
                      <c:pt idx="600">
                        <c:v>1132</c:v>
                      </c:pt>
                      <c:pt idx="601">
                        <c:v>1133</c:v>
                      </c:pt>
                      <c:pt idx="602">
                        <c:v>1134</c:v>
                      </c:pt>
                      <c:pt idx="603">
                        <c:v>1135</c:v>
                      </c:pt>
                      <c:pt idx="604">
                        <c:v>1136</c:v>
                      </c:pt>
                      <c:pt idx="605">
                        <c:v>1137</c:v>
                      </c:pt>
                      <c:pt idx="606">
                        <c:v>1138</c:v>
                      </c:pt>
                      <c:pt idx="607">
                        <c:v>1139</c:v>
                      </c:pt>
                      <c:pt idx="608">
                        <c:v>1140</c:v>
                      </c:pt>
                      <c:pt idx="609">
                        <c:v>1141</c:v>
                      </c:pt>
                      <c:pt idx="610">
                        <c:v>1142</c:v>
                      </c:pt>
                      <c:pt idx="611">
                        <c:v>1143</c:v>
                      </c:pt>
                      <c:pt idx="612">
                        <c:v>1145</c:v>
                      </c:pt>
                      <c:pt idx="613">
                        <c:v>1146</c:v>
                      </c:pt>
                      <c:pt idx="614">
                        <c:v>1147</c:v>
                      </c:pt>
                      <c:pt idx="615">
                        <c:v>1148</c:v>
                      </c:pt>
                      <c:pt idx="616">
                        <c:v>1149</c:v>
                      </c:pt>
                      <c:pt idx="617">
                        <c:v>1150</c:v>
                      </c:pt>
                      <c:pt idx="618">
                        <c:v>1151</c:v>
                      </c:pt>
                      <c:pt idx="619">
                        <c:v>1153</c:v>
                      </c:pt>
                      <c:pt idx="620">
                        <c:v>1154</c:v>
                      </c:pt>
                      <c:pt idx="621">
                        <c:v>1155</c:v>
                      </c:pt>
                      <c:pt idx="622">
                        <c:v>1156</c:v>
                      </c:pt>
                      <c:pt idx="623">
                        <c:v>1157</c:v>
                      </c:pt>
                      <c:pt idx="624">
                        <c:v>1158</c:v>
                      </c:pt>
                      <c:pt idx="625">
                        <c:v>1159</c:v>
                      </c:pt>
                      <c:pt idx="626">
                        <c:v>1160</c:v>
                      </c:pt>
                      <c:pt idx="627">
                        <c:v>1161</c:v>
                      </c:pt>
                      <c:pt idx="628">
                        <c:v>1162</c:v>
                      </c:pt>
                      <c:pt idx="629">
                        <c:v>1165</c:v>
                      </c:pt>
                      <c:pt idx="630">
                        <c:v>1166</c:v>
                      </c:pt>
                      <c:pt idx="631">
                        <c:v>1167</c:v>
                      </c:pt>
                      <c:pt idx="632">
                        <c:v>1168</c:v>
                      </c:pt>
                      <c:pt idx="633">
                        <c:v>1169</c:v>
                      </c:pt>
                      <c:pt idx="634">
                        <c:v>1170</c:v>
                      </c:pt>
                      <c:pt idx="635">
                        <c:v>1173</c:v>
                      </c:pt>
                      <c:pt idx="636">
                        <c:v>1174</c:v>
                      </c:pt>
                      <c:pt idx="637">
                        <c:v>1175</c:v>
                      </c:pt>
                      <c:pt idx="638">
                        <c:v>1180</c:v>
                      </c:pt>
                      <c:pt idx="639">
                        <c:v>1181</c:v>
                      </c:pt>
                      <c:pt idx="640">
                        <c:v>1182</c:v>
                      </c:pt>
                      <c:pt idx="641">
                        <c:v>1183</c:v>
                      </c:pt>
                      <c:pt idx="642">
                        <c:v>1184</c:v>
                      </c:pt>
                      <c:pt idx="643">
                        <c:v>1185</c:v>
                      </c:pt>
                      <c:pt idx="644">
                        <c:v>1186</c:v>
                      </c:pt>
                      <c:pt idx="645">
                        <c:v>1187</c:v>
                      </c:pt>
                      <c:pt idx="646">
                        <c:v>1188</c:v>
                      </c:pt>
                      <c:pt idx="647">
                        <c:v>1189</c:v>
                      </c:pt>
                      <c:pt idx="648">
                        <c:v>1190</c:v>
                      </c:pt>
                      <c:pt idx="649">
                        <c:v>1192</c:v>
                      </c:pt>
                      <c:pt idx="650">
                        <c:v>1193</c:v>
                      </c:pt>
                      <c:pt idx="651">
                        <c:v>1194</c:v>
                      </c:pt>
                      <c:pt idx="652">
                        <c:v>1195</c:v>
                      </c:pt>
                      <c:pt idx="653">
                        <c:v>1197</c:v>
                      </c:pt>
                      <c:pt idx="654">
                        <c:v>1198</c:v>
                      </c:pt>
                      <c:pt idx="655">
                        <c:v>1199</c:v>
                      </c:pt>
                      <c:pt idx="656">
                        <c:v>1200</c:v>
                      </c:pt>
                      <c:pt idx="657">
                        <c:v>1201</c:v>
                      </c:pt>
                      <c:pt idx="658">
                        <c:v>1203</c:v>
                      </c:pt>
                      <c:pt idx="659">
                        <c:v>1204</c:v>
                      </c:pt>
                      <c:pt idx="660">
                        <c:v>1205</c:v>
                      </c:pt>
                      <c:pt idx="661">
                        <c:v>1208</c:v>
                      </c:pt>
                      <c:pt idx="662">
                        <c:v>1209</c:v>
                      </c:pt>
                      <c:pt idx="663">
                        <c:v>1210</c:v>
                      </c:pt>
                      <c:pt idx="664">
                        <c:v>1214</c:v>
                      </c:pt>
                      <c:pt idx="665">
                        <c:v>1215</c:v>
                      </c:pt>
                      <c:pt idx="666">
                        <c:v>1216</c:v>
                      </c:pt>
                      <c:pt idx="667">
                        <c:v>1217</c:v>
                      </c:pt>
                      <c:pt idx="668">
                        <c:v>1220</c:v>
                      </c:pt>
                      <c:pt idx="669">
                        <c:v>1221</c:v>
                      </c:pt>
                      <c:pt idx="670">
                        <c:v>1225</c:v>
                      </c:pt>
                      <c:pt idx="671">
                        <c:v>1229</c:v>
                      </c:pt>
                      <c:pt idx="672">
                        <c:v>1231</c:v>
                      </c:pt>
                      <c:pt idx="673">
                        <c:v>1232</c:v>
                      </c:pt>
                      <c:pt idx="674">
                        <c:v>1242</c:v>
                      </c:pt>
                      <c:pt idx="675">
                        <c:v>1253</c:v>
                      </c:pt>
                      <c:pt idx="676">
                        <c:v>1255</c:v>
                      </c:pt>
                      <c:pt idx="677">
                        <c:v>1256</c:v>
                      </c:pt>
                      <c:pt idx="678">
                        <c:v>1258</c:v>
                      </c:pt>
                      <c:pt idx="679">
                        <c:v>1259</c:v>
                      </c:pt>
                      <c:pt idx="680">
                        <c:v>1260</c:v>
                      </c:pt>
                      <c:pt idx="681">
                        <c:v>1261</c:v>
                      </c:pt>
                      <c:pt idx="682">
                        <c:v>1262</c:v>
                      </c:pt>
                      <c:pt idx="683">
                        <c:v>1263</c:v>
                      </c:pt>
                      <c:pt idx="684">
                        <c:v>1264</c:v>
                      </c:pt>
                      <c:pt idx="685">
                        <c:v>1266</c:v>
                      </c:pt>
                      <c:pt idx="686">
                        <c:v>1269</c:v>
                      </c:pt>
                      <c:pt idx="687">
                        <c:v>1279</c:v>
                      </c:pt>
                      <c:pt idx="688">
                        <c:v>1280</c:v>
                      </c:pt>
                      <c:pt idx="689">
                        <c:v>1290</c:v>
                      </c:pt>
                      <c:pt idx="690">
                        <c:v>1291</c:v>
                      </c:pt>
                      <c:pt idx="691">
                        <c:v>1292</c:v>
                      </c:pt>
                      <c:pt idx="692">
                        <c:v>1293</c:v>
                      </c:pt>
                      <c:pt idx="693">
                        <c:v>1294</c:v>
                      </c:pt>
                      <c:pt idx="694">
                        <c:v>1295</c:v>
                      </c:pt>
                      <c:pt idx="695">
                        <c:v>1300</c:v>
                      </c:pt>
                      <c:pt idx="696">
                        <c:v>1301</c:v>
                      </c:pt>
                      <c:pt idx="697">
                        <c:v>1302</c:v>
                      </c:pt>
                      <c:pt idx="698">
                        <c:v>1303</c:v>
                      </c:pt>
                      <c:pt idx="699">
                        <c:v>1305</c:v>
                      </c:pt>
                      <c:pt idx="700">
                        <c:v>1306</c:v>
                      </c:pt>
                      <c:pt idx="701">
                        <c:v>1307</c:v>
                      </c:pt>
                      <c:pt idx="702">
                        <c:v>1308</c:v>
                      </c:pt>
                      <c:pt idx="703">
                        <c:v>1310</c:v>
                      </c:pt>
                      <c:pt idx="704">
                        <c:v>1311</c:v>
                      </c:pt>
                      <c:pt idx="705">
                        <c:v>1312</c:v>
                      </c:pt>
                      <c:pt idx="706">
                        <c:v>1313</c:v>
                      </c:pt>
                      <c:pt idx="707">
                        <c:v>1314</c:v>
                      </c:pt>
                      <c:pt idx="708">
                        <c:v>1315</c:v>
                      </c:pt>
                      <c:pt idx="709">
                        <c:v>1316</c:v>
                      </c:pt>
                      <c:pt idx="710">
                        <c:v>1317</c:v>
                      </c:pt>
                      <c:pt idx="711">
                        <c:v>1318</c:v>
                      </c:pt>
                      <c:pt idx="712">
                        <c:v>1319</c:v>
                      </c:pt>
                      <c:pt idx="713">
                        <c:v>1320</c:v>
                      </c:pt>
                      <c:pt idx="714">
                        <c:v>1322</c:v>
                      </c:pt>
                      <c:pt idx="715">
                        <c:v>1323</c:v>
                      </c:pt>
                      <c:pt idx="716">
                        <c:v>1324</c:v>
                      </c:pt>
                      <c:pt idx="717">
                        <c:v>1325</c:v>
                      </c:pt>
                      <c:pt idx="718">
                        <c:v>1326</c:v>
                      </c:pt>
                      <c:pt idx="719">
                        <c:v>1327</c:v>
                      </c:pt>
                      <c:pt idx="720">
                        <c:v>1328</c:v>
                      </c:pt>
                      <c:pt idx="721">
                        <c:v>1329</c:v>
                      </c:pt>
                      <c:pt idx="722">
                        <c:v>1331</c:v>
                      </c:pt>
                      <c:pt idx="723">
                        <c:v>1333</c:v>
                      </c:pt>
                      <c:pt idx="724">
                        <c:v>1337</c:v>
                      </c:pt>
                      <c:pt idx="725">
                        <c:v>1338</c:v>
                      </c:pt>
                      <c:pt idx="726">
                        <c:v>1339</c:v>
                      </c:pt>
                      <c:pt idx="727">
                        <c:v>1342</c:v>
                      </c:pt>
                      <c:pt idx="728">
                        <c:v>1343</c:v>
                      </c:pt>
                      <c:pt idx="729">
                        <c:v>1344</c:v>
                      </c:pt>
                      <c:pt idx="730">
                        <c:v>1345</c:v>
                      </c:pt>
                      <c:pt idx="731">
                        <c:v>1346</c:v>
                      </c:pt>
                      <c:pt idx="732">
                        <c:v>1348</c:v>
                      </c:pt>
                      <c:pt idx="733">
                        <c:v>1349</c:v>
                      </c:pt>
                      <c:pt idx="734">
                        <c:v>1353</c:v>
                      </c:pt>
                      <c:pt idx="735">
                        <c:v>1355</c:v>
                      </c:pt>
                      <c:pt idx="736">
                        <c:v>1360</c:v>
                      </c:pt>
                      <c:pt idx="737">
                        <c:v>1361</c:v>
                      </c:pt>
                      <c:pt idx="738">
                        <c:v>1363</c:v>
                      </c:pt>
                      <c:pt idx="739">
                        <c:v>1364</c:v>
                      </c:pt>
                      <c:pt idx="740">
                        <c:v>1365</c:v>
                      </c:pt>
                      <c:pt idx="741">
                        <c:v>1366</c:v>
                      </c:pt>
                      <c:pt idx="742">
                        <c:v>1367</c:v>
                      </c:pt>
                      <c:pt idx="743">
                        <c:v>1369</c:v>
                      </c:pt>
                      <c:pt idx="744">
                        <c:v>1372</c:v>
                      </c:pt>
                      <c:pt idx="745">
                        <c:v>1373</c:v>
                      </c:pt>
                      <c:pt idx="746">
                        <c:v>1374</c:v>
                      </c:pt>
                      <c:pt idx="747">
                        <c:v>1375</c:v>
                      </c:pt>
                      <c:pt idx="748">
                        <c:v>1376</c:v>
                      </c:pt>
                      <c:pt idx="749">
                        <c:v>1377</c:v>
                      </c:pt>
                      <c:pt idx="750">
                        <c:v>1378</c:v>
                      </c:pt>
                      <c:pt idx="751">
                        <c:v>1379</c:v>
                      </c:pt>
                      <c:pt idx="752">
                        <c:v>1380</c:v>
                      </c:pt>
                      <c:pt idx="753">
                        <c:v>1381</c:v>
                      </c:pt>
                      <c:pt idx="754">
                        <c:v>1383</c:v>
                      </c:pt>
                      <c:pt idx="755">
                        <c:v>1384</c:v>
                      </c:pt>
                      <c:pt idx="756">
                        <c:v>1385</c:v>
                      </c:pt>
                      <c:pt idx="757">
                        <c:v>1386</c:v>
                      </c:pt>
                      <c:pt idx="758">
                        <c:v>1390</c:v>
                      </c:pt>
                      <c:pt idx="759">
                        <c:v>1391</c:v>
                      </c:pt>
                      <c:pt idx="760">
                        <c:v>1392</c:v>
                      </c:pt>
                      <c:pt idx="761">
                        <c:v>1393</c:v>
                      </c:pt>
                      <c:pt idx="762">
                        <c:v>1394</c:v>
                      </c:pt>
                      <c:pt idx="763">
                        <c:v>1395</c:v>
                      </c:pt>
                      <c:pt idx="764">
                        <c:v>1396</c:v>
                      </c:pt>
                      <c:pt idx="765">
                        <c:v>1397</c:v>
                      </c:pt>
                      <c:pt idx="766">
                        <c:v>1398</c:v>
                      </c:pt>
                      <c:pt idx="767">
                        <c:v>1400</c:v>
                      </c:pt>
                      <c:pt idx="768">
                        <c:v>1401</c:v>
                      </c:pt>
                      <c:pt idx="769">
                        <c:v>1402</c:v>
                      </c:pt>
                      <c:pt idx="770">
                        <c:v>1403</c:v>
                      </c:pt>
                      <c:pt idx="771">
                        <c:v>1405</c:v>
                      </c:pt>
                      <c:pt idx="772">
                        <c:v>1407</c:v>
                      </c:pt>
                      <c:pt idx="773">
                        <c:v>1408</c:v>
                      </c:pt>
                      <c:pt idx="774">
                        <c:v>1410</c:v>
                      </c:pt>
                      <c:pt idx="775">
                        <c:v>1411</c:v>
                      </c:pt>
                      <c:pt idx="776">
                        <c:v>1412</c:v>
                      </c:pt>
                      <c:pt idx="777">
                        <c:v>1413</c:v>
                      </c:pt>
                      <c:pt idx="778">
                        <c:v>1414</c:v>
                      </c:pt>
                      <c:pt idx="779">
                        <c:v>1415</c:v>
                      </c:pt>
                      <c:pt idx="780">
                        <c:v>1416</c:v>
                      </c:pt>
                      <c:pt idx="781">
                        <c:v>1417</c:v>
                      </c:pt>
                      <c:pt idx="782">
                        <c:v>1418</c:v>
                      </c:pt>
                      <c:pt idx="783">
                        <c:v>1419</c:v>
                      </c:pt>
                      <c:pt idx="784">
                        <c:v>1420</c:v>
                      </c:pt>
                      <c:pt idx="785">
                        <c:v>1421</c:v>
                      </c:pt>
                      <c:pt idx="786">
                        <c:v>1423</c:v>
                      </c:pt>
                      <c:pt idx="787">
                        <c:v>1424</c:v>
                      </c:pt>
                      <c:pt idx="788">
                        <c:v>1425</c:v>
                      </c:pt>
                      <c:pt idx="789">
                        <c:v>1426</c:v>
                      </c:pt>
                      <c:pt idx="790">
                        <c:v>1427</c:v>
                      </c:pt>
                      <c:pt idx="791">
                        <c:v>1428</c:v>
                      </c:pt>
                      <c:pt idx="792">
                        <c:v>1429</c:v>
                      </c:pt>
                      <c:pt idx="793">
                        <c:v>1430</c:v>
                      </c:pt>
                      <c:pt idx="794">
                        <c:v>1432</c:v>
                      </c:pt>
                      <c:pt idx="795">
                        <c:v>1434</c:v>
                      </c:pt>
                      <c:pt idx="796">
                        <c:v>1435</c:v>
                      </c:pt>
                      <c:pt idx="797">
                        <c:v>1436</c:v>
                      </c:pt>
                      <c:pt idx="798">
                        <c:v>1437</c:v>
                      </c:pt>
                      <c:pt idx="799">
                        <c:v>1439</c:v>
                      </c:pt>
                      <c:pt idx="800">
                        <c:v>1440</c:v>
                      </c:pt>
                      <c:pt idx="801">
                        <c:v>1442</c:v>
                      </c:pt>
                      <c:pt idx="802">
                        <c:v>1443</c:v>
                      </c:pt>
                      <c:pt idx="803">
                        <c:v>1444</c:v>
                      </c:pt>
                      <c:pt idx="804">
                        <c:v>1445</c:v>
                      </c:pt>
                      <c:pt idx="805">
                        <c:v>1446</c:v>
                      </c:pt>
                      <c:pt idx="806">
                        <c:v>1447</c:v>
                      </c:pt>
                      <c:pt idx="807">
                        <c:v>1448</c:v>
                      </c:pt>
                      <c:pt idx="808">
                        <c:v>1449</c:v>
                      </c:pt>
                      <c:pt idx="809">
                        <c:v>1450</c:v>
                      </c:pt>
                      <c:pt idx="810">
                        <c:v>1451</c:v>
                      </c:pt>
                      <c:pt idx="811">
                        <c:v>1453</c:v>
                      </c:pt>
                      <c:pt idx="812">
                        <c:v>1454</c:v>
                      </c:pt>
                      <c:pt idx="813">
                        <c:v>1455</c:v>
                      </c:pt>
                      <c:pt idx="814">
                        <c:v>1456</c:v>
                      </c:pt>
                      <c:pt idx="815">
                        <c:v>1457</c:v>
                      </c:pt>
                      <c:pt idx="816">
                        <c:v>1458</c:v>
                      </c:pt>
                      <c:pt idx="817">
                        <c:v>1459</c:v>
                      </c:pt>
                      <c:pt idx="818">
                        <c:v>1460</c:v>
                      </c:pt>
                      <c:pt idx="819">
                        <c:v>1461</c:v>
                      </c:pt>
                      <c:pt idx="820">
                        <c:v>1462</c:v>
                      </c:pt>
                      <c:pt idx="821">
                        <c:v>1463</c:v>
                      </c:pt>
                      <c:pt idx="822">
                        <c:v>1464</c:v>
                      </c:pt>
                      <c:pt idx="823">
                        <c:v>1465</c:v>
                      </c:pt>
                      <c:pt idx="824">
                        <c:v>1466</c:v>
                      </c:pt>
                      <c:pt idx="825">
                        <c:v>1467</c:v>
                      </c:pt>
                      <c:pt idx="826">
                        <c:v>1468</c:v>
                      </c:pt>
                      <c:pt idx="827">
                        <c:v>1469</c:v>
                      </c:pt>
                      <c:pt idx="828">
                        <c:v>1470</c:v>
                      </c:pt>
                      <c:pt idx="829">
                        <c:v>1471</c:v>
                      </c:pt>
                      <c:pt idx="830">
                        <c:v>1472</c:v>
                      </c:pt>
                      <c:pt idx="831">
                        <c:v>1473</c:v>
                      </c:pt>
                      <c:pt idx="832">
                        <c:v>1474</c:v>
                      </c:pt>
                      <c:pt idx="833">
                        <c:v>1475</c:v>
                      </c:pt>
                      <c:pt idx="834">
                        <c:v>1476</c:v>
                      </c:pt>
                      <c:pt idx="835">
                        <c:v>1477</c:v>
                      </c:pt>
                      <c:pt idx="836">
                        <c:v>1478</c:v>
                      </c:pt>
                      <c:pt idx="837">
                        <c:v>1479</c:v>
                      </c:pt>
                      <c:pt idx="838">
                        <c:v>1480</c:v>
                      </c:pt>
                      <c:pt idx="839">
                        <c:v>1481</c:v>
                      </c:pt>
                      <c:pt idx="840">
                        <c:v>1482</c:v>
                      </c:pt>
                      <c:pt idx="841">
                        <c:v>1483</c:v>
                      </c:pt>
                      <c:pt idx="842">
                        <c:v>1484</c:v>
                      </c:pt>
                      <c:pt idx="843">
                        <c:v>1485</c:v>
                      </c:pt>
                      <c:pt idx="844">
                        <c:v>1486</c:v>
                      </c:pt>
                      <c:pt idx="845">
                        <c:v>1487</c:v>
                      </c:pt>
                      <c:pt idx="846">
                        <c:v>1488</c:v>
                      </c:pt>
                      <c:pt idx="847">
                        <c:v>1489</c:v>
                      </c:pt>
                      <c:pt idx="848">
                        <c:v>1490</c:v>
                      </c:pt>
                      <c:pt idx="849">
                        <c:v>1491</c:v>
                      </c:pt>
                      <c:pt idx="850">
                        <c:v>1492</c:v>
                      </c:pt>
                      <c:pt idx="851">
                        <c:v>1493</c:v>
                      </c:pt>
                      <c:pt idx="852">
                        <c:v>1494</c:v>
                      </c:pt>
                      <c:pt idx="853">
                        <c:v>1495</c:v>
                      </c:pt>
                      <c:pt idx="854">
                        <c:v>1496</c:v>
                      </c:pt>
                      <c:pt idx="855">
                        <c:v>1497</c:v>
                      </c:pt>
                      <c:pt idx="856">
                        <c:v>1498</c:v>
                      </c:pt>
                      <c:pt idx="857">
                        <c:v>1499</c:v>
                      </c:pt>
                      <c:pt idx="858">
                        <c:v>1500</c:v>
                      </c:pt>
                      <c:pt idx="859">
                        <c:v>1501</c:v>
                      </c:pt>
                      <c:pt idx="860">
                        <c:v>1502</c:v>
                      </c:pt>
                      <c:pt idx="861">
                        <c:v>1503</c:v>
                      </c:pt>
                      <c:pt idx="862">
                        <c:v>1504</c:v>
                      </c:pt>
                      <c:pt idx="863">
                        <c:v>1505</c:v>
                      </c:pt>
                      <c:pt idx="864">
                        <c:v>1506</c:v>
                      </c:pt>
                      <c:pt idx="865">
                        <c:v>1507</c:v>
                      </c:pt>
                      <c:pt idx="866">
                        <c:v>1509</c:v>
                      </c:pt>
                      <c:pt idx="867">
                        <c:v>1510</c:v>
                      </c:pt>
                      <c:pt idx="868">
                        <c:v>1511</c:v>
                      </c:pt>
                      <c:pt idx="869">
                        <c:v>1512</c:v>
                      </c:pt>
                      <c:pt idx="870">
                        <c:v>1514</c:v>
                      </c:pt>
                      <c:pt idx="871">
                        <c:v>1515</c:v>
                      </c:pt>
                      <c:pt idx="872">
                        <c:v>1516</c:v>
                      </c:pt>
                      <c:pt idx="873">
                        <c:v>1517</c:v>
                      </c:pt>
                      <c:pt idx="874">
                        <c:v>1518</c:v>
                      </c:pt>
                      <c:pt idx="875">
                        <c:v>1519</c:v>
                      </c:pt>
                      <c:pt idx="876">
                        <c:v>1520</c:v>
                      </c:pt>
                      <c:pt idx="877">
                        <c:v>1521</c:v>
                      </c:pt>
                      <c:pt idx="878">
                        <c:v>1522</c:v>
                      </c:pt>
                      <c:pt idx="879">
                        <c:v>1523</c:v>
                      </c:pt>
                      <c:pt idx="880">
                        <c:v>1524</c:v>
                      </c:pt>
                      <c:pt idx="881">
                        <c:v>1525</c:v>
                      </c:pt>
                      <c:pt idx="882">
                        <c:v>1526</c:v>
                      </c:pt>
                      <c:pt idx="883">
                        <c:v>1527</c:v>
                      </c:pt>
                      <c:pt idx="884">
                        <c:v>1528</c:v>
                      </c:pt>
                      <c:pt idx="885">
                        <c:v>1529</c:v>
                      </c:pt>
                      <c:pt idx="886">
                        <c:v>1530</c:v>
                      </c:pt>
                      <c:pt idx="887">
                        <c:v>1531</c:v>
                      </c:pt>
                      <c:pt idx="888">
                        <c:v>1532</c:v>
                      </c:pt>
                      <c:pt idx="889">
                        <c:v>1533</c:v>
                      </c:pt>
                      <c:pt idx="890">
                        <c:v>1534</c:v>
                      </c:pt>
                      <c:pt idx="891">
                        <c:v>1535</c:v>
                      </c:pt>
                      <c:pt idx="892">
                        <c:v>1536</c:v>
                      </c:pt>
                      <c:pt idx="893">
                        <c:v>1537</c:v>
                      </c:pt>
                      <c:pt idx="894">
                        <c:v>1538</c:v>
                      </c:pt>
                      <c:pt idx="895">
                        <c:v>1539</c:v>
                      </c:pt>
                      <c:pt idx="896">
                        <c:v>1540</c:v>
                      </c:pt>
                      <c:pt idx="897">
                        <c:v>1541</c:v>
                      </c:pt>
                      <c:pt idx="898">
                        <c:v>1542</c:v>
                      </c:pt>
                      <c:pt idx="899">
                        <c:v>1543</c:v>
                      </c:pt>
                      <c:pt idx="900">
                        <c:v>1544</c:v>
                      </c:pt>
                      <c:pt idx="901">
                        <c:v>1545</c:v>
                      </c:pt>
                      <c:pt idx="902">
                        <c:v>1546</c:v>
                      </c:pt>
                      <c:pt idx="903">
                        <c:v>1547</c:v>
                      </c:pt>
                      <c:pt idx="904">
                        <c:v>1548</c:v>
                      </c:pt>
                      <c:pt idx="905">
                        <c:v>1549</c:v>
                      </c:pt>
                      <c:pt idx="906">
                        <c:v>1550</c:v>
                      </c:pt>
                      <c:pt idx="907">
                        <c:v>1551</c:v>
                      </c:pt>
                      <c:pt idx="908">
                        <c:v>1552</c:v>
                      </c:pt>
                      <c:pt idx="909">
                        <c:v>1553</c:v>
                      </c:pt>
                      <c:pt idx="910">
                        <c:v>1554</c:v>
                      </c:pt>
                      <c:pt idx="911">
                        <c:v>1555</c:v>
                      </c:pt>
                      <c:pt idx="912">
                        <c:v>1556</c:v>
                      </c:pt>
                      <c:pt idx="913">
                        <c:v>1557</c:v>
                      </c:pt>
                      <c:pt idx="914">
                        <c:v>1558</c:v>
                      </c:pt>
                      <c:pt idx="915">
                        <c:v>1559</c:v>
                      </c:pt>
                      <c:pt idx="916">
                        <c:v>1560</c:v>
                      </c:pt>
                      <c:pt idx="917">
                        <c:v>1561</c:v>
                      </c:pt>
                      <c:pt idx="918">
                        <c:v>1562</c:v>
                      </c:pt>
                      <c:pt idx="919">
                        <c:v>1563</c:v>
                      </c:pt>
                      <c:pt idx="920">
                        <c:v>1564</c:v>
                      </c:pt>
                      <c:pt idx="921">
                        <c:v>1565</c:v>
                      </c:pt>
                      <c:pt idx="922">
                        <c:v>1566</c:v>
                      </c:pt>
                      <c:pt idx="923">
                        <c:v>1567</c:v>
                      </c:pt>
                      <c:pt idx="924">
                        <c:v>1568</c:v>
                      </c:pt>
                      <c:pt idx="925">
                        <c:v>1569</c:v>
                      </c:pt>
                      <c:pt idx="926">
                        <c:v>1570</c:v>
                      </c:pt>
                      <c:pt idx="927">
                        <c:v>1571</c:v>
                      </c:pt>
                      <c:pt idx="928">
                        <c:v>1572</c:v>
                      </c:pt>
                      <c:pt idx="929">
                        <c:v>1573</c:v>
                      </c:pt>
                      <c:pt idx="930">
                        <c:v>1574</c:v>
                      </c:pt>
                      <c:pt idx="931">
                        <c:v>1575</c:v>
                      </c:pt>
                      <c:pt idx="932">
                        <c:v>1576</c:v>
                      </c:pt>
                      <c:pt idx="933">
                        <c:v>1577</c:v>
                      </c:pt>
                      <c:pt idx="934">
                        <c:v>1578</c:v>
                      </c:pt>
                      <c:pt idx="935">
                        <c:v>1579</c:v>
                      </c:pt>
                      <c:pt idx="936">
                        <c:v>1580</c:v>
                      </c:pt>
                      <c:pt idx="937">
                        <c:v>1582</c:v>
                      </c:pt>
                      <c:pt idx="938">
                        <c:v>1583</c:v>
                      </c:pt>
                      <c:pt idx="939">
                        <c:v>1584</c:v>
                      </c:pt>
                      <c:pt idx="940">
                        <c:v>1585</c:v>
                      </c:pt>
                      <c:pt idx="941">
                        <c:v>1586</c:v>
                      </c:pt>
                      <c:pt idx="942">
                        <c:v>1587</c:v>
                      </c:pt>
                      <c:pt idx="943">
                        <c:v>1588</c:v>
                      </c:pt>
                      <c:pt idx="944">
                        <c:v>1589</c:v>
                      </c:pt>
                      <c:pt idx="945">
                        <c:v>1591</c:v>
                      </c:pt>
                      <c:pt idx="946">
                        <c:v>1592</c:v>
                      </c:pt>
                      <c:pt idx="947">
                        <c:v>1593</c:v>
                      </c:pt>
                      <c:pt idx="948">
                        <c:v>1594</c:v>
                      </c:pt>
                      <c:pt idx="949">
                        <c:v>1595</c:v>
                      </c:pt>
                      <c:pt idx="950">
                        <c:v>1596</c:v>
                      </c:pt>
                      <c:pt idx="951">
                        <c:v>1597</c:v>
                      </c:pt>
                      <c:pt idx="952">
                        <c:v>1598</c:v>
                      </c:pt>
                      <c:pt idx="953">
                        <c:v>1599</c:v>
                      </c:pt>
                      <c:pt idx="954">
                        <c:v>1600</c:v>
                      </c:pt>
                      <c:pt idx="955">
                        <c:v>1601</c:v>
                      </c:pt>
                      <c:pt idx="956">
                        <c:v>1602</c:v>
                      </c:pt>
                      <c:pt idx="957">
                        <c:v>1603</c:v>
                      </c:pt>
                      <c:pt idx="958">
                        <c:v>1604</c:v>
                      </c:pt>
                      <c:pt idx="959">
                        <c:v>1605</c:v>
                      </c:pt>
                      <c:pt idx="960">
                        <c:v>1606</c:v>
                      </c:pt>
                      <c:pt idx="961">
                        <c:v>1607</c:v>
                      </c:pt>
                      <c:pt idx="962">
                        <c:v>1608</c:v>
                      </c:pt>
                      <c:pt idx="963">
                        <c:v>1609</c:v>
                      </c:pt>
                      <c:pt idx="964">
                        <c:v>1610</c:v>
                      </c:pt>
                      <c:pt idx="965">
                        <c:v>1611</c:v>
                      </c:pt>
                      <c:pt idx="966">
                        <c:v>1612</c:v>
                      </c:pt>
                      <c:pt idx="967">
                        <c:v>1613</c:v>
                      </c:pt>
                      <c:pt idx="968">
                        <c:v>1614</c:v>
                      </c:pt>
                      <c:pt idx="969">
                        <c:v>1615</c:v>
                      </c:pt>
                      <c:pt idx="970">
                        <c:v>1616</c:v>
                      </c:pt>
                      <c:pt idx="971">
                        <c:v>1617</c:v>
                      </c:pt>
                      <c:pt idx="972">
                        <c:v>1618</c:v>
                      </c:pt>
                      <c:pt idx="973">
                        <c:v>1619</c:v>
                      </c:pt>
                      <c:pt idx="974">
                        <c:v>1620</c:v>
                      </c:pt>
                      <c:pt idx="975">
                        <c:v>1621</c:v>
                      </c:pt>
                      <c:pt idx="976">
                        <c:v>1622</c:v>
                      </c:pt>
                      <c:pt idx="977">
                        <c:v>1623</c:v>
                      </c:pt>
                      <c:pt idx="978">
                        <c:v>1624</c:v>
                      </c:pt>
                      <c:pt idx="979">
                        <c:v>1625</c:v>
                      </c:pt>
                      <c:pt idx="980">
                        <c:v>1626</c:v>
                      </c:pt>
                      <c:pt idx="981">
                        <c:v>1627</c:v>
                      </c:pt>
                      <c:pt idx="982">
                        <c:v>1628</c:v>
                      </c:pt>
                      <c:pt idx="983">
                        <c:v>1629</c:v>
                      </c:pt>
                      <c:pt idx="984">
                        <c:v>1630</c:v>
                      </c:pt>
                      <c:pt idx="985">
                        <c:v>1631</c:v>
                      </c:pt>
                      <c:pt idx="986">
                        <c:v>1632</c:v>
                      </c:pt>
                      <c:pt idx="987">
                        <c:v>1633</c:v>
                      </c:pt>
                      <c:pt idx="988">
                        <c:v>1634</c:v>
                      </c:pt>
                      <c:pt idx="989">
                        <c:v>1635</c:v>
                      </c:pt>
                      <c:pt idx="990">
                        <c:v>1636</c:v>
                      </c:pt>
                      <c:pt idx="991">
                        <c:v>1637</c:v>
                      </c:pt>
                      <c:pt idx="992">
                        <c:v>1638</c:v>
                      </c:pt>
                      <c:pt idx="993">
                        <c:v>1639</c:v>
                      </c:pt>
                      <c:pt idx="994">
                        <c:v>1640</c:v>
                      </c:pt>
                      <c:pt idx="995">
                        <c:v>1641</c:v>
                      </c:pt>
                      <c:pt idx="996">
                        <c:v>1642</c:v>
                      </c:pt>
                      <c:pt idx="997">
                        <c:v>1643</c:v>
                      </c:pt>
                      <c:pt idx="998">
                        <c:v>1644</c:v>
                      </c:pt>
                      <c:pt idx="999">
                        <c:v>1645</c:v>
                      </c:pt>
                      <c:pt idx="1000">
                        <c:v>1646</c:v>
                      </c:pt>
                      <c:pt idx="1001">
                        <c:v>1647</c:v>
                      </c:pt>
                      <c:pt idx="1002">
                        <c:v>1648</c:v>
                      </c:pt>
                      <c:pt idx="1003">
                        <c:v>1649</c:v>
                      </c:pt>
                      <c:pt idx="1004">
                        <c:v>1650</c:v>
                      </c:pt>
                      <c:pt idx="1005">
                        <c:v>1651</c:v>
                      </c:pt>
                      <c:pt idx="1006">
                        <c:v>1652</c:v>
                      </c:pt>
                      <c:pt idx="1007">
                        <c:v>1653</c:v>
                      </c:pt>
                      <c:pt idx="1008">
                        <c:v>1654</c:v>
                      </c:pt>
                      <c:pt idx="1009">
                        <c:v>1655</c:v>
                      </c:pt>
                      <c:pt idx="1010">
                        <c:v>1656</c:v>
                      </c:pt>
                      <c:pt idx="1011">
                        <c:v>1657</c:v>
                      </c:pt>
                      <c:pt idx="1012">
                        <c:v>1658</c:v>
                      </c:pt>
                      <c:pt idx="1013">
                        <c:v>1659</c:v>
                      </c:pt>
                      <c:pt idx="1014">
                        <c:v>1660</c:v>
                      </c:pt>
                      <c:pt idx="1015">
                        <c:v>1661</c:v>
                      </c:pt>
                      <c:pt idx="1016">
                        <c:v>1663</c:v>
                      </c:pt>
                      <c:pt idx="1017">
                        <c:v>1664</c:v>
                      </c:pt>
                      <c:pt idx="1018">
                        <c:v>1668</c:v>
                      </c:pt>
                      <c:pt idx="1019">
                        <c:v>1669</c:v>
                      </c:pt>
                      <c:pt idx="1020">
                        <c:v>1672</c:v>
                      </c:pt>
                      <c:pt idx="1021">
                        <c:v>1673</c:v>
                      </c:pt>
                      <c:pt idx="1022">
                        <c:v>1674</c:v>
                      </c:pt>
                      <c:pt idx="1023">
                        <c:v>1675</c:v>
                      </c:pt>
                      <c:pt idx="1024">
                        <c:v>1676</c:v>
                      </c:pt>
                      <c:pt idx="1025">
                        <c:v>1677</c:v>
                      </c:pt>
                      <c:pt idx="1026">
                        <c:v>1678</c:v>
                      </c:pt>
                      <c:pt idx="1027">
                        <c:v>1679</c:v>
                      </c:pt>
                      <c:pt idx="1028">
                        <c:v>1680</c:v>
                      </c:pt>
                      <c:pt idx="1029">
                        <c:v>1681</c:v>
                      </c:pt>
                      <c:pt idx="1030">
                        <c:v>1682</c:v>
                      </c:pt>
                      <c:pt idx="1031">
                        <c:v>1683</c:v>
                      </c:pt>
                      <c:pt idx="1032">
                        <c:v>1684</c:v>
                      </c:pt>
                      <c:pt idx="1033">
                        <c:v>1685</c:v>
                      </c:pt>
                      <c:pt idx="1034">
                        <c:v>1686</c:v>
                      </c:pt>
                      <c:pt idx="1035">
                        <c:v>1687</c:v>
                      </c:pt>
                      <c:pt idx="1036">
                        <c:v>1688</c:v>
                      </c:pt>
                      <c:pt idx="1037">
                        <c:v>1689</c:v>
                      </c:pt>
                      <c:pt idx="1038">
                        <c:v>1690</c:v>
                      </c:pt>
                      <c:pt idx="1039">
                        <c:v>1701</c:v>
                      </c:pt>
                      <c:pt idx="1040">
                        <c:v>1704</c:v>
                      </c:pt>
                      <c:pt idx="1041">
                        <c:v>1708</c:v>
                      </c:pt>
                      <c:pt idx="1042">
                        <c:v>1709</c:v>
                      </c:pt>
                      <c:pt idx="1043">
                        <c:v>1710</c:v>
                      </c:pt>
                      <c:pt idx="1044">
                        <c:v>1712</c:v>
                      </c:pt>
                      <c:pt idx="1045">
                        <c:v>1713</c:v>
                      </c:pt>
                      <c:pt idx="1046">
                        <c:v>1714</c:v>
                      </c:pt>
                      <c:pt idx="1047">
                        <c:v>1715</c:v>
                      </c:pt>
                      <c:pt idx="1048">
                        <c:v>1716</c:v>
                      </c:pt>
                      <c:pt idx="1049">
                        <c:v>1717</c:v>
                      </c:pt>
                      <c:pt idx="1050">
                        <c:v>1718</c:v>
                      </c:pt>
                      <c:pt idx="1051">
                        <c:v>1721</c:v>
                      </c:pt>
                      <c:pt idx="1052">
                        <c:v>1722</c:v>
                      </c:pt>
                      <c:pt idx="1053">
                        <c:v>1725</c:v>
                      </c:pt>
                      <c:pt idx="1054">
                        <c:v>1726</c:v>
                      </c:pt>
                      <c:pt idx="1055">
                        <c:v>1732</c:v>
                      </c:pt>
                      <c:pt idx="1056">
                        <c:v>1746</c:v>
                      </c:pt>
                      <c:pt idx="1057">
                        <c:v>1951</c:v>
                      </c:pt>
                    </c:numCache>
                  </c:numRef>
                </c:xVal>
                <c:yVal>
                  <c:numRef>
                    <c:extLst xmlns:c15="http://schemas.microsoft.com/office/drawing/2012/chart">
                      <c:ext xmlns:c15="http://schemas.microsoft.com/office/drawing/2012/chart" uri="{02D57815-91ED-43cb-92C2-25804820EDAC}">
                        <c15:formulaRef>
                          <c15:sqref>'Brachy NFY'!$F$3:$F$1060</c15:sqref>
                        </c15:formulaRef>
                      </c:ext>
                    </c:extLst>
                    <c:numCache>
                      <c:formatCode>General</c:formatCode>
                      <c:ptCount val="1058"/>
                      <c:pt idx="26">
                        <c:v>1</c:v>
                      </c:pt>
                      <c:pt idx="69">
                        <c:v>1</c:v>
                      </c:pt>
                      <c:pt idx="82">
                        <c:v>1</c:v>
                      </c:pt>
                      <c:pt idx="93">
                        <c:v>1</c:v>
                      </c:pt>
                      <c:pt idx="111">
                        <c:v>1</c:v>
                      </c:pt>
                      <c:pt idx="133">
                        <c:v>1</c:v>
                      </c:pt>
                      <c:pt idx="138">
                        <c:v>1</c:v>
                      </c:pt>
                      <c:pt idx="145">
                        <c:v>1</c:v>
                      </c:pt>
                      <c:pt idx="152">
                        <c:v>1</c:v>
                      </c:pt>
                      <c:pt idx="160">
                        <c:v>1</c:v>
                      </c:pt>
                      <c:pt idx="164">
                        <c:v>1</c:v>
                      </c:pt>
                      <c:pt idx="189">
                        <c:v>1</c:v>
                      </c:pt>
                      <c:pt idx="197">
                        <c:v>1</c:v>
                      </c:pt>
                      <c:pt idx="198">
                        <c:v>1</c:v>
                      </c:pt>
                      <c:pt idx="200">
                        <c:v>1</c:v>
                      </c:pt>
                      <c:pt idx="205">
                        <c:v>1</c:v>
                      </c:pt>
                      <c:pt idx="228">
                        <c:v>1</c:v>
                      </c:pt>
                      <c:pt idx="232">
                        <c:v>1</c:v>
                      </c:pt>
                      <c:pt idx="234">
                        <c:v>1</c:v>
                      </c:pt>
                      <c:pt idx="235">
                        <c:v>1</c:v>
                      </c:pt>
                      <c:pt idx="248">
                        <c:v>1</c:v>
                      </c:pt>
                      <c:pt idx="258">
                        <c:v>1</c:v>
                      </c:pt>
                      <c:pt idx="259">
                        <c:v>1</c:v>
                      </c:pt>
                      <c:pt idx="263">
                        <c:v>1</c:v>
                      </c:pt>
                      <c:pt idx="273">
                        <c:v>1</c:v>
                      </c:pt>
                      <c:pt idx="275">
                        <c:v>1</c:v>
                      </c:pt>
                      <c:pt idx="283">
                        <c:v>1</c:v>
                      </c:pt>
                      <c:pt idx="286">
                        <c:v>1</c:v>
                      </c:pt>
                      <c:pt idx="290">
                        <c:v>1</c:v>
                      </c:pt>
                      <c:pt idx="298">
                        <c:v>1</c:v>
                      </c:pt>
                      <c:pt idx="310">
                        <c:v>1</c:v>
                      </c:pt>
                      <c:pt idx="311">
                        <c:v>1</c:v>
                      </c:pt>
                      <c:pt idx="314">
                        <c:v>1</c:v>
                      </c:pt>
                      <c:pt idx="317">
                        <c:v>1</c:v>
                      </c:pt>
                      <c:pt idx="327">
                        <c:v>1</c:v>
                      </c:pt>
                      <c:pt idx="335">
                        <c:v>1</c:v>
                      </c:pt>
                      <c:pt idx="337">
                        <c:v>4</c:v>
                      </c:pt>
                      <c:pt idx="338">
                        <c:v>1</c:v>
                      </c:pt>
                      <c:pt idx="342">
                        <c:v>1</c:v>
                      </c:pt>
                      <c:pt idx="350">
                        <c:v>1</c:v>
                      </c:pt>
                      <c:pt idx="352">
                        <c:v>1</c:v>
                      </c:pt>
                      <c:pt idx="355">
                        <c:v>1</c:v>
                      </c:pt>
                      <c:pt idx="368">
                        <c:v>1</c:v>
                      </c:pt>
                      <c:pt idx="381">
                        <c:v>1</c:v>
                      </c:pt>
                      <c:pt idx="387">
                        <c:v>1</c:v>
                      </c:pt>
                      <c:pt idx="389">
                        <c:v>1</c:v>
                      </c:pt>
                      <c:pt idx="391">
                        <c:v>1</c:v>
                      </c:pt>
                      <c:pt idx="396">
                        <c:v>1</c:v>
                      </c:pt>
                      <c:pt idx="397">
                        <c:v>1</c:v>
                      </c:pt>
                      <c:pt idx="404">
                        <c:v>1</c:v>
                      </c:pt>
                      <c:pt idx="405">
                        <c:v>1</c:v>
                      </c:pt>
                      <c:pt idx="413">
                        <c:v>1</c:v>
                      </c:pt>
                      <c:pt idx="414">
                        <c:v>1</c:v>
                      </c:pt>
                      <c:pt idx="419">
                        <c:v>1</c:v>
                      </c:pt>
                      <c:pt idx="423">
                        <c:v>1</c:v>
                      </c:pt>
                      <c:pt idx="424">
                        <c:v>1</c:v>
                      </c:pt>
                      <c:pt idx="427">
                        <c:v>1</c:v>
                      </c:pt>
                      <c:pt idx="432">
                        <c:v>1</c:v>
                      </c:pt>
                      <c:pt idx="433">
                        <c:v>1</c:v>
                      </c:pt>
                      <c:pt idx="434">
                        <c:v>1</c:v>
                      </c:pt>
                      <c:pt idx="438">
                        <c:v>1</c:v>
                      </c:pt>
                      <c:pt idx="440">
                        <c:v>1</c:v>
                      </c:pt>
                      <c:pt idx="441">
                        <c:v>1</c:v>
                      </c:pt>
                      <c:pt idx="455">
                        <c:v>1</c:v>
                      </c:pt>
                      <c:pt idx="460">
                        <c:v>1</c:v>
                      </c:pt>
                      <c:pt idx="470">
                        <c:v>1</c:v>
                      </c:pt>
                      <c:pt idx="479">
                        <c:v>1</c:v>
                      </c:pt>
                      <c:pt idx="480">
                        <c:v>1</c:v>
                      </c:pt>
                      <c:pt idx="482">
                        <c:v>1</c:v>
                      </c:pt>
                      <c:pt idx="483">
                        <c:v>1</c:v>
                      </c:pt>
                      <c:pt idx="484">
                        <c:v>1</c:v>
                      </c:pt>
                      <c:pt idx="488">
                        <c:v>1</c:v>
                      </c:pt>
                      <c:pt idx="493">
                        <c:v>1</c:v>
                      </c:pt>
                      <c:pt idx="506">
                        <c:v>1</c:v>
                      </c:pt>
                      <c:pt idx="513">
                        <c:v>1</c:v>
                      </c:pt>
                      <c:pt idx="514">
                        <c:v>1</c:v>
                      </c:pt>
                      <c:pt idx="515">
                        <c:v>1</c:v>
                      </c:pt>
                      <c:pt idx="538">
                        <c:v>1</c:v>
                      </c:pt>
                      <c:pt idx="539">
                        <c:v>1</c:v>
                      </c:pt>
                      <c:pt idx="545">
                        <c:v>1</c:v>
                      </c:pt>
                      <c:pt idx="547">
                        <c:v>1</c:v>
                      </c:pt>
                      <c:pt idx="549">
                        <c:v>1</c:v>
                      </c:pt>
                      <c:pt idx="551">
                        <c:v>1</c:v>
                      </c:pt>
                      <c:pt idx="561">
                        <c:v>1</c:v>
                      </c:pt>
                      <c:pt idx="563">
                        <c:v>1</c:v>
                      </c:pt>
                      <c:pt idx="570">
                        <c:v>1</c:v>
                      </c:pt>
                      <c:pt idx="574">
                        <c:v>1</c:v>
                      </c:pt>
                      <c:pt idx="575">
                        <c:v>1</c:v>
                      </c:pt>
                      <c:pt idx="578">
                        <c:v>1</c:v>
                      </c:pt>
                      <c:pt idx="597">
                        <c:v>1</c:v>
                      </c:pt>
                      <c:pt idx="602">
                        <c:v>1</c:v>
                      </c:pt>
                      <c:pt idx="603">
                        <c:v>4</c:v>
                      </c:pt>
                      <c:pt idx="604">
                        <c:v>4</c:v>
                      </c:pt>
                      <c:pt idx="605">
                        <c:v>7</c:v>
                      </c:pt>
                      <c:pt idx="606">
                        <c:v>3</c:v>
                      </c:pt>
                      <c:pt idx="608">
                        <c:v>1</c:v>
                      </c:pt>
                      <c:pt idx="609">
                        <c:v>1</c:v>
                      </c:pt>
                      <c:pt idx="615">
                        <c:v>1</c:v>
                      </c:pt>
                      <c:pt idx="621">
                        <c:v>1</c:v>
                      </c:pt>
                      <c:pt idx="632">
                        <c:v>1</c:v>
                      </c:pt>
                      <c:pt idx="633">
                        <c:v>1</c:v>
                      </c:pt>
                      <c:pt idx="634">
                        <c:v>1</c:v>
                      </c:pt>
                      <c:pt idx="636">
                        <c:v>1</c:v>
                      </c:pt>
                      <c:pt idx="644">
                        <c:v>1</c:v>
                      </c:pt>
                      <c:pt idx="648">
                        <c:v>1</c:v>
                      </c:pt>
                      <c:pt idx="666">
                        <c:v>1</c:v>
                      </c:pt>
                      <c:pt idx="678">
                        <c:v>1</c:v>
                      </c:pt>
                      <c:pt idx="680">
                        <c:v>1</c:v>
                      </c:pt>
                      <c:pt idx="684">
                        <c:v>1</c:v>
                      </c:pt>
                      <c:pt idx="687">
                        <c:v>1</c:v>
                      </c:pt>
                      <c:pt idx="695">
                        <c:v>1</c:v>
                      </c:pt>
                      <c:pt idx="700">
                        <c:v>1</c:v>
                      </c:pt>
                      <c:pt idx="704">
                        <c:v>1</c:v>
                      </c:pt>
                      <c:pt idx="705">
                        <c:v>1</c:v>
                      </c:pt>
                      <c:pt idx="706">
                        <c:v>1</c:v>
                      </c:pt>
                      <c:pt idx="715">
                        <c:v>1</c:v>
                      </c:pt>
                      <c:pt idx="718">
                        <c:v>1</c:v>
                      </c:pt>
                      <c:pt idx="733">
                        <c:v>1</c:v>
                      </c:pt>
                      <c:pt idx="741">
                        <c:v>1</c:v>
                      </c:pt>
                      <c:pt idx="745">
                        <c:v>1</c:v>
                      </c:pt>
                      <c:pt idx="748">
                        <c:v>1</c:v>
                      </c:pt>
                      <c:pt idx="758">
                        <c:v>1</c:v>
                      </c:pt>
                      <c:pt idx="762">
                        <c:v>1</c:v>
                      </c:pt>
                      <c:pt idx="764">
                        <c:v>1</c:v>
                      </c:pt>
                      <c:pt idx="769">
                        <c:v>1</c:v>
                      </c:pt>
                      <c:pt idx="776">
                        <c:v>1</c:v>
                      </c:pt>
                      <c:pt idx="780">
                        <c:v>1</c:v>
                      </c:pt>
                      <c:pt idx="781">
                        <c:v>1</c:v>
                      </c:pt>
                      <c:pt idx="783">
                        <c:v>1</c:v>
                      </c:pt>
                      <c:pt idx="789">
                        <c:v>1</c:v>
                      </c:pt>
                      <c:pt idx="790">
                        <c:v>1</c:v>
                      </c:pt>
                      <c:pt idx="793">
                        <c:v>1</c:v>
                      </c:pt>
                      <c:pt idx="795">
                        <c:v>1</c:v>
                      </c:pt>
                      <c:pt idx="796">
                        <c:v>1</c:v>
                      </c:pt>
                      <c:pt idx="797">
                        <c:v>1</c:v>
                      </c:pt>
                      <c:pt idx="798">
                        <c:v>1</c:v>
                      </c:pt>
                      <c:pt idx="800">
                        <c:v>1</c:v>
                      </c:pt>
                      <c:pt idx="801">
                        <c:v>1</c:v>
                      </c:pt>
                      <c:pt idx="806">
                        <c:v>34</c:v>
                      </c:pt>
                      <c:pt idx="808">
                        <c:v>1</c:v>
                      </c:pt>
                      <c:pt idx="814">
                        <c:v>1</c:v>
                      </c:pt>
                      <c:pt idx="819">
                        <c:v>1</c:v>
                      </c:pt>
                      <c:pt idx="822">
                        <c:v>1</c:v>
                      </c:pt>
                      <c:pt idx="824">
                        <c:v>1</c:v>
                      </c:pt>
                      <c:pt idx="826">
                        <c:v>2</c:v>
                      </c:pt>
                      <c:pt idx="827">
                        <c:v>1</c:v>
                      </c:pt>
                      <c:pt idx="829">
                        <c:v>1</c:v>
                      </c:pt>
                      <c:pt idx="830">
                        <c:v>1</c:v>
                      </c:pt>
                      <c:pt idx="832">
                        <c:v>1</c:v>
                      </c:pt>
                      <c:pt idx="833">
                        <c:v>1</c:v>
                      </c:pt>
                      <c:pt idx="834">
                        <c:v>1</c:v>
                      </c:pt>
                      <c:pt idx="835">
                        <c:v>1</c:v>
                      </c:pt>
                      <c:pt idx="837">
                        <c:v>1</c:v>
                      </c:pt>
                      <c:pt idx="838">
                        <c:v>1</c:v>
                      </c:pt>
                      <c:pt idx="839">
                        <c:v>1</c:v>
                      </c:pt>
                      <c:pt idx="841">
                        <c:v>1</c:v>
                      </c:pt>
                      <c:pt idx="843">
                        <c:v>1</c:v>
                      </c:pt>
                      <c:pt idx="844">
                        <c:v>1</c:v>
                      </c:pt>
                      <c:pt idx="845">
                        <c:v>1</c:v>
                      </c:pt>
                      <c:pt idx="846">
                        <c:v>1</c:v>
                      </c:pt>
                      <c:pt idx="849">
                        <c:v>8</c:v>
                      </c:pt>
                      <c:pt idx="851">
                        <c:v>1</c:v>
                      </c:pt>
                      <c:pt idx="853">
                        <c:v>1</c:v>
                      </c:pt>
                      <c:pt idx="854">
                        <c:v>1</c:v>
                      </c:pt>
                      <c:pt idx="857">
                        <c:v>1</c:v>
                      </c:pt>
                      <c:pt idx="858">
                        <c:v>1</c:v>
                      </c:pt>
                      <c:pt idx="859">
                        <c:v>1</c:v>
                      </c:pt>
                      <c:pt idx="860">
                        <c:v>1</c:v>
                      </c:pt>
                      <c:pt idx="864">
                        <c:v>1</c:v>
                      </c:pt>
                      <c:pt idx="865">
                        <c:v>1</c:v>
                      </c:pt>
                      <c:pt idx="868">
                        <c:v>1</c:v>
                      </c:pt>
                      <c:pt idx="869">
                        <c:v>1</c:v>
                      </c:pt>
                      <c:pt idx="873">
                        <c:v>1</c:v>
                      </c:pt>
                      <c:pt idx="875">
                        <c:v>1</c:v>
                      </c:pt>
                      <c:pt idx="876">
                        <c:v>3</c:v>
                      </c:pt>
                      <c:pt idx="877">
                        <c:v>1</c:v>
                      </c:pt>
                      <c:pt idx="878">
                        <c:v>1</c:v>
                      </c:pt>
                      <c:pt idx="880">
                        <c:v>1</c:v>
                      </c:pt>
                      <c:pt idx="882">
                        <c:v>1</c:v>
                      </c:pt>
                      <c:pt idx="884">
                        <c:v>1</c:v>
                      </c:pt>
                      <c:pt idx="885">
                        <c:v>3</c:v>
                      </c:pt>
                      <c:pt idx="886">
                        <c:v>1</c:v>
                      </c:pt>
                      <c:pt idx="887">
                        <c:v>1</c:v>
                      </c:pt>
                      <c:pt idx="888">
                        <c:v>1</c:v>
                      </c:pt>
                      <c:pt idx="889">
                        <c:v>1</c:v>
                      </c:pt>
                      <c:pt idx="891">
                        <c:v>1</c:v>
                      </c:pt>
                      <c:pt idx="892">
                        <c:v>1</c:v>
                      </c:pt>
                      <c:pt idx="893">
                        <c:v>1</c:v>
                      </c:pt>
                      <c:pt idx="894">
                        <c:v>1</c:v>
                      </c:pt>
                      <c:pt idx="895">
                        <c:v>1</c:v>
                      </c:pt>
                      <c:pt idx="896">
                        <c:v>1</c:v>
                      </c:pt>
                      <c:pt idx="897">
                        <c:v>2</c:v>
                      </c:pt>
                      <c:pt idx="898">
                        <c:v>1</c:v>
                      </c:pt>
                      <c:pt idx="899">
                        <c:v>1</c:v>
                      </c:pt>
                      <c:pt idx="901">
                        <c:v>1</c:v>
                      </c:pt>
                      <c:pt idx="902">
                        <c:v>1</c:v>
                      </c:pt>
                      <c:pt idx="903">
                        <c:v>1</c:v>
                      </c:pt>
                      <c:pt idx="904">
                        <c:v>1</c:v>
                      </c:pt>
                      <c:pt idx="905">
                        <c:v>1</c:v>
                      </c:pt>
                      <c:pt idx="906">
                        <c:v>21</c:v>
                      </c:pt>
                      <c:pt idx="907">
                        <c:v>2</c:v>
                      </c:pt>
                      <c:pt idx="910">
                        <c:v>2</c:v>
                      </c:pt>
                      <c:pt idx="911">
                        <c:v>2</c:v>
                      </c:pt>
                      <c:pt idx="913">
                        <c:v>1</c:v>
                      </c:pt>
                      <c:pt idx="914">
                        <c:v>1</c:v>
                      </c:pt>
                      <c:pt idx="915">
                        <c:v>1</c:v>
                      </c:pt>
                      <c:pt idx="916">
                        <c:v>3</c:v>
                      </c:pt>
                      <c:pt idx="917">
                        <c:v>1</c:v>
                      </c:pt>
                      <c:pt idx="918">
                        <c:v>7</c:v>
                      </c:pt>
                      <c:pt idx="919">
                        <c:v>1</c:v>
                      </c:pt>
                      <c:pt idx="920">
                        <c:v>1</c:v>
                      </c:pt>
                      <c:pt idx="921">
                        <c:v>57</c:v>
                      </c:pt>
                      <c:pt idx="922">
                        <c:v>36</c:v>
                      </c:pt>
                      <c:pt idx="923">
                        <c:v>1</c:v>
                      </c:pt>
                      <c:pt idx="924">
                        <c:v>7</c:v>
                      </c:pt>
                      <c:pt idx="925">
                        <c:v>3</c:v>
                      </c:pt>
                      <c:pt idx="926">
                        <c:v>1</c:v>
                      </c:pt>
                      <c:pt idx="927">
                        <c:v>1</c:v>
                      </c:pt>
                      <c:pt idx="928">
                        <c:v>1</c:v>
                      </c:pt>
                      <c:pt idx="929">
                        <c:v>1</c:v>
                      </c:pt>
                      <c:pt idx="930">
                        <c:v>3</c:v>
                      </c:pt>
                      <c:pt idx="931">
                        <c:v>5</c:v>
                      </c:pt>
                      <c:pt idx="932">
                        <c:v>3</c:v>
                      </c:pt>
                      <c:pt idx="933">
                        <c:v>1</c:v>
                      </c:pt>
                      <c:pt idx="935">
                        <c:v>1</c:v>
                      </c:pt>
                      <c:pt idx="938">
                        <c:v>1</c:v>
                      </c:pt>
                      <c:pt idx="939">
                        <c:v>4</c:v>
                      </c:pt>
                      <c:pt idx="946">
                        <c:v>1</c:v>
                      </c:pt>
                      <c:pt idx="947">
                        <c:v>1</c:v>
                      </c:pt>
                      <c:pt idx="948">
                        <c:v>1</c:v>
                      </c:pt>
                      <c:pt idx="950">
                        <c:v>1</c:v>
                      </c:pt>
                      <c:pt idx="951">
                        <c:v>1</c:v>
                      </c:pt>
                      <c:pt idx="952">
                        <c:v>1</c:v>
                      </c:pt>
                      <c:pt idx="953">
                        <c:v>1</c:v>
                      </c:pt>
                      <c:pt idx="954">
                        <c:v>1</c:v>
                      </c:pt>
                      <c:pt idx="955">
                        <c:v>3</c:v>
                      </c:pt>
                      <c:pt idx="956">
                        <c:v>5</c:v>
                      </c:pt>
                      <c:pt idx="957">
                        <c:v>5</c:v>
                      </c:pt>
                      <c:pt idx="958">
                        <c:v>1</c:v>
                      </c:pt>
                      <c:pt idx="959">
                        <c:v>1</c:v>
                      </c:pt>
                      <c:pt idx="960">
                        <c:v>1</c:v>
                      </c:pt>
                      <c:pt idx="962">
                        <c:v>10</c:v>
                      </c:pt>
                      <c:pt idx="963">
                        <c:v>17</c:v>
                      </c:pt>
                      <c:pt idx="964">
                        <c:v>1</c:v>
                      </c:pt>
                      <c:pt idx="965">
                        <c:v>1</c:v>
                      </c:pt>
                      <c:pt idx="966">
                        <c:v>1</c:v>
                      </c:pt>
                      <c:pt idx="967">
                        <c:v>1</c:v>
                      </c:pt>
                      <c:pt idx="968">
                        <c:v>1</c:v>
                      </c:pt>
                      <c:pt idx="969">
                        <c:v>7</c:v>
                      </c:pt>
                      <c:pt idx="970">
                        <c:v>2</c:v>
                      </c:pt>
                      <c:pt idx="972">
                        <c:v>1</c:v>
                      </c:pt>
                      <c:pt idx="973">
                        <c:v>3</c:v>
                      </c:pt>
                      <c:pt idx="974">
                        <c:v>1</c:v>
                      </c:pt>
                      <c:pt idx="976">
                        <c:v>1</c:v>
                      </c:pt>
                      <c:pt idx="978">
                        <c:v>5</c:v>
                      </c:pt>
                      <c:pt idx="979">
                        <c:v>1</c:v>
                      </c:pt>
                      <c:pt idx="980">
                        <c:v>1</c:v>
                      </c:pt>
                      <c:pt idx="982">
                        <c:v>1</c:v>
                      </c:pt>
                      <c:pt idx="983">
                        <c:v>1</c:v>
                      </c:pt>
                      <c:pt idx="984">
                        <c:v>1</c:v>
                      </c:pt>
                      <c:pt idx="985">
                        <c:v>1</c:v>
                      </c:pt>
                      <c:pt idx="986">
                        <c:v>5</c:v>
                      </c:pt>
                      <c:pt idx="987">
                        <c:v>11</c:v>
                      </c:pt>
                      <c:pt idx="988">
                        <c:v>1</c:v>
                      </c:pt>
                      <c:pt idx="989">
                        <c:v>1</c:v>
                      </c:pt>
                      <c:pt idx="990">
                        <c:v>4</c:v>
                      </c:pt>
                      <c:pt idx="991">
                        <c:v>126</c:v>
                      </c:pt>
                      <c:pt idx="992">
                        <c:v>35</c:v>
                      </c:pt>
                      <c:pt idx="994">
                        <c:v>2</c:v>
                      </c:pt>
                      <c:pt idx="995">
                        <c:v>6</c:v>
                      </c:pt>
                      <c:pt idx="996">
                        <c:v>4</c:v>
                      </c:pt>
                      <c:pt idx="997">
                        <c:v>3</c:v>
                      </c:pt>
                      <c:pt idx="998">
                        <c:v>3</c:v>
                      </c:pt>
                      <c:pt idx="999">
                        <c:v>1</c:v>
                      </c:pt>
                      <c:pt idx="1000">
                        <c:v>3</c:v>
                      </c:pt>
                      <c:pt idx="1001">
                        <c:v>1</c:v>
                      </c:pt>
                      <c:pt idx="1002">
                        <c:v>1</c:v>
                      </c:pt>
                      <c:pt idx="1003">
                        <c:v>2</c:v>
                      </c:pt>
                      <c:pt idx="1004">
                        <c:v>1</c:v>
                      </c:pt>
                      <c:pt idx="1005">
                        <c:v>1</c:v>
                      </c:pt>
                      <c:pt idx="1006">
                        <c:v>3</c:v>
                      </c:pt>
                      <c:pt idx="1007">
                        <c:v>4</c:v>
                      </c:pt>
                      <c:pt idx="1008">
                        <c:v>1</c:v>
                      </c:pt>
                      <c:pt idx="1009">
                        <c:v>3</c:v>
                      </c:pt>
                      <c:pt idx="1010">
                        <c:v>1</c:v>
                      </c:pt>
                      <c:pt idx="1011">
                        <c:v>3</c:v>
                      </c:pt>
                      <c:pt idx="1013">
                        <c:v>1</c:v>
                      </c:pt>
                      <c:pt idx="1018">
                        <c:v>1</c:v>
                      </c:pt>
                      <c:pt idx="1025">
                        <c:v>3</c:v>
                      </c:pt>
                      <c:pt idx="1026">
                        <c:v>3</c:v>
                      </c:pt>
                      <c:pt idx="1028">
                        <c:v>1</c:v>
                      </c:pt>
                      <c:pt idx="1029">
                        <c:v>3</c:v>
                      </c:pt>
                      <c:pt idx="1030">
                        <c:v>2</c:v>
                      </c:pt>
                      <c:pt idx="1045">
                        <c:v>1</c:v>
                      </c:pt>
                      <c:pt idx="1046">
                        <c:v>1</c:v>
                      </c:pt>
                      <c:pt idx="1047">
                        <c:v>1</c:v>
                      </c:pt>
                      <c:pt idx="1048">
                        <c:v>1</c:v>
                      </c:pt>
                      <c:pt idx="1050">
                        <c:v>1</c:v>
                      </c:pt>
                      <c:pt idx="1051">
                        <c:v>1</c:v>
                      </c:pt>
                      <c:pt idx="1052">
                        <c:v>1</c:v>
                      </c:pt>
                      <c:pt idx="1054">
                        <c:v>1</c:v>
                      </c:pt>
                      <c:pt idx="1055">
                        <c:v>1</c:v>
                      </c:pt>
                      <c:pt idx="1056">
                        <c:v>1</c:v>
                      </c:pt>
                    </c:numCache>
                  </c:numRef>
                </c:yVal>
                <c:smooth val="0"/>
              </c15:ser>
            </c15:filteredScatterSeries>
          </c:ext>
        </c:extLst>
      </c:scatterChart>
      <c:valAx>
        <c:axId val="424490168"/>
        <c:scaling>
          <c:orientation val="minMax"/>
          <c:max val="1800"/>
          <c:min val="0"/>
        </c:scaling>
        <c:delete val="0"/>
        <c:axPos val="b"/>
        <c:title>
          <c:tx>
            <c:rich>
              <a:bodyPr rot="0" spcFirstLastPara="1" vertOverflow="ellipsis" vert="horz" wrap="square" anchor="ctr" anchorCtr="1"/>
              <a:lstStyle/>
              <a:p>
                <a:pPr>
                  <a:defRPr sz="800" b="1" i="0" u="none" strike="noStrike" kern="1200" baseline="0">
                    <a:solidFill>
                      <a:schemeClr val="tx1"/>
                    </a:solidFill>
                    <a:latin typeface="+mn-lt"/>
                    <a:ea typeface="+mn-ea"/>
                    <a:cs typeface="+mn-cs"/>
                  </a:defRPr>
                </a:pPr>
                <a:r>
                  <a:rPr lang="en-US" sz="800" b="1">
                    <a:solidFill>
                      <a:schemeClr val="tx1"/>
                    </a:solidFill>
                  </a:rPr>
                  <a:t>cDNA Position</a:t>
                </a:r>
              </a:p>
            </c:rich>
          </c:tx>
          <c:layout/>
          <c:overlay val="0"/>
          <c:spPr>
            <a:noFill/>
            <a:ln>
              <a:noFill/>
            </a:ln>
            <a:effectLst/>
          </c:spPr>
          <c:txPr>
            <a:bodyPr rot="0" spcFirstLastPara="1" vertOverflow="ellipsis" vert="horz" wrap="square" anchor="ctr" anchorCtr="1"/>
            <a:lstStyle/>
            <a:p>
              <a:pPr>
                <a:defRPr sz="800" b="1" i="0" u="none" strike="noStrike" kern="1200" baseline="0">
                  <a:solidFill>
                    <a:schemeClr val="tx1"/>
                  </a:solidFill>
                  <a:latin typeface="+mn-lt"/>
                  <a:ea typeface="+mn-ea"/>
                  <a:cs typeface="+mn-cs"/>
                </a:defRPr>
              </a:pPr>
              <a:endParaRPr lang="en-US"/>
            </a:p>
          </c:txPr>
        </c:title>
        <c:numFmt formatCode="General"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800" b="0" i="0" u="none" strike="noStrike" kern="1200" baseline="0">
                <a:solidFill>
                  <a:schemeClr val="tx1"/>
                </a:solidFill>
                <a:latin typeface="+mn-lt"/>
                <a:ea typeface="+mn-ea"/>
                <a:cs typeface="+mn-cs"/>
              </a:defRPr>
            </a:pPr>
            <a:endParaRPr lang="en-US"/>
          </a:p>
        </c:txPr>
        <c:crossAx val="241376952"/>
        <c:crosses val="autoZero"/>
        <c:crossBetween val="midCat"/>
      </c:valAx>
      <c:valAx>
        <c:axId val="241376952"/>
        <c:scaling>
          <c:orientation val="minMax"/>
        </c:scaling>
        <c:delete val="0"/>
        <c:axPos val="l"/>
        <c:title>
          <c:tx>
            <c:rich>
              <a:bodyPr rot="-5400000" spcFirstLastPara="1" vertOverflow="ellipsis" vert="horz" wrap="square" anchor="ctr" anchorCtr="1"/>
              <a:lstStyle/>
              <a:p>
                <a:pPr>
                  <a:defRPr sz="800" b="1" i="0" u="none" strike="noStrike" kern="1200" baseline="0">
                    <a:solidFill>
                      <a:schemeClr val="tx1"/>
                    </a:solidFill>
                    <a:latin typeface="+mn-lt"/>
                    <a:ea typeface="+mn-ea"/>
                    <a:cs typeface="+mn-cs"/>
                  </a:defRPr>
                </a:pPr>
                <a:r>
                  <a:rPr lang="en-US" sz="800" b="1" dirty="0" smtClean="0">
                    <a:solidFill>
                      <a:schemeClr val="tx1"/>
                    </a:solidFill>
                  </a:rPr>
                  <a:t>PARE Abundance </a:t>
                </a:r>
                <a:r>
                  <a:rPr lang="en-US" sz="800" b="1" dirty="0">
                    <a:solidFill>
                      <a:schemeClr val="tx1"/>
                    </a:solidFill>
                  </a:rPr>
                  <a:t>(TP10M)</a:t>
                </a:r>
              </a:p>
            </c:rich>
          </c:tx>
          <c:layout/>
          <c:overlay val="0"/>
          <c:spPr>
            <a:noFill/>
            <a:ln>
              <a:noFill/>
            </a:ln>
            <a:effectLst/>
          </c:spPr>
          <c:txPr>
            <a:bodyPr rot="-5400000" spcFirstLastPara="1" vertOverflow="ellipsis" vert="horz" wrap="square" anchor="ctr" anchorCtr="1"/>
            <a:lstStyle/>
            <a:p>
              <a:pPr>
                <a:defRPr sz="800" b="1" i="0" u="none" strike="noStrike" kern="1200" baseline="0">
                  <a:solidFill>
                    <a:schemeClr val="tx1"/>
                  </a:solidFill>
                  <a:latin typeface="+mn-lt"/>
                  <a:ea typeface="+mn-ea"/>
                  <a:cs typeface="+mn-cs"/>
                </a:defRPr>
              </a:pPr>
              <a:endParaRPr lang="en-US"/>
            </a:p>
          </c:txPr>
        </c:title>
        <c:numFmt formatCode="General" sourceLinked="1"/>
        <c:majorTickMark val="out"/>
        <c:minorTickMark val="none"/>
        <c:tickLblPos val="nextTo"/>
        <c:spPr>
          <a:noFill/>
          <a:ln w="6350" cap="flat" cmpd="sng" algn="ctr">
            <a:solidFill>
              <a:schemeClr val="tx1"/>
            </a:solidFill>
            <a:round/>
          </a:ln>
          <a:effectLst/>
        </c:spPr>
        <c:txPr>
          <a:bodyPr rot="-60000000" spcFirstLastPara="1" vertOverflow="ellipsis" vert="horz" wrap="square" anchor="ctr" anchorCtr="1"/>
          <a:lstStyle/>
          <a:p>
            <a:pPr>
              <a:defRPr sz="800" b="0" i="0" u="none" strike="noStrike" kern="1200" baseline="0">
                <a:solidFill>
                  <a:schemeClr val="tx1"/>
                </a:solidFill>
                <a:latin typeface="+mn-lt"/>
                <a:ea typeface="+mn-ea"/>
                <a:cs typeface="+mn-cs"/>
              </a:defRPr>
            </a:pPr>
            <a:endParaRPr lang="en-US"/>
          </a:p>
        </c:txPr>
        <c:crossAx val="424490168"/>
        <c:crosses val="autoZero"/>
        <c:crossBetween val="midCat"/>
      </c:valAx>
      <c:spPr>
        <a:noFill/>
        <a:ln>
          <a:noFill/>
        </a:ln>
        <a:effectLst/>
      </c:spPr>
    </c:plotArea>
    <c:plotVisOnly val="1"/>
    <c:dispBlanksAs val="gap"/>
    <c:showDLblsOverMax val="0"/>
  </c:chart>
  <c:spPr>
    <a:solidFill>
      <a:schemeClr val="bg1"/>
    </a:solidFill>
    <a:ln w="6350" cap="flat" cmpd="sng" algn="ctr">
      <a:solidFill>
        <a:schemeClr val="tx1"/>
      </a:solidFill>
      <a:round/>
    </a:ln>
    <a:effectLst/>
  </c:spPr>
  <c:txPr>
    <a:bodyPr/>
    <a:lstStyle/>
    <a:p>
      <a:pPr>
        <a:defRPr/>
      </a:pPr>
      <a:endParaRPr lang="en-US"/>
    </a:p>
  </c:txPr>
  <c:externalData r:id="rId3">
    <c:autoUpdate val="0"/>
  </c:externalData>
</c:chartSpace>
</file>

<file path=ppt/charts/chart10.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r>
              <a:rPr lang="en-US">
                <a:solidFill>
                  <a:schemeClr val="tx1"/>
                </a:solidFill>
              </a:rPr>
              <a:t>Bdi-miR168</a:t>
            </a:r>
            <a:r>
              <a:rPr lang="en-US" baseline="0">
                <a:solidFill>
                  <a:schemeClr val="tx1"/>
                </a:solidFill>
              </a:rPr>
              <a:t> targeting Bdi-AGO1a</a:t>
            </a:r>
            <a:endParaRPr lang="en-US">
              <a:solidFill>
                <a:schemeClr val="tx1"/>
              </a:solidFill>
            </a:endParaRPr>
          </a:p>
        </c:rich>
      </c:tx>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endParaRPr lang="en-US"/>
        </a:p>
      </c:txPr>
    </c:title>
    <c:autoTitleDeleted val="0"/>
    <c:plotArea>
      <c:layout/>
      <c:scatterChart>
        <c:scatterStyle val="lineMarker"/>
        <c:varyColors val="0"/>
        <c:ser>
          <c:idx val="3"/>
          <c:order val="3"/>
          <c:tx>
            <c:strRef>
              <c:f>AGO1a!$F$1</c:f>
              <c:strCache>
                <c:ptCount val="1"/>
                <c:pt idx="0">
                  <c:v>BDI507cDNA_tplot</c:v>
                </c:pt>
              </c:strCache>
            </c:strRef>
          </c:tx>
          <c:spPr>
            <a:ln w="19050" cap="rnd">
              <a:noFill/>
              <a:round/>
            </a:ln>
            <a:effectLst/>
          </c:spPr>
          <c:marker>
            <c:symbol val="circle"/>
            <c:size val="5"/>
            <c:spPr>
              <a:solidFill>
                <a:schemeClr val="tx1"/>
              </a:solidFill>
              <a:ln w="9525">
                <a:solidFill>
                  <a:schemeClr val="tx1"/>
                </a:solidFill>
              </a:ln>
              <a:effectLst/>
            </c:spPr>
          </c:marker>
          <c:dPt>
            <c:idx val="671"/>
            <c:marker>
              <c:symbol val="circle"/>
              <c:size val="5"/>
              <c:spPr>
                <a:solidFill>
                  <a:srgbClr val="FF0000"/>
                </a:solidFill>
                <a:ln w="9525">
                  <a:solidFill>
                    <a:srgbClr val="FF0000"/>
                  </a:solidFill>
                </a:ln>
                <a:effectLst/>
              </c:spPr>
            </c:marker>
            <c:bubble3D val="0"/>
          </c:dPt>
          <c:xVal>
            <c:numRef>
              <c:f>AGO1a!$B$2:$B$1002</c:f>
              <c:numCache>
                <c:formatCode>General</c:formatCode>
                <c:ptCount val="1001"/>
                <c:pt idx="0">
                  <c:v>3583</c:v>
                </c:pt>
                <c:pt idx="1">
                  <c:v>2443</c:v>
                </c:pt>
                <c:pt idx="2">
                  <c:v>2713</c:v>
                </c:pt>
                <c:pt idx="3">
                  <c:v>3344</c:v>
                </c:pt>
                <c:pt idx="4">
                  <c:v>2251</c:v>
                </c:pt>
                <c:pt idx="5">
                  <c:v>3693</c:v>
                </c:pt>
                <c:pt idx="6">
                  <c:v>1477</c:v>
                </c:pt>
                <c:pt idx="7">
                  <c:v>3872</c:v>
                </c:pt>
                <c:pt idx="8">
                  <c:v>3871</c:v>
                </c:pt>
                <c:pt idx="9">
                  <c:v>3404</c:v>
                </c:pt>
                <c:pt idx="10">
                  <c:v>2409</c:v>
                </c:pt>
                <c:pt idx="11">
                  <c:v>3714</c:v>
                </c:pt>
                <c:pt idx="12">
                  <c:v>1420</c:v>
                </c:pt>
                <c:pt idx="13">
                  <c:v>3967</c:v>
                </c:pt>
                <c:pt idx="14">
                  <c:v>2893</c:v>
                </c:pt>
                <c:pt idx="15">
                  <c:v>3641</c:v>
                </c:pt>
                <c:pt idx="16">
                  <c:v>3271</c:v>
                </c:pt>
                <c:pt idx="17">
                  <c:v>2641</c:v>
                </c:pt>
                <c:pt idx="18">
                  <c:v>3549</c:v>
                </c:pt>
                <c:pt idx="19">
                  <c:v>1941</c:v>
                </c:pt>
                <c:pt idx="20">
                  <c:v>2664</c:v>
                </c:pt>
                <c:pt idx="21">
                  <c:v>3924</c:v>
                </c:pt>
                <c:pt idx="22">
                  <c:v>3707</c:v>
                </c:pt>
                <c:pt idx="23">
                  <c:v>2278</c:v>
                </c:pt>
                <c:pt idx="24">
                  <c:v>3457</c:v>
                </c:pt>
                <c:pt idx="25">
                  <c:v>3546</c:v>
                </c:pt>
                <c:pt idx="26">
                  <c:v>3319</c:v>
                </c:pt>
                <c:pt idx="27">
                  <c:v>2821</c:v>
                </c:pt>
                <c:pt idx="28">
                  <c:v>2403</c:v>
                </c:pt>
                <c:pt idx="29">
                  <c:v>864</c:v>
                </c:pt>
                <c:pt idx="30">
                  <c:v>1729</c:v>
                </c:pt>
                <c:pt idx="31">
                  <c:v>3322</c:v>
                </c:pt>
                <c:pt idx="32">
                  <c:v>3378</c:v>
                </c:pt>
                <c:pt idx="33">
                  <c:v>3633</c:v>
                </c:pt>
                <c:pt idx="34">
                  <c:v>3579</c:v>
                </c:pt>
                <c:pt idx="35">
                  <c:v>2054</c:v>
                </c:pt>
                <c:pt idx="36">
                  <c:v>2164</c:v>
                </c:pt>
                <c:pt idx="37">
                  <c:v>2766</c:v>
                </c:pt>
                <c:pt idx="38">
                  <c:v>3688</c:v>
                </c:pt>
                <c:pt idx="39">
                  <c:v>4050</c:v>
                </c:pt>
                <c:pt idx="40">
                  <c:v>3248</c:v>
                </c:pt>
                <c:pt idx="41">
                  <c:v>2981</c:v>
                </c:pt>
                <c:pt idx="42">
                  <c:v>2548</c:v>
                </c:pt>
                <c:pt idx="43">
                  <c:v>3840</c:v>
                </c:pt>
                <c:pt idx="44">
                  <c:v>3954</c:v>
                </c:pt>
                <c:pt idx="45">
                  <c:v>868</c:v>
                </c:pt>
                <c:pt idx="46">
                  <c:v>3818</c:v>
                </c:pt>
                <c:pt idx="47">
                  <c:v>3735</c:v>
                </c:pt>
                <c:pt idx="48">
                  <c:v>2999</c:v>
                </c:pt>
                <c:pt idx="49">
                  <c:v>3475</c:v>
                </c:pt>
                <c:pt idx="50">
                  <c:v>2720</c:v>
                </c:pt>
                <c:pt idx="51">
                  <c:v>3933</c:v>
                </c:pt>
                <c:pt idx="52">
                  <c:v>3622</c:v>
                </c:pt>
                <c:pt idx="53">
                  <c:v>3934</c:v>
                </c:pt>
                <c:pt idx="54">
                  <c:v>3075</c:v>
                </c:pt>
                <c:pt idx="55">
                  <c:v>2114</c:v>
                </c:pt>
                <c:pt idx="56">
                  <c:v>3931</c:v>
                </c:pt>
                <c:pt idx="57">
                  <c:v>2386</c:v>
                </c:pt>
                <c:pt idx="58">
                  <c:v>3576</c:v>
                </c:pt>
                <c:pt idx="59">
                  <c:v>3674</c:v>
                </c:pt>
                <c:pt idx="60">
                  <c:v>3507</c:v>
                </c:pt>
                <c:pt idx="61">
                  <c:v>3648</c:v>
                </c:pt>
                <c:pt idx="62">
                  <c:v>3848</c:v>
                </c:pt>
                <c:pt idx="63">
                  <c:v>1032</c:v>
                </c:pt>
                <c:pt idx="64">
                  <c:v>3014</c:v>
                </c:pt>
                <c:pt idx="65">
                  <c:v>2057</c:v>
                </c:pt>
                <c:pt idx="66">
                  <c:v>3037</c:v>
                </c:pt>
                <c:pt idx="67">
                  <c:v>3917</c:v>
                </c:pt>
                <c:pt idx="68">
                  <c:v>3022</c:v>
                </c:pt>
                <c:pt idx="69">
                  <c:v>2250</c:v>
                </c:pt>
                <c:pt idx="70">
                  <c:v>4017</c:v>
                </c:pt>
                <c:pt idx="71">
                  <c:v>4006</c:v>
                </c:pt>
                <c:pt idx="72">
                  <c:v>2552</c:v>
                </c:pt>
                <c:pt idx="73">
                  <c:v>3906</c:v>
                </c:pt>
                <c:pt idx="74">
                  <c:v>2212</c:v>
                </c:pt>
                <c:pt idx="75">
                  <c:v>4023</c:v>
                </c:pt>
                <c:pt idx="76">
                  <c:v>2656</c:v>
                </c:pt>
                <c:pt idx="77">
                  <c:v>3199</c:v>
                </c:pt>
                <c:pt idx="78">
                  <c:v>2774</c:v>
                </c:pt>
                <c:pt idx="79">
                  <c:v>3592</c:v>
                </c:pt>
                <c:pt idx="80">
                  <c:v>2938</c:v>
                </c:pt>
                <c:pt idx="81">
                  <c:v>2330</c:v>
                </c:pt>
                <c:pt idx="82">
                  <c:v>1395</c:v>
                </c:pt>
                <c:pt idx="83">
                  <c:v>2375</c:v>
                </c:pt>
                <c:pt idx="84">
                  <c:v>3621</c:v>
                </c:pt>
                <c:pt idx="85">
                  <c:v>3398</c:v>
                </c:pt>
                <c:pt idx="86">
                  <c:v>3333</c:v>
                </c:pt>
                <c:pt idx="87">
                  <c:v>3461</c:v>
                </c:pt>
                <c:pt idx="88">
                  <c:v>3150</c:v>
                </c:pt>
                <c:pt idx="89">
                  <c:v>3032</c:v>
                </c:pt>
                <c:pt idx="90">
                  <c:v>1185</c:v>
                </c:pt>
                <c:pt idx="91">
                  <c:v>3625</c:v>
                </c:pt>
                <c:pt idx="92">
                  <c:v>2949</c:v>
                </c:pt>
                <c:pt idx="93">
                  <c:v>3888</c:v>
                </c:pt>
                <c:pt idx="94">
                  <c:v>2945</c:v>
                </c:pt>
                <c:pt idx="95">
                  <c:v>4029</c:v>
                </c:pt>
                <c:pt idx="96">
                  <c:v>2906</c:v>
                </c:pt>
                <c:pt idx="97">
                  <c:v>3158</c:v>
                </c:pt>
                <c:pt idx="98">
                  <c:v>2327</c:v>
                </c:pt>
                <c:pt idx="99">
                  <c:v>1654</c:v>
                </c:pt>
                <c:pt idx="100">
                  <c:v>3105</c:v>
                </c:pt>
                <c:pt idx="101">
                  <c:v>3309</c:v>
                </c:pt>
                <c:pt idx="102">
                  <c:v>1422</c:v>
                </c:pt>
                <c:pt idx="103">
                  <c:v>1826</c:v>
                </c:pt>
                <c:pt idx="104">
                  <c:v>2901</c:v>
                </c:pt>
                <c:pt idx="105">
                  <c:v>3732</c:v>
                </c:pt>
                <c:pt idx="106">
                  <c:v>1930</c:v>
                </c:pt>
                <c:pt idx="107">
                  <c:v>3300</c:v>
                </c:pt>
                <c:pt idx="108">
                  <c:v>1444</c:v>
                </c:pt>
                <c:pt idx="109">
                  <c:v>1914</c:v>
                </c:pt>
                <c:pt idx="110">
                  <c:v>1805</c:v>
                </c:pt>
                <c:pt idx="111">
                  <c:v>1598</c:v>
                </c:pt>
                <c:pt idx="112">
                  <c:v>2016</c:v>
                </c:pt>
                <c:pt idx="113">
                  <c:v>2500</c:v>
                </c:pt>
                <c:pt idx="114">
                  <c:v>3569</c:v>
                </c:pt>
                <c:pt idx="115">
                  <c:v>3005</c:v>
                </c:pt>
                <c:pt idx="116">
                  <c:v>3405</c:v>
                </c:pt>
                <c:pt idx="117">
                  <c:v>1966</c:v>
                </c:pt>
                <c:pt idx="118">
                  <c:v>1820</c:v>
                </c:pt>
                <c:pt idx="119">
                  <c:v>2137</c:v>
                </c:pt>
                <c:pt idx="120">
                  <c:v>3388</c:v>
                </c:pt>
                <c:pt idx="121">
                  <c:v>1040</c:v>
                </c:pt>
                <c:pt idx="122">
                  <c:v>3997</c:v>
                </c:pt>
                <c:pt idx="123">
                  <c:v>1666</c:v>
                </c:pt>
                <c:pt idx="124">
                  <c:v>1973</c:v>
                </c:pt>
                <c:pt idx="125">
                  <c:v>3317</c:v>
                </c:pt>
                <c:pt idx="126">
                  <c:v>2787</c:v>
                </c:pt>
                <c:pt idx="127">
                  <c:v>2692</c:v>
                </c:pt>
                <c:pt idx="128">
                  <c:v>3096</c:v>
                </c:pt>
                <c:pt idx="129">
                  <c:v>3273</c:v>
                </c:pt>
                <c:pt idx="130">
                  <c:v>2382</c:v>
                </c:pt>
                <c:pt idx="131">
                  <c:v>3899</c:v>
                </c:pt>
                <c:pt idx="132">
                  <c:v>4022</c:v>
                </c:pt>
                <c:pt idx="133">
                  <c:v>2071</c:v>
                </c:pt>
                <c:pt idx="134">
                  <c:v>2063</c:v>
                </c:pt>
                <c:pt idx="135">
                  <c:v>2136</c:v>
                </c:pt>
                <c:pt idx="136">
                  <c:v>2964</c:v>
                </c:pt>
                <c:pt idx="137">
                  <c:v>2159</c:v>
                </c:pt>
                <c:pt idx="138">
                  <c:v>1886</c:v>
                </c:pt>
                <c:pt idx="139">
                  <c:v>3116</c:v>
                </c:pt>
                <c:pt idx="140">
                  <c:v>3291</c:v>
                </c:pt>
                <c:pt idx="141">
                  <c:v>2693</c:v>
                </c:pt>
                <c:pt idx="142">
                  <c:v>4012</c:v>
                </c:pt>
                <c:pt idx="143">
                  <c:v>3027</c:v>
                </c:pt>
                <c:pt idx="144">
                  <c:v>2450</c:v>
                </c:pt>
                <c:pt idx="145">
                  <c:v>3460</c:v>
                </c:pt>
                <c:pt idx="146">
                  <c:v>3940</c:v>
                </c:pt>
                <c:pt idx="147">
                  <c:v>2880</c:v>
                </c:pt>
                <c:pt idx="148">
                  <c:v>2770</c:v>
                </c:pt>
                <c:pt idx="149">
                  <c:v>3151</c:v>
                </c:pt>
                <c:pt idx="150">
                  <c:v>3698</c:v>
                </c:pt>
                <c:pt idx="151">
                  <c:v>3652</c:v>
                </c:pt>
                <c:pt idx="152">
                  <c:v>3220</c:v>
                </c:pt>
                <c:pt idx="153">
                  <c:v>3126</c:v>
                </c:pt>
                <c:pt idx="154">
                  <c:v>3443</c:v>
                </c:pt>
                <c:pt idx="155">
                  <c:v>3964</c:v>
                </c:pt>
                <c:pt idx="156">
                  <c:v>3582</c:v>
                </c:pt>
                <c:pt idx="157">
                  <c:v>2408</c:v>
                </c:pt>
                <c:pt idx="158">
                  <c:v>3295</c:v>
                </c:pt>
                <c:pt idx="159">
                  <c:v>3224</c:v>
                </c:pt>
                <c:pt idx="160">
                  <c:v>3025</c:v>
                </c:pt>
                <c:pt idx="161">
                  <c:v>3667</c:v>
                </c:pt>
                <c:pt idx="162">
                  <c:v>2368</c:v>
                </c:pt>
                <c:pt idx="163">
                  <c:v>2848</c:v>
                </c:pt>
                <c:pt idx="164">
                  <c:v>2206</c:v>
                </c:pt>
                <c:pt idx="165">
                  <c:v>3645</c:v>
                </c:pt>
                <c:pt idx="166">
                  <c:v>3523</c:v>
                </c:pt>
                <c:pt idx="167">
                  <c:v>2717</c:v>
                </c:pt>
                <c:pt idx="168">
                  <c:v>2166</c:v>
                </c:pt>
                <c:pt idx="169">
                  <c:v>2198</c:v>
                </c:pt>
                <c:pt idx="170">
                  <c:v>2445</c:v>
                </c:pt>
                <c:pt idx="171">
                  <c:v>3969</c:v>
                </c:pt>
                <c:pt idx="172">
                  <c:v>2710</c:v>
                </c:pt>
                <c:pt idx="173">
                  <c:v>1912</c:v>
                </c:pt>
                <c:pt idx="174">
                  <c:v>3929</c:v>
                </c:pt>
                <c:pt idx="175">
                  <c:v>3820</c:v>
                </c:pt>
                <c:pt idx="176">
                  <c:v>2296</c:v>
                </c:pt>
                <c:pt idx="177">
                  <c:v>3038</c:v>
                </c:pt>
                <c:pt idx="178">
                  <c:v>1933</c:v>
                </c:pt>
                <c:pt idx="179">
                  <c:v>2730</c:v>
                </c:pt>
                <c:pt idx="180">
                  <c:v>3996</c:v>
                </c:pt>
                <c:pt idx="181">
                  <c:v>2061</c:v>
                </c:pt>
                <c:pt idx="182">
                  <c:v>3922</c:v>
                </c:pt>
                <c:pt idx="183">
                  <c:v>2181</c:v>
                </c:pt>
                <c:pt idx="184">
                  <c:v>3341</c:v>
                </c:pt>
                <c:pt idx="185">
                  <c:v>2667</c:v>
                </c:pt>
                <c:pt idx="186">
                  <c:v>2923</c:v>
                </c:pt>
                <c:pt idx="187">
                  <c:v>3528</c:v>
                </c:pt>
                <c:pt idx="188">
                  <c:v>3524</c:v>
                </c:pt>
                <c:pt idx="189">
                  <c:v>2668</c:v>
                </c:pt>
                <c:pt idx="190">
                  <c:v>3948</c:v>
                </c:pt>
                <c:pt idx="191">
                  <c:v>3831</c:v>
                </c:pt>
                <c:pt idx="192">
                  <c:v>2669</c:v>
                </c:pt>
                <c:pt idx="193">
                  <c:v>3743</c:v>
                </c:pt>
                <c:pt idx="194">
                  <c:v>841</c:v>
                </c:pt>
                <c:pt idx="195">
                  <c:v>3897</c:v>
                </c:pt>
                <c:pt idx="196">
                  <c:v>2496</c:v>
                </c:pt>
                <c:pt idx="197">
                  <c:v>2392</c:v>
                </c:pt>
                <c:pt idx="198">
                  <c:v>3383</c:v>
                </c:pt>
                <c:pt idx="199">
                  <c:v>3919</c:v>
                </c:pt>
                <c:pt idx="200">
                  <c:v>3459</c:v>
                </c:pt>
                <c:pt idx="201">
                  <c:v>3385</c:v>
                </c:pt>
                <c:pt idx="202">
                  <c:v>4005</c:v>
                </c:pt>
                <c:pt idx="203">
                  <c:v>4009</c:v>
                </c:pt>
                <c:pt idx="204">
                  <c:v>3803</c:v>
                </c:pt>
                <c:pt idx="205">
                  <c:v>2100</c:v>
                </c:pt>
                <c:pt idx="206">
                  <c:v>2933</c:v>
                </c:pt>
                <c:pt idx="207">
                  <c:v>1954</c:v>
                </c:pt>
                <c:pt idx="208">
                  <c:v>2715</c:v>
                </c:pt>
                <c:pt idx="209">
                  <c:v>2423</c:v>
                </c:pt>
                <c:pt idx="210">
                  <c:v>3377</c:v>
                </c:pt>
                <c:pt idx="211">
                  <c:v>3262</c:v>
                </c:pt>
                <c:pt idx="212">
                  <c:v>2030</c:v>
                </c:pt>
                <c:pt idx="213">
                  <c:v>2847</c:v>
                </c:pt>
                <c:pt idx="214">
                  <c:v>4039</c:v>
                </c:pt>
                <c:pt idx="215">
                  <c:v>2055</c:v>
                </c:pt>
                <c:pt idx="216">
                  <c:v>1679</c:v>
                </c:pt>
                <c:pt idx="217">
                  <c:v>1981</c:v>
                </c:pt>
                <c:pt idx="218">
                  <c:v>2396</c:v>
                </c:pt>
                <c:pt idx="219">
                  <c:v>4082</c:v>
                </c:pt>
                <c:pt idx="220">
                  <c:v>3316</c:v>
                </c:pt>
                <c:pt idx="221">
                  <c:v>1181</c:v>
                </c:pt>
                <c:pt idx="222">
                  <c:v>3673</c:v>
                </c:pt>
                <c:pt idx="223">
                  <c:v>1794</c:v>
                </c:pt>
                <c:pt idx="224">
                  <c:v>3294</c:v>
                </c:pt>
                <c:pt idx="225">
                  <c:v>2975</c:v>
                </c:pt>
                <c:pt idx="226">
                  <c:v>3580</c:v>
                </c:pt>
                <c:pt idx="227">
                  <c:v>3876</c:v>
                </c:pt>
                <c:pt idx="228">
                  <c:v>3318</c:v>
                </c:pt>
                <c:pt idx="229">
                  <c:v>2984</c:v>
                </c:pt>
                <c:pt idx="230">
                  <c:v>3189</c:v>
                </c:pt>
                <c:pt idx="231">
                  <c:v>2967</c:v>
                </c:pt>
                <c:pt idx="232">
                  <c:v>3028</c:v>
                </c:pt>
                <c:pt idx="233">
                  <c:v>3169</c:v>
                </c:pt>
                <c:pt idx="234">
                  <c:v>3288</c:v>
                </c:pt>
                <c:pt idx="235">
                  <c:v>3686</c:v>
                </c:pt>
                <c:pt idx="236">
                  <c:v>3841</c:v>
                </c:pt>
                <c:pt idx="237">
                  <c:v>3469</c:v>
                </c:pt>
                <c:pt idx="238">
                  <c:v>2988</c:v>
                </c:pt>
                <c:pt idx="239">
                  <c:v>3976</c:v>
                </c:pt>
                <c:pt idx="240">
                  <c:v>3509</c:v>
                </c:pt>
                <c:pt idx="241">
                  <c:v>2171</c:v>
                </c:pt>
                <c:pt idx="242">
                  <c:v>893</c:v>
                </c:pt>
                <c:pt idx="243">
                  <c:v>2589</c:v>
                </c:pt>
                <c:pt idx="244">
                  <c:v>2490</c:v>
                </c:pt>
                <c:pt idx="245">
                  <c:v>2291</c:v>
                </c:pt>
                <c:pt idx="246">
                  <c:v>2357</c:v>
                </c:pt>
                <c:pt idx="247">
                  <c:v>3654</c:v>
                </c:pt>
                <c:pt idx="248">
                  <c:v>3856</c:v>
                </c:pt>
                <c:pt idx="249">
                  <c:v>1221</c:v>
                </c:pt>
                <c:pt idx="250">
                  <c:v>856</c:v>
                </c:pt>
                <c:pt idx="251">
                  <c:v>3373</c:v>
                </c:pt>
                <c:pt idx="252">
                  <c:v>3290</c:v>
                </c:pt>
                <c:pt idx="253">
                  <c:v>3266</c:v>
                </c:pt>
                <c:pt idx="254">
                  <c:v>3026</c:v>
                </c:pt>
                <c:pt idx="255">
                  <c:v>2126</c:v>
                </c:pt>
                <c:pt idx="256">
                  <c:v>2588</c:v>
                </c:pt>
                <c:pt idx="257">
                  <c:v>2233</c:v>
                </c:pt>
                <c:pt idx="258">
                  <c:v>2796</c:v>
                </c:pt>
                <c:pt idx="259">
                  <c:v>3823</c:v>
                </c:pt>
                <c:pt idx="260">
                  <c:v>1883</c:v>
                </c:pt>
                <c:pt idx="261">
                  <c:v>1711</c:v>
                </c:pt>
                <c:pt idx="262">
                  <c:v>2090</c:v>
                </c:pt>
                <c:pt idx="263">
                  <c:v>2900</c:v>
                </c:pt>
                <c:pt idx="264">
                  <c:v>3024</c:v>
                </c:pt>
                <c:pt idx="265">
                  <c:v>3501</c:v>
                </c:pt>
                <c:pt idx="266">
                  <c:v>2987</c:v>
                </c:pt>
                <c:pt idx="267">
                  <c:v>2491</c:v>
                </c:pt>
                <c:pt idx="268">
                  <c:v>3541</c:v>
                </c:pt>
                <c:pt idx="269">
                  <c:v>3700</c:v>
                </c:pt>
                <c:pt idx="270">
                  <c:v>2778</c:v>
                </c:pt>
                <c:pt idx="271">
                  <c:v>4030</c:v>
                </c:pt>
                <c:pt idx="272">
                  <c:v>3215</c:v>
                </c:pt>
                <c:pt idx="273">
                  <c:v>475</c:v>
                </c:pt>
                <c:pt idx="274">
                  <c:v>2034</c:v>
                </c:pt>
                <c:pt idx="275">
                  <c:v>3734</c:v>
                </c:pt>
                <c:pt idx="276">
                  <c:v>1953</c:v>
                </c:pt>
                <c:pt idx="277">
                  <c:v>2146</c:v>
                </c:pt>
                <c:pt idx="278">
                  <c:v>2991</c:v>
                </c:pt>
                <c:pt idx="279">
                  <c:v>1273</c:v>
                </c:pt>
                <c:pt idx="280">
                  <c:v>3255</c:v>
                </c:pt>
                <c:pt idx="281">
                  <c:v>1923</c:v>
                </c:pt>
                <c:pt idx="282">
                  <c:v>2026</c:v>
                </c:pt>
                <c:pt idx="283">
                  <c:v>2935</c:v>
                </c:pt>
                <c:pt idx="284">
                  <c:v>1053</c:v>
                </c:pt>
                <c:pt idx="285">
                  <c:v>873</c:v>
                </c:pt>
                <c:pt idx="286">
                  <c:v>2134</c:v>
                </c:pt>
                <c:pt idx="287">
                  <c:v>2600</c:v>
                </c:pt>
                <c:pt idx="288">
                  <c:v>3257</c:v>
                </c:pt>
                <c:pt idx="289">
                  <c:v>3081</c:v>
                </c:pt>
                <c:pt idx="290">
                  <c:v>3334</c:v>
                </c:pt>
                <c:pt idx="291">
                  <c:v>3209</c:v>
                </c:pt>
                <c:pt idx="292">
                  <c:v>1525</c:v>
                </c:pt>
                <c:pt idx="293">
                  <c:v>3240</c:v>
                </c:pt>
                <c:pt idx="294">
                  <c:v>3259</c:v>
                </c:pt>
                <c:pt idx="295">
                  <c:v>3561</c:v>
                </c:pt>
                <c:pt idx="296">
                  <c:v>2201</c:v>
                </c:pt>
                <c:pt idx="297">
                  <c:v>2093</c:v>
                </c:pt>
                <c:pt idx="298">
                  <c:v>3855</c:v>
                </c:pt>
                <c:pt idx="299">
                  <c:v>3999</c:v>
                </c:pt>
                <c:pt idx="300">
                  <c:v>3731</c:v>
                </c:pt>
                <c:pt idx="301">
                  <c:v>851</c:v>
                </c:pt>
                <c:pt idx="302">
                  <c:v>2946</c:v>
                </c:pt>
                <c:pt idx="303">
                  <c:v>3536</c:v>
                </c:pt>
                <c:pt idx="304">
                  <c:v>2622</c:v>
                </c:pt>
                <c:pt idx="305">
                  <c:v>2882</c:v>
                </c:pt>
                <c:pt idx="306">
                  <c:v>3036</c:v>
                </c:pt>
                <c:pt idx="307">
                  <c:v>3441</c:v>
                </c:pt>
                <c:pt idx="308">
                  <c:v>2878</c:v>
                </c:pt>
                <c:pt idx="309">
                  <c:v>2776</c:v>
                </c:pt>
                <c:pt idx="310">
                  <c:v>2845</c:v>
                </c:pt>
                <c:pt idx="311">
                  <c:v>3882</c:v>
                </c:pt>
                <c:pt idx="312">
                  <c:v>3644</c:v>
                </c:pt>
                <c:pt idx="313">
                  <c:v>3620</c:v>
                </c:pt>
                <c:pt idx="314">
                  <c:v>2804</c:v>
                </c:pt>
                <c:pt idx="315">
                  <c:v>2258</c:v>
                </c:pt>
                <c:pt idx="316">
                  <c:v>3296</c:v>
                </c:pt>
                <c:pt idx="317">
                  <c:v>3826</c:v>
                </c:pt>
                <c:pt idx="318">
                  <c:v>3854</c:v>
                </c:pt>
                <c:pt idx="319">
                  <c:v>3284</c:v>
                </c:pt>
                <c:pt idx="320">
                  <c:v>3651</c:v>
                </c:pt>
                <c:pt idx="321">
                  <c:v>3601</c:v>
                </c:pt>
                <c:pt idx="322">
                  <c:v>3558</c:v>
                </c:pt>
                <c:pt idx="323">
                  <c:v>3510</c:v>
                </c:pt>
                <c:pt idx="324">
                  <c:v>1423</c:v>
                </c:pt>
                <c:pt idx="325">
                  <c:v>3513</c:v>
                </c:pt>
                <c:pt idx="326">
                  <c:v>3467</c:v>
                </c:pt>
                <c:pt idx="327">
                  <c:v>2390</c:v>
                </c:pt>
                <c:pt idx="328">
                  <c:v>2739</c:v>
                </c:pt>
                <c:pt idx="329">
                  <c:v>3752</c:v>
                </c:pt>
                <c:pt idx="330">
                  <c:v>3339</c:v>
                </c:pt>
                <c:pt idx="331">
                  <c:v>3627</c:v>
                </c:pt>
                <c:pt idx="332">
                  <c:v>3704</c:v>
                </c:pt>
                <c:pt idx="333">
                  <c:v>2228</c:v>
                </c:pt>
                <c:pt idx="334">
                  <c:v>2758</c:v>
                </c:pt>
                <c:pt idx="335">
                  <c:v>3588</c:v>
                </c:pt>
                <c:pt idx="336">
                  <c:v>2777</c:v>
                </c:pt>
                <c:pt idx="337">
                  <c:v>2920</c:v>
                </c:pt>
                <c:pt idx="338">
                  <c:v>940</c:v>
                </c:pt>
                <c:pt idx="339">
                  <c:v>2966</c:v>
                </c:pt>
                <c:pt idx="340">
                  <c:v>3659</c:v>
                </c:pt>
                <c:pt idx="341">
                  <c:v>1242</c:v>
                </c:pt>
                <c:pt idx="342">
                  <c:v>1919</c:v>
                </c:pt>
                <c:pt idx="343">
                  <c:v>1240</c:v>
                </c:pt>
                <c:pt idx="344">
                  <c:v>3637</c:v>
                </c:pt>
                <c:pt idx="345">
                  <c:v>3279</c:v>
                </c:pt>
                <c:pt idx="346">
                  <c:v>3382</c:v>
                </c:pt>
                <c:pt idx="347">
                  <c:v>2128</c:v>
                </c:pt>
                <c:pt idx="348">
                  <c:v>3758</c:v>
                </c:pt>
                <c:pt idx="349">
                  <c:v>3338</c:v>
                </c:pt>
                <c:pt idx="350">
                  <c:v>2982</c:v>
                </c:pt>
                <c:pt idx="351">
                  <c:v>2226</c:v>
                </c:pt>
                <c:pt idx="352">
                  <c:v>1938</c:v>
                </c:pt>
                <c:pt idx="353">
                  <c:v>3160</c:v>
                </c:pt>
                <c:pt idx="354">
                  <c:v>3572</c:v>
                </c:pt>
                <c:pt idx="355">
                  <c:v>1184</c:v>
                </c:pt>
                <c:pt idx="356">
                  <c:v>3879</c:v>
                </c:pt>
                <c:pt idx="357">
                  <c:v>3298</c:v>
                </c:pt>
                <c:pt idx="358">
                  <c:v>3221</c:v>
                </c:pt>
                <c:pt idx="359">
                  <c:v>3935</c:v>
                </c:pt>
                <c:pt idx="360">
                  <c:v>2351</c:v>
                </c:pt>
                <c:pt idx="361">
                  <c:v>3352</c:v>
                </c:pt>
                <c:pt idx="362">
                  <c:v>3260</c:v>
                </c:pt>
                <c:pt idx="363">
                  <c:v>3358</c:v>
                </c:pt>
                <c:pt idx="364">
                  <c:v>3957</c:v>
                </c:pt>
                <c:pt idx="365">
                  <c:v>3349</c:v>
                </c:pt>
                <c:pt idx="366">
                  <c:v>712</c:v>
                </c:pt>
                <c:pt idx="367">
                  <c:v>2587</c:v>
                </c:pt>
                <c:pt idx="368">
                  <c:v>2807</c:v>
                </c:pt>
                <c:pt idx="369">
                  <c:v>1775</c:v>
                </c:pt>
                <c:pt idx="370">
                  <c:v>3107</c:v>
                </c:pt>
                <c:pt idx="371">
                  <c:v>2394</c:v>
                </c:pt>
                <c:pt idx="372">
                  <c:v>1189</c:v>
                </c:pt>
                <c:pt idx="373">
                  <c:v>3636</c:v>
                </c:pt>
                <c:pt idx="374">
                  <c:v>1114</c:v>
                </c:pt>
                <c:pt idx="375">
                  <c:v>3936</c:v>
                </c:pt>
                <c:pt idx="376">
                  <c:v>2273</c:v>
                </c:pt>
                <c:pt idx="377">
                  <c:v>379</c:v>
                </c:pt>
                <c:pt idx="378">
                  <c:v>2453</c:v>
                </c:pt>
                <c:pt idx="379">
                  <c:v>2921</c:v>
                </c:pt>
                <c:pt idx="380">
                  <c:v>3710</c:v>
                </c:pt>
                <c:pt idx="381">
                  <c:v>3990</c:v>
                </c:pt>
                <c:pt idx="382">
                  <c:v>3730</c:v>
                </c:pt>
                <c:pt idx="383">
                  <c:v>2004</c:v>
                </c:pt>
                <c:pt idx="384">
                  <c:v>3242</c:v>
                </c:pt>
                <c:pt idx="385">
                  <c:v>2653</c:v>
                </c:pt>
                <c:pt idx="386">
                  <c:v>2943</c:v>
                </c:pt>
                <c:pt idx="387">
                  <c:v>2698</c:v>
                </c:pt>
                <c:pt idx="388">
                  <c:v>2044</c:v>
                </c:pt>
                <c:pt idx="389">
                  <c:v>3329</c:v>
                </c:pt>
                <c:pt idx="390">
                  <c:v>2125</c:v>
                </c:pt>
                <c:pt idx="391">
                  <c:v>3678</c:v>
                </c:pt>
                <c:pt idx="392">
                  <c:v>2046</c:v>
                </c:pt>
                <c:pt idx="393">
                  <c:v>2841</c:v>
                </c:pt>
                <c:pt idx="394">
                  <c:v>3543</c:v>
                </c:pt>
                <c:pt idx="395">
                  <c:v>3965</c:v>
                </c:pt>
                <c:pt idx="396">
                  <c:v>3845</c:v>
                </c:pt>
                <c:pt idx="397">
                  <c:v>2091</c:v>
                </c:pt>
                <c:pt idx="398">
                  <c:v>3062</c:v>
                </c:pt>
                <c:pt idx="399">
                  <c:v>2775</c:v>
                </c:pt>
                <c:pt idx="400">
                  <c:v>2387</c:v>
                </c:pt>
                <c:pt idx="401">
                  <c:v>3529</c:v>
                </c:pt>
                <c:pt idx="402">
                  <c:v>1461</c:v>
                </c:pt>
                <c:pt idx="403">
                  <c:v>3083</c:v>
                </c:pt>
                <c:pt idx="404">
                  <c:v>1034</c:v>
                </c:pt>
                <c:pt idx="405">
                  <c:v>4020</c:v>
                </c:pt>
                <c:pt idx="406">
                  <c:v>3918</c:v>
                </c:pt>
                <c:pt idx="407">
                  <c:v>4081</c:v>
                </c:pt>
                <c:pt idx="408">
                  <c:v>3011</c:v>
                </c:pt>
                <c:pt idx="409">
                  <c:v>3729</c:v>
                </c:pt>
                <c:pt idx="410">
                  <c:v>3335</c:v>
                </c:pt>
                <c:pt idx="411">
                  <c:v>1974</c:v>
                </c:pt>
                <c:pt idx="412">
                  <c:v>2421</c:v>
                </c:pt>
                <c:pt idx="413">
                  <c:v>3895</c:v>
                </c:pt>
                <c:pt idx="414">
                  <c:v>3609</c:v>
                </c:pt>
                <c:pt idx="415">
                  <c:v>3476</c:v>
                </c:pt>
                <c:pt idx="416">
                  <c:v>3306</c:v>
                </c:pt>
                <c:pt idx="417">
                  <c:v>3076</c:v>
                </c:pt>
                <c:pt idx="418">
                  <c:v>3614</c:v>
                </c:pt>
                <c:pt idx="419">
                  <c:v>3682</c:v>
                </c:pt>
                <c:pt idx="420">
                  <c:v>3098</c:v>
                </c:pt>
                <c:pt idx="421">
                  <c:v>2499</c:v>
                </c:pt>
                <c:pt idx="422">
                  <c:v>3920</c:v>
                </c:pt>
                <c:pt idx="423">
                  <c:v>3932</c:v>
                </c:pt>
                <c:pt idx="424">
                  <c:v>3386</c:v>
                </c:pt>
                <c:pt idx="425">
                  <c:v>3231</c:v>
                </c:pt>
                <c:pt idx="426">
                  <c:v>3253</c:v>
                </c:pt>
                <c:pt idx="427">
                  <c:v>3736</c:v>
                </c:pt>
                <c:pt idx="428">
                  <c:v>655</c:v>
                </c:pt>
                <c:pt idx="429">
                  <c:v>2661</c:v>
                </c:pt>
                <c:pt idx="430">
                  <c:v>3227</c:v>
                </c:pt>
                <c:pt idx="431">
                  <c:v>3336</c:v>
                </c:pt>
                <c:pt idx="432">
                  <c:v>3033</c:v>
                </c:pt>
                <c:pt idx="433">
                  <c:v>3201</c:v>
                </c:pt>
                <c:pt idx="434">
                  <c:v>2087</c:v>
                </c:pt>
                <c:pt idx="435">
                  <c:v>3159</c:v>
                </c:pt>
                <c:pt idx="436">
                  <c:v>2202</c:v>
                </c:pt>
                <c:pt idx="437">
                  <c:v>3635</c:v>
                </c:pt>
                <c:pt idx="438">
                  <c:v>2980</c:v>
                </c:pt>
                <c:pt idx="439">
                  <c:v>3522</c:v>
                </c:pt>
                <c:pt idx="440">
                  <c:v>3672</c:v>
                </c:pt>
                <c:pt idx="441">
                  <c:v>3007</c:v>
                </c:pt>
                <c:pt idx="442">
                  <c:v>3914</c:v>
                </c:pt>
                <c:pt idx="443">
                  <c:v>3534</c:v>
                </c:pt>
                <c:pt idx="444">
                  <c:v>3887</c:v>
                </c:pt>
                <c:pt idx="445">
                  <c:v>580</c:v>
                </c:pt>
                <c:pt idx="446">
                  <c:v>1556</c:v>
                </c:pt>
                <c:pt idx="447">
                  <c:v>1680</c:v>
                </c:pt>
                <c:pt idx="448">
                  <c:v>1590</c:v>
                </c:pt>
                <c:pt idx="449">
                  <c:v>3822</c:v>
                </c:pt>
                <c:pt idx="450">
                  <c:v>3245</c:v>
                </c:pt>
                <c:pt idx="451">
                  <c:v>3719</c:v>
                </c:pt>
                <c:pt idx="452">
                  <c:v>2731</c:v>
                </c:pt>
                <c:pt idx="453">
                  <c:v>2963</c:v>
                </c:pt>
                <c:pt idx="454">
                  <c:v>3685</c:v>
                </c:pt>
                <c:pt idx="455">
                  <c:v>3712</c:v>
                </c:pt>
                <c:pt idx="456">
                  <c:v>3571</c:v>
                </c:pt>
                <c:pt idx="457">
                  <c:v>1950</c:v>
                </c:pt>
                <c:pt idx="458">
                  <c:v>2603</c:v>
                </c:pt>
                <c:pt idx="459">
                  <c:v>2135</c:v>
                </c:pt>
                <c:pt idx="460">
                  <c:v>2506</c:v>
                </c:pt>
                <c:pt idx="461">
                  <c:v>3653</c:v>
                </c:pt>
                <c:pt idx="462">
                  <c:v>1557</c:v>
                </c:pt>
                <c:pt idx="463">
                  <c:v>2204</c:v>
                </c:pt>
                <c:pt idx="464">
                  <c:v>3068</c:v>
                </c:pt>
                <c:pt idx="465">
                  <c:v>1997</c:v>
                </c:pt>
                <c:pt idx="466">
                  <c:v>3134</c:v>
                </c:pt>
                <c:pt idx="467">
                  <c:v>2519</c:v>
                </c:pt>
                <c:pt idx="468">
                  <c:v>3031</c:v>
                </c:pt>
                <c:pt idx="469">
                  <c:v>2086</c:v>
                </c:pt>
                <c:pt idx="470">
                  <c:v>3225</c:v>
                </c:pt>
                <c:pt idx="471">
                  <c:v>1771</c:v>
                </c:pt>
                <c:pt idx="472">
                  <c:v>3725</c:v>
                </c:pt>
                <c:pt idx="473">
                  <c:v>3285</c:v>
                </c:pt>
                <c:pt idx="474">
                  <c:v>3418</c:v>
                </c:pt>
                <c:pt idx="475">
                  <c:v>3477</c:v>
                </c:pt>
                <c:pt idx="476">
                  <c:v>511</c:v>
                </c:pt>
                <c:pt idx="477">
                  <c:v>2255</c:v>
                </c:pt>
                <c:pt idx="478">
                  <c:v>3617</c:v>
                </c:pt>
                <c:pt idx="479">
                  <c:v>2383</c:v>
                </c:pt>
                <c:pt idx="480">
                  <c:v>3793</c:v>
                </c:pt>
                <c:pt idx="481">
                  <c:v>1555</c:v>
                </c:pt>
                <c:pt idx="482">
                  <c:v>3975</c:v>
                </c:pt>
                <c:pt idx="483">
                  <c:v>3679</c:v>
                </c:pt>
                <c:pt idx="484">
                  <c:v>3837</c:v>
                </c:pt>
                <c:pt idx="485">
                  <c:v>2822</c:v>
                </c:pt>
                <c:pt idx="486">
                  <c:v>1945</c:v>
                </c:pt>
                <c:pt idx="487">
                  <c:v>3853</c:v>
                </c:pt>
                <c:pt idx="488">
                  <c:v>3910</c:v>
                </c:pt>
                <c:pt idx="489">
                  <c:v>2737</c:v>
                </c:pt>
                <c:pt idx="490">
                  <c:v>2274</c:v>
                </c:pt>
                <c:pt idx="491">
                  <c:v>2986</c:v>
                </c:pt>
                <c:pt idx="492">
                  <c:v>2083</c:v>
                </c:pt>
                <c:pt idx="493">
                  <c:v>3978</c:v>
                </c:pt>
                <c:pt idx="494">
                  <c:v>3030</c:v>
                </c:pt>
                <c:pt idx="495">
                  <c:v>3921</c:v>
                </c:pt>
                <c:pt idx="496">
                  <c:v>2501</c:v>
                </c:pt>
                <c:pt idx="497">
                  <c:v>2048</c:v>
                </c:pt>
                <c:pt idx="498">
                  <c:v>2068</c:v>
                </c:pt>
                <c:pt idx="499">
                  <c:v>2953</c:v>
                </c:pt>
                <c:pt idx="500">
                  <c:v>2520</c:v>
                </c:pt>
                <c:pt idx="501">
                  <c:v>3661</c:v>
                </c:pt>
                <c:pt idx="502">
                  <c:v>3239</c:v>
                </c:pt>
                <c:pt idx="503">
                  <c:v>3353</c:v>
                </c:pt>
                <c:pt idx="504">
                  <c:v>3185</c:v>
                </c:pt>
                <c:pt idx="505">
                  <c:v>3535</c:v>
                </c:pt>
                <c:pt idx="506">
                  <c:v>3733</c:v>
                </c:pt>
                <c:pt idx="507">
                  <c:v>3186</c:v>
                </c:pt>
                <c:pt idx="508">
                  <c:v>3351</c:v>
                </c:pt>
                <c:pt idx="509">
                  <c:v>1929</c:v>
                </c:pt>
                <c:pt idx="510">
                  <c:v>3656</c:v>
                </c:pt>
                <c:pt idx="511">
                  <c:v>3657</c:v>
                </c:pt>
                <c:pt idx="512">
                  <c:v>1976</c:v>
                </c:pt>
                <c:pt idx="513">
                  <c:v>3665</c:v>
                </c:pt>
                <c:pt idx="514">
                  <c:v>3292</c:v>
                </c:pt>
                <c:pt idx="515">
                  <c:v>1510</c:v>
                </c:pt>
                <c:pt idx="516">
                  <c:v>3447</c:v>
                </c:pt>
                <c:pt idx="517">
                  <c:v>2331</c:v>
                </c:pt>
                <c:pt idx="518">
                  <c:v>2908</c:v>
                </c:pt>
                <c:pt idx="519">
                  <c:v>1416</c:v>
                </c:pt>
                <c:pt idx="520">
                  <c:v>1356</c:v>
                </c:pt>
                <c:pt idx="521">
                  <c:v>2352</c:v>
                </c:pt>
                <c:pt idx="522">
                  <c:v>3624</c:v>
                </c:pt>
                <c:pt idx="523">
                  <c:v>3623</c:v>
                </c:pt>
                <c:pt idx="524">
                  <c:v>2695</c:v>
                </c:pt>
                <c:pt idx="525">
                  <c:v>2974</c:v>
                </c:pt>
                <c:pt idx="526">
                  <c:v>853</c:v>
                </c:pt>
                <c:pt idx="527">
                  <c:v>2489</c:v>
                </c:pt>
                <c:pt idx="528">
                  <c:v>2722</c:v>
                </c:pt>
                <c:pt idx="529">
                  <c:v>3264</c:v>
                </c:pt>
                <c:pt idx="530">
                  <c:v>3968</c:v>
                </c:pt>
                <c:pt idx="531">
                  <c:v>2825</c:v>
                </c:pt>
                <c:pt idx="532">
                  <c:v>2039</c:v>
                </c:pt>
                <c:pt idx="533">
                  <c:v>3254</c:v>
                </c:pt>
                <c:pt idx="534">
                  <c:v>3324</c:v>
                </c:pt>
                <c:pt idx="535">
                  <c:v>3340</c:v>
                </c:pt>
                <c:pt idx="536">
                  <c:v>2531</c:v>
                </c:pt>
                <c:pt idx="537">
                  <c:v>4034</c:v>
                </c:pt>
                <c:pt idx="538">
                  <c:v>2521</c:v>
                </c:pt>
                <c:pt idx="539">
                  <c:v>2241</c:v>
                </c:pt>
                <c:pt idx="540">
                  <c:v>2195</c:v>
                </c:pt>
                <c:pt idx="541">
                  <c:v>3691</c:v>
                </c:pt>
                <c:pt idx="542">
                  <c:v>3058</c:v>
                </c:pt>
                <c:pt idx="543">
                  <c:v>2102</c:v>
                </c:pt>
                <c:pt idx="544">
                  <c:v>3244</c:v>
                </c:pt>
                <c:pt idx="545">
                  <c:v>1619</c:v>
                </c:pt>
                <c:pt idx="546">
                  <c:v>2384</c:v>
                </c:pt>
                <c:pt idx="547">
                  <c:v>1891</c:v>
                </c:pt>
                <c:pt idx="548">
                  <c:v>4049</c:v>
                </c:pt>
                <c:pt idx="549">
                  <c:v>2826</c:v>
                </c:pt>
                <c:pt idx="550">
                  <c:v>1928</c:v>
                </c:pt>
                <c:pt idx="551">
                  <c:v>259</c:v>
                </c:pt>
                <c:pt idx="552">
                  <c:v>3834</c:v>
                </c:pt>
                <c:pt idx="553">
                  <c:v>1796</c:v>
                </c:pt>
                <c:pt idx="554">
                  <c:v>3362</c:v>
                </c:pt>
                <c:pt idx="555">
                  <c:v>2246</c:v>
                </c:pt>
                <c:pt idx="556">
                  <c:v>1925</c:v>
                </c:pt>
                <c:pt idx="557">
                  <c:v>422</c:v>
                </c:pt>
                <c:pt idx="558">
                  <c:v>2186</c:v>
                </c:pt>
                <c:pt idx="559">
                  <c:v>1803</c:v>
                </c:pt>
                <c:pt idx="560">
                  <c:v>3421</c:v>
                </c:pt>
                <c:pt idx="561">
                  <c:v>2913</c:v>
                </c:pt>
                <c:pt idx="562">
                  <c:v>2502</c:v>
                </c:pt>
                <c:pt idx="563">
                  <c:v>3565</c:v>
                </c:pt>
                <c:pt idx="564">
                  <c:v>3087</c:v>
                </c:pt>
                <c:pt idx="565">
                  <c:v>3256</c:v>
                </c:pt>
                <c:pt idx="566">
                  <c:v>3104</c:v>
                </c:pt>
                <c:pt idx="567">
                  <c:v>3250</c:v>
                </c:pt>
                <c:pt idx="568">
                  <c:v>2830</c:v>
                </c:pt>
                <c:pt idx="569">
                  <c:v>3002</c:v>
                </c:pt>
                <c:pt idx="570">
                  <c:v>2497</c:v>
                </c:pt>
                <c:pt idx="571">
                  <c:v>4007</c:v>
                </c:pt>
                <c:pt idx="572">
                  <c:v>840</c:v>
                </c:pt>
                <c:pt idx="573">
                  <c:v>2595</c:v>
                </c:pt>
                <c:pt idx="574">
                  <c:v>3878</c:v>
                </c:pt>
                <c:pt idx="575">
                  <c:v>3512</c:v>
                </c:pt>
                <c:pt idx="576">
                  <c:v>3630</c:v>
                </c:pt>
                <c:pt idx="577">
                  <c:v>2849</c:v>
                </c:pt>
                <c:pt idx="578">
                  <c:v>1251</c:v>
                </c:pt>
                <c:pt idx="579">
                  <c:v>3930</c:v>
                </c:pt>
                <c:pt idx="580">
                  <c:v>3008</c:v>
                </c:pt>
                <c:pt idx="581">
                  <c:v>2118</c:v>
                </c:pt>
                <c:pt idx="582">
                  <c:v>2084</c:v>
                </c:pt>
                <c:pt idx="583">
                  <c:v>1361</c:v>
                </c:pt>
                <c:pt idx="584">
                  <c:v>2027</c:v>
                </c:pt>
                <c:pt idx="585">
                  <c:v>2235</c:v>
                </c:pt>
                <c:pt idx="586">
                  <c:v>1124</c:v>
                </c:pt>
                <c:pt idx="587">
                  <c:v>3971</c:v>
                </c:pt>
                <c:pt idx="588">
                  <c:v>1741</c:v>
                </c:pt>
                <c:pt idx="589">
                  <c:v>2280</c:v>
                </c:pt>
                <c:pt idx="590">
                  <c:v>2843</c:v>
                </c:pt>
                <c:pt idx="591">
                  <c:v>2385</c:v>
                </c:pt>
                <c:pt idx="592">
                  <c:v>2912</c:v>
                </c:pt>
                <c:pt idx="593">
                  <c:v>850</c:v>
                </c:pt>
                <c:pt idx="594">
                  <c:v>2180</c:v>
                </c:pt>
                <c:pt idx="595">
                  <c:v>4019</c:v>
                </c:pt>
                <c:pt idx="596">
                  <c:v>3325</c:v>
                </c:pt>
                <c:pt idx="597">
                  <c:v>3655</c:v>
                </c:pt>
                <c:pt idx="598">
                  <c:v>3420</c:v>
                </c:pt>
                <c:pt idx="599">
                  <c:v>1773</c:v>
                </c:pt>
                <c:pt idx="600">
                  <c:v>3695</c:v>
                </c:pt>
                <c:pt idx="601">
                  <c:v>2507</c:v>
                </c:pt>
                <c:pt idx="602">
                  <c:v>3946</c:v>
                </c:pt>
                <c:pt idx="603">
                  <c:v>1774</c:v>
                </c:pt>
                <c:pt idx="604">
                  <c:v>2056</c:v>
                </c:pt>
                <c:pt idx="605">
                  <c:v>3307</c:v>
                </c:pt>
                <c:pt idx="606">
                  <c:v>3628</c:v>
                </c:pt>
                <c:pt idx="607">
                  <c:v>4015</c:v>
                </c:pt>
                <c:pt idx="608">
                  <c:v>3552</c:v>
                </c:pt>
                <c:pt idx="609">
                  <c:v>1890</c:v>
                </c:pt>
                <c:pt idx="610">
                  <c:v>2347</c:v>
                </c:pt>
                <c:pt idx="611">
                  <c:v>4032</c:v>
                </c:pt>
                <c:pt idx="612">
                  <c:v>1241</c:v>
                </c:pt>
                <c:pt idx="613">
                  <c:v>3581</c:v>
                </c:pt>
                <c:pt idx="614">
                  <c:v>3243</c:v>
                </c:pt>
                <c:pt idx="615">
                  <c:v>1911</c:v>
                </c:pt>
                <c:pt idx="616">
                  <c:v>2803</c:v>
                </c:pt>
                <c:pt idx="617">
                  <c:v>2950</c:v>
                </c:pt>
                <c:pt idx="618">
                  <c:v>3594</c:v>
                </c:pt>
                <c:pt idx="619">
                  <c:v>1497</c:v>
                </c:pt>
                <c:pt idx="620">
                  <c:v>3389</c:v>
                </c:pt>
                <c:pt idx="621">
                  <c:v>2243</c:v>
                </c:pt>
                <c:pt idx="622">
                  <c:v>1039</c:v>
                </c:pt>
                <c:pt idx="623">
                  <c:v>2088</c:v>
                </c:pt>
                <c:pt idx="624">
                  <c:v>2769</c:v>
                </c:pt>
                <c:pt idx="625">
                  <c:v>2718</c:v>
                </c:pt>
                <c:pt idx="626">
                  <c:v>3097</c:v>
                </c:pt>
                <c:pt idx="627">
                  <c:v>1499</c:v>
                </c:pt>
                <c:pt idx="628">
                  <c:v>2416</c:v>
                </c:pt>
                <c:pt idx="629">
                  <c:v>3223</c:v>
                </c:pt>
                <c:pt idx="630">
                  <c:v>1759</c:v>
                </c:pt>
                <c:pt idx="631">
                  <c:v>3709</c:v>
                </c:pt>
                <c:pt idx="632">
                  <c:v>2788</c:v>
                </c:pt>
                <c:pt idx="633">
                  <c:v>3308</c:v>
                </c:pt>
                <c:pt idx="634">
                  <c:v>3687</c:v>
                </c:pt>
                <c:pt idx="635">
                  <c:v>766</c:v>
                </c:pt>
                <c:pt idx="636">
                  <c:v>3597</c:v>
                </c:pt>
                <c:pt idx="637">
                  <c:v>3468</c:v>
                </c:pt>
                <c:pt idx="638">
                  <c:v>2956</c:v>
                </c:pt>
                <c:pt idx="639">
                  <c:v>3638</c:v>
                </c:pt>
                <c:pt idx="640">
                  <c:v>2275</c:v>
                </c:pt>
                <c:pt idx="641">
                  <c:v>4042</c:v>
                </c:pt>
                <c:pt idx="642">
                  <c:v>3703</c:v>
                </c:pt>
                <c:pt idx="643">
                  <c:v>2527</c:v>
                </c:pt>
                <c:pt idx="644">
                  <c:v>2391</c:v>
                </c:pt>
                <c:pt idx="645">
                  <c:v>3531</c:v>
                </c:pt>
                <c:pt idx="646">
                  <c:v>3252</c:v>
                </c:pt>
                <c:pt idx="647">
                  <c:v>1806</c:v>
                </c:pt>
                <c:pt idx="648">
                  <c:v>3851</c:v>
                </c:pt>
                <c:pt idx="649">
                  <c:v>3265</c:v>
                </c:pt>
                <c:pt idx="650">
                  <c:v>2081</c:v>
                </c:pt>
                <c:pt idx="651">
                  <c:v>3345</c:v>
                </c:pt>
                <c:pt idx="652">
                  <c:v>2985</c:v>
                </c:pt>
                <c:pt idx="653">
                  <c:v>3182</c:v>
                </c:pt>
                <c:pt idx="654">
                  <c:v>2608</c:v>
                </c:pt>
                <c:pt idx="655">
                  <c:v>3676</c:v>
                </c:pt>
                <c:pt idx="656">
                  <c:v>3875</c:v>
                </c:pt>
                <c:pt idx="657">
                  <c:v>2733</c:v>
                </c:pt>
                <c:pt idx="658">
                  <c:v>4018</c:v>
                </c:pt>
                <c:pt idx="659">
                  <c:v>3302</c:v>
                </c:pt>
                <c:pt idx="660">
                  <c:v>3287</c:v>
                </c:pt>
                <c:pt idx="661">
                  <c:v>1004</c:v>
                </c:pt>
                <c:pt idx="662">
                  <c:v>3629</c:v>
                </c:pt>
                <c:pt idx="663">
                  <c:v>2488</c:v>
                </c:pt>
                <c:pt idx="664">
                  <c:v>2393</c:v>
                </c:pt>
                <c:pt idx="665">
                  <c:v>2886</c:v>
                </c:pt>
                <c:pt idx="666">
                  <c:v>3479</c:v>
                </c:pt>
                <c:pt idx="667">
                  <c:v>2003</c:v>
                </c:pt>
                <c:pt idx="668">
                  <c:v>1549</c:v>
                </c:pt>
                <c:pt idx="669">
                  <c:v>2549</c:v>
                </c:pt>
                <c:pt idx="670">
                  <c:v>604</c:v>
                </c:pt>
                <c:pt idx="671">
                  <c:v>785</c:v>
                </c:pt>
                <c:pt idx="672">
                  <c:v>3176</c:v>
                </c:pt>
                <c:pt idx="673">
                  <c:v>3442</c:v>
                </c:pt>
                <c:pt idx="674">
                  <c:v>3747</c:v>
                </c:pt>
                <c:pt idx="675">
                  <c:v>2859</c:v>
                </c:pt>
                <c:pt idx="676">
                  <c:v>2924</c:v>
                </c:pt>
                <c:pt idx="677">
                  <c:v>3716</c:v>
                </c:pt>
                <c:pt idx="678">
                  <c:v>3314</c:v>
                </c:pt>
                <c:pt idx="679">
                  <c:v>3892</c:v>
                </c:pt>
                <c:pt idx="680">
                  <c:v>3305</c:v>
                </c:pt>
                <c:pt idx="681">
                  <c:v>3912</c:v>
                </c:pt>
                <c:pt idx="682">
                  <c:v>2840</c:v>
                </c:pt>
                <c:pt idx="683">
                  <c:v>3465</c:v>
                </c:pt>
                <c:pt idx="684">
                  <c:v>3310</c:v>
                </c:pt>
                <c:pt idx="685">
                  <c:v>2005</c:v>
                </c:pt>
                <c:pt idx="686">
                  <c:v>3540</c:v>
                </c:pt>
                <c:pt idx="687">
                  <c:v>2742</c:v>
                </c:pt>
                <c:pt idx="688">
                  <c:v>3165</c:v>
                </c:pt>
                <c:pt idx="689">
                  <c:v>3128</c:v>
                </c:pt>
                <c:pt idx="690">
                  <c:v>1325</c:v>
                </c:pt>
                <c:pt idx="691">
                  <c:v>1952</c:v>
                </c:pt>
                <c:pt idx="692">
                  <c:v>2951</c:v>
                </c:pt>
                <c:pt idx="693">
                  <c:v>3526</c:v>
                </c:pt>
                <c:pt idx="694">
                  <c:v>4084</c:v>
                </c:pt>
                <c:pt idx="695">
                  <c:v>3299</c:v>
                </c:pt>
                <c:pt idx="696">
                  <c:v>3414</c:v>
                </c:pt>
                <c:pt idx="697">
                  <c:v>3167</c:v>
                </c:pt>
                <c:pt idx="698">
                  <c:v>2573</c:v>
                </c:pt>
                <c:pt idx="699">
                  <c:v>2936</c:v>
                </c:pt>
                <c:pt idx="700">
                  <c:v>3127</c:v>
                </c:pt>
                <c:pt idx="701">
                  <c:v>2470</c:v>
                </c:pt>
                <c:pt idx="702">
                  <c:v>2028</c:v>
                </c:pt>
                <c:pt idx="703">
                  <c:v>3003</c:v>
                </c:pt>
                <c:pt idx="704">
                  <c:v>2620</c:v>
                </c:pt>
                <c:pt idx="705">
                  <c:v>3332</c:v>
                </c:pt>
                <c:pt idx="706">
                  <c:v>2744</c:v>
                </c:pt>
                <c:pt idx="707">
                  <c:v>3847</c:v>
                </c:pt>
                <c:pt idx="708">
                  <c:v>3123</c:v>
                </c:pt>
                <c:pt idx="709">
                  <c:v>1975</c:v>
                </c:pt>
                <c:pt idx="710">
                  <c:v>3585</c:v>
                </c:pt>
                <c:pt idx="711">
                  <c:v>3927</c:v>
                </c:pt>
                <c:pt idx="712">
                  <c:v>3001</c:v>
                </c:pt>
                <c:pt idx="713">
                  <c:v>2572</c:v>
                </c:pt>
                <c:pt idx="714">
                  <c:v>3415</c:v>
                </c:pt>
                <c:pt idx="715">
                  <c:v>3697</c:v>
                </c:pt>
                <c:pt idx="716">
                  <c:v>3370</c:v>
                </c:pt>
                <c:pt idx="717">
                  <c:v>4014</c:v>
                </c:pt>
                <c:pt idx="718">
                  <c:v>2696</c:v>
                </c:pt>
                <c:pt idx="719">
                  <c:v>2666</c:v>
                </c:pt>
                <c:pt idx="720">
                  <c:v>2697</c:v>
                </c:pt>
                <c:pt idx="721">
                  <c:v>3537</c:v>
                </c:pt>
                <c:pt idx="722">
                  <c:v>2789</c:v>
                </c:pt>
                <c:pt idx="723">
                  <c:v>2876</c:v>
                </c:pt>
                <c:pt idx="724">
                  <c:v>2992</c:v>
                </c:pt>
                <c:pt idx="725">
                  <c:v>3330</c:v>
                </c:pt>
                <c:pt idx="726">
                  <c:v>3187</c:v>
                </c:pt>
                <c:pt idx="727">
                  <c:v>3916</c:v>
                </c:pt>
                <c:pt idx="728">
                  <c:v>2378</c:v>
                </c:pt>
                <c:pt idx="729">
                  <c:v>1818</c:v>
                </c:pt>
                <c:pt idx="730">
                  <c:v>2402</c:v>
                </c:pt>
                <c:pt idx="731">
                  <c:v>2199</c:v>
                </c:pt>
                <c:pt idx="732">
                  <c:v>4011</c:v>
                </c:pt>
                <c:pt idx="733">
                  <c:v>3511</c:v>
                </c:pt>
                <c:pt idx="734">
                  <c:v>2868</c:v>
                </c:pt>
                <c:pt idx="735">
                  <c:v>2621</c:v>
                </c:pt>
                <c:pt idx="736">
                  <c:v>3034</c:v>
                </c:pt>
                <c:pt idx="737">
                  <c:v>2855</c:v>
                </c:pt>
                <c:pt idx="738">
                  <c:v>3835</c:v>
                </c:pt>
                <c:pt idx="739">
                  <c:v>2580</c:v>
                </c:pt>
                <c:pt idx="740">
                  <c:v>2962</c:v>
                </c:pt>
                <c:pt idx="741">
                  <c:v>3190</c:v>
                </c:pt>
                <c:pt idx="742">
                  <c:v>213</c:v>
                </c:pt>
                <c:pt idx="743">
                  <c:v>3555</c:v>
                </c:pt>
                <c:pt idx="744">
                  <c:v>2175</c:v>
                </c:pt>
                <c:pt idx="745">
                  <c:v>2542</c:v>
                </c:pt>
                <c:pt idx="746">
                  <c:v>3925</c:v>
                </c:pt>
                <c:pt idx="747">
                  <c:v>2846</c:v>
                </c:pt>
                <c:pt idx="748">
                  <c:v>2503</c:v>
                </c:pt>
                <c:pt idx="749">
                  <c:v>2630</c:v>
                </c:pt>
                <c:pt idx="750">
                  <c:v>3247</c:v>
                </c:pt>
                <c:pt idx="751">
                  <c:v>4010</c:v>
                </c:pt>
                <c:pt idx="752">
                  <c:v>3913</c:v>
                </c:pt>
                <c:pt idx="753">
                  <c:v>2007</c:v>
                </c:pt>
                <c:pt idx="754">
                  <c:v>3972</c:v>
                </c:pt>
                <c:pt idx="755">
                  <c:v>3320</c:v>
                </c:pt>
                <c:pt idx="756">
                  <c:v>3911</c:v>
                </c:pt>
                <c:pt idx="757">
                  <c:v>3612</c:v>
                </c:pt>
                <c:pt idx="758">
                  <c:v>1668</c:v>
                </c:pt>
                <c:pt idx="759">
                  <c:v>3671</c:v>
                </c:pt>
                <c:pt idx="760">
                  <c:v>2694</c:v>
                </c:pt>
                <c:pt idx="761">
                  <c:v>3846</c:v>
                </c:pt>
                <c:pt idx="762">
                  <c:v>3915</c:v>
                </c:pt>
                <c:pt idx="763">
                  <c:v>3327</c:v>
                </c:pt>
                <c:pt idx="764">
                  <c:v>3618</c:v>
                </c:pt>
                <c:pt idx="765">
                  <c:v>717</c:v>
                </c:pt>
                <c:pt idx="766">
                  <c:v>1229</c:v>
                </c:pt>
                <c:pt idx="767">
                  <c:v>2167</c:v>
                </c:pt>
                <c:pt idx="768">
                  <c:v>3677</c:v>
                </c:pt>
                <c:pt idx="769">
                  <c:v>3323</c:v>
                </c:pt>
                <c:pt idx="770">
                  <c:v>2971</c:v>
                </c:pt>
                <c:pt idx="771">
                  <c:v>1801</c:v>
                </c:pt>
                <c:pt idx="772">
                  <c:v>2320</c:v>
                </c:pt>
                <c:pt idx="773">
                  <c:v>3538</c:v>
                </c:pt>
                <c:pt idx="774">
                  <c:v>613</c:v>
                </c:pt>
                <c:pt idx="775">
                  <c:v>1889</c:v>
                </c:pt>
                <c:pt idx="776">
                  <c:v>3850</c:v>
                </c:pt>
                <c:pt idx="777">
                  <c:v>2045</c:v>
                </c:pt>
                <c:pt idx="778">
                  <c:v>3550</c:v>
                </c:pt>
                <c:pt idx="779">
                  <c:v>3905</c:v>
                </c:pt>
                <c:pt idx="780">
                  <c:v>3584</c:v>
                </c:pt>
                <c:pt idx="781">
                  <c:v>2209</c:v>
                </c:pt>
                <c:pt idx="782">
                  <c:v>3163</c:v>
                </c:pt>
                <c:pt idx="783">
                  <c:v>3381</c:v>
                </c:pt>
                <c:pt idx="784">
                  <c:v>3560</c:v>
                </c:pt>
                <c:pt idx="785">
                  <c:v>1968</c:v>
                </c:pt>
                <c:pt idx="786">
                  <c:v>1558</c:v>
                </c:pt>
                <c:pt idx="787">
                  <c:v>2771</c:v>
                </c:pt>
                <c:pt idx="788">
                  <c:v>3061</c:v>
                </c:pt>
                <c:pt idx="789">
                  <c:v>3363</c:v>
                </c:pt>
                <c:pt idx="790">
                  <c:v>3548</c:v>
                </c:pt>
                <c:pt idx="791">
                  <c:v>2176</c:v>
                </c:pt>
                <c:pt idx="792">
                  <c:v>922</c:v>
                </c:pt>
                <c:pt idx="793">
                  <c:v>2703</c:v>
                </c:pt>
                <c:pt idx="794">
                  <c:v>2472</c:v>
                </c:pt>
                <c:pt idx="795">
                  <c:v>3251</c:v>
                </c:pt>
                <c:pt idx="796">
                  <c:v>3718</c:v>
                </c:pt>
                <c:pt idx="797">
                  <c:v>1511</c:v>
                </c:pt>
                <c:pt idx="798">
                  <c:v>2686</c:v>
                </c:pt>
                <c:pt idx="799">
                  <c:v>4008</c:v>
                </c:pt>
                <c:pt idx="800">
                  <c:v>3953</c:v>
                </c:pt>
                <c:pt idx="801">
                  <c:v>2910</c:v>
                </c:pt>
                <c:pt idx="802">
                  <c:v>3505</c:v>
                </c:pt>
                <c:pt idx="803">
                  <c:v>3844</c:v>
                </c:pt>
                <c:pt idx="804">
                  <c:v>2791</c:v>
                </c:pt>
                <c:pt idx="805">
                  <c:v>1667</c:v>
                </c:pt>
                <c:pt idx="806">
                  <c:v>3162</c:v>
                </c:pt>
                <c:pt idx="807">
                  <c:v>2404</c:v>
                </c:pt>
                <c:pt idx="808">
                  <c:v>3384</c:v>
                </c:pt>
                <c:pt idx="809">
                  <c:v>1636</c:v>
                </c:pt>
                <c:pt idx="810">
                  <c:v>2326</c:v>
                </c:pt>
                <c:pt idx="811">
                  <c:v>3527</c:v>
                </c:pt>
                <c:pt idx="812">
                  <c:v>3297</c:v>
                </c:pt>
                <c:pt idx="813">
                  <c:v>3891</c:v>
                </c:pt>
                <c:pt idx="814">
                  <c:v>3094</c:v>
                </c:pt>
                <c:pt idx="815">
                  <c:v>2721</c:v>
                </c:pt>
                <c:pt idx="816">
                  <c:v>3506</c:v>
                </c:pt>
                <c:pt idx="817">
                  <c:v>3148</c:v>
                </c:pt>
                <c:pt idx="818">
                  <c:v>3553</c:v>
                </c:pt>
                <c:pt idx="819">
                  <c:v>3852</c:v>
                </c:pt>
                <c:pt idx="820">
                  <c:v>4001</c:v>
                </c:pt>
                <c:pt idx="821">
                  <c:v>3890</c:v>
                </c:pt>
                <c:pt idx="822">
                  <c:v>3539</c:v>
                </c:pt>
                <c:pt idx="823">
                  <c:v>2242</c:v>
                </c:pt>
                <c:pt idx="824">
                  <c:v>3938</c:v>
                </c:pt>
                <c:pt idx="825">
                  <c:v>1554</c:v>
                </c:pt>
                <c:pt idx="826">
                  <c:v>1772</c:v>
                </c:pt>
                <c:pt idx="827">
                  <c:v>2511</c:v>
                </c:pt>
                <c:pt idx="828">
                  <c:v>2569</c:v>
                </c:pt>
                <c:pt idx="829">
                  <c:v>3006</c:v>
                </c:pt>
                <c:pt idx="830">
                  <c:v>3191</c:v>
                </c:pt>
                <c:pt idx="831">
                  <c:v>3880</c:v>
                </c:pt>
                <c:pt idx="832">
                  <c:v>2615</c:v>
                </c:pt>
                <c:pt idx="833">
                  <c:v>1675</c:v>
                </c:pt>
                <c:pt idx="834">
                  <c:v>2133</c:v>
                </c:pt>
                <c:pt idx="835">
                  <c:v>3312</c:v>
                </c:pt>
                <c:pt idx="836">
                  <c:v>1887</c:v>
                </c:pt>
                <c:pt idx="837">
                  <c:v>3249</c:v>
                </c:pt>
                <c:pt idx="838">
                  <c:v>1707</c:v>
                </c:pt>
                <c:pt idx="839">
                  <c:v>3147</c:v>
                </c:pt>
                <c:pt idx="840">
                  <c:v>3694</c:v>
                </c:pt>
                <c:pt idx="841">
                  <c:v>3993</c:v>
                </c:pt>
                <c:pt idx="842">
                  <c:v>3138</c:v>
                </c:pt>
                <c:pt idx="843">
                  <c:v>1324</c:v>
                </c:pt>
                <c:pt idx="844">
                  <c:v>1656</c:v>
                </c:pt>
                <c:pt idx="845">
                  <c:v>2869</c:v>
                </c:pt>
                <c:pt idx="846">
                  <c:v>3233</c:v>
                </c:pt>
                <c:pt idx="847">
                  <c:v>1913</c:v>
                </c:pt>
                <c:pt idx="848">
                  <c:v>2365</c:v>
                </c:pt>
                <c:pt idx="849">
                  <c:v>2719</c:v>
                </c:pt>
                <c:pt idx="850">
                  <c:v>3767</c:v>
                </c:pt>
                <c:pt idx="851">
                  <c:v>2679</c:v>
                </c:pt>
                <c:pt idx="852">
                  <c:v>3137</c:v>
                </c:pt>
                <c:pt idx="853">
                  <c:v>3315</c:v>
                </c:pt>
                <c:pt idx="854">
                  <c:v>3241</c:v>
                </c:pt>
                <c:pt idx="855">
                  <c:v>4000</c:v>
                </c:pt>
                <c:pt idx="856">
                  <c:v>3508</c:v>
                </c:pt>
                <c:pt idx="857">
                  <c:v>2927</c:v>
                </c:pt>
                <c:pt idx="858">
                  <c:v>3970</c:v>
                </c:pt>
                <c:pt idx="859">
                  <c:v>777</c:v>
                </c:pt>
                <c:pt idx="860">
                  <c:v>3992</c:v>
                </c:pt>
                <c:pt idx="861">
                  <c:v>3670</c:v>
                </c:pt>
                <c:pt idx="862">
                  <c:v>2070</c:v>
                </c:pt>
                <c:pt idx="863">
                  <c:v>4035</c:v>
                </c:pt>
                <c:pt idx="864">
                  <c:v>212</c:v>
                </c:pt>
                <c:pt idx="865">
                  <c:v>2605</c:v>
                </c:pt>
                <c:pt idx="866">
                  <c:v>3619</c:v>
                </c:pt>
                <c:pt idx="867">
                  <c:v>3337</c:v>
                </c:pt>
                <c:pt idx="868">
                  <c:v>3263</c:v>
                </c:pt>
                <c:pt idx="869">
                  <c:v>3108</c:v>
                </c:pt>
                <c:pt idx="870">
                  <c:v>3701</c:v>
                </c:pt>
                <c:pt idx="871">
                  <c:v>3408</c:v>
                </c:pt>
                <c:pt idx="872">
                  <c:v>2782</c:v>
                </c:pt>
                <c:pt idx="873">
                  <c:v>1969</c:v>
                </c:pt>
                <c:pt idx="874">
                  <c:v>843</c:v>
                </c:pt>
                <c:pt idx="875">
                  <c:v>3564</c:v>
                </c:pt>
                <c:pt idx="876">
                  <c:v>3643</c:v>
                </c:pt>
                <c:pt idx="877">
                  <c:v>3649</c:v>
                </c:pt>
                <c:pt idx="878">
                  <c:v>1659</c:v>
                </c:pt>
                <c:pt idx="879">
                  <c:v>3166</c:v>
                </c:pt>
                <c:pt idx="880">
                  <c:v>3849</c:v>
                </c:pt>
                <c:pt idx="881">
                  <c:v>2150</c:v>
                </c:pt>
                <c:pt idx="882">
                  <c:v>2746</c:v>
                </c:pt>
                <c:pt idx="883">
                  <c:v>265</c:v>
                </c:pt>
                <c:pt idx="884">
                  <c:v>1888</c:v>
                </c:pt>
                <c:pt idx="885">
                  <c:v>3595</c:v>
                </c:pt>
                <c:pt idx="886">
                  <c:v>1052</c:v>
                </c:pt>
                <c:pt idx="887">
                  <c:v>3578</c:v>
                </c:pt>
                <c:pt idx="888">
                  <c:v>2555</c:v>
                </c:pt>
                <c:pt idx="889">
                  <c:v>3590</c:v>
                </c:pt>
                <c:pt idx="890">
                  <c:v>3952</c:v>
                </c:pt>
                <c:pt idx="891">
                  <c:v>2877</c:v>
                </c:pt>
                <c:pt idx="892">
                  <c:v>3119</c:v>
                </c:pt>
                <c:pt idx="893">
                  <c:v>2772</c:v>
                </c:pt>
                <c:pt idx="894">
                  <c:v>2350</c:v>
                </c:pt>
                <c:pt idx="895">
                  <c:v>2902</c:v>
                </c:pt>
                <c:pt idx="896">
                  <c:v>3195</c:v>
                </c:pt>
                <c:pt idx="897">
                  <c:v>3286</c:v>
                </c:pt>
                <c:pt idx="898">
                  <c:v>685</c:v>
                </c:pt>
                <c:pt idx="899">
                  <c:v>3575</c:v>
                </c:pt>
                <c:pt idx="900">
                  <c:v>2505</c:v>
                </c:pt>
                <c:pt idx="901">
                  <c:v>2916</c:v>
                </c:pt>
                <c:pt idx="902">
                  <c:v>3387</c:v>
                </c:pt>
                <c:pt idx="903">
                  <c:v>2448</c:v>
                </c:pt>
                <c:pt idx="904">
                  <c:v>2553</c:v>
                </c:pt>
                <c:pt idx="905">
                  <c:v>2095</c:v>
                </c:pt>
                <c:pt idx="906">
                  <c:v>1478</c:v>
                </c:pt>
                <c:pt idx="907">
                  <c:v>3745</c:v>
                </c:pt>
                <c:pt idx="908">
                  <c:v>3631</c:v>
                </c:pt>
                <c:pt idx="909">
                  <c:v>4038</c:v>
                </c:pt>
                <c:pt idx="910">
                  <c:v>643</c:v>
                </c:pt>
                <c:pt idx="911">
                  <c:v>956</c:v>
                </c:pt>
                <c:pt idx="912">
                  <c:v>3945</c:v>
                </c:pt>
                <c:pt idx="913">
                  <c:v>2607</c:v>
                </c:pt>
                <c:pt idx="914">
                  <c:v>2618</c:v>
                </c:pt>
                <c:pt idx="915">
                  <c:v>3533</c:v>
                </c:pt>
                <c:pt idx="916">
                  <c:v>3675</c:v>
                </c:pt>
                <c:pt idx="917">
                  <c:v>2222</c:v>
                </c:pt>
                <c:pt idx="918">
                  <c:v>3551</c:v>
                </c:pt>
                <c:pt idx="919">
                  <c:v>3862</c:v>
                </c:pt>
                <c:pt idx="920">
                  <c:v>2025</c:v>
                </c:pt>
                <c:pt idx="921">
                  <c:v>1369</c:v>
                </c:pt>
                <c:pt idx="922">
                  <c:v>2172</c:v>
                </c:pt>
                <c:pt idx="923">
                  <c:v>3662</c:v>
                </c:pt>
                <c:pt idx="924">
                  <c:v>2995</c:v>
                </c:pt>
                <c:pt idx="925">
                  <c:v>2957</c:v>
                </c:pt>
                <c:pt idx="926">
                  <c:v>2842</c:v>
                </c:pt>
                <c:pt idx="927">
                  <c:v>3961</c:v>
                </c:pt>
                <c:pt idx="928">
                  <c:v>3658</c:v>
                </c:pt>
                <c:pt idx="929">
                  <c:v>3261</c:v>
                </c:pt>
                <c:pt idx="930">
                  <c:v>3908</c:v>
                </c:pt>
                <c:pt idx="931">
                  <c:v>2904</c:v>
                </c:pt>
                <c:pt idx="932">
                  <c:v>3502</c:v>
                </c:pt>
                <c:pt idx="933">
                  <c:v>2374</c:v>
                </c:pt>
                <c:pt idx="934">
                  <c:v>3214</c:v>
                </c:pt>
                <c:pt idx="935">
                  <c:v>1474</c:v>
                </c:pt>
                <c:pt idx="936">
                  <c:v>3144</c:v>
                </c:pt>
                <c:pt idx="937">
                  <c:v>3374</c:v>
                </c:pt>
                <c:pt idx="938">
                  <c:v>2059</c:v>
                </c:pt>
                <c:pt idx="939">
                  <c:v>2925</c:v>
                </c:pt>
                <c:pt idx="940">
                  <c:v>2373</c:v>
                </c:pt>
                <c:pt idx="941">
                  <c:v>3647</c:v>
                </c:pt>
                <c:pt idx="942">
                  <c:v>2585</c:v>
                </c:pt>
                <c:pt idx="943">
                  <c:v>3168</c:v>
                </c:pt>
                <c:pt idx="944">
                  <c:v>2948</c:v>
                </c:pt>
                <c:pt idx="945">
                  <c:v>4021</c:v>
                </c:pt>
                <c:pt idx="946">
                  <c:v>896</c:v>
                </c:pt>
                <c:pt idx="947">
                  <c:v>3577</c:v>
                </c:pt>
                <c:pt idx="948">
                  <c:v>3226</c:v>
                </c:pt>
                <c:pt idx="949">
                  <c:v>3029</c:v>
                </c:pt>
                <c:pt idx="950">
                  <c:v>2104</c:v>
                </c:pt>
                <c:pt idx="951">
                  <c:v>2257</c:v>
                </c:pt>
                <c:pt idx="952">
                  <c:v>3293</c:v>
                </c:pt>
                <c:pt idx="953">
                  <c:v>3056</c:v>
                </c:pt>
                <c:pt idx="954">
                  <c:v>2395</c:v>
                </c:pt>
                <c:pt idx="955">
                  <c:v>1105</c:v>
                </c:pt>
                <c:pt idx="956">
                  <c:v>3839</c:v>
                </c:pt>
                <c:pt idx="957">
                  <c:v>3023</c:v>
                </c:pt>
                <c:pt idx="958">
                  <c:v>3188</c:v>
                </c:pt>
                <c:pt idx="959">
                  <c:v>3554</c:v>
                </c:pt>
                <c:pt idx="960">
                  <c:v>2574</c:v>
                </c:pt>
                <c:pt idx="961">
                  <c:v>1738</c:v>
                </c:pt>
                <c:pt idx="962">
                  <c:v>770</c:v>
                </c:pt>
                <c:pt idx="963">
                  <c:v>2240</c:v>
                </c:pt>
                <c:pt idx="964">
                  <c:v>2466</c:v>
                </c:pt>
                <c:pt idx="965">
                  <c:v>1316</c:v>
                </c:pt>
                <c:pt idx="966">
                  <c:v>3669</c:v>
                </c:pt>
                <c:pt idx="967">
                  <c:v>4004</c:v>
                </c:pt>
                <c:pt idx="968">
                  <c:v>2324</c:v>
                </c:pt>
                <c:pt idx="969">
                  <c:v>3955</c:v>
                </c:pt>
                <c:pt idx="970">
                  <c:v>3411</c:v>
                </c:pt>
                <c:pt idx="971">
                  <c:v>3664</c:v>
                </c:pt>
                <c:pt idx="972">
                  <c:v>3321</c:v>
                </c:pt>
                <c:pt idx="973">
                  <c:v>3545</c:v>
                </c:pt>
                <c:pt idx="974">
                  <c:v>3432</c:v>
                </c:pt>
                <c:pt idx="975">
                  <c:v>3650</c:v>
                </c:pt>
                <c:pt idx="976">
                  <c:v>3728</c:v>
                </c:pt>
                <c:pt idx="977">
                  <c:v>3525</c:v>
                </c:pt>
                <c:pt idx="978">
                  <c:v>3974</c:v>
                </c:pt>
                <c:pt idx="979">
                  <c:v>2439</c:v>
                </c:pt>
                <c:pt idx="980">
                  <c:v>2824</c:v>
                </c:pt>
                <c:pt idx="981">
                  <c:v>2954</c:v>
                </c:pt>
                <c:pt idx="982">
                  <c:v>2591</c:v>
                </c:pt>
                <c:pt idx="983">
                  <c:v>3145</c:v>
                </c:pt>
                <c:pt idx="984">
                  <c:v>2029</c:v>
                </c:pt>
                <c:pt idx="985">
                  <c:v>3772</c:v>
                </c:pt>
                <c:pt idx="986">
                  <c:v>1777</c:v>
                </c:pt>
                <c:pt idx="987">
                  <c:v>2276</c:v>
                </c:pt>
                <c:pt idx="988">
                  <c:v>2725</c:v>
                </c:pt>
                <c:pt idx="989">
                  <c:v>3095</c:v>
                </c:pt>
                <c:pt idx="990">
                  <c:v>1633</c:v>
                </c:pt>
                <c:pt idx="991">
                  <c:v>2875</c:v>
                </c:pt>
                <c:pt idx="992">
                  <c:v>3692</c:v>
                </c:pt>
                <c:pt idx="993">
                  <c:v>3923</c:v>
                </c:pt>
                <c:pt idx="994">
                  <c:v>2452</c:v>
                </c:pt>
                <c:pt idx="995">
                  <c:v>3258</c:v>
                </c:pt>
              </c:numCache>
            </c:numRef>
          </c:xVal>
          <c:yVal>
            <c:numRef>
              <c:f>AGO1a!$F$2:$F$1002</c:f>
              <c:numCache>
                <c:formatCode>General</c:formatCode>
                <c:ptCount val="1001"/>
                <c:pt idx="0">
                  <c:v>2</c:v>
                </c:pt>
                <c:pt idx="1">
                  <c:v>1</c:v>
                </c:pt>
                <c:pt idx="3">
                  <c:v>1</c:v>
                </c:pt>
                <c:pt idx="5">
                  <c:v>1</c:v>
                </c:pt>
                <c:pt idx="6">
                  <c:v>1</c:v>
                </c:pt>
                <c:pt idx="8">
                  <c:v>1</c:v>
                </c:pt>
                <c:pt idx="13">
                  <c:v>1</c:v>
                </c:pt>
                <c:pt idx="14">
                  <c:v>1</c:v>
                </c:pt>
                <c:pt idx="16">
                  <c:v>1</c:v>
                </c:pt>
                <c:pt idx="17">
                  <c:v>1</c:v>
                </c:pt>
                <c:pt idx="18">
                  <c:v>1</c:v>
                </c:pt>
                <c:pt idx="23">
                  <c:v>1</c:v>
                </c:pt>
                <c:pt idx="25">
                  <c:v>1</c:v>
                </c:pt>
                <c:pt idx="26">
                  <c:v>1</c:v>
                </c:pt>
                <c:pt idx="29">
                  <c:v>1</c:v>
                </c:pt>
                <c:pt idx="34">
                  <c:v>2</c:v>
                </c:pt>
                <c:pt idx="35">
                  <c:v>1</c:v>
                </c:pt>
                <c:pt idx="37">
                  <c:v>1</c:v>
                </c:pt>
                <c:pt idx="40">
                  <c:v>1</c:v>
                </c:pt>
                <c:pt idx="42">
                  <c:v>1</c:v>
                </c:pt>
                <c:pt idx="43">
                  <c:v>1</c:v>
                </c:pt>
                <c:pt idx="47">
                  <c:v>1</c:v>
                </c:pt>
                <c:pt idx="49">
                  <c:v>1</c:v>
                </c:pt>
                <c:pt idx="50">
                  <c:v>1</c:v>
                </c:pt>
                <c:pt idx="51">
                  <c:v>1</c:v>
                </c:pt>
                <c:pt idx="52">
                  <c:v>1</c:v>
                </c:pt>
                <c:pt idx="53">
                  <c:v>1</c:v>
                </c:pt>
                <c:pt idx="58">
                  <c:v>2</c:v>
                </c:pt>
                <c:pt idx="60">
                  <c:v>1</c:v>
                </c:pt>
                <c:pt idx="64">
                  <c:v>1</c:v>
                </c:pt>
                <c:pt idx="65">
                  <c:v>1</c:v>
                </c:pt>
                <c:pt idx="66">
                  <c:v>1</c:v>
                </c:pt>
                <c:pt idx="67">
                  <c:v>1</c:v>
                </c:pt>
                <c:pt idx="68">
                  <c:v>1</c:v>
                </c:pt>
                <c:pt idx="71">
                  <c:v>1</c:v>
                </c:pt>
                <c:pt idx="72">
                  <c:v>1</c:v>
                </c:pt>
                <c:pt idx="73">
                  <c:v>1</c:v>
                </c:pt>
                <c:pt idx="75">
                  <c:v>1</c:v>
                </c:pt>
                <c:pt idx="76">
                  <c:v>1</c:v>
                </c:pt>
                <c:pt idx="79">
                  <c:v>1</c:v>
                </c:pt>
                <c:pt idx="80">
                  <c:v>1</c:v>
                </c:pt>
                <c:pt idx="84">
                  <c:v>1</c:v>
                </c:pt>
                <c:pt idx="88">
                  <c:v>1</c:v>
                </c:pt>
                <c:pt idx="89">
                  <c:v>1</c:v>
                </c:pt>
                <c:pt idx="91">
                  <c:v>1</c:v>
                </c:pt>
                <c:pt idx="92">
                  <c:v>1</c:v>
                </c:pt>
                <c:pt idx="94">
                  <c:v>1</c:v>
                </c:pt>
                <c:pt idx="96">
                  <c:v>1</c:v>
                </c:pt>
                <c:pt idx="104">
                  <c:v>1</c:v>
                </c:pt>
                <c:pt idx="106">
                  <c:v>1</c:v>
                </c:pt>
                <c:pt idx="107">
                  <c:v>1</c:v>
                </c:pt>
                <c:pt idx="109">
                  <c:v>1</c:v>
                </c:pt>
                <c:pt idx="113">
                  <c:v>1</c:v>
                </c:pt>
                <c:pt idx="120">
                  <c:v>1</c:v>
                </c:pt>
                <c:pt idx="121">
                  <c:v>1</c:v>
                </c:pt>
                <c:pt idx="122">
                  <c:v>1</c:v>
                </c:pt>
                <c:pt idx="123">
                  <c:v>1</c:v>
                </c:pt>
                <c:pt idx="127">
                  <c:v>1</c:v>
                </c:pt>
                <c:pt idx="135">
                  <c:v>1</c:v>
                </c:pt>
                <c:pt idx="136">
                  <c:v>1</c:v>
                </c:pt>
                <c:pt idx="140">
                  <c:v>1</c:v>
                </c:pt>
                <c:pt idx="143">
                  <c:v>1</c:v>
                </c:pt>
                <c:pt idx="148">
                  <c:v>1</c:v>
                </c:pt>
                <c:pt idx="156">
                  <c:v>1</c:v>
                </c:pt>
                <c:pt idx="158">
                  <c:v>1</c:v>
                </c:pt>
                <c:pt idx="160">
                  <c:v>1</c:v>
                </c:pt>
                <c:pt idx="163">
                  <c:v>1</c:v>
                </c:pt>
                <c:pt idx="166">
                  <c:v>1</c:v>
                </c:pt>
                <c:pt idx="167">
                  <c:v>1</c:v>
                </c:pt>
                <c:pt idx="170">
                  <c:v>1</c:v>
                </c:pt>
                <c:pt idx="172">
                  <c:v>1</c:v>
                </c:pt>
                <c:pt idx="177">
                  <c:v>1</c:v>
                </c:pt>
                <c:pt idx="179">
                  <c:v>1</c:v>
                </c:pt>
                <c:pt idx="180">
                  <c:v>1</c:v>
                </c:pt>
                <c:pt idx="185">
                  <c:v>1</c:v>
                </c:pt>
                <c:pt idx="186">
                  <c:v>1</c:v>
                </c:pt>
                <c:pt idx="187">
                  <c:v>1</c:v>
                </c:pt>
                <c:pt idx="189">
                  <c:v>1</c:v>
                </c:pt>
                <c:pt idx="190">
                  <c:v>1</c:v>
                </c:pt>
                <c:pt idx="200">
                  <c:v>1</c:v>
                </c:pt>
                <c:pt idx="203">
                  <c:v>1</c:v>
                </c:pt>
                <c:pt idx="205">
                  <c:v>1</c:v>
                </c:pt>
                <c:pt idx="206">
                  <c:v>1</c:v>
                </c:pt>
                <c:pt idx="208">
                  <c:v>1</c:v>
                </c:pt>
                <c:pt idx="210">
                  <c:v>1</c:v>
                </c:pt>
                <c:pt idx="211">
                  <c:v>1</c:v>
                </c:pt>
                <c:pt idx="212">
                  <c:v>2</c:v>
                </c:pt>
                <c:pt idx="213">
                  <c:v>1</c:v>
                </c:pt>
                <c:pt idx="214">
                  <c:v>1</c:v>
                </c:pt>
                <c:pt idx="215">
                  <c:v>1</c:v>
                </c:pt>
                <c:pt idx="217">
                  <c:v>1</c:v>
                </c:pt>
                <c:pt idx="218">
                  <c:v>1</c:v>
                </c:pt>
                <c:pt idx="219">
                  <c:v>1</c:v>
                </c:pt>
                <c:pt idx="221">
                  <c:v>1</c:v>
                </c:pt>
                <c:pt idx="226">
                  <c:v>1</c:v>
                </c:pt>
                <c:pt idx="228">
                  <c:v>1</c:v>
                </c:pt>
                <c:pt idx="230">
                  <c:v>1</c:v>
                </c:pt>
                <c:pt idx="232">
                  <c:v>2</c:v>
                </c:pt>
                <c:pt idx="233">
                  <c:v>1</c:v>
                </c:pt>
                <c:pt idx="234">
                  <c:v>1</c:v>
                </c:pt>
                <c:pt idx="235">
                  <c:v>1</c:v>
                </c:pt>
                <c:pt idx="236">
                  <c:v>1</c:v>
                </c:pt>
                <c:pt idx="242">
                  <c:v>1</c:v>
                </c:pt>
                <c:pt idx="243">
                  <c:v>1</c:v>
                </c:pt>
                <c:pt idx="245">
                  <c:v>1</c:v>
                </c:pt>
                <c:pt idx="247">
                  <c:v>1</c:v>
                </c:pt>
                <c:pt idx="248">
                  <c:v>1</c:v>
                </c:pt>
                <c:pt idx="249">
                  <c:v>1</c:v>
                </c:pt>
                <c:pt idx="250">
                  <c:v>1</c:v>
                </c:pt>
                <c:pt idx="251">
                  <c:v>1</c:v>
                </c:pt>
                <c:pt idx="252">
                  <c:v>1</c:v>
                </c:pt>
                <c:pt idx="254">
                  <c:v>1</c:v>
                </c:pt>
                <c:pt idx="256">
                  <c:v>1</c:v>
                </c:pt>
                <c:pt idx="258">
                  <c:v>1</c:v>
                </c:pt>
                <c:pt idx="259">
                  <c:v>1</c:v>
                </c:pt>
                <c:pt idx="262">
                  <c:v>1</c:v>
                </c:pt>
                <c:pt idx="264">
                  <c:v>1</c:v>
                </c:pt>
                <c:pt idx="265">
                  <c:v>1</c:v>
                </c:pt>
                <c:pt idx="267">
                  <c:v>1</c:v>
                </c:pt>
                <c:pt idx="268">
                  <c:v>1</c:v>
                </c:pt>
                <c:pt idx="271">
                  <c:v>1</c:v>
                </c:pt>
                <c:pt idx="275">
                  <c:v>1</c:v>
                </c:pt>
                <c:pt idx="278">
                  <c:v>1</c:v>
                </c:pt>
                <c:pt idx="279">
                  <c:v>1</c:v>
                </c:pt>
                <c:pt idx="280">
                  <c:v>1</c:v>
                </c:pt>
                <c:pt idx="286">
                  <c:v>1</c:v>
                </c:pt>
                <c:pt idx="288">
                  <c:v>1</c:v>
                </c:pt>
                <c:pt idx="290">
                  <c:v>1</c:v>
                </c:pt>
                <c:pt idx="293">
                  <c:v>1</c:v>
                </c:pt>
                <c:pt idx="294">
                  <c:v>1</c:v>
                </c:pt>
                <c:pt idx="296">
                  <c:v>1</c:v>
                </c:pt>
                <c:pt idx="298">
                  <c:v>1</c:v>
                </c:pt>
                <c:pt idx="299">
                  <c:v>1</c:v>
                </c:pt>
                <c:pt idx="302">
                  <c:v>1</c:v>
                </c:pt>
                <c:pt idx="303">
                  <c:v>1</c:v>
                </c:pt>
                <c:pt idx="304">
                  <c:v>1</c:v>
                </c:pt>
                <c:pt idx="305">
                  <c:v>1</c:v>
                </c:pt>
                <c:pt idx="306">
                  <c:v>1</c:v>
                </c:pt>
                <c:pt idx="308">
                  <c:v>1</c:v>
                </c:pt>
                <c:pt idx="309">
                  <c:v>1</c:v>
                </c:pt>
                <c:pt idx="313">
                  <c:v>1</c:v>
                </c:pt>
                <c:pt idx="316">
                  <c:v>1</c:v>
                </c:pt>
                <c:pt idx="317">
                  <c:v>1</c:v>
                </c:pt>
                <c:pt idx="318">
                  <c:v>1</c:v>
                </c:pt>
                <c:pt idx="322">
                  <c:v>1</c:v>
                </c:pt>
                <c:pt idx="323">
                  <c:v>1</c:v>
                </c:pt>
                <c:pt idx="325">
                  <c:v>1</c:v>
                </c:pt>
                <c:pt idx="327">
                  <c:v>2</c:v>
                </c:pt>
                <c:pt idx="329">
                  <c:v>1</c:v>
                </c:pt>
                <c:pt idx="330">
                  <c:v>1</c:v>
                </c:pt>
                <c:pt idx="331">
                  <c:v>1</c:v>
                </c:pt>
                <c:pt idx="335">
                  <c:v>1</c:v>
                </c:pt>
                <c:pt idx="340">
                  <c:v>1</c:v>
                </c:pt>
                <c:pt idx="341">
                  <c:v>1</c:v>
                </c:pt>
                <c:pt idx="342">
                  <c:v>1</c:v>
                </c:pt>
                <c:pt idx="344">
                  <c:v>1</c:v>
                </c:pt>
                <c:pt idx="349">
                  <c:v>1</c:v>
                </c:pt>
                <c:pt idx="353">
                  <c:v>1</c:v>
                </c:pt>
                <c:pt idx="354">
                  <c:v>1</c:v>
                </c:pt>
                <c:pt idx="355">
                  <c:v>1</c:v>
                </c:pt>
                <c:pt idx="359">
                  <c:v>3</c:v>
                </c:pt>
                <c:pt idx="360">
                  <c:v>1</c:v>
                </c:pt>
                <c:pt idx="362">
                  <c:v>1</c:v>
                </c:pt>
                <c:pt idx="365">
                  <c:v>1</c:v>
                </c:pt>
                <c:pt idx="366">
                  <c:v>1</c:v>
                </c:pt>
                <c:pt idx="367">
                  <c:v>1</c:v>
                </c:pt>
                <c:pt idx="370">
                  <c:v>1</c:v>
                </c:pt>
                <c:pt idx="375">
                  <c:v>1</c:v>
                </c:pt>
                <c:pt idx="376">
                  <c:v>1</c:v>
                </c:pt>
                <c:pt idx="377">
                  <c:v>1</c:v>
                </c:pt>
                <c:pt idx="379">
                  <c:v>1</c:v>
                </c:pt>
                <c:pt idx="382">
                  <c:v>1</c:v>
                </c:pt>
                <c:pt idx="383">
                  <c:v>1</c:v>
                </c:pt>
                <c:pt idx="384">
                  <c:v>2</c:v>
                </c:pt>
                <c:pt idx="386">
                  <c:v>1</c:v>
                </c:pt>
                <c:pt idx="387">
                  <c:v>1</c:v>
                </c:pt>
                <c:pt idx="389">
                  <c:v>1</c:v>
                </c:pt>
                <c:pt idx="390">
                  <c:v>1</c:v>
                </c:pt>
                <c:pt idx="391">
                  <c:v>1</c:v>
                </c:pt>
                <c:pt idx="396">
                  <c:v>3</c:v>
                </c:pt>
                <c:pt idx="398">
                  <c:v>1</c:v>
                </c:pt>
                <c:pt idx="401">
                  <c:v>1</c:v>
                </c:pt>
                <c:pt idx="406">
                  <c:v>1</c:v>
                </c:pt>
                <c:pt idx="407">
                  <c:v>1</c:v>
                </c:pt>
                <c:pt idx="410">
                  <c:v>1</c:v>
                </c:pt>
                <c:pt idx="413">
                  <c:v>1</c:v>
                </c:pt>
                <c:pt idx="418">
                  <c:v>1</c:v>
                </c:pt>
                <c:pt idx="420">
                  <c:v>1</c:v>
                </c:pt>
                <c:pt idx="421">
                  <c:v>1</c:v>
                </c:pt>
                <c:pt idx="422">
                  <c:v>15</c:v>
                </c:pt>
                <c:pt idx="425">
                  <c:v>1</c:v>
                </c:pt>
                <c:pt idx="426">
                  <c:v>1</c:v>
                </c:pt>
                <c:pt idx="431">
                  <c:v>1</c:v>
                </c:pt>
                <c:pt idx="432">
                  <c:v>1</c:v>
                </c:pt>
                <c:pt idx="438">
                  <c:v>1</c:v>
                </c:pt>
                <c:pt idx="440">
                  <c:v>2</c:v>
                </c:pt>
                <c:pt idx="442">
                  <c:v>2</c:v>
                </c:pt>
                <c:pt idx="444">
                  <c:v>1</c:v>
                </c:pt>
                <c:pt idx="446">
                  <c:v>1</c:v>
                </c:pt>
                <c:pt idx="449">
                  <c:v>1</c:v>
                </c:pt>
                <c:pt idx="451">
                  <c:v>1</c:v>
                </c:pt>
                <c:pt idx="453">
                  <c:v>1</c:v>
                </c:pt>
                <c:pt idx="454">
                  <c:v>1</c:v>
                </c:pt>
                <c:pt idx="455">
                  <c:v>1</c:v>
                </c:pt>
                <c:pt idx="458">
                  <c:v>1</c:v>
                </c:pt>
                <c:pt idx="459">
                  <c:v>1</c:v>
                </c:pt>
                <c:pt idx="460">
                  <c:v>1</c:v>
                </c:pt>
                <c:pt idx="461">
                  <c:v>1</c:v>
                </c:pt>
                <c:pt idx="468">
                  <c:v>1</c:v>
                </c:pt>
                <c:pt idx="470">
                  <c:v>1</c:v>
                </c:pt>
                <c:pt idx="471">
                  <c:v>1</c:v>
                </c:pt>
                <c:pt idx="472">
                  <c:v>1</c:v>
                </c:pt>
                <c:pt idx="473">
                  <c:v>1</c:v>
                </c:pt>
                <c:pt idx="475">
                  <c:v>1</c:v>
                </c:pt>
                <c:pt idx="478">
                  <c:v>1</c:v>
                </c:pt>
                <c:pt idx="479">
                  <c:v>1</c:v>
                </c:pt>
                <c:pt idx="481">
                  <c:v>1</c:v>
                </c:pt>
                <c:pt idx="483">
                  <c:v>1</c:v>
                </c:pt>
                <c:pt idx="484">
                  <c:v>1</c:v>
                </c:pt>
                <c:pt idx="487">
                  <c:v>1</c:v>
                </c:pt>
                <c:pt idx="489">
                  <c:v>1</c:v>
                </c:pt>
                <c:pt idx="493">
                  <c:v>1</c:v>
                </c:pt>
                <c:pt idx="494">
                  <c:v>1</c:v>
                </c:pt>
                <c:pt idx="495">
                  <c:v>3</c:v>
                </c:pt>
                <c:pt idx="496">
                  <c:v>1</c:v>
                </c:pt>
                <c:pt idx="498">
                  <c:v>1</c:v>
                </c:pt>
                <c:pt idx="500">
                  <c:v>1</c:v>
                </c:pt>
                <c:pt idx="501">
                  <c:v>1</c:v>
                </c:pt>
                <c:pt idx="502">
                  <c:v>1</c:v>
                </c:pt>
                <c:pt idx="503">
                  <c:v>1</c:v>
                </c:pt>
                <c:pt idx="510">
                  <c:v>1</c:v>
                </c:pt>
                <c:pt idx="511">
                  <c:v>1</c:v>
                </c:pt>
                <c:pt idx="514">
                  <c:v>1</c:v>
                </c:pt>
                <c:pt idx="519">
                  <c:v>1</c:v>
                </c:pt>
                <c:pt idx="520">
                  <c:v>1</c:v>
                </c:pt>
                <c:pt idx="521">
                  <c:v>1</c:v>
                </c:pt>
                <c:pt idx="527">
                  <c:v>1</c:v>
                </c:pt>
                <c:pt idx="529">
                  <c:v>1</c:v>
                </c:pt>
                <c:pt idx="537">
                  <c:v>1</c:v>
                </c:pt>
                <c:pt idx="541">
                  <c:v>1</c:v>
                </c:pt>
                <c:pt idx="546">
                  <c:v>1</c:v>
                </c:pt>
                <c:pt idx="547">
                  <c:v>1</c:v>
                </c:pt>
                <c:pt idx="548">
                  <c:v>1</c:v>
                </c:pt>
                <c:pt idx="549">
                  <c:v>1</c:v>
                </c:pt>
                <c:pt idx="552">
                  <c:v>1</c:v>
                </c:pt>
                <c:pt idx="553">
                  <c:v>1</c:v>
                </c:pt>
                <c:pt idx="560">
                  <c:v>1</c:v>
                </c:pt>
                <c:pt idx="562">
                  <c:v>1</c:v>
                </c:pt>
                <c:pt idx="563">
                  <c:v>1</c:v>
                </c:pt>
                <c:pt idx="565">
                  <c:v>1</c:v>
                </c:pt>
                <c:pt idx="566">
                  <c:v>1</c:v>
                </c:pt>
                <c:pt idx="567">
                  <c:v>1</c:v>
                </c:pt>
                <c:pt idx="570">
                  <c:v>1</c:v>
                </c:pt>
                <c:pt idx="575">
                  <c:v>1</c:v>
                </c:pt>
                <c:pt idx="576">
                  <c:v>1</c:v>
                </c:pt>
                <c:pt idx="579">
                  <c:v>1</c:v>
                </c:pt>
                <c:pt idx="586">
                  <c:v>1</c:v>
                </c:pt>
                <c:pt idx="589">
                  <c:v>1</c:v>
                </c:pt>
                <c:pt idx="591">
                  <c:v>1</c:v>
                </c:pt>
                <c:pt idx="592">
                  <c:v>1</c:v>
                </c:pt>
                <c:pt idx="593">
                  <c:v>1</c:v>
                </c:pt>
                <c:pt idx="596">
                  <c:v>1</c:v>
                </c:pt>
                <c:pt idx="600">
                  <c:v>1</c:v>
                </c:pt>
                <c:pt idx="606">
                  <c:v>1</c:v>
                </c:pt>
                <c:pt idx="607">
                  <c:v>1</c:v>
                </c:pt>
                <c:pt idx="608">
                  <c:v>1</c:v>
                </c:pt>
                <c:pt idx="609">
                  <c:v>1</c:v>
                </c:pt>
                <c:pt idx="611">
                  <c:v>1</c:v>
                </c:pt>
                <c:pt idx="613">
                  <c:v>1</c:v>
                </c:pt>
                <c:pt idx="616">
                  <c:v>1</c:v>
                </c:pt>
                <c:pt idx="617">
                  <c:v>1</c:v>
                </c:pt>
                <c:pt idx="619">
                  <c:v>1</c:v>
                </c:pt>
                <c:pt idx="621">
                  <c:v>1</c:v>
                </c:pt>
                <c:pt idx="626">
                  <c:v>1</c:v>
                </c:pt>
                <c:pt idx="627">
                  <c:v>1</c:v>
                </c:pt>
                <c:pt idx="633">
                  <c:v>1</c:v>
                </c:pt>
                <c:pt idx="634">
                  <c:v>1</c:v>
                </c:pt>
                <c:pt idx="638">
                  <c:v>1</c:v>
                </c:pt>
                <c:pt idx="641">
                  <c:v>1</c:v>
                </c:pt>
                <c:pt idx="644">
                  <c:v>3</c:v>
                </c:pt>
                <c:pt idx="646">
                  <c:v>1</c:v>
                </c:pt>
                <c:pt idx="648">
                  <c:v>1</c:v>
                </c:pt>
                <c:pt idx="649">
                  <c:v>1</c:v>
                </c:pt>
                <c:pt idx="651">
                  <c:v>1</c:v>
                </c:pt>
                <c:pt idx="655">
                  <c:v>1</c:v>
                </c:pt>
                <c:pt idx="664">
                  <c:v>1</c:v>
                </c:pt>
                <c:pt idx="666">
                  <c:v>1</c:v>
                </c:pt>
                <c:pt idx="671">
                  <c:v>1</c:v>
                </c:pt>
                <c:pt idx="672">
                  <c:v>1</c:v>
                </c:pt>
                <c:pt idx="675">
                  <c:v>1</c:v>
                </c:pt>
                <c:pt idx="676">
                  <c:v>1</c:v>
                </c:pt>
                <c:pt idx="677">
                  <c:v>1</c:v>
                </c:pt>
                <c:pt idx="679">
                  <c:v>1</c:v>
                </c:pt>
                <c:pt idx="684">
                  <c:v>1</c:v>
                </c:pt>
                <c:pt idx="686">
                  <c:v>1</c:v>
                </c:pt>
                <c:pt idx="687">
                  <c:v>1</c:v>
                </c:pt>
                <c:pt idx="689">
                  <c:v>1</c:v>
                </c:pt>
                <c:pt idx="694">
                  <c:v>1</c:v>
                </c:pt>
                <c:pt idx="696">
                  <c:v>1</c:v>
                </c:pt>
                <c:pt idx="697">
                  <c:v>1</c:v>
                </c:pt>
                <c:pt idx="699">
                  <c:v>1</c:v>
                </c:pt>
                <c:pt idx="700">
                  <c:v>1</c:v>
                </c:pt>
                <c:pt idx="702">
                  <c:v>1</c:v>
                </c:pt>
                <c:pt idx="706">
                  <c:v>1</c:v>
                </c:pt>
                <c:pt idx="707">
                  <c:v>1</c:v>
                </c:pt>
                <c:pt idx="708">
                  <c:v>1</c:v>
                </c:pt>
                <c:pt idx="710">
                  <c:v>6</c:v>
                </c:pt>
                <c:pt idx="712">
                  <c:v>1</c:v>
                </c:pt>
                <c:pt idx="717">
                  <c:v>1</c:v>
                </c:pt>
                <c:pt idx="721">
                  <c:v>1</c:v>
                </c:pt>
                <c:pt idx="724">
                  <c:v>1</c:v>
                </c:pt>
                <c:pt idx="725">
                  <c:v>1</c:v>
                </c:pt>
                <c:pt idx="727">
                  <c:v>1</c:v>
                </c:pt>
                <c:pt idx="730">
                  <c:v>1</c:v>
                </c:pt>
                <c:pt idx="733">
                  <c:v>1</c:v>
                </c:pt>
                <c:pt idx="735">
                  <c:v>1</c:v>
                </c:pt>
                <c:pt idx="736">
                  <c:v>1</c:v>
                </c:pt>
                <c:pt idx="737">
                  <c:v>1</c:v>
                </c:pt>
                <c:pt idx="740">
                  <c:v>1</c:v>
                </c:pt>
                <c:pt idx="741">
                  <c:v>1</c:v>
                </c:pt>
                <c:pt idx="743">
                  <c:v>1</c:v>
                </c:pt>
                <c:pt idx="747">
                  <c:v>1</c:v>
                </c:pt>
                <c:pt idx="752">
                  <c:v>7</c:v>
                </c:pt>
                <c:pt idx="755">
                  <c:v>1</c:v>
                </c:pt>
                <c:pt idx="756">
                  <c:v>1</c:v>
                </c:pt>
                <c:pt idx="757">
                  <c:v>1</c:v>
                </c:pt>
                <c:pt idx="760">
                  <c:v>1</c:v>
                </c:pt>
                <c:pt idx="761">
                  <c:v>7</c:v>
                </c:pt>
                <c:pt idx="764">
                  <c:v>1</c:v>
                </c:pt>
                <c:pt idx="766">
                  <c:v>1</c:v>
                </c:pt>
                <c:pt idx="767">
                  <c:v>1</c:v>
                </c:pt>
                <c:pt idx="768">
                  <c:v>1</c:v>
                </c:pt>
                <c:pt idx="770">
                  <c:v>1</c:v>
                </c:pt>
                <c:pt idx="771">
                  <c:v>1</c:v>
                </c:pt>
                <c:pt idx="778">
                  <c:v>1</c:v>
                </c:pt>
                <c:pt idx="779">
                  <c:v>1</c:v>
                </c:pt>
                <c:pt idx="780">
                  <c:v>3</c:v>
                </c:pt>
                <c:pt idx="781">
                  <c:v>1</c:v>
                </c:pt>
                <c:pt idx="782">
                  <c:v>1</c:v>
                </c:pt>
                <c:pt idx="785">
                  <c:v>1</c:v>
                </c:pt>
                <c:pt idx="787">
                  <c:v>1</c:v>
                </c:pt>
                <c:pt idx="788">
                  <c:v>1</c:v>
                </c:pt>
                <c:pt idx="789">
                  <c:v>1</c:v>
                </c:pt>
                <c:pt idx="790">
                  <c:v>1</c:v>
                </c:pt>
                <c:pt idx="793">
                  <c:v>1</c:v>
                </c:pt>
                <c:pt idx="794">
                  <c:v>1</c:v>
                </c:pt>
                <c:pt idx="795">
                  <c:v>1</c:v>
                </c:pt>
                <c:pt idx="796">
                  <c:v>1</c:v>
                </c:pt>
                <c:pt idx="798">
                  <c:v>1</c:v>
                </c:pt>
                <c:pt idx="799">
                  <c:v>1</c:v>
                </c:pt>
                <c:pt idx="800">
                  <c:v>1</c:v>
                </c:pt>
                <c:pt idx="802">
                  <c:v>1</c:v>
                </c:pt>
                <c:pt idx="803">
                  <c:v>1</c:v>
                </c:pt>
                <c:pt idx="806">
                  <c:v>1</c:v>
                </c:pt>
                <c:pt idx="813">
                  <c:v>6</c:v>
                </c:pt>
                <c:pt idx="814">
                  <c:v>1</c:v>
                </c:pt>
                <c:pt idx="816">
                  <c:v>1</c:v>
                </c:pt>
                <c:pt idx="817">
                  <c:v>1</c:v>
                </c:pt>
                <c:pt idx="818">
                  <c:v>1</c:v>
                </c:pt>
                <c:pt idx="819">
                  <c:v>1</c:v>
                </c:pt>
                <c:pt idx="820">
                  <c:v>1</c:v>
                </c:pt>
                <c:pt idx="822">
                  <c:v>1</c:v>
                </c:pt>
                <c:pt idx="828">
                  <c:v>1</c:v>
                </c:pt>
                <c:pt idx="829">
                  <c:v>1</c:v>
                </c:pt>
                <c:pt idx="830">
                  <c:v>1</c:v>
                </c:pt>
                <c:pt idx="834">
                  <c:v>1</c:v>
                </c:pt>
                <c:pt idx="835">
                  <c:v>1</c:v>
                </c:pt>
                <c:pt idx="837">
                  <c:v>1</c:v>
                </c:pt>
                <c:pt idx="839">
                  <c:v>1</c:v>
                </c:pt>
                <c:pt idx="840">
                  <c:v>1</c:v>
                </c:pt>
                <c:pt idx="841">
                  <c:v>1</c:v>
                </c:pt>
                <c:pt idx="842">
                  <c:v>1</c:v>
                </c:pt>
                <c:pt idx="844">
                  <c:v>1</c:v>
                </c:pt>
                <c:pt idx="845">
                  <c:v>1</c:v>
                </c:pt>
                <c:pt idx="848">
                  <c:v>1</c:v>
                </c:pt>
                <c:pt idx="849">
                  <c:v>1</c:v>
                </c:pt>
                <c:pt idx="851">
                  <c:v>1</c:v>
                </c:pt>
                <c:pt idx="852">
                  <c:v>1</c:v>
                </c:pt>
                <c:pt idx="854">
                  <c:v>1</c:v>
                </c:pt>
                <c:pt idx="855">
                  <c:v>1</c:v>
                </c:pt>
                <c:pt idx="856">
                  <c:v>1</c:v>
                </c:pt>
                <c:pt idx="860">
                  <c:v>1</c:v>
                </c:pt>
                <c:pt idx="861">
                  <c:v>1</c:v>
                </c:pt>
                <c:pt idx="862">
                  <c:v>1</c:v>
                </c:pt>
                <c:pt idx="863">
                  <c:v>1</c:v>
                </c:pt>
                <c:pt idx="864">
                  <c:v>1</c:v>
                </c:pt>
                <c:pt idx="865">
                  <c:v>1</c:v>
                </c:pt>
                <c:pt idx="866">
                  <c:v>1</c:v>
                </c:pt>
                <c:pt idx="869">
                  <c:v>1</c:v>
                </c:pt>
                <c:pt idx="872">
                  <c:v>1</c:v>
                </c:pt>
                <c:pt idx="878">
                  <c:v>1</c:v>
                </c:pt>
                <c:pt idx="879">
                  <c:v>1</c:v>
                </c:pt>
                <c:pt idx="882">
                  <c:v>1</c:v>
                </c:pt>
                <c:pt idx="887">
                  <c:v>2</c:v>
                </c:pt>
                <c:pt idx="888">
                  <c:v>1</c:v>
                </c:pt>
                <c:pt idx="889">
                  <c:v>1</c:v>
                </c:pt>
                <c:pt idx="890">
                  <c:v>1</c:v>
                </c:pt>
                <c:pt idx="891">
                  <c:v>1</c:v>
                </c:pt>
                <c:pt idx="893">
                  <c:v>1</c:v>
                </c:pt>
                <c:pt idx="895">
                  <c:v>1</c:v>
                </c:pt>
                <c:pt idx="896">
                  <c:v>1</c:v>
                </c:pt>
                <c:pt idx="898">
                  <c:v>1</c:v>
                </c:pt>
                <c:pt idx="899">
                  <c:v>1</c:v>
                </c:pt>
                <c:pt idx="907">
                  <c:v>1</c:v>
                </c:pt>
                <c:pt idx="908">
                  <c:v>1</c:v>
                </c:pt>
                <c:pt idx="915">
                  <c:v>1</c:v>
                </c:pt>
                <c:pt idx="916">
                  <c:v>1</c:v>
                </c:pt>
                <c:pt idx="917">
                  <c:v>1</c:v>
                </c:pt>
                <c:pt idx="919">
                  <c:v>1</c:v>
                </c:pt>
                <c:pt idx="924">
                  <c:v>1</c:v>
                </c:pt>
                <c:pt idx="928">
                  <c:v>1</c:v>
                </c:pt>
                <c:pt idx="929">
                  <c:v>1</c:v>
                </c:pt>
                <c:pt idx="930">
                  <c:v>1</c:v>
                </c:pt>
                <c:pt idx="933">
                  <c:v>1</c:v>
                </c:pt>
                <c:pt idx="934">
                  <c:v>1</c:v>
                </c:pt>
                <c:pt idx="935">
                  <c:v>1</c:v>
                </c:pt>
                <c:pt idx="936">
                  <c:v>1</c:v>
                </c:pt>
                <c:pt idx="941">
                  <c:v>1</c:v>
                </c:pt>
                <c:pt idx="943">
                  <c:v>1</c:v>
                </c:pt>
                <c:pt idx="944">
                  <c:v>1</c:v>
                </c:pt>
                <c:pt idx="945">
                  <c:v>1</c:v>
                </c:pt>
                <c:pt idx="947">
                  <c:v>2</c:v>
                </c:pt>
                <c:pt idx="948">
                  <c:v>1</c:v>
                </c:pt>
                <c:pt idx="949">
                  <c:v>1</c:v>
                </c:pt>
                <c:pt idx="950">
                  <c:v>1</c:v>
                </c:pt>
                <c:pt idx="951">
                  <c:v>1</c:v>
                </c:pt>
                <c:pt idx="954">
                  <c:v>1</c:v>
                </c:pt>
                <c:pt idx="955">
                  <c:v>1</c:v>
                </c:pt>
                <c:pt idx="956">
                  <c:v>1</c:v>
                </c:pt>
                <c:pt idx="957">
                  <c:v>2</c:v>
                </c:pt>
                <c:pt idx="958">
                  <c:v>1</c:v>
                </c:pt>
                <c:pt idx="960">
                  <c:v>1</c:v>
                </c:pt>
                <c:pt idx="965">
                  <c:v>1</c:v>
                </c:pt>
                <c:pt idx="973">
                  <c:v>1</c:v>
                </c:pt>
                <c:pt idx="976">
                  <c:v>1</c:v>
                </c:pt>
                <c:pt idx="978">
                  <c:v>1</c:v>
                </c:pt>
                <c:pt idx="982">
                  <c:v>1</c:v>
                </c:pt>
                <c:pt idx="984">
                  <c:v>1</c:v>
                </c:pt>
                <c:pt idx="985">
                  <c:v>1</c:v>
                </c:pt>
                <c:pt idx="987">
                  <c:v>1</c:v>
                </c:pt>
                <c:pt idx="988">
                  <c:v>1</c:v>
                </c:pt>
                <c:pt idx="991">
                  <c:v>1</c:v>
                </c:pt>
                <c:pt idx="993">
                  <c:v>1</c:v>
                </c:pt>
                <c:pt idx="995">
                  <c:v>1</c:v>
                </c:pt>
              </c:numCache>
            </c:numRef>
          </c:yVal>
          <c:smooth val="0"/>
        </c:ser>
        <c:dLbls>
          <c:showLegendKey val="0"/>
          <c:showVal val="0"/>
          <c:showCatName val="0"/>
          <c:showSerName val="0"/>
          <c:showPercent val="0"/>
          <c:showBubbleSize val="0"/>
        </c:dLbls>
        <c:axId val="420210480"/>
        <c:axId val="526696368"/>
        <c:extLst>
          <c:ext xmlns:c15="http://schemas.microsoft.com/office/drawing/2012/chart" uri="{02D57815-91ED-43cb-92C2-25804820EDAC}">
            <c15:filteredScatterSeries>
              <c15:ser>
                <c:idx val="0"/>
                <c:order val="0"/>
                <c:tx>
                  <c:strRef>
                    <c:extLst>
                      <c:ext uri="{02D57815-91ED-43cb-92C2-25804820EDAC}">
                        <c15:formulaRef>
                          <c15:sqref>AGO1a!$C$1</c15:sqref>
                        </c15:formulaRef>
                      </c:ext>
                    </c:extLst>
                    <c:strCache>
                      <c:ptCount val="1"/>
                      <c:pt idx="0">
                        <c:v>BDI283cDNA_tplot</c:v>
                      </c:pt>
                    </c:strCache>
                  </c:strRef>
                </c:tx>
                <c:spPr>
                  <a:ln w="19050" cap="rnd">
                    <a:noFill/>
                    <a:round/>
                  </a:ln>
                  <a:effectLst/>
                </c:spPr>
                <c:marker>
                  <c:symbol val="circle"/>
                  <c:size val="5"/>
                  <c:spPr>
                    <a:solidFill>
                      <a:schemeClr val="accent1"/>
                    </a:solidFill>
                    <a:ln w="9525">
                      <a:solidFill>
                        <a:schemeClr val="accent1"/>
                      </a:solidFill>
                    </a:ln>
                    <a:effectLst/>
                  </c:spPr>
                </c:marker>
                <c:xVal>
                  <c:numRef>
                    <c:extLst>
                      <c:ext uri="{02D57815-91ED-43cb-92C2-25804820EDAC}">
                        <c15:formulaRef>
                          <c15:sqref>AGO1a!$B$2:$B$1002</c15:sqref>
                        </c15:formulaRef>
                      </c:ext>
                    </c:extLst>
                    <c:numCache>
                      <c:formatCode>General</c:formatCode>
                      <c:ptCount val="1001"/>
                      <c:pt idx="0">
                        <c:v>3583</c:v>
                      </c:pt>
                      <c:pt idx="1">
                        <c:v>2443</c:v>
                      </c:pt>
                      <c:pt idx="2">
                        <c:v>2713</c:v>
                      </c:pt>
                      <c:pt idx="3">
                        <c:v>3344</c:v>
                      </c:pt>
                      <c:pt idx="4">
                        <c:v>2251</c:v>
                      </c:pt>
                      <c:pt idx="5">
                        <c:v>3693</c:v>
                      </c:pt>
                      <c:pt idx="6">
                        <c:v>1477</c:v>
                      </c:pt>
                      <c:pt idx="7">
                        <c:v>3872</c:v>
                      </c:pt>
                      <c:pt idx="8">
                        <c:v>3871</c:v>
                      </c:pt>
                      <c:pt idx="9">
                        <c:v>3404</c:v>
                      </c:pt>
                      <c:pt idx="10">
                        <c:v>2409</c:v>
                      </c:pt>
                      <c:pt idx="11">
                        <c:v>3714</c:v>
                      </c:pt>
                      <c:pt idx="12">
                        <c:v>1420</c:v>
                      </c:pt>
                      <c:pt idx="13">
                        <c:v>3967</c:v>
                      </c:pt>
                      <c:pt idx="14">
                        <c:v>2893</c:v>
                      </c:pt>
                      <c:pt idx="15">
                        <c:v>3641</c:v>
                      </c:pt>
                      <c:pt idx="16">
                        <c:v>3271</c:v>
                      </c:pt>
                      <c:pt idx="17">
                        <c:v>2641</c:v>
                      </c:pt>
                      <c:pt idx="18">
                        <c:v>3549</c:v>
                      </c:pt>
                      <c:pt idx="19">
                        <c:v>1941</c:v>
                      </c:pt>
                      <c:pt idx="20">
                        <c:v>2664</c:v>
                      </c:pt>
                      <c:pt idx="21">
                        <c:v>3924</c:v>
                      </c:pt>
                      <c:pt idx="22">
                        <c:v>3707</c:v>
                      </c:pt>
                      <c:pt idx="23">
                        <c:v>2278</c:v>
                      </c:pt>
                      <c:pt idx="24">
                        <c:v>3457</c:v>
                      </c:pt>
                      <c:pt idx="25">
                        <c:v>3546</c:v>
                      </c:pt>
                      <c:pt idx="26">
                        <c:v>3319</c:v>
                      </c:pt>
                      <c:pt idx="27">
                        <c:v>2821</c:v>
                      </c:pt>
                      <c:pt idx="28">
                        <c:v>2403</c:v>
                      </c:pt>
                      <c:pt idx="29">
                        <c:v>864</c:v>
                      </c:pt>
                      <c:pt idx="30">
                        <c:v>1729</c:v>
                      </c:pt>
                      <c:pt idx="31">
                        <c:v>3322</c:v>
                      </c:pt>
                      <c:pt idx="32">
                        <c:v>3378</c:v>
                      </c:pt>
                      <c:pt idx="33">
                        <c:v>3633</c:v>
                      </c:pt>
                      <c:pt idx="34">
                        <c:v>3579</c:v>
                      </c:pt>
                      <c:pt idx="35">
                        <c:v>2054</c:v>
                      </c:pt>
                      <c:pt idx="36">
                        <c:v>2164</c:v>
                      </c:pt>
                      <c:pt idx="37">
                        <c:v>2766</c:v>
                      </c:pt>
                      <c:pt idx="38">
                        <c:v>3688</c:v>
                      </c:pt>
                      <c:pt idx="39">
                        <c:v>4050</c:v>
                      </c:pt>
                      <c:pt idx="40">
                        <c:v>3248</c:v>
                      </c:pt>
                      <c:pt idx="41">
                        <c:v>2981</c:v>
                      </c:pt>
                      <c:pt idx="42">
                        <c:v>2548</c:v>
                      </c:pt>
                      <c:pt idx="43">
                        <c:v>3840</c:v>
                      </c:pt>
                      <c:pt idx="44">
                        <c:v>3954</c:v>
                      </c:pt>
                      <c:pt idx="45">
                        <c:v>868</c:v>
                      </c:pt>
                      <c:pt idx="46">
                        <c:v>3818</c:v>
                      </c:pt>
                      <c:pt idx="47">
                        <c:v>3735</c:v>
                      </c:pt>
                      <c:pt idx="48">
                        <c:v>2999</c:v>
                      </c:pt>
                      <c:pt idx="49">
                        <c:v>3475</c:v>
                      </c:pt>
                      <c:pt idx="50">
                        <c:v>2720</c:v>
                      </c:pt>
                      <c:pt idx="51">
                        <c:v>3933</c:v>
                      </c:pt>
                      <c:pt idx="52">
                        <c:v>3622</c:v>
                      </c:pt>
                      <c:pt idx="53">
                        <c:v>3934</c:v>
                      </c:pt>
                      <c:pt idx="54">
                        <c:v>3075</c:v>
                      </c:pt>
                      <c:pt idx="55">
                        <c:v>2114</c:v>
                      </c:pt>
                      <c:pt idx="56">
                        <c:v>3931</c:v>
                      </c:pt>
                      <c:pt idx="57">
                        <c:v>2386</c:v>
                      </c:pt>
                      <c:pt idx="58">
                        <c:v>3576</c:v>
                      </c:pt>
                      <c:pt idx="59">
                        <c:v>3674</c:v>
                      </c:pt>
                      <c:pt idx="60">
                        <c:v>3507</c:v>
                      </c:pt>
                      <c:pt idx="61">
                        <c:v>3648</c:v>
                      </c:pt>
                      <c:pt idx="62">
                        <c:v>3848</c:v>
                      </c:pt>
                      <c:pt idx="63">
                        <c:v>1032</c:v>
                      </c:pt>
                      <c:pt idx="64">
                        <c:v>3014</c:v>
                      </c:pt>
                      <c:pt idx="65">
                        <c:v>2057</c:v>
                      </c:pt>
                      <c:pt idx="66">
                        <c:v>3037</c:v>
                      </c:pt>
                      <c:pt idx="67">
                        <c:v>3917</c:v>
                      </c:pt>
                      <c:pt idx="68">
                        <c:v>3022</c:v>
                      </c:pt>
                      <c:pt idx="69">
                        <c:v>2250</c:v>
                      </c:pt>
                      <c:pt idx="70">
                        <c:v>4017</c:v>
                      </c:pt>
                      <c:pt idx="71">
                        <c:v>4006</c:v>
                      </c:pt>
                      <c:pt idx="72">
                        <c:v>2552</c:v>
                      </c:pt>
                      <c:pt idx="73">
                        <c:v>3906</c:v>
                      </c:pt>
                      <c:pt idx="74">
                        <c:v>2212</c:v>
                      </c:pt>
                      <c:pt idx="75">
                        <c:v>4023</c:v>
                      </c:pt>
                      <c:pt idx="76">
                        <c:v>2656</c:v>
                      </c:pt>
                      <c:pt idx="77">
                        <c:v>3199</c:v>
                      </c:pt>
                      <c:pt idx="78">
                        <c:v>2774</c:v>
                      </c:pt>
                      <c:pt idx="79">
                        <c:v>3592</c:v>
                      </c:pt>
                      <c:pt idx="80">
                        <c:v>2938</c:v>
                      </c:pt>
                      <c:pt idx="81">
                        <c:v>2330</c:v>
                      </c:pt>
                      <c:pt idx="82">
                        <c:v>1395</c:v>
                      </c:pt>
                      <c:pt idx="83">
                        <c:v>2375</c:v>
                      </c:pt>
                      <c:pt idx="84">
                        <c:v>3621</c:v>
                      </c:pt>
                      <c:pt idx="85">
                        <c:v>3398</c:v>
                      </c:pt>
                      <c:pt idx="86">
                        <c:v>3333</c:v>
                      </c:pt>
                      <c:pt idx="87">
                        <c:v>3461</c:v>
                      </c:pt>
                      <c:pt idx="88">
                        <c:v>3150</c:v>
                      </c:pt>
                      <c:pt idx="89">
                        <c:v>3032</c:v>
                      </c:pt>
                      <c:pt idx="90">
                        <c:v>1185</c:v>
                      </c:pt>
                      <c:pt idx="91">
                        <c:v>3625</c:v>
                      </c:pt>
                      <c:pt idx="92">
                        <c:v>2949</c:v>
                      </c:pt>
                      <c:pt idx="93">
                        <c:v>3888</c:v>
                      </c:pt>
                      <c:pt idx="94">
                        <c:v>2945</c:v>
                      </c:pt>
                      <c:pt idx="95">
                        <c:v>4029</c:v>
                      </c:pt>
                      <c:pt idx="96">
                        <c:v>2906</c:v>
                      </c:pt>
                      <c:pt idx="97">
                        <c:v>3158</c:v>
                      </c:pt>
                      <c:pt idx="98">
                        <c:v>2327</c:v>
                      </c:pt>
                      <c:pt idx="99">
                        <c:v>1654</c:v>
                      </c:pt>
                      <c:pt idx="100">
                        <c:v>3105</c:v>
                      </c:pt>
                      <c:pt idx="101">
                        <c:v>3309</c:v>
                      </c:pt>
                      <c:pt idx="102">
                        <c:v>1422</c:v>
                      </c:pt>
                      <c:pt idx="103">
                        <c:v>1826</c:v>
                      </c:pt>
                      <c:pt idx="104">
                        <c:v>2901</c:v>
                      </c:pt>
                      <c:pt idx="105">
                        <c:v>3732</c:v>
                      </c:pt>
                      <c:pt idx="106">
                        <c:v>1930</c:v>
                      </c:pt>
                      <c:pt idx="107">
                        <c:v>3300</c:v>
                      </c:pt>
                      <c:pt idx="108">
                        <c:v>1444</c:v>
                      </c:pt>
                      <c:pt idx="109">
                        <c:v>1914</c:v>
                      </c:pt>
                      <c:pt idx="110">
                        <c:v>1805</c:v>
                      </c:pt>
                      <c:pt idx="111">
                        <c:v>1598</c:v>
                      </c:pt>
                      <c:pt idx="112">
                        <c:v>2016</c:v>
                      </c:pt>
                      <c:pt idx="113">
                        <c:v>2500</c:v>
                      </c:pt>
                      <c:pt idx="114">
                        <c:v>3569</c:v>
                      </c:pt>
                      <c:pt idx="115">
                        <c:v>3005</c:v>
                      </c:pt>
                      <c:pt idx="116">
                        <c:v>3405</c:v>
                      </c:pt>
                      <c:pt idx="117">
                        <c:v>1966</c:v>
                      </c:pt>
                      <c:pt idx="118">
                        <c:v>1820</c:v>
                      </c:pt>
                      <c:pt idx="119">
                        <c:v>2137</c:v>
                      </c:pt>
                      <c:pt idx="120">
                        <c:v>3388</c:v>
                      </c:pt>
                      <c:pt idx="121">
                        <c:v>1040</c:v>
                      </c:pt>
                      <c:pt idx="122">
                        <c:v>3997</c:v>
                      </c:pt>
                      <c:pt idx="123">
                        <c:v>1666</c:v>
                      </c:pt>
                      <c:pt idx="124">
                        <c:v>1973</c:v>
                      </c:pt>
                      <c:pt idx="125">
                        <c:v>3317</c:v>
                      </c:pt>
                      <c:pt idx="126">
                        <c:v>2787</c:v>
                      </c:pt>
                      <c:pt idx="127">
                        <c:v>2692</c:v>
                      </c:pt>
                      <c:pt idx="128">
                        <c:v>3096</c:v>
                      </c:pt>
                      <c:pt idx="129">
                        <c:v>3273</c:v>
                      </c:pt>
                      <c:pt idx="130">
                        <c:v>2382</c:v>
                      </c:pt>
                      <c:pt idx="131">
                        <c:v>3899</c:v>
                      </c:pt>
                      <c:pt idx="132">
                        <c:v>4022</c:v>
                      </c:pt>
                      <c:pt idx="133">
                        <c:v>2071</c:v>
                      </c:pt>
                      <c:pt idx="134">
                        <c:v>2063</c:v>
                      </c:pt>
                      <c:pt idx="135">
                        <c:v>2136</c:v>
                      </c:pt>
                      <c:pt idx="136">
                        <c:v>2964</c:v>
                      </c:pt>
                      <c:pt idx="137">
                        <c:v>2159</c:v>
                      </c:pt>
                      <c:pt idx="138">
                        <c:v>1886</c:v>
                      </c:pt>
                      <c:pt idx="139">
                        <c:v>3116</c:v>
                      </c:pt>
                      <c:pt idx="140">
                        <c:v>3291</c:v>
                      </c:pt>
                      <c:pt idx="141">
                        <c:v>2693</c:v>
                      </c:pt>
                      <c:pt idx="142">
                        <c:v>4012</c:v>
                      </c:pt>
                      <c:pt idx="143">
                        <c:v>3027</c:v>
                      </c:pt>
                      <c:pt idx="144">
                        <c:v>2450</c:v>
                      </c:pt>
                      <c:pt idx="145">
                        <c:v>3460</c:v>
                      </c:pt>
                      <c:pt idx="146">
                        <c:v>3940</c:v>
                      </c:pt>
                      <c:pt idx="147">
                        <c:v>2880</c:v>
                      </c:pt>
                      <c:pt idx="148">
                        <c:v>2770</c:v>
                      </c:pt>
                      <c:pt idx="149">
                        <c:v>3151</c:v>
                      </c:pt>
                      <c:pt idx="150">
                        <c:v>3698</c:v>
                      </c:pt>
                      <c:pt idx="151">
                        <c:v>3652</c:v>
                      </c:pt>
                      <c:pt idx="152">
                        <c:v>3220</c:v>
                      </c:pt>
                      <c:pt idx="153">
                        <c:v>3126</c:v>
                      </c:pt>
                      <c:pt idx="154">
                        <c:v>3443</c:v>
                      </c:pt>
                      <c:pt idx="155">
                        <c:v>3964</c:v>
                      </c:pt>
                      <c:pt idx="156">
                        <c:v>3582</c:v>
                      </c:pt>
                      <c:pt idx="157">
                        <c:v>2408</c:v>
                      </c:pt>
                      <c:pt idx="158">
                        <c:v>3295</c:v>
                      </c:pt>
                      <c:pt idx="159">
                        <c:v>3224</c:v>
                      </c:pt>
                      <c:pt idx="160">
                        <c:v>3025</c:v>
                      </c:pt>
                      <c:pt idx="161">
                        <c:v>3667</c:v>
                      </c:pt>
                      <c:pt idx="162">
                        <c:v>2368</c:v>
                      </c:pt>
                      <c:pt idx="163">
                        <c:v>2848</c:v>
                      </c:pt>
                      <c:pt idx="164">
                        <c:v>2206</c:v>
                      </c:pt>
                      <c:pt idx="165">
                        <c:v>3645</c:v>
                      </c:pt>
                      <c:pt idx="166">
                        <c:v>3523</c:v>
                      </c:pt>
                      <c:pt idx="167">
                        <c:v>2717</c:v>
                      </c:pt>
                      <c:pt idx="168">
                        <c:v>2166</c:v>
                      </c:pt>
                      <c:pt idx="169">
                        <c:v>2198</c:v>
                      </c:pt>
                      <c:pt idx="170">
                        <c:v>2445</c:v>
                      </c:pt>
                      <c:pt idx="171">
                        <c:v>3969</c:v>
                      </c:pt>
                      <c:pt idx="172">
                        <c:v>2710</c:v>
                      </c:pt>
                      <c:pt idx="173">
                        <c:v>1912</c:v>
                      </c:pt>
                      <c:pt idx="174">
                        <c:v>3929</c:v>
                      </c:pt>
                      <c:pt idx="175">
                        <c:v>3820</c:v>
                      </c:pt>
                      <c:pt idx="176">
                        <c:v>2296</c:v>
                      </c:pt>
                      <c:pt idx="177">
                        <c:v>3038</c:v>
                      </c:pt>
                      <c:pt idx="178">
                        <c:v>1933</c:v>
                      </c:pt>
                      <c:pt idx="179">
                        <c:v>2730</c:v>
                      </c:pt>
                      <c:pt idx="180">
                        <c:v>3996</c:v>
                      </c:pt>
                      <c:pt idx="181">
                        <c:v>2061</c:v>
                      </c:pt>
                      <c:pt idx="182">
                        <c:v>3922</c:v>
                      </c:pt>
                      <c:pt idx="183">
                        <c:v>2181</c:v>
                      </c:pt>
                      <c:pt idx="184">
                        <c:v>3341</c:v>
                      </c:pt>
                      <c:pt idx="185">
                        <c:v>2667</c:v>
                      </c:pt>
                      <c:pt idx="186">
                        <c:v>2923</c:v>
                      </c:pt>
                      <c:pt idx="187">
                        <c:v>3528</c:v>
                      </c:pt>
                      <c:pt idx="188">
                        <c:v>3524</c:v>
                      </c:pt>
                      <c:pt idx="189">
                        <c:v>2668</c:v>
                      </c:pt>
                      <c:pt idx="190">
                        <c:v>3948</c:v>
                      </c:pt>
                      <c:pt idx="191">
                        <c:v>3831</c:v>
                      </c:pt>
                      <c:pt idx="192">
                        <c:v>2669</c:v>
                      </c:pt>
                      <c:pt idx="193">
                        <c:v>3743</c:v>
                      </c:pt>
                      <c:pt idx="194">
                        <c:v>841</c:v>
                      </c:pt>
                      <c:pt idx="195">
                        <c:v>3897</c:v>
                      </c:pt>
                      <c:pt idx="196">
                        <c:v>2496</c:v>
                      </c:pt>
                      <c:pt idx="197">
                        <c:v>2392</c:v>
                      </c:pt>
                      <c:pt idx="198">
                        <c:v>3383</c:v>
                      </c:pt>
                      <c:pt idx="199">
                        <c:v>3919</c:v>
                      </c:pt>
                      <c:pt idx="200">
                        <c:v>3459</c:v>
                      </c:pt>
                      <c:pt idx="201">
                        <c:v>3385</c:v>
                      </c:pt>
                      <c:pt idx="202">
                        <c:v>4005</c:v>
                      </c:pt>
                      <c:pt idx="203">
                        <c:v>4009</c:v>
                      </c:pt>
                      <c:pt idx="204">
                        <c:v>3803</c:v>
                      </c:pt>
                      <c:pt idx="205">
                        <c:v>2100</c:v>
                      </c:pt>
                      <c:pt idx="206">
                        <c:v>2933</c:v>
                      </c:pt>
                      <c:pt idx="207">
                        <c:v>1954</c:v>
                      </c:pt>
                      <c:pt idx="208">
                        <c:v>2715</c:v>
                      </c:pt>
                      <c:pt idx="209">
                        <c:v>2423</c:v>
                      </c:pt>
                      <c:pt idx="210">
                        <c:v>3377</c:v>
                      </c:pt>
                      <c:pt idx="211">
                        <c:v>3262</c:v>
                      </c:pt>
                      <c:pt idx="212">
                        <c:v>2030</c:v>
                      </c:pt>
                      <c:pt idx="213">
                        <c:v>2847</c:v>
                      </c:pt>
                      <c:pt idx="214">
                        <c:v>4039</c:v>
                      </c:pt>
                      <c:pt idx="215">
                        <c:v>2055</c:v>
                      </c:pt>
                      <c:pt idx="216">
                        <c:v>1679</c:v>
                      </c:pt>
                      <c:pt idx="217">
                        <c:v>1981</c:v>
                      </c:pt>
                      <c:pt idx="218">
                        <c:v>2396</c:v>
                      </c:pt>
                      <c:pt idx="219">
                        <c:v>4082</c:v>
                      </c:pt>
                      <c:pt idx="220">
                        <c:v>3316</c:v>
                      </c:pt>
                      <c:pt idx="221">
                        <c:v>1181</c:v>
                      </c:pt>
                      <c:pt idx="222">
                        <c:v>3673</c:v>
                      </c:pt>
                      <c:pt idx="223">
                        <c:v>1794</c:v>
                      </c:pt>
                      <c:pt idx="224">
                        <c:v>3294</c:v>
                      </c:pt>
                      <c:pt idx="225">
                        <c:v>2975</c:v>
                      </c:pt>
                      <c:pt idx="226">
                        <c:v>3580</c:v>
                      </c:pt>
                      <c:pt idx="227">
                        <c:v>3876</c:v>
                      </c:pt>
                      <c:pt idx="228">
                        <c:v>3318</c:v>
                      </c:pt>
                      <c:pt idx="229">
                        <c:v>2984</c:v>
                      </c:pt>
                      <c:pt idx="230">
                        <c:v>3189</c:v>
                      </c:pt>
                      <c:pt idx="231">
                        <c:v>2967</c:v>
                      </c:pt>
                      <c:pt idx="232">
                        <c:v>3028</c:v>
                      </c:pt>
                      <c:pt idx="233">
                        <c:v>3169</c:v>
                      </c:pt>
                      <c:pt idx="234">
                        <c:v>3288</c:v>
                      </c:pt>
                      <c:pt idx="235">
                        <c:v>3686</c:v>
                      </c:pt>
                      <c:pt idx="236">
                        <c:v>3841</c:v>
                      </c:pt>
                      <c:pt idx="237">
                        <c:v>3469</c:v>
                      </c:pt>
                      <c:pt idx="238">
                        <c:v>2988</c:v>
                      </c:pt>
                      <c:pt idx="239">
                        <c:v>3976</c:v>
                      </c:pt>
                      <c:pt idx="240">
                        <c:v>3509</c:v>
                      </c:pt>
                      <c:pt idx="241">
                        <c:v>2171</c:v>
                      </c:pt>
                      <c:pt idx="242">
                        <c:v>893</c:v>
                      </c:pt>
                      <c:pt idx="243">
                        <c:v>2589</c:v>
                      </c:pt>
                      <c:pt idx="244">
                        <c:v>2490</c:v>
                      </c:pt>
                      <c:pt idx="245">
                        <c:v>2291</c:v>
                      </c:pt>
                      <c:pt idx="246">
                        <c:v>2357</c:v>
                      </c:pt>
                      <c:pt idx="247">
                        <c:v>3654</c:v>
                      </c:pt>
                      <c:pt idx="248">
                        <c:v>3856</c:v>
                      </c:pt>
                      <c:pt idx="249">
                        <c:v>1221</c:v>
                      </c:pt>
                      <c:pt idx="250">
                        <c:v>856</c:v>
                      </c:pt>
                      <c:pt idx="251">
                        <c:v>3373</c:v>
                      </c:pt>
                      <c:pt idx="252">
                        <c:v>3290</c:v>
                      </c:pt>
                      <c:pt idx="253">
                        <c:v>3266</c:v>
                      </c:pt>
                      <c:pt idx="254">
                        <c:v>3026</c:v>
                      </c:pt>
                      <c:pt idx="255">
                        <c:v>2126</c:v>
                      </c:pt>
                      <c:pt idx="256">
                        <c:v>2588</c:v>
                      </c:pt>
                      <c:pt idx="257">
                        <c:v>2233</c:v>
                      </c:pt>
                      <c:pt idx="258">
                        <c:v>2796</c:v>
                      </c:pt>
                      <c:pt idx="259">
                        <c:v>3823</c:v>
                      </c:pt>
                      <c:pt idx="260">
                        <c:v>1883</c:v>
                      </c:pt>
                      <c:pt idx="261">
                        <c:v>1711</c:v>
                      </c:pt>
                      <c:pt idx="262">
                        <c:v>2090</c:v>
                      </c:pt>
                      <c:pt idx="263">
                        <c:v>2900</c:v>
                      </c:pt>
                      <c:pt idx="264">
                        <c:v>3024</c:v>
                      </c:pt>
                      <c:pt idx="265">
                        <c:v>3501</c:v>
                      </c:pt>
                      <c:pt idx="266">
                        <c:v>2987</c:v>
                      </c:pt>
                      <c:pt idx="267">
                        <c:v>2491</c:v>
                      </c:pt>
                      <c:pt idx="268">
                        <c:v>3541</c:v>
                      </c:pt>
                      <c:pt idx="269">
                        <c:v>3700</c:v>
                      </c:pt>
                      <c:pt idx="270">
                        <c:v>2778</c:v>
                      </c:pt>
                      <c:pt idx="271">
                        <c:v>4030</c:v>
                      </c:pt>
                      <c:pt idx="272">
                        <c:v>3215</c:v>
                      </c:pt>
                      <c:pt idx="273">
                        <c:v>475</c:v>
                      </c:pt>
                      <c:pt idx="274">
                        <c:v>2034</c:v>
                      </c:pt>
                      <c:pt idx="275">
                        <c:v>3734</c:v>
                      </c:pt>
                      <c:pt idx="276">
                        <c:v>1953</c:v>
                      </c:pt>
                      <c:pt idx="277">
                        <c:v>2146</c:v>
                      </c:pt>
                      <c:pt idx="278">
                        <c:v>2991</c:v>
                      </c:pt>
                      <c:pt idx="279">
                        <c:v>1273</c:v>
                      </c:pt>
                      <c:pt idx="280">
                        <c:v>3255</c:v>
                      </c:pt>
                      <c:pt idx="281">
                        <c:v>1923</c:v>
                      </c:pt>
                      <c:pt idx="282">
                        <c:v>2026</c:v>
                      </c:pt>
                      <c:pt idx="283">
                        <c:v>2935</c:v>
                      </c:pt>
                      <c:pt idx="284">
                        <c:v>1053</c:v>
                      </c:pt>
                      <c:pt idx="285">
                        <c:v>873</c:v>
                      </c:pt>
                      <c:pt idx="286">
                        <c:v>2134</c:v>
                      </c:pt>
                      <c:pt idx="287">
                        <c:v>2600</c:v>
                      </c:pt>
                      <c:pt idx="288">
                        <c:v>3257</c:v>
                      </c:pt>
                      <c:pt idx="289">
                        <c:v>3081</c:v>
                      </c:pt>
                      <c:pt idx="290">
                        <c:v>3334</c:v>
                      </c:pt>
                      <c:pt idx="291">
                        <c:v>3209</c:v>
                      </c:pt>
                      <c:pt idx="292">
                        <c:v>1525</c:v>
                      </c:pt>
                      <c:pt idx="293">
                        <c:v>3240</c:v>
                      </c:pt>
                      <c:pt idx="294">
                        <c:v>3259</c:v>
                      </c:pt>
                      <c:pt idx="295">
                        <c:v>3561</c:v>
                      </c:pt>
                      <c:pt idx="296">
                        <c:v>2201</c:v>
                      </c:pt>
                      <c:pt idx="297">
                        <c:v>2093</c:v>
                      </c:pt>
                      <c:pt idx="298">
                        <c:v>3855</c:v>
                      </c:pt>
                      <c:pt idx="299">
                        <c:v>3999</c:v>
                      </c:pt>
                      <c:pt idx="300">
                        <c:v>3731</c:v>
                      </c:pt>
                      <c:pt idx="301">
                        <c:v>851</c:v>
                      </c:pt>
                      <c:pt idx="302">
                        <c:v>2946</c:v>
                      </c:pt>
                      <c:pt idx="303">
                        <c:v>3536</c:v>
                      </c:pt>
                      <c:pt idx="304">
                        <c:v>2622</c:v>
                      </c:pt>
                      <c:pt idx="305">
                        <c:v>2882</c:v>
                      </c:pt>
                      <c:pt idx="306">
                        <c:v>3036</c:v>
                      </c:pt>
                      <c:pt idx="307">
                        <c:v>3441</c:v>
                      </c:pt>
                      <c:pt idx="308">
                        <c:v>2878</c:v>
                      </c:pt>
                      <c:pt idx="309">
                        <c:v>2776</c:v>
                      </c:pt>
                      <c:pt idx="310">
                        <c:v>2845</c:v>
                      </c:pt>
                      <c:pt idx="311">
                        <c:v>3882</c:v>
                      </c:pt>
                      <c:pt idx="312">
                        <c:v>3644</c:v>
                      </c:pt>
                      <c:pt idx="313">
                        <c:v>3620</c:v>
                      </c:pt>
                      <c:pt idx="314">
                        <c:v>2804</c:v>
                      </c:pt>
                      <c:pt idx="315">
                        <c:v>2258</c:v>
                      </c:pt>
                      <c:pt idx="316">
                        <c:v>3296</c:v>
                      </c:pt>
                      <c:pt idx="317">
                        <c:v>3826</c:v>
                      </c:pt>
                      <c:pt idx="318">
                        <c:v>3854</c:v>
                      </c:pt>
                      <c:pt idx="319">
                        <c:v>3284</c:v>
                      </c:pt>
                      <c:pt idx="320">
                        <c:v>3651</c:v>
                      </c:pt>
                      <c:pt idx="321">
                        <c:v>3601</c:v>
                      </c:pt>
                      <c:pt idx="322">
                        <c:v>3558</c:v>
                      </c:pt>
                      <c:pt idx="323">
                        <c:v>3510</c:v>
                      </c:pt>
                      <c:pt idx="324">
                        <c:v>1423</c:v>
                      </c:pt>
                      <c:pt idx="325">
                        <c:v>3513</c:v>
                      </c:pt>
                      <c:pt idx="326">
                        <c:v>3467</c:v>
                      </c:pt>
                      <c:pt idx="327">
                        <c:v>2390</c:v>
                      </c:pt>
                      <c:pt idx="328">
                        <c:v>2739</c:v>
                      </c:pt>
                      <c:pt idx="329">
                        <c:v>3752</c:v>
                      </c:pt>
                      <c:pt idx="330">
                        <c:v>3339</c:v>
                      </c:pt>
                      <c:pt idx="331">
                        <c:v>3627</c:v>
                      </c:pt>
                      <c:pt idx="332">
                        <c:v>3704</c:v>
                      </c:pt>
                      <c:pt idx="333">
                        <c:v>2228</c:v>
                      </c:pt>
                      <c:pt idx="334">
                        <c:v>2758</c:v>
                      </c:pt>
                      <c:pt idx="335">
                        <c:v>3588</c:v>
                      </c:pt>
                      <c:pt idx="336">
                        <c:v>2777</c:v>
                      </c:pt>
                      <c:pt idx="337">
                        <c:v>2920</c:v>
                      </c:pt>
                      <c:pt idx="338">
                        <c:v>940</c:v>
                      </c:pt>
                      <c:pt idx="339">
                        <c:v>2966</c:v>
                      </c:pt>
                      <c:pt idx="340">
                        <c:v>3659</c:v>
                      </c:pt>
                      <c:pt idx="341">
                        <c:v>1242</c:v>
                      </c:pt>
                      <c:pt idx="342">
                        <c:v>1919</c:v>
                      </c:pt>
                      <c:pt idx="343">
                        <c:v>1240</c:v>
                      </c:pt>
                      <c:pt idx="344">
                        <c:v>3637</c:v>
                      </c:pt>
                      <c:pt idx="345">
                        <c:v>3279</c:v>
                      </c:pt>
                      <c:pt idx="346">
                        <c:v>3382</c:v>
                      </c:pt>
                      <c:pt idx="347">
                        <c:v>2128</c:v>
                      </c:pt>
                      <c:pt idx="348">
                        <c:v>3758</c:v>
                      </c:pt>
                      <c:pt idx="349">
                        <c:v>3338</c:v>
                      </c:pt>
                      <c:pt idx="350">
                        <c:v>2982</c:v>
                      </c:pt>
                      <c:pt idx="351">
                        <c:v>2226</c:v>
                      </c:pt>
                      <c:pt idx="352">
                        <c:v>1938</c:v>
                      </c:pt>
                      <c:pt idx="353">
                        <c:v>3160</c:v>
                      </c:pt>
                      <c:pt idx="354">
                        <c:v>3572</c:v>
                      </c:pt>
                      <c:pt idx="355">
                        <c:v>1184</c:v>
                      </c:pt>
                      <c:pt idx="356">
                        <c:v>3879</c:v>
                      </c:pt>
                      <c:pt idx="357">
                        <c:v>3298</c:v>
                      </c:pt>
                      <c:pt idx="358">
                        <c:v>3221</c:v>
                      </c:pt>
                      <c:pt idx="359">
                        <c:v>3935</c:v>
                      </c:pt>
                      <c:pt idx="360">
                        <c:v>2351</c:v>
                      </c:pt>
                      <c:pt idx="361">
                        <c:v>3352</c:v>
                      </c:pt>
                      <c:pt idx="362">
                        <c:v>3260</c:v>
                      </c:pt>
                      <c:pt idx="363">
                        <c:v>3358</c:v>
                      </c:pt>
                      <c:pt idx="364">
                        <c:v>3957</c:v>
                      </c:pt>
                      <c:pt idx="365">
                        <c:v>3349</c:v>
                      </c:pt>
                      <c:pt idx="366">
                        <c:v>712</c:v>
                      </c:pt>
                      <c:pt idx="367">
                        <c:v>2587</c:v>
                      </c:pt>
                      <c:pt idx="368">
                        <c:v>2807</c:v>
                      </c:pt>
                      <c:pt idx="369">
                        <c:v>1775</c:v>
                      </c:pt>
                      <c:pt idx="370">
                        <c:v>3107</c:v>
                      </c:pt>
                      <c:pt idx="371">
                        <c:v>2394</c:v>
                      </c:pt>
                      <c:pt idx="372">
                        <c:v>1189</c:v>
                      </c:pt>
                      <c:pt idx="373">
                        <c:v>3636</c:v>
                      </c:pt>
                      <c:pt idx="374">
                        <c:v>1114</c:v>
                      </c:pt>
                      <c:pt idx="375">
                        <c:v>3936</c:v>
                      </c:pt>
                      <c:pt idx="376">
                        <c:v>2273</c:v>
                      </c:pt>
                      <c:pt idx="377">
                        <c:v>379</c:v>
                      </c:pt>
                      <c:pt idx="378">
                        <c:v>2453</c:v>
                      </c:pt>
                      <c:pt idx="379">
                        <c:v>2921</c:v>
                      </c:pt>
                      <c:pt idx="380">
                        <c:v>3710</c:v>
                      </c:pt>
                      <c:pt idx="381">
                        <c:v>3990</c:v>
                      </c:pt>
                      <c:pt idx="382">
                        <c:v>3730</c:v>
                      </c:pt>
                      <c:pt idx="383">
                        <c:v>2004</c:v>
                      </c:pt>
                      <c:pt idx="384">
                        <c:v>3242</c:v>
                      </c:pt>
                      <c:pt idx="385">
                        <c:v>2653</c:v>
                      </c:pt>
                      <c:pt idx="386">
                        <c:v>2943</c:v>
                      </c:pt>
                      <c:pt idx="387">
                        <c:v>2698</c:v>
                      </c:pt>
                      <c:pt idx="388">
                        <c:v>2044</c:v>
                      </c:pt>
                      <c:pt idx="389">
                        <c:v>3329</c:v>
                      </c:pt>
                      <c:pt idx="390">
                        <c:v>2125</c:v>
                      </c:pt>
                      <c:pt idx="391">
                        <c:v>3678</c:v>
                      </c:pt>
                      <c:pt idx="392">
                        <c:v>2046</c:v>
                      </c:pt>
                      <c:pt idx="393">
                        <c:v>2841</c:v>
                      </c:pt>
                      <c:pt idx="394">
                        <c:v>3543</c:v>
                      </c:pt>
                      <c:pt idx="395">
                        <c:v>3965</c:v>
                      </c:pt>
                      <c:pt idx="396">
                        <c:v>3845</c:v>
                      </c:pt>
                      <c:pt idx="397">
                        <c:v>2091</c:v>
                      </c:pt>
                      <c:pt idx="398">
                        <c:v>3062</c:v>
                      </c:pt>
                      <c:pt idx="399">
                        <c:v>2775</c:v>
                      </c:pt>
                      <c:pt idx="400">
                        <c:v>2387</c:v>
                      </c:pt>
                      <c:pt idx="401">
                        <c:v>3529</c:v>
                      </c:pt>
                      <c:pt idx="402">
                        <c:v>1461</c:v>
                      </c:pt>
                      <c:pt idx="403">
                        <c:v>3083</c:v>
                      </c:pt>
                      <c:pt idx="404">
                        <c:v>1034</c:v>
                      </c:pt>
                      <c:pt idx="405">
                        <c:v>4020</c:v>
                      </c:pt>
                      <c:pt idx="406">
                        <c:v>3918</c:v>
                      </c:pt>
                      <c:pt idx="407">
                        <c:v>4081</c:v>
                      </c:pt>
                      <c:pt idx="408">
                        <c:v>3011</c:v>
                      </c:pt>
                      <c:pt idx="409">
                        <c:v>3729</c:v>
                      </c:pt>
                      <c:pt idx="410">
                        <c:v>3335</c:v>
                      </c:pt>
                      <c:pt idx="411">
                        <c:v>1974</c:v>
                      </c:pt>
                      <c:pt idx="412">
                        <c:v>2421</c:v>
                      </c:pt>
                      <c:pt idx="413">
                        <c:v>3895</c:v>
                      </c:pt>
                      <c:pt idx="414">
                        <c:v>3609</c:v>
                      </c:pt>
                      <c:pt idx="415">
                        <c:v>3476</c:v>
                      </c:pt>
                      <c:pt idx="416">
                        <c:v>3306</c:v>
                      </c:pt>
                      <c:pt idx="417">
                        <c:v>3076</c:v>
                      </c:pt>
                      <c:pt idx="418">
                        <c:v>3614</c:v>
                      </c:pt>
                      <c:pt idx="419">
                        <c:v>3682</c:v>
                      </c:pt>
                      <c:pt idx="420">
                        <c:v>3098</c:v>
                      </c:pt>
                      <c:pt idx="421">
                        <c:v>2499</c:v>
                      </c:pt>
                      <c:pt idx="422">
                        <c:v>3920</c:v>
                      </c:pt>
                      <c:pt idx="423">
                        <c:v>3932</c:v>
                      </c:pt>
                      <c:pt idx="424">
                        <c:v>3386</c:v>
                      </c:pt>
                      <c:pt idx="425">
                        <c:v>3231</c:v>
                      </c:pt>
                      <c:pt idx="426">
                        <c:v>3253</c:v>
                      </c:pt>
                      <c:pt idx="427">
                        <c:v>3736</c:v>
                      </c:pt>
                      <c:pt idx="428">
                        <c:v>655</c:v>
                      </c:pt>
                      <c:pt idx="429">
                        <c:v>2661</c:v>
                      </c:pt>
                      <c:pt idx="430">
                        <c:v>3227</c:v>
                      </c:pt>
                      <c:pt idx="431">
                        <c:v>3336</c:v>
                      </c:pt>
                      <c:pt idx="432">
                        <c:v>3033</c:v>
                      </c:pt>
                      <c:pt idx="433">
                        <c:v>3201</c:v>
                      </c:pt>
                      <c:pt idx="434">
                        <c:v>2087</c:v>
                      </c:pt>
                      <c:pt idx="435">
                        <c:v>3159</c:v>
                      </c:pt>
                      <c:pt idx="436">
                        <c:v>2202</c:v>
                      </c:pt>
                      <c:pt idx="437">
                        <c:v>3635</c:v>
                      </c:pt>
                      <c:pt idx="438">
                        <c:v>2980</c:v>
                      </c:pt>
                      <c:pt idx="439">
                        <c:v>3522</c:v>
                      </c:pt>
                      <c:pt idx="440">
                        <c:v>3672</c:v>
                      </c:pt>
                      <c:pt idx="441">
                        <c:v>3007</c:v>
                      </c:pt>
                      <c:pt idx="442">
                        <c:v>3914</c:v>
                      </c:pt>
                      <c:pt idx="443">
                        <c:v>3534</c:v>
                      </c:pt>
                      <c:pt idx="444">
                        <c:v>3887</c:v>
                      </c:pt>
                      <c:pt idx="445">
                        <c:v>580</c:v>
                      </c:pt>
                      <c:pt idx="446">
                        <c:v>1556</c:v>
                      </c:pt>
                      <c:pt idx="447">
                        <c:v>1680</c:v>
                      </c:pt>
                      <c:pt idx="448">
                        <c:v>1590</c:v>
                      </c:pt>
                      <c:pt idx="449">
                        <c:v>3822</c:v>
                      </c:pt>
                      <c:pt idx="450">
                        <c:v>3245</c:v>
                      </c:pt>
                      <c:pt idx="451">
                        <c:v>3719</c:v>
                      </c:pt>
                      <c:pt idx="452">
                        <c:v>2731</c:v>
                      </c:pt>
                      <c:pt idx="453">
                        <c:v>2963</c:v>
                      </c:pt>
                      <c:pt idx="454">
                        <c:v>3685</c:v>
                      </c:pt>
                      <c:pt idx="455">
                        <c:v>3712</c:v>
                      </c:pt>
                      <c:pt idx="456">
                        <c:v>3571</c:v>
                      </c:pt>
                      <c:pt idx="457">
                        <c:v>1950</c:v>
                      </c:pt>
                      <c:pt idx="458">
                        <c:v>2603</c:v>
                      </c:pt>
                      <c:pt idx="459">
                        <c:v>2135</c:v>
                      </c:pt>
                      <c:pt idx="460">
                        <c:v>2506</c:v>
                      </c:pt>
                      <c:pt idx="461">
                        <c:v>3653</c:v>
                      </c:pt>
                      <c:pt idx="462">
                        <c:v>1557</c:v>
                      </c:pt>
                      <c:pt idx="463">
                        <c:v>2204</c:v>
                      </c:pt>
                      <c:pt idx="464">
                        <c:v>3068</c:v>
                      </c:pt>
                      <c:pt idx="465">
                        <c:v>1997</c:v>
                      </c:pt>
                      <c:pt idx="466">
                        <c:v>3134</c:v>
                      </c:pt>
                      <c:pt idx="467">
                        <c:v>2519</c:v>
                      </c:pt>
                      <c:pt idx="468">
                        <c:v>3031</c:v>
                      </c:pt>
                      <c:pt idx="469">
                        <c:v>2086</c:v>
                      </c:pt>
                      <c:pt idx="470">
                        <c:v>3225</c:v>
                      </c:pt>
                      <c:pt idx="471">
                        <c:v>1771</c:v>
                      </c:pt>
                      <c:pt idx="472">
                        <c:v>3725</c:v>
                      </c:pt>
                      <c:pt idx="473">
                        <c:v>3285</c:v>
                      </c:pt>
                      <c:pt idx="474">
                        <c:v>3418</c:v>
                      </c:pt>
                      <c:pt idx="475">
                        <c:v>3477</c:v>
                      </c:pt>
                      <c:pt idx="476">
                        <c:v>511</c:v>
                      </c:pt>
                      <c:pt idx="477">
                        <c:v>2255</c:v>
                      </c:pt>
                      <c:pt idx="478">
                        <c:v>3617</c:v>
                      </c:pt>
                      <c:pt idx="479">
                        <c:v>2383</c:v>
                      </c:pt>
                      <c:pt idx="480">
                        <c:v>3793</c:v>
                      </c:pt>
                      <c:pt idx="481">
                        <c:v>1555</c:v>
                      </c:pt>
                      <c:pt idx="482">
                        <c:v>3975</c:v>
                      </c:pt>
                      <c:pt idx="483">
                        <c:v>3679</c:v>
                      </c:pt>
                      <c:pt idx="484">
                        <c:v>3837</c:v>
                      </c:pt>
                      <c:pt idx="485">
                        <c:v>2822</c:v>
                      </c:pt>
                      <c:pt idx="486">
                        <c:v>1945</c:v>
                      </c:pt>
                      <c:pt idx="487">
                        <c:v>3853</c:v>
                      </c:pt>
                      <c:pt idx="488">
                        <c:v>3910</c:v>
                      </c:pt>
                      <c:pt idx="489">
                        <c:v>2737</c:v>
                      </c:pt>
                      <c:pt idx="490">
                        <c:v>2274</c:v>
                      </c:pt>
                      <c:pt idx="491">
                        <c:v>2986</c:v>
                      </c:pt>
                      <c:pt idx="492">
                        <c:v>2083</c:v>
                      </c:pt>
                      <c:pt idx="493">
                        <c:v>3978</c:v>
                      </c:pt>
                      <c:pt idx="494">
                        <c:v>3030</c:v>
                      </c:pt>
                      <c:pt idx="495">
                        <c:v>3921</c:v>
                      </c:pt>
                      <c:pt idx="496">
                        <c:v>2501</c:v>
                      </c:pt>
                      <c:pt idx="497">
                        <c:v>2048</c:v>
                      </c:pt>
                      <c:pt idx="498">
                        <c:v>2068</c:v>
                      </c:pt>
                      <c:pt idx="499">
                        <c:v>2953</c:v>
                      </c:pt>
                      <c:pt idx="500">
                        <c:v>2520</c:v>
                      </c:pt>
                      <c:pt idx="501">
                        <c:v>3661</c:v>
                      </c:pt>
                      <c:pt idx="502">
                        <c:v>3239</c:v>
                      </c:pt>
                      <c:pt idx="503">
                        <c:v>3353</c:v>
                      </c:pt>
                      <c:pt idx="504">
                        <c:v>3185</c:v>
                      </c:pt>
                      <c:pt idx="505">
                        <c:v>3535</c:v>
                      </c:pt>
                      <c:pt idx="506">
                        <c:v>3733</c:v>
                      </c:pt>
                      <c:pt idx="507">
                        <c:v>3186</c:v>
                      </c:pt>
                      <c:pt idx="508">
                        <c:v>3351</c:v>
                      </c:pt>
                      <c:pt idx="509">
                        <c:v>1929</c:v>
                      </c:pt>
                      <c:pt idx="510">
                        <c:v>3656</c:v>
                      </c:pt>
                      <c:pt idx="511">
                        <c:v>3657</c:v>
                      </c:pt>
                      <c:pt idx="512">
                        <c:v>1976</c:v>
                      </c:pt>
                      <c:pt idx="513">
                        <c:v>3665</c:v>
                      </c:pt>
                      <c:pt idx="514">
                        <c:v>3292</c:v>
                      </c:pt>
                      <c:pt idx="515">
                        <c:v>1510</c:v>
                      </c:pt>
                      <c:pt idx="516">
                        <c:v>3447</c:v>
                      </c:pt>
                      <c:pt idx="517">
                        <c:v>2331</c:v>
                      </c:pt>
                      <c:pt idx="518">
                        <c:v>2908</c:v>
                      </c:pt>
                      <c:pt idx="519">
                        <c:v>1416</c:v>
                      </c:pt>
                      <c:pt idx="520">
                        <c:v>1356</c:v>
                      </c:pt>
                      <c:pt idx="521">
                        <c:v>2352</c:v>
                      </c:pt>
                      <c:pt idx="522">
                        <c:v>3624</c:v>
                      </c:pt>
                      <c:pt idx="523">
                        <c:v>3623</c:v>
                      </c:pt>
                      <c:pt idx="524">
                        <c:v>2695</c:v>
                      </c:pt>
                      <c:pt idx="525">
                        <c:v>2974</c:v>
                      </c:pt>
                      <c:pt idx="526">
                        <c:v>853</c:v>
                      </c:pt>
                      <c:pt idx="527">
                        <c:v>2489</c:v>
                      </c:pt>
                      <c:pt idx="528">
                        <c:v>2722</c:v>
                      </c:pt>
                      <c:pt idx="529">
                        <c:v>3264</c:v>
                      </c:pt>
                      <c:pt idx="530">
                        <c:v>3968</c:v>
                      </c:pt>
                      <c:pt idx="531">
                        <c:v>2825</c:v>
                      </c:pt>
                      <c:pt idx="532">
                        <c:v>2039</c:v>
                      </c:pt>
                      <c:pt idx="533">
                        <c:v>3254</c:v>
                      </c:pt>
                      <c:pt idx="534">
                        <c:v>3324</c:v>
                      </c:pt>
                      <c:pt idx="535">
                        <c:v>3340</c:v>
                      </c:pt>
                      <c:pt idx="536">
                        <c:v>2531</c:v>
                      </c:pt>
                      <c:pt idx="537">
                        <c:v>4034</c:v>
                      </c:pt>
                      <c:pt idx="538">
                        <c:v>2521</c:v>
                      </c:pt>
                      <c:pt idx="539">
                        <c:v>2241</c:v>
                      </c:pt>
                      <c:pt idx="540">
                        <c:v>2195</c:v>
                      </c:pt>
                      <c:pt idx="541">
                        <c:v>3691</c:v>
                      </c:pt>
                      <c:pt idx="542">
                        <c:v>3058</c:v>
                      </c:pt>
                      <c:pt idx="543">
                        <c:v>2102</c:v>
                      </c:pt>
                      <c:pt idx="544">
                        <c:v>3244</c:v>
                      </c:pt>
                      <c:pt idx="545">
                        <c:v>1619</c:v>
                      </c:pt>
                      <c:pt idx="546">
                        <c:v>2384</c:v>
                      </c:pt>
                      <c:pt idx="547">
                        <c:v>1891</c:v>
                      </c:pt>
                      <c:pt idx="548">
                        <c:v>4049</c:v>
                      </c:pt>
                      <c:pt idx="549">
                        <c:v>2826</c:v>
                      </c:pt>
                      <c:pt idx="550">
                        <c:v>1928</c:v>
                      </c:pt>
                      <c:pt idx="551">
                        <c:v>259</c:v>
                      </c:pt>
                      <c:pt idx="552">
                        <c:v>3834</c:v>
                      </c:pt>
                      <c:pt idx="553">
                        <c:v>1796</c:v>
                      </c:pt>
                      <c:pt idx="554">
                        <c:v>3362</c:v>
                      </c:pt>
                      <c:pt idx="555">
                        <c:v>2246</c:v>
                      </c:pt>
                      <c:pt idx="556">
                        <c:v>1925</c:v>
                      </c:pt>
                      <c:pt idx="557">
                        <c:v>422</c:v>
                      </c:pt>
                      <c:pt idx="558">
                        <c:v>2186</c:v>
                      </c:pt>
                      <c:pt idx="559">
                        <c:v>1803</c:v>
                      </c:pt>
                      <c:pt idx="560">
                        <c:v>3421</c:v>
                      </c:pt>
                      <c:pt idx="561">
                        <c:v>2913</c:v>
                      </c:pt>
                      <c:pt idx="562">
                        <c:v>2502</c:v>
                      </c:pt>
                      <c:pt idx="563">
                        <c:v>3565</c:v>
                      </c:pt>
                      <c:pt idx="564">
                        <c:v>3087</c:v>
                      </c:pt>
                      <c:pt idx="565">
                        <c:v>3256</c:v>
                      </c:pt>
                      <c:pt idx="566">
                        <c:v>3104</c:v>
                      </c:pt>
                      <c:pt idx="567">
                        <c:v>3250</c:v>
                      </c:pt>
                      <c:pt idx="568">
                        <c:v>2830</c:v>
                      </c:pt>
                      <c:pt idx="569">
                        <c:v>3002</c:v>
                      </c:pt>
                      <c:pt idx="570">
                        <c:v>2497</c:v>
                      </c:pt>
                      <c:pt idx="571">
                        <c:v>4007</c:v>
                      </c:pt>
                      <c:pt idx="572">
                        <c:v>840</c:v>
                      </c:pt>
                      <c:pt idx="573">
                        <c:v>2595</c:v>
                      </c:pt>
                      <c:pt idx="574">
                        <c:v>3878</c:v>
                      </c:pt>
                      <c:pt idx="575">
                        <c:v>3512</c:v>
                      </c:pt>
                      <c:pt idx="576">
                        <c:v>3630</c:v>
                      </c:pt>
                      <c:pt idx="577">
                        <c:v>2849</c:v>
                      </c:pt>
                      <c:pt idx="578">
                        <c:v>1251</c:v>
                      </c:pt>
                      <c:pt idx="579">
                        <c:v>3930</c:v>
                      </c:pt>
                      <c:pt idx="580">
                        <c:v>3008</c:v>
                      </c:pt>
                      <c:pt idx="581">
                        <c:v>2118</c:v>
                      </c:pt>
                      <c:pt idx="582">
                        <c:v>2084</c:v>
                      </c:pt>
                      <c:pt idx="583">
                        <c:v>1361</c:v>
                      </c:pt>
                      <c:pt idx="584">
                        <c:v>2027</c:v>
                      </c:pt>
                      <c:pt idx="585">
                        <c:v>2235</c:v>
                      </c:pt>
                      <c:pt idx="586">
                        <c:v>1124</c:v>
                      </c:pt>
                      <c:pt idx="587">
                        <c:v>3971</c:v>
                      </c:pt>
                      <c:pt idx="588">
                        <c:v>1741</c:v>
                      </c:pt>
                      <c:pt idx="589">
                        <c:v>2280</c:v>
                      </c:pt>
                      <c:pt idx="590">
                        <c:v>2843</c:v>
                      </c:pt>
                      <c:pt idx="591">
                        <c:v>2385</c:v>
                      </c:pt>
                      <c:pt idx="592">
                        <c:v>2912</c:v>
                      </c:pt>
                      <c:pt idx="593">
                        <c:v>850</c:v>
                      </c:pt>
                      <c:pt idx="594">
                        <c:v>2180</c:v>
                      </c:pt>
                      <c:pt idx="595">
                        <c:v>4019</c:v>
                      </c:pt>
                      <c:pt idx="596">
                        <c:v>3325</c:v>
                      </c:pt>
                      <c:pt idx="597">
                        <c:v>3655</c:v>
                      </c:pt>
                      <c:pt idx="598">
                        <c:v>3420</c:v>
                      </c:pt>
                      <c:pt idx="599">
                        <c:v>1773</c:v>
                      </c:pt>
                      <c:pt idx="600">
                        <c:v>3695</c:v>
                      </c:pt>
                      <c:pt idx="601">
                        <c:v>2507</c:v>
                      </c:pt>
                      <c:pt idx="602">
                        <c:v>3946</c:v>
                      </c:pt>
                      <c:pt idx="603">
                        <c:v>1774</c:v>
                      </c:pt>
                      <c:pt idx="604">
                        <c:v>2056</c:v>
                      </c:pt>
                      <c:pt idx="605">
                        <c:v>3307</c:v>
                      </c:pt>
                      <c:pt idx="606">
                        <c:v>3628</c:v>
                      </c:pt>
                      <c:pt idx="607">
                        <c:v>4015</c:v>
                      </c:pt>
                      <c:pt idx="608">
                        <c:v>3552</c:v>
                      </c:pt>
                      <c:pt idx="609">
                        <c:v>1890</c:v>
                      </c:pt>
                      <c:pt idx="610">
                        <c:v>2347</c:v>
                      </c:pt>
                      <c:pt idx="611">
                        <c:v>4032</c:v>
                      </c:pt>
                      <c:pt idx="612">
                        <c:v>1241</c:v>
                      </c:pt>
                      <c:pt idx="613">
                        <c:v>3581</c:v>
                      </c:pt>
                      <c:pt idx="614">
                        <c:v>3243</c:v>
                      </c:pt>
                      <c:pt idx="615">
                        <c:v>1911</c:v>
                      </c:pt>
                      <c:pt idx="616">
                        <c:v>2803</c:v>
                      </c:pt>
                      <c:pt idx="617">
                        <c:v>2950</c:v>
                      </c:pt>
                      <c:pt idx="618">
                        <c:v>3594</c:v>
                      </c:pt>
                      <c:pt idx="619">
                        <c:v>1497</c:v>
                      </c:pt>
                      <c:pt idx="620">
                        <c:v>3389</c:v>
                      </c:pt>
                      <c:pt idx="621">
                        <c:v>2243</c:v>
                      </c:pt>
                      <c:pt idx="622">
                        <c:v>1039</c:v>
                      </c:pt>
                      <c:pt idx="623">
                        <c:v>2088</c:v>
                      </c:pt>
                      <c:pt idx="624">
                        <c:v>2769</c:v>
                      </c:pt>
                      <c:pt idx="625">
                        <c:v>2718</c:v>
                      </c:pt>
                      <c:pt idx="626">
                        <c:v>3097</c:v>
                      </c:pt>
                      <c:pt idx="627">
                        <c:v>1499</c:v>
                      </c:pt>
                      <c:pt idx="628">
                        <c:v>2416</c:v>
                      </c:pt>
                      <c:pt idx="629">
                        <c:v>3223</c:v>
                      </c:pt>
                      <c:pt idx="630">
                        <c:v>1759</c:v>
                      </c:pt>
                      <c:pt idx="631">
                        <c:v>3709</c:v>
                      </c:pt>
                      <c:pt idx="632">
                        <c:v>2788</c:v>
                      </c:pt>
                      <c:pt idx="633">
                        <c:v>3308</c:v>
                      </c:pt>
                      <c:pt idx="634">
                        <c:v>3687</c:v>
                      </c:pt>
                      <c:pt idx="635">
                        <c:v>766</c:v>
                      </c:pt>
                      <c:pt idx="636">
                        <c:v>3597</c:v>
                      </c:pt>
                      <c:pt idx="637">
                        <c:v>3468</c:v>
                      </c:pt>
                      <c:pt idx="638">
                        <c:v>2956</c:v>
                      </c:pt>
                      <c:pt idx="639">
                        <c:v>3638</c:v>
                      </c:pt>
                      <c:pt idx="640">
                        <c:v>2275</c:v>
                      </c:pt>
                      <c:pt idx="641">
                        <c:v>4042</c:v>
                      </c:pt>
                      <c:pt idx="642">
                        <c:v>3703</c:v>
                      </c:pt>
                      <c:pt idx="643">
                        <c:v>2527</c:v>
                      </c:pt>
                      <c:pt idx="644">
                        <c:v>2391</c:v>
                      </c:pt>
                      <c:pt idx="645">
                        <c:v>3531</c:v>
                      </c:pt>
                      <c:pt idx="646">
                        <c:v>3252</c:v>
                      </c:pt>
                      <c:pt idx="647">
                        <c:v>1806</c:v>
                      </c:pt>
                      <c:pt idx="648">
                        <c:v>3851</c:v>
                      </c:pt>
                      <c:pt idx="649">
                        <c:v>3265</c:v>
                      </c:pt>
                      <c:pt idx="650">
                        <c:v>2081</c:v>
                      </c:pt>
                      <c:pt idx="651">
                        <c:v>3345</c:v>
                      </c:pt>
                      <c:pt idx="652">
                        <c:v>2985</c:v>
                      </c:pt>
                      <c:pt idx="653">
                        <c:v>3182</c:v>
                      </c:pt>
                      <c:pt idx="654">
                        <c:v>2608</c:v>
                      </c:pt>
                      <c:pt idx="655">
                        <c:v>3676</c:v>
                      </c:pt>
                      <c:pt idx="656">
                        <c:v>3875</c:v>
                      </c:pt>
                      <c:pt idx="657">
                        <c:v>2733</c:v>
                      </c:pt>
                      <c:pt idx="658">
                        <c:v>4018</c:v>
                      </c:pt>
                      <c:pt idx="659">
                        <c:v>3302</c:v>
                      </c:pt>
                      <c:pt idx="660">
                        <c:v>3287</c:v>
                      </c:pt>
                      <c:pt idx="661">
                        <c:v>1004</c:v>
                      </c:pt>
                      <c:pt idx="662">
                        <c:v>3629</c:v>
                      </c:pt>
                      <c:pt idx="663">
                        <c:v>2488</c:v>
                      </c:pt>
                      <c:pt idx="664">
                        <c:v>2393</c:v>
                      </c:pt>
                      <c:pt idx="665">
                        <c:v>2886</c:v>
                      </c:pt>
                      <c:pt idx="666">
                        <c:v>3479</c:v>
                      </c:pt>
                      <c:pt idx="667">
                        <c:v>2003</c:v>
                      </c:pt>
                      <c:pt idx="668">
                        <c:v>1549</c:v>
                      </c:pt>
                      <c:pt idx="669">
                        <c:v>2549</c:v>
                      </c:pt>
                      <c:pt idx="670">
                        <c:v>604</c:v>
                      </c:pt>
                      <c:pt idx="671">
                        <c:v>785</c:v>
                      </c:pt>
                      <c:pt idx="672">
                        <c:v>3176</c:v>
                      </c:pt>
                      <c:pt idx="673">
                        <c:v>3442</c:v>
                      </c:pt>
                      <c:pt idx="674">
                        <c:v>3747</c:v>
                      </c:pt>
                      <c:pt idx="675">
                        <c:v>2859</c:v>
                      </c:pt>
                      <c:pt idx="676">
                        <c:v>2924</c:v>
                      </c:pt>
                      <c:pt idx="677">
                        <c:v>3716</c:v>
                      </c:pt>
                      <c:pt idx="678">
                        <c:v>3314</c:v>
                      </c:pt>
                      <c:pt idx="679">
                        <c:v>3892</c:v>
                      </c:pt>
                      <c:pt idx="680">
                        <c:v>3305</c:v>
                      </c:pt>
                      <c:pt idx="681">
                        <c:v>3912</c:v>
                      </c:pt>
                      <c:pt idx="682">
                        <c:v>2840</c:v>
                      </c:pt>
                      <c:pt idx="683">
                        <c:v>3465</c:v>
                      </c:pt>
                      <c:pt idx="684">
                        <c:v>3310</c:v>
                      </c:pt>
                      <c:pt idx="685">
                        <c:v>2005</c:v>
                      </c:pt>
                      <c:pt idx="686">
                        <c:v>3540</c:v>
                      </c:pt>
                      <c:pt idx="687">
                        <c:v>2742</c:v>
                      </c:pt>
                      <c:pt idx="688">
                        <c:v>3165</c:v>
                      </c:pt>
                      <c:pt idx="689">
                        <c:v>3128</c:v>
                      </c:pt>
                      <c:pt idx="690">
                        <c:v>1325</c:v>
                      </c:pt>
                      <c:pt idx="691">
                        <c:v>1952</c:v>
                      </c:pt>
                      <c:pt idx="692">
                        <c:v>2951</c:v>
                      </c:pt>
                      <c:pt idx="693">
                        <c:v>3526</c:v>
                      </c:pt>
                      <c:pt idx="694">
                        <c:v>4084</c:v>
                      </c:pt>
                      <c:pt idx="695">
                        <c:v>3299</c:v>
                      </c:pt>
                      <c:pt idx="696">
                        <c:v>3414</c:v>
                      </c:pt>
                      <c:pt idx="697">
                        <c:v>3167</c:v>
                      </c:pt>
                      <c:pt idx="698">
                        <c:v>2573</c:v>
                      </c:pt>
                      <c:pt idx="699">
                        <c:v>2936</c:v>
                      </c:pt>
                      <c:pt idx="700">
                        <c:v>3127</c:v>
                      </c:pt>
                      <c:pt idx="701">
                        <c:v>2470</c:v>
                      </c:pt>
                      <c:pt idx="702">
                        <c:v>2028</c:v>
                      </c:pt>
                      <c:pt idx="703">
                        <c:v>3003</c:v>
                      </c:pt>
                      <c:pt idx="704">
                        <c:v>2620</c:v>
                      </c:pt>
                      <c:pt idx="705">
                        <c:v>3332</c:v>
                      </c:pt>
                      <c:pt idx="706">
                        <c:v>2744</c:v>
                      </c:pt>
                      <c:pt idx="707">
                        <c:v>3847</c:v>
                      </c:pt>
                      <c:pt idx="708">
                        <c:v>3123</c:v>
                      </c:pt>
                      <c:pt idx="709">
                        <c:v>1975</c:v>
                      </c:pt>
                      <c:pt idx="710">
                        <c:v>3585</c:v>
                      </c:pt>
                      <c:pt idx="711">
                        <c:v>3927</c:v>
                      </c:pt>
                      <c:pt idx="712">
                        <c:v>3001</c:v>
                      </c:pt>
                      <c:pt idx="713">
                        <c:v>2572</c:v>
                      </c:pt>
                      <c:pt idx="714">
                        <c:v>3415</c:v>
                      </c:pt>
                      <c:pt idx="715">
                        <c:v>3697</c:v>
                      </c:pt>
                      <c:pt idx="716">
                        <c:v>3370</c:v>
                      </c:pt>
                      <c:pt idx="717">
                        <c:v>4014</c:v>
                      </c:pt>
                      <c:pt idx="718">
                        <c:v>2696</c:v>
                      </c:pt>
                      <c:pt idx="719">
                        <c:v>2666</c:v>
                      </c:pt>
                      <c:pt idx="720">
                        <c:v>2697</c:v>
                      </c:pt>
                      <c:pt idx="721">
                        <c:v>3537</c:v>
                      </c:pt>
                      <c:pt idx="722">
                        <c:v>2789</c:v>
                      </c:pt>
                      <c:pt idx="723">
                        <c:v>2876</c:v>
                      </c:pt>
                      <c:pt idx="724">
                        <c:v>2992</c:v>
                      </c:pt>
                      <c:pt idx="725">
                        <c:v>3330</c:v>
                      </c:pt>
                      <c:pt idx="726">
                        <c:v>3187</c:v>
                      </c:pt>
                      <c:pt idx="727">
                        <c:v>3916</c:v>
                      </c:pt>
                      <c:pt idx="728">
                        <c:v>2378</c:v>
                      </c:pt>
                      <c:pt idx="729">
                        <c:v>1818</c:v>
                      </c:pt>
                      <c:pt idx="730">
                        <c:v>2402</c:v>
                      </c:pt>
                      <c:pt idx="731">
                        <c:v>2199</c:v>
                      </c:pt>
                      <c:pt idx="732">
                        <c:v>4011</c:v>
                      </c:pt>
                      <c:pt idx="733">
                        <c:v>3511</c:v>
                      </c:pt>
                      <c:pt idx="734">
                        <c:v>2868</c:v>
                      </c:pt>
                      <c:pt idx="735">
                        <c:v>2621</c:v>
                      </c:pt>
                      <c:pt idx="736">
                        <c:v>3034</c:v>
                      </c:pt>
                      <c:pt idx="737">
                        <c:v>2855</c:v>
                      </c:pt>
                      <c:pt idx="738">
                        <c:v>3835</c:v>
                      </c:pt>
                      <c:pt idx="739">
                        <c:v>2580</c:v>
                      </c:pt>
                      <c:pt idx="740">
                        <c:v>2962</c:v>
                      </c:pt>
                      <c:pt idx="741">
                        <c:v>3190</c:v>
                      </c:pt>
                      <c:pt idx="742">
                        <c:v>213</c:v>
                      </c:pt>
                      <c:pt idx="743">
                        <c:v>3555</c:v>
                      </c:pt>
                      <c:pt idx="744">
                        <c:v>2175</c:v>
                      </c:pt>
                      <c:pt idx="745">
                        <c:v>2542</c:v>
                      </c:pt>
                      <c:pt idx="746">
                        <c:v>3925</c:v>
                      </c:pt>
                      <c:pt idx="747">
                        <c:v>2846</c:v>
                      </c:pt>
                      <c:pt idx="748">
                        <c:v>2503</c:v>
                      </c:pt>
                      <c:pt idx="749">
                        <c:v>2630</c:v>
                      </c:pt>
                      <c:pt idx="750">
                        <c:v>3247</c:v>
                      </c:pt>
                      <c:pt idx="751">
                        <c:v>4010</c:v>
                      </c:pt>
                      <c:pt idx="752">
                        <c:v>3913</c:v>
                      </c:pt>
                      <c:pt idx="753">
                        <c:v>2007</c:v>
                      </c:pt>
                      <c:pt idx="754">
                        <c:v>3972</c:v>
                      </c:pt>
                      <c:pt idx="755">
                        <c:v>3320</c:v>
                      </c:pt>
                      <c:pt idx="756">
                        <c:v>3911</c:v>
                      </c:pt>
                      <c:pt idx="757">
                        <c:v>3612</c:v>
                      </c:pt>
                      <c:pt idx="758">
                        <c:v>1668</c:v>
                      </c:pt>
                      <c:pt idx="759">
                        <c:v>3671</c:v>
                      </c:pt>
                      <c:pt idx="760">
                        <c:v>2694</c:v>
                      </c:pt>
                      <c:pt idx="761">
                        <c:v>3846</c:v>
                      </c:pt>
                      <c:pt idx="762">
                        <c:v>3915</c:v>
                      </c:pt>
                      <c:pt idx="763">
                        <c:v>3327</c:v>
                      </c:pt>
                      <c:pt idx="764">
                        <c:v>3618</c:v>
                      </c:pt>
                      <c:pt idx="765">
                        <c:v>717</c:v>
                      </c:pt>
                      <c:pt idx="766">
                        <c:v>1229</c:v>
                      </c:pt>
                      <c:pt idx="767">
                        <c:v>2167</c:v>
                      </c:pt>
                      <c:pt idx="768">
                        <c:v>3677</c:v>
                      </c:pt>
                      <c:pt idx="769">
                        <c:v>3323</c:v>
                      </c:pt>
                      <c:pt idx="770">
                        <c:v>2971</c:v>
                      </c:pt>
                      <c:pt idx="771">
                        <c:v>1801</c:v>
                      </c:pt>
                      <c:pt idx="772">
                        <c:v>2320</c:v>
                      </c:pt>
                      <c:pt idx="773">
                        <c:v>3538</c:v>
                      </c:pt>
                      <c:pt idx="774">
                        <c:v>613</c:v>
                      </c:pt>
                      <c:pt idx="775">
                        <c:v>1889</c:v>
                      </c:pt>
                      <c:pt idx="776">
                        <c:v>3850</c:v>
                      </c:pt>
                      <c:pt idx="777">
                        <c:v>2045</c:v>
                      </c:pt>
                      <c:pt idx="778">
                        <c:v>3550</c:v>
                      </c:pt>
                      <c:pt idx="779">
                        <c:v>3905</c:v>
                      </c:pt>
                      <c:pt idx="780">
                        <c:v>3584</c:v>
                      </c:pt>
                      <c:pt idx="781">
                        <c:v>2209</c:v>
                      </c:pt>
                      <c:pt idx="782">
                        <c:v>3163</c:v>
                      </c:pt>
                      <c:pt idx="783">
                        <c:v>3381</c:v>
                      </c:pt>
                      <c:pt idx="784">
                        <c:v>3560</c:v>
                      </c:pt>
                      <c:pt idx="785">
                        <c:v>1968</c:v>
                      </c:pt>
                      <c:pt idx="786">
                        <c:v>1558</c:v>
                      </c:pt>
                      <c:pt idx="787">
                        <c:v>2771</c:v>
                      </c:pt>
                      <c:pt idx="788">
                        <c:v>3061</c:v>
                      </c:pt>
                      <c:pt idx="789">
                        <c:v>3363</c:v>
                      </c:pt>
                      <c:pt idx="790">
                        <c:v>3548</c:v>
                      </c:pt>
                      <c:pt idx="791">
                        <c:v>2176</c:v>
                      </c:pt>
                      <c:pt idx="792">
                        <c:v>922</c:v>
                      </c:pt>
                      <c:pt idx="793">
                        <c:v>2703</c:v>
                      </c:pt>
                      <c:pt idx="794">
                        <c:v>2472</c:v>
                      </c:pt>
                      <c:pt idx="795">
                        <c:v>3251</c:v>
                      </c:pt>
                      <c:pt idx="796">
                        <c:v>3718</c:v>
                      </c:pt>
                      <c:pt idx="797">
                        <c:v>1511</c:v>
                      </c:pt>
                      <c:pt idx="798">
                        <c:v>2686</c:v>
                      </c:pt>
                      <c:pt idx="799">
                        <c:v>4008</c:v>
                      </c:pt>
                      <c:pt idx="800">
                        <c:v>3953</c:v>
                      </c:pt>
                      <c:pt idx="801">
                        <c:v>2910</c:v>
                      </c:pt>
                      <c:pt idx="802">
                        <c:v>3505</c:v>
                      </c:pt>
                      <c:pt idx="803">
                        <c:v>3844</c:v>
                      </c:pt>
                      <c:pt idx="804">
                        <c:v>2791</c:v>
                      </c:pt>
                      <c:pt idx="805">
                        <c:v>1667</c:v>
                      </c:pt>
                      <c:pt idx="806">
                        <c:v>3162</c:v>
                      </c:pt>
                      <c:pt idx="807">
                        <c:v>2404</c:v>
                      </c:pt>
                      <c:pt idx="808">
                        <c:v>3384</c:v>
                      </c:pt>
                      <c:pt idx="809">
                        <c:v>1636</c:v>
                      </c:pt>
                      <c:pt idx="810">
                        <c:v>2326</c:v>
                      </c:pt>
                      <c:pt idx="811">
                        <c:v>3527</c:v>
                      </c:pt>
                      <c:pt idx="812">
                        <c:v>3297</c:v>
                      </c:pt>
                      <c:pt idx="813">
                        <c:v>3891</c:v>
                      </c:pt>
                      <c:pt idx="814">
                        <c:v>3094</c:v>
                      </c:pt>
                      <c:pt idx="815">
                        <c:v>2721</c:v>
                      </c:pt>
                      <c:pt idx="816">
                        <c:v>3506</c:v>
                      </c:pt>
                      <c:pt idx="817">
                        <c:v>3148</c:v>
                      </c:pt>
                      <c:pt idx="818">
                        <c:v>3553</c:v>
                      </c:pt>
                      <c:pt idx="819">
                        <c:v>3852</c:v>
                      </c:pt>
                      <c:pt idx="820">
                        <c:v>4001</c:v>
                      </c:pt>
                      <c:pt idx="821">
                        <c:v>3890</c:v>
                      </c:pt>
                      <c:pt idx="822">
                        <c:v>3539</c:v>
                      </c:pt>
                      <c:pt idx="823">
                        <c:v>2242</c:v>
                      </c:pt>
                      <c:pt idx="824">
                        <c:v>3938</c:v>
                      </c:pt>
                      <c:pt idx="825">
                        <c:v>1554</c:v>
                      </c:pt>
                      <c:pt idx="826">
                        <c:v>1772</c:v>
                      </c:pt>
                      <c:pt idx="827">
                        <c:v>2511</c:v>
                      </c:pt>
                      <c:pt idx="828">
                        <c:v>2569</c:v>
                      </c:pt>
                      <c:pt idx="829">
                        <c:v>3006</c:v>
                      </c:pt>
                      <c:pt idx="830">
                        <c:v>3191</c:v>
                      </c:pt>
                      <c:pt idx="831">
                        <c:v>3880</c:v>
                      </c:pt>
                      <c:pt idx="832">
                        <c:v>2615</c:v>
                      </c:pt>
                      <c:pt idx="833">
                        <c:v>1675</c:v>
                      </c:pt>
                      <c:pt idx="834">
                        <c:v>2133</c:v>
                      </c:pt>
                      <c:pt idx="835">
                        <c:v>3312</c:v>
                      </c:pt>
                      <c:pt idx="836">
                        <c:v>1887</c:v>
                      </c:pt>
                      <c:pt idx="837">
                        <c:v>3249</c:v>
                      </c:pt>
                      <c:pt idx="838">
                        <c:v>1707</c:v>
                      </c:pt>
                      <c:pt idx="839">
                        <c:v>3147</c:v>
                      </c:pt>
                      <c:pt idx="840">
                        <c:v>3694</c:v>
                      </c:pt>
                      <c:pt idx="841">
                        <c:v>3993</c:v>
                      </c:pt>
                      <c:pt idx="842">
                        <c:v>3138</c:v>
                      </c:pt>
                      <c:pt idx="843">
                        <c:v>1324</c:v>
                      </c:pt>
                      <c:pt idx="844">
                        <c:v>1656</c:v>
                      </c:pt>
                      <c:pt idx="845">
                        <c:v>2869</c:v>
                      </c:pt>
                      <c:pt idx="846">
                        <c:v>3233</c:v>
                      </c:pt>
                      <c:pt idx="847">
                        <c:v>1913</c:v>
                      </c:pt>
                      <c:pt idx="848">
                        <c:v>2365</c:v>
                      </c:pt>
                      <c:pt idx="849">
                        <c:v>2719</c:v>
                      </c:pt>
                      <c:pt idx="850">
                        <c:v>3767</c:v>
                      </c:pt>
                      <c:pt idx="851">
                        <c:v>2679</c:v>
                      </c:pt>
                      <c:pt idx="852">
                        <c:v>3137</c:v>
                      </c:pt>
                      <c:pt idx="853">
                        <c:v>3315</c:v>
                      </c:pt>
                      <c:pt idx="854">
                        <c:v>3241</c:v>
                      </c:pt>
                      <c:pt idx="855">
                        <c:v>4000</c:v>
                      </c:pt>
                      <c:pt idx="856">
                        <c:v>3508</c:v>
                      </c:pt>
                      <c:pt idx="857">
                        <c:v>2927</c:v>
                      </c:pt>
                      <c:pt idx="858">
                        <c:v>3970</c:v>
                      </c:pt>
                      <c:pt idx="859">
                        <c:v>777</c:v>
                      </c:pt>
                      <c:pt idx="860">
                        <c:v>3992</c:v>
                      </c:pt>
                      <c:pt idx="861">
                        <c:v>3670</c:v>
                      </c:pt>
                      <c:pt idx="862">
                        <c:v>2070</c:v>
                      </c:pt>
                      <c:pt idx="863">
                        <c:v>4035</c:v>
                      </c:pt>
                      <c:pt idx="864">
                        <c:v>212</c:v>
                      </c:pt>
                      <c:pt idx="865">
                        <c:v>2605</c:v>
                      </c:pt>
                      <c:pt idx="866">
                        <c:v>3619</c:v>
                      </c:pt>
                      <c:pt idx="867">
                        <c:v>3337</c:v>
                      </c:pt>
                      <c:pt idx="868">
                        <c:v>3263</c:v>
                      </c:pt>
                      <c:pt idx="869">
                        <c:v>3108</c:v>
                      </c:pt>
                      <c:pt idx="870">
                        <c:v>3701</c:v>
                      </c:pt>
                      <c:pt idx="871">
                        <c:v>3408</c:v>
                      </c:pt>
                      <c:pt idx="872">
                        <c:v>2782</c:v>
                      </c:pt>
                      <c:pt idx="873">
                        <c:v>1969</c:v>
                      </c:pt>
                      <c:pt idx="874">
                        <c:v>843</c:v>
                      </c:pt>
                      <c:pt idx="875">
                        <c:v>3564</c:v>
                      </c:pt>
                      <c:pt idx="876">
                        <c:v>3643</c:v>
                      </c:pt>
                      <c:pt idx="877">
                        <c:v>3649</c:v>
                      </c:pt>
                      <c:pt idx="878">
                        <c:v>1659</c:v>
                      </c:pt>
                      <c:pt idx="879">
                        <c:v>3166</c:v>
                      </c:pt>
                      <c:pt idx="880">
                        <c:v>3849</c:v>
                      </c:pt>
                      <c:pt idx="881">
                        <c:v>2150</c:v>
                      </c:pt>
                      <c:pt idx="882">
                        <c:v>2746</c:v>
                      </c:pt>
                      <c:pt idx="883">
                        <c:v>265</c:v>
                      </c:pt>
                      <c:pt idx="884">
                        <c:v>1888</c:v>
                      </c:pt>
                      <c:pt idx="885">
                        <c:v>3595</c:v>
                      </c:pt>
                      <c:pt idx="886">
                        <c:v>1052</c:v>
                      </c:pt>
                      <c:pt idx="887">
                        <c:v>3578</c:v>
                      </c:pt>
                      <c:pt idx="888">
                        <c:v>2555</c:v>
                      </c:pt>
                      <c:pt idx="889">
                        <c:v>3590</c:v>
                      </c:pt>
                      <c:pt idx="890">
                        <c:v>3952</c:v>
                      </c:pt>
                      <c:pt idx="891">
                        <c:v>2877</c:v>
                      </c:pt>
                      <c:pt idx="892">
                        <c:v>3119</c:v>
                      </c:pt>
                      <c:pt idx="893">
                        <c:v>2772</c:v>
                      </c:pt>
                      <c:pt idx="894">
                        <c:v>2350</c:v>
                      </c:pt>
                      <c:pt idx="895">
                        <c:v>2902</c:v>
                      </c:pt>
                      <c:pt idx="896">
                        <c:v>3195</c:v>
                      </c:pt>
                      <c:pt idx="897">
                        <c:v>3286</c:v>
                      </c:pt>
                      <c:pt idx="898">
                        <c:v>685</c:v>
                      </c:pt>
                      <c:pt idx="899">
                        <c:v>3575</c:v>
                      </c:pt>
                      <c:pt idx="900">
                        <c:v>2505</c:v>
                      </c:pt>
                      <c:pt idx="901">
                        <c:v>2916</c:v>
                      </c:pt>
                      <c:pt idx="902">
                        <c:v>3387</c:v>
                      </c:pt>
                      <c:pt idx="903">
                        <c:v>2448</c:v>
                      </c:pt>
                      <c:pt idx="904">
                        <c:v>2553</c:v>
                      </c:pt>
                      <c:pt idx="905">
                        <c:v>2095</c:v>
                      </c:pt>
                      <c:pt idx="906">
                        <c:v>1478</c:v>
                      </c:pt>
                      <c:pt idx="907">
                        <c:v>3745</c:v>
                      </c:pt>
                      <c:pt idx="908">
                        <c:v>3631</c:v>
                      </c:pt>
                      <c:pt idx="909">
                        <c:v>4038</c:v>
                      </c:pt>
                      <c:pt idx="910">
                        <c:v>643</c:v>
                      </c:pt>
                      <c:pt idx="911">
                        <c:v>956</c:v>
                      </c:pt>
                      <c:pt idx="912">
                        <c:v>3945</c:v>
                      </c:pt>
                      <c:pt idx="913">
                        <c:v>2607</c:v>
                      </c:pt>
                      <c:pt idx="914">
                        <c:v>2618</c:v>
                      </c:pt>
                      <c:pt idx="915">
                        <c:v>3533</c:v>
                      </c:pt>
                      <c:pt idx="916">
                        <c:v>3675</c:v>
                      </c:pt>
                      <c:pt idx="917">
                        <c:v>2222</c:v>
                      </c:pt>
                      <c:pt idx="918">
                        <c:v>3551</c:v>
                      </c:pt>
                      <c:pt idx="919">
                        <c:v>3862</c:v>
                      </c:pt>
                      <c:pt idx="920">
                        <c:v>2025</c:v>
                      </c:pt>
                      <c:pt idx="921">
                        <c:v>1369</c:v>
                      </c:pt>
                      <c:pt idx="922">
                        <c:v>2172</c:v>
                      </c:pt>
                      <c:pt idx="923">
                        <c:v>3662</c:v>
                      </c:pt>
                      <c:pt idx="924">
                        <c:v>2995</c:v>
                      </c:pt>
                      <c:pt idx="925">
                        <c:v>2957</c:v>
                      </c:pt>
                      <c:pt idx="926">
                        <c:v>2842</c:v>
                      </c:pt>
                      <c:pt idx="927">
                        <c:v>3961</c:v>
                      </c:pt>
                      <c:pt idx="928">
                        <c:v>3658</c:v>
                      </c:pt>
                      <c:pt idx="929">
                        <c:v>3261</c:v>
                      </c:pt>
                      <c:pt idx="930">
                        <c:v>3908</c:v>
                      </c:pt>
                      <c:pt idx="931">
                        <c:v>2904</c:v>
                      </c:pt>
                      <c:pt idx="932">
                        <c:v>3502</c:v>
                      </c:pt>
                      <c:pt idx="933">
                        <c:v>2374</c:v>
                      </c:pt>
                      <c:pt idx="934">
                        <c:v>3214</c:v>
                      </c:pt>
                      <c:pt idx="935">
                        <c:v>1474</c:v>
                      </c:pt>
                      <c:pt idx="936">
                        <c:v>3144</c:v>
                      </c:pt>
                      <c:pt idx="937">
                        <c:v>3374</c:v>
                      </c:pt>
                      <c:pt idx="938">
                        <c:v>2059</c:v>
                      </c:pt>
                      <c:pt idx="939">
                        <c:v>2925</c:v>
                      </c:pt>
                      <c:pt idx="940">
                        <c:v>2373</c:v>
                      </c:pt>
                      <c:pt idx="941">
                        <c:v>3647</c:v>
                      </c:pt>
                      <c:pt idx="942">
                        <c:v>2585</c:v>
                      </c:pt>
                      <c:pt idx="943">
                        <c:v>3168</c:v>
                      </c:pt>
                      <c:pt idx="944">
                        <c:v>2948</c:v>
                      </c:pt>
                      <c:pt idx="945">
                        <c:v>4021</c:v>
                      </c:pt>
                      <c:pt idx="946">
                        <c:v>896</c:v>
                      </c:pt>
                      <c:pt idx="947">
                        <c:v>3577</c:v>
                      </c:pt>
                      <c:pt idx="948">
                        <c:v>3226</c:v>
                      </c:pt>
                      <c:pt idx="949">
                        <c:v>3029</c:v>
                      </c:pt>
                      <c:pt idx="950">
                        <c:v>2104</c:v>
                      </c:pt>
                      <c:pt idx="951">
                        <c:v>2257</c:v>
                      </c:pt>
                      <c:pt idx="952">
                        <c:v>3293</c:v>
                      </c:pt>
                      <c:pt idx="953">
                        <c:v>3056</c:v>
                      </c:pt>
                      <c:pt idx="954">
                        <c:v>2395</c:v>
                      </c:pt>
                      <c:pt idx="955">
                        <c:v>1105</c:v>
                      </c:pt>
                      <c:pt idx="956">
                        <c:v>3839</c:v>
                      </c:pt>
                      <c:pt idx="957">
                        <c:v>3023</c:v>
                      </c:pt>
                      <c:pt idx="958">
                        <c:v>3188</c:v>
                      </c:pt>
                      <c:pt idx="959">
                        <c:v>3554</c:v>
                      </c:pt>
                      <c:pt idx="960">
                        <c:v>2574</c:v>
                      </c:pt>
                      <c:pt idx="961">
                        <c:v>1738</c:v>
                      </c:pt>
                      <c:pt idx="962">
                        <c:v>770</c:v>
                      </c:pt>
                      <c:pt idx="963">
                        <c:v>2240</c:v>
                      </c:pt>
                      <c:pt idx="964">
                        <c:v>2466</c:v>
                      </c:pt>
                      <c:pt idx="965">
                        <c:v>1316</c:v>
                      </c:pt>
                      <c:pt idx="966">
                        <c:v>3669</c:v>
                      </c:pt>
                      <c:pt idx="967">
                        <c:v>4004</c:v>
                      </c:pt>
                      <c:pt idx="968">
                        <c:v>2324</c:v>
                      </c:pt>
                      <c:pt idx="969">
                        <c:v>3955</c:v>
                      </c:pt>
                      <c:pt idx="970">
                        <c:v>3411</c:v>
                      </c:pt>
                      <c:pt idx="971">
                        <c:v>3664</c:v>
                      </c:pt>
                      <c:pt idx="972">
                        <c:v>3321</c:v>
                      </c:pt>
                      <c:pt idx="973">
                        <c:v>3545</c:v>
                      </c:pt>
                      <c:pt idx="974">
                        <c:v>3432</c:v>
                      </c:pt>
                      <c:pt idx="975">
                        <c:v>3650</c:v>
                      </c:pt>
                      <c:pt idx="976">
                        <c:v>3728</c:v>
                      </c:pt>
                      <c:pt idx="977">
                        <c:v>3525</c:v>
                      </c:pt>
                      <c:pt idx="978">
                        <c:v>3974</c:v>
                      </c:pt>
                      <c:pt idx="979">
                        <c:v>2439</c:v>
                      </c:pt>
                      <c:pt idx="980">
                        <c:v>2824</c:v>
                      </c:pt>
                      <c:pt idx="981">
                        <c:v>2954</c:v>
                      </c:pt>
                      <c:pt idx="982">
                        <c:v>2591</c:v>
                      </c:pt>
                      <c:pt idx="983">
                        <c:v>3145</c:v>
                      </c:pt>
                      <c:pt idx="984">
                        <c:v>2029</c:v>
                      </c:pt>
                      <c:pt idx="985">
                        <c:v>3772</c:v>
                      </c:pt>
                      <c:pt idx="986">
                        <c:v>1777</c:v>
                      </c:pt>
                      <c:pt idx="987">
                        <c:v>2276</c:v>
                      </c:pt>
                      <c:pt idx="988">
                        <c:v>2725</c:v>
                      </c:pt>
                      <c:pt idx="989">
                        <c:v>3095</c:v>
                      </c:pt>
                      <c:pt idx="990">
                        <c:v>1633</c:v>
                      </c:pt>
                      <c:pt idx="991">
                        <c:v>2875</c:v>
                      </c:pt>
                      <c:pt idx="992">
                        <c:v>3692</c:v>
                      </c:pt>
                      <c:pt idx="993">
                        <c:v>3923</c:v>
                      </c:pt>
                      <c:pt idx="994">
                        <c:v>2452</c:v>
                      </c:pt>
                      <c:pt idx="995">
                        <c:v>3258</c:v>
                      </c:pt>
                    </c:numCache>
                  </c:numRef>
                </c:xVal>
                <c:yVal>
                  <c:numRef>
                    <c:extLst>
                      <c:ext uri="{02D57815-91ED-43cb-92C2-25804820EDAC}">
                        <c15:formulaRef>
                          <c15:sqref>AGO1a!$C$2:$C$1002</c15:sqref>
                        </c15:formulaRef>
                      </c:ext>
                    </c:extLst>
                    <c:numCache>
                      <c:formatCode>General</c:formatCode>
                      <c:ptCount val="1001"/>
                      <c:pt idx="0">
                        <c:v>4</c:v>
                      </c:pt>
                      <c:pt idx="9">
                        <c:v>1</c:v>
                      </c:pt>
                      <c:pt idx="11">
                        <c:v>1</c:v>
                      </c:pt>
                      <c:pt idx="15">
                        <c:v>1</c:v>
                      </c:pt>
                      <c:pt idx="18">
                        <c:v>1</c:v>
                      </c:pt>
                      <c:pt idx="20">
                        <c:v>1</c:v>
                      </c:pt>
                      <c:pt idx="21">
                        <c:v>1</c:v>
                      </c:pt>
                      <c:pt idx="22">
                        <c:v>1</c:v>
                      </c:pt>
                      <c:pt idx="25">
                        <c:v>1</c:v>
                      </c:pt>
                      <c:pt idx="28">
                        <c:v>1</c:v>
                      </c:pt>
                      <c:pt idx="31">
                        <c:v>1</c:v>
                      </c:pt>
                      <c:pt idx="32">
                        <c:v>1</c:v>
                      </c:pt>
                      <c:pt idx="34">
                        <c:v>1</c:v>
                      </c:pt>
                      <c:pt idx="36">
                        <c:v>1</c:v>
                      </c:pt>
                      <c:pt idx="38">
                        <c:v>1</c:v>
                      </c:pt>
                      <c:pt idx="41">
                        <c:v>1</c:v>
                      </c:pt>
                      <c:pt idx="44">
                        <c:v>1</c:v>
                      </c:pt>
                      <c:pt idx="46">
                        <c:v>1</c:v>
                      </c:pt>
                      <c:pt idx="48">
                        <c:v>1</c:v>
                      </c:pt>
                      <c:pt idx="58">
                        <c:v>1</c:v>
                      </c:pt>
                      <c:pt idx="59">
                        <c:v>1</c:v>
                      </c:pt>
                      <c:pt idx="60">
                        <c:v>1</c:v>
                      </c:pt>
                      <c:pt idx="62">
                        <c:v>1</c:v>
                      </c:pt>
                      <c:pt idx="66">
                        <c:v>1</c:v>
                      </c:pt>
                      <c:pt idx="67">
                        <c:v>1</c:v>
                      </c:pt>
                      <c:pt idx="73">
                        <c:v>1</c:v>
                      </c:pt>
                      <c:pt idx="75">
                        <c:v>1</c:v>
                      </c:pt>
                      <c:pt idx="86">
                        <c:v>1</c:v>
                      </c:pt>
                      <c:pt idx="90">
                        <c:v>1</c:v>
                      </c:pt>
                      <c:pt idx="91">
                        <c:v>1</c:v>
                      </c:pt>
                      <c:pt idx="93">
                        <c:v>1</c:v>
                      </c:pt>
                      <c:pt idx="94">
                        <c:v>1</c:v>
                      </c:pt>
                      <c:pt idx="103">
                        <c:v>1</c:v>
                      </c:pt>
                      <c:pt idx="108">
                        <c:v>1</c:v>
                      </c:pt>
                      <c:pt idx="114">
                        <c:v>1</c:v>
                      </c:pt>
                      <c:pt idx="118">
                        <c:v>1</c:v>
                      </c:pt>
                      <c:pt idx="119">
                        <c:v>1</c:v>
                      </c:pt>
                      <c:pt idx="120">
                        <c:v>1</c:v>
                      </c:pt>
                      <c:pt idx="122">
                        <c:v>1</c:v>
                      </c:pt>
                      <c:pt idx="126">
                        <c:v>1</c:v>
                      </c:pt>
                      <c:pt idx="132">
                        <c:v>1</c:v>
                      </c:pt>
                      <c:pt idx="135">
                        <c:v>1</c:v>
                      </c:pt>
                      <c:pt idx="136">
                        <c:v>1</c:v>
                      </c:pt>
                      <c:pt idx="139">
                        <c:v>1</c:v>
                      </c:pt>
                      <c:pt idx="143">
                        <c:v>2</c:v>
                      </c:pt>
                      <c:pt idx="145">
                        <c:v>1</c:v>
                      </c:pt>
                      <c:pt idx="146">
                        <c:v>1</c:v>
                      </c:pt>
                      <c:pt idx="147">
                        <c:v>1</c:v>
                      </c:pt>
                      <c:pt idx="150">
                        <c:v>1</c:v>
                      </c:pt>
                      <c:pt idx="151">
                        <c:v>1</c:v>
                      </c:pt>
                      <c:pt idx="152">
                        <c:v>1</c:v>
                      </c:pt>
                      <c:pt idx="154">
                        <c:v>1</c:v>
                      </c:pt>
                      <c:pt idx="156">
                        <c:v>2</c:v>
                      </c:pt>
                      <c:pt idx="159">
                        <c:v>1</c:v>
                      </c:pt>
                      <c:pt idx="160">
                        <c:v>1</c:v>
                      </c:pt>
                      <c:pt idx="161">
                        <c:v>1</c:v>
                      </c:pt>
                      <c:pt idx="162">
                        <c:v>1</c:v>
                      </c:pt>
                      <c:pt idx="164">
                        <c:v>1</c:v>
                      </c:pt>
                      <c:pt idx="170">
                        <c:v>1</c:v>
                      </c:pt>
                      <c:pt idx="174">
                        <c:v>1</c:v>
                      </c:pt>
                      <c:pt idx="175">
                        <c:v>1</c:v>
                      </c:pt>
                      <c:pt idx="177">
                        <c:v>1</c:v>
                      </c:pt>
                      <c:pt idx="178">
                        <c:v>1</c:v>
                      </c:pt>
                      <c:pt idx="186">
                        <c:v>1</c:v>
                      </c:pt>
                      <c:pt idx="188">
                        <c:v>1</c:v>
                      </c:pt>
                      <c:pt idx="190">
                        <c:v>1</c:v>
                      </c:pt>
                      <c:pt idx="195">
                        <c:v>1</c:v>
                      </c:pt>
                      <c:pt idx="197">
                        <c:v>1</c:v>
                      </c:pt>
                      <c:pt idx="199">
                        <c:v>1</c:v>
                      </c:pt>
                      <c:pt idx="201">
                        <c:v>1</c:v>
                      </c:pt>
                      <c:pt idx="202">
                        <c:v>1</c:v>
                      </c:pt>
                      <c:pt idx="203">
                        <c:v>1</c:v>
                      </c:pt>
                      <c:pt idx="204">
                        <c:v>1</c:v>
                      </c:pt>
                      <c:pt idx="210">
                        <c:v>1</c:v>
                      </c:pt>
                      <c:pt idx="211">
                        <c:v>1</c:v>
                      </c:pt>
                      <c:pt idx="212">
                        <c:v>1</c:v>
                      </c:pt>
                      <c:pt idx="215">
                        <c:v>1</c:v>
                      </c:pt>
                      <c:pt idx="224">
                        <c:v>1</c:v>
                      </c:pt>
                      <c:pt idx="225">
                        <c:v>1</c:v>
                      </c:pt>
                      <c:pt idx="226">
                        <c:v>2</c:v>
                      </c:pt>
                      <c:pt idx="229">
                        <c:v>1</c:v>
                      </c:pt>
                      <c:pt idx="232">
                        <c:v>3</c:v>
                      </c:pt>
                      <c:pt idx="234">
                        <c:v>1</c:v>
                      </c:pt>
                      <c:pt idx="237">
                        <c:v>1</c:v>
                      </c:pt>
                      <c:pt idx="238">
                        <c:v>1</c:v>
                      </c:pt>
                      <c:pt idx="240">
                        <c:v>1</c:v>
                      </c:pt>
                      <c:pt idx="244">
                        <c:v>1</c:v>
                      </c:pt>
                      <c:pt idx="251">
                        <c:v>1</c:v>
                      </c:pt>
                      <c:pt idx="254">
                        <c:v>2</c:v>
                      </c:pt>
                      <c:pt idx="257">
                        <c:v>1</c:v>
                      </c:pt>
                      <c:pt idx="259">
                        <c:v>1</c:v>
                      </c:pt>
                      <c:pt idx="264">
                        <c:v>6</c:v>
                      </c:pt>
                      <c:pt idx="267">
                        <c:v>1</c:v>
                      </c:pt>
                      <c:pt idx="268">
                        <c:v>1</c:v>
                      </c:pt>
                      <c:pt idx="269">
                        <c:v>1</c:v>
                      </c:pt>
                      <c:pt idx="270">
                        <c:v>1</c:v>
                      </c:pt>
                      <c:pt idx="275">
                        <c:v>1</c:v>
                      </c:pt>
                      <c:pt idx="276">
                        <c:v>1</c:v>
                      </c:pt>
                      <c:pt idx="277">
                        <c:v>1</c:v>
                      </c:pt>
                      <c:pt idx="279">
                        <c:v>1</c:v>
                      </c:pt>
                      <c:pt idx="280">
                        <c:v>1</c:v>
                      </c:pt>
                      <c:pt idx="282">
                        <c:v>1</c:v>
                      </c:pt>
                      <c:pt idx="283">
                        <c:v>1</c:v>
                      </c:pt>
                      <c:pt idx="287">
                        <c:v>1</c:v>
                      </c:pt>
                      <c:pt idx="288">
                        <c:v>1</c:v>
                      </c:pt>
                      <c:pt idx="290">
                        <c:v>1</c:v>
                      </c:pt>
                      <c:pt idx="291">
                        <c:v>1</c:v>
                      </c:pt>
                      <c:pt idx="293">
                        <c:v>1</c:v>
                      </c:pt>
                      <c:pt idx="294">
                        <c:v>2</c:v>
                      </c:pt>
                      <c:pt idx="299">
                        <c:v>1</c:v>
                      </c:pt>
                      <c:pt idx="300">
                        <c:v>1</c:v>
                      </c:pt>
                      <c:pt idx="301">
                        <c:v>1</c:v>
                      </c:pt>
                      <c:pt idx="302">
                        <c:v>1</c:v>
                      </c:pt>
                      <c:pt idx="306">
                        <c:v>1</c:v>
                      </c:pt>
                      <c:pt idx="307">
                        <c:v>1</c:v>
                      </c:pt>
                      <c:pt idx="310">
                        <c:v>1</c:v>
                      </c:pt>
                      <c:pt idx="312">
                        <c:v>1</c:v>
                      </c:pt>
                      <c:pt idx="318">
                        <c:v>1</c:v>
                      </c:pt>
                      <c:pt idx="320">
                        <c:v>1</c:v>
                      </c:pt>
                      <c:pt idx="321">
                        <c:v>1</c:v>
                      </c:pt>
                      <c:pt idx="322">
                        <c:v>1</c:v>
                      </c:pt>
                      <c:pt idx="324">
                        <c:v>1</c:v>
                      </c:pt>
                      <c:pt idx="326">
                        <c:v>1</c:v>
                      </c:pt>
                      <c:pt idx="327">
                        <c:v>1</c:v>
                      </c:pt>
                      <c:pt idx="335">
                        <c:v>1</c:v>
                      </c:pt>
                      <c:pt idx="336">
                        <c:v>1</c:v>
                      </c:pt>
                      <c:pt idx="338">
                        <c:v>1</c:v>
                      </c:pt>
                      <c:pt idx="339">
                        <c:v>1</c:v>
                      </c:pt>
                      <c:pt idx="343">
                        <c:v>1</c:v>
                      </c:pt>
                      <c:pt idx="345">
                        <c:v>1</c:v>
                      </c:pt>
                      <c:pt idx="350">
                        <c:v>1</c:v>
                      </c:pt>
                      <c:pt idx="352">
                        <c:v>1</c:v>
                      </c:pt>
                      <c:pt idx="356">
                        <c:v>1</c:v>
                      </c:pt>
                      <c:pt idx="357">
                        <c:v>1</c:v>
                      </c:pt>
                      <c:pt idx="358">
                        <c:v>1</c:v>
                      </c:pt>
                      <c:pt idx="359">
                        <c:v>2</c:v>
                      </c:pt>
                      <c:pt idx="380">
                        <c:v>1</c:v>
                      </c:pt>
                      <c:pt idx="381">
                        <c:v>1</c:v>
                      </c:pt>
                      <c:pt idx="384">
                        <c:v>2</c:v>
                      </c:pt>
                      <c:pt idx="385">
                        <c:v>1</c:v>
                      </c:pt>
                      <c:pt idx="391">
                        <c:v>1</c:v>
                      </c:pt>
                      <c:pt idx="394">
                        <c:v>1</c:v>
                      </c:pt>
                      <c:pt idx="395">
                        <c:v>1</c:v>
                      </c:pt>
                      <c:pt idx="396">
                        <c:v>2</c:v>
                      </c:pt>
                      <c:pt idx="399">
                        <c:v>1</c:v>
                      </c:pt>
                      <c:pt idx="401">
                        <c:v>1</c:v>
                      </c:pt>
                      <c:pt idx="404">
                        <c:v>1</c:v>
                      </c:pt>
                      <c:pt idx="406">
                        <c:v>1</c:v>
                      </c:pt>
                      <c:pt idx="408">
                        <c:v>1</c:v>
                      </c:pt>
                      <c:pt idx="409">
                        <c:v>1</c:v>
                      </c:pt>
                      <c:pt idx="410">
                        <c:v>1</c:v>
                      </c:pt>
                      <c:pt idx="413">
                        <c:v>1</c:v>
                      </c:pt>
                      <c:pt idx="416">
                        <c:v>1</c:v>
                      </c:pt>
                      <c:pt idx="419">
                        <c:v>1</c:v>
                      </c:pt>
                      <c:pt idx="422">
                        <c:v>7</c:v>
                      </c:pt>
                      <c:pt idx="423">
                        <c:v>1</c:v>
                      </c:pt>
                      <c:pt idx="426">
                        <c:v>1</c:v>
                      </c:pt>
                      <c:pt idx="427">
                        <c:v>1</c:v>
                      </c:pt>
                      <c:pt idx="429">
                        <c:v>1</c:v>
                      </c:pt>
                      <c:pt idx="430">
                        <c:v>1</c:v>
                      </c:pt>
                      <c:pt idx="431">
                        <c:v>1</c:v>
                      </c:pt>
                      <c:pt idx="432">
                        <c:v>1</c:v>
                      </c:pt>
                      <c:pt idx="433">
                        <c:v>1</c:v>
                      </c:pt>
                      <c:pt idx="434">
                        <c:v>1</c:v>
                      </c:pt>
                      <c:pt idx="436">
                        <c:v>1</c:v>
                      </c:pt>
                      <c:pt idx="437">
                        <c:v>1</c:v>
                      </c:pt>
                      <c:pt idx="439">
                        <c:v>1</c:v>
                      </c:pt>
                      <c:pt idx="440">
                        <c:v>1</c:v>
                      </c:pt>
                      <c:pt idx="441">
                        <c:v>1</c:v>
                      </c:pt>
                      <c:pt idx="442">
                        <c:v>6</c:v>
                      </c:pt>
                      <c:pt idx="443">
                        <c:v>1</c:v>
                      </c:pt>
                      <c:pt idx="444">
                        <c:v>1</c:v>
                      </c:pt>
                      <c:pt idx="446">
                        <c:v>1</c:v>
                      </c:pt>
                      <c:pt idx="453">
                        <c:v>1</c:v>
                      </c:pt>
                      <c:pt idx="455">
                        <c:v>1</c:v>
                      </c:pt>
                      <c:pt idx="456">
                        <c:v>1</c:v>
                      </c:pt>
                      <c:pt idx="461">
                        <c:v>1</c:v>
                      </c:pt>
                      <c:pt idx="464">
                        <c:v>1</c:v>
                      </c:pt>
                      <c:pt idx="472">
                        <c:v>1</c:v>
                      </c:pt>
                      <c:pt idx="478">
                        <c:v>1</c:v>
                      </c:pt>
                      <c:pt idx="482">
                        <c:v>1</c:v>
                      </c:pt>
                      <c:pt idx="483">
                        <c:v>1</c:v>
                      </c:pt>
                      <c:pt idx="488">
                        <c:v>1</c:v>
                      </c:pt>
                      <c:pt idx="491">
                        <c:v>1</c:v>
                      </c:pt>
                      <c:pt idx="492">
                        <c:v>1</c:v>
                      </c:pt>
                      <c:pt idx="494">
                        <c:v>1</c:v>
                      </c:pt>
                      <c:pt idx="495">
                        <c:v>4</c:v>
                      </c:pt>
                      <c:pt idx="496">
                        <c:v>1</c:v>
                      </c:pt>
                      <c:pt idx="502">
                        <c:v>1</c:v>
                      </c:pt>
                      <c:pt idx="505">
                        <c:v>1</c:v>
                      </c:pt>
                      <c:pt idx="510">
                        <c:v>1</c:v>
                      </c:pt>
                      <c:pt idx="512">
                        <c:v>1</c:v>
                      </c:pt>
                      <c:pt idx="513">
                        <c:v>1</c:v>
                      </c:pt>
                      <c:pt idx="518">
                        <c:v>1</c:v>
                      </c:pt>
                      <c:pt idx="522">
                        <c:v>1</c:v>
                      </c:pt>
                      <c:pt idx="523">
                        <c:v>1</c:v>
                      </c:pt>
                      <c:pt idx="528">
                        <c:v>1</c:v>
                      </c:pt>
                      <c:pt idx="529">
                        <c:v>1</c:v>
                      </c:pt>
                      <c:pt idx="533">
                        <c:v>1</c:v>
                      </c:pt>
                      <c:pt idx="534">
                        <c:v>1</c:v>
                      </c:pt>
                      <c:pt idx="536">
                        <c:v>1</c:v>
                      </c:pt>
                      <c:pt idx="537">
                        <c:v>1</c:v>
                      </c:pt>
                      <c:pt idx="539">
                        <c:v>1</c:v>
                      </c:pt>
                      <c:pt idx="542">
                        <c:v>1</c:v>
                      </c:pt>
                      <c:pt idx="546">
                        <c:v>1</c:v>
                      </c:pt>
                      <c:pt idx="548">
                        <c:v>1</c:v>
                      </c:pt>
                      <c:pt idx="551">
                        <c:v>1</c:v>
                      </c:pt>
                      <c:pt idx="552">
                        <c:v>1</c:v>
                      </c:pt>
                      <c:pt idx="554">
                        <c:v>1</c:v>
                      </c:pt>
                      <c:pt idx="556">
                        <c:v>1</c:v>
                      </c:pt>
                      <c:pt idx="559">
                        <c:v>1</c:v>
                      </c:pt>
                      <c:pt idx="562">
                        <c:v>1</c:v>
                      </c:pt>
                      <c:pt idx="567">
                        <c:v>1</c:v>
                      </c:pt>
                      <c:pt idx="571">
                        <c:v>1</c:v>
                      </c:pt>
                      <c:pt idx="574">
                        <c:v>1</c:v>
                      </c:pt>
                      <c:pt idx="579">
                        <c:v>1</c:v>
                      </c:pt>
                      <c:pt idx="584">
                        <c:v>1</c:v>
                      </c:pt>
                      <c:pt idx="587">
                        <c:v>1</c:v>
                      </c:pt>
                      <c:pt idx="588">
                        <c:v>1</c:v>
                      </c:pt>
                      <c:pt idx="591">
                        <c:v>1</c:v>
                      </c:pt>
                      <c:pt idx="592">
                        <c:v>1</c:v>
                      </c:pt>
                      <c:pt idx="595">
                        <c:v>1</c:v>
                      </c:pt>
                      <c:pt idx="602">
                        <c:v>1</c:v>
                      </c:pt>
                      <c:pt idx="604">
                        <c:v>1</c:v>
                      </c:pt>
                      <c:pt idx="605">
                        <c:v>1</c:v>
                      </c:pt>
                      <c:pt idx="609">
                        <c:v>1</c:v>
                      </c:pt>
                      <c:pt idx="613">
                        <c:v>1</c:v>
                      </c:pt>
                      <c:pt idx="615">
                        <c:v>1</c:v>
                      </c:pt>
                      <c:pt idx="623">
                        <c:v>1</c:v>
                      </c:pt>
                      <c:pt idx="629">
                        <c:v>1</c:v>
                      </c:pt>
                      <c:pt idx="631">
                        <c:v>1</c:v>
                      </c:pt>
                      <c:pt idx="632">
                        <c:v>1</c:v>
                      </c:pt>
                      <c:pt idx="638">
                        <c:v>1</c:v>
                      </c:pt>
                      <c:pt idx="639">
                        <c:v>1</c:v>
                      </c:pt>
                      <c:pt idx="641">
                        <c:v>1</c:v>
                      </c:pt>
                      <c:pt idx="645">
                        <c:v>1</c:v>
                      </c:pt>
                      <c:pt idx="646">
                        <c:v>1</c:v>
                      </c:pt>
                      <c:pt idx="647">
                        <c:v>1</c:v>
                      </c:pt>
                      <c:pt idx="648">
                        <c:v>1</c:v>
                      </c:pt>
                      <c:pt idx="653">
                        <c:v>1</c:v>
                      </c:pt>
                      <c:pt idx="655">
                        <c:v>1</c:v>
                      </c:pt>
                      <c:pt idx="660">
                        <c:v>1</c:v>
                      </c:pt>
                      <c:pt idx="661">
                        <c:v>1</c:v>
                      </c:pt>
                      <c:pt idx="664">
                        <c:v>1</c:v>
                      </c:pt>
                      <c:pt idx="674">
                        <c:v>1</c:v>
                      </c:pt>
                      <c:pt idx="676">
                        <c:v>1</c:v>
                      </c:pt>
                      <c:pt idx="679">
                        <c:v>1</c:v>
                      </c:pt>
                      <c:pt idx="681">
                        <c:v>1</c:v>
                      </c:pt>
                      <c:pt idx="688">
                        <c:v>1</c:v>
                      </c:pt>
                      <c:pt idx="689">
                        <c:v>1</c:v>
                      </c:pt>
                      <c:pt idx="691">
                        <c:v>1</c:v>
                      </c:pt>
                      <c:pt idx="695">
                        <c:v>1</c:v>
                      </c:pt>
                      <c:pt idx="696">
                        <c:v>1</c:v>
                      </c:pt>
                      <c:pt idx="703">
                        <c:v>1</c:v>
                      </c:pt>
                      <c:pt idx="707">
                        <c:v>2</c:v>
                      </c:pt>
                      <c:pt idx="710">
                        <c:v>5</c:v>
                      </c:pt>
                      <c:pt idx="713">
                        <c:v>1</c:v>
                      </c:pt>
                      <c:pt idx="715">
                        <c:v>1</c:v>
                      </c:pt>
                      <c:pt idx="718">
                        <c:v>1</c:v>
                      </c:pt>
                      <c:pt idx="719">
                        <c:v>1</c:v>
                      </c:pt>
                      <c:pt idx="723">
                        <c:v>1</c:v>
                      </c:pt>
                      <c:pt idx="724">
                        <c:v>1</c:v>
                      </c:pt>
                      <c:pt idx="726">
                        <c:v>1</c:v>
                      </c:pt>
                      <c:pt idx="727">
                        <c:v>1</c:v>
                      </c:pt>
                      <c:pt idx="732">
                        <c:v>1</c:v>
                      </c:pt>
                      <c:pt idx="741">
                        <c:v>1</c:v>
                      </c:pt>
                      <c:pt idx="749">
                        <c:v>1</c:v>
                      </c:pt>
                      <c:pt idx="751">
                        <c:v>1</c:v>
                      </c:pt>
                      <c:pt idx="752">
                        <c:v>6</c:v>
                      </c:pt>
                      <c:pt idx="753">
                        <c:v>1</c:v>
                      </c:pt>
                      <c:pt idx="755">
                        <c:v>1</c:v>
                      </c:pt>
                      <c:pt idx="757">
                        <c:v>1</c:v>
                      </c:pt>
                      <c:pt idx="761">
                        <c:v>5</c:v>
                      </c:pt>
                      <c:pt idx="764">
                        <c:v>1</c:v>
                      </c:pt>
                      <c:pt idx="768">
                        <c:v>1</c:v>
                      </c:pt>
                      <c:pt idx="769">
                        <c:v>1</c:v>
                      </c:pt>
                      <c:pt idx="773">
                        <c:v>1</c:v>
                      </c:pt>
                      <c:pt idx="776">
                        <c:v>1</c:v>
                      </c:pt>
                      <c:pt idx="777">
                        <c:v>1</c:v>
                      </c:pt>
                      <c:pt idx="779">
                        <c:v>1</c:v>
                      </c:pt>
                      <c:pt idx="780">
                        <c:v>2</c:v>
                      </c:pt>
                      <c:pt idx="783">
                        <c:v>1</c:v>
                      </c:pt>
                      <c:pt idx="792">
                        <c:v>1</c:v>
                      </c:pt>
                      <c:pt idx="799">
                        <c:v>1</c:v>
                      </c:pt>
                      <c:pt idx="803">
                        <c:v>1</c:v>
                      </c:pt>
                      <c:pt idx="812">
                        <c:v>1</c:v>
                      </c:pt>
                      <c:pt idx="813">
                        <c:v>3</c:v>
                      </c:pt>
                      <c:pt idx="815">
                        <c:v>1</c:v>
                      </c:pt>
                      <c:pt idx="819">
                        <c:v>1</c:v>
                      </c:pt>
                      <c:pt idx="822">
                        <c:v>1</c:v>
                      </c:pt>
                      <c:pt idx="823">
                        <c:v>1</c:v>
                      </c:pt>
                      <c:pt idx="828">
                        <c:v>1</c:v>
                      </c:pt>
                      <c:pt idx="831">
                        <c:v>1</c:v>
                      </c:pt>
                      <c:pt idx="836">
                        <c:v>1</c:v>
                      </c:pt>
                      <c:pt idx="837">
                        <c:v>1</c:v>
                      </c:pt>
                      <c:pt idx="839">
                        <c:v>1</c:v>
                      </c:pt>
                      <c:pt idx="840">
                        <c:v>1</c:v>
                      </c:pt>
                      <c:pt idx="843">
                        <c:v>1</c:v>
                      </c:pt>
                      <c:pt idx="846">
                        <c:v>1</c:v>
                      </c:pt>
                      <c:pt idx="847">
                        <c:v>1</c:v>
                      </c:pt>
                      <c:pt idx="850">
                        <c:v>1</c:v>
                      </c:pt>
                      <c:pt idx="853">
                        <c:v>1</c:v>
                      </c:pt>
                      <c:pt idx="854">
                        <c:v>1</c:v>
                      </c:pt>
                      <c:pt idx="855">
                        <c:v>1</c:v>
                      </c:pt>
                      <c:pt idx="856">
                        <c:v>1</c:v>
                      </c:pt>
                      <c:pt idx="858">
                        <c:v>1</c:v>
                      </c:pt>
                      <c:pt idx="860">
                        <c:v>1</c:v>
                      </c:pt>
                      <c:pt idx="863">
                        <c:v>1</c:v>
                      </c:pt>
                      <c:pt idx="866">
                        <c:v>1</c:v>
                      </c:pt>
                      <c:pt idx="868">
                        <c:v>1</c:v>
                      </c:pt>
                      <c:pt idx="870">
                        <c:v>1</c:v>
                      </c:pt>
                      <c:pt idx="871">
                        <c:v>1</c:v>
                      </c:pt>
                      <c:pt idx="873">
                        <c:v>1</c:v>
                      </c:pt>
                      <c:pt idx="875">
                        <c:v>1</c:v>
                      </c:pt>
                      <c:pt idx="876">
                        <c:v>1</c:v>
                      </c:pt>
                      <c:pt idx="877">
                        <c:v>1</c:v>
                      </c:pt>
                      <c:pt idx="879">
                        <c:v>1</c:v>
                      </c:pt>
                      <c:pt idx="881">
                        <c:v>1</c:v>
                      </c:pt>
                      <c:pt idx="885">
                        <c:v>1</c:v>
                      </c:pt>
                      <c:pt idx="887">
                        <c:v>1</c:v>
                      </c:pt>
                      <c:pt idx="890">
                        <c:v>1</c:v>
                      </c:pt>
                      <c:pt idx="892">
                        <c:v>1</c:v>
                      </c:pt>
                      <c:pt idx="894">
                        <c:v>1</c:v>
                      </c:pt>
                      <c:pt idx="895">
                        <c:v>1</c:v>
                      </c:pt>
                      <c:pt idx="899">
                        <c:v>1</c:v>
                      </c:pt>
                      <c:pt idx="900">
                        <c:v>1</c:v>
                      </c:pt>
                      <c:pt idx="912">
                        <c:v>1</c:v>
                      </c:pt>
                      <c:pt idx="913">
                        <c:v>1</c:v>
                      </c:pt>
                      <c:pt idx="914">
                        <c:v>1</c:v>
                      </c:pt>
                      <c:pt idx="916">
                        <c:v>1</c:v>
                      </c:pt>
                      <c:pt idx="923">
                        <c:v>1</c:v>
                      </c:pt>
                      <c:pt idx="929">
                        <c:v>1</c:v>
                      </c:pt>
                      <c:pt idx="937">
                        <c:v>1</c:v>
                      </c:pt>
                      <c:pt idx="938">
                        <c:v>1</c:v>
                      </c:pt>
                      <c:pt idx="939">
                        <c:v>1</c:v>
                      </c:pt>
                      <c:pt idx="942">
                        <c:v>1</c:v>
                      </c:pt>
                      <c:pt idx="943">
                        <c:v>1</c:v>
                      </c:pt>
                      <c:pt idx="945">
                        <c:v>1</c:v>
                      </c:pt>
                      <c:pt idx="947">
                        <c:v>1</c:v>
                      </c:pt>
                      <c:pt idx="948">
                        <c:v>1</c:v>
                      </c:pt>
                      <c:pt idx="949">
                        <c:v>2</c:v>
                      </c:pt>
                      <c:pt idx="953">
                        <c:v>1</c:v>
                      </c:pt>
                      <c:pt idx="957">
                        <c:v>3</c:v>
                      </c:pt>
                      <c:pt idx="961">
                        <c:v>1</c:v>
                      </c:pt>
                      <c:pt idx="963">
                        <c:v>1</c:v>
                      </c:pt>
                      <c:pt idx="967">
                        <c:v>1</c:v>
                      </c:pt>
                      <c:pt idx="969">
                        <c:v>1</c:v>
                      </c:pt>
                      <c:pt idx="970">
                        <c:v>1</c:v>
                      </c:pt>
                      <c:pt idx="972">
                        <c:v>1</c:v>
                      </c:pt>
                      <c:pt idx="975">
                        <c:v>1</c:v>
                      </c:pt>
                      <c:pt idx="976">
                        <c:v>1</c:v>
                      </c:pt>
                      <c:pt idx="977">
                        <c:v>1</c:v>
                      </c:pt>
                      <c:pt idx="981">
                        <c:v>1</c:v>
                      </c:pt>
                      <c:pt idx="982">
                        <c:v>1</c:v>
                      </c:pt>
                      <c:pt idx="983">
                        <c:v>1</c:v>
                      </c:pt>
                      <c:pt idx="990">
                        <c:v>1</c:v>
                      </c:pt>
                      <c:pt idx="995">
                        <c:v>2</c:v>
                      </c:pt>
                    </c:numCache>
                  </c:numRef>
                </c:yVal>
                <c:smooth val="0"/>
              </c15:ser>
            </c15:filteredScatterSeries>
            <c15:filteredScatterSeries>
              <c15:ser>
                <c:idx val="1"/>
                <c:order val="1"/>
                <c:tx>
                  <c:strRef>
                    <c:extLst xmlns:c15="http://schemas.microsoft.com/office/drawing/2012/chart">
                      <c:ext xmlns:c15="http://schemas.microsoft.com/office/drawing/2012/chart" uri="{02D57815-91ED-43cb-92C2-25804820EDAC}">
                        <c15:formulaRef>
                          <c15:sqref>AGO1a!$D$1</c15:sqref>
                        </c15:formulaRef>
                      </c:ext>
                    </c:extLst>
                    <c:strCache>
                      <c:ptCount val="1"/>
                      <c:pt idx="0">
                        <c:v>BDI490bcDNA_tplot</c:v>
                      </c:pt>
                    </c:strCache>
                  </c:strRef>
                </c:tx>
                <c:spPr>
                  <a:ln w="19050" cap="rnd">
                    <a:noFill/>
                    <a:round/>
                  </a:ln>
                  <a:effectLst/>
                </c:spPr>
                <c:marker>
                  <c:symbol val="circle"/>
                  <c:size val="5"/>
                  <c:spPr>
                    <a:solidFill>
                      <a:schemeClr val="accent2"/>
                    </a:solidFill>
                    <a:ln w="9525">
                      <a:solidFill>
                        <a:schemeClr val="accent2"/>
                      </a:solidFill>
                    </a:ln>
                    <a:effectLst/>
                  </c:spPr>
                </c:marker>
                <c:xVal>
                  <c:numRef>
                    <c:extLst xmlns:c15="http://schemas.microsoft.com/office/drawing/2012/chart">
                      <c:ext xmlns:c15="http://schemas.microsoft.com/office/drawing/2012/chart" uri="{02D57815-91ED-43cb-92C2-25804820EDAC}">
                        <c15:formulaRef>
                          <c15:sqref>AGO1a!$B$2:$B$1002</c15:sqref>
                        </c15:formulaRef>
                      </c:ext>
                    </c:extLst>
                    <c:numCache>
                      <c:formatCode>General</c:formatCode>
                      <c:ptCount val="1001"/>
                      <c:pt idx="0">
                        <c:v>3583</c:v>
                      </c:pt>
                      <c:pt idx="1">
                        <c:v>2443</c:v>
                      </c:pt>
                      <c:pt idx="2">
                        <c:v>2713</c:v>
                      </c:pt>
                      <c:pt idx="3">
                        <c:v>3344</c:v>
                      </c:pt>
                      <c:pt idx="4">
                        <c:v>2251</c:v>
                      </c:pt>
                      <c:pt idx="5">
                        <c:v>3693</c:v>
                      </c:pt>
                      <c:pt idx="6">
                        <c:v>1477</c:v>
                      </c:pt>
                      <c:pt idx="7">
                        <c:v>3872</c:v>
                      </c:pt>
                      <c:pt idx="8">
                        <c:v>3871</c:v>
                      </c:pt>
                      <c:pt idx="9">
                        <c:v>3404</c:v>
                      </c:pt>
                      <c:pt idx="10">
                        <c:v>2409</c:v>
                      </c:pt>
                      <c:pt idx="11">
                        <c:v>3714</c:v>
                      </c:pt>
                      <c:pt idx="12">
                        <c:v>1420</c:v>
                      </c:pt>
                      <c:pt idx="13">
                        <c:v>3967</c:v>
                      </c:pt>
                      <c:pt idx="14">
                        <c:v>2893</c:v>
                      </c:pt>
                      <c:pt idx="15">
                        <c:v>3641</c:v>
                      </c:pt>
                      <c:pt idx="16">
                        <c:v>3271</c:v>
                      </c:pt>
                      <c:pt idx="17">
                        <c:v>2641</c:v>
                      </c:pt>
                      <c:pt idx="18">
                        <c:v>3549</c:v>
                      </c:pt>
                      <c:pt idx="19">
                        <c:v>1941</c:v>
                      </c:pt>
                      <c:pt idx="20">
                        <c:v>2664</c:v>
                      </c:pt>
                      <c:pt idx="21">
                        <c:v>3924</c:v>
                      </c:pt>
                      <c:pt idx="22">
                        <c:v>3707</c:v>
                      </c:pt>
                      <c:pt idx="23">
                        <c:v>2278</c:v>
                      </c:pt>
                      <c:pt idx="24">
                        <c:v>3457</c:v>
                      </c:pt>
                      <c:pt idx="25">
                        <c:v>3546</c:v>
                      </c:pt>
                      <c:pt idx="26">
                        <c:v>3319</c:v>
                      </c:pt>
                      <c:pt idx="27">
                        <c:v>2821</c:v>
                      </c:pt>
                      <c:pt idx="28">
                        <c:v>2403</c:v>
                      </c:pt>
                      <c:pt idx="29">
                        <c:v>864</c:v>
                      </c:pt>
                      <c:pt idx="30">
                        <c:v>1729</c:v>
                      </c:pt>
                      <c:pt idx="31">
                        <c:v>3322</c:v>
                      </c:pt>
                      <c:pt idx="32">
                        <c:v>3378</c:v>
                      </c:pt>
                      <c:pt idx="33">
                        <c:v>3633</c:v>
                      </c:pt>
                      <c:pt idx="34">
                        <c:v>3579</c:v>
                      </c:pt>
                      <c:pt idx="35">
                        <c:v>2054</c:v>
                      </c:pt>
                      <c:pt idx="36">
                        <c:v>2164</c:v>
                      </c:pt>
                      <c:pt idx="37">
                        <c:v>2766</c:v>
                      </c:pt>
                      <c:pt idx="38">
                        <c:v>3688</c:v>
                      </c:pt>
                      <c:pt idx="39">
                        <c:v>4050</c:v>
                      </c:pt>
                      <c:pt idx="40">
                        <c:v>3248</c:v>
                      </c:pt>
                      <c:pt idx="41">
                        <c:v>2981</c:v>
                      </c:pt>
                      <c:pt idx="42">
                        <c:v>2548</c:v>
                      </c:pt>
                      <c:pt idx="43">
                        <c:v>3840</c:v>
                      </c:pt>
                      <c:pt idx="44">
                        <c:v>3954</c:v>
                      </c:pt>
                      <c:pt idx="45">
                        <c:v>868</c:v>
                      </c:pt>
                      <c:pt idx="46">
                        <c:v>3818</c:v>
                      </c:pt>
                      <c:pt idx="47">
                        <c:v>3735</c:v>
                      </c:pt>
                      <c:pt idx="48">
                        <c:v>2999</c:v>
                      </c:pt>
                      <c:pt idx="49">
                        <c:v>3475</c:v>
                      </c:pt>
                      <c:pt idx="50">
                        <c:v>2720</c:v>
                      </c:pt>
                      <c:pt idx="51">
                        <c:v>3933</c:v>
                      </c:pt>
                      <c:pt idx="52">
                        <c:v>3622</c:v>
                      </c:pt>
                      <c:pt idx="53">
                        <c:v>3934</c:v>
                      </c:pt>
                      <c:pt idx="54">
                        <c:v>3075</c:v>
                      </c:pt>
                      <c:pt idx="55">
                        <c:v>2114</c:v>
                      </c:pt>
                      <c:pt idx="56">
                        <c:v>3931</c:v>
                      </c:pt>
                      <c:pt idx="57">
                        <c:v>2386</c:v>
                      </c:pt>
                      <c:pt idx="58">
                        <c:v>3576</c:v>
                      </c:pt>
                      <c:pt idx="59">
                        <c:v>3674</c:v>
                      </c:pt>
                      <c:pt idx="60">
                        <c:v>3507</c:v>
                      </c:pt>
                      <c:pt idx="61">
                        <c:v>3648</c:v>
                      </c:pt>
                      <c:pt idx="62">
                        <c:v>3848</c:v>
                      </c:pt>
                      <c:pt idx="63">
                        <c:v>1032</c:v>
                      </c:pt>
                      <c:pt idx="64">
                        <c:v>3014</c:v>
                      </c:pt>
                      <c:pt idx="65">
                        <c:v>2057</c:v>
                      </c:pt>
                      <c:pt idx="66">
                        <c:v>3037</c:v>
                      </c:pt>
                      <c:pt idx="67">
                        <c:v>3917</c:v>
                      </c:pt>
                      <c:pt idx="68">
                        <c:v>3022</c:v>
                      </c:pt>
                      <c:pt idx="69">
                        <c:v>2250</c:v>
                      </c:pt>
                      <c:pt idx="70">
                        <c:v>4017</c:v>
                      </c:pt>
                      <c:pt idx="71">
                        <c:v>4006</c:v>
                      </c:pt>
                      <c:pt idx="72">
                        <c:v>2552</c:v>
                      </c:pt>
                      <c:pt idx="73">
                        <c:v>3906</c:v>
                      </c:pt>
                      <c:pt idx="74">
                        <c:v>2212</c:v>
                      </c:pt>
                      <c:pt idx="75">
                        <c:v>4023</c:v>
                      </c:pt>
                      <c:pt idx="76">
                        <c:v>2656</c:v>
                      </c:pt>
                      <c:pt idx="77">
                        <c:v>3199</c:v>
                      </c:pt>
                      <c:pt idx="78">
                        <c:v>2774</c:v>
                      </c:pt>
                      <c:pt idx="79">
                        <c:v>3592</c:v>
                      </c:pt>
                      <c:pt idx="80">
                        <c:v>2938</c:v>
                      </c:pt>
                      <c:pt idx="81">
                        <c:v>2330</c:v>
                      </c:pt>
                      <c:pt idx="82">
                        <c:v>1395</c:v>
                      </c:pt>
                      <c:pt idx="83">
                        <c:v>2375</c:v>
                      </c:pt>
                      <c:pt idx="84">
                        <c:v>3621</c:v>
                      </c:pt>
                      <c:pt idx="85">
                        <c:v>3398</c:v>
                      </c:pt>
                      <c:pt idx="86">
                        <c:v>3333</c:v>
                      </c:pt>
                      <c:pt idx="87">
                        <c:v>3461</c:v>
                      </c:pt>
                      <c:pt idx="88">
                        <c:v>3150</c:v>
                      </c:pt>
                      <c:pt idx="89">
                        <c:v>3032</c:v>
                      </c:pt>
                      <c:pt idx="90">
                        <c:v>1185</c:v>
                      </c:pt>
                      <c:pt idx="91">
                        <c:v>3625</c:v>
                      </c:pt>
                      <c:pt idx="92">
                        <c:v>2949</c:v>
                      </c:pt>
                      <c:pt idx="93">
                        <c:v>3888</c:v>
                      </c:pt>
                      <c:pt idx="94">
                        <c:v>2945</c:v>
                      </c:pt>
                      <c:pt idx="95">
                        <c:v>4029</c:v>
                      </c:pt>
                      <c:pt idx="96">
                        <c:v>2906</c:v>
                      </c:pt>
                      <c:pt idx="97">
                        <c:v>3158</c:v>
                      </c:pt>
                      <c:pt idx="98">
                        <c:v>2327</c:v>
                      </c:pt>
                      <c:pt idx="99">
                        <c:v>1654</c:v>
                      </c:pt>
                      <c:pt idx="100">
                        <c:v>3105</c:v>
                      </c:pt>
                      <c:pt idx="101">
                        <c:v>3309</c:v>
                      </c:pt>
                      <c:pt idx="102">
                        <c:v>1422</c:v>
                      </c:pt>
                      <c:pt idx="103">
                        <c:v>1826</c:v>
                      </c:pt>
                      <c:pt idx="104">
                        <c:v>2901</c:v>
                      </c:pt>
                      <c:pt idx="105">
                        <c:v>3732</c:v>
                      </c:pt>
                      <c:pt idx="106">
                        <c:v>1930</c:v>
                      </c:pt>
                      <c:pt idx="107">
                        <c:v>3300</c:v>
                      </c:pt>
                      <c:pt idx="108">
                        <c:v>1444</c:v>
                      </c:pt>
                      <c:pt idx="109">
                        <c:v>1914</c:v>
                      </c:pt>
                      <c:pt idx="110">
                        <c:v>1805</c:v>
                      </c:pt>
                      <c:pt idx="111">
                        <c:v>1598</c:v>
                      </c:pt>
                      <c:pt idx="112">
                        <c:v>2016</c:v>
                      </c:pt>
                      <c:pt idx="113">
                        <c:v>2500</c:v>
                      </c:pt>
                      <c:pt idx="114">
                        <c:v>3569</c:v>
                      </c:pt>
                      <c:pt idx="115">
                        <c:v>3005</c:v>
                      </c:pt>
                      <c:pt idx="116">
                        <c:v>3405</c:v>
                      </c:pt>
                      <c:pt idx="117">
                        <c:v>1966</c:v>
                      </c:pt>
                      <c:pt idx="118">
                        <c:v>1820</c:v>
                      </c:pt>
                      <c:pt idx="119">
                        <c:v>2137</c:v>
                      </c:pt>
                      <c:pt idx="120">
                        <c:v>3388</c:v>
                      </c:pt>
                      <c:pt idx="121">
                        <c:v>1040</c:v>
                      </c:pt>
                      <c:pt idx="122">
                        <c:v>3997</c:v>
                      </c:pt>
                      <c:pt idx="123">
                        <c:v>1666</c:v>
                      </c:pt>
                      <c:pt idx="124">
                        <c:v>1973</c:v>
                      </c:pt>
                      <c:pt idx="125">
                        <c:v>3317</c:v>
                      </c:pt>
                      <c:pt idx="126">
                        <c:v>2787</c:v>
                      </c:pt>
                      <c:pt idx="127">
                        <c:v>2692</c:v>
                      </c:pt>
                      <c:pt idx="128">
                        <c:v>3096</c:v>
                      </c:pt>
                      <c:pt idx="129">
                        <c:v>3273</c:v>
                      </c:pt>
                      <c:pt idx="130">
                        <c:v>2382</c:v>
                      </c:pt>
                      <c:pt idx="131">
                        <c:v>3899</c:v>
                      </c:pt>
                      <c:pt idx="132">
                        <c:v>4022</c:v>
                      </c:pt>
                      <c:pt idx="133">
                        <c:v>2071</c:v>
                      </c:pt>
                      <c:pt idx="134">
                        <c:v>2063</c:v>
                      </c:pt>
                      <c:pt idx="135">
                        <c:v>2136</c:v>
                      </c:pt>
                      <c:pt idx="136">
                        <c:v>2964</c:v>
                      </c:pt>
                      <c:pt idx="137">
                        <c:v>2159</c:v>
                      </c:pt>
                      <c:pt idx="138">
                        <c:v>1886</c:v>
                      </c:pt>
                      <c:pt idx="139">
                        <c:v>3116</c:v>
                      </c:pt>
                      <c:pt idx="140">
                        <c:v>3291</c:v>
                      </c:pt>
                      <c:pt idx="141">
                        <c:v>2693</c:v>
                      </c:pt>
                      <c:pt idx="142">
                        <c:v>4012</c:v>
                      </c:pt>
                      <c:pt idx="143">
                        <c:v>3027</c:v>
                      </c:pt>
                      <c:pt idx="144">
                        <c:v>2450</c:v>
                      </c:pt>
                      <c:pt idx="145">
                        <c:v>3460</c:v>
                      </c:pt>
                      <c:pt idx="146">
                        <c:v>3940</c:v>
                      </c:pt>
                      <c:pt idx="147">
                        <c:v>2880</c:v>
                      </c:pt>
                      <c:pt idx="148">
                        <c:v>2770</c:v>
                      </c:pt>
                      <c:pt idx="149">
                        <c:v>3151</c:v>
                      </c:pt>
                      <c:pt idx="150">
                        <c:v>3698</c:v>
                      </c:pt>
                      <c:pt idx="151">
                        <c:v>3652</c:v>
                      </c:pt>
                      <c:pt idx="152">
                        <c:v>3220</c:v>
                      </c:pt>
                      <c:pt idx="153">
                        <c:v>3126</c:v>
                      </c:pt>
                      <c:pt idx="154">
                        <c:v>3443</c:v>
                      </c:pt>
                      <c:pt idx="155">
                        <c:v>3964</c:v>
                      </c:pt>
                      <c:pt idx="156">
                        <c:v>3582</c:v>
                      </c:pt>
                      <c:pt idx="157">
                        <c:v>2408</c:v>
                      </c:pt>
                      <c:pt idx="158">
                        <c:v>3295</c:v>
                      </c:pt>
                      <c:pt idx="159">
                        <c:v>3224</c:v>
                      </c:pt>
                      <c:pt idx="160">
                        <c:v>3025</c:v>
                      </c:pt>
                      <c:pt idx="161">
                        <c:v>3667</c:v>
                      </c:pt>
                      <c:pt idx="162">
                        <c:v>2368</c:v>
                      </c:pt>
                      <c:pt idx="163">
                        <c:v>2848</c:v>
                      </c:pt>
                      <c:pt idx="164">
                        <c:v>2206</c:v>
                      </c:pt>
                      <c:pt idx="165">
                        <c:v>3645</c:v>
                      </c:pt>
                      <c:pt idx="166">
                        <c:v>3523</c:v>
                      </c:pt>
                      <c:pt idx="167">
                        <c:v>2717</c:v>
                      </c:pt>
                      <c:pt idx="168">
                        <c:v>2166</c:v>
                      </c:pt>
                      <c:pt idx="169">
                        <c:v>2198</c:v>
                      </c:pt>
                      <c:pt idx="170">
                        <c:v>2445</c:v>
                      </c:pt>
                      <c:pt idx="171">
                        <c:v>3969</c:v>
                      </c:pt>
                      <c:pt idx="172">
                        <c:v>2710</c:v>
                      </c:pt>
                      <c:pt idx="173">
                        <c:v>1912</c:v>
                      </c:pt>
                      <c:pt idx="174">
                        <c:v>3929</c:v>
                      </c:pt>
                      <c:pt idx="175">
                        <c:v>3820</c:v>
                      </c:pt>
                      <c:pt idx="176">
                        <c:v>2296</c:v>
                      </c:pt>
                      <c:pt idx="177">
                        <c:v>3038</c:v>
                      </c:pt>
                      <c:pt idx="178">
                        <c:v>1933</c:v>
                      </c:pt>
                      <c:pt idx="179">
                        <c:v>2730</c:v>
                      </c:pt>
                      <c:pt idx="180">
                        <c:v>3996</c:v>
                      </c:pt>
                      <c:pt idx="181">
                        <c:v>2061</c:v>
                      </c:pt>
                      <c:pt idx="182">
                        <c:v>3922</c:v>
                      </c:pt>
                      <c:pt idx="183">
                        <c:v>2181</c:v>
                      </c:pt>
                      <c:pt idx="184">
                        <c:v>3341</c:v>
                      </c:pt>
                      <c:pt idx="185">
                        <c:v>2667</c:v>
                      </c:pt>
                      <c:pt idx="186">
                        <c:v>2923</c:v>
                      </c:pt>
                      <c:pt idx="187">
                        <c:v>3528</c:v>
                      </c:pt>
                      <c:pt idx="188">
                        <c:v>3524</c:v>
                      </c:pt>
                      <c:pt idx="189">
                        <c:v>2668</c:v>
                      </c:pt>
                      <c:pt idx="190">
                        <c:v>3948</c:v>
                      </c:pt>
                      <c:pt idx="191">
                        <c:v>3831</c:v>
                      </c:pt>
                      <c:pt idx="192">
                        <c:v>2669</c:v>
                      </c:pt>
                      <c:pt idx="193">
                        <c:v>3743</c:v>
                      </c:pt>
                      <c:pt idx="194">
                        <c:v>841</c:v>
                      </c:pt>
                      <c:pt idx="195">
                        <c:v>3897</c:v>
                      </c:pt>
                      <c:pt idx="196">
                        <c:v>2496</c:v>
                      </c:pt>
                      <c:pt idx="197">
                        <c:v>2392</c:v>
                      </c:pt>
                      <c:pt idx="198">
                        <c:v>3383</c:v>
                      </c:pt>
                      <c:pt idx="199">
                        <c:v>3919</c:v>
                      </c:pt>
                      <c:pt idx="200">
                        <c:v>3459</c:v>
                      </c:pt>
                      <c:pt idx="201">
                        <c:v>3385</c:v>
                      </c:pt>
                      <c:pt idx="202">
                        <c:v>4005</c:v>
                      </c:pt>
                      <c:pt idx="203">
                        <c:v>4009</c:v>
                      </c:pt>
                      <c:pt idx="204">
                        <c:v>3803</c:v>
                      </c:pt>
                      <c:pt idx="205">
                        <c:v>2100</c:v>
                      </c:pt>
                      <c:pt idx="206">
                        <c:v>2933</c:v>
                      </c:pt>
                      <c:pt idx="207">
                        <c:v>1954</c:v>
                      </c:pt>
                      <c:pt idx="208">
                        <c:v>2715</c:v>
                      </c:pt>
                      <c:pt idx="209">
                        <c:v>2423</c:v>
                      </c:pt>
                      <c:pt idx="210">
                        <c:v>3377</c:v>
                      </c:pt>
                      <c:pt idx="211">
                        <c:v>3262</c:v>
                      </c:pt>
                      <c:pt idx="212">
                        <c:v>2030</c:v>
                      </c:pt>
                      <c:pt idx="213">
                        <c:v>2847</c:v>
                      </c:pt>
                      <c:pt idx="214">
                        <c:v>4039</c:v>
                      </c:pt>
                      <c:pt idx="215">
                        <c:v>2055</c:v>
                      </c:pt>
                      <c:pt idx="216">
                        <c:v>1679</c:v>
                      </c:pt>
                      <c:pt idx="217">
                        <c:v>1981</c:v>
                      </c:pt>
                      <c:pt idx="218">
                        <c:v>2396</c:v>
                      </c:pt>
                      <c:pt idx="219">
                        <c:v>4082</c:v>
                      </c:pt>
                      <c:pt idx="220">
                        <c:v>3316</c:v>
                      </c:pt>
                      <c:pt idx="221">
                        <c:v>1181</c:v>
                      </c:pt>
                      <c:pt idx="222">
                        <c:v>3673</c:v>
                      </c:pt>
                      <c:pt idx="223">
                        <c:v>1794</c:v>
                      </c:pt>
                      <c:pt idx="224">
                        <c:v>3294</c:v>
                      </c:pt>
                      <c:pt idx="225">
                        <c:v>2975</c:v>
                      </c:pt>
                      <c:pt idx="226">
                        <c:v>3580</c:v>
                      </c:pt>
                      <c:pt idx="227">
                        <c:v>3876</c:v>
                      </c:pt>
                      <c:pt idx="228">
                        <c:v>3318</c:v>
                      </c:pt>
                      <c:pt idx="229">
                        <c:v>2984</c:v>
                      </c:pt>
                      <c:pt idx="230">
                        <c:v>3189</c:v>
                      </c:pt>
                      <c:pt idx="231">
                        <c:v>2967</c:v>
                      </c:pt>
                      <c:pt idx="232">
                        <c:v>3028</c:v>
                      </c:pt>
                      <c:pt idx="233">
                        <c:v>3169</c:v>
                      </c:pt>
                      <c:pt idx="234">
                        <c:v>3288</c:v>
                      </c:pt>
                      <c:pt idx="235">
                        <c:v>3686</c:v>
                      </c:pt>
                      <c:pt idx="236">
                        <c:v>3841</c:v>
                      </c:pt>
                      <c:pt idx="237">
                        <c:v>3469</c:v>
                      </c:pt>
                      <c:pt idx="238">
                        <c:v>2988</c:v>
                      </c:pt>
                      <c:pt idx="239">
                        <c:v>3976</c:v>
                      </c:pt>
                      <c:pt idx="240">
                        <c:v>3509</c:v>
                      </c:pt>
                      <c:pt idx="241">
                        <c:v>2171</c:v>
                      </c:pt>
                      <c:pt idx="242">
                        <c:v>893</c:v>
                      </c:pt>
                      <c:pt idx="243">
                        <c:v>2589</c:v>
                      </c:pt>
                      <c:pt idx="244">
                        <c:v>2490</c:v>
                      </c:pt>
                      <c:pt idx="245">
                        <c:v>2291</c:v>
                      </c:pt>
                      <c:pt idx="246">
                        <c:v>2357</c:v>
                      </c:pt>
                      <c:pt idx="247">
                        <c:v>3654</c:v>
                      </c:pt>
                      <c:pt idx="248">
                        <c:v>3856</c:v>
                      </c:pt>
                      <c:pt idx="249">
                        <c:v>1221</c:v>
                      </c:pt>
                      <c:pt idx="250">
                        <c:v>856</c:v>
                      </c:pt>
                      <c:pt idx="251">
                        <c:v>3373</c:v>
                      </c:pt>
                      <c:pt idx="252">
                        <c:v>3290</c:v>
                      </c:pt>
                      <c:pt idx="253">
                        <c:v>3266</c:v>
                      </c:pt>
                      <c:pt idx="254">
                        <c:v>3026</c:v>
                      </c:pt>
                      <c:pt idx="255">
                        <c:v>2126</c:v>
                      </c:pt>
                      <c:pt idx="256">
                        <c:v>2588</c:v>
                      </c:pt>
                      <c:pt idx="257">
                        <c:v>2233</c:v>
                      </c:pt>
                      <c:pt idx="258">
                        <c:v>2796</c:v>
                      </c:pt>
                      <c:pt idx="259">
                        <c:v>3823</c:v>
                      </c:pt>
                      <c:pt idx="260">
                        <c:v>1883</c:v>
                      </c:pt>
                      <c:pt idx="261">
                        <c:v>1711</c:v>
                      </c:pt>
                      <c:pt idx="262">
                        <c:v>2090</c:v>
                      </c:pt>
                      <c:pt idx="263">
                        <c:v>2900</c:v>
                      </c:pt>
                      <c:pt idx="264">
                        <c:v>3024</c:v>
                      </c:pt>
                      <c:pt idx="265">
                        <c:v>3501</c:v>
                      </c:pt>
                      <c:pt idx="266">
                        <c:v>2987</c:v>
                      </c:pt>
                      <c:pt idx="267">
                        <c:v>2491</c:v>
                      </c:pt>
                      <c:pt idx="268">
                        <c:v>3541</c:v>
                      </c:pt>
                      <c:pt idx="269">
                        <c:v>3700</c:v>
                      </c:pt>
                      <c:pt idx="270">
                        <c:v>2778</c:v>
                      </c:pt>
                      <c:pt idx="271">
                        <c:v>4030</c:v>
                      </c:pt>
                      <c:pt idx="272">
                        <c:v>3215</c:v>
                      </c:pt>
                      <c:pt idx="273">
                        <c:v>475</c:v>
                      </c:pt>
                      <c:pt idx="274">
                        <c:v>2034</c:v>
                      </c:pt>
                      <c:pt idx="275">
                        <c:v>3734</c:v>
                      </c:pt>
                      <c:pt idx="276">
                        <c:v>1953</c:v>
                      </c:pt>
                      <c:pt idx="277">
                        <c:v>2146</c:v>
                      </c:pt>
                      <c:pt idx="278">
                        <c:v>2991</c:v>
                      </c:pt>
                      <c:pt idx="279">
                        <c:v>1273</c:v>
                      </c:pt>
                      <c:pt idx="280">
                        <c:v>3255</c:v>
                      </c:pt>
                      <c:pt idx="281">
                        <c:v>1923</c:v>
                      </c:pt>
                      <c:pt idx="282">
                        <c:v>2026</c:v>
                      </c:pt>
                      <c:pt idx="283">
                        <c:v>2935</c:v>
                      </c:pt>
                      <c:pt idx="284">
                        <c:v>1053</c:v>
                      </c:pt>
                      <c:pt idx="285">
                        <c:v>873</c:v>
                      </c:pt>
                      <c:pt idx="286">
                        <c:v>2134</c:v>
                      </c:pt>
                      <c:pt idx="287">
                        <c:v>2600</c:v>
                      </c:pt>
                      <c:pt idx="288">
                        <c:v>3257</c:v>
                      </c:pt>
                      <c:pt idx="289">
                        <c:v>3081</c:v>
                      </c:pt>
                      <c:pt idx="290">
                        <c:v>3334</c:v>
                      </c:pt>
                      <c:pt idx="291">
                        <c:v>3209</c:v>
                      </c:pt>
                      <c:pt idx="292">
                        <c:v>1525</c:v>
                      </c:pt>
                      <c:pt idx="293">
                        <c:v>3240</c:v>
                      </c:pt>
                      <c:pt idx="294">
                        <c:v>3259</c:v>
                      </c:pt>
                      <c:pt idx="295">
                        <c:v>3561</c:v>
                      </c:pt>
                      <c:pt idx="296">
                        <c:v>2201</c:v>
                      </c:pt>
                      <c:pt idx="297">
                        <c:v>2093</c:v>
                      </c:pt>
                      <c:pt idx="298">
                        <c:v>3855</c:v>
                      </c:pt>
                      <c:pt idx="299">
                        <c:v>3999</c:v>
                      </c:pt>
                      <c:pt idx="300">
                        <c:v>3731</c:v>
                      </c:pt>
                      <c:pt idx="301">
                        <c:v>851</c:v>
                      </c:pt>
                      <c:pt idx="302">
                        <c:v>2946</c:v>
                      </c:pt>
                      <c:pt idx="303">
                        <c:v>3536</c:v>
                      </c:pt>
                      <c:pt idx="304">
                        <c:v>2622</c:v>
                      </c:pt>
                      <c:pt idx="305">
                        <c:v>2882</c:v>
                      </c:pt>
                      <c:pt idx="306">
                        <c:v>3036</c:v>
                      </c:pt>
                      <c:pt idx="307">
                        <c:v>3441</c:v>
                      </c:pt>
                      <c:pt idx="308">
                        <c:v>2878</c:v>
                      </c:pt>
                      <c:pt idx="309">
                        <c:v>2776</c:v>
                      </c:pt>
                      <c:pt idx="310">
                        <c:v>2845</c:v>
                      </c:pt>
                      <c:pt idx="311">
                        <c:v>3882</c:v>
                      </c:pt>
                      <c:pt idx="312">
                        <c:v>3644</c:v>
                      </c:pt>
                      <c:pt idx="313">
                        <c:v>3620</c:v>
                      </c:pt>
                      <c:pt idx="314">
                        <c:v>2804</c:v>
                      </c:pt>
                      <c:pt idx="315">
                        <c:v>2258</c:v>
                      </c:pt>
                      <c:pt idx="316">
                        <c:v>3296</c:v>
                      </c:pt>
                      <c:pt idx="317">
                        <c:v>3826</c:v>
                      </c:pt>
                      <c:pt idx="318">
                        <c:v>3854</c:v>
                      </c:pt>
                      <c:pt idx="319">
                        <c:v>3284</c:v>
                      </c:pt>
                      <c:pt idx="320">
                        <c:v>3651</c:v>
                      </c:pt>
                      <c:pt idx="321">
                        <c:v>3601</c:v>
                      </c:pt>
                      <c:pt idx="322">
                        <c:v>3558</c:v>
                      </c:pt>
                      <c:pt idx="323">
                        <c:v>3510</c:v>
                      </c:pt>
                      <c:pt idx="324">
                        <c:v>1423</c:v>
                      </c:pt>
                      <c:pt idx="325">
                        <c:v>3513</c:v>
                      </c:pt>
                      <c:pt idx="326">
                        <c:v>3467</c:v>
                      </c:pt>
                      <c:pt idx="327">
                        <c:v>2390</c:v>
                      </c:pt>
                      <c:pt idx="328">
                        <c:v>2739</c:v>
                      </c:pt>
                      <c:pt idx="329">
                        <c:v>3752</c:v>
                      </c:pt>
                      <c:pt idx="330">
                        <c:v>3339</c:v>
                      </c:pt>
                      <c:pt idx="331">
                        <c:v>3627</c:v>
                      </c:pt>
                      <c:pt idx="332">
                        <c:v>3704</c:v>
                      </c:pt>
                      <c:pt idx="333">
                        <c:v>2228</c:v>
                      </c:pt>
                      <c:pt idx="334">
                        <c:v>2758</c:v>
                      </c:pt>
                      <c:pt idx="335">
                        <c:v>3588</c:v>
                      </c:pt>
                      <c:pt idx="336">
                        <c:v>2777</c:v>
                      </c:pt>
                      <c:pt idx="337">
                        <c:v>2920</c:v>
                      </c:pt>
                      <c:pt idx="338">
                        <c:v>940</c:v>
                      </c:pt>
                      <c:pt idx="339">
                        <c:v>2966</c:v>
                      </c:pt>
                      <c:pt idx="340">
                        <c:v>3659</c:v>
                      </c:pt>
                      <c:pt idx="341">
                        <c:v>1242</c:v>
                      </c:pt>
                      <c:pt idx="342">
                        <c:v>1919</c:v>
                      </c:pt>
                      <c:pt idx="343">
                        <c:v>1240</c:v>
                      </c:pt>
                      <c:pt idx="344">
                        <c:v>3637</c:v>
                      </c:pt>
                      <c:pt idx="345">
                        <c:v>3279</c:v>
                      </c:pt>
                      <c:pt idx="346">
                        <c:v>3382</c:v>
                      </c:pt>
                      <c:pt idx="347">
                        <c:v>2128</c:v>
                      </c:pt>
                      <c:pt idx="348">
                        <c:v>3758</c:v>
                      </c:pt>
                      <c:pt idx="349">
                        <c:v>3338</c:v>
                      </c:pt>
                      <c:pt idx="350">
                        <c:v>2982</c:v>
                      </c:pt>
                      <c:pt idx="351">
                        <c:v>2226</c:v>
                      </c:pt>
                      <c:pt idx="352">
                        <c:v>1938</c:v>
                      </c:pt>
                      <c:pt idx="353">
                        <c:v>3160</c:v>
                      </c:pt>
                      <c:pt idx="354">
                        <c:v>3572</c:v>
                      </c:pt>
                      <c:pt idx="355">
                        <c:v>1184</c:v>
                      </c:pt>
                      <c:pt idx="356">
                        <c:v>3879</c:v>
                      </c:pt>
                      <c:pt idx="357">
                        <c:v>3298</c:v>
                      </c:pt>
                      <c:pt idx="358">
                        <c:v>3221</c:v>
                      </c:pt>
                      <c:pt idx="359">
                        <c:v>3935</c:v>
                      </c:pt>
                      <c:pt idx="360">
                        <c:v>2351</c:v>
                      </c:pt>
                      <c:pt idx="361">
                        <c:v>3352</c:v>
                      </c:pt>
                      <c:pt idx="362">
                        <c:v>3260</c:v>
                      </c:pt>
                      <c:pt idx="363">
                        <c:v>3358</c:v>
                      </c:pt>
                      <c:pt idx="364">
                        <c:v>3957</c:v>
                      </c:pt>
                      <c:pt idx="365">
                        <c:v>3349</c:v>
                      </c:pt>
                      <c:pt idx="366">
                        <c:v>712</c:v>
                      </c:pt>
                      <c:pt idx="367">
                        <c:v>2587</c:v>
                      </c:pt>
                      <c:pt idx="368">
                        <c:v>2807</c:v>
                      </c:pt>
                      <c:pt idx="369">
                        <c:v>1775</c:v>
                      </c:pt>
                      <c:pt idx="370">
                        <c:v>3107</c:v>
                      </c:pt>
                      <c:pt idx="371">
                        <c:v>2394</c:v>
                      </c:pt>
                      <c:pt idx="372">
                        <c:v>1189</c:v>
                      </c:pt>
                      <c:pt idx="373">
                        <c:v>3636</c:v>
                      </c:pt>
                      <c:pt idx="374">
                        <c:v>1114</c:v>
                      </c:pt>
                      <c:pt idx="375">
                        <c:v>3936</c:v>
                      </c:pt>
                      <c:pt idx="376">
                        <c:v>2273</c:v>
                      </c:pt>
                      <c:pt idx="377">
                        <c:v>379</c:v>
                      </c:pt>
                      <c:pt idx="378">
                        <c:v>2453</c:v>
                      </c:pt>
                      <c:pt idx="379">
                        <c:v>2921</c:v>
                      </c:pt>
                      <c:pt idx="380">
                        <c:v>3710</c:v>
                      </c:pt>
                      <c:pt idx="381">
                        <c:v>3990</c:v>
                      </c:pt>
                      <c:pt idx="382">
                        <c:v>3730</c:v>
                      </c:pt>
                      <c:pt idx="383">
                        <c:v>2004</c:v>
                      </c:pt>
                      <c:pt idx="384">
                        <c:v>3242</c:v>
                      </c:pt>
                      <c:pt idx="385">
                        <c:v>2653</c:v>
                      </c:pt>
                      <c:pt idx="386">
                        <c:v>2943</c:v>
                      </c:pt>
                      <c:pt idx="387">
                        <c:v>2698</c:v>
                      </c:pt>
                      <c:pt idx="388">
                        <c:v>2044</c:v>
                      </c:pt>
                      <c:pt idx="389">
                        <c:v>3329</c:v>
                      </c:pt>
                      <c:pt idx="390">
                        <c:v>2125</c:v>
                      </c:pt>
                      <c:pt idx="391">
                        <c:v>3678</c:v>
                      </c:pt>
                      <c:pt idx="392">
                        <c:v>2046</c:v>
                      </c:pt>
                      <c:pt idx="393">
                        <c:v>2841</c:v>
                      </c:pt>
                      <c:pt idx="394">
                        <c:v>3543</c:v>
                      </c:pt>
                      <c:pt idx="395">
                        <c:v>3965</c:v>
                      </c:pt>
                      <c:pt idx="396">
                        <c:v>3845</c:v>
                      </c:pt>
                      <c:pt idx="397">
                        <c:v>2091</c:v>
                      </c:pt>
                      <c:pt idx="398">
                        <c:v>3062</c:v>
                      </c:pt>
                      <c:pt idx="399">
                        <c:v>2775</c:v>
                      </c:pt>
                      <c:pt idx="400">
                        <c:v>2387</c:v>
                      </c:pt>
                      <c:pt idx="401">
                        <c:v>3529</c:v>
                      </c:pt>
                      <c:pt idx="402">
                        <c:v>1461</c:v>
                      </c:pt>
                      <c:pt idx="403">
                        <c:v>3083</c:v>
                      </c:pt>
                      <c:pt idx="404">
                        <c:v>1034</c:v>
                      </c:pt>
                      <c:pt idx="405">
                        <c:v>4020</c:v>
                      </c:pt>
                      <c:pt idx="406">
                        <c:v>3918</c:v>
                      </c:pt>
                      <c:pt idx="407">
                        <c:v>4081</c:v>
                      </c:pt>
                      <c:pt idx="408">
                        <c:v>3011</c:v>
                      </c:pt>
                      <c:pt idx="409">
                        <c:v>3729</c:v>
                      </c:pt>
                      <c:pt idx="410">
                        <c:v>3335</c:v>
                      </c:pt>
                      <c:pt idx="411">
                        <c:v>1974</c:v>
                      </c:pt>
                      <c:pt idx="412">
                        <c:v>2421</c:v>
                      </c:pt>
                      <c:pt idx="413">
                        <c:v>3895</c:v>
                      </c:pt>
                      <c:pt idx="414">
                        <c:v>3609</c:v>
                      </c:pt>
                      <c:pt idx="415">
                        <c:v>3476</c:v>
                      </c:pt>
                      <c:pt idx="416">
                        <c:v>3306</c:v>
                      </c:pt>
                      <c:pt idx="417">
                        <c:v>3076</c:v>
                      </c:pt>
                      <c:pt idx="418">
                        <c:v>3614</c:v>
                      </c:pt>
                      <c:pt idx="419">
                        <c:v>3682</c:v>
                      </c:pt>
                      <c:pt idx="420">
                        <c:v>3098</c:v>
                      </c:pt>
                      <c:pt idx="421">
                        <c:v>2499</c:v>
                      </c:pt>
                      <c:pt idx="422">
                        <c:v>3920</c:v>
                      </c:pt>
                      <c:pt idx="423">
                        <c:v>3932</c:v>
                      </c:pt>
                      <c:pt idx="424">
                        <c:v>3386</c:v>
                      </c:pt>
                      <c:pt idx="425">
                        <c:v>3231</c:v>
                      </c:pt>
                      <c:pt idx="426">
                        <c:v>3253</c:v>
                      </c:pt>
                      <c:pt idx="427">
                        <c:v>3736</c:v>
                      </c:pt>
                      <c:pt idx="428">
                        <c:v>655</c:v>
                      </c:pt>
                      <c:pt idx="429">
                        <c:v>2661</c:v>
                      </c:pt>
                      <c:pt idx="430">
                        <c:v>3227</c:v>
                      </c:pt>
                      <c:pt idx="431">
                        <c:v>3336</c:v>
                      </c:pt>
                      <c:pt idx="432">
                        <c:v>3033</c:v>
                      </c:pt>
                      <c:pt idx="433">
                        <c:v>3201</c:v>
                      </c:pt>
                      <c:pt idx="434">
                        <c:v>2087</c:v>
                      </c:pt>
                      <c:pt idx="435">
                        <c:v>3159</c:v>
                      </c:pt>
                      <c:pt idx="436">
                        <c:v>2202</c:v>
                      </c:pt>
                      <c:pt idx="437">
                        <c:v>3635</c:v>
                      </c:pt>
                      <c:pt idx="438">
                        <c:v>2980</c:v>
                      </c:pt>
                      <c:pt idx="439">
                        <c:v>3522</c:v>
                      </c:pt>
                      <c:pt idx="440">
                        <c:v>3672</c:v>
                      </c:pt>
                      <c:pt idx="441">
                        <c:v>3007</c:v>
                      </c:pt>
                      <c:pt idx="442">
                        <c:v>3914</c:v>
                      </c:pt>
                      <c:pt idx="443">
                        <c:v>3534</c:v>
                      </c:pt>
                      <c:pt idx="444">
                        <c:v>3887</c:v>
                      </c:pt>
                      <c:pt idx="445">
                        <c:v>580</c:v>
                      </c:pt>
                      <c:pt idx="446">
                        <c:v>1556</c:v>
                      </c:pt>
                      <c:pt idx="447">
                        <c:v>1680</c:v>
                      </c:pt>
                      <c:pt idx="448">
                        <c:v>1590</c:v>
                      </c:pt>
                      <c:pt idx="449">
                        <c:v>3822</c:v>
                      </c:pt>
                      <c:pt idx="450">
                        <c:v>3245</c:v>
                      </c:pt>
                      <c:pt idx="451">
                        <c:v>3719</c:v>
                      </c:pt>
                      <c:pt idx="452">
                        <c:v>2731</c:v>
                      </c:pt>
                      <c:pt idx="453">
                        <c:v>2963</c:v>
                      </c:pt>
                      <c:pt idx="454">
                        <c:v>3685</c:v>
                      </c:pt>
                      <c:pt idx="455">
                        <c:v>3712</c:v>
                      </c:pt>
                      <c:pt idx="456">
                        <c:v>3571</c:v>
                      </c:pt>
                      <c:pt idx="457">
                        <c:v>1950</c:v>
                      </c:pt>
                      <c:pt idx="458">
                        <c:v>2603</c:v>
                      </c:pt>
                      <c:pt idx="459">
                        <c:v>2135</c:v>
                      </c:pt>
                      <c:pt idx="460">
                        <c:v>2506</c:v>
                      </c:pt>
                      <c:pt idx="461">
                        <c:v>3653</c:v>
                      </c:pt>
                      <c:pt idx="462">
                        <c:v>1557</c:v>
                      </c:pt>
                      <c:pt idx="463">
                        <c:v>2204</c:v>
                      </c:pt>
                      <c:pt idx="464">
                        <c:v>3068</c:v>
                      </c:pt>
                      <c:pt idx="465">
                        <c:v>1997</c:v>
                      </c:pt>
                      <c:pt idx="466">
                        <c:v>3134</c:v>
                      </c:pt>
                      <c:pt idx="467">
                        <c:v>2519</c:v>
                      </c:pt>
                      <c:pt idx="468">
                        <c:v>3031</c:v>
                      </c:pt>
                      <c:pt idx="469">
                        <c:v>2086</c:v>
                      </c:pt>
                      <c:pt idx="470">
                        <c:v>3225</c:v>
                      </c:pt>
                      <c:pt idx="471">
                        <c:v>1771</c:v>
                      </c:pt>
                      <c:pt idx="472">
                        <c:v>3725</c:v>
                      </c:pt>
                      <c:pt idx="473">
                        <c:v>3285</c:v>
                      </c:pt>
                      <c:pt idx="474">
                        <c:v>3418</c:v>
                      </c:pt>
                      <c:pt idx="475">
                        <c:v>3477</c:v>
                      </c:pt>
                      <c:pt idx="476">
                        <c:v>511</c:v>
                      </c:pt>
                      <c:pt idx="477">
                        <c:v>2255</c:v>
                      </c:pt>
                      <c:pt idx="478">
                        <c:v>3617</c:v>
                      </c:pt>
                      <c:pt idx="479">
                        <c:v>2383</c:v>
                      </c:pt>
                      <c:pt idx="480">
                        <c:v>3793</c:v>
                      </c:pt>
                      <c:pt idx="481">
                        <c:v>1555</c:v>
                      </c:pt>
                      <c:pt idx="482">
                        <c:v>3975</c:v>
                      </c:pt>
                      <c:pt idx="483">
                        <c:v>3679</c:v>
                      </c:pt>
                      <c:pt idx="484">
                        <c:v>3837</c:v>
                      </c:pt>
                      <c:pt idx="485">
                        <c:v>2822</c:v>
                      </c:pt>
                      <c:pt idx="486">
                        <c:v>1945</c:v>
                      </c:pt>
                      <c:pt idx="487">
                        <c:v>3853</c:v>
                      </c:pt>
                      <c:pt idx="488">
                        <c:v>3910</c:v>
                      </c:pt>
                      <c:pt idx="489">
                        <c:v>2737</c:v>
                      </c:pt>
                      <c:pt idx="490">
                        <c:v>2274</c:v>
                      </c:pt>
                      <c:pt idx="491">
                        <c:v>2986</c:v>
                      </c:pt>
                      <c:pt idx="492">
                        <c:v>2083</c:v>
                      </c:pt>
                      <c:pt idx="493">
                        <c:v>3978</c:v>
                      </c:pt>
                      <c:pt idx="494">
                        <c:v>3030</c:v>
                      </c:pt>
                      <c:pt idx="495">
                        <c:v>3921</c:v>
                      </c:pt>
                      <c:pt idx="496">
                        <c:v>2501</c:v>
                      </c:pt>
                      <c:pt idx="497">
                        <c:v>2048</c:v>
                      </c:pt>
                      <c:pt idx="498">
                        <c:v>2068</c:v>
                      </c:pt>
                      <c:pt idx="499">
                        <c:v>2953</c:v>
                      </c:pt>
                      <c:pt idx="500">
                        <c:v>2520</c:v>
                      </c:pt>
                      <c:pt idx="501">
                        <c:v>3661</c:v>
                      </c:pt>
                      <c:pt idx="502">
                        <c:v>3239</c:v>
                      </c:pt>
                      <c:pt idx="503">
                        <c:v>3353</c:v>
                      </c:pt>
                      <c:pt idx="504">
                        <c:v>3185</c:v>
                      </c:pt>
                      <c:pt idx="505">
                        <c:v>3535</c:v>
                      </c:pt>
                      <c:pt idx="506">
                        <c:v>3733</c:v>
                      </c:pt>
                      <c:pt idx="507">
                        <c:v>3186</c:v>
                      </c:pt>
                      <c:pt idx="508">
                        <c:v>3351</c:v>
                      </c:pt>
                      <c:pt idx="509">
                        <c:v>1929</c:v>
                      </c:pt>
                      <c:pt idx="510">
                        <c:v>3656</c:v>
                      </c:pt>
                      <c:pt idx="511">
                        <c:v>3657</c:v>
                      </c:pt>
                      <c:pt idx="512">
                        <c:v>1976</c:v>
                      </c:pt>
                      <c:pt idx="513">
                        <c:v>3665</c:v>
                      </c:pt>
                      <c:pt idx="514">
                        <c:v>3292</c:v>
                      </c:pt>
                      <c:pt idx="515">
                        <c:v>1510</c:v>
                      </c:pt>
                      <c:pt idx="516">
                        <c:v>3447</c:v>
                      </c:pt>
                      <c:pt idx="517">
                        <c:v>2331</c:v>
                      </c:pt>
                      <c:pt idx="518">
                        <c:v>2908</c:v>
                      </c:pt>
                      <c:pt idx="519">
                        <c:v>1416</c:v>
                      </c:pt>
                      <c:pt idx="520">
                        <c:v>1356</c:v>
                      </c:pt>
                      <c:pt idx="521">
                        <c:v>2352</c:v>
                      </c:pt>
                      <c:pt idx="522">
                        <c:v>3624</c:v>
                      </c:pt>
                      <c:pt idx="523">
                        <c:v>3623</c:v>
                      </c:pt>
                      <c:pt idx="524">
                        <c:v>2695</c:v>
                      </c:pt>
                      <c:pt idx="525">
                        <c:v>2974</c:v>
                      </c:pt>
                      <c:pt idx="526">
                        <c:v>853</c:v>
                      </c:pt>
                      <c:pt idx="527">
                        <c:v>2489</c:v>
                      </c:pt>
                      <c:pt idx="528">
                        <c:v>2722</c:v>
                      </c:pt>
                      <c:pt idx="529">
                        <c:v>3264</c:v>
                      </c:pt>
                      <c:pt idx="530">
                        <c:v>3968</c:v>
                      </c:pt>
                      <c:pt idx="531">
                        <c:v>2825</c:v>
                      </c:pt>
                      <c:pt idx="532">
                        <c:v>2039</c:v>
                      </c:pt>
                      <c:pt idx="533">
                        <c:v>3254</c:v>
                      </c:pt>
                      <c:pt idx="534">
                        <c:v>3324</c:v>
                      </c:pt>
                      <c:pt idx="535">
                        <c:v>3340</c:v>
                      </c:pt>
                      <c:pt idx="536">
                        <c:v>2531</c:v>
                      </c:pt>
                      <c:pt idx="537">
                        <c:v>4034</c:v>
                      </c:pt>
                      <c:pt idx="538">
                        <c:v>2521</c:v>
                      </c:pt>
                      <c:pt idx="539">
                        <c:v>2241</c:v>
                      </c:pt>
                      <c:pt idx="540">
                        <c:v>2195</c:v>
                      </c:pt>
                      <c:pt idx="541">
                        <c:v>3691</c:v>
                      </c:pt>
                      <c:pt idx="542">
                        <c:v>3058</c:v>
                      </c:pt>
                      <c:pt idx="543">
                        <c:v>2102</c:v>
                      </c:pt>
                      <c:pt idx="544">
                        <c:v>3244</c:v>
                      </c:pt>
                      <c:pt idx="545">
                        <c:v>1619</c:v>
                      </c:pt>
                      <c:pt idx="546">
                        <c:v>2384</c:v>
                      </c:pt>
                      <c:pt idx="547">
                        <c:v>1891</c:v>
                      </c:pt>
                      <c:pt idx="548">
                        <c:v>4049</c:v>
                      </c:pt>
                      <c:pt idx="549">
                        <c:v>2826</c:v>
                      </c:pt>
                      <c:pt idx="550">
                        <c:v>1928</c:v>
                      </c:pt>
                      <c:pt idx="551">
                        <c:v>259</c:v>
                      </c:pt>
                      <c:pt idx="552">
                        <c:v>3834</c:v>
                      </c:pt>
                      <c:pt idx="553">
                        <c:v>1796</c:v>
                      </c:pt>
                      <c:pt idx="554">
                        <c:v>3362</c:v>
                      </c:pt>
                      <c:pt idx="555">
                        <c:v>2246</c:v>
                      </c:pt>
                      <c:pt idx="556">
                        <c:v>1925</c:v>
                      </c:pt>
                      <c:pt idx="557">
                        <c:v>422</c:v>
                      </c:pt>
                      <c:pt idx="558">
                        <c:v>2186</c:v>
                      </c:pt>
                      <c:pt idx="559">
                        <c:v>1803</c:v>
                      </c:pt>
                      <c:pt idx="560">
                        <c:v>3421</c:v>
                      </c:pt>
                      <c:pt idx="561">
                        <c:v>2913</c:v>
                      </c:pt>
                      <c:pt idx="562">
                        <c:v>2502</c:v>
                      </c:pt>
                      <c:pt idx="563">
                        <c:v>3565</c:v>
                      </c:pt>
                      <c:pt idx="564">
                        <c:v>3087</c:v>
                      </c:pt>
                      <c:pt idx="565">
                        <c:v>3256</c:v>
                      </c:pt>
                      <c:pt idx="566">
                        <c:v>3104</c:v>
                      </c:pt>
                      <c:pt idx="567">
                        <c:v>3250</c:v>
                      </c:pt>
                      <c:pt idx="568">
                        <c:v>2830</c:v>
                      </c:pt>
                      <c:pt idx="569">
                        <c:v>3002</c:v>
                      </c:pt>
                      <c:pt idx="570">
                        <c:v>2497</c:v>
                      </c:pt>
                      <c:pt idx="571">
                        <c:v>4007</c:v>
                      </c:pt>
                      <c:pt idx="572">
                        <c:v>840</c:v>
                      </c:pt>
                      <c:pt idx="573">
                        <c:v>2595</c:v>
                      </c:pt>
                      <c:pt idx="574">
                        <c:v>3878</c:v>
                      </c:pt>
                      <c:pt idx="575">
                        <c:v>3512</c:v>
                      </c:pt>
                      <c:pt idx="576">
                        <c:v>3630</c:v>
                      </c:pt>
                      <c:pt idx="577">
                        <c:v>2849</c:v>
                      </c:pt>
                      <c:pt idx="578">
                        <c:v>1251</c:v>
                      </c:pt>
                      <c:pt idx="579">
                        <c:v>3930</c:v>
                      </c:pt>
                      <c:pt idx="580">
                        <c:v>3008</c:v>
                      </c:pt>
                      <c:pt idx="581">
                        <c:v>2118</c:v>
                      </c:pt>
                      <c:pt idx="582">
                        <c:v>2084</c:v>
                      </c:pt>
                      <c:pt idx="583">
                        <c:v>1361</c:v>
                      </c:pt>
                      <c:pt idx="584">
                        <c:v>2027</c:v>
                      </c:pt>
                      <c:pt idx="585">
                        <c:v>2235</c:v>
                      </c:pt>
                      <c:pt idx="586">
                        <c:v>1124</c:v>
                      </c:pt>
                      <c:pt idx="587">
                        <c:v>3971</c:v>
                      </c:pt>
                      <c:pt idx="588">
                        <c:v>1741</c:v>
                      </c:pt>
                      <c:pt idx="589">
                        <c:v>2280</c:v>
                      </c:pt>
                      <c:pt idx="590">
                        <c:v>2843</c:v>
                      </c:pt>
                      <c:pt idx="591">
                        <c:v>2385</c:v>
                      </c:pt>
                      <c:pt idx="592">
                        <c:v>2912</c:v>
                      </c:pt>
                      <c:pt idx="593">
                        <c:v>850</c:v>
                      </c:pt>
                      <c:pt idx="594">
                        <c:v>2180</c:v>
                      </c:pt>
                      <c:pt idx="595">
                        <c:v>4019</c:v>
                      </c:pt>
                      <c:pt idx="596">
                        <c:v>3325</c:v>
                      </c:pt>
                      <c:pt idx="597">
                        <c:v>3655</c:v>
                      </c:pt>
                      <c:pt idx="598">
                        <c:v>3420</c:v>
                      </c:pt>
                      <c:pt idx="599">
                        <c:v>1773</c:v>
                      </c:pt>
                      <c:pt idx="600">
                        <c:v>3695</c:v>
                      </c:pt>
                      <c:pt idx="601">
                        <c:v>2507</c:v>
                      </c:pt>
                      <c:pt idx="602">
                        <c:v>3946</c:v>
                      </c:pt>
                      <c:pt idx="603">
                        <c:v>1774</c:v>
                      </c:pt>
                      <c:pt idx="604">
                        <c:v>2056</c:v>
                      </c:pt>
                      <c:pt idx="605">
                        <c:v>3307</c:v>
                      </c:pt>
                      <c:pt idx="606">
                        <c:v>3628</c:v>
                      </c:pt>
                      <c:pt idx="607">
                        <c:v>4015</c:v>
                      </c:pt>
                      <c:pt idx="608">
                        <c:v>3552</c:v>
                      </c:pt>
                      <c:pt idx="609">
                        <c:v>1890</c:v>
                      </c:pt>
                      <c:pt idx="610">
                        <c:v>2347</c:v>
                      </c:pt>
                      <c:pt idx="611">
                        <c:v>4032</c:v>
                      </c:pt>
                      <c:pt idx="612">
                        <c:v>1241</c:v>
                      </c:pt>
                      <c:pt idx="613">
                        <c:v>3581</c:v>
                      </c:pt>
                      <c:pt idx="614">
                        <c:v>3243</c:v>
                      </c:pt>
                      <c:pt idx="615">
                        <c:v>1911</c:v>
                      </c:pt>
                      <c:pt idx="616">
                        <c:v>2803</c:v>
                      </c:pt>
                      <c:pt idx="617">
                        <c:v>2950</c:v>
                      </c:pt>
                      <c:pt idx="618">
                        <c:v>3594</c:v>
                      </c:pt>
                      <c:pt idx="619">
                        <c:v>1497</c:v>
                      </c:pt>
                      <c:pt idx="620">
                        <c:v>3389</c:v>
                      </c:pt>
                      <c:pt idx="621">
                        <c:v>2243</c:v>
                      </c:pt>
                      <c:pt idx="622">
                        <c:v>1039</c:v>
                      </c:pt>
                      <c:pt idx="623">
                        <c:v>2088</c:v>
                      </c:pt>
                      <c:pt idx="624">
                        <c:v>2769</c:v>
                      </c:pt>
                      <c:pt idx="625">
                        <c:v>2718</c:v>
                      </c:pt>
                      <c:pt idx="626">
                        <c:v>3097</c:v>
                      </c:pt>
                      <c:pt idx="627">
                        <c:v>1499</c:v>
                      </c:pt>
                      <c:pt idx="628">
                        <c:v>2416</c:v>
                      </c:pt>
                      <c:pt idx="629">
                        <c:v>3223</c:v>
                      </c:pt>
                      <c:pt idx="630">
                        <c:v>1759</c:v>
                      </c:pt>
                      <c:pt idx="631">
                        <c:v>3709</c:v>
                      </c:pt>
                      <c:pt idx="632">
                        <c:v>2788</c:v>
                      </c:pt>
                      <c:pt idx="633">
                        <c:v>3308</c:v>
                      </c:pt>
                      <c:pt idx="634">
                        <c:v>3687</c:v>
                      </c:pt>
                      <c:pt idx="635">
                        <c:v>766</c:v>
                      </c:pt>
                      <c:pt idx="636">
                        <c:v>3597</c:v>
                      </c:pt>
                      <c:pt idx="637">
                        <c:v>3468</c:v>
                      </c:pt>
                      <c:pt idx="638">
                        <c:v>2956</c:v>
                      </c:pt>
                      <c:pt idx="639">
                        <c:v>3638</c:v>
                      </c:pt>
                      <c:pt idx="640">
                        <c:v>2275</c:v>
                      </c:pt>
                      <c:pt idx="641">
                        <c:v>4042</c:v>
                      </c:pt>
                      <c:pt idx="642">
                        <c:v>3703</c:v>
                      </c:pt>
                      <c:pt idx="643">
                        <c:v>2527</c:v>
                      </c:pt>
                      <c:pt idx="644">
                        <c:v>2391</c:v>
                      </c:pt>
                      <c:pt idx="645">
                        <c:v>3531</c:v>
                      </c:pt>
                      <c:pt idx="646">
                        <c:v>3252</c:v>
                      </c:pt>
                      <c:pt idx="647">
                        <c:v>1806</c:v>
                      </c:pt>
                      <c:pt idx="648">
                        <c:v>3851</c:v>
                      </c:pt>
                      <c:pt idx="649">
                        <c:v>3265</c:v>
                      </c:pt>
                      <c:pt idx="650">
                        <c:v>2081</c:v>
                      </c:pt>
                      <c:pt idx="651">
                        <c:v>3345</c:v>
                      </c:pt>
                      <c:pt idx="652">
                        <c:v>2985</c:v>
                      </c:pt>
                      <c:pt idx="653">
                        <c:v>3182</c:v>
                      </c:pt>
                      <c:pt idx="654">
                        <c:v>2608</c:v>
                      </c:pt>
                      <c:pt idx="655">
                        <c:v>3676</c:v>
                      </c:pt>
                      <c:pt idx="656">
                        <c:v>3875</c:v>
                      </c:pt>
                      <c:pt idx="657">
                        <c:v>2733</c:v>
                      </c:pt>
                      <c:pt idx="658">
                        <c:v>4018</c:v>
                      </c:pt>
                      <c:pt idx="659">
                        <c:v>3302</c:v>
                      </c:pt>
                      <c:pt idx="660">
                        <c:v>3287</c:v>
                      </c:pt>
                      <c:pt idx="661">
                        <c:v>1004</c:v>
                      </c:pt>
                      <c:pt idx="662">
                        <c:v>3629</c:v>
                      </c:pt>
                      <c:pt idx="663">
                        <c:v>2488</c:v>
                      </c:pt>
                      <c:pt idx="664">
                        <c:v>2393</c:v>
                      </c:pt>
                      <c:pt idx="665">
                        <c:v>2886</c:v>
                      </c:pt>
                      <c:pt idx="666">
                        <c:v>3479</c:v>
                      </c:pt>
                      <c:pt idx="667">
                        <c:v>2003</c:v>
                      </c:pt>
                      <c:pt idx="668">
                        <c:v>1549</c:v>
                      </c:pt>
                      <c:pt idx="669">
                        <c:v>2549</c:v>
                      </c:pt>
                      <c:pt idx="670">
                        <c:v>604</c:v>
                      </c:pt>
                      <c:pt idx="671">
                        <c:v>785</c:v>
                      </c:pt>
                      <c:pt idx="672">
                        <c:v>3176</c:v>
                      </c:pt>
                      <c:pt idx="673">
                        <c:v>3442</c:v>
                      </c:pt>
                      <c:pt idx="674">
                        <c:v>3747</c:v>
                      </c:pt>
                      <c:pt idx="675">
                        <c:v>2859</c:v>
                      </c:pt>
                      <c:pt idx="676">
                        <c:v>2924</c:v>
                      </c:pt>
                      <c:pt idx="677">
                        <c:v>3716</c:v>
                      </c:pt>
                      <c:pt idx="678">
                        <c:v>3314</c:v>
                      </c:pt>
                      <c:pt idx="679">
                        <c:v>3892</c:v>
                      </c:pt>
                      <c:pt idx="680">
                        <c:v>3305</c:v>
                      </c:pt>
                      <c:pt idx="681">
                        <c:v>3912</c:v>
                      </c:pt>
                      <c:pt idx="682">
                        <c:v>2840</c:v>
                      </c:pt>
                      <c:pt idx="683">
                        <c:v>3465</c:v>
                      </c:pt>
                      <c:pt idx="684">
                        <c:v>3310</c:v>
                      </c:pt>
                      <c:pt idx="685">
                        <c:v>2005</c:v>
                      </c:pt>
                      <c:pt idx="686">
                        <c:v>3540</c:v>
                      </c:pt>
                      <c:pt idx="687">
                        <c:v>2742</c:v>
                      </c:pt>
                      <c:pt idx="688">
                        <c:v>3165</c:v>
                      </c:pt>
                      <c:pt idx="689">
                        <c:v>3128</c:v>
                      </c:pt>
                      <c:pt idx="690">
                        <c:v>1325</c:v>
                      </c:pt>
                      <c:pt idx="691">
                        <c:v>1952</c:v>
                      </c:pt>
                      <c:pt idx="692">
                        <c:v>2951</c:v>
                      </c:pt>
                      <c:pt idx="693">
                        <c:v>3526</c:v>
                      </c:pt>
                      <c:pt idx="694">
                        <c:v>4084</c:v>
                      </c:pt>
                      <c:pt idx="695">
                        <c:v>3299</c:v>
                      </c:pt>
                      <c:pt idx="696">
                        <c:v>3414</c:v>
                      </c:pt>
                      <c:pt idx="697">
                        <c:v>3167</c:v>
                      </c:pt>
                      <c:pt idx="698">
                        <c:v>2573</c:v>
                      </c:pt>
                      <c:pt idx="699">
                        <c:v>2936</c:v>
                      </c:pt>
                      <c:pt idx="700">
                        <c:v>3127</c:v>
                      </c:pt>
                      <c:pt idx="701">
                        <c:v>2470</c:v>
                      </c:pt>
                      <c:pt idx="702">
                        <c:v>2028</c:v>
                      </c:pt>
                      <c:pt idx="703">
                        <c:v>3003</c:v>
                      </c:pt>
                      <c:pt idx="704">
                        <c:v>2620</c:v>
                      </c:pt>
                      <c:pt idx="705">
                        <c:v>3332</c:v>
                      </c:pt>
                      <c:pt idx="706">
                        <c:v>2744</c:v>
                      </c:pt>
                      <c:pt idx="707">
                        <c:v>3847</c:v>
                      </c:pt>
                      <c:pt idx="708">
                        <c:v>3123</c:v>
                      </c:pt>
                      <c:pt idx="709">
                        <c:v>1975</c:v>
                      </c:pt>
                      <c:pt idx="710">
                        <c:v>3585</c:v>
                      </c:pt>
                      <c:pt idx="711">
                        <c:v>3927</c:v>
                      </c:pt>
                      <c:pt idx="712">
                        <c:v>3001</c:v>
                      </c:pt>
                      <c:pt idx="713">
                        <c:v>2572</c:v>
                      </c:pt>
                      <c:pt idx="714">
                        <c:v>3415</c:v>
                      </c:pt>
                      <c:pt idx="715">
                        <c:v>3697</c:v>
                      </c:pt>
                      <c:pt idx="716">
                        <c:v>3370</c:v>
                      </c:pt>
                      <c:pt idx="717">
                        <c:v>4014</c:v>
                      </c:pt>
                      <c:pt idx="718">
                        <c:v>2696</c:v>
                      </c:pt>
                      <c:pt idx="719">
                        <c:v>2666</c:v>
                      </c:pt>
                      <c:pt idx="720">
                        <c:v>2697</c:v>
                      </c:pt>
                      <c:pt idx="721">
                        <c:v>3537</c:v>
                      </c:pt>
                      <c:pt idx="722">
                        <c:v>2789</c:v>
                      </c:pt>
                      <c:pt idx="723">
                        <c:v>2876</c:v>
                      </c:pt>
                      <c:pt idx="724">
                        <c:v>2992</c:v>
                      </c:pt>
                      <c:pt idx="725">
                        <c:v>3330</c:v>
                      </c:pt>
                      <c:pt idx="726">
                        <c:v>3187</c:v>
                      </c:pt>
                      <c:pt idx="727">
                        <c:v>3916</c:v>
                      </c:pt>
                      <c:pt idx="728">
                        <c:v>2378</c:v>
                      </c:pt>
                      <c:pt idx="729">
                        <c:v>1818</c:v>
                      </c:pt>
                      <c:pt idx="730">
                        <c:v>2402</c:v>
                      </c:pt>
                      <c:pt idx="731">
                        <c:v>2199</c:v>
                      </c:pt>
                      <c:pt idx="732">
                        <c:v>4011</c:v>
                      </c:pt>
                      <c:pt idx="733">
                        <c:v>3511</c:v>
                      </c:pt>
                      <c:pt idx="734">
                        <c:v>2868</c:v>
                      </c:pt>
                      <c:pt idx="735">
                        <c:v>2621</c:v>
                      </c:pt>
                      <c:pt idx="736">
                        <c:v>3034</c:v>
                      </c:pt>
                      <c:pt idx="737">
                        <c:v>2855</c:v>
                      </c:pt>
                      <c:pt idx="738">
                        <c:v>3835</c:v>
                      </c:pt>
                      <c:pt idx="739">
                        <c:v>2580</c:v>
                      </c:pt>
                      <c:pt idx="740">
                        <c:v>2962</c:v>
                      </c:pt>
                      <c:pt idx="741">
                        <c:v>3190</c:v>
                      </c:pt>
                      <c:pt idx="742">
                        <c:v>213</c:v>
                      </c:pt>
                      <c:pt idx="743">
                        <c:v>3555</c:v>
                      </c:pt>
                      <c:pt idx="744">
                        <c:v>2175</c:v>
                      </c:pt>
                      <c:pt idx="745">
                        <c:v>2542</c:v>
                      </c:pt>
                      <c:pt idx="746">
                        <c:v>3925</c:v>
                      </c:pt>
                      <c:pt idx="747">
                        <c:v>2846</c:v>
                      </c:pt>
                      <c:pt idx="748">
                        <c:v>2503</c:v>
                      </c:pt>
                      <c:pt idx="749">
                        <c:v>2630</c:v>
                      </c:pt>
                      <c:pt idx="750">
                        <c:v>3247</c:v>
                      </c:pt>
                      <c:pt idx="751">
                        <c:v>4010</c:v>
                      </c:pt>
                      <c:pt idx="752">
                        <c:v>3913</c:v>
                      </c:pt>
                      <c:pt idx="753">
                        <c:v>2007</c:v>
                      </c:pt>
                      <c:pt idx="754">
                        <c:v>3972</c:v>
                      </c:pt>
                      <c:pt idx="755">
                        <c:v>3320</c:v>
                      </c:pt>
                      <c:pt idx="756">
                        <c:v>3911</c:v>
                      </c:pt>
                      <c:pt idx="757">
                        <c:v>3612</c:v>
                      </c:pt>
                      <c:pt idx="758">
                        <c:v>1668</c:v>
                      </c:pt>
                      <c:pt idx="759">
                        <c:v>3671</c:v>
                      </c:pt>
                      <c:pt idx="760">
                        <c:v>2694</c:v>
                      </c:pt>
                      <c:pt idx="761">
                        <c:v>3846</c:v>
                      </c:pt>
                      <c:pt idx="762">
                        <c:v>3915</c:v>
                      </c:pt>
                      <c:pt idx="763">
                        <c:v>3327</c:v>
                      </c:pt>
                      <c:pt idx="764">
                        <c:v>3618</c:v>
                      </c:pt>
                      <c:pt idx="765">
                        <c:v>717</c:v>
                      </c:pt>
                      <c:pt idx="766">
                        <c:v>1229</c:v>
                      </c:pt>
                      <c:pt idx="767">
                        <c:v>2167</c:v>
                      </c:pt>
                      <c:pt idx="768">
                        <c:v>3677</c:v>
                      </c:pt>
                      <c:pt idx="769">
                        <c:v>3323</c:v>
                      </c:pt>
                      <c:pt idx="770">
                        <c:v>2971</c:v>
                      </c:pt>
                      <c:pt idx="771">
                        <c:v>1801</c:v>
                      </c:pt>
                      <c:pt idx="772">
                        <c:v>2320</c:v>
                      </c:pt>
                      <c:pt idx="773">
                        <c:v>3538</c:v>
                      </c:pt>
                      <c:pt idx="774">
                        <c:v>613</c:v>
                      </c:pt>
                      <c:pt idx="775">
                        <c:v>1889</c:v>
                      </c:pt>
                      <c:pt idx="776">
                        <c:v>3850</c:v>
                      </c:pt>
                      <c:pt idx="777">
                        <c:v>2045</c:v>
                      </c:pt>
                      <c:pt idx="778">
                        <c:v>3550</c:v>
                      </c:pt>
                      <c:pt idx="779">
                        <c:v>3905</c:v>
                      </c:pt>
                      <c:pt idx="780">
                        <c:v>3584</c:v>
                      </c:pt>
                      <c:pt idx="781">
                        <c:v>2209</c:v>
                      </c:pt>
                      <c:pt idx="782">
                        <c:v>3163</c:v>
                      </c:pt>
                      <c:pt idx="783">
                        <c:v>3381</c:v>
                      </c:pt>
                      <c:pt idx="784">
                        <c:v>3560</c:v>
                      </c:pt>
                      <c:pt idx="785">
                        <c:v>1968</c:v>
                      </c:pt>
                      <c:pt idx="786">
                        <c:v>1558</c:v>
                      </c:pt>
                      <c:pt idx="787">
                        <c:v>2771</c:v>
                      </c:pt>
                      <c:pt idx="788">
                        <c:v>3061</c:v>
                      </c:pt>
                      <c:pt idx="789">
                        <c:v>3363</c:v>
                      </c:pt>
                      <c:pt idx="790">
                        <c:v>3548</c:v>
                      </c:pt>
                      <c:pt idx="791">
                        <c:v>2176</c:v>
                      </c:pt>
                      <c:pt idx="792">
                        <c:v>922</c:v>
                      </c:pt>
                      <c:pt idx="793">
                        <c:v>2703</c:v>
                      </c:pt>
                      <c:pt idx="794">
                        <c:v>2472</c:v>
                      </c:pt>
                      <c:pt idx="795">
                        <c:v>3251</c:v>
                      </c:pt>
                      <c:pt idx="796">
                        <c:v>3718</c:v>
                      </c:pt>
                      <c:pt idx="797">
                        <c:v>1511</c:v>
                      </c:pt>
                      <c:pt idx="798">
                        <c:v>2686</c:v>
                      </c:pt>
                      <c:pt idx="799">
                        <c:v>4008</c:v>
                      </c:pt>
                      <c:pt idx="800">
                        <c:v>3953</c:v>
                      </c:pt>
                      <c:pt idx="801">
                        <c:v>2910</c:v>
                      </c:pt>
                      <c:pt idx="802">
                        <c:v>3505</c:v>
                      </c:pt>
                      <c:pt idx="803">
                        <c:v>3844</c:v>
                      </c:pt>
                      <c:pt idx="804">
                        <c:v>2791</c:v>
                      </c:pt>
                      <c:pt idx="805">
                        <c:v>1667</c:v>
                      </c:pt>
                      <c:pt idx="806">
                        <c:v>3162</c:v>
                      </c:pt>
                      <c:pt idx="807">
                        <c:v>2404</c:v>
                      </c:pt>
                      <c:pt idx="808">
                        <c:v>3384</c:v>
                      </c:pt>
                      <c:pt idx="809">
                        <c:v>1636</c:v>
                      </c:pt>
                      <c:pt idx="810">
                        <c:v>2326</c:v>
                      </c:pt>
                      <c:pt idx="811">
                        <c:v>3527</c:v>
                      </c:pt>
                      <c:pt idx="812">
                        <c:v>3297</c:v>
                      </c:pt>
                      <c:pt idx="813">
                        <c:v>3891</c:v>
                      </c:pt>
                      <c:pt idx="814">
                        <c:v>3094</c:v>
                      </c:pt>
                      <c:pt idx="815">
                        <c:v>2721</c:v>
                      </c:pt>
                      <c:pt idx="816">
                        <c:v>3506</c:v>
                      </c:pt>
                      <c:pt idx="817">
                        <c:v>3148</c:v>
                      </c:pt>
                      <c:pt idx="818">
                        <c:v>3553</c:v>
                      </c:pt>
                      <c:pt idx="819">
                        <c:v>3852</c:v>
                      </c:pt>
                      <c:pt idx="820">
                        <c:v>4001</c:v>
                      </c:pt>
                      <c:pt idx="821">
                        <c:v>3890</c:v>
                      </c:pt>
                      <c:pt idx="822">
                        <c:v>3539</c:v>
                      </c:pt>
                      <c:pt idx="823">
                        <c:v>2242</c:v>
                      </c:pt>
                      <c:pt idx="824">
                        <c:v>3938</c:v>
                      </c:pt>
                      <c:pt idx="825">
                        <c:v>1554</c:v>
                      </c:pt>
                      <c:pt idx="826">
                        <c:v>1772</c:v>
                      </c:pt>
                      <c:pt idx="827">
                        <c:v>2511</c:v>
                      </c:pt>
                      <c:pt idx="828">
                        <c:v>2569</c:v>
                      </c:pt>
                      <c:pt idx="829">
                        <c:v>3006</c:v>
                      </c:pt>
                      <c:pt idx="830">
                        <c:v>3191</c:v>
                      </c:pt>
                      <c:pt idx="831">
                        <c:v>3880</c:v>
                      </c:pt>
                      <c:pt idx="832">
                        <c:v>2615</c:v>
                      </c:pt>
                      <c:pt idx="833">
                        <c:v>1675</c:v>
                      </c:pt>
                      <c:pt idx="834">
                        <c:v>2133</c:v>
                      </c:pt>
                      <c:pt idx="835">
                        <c:v>3312</c:v>
                      </c:pt>
                      <c:pt idx="836">
                        <c:v>1887</c:v>
                      </c:pt>
                      <c:pt idx="837">
                        <c:v>3249</c:v>
                      </c:pt>
                      <c:pt idx="838">
                        <c:v>1707</c:v>
                      </c:pt>
                      <c:pt idx="839">
                        <c:v>3147</c:v>
                      </c:pt>
                      <c:pt idx="840">
                        <c:v>3694</c:v>
                      </c:pt>
                      <c:pt idx="841">
                        <c:v>3993</c:v>
                      </c:pt>
                      <c:pt idx="842">
                        <c:v>3138</c:v>
                      </c:pt>
                      <c:pt idx="843">
                        <c:v>1324</c:v>
                      </c:pt>
                      <c:pt idx="844">
                        <c:v>1656</c:v>
                      </c:pt>
                      <c:pt idx="845">
                        <c:v>2869</c:v>
                      </c:pt>
                      <c:pt idx="846">
                        <c:v>3233</c:v>
                      </c:pt>
                      <c:pt idx="847">
                        <c:v>1913</c:v>
                      </c:pt>
                      <c:pt idx="848">
                        <c:v>2365</c:v>
                      </c:pt>
                      <c:pt idx="849">
                        <c:v>2719</c:v>
                      </c:pt>
                      <c:pt idx="850">
                        <c:v>3767</c:v>
                      </c:pt>
                      <c:pt idx="851">
                        <c:v>2679</c:v>
                      </c:pt>
                      <c:pt idx="852">
                        <c:v>3137</c:v>
                      </c:pt>
                      <c:pt idx="853">
                        <c:v>3315</c:v>
                      </c:pt>
                      <c:pt idx="854">
                        <c:v>3241</c:v>
                      </c:pt>
                      <c:pt idx="855">
                        <c:v>4000</c:v>
                      </c:pt>
                      <c:pt idx="856">
                        <c:v>3508</c:v>
                      </c:pt>
                      <c:pt idx="857">
                        <c:v>2927</c:v>
                      </c:pt>
                      <c:pt idx="858">
                        <c:v>3970</c:v>
                      </c:pt>
                      <c:pt idx="859">
                        <c:v>777</c:v>
                      </c:pt>
                      <c:pt idx="860">
                        <c:v>3992</c:v>
                      </c:pt>
                      <c:pt idx="861">
                        <c:v>3670</c:v>
                      </c:pt>
                      <c:pt idx="862">
                        <c:v>2070</c:v>
                      </c:pt>
                      <c:pt idx="863">
                        <c:v>4035</c:v>
                      </c:pt>
                      <c:pt idx="864">
                        <c:v>212</c:v>
                      </c:pt>
                      <c:pt idx="865">
                        <c:v>2605</c:v>
                      </c:pt>
                      <c:pt idx="866">
                        <c:v>3619</c:v>
                      </c:pt>
                      <c:pt idx="867">
                        <c:v>3337</c:v>
                      </c:pt>
                      <c:pt idx="868">
                        <c:v>3263</c:v>
                      </c:pt>
                      <c:pt idx="869">
                        <c:v>3108</c:v>
                      </c:pt>
                      <c:pt idx="870">
                        <c:v>3701</c:v>
                      </c:pt>
                      <c:pt idx="871">
                        <c:v>3408</c:v>
                      </c:pt>
                      <c:pt idx="872">
                        <c:v>2782</c:v>
                      </c:pt>
                      <c:pt idx="873">
                        <c:v>1969</c:v>
                      </c:pt>
                      <c:pt idx="874">
                        <c:v>843</c:v>
                      </c:pt>
                      <c:pt idx="875">
                        <c:v>3564</c:v>
                      </c:pt>
                      <c:pt idx="876">
                        <c:v>3643</c:v>
                      </c:pt>
                      <c:pt idx="877">
                        <c:v>3649</c:v>
                      </c:pt>
                      <c:pt idx="878">
                        <c:v>1659</c:v>
                      </c:pt>
                      <c:pt idx="879">
                        <c:v>3166</c:v>
                      </c:pt>
                      <c:pt idx="880">
                        <c:v>3849</c:v>
                      </c:pt>
                      <c:pt idx="881">
                        <c:v>2150</c:v>
                      </c:pt>
                      <c:pt idx="882">
                        <c:v>2746</c:v>
                      </c:pt>
                      <c:pt idx="883">
                        <c:v>265</c:v>
                      </c:pt>
                      <c:pt idx="884">
                        <c:v>1888</c:v>
                      </c:pt>
                      <c:pt idx="885">
                        <c:v>3595</c:v>
                      </c:pt>
                      <c:pt idx="886">
                        <c:v>1052</c:v>
                      </c:pt>
                      <c:pt idx="887">
                        <c:v>3578</c:v>
                      </c:pt>
                      <c:pt idx="888">
                        <c:v>2555</c:v>
                      </c:pt>
                      <c:pt idx="889">
                        <c:v>3590</c:v>
                      </c:pt>
                      <c:pt idx="890">
                        <c:v>3952</c:v>
                      </c:pt>
                      <c:pt idx="891">
                        <c:v>2877</c:v>
                      </c:pt>
                      <c:pt idx="892">
                        <c:v>3119</c:v>
                      </c:pt>
                      <c:pt idx="893">
                        <c:v>2772</c:v>
                      </c:pt>
                      <c:pt idx="894">
                        <c:v>2350</c:v>
                      </c:pt>
                      <c:pt idx="895">
                        <c:v>2902</c:v>
                      </c:pt>
                      <c:pt idx="896">
                        <c:v>3195</c:v>
                      </c:pt>
                      <c:pt idx="897">
                        <c:v>3286</c:v>
                      </c:pt>
                      <c:pt idx="898">
                        <c:v>685</c:v>
                      </c:pt>
                      <c:pt idx="899">
                        <c:v>3575</c:v>
                      </c:pt>
                      <c:pt idx="900">
                        <c:v>2505</c:v>
                      </c:pt>
                      <c:pt idx="901">
                        <c:v>2916</c:v>
                      </c:pt>
                      <c:pt idx="902">
                        <c:v>3387</c:v>
                      </c:pt>
                      <c:pt idx="903">
                        <c:v>2448</c:v>
                      </c:pt>
                      <c:pt idx="904">
                        <c:v>2553</c:v>
                      </c:pt>
                      <c:pt idx="905">
                        <c:v>2095</c:v>
                      </c:pt>
                      <c:pt idx="906">
                        <c:v>1478</c:v>
                      </c:pt>
                      <c:pt idx="907">
                        <c:v>3745</c:v>
                      </c:pt>
                      <c:pt idx="908">
                        <c:v>3631</c:v>
                      </c:pt>
                      <c:pt idx="909">
                        <c:v>4038</c:v>
                      </c:pt>
                      <c:pt idx="910">
                        <c:v>643</c:v>
                      </c:pt>
                      <c:pt idx="911">
                        <c:v>956</c:v>
                      </c:pt>
                      <c:pt idx="912">
                        <c:v>3945</c:v>
                      </c:pt>
                      <c:pt idx="913">
                        <c:v>2607</c:v>
                      </c:pt>
                      <c:pt idx="914">
                        <c:v>2618</c:v>
                      </c:pt>
                      <c:pt idx="915">
                        <c:v>3533</c:v>
                      </c:pt>
                      <c:pt idx="916">
                        <c:v>3675</c:v>
                      </c:pt>
                      <c:pt idx="917">
                        <c:v>2222</c:v>
                      </c:pt>
                      <c:pt idx="918">
                        <c:v>3551</c:v>
                      </c:pt>
                      <c:pt idx="919">
                        <c:v>3862</c:v>
                      </c:pt>
                      <c:pt idx="920">
                        <c:v>2025</c:v>
                      </c:pt>
                      <c:pt idx="921">
                        <c:v>1369</c:v>
                      </c:pt>
                      <c:pt idx="922">
                        <c:v>2172</c:v>
                      </c:pt>
                      <c:pt idx="923">
                        <c:v>3662</c:v>
                      </c:pt>
                      <c:pt idx="924">
                        <c:v>2995</c:v>
                      </c:pt>
                      <c:pt idx="925">
                        <c:v>2957</c:v>
                      </c:pt>
                      <c:pt idx="926">
                        <c:v>2842</c:v>
                      </c:pt>
                      <c:pt idx="927">
                        <c:v>3961</c:v>
                      </c:pt>
                      <c:pt idx="928">
                        <c:v>3658</c:v>
                      </c:pt>
                      <c:pt idx="929">
                        <c:v>3261</c:v>
                      </c:pt>
                      <c:pt idx="930">
                        <c:v>3908</c:v>
                      </c:pt>
                      <c:pt idx="931">
                        <c:v>2904</c:v>
                      </c:pt>
                      <c:pt idx="932">
                        <c:v>3502</c:v>
                      </c:pt>
                      <c:pt idx="933">
                        <c:v>2374</c:v>
                      </c:pt>
                      <c:pt idx="934">
                        <c:v>3214</c:v>
                      </c:pt>
                      <c:pt idx="935">
                        <c:v>1474</c:v>
                      </c:pt>
                      <c:pt idx="936">
                        <c:v>3144</c:v>
                      </c:pt>
                      <c:pt idx="937">
                        <c:v>3374</c:v>
                      </c:pt>
                      <c:pt idx="938">
                        <c:v>2059</c:v>
                      </c:pt>
                      <c:pt idx="939">
                        <c:v>2925</c:v>
                      </c:pt>
                      <c:pt idx="940">
                        <c:v>2373</c:v>
                      </c:pt>
                      <c:pt idx="941">
                        <c:v>3647</c:v>
                      </c:pt>
                      <c:pt idx="942">
                        <c:v>2585</c:v>
                      </c:pt>
                      <c:pt idx="943">
                        <c:v>3168</c:v>
                      </c:pt>
                      <c:pt idx="944">
                        <c:v>2948</c:v>
                      </c:pt>
                      <c:pt idx="945">
                        <c:v>4021</c:v>
                      </c:pt>
                      <c:pt idx="946">
                        <c:v>896</c:v>
                      </c:pt>
                      <c:pt idx="947">
                        <c:v>3577</c:v>
                      </c:pt>
                      <c:pt idx="948">
                        <c:v>3226</c:v>
                      </c:pt>
                      <c:pt idx="949">
                        <c:v>3029</c:v>
                      </c:pt>
                      <c:pt idx="950">
                        <c:v>2104</c:v>
                      </c:pt>
                      <c:pt idx="951">
                        <c:v>2257</c:v>
                      </c:pt>
                      <c:pt idx="952">
                        <c:v>3293</c:v>
                      </c:pt>
                      <c:pt idx="953">
                        <c:v>3056</c:v>
                      </c:pt>
                      <c:pt idx="954">
                        <c:v>2395</c:v>
                      </c:pt>
                      <c:pt idx="955">
                        <c:v>1105</c:v>
                      </c:pt>
                      <c:pt idx="956">
                        <c:v>3839</c:v>
                      </c:pt>
                      <c:pt idx="957">
                        <c:v>3023</c:v>
                      </c:pt>
                      <c:pt idx="958">
                        <c:v>3188</c:v>
                      </c:pt>
                      <c:pt idx="959">
                        <c:v>3554</c:v>
                      </c:pt>
                      <c:pt idx="960">
                        <c:v>2574</c:v>
                      </c:pt>
                      <c:pt idx="961">
                        <c:v>1738</c:v>
                      </c:pt>
                      <c:pt idx="962">
                        <c:v>770</c:v>
                      </c:pt>
                      <c:pt idx="963">
                        <c:v>2240</c:v>
                      </c:pt>
                      <c:pt idx="964">
                        <c:v>2466</c:v>
                      </c:pt>
                      <c:pt idx="965">
                        <c:v>1316</c:v>
                      </c:pt>
                      <c:pt idx="966">
                        <c:v>3669</c:v>
                      </c:pt>
                      <c:pt idx="967">
                        <c:v>4004</c:v>
                      </c:pt>
                      <c:pt idx="968">
                        <c:v>2324</c:v>
                      </c:pt>
                      <c:pt idx="969">
                        <c:v>3955</c:v>
                      </c:pt>
                      <c:pt idx="970">
                        <c:v>3411</c:v>
                      </c:pt>
                      <c:pt idx="971">
                        <c:v>3664</c:v>
                      </c:pt>
                      <c:pt idx="972">
                        <c:v>3321</c:v>
                      </c:pt>
                      <c:pt idx="973">
                        <c:v>3545</c:v>
                      </c:pt>
                      <c:pt idx="974">
                        <c:v>3432</c:v>
                      </c:pt>
                      <c:pt idx="975">
                        <c:v>3650</c:v>
                      </c:pt>
                      <c:pt idx="976">
                        <c:v>3728</c:v>
                      </c:pt>
                      <c:pt idx="977">
                        <c:v>3525</c:v>
                      </c:pt>
                      <c:pt idx="978">
                        <c:v>3974</c:v>
                      </c:pt>
                      <c:pt idx="979">
                        <c:v>2439</c:v>
                      </c:pt>
                      <c:pt idx="980">
                        <c:v>2824</c:v>
                      </c:pt>
                      <c:pt idx="981">
                        <c:v>2954</c:v>
                      </c:pt>
                      <c:pt idx="982">
                        <c:v>2591</c:v>
                      </c:pt>
                      <c:pt idx="983">
                        <c:v>3145</c:v>
                      </c:pt>
                      <c:pt idx="984">
                        <c:v>2029</c:v>
                      </c:pt>
                      <c:pt idx="985">
                        <c:v>3772</c:v>
                      </c:pt>
                      <c:pt idx="986">
                        <c:v>1777</c:v>
                      </c:pt>
                      <c:pt idx="987">
                        <c:v>2276</c:v>
                      </c:pt>
                      <c:pt idx="988">
                        <c:v>2725</c:v>
                      </c:pt>
                      <c:pt idx="989">
                        <c:v>3095</c:v>
                      </c:pt>
                      <c:pt idx="990">
                        <c:v>1633</c:v>
                      </c:pt>
                      <c:pt idx="991">
                        <c:v>2875</c:v>
                      </c:pt>
                      <c:pt idx="992">
                        <c:v>3692</c:v>
                      </c:pt>
                      <c:pt idx="993">
                        <c:v>3923</c:v>
                      </c:pt>
                      <c:pt idx="994">
                        <c:v>2452</c:v>
                      </c:pt>
                      <c:pt idx="995">
                        <c:v>3258</c:v>
                      </c:pt>
                    </c:numCache>
                  </c:numRef>
                </c:xVal>
                <c:yVal>
                  <c:numRef>
                    <c:extLst xmlns:c15="http://schemas.microsoft.com/office/drawing/2012/chart">
                      <c:ext xmlns:c15="http://schemas.microsoft.com/office/drawing/2012/chart" uri="{02D57815-91ED-43cb-92C2-25804820EDAC}">
                        <c15:formulaRef>
                          <c15:sqref>AGO1a!$D$2:$D$1002</c15:sqref>
                        </c15:formulaRef>
                      </c:ext>
                    </c:extLst>
                    <c:numCache>
                      <c:formatCode>General</c:formatCode>
                      <c:ptCount val="1001"/>
                      <c:pt idx="0">
                        <c:v>3</c:v>
                      </c:pt>
                      <c:pt idx="1">
                        <c:v>1</c:v>
                      </c:pt>
                      <c:pt idx="3">
                        <c:v>1</c:v>
                      </c:pt>
                      <c:pt idx="4">
                        <c:v>1</c:v>
                      </c:pt>
                      <c:pt idx="7">
                        <c:v>1</c:v>
                      </c:pt>
                      <c:pt idx="10">
                        <c:v>1</c:v>
                      </c:pt>
                      <c:pt idx="12">
                        <c:v>1</c:v>
                      </c:pt>
                      <c:pt idx="21">
                        <c:v>1</c:v>
                      </c:pt>
                      <c:pt idx="24">
                        <c:v>1</c:v>
                      </c:pt>
                      <c:pt idx="26">
                        <c:v>1</c:v>
                      </c:pt>
                      <c:pt idx="27">
                        <c:v>1</c:v>
                      </c:pt>
                      <c:pt idx="30">
                        <c:v>1</c:v>
                      </c:pt>
                      <c:pt idx="32">
                        <c:v>1</c:v>
                      </c:pt>
                      <c:pt idx="33">
                        <c:v>1</c:v>
                      </c:pt>
                      <c:pt idx="34">
                        <c:v>1</c:v>
                      </c:pt>
                      <c:pt idx="36">
                        <c:v>1</c:v>
                      </c:pt>
                      <c:pt idx="39">
                        <c:v>1</c:v>
                      </c:pt>
                      <c:pt idx="45">
                        <c:v>1</c:v>
                      </c:pt>
                      <c:pt idx="53">
                        <c:v>1</c:v>
                      </c:pt>
                      <c:pt idx="54">
                        <c:v>1</c:v>
                      </c:pt>
                      <c:pt idx="55">
                        <c:v>1</c:v>
                      </c:pt>
                      <c:pt idx="56">
                        <c:v>1</c:v>
                      </c:pt>
                      <c:pt idx="57">
                        <c:v>1</c:v>
                      </c:pt>
                      <c:pt idx="58">
                        <c:v>1</c:v>
                      </c:pt>
                      <c:pt idx="60">
                        <c:v>1</c:v>
                      </c:pt>
                      <c:pt idx="61">
                        <c:v>1</c:v>
                      </c:pt>
                      <c:pt idx="62">
                        <c:v>1</c:v>
                      </c:pt>
                      <c:pt idx="63">
                        <c:v>1</c:v>
                      </c:pt>
                      <c:pt idx="66">
                        <c:v>1</c:v>
                      </c:pt>
                      <c:pt idx="68">
                        <c:v>1</c:v>
                      </c:pt>
                      <c:pt idx="69">
                        <c:v>1</c:v>
                      </c:pt>
                      <c:pt idx="70">
                        <c:v>1</c:v>
                      </c:pt>
                      <c:pt idx="71">
                        <c:v>1</c:v>
                      </c:pt>
                      <c:pt idx="73">
                        <c:v>1</c:v>
                      </c:pt>
                      <c:pt idx="75">
                        <c:v>1</c:v>
                      </c:pt>
                      <c:pt idx="77">
                        <c:v>1</c:v>
                      </c:pt>
                      <c:pt idx="78">
                        <c:v>1</c:v>
                      </c:pt>
                      <c:pt idx="80">
                        <c:v>1</c:v>
                      </c:pt>
                      <c:pt idx="81">
                        <c:v>1</c:v>
                      </c:pt>
                      <c:pt idx="83">
                        <c:v>1</c:v>
                      </c:pt>
                      <c:pt idx="85">
                        <c:v>1</c:v>
                      </c:pt>
                      <c:pt idx="87">
                        <c:v>1</c:v>
                      </c:pt>
                      <c:pt idx="89">
                        <c:v>1</c:v>
                      </c:pt>
                      <c:pt idx="93">
                        <c:v>1</c:v>
                      </c:pt>
                      <c:pt idx="94">
                        <c:v>1</c:v>
                      </c:pt>
                      <c:pt idx="95">
                        <c:v>1</c:v>
                      </c:pt>
                      <c:pt idx="98">
                        <c:v>1</c:v>
                      </c:pt>
                      <c:pt idx="100">
                        <c:v>1</c:v>
                      </c:pt>
                      <c:pt idx="102">
                        <c:v>1</c:v>
                      </c:pt>
                      <c:pt idx="104">
                        <c:v>1</c:v>
                      </c:pt>
                      <c:pt idx="105">
                        <c:v>1</c:v>
                      </c:pt>
                      <c:pt idx="110">
                        <c:v>1</c:v>
                      </c:pt>
                      <c:pt idx="111">
                        <c:v>1</c:v>
                      </c:pt>
                      <c:pt idx="112">
                        <c:v>1</c:v>
                      </c:pt>
                      <c:pt idx="115">
                        <c:v>1</c:v>
                      </c:pt>
                      <c:pt idx="116">
                        <c:v>1</c:v>
                      </c:pt>
                      <c:pt idx="117">
                        <c:v>1</c:v>
                      </c:pt>
                      <c:pt idx="122">
                        <c:v>1</c:v>
                      </c:pt>
                      <c:pt idx="123">
                        <c:v>1</c:v>
                      </c:pt>
                      <c:pt idx="124">
                        <c:v>1</c:v>
                      </c:pt>
                      <c:pt idx="125">
                        <c:v>1</c:v>
                      </c:pt>
                      <c:pt idx="130">
                        <c:v>1</c:v>
                      </c:pt>
                      <c:pt idx="131">
                        <c:v>1</c:v>
                      </c:pt>
                      <c:pt idx="132">
                        <c:v>1</c:v>
                      </c:pt>
                      <c:pt idx="133">
                        <c:v>1</c:v>
                      </c:pt>
                      <c:pt idx="134">
                        <c:v>1</c:v>
                      </c:pt>
                      <c:pt idx="135">
                        <c:v>1</c:v>
                      </c:pt>
                      <c:pt idx="136">
                        <c:v>1</c:v>
                      </c:pt>
                      <c:pt idx="138">
                        <c:v>1</c:v>
                      </c:pt>
                      <c:pt idx="139">
                        <c:v>1</c:v>
                      </c:pt>
                      <c:pt idx="140">
                        <c:v>1</c:v>
                      </c:pt>
                      <c:pt idx="142">
                        <c:v>1</c:v>
                      </c:pt>
                      <c:pt idx="143">
                        <c:v>1</c:v>
                      </c:pt>
                      <c:pt idx="146">
                        <c:v>1</c:v>
                      </c:pt>
                      <c:pt idx="149">
                        <c:v>1</c:v>
                      </c:pt>
                      <c:pt idx="153">
                        <c:v>1</c:v>
                      </c:pt>
                      <c:pt idx="155">
                        <c:v>1</c:v>
                      </c:pt>
                      <c:pt idx="156">
                        <c:v>1</c:v>
                      </c:pt>
                      <c:pt idx="160">
                        <c:v>1</c:v>
                      </c:pt>
                      <c:pt idx="167">
                        <c:v>1</c:v>
                      </c:pt>
                      <c:pt idx="168">
                        <c:v>1</c:v>
                      </c:pt>
                      <c:pt idx="169">
                        <c:v>1</c:v>
                      </c:pt>
                      <c:pt idx="170">
                        <c:v>1</c:v>
                      </c:pt>
                      <c:pt idx="171">
                        <c:v>1</c:v>
                      </c:pt>
                      <c:pt idx="172">
                        <c:v>1</c:v>
                      </c:pt>
                      <c:pt idx="173">
                        <c:v>1</c:v>
                      </c:pt>
                      <c:pt idx="176">
                        <c:v>1</c:v>
                      </c:pt>
                      <c:pt idx="177">
                        <c:v>1</c:v>
                      </c:pt>
                      <c:pt idx="180">
                        <c:v>1</c:v>
                      </c:pt>
                      <c:pt idx="181">
                        <c:v>1</c:v>
                      </c:pt>
                      <c:pt idx="182">
                        <c:v>1</c:v>
                      </c:pt>
                      <c:pt idx="183">
                        <c:v>1</c:v>
                      </c:pt>
                      <c:pt idx="190">
                        <c:v>1</c:v>
                      </c:pt>
                      <c:pt idx="191">
                        <c:v>1</c:v>
                      </c:pt>
                      <c:pt idx="194">
                        <c:v>1</c:v>
                      </c:pt>
                      <c:pt idx="197">
                        <c:v>1</c:v>
                      </c:pt>
                      <c:pt idx="209">
                        <c:v>1</c:v>
                      </c:pt>
                      <c:pt idx="210">
                        <c:v>1</c:v>
                      </c:pt>
                      <c:pt idx="211">
                        <c:v>1</c:v>
                      </c:pt>
                      <c:pt idx="212">
                        <c:v>1</c:v>
                      </c:pt>
                      <c:pt idx="215">
                        <c:v>1</c:v>
                      </c:pt>
                      <c:pt idx="218">
                        <c:v>1</c:v>
                      </c:pt>
                      <c:pt idx="220">
                        <c:v>1</c:v>
                      </c:pt>
                      <c:pt idx="222">
                        <c:v>1</c:v>
                      </c:pt>
                      <c:pt idx="223">
                        <c:v>1</c:v>
                      </c:pt>
                      <c:pt idx="224">
                        <c:v>1</c:v>
                      </c:pt>
                      <c:pt idx="226">
                        <c:v>1</c:v>
                      </c:pt>
                      <c:pt idx="227">
                        <c:v>1</c:v>
                      </c:pt>
                      <c:pt idx="228">
                        <c:v>1</c:v>
                      </c:pt>
                      <c:pt idx="230">
                        <c:v>1</c:v>
                      </c:pt>
                      <c:pt idx="231">
                        <c:v>1</c:v>
                      </c:pt>
                      <c:pt idx="232">
                        <c:v>3</c:v>
                      </c:pt>
                      <c:pt idx="235">
                        <c:v>1</c:v>
                      </c:pt>
                      <c:pt idx="238">
                        <c:v>1</c:v>
                      </c:pt>
                      <c:pt idx="239">
                        <c:v>1</c:v>
                      </c:pt>
                      <c:pt idx="240">
                        <c:v>1</c:v>
                      </c:pt>
                      <c:pt idx="241">
                        <c:v>1</c:v>
                      </c:pt>
                      <c:pt idx="243">
                        <c:v>1</c:v>
                      </c:pt>
                      <c:pt idx="252">
                        <c:v>1</c:v>
                      </c:pt>
                      <c:pt idx="253">
                        <c:v>1</c:v>
                      </c:pt>
                      <c:pt idx="254">
                        <c:v>1</c:v>
                      </c:pt>
                      <c:pt idx="255">
                        <c:v>1</c:v>
                      </c:pt>
                      <c:pt idx="259">
                        <c:v>1</c:v>
                      </c:pt>
                      <c:pt idx="260">
                        <c:v>1</c:v>
                      </c:pt>
                      <c:pt idx="263">
                        <c:v>1</c:v>
                      </c:pt>
                      <c:pt idx="264">
                        <c:v>2</c:v>
                      </c:pt>
                      <c:pt idx="270">
                        <c:v>1</c:v>
                      </c:pt>
                      <c:pt idx="272">
                        <c:v>1</c:v>
                      </c:pt>
                      <c:pt idx="273">
                        <c:v>1</c:v>
                      </c:pt>
                      <c:pt idx="274">
                        <c:v>1</c:v>
                      </c:pt>
                      <c:pt idx="275">
                        <c:v>1</c:v>
                      </c:pt>
                      <c:pt idx="278">
                        <c:v>1</c:v>
                      </c:pt>
                      <c:pt idx="279">
                        <c:v>1</c:v>
                      </c:pt>
                      <c:pt idx="280">
                        <c:v>1</c:v>
                      </c:pt>
                      <c:pt idx="281">
                        <c:v>1</c:v>
                      </c:pt>
                      <c:pt idx="282">
                        <c:v>1</c:v>
                      </c:pt>
                      <c:pt idx="284">
                        <c:v>1</c:v>
                      </c:pt>
                      <c:pt idx="285">
                        <c:v>1</c:v>
                      </c:pt>
                      <c:pt idx="287">
                        <c:v>1</c:v>
                      </c:pt>
                      <c:pt idx="288">
                        <c:v>2</c:v>
                      </c:pt>
                      <c:pt idx="289">
                        <c:v>1</c:v>
                      </c:pt>
                      <c:pt idx="290">
                        <c:v>1</c:v>
                      </c:pt>
                      <c:pt idx="292">
                        <c:v>1</c:v>
                      </c:pt>
                      <c:pt idx="293">
                        <c:v>1</c:v>
                      </c:pt>
                      <c:pt idx="294">
                        <c:v>1</c:v>
                      </c:pt>
                      <c:pt idx="295">
                        <c:v>1</c:v>
                      </c:pt>
                      <c:pt idx="300">
                        <c:v>1</c:v>
                      </c:pt>
                      <c:pt idx="302">
                        <c:v>1</c:v>
                      </c:pt>
                      <c:pt idx="303">
                        <c:v>1</c:v>
                      </c:pt>
                      <c:pt idx="305">
                        <c:v>1</c:v>
                      </c:pt>
                      <c:pt idx="306">
                        <c:v>1</c:v>
                      </c:pt>
                      <c:pt idx="308">
                        <c:v>1</c:v>
                      </c:pt>
                      <c:pt idx="311">
                        <c:v>1</c:v>
                      </c:pt>
                      <c:pt idx="315">
                        <c:v>1</c:v>
                      </c:pt>
                      <c:pt idx="316">
                        <c:v>1</c:v>
                      </c:pt>
                      <c:pt idx="318">
                        <c:v>1</c:v>
                      </c:pt>
                      <c:pt idx="324">
                        <c:v>1</c:v>
                      </c:pt>
                      <c:pt idx="327">
                        <c:v>1</c:v>
                      </c:pt>
                      <c:pt idx="328">
                        <c:v>1</c:v>
                      </c:pt>
                      <c:pt idx="330">
                        <c:v>1</c:v>
                      </c:pt>
                      <c:pt idx="333">
                        <c:v>1</c:v>
                      </c:pt>
                      <c:pt idx="334">
                        <c:v>1</c:v>
                      </c:pt>
                      <c:pt idx="337">
                        <c:v>1</c:v>
                      </c:pt>
                      <c:pt idx="340">
                        <c:v>1</c:v>
                      </c:pt>
                      <c:pt idx="342">
                        <c:v>1</c:v>
                      </c:pt>
                      <c:pt idx="344">
                        <c:v>1</c:v>
                      </c:pt>
                      <c:pt idx="346">
                        <c:v>1</c:v>
                      </c:pt>
                      <c:pt idx="347">
                        <c:v>1</c:v>
                      </c:pt>
                      <c:pt idx="348">
                        <c:v>1</c:v>
                      </c:pt>
                      <c:pt idx="351">
                        <c:v>1</c:v>
                      </c:pt>
                      <c:pt idx="353">
                        <c:v>1</c:v>
                      </c:pt>
                      <c:pt idx="356">
                        <c:v>1</c:v>
                      </c:pt>
                      <c:pt idx="359">
                        <c:v>3</c:v>
                      </c:pt>
                      <c:pt idx="361">
                        <c:v>1</c:v>
                      </c:pt>
                      <c:pt idx="362">
                        <c:v>1</c:v>
                      </c:pt>
                      <c:pt idx="363">
                        <c:v>1</c:v>
                      </c:pt>
                      <c:pt idx="364">
                        <c:v>1</c:v>
                      </c:pt>
                      <c:pt idx="369">
                        <c:v>1</c:v>
                      </c:pt>
                      <c:pt idx="370">
                        <c:v>1</c:v>
                      </c:pt>
                      <c:pt idx="371">
                        <c:v>1</c:v>
                      </c:pt>
                      <c:pt idx="373">
                        <c:v>1</c:v>
                      </c:pt>
                      <c:pt idx="374">
                        <c:v>1</c:v>
                      </c:pt>
                      <c:pt idx="375">
                        <c:v>1</c:v>
                      </c:pt>
                      <c:pt idx="378">
                        <c:v>1</c:v>
                      </c:pt>
                      <c:pt idx="379">
                        <c:v>1</c:v>
                      </c:pt>
                      <c:pt idx="381">
                        <c:v>1</c:v>
                      </c:pt>
                      <c:pt idx="382">
                        <c:v>1</c:v>
                      </c:pt>
                      <c:pt idx="383">
                        <c:v>1</c:v>
                      </c:pt>
                      <c:pt idx="384">
                        <c:v>3</c:v>
                      </c:pt>
                      <c:pt idx="386">
                        <c:v>1</c:v>
                      </c:pt>
                      <c:pt idx="392">
                        <c:v>1</c:v>
                      </c:pt>
                      <c:pt idx="393">
                        <c:v>1</c:v>
                      </c:pt>
                      <c:pt idx="396">
                        <c:v>1</c:v>
                      </c:pt>
                      <c:pt idx="400">
                        <c:v>1</c:v>
                      </c:pt>
                      <c:pt idx="405">
                        <c:v>1</c:v>
                      </c:pt>
                      <c:pt idx="406">
                        <c:v>1</c:v>
                      </c:pt>
                      <c:pt idx="410">
                        <c:v>1</c:v>
                      </c:pt>
                      <c:pt idx="411">
                        <c:v>1</c:v>
                      </c:pt>
                      <c:pt idx="415">
                        <c:v>1</c:v>
                      </c:pt>
                      <c:pt idx="421">
                        <c:v>1</c:v>
                      </c:pt>
                      <c:pt idx="422">
                        <c:v>11</c:v>
                      </c:pt>
                      <c:pt idx="423">
                        <c:v>1</c:v>
                      </c:pt>
                      <c:pt idx="426">
                        <c:v>1</c:v>
                      </c:pt>
                      <c:pt idx="428">
                        <c:v>1</c:v>
                      </c:pt>
                      <c:pt idx="431">
                        <c:v>1</c:v>
                      </c:pt>
                      <c:pt idx="432">
                        <c:v>1</c:v>
                      </c:pt>
                      <c:pt idx="435">
                        <c:v>1</c:v>
                      </c:pt>
                      <c:pt idx="440">
                        <c:v>1</c:v>
                      </c:pt>
                      <c:pt idx="442">
                        <c:v>2</c:v>
                      </c:pt>
                      <c:pt idx="443">
                        <c:v>1</c:v>
                      </c:pt>
                      <c:pt idx="444">
                        <c:v>1</c:v>
                      </c:pt>
                      <c:pt idx="445">
                        <c:v>1</c:v>
                      </c:pt>
                      <c:pt idx="446">
                        <c:v>1</c:v>
                      </c:pt>
                      <c:pt idx="447">
                        <c:v>1</c:v>
                      </c:pt>
                      <c:pt idx="448">
                        <c:v>1</c:v>
                      </c:pt>
                      <c:pt idx="450">
                        <c:v>1</c:v>
                      </c:pt>
                      <c:pt idx="453">
                        <c:v>1</c:v>
                      </c:pt>
                      <c:pt idx="454">
                        <c:v>1</c:v>
                      </c:pt>
                      <c:pt idx="455">
                        <c:v>1</c:v>
                      </c:pt>
                      <c:pt idx="460">
                        <c:v>1</c:v>
                      </c:pt>
                      <c:pt idx="461">
                        <c:v>1</c:v>
                      </c:pt>
                      <c:pt idx="462">
                        <c:v>1</c:v>
                      </c:pt>
                      <c:pt idx="463">
                        <c:v>1</c:v>
                      </c:pt>
                      <c:pt idx="466">
                        <c:v>1</c:v>
                      </c:pt>
                      <c:pt idx="467">
                        <c:v>1</c:v>
                      </c:pt>
                      <c:pt idx="468">
                        <c:v>1</c:v>
                      </c:pt>
                      <c:pt idx="469">
                        <c:v>1</c:v>
                      </c:pt>
                      <c:pt idx="473">
                        <c:v>1</c:v>
                      </c:pt>
                      <c:pt idx="474">
                        <c:v>1</c:v>
                      </c:pt>
                      <c:pt idx="477">
                        <c:v>1</c:v>
                      </c:pt>
                      <c:pt idx="478">
                        <c:v>1</c:v>
                      </c:pt>
                      <c:pt idx="479">
                        <c:v>1</c:v>
                      </c:pt>
                      <c:pt idx="486">
                        <c:v>1</c:v>
                      </c:pt>
                      <c:pt idx="487">
                        <c:v>1</c:v>
                      </c:pt>
                      <c:pt idx="490">
                        <c:v>1</c:v>
                      </c:pt>
                      <c:pt idx="491">
                        <c:v>1</c:v>
                      </c:pt>
                      <c:pt idx="494">
                        <c:v>1</c:v>
                      </c:pt>
                      <c:pt idx="495">
                        <c:v>3</c:v>
                      </c:pt>
                      <c:pt idx="496">
                        <c:v>1</c:v>
                      </c:pt>
                      <c:pt idx="502">
                        <c:v>1</c:v>
                      </c:pt>
                      <c:pt idx="504">
                        <c:v>1</c:v>
                      </c:pt>
                      <c:pt idx="506">
                        <c:v>1</c:v>
                      </c:pt>
                      <c:pt idx="508">
                        <c:v>1</c:v>
                      </c:pt>
                      <c:pt idx="509">
                        <c:v>1</c:v>
                      </c:pt>
                      <c:pt idx="510">
                        <c:v>1</c:v>
                      </c:pt>
                      <c:pt idx="517">
                        <c:v>1</c:v>
                      </c:pt>
                      <c:pt idx="529">
                        <c:v>1</c:v>
                      </c:pt>
                      <c:pt idx="533">
                        <c:v>1</c:v>
                      </c:pt>
                      <c:pt idx="535">
                        <c:v>1</c:v>
                      </c:pt>
                      <c:pt idx="538">
                        <c:v>1</c:v>
                      </c:pt>
                      <c:pt idx="540">
                        <c:v>1</c:v>
                      </c:pt>
                      <c:pt idx="546">
                        <c:v>1</c:v>
                      </c:pt>
                      <c:pt idx="547">
                        <c:v>1</c:v>
                      </c:pt>
                      <c:pt idx="548">
                        <c:v>1</c:v>
                      </c:pt>
                      <c:pt idx="549">
                        <c:v>1</c:v>
                      </c:pt>
                      <c:pt idx="552">
                        <c:v>1</c:v>
                      </c:pt>
                      <c:pt idx="554">
                        <c:v>1</c:v>
                      </c:pt>
                      <c:pt idx="555">
                        <c:v>1</c:v>
                      </c:pt>
                      <c:pt idx="558">
                        <c:v>1</c:v>
                      </c:pt>
                      <c:pt idx="561">
                        <c:v>1</c:v>
                      </c:pt>
                      <c:pt idx="564">
                        <c:v>1</c:v>
                      </c:pt>
                      <c:pt idx="565">
                        <c:v>1</c:v>
                      </c:pt>
                      <c:pt idx="567">
                        <c:v>1</c:v>
                      </c:pt>
                      <c:pt idx="570">
                        <c:v>1</c:v>
                      </c:pt>
                      <c:pt idx="571">
                        <c:v>1</c:v>
                      </c:pt>
                      <c:pt idx="572">
                        <c:v>1</c:v>
                      </c:pt>
                      <c:pt idx="576">
                        <c:v>1</c:v>
                      </c:pt>
                      <c:pt idx="577">
                        <c:v>1</c:v>
                      </c:pt>
                      <c:pt idx="578">
                        <c:v>1</c:v>
                      </c:pt>
                      <c:pt idx="585">
                        <c:v>1</c:v>
                      </c:pt>
                      <c:pt idx="587">
                        <c:v>1</c:v>
                      </c:pt>
                      <c:pt idx="590">
                        <c:v>1</c:v>
                      </c:pt>
                      <c:pt idx="596">
                        <c:v>1</c:v>
                      </c:pt>
                      <c:pt idx="597">
                        <c:v>1</c:v>
                      </c:pt>
                      <c:pt idx="598">
                        <c:v>1</c:v>
                      </c:pt>
                      <c:pt idx="599">
                        <c:v>1</c:v>
                      </c:pt>
                      <c:pt idx="603">
                        <c:v>1</c:v>
                      </c:pt>
                      <c:pt idx="608">
                        <c:v>1</c:v>
                      </c:pt>
                      <c:pt idx="609">
                        <c:v>1</c:v>
                      </c:pt>
                      <c:pt idx="612">
                        <c:v>1</c:v>
                      </c:pt>
                      <c:pt idx="613">
                        <c:v>1</c:v>
                      </c:pt>
                      <c:pt idx="614">
                        <c:v>1</c:v>
                      </c:pt>
                      <c:pt idx="618">
                        <c:v>1</c:v>
                      </c:pt>
                      <c:pt idx="620">
                        <c:v>1</c:v>
                      </c:pt>
                      <c:pt idx="622">
                        <c:v>1</c:v>
                      </c:pt>
                      <c:pt idx="624">
                        <c:v>1</c:v>
                      </c:pt>
                      <c:pt idx="625">
                        <c:v>1</c:v>
                      </c:pt>
                      <c:pt idx="627">
                        <c:v>1</c:v>
                      </c:pt>
                      <c:pt idx="628">
                        <c:v>1</c:v>
                      </c:pt>
                      <c:pt idx="630">
                        <c:v>1</c:v>
                      </c:pt>
                      <c:pt idx="634">
                        <c:v>1</c:v>
                      </c:pt>
                      <c:pt idx="635">
                        <c:v>1</c:v>
                      </c:pt>
                      <c:pt idx="636">
                        <c:v>1</c:v>
                      </c:pt>
                      <c:pt idx="638">
                        <c:v>1</c:v>
                      </c:pt>
                      <c:pt idx="640">
                        <c:v>1</c:v>
                      </c:pt>
                      <c:pt idx="648">
                        <c:v>1</c:v>
                      </c:pt>
                      <c:pt idx="649">
                        <c:v>1</c:v>
                      </c:pt>
                      <c:pt idx="650">
                        <c:v>1</c:v>
                      </c:pt>
                      <c:pt idx="652">
                        <c:v>1</c:v>
                      </c:pt>
                      <c:pt idx="655">
                        <c:v>1</c:v>
                      </c:pt>
                      <c:pt idx="657">
                        <c:v>1</c:v>
                      </c:pt>
                      <c:pt idx="658">
                        <c:v>1</c:v>
                      </c:pt>
                      <c:pt idx="659">
                        <c:v>1</c:v>
                      </c:pt>
                      <c:pt idx="660">
                        <c:v>1</c:v>
                      </c:pt>
                      <c:pt idx="667">
                        <c:v>1</c:v>
                      </c:pt>
                      <c:pt idx="668">
                        <c:v>1</c:v>
                      </c:pt>
                      <c:pt idx="670">
                        <c:v>1</c:v>
                      </c:pt>
                      <c:pt idx="677">
                        <c:v>1</c:v>
                      </c:pt>
                      <c:pt idx="678">
                        <c:v>1</c:v>
                      </c:pt>
                      <c:pt idx="679">
                        <c:v>1</c:v>
                      </c:pt>
                      <c:pt idx="681">
                        <c:v>1</c:v>
                      </c:pt>
                      <c:pt idx="682">
                        <c:v>1</c:v>
                      </c:pt>
                      <c:pt idx="683">
                        <c:v>1</c:v>
                      </c:pt>
                      <c:pt idx="685">
                        <c:v>1</c:v>
                      </c:pt>
                      <c:pt idx="691">
                        <c:v>1</c:v>
                      </c:pt>
                      <c:pt idx="693">
                        <c:v>1</c:v>
                      </c:pt>
                      <c:pt idx="696">
                        <c:v>1</c:v>
                      </c:pt>
                      <c:pt idx="698">
                        <c:v>1</c:v>
                      </c:pt>
                      <c:pt idx="700">
                        <c:v>1</c:v>
                      </c:pt>
                      <c:pt idx="702">
                        <c:v>1</c:v>
                      </c:pt>
                      <c:pt idx="705">
                        <c:v>1</c:v>
                      </c:pt>
                      <c:pt idx="707">
                        <c:v>3</c:v>
                      </c:pt>
                      <c:pt idx="709">
                        <c:v>1</c:v>
                      </c:pt>
                      <c:pt idx="710">
                        <c:v>3</c:v>
                      </c:pt>
                      <c:pt idx="713">
                        <c:v>1</c:v>
                      </c:pt>
                      <c:pt idx="714">
                        <c:v>1</c:v>
                      </c:pt>
                      <c:pt idx="716">
                        <c:v>1</c:v>
                      </c:pt>
                      <c:pt idx="717">
                        <c:v>1</c:v>
                      </c:pt>
                      <c:pt idx="720">
                        <c:v>1</c:v>
                      </c:pt>
                      <c:pt idx="727">
                        <c:v>1</c:v>
                      </c:pt>
                      <c:pt idx="730">
                        <c:v>1</c:v>
                      </c:pt>
                      <c:pt idx="731">
                        <c:v>1</c:v>
                      </c:pt>
                      <c:pt idx="733">
                        <c:v>1</c:v>
                      </c:pt>
                      <c:pt idx="734">
                        <c:v>1</c:v>
                      </c:pt>
                      <c:pt idx="735">
                        <c:v>1</c:v>
                      </c:pt>
                      <c:pt idx="736">
                        <c:v>1</c:v>
                      </c:pt>
                      <c:pt idx="738">
                        <c:v>1</c:v>
                      </c:pt>
                      <c:pt idx="739">
                        <c:v>1</c:v>
                      </c:pt>
                      <c:pt idx="740">
                        <c:v>1</c:v>
                      </c:pt>
                      <c:pt idx="742">
                        <c:v>1</c:v>
                      </c:pt>
                      <c:pt idx="744">
                        <c:v>1</c:v>
                      </c:pt>
                      <c:pt idx="746">
                        <c:v>1</c:v>
                      </c:pt>
                      <c:pt idx="752">
                        <c:v>2</c:v>
                      </c:pt>
                      <c:pt idx="753">
                        <c:v>1</c:v>
                      </c:pt>
                      <c:pt idx="754">
                        <c:v>1</c:v>
                      </c:pt>
                      <c:pt idx="755">
                        <c:v>1</c:v>
                      </c:pt>
                      <c:pt idx="759">
                        <c:v>1</c:v>
                      </c:pt>
                      <c:pt idx="761">
                        <c:v>11</c:v>
                      </c:pt>
                      <c:pt idx="764">
                        <c:v>1</c:v>
                      </c:pt>
                      <c:pt idx="765">
                        <c:v>1</c:v>
                      </c:pt>
                      <c:pt idx="768">
                        <c:v>1</c:v>
                      </c:pt>
                      <c:pt idx="769">
                        <c:v>1</c:v>
                      </c:pt>
                      <c:pt idx="775">
                        <c:v>1</c:v>
                      </c:pt>
                      <c:pt idx="779">
                        <c:v>1</c:v>
                      </c:pt>
                      <c:pt idx="780">
                        <c:v>2</c:v>
                      </c:pt>
                      <c:pt idx="782">
                        <c:v>1</c:v>
                      </c:pt>
                      <c:pt idx="783">
                        <c:v>1</c:v>
                      </c:pt>
                      <c:pt idx="784">
                        <c:v>1</c:v>
                      </c:pt>
                      <c:pt idx="786">
                        <c:v>1</c:v>
                      </c:pt>
                      <c:pt idx="795">
                        <c:v>2</c:v>
                      </c:pt>
                      <c:pt idx="796">
                        <c:v>1</c:v>
                      </c:pt>
                      <c:pt idx="797">
                        <c:v>1</c:v>
                      </c:pt>
                      <c:pt idx="801">
                        <c:v>1</c:v>
                      </c:pt>
                      <c:pt idx="802">
                        <c:v>1</c:v>
                      </c:pt>
                      <c:pt idx="803">
                        <c:v>1</c:v>
                      </c:pt>
                      <c:pt idx="804">
                        <c:v>1</c:v>
                      </c:pt>
                      <c:pt idx="806">
                        <c:v>1</c:v>
                      </c:pt>
                      <c:pt idx="808">
                        <c:v>1</c:v>
                      </c:pt>
                      <c:pt idx="810">
                        <c:v>1</c:v>
                      </c:pt>
                      <c:pt idx="811">
                        <c:v>1</c:v>
                      </c:pt>
                      <c:pt idx="813">
                        <c:v>3</c:v>
                      </c:pt>
                      <c:pt idx="815">
                        <c:v>1</c:v>
                      </c:pt>
                      <c:pt idx="819">
                        <c:v>1</c:v>
                      </c:pt>
                      <c:pt idx="824">
                        <c:v>1</c:v>
                      </c:pt>
                      <c:pt idx="825">
                        <c:v>1</c:v>
                      </c:pt>
                      <c:pt idx="827">
                        <c:v>1</c:v>
                      </c:pt>
                      <c:pt idx="831">
                        <c:v>1</c:v>
                      </c:pt>
                      <c:pt idx="833">
                        <c:v>1</c:v>
                      </c:pt>
                      <c:pt idx="835">
                        <c:v>1</c:v>
                      </c:pt>
                      <c:pt idx="836">
                        <c:v>1</c:v>
                      </c:pt>
                      <c:pt idx="837">
                        <c:v>1</c:v>
                      </c:pt>
                      <c:pt idx="839">
                        <c:v>1</c:v>
                      </c:pt>
                      <c:pt idx="841">
                        <c:v>1</c:v>
                      </c:pt>
                      <c:pt idx="842">
                        <c:v>1</c:v>
                      </c:pt>
                      <c:pt idx="847">
                        <c:v>1</c:v>
                      </c:pt>
                      <c:pt idx="854">
                        <c:v>1</c:v>
                      </c:pt>
                      <c:pt idx="857">
                        <c:v>1</c:v>
                      </c:pt>
                      <c:pt idx="858">
                        <c:v>1</c:v>
                      </c:pt>
                      <c:pt idx="863">
                        <c:v>1</c:v>
                      </c:pt>
                      <c:pt idx="867">
                        <c:v>1</c:v>
                      </c:pt>
                      <c:pt idx="868">
                        <c:v>1</c:v>
                      </c:pt>
                      <c:pt idx="873">
                        <c:v>1</c:v>
                      </c:pt>
                      <c:pt idx="875">
                        <c:v>1</c:v>
                      </c:pt>
                      <c:pt idx="876">
                        <c:v>1</c:v>
                      </c:pt>
                      <c:pt idx="879">
                        <c:v>1</c:v>
                      </c:pt>
                      <c:pt idx="883">
                        <c:v>-1</c:v>
                      </c:pt>
                      <c:pt idx="884">
                        <c:v>1</c:v>
                      </c:pt>
                      <c:pt idx="887">
                        <c:v>2</c:v>
                      </c:pt>
                      <c:pt idx="895">
                        <c:v>2</c:v>
                      </c:pt>
                      <c:pt idx="897">
                        <c:v>1</c:v>
                      </c:pt>
                      <c:pt idx="899">
                        <c:v>1</c:v>
                      </c:pt>
                      <c:pt idx="902">
                        <c:v>1</c:v>
                      </c:pt>
                      <c:pt idx="903">
                        <c:v>1</c:v>
                      </c:pt>
                      <c:pt idx="904">
                        <c:v>1</c:v>
                      </c:pt>
                      <c:pt idx="905">
                        <c:v>1</c:v>
                      </c:pt>
                      <c:pt idx="906">
                        <c:v>1</c:v>
                      </c:pt>
                      <c:pt idx="908">
                        <c:v>1</c:v>
                      </c:pt>
                      <c:pt idx="909">
                        <c:v>1</c:v>
                      </c:pt>
                      <c:pt idx="916">
                        <c:v>1</c:v>
                      </c:pt>
                      <c:pt idx="921">
                        <c:v>1</c:v>
                      </c:pt>
                      <c:pt idx="922">
                        <c:v>1</c:v>
                      </c:pt>
                      <c:pt idx="925">
                        <c:v>1</c:v>
                      </c:pt>
                      <c:pt idx="927">
                        <c:v>1</c:v>
                      </c:pt>
                      <c:pt idx="928">
                        <c:v>1</c:v>
                      </c:pt>
                      <c:pt idx="929">
                        <c:v>1</c:v>
                      </c:pt>
                      <c:pt idx="931">
                        <c:v>1</c:v>
                      </c:pt>
                      <c:pt idx="933">
                        <c:v>1</c:v>
                      </c:pt>
                      <c:pt idx="936">
                        <c:v>1</c:v>
                      </c:pt>
                      <c:pt idx="937">
                        <c:v>1</c:v>
                      </c:pt>
                      <c:pt idx="939">
                        <c:v>1</c:v>
                      </c:pt>
                      <c:pt idx="940">
                        <c:v>1</c:v>
                      </c:pt>
                      <c:pt idx="943">
                        <c:v>1</c:v>
                      </c:pt>
                      <c:pt idx="945">
                        <c:v>2</c:v>
                      </c:pt>
                      <c:pt idx="946">
                        <c:v>1</c:v>
                      </c:pt>
                      <c:pt idx="947">
                        <c:v>1</c:v>
                      </c:pt>
                      <c:pt idx="949">
                        <c:v>1</c:v>
                      </c:pt>
                      <c:pt idx="951">
                        <c:v>1</c:v>
                      </c:pt>
                      <c:pt idx="952">
                        <c:v>1</c:v>
                      </c:pt>
                      <c:pt idx="954">
                        <c:v>1</c:v>
                      </c:pt>
                      <c:pt idx="955">
                        <c:v>1</c:v>
                      </c:pt>
                      <c:pt idx="957">
                        <c:v>2</c:v>
                      </c:pt>
                      <c:pt idx="962">
                        <c:v>1</c:v>
                      </c:pt>
                      <c:pt idx="963">
                        <c:v>1</c:v>
                      </c:pt>
                      <c:pt idx="968">
                        <c:v>1</c:v>
                      </c:pt>
                      <c:pt idx="970">
                        <c:v>1</c:v>
                      </c:pt>
                      <c:pt idx="971">
                        <c:v>1</c:v>
                      </c:pt>
                      <c:pt idx="974">
                        <c:v>1</c:v>
                      </c:pt>
                      <c:pt idx="976">
                        <c:v>1</c:v>
                      </c:pt>
                      <c:pt idx="979">
                        <c:v>1</c:v>
                      </c:pt>
                      <c:pt idx="983">
                        <c:v>1</c:v>
                      </c:pt>
                      <c:pt idx="984">
                        <c:v>1</c:v>
                      </c:pt>
                      <c:pt idx="989">
                        <c:v>1</c:v>
                      </c:pt>
                      <c:pt idx="994">
                        <c:v>1</c:v>
                      </c:pt>
                      <c:pt idx="995">
                        <c:v>2</c:v>
                      </c:pt>
                    </c:numCache>
                  </c:numRef>
                </c:yVal>
                <c:smooth val="0"/>
              </c15:ser>
            </c15:filteredScatterSeries>
            <c15:filteredScatterSeries>
              <c15:ser>
                <c:idx val="2"/>
                <c:order val="2"/>
                <c:tx>
                  <c:strRef>
                    <c:extLst xmlns:c15="http://schemas.microsoft.com/office/drawing/2012/chart">
                      <c:ext xmlns:c15="http://schemas.microsoft.com/office/drawing/2012/chart" uri="{02D57815-91ED-43cb-92C2-25804820EDAC}">
                        <c15:formulaRef>
                          <c15:sqref>AGO1a!$E$1</c15:sqref>
                        </c15:formulaRef>
                      </c:ext>
                    </c:extLst>
                    <c:strCache>
                      <c:ptCount val="1"/>
                      <c:pt idx="0">
                        <c:v>BDI490cDNA_tplot</c:v>
                      </c:pt>
                    </c:strCache>
                  </c:strRef>
                </c:tx>
                <c:spPr>
                  <a:ln w="19050" cap="rnd">
                    <a:noFill/>
                    <a:round/>
                  </a:ln>
                  <a:effectLst/>
                </c:spPr>
                <c:marker>
                  <c:symbol val="circle"/>
                  <c:size val="5"/>
                  <c:spPr>
                    <a:solidFill>
                      <a:schemeClr val="accent3"/>
                    </a:solidFill>
                    <a:ln w="9525">
                      <a:solidFill>
                        <a:schemeClr val="accent3"/>
                      </a:solidFill>
                    </a:ln>
                    <a:effectLst/>
                  </c:spPr>
                </c:marker>
                <c:xVal>
                  <c:numRef>
                    <c:extLst xmlns:c15="http://schemas.microsoft.com/office/drawing/2012/chart">
                      <c:ext xmlns:c15="http://schemas.microsoft.com/office/drawing/2012/chart" uri="{02D57815-91ED-43cb-92C2-25804820EDAC}">
                        <c15:formulaRef>
                          <c15:sqref>AGO1a!$B$2:$B$1002</c15:sqref>
                        </c15:formulaRef>
                      </c:ext>
                    </c:extLst>
                    <c:numCache>
                      <c:formatCode>General</c:formatCode>
                      <c:ptCount val="1001"/>
                      <c:pt idx="0">
                        <c:v>3583</c:v>
                      </c:pt>
                      <c:pt idx="1">
                        <c:v>2443</c:v>
                      </c:pt>
                      <c:pt idx="2">
                        <c:v>2713</c:v>
                      </c:pt>
                      <c:pt idx="3">
                        <c:v>3344</c:v>
                      </c:pt>
                      <c:pt idx="4">
                        <c:v>2251</c:v>
                      </c:pt>
                      <c:pt idx="5">
                        <c:v>3693</c:v>
                      </c:pt>
                      <c:pt idx="6">
                        <c:v>1477</c:v>
                      </c:pt>
                      <c:pt idx="7">
                        <c:v>3872</c:v>
                      </c:pt>
                      <c:pt idx="8">
                        <c:v>3871</c:v>
                      </c:pt>
                      <c:pt idx="9">
                        <c:v>3404</c:v>
                      </c:pt>
                      <c:pt idx="10">
                        <c:v>2409</c:v>
                      </c:pt>
                      <c:pt idx="11">
                        <c:v>3714</c:v>
                      </c:pt>
                      <c:pt idx="12">
                        <c:v>1420</c:v>
                      </c:pt>
                      <c:pt idx="13">
                        <c:v>3967</c:v>
                      </c:pt>
                      <c:pt idx="14">
                        <c:v>2893</c:v>
                      </c:pt>
                      <c:pt idx="15">
                        <c:v>3641</c:v>
                      </c:pt>
                      <c:pt idx="16">
                        <c:v>3271</c:v>
                      </c:pt>
                      <c:pt idx="17">
                        <c:v>2641</c:v>
                      </c:pt>
                      <c:pt idx="18">
                        <c:v>3549</c:v>
                      </c:pt>
                      <c:pt idx="19">
                        <c:v>1941</c:v>
                      </c:pt>
                      <c:pt idx="20">
                        <c:v>2664</c:v>
                      </c:pt>
                      <c:pt idx="21">
                        <c:v>3924</c:v>
                      </c:pt>
                      <c:pt idx="22">
                        <c:v>3707</c:v>
                      </c:pt>
                      <c:pt idx="23">
                        <c:v>2278</c:v>
                      </c:pt>
                      <c:pt idx="24">
                        <c:v>3457</c:v>
                      </c:pt>
                      <c:pt idx="25">
                        <c:v>3546</c:v>
                      </c:pt>
                      <c:pt idx="26">
                        <c:v>3319</c:v>
                      </c:pt>
                      <c:pt idx="27">
                        <c:v>2821</c:v>
                      </c:pt>
                      <c:pt idx="28">
                        <c:v>2403</c:v>
                      </c:pt>
                      <c:pt idx="29">
                        <c:v>864</c:v>
                      </c:pt>
                      <c:pt idx="30">
                        <c:v>1729</c:v>
                      </c:pt>
                      <c:pt idx="31">
                        <c:v>3322</c:v>
                      </c:pt>
                      <c:pt idx="32">
                        <c:v>3378</c:v>
                      </c:pt>
                      <c:pt idx="33">
                        <c:v>3633</c:v>
                      </c:pt>
                      <c:pt idx="34">
                        <c:v>3579</c:v>
                      </c:pt>
                      <c:pt idx="35">
                        <c:v>2054</c:v>
                      </c:pt>
                      <c:pt idx="36">
                        <c:v>2164</c:v>
                      </c:pt>
                      <c:pt idx="37">
                        <c:v>2766</c:v>
                      </c:pt>
                      <c:pt idx="38">
                        <c:v>3688</c:v>
                      </c:pt>
                      <c:pt idx="39">
                        <c:v>4050</c:v>
                      </c:pt>
                      <c:pt idx="40">
                        <c:v>3248</c:v>
                      </c:pt>
                      <c:pt idx="41">
                        <c:v>2981</c:v>
                      </c:pt>
                      <c:pt idx="42">
                        <c:v>2548</c:v>
                      </c:pt>
                      <c:pt idx="43">
                        <c:v>3840</c:v>
                      </c:pt>
                      <c:pt idx="44">
                        <c:v>3954</c:v>
                      </c:pt>
                      <c:pt idx="45">
                        <c:v>868</c:v>
                      </c:pt>
                      <c:pt idx="46">
                        <c:v>3818</c:v>
                      </c:pt>
                      <c:pt idx="47">
                        <c:v>3735</c:v>
                      </c:pt>
                      <c:pt idx="48">
                        <c:v>2999</c:v>
                      </c:pt>
                      <c:pt idx="49">
                        <c:v>3475</c:v>
                      </c:pt>
                      <c:pt idx="50">
                        <c:v>2720</c:v>
                      </c:pt>
                      <c:pt idx="51">
                        <c:v>3933</c:v>
                      </c:pt>
                      <c:pt idx="52">
                        <c:v>3622</c:v>
                      </c:pt>
                      <c:pt idx="53">
                        <c:v>3934</c:v>
                      </c:pt>
                      <c:pt idx="54">
                        <c:v>3075</c:v>
                      </c:pt>
                      <c:pt idx="55">
                        <c:v>2114</c:v>
                      </c:pt>
                      <c:pt idx="56">
                        <c:v>3931</c:v>
                      </c:pt>
                      <c:pt idx="57">
                        <c:v>2386</c:v>
                      </c:pt>
                      <c:pt idx="58">
                        <c:v>3576</c:v>
                      </c:pt>
                      <c:pt idx="59">
                        <c:v>3674</c:v>
                      </c:pt>
                      <c:pt idx="60">
                        <c:v>3507</c:v>
                      </c:pt>
                      <c:pt idx="61">
                        <c:v>3648</c:v>
                      </c:pt>
                      <c:pt idx="62">
                        <c:v>3848</c:v>
                      </c:pt>
                      <c:pt idx="63">
                        <c:v>1032</c:v>
                      </c:pt>
                      <c:pt idx="64">
                        <c:v>3014</c:v>
                      </c:pt>
                      <c:pt idx="65">
                        <c:v>2057</c:v>
                      </c:pt>
                      <c:pt idx="66">
                        <c:v>3037</c:v>
                      </c:pt>
                      <c:pt idx="67">
                        <c:v>3917</c:v>
                      </c:pt>
                      <c:pt idx="68">
                        <c:v>3022</c:v>
                      </c:pt>
                      <c:pt idx="69">
                        <c:v>2250</c:v>
                      </c:pt>
                      <c:pt idx="70">
                        <c:v>4017</c:v>
                      </c:pt>
                      <c:pt idx="71">
                        <c:v>4006</c:v>
                      </c:pt>
                      <c:pt idx="72">
                        <c:v>2552</c:v>
                      </c:pt>
                      <c:pt idx="73">
                        <c:v>3906</c:v>
                      </c:pt>
                      <c:pt idx="74">
                        <c:v>2212</c:v>
                      </c:pt>
                      <c:pt idx="75">
                        <c:v>4023</c:v>
                      </c:pt>
                      <c:pt idx="76">
                        <c:v>2656</c:v>
                      </c:pt>
                      <c:pt idx="77">
                        <c:v>3199</c:v>
                      </c:pt>
                      <c:pt idx="78">
                        <c:v>2774</c:v>
                      </c:pt>
                      <c:pt idx="79">
                        <c:v>3592</c:v>
                      </c:pt>
                      <c:pt idx="80">
                        <c:v>2938</c:v>
                      </c:pt>
                      <c:pt idx="81">
                        <c:v>2330</c:v>
                      </c:pt>
                      <c:pt idx="82">
                        <c:v>1395</c:v>
                      </c:pt>
                      <c:pt idx="83">
                        <c:v>2375</c:v>
                      </c:pt>
                      <c:pt idx="84">
                        <c:v>3621</c:v>
                      </c:pt>
                      <c:pt idx="85">
                        <c:v>3398</c:v>
                      </c:pt>
                      <c:pt idx="86">
                        <c:v>3333</c:v>
                      </c:pt>
                      <c:pt idx="87">
                        <c:v>3461</c:v>
                      </c:pt>
                      <c:pt idx="88">
                        <c:v>3150</c:v>
                      </c:pt>
                      <c:pt idx="89">
                        <c:v>3032</c:v>
                      </c:pt>
                      <c:pt idx="90">
                        <c:v>1185</c:v>
                      </c:pt>
                      <c:pt idx="91">
                        <c:v>3625</c:v>
                      </c:pt>
                      <c:pt idx="92">
                        <c:v>2949</c:v>
                      </c:pt>
                      <c:pt idx="93">
                        <c:v>3888</c:v>
                      </c:pt>
                      <c:pt idx="94">
                        <c:v>2945</c:v>
                      </c:pt>
                      <c:pt idx="95">
                        <c:v>4029</c:v>
                      </c:pt>
                      <c:pt idx="96">
                        <c:v>2906</c:v>
                      </c:pt>
                      <c:pt idx="97">
                        <c:v>3158</c:v>
                      </c:pt>
                      <c:pt idx="98">
                        <c:v>2327</c:v>
                      </c:pt>
                      <c:pt idx="99">
                        <c:v>1654</c:v>
                      </c:pt>
                      <c:pt idx="100">
                        <c:v>3105</c:v>
                      </c:pt>
                      <c:pt idx="101">
                        <c:v>3309</c:v>
                      </c:pt>
                      <c:pt idx="102">
                        <c:v>1422</c:v>
                      </c:pt>
                      <c:pt idx="103">
                        <c:v>1826</c:v>
                      </c:pt>
                      <c:pt idx="104">
                        <c:v>2901</c:v>
                      </c:pt>
                      <c:pt idx="105">
                        <c:v>3732</c:v>
                      </c:pt>
                      <c:pt idx="106">
                        <c:v>1930</c:v>
                      </c:pt>
                      <c:pt idx="107">
                        <c:v>3300</c:v>
                      </c:pt>
                      <c:pt idx="108">
                        <c:v>1444</c:v>
                      </c:pt>
                      <c:pt idx="109">
                        <c:v>1914</c:v>
                      </c:pt>
                      <c:pt idx="110">
                        <c:v>1805</c:v>
                      </c:pt>
                      <c:pt idx="111">
                        <c:v>1598</c:v>
                      </c:pt>
                      <c:pt idx="112">
                        <c:v>2016</c:v>
                      </c:pt>
                      <c:pt idx="113">
                        <c:v>2500</c:v>
                      </c:pt>
                      <c:pt idx="114">
                        <c:v>3569</c:v>
                      </c:pt>
                      <c:pt idx="115">
                        <c:v>3005</c:v>
                      </c:pt>
                      <c:pt idx="116">
                        <c:v>3405</c:v>
                      </c:pt>
                      <c:pt idx="117">
                        <c:v>1966</c:v>
                      </c:pt>
                      <c:pt idx="118">
                        <c:v>1820</c:v>
                      </c:pt>
                      <c:pt idx="119">
                        <c:v>2137</c:v>
                      </c:pt>
                      <c:pt idx="120">
                        <c:v>3388</c:v>
                      </c:pt>
                      <c:pt idx="121">
                        <c:v>1040</c:v>
                      </c:pt>
                      <c:pt idx="122">
                        <c:v>3997</c:v>
                      </c:pt>
                      <c:pt idx="123">
                        <c:v>1666</c:v>
                      </c:pt>
                      <c:pt idx="124">
                        <c:v>1973</c:v>
                      </c:pt>
                      <c:pt idx="125">
                        <c:v>3317</c:v>
                      </c:pt>
                      <c:pt idx="126">
                        <c:v>2787</c:v>
                      </c:pt>
                      <c:pt idx="127">
                        <c:v>2692</c:v>
                      </c:pt>
                      <c:pt idx="128">
                        <c:v>3096</c:v>
                      </c:pt>
                      <c:pt idx="129">
                        <c:v>3273</c:v>
                      </c:pt>
                      <c:pt idx="130">
                        <c:v>2382</c:v>
                      </c:pt>
                      <c:pt idx="131">
                        <c:v>3899</c:v>
                      </c:pt>
                      <c:pt idx="132">
                        <c:v>4022</c:v>
                      </c:pt>
                      <c:pt idx="133">
                        <c:v>2071</c:v>
                      </c:pt>
                      <c:pt idx="134">
                        <c:v>2063</c:v>
                      </c:pt>
                      <c:pt idx="135">
                        <c:v>2136</c:v>
                      </c:pt>
                      <c:pt idx="136">
                        <c:v>2964</c:v>
                      </c:pt>
                      <c:pt idx="137">
                        <c:v>2159</c:v>
                      </c:pt>
                      <c:pt idx="138">
                        <c:v>1886</c:v>
                      </c:pt>
                      <c:pt idx="139">
                        <c:v>3116</c:v>
                      </c:pt>
                      <c:pt idx="140">
                        <c:v>3291</c:v>
                      </c:pt>
                      <c:pt idx="141">
                        <c:v>2693</c:v>
                      </c:pt>
                      <c:pt idx="142">
                        <c:v>4012</c:v>
                      </c:pt>
                      <c:pt idx="143">
                        <c:v>3027</c:v>
                      </c:pt>
                      <c:pt idx="144">
                        <c:v>2450</c:v>
                      </c:pt>
                      <c:pt idx="145">
                        <c:v>3460</c:v>
                      </c:pt>
                      <c:pt idx="146">
                        <c:v>3940</c:v>
                      </c:pt>
                      <c:pt idx="147">
                        <c:v>2880</c:v>
                      </c:pt>
                      <c:pt idx="148">
                        <c:v>2770</c:v>
                      </c:pt>
                      <c:pt idx="149">
                        <c:v>3151</c:v>
                      </c:pt>
                      <c:pt idx="150">
                        <c:v>3698</c:v>
                      </c:pt>
                      <c:pt idx="151">
                        <c:v>3652</c:v>
                      </c:pt>
                      <c:pt idx="152">
                        <c:v>3220</c:v>
                      </c:pt>
                      <c:pt idx="153">
                        <c:v>3126</c:v>
                      </c:pt>
                      <c:pt idx="154">
                        <c:v>3443</c:v>
                      </c:pt>
                      <c:pt idx="155">
                        <c:v>3964</c:v>
                      </c:pt>
                      <c:pt idx="156">
                        <c:v>3582</c:v>
                      </c:pt>
                      <c:pt idx="157">
                        <c:v>2408</c:v>
                      </c:pt>
                      <c:pt idx="158">
                        <c:v>3295</c:v>
                      </c:pt>
                      <c:pt idx="159">
                        <c:v>3224</c:v>
                      </c:pt>
                      <c:pt idx="160">
                        <c:v>3025</c:v>
                      </c:pt>
                      <c:pt idx="161">
                        <c:v>3667</c:v>
                      </c:pt>
                      <c:pt idx="162">
                        <c:v>2368</c:v>
                      </c:pt>
                      <c:pt idx="163">
                        <c:v>2848</c:v>
                      </c:pt>
                      <c:pt idx="164">
                        <c:v>2206</c:v>
                      </c:pt>
                      <c:pt idx="165">
                        <c:v>3645</c:v>
                      </c:pt>
                      <c:pt idx="166">
                        <c:v>3523</c:v>
                      </c:pt>
                      <c:pt idx="167">
                        <c:v>2717</c:v>
                      </c:pt>
                      <c:pt idx="168">
                        <c:v>2166</c:v>
                      </c:pt>
                      <c:pt idx="169">
                        <c:v>2198</c:v>
                      </c:pt>
                      <c:pt idx="170">
                        <c:v>2445</c:v>
                      </c:pt>
                      <c:pt idx="171">
                        <c:v>3969</c:v>
                      </c:pt>
                      <c:pt idx="172">
                        <c:v>2710</c:v>
                      </c:pt>
                      <c:pt idx="173">
                        <c:v>1912</c:v>
                      </c:pt>
                      <c:pt idx="174">
                        <c:v>3929</c:v>
                      </c:pt>
                      <c:pt idx="175">
                        <c:v>3820</c:v>
                      </c:pt>
                      <c:pt idx="176">
                        <c:v>2296</c:v>
                      </c:pt>
                      <c:pt idx="177">
                        <c:v>3038</c:v>
                      </c:pt>
                      <c:pt idx="178">
                        <c:v>1933</c:v>
                      </c:pt>
                      <c:pt idx="179">
                        <c:v>2730</c:v>
                      </c:pt>
                      <c:pt idx="180">
                        <c:v>3996</c:v>
                      </c:pt>
                      <c:pt idx="181">
                        <c:v>2061</c:v>
                      </c:pt>
                      <c:pt idx="182">
                        <c:v>3922</c:v>
                      </c:pt>
                      <c:pt idx="183">
                        <c:v>2181</c:v>
                      </c:pt>
                      <c:pt idx="184">
                        <c:v>3341</c:v>
                      </c:pt>
                      <c:pt idx="185">
                        <c:v>2667</c:v>
                      </c:pt>
                      <c:pt idx="186">
                        <c:v>2923</c:v>
                      </c:pt>
                      <c:pt idx="187">
                        <c:v>3528</c:v>
                      </c:pt>
                      <c:pt idx="188">
                        <c:v>3524</c:v>
                      </c:pt>
                      <c:pt idx="189">
                        <c:v>2668</c:v>
                      </c:pt>
                      <c:pt idx="190">
                        <c:v>3948</c:v>
                      </c:pt>
                      <c:pt idx="191">
                        <c:v>3831</c:v>
                      </c:pt>
                      <c:pt idx="192">
                        <c:v>2669</c:v>
                      </c:pt>
                      <c:pt idx="193">
                        <c:v>3743</c:v>
                      </c:pt>
                      <c:pt idx="194">
                        <c:v>841</c:v>
                      </c:pt>
                      <c:pt idx="195">
                        <c:v>3897</c:v>
                      </c:pt>
                      <c:pt idx="196">
                        <c:v>2496</c:v>
                      </c:pt>
                      <c:pt idx="197">
                        <c:v>2392</c:v>
                      </c:pt>
                      <c:pt idx="198">
                        <c:v>3383</c:v>
                      </c:pt>
                      <c:pt idx="199">
                        <c:v>3919</c:v>
                      </c:pt>
                      <c:pt idx="200">
                        <c:v>3459</c:v>
                      </c:pt>
                      <c:pt idx="201">
                        <c:v>3385</c:v>
                      </c:pt>
                      <c:pt idx="202">
                        <c:v>4005</c:v>
                      </c:pt>
                      <c:pt idx="203">
                        <c:v>4009</c:v>
                      </c:pt>
                      <c:pt idx="204">
                        <c:v>3803</c:v>
                      </c:pt>
                      <c:pt idx="205">
                        <c:v>2100</c:v>
                      </c:pt>
                      <c:pt idx="206">
                        <c:v>2933</c:v>
                      </c:pt>
                      <c:pt idx="207">
                        <c:v>1954</c:v>
                      </c:pt>
                      <c:pt idx="208">
                        <c:v>2715</c:v>
                      </c:pt>
                      <c:pt idx="209">
                        <c:v>2423</c:v>
                      </c:pt>
                      <c:pt idx="210">
                        <c:v>3377</c:v>
                      </c:pt>
                      <c:pt idx="211">
                        <c:v>3262</c:v>
                      </c:pt>
                      <c:pt idx="212">
                        <c:v>2030</c:v>
                      </c:pt>
                      <c:pt idx="213">
                        <c:v>2847</c:v>
                      </c:pt>
                      <c:pt idx="214">
                        <c:v>4039</c:v>
                      </c:pt>
                      <c:pt idx="215">
                        <c:v>2055</c:v>
                      </c:pt>
                      <c:pt idx="216">
                        <c:v>1679</c:v>
                      </c:pt>
                      <c:pt idx="217">
                        <c:v>1981</c:v>
                      </c:pt>
                      <c:pt idx="218">
                        <c:v>2396</c:v>
                      </c:pt>
                      <c:pt idx="219">
                        <c:v>4082</c:v>
                      </c:pt>
                      <c:pt idx="220">
                        <c:v>3316</c:v>
                      </c:pt>
                      <c:pt idx="221">
                        <c:v>1181</c:v>
                      </c:pt>
                      <c:pt idx="222">
                        <c:v>3673</c:v>
                      </c:pt>
                      <c:pt idx="223">
                        <c:v>1794</c:v>
                      </c:pt>
                      <c:pt idx="224">
                        <c:v>3294</c:v>
                      </c:pt>
                      <c:pt idx="225">
                        <c:v>2975</c:v>
                      </c:pt>
                      <c:pt idx="226">
                        <c:v>3580</c:v>
                      </c:pt>
                      <c:pt idx="227">
                        <c:v>3876</c:v>
                      </c:pt>
                      <c:pt idx="228">
                        <c:v>3318</c:v>
                      </c:pt>
                      <c:pt idx="229">
                        <c:v>2984</c:v>
                      </c:pt>
                      <c:pt idx="230">
                        <c:v>3189</c:v>
                      </c:pt>
                      <c:pt idx="231">
                        <c:v>2967</c:v>
                      </c:pt>
                      <c:pt idx="232">
                        <c:v>3028</c:v>
                      </c:pt>
                      <c:pt idx="233">
                        <c:v>3169</c:v>
                      </c:pt>
                      <c:pt idx="234">
                        <c:v>3288</c:v>
                      </c:pt>
                      <c:pt idx="235">
                        <c:v>3686</c:v>
                      </c:pt>
                      <c:pt idx="236">
                        <c:v>3841</c:v>
                      </c:pt>
                      <c:pt idx="237">
                        <c:v>3469</c:v>
                      </c:pt>
                      <c:pt idx="238">
                        <c:v>2988</c:v>
                      </c:pt>
                      <c:pt idx="239">
                        <c:v>3976</c:v>
                      </c:pt>
                      <c:pt idx="240">
                        <c:v>3509</c:v>
                      </c:pt>
                      <c:pt idx="241">
                        <c:v>2171</c:v>
                      </c:pt>
                      <c:pt idx="242">
                        <c:v>893</c:v>
                      </c:pt>
                      <c:pt idx="243">
                        <c:v>2589</c:v>
                      </c:pt>
                      <c:pt idx="244">
                        <c:v>2490</c:v>
                      </c:pt>
                      <c:pt idx="245">
                        <c:v>2291</c:v>
                      </c:pt>
                      <c:pt idx="246">
                        <c:v>2357</c:v>
                      </c:pt>
                      <c:pt idx="247">
                        <c:v>3654</c:v>
                      </c:pt>
                      <c:pt idx="248">
                        <c:v>3856</c:v>
                      </c:pt>
                      <c:pt idx="249">
                        <c:v>1221</c:v>
                      </c:pt>
                      <c:pt idx="250">
                        <c:v>856</c:v>
                      </c:pt>
                      <c:pt idx="251">
                        <c:v>3373</c:v>
                      </c:pt>
                      <c:pt idx="252">
                        <c:v>3290</c:v>
                      </c:pt>
                      <c:pt idx="253">
                        <c:v>3266</c:v>
                      </c:pt>
                      <c:pt idx="254">
                        <c:v>3026</c:v>
                      </c:pt>
                      <c:pt idx="255">
                        <c:v>2126</c:v>
                      </c:pt>
                      <c:pt idx="256">
                        <c:v>2588</c:v>
                      </c:pt>
                      <c:pt idx="257">
                        <c:v>2233</c:v>
                      </c:pt>
                      <c:pt idx="258">
                        <c:v>2796</c:v>
                      </c:pt>
                      <c:pt idx="259">
                        <c:v>3823</c:v>
                      </c:pt>
                      <c:pt idx="260">
                        <c:v>1883</c:v>
                      </c:pt>
                      <c:pt idx="261">
                        <c:v>1711</c:v>
                      </c:pt>
                      <c:pt idx="262">
                        <c:v>2090</c:v>
                      </c:pt>
                      <c:pt idx="263">
                        <c:v>2900</c:v>
                      </c:pt>
                      <c:pt idx="264">
                        <c:v>3024</c:v>
                      </c:pt>
                      <c:pt idx="265">
                        <c:v>3501</c:v>
                      </c:pt>
                      <c:pt idx="266">
                        <c:v>2987</c:v>
                      </c:pt>
                      <c:pt idx="267">
                        <c:v>2491</c:v>
                      </c:pt>
                      <c:pt idx="268">
                        <c:v>3541</c:v>
                      </c:pt>
                      <c:pt idx="269">
                        <c:v>3700</c:v>
                      </c:pt>
                      <c:pt idx="270">
                        <c:v>2778</c:v>
                      </c:pt>
                      <c:pt idx="271">
                        <c:v>4030</c:v>
                      </c:pt>
                      <c:pt idx="272">
                        <c:v>3215</c:v>
                      </c:pt>
                      <c:pt idx="273">
                        <c:v>475</c:v>
                      </c:pt>
                      <c:pt idx="274">
                        <c:v>2034</c:v>
                      </c:pt>
                      <c:pt idx="275">
                        <c:v>3734</c:v>
                      </c:pt>
                      <c:pt idx="276">
                        <c:v>1953</c:v>
                      </c:pt>
                      <c:pt idx="277">
                        <c:v>2146</c:v>
                      </c:pt>
                      <c:pt idx="278">
                        <c:v>2991</c:v>
                      </c:pt>
                      <c:pt idx="279">
                        <c:v>1273</c:v>
                      </c:pt>
                      <c:pt idx="280">
                        <c:v>3255</c:v>
                      </c:pt>
                      <c:pt idx="281">
                        <c:v>1923</c:v>
                      </c:pt>
                      <c:pt idx="282">
                        <c:v>2026</c:v>
                      </c:pt>
                      <c:pt idx="283">
                        <c:v>2935</c:v>
                      </c:pt>
                      <c:pt idx="284">
                        <c:v>1053</c:v>
                      </c:pt>
                      <c:pt idx="285">
                        <c:v>873</c:v>
                      </c:pt>
                      <c:pt idx="286">
                        <c:v>2134</c:v>
                      </c:pt>
                      <c:pt idx="287">
                        <c:v>2600</c:v>
                      </c:pt>
                      <c:pt idx="288">
                        <c:v>3257</c:v>
                      </c:pt>
                      <c:pt idx="289">
                        <c:v>3081</c:v>
                      </c:pt>
                      <c:pt idx="290">
                        <c:v>3334</c:v>
                      </c:pt>
                      <c:pt idx="291">
                        <c:v>3209</c:v>
                      </c:pt>
                      <c:pt idx="292">
                        <c:v>1525</c:v>
                      </c:pt>
                      <c:pt idx="293">
                        <c:v>3240</c:v>
                      </c:pt>
                      <c:pt idx="294">
                        <c:v>3259</c:v>
                      </c:pt>
                      <c:pt idx="295">
                        <c:v>3561</c:v>
                      </c:pt>
                      <c:pt idx="296">
                        <c:v>2201</c:v>
                      </c:pt>
                      <c:pt idx="297">
                        <c:v>2093</c:v>
                      </c:pt>
                      <c:pt idx="298">
                        <c:v>3855</c:v>
                      </c:pt>
                      <c:pt idx="299">
                        <c:v>3999</c:v>
                      </c:pt>
                      <c:pt idx="300">
                        <c:v>3731</c:v>
                      </c:pt>
                      <c:pt idx="301">
                        <c:v>851</c:v>
                      </c:pt>
                      <c:pt idx="302">
                        <c:v>2946</c:v>
                      </c:pt>
                      <c:pt idx="303">
                        <c:v>3536</c:v>
                      </c:pt>
                      <c:pt idx="304">
                        <c:v>2622</c:v>
                      </c:pt>
                      <c:pt idx="305">
                        <c:v>2882</c:v>
                      </c:pt>
                      <c:pt idx="306">
                        <c:v>3036</c:v>
                      </c:pt>
                      <c:pt idx="307">
                        <c:v>3441</c:v>
                      </c:pt>
                      <c:pt idx="308">
                        <c:v>2878</c:v>
                      </c:pt>
                      <c:pt idx="309">
                        <c:v>2776</c:v>
                      </c:pt>
                      <c:pt idx="310">
                        <c:v>2845</c:v>
                      </c:pt>
                      <c:pt idx="311">
                        <c:v>3882</c:v>
                      </c:pt>
                      <c:pt idx="312">
                        <c:v>3644</c:v>
                      </c:pt>
                      <c:pt idx="313">
                        <c:v>3620</c:v>
                      </c:pt>
                      <c:pt idx="314">
                        <c:v>2804</c:v>
                      </c:pt>
                      <c:pt idx="315">
                        <c:v>2258</c:v>
                      </c:pt>
                      <c:pt idx="316">
                        <c:v>3296</c:v>
                      </c:pt>
                      <c:pt idx="317">
                        <c:v>3826</c:v>
                      </c:pt>
                      <c:pt idx="318">
                        <c:v>3854</c:v>
                      </c:pt>
                      <c:pt idx="319">
                        <c:v>3284</c:v>
                      </c:pt>
                      <c:pt idx="320">
                        <c:v>3651</c:v>
                      </c:pt>
                      <c:pt idx="321">
                        <c:v>3601</c:v>
                      </c:pt>
                      <c:pt idx="322">
                        <c:v>3558</c:v>
                      </c:pt>
                      <c:pt idx="323">
                        <c:v>3510</c:v>
                      </c:pt>
                      <c:pt idx="324">
                        <c:v>1423</c:v>
                      </c:pt>
                      <c:pt idx="325">
                        <c:v>3513</c:v>
                      </c:pt>
                      <c:pt idx="326">
                        <c:v>3467</c:v>
                      </c:pt>
                      <c:pt idx="327">
                        <c:v>2390</c:v>
                      </c:pt>
                      <c:pt idx="328">
                        <c:v>2739</c:v>
                      </c:pt>
                      <c:pt idx="329">
                        <c:v>3752</c:v>
                      </c:pt>
                      <c:pt idx="330">
                        <c:v>3339</c:v>
                      </c:pt>
                      <c:pt idx="331">
                        <c:v>3627</c:v>
                      </c:pt>
                      <c:pt idx="332">
                        <c:v>3704</c:v>
                      </c:pt>
                      <c:pt idx="333">
                        <c:v>2228</c:v>
                      </c:pt>
                      <c:pt idx="334">
                        <c:v>2758</c:v>
                      </c:pt>
                      <c:pt idx="335">
                        <c:v>3588</c:v>
                      </c:pt>
                      <c:pt idx="336">
                        <c:v>2777</c:v>
                      </c:pt>
                      <c:pt idx="337">
                        <c:v>2920</c:v>
                      </c:pt>
                      <c:pt idx="338">
                        <c:v>940</c:v>
                      </c:pt>
                      <c:pt idx="339">
                        <c:v>2966</c:v>
                      </c:pt>
                      <c:pt idx="340">
                        <c:v>3659</c:v>
                      </c:pt>
                      <c:pt idx="341">
                        <c:v>1242</c:v>
                      </c:pt>
                      <c:pt idx="342">
                        <c:v>1919</c:v>
                      </c:pt>
                      <c:pt idx="343">
                        <c:v>1240</c:v>
                      </c:pt>
                      <c:pt idx="344">
                        <c:v>3637</c:v>
                      </c:pt>
                      <c:pt idx="345">
                        <c:v>3279</c:v>
                      </c:pt>
                      <c:pt idx="346">
                        <c:v>3382</c:v>
                      </c:pt>
                      <c:pt idx="347">
                        <c:v>2128</c:v>
                      </c:pt>
                      <c:pt idx="348">
                        <c:v>3758</c:v>
                      </c:pt>
                      <c:pt idx="349">
                        <c:v>3338</c:v>
                      </c:pt>
                      <c:pt idx="350">
                        <c:v>2982</c:v>
                      </c:pt>
                      <c:pt idx="351">
                        <c:v>2226</c:v>
                      </c:pt>
                      <c:pt idx="352">
                        <c:v>1938</c:v>
                      </c:pt>
                      <c:pt idx="353">
                        <c:v>3160</c:v>
                      </c:pt>
                      <c:pt idx="354">
                        <c:v>3572</c:v>
                      </c:pt>
                      <c:pt idx="355">
                        <c:v>1184</c:v>
                      </c:pt>
                      <c:pt idx="356">
                        <c:v>3879</c:v>
                      </c:pt>
                      <c:pt idx="357">
                        <c:v>3298</c:v>
                      </c:pt>
                      <c:pt idx="358">
                        <c:v>3221</c:v>
                      </c:pt>
                      <c:pt idx="359">
                        <c:v>3935</c:v>
                      </c:pt>
                      <c:pt idx="360">
                        <c:v>2351</c:v>
                      </c:pt>
                      <c:pt idx="361">
                        <c:v>3352</c:v>
                      </c:pt>
                      <c:pt idx="362">
                        <c:v>3260</c:v>
                      </c:pt>
                      <c:pt idx="363">
                        <c:v>3358</c:v>
                      </c:pt>
                      <c:pt idx="364">
                        <c:v>3957</c:v>
                      </c:pt>
                      <c:pt idx="365">
                        <c:v>3349</c:v>
                      </c:pt>
                      <c:pt idx="366">
                        <c:v>712</c:v>
                      </c:pt>
                      <c:pt idx="367">
                        <c:v>2587</c:v>
                      </c:pt>
                      <c:pt idx="368">
                        <c:v>2807</c:v>
                      </c:pt>
                      <c:pt idx="369">
                        <c:v>1775</c:v>
                      </c:pt>
                      <c:pt idx="370">
                        <c:v>3107</c:v>
                      </c:pt>
                      <c:pt idx="371">
                        <c:v>2394</c:v>
                      </c:pt>
                      <c:pt idx="372">
                        <c:v>1189</c:v>
                      </c:pt>
                      <c:pt idx="373">
                        <c:v>3636</c:v>
                      </c:pt>
                      <c:pt idx="374">
                        <c:v>1114</c:v>
                      </c:pt>
                      <c:pt idx="375">
                        <c:v>3936</c:v>
                      </c:pt>
                      <c:pt idx="376">
                        <c:v>2273</c:v>
                      </c:pt>
                      <c:pt idx="377">
                        <c:v>379</c:v>
                      </c:pt>
                      <c:pt idx="378">
                        <c:v>2453</c:v>
                      </c:pt>
                      <c:pt idx="379">
                        <c:v>2921</c:v>
                      </c:pt>
                      <c:pt idx="380">
                        <c:v>3710</c:v>
                      </c:pt>
                      <c:pt idx="381">
                        <c:v>3990</c:v>
                      </c:pt>
                      <c:pt idx="382">
                        <c:v>3730</c:v>
                      </c:pt>
                      <c:pt idx="383">
                        <c:v>2004</c:v>
                      </c:pt>
                      <c:pt idx="384">
                        <c:v>3242</c:v>
                      </c:pt>
                      <c:pt idx="385">
                        <c:v>2653</c:v>
                      </c:pt>
                      <c:pt idx="386">
                        <c:v>2943</c:v>
                      </c:pt>
                      <c:pt idx="387">
                        <c:v>2698</c:v>
                      </c:pt>
                      <c:pt idx="388">
                        <c:v>2044</c:v>
                      </c:pt>
                      <c:pt idx="389">
                        <c:v>3329</c:v>
                      </c:pt>
                      <c:pt idx="390">
                        <c:v>2125</c:v>
                      </c:pt>
                      <c:pt idx="391">
                        <c:v>3678</c:v>
                      </c:pt>
                      <c:pt idx="392">
                        <c:v>2046</c:v>
                      </c:pt>
                      <c:pt idx="393">
                        <c:v>2841</c:v>
                      </c:pt>
                      <c:pt idx="394">
                        <c:v>3543</c:v>
                      </c:pt>
                      <c:pt idx="395">
                        <c:v>3965</c:v>
                      </c:pt>
                      <c:pt idx="396">
                        <c:v>3845</c:v>
                      </c:pt>
                      <c:pt idx="397">
                        <c:v>2091</c:v>
                      </c:pt>
                      <c:pt idx="398">
                        <c:v>3062</c:v>
                      </c:pt>
                      <c:pt idx="399">
                        <c:v>2775</c:v>
                      </c:pt>
                      <c:pt idx="400">
                        <c:v>2387</c:v>
                      </c:pt>
                      <c:pt idx="401">
                        <c:v>3529</c:v>
                      </c:pt>
                      <c:pt idx="402">
                        <c:v>1461</c:v>
                      </c:pt>
                      <c:pt idx="403">
                        <c:v>3083</c:v>
                      </c:pt>
                      <c:pt idx="404">
                        <c:v>1034</c:v>
                      </c:pt>
                      <c:pt idx="405">
                        <c:v>4020</c:v>
                      </c:pt>
                      <c:pt idx="406">
                        <c:v>3918</c:v>
                      </c:pt>
                      <c:pt idx="407">
                        <c:v>4081</c:v>
                      </c:pt>
                      <c:pt idx="408">
                        <c:v>3011</c:v>
                      </c:pt>
                      <c:pt idx="409">
                        <c:v>3729</c:v>
                      </c:pt>
                      <c:pt idx="410">
                        <c:v>3335</c:v>
                      </c:pt>
                      <c:pt idx="411">
                        <c:v>1974</c:v>
                      </c:pt>
                      <c:pt idx="412">
                        <c:v>2421</c:v>
                      </c:pt>
                      <c:pt idx="413">
                        <c:v>3895</c:v>
                      </c:pt>
                      <c:pt idx="414">
                        <c:v>3609</c:v>
                      </c:pt>
                      <c:pt idx="415">
                        <c:v>3476</c:v>
                      </c:pt>
                      <c:pt idx="416">
                        <c:v>3306</c:v>
                      </c:pt>
                      <c:pt idx="417">
                        <c:v>3076</c:v>
                      </c:pt>
                      <c:pt idx="418">
                        <c:v>3614</c:v>
                      </c:pt>
                      <c:pt idx="419">
                        <c:v>3682</c:v>
                      </c:pt>
                      <c:pt idx="420">
                        <c:v>3098</c:v>
                      </c:pt>
                      <c:pt idx="421">
                        <c:v>2499</c:v>
                      </c:pt>
                      <c:pt idx="422">
                        <c:v>3920</c:v>
                      </c:pt>
                      <c:pt idx="423">
                        <c:v>3932</c:v>
                      </c:pt>
                      <c:pt idx="424">
                        <c:v>3386</c:v>
                      </c:pt>
                      <c:pt idx="425">
                        <c:v>3231</c:v>
                      </c:pt>
                      <c:pt idx="426">
                        <c:v>3253</c:v>
                      </c:pt>
                      <c:pt idx="427">
                        <c:v>3736</c:v>
                      </c:pt>
                      <c:pt idx="428">
                        <c:v>655</c:v>
                      </c:pt>
                      <c:pt idx="429">
                        <c:v>2661</c:v>
                      </c:pt>
                      <c:pt idx="430">
                        <c:v>3227</c:v>
                      </c:pt>
                      <c:pt idx="431">
                        <c:v>3336</c:v>
                      </c:pt>
                      <c:pt idx="432">
                        <c:v>3033</c:v>
                      </c:pt>
                      <c:pt idx="433">
                        <c:v>3201</c:v>
                      </c:pt>
                      <c:pt idx="434">
                        <c:v>2087</c:v>
                      </c:pt>
                      <c:pt idx="435">
                        <c:v>3159</c:v>
                      </c:pt>
                      <c:pt idx="436">
                        <c:v>2202</c:v>
                      </c:pt>
                      <c:pt idx="437">
                        <c:v>3635</c:v>
                      </c:pt>
                      <c:pt idx="438">
                        <c:v>2980</c:v>
                      </c:pt>
                      <c:pt idx="439">
                        <c:v>3522</c:v>
                      </c:pt>
                      <c:pt idx="440">
                        <c:v>3672</c:v>
                      </c:pt>
                      <c:pt idx="441">
                        <c:v>3007</c:v>
                      </c:pt>
                      <c:pt idx="442">
                        <c:v>3914</c:v>
                      </c:pt>
                      <c:pt idx="443">
                        <c:v>3534</c:v>
                      </c:pt>
                      <c:pt idx="444">
                        <c:v>3887</c:v>
                      </c:pt>
                      <c:pt idx="445">
                        <c:v>580</c:v>
                      </c:pt>
                      <c:pt idx="446">
                        <c:v>1556</c:v>
                      </c:pt>
                      <c:pt idx="447">
                        <c:v>1680</c:v>
                      </c:pt>
                      <c:pt idx="448">
                        <c:v>1590</c:v>
                      </c:pt>
                      <c:pt idx="449">
                        <c:v>3822</c:v>
                      </c:pt>
                      <c:pt idx="450">
                        <c:v>3245</c:v>
                      </c:pt>
                      <c:pt idx="451">
                        <c:v>3719</c:v>
                      </c:pt>
                      <c:pt idx="452">
                        <c:v>2731</c:v>
                      </c:pt>
                      <c:pt idx="453">
                        <c:v>2963</c:v>
                      </c:pt>
                      <c:pt idx="454">
                        <c:v>3685</c:v>
                      </c:pt>
                      <c:pt idx="455">
                        <c:v>3712</c:v>
                      </c:pt>
                      <c:pt idx="456">
                        <c:v>3571</c:v>
                      </c:pt>
                      <c:pt idx="457">
                        <c:v>1950</c:v>
                      </c:pt>
                      <c:pt idx="458">
                        <c:v>2603</c:v>
                      </c:pt>
                      <c:pt idx="459">
                        <c:v>2135</c:v>
                      </c:pt>
                      <c:pt idx="460">
                        <c:v>2506</c:v>
                      </c:pt>
                      <c:pt idx="461">
                        <c:v>3653</c:v>
                      </c:pt>
                      <c:pt idx="462">
                        <c:v>1557</c:v>
                      </c:pt>
                      <c:pt idx="463">
                        <c:v>2204</c:v>
                      </c:pt>
                      <c:pt idx="464">
                        <c:v>3068</c:v>
                      </c:pt>
                      <c:pt idx="465">
                        <c:v>1997</c:v>
                      </c:pt>
                      <c:pt idx="466">
                        <c:v>3134</c:v>
                      </c:pt>
                      <c:pt idx="467">
                        <c:v>2519</c:v>
                      </c:pt>
                      <c:pt idx="468">
                        <c:v>3031</c:v>
                      </c:pt>
                      <c:pt idx="469">
                        <c:v>2086</c:v>
                      </c:pt>
                      <c:pt idx="470">
                        <c:v>3225</c:v>
                      </c:pt>
                      <c:pt idx="471">
                        <c:v>1771</c:v>
                      </c:pt>
                      <c:pt idx="472">
                        <c:v>3725</c:v>
                      </c:pt>
                      <c:pt idx="473">
                        <c:v>3285</c:v>
                      </c:pt>
                      <c:pt idx="474">
                        <c:v>3418</c:v>
                      </c:pt>
                      <c:pt idx="475">
                        <c:v>3477</c:v>
                      </c:pt>
                      <c:pt idx="476">
                        <c:v>511</c:v>
                      </c:pt>
                      <c:pt idx="477">
                        <c:v>2255</c:v>
                      </c:pt>
                      <c:pt idx="478">
                        <c:v>3617</c:v>
                      </c:pt>
                      <c:pt idx="479">
                        <c:v>2383</c:v>
                      </c:pt>
                      <c:pt idx="480">
                        <c:v>3793</c:v>
                      </c:pt>
                      <c:pt idx="481">
                        <c:v>1555</c:v>
                      </c:pt>
                      <c:pt idx="482">
                        <c:v>3975</c:v>
                      </c:pt>
                      <c:pt idx="483">
                        <c:v>3679</c:v>
                      </c:pt>
                      <c:pt idx="484">
                        <c:v>3837</c:v>
                      </c:pt>
                      <c:pt idx="485">
                        <c:v>2822</c:v>
                      </c:pt>
                      <c:pt idx="486">
                        <c:v>1945</c:v>
                      </c:pt>
                      <c:pt idx="487">
                        <c:v>3853</c:v>
                      </c:pt>
                      <c:pt idx="488">
                        <c:v>3910</c:v>
                      </c:pt>
                      <c:pt idx="489">
                        <c:v>2737</c:v>
                      </c:pt>
                      <c:pt idx="490">
                        <c:v>2274</c:v>
                      </c:pt>
                      <c:pt idx="491">
                        <c:v>2986</c:v>
                      </c:pt>
                      <c:pt idx="492">
                        <c:v>2083</c:v>
                      </c:pt>
                      <c:pt idx="493">
                        <c:v>3978</c:v>
                      </c:pt>
                      <c:pt idx="494">
                        <c:v>3030</c:v>
                      </c:pt>
                      <c:pt idx="495">
                        <c:v>3921</c:v>
                      </c:pt>
                      <c:pt idx="496">
                        <c:v>2501</c:v>
                      </c:pt>
                      <c:pt idx="497">
                        <c:v>2048</c:v>
                      </c:pt>
                      <c:pt idx="498">
                        <c:v>2068</c:v>
                      </c:pt>
                      <c:pt idx="499">
                        <c:v>2953</c:v>
                      </c:pt>
                      <c:pt idx="500">
                        <c:v>2520</c:v>
                      </c:pt>
                      <c:pt idx="501">
                        <c:v>3661</c:v>
                      </c:pt>
                      <c:pt idx="502">
                        <c:v>3239</c:v>
                      </c:pt>
                      <c:pt idx="503">
                        <c:v>3353</c:v>
                      </c:pt>
                      <c:pt idx="504">
                        <c:v>3185</c:v>
                      </c:pt>
                      <c:pt idx="505">
                        <c:v>3535</c:v>
                      </c:pt>
                      <c:pt idx="506">
                        <c:v>3733</c:v>
                      </c:pt>
                      <c:pt idx="507">
                        <c:v>3186</c:v>
                      </c:pt>
                      <c:pt idx="508">
                        <c:v>3351</c:v>
                      </c:pt>
                      <c:pt idx="509">
                        <c:v>1929</c:v>
                      </c:pt>
                      <c:pt idx="510">
                        <c:v>3656</c:v>
                      </c:pt>
                      <c:pt idx="511">
                        <c:v>3657</c:v>
                      </c:pt>
                      <c:pt idx="512">
                        <c:v>1976</c:v>
                      </c:pt>
                      <c:pt idx="513">
                        <c:v>3665</c:v>
                      </c:pt>
                      <c:pt idx="514">
                        <c:v>3292</c:v>
                      </c:pt>
                      <c:pt idx="515">
                        <c:v>1510</c:v>
                      </c:pt>
                      <c:pt idx="516">
                        <c:v>3447</c:v>
                      </c:pt>
                      <c:pt idx="517">
                        <c:v>2331</c:v>
                      </c:pt>
                      <c:pt idx="518">
                        <c:v>2908</c:v>
                      </c:pt>
                      <c:pt idx="519">
                        <c:v>1416</c:v>
                      </c:pt>
                      <c:pt idx="520">
                        <c:v>1356</c:v>
                      </c:pt>
                      <c:pt idx="521">
                        <c:v>2352</c:v>
                      </c:pt>
                      <c:pt idx="522">
                        <c:v>3624</c:v>
                      </c:pt>
                      <c:pt idx="523">
                        <c:v>3623</c:v>
                      </c:pt>
                      <c:pt idx="524">
                        <c:v>2695</c:v>
                      </c:pt>
                      <c:pt idx="525">
                        <c:v>2974</c:v>
                      </c:pt>
                      <c:pt idx="526">
                        <c:v>853</c:v>
                      </c:pt>
                      <c:pt idx="527">
                        <c:v>2489</c:v>
                      </c:pt>
                      <c:pt idx="528">
                        <c:v>2722</c:v>
                      </c:pt>
                      <c:pt idx="529">
                        <c:v>3264</c:v>
                      </c:pt>
                      <c:pt idx="530">
                        <c:v>3968</c:v>
                      </c:pt>
                      <c:pt idx="531">
                        <c:v>2825</c:v>
                      </c:pt>
                      <c:pt idx="532">
                        <c:v>2039</c:v>
                      </c:pt>
                      <c:pt idx="533">
                        <c:v>3254</c:v>
                      </c:pt>
                      <c:pt idx="534">
                        <c:v>3324</c:v>
                      </c:pt>
                      <c:pt idx="535">
                        <c:v>3340</c:v>
                      </c:pt>
                      <c:pt idx="536">
                        <c:v>2531</c:v>
                      </c:pt>
                      <c:pt idx="537">
                        <c:v>4034</c:v>
                      </c:pt>
                      <c:pt idx="538">
                        <c:v>2521</c:v>
                      </c:pt>
                      <c:pt idx="539">
                        <c:v>2241</c:v>
                      </c:pt>
                      <c:pt idx="540">
                        <c:v>2195</c:v>
                      </c:pt>
                      <c:pt idx="541">
                        <c:v>3691</c:v>
                      </c:pt>
                      <c:pt idx="542">
                        <c:v>3058</c:v>
                      </c:pt>
                      <c:pt idx="543">
                        <c:v>2102</c:v>
                      </c:pt>
                      <c:pt idx="544">
                        <c:v>3244</c:v>
                      </c:pt>
                      <c:pt idx="545">
                        <c:v>1619</c:v>
                      </c:pt>
                      <c:pt idx="546">
                        <c:v>2384</c:v>
                      </c:pt>
                      <c:pt idx="547">
                        <c:v>1891</c:v>
                      </c:pt>
                      <c:pt idx="548">
                        <c:v>4049</c:v>
                      </c:pt>
                      <c:pt idx="549">
                        <c:v>2826</c:v>
                      </c:pt>
                      <c:pt idx="550">
                        <c:v>1928</c:v>
                      </c:pt>
                      <c:pt idx="551">
                        <c:v>259</c:v>
                      </c:pt>
                      <c:pt idx="552">
                        <c:v>3834</c:v>
                      </c:pt>
                      <c:pt idx="553">
                        <c:v>1796</c:v>
                      </c:pt>
                      <c:pt idx="554">
                        <c:v>3362</c:v>
                      </c:pt>
                      <c:pt idx="555">
                        <c:v>2246</c:v>
                      </c:pt>
                      <c:pt idx="556">
                        <c:v>1925</c:v>
                      </c:pt>
                      <c:pt idx="557">
                        <c:v>422</c:v>
                      </c:pt>
                      <c:pt idx="558">
                        <c:v>2186</c:v>
                      </c:pt>
                      <c:pt idx="559">
                        <c:v>1803</c:v>
                      </c:pt>
                      <c:pt idx="560">
                        <c:v>3421</c:v>
                      </c:pt>
                      <c:pt idx="561">
                        <c:v>2913</c:v>
                      </c:pt>
                      <c:pt idx="562">
                        <c:v>2502</c:v>
                      </c:pt>
                      <c:pt idx="563">
                        <c:v>3565</c:v>
                      </c:pt>
                      <c:pt idx="564">
                        <c:v>3087</c:v>
                      </c:pt>
                      <c:pt idx="565">
                        <c:v>3256</c:v>
                      </c:pt>
                      <c:pt idx="566">
                        <c:v>3104</c:v>
                      </c:pt>
                      <c:pt idx="567">
                        <c:v>3250</c:v>
                      </c:pt>
                      <c:pt idx="568">
                        <c:v>2830</c:v>
                      </c:pt>
                      <c:pt idx="569">
                        <c:v>3002</c:v>
                      </c:pt>
                      <c:pt idx="570">
                        <c:v>2497</c:v>
                      </c:pt>
                      <c:pt idx="571">
                        <c:v>4007</c:v>
                      </c:pt>
                      <c:pt idx="572">
                        <c:v>840</c:v>
                      </c:pt>
                      <c:pt idx="573">
                        <c:v>2595</c:v>
                      </c:pt>
                      <c:pt idx="574">
                        <c:v>3878</c:v>
                      </c:pt>
                      <c:pt idx="575">
                        <c:v>3512</c:v>
                      </c:pt>
                      <c:pt idx="576">
                        <c:v>3630</c:v>
                      </c:pt>
                      <c:pt idx="577">
                        <c:v>2849</c:v>
                      </c:pt>
                      <c:pt idx="578">
                        <c:v>1251</c:v>
                      </c:pt>
                      <c:pt idx="579">
                        <c:v>3930</c:v>
                      </c:pt>
                      <c:pt idx="580">
                        <c:v>3008</c:v>
                      </c:pt>
                      <c:pt idx="581">
                        <c:v>2118</c:v>
                      </c:pt>
                      <c:pt idx="582">
                        <c:v>2084</c:v>
                      </c:pt>
                      <c:pt idx="583">
                        <c:v>1361</c:v>
                      </c:pt>
                      <c:pt idx="584">
                        <c:v>2027</c:v>
                      </c:pt>
                      <c:pt idx="585">
                        <c:v>2235</c:v>
                      </c:pt>
                      <c:pt idx="586">
                        <c:v>1124</c:v>
                      </c:pt>
                      <c:pt idx="587">
                        <c:v>3971</c:v>
                      </c:pt>
                      <c:pt idx="588">
                        <c:v>1741</c:v>
                      </c:pt>
                      <c:pt idx="589">
                        <c:v>2280</c:v>
                      </c:pt>
                      <c:pt idx="590">
                        <c:v>2843</c:v>
                      </c:pt>
                      <c:pt idx="591">
                        <c:v>2385</c:v>
                      </c:pt>
                      <c:pt idx="592">
                        <c:v>2912</c:v>
                      </c:pt>
                      <c:pt idx="593">
                        <c:v>850</c:v>
                      </c:pt>
                      <c:pt idx="594">
                        <c:v>2180</c:v>
                      </c:pt>
                      <c:pt idx="595">
                        <c:v>4019</c:v>
                      </c:pt>
                      <c:pt idx="596">
                        <c:v>3325</c:v>
                      </c:pt>
                      <c:pt idx="597">
                        <c:v>3655</c:v>
                      </c:pt>
                      <c:pt idx="598">
                        <c:v>3420</c:v>
                      </c:pt>
                      <c:pt idx="599">
                        <c:v>1773</c:v>
                      </c:pt>
                      <c:pt idx="600">
                        <c:v>3695</c:v>
                      </c:pt>
                      <c:pt idx="601">
                        <c:v>2507</c:v>
                      </c:pt>
                      <c:pt idx="602">
                        <c:v>3946</c:v>
                      </c:pt>
                      <c:pt idx="603">
                        <c:v>1774</c:v>
                      </c:pt>
                      <c:pt idx="604">
                        <c:v>2056</c:v>
                      </c:pt>
                      <c:pt idx="605">
                        <c:v>3307</c:v>
                      </c:pt>
                      <c:pt idx="606">
                        <c:v>3628</c:v>
                      </c:pt>
                      <c:pt idx="607">
                        <c:v>4015</c:v>
                      </c:pt>
                      <c:pt idx="608">
                        <c:v>3552</c:v>
                      </c:pt>
                      <c:pt idx="609">
                        <c:v>1890</c:v>
                      </c:pt>
                      <c:pt idx="610">
                        <c:v>2347</c:v>
                      </c:pt>
                      <c:pt idx="611">
                        <c:v>4032</c:v>
                      </c:pt>
                      <c:pt idx="612">
                        <c:v>1241</c:v>
                      </c:pt>
                      <c:pt idx="613">
                        <c:v>3581</c:v>
                      </c:pt>
                      <c:pt idx="614">
                        <c:v>3243</c:v>
                      </c:pt>
                      <c:pt idx="615">
                        <c:v>1911</c:v>
                      </c:pt>
                      <c:pt idx="616">
                        <c:v>2803</c:v>
                      </c:pt>
                      <c:pt idx="617">
                        <c:v>2950</c:v>
                      </c:pt>
                      <c:pt idx="618">
                        <c:v>3594</c:v>
                      </c:pt>
                      <c:pt idx="619">
                        <c:v>1497</c:v>
                      </c:pt>
                      <c:pt idx="620">
                        <c:v>3389</c:v>
                      </c:pt>
                      <c:pt idx="621">
                        <c:v>2243</c:v>
                      </c:pt>
                      <c:pt idx="622">
                        <c:v>1039</c:v>
                      </c:pt>
                      <c:pt idx="623">
                        <c:v>2088</c:v>
                      </c:pt>
                      <c:pt idx="624">
                        <c:v>2769</c:v>
                      </c:pt>
                      <c:pt idx="625">
                        <c:v>2718</c:v>
                      </c:pt>
                      <c:pt idx="626">
                        <c:v>3097</c:v>
                      </c:pt>
                      <c:pt idx="627">
                        <c:v>1499</c:v>
                      </c:pt>
                      <c:pt idx="628">
                        <c:v>2416</c:v>
                      </c:pt>
                      <c:pt idx="629">
                        <c:v>3223</c:v>
                      </c:pt>
                      <c:pt idx="630">
                        <c:v>1759</c:v>
                      </c:pt>
                      <c:pt idx="631">
                        <c:v>3709</c:v>
                      </c:pt>
                      <c:pt idx="632">
                        <c:v>2788</c:v>
                      </c:pt>
                      <c:pt idx="633">
                        <c:v>3308</c:v>
                      </c:pt>
                      <c:pt idx="634">
                        <c:v>3687</c:v>
                      </c:pt>
                      <c:pt idx="635">
                        <c:v>766</c:v>
                      </c:pt>
                      <c:pt idx="636">
                        <c:v>3597</c:v>
                      </c:pt>
                      <c:pt idx="637">
                        <c:v>3468</c:v>
                      </c:pt>
                      <c:pt idx="638">
                        <c:v>2956</c:v>
                      </c:pt>
                      <c:pt idx="639">
                        <c:v>3638</c:v>
                      </c:pt>
                      <c:pt idx="640">
                        <c:v>2275</c:v>
                      </c:pt>
                      <c:pt idx="641">
                        <c:v>4042</c:v>
                      </c:pt>
                      <c:pt idx="642">
                        <c:v>3703</c:v>
                      </c:pt>
                      <c:pt idx="643">
                        <c:v>2527</c:v>
                      </c:pt>
                      <c:pt idx="644">
                        <c:v>2391</c:v>
                      </c:pt>
                      <c:pt idx="645">
                        <c:v>3531</c:v>
                      </c:pt>
                      <c:pt idx="646">
                        <c:v>3252</c:v>
                      </c:pt>
                      <c:pt idx="647">
                        <c:v>1806</c:v>
                      </c:pt>
                      <c:pt idx="648">
                        <c:v>3851</c:v>
                      </c:pt>
                      <c:pt idx="649">
                        <c:v>3265</c:v>
                      </c:pt>
                      <c:pt idx="650">
                        <c:v>2081</c:v>
                      </c:pt>
                      <c:pt idx="651">
                        <c:v>3345</c:v>
                      </c:pt>
                      <c:pt idx="652">
                        <c:v>2985</c:v>
                      </c:pt>
                      <c:pt idx="653">
                        <c:v>3182</c:v>
                      </c:pt>
                      <c:pt idx="654">
                        <c:v>2608</c:v>
                      </c:pt>
                      <c:pt idx="655">
                        <c:v>3676</c:v>
                      </c:pt>
                      <c:pt idx="656">
                        <c:v>3875</c:v>
                      </c:pt>
                      <c:pt idx="657">
                        <c:v>2733</c:v>
                      </c:pt>
                      <c:pt idx="658">
                        <c:v>4018</c:v>
                      </c:pt>
                      <c:pt idx="659">
                        <c:v>3302</c:v>
                      </c:pt>
                      <c:pt idx="660">
                        <c:v>3287</c:v>
                      </c:pt>
                      <c:pt idx="661">
                        <c:v>1004</c:v>
                      </c:pt>
                      <c:pt idx="662">
                        <c:v>3629</c:v>
                      </c:pt>
                      <c:pt idx="663">
                        <c:v>2488</c:v>
                      </c:pt>
                      <c:pt idx="664">
                        <c:v>2393</c:v>
                      </c:pt>
                      <c:pt idx="665">
                        <c:v>2886</c:v>
                      </c:pt>
                      <c:pt idx="666">
                        <c:v>3479</c:v>
                      </c:pt>
                      <c:pt idx="667">
                        <c:v>2003</c:v>
                      </c:pt>
                      <c:pt idx="668">
                        <c:v>1549</c:v>
                      </c:pt>
                      <c:pt idx="669">
                        <c:v>2549</c:v>
                      </c:pt>
                      <c:pt idx="670">
                        <c:v>604</c:v>
                      </c:pt>
                      <c:pt idx="671">
                        <c:v>785</c:v>
                      </c:pt>
                      <c:pt idx="672">
                        <c:v>3176</c:v>
                      </c:pt>
                      <c:pt idx="673">
                        <c:v>3442</c:v>
                      </c:pt>
                      <c:pt idx="674">
                        <c:v>3747</c:v>
                      </c:pt>
                      <c:pt idx="675">
                        <c:v>2859</c:v>
                      </c:pt>
                      <c:pt idx="676">
                        <c:v>2924</c:v>
                      </c:pt>
                      <c:pt idx="677">
                        <c:v>3716</c:v>
                      </c:pt>
                      <c:pt idx="678">
                        <c:v>3314</c:v>
                      </c:pt>
                      <c:pt idx="679">
                        <c:v>3892</c:v>
                      </c:pt>
                      <c:pt idx="680">
                        <c:v>3305</c:v>
                      </c:pt>
                      <c:pt idx="681">
                        <c:v>3912</c:v>
                      </c:pt>
                      <c:pt idx="682">
                        <c:v>2840</c:v>
                      </c:pt>
                      <c:pt idx="683">
                        <c:v>3465</c:v>
                      </c:pt>
                      <c:pt idx="684">
                        <c:v>3310</c:v>
                      </c:pt>
                      <c:pt idx="685">
                        <c:v>2005</c:v>
                      </c:pt>
                      <c:pt idx="686">
                        <c:v>3540</c:v>
                      </c:pt>
                      <c:pt idx="687">
                        <c:v>2742</c:v>
                      </c:pt>
                      <c:pt idx="688">
                        <c:v>3165</c:v>
                      </c:pt>
                      <c:pt idx="689">
                        <c:v>3128</c:v>
                      </c:pt>
                      <c:pt idx="690">
                        <c:v>1325</c:v>
                      </c:pt>
                      <c:pt idx="691">
                        <c:v>1952</c:v>
                      </c:pt>
                      <c:pt idx="692">
                        <c:v>2951</c:v>
                      </c:pt>
                      <c:pt idx="693">
                        <c:v>3526</c:v>
                      </c:pt>
                      <c:pt idx="694">
                        <c:v>4084</c:v>
                      </c:pt>
                      <c:pt idx="695">
                        <c:v>3299</c:v>
                      </c:pt>
                      <c:pt idx="696">
                        <c:v>3414</c:v>
                      </c:pt>
                      <c:pt idx="697">
                        <c:v>3167</c:v>
                      </c:pt>
                      <c:pt idx="698">
                        <c:v>2573</c:v>
                      </c:pt>
                      <c:pt idx="699">
                        <c:v>2936</c:v>
                      </c:pt>
                      <c:pt idx="700">
                        <c:v>3127</c:v>
                      </c:pt>
                      <c:pt idx="701">
                        <c:v>2470</c:v>
                      </c:pt>
                      <c:pt idx="702">
                        <c:v>2028</c:v>
                      </c:pt>
                      <c:pt idx="703">
                        <c:v>3003</c:v>
                      </c:pt>
                      <c:pt idx="704">
                        <c:v>2620</c:v>
                      </c:pt>
                      <c:pt idx="705">
                        <c:v>3332</c:v>
                      </c:pt>
                      <c:pt idx="706">
                        <c:v>2744</c:v>
                      </c:pt>
                      <c:pt idx="707">
                        <c:v>3847</c:v>
                      </c:pt>
                      <c:pt idx="708">
                        <c:v>3123</c:v>
                      </c:pt>
                      <c:pt idx="709">
                        <c:v>1975</c:v>
                      </c:pt>
                      <c:pt idx="710">
                        <c:v>3585</c:v>
                      </c:pt>
                      <c:pt idx="711">
                        <c:v>3927</c:v>
                      </c:pt>
                      <c:pt idx="712">
                        <c:v>3001</c:v>
                      </c:pt>
                      <c:pt idx="713">
                        <c:v>2572</c:v>
                      </c:pt>
                      <c:pt idx="714">
                        <c:v>3415</c:v>
                      </c:pt>
                      <c:pt idx="715">
                        <c:v>3697</c:v>
                      </c:pt>
                      <c:pt idx="716">
                        <c:v>3370</c:v>
                      </c:pt>
                      <c:pt idx="717">
                        <c:v>4014</c:v>
                      </c:pt>
                      <c:pt idx="718">
                        <c:v>2696</c:v>
                      </c:pt>
                      <c:pt idx="719">
                        <c:v>2666</c:v>
                      </c:pt>
                      <c:pt idx="720">
                        <c:v>2697</c:v>
                      </c:pt>
                      <c:pt idx="721">
                        <c:v>3537</c:v>
                      </c:pt>
                      <c:pt idx="722">
                        <c:v>2789</c:v>
                      </c:pt>
                      <c:pt idx="723">
                        <c:v>2876</c:v>
                      </c:pt>
                      <c:pt idx="724">
                        <c:v>2992</c:v>
                      </c:pt>
                      <c:pt idx="725">
                        <c:v>3330</c:v>
                      </c:pt>
                      <c:pt idx="726">
                        <c:v>3187</c:v>
                      </c:pt>
                      <c:pt idx="727">
                        <c:v>3916</c:v>
                      </c:pt>
                      <c:pt idx="728">
                        <c:v>2378</c:v>
                      </c:pt>
                      <c:pt idx="729">
                        <c:v>1818</c:v>
                      </c:pt>
                      <c:pt idx="730">
                        <c:v>2402</c:v>
                      </c:pt>
                      <c:pt idx="731">
                        <c:v>2199</c:v>
                      </c:pt>
                      <c:pt idx="732">
                        <c:v>4011</c:v>
                      </c:pt>
                      <c:pt idx="733">
                        <c:v>3511</c:v>
                      </c:pt>
                      <c:pt idx="734">
                        <c:v>2868</c:v>
                      </c:pt>
                      <c:pt idx="735">
                        <c:v>2621</c:v>
                      </c:pt>
                      <c:pt idx="736">
                        <c:v>3034</c:v>
                      </c:pt>
                      <c:pt idx="737">
                        <c:v>2855</c:v>
                      </c:pt>
                      <c:pt idx="738">
                        <c:v>3835</c:v>
                      </c:pt>
                      <c:pt idx="739">
                        <c:v>2580</c:v>
                      </c:pt>
                      <c:pt idx="740">
                        <c:v>2962</c:v>
                      </c:pt>
                      <c:pt idx="741">
                        <c:v>3190</c:v>
                      </c:pt>
                      <c:pt idx="742">
                        <c:v>213</c:v>
                      </c:pt>
                      <c:pt idx="743">
                        <c:v>3555</c:v>
                      </c:pt>
                      <c:pt idx="744">
                        <c:v>2175</c:v>
                      </c:pt>
                      <c:pt idx="745">
                        <c:v>2542</c:v>
                      </c:pt>
                      <c:pt idx="746">
                        <c:v>3925</c:v>
                      </c:pt>
                      <c:pt idx="747">
                        <c:v>2846</c:v>
                      </c:pt>
                      <c:pt idx="748">
                        <c:v>2503</c:v>
                      </c:pt>
                      <c:pt idx="749">
                        <c:v>2630</c:v>
                      </c:pt>
                      <c:pt idx="750">
                        <c:v>3247</c:v>
                      </c:pt>
                      <c:pt idx="751">
                        <c:v>4010</c:v>
                      </c:pt>
                      <c:pt idx="752">
                        <c:v>3913</c:v>
                      </c:pt>
                      <c:pt idx="753">
                        <c:v>2007</c:v>
                      </c:pt>
                      <c:pt idx="754">
                        <c:v>3972</c:v>
                      </c:pt>
                      <c:pt idx="755">
                        <c:v>3320</c:v>
                      </c:pt>
                      <c:pt idx="756">
                        <c:v>3911</c:v>
                      </c:pt>
                      <c:pt idx="757">
                        <c:v>3612</c:v>
                      </c:pt>
                      <c:pt idx="758">
                        <c:v>1668</c:v>
                      </c:pt>
                      <c:pt idx="759">
                        <c:v>3671</c:v>
                      </c:pt>
                      <c:pt idx="760">
                        <c:v>2694</c:v>
                      </c:pt>
                      <c:pt idx="761">
                        <c:v>3846</c:v>
                      </c:pt>
                      <c:pt idx="762">
                        <c:v>3915</c:v>
                      </c:pt>
                      <c:pt idx="763">
                        <c:v>3327</c:v>
                      </c:pt>
                      <c:pt idx="764">
                        <c:v>3618</c:v>
                      </c:pt>
                      <c:pt idx="765">
                        <c:v>717</c:v>
                      </c:pt>
                      <c:pt idx="766">
                        <c:v>1229</c:v>
                      </c:pt>
                      <c:pt idx="767">
                        <c:v>2167</c:v>
                      </c:pt>
                      <c:pt idx="768">
                        <c:v>3677</c:v>
                      </c:pt>
                      <c:pt idx="769">
                        <c:v>3323</c:v>
                      </c:pt>
                      <c:pt idx="770">
                        <c:v>2971</c:v>
                      </c:pt>
                      <c:pt idx="771">
                        <c:v>1801</c:v>
                      </c:pt>
                      <c:pt idx="772">
                        <c:v>2320</c:v>
                      </c:pt>
                      <c:pt idx="773">
                        <c:v>3538</c:v>
                      </c:pt>
                      <c:pt idx="774">
                        <c:v>613</c:v>
                      </c:pt>
                      <c:pt idx="775">
                        <c:v>1889</c:v>
                      </c:pt>
                      <c:pt idx="776">
                        <c:v>3850</c:v>
                      </c:pt>
                      <c:pt idx="777">
                        <c:v>2045</c:v>
                      </c:pt>
                      <c:pt idx="778">
                        <c:v>3550</c:v>
                      </c:pt>
                      <c:pt idx="779">
                        <c:v>3905</c:v>
                      </c:pt>
                      <c:pt idx="780">
                        <c:v>3584</c:v>
                      </c:pt>
                      <c:pt idx="781">
                        <c:v>2209</c:v>
                      </c:pt>
                      <c:pt idx="782">
                        <c:v>3163</c:v>
                      </c:pt>
                      <c:pt idx="783">
                        <c:v>3381</c:v>
                      </c:pt>
                      <c:pt idx="784">
                        <c:v>3560</c:v>
                      </c:pt>
                      <c:pt idx="785">
                        <c:v>1968</c:v>
                      </c:pt>
                      <c:pt idx="786">
                        <c:v>1558</c:v>
                      </c:pt>
                      <c:pt idx="787">
                        <c:v>2771</c:v>
                      </c:pt>
                      <c:pt idx="788">
                        <c:v>3061</c:v>
                      </c:pt>
                      <c:pt idx="789">
                        <c:v>3363</c:v>
                      </c:pt>
                      <c:pt idx="790">
                        <c:v>3548</c:v>
                      </c:pt>
                      <c:pt idx="791">
                        <c:v>2176</c:v>
                      </c:pt>
                      <c:pt idx="792">
                        <c:v>922</c:v>
                      </c:pt>
                      <c:pt idx="793">
                        <c:v>2703</c:v>
                      </c:pt>
                      <c:pt idx="794">
                        <c:v>2472</c:v>
                      </c:pt>
                      <c:pt idx="795">
                        <c:v>3251</c:v>
                      </c:pt>
                      <c:pt idx="796">
                        <c:v>3718</c:v>
                      </c:pt>
                      <c:pt idx="797">
                        <c:v>1511</c:v>
                      </c:pt>
                      <c:pt idx="798">
                        <c:v>2686</c:v>
                      </c:pt>
                      <c:pt idx="799">
                        <c:v>4008</c:v>
                      </c:pt>
                      <c:pt idx="800">
                        <c:v>3953</c:v>
                      </c:pt>
                      <c:pt idx="801">
                        <c:v>2910</c:v>
                      </c:pt>
                      <c:pt idx="802">
                        <c:v>3505</c:v>
                      </c:pt>
                      <c:pt idx="803">
                        <c:v>3844</c:v>
                      </c:pt>
                      <c:pt idx="804">
                        <c:v>2791</c:v>
                      </c:pt>
                      <c:pt idx="805">
                        <c:v>1667</c:v>
                      </c:pt>
                      <c:pt idx="806">
                        <c:v>3162</c:v>
                      </c:pt>
                      <c:pt idx="807">
                        <c:v>2404</c:v>
                      </c:pt>
                      <c:pt idx="808">
                        <c:v>3384</c:v>
                      </c:pt>
                      <c:pt idx="809">
                        <c:v>1636</c:v>
                      </c:pt>
                      <c:pt idx="810">
                        <c:v>2326</c:v>
                      </c:pt>
                      <c:pt idx="811">
                        <c:v>3527</c:v>
                      </c:pt>
                      <c:pt idx="812">
                        <c:v>3297</c:v>
                      </c:pt>
                      <c:pt idx="813">
                        <c:v>3891</c:v>
                      </c:pt>
                      <c:pt idx="814">
                        <c:v>3094</c:v>
                      </c:pt>
                      <c:pt idx="815">
                        <c:v>2721</c:v>
                      </c:pt>
                      <c:pt idx="816">
                        <c:v>3506</c:v>
                      </c:pt>
                      <c:pt idx="817">
                        <c:v>3148</c:v>
                      </c:pt>
                      <c:pt idx="818">
                        <c:v>3553</c:v>
                      </c:pt>
                      <c:pt idx="819">
                        <c:v>3852</c:v>
                      </c:pt>
                      <c:pt idx="820">
                        <c:v>4001</c:v>
                      </c:pt>
                      <c:pt idx="821">
                        <c:v>3890</c:v>
                      </c:pt>
                      <c:pt idx="822">
                        <c:v>3539</c:v>
                      </c:pt>
                      <c:pt idx="823">
                        <c:v>2242</c:v>
                      </c:pt>
                      <c:pt idx="824">
                        <c:v>3938</c:v>
                      </c:pt>
                      <c:pt idx="825">
                        <c:v>1554</c:v>
                      </c:pt>
                      <c:pt idx="826">
                        <c:v>1772</c:v>
                      </c:pt>
                      <c:pt idx="827">
                        <c:v>2511</c:v>
                      </c:pt>
                      <c:pt idx="828">
                        <c:v>2569</c:v>
                      </c:pt>
                      <c:pt idx="829">
                        <c:v>3006</c:v>
                      </c:pt>
                      <c:pt idx="830">
                        <c:v>3191</c:v>
                      </c:pt>
                      <c:pt idx="831">
                        <c:v>3880</c:v>
                      </c:pt>
                      <c:pt idx="832">
                        <c:v>2615</c:v>
                      </c:pt>
                      <c:pt idx="833">
                        <c:v>1675</c:v>
                      </c:pt>
                      <c:pt idx="834">
                        <c:v>2133</c:v>
                      </c:pt>
                      <c:pt idx="835">
                        <c:v>3312</c:v>
                      </c:pt>
                      <c:pt idx="836">
                        <c:v>1887</c:v>
                      </c:pt>
                      <c:pt idx="837">
                        <c:v>3249</c:v>
                      </c:pt>
                      <c:pt idx="838">
                        <c:v>1707</c:v>
                      </c:pt>
                      <c:pt idx="839">
                        <c:v>3147</c:v>
                      </c:pt>
                      <c:pt idx="840">
                        <c:v>3694</c:v>
                      </c:pt>
                      <c:pt idx="841">
                        <c:v>3993</c:v>
                      </c:pt>
                      <c:pt idx="842">
                        <c:v>3138</c:v>
                      </c:pt>
                      <c:pt idx="843">
                        <c:v>1324</c:v>
                      </c:pt>
                      <c:pt idx="844">
                        <c:v>1656</c:v>
                      </c:pt>
                      <c:pt idx="845">
                        <c:v>2869</c:v>
                      </c:pt>
                      <c:pt idx="846">
                        <c:v>3233</c:v>
                      </c:pt>
                      <c:pt idx="847">
                        <c:v>1913</c:v>
                      </c:pt>
                      <c:pt idx="848">
                        <c:v>2365</c:v>
                      </c:pt>
                      <c:pt idx="849">
                        <c:v>2719</c:v>
                      </c:pt>
                      <c:pt idx="850">
                        <c:v>3767</c:v>
                      </c:pt>
                      <c:pt idx="851">
                        <c:v>2679</c:v>
                      </c:pt>
                      <c:pt idx="852">
                        <c:v>3137</c:v>
                      </c:pt>
                      <c:pt idx="853">
                        <c:v>3315</c:v>
                      </c:pt>
                      <c:pt idx="854">
                        <c:v>3241</c:v>
                      </c:pt>
                      <c:pt idx="855">
                        <c:v>4000</c:v>
                      </c:pt>
                      <c:pt idx="856">
                        <c:v>3508</c:v>
                      </c:pt>
                      <c:pt idx="857">
                        <c:v>2927</c:v>
                      </c:pt>
                      <c:pt idx="858">
                        <c:v>3970</c:v>
                      </c:pt>
                      <c:pt idx="859">
                        <c:v>777</c:v>
                      </c:pt>
                      <c:pt idx="860">
                        <c:v>3992</c:v>
                      </c:pt>
                      <c:pt idx="861">
                        <c:v>3670</c:v>
                      </c:pt>
                      <c:pt idx="862">
                        <c:v>2070</c:v>
                      </c:pt>
                      <c:pt idx="863">
                        <c:v>4035</c:v>
                      </c:pt>
                      <c:pt idx="864">
                        <c:v>212</c:v>
                      </c:pt>
                      <c:pt idx="865">
                        <c:v>2605</c:v>
                      </c:pt>
                      <c:pt idx="866">
                        <c:v>3619</c:v>
                      </c:pt>
                      <c:pt idx="867">
                        <c:v>3337</c:v>
                      </c:pt>
                      <c:pt idx="868">
                        <c:v>3263</c:v>
                      </c:pt>
                      <c:pt idx="869">
                        <c:v>3108</c:v>
                      </c:pt>
                      <c:pt idx="870">
                        <c:v>3701</c:v>
                      </c:pt>
                      <c:pt idx="871">
                        <c:v>3408</c:v>
                      </c:pt>
                      <c:pt idx="872">
                        <c:v>2782</c:v>
                      </c:pt>
                      <c:pt idx="873">
                        <c:v>1969</c:v>
                      </c:pt>
                      <c:pt idx="874">
                        <c:v>843</c:v>
                      </c:pt>
                      <c:pt idx="875">
                        <c:v>3564</c:v>
                      </c:pt>
                      <c:pt idx="876">
                        <c:v>3643</c:v>
                      </c:pt>
                      <c:pt idx="877">
                        <c:v>3649</c:v>
                      </c:pt>
                      <c:pt idx="878">
                        <c:v>1659</c:v>
                      </c:pt>
                      <c:pt idx="879">
                        <c:v>3166</c:v>
                      </c:pt>
                      <c:pt idx="880">
                        <c:v>3849</c:v>
                      </c:pt>
                      <c:pt idx="881">
                        <c:v>2150</c:v>
                      </c:pt>
                      <c:pt idx="882">
                        <c:v>2746</c:v>
                      </c:pt>
                      <c:pt idx="883">
                        <c:v>265</c:v>
                      </c:pt>
                      <c:pt idx="884">
                        <c:v>1888</c:v>
                      </c:pt>
                      <c:pt idx="885">
                        <c:v>3595</c:v>
                      </c:pt>
                      <c:pt idx="886">
                        <c:v>1052</c:v>
                      </c:pt>
                      <c:pt idx="887">
                        <c:v>3578</c:v>
                      </c:pt>
                      <c:pt idx="888">
                        <c:v>2555</c:v>
                      </c:pt>
                      <c:pt idx="889">
                        <c:v>3590</c:v>
                      </c:pt>
                      <c:pt idx="890">
                        <c:v>3952</c:v>
                      </c:pt>
                      <c:pt idx="891">
                        <c:v>2877</c:v>
                      </c:pt>
                      <c:pt idx="892">
                        <c:v>3119</c:v>
                      </c:pt>
                      <c:pt idx="893">
                        <c:v>2772</c:v>
                      </c:pt>
                      <c:pt idx="894">
                        <c:v>2350</c:v>
                      </c:pt>
                      <c:pt idx="895">
                        <c:v>2902</c:v>
                      </c:pt>
                      <c:pt idx="896">
                        <c:v>3195</c:v>
                      </c:pt>
                      <c:pt idx="897">
                        <c:v>3286</c:v>
                      </c:pt>
                      <c:pt idx="898">
                        <c:v>685</c:v>
                      </c:pt>
                      <c:pt idx="899">
                        <c:v>3575</c:v>
                      </c:pt>
                      <c:pt idx="900">
                        <c:v>2505</c:v>
                      </c:pt>
                      <c:pt idx="901">
                        <c:v>2916</c:v>
                      </c:pt>
                      <c:pt idx="902">
                        <c:v>3387</c:v>
                      </c:pt>
                      <c:pt idx="903">
                        <c:v>2448</c:v>
                      </c:pt>
                      <c:pt idx="904">
                        <c:v>2553</c:v>
                      </c:pt>
                      <c:pt idx="905">
                        <c:v>2095</c:v>
                      </c:pt>
                      <c:pt idx="906">
                        <c:v>1478</c:v>
                      </c:pt>
                      <c:pt idx="907">
                        <c:v>3745</c:v>
                      </c:pt>
                      <c:pt idx="908">
                        <c:v>3631</c:v>
                      </c:pt>
                      <c:pt idx="909">
                        <c:v>4038</c:v>
                      </c:pt>
                      <c:pt idx="910">
                        <c:v>643</c:v>
                      </c:pt>
                      <c:pt idx="911">
                        <c:v>956</c:v>
                      </c:pt>
                      <c:pt idx="912">
                        <c:v>3945</c:v>
                      </c:pt>
                      <c:pt idx="913">
                        <c:v>2607</c:v>
                      </c:pt>
                      <c:pt idx="914">
                        <c:v>2618</c:v>
                      </c:pt>
                      <c:pt idx="915">
                        <c:v>3533</c:v>
                      </c:pt>
                      <c:pt idx="916">
                        <c:v>3675</c:v>
                      </c:pt>
                      <c:pt idx="917">
                        <c:v>2222</c:v>
                      </c:pt>
                      <c:pt idx="918">
                        <c:v>3551</c:v>
                      </c:pt>
                      <c:pt idx="919">
                        <c:v>3862</c:v>
                      </c:pt>
                      <c:pt idx="920">
                        <c:v>2025</c:v>
                      </c:pt>
                      <c:pt idx="921">
                        <c:v>1369</c:v>
                      </c:pt>
                      <c:pt idx="922">
                        <c:v>2172</c:v>
                      </c:pt>
                      <c:pt idx="923">
                        <c:v>3662</c:v>
                      </c:pt>
                      <c:pt idx="924">
                        <c:v>2995</c:v>
                      </c:pt>
                      <c:pt idx="925">
                        <c:v>2957</c:v>
                      </c:pt>
                      <c:pt idx="926">
                        <c:v>2842</c:v>
                      </c:pt>
                      <c:pt idx="927">
                        <c:v>3961</c:v>
                      </c:pt>
                      <c:pt idx="928">
                        <c:v>3658</c:v>
                      </c:pt>
                      <c:pt idx="929">
                        <c:v>3261</c:v>
                      </c:pt>
                      <c:pt idx="930">
                        <c:v>3908</c:v>
                      </c:pt>
                      <c:pt idx="931">
                        <c:v>2904</c:v>
                      </c:pt>
                      <c:pt idx="932">
                        <c:v>3502</c:v>
                      </c:pt>
                      <c:pt idx="933">
                        <c:v>2374</c:v>
                      </c:pt>
                      <c:pt idx="934">
                        <c:v>3214</c:v>
                      </c:pt>
                      <c:pt idx="935">
                        <c:v>1474</c:v>
                      </c:pt>
                      <c:pt idx="936">
                        <c:v>3144</c:v>
                      </c:pt>
                      <c:pt idx="937">
                        <c:v>3374</c:v>
                      </c:pt>
                      <c:pt idx="938">
                        <c:v>2059</c:v>
                      </c:pt>
                      <c:pt idx="939">
                        <c:v>2925</c:v>
                      </c:pt>
                      <c:pt idx="940">
                        <c:v>2373</c:v>
                      </c:pt>
                      <c:pt idx="941">
                        <c:v>3647</c:v>
                      </c:pt>
                      <c:pt idx="942">
                        <c:v>2585</c:v>
                      </c:pt>
                      <c:pt idx="943">
                        <c:v>3168</c:v>
                      </c:pt>
                      <c:pt idx="944">
                        <c:v>2948</c:v>
                      </c:pt>
                      <c:pt idx="945">
                        <c:v>4021</c:v>
                      </c:pt>
                      <c:pt idx="946">
                        <c:v>896</c:v>
                      </c:pt>
                      <c:pt idx="947">
                        <c:v>3577</c:v>
                      </c:pt>
                      <c:pt idx="948">
                        <c:v>3226</c:v>
                      </c:pt>
                      <c:pt idx="949">
                        <c:v>3029</c:v>
                      </c:pt>
                      <c:pt idx="950">
                        <c:v>2104</c:v>
                      </c:pt>
                      <c:pt idx="951">
                        <c:v>2257</c:v>
                      </c:pt>
                      <c:pt idx="952">
                        <c:v>3293</c:v>
                      </c:pt>
                      <c:pt idx="953">
                        <c:v>3056</c:v>
                      </c:pt>
                      <c:pt idx="954">
                        <c:v>2395</c:v>
                      </c:pt>
                      <c:pt idx="955">
                        <c:v>1105</c:v>
                      </c:pt>
                      <c:pt idx="956">
                        <c:v>3839</c:v>
                      </c:pt>
                      <c:pt idx="957">
                        <c:v>3023</c:v>
                      </c:pt>
                      <c:pt idx="958">
                        <c:v>3188</c:v>
                      </c:pt>
                      <c:pt idx="959">
                        <c:v>3554</c:v>
                      </c:pt>
                      <c:pt idx="960">
                        <c:v>2574</c:v>
                      </c:pt>
                      <c:pt idx="961">
                        <c:v>1738</c:v>
                      </c:pt>
                      <c:pt idx="962">
                        <c:v>770</c:v>
                      </c:pt>
                      <c:pt idx="963">
                        <c:v>2240</c:v>
                      </c:pt>
                      <c:pt idx="964">
                        <c:v>2466</c:v>
                      </c:pt>
                      <c:pt idx="965">
                        <c:v>1316</c:v>
                      </c:pt>
                      <c:pt idx="966">
                        <c:v>3669</c:v>
                      </c:pt>
                      <c:pt idx="967">
                        <c:v>4004</c:v>
                      </c:pt>
                      <c:pt idx="968">
                        <c:v>2324</c:v>
                      </c:pt>
                      <c:pt idx="969">
                        <c:v>3955</c:v>
                      </c:pt>
                      <c:pt idx="970">
                        <c:v>3411</c:v>
                      </c:pt>
                      <c:pt idx="971">
                        <c:v>3664</c:v>
                      </c:pt>
                      <c:pt idx="972">
                        <c:v>3321</c:v>
                      </c:pt>
                      <c:pt idx="973">
                        <c:v>3545</c:v>
                      </c:pt>
                      <c:pt idx="974">
                        <c:v>3432</c:v>
                      </c:pt>
                      <c:pt idx="975">
                        <c:v>3650</c:v>
                      </c:pt>
                      <c:pt idx="976">
                        <c:v>3728</c:v>
                      </c:pt>
                      <c:pt idx="977">
                        <c:v>3525</c:v>
                      </c:pt>
                      <c:pt idx="978">
                        <c:v>3974</c:v>
                      </c:pt>
                      <c:pt idx="979">
                        <c:v>2439</c:v>
                      </c:pt>
                      <c:pt idx="980">
                        <c:v>2824</c:v>
                      </c:pt>
                      <c:pt idx="981">
                        <c:v>2954</c:v>
                      </c:pt>
                      <c:pt idx="982">
                        <c:v>2591</c:v>
                      </c:pt>
                      <c:pt idx="983">
                        <c:v>3145</c:v>
                      </c:pt>
                      <c:pt idx="984">
                        <c:v>2029</c:v>
                      </c:pt>
                      <c:pt idx="985">
                        <c:v>3772</c:v>
                      </c:pt>
                      <c:pt idx="986">
                        <c:v>1777</c:v>
                      </c:pt>
                      <c:pt idx="987">
                        <c:v>2276</c:v>
                      </c:pt>
                      <c:pt idx="988">
                        <c:v>2725</c:v>
                      </c:pt>
                      <c:pt idx="989">
                        <c:v>3095</c:v>
                      </c:pt>
                      <c:pt idx="990">
                        <c:v>1633</c:v>
                      </c:pt>
                      <c:pt idx="991">
                        <c:v>2875</c:v>
                      </c:pt>
                      <c:pt idx="992">
                        <c:v>3692</c:v>
                      </c:pt>
                      <c:pt idx="993">
                        <c:v>3923</c:v>
                      </c:pt>
                      <c:pt idx="994">
                        <c:v>2452</c:v>
                      </c:pt>
                      <c:pt idx="995">
                        <c:v>3258</c:v>
                      </c:pt>
                    </c:numCache>
                  </c:numRef>
                </c:xVal>
                <c:yVal>
                  <c:numRef>
                    <c:extLst xmlns:c15="http://schemas.microsoft.com/office/drawing/2012/chart">
                      <c:ext xmlns:c15="http://schemas.microsoft.com/office/drawing/2012/chart" uri="{02D57815-91ED-43cb-92C2-25804820EDAC}">
                        <c15:formulaRef>
                          <c15:sqref>AGO1a!$E$2:$E$1002</c15:sqref>
                        </c15:formulaRef>
                      </c:ext>
                    </c:extLst>
                    <c:numCache>
                      <c:formatCode>General</c:formatCode>
                      <c:ptCount val="1001"/>
                      <c:pt idx="0">
                        <c:v>4</c:v>
                      </c:pt>
                      <c:pt idx="2">
                        <c:v>1</c:v>
                      </c:pt>
                      <c:pt idx="3">
                        <c:v>1</c:v>
                      </c:pt>
                      <c:pt idx="4">
                        <c:v>1</c:v>
                      </c:pt>
                      <c:pt idx="19">
                        <c:v>1</c:v>
                      </c:pt>
                      <c:pt idx="26">
                        <c:v>1</c:v>
                      </c:pt>
                      <c:pt idx="32">
                        <c:v>1</c:v>
                      </c:pt>
                      <c:pt idx="34">
                        <c:v>1</c:v>
                      </c:pt>
                      <c:pt idx="36">
                        <c:v>1</c:v>
                      </c:pt>
                      <c:pt idx="38">
                        <c:v>1</c:v>
                      </c:pt>
                      <c:pt idx="51">
                        <c:v>1</c:v>
                      </c:pt>
                      <c:pt idx="54">
                        <c:v>1</c:v>
                      </c:pt>
                      <c:pt idx="57">
                        <c:v>1</c:v>
                      </c:pt>
                      <c:pt idx="60">
                        <c:v>1</c:v>
                      </c:pt>
                      <c:pt idx="65">
                        <c:v>1</c:v>
                      </c:pt>
                      <c:pt idx="66">
                        <c:v>1</c:v>
                      </c:pt>
                      <c:pt idx="67">
                        <c:v>1</c:v>
                      </c:pt>
                      <c:pt idx="69">
                        <c:v>1</c:v>
                      </c:pt>
                      <c:pt idx="71">
                        <c:v>1</c:v>
                      </c:pt>
                      <c:pt idx="73">
                        <c:v>1</c:v>
                      </c:pt>
                      <c:pt idx="74">
                        <c:v>1</c:v>
                      </c:pt>
                      <c:pt idx="79">
                        <c:v>1</c:v>
                      </c:pt>
                      <c:pt idx="82">
                        <c:v>1</c:v>
                      </c:pt>
                      <c:pt idx="86">
                        <c:v>1</c:v>
                      </c:pt>
                      <c:pt idx="87">
                        <c:v>1</c:v>
                      </c:pt>
                      <c:pt idx="89">
                        <c:v>1</c:v>
                      </c:pt>
                      <c:pt idx="97">
                        <c:v>1</c:v>
                      </c:pt>
                      <c:pt idx="99">
                        <c:v>1</c:v>
                      </c:pt>
                      <c:pt idx="101">
                        <c:v>1</c:v>
                      </c:pt>
                      <c:pt idx="105">
                        <c:v>1</c:v>
                      </c:pt>
                      <c:pt idx="106">
                        <c:v>1</c:v>
                      </c:pt>
                      <c:pt idx="126">
                        <c:v>1</c:v>
                      </c:pt>
                      <c:pt idx="128">
                        <c:v>1</c:v>
                      </c:pt>
                      <c:pt idx="129">
                        <c:v>1</c:v>
                      </c:pt>
                      <c:pt idx="132">
                        <c:v>1</c:v>
                      </c:pt>
                      <c:pt idx="135">
                        <c:v>1</c:v>
                      </c:pt>
                      <c:pt idx="137">
                        <c:v>1</c:v>
                      </c:pt>
                      <c:pt idx="141">
                        <c:v>1</c:v>
                      </c:pt>
                      <c:pt idx="143">
                        <c:v>1</c:v>
                      </c:pt>
                      <c:pt idx="144">
                        <c:v>1</c:v>
                      </c:pt>
                      <c:pt idx="148">
                        <c:v>1</c:v>
                      </c:pt>
                      <c:pt idx="154">
                        <c:v>1</c:v>
                      </c:pt>
                      <c:pt idx="156">
                        <c:v>1</c:v>
                      </c:pt>
                      <c:pt idx="157">
                        <c:v>1</c:v>
                      </c:pt>
                      <c:pt idx="158">
                        <c:v>1</c:v>
                      </c:pt>
                      <c:pt idx="159">
                        <c:v>1</c:v>
                      </c:pt>
                      <c:pt idx="160">
                        <c:v>1</c:v>
                      </c:pt>
                      <c:pt idx="164">
                        <c:v>1</c:v>
                      </c:pt>
                      <c:pt idx="165">
                        <c:v>1</c:v>
                      </c:pt>
                      <c:pt idx="166">
                        <c:v>1</c:v>
                      </c:pt>
                      <c:pt idx="168">
                        <c:v>1</c:v>
                      </c:pt>
                      <c:pt idx="170">
                        <c:v>1</c:v>
                      </c:pt>
                      <c:pt idx="174">
                        <c:v>1</c:v>
                      </c:pt>
                      <c:pt idx="177">
                        <c:v>1</c:v>
                      </c:pt>
                      <c:pt idx="180">
                        <c:v>1</c:v>
                      </c:pt>
                      <c:pt idx="184">
                        <c:v>1</c:v>
                      </c:pt>
                      <c:pt idx="191">
                        <c:v>1</c:v>
                      </c:pt>
                      <c:pt idx="192">
                        <c:v>1</c:v>
                      </c:pt>
                      <c:pt idx="193">
                        <c:v>1</c:v>
                      </c:pt>
                      <c:pt idx="196">
                        <c:v>1</c:v>
                      </c:pt>
                      <c:pt idx="198">
                        <c:v>1</c:v>
                      </c:pt>
                      <c:pt idx="199">
                        <c:v>1</c:v>
                      </c:pt>
                      <c:pt idx="203">
                        <c:v>1</c:v>
                      </c:pt>
                      <c:pt idx="207">
                        <c:v>1</c:v>
                      </c:pt>
                      <c:pt idx="212">
                        <c:v>1</c:v>
                      </c:pt>
                      <c:pt idx="214">
                        <c:v>1</c:v>
                      </c:pt>
                      <c:pt idx="216">
                        <c:v>1</c:v>
                      </c:pt>
                      <c:pt idx="220">
                        <c:v>1</c:v>
                      </c:pt>
                      <c:pt idx="224">
                        <c:v>1</c:v>
                      </c:pt>
                      <c:pt idx="228">
                        <c:v>1</c:v>
                      </c:pt>
                      <c:pt idx="230">
                        <c:v>1</c:v>
                      </c:pt>
                      <c:pt idx="232">
                        <c:v>3</c:v>
                      </c:pt>
                      <c:pt idx="237">
                        <c:v>1</c:v>
                      </c:pt>
                      <c:pt idx="241">
                        <c:v>1</c:v>
                      </c:pt>
                      <c:pt idx="246">
                        <c:v>1</c:v>
                      </c:pt>
                      <c:pt idx="253">
                        <c:v>1</c:v>
                      </c:pt>
                      <c:pt idx="254">
                        <c:v>1</c:v>
                      </c:pt>
                      <c:pt idx="258">
                        <c:v>1</c:v>
                      </c:pt>
                      <c:pt idx="259">
                        <c:v>1</c:v>
                      </c:pt>
                      <c:pt idx="261">
                        <c:v>1</c:v>
                      </c:pt>
                      <c:pt idx="263">
                        <c:v>1</c:v>
                      </c:pt>
                      <c:pt idx="264">
                        <c:v>3</c:v>
                      </c:pt>
                      <c:pt idx="265">
                        <c:v>1</c:v>
                      </c:pt>
                      <c:pt idx="266">
                        <c:v>1</c:v>
                      </c:pt>
                      <c:pt idx="269">
                        <c:v>1</c:v>
                      </c:pt>
                      <c:pt idx="275">
                        <c:v>1</c:v>
                      </c:pt>
                      <c:pt idx="279">
                        <c:v>1</c:v>
                      </c:pt>
                      <c:pt idx="280">
                        <c:v>1</c:v>
                      </c:pt>
                      <c:pt idx="288">
                        <c:v>1</c:v>
                      </c:pt>
                      <c:pt idx="290">
                        <c:v>2</c:v>
                      </c:pt>
                      <c:pt idx="293">
                        <c:v>1</c:v>
                      </c:pt>
                      <c:pt idx="294">
                        <c:v>3</c:v>
                      </c:pt>
                      <c:pt idx="296">
                        <c:v>1</c:v>
                      </c:pt>
                      <c:pt idx="297">
                        <c:v>1</c:v>
                      </c:pt>
                      <c:pt idx="299">
                        <c:v>1</c:v>
                      </c:pt>
                      <c:pt idx="303">
                        <c:v>1</c:v>
                      </c:pt>
                      <c:pt idx="306">
                        <c:v>1</c:v>
                      </c:pt>
                      <c:pt idx="314">
                        <c:v>1</c:v>
                      </c:pt>
                      <c:pt idx="319">
                        <c:v>1</c:v>
                      </c:pt>
                      <c:pt idx="320">
                        <c:v>1</c:v>
                      </c:pt>
                      <c:pt idx="332">
                        <c:v>1</c:v>
                      </c:pt>
                      <c:pt idx="346">
                        <c:v>1</c:v>
                      </c:pt>
                      <c:pt idx="354">
                        <c:v>1</c:v>
                      </c:pt>
                      <c:pt idx="359">
                        <c:v>3</c:v>
                      </c:pt>
                      <c:pt idx="362">
                        <c:v>1</c:v>
                      </c:pt>
                      <c:pt idx="368">
                        <c:v>1</c:v>
                      </c:pt>
                      <c:pt idx="369">
                        <c:v>1</c:v>
                      </c:pt>
                      <c:pt idx="372">
                        <c:v>1</c:v>
                      </c:pt>
                      <c:pt idx="379">
                        <c:v>1</c:v>
                      </c:pt>
                      <c:pt idx="384">
                        <c:v>3</c:v>
                      </c:pt>
                      <c:pt idx="386">
                        <c:v>1</c:v>
                      </c:pt>
                      <c:pt idx="387">
                        <c:v>1</c:v>
                      </c:pt>
                      <c:pt idx="388">
                        <c:v>1</c:v>
                      </c:pt>
                      <c:pt idx="396">
                        <c:v>1</c:v>
                      </c:pt>
                      <c:pt idx="397">
                        <c:v>1</c:v>
                      </c:pt>
                      <c:pt idx="400">
                        <c:v>1</c:v>
                      </c:pt>
                      <c:pt idx="402">
                        <c:v>1</c:v>
                      </c:pt>
                      <c:pt idx="403">
                        <c:v>1</c:v>
                      </c:pt>
                      <c:pt idx="410">
                        <c:v>1</c:v>
                      </c:pt>
                      <c:pt idx="412">
                        <c:v>1</c:v>
                      </c:pt>
                      <c:pt idx="414">
                        <c:v>1</c:v>
                      </c:pt>
                      <c:pt idx="417">
                        <c:v>1</c:v>
                      </c:pt>
                      <c:pt idx="418">
                        <c:v>1</c:v>
                      </c:pt>
                      <c:pt idx="422">
                        <c:v>12</c:v>
                      </c:pt>
                      <c:pt idx="424">
                        <c:v>1</c:v>
                      </c:pt>
                      <c:pt idx="426">
                        <c:v>1</c:v>
                      </c:pt>
                      <c:pt idx="432">
                        <c:v>1</c:v>
                      </c:pt>
                      <c:pt idx="440">
                        <c:v>1</c:v>
                      </c:pt>
                      <c:pt idx="441">
                        <c:v>1</c:v>
                      </c:pt>
                      <c:pt idx="442">
                        <c:v>3</c:v>
                      </c:pt>
                      <c:pt idx="443">
                        <c:v>1</c:v>
                      </c:pt>
                      <c:pt idx="446">
                        <c:v>1</c:v>
                      </c:pt>
                      <c:pt idx="449">
                        <c:v>1</c:v>
                      </c:pt>
                      <c:pt idx="452">
                        <c:v>1</c:v>
                      </c:pt>
                      <c:pt idx="453">
                        <c:v>1</c:v>
                      </c:pt>
                      <c:pt idx="457">
                        <c:v>1</c:v>
                      </c:pt>
                      <c:pt idx="465">
                        <c:v>1</c:v>
                      </c:pt>
                      <c:pt idx="468">
                        <c:v>1</c:v>
                      </c:pt>
                      <c:pt idx="475">
                        <c:v>1</c:v>
                      </c:pt>
                      <c:pt idx="476">
                        <c:v>1</c:v>
                      </c:pt>
                      <c:pt idx="480">
                        <c:v>1</c:v>
                      </c:pt>
                      <c:pt idx="485">
                        <c:v>1</c:v>
                      </c:pt>
                      <c:pt idx="487">
                        <c:v>1</c:v>
                      </c:pt>
                      <c:pt idx="491">
                        <c:v>1</c:v>
                      </c:pt>
                      <c:pt idx="494">
                        <c:v>1</c:v>
                      </c:pt>
                      <c:pt idx="495">
                        <c:v>6</c:v>
                      </c:pt>
                      <c:pt idx="497">
                        <c:v>1</c:v>
                      </c:pt>
                      <c:pt idx="499">
                        <c:v>1</c:v>
                      </c:pt>
                      <c:pt idx="507">
                        <c:v>1</c:v>
                      </c:pt>
                      <c:pt idx="511">
                        <c:v>1</c:v>
                      </c:pt>
                      <c:pt idx="513">
                        <c:v>1</c:v>
                      </c:pt>
                      <c:pt idx="515">
                        <c:v>1</c:v>
                      </c:pt>
                      <c:pt idx="516">
                        <c:v>1</c:v>
                      </c:pt>
                      <c:pt idx="524">
                        <c:v>1</c:v>
                      </c:pt>
                      <c:pt idx="525">
                        <c:v>1</c:v>
                      </c:pt>
                      <c:pt idx="526">
                        <c:v>1</c:v>
                      </c:pt>
                      <c:pt idx="530">
                        <c:v>1</c:v>
                      </c:pt>
                      <c:pt idx="531">
                        <c:v>1</c:v>
                      </c:pt>
                      <c:pt idx="532">
                        <c:v>1</c:v>
                      </c:pt>
                      <c:pt idx="533">
                        <c:v>1</c:v>
                      </c:pt>
                      <c:pt idx="534">
                        <c:v>1</c:v>
                      </c:pt>
                      <c:pt idx="541">
                        <c:v>1</c:v>
                      </c:pt>
                      <c:pt idx="543">
                        <c:v>1</c:v>
                      </c:pt>
                      <c:pt idx="544">
                        <c:v>1</c:v>
                      </c:pt>
                      <c:pt idx="545">
                        <c:v>1</c:v>
                      </c:pt>
                      <c:pt idx="547">
                        <c:v>1</c:v>
                      </c:pt>
                      <c:pt idx="550">
                        <c:v>1</c:v>
                      </c:pt>
                      <c:pt idx="552">
                        <c:v>1</c:v>
                      </c:pt>
                      <c:pt idx="557">
                        <c:v>1</c:v>
                      </c:pt>
                      <c:pt idx="562">
                        <c:v>1</c:v>
                      </c:pt>
                      <c:pt idx="565">
                        <c:v>1</c:v>
                      </c:pt>
                      <c:pt idx="567">
                        <c:v>1</c:v>
                      </c:pt>
                      <c:pt idx="568">
                        <c:v>1</c:v>
                      </c:pt>
                      <c:pt idx="569">
                        <c:v>1</c:v>
                      </c:pt>
                      <c:pt idx="573">
                        <c:v>1</c:v>
                      </c:pt>
                      <c:pt idx="580">
                        <c:v>1</c:v>
                      </c:pt>
                      <c:pt idx="581">
                        <c:v>1</c:v>
                      </c:pt>
                      <c:pt idx="582">
                        <c:v>1</c:v>
                      </c:pt>
                      <c:pt idx="583">
                        <c:v>1</c:v>
                      </c:pt>
                      <c:pt idx="587">
                        <c:v>1</c:v>
                      </c:pt>
                      <c:pt idx="589">
                        <c:v>1</c:v>
                      </c:pt>
                      <c:pt idx="591">
                        <c:v>1</c:v>
                      </c:pt>
                      <c:pt idx="592">
                        <c:v>1</c:v>
                      </c:pt>
                      <c:pt idx="594">
                        <c:v>1</c:v>
                      </c:pt>
                      <c:pt idx="598">
                        <c:v>1</c:v>
                      </c:pt>
                      <c:pt idx="599">
                        <c:v>1</c:v>
                      </c:pt>
                      <c:pt idx="601">
                        <c:v>1</c:v>
                      </c:pt>
                      <c:pt idx="607">
                        <c:v>1</c:v>
                      </c:pt>
                      <c:pt idx="609">
                        <c:v>1</c:v>
                      </c:pt>
                      <c:pt idx="610">
                        <c:v>1</c:v>
                      </c:pt>
                      <c:pt idx="614">
                        <c:v>1</c:v>
                      </c:pt>
                      <c:pt idx="621">
                        <c:v>1</c:v>
                      </c:pt>
                      <c:pt idx="623">
                        <c:v>1</c:v>
                      </c:pt>
                      <c:pt idx="626">
                        <c:v>1</c:v>
                      </c:pt>
                      <c:pt idx="627">
                        <c:v>1</c:v>
                      </c:pt>
                      <c:pt idx="628">
                        <c:v>1</c:v>
                      </c:pt>
                      <c:pt idx="631">
                        <c:v>1</c:v>
                      </c:pt>
                      <c:pt idx="637">
                        <c:v>1</c:v>
                      </c:pt>
                      <c:pt idx="638">
                        <c:v>1</c:v>
                      </c:pt>
                      <c:pt idx="639">
                        <c:v>1</c:v>
                      </c:pt>
                      <c:pt idx="642">
                        <c:v>1</c:v>
                      </c:pt>
                      <c:pt idx="643">
                        <c:v>1</c:v>
                      </c:pt>
                      <c:pt idx="644">
                        <c:v>1</c:v>
                      </c:pt>
                      <c:pt idx="646">
                        <c:v>1</c:v>
                      </c:pt>
                      <c:pt idx="650">
                        <c:v>1</c:v>
                      </c:pt>
                      <c:pt idx="651">
                        <c:v>1</c:v>
                      </c:pt>
                      <c:pt idx="654">
                        <c:v>1</c:v>
                      </c:pt>
                      <c:pt idx="655">
                        <c:v>1</c:v>
                      </c:pt>
                      <c:pt idx="656">
                        <c:v>1</c:v>
                      </c:pt>
                      <c:pt idx="658">
                        <c:v>1</c:v>
                      </c:pt>
                      <c:pt idx="660">
                        <c:v>1</c:v>
                      </c:pt>
                      <c:pt idx="662">
                        <c:v>1</c:v>
                      </c:pt>
                      <c:pt idx="663">
                        <c:v>1</c:v>
                      </c:pt>
                      <c:pt idx="664">
                        <c:v>1</c:v>
                      </c:pt>
                      <c:pt idx="665">
                        <c:v>1</c:v>
                      </c:pt>
                      <c:pt idx="669">
                        <c:v>1</c:v>
                      </c:pt>
                      <c:pt idx="673">
                        <c:v>1</c:v>
                      </c:pt>
                      <c:pt idx="679">
                        <c:v>1</c:v>
                      </c:pt>
                      <c:pt idx="680">
                        <c:v>1</c:v>
                      </c:pt>
                      <c:pt idx="683">
                        <c:v>1</c:v>
                      </c:pt>
                      <c:pt idx="686">
                        <c:v>1</c:v>
                      </c:pt>
                      <c:pt idx="689">
                        <c:v>1</c:v>
                      </c:pt>
                      <c:pt idx="690">
                        <c:v>1</c:v>
                      </c:pt>
                      <c:pt idx="691">
                        <c:v>1</c:v>
                      </c:pt>
                      <c:pt idx="692">
                        <c:v>1</c:v>
                      </c:pt>
                      <c:pt idx="697">
                        <c:v>1</c:v>
                      </c:pt>
                      <c:pt idx="701">
                        <c:v>1</c:v>
                      </c:pt>
                      <c:pt idx="704">
                        <c:v>1</c:v>
                      </c:pt>
                      <c:pt idx="707">
                        <c:v>2</c:v>
                      </c:pt>
                      <c:pt idx="710">
                        <c:v>4</c:v>
                      </c:pt>
                      <c:pt idx="711">
                        <c:v>1</c:v>
                      </c:pt>
                      <c:pt idx="712">
                        <c:v>1</c:v>
                      </c:pt>
                      <c:pt idx="720">
                        <c:v>1</c:v>
                      </c:pt>
                      <c:pt idx="722">
                        <c:v>1</c:v>
                      </c:pt>
                      <c:pt idx="727">
                        <c:v>1</c:v>
                      </c:pt>
                      <c:pt idx="728">
                        <c:v>1</c:v>
                      </c:pt>
                      <c:pt idx="729">
                        <c:v>1</c:v>
                      </c:pt>
                      <c:pt idx="736">
                        <c:v>1</c:v>
                      </c:pt>
                      <c:pt idx="738">
                        <c:v>1</c:v>
                      </c:pt>
                      <c:pt idx="744">
                        <c:v>1</c:v>
                      </c:pt>
                      <c:pt idx="745">
                        <c:v>1</c:v>
                      </c:pt>
                      <c:pt idx="748">
                        <c:v>1</c:v>
                      </c:pt>
                      <c:pt idx="750">
                        <c:v>1</c:v>
                      </c:pt>
                      <c:pt idx="752">
                        <c:v>4</c:v>
                      </c:pt>
                      <c:pt idx="753">
                        <c:v>1</c:v>
                      </c:pt>
                      <c:pt idx="754">
                        <c:v>1</c:v>
                      </c:pt>
                      <c:pt idx="755">
                        <c:v>1</c:v>
                      </c:pt>
                      <c:pt idx="757">
                        <c:v>1</c:v>
                      </c:pt>
                      <c:pt idx="758">
                        <c:v>1</c:v>
                      </c:pt>
                      <c:pt idx="760">
                        <c:v>1</c:v>
                      </c:pt>
                      <c:pt idx="761">
                        <c:v>13</c:v>
                      </c:pt>
                      <c:pt idx="762">
                        <c:v>1</c:v>
                      </c:pt>
                      <c:pt idx="763">
                        <c:v>1</c:v>
                      </c:pt>
                      <c:pt idx="764">
                        <c:v>1</c:v>
                      </c:pt>
                      <c:pt idx="769">
                        <c:v>1</c:v>
                      </c:pt>
                      <c:pt idx="772">
                        <c:v>1</c:v>
                      </c:pt>
                      <c:pt idx="774">
                        <c:v>1</c:v>
                      </c:pt>
                      <c:pt idx="780">
                        <c:v>2</c:v>
                      </c:pt>
                      <c:pt idx="791">
                        <c:v>1</c:v>
                      </c:pt>
                      <c:pt idx="795">
                        <c:v>1</c:v>
                      </c:pt>
                      <c:pt idx="796">
                        <c:v>1</c:v>
                      </c:pt>
                      <c:pt idx="802">
                        <c:v>1</c:v>
                      </c:pt>
                      <c:pt idx="803">
                        <c:v>1</c:v>
                      </c:pt>
                      <c:pt idx="805">
                        <c:v>1</c:v>
                      </c:pt>
                      <c:pt idx="806">
                        <c:v>1</c:v>
                      </c:pt>
                      <c:pt idx="807">
                        <c:v>1</c:v>
                      </c:pt>
                      <c:pt idx="808">
                        <c:v>1</c:v>
                      </c:pt>
                      <c:pt idx="809">
                        <c:v>1</c:v>
                      </c:pt>
                      <c:pt idx="812">
                        <c:v>1</c:v>
                      </c:pt>
                      <c:pt idx="813">
                        <c:v>4</c:v>
                      </c:pt>
                      <c:pt idx="818">
                        <c:v>1</c:v>
                      </c:pt>
                      <c:pt idx="819">
                        <c:v>1</c:v>
                      </c:pt>
                      <c:pt idx="821">
                        <c:v>1</c:v>
                      </c:pt>
                      <c:pt idx="825">
                        <c:v>1</c:v>
                      </c:pt>
                      <c:pt idx="826">
                        <c:v>1</c:v>
                      </c:pt>
                      <c:pt idx="832">
                        <c:v>1</c:v>
                      </c:pt>
                      <c:pt idx="836">
                        <c:v>1</c:v>
                      </c:pt>
                      <c:pt idx="837">
                        <c:v>1</c:v>
                      </c:pt>
                      <c:pt idx="838">
                        <c:v>1</c:v>
                      </c:pt>
                      <c:pt idx="839">
                        <c:v>1</c:v>
                      </c:pt>
                      <c:pt idx="841">
                        <c:v>1</c:v>
                      </c:pt>
                      <c:pt idx="842">
                        <c:v>1</c:v>
                      </c:pt>
                      <c:pt idx="854">
                        <c:v>1</c:v>
                      </c:pt>
                      <c:pt idx="856">
                        <c:v>1</c:v>
                      </c:pt>
                      <c:pt idx="859">
                        <c:v>1</c:v>
                      </c:pt>
                      <c:pt idx="860">
                        <c:v>1</c:v>
                      </c:pt>
                      <c:pt idx="863">
                        <c:v>1</c:v>
                      </c:pt>
                      <c:pt idx="868">
                        <c:v>2</c:v>
                      </c:pt>
                      <c:pt idx="871">
                        <c:v>1</c:v>
                      </c:pt>
                      <c:pt idx="872">
                        <c:v>1</c:v>
                      </c:pt>
                      <c:pt idx="874">
                        <c:v>1</c:v>
                      </c:pt>
                      <c:pt idx="876">
                        <c:v>1</c:v>
                      </c:pt>
                      <c:pt idx="879">
                        <c:v>1</c:v>
                      </c:pt>
                      <c:pt idx="880">
                        <c:v>1</c:v>
                      </c:pt>
                      <c:pt idx="881">
                        <c:v>1</c:v>
                      </c:pt>
                      <c:pt idx="886">
                        <c:v>1</c:v>
                      </c:pt>
                      <c:pt idx="887">
                        <c:v>1</c:v>
                      </c:pt>
                      <c:pt idx="890">
                        <c:v>1</c:v>
                      </c:pt>
                      <c:pt idx="895">
                        <c:v>2</c:v>
                      </c:pt>
                      <c:pt idx="899">
                        <c:v>1</c:v>
                      </c:pt>
                      <c:pt idx="901">
                        <c:v>1</c:v>
                      </c:pt>
                      <c:pt idx="902">
                        <c:v>1</c:v>
                      </c:pt>
                      <c:pt idx="905">
                        <c:v>1</c:v>
                      </c:pt>
                      <c:pt idx="907">
                        <c:v>1</c:v>
                      </c:pt>
                      <c:pt idx="910">
                        <c:v>1</c:v>
                      </c:pt>
                      <c:pt idx="911">
                        <c:v>1</c:v>
                      </c:pt>
                      <c:pt idx="914">
                        <c:v>1</c:v>
                      </c:pt>
                      <c:pt idx="915">
                        <c:v>1</c:v>
                      </c:pt>
                      <c:pt idx="916">
                        <c:v>1</c:v>
                      </c:pt>
                      <c:pt idx="918">
                        <c:v>1</c:v>
                      </c:pt>
                      <c:pt idx="920">
                        <c:v>1</c:v>
                      </c:pt>
                      <c:pt idx="926">
                        <c:v>1</c:v>
                      </c:pt>
                      <c:pt idx="929">
                        <c:v>2</c:v>
                      </c:pt>
                      <c:pt idx="932">
                        <c:v>1</c:v>
                      </c:pt>
                      <c:pt idx="937">
                        <c:v>1</c:v>
                      </c:pt>
                      <c:pt idx="943">
                        <c:v>1</c:v>
                      </c:pt>
                      <c:pt idx="945">
                        <c:v>1</c:v>
                      </c:pt>
                      <c:pt idx="947">
                        <c:v>1</c:v>
                      </c:pt>
                      <c:pt idx="949">
                        <c:v>1</c:v>
                      </c:pt>
                      <c:pt idx="950">
                        <c:v>1</c:v>
                      </c:pt>
                      <c:pt idx="953">
                        <c:v>1</c:v>
                      </c:pt>
                      <c:pt idx="957">
                        <c:v>2</c:v>
                      </c:pt>
                      <c:pt idx="959">
                        <c:v>1</c:v>
                      </c:pt>
                      <c:pt idx="964">
                        <c:v>1</c:v>
                      </c:pt>
                      <c:pt idx="966">
                        <c:v>1</c:v>
                      </c:pt>
                      <c:pt idx="968">
                        <c:v>1</c:v>
                      </c:pt>
                      <c:pt idx="972">
                        <c:v>1</c:v>
                      </c:pt>
                      <c:pt idx="973">
                        <c:v>1</c:v>
                      </c:pt>
                      <c:pt idx="980">
                        <c:v>1</c:v>
                      </c:pt>
                      <c:pt idx="983">
                        <c:v>1</c:v>
                      </c:pt>
                      <c:pt idx="984">
                        <c:v>1</c:v>
                      </c:pt>
                      <c:pt idx="986">
                        <c:v>1</c:v>
                      </c:pt>
                      <c:pt idx="988">
                        <c:v>1</c:v>
                      </c:pt>
                      <c:pt idx="992">
                        <c:v>1</c:v>
                      </c:pt>
                      <c:pt idx="993">
                        <c:v>1</c:v>
                      </c:pt>
                      <c:pt idx="995">
                        <c:v>1</c:v>
                      </c:pt>
                    </c:numCache>
                  </c:numRef>
                </c:yVal>
                <c:smooth val="0"/>
              </c15:ser>
            </c15:filteredScatterSeries>
          </c:ext>
        </c:extLst>
      </c:scatterChart>
      <c:valAx>
        <c:axId val="420210480"/>
        <c:scaling>
          <c:orientation val="minMax"/>
        </c:scaling>
        <c:delete val="0"/>
        <c:axPos val="b"/>
        <c:title>
          <c:tx>
            <c:rich>
              <a:bodyPr rot="0" spcFirstLastPara="1" vertOverflow="ellipsis" vert="horz" wrap="square" anchor="ctr" anchorCtr="1"/>
              <a:lstStyle/>
              <a:p>
                <a:pPr>
                  <a:defRPr sz="1000" b="0" i="0" u="none" strike="noStrike" kern="1200" baseline="0">
                    <a:solidFill>
                      <a:schemeClr val="tx1"/>
                    </a:solidFill>
                    <a:latin typeface="+mn-lt"/>
                    <a:ea typeface="+mn-ea"/>
                    <a:cs typeface="+mn-cs"/>
                  </a:defRPr>
                </a:pPr>
                <a:r>
                  <a:rPr lang="en-US">
                    <a:solidFill>
                      <a:schemeClr val="tx1"/>
                    </a:solidFill>
                  </a:rPr>
                  <a:t>cDNA Position</a:t>
                </a:r>
              </a:p>
            </c:rich>
          </c:tx>
          <c:layout/>
          <c:overlay val="0"/>
          <c:spPr>
            <a:noFill/>
            <a:ln>
              <a:noFill/>
            </a:ln>
            <a:effectLst/>
          </c:spPr>
          <c:txPr>
            <a:bodyPr rot="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title>
        <c:numFmt formatCode="General"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526696368"/>
        <c:crosses val="autoZero"/>
        <c:crossBetween val="midCat"/>
      </c:valAx>
      <c:valAx>
        <c:axId val="526696368"/>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r>
                  <a:rPr lang="en-US">
                    <a:solidFill>
                      <a:schemeClr val="tx1"/>
                    </a:solidFill>
                  </a:rPr>
                  <a:t>PARE</a:t>
                </a:r>
                <a:r>
                  <a:rPr lang="en-US" baseline="0">
                    <a:solidFill>
                      <a:schemeClr val="tx1"/>
                    </a:solidFill>
                  </a:rPr>
                  <a:t> Abundance (TP10M)</a:t>
                </a:r>
                <a:endParaRPr lang="en-US">
                  <a:solidFill>
                    <a:schemeClr val="tx1"/>
                  </a:solidFill>
                </a:endParaRPr>
              </a:p>
            </c:rich>
          </c:tx>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title>
        <c:numFmt formatCode="General"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420210480"/>
        <c:crosses val="autoZero"/>
        <c:crossBetween val="midCat"/>
      </c:valAx>
      <c:spPr>
        <a:noFill/>
        <a:ln>
          <a:noFill/>
        </a:ln>
        <a:effectLst/>
      </c:spPr>
    </c:plotArea>
    <c:plotVisOnly val="1"/>
    <c:dispBlanksAs val="gap"/>
    <c:showDLblsOverMax val="0"/>
  </c:chart>
  <c:spPr>
    <a:noFill/>
    <a:ln>
      <a:solidFill>
        <a:schemeClr val="tx1"/>
      </a:solidFill>
    </a:ln>
    <a:effectLst/>
  </c:spPr>
  <c:txPr>
    <a:bodyPr/>
    <a:lstStyle/>
    <a:p>
      <a:pPr>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200" b="1" i="0" u="none" strike="noStrike" kern="1200" spc="0" baseline="0">
                <a:solidFill>
                  <a:schemeClr val="tx1"/>
                </a:solidFill>
                <a:latin typeface="+mn-lt"/>
                <a:ea typeface="+mn-ea"/>
                <a:cs typeface="+mn-cs"/>
              </a:defRPr>
            </a:pPr>
            <a:r>
              <a:rPr lang="en-US" sz="1200" b="1" dirty="0" smtClean="0">
                <a:solidFill>
                  <a:schemeClr val="tx1"/>
                </a:solidFill>
                <a:effectLst/>
              </a:rPr>
              <a:t>Cold</a:t>
            </a:r>
            <a:endParaRPr lang="en-US" sz="1200" b="1" dirty="0">
              <a:solidFill>
                <a:schemeClr val="tx1"/>
              </a:solidFill>
              <a:effectLst/>
            </a:endParaRPr>
          </a:p>
        </c:rich>
      </c:tx>
      <c:layout/>
      <c:overlay val="0"/>
      <c:spPr>
        <a:noFill/>
        <a:ln>
          <a:noFill/>
        </a:ln>
        <a:effectLst/>
      </c:spPr>
      <c:txPr>
        <a:bodyPr rot="0" spcFirstLastPara="1" vertOverflow="ellipsis" vert="horz" wrap="square" anchor="ctr" anchorCtr="1"/>
        <a:lstStyle/>
        <a:p>
          <a:pPr>
            <a:defRPr sz="1200" b="1" i="0" u="none" strike="noStrike" kern="1200" spc="0" baseline="0">
              <a:solidFill>
                <a:schemeClr val="tx1"/>
              </a:solidFill>
              <a:latin typeface="+mn-lt"/>
              <a:ea typeface="+mn-ea"/>
              <a:cs typeface="+mn-cs"/>
            </a:defRPr>
          </a:pPr>
          <a:endParaRPr lang="en-US"/>
        </a:p>
      </c:txPr>
    </c:title>
    <c:autoTitleDeleted val="0"/>
    <c:plotArea>
      <c:layout>
        <c:manualLayout>
          <c:layoutTarget val="inner"/>
          <c:xMode val="edge"/>
          <c:yMode val="edge"/>
          <c:x val="0.17734814814814814"/>
          <c:y val="0.17171296296296296"/>
          <c:w val="0.70929999999999982"/>
          <c:h val="0.59860717410323705"/>
        </c:manualLayout>
      </c:layout>
      <c:scatterChart>
        <c:scatterStyle val="lineMarker"/>
        <c:varyColors val="0"/>
        <c:ser>
          <c:idx val="2"/>
          <c:order val="2"/>
          <c:tx>
            <c:strRef>
              <c:f>'Brachy NFY'!$E$2</c:f>
              <c:strCache>
                <c:ptCount val="1"/>
                <c:pt idx="0">
                  <c:v>Cold1</c:v>
                </c:pt>
              </c:strCache>
              <c:extLst xmlns:c15="http://schemas.microsoft.com/office/drawing/2012/chart"/>
            </c:strRef>
          </c:tx>
          <c:spPr>
            <a:ln w="19050" cap="rnd">
              <a:noFill/>
              <a:round/>
            </a:ln>
            <a:effectLst/>
          </c:spPr>
          <c:marker>
            <c:symbol val="circle"/>
            <c:size val="5"/>
            <c:spPr>
              <a:solidFill>
                <a:schemeClr val="tx1"/>
              </a:solidFill>
              <a:ln w="9525">
                <a:solidFill>
                  <a:schemeClr val="tx1"/>
                </a:solidFill>
              </a:ln>
              <a:effectLst/>
            </c:spPr>
          </c:marker>
          <c:dPt>
            <c:idx val="806"/>
            <c:marker>
              <c:symbol val="circle"/>
              <c:size val="5"/>
              <c:spPr>
                <a:solidFill>
                  <a:srgbClr val="FF0000"/>
                </a:solidFill>
                <a:ln w="9525">
                  <a:solidFill>
                    <a:srgbClr val="FF0000"/>
                  </a:solidFill>
                </a:ln>
                <a:effectLst/>
              </c:spPr>
            </c:marker>
            <c:bubble3D val="0"/>
          </c:dPt>
          <c:xVal>
            <c:numRef>
              <c:f>'Brachy NFY'!$B$3:$B$1060</c:f>
              <c:numCache>
                <c:formatCode>General</c:formatCode>
                <c:ptCount val="1058"/>
                <c:pt idx="0">
                  <c:v>52</c:v>
                </c:pt>
                <c:pt idx="1">
                  <c:v>62</c:v>
                </c:pt>
                <c:pt idx="2">
                  <c:v>69</c:v>
                </c:pt>
                <c:pt idx="3">
                  <c:v>77</c:v>
                </c:pt>
                <c:pt idx="4">
                  <c:v>89</c:v>
                </c:pt>
                <c:pt idx="5">
                  <c:v>92</c:v>
                </c:pt>
                <c:pt idx="6">
                  <c:v>95</c:v>
                </c:pt>
                <c:pt idx="7">
                  <c:v>100</c:v>
                </c:pt>
                <c:pt idx="8">
                  <c:v>116</c:v>
                </c:pt>
                <c:pt idx="9">
                  <c:v>123</c:v>
                </c:pt>
                <c:pt idx="10">
                  <c:v>125</c:v>
                </c:pt>
                <c:pt idx="11">
                  <c:v>129</c:v>
                </c:pt>
                <c:pt idx="12">
                  <c:v>135</c:v>
                </c:pt>
                <c:pt idx="13">
                  <c:v>146</c:v>
                </c:pt>
                <c:pt idx="14">
                  <c:v>147</c:v>
                </c:pt>
                <c:pt idx="15">
                  <c:v>148</c:v>
                </c:pt>
                <c:pt idx="16">
                  <c:v>149</c:v>
                </c:pt>
                <c:pt idx="17">
                  <c:v>150</c:v>
                </c:pt>
                <c:pt idx="18">
                  <c:v>152</c:v>
                </c:pt>
                <c:pt idx="19">
                  <c:v>153</c:v>
                </c:pt>
                <c:pt idx="20">
                  <c:v>155</c:v>
                </c:pt>
                <c:pt idx="21">
                  <c:v>157</c:v>
                </c:pt>
                <c:pt idx="22">
                  <c:v>158</c:v>
                </c:pt>
                <c:pt idx="23">
                  <c:v>159</c:v>
                </c:pt>
                <c:pt idx="24">
                  <c:v>160</c:v>
                </c:pt>
                <c:pt idx="25">
                  <c:v>162</c:v>
                </c:pt>
                <c:pt idx="26">
                  <c:v>164</c:v>
                </c:pt>
                <c:pt idx="27">
                  <c:v>169</c:v>
                </c:pt>
                <c:pt idx="28">
                  <c:v>171</c:v>
                </c:pt>
                <c:pt idx="29">
                  <c:v>173</c:v>
                </c:pt>
                <c:pt idx="30">
                  <c:v>174</c:v>
                </c:pt>
                <c:pt idx="31">
                  <c:v>181</c:v>
                </c:pt>
                <c:pt idx="32">
                  <c:v>186</c:v>
                </c:pt>
                <c:pt idx="33">
                  <c:v>187</c:v>
                </c:pt>
                <c:pt idx="34">
                  <c:v>190</c:v>
                </c:pt>
                <c:pt idx="35">
                  <c:v>192</c:v>
                </c:pt>
                <c:pt idx="36">
                  <c:v>197</c:v>
                </c:pt>
                <c:pt idx="37">
                  <c:v>202</c:v>
                </c:pt>
                <c:pt idx="38">
                  <c:v>204</c:v>
                </c:pt>
                <c:pt idx="39">
                  <c:v>206</c:v>
                </c:pt>
                <c:pt idx="40">
                  <c:v>208</c:v>
                </c:pt>
                <c:pt idx="41">
                  <c:v>209</c:v>
                </c:pt>
                <c:pt idx="42">
                  <c:v>210</c:v>
                </c:pt>
                <c:pt idx="43">
                  <c:v>217</c:v>
                </c:pt>
                <c:pt idx="44">
                  <c:v>219</c:v>
                </c:pt>
                <c:pt idx="45">
                  <c:v>220</c:v>
                </c:pt>
                <c:pt idx="46">
                  <c:v>222</c:v>
                </c:pt>
                <c:pt idx="47">
                  <c:v>226</c:v>
                </c:pt>
                <c:pt idx="48">
                  <c:v>227</c:v>
                </c:pt>
                <c:pt idx="49">
                  <c:v>230</c:v>
                </c:pt>
                <c:pt idx="50">
                  <c:v>231</c:v>
                </c:pt>
                <c:pt idx="51">
                  <c:v>232</c:v>
                </c:pt>
                <c:pt idx="52">
                  <c:v>235</c:v>
                </c:pt>
                <c:pt idx="53">
                  <c:v>236</c:v>
                </c:pt>
                <c:pt idx="54">
                  <c:v>240</c:v>
                </c:pt>
                <c:pt idx="55">
                  <c:v>241</c:v>
                </c:pt>
                <c:pt idx="56">
                  <c:v>244</c:v>
                </c:pt>
                <c:pt idx="57">
                  <c:v>245</c:v>
                </c:pt>
                <c:pt idx="58">
                  <c:v>247</c:v>
                </c:pt>
                <c:pt idx="59">
                  <c:v>248</c:v>
                </c:pt>
                <c:pt idx="60">
                  <c:v>251</c:v>
                </c:pt>
                <c:pt idx="61">
                  <c:v>254</c:v>
                </c:pt>
                <c:pt idx="62">
                  <c:v>255</c:v>
                </c:pt>
                <c:pt idx="63">
                  <c:v>258</c:v>
                </c:pt>
                <c:pt idx="64">
                  <c:v>260</c:v>
                </c:pt>
                <c:pt idx="65">
                  <c:v>261</c:v>
                </c:pt>
                <c:pt idx="66">
                  <c:v>262</c:v>
                </c:pt>
                <c:pt idx="67">
                  <c:v>263</c:v>
                </c:pt>
                <c:pt idx="68">
                  <c:v>264</c:v>
                </c:pt>
                <c:pt idx="69">
                  <c:v>265</c:v>
                </c:pt>
                <c:pt idx="70">
                  <c:v>266</c:v>
                </c:pt>
                <c:pt idx="71">
                  <c:v>267</c:v>
                </c:pt>
                <c:pt idx="72">
                  <c:v>268</c:v>
                </c:pt>
                <c:pt idx="73">
                  <c:v>270</c:v>
                </c:pt>
                <c:pt idx="74">
                  <c:v>273</c:v>
                </c:pt>
                <c:pt idx="75">
                  <c:v>286</c:v>
                </c:pt>
                <c:pt idx="76">
                  <c:v>289</c:v>
                </c:pt>
                <c:pt idx="77">
                  <c:v>290</c:v>
                </c:pt>
                <c:pt idx="78">
                  <c:v>292</c:v>
                </c:pt>
                <c:pt idx="79">
                  <c:v>294</c:v>
                </c:pt>
                <c:pt idx="80">
                  <c:v>295</c:v>
                </c:pt>
                <c:pt idx="81">
                  <c:v>297</c:v>
                </c:pt>
                <c:pt idx="82">
                  <c:v>302</c:v>
                </c:pt>
                <c:pt idx="83">
                  <c:v>303</c:v>
                </c:pt>
                <c:pt idx="84">
                  <c:v>307</c:v>
                </c:pt>
                <c:pt idx="85">
                  <c:v>309</c:v>
                </c:pt>
                <c:pt idx="86">
                  <c:v>310</c:v>
                </c:pt>
                <c:pt idx="87">
                  <c:v>312</c:v>
                </c:pt>
                <c:pt idx="88">
                  <c:v>313</c:v>
                </c:pt>
                <c:pt idx="89">
                  <c:v>314</c:v>
                </c:pt>
                <c:pt idx="90">
                  <c:v>315</c:v>
                </c:pt>
                <c:pt idx="91">
                  <c:v>316</c:v>
                </c:pt>
                <c:pt idx="92">
                  <c:v>326</c:v>
                </c:pt>
                <c:pt idx="93">
                  <c:v>330</c:v>
                </c:pt>
                <c:pt idx="94">
                  <c:v>335</c:v>
                </c:pt>
                <c:pt idx="95">
                  <c:v>338</c:v>
                </c:pt>
                <c:pt idx="96">
                  <c:v>339</c:v>
                </c:pt>
                <c:pt idx="97">
                  <c:v>344</c:v>
                </c:pt>
                <c:pt idx="98">
                  <c:v>349</c:v>
                </c:pt>
                <c:pt idx="99">
                  <c:v>351</c:v>
                </c:pt>
                <c:pt idx="100">
                  <c:v>354</c:v>
                </c:pt>
                <c:pt idx="101">
                  <c:v>357</c:v>
                </c:pt>
                <c:pt idx="102">
                  <c:v>361</c:v>
                </c:pt>
                <c:pt idx="103">
                  <c:v>364</c:v>
                </c:pt>
                <c:pt idx="104">
                  <c:v>373</c:v>
                </c:pt>
                <c:pt idx="105">
                  <c:v>377</c:v>
                </c:pt>
                <c:pt idx="106">
                  <c:v>378</c:v>
                </c:pt>
                <c:pt idx="107">
                  <c:v>379</c:v>
                </c:pt>
                <c:pt idx="108">
                  <c:v>382</c:v>
                </c:pt>
                <c:pt idx="109">
                  <c:v>390</c:v>
                </c:pt>
                <c:pt idx="110">
                  <c:v>394</c:v>
                </c:pt>
                <c:pt idx="111">
                  <c:v>396</c:v>
                </c:pt>
                <c:pt idx="112">
                  <c:v>397</c:v>
                </c:pt>
                <c:pt idx="113">
                  <c:v>400</c:v>
                </c:pt>
                <c:pt idx="114">
                  <c:v>403</c:v>
                </c:pt>
                <c:pt idx="115">
                  <c:v>405</c:v>
                </c:pt>
                <c:pt idx="116">
                  <c:v>406</c:v>
                </c:pt>
                <c:pt idx="117">
                  <c:v>407</c:v>
                </c:pt>
                <c:pt idx="118">
                  <c:v>408</c:v>
                </c:pt>
                <c:pt idx="119">
                  <c:v>409</c:v>
                </c:pt>
                <c:pt idx="120">
                  <c:v>410</c:v>
                </c:pt>
                <c:pt idx="121">
                  <c:v>416</c:v>
                </c:pt>
                <c:pt idx="122">
                  <c:v>418</c:v>
                </c:pt>
                <c:pt idx="123">
                  <c:v>423</c:v>
                </c:pt>
                <c:pt idx="124">
                  <c:v>424</c:v>
                </c:pt>
                <c:pt idx="125">
                  <c:v>426</c:v>
                </c:pt>
                <c:pt idx="126">
                  <c:v>428</c:v>
                </c:pt>
                <c:pt idx="127">
                  <c:v>429</c:v>
                </c:pt>
                <c:pt idx="128">
                  <c:v>430</c:v>
                </c:pt>
                <c:pt idx="129">
                  <c:v>433</c:v>
                </c:pt>
                <c:pt idx="130">
                  <c:v>438</c:v>
                </c:pt>
                <c:pt idx="131">
                  <c:v>440</c:v>
                </c:pt>
                <c:pt idx="132">
                  <c:v>450</c:v>
                </c:pt>
                <c:pt idx="133">
                  <c:v>453</c:v>
                </c:pt>
                <c:pt idx="134">
                  <c:v>460</c:v>
                </c:pt>
                <c:pt idx="135">
                  <c:v>461</c:v>
                </c:pt>
                <c:pt idx="136">
                  <c:v>464</c:v>
                </c:pt>
                <c:pt idx="137">
                  <c:v>465</c:v>
                </c:pt>
                <c:pt idx="138">
                  <c:v>466</c:v>
                </c:pt>
                <c:pt idx="139">
                  <c:v>467</c:v>
                </c:pt>
                <c:pt idx="140">
                  <c:v>468</c:v>
                </c:pt>
                <c:pt idx="141">
                  <c:v>469</c:v>
                </c:pt>
                <c:pt idx="142">
                  <c:v>470</c:v>
                </c:pt>
                <c:pt idx="143">
                  <c:v>471</c:v>
                </c:pt>
                <c:pt idx="144">
                  <c:v>472</c:v>
                </c:pt>
                <c:pt idx="145">
                  <c:v>473</c:v>
                </c:pt>
                <c:pt idx="146">
                  <c:v>474</c:v>
                </c:pt>
                <c:pt idx="147">
                  <c:v>475</c:v>
                </c:pt>
                <c:pt idx="148">
                  <c:v>477</c:v>
                </c:pt>
                <c:pt idx="149">
                  <c:v>478</c:v>
                </c:pt>
                <c:pt idx="150">
                  <c:v>479</c:v>
                </c:pt>
                <c:pt idx="151">
                  <c:v>480</c:v>
                </c:pt>
                <c:pt idx="152">
                  <c:v>485</c:v>
                </c:pt>
                <c:pt idx="153">
                  <c:v>488</c:v>
                </c:pt>
                <c:pt idx="154">
                  <c:v>489</c:v>
                </c:pt>
                <c:pt idx="155">
                  <c:v>491</c:v>
                </c:pt>
                <c:pt idx="156">
                  <c:v>492</c:v>
                </c:pt>
                <c:pt idx="157">
                  <c:v>494</c:v>
                </c:pt>
                <c:pt idx="158">
                  <c:v>495</c:v>
                </c:pt>
                <c:pt idx="159">
                  <c:v>497</c:v>
                </c:pt>
                <c:pt idx="160">
                  <c:v>498</c:v>
                </c:pt>
                <c:pt idx="161">
                  <c:v>499</c:v>
                </c:pt>
                <c:pt idx="162">
                  <c:v>500</c:v>
                </c:pt>
                <c:pt idx="163">
                  <c:v>501</c:v>
                </c:pt>
                <c:pt idx="164">
                  <c:v>502</c:v>
                </c:pt>
                <c:pt idx="165">
                  <c:v>503</c:v>
                </c:pt>
                <c:pt idx="166">
                  <c:v>504</c:v>
                </c:pt>
                <c:pt idx="167">
                  <c:v>505</c:v>
                </c:pt>
                <c:pt idx="168">
                  <c:v>508</c:v>
                </c:pt>
                <c:pt idx="169">
                  <c:v>510</c:v>
                </c:pt>
                <c:pt idx="170">
                  <c:v>511</c:v>
                </c:pt>
                <c:pt idx="171">
                  <c:v>513</c:v>
                </c:pt>
                <c:pt idx="172">
                  <c:v>516</c:v>
                </c:pt>
                <c:pt idx="173">
                  <c:v>518</c:v>
                </c:pt>
                <c:pt idx="174">
                  <c:v>519</c:v>
                </c:pt>
                <c:pt idx="175">
                  <c:v>520</c:v>
                </c:pt>
                <c:pt idx="176">
                  <c:v>521</c:v>
                </c:pt>
                <c:pt idx="177">
                  <c:v>522</c:v>
                </c:pt>
                <c:pt idx="178">
                  <c:v>523</c:v>
                </c:pt>
                <c:pt idx="179">
                  <c:v>524</c:v>
                </c:pt>
                <c:pt idx="180">
                  <c:v>525</c:v>
                </c:pt>
                <c:pt idx="181">
                  <c:v>527</c:v>
                </c:pt>
                <c:pt idx="182">
                  <c:v>530</c:v>
                </c:pt>
                <c:pt idx="183">
                  <c:v>531</c:v>
                </c:pt>
                <c:pt idx="184">
                  <c:v>532</c:v>
                </c:pt>
                <c:pt idx="185">
                  <c:v>533</c:v>
                </c:pt>
                <c:pt idx="186">
                  <c:v>537</c:v>
                </c:pt>
                <c:pt idx="187">
                  <c:v>538</c:v>
                </c:pt>
                <c:pt idx="188">
                  <c:v>539</c:v>
                </c:pt>
                <c:pt idx="189">
                  <c:v>541</c:v>
                </c:pt>
                <c:pt idx="190">
                  <c:v>542</c:v>
                </c:pt>
                <c:pt idx="191">
                  <c:v>543</c:v>
                </c:pt>
                <c:pt idx="192">
                  <c:v>544</c:v>
                </c:pt>
                <c:pt idx="193">
                  <c:v>545</c:v>
                </c:pt>
                <c:pt idx="194">
                  <c:v>549</c:v>
                </c:pt>
                <c:pt idx="195">
                  <c:v>550</c:v>
                </c:pt>
                <c:pt idx="196">
                  <c:v>551</c:v>
                </c:pt>
                <c:pt idx="197">
                  <c:v>552</c:v>
                </c:pt>
                <c:pt idx="198">
                  <c:v>553</c:v>
                </c:pt>
                <c:pt idx="199">
                  <c:v>554</c:v>
                </c:pt>
                <c:pt idx="200">
                  <c:v>555</c:v>
                </c:pt>
                <c:pt idx="201">
                  <c:v>556</c:v>
                </c:pt>
                <c:pt idx="202">
                  <c:v>557</c:v>
                </c:pt>
                <c:pt idx="203">
                  <c:v>558</c:v>
                </c:pt>
                <c:pt idx="204">
                  <c:v>561</c:v>
                </c:pt>
                <c:pt idx="205">
                  <c:v>562</c:v>
                </c:pt>
                <c:pt idx="206">
                  <c:v>564</c:v>
                </c:pt>
                <c:pt idx="207">
                  <c:v>565</c:v>
                </c:pt>
                <c:pt idx="208">
                  <c:v>568</c:v>
                </c:pt>
                <c:pt idx="209">
                  <c:v>570</c:v>
                </c:pt>
                <c:pt idx="210">
                  <c:v>571</c:v>
                </c:pt>
                <c:pt idx="211">
                  <c:v>573</c:v>
                </c:pt>
                <c:pt idx="212">
                  <c:v>574</c:v>
                </c:pt>
                <c:pt idx="213">
                  <c:v>575</c:v>
                </c:pt>
                <c:pt idx="214">
                  <c:v>582</c:v>
                </c:pt>
                <c:pt idx="215">
                  <c:v>586</c:v>
                </c:pt>
                <c:pt idx="216">
                  <c:v>587</c:v>
                </c:pt>
                <c:pt idx="217">
                  <c:v>589</c:v>
                </c:pt>
                <c:pt idx="218">
                  <c:v>590</c:v>
                </c:pt>
                <c:pt idx="219">
                  <c:v>591</c:v>
                </c:pt>
                <c:pt idx="220">
                  <c:v>592</c:v>
                </c:pt>
                <c:pt idx="221">
                  <c:v>595</c:v>
                </c:pt>
                <c:pt idx="222">
                  <c:v>596</c:v>
                </c:pt>
                <c:pt idx="223">
                  <c:v>597</c:v>
                </c:pt>
                <c:pt idx="224">
                  <c:v>598</c:v>
                </c:pt>
                <c:pt idx="225">
                  <c:v>604</c:v>
                </c:pt>
                <c:pt idx="226">
                  <c:v>605</c:v>
                </c:pt>
                <c:pt idx="227">
                  <c:v>608</c:v>
                </c:pt>
                <c:pt idx="228">
                  <c:v>609</c:v>
                </c:pt>
                <c:pt idx="229">
                  <c:v>610</c:v>
                </c:pt>
                <c:pt idx="230">
                  <c:v>611</c:v>
                </c:pt>
                <c:pt idx="231">
                  <c:v>612</c:v>
                </c:pt>
                <c:pt idx="232">
                  <c:v>613</c:v>
                </c:pt>
                <c:pt idx="233">
                  <c:v>623</c:v>
                </c:pt>
                <c:pt idx="234">
                  <c:v>624</c:v>
                </c:pt>
                <c:pt idx="235">
                  <c:v>625</c:v>
                </c:pt>
                <c:pt idx="236">
                  <c:v>627</c:v>
                </c:pt>
                <c:pt idx="237">
                  <c:v>628</c:v>
                </c:pt>
                <c:pt idx="238">
                  <c:v>629</c:v>
                </c:pt>
                <c:pt idx="239">
                  <c:v>631</c:v>
                </c:pt>
                <c:pt idx="240">
                  <c:v>634</c:v>
                </c:pt>
                <c:pt idx="241">
                  <c:v>636</c:v>
                </c:pt>
                <c:pt idx="242">
                  <c:v>638</c:v>
                </c:pt>
                <c:pt idx="243">
                  <c:v>639</c:v>
                </c:pt>
                <c:pt idx="244">
                  <c:v>642</c:v>
                </c:pt>
                <c:pt idx="245">
                  <c:v>643</c:v>
                </c:pt>
                <c:pt idx="246">
                  <c:v>644</c:v>
                </c:pt>
                <c:pt idx="247">
                  <c:v>646</c:v>
                </c:pt>
                <c:pt idx="248">
                  <c:v>647</c:v>
                </c:pt>
                <c:pt idx="249">
                  <c:v>649</c:v>
                </c:pt>
                <c:pt idx="250">
                  <c:v>650</c:v>
                </c:pt>
                <c:pt idx="251">
                  <c:v>652</c:v>
                </c:pt>
                <c:pt idx="252">
                  <c:v>653</c:v>
                </c:pt>
                <c:pt idx="253">
                  <c:v>654</c:v>
                </c:pt>
                <c:pt idx="254">
                  <c:v>656</c:v>
                </c:pt>
                <c:pt idx="255">
                  <c:v>657</c:v>
                </c:pt>
                <c:pt idx="256">
                  <c:v>659</c:v>
                </c:pt>
                <c:pt idx="257">
                  <c:v>661</c:v>
                </c:pt>
                <c:pt idx="258">
                  <c:v>665</c:v>
                </c:pt>
                <c:pt idx="259">
                  <c:v>667</c:v>
                </c:pt>
                <c:pt idx="260">
                  <c:v>668</c:v>
                </c:pt>
                <c:pt idx="261">
                  <c:v>669</c:v>
                </c:pt>
                <c:pt idx="262">
                  <c:v>670</c:v>
                </c:pt>
                <c:pt idx="263">
                  <c:v>671</c:v>
                </c:pt>
                <c:pt idx="264">
                  <c:v>672</c:v>
                </c:pt>
                <c:pt idx="265">
                  <c:v>673</c:v>
                </c:pt>
                <c:pt idx="266">
                  <c:v>674</c:v>
                </c:pt>
                <c:pt idx="267">
                  <c:v>675</c:v>
                </c:pt>
                <c:pt idx="268">
                  <c:v>676</c:v>
                </c:pt>
                <c:pt idx="269">
                  <c:v>677</c:v>
                </c:pt>
                <c:pt idx="270">
                  <c:v>678</c:v>
                </c:pt>
                <c:pt idx="271">
                  <c:v>681</c:v>
                </c:pt>
                <c:pt idx="272">
                  <c:v>682</c:v>
                </c:pt>
                <c:pt idx="273">
                  <c:v>683</c:v>
                </c:pt>
                <c:pt idx="274">
                  <c:v>684</c:v>
                </c:pt>
                <c:pt idx="275">
                  <c:v>685</c:v>
                </c:pt>
                <c:pt idx="276">
                  <c:v>686</c:v>
                </c:pt>
                <c:pt idx="277">
                  <c:v>687</c:v>
                </c:pt>
                <c:pt idx="278">
                  <c:v>688</c:v>
                </c:pt>
                <c:pt idx="279">
                  <c:v>689</c:v>
                </c:pt>
                <c:pt idx="280">
                  <c:v>693</c:v>
                </c:pt>
                <c:pt idx="281">
                  <c:v>694</c:v>
                </c:pt>
                <c:pt idx="282">
                  <c:v>698</c:v>
                </c:pt>
                <c:pt idx="283">
                  <c:v>701</c:v>
                </c:pt>
                <c:pt idx="284">
                  <c:v>702</c:v>
                </c:pt>
                <c:pt idx="285">
                  <c:v>703</c:v>
                </c:pt>
                <c:pt idx="286">
                  <c:v>707</c:v>
                </c:pt>
                <c:pt idx="287">
                  <c:v>708</c:v>
                </c:pt>
                <c:pt idx="288">
                  <c:v>712</c:v>
                </c:pt>
                <c:pt idx="289">
                  <c:v>713</c:v>
                </c:pt>
                <c:pt idx="290">
                  <c:v>714</c:v>
                </c:pt>
                <c:pt idx="291">
                  <c:v>719</c:v>
                </c:pt>
                <c:pt idx="292">
                  <c:v>720</c:v>
                </c:pt>
                <c:pt idx="293">
                  <c:v>721</c:v>
                </c:pt>
                <c:pt idx="294">
                  <c:v>723</c:v>
                </c:pt>
                <c:pt idx="295">
                  <c:v>724</c:v>
                </c:pt>
                <c:pt idx="296">
                  <c:v>725</c:v>
                </c:pt>
                <c:pt idx="297">
                  <c:v>726</c:v>
                </c:pt>
                <c:pt idx="298">
                  <c:v>727</c:v>
                </c:pt>
                <c:pt idx="299">
                  <c:v>728</c:v>
                </c:pt>
                <c:pt idx="300">
                  <c:v>729</c:v>
                </c:pt>
                <c:pt idx="301">
                  <c:v>730</c:v>
                </c:pt>
                <c:pt idx="302">
                  <c:v>732</c:v>
                </c:pt>
                <c:pt idx="303">
                  <c:v>734</c:v>
                </c:pt>
                <c:pt idx="304">
                  <c:v>735</c:v>
                </c:pt>
                <c:pt idx="305">
                  <c:v>736</c:v>
                </c:pt>
                <c:pt idx="306">
                  <c:v>737</c:v>
                </c:pt>
                <c:pt idx="307">
                  <c:v>738</c:v>
                </c:pt>
                <c:pt idx="308">
                  <c:v>739</c:v>
                </c:pt>
                <c:pt idx="309">
                  <c:v>740</c:v>
                </c:pt>
                <c:pt idx="310">
                  <c:v>741</c:v>
                </c:pt>
                <c:pt idx="311">
                  <c:v>742</c:v>
                </c:pt>
                <c:pt idx="312">
                  <c:v>743</c:v>
                </c:pt>
                <c:pt idx="313">
                  <c:v>744</c:v>
                </c:pt>
                <c:pt idx="314">
                  <c:v>745</c:v>
                </c:pt>
                <c:pt idx="315">
                  <c:v>746</c:v>
                </c:pt>
                <c:pt idx="316">
                  <c:v>747</c:v>
                </c:pt>
                <c:pt idx="317">
                  <c:v>748</c:v>
                </c:pt>
                <c:pt idx="318">
                  <c:v>749</c:v>
                </c:pt>
                <c:pt idx="319">
                  <c:v>750</c:v>
                </c:pt>
                <c:pt idx="320">
                  <c:v>751</c:v>
                </c:pt>
                <c:pt idx="321">
                  <c:v>757</c:v>
                </c:pt>
                <c:pt idx="322">
                  <c:v>758</c:v>
                </c:pt>
                <c:pt idx="323">
                  <c:v>759</c:v>
                </c:pt>
                <c:pt idx="324">
                  <c:v>760</c:v>
                </c:pt>
                <c:pt idx="325">
                  <c:v>761</c:v>
                </c:pt>
                <c:pt idx="326">
                  <c:v>762</c:v>
                </c:pt>
                <c:pt idx="327">
                  <c:v>765</c:v>
                </c:pt>
                <c:pt idx="328">
                  <c:v>766</c:v>
                </c:pt>
                <c:pt idx="329">
                  <c:v>767</c:v>
                </c:pt>
                <c:pt idx="330">
                  <c:v>769</c:v>
                </c:pt>
                <c:pt idx="331">
                  <c:v>770</c:v>
                </c:pt>
                <c:pt idx="332">
                  <c:v>772</c:v>
                </c:pt>
                <c:pt idx="333">
                  <c:v>773</c:v>
                </c:pt>
                <c:pt idx="334">
                  <c:v>774</c:v>
                </c:pt>
                <c:pt idx="335">
                  <c:v>775</c:v>
                </c:pt>
                <c:pt idx="336">
                  <c:v>776</c:v>
                </c:pt>
                <c:pt idx="337">
                  <c:v>777</c:v>
                </c:pt>
                <c:pt idx="338">
                  <c:v>778</c:v>
                </c:pt>
                <c:pt idx="339">
                  <c:v>779</c:v>
                </c:pt>
                <c:pt idx="340">
                  <c:v>781</c:v>
                </c:pt>
                <c:pt idx="341">
                  <c:v>782</c:v>
                </c:pt>
                <c:pt idx="342">
                  <c:v>783</c:v>
                </c:pt>
                <c:pt idx="343">
                  <c:v>784</c:v>
                </c:pt>
                <c:pt idx="344">
                  <c:v>786</c:v>
                </c:pt>
                <c:pt idx="345">
                  <c:v>787</c:v>
                </c:pt>
                <c:pt idx="346">
                  <c:v>788</c:v>
                </c:pt>
                <c:pt idx="347">
                  <c:v>789</c:v>
                </c:pt>
                <c:pt idx="348">
                  <c:v>790</c:v>
                </c:pt>
                <c:pt idx="349">
                  <c:v>794</c:v>
                </c:pt>
                <c:pt idx="350">
                  <c:v>795</c:v>
                </c:pt>
                <c:pt idx="351">
                  <c:v>796</c:v>
                </c:pt>
                <c:pt idx="352">
                  <c:v>797</c:v>
                </c:pt>
                <c:pt idx="353">
                  <c:v>798</c:v>
                </c:pt>
                <c:pt idx="354">
                  <c:v>800</c:v>
                </c:pt>
                <c:pt idx="355">
                  <c:v>801</c:v>
                </c:pt>
                <c:pt idx="356">
                  <c:v>802</c:v>
                </c:pt>
                <c:pt idx="357">
                  <c:v>803</c:v>
                </c:pt>
                <c:pt idx="358">
                  <c:v>804</c:v>
                </c:pt>
                <c:pt idx="359">
                  <c:v>805</c:v>
                </c:pt>
                <c:pt idx="360">
                  <c:v>806</c:v>
                </c:pt>
                <c:pt idx="361">
                  <c:v>807</c:v>
                </c:pt>
                <c:pt idx="362">
                  <c:v>808</c:v>
                </c:pt>
                <c:pt idx="363">
                  <c:v>811</c:v>
                </c:pt>
                <c:pt idx="364">
                  <c:v>812</c:v>
                </c:pt>
                <c:pt idx="365">
                  <c:v>813</c:v>
                </c:pt>
                <c:pt idx="366">
                  <c:v>814</c:v>
                </c:pt>
                <c:pt idx="367">
                  <c:v>815</c:v>
                </c:pt>
                <c:pt idx="368">
                  <c:v>816</c:v>
                </c:pt>
                <c:pt idx="369">
                  <c:v>817</c:v>
                </c:pt>
                <c:pt idx="370">
                  <c:v>818</c:v>
                </c:pt>
                <c:pt idx="371">
                  <c:v>819</c:v>
                </c:pt>
                <c:pt idx="372">
                  <c:v>820</c:v>
                </c:pt>
                <c:pt idx="373">
                  <c:v>821</c:v>
                </c:pt>
                <c:pt idx="374">
                  <c:v>822</c:v>
                </c:pt>
                <c:pt idx="375">
                  <c:v>823</c:v>
                </c:pt>
                <c:pt idx="376">
                  <c:v>825</c:v>
                </c:pt>
                <c:pt idx="377">
                  <c:v>826</c:v>
                </c:pt>
                <c:pt idx="378">
                  <c:v>827</c:v>
                </c:pt>
                <c:pt idx="379">
                  <c:v>828</c:v>
                </c:pt>
                <c:pt idx="380">
                  <c:v>829</c:v>
                </c:pt>
                <c:pt idx="381">
                  <c:v>830</c:v>
                </c:pt>
                <c:pt idx="382">
                  <c:v>831</c:v>
                </c:pt>
                <c:pt idx="383">
                  <c:v>832</c:v>
                </c:pt>
                <c:pt idx="384">
                  <c:v>834</c:v>
                </c:pt>
                <c:pt idx="385">
                  <c:v>836</c:v>
                </c:pt>
                <c:pt idx="386">
                  <c:v>837</c:v>
                </c:pt>
                <c:pt idx="387">
                  <c:v>838</c:v>
                </c:pt>
                <c:pt idx="388">
                  <c:v>839</c:v>
                </c:pt>
                <c:pt idx="389">
                  <c:v>840</c:v>
                </c:pt>
                <c:pt idx="390">
                  <c:v>842</c:v>
                </c:pt>
                <c:pt idx="391">
                  <c:v>843</c:v>
                </c:pt>
                <c:pt idx="392">
                  <c:v>844</c:v>
                </c:pt>
                <c:pt idx="393">
                  <c:v>845</c:v>
                </c:pt>
                <c:pt idx="394">
                  <c:v>846</c:v>
                </c:pt>
                <c:pt idx="395">
                  <c:v>847</c:v>
                </c:pt>
                <c:pt idx="396">
                  <c:v>848</c:v>
                </c:pt>
                <c:pt idx="397">
                  <c:v>849</c:v>
                </c:pt>
                <c:pt idx="398">
                  <c:v>850</c:v>
                </c:pt>
                <c:pt idx="399">
                  <c:v>851</c:v>
                </c:pt>
                <c:pt idx="400">
                  <c:v>853</c:v>
                </c:pt>
                <c:pt idx="401">
                  <c:v>854</c:v>
                </c:pt>
                <c:pt idx="402">
                  <c:v>855</c:v>
                </c:pt>
                <c:pt idx="403">
                  <c:v>856</c:v>
                </c:pt>
                <c:pt idx="404">
                  <c:v>857</c:v>
                </c:pt>
                <c:pt idx="405">
                  <c:v>859</c:v>
                </c:pt>
                <c:pt idx="406">
                  <c:v>860</c:v>
                </c:pt>
                <c:pt idx="407">
                  <c:v>861</c:v>
                </c:pt>
                <c:pt idx="408">
                  <c:v>862</c:v>
                </c:pt>
                <c:pt idx="409">
                  <c:v>863</c:v>
                </c:pt>
                <c:pt idx="410">
                  <c:v>865</c:v>
                </c:pt>
                <c:pt idx="411">
                  <c:v>867</c:v>
                </c:pt>
                <c:pt idx="412">
                  <c:v>868</c:v>
                </c:pt>
                <c:pt idx="413">
                  <c:v>869</c:v>
                </c:pt>
                <c:pt idx="414">
                  <c:v>876</c:v>
                </c:pt>
                <c:pt idx="415">
                  <c:v>877</c:v>
                </c:pt>
                <c:pt idx="416">
                  <c:v>882</c:v>
                </c:pt>
                <c:pt idx="417">
                  <c:v>883</c:v>
                </c:pt>
                <c:pt idx="418">
                  <c:v>885</c:v>
                </c:pt>
                <c:pt idx="419">
                  <c:v>886</c:v>
                </c:pt>
                <c:pt idx="420">
                  <c:v>887</c:v>
                </c:pt>
                <c:pt idx="421">
                  <c:v>888</c:v>
                </c:pt>
                <c:pt idx="422">
                  <c:v>889</c:v>
                </c:pt>
                <c:pt idx="423">
                  <c:v>890</c:v>
                </c:pt>
                <c:pt idx="424">
                  <c:v>891</c:v>
                </c:pt>
                <c:pt idx="425">
                  <c:v>892</c:v>
                </c:pt>
                <c:pt idx="426">
                  <c:v>893</c:v>
                </c:pt>
                <c:pt idx="427">
                  <c:v>895</c:v>
                </c:pt>
                <c:pt idx="428">
                  <c:v>896</c:v>
                </c:pt>
                <c:pt idx="429">
                  <c:v>897</c:v>
                </c:pt>
                <c:pt idx="430">
                  <c:v>898</c:v>
                </c:pt>
                <c:pt idx="431">
                  <c:v>900</c:v>
                </c:pt>
                <c:pt idx="432">
                  <c:v>901</c:v>
                </c:pt>
                <c:pt idx="433">
                  <c:v>902</c:v>
                </c:pt>
                <c:pt idx="434">
                  <c:v>903</c:v>
                </c:pt>
                <c:pt idx="435">
                  <c:v>904</c:v>
                </c:pt>
                <c:pt idx="436">
                  <c:v>905</c:v>
                </c:pt>
                <c:pt idx="437">
                  <c:v>907</c:v>
                </c:pt>
                <c:pt idx="438">
                  <c:v>908</c:v>
                </c:pt>
                <c:pt idx="439">
                  <c:v>909</c:v>
                </c:pt>
                <c:pt idx="440">
                  <c:v>910</c:v>
                </c:pt>
                <c:pt idx="441">
                  <c:v>911</c:v>
                </c:pt>
                <c:pt idx="442">
                  <c:v>912</c:v>
                </c:pt>
                <c:pt idx="443">
                  <c:v>913</c:v>
                </c:pt>
                <c:pt idx="444">
                  <c:v>918</c:v>
                </c:pt>
                <c:pt idx="445">
                  <c:v>919</c:v>
                </c:pt>
                <c:pt idx="446">
                  <c:v>920</c:v>
                </c:pt>
                <c:pt idx="447">
                  <c:v>922</c:v>
                </c:pt>
                <c:pt idx="448">
                  <c:v>923</c:v>
                </c:pt>
                <c:pt idx="449">
                  <c:v>924</c:v>
                </c:pt>
                <c:pt idx="450">
                  <c:v>925</c:v>
                </c:pt>
                <c:pt idx="451">
                  <c:v>926</c:v>
                </c:pt>
                <c:pt idx="452">
                  <c:v>927</c:v>
                </c:pt>
                <c:pt idx="453">
                  <c:v>928</c:v>
                </c:pt>
                <c:pt idx="454">
                  <c:v>929</c:v>
                </c:pt>
                <c:pt idx="455">
                  <c:v>930</c:v>
                </c:pt>
                <c:pt idx="456">
                  <c:v>931</c:v>
                </c:pt>
                <c:pt idx="457">
                  <c:v>934</c:v>
                </c:pt>
                <c:pt idx="458">
                  <c:v>935</c:v>
                </c:pt>
                <c:pt idx="459">
                  <c:v>940</c:v>
                </c:pt>
                <c:pt idx="460">
                  <c:v>941</c:v>
                </c:pt>
                <c:pt idx="461">
                  <c:v>942</c:v>
                </c:pt>
                <c:pt idx="462">
                  <c:v>943</c:v>
                </c:pt>
                <c:pt idx="463">
                  <c:v>944</c:v>
                </c:pt>
                <c:pt idx="464">
                  <c:v>945</c:v>
                </c:pt>
                <c:pt idx="465">
                  <c:v>946</c:v>
                </c:pt>
                <c:pt idx="466">
                  <c:v>947</c:v>
                </c:pt>
                <c:pt idx="467">
                  <c:v>948</c:v>
                </c:pt>
                <c:pt idx="468">
                  <c:v>949</c:v>
                </c:pt>
                <c:pt idx="469">
                  <c:v>950</c:v>
                </c:pt>
                <c:pt idx="470">
                  <c:v>951</c:v>
                </c:pt>
                <c:pt idx="471">
                  <c:v>952</c:v>
                </c:pt>
                <c:pt idx="472">
                  <c:v>954</c:v>
                </c:pt>
                <c:pt idx="473">
                  <c:v>955</c:v>
                </c:pt>
                <c:pt idx="474">
                  <c:v>956</c:v>
                </c:pt>
                <c:pt idx="475">
                  <c:v>961</c:v>
                </c:pt>
                <c:pt idx="476">
                  <c:v>964</c:v>
                </c:pt>
                <c:pt idx="477">
                  <c:v>965</c:v>
                </c:pt>
                <c:pt idx="478">
                  <c:v>966</c:v>
                </c:pt>
                <c:pt idx="479">
                  <c:v>969</c:v>
                </c:pt>
                <c:pt idx="480">
                  <c:v>970</c:v>
                </c:pt>
                <c:pt idx="481">
                  <c:v>973</c:v>
                </c:pt>
                <c:pt idx="482">
                  <c:v>974</c:v>
                </c:pt>
                <c:pt idx="483">
                  <c:v>975</c:v>
                </c:pt>
                <c:pt idx="484">
                  <c:v>977</c:v>
                </c:pt>
                <c:pt idx="485">
                  <c:v>978</c:v>
                </c:pt>
                <c:pt idx="486">
                  <c:v>979</c:v>
                </c:pt>
                <c:pt idx="487">
                  <c:v>980</c:v>
                </c:pt>
                <c:pt idx="488">
                  <c:v>983</c:v>
                </c:pt>
                <c:pt idx="489">
                  <c:v>984</c:v>
                </c:pt>
                <c:pt idx="490">
                  <c:v>986</c:v>
                </c:pt>
                <c:pt idx="491">
                  <c:v>987</c:v>
                </c:pt>
                <c:pt idx="492">
                  <c:v>988</c:v>
                </c:pt>
                <c:pt idx="493">
                  <c:v>989</c:v>
                </c:pt>
                <c:pt idx="494">
                  <c:v>990</c:v>
                </c:pt>
                <c:pt idx="495">
                  <c:v>991</c:v>
                </c:pt>
                <c:pt idx="496">
                  <c:v>992</c:v>
                </c:pt>
                <c:pt idx="497">
                  <c:v>994</c:v>
                </c:pt>
                <c:pt idx="498">
                  <c:v>995</c:v>
                </c:pt>
                <c:pt idx="499">
                  <c:v>996</c:v>
                </c:pt>
                <c:pt idx="500">
                  <c:v>997</c:v>
                </c:pt>
                <c:pt idx="501">
                  <c:v>998</c:v>
                </c:pt>
                <c:pt idx="502">
                  <c:v>999</c:v>
                </c:pt>
                <c:pt idx="503">
                  <c:v>1000</c:v>
                </c:pt>
                <c:pt idx="504">
                  <c:v>1001</c:v>
                </c:pt>
                <c:pt idx="505">
                  <c:v>1002</c:v>
                </c:pt>
                <c:pt idx="506">
                  <c:v>1003</c:v>
                </c:pt>
                <c:pt idx="507">
                  <c:v>1004</c:v>
                </c:pt>
                <c:pt idx="508">
                  <c:v>1005</c:v>
                </c:pt>
                <c:pt idx="509">
                  <c:v>1006</c:v>
                </c:pt>
                <c:pt idx="510">
                  <c:v>1008</c:v>
                </c:pt>
                <c:pt idx="511">
                  <c:v>1009</c:v>
                </c:pt>
                <c:pt idx="512">
                  <c:v>1010</c:v>
                </c:pt>
                <c:pt idx="513">
                  <c:v>1011</c:v>
                </c:pt>
                <c:pt idx="514">
                  <c:v>1012</c:v>
                </c:pt>
                <c:pt idx="515">
                  <c:v>1013</c:v>
                </c:pt>
                <c:pt idx="516">
                  <c:v>1015</c:v>
                </c:pt>
                <c:pt idx="517">
                  <c:v>1020</c:v>
                </c:pt>
                <c:pt idx="518">
                  <c:v>1021</c:v>
                </c:pt>
                <c:pt idx="519">
                  <c:v>1022</c:v>
                </c:pt>
                <c:pt idx="520">
                  <c:v>1023</c:v>
                </c:pt>
                <c:pt idx="521">
                  <c:v>1024</c:v>
                </c:pt>
                <c:pt idx="522">
                  <c:v>1025</c:v>
                </c:pt>
                <c:pt idx="523">
                  <c:v>1027</c:v>
                </c:pt>
                <c:pt idx="524">
                  <c:v>1031</c:v>
                </c:pt>
                <c:pt idx="525">
                  <c:v>1032</c:v>
                </c:pt>
                <c:pt idx="526">
                  <c:v>1033</c:v>
                </c:pt>
                <c:pt idx="527">
                  <c:v>1034</c:v>
                </c:pt>
                <c:pt idx="528">
                  <c:v>1035</c:v>
                </c:pt>
                <c:pt idx="529">
                  <c:v>1037</c:v>
                </c:pt>
                <c:pt idx="530">
                  <c:v>1039</c:v>
                </c:pt>
                <c:pt idx="531">
                  <c:v>1040</c:v>
                </c:pt>
                <c:pt idx="532">
                  <c:v>1041</c:v>
                </c:pt>
                <c:pt idx="533">
                  <c:v>1043</c:v>
                </c:pt>
                <c:pt idx="534">
                  <c:v>1044</c:v>
                </c:pt>
                <c:pt idx="535">
                  <c:v>1045</c:v>
                </c:pt>
                <c:pt idx="536">
                  <c:v>1046</c:v>
                </c:pt>
                <c:pt idx="537">
                  <c:v>1047</c:v>
                </c:pt>
                <c:pt idx="538">
                  <c:v>1048</c:v>
                </c:pt>
                <c:pt idx="539">
                  <c:v>1049</c:v>
                </c:pt>
                <c:pt idx="540">
                  <c:v>1050</c:v>
                </c:pt>
                <c:pt idx="541">
                  <c:v>1051</c:v>
                </c:pt>
                <c:pt idx="542">
                  <c:v>1052</c:v>
                </c:pt>
                <c:pt idx="543">
                  <c:v>1053</c:v>
                </c:pt>
                <c:pt idx="544">
                  <c:v>1054</c:v>
                </c:pt>
                <c:pt idx="545">
                  <c:v>1055</c:v>
                </c:pt>
                <c:pt idx="546">
                  <c:v>1057</c:v>
                </c:pt>
                <c:pt idx="547">
                  <c:v>1059</c:v>
                </c:pt>
                <c:pt idx="548">
                  <c:v>1060</c:v>
                </c:pt>
                <c:pt idx="549">
                  <c:v>1061</c:v>
                </c:pt>
                <c:pt idx="550">
                  <c:v>1062</c:v>
                </c:pt>
                <c:pt idx="551">
                  <c:v>1063</c:v>
                </c:pt>
                <c:pt idx="552">
                  <c:v>1064</c:v>
                </c:pt>
                <c:pt idx="553">
                  <c:v>1065</c:v>
                </c:pt>
                <c:pt idx="554">
                  <c:v>1066</c:v>
                </c:pt>
                <c:pt idx="555">
                  <c:v>1067</c:v>
                </c:pt>
                <c:pt idx="556">
                  <c:v>1068</c:v>
                </c:pt>
                <c:pt idx="557">
                  <c:v>1069</c:v>
                </c:pt>
                <c:pt idx="558">
                  <c:v>1070</c:v>
                </c:pt>
                <c:pt idx="559">
                  <c:v>1072</c:v>
                </c:pt>
                <c:pt idx="560">
                  <c:v>1073</c:v>
                </c:pt>
                <c:pt idx="561">
                  <c:v>1074</c:v>
                </c:pt>
                <c:pt idx="562">
                  <c:v>1077</c:v>
                </c:pt>
                <c:pt idx="563">
                  <c:v>1080</c:v>
                </c:pt>
                <c:pt idx="564">
                  <c:v>1081</c:v>
                </c:pt>
                <c:pt idx="565">
                  <c:v>1082</c:v>
                </c:pt>
                <c:pt idx="566">
                  <c:v>1083</c:v>
                </c:pt>
                <c:pt idx="567">
                  <c:v>1084</c:v>
                </c:pt>
                <c:pt idx="568">
                  <c:v>1085</c:v>
                </c:pt>
                <c:pt idx="569">
                  <c:v>1090</c:v>
                </c:pt>
                <c:pt idx="570">
                  <c:v>1091</c:v>
                </c:pt>
                <c:pt idx="571">
                  <c:v>1092</c:v>
                </c:pt>
                <c:pt idx="572">
                  <c:v>1093</c:v>
                </c:pt>
                <c:pt idx="573">
                  <c:v>1094</c:v>
                </c:pt>
                <c:pt idx="574">
                  <c:v>1099</c:v>
                </c:pt>
                <c:pt idx="575">
                  <c:v>1100</c:v>
                </c:pt>
                <c:pt idx="576">
                  <c:v>1101</c:v>
                </c:pt>
                <c:pt idx="577">
                  <c:v>1102</c:v>
                </c:pt>
                <c:pt idx="578">
                  <c:v>1103</c:v>
                </c:pt>
                <c:pt idx="579">
                  <c:v>1104</c:v>
                </c:pt>
                <c:pt idx="580">
                  <c:v>1105</c:v>
                </c:pt>
                <c:pt idx="581">
                  <c:v>1106</c:v>
                </c:pt>
                <c:pt idx="582">
                  <c:v>1107</c:v>
                </c:pt>
                <c:pt idx="583">
                  <c:v>1108</c:v>
                </c:pt>
                <c:pt idx="584">
                  <c:v>1110</c:v>
                </c:pt>
                <c:pt idx="585">
                  <c:v>1111</c:v>
                </c:pt>
                <c:pt idx="586">
                  <c:v>1112</c:v>
                </c:pt>
                <c:pt idx="587">
                  <c:v>1113</c:v>
                </c:pt>
                <c:pt idx="588">
                  <c:v>1114</c:v>
                </c:pt>
                <c:pt idx="589">
                  <c:v>1115</c:v>
                </c:pt>
                <c:pt idx="590">
                  <c:v>1116</c:v>
                </c:pt>
                <c:pt idx="591">
                  <c:v>1118</c:v>
                </c:pt>
                <c:pt idx="592">
                  <c:v>1119</c:v>
                </c:pt>
                <c:pt idx="593">
                  <c:v>1120</c:v>
                </c:pt>
                <c:pt idx="594">
                  <c:v>1121</c:v>
                </c:pt>
                <c:pt idx="595">
                  <c:v>1122</c:v>
                </c:pt>
                <c:pt idx="596">
                  <c:v>1123</c:v>
                </c:pt>
                <c:pt idx="597">
                  <c:v>1124</c:v>
                </c:pt>
                <c:pt idx="598">
                  <c:v>1130</c:v>
                </c:pt>
                <c:pt idx="599">
                  <c:v>1131</c:v>
                </c:pt>
                <c:pt idx="600">
                  <c:v>1132</c:v>
                </c:pt>
                <c:pt idx="601">
                  <c:v>1133</c:v>
                </c:pt>
                <c:pt idx="602">
                  <c:v>1134</c:v>
                </c:pt>
                <c:pt idx="603">
                  <c:v>1135</c:v>
                </c:pt>
                <c:pt idx="604">
                  <c:v>1136</c:v>
                </c:pt>
                <c:pt idx="605">
                  <c:v>1137</c:v>
                </c:pt>
                <c:pt idx="606">
                  <c:v>1138</c:v>
                </c:pt>
                <c:pt idx="607">
                  <c:v>1139</c:v>
                </c:pt>
                <c:pt idx="608">
                  <c:v>1140</c:v>
                </c:pt>
                <c:pt idx="609">
                  <c:v>1141</c:v>
                </c:pt>
                <c:pt idx="610">
                  <c:v>1142</c:v>
                </c:pt>
                <c:pt idx="611">
                  <c:v>1143</c:v>
                </c:pt>
                <c:pt idx="612">
                  <c:v>1145</c:v>
                </c:pt>
                <c:pt idx="613">
                  <c:v>1146</c:v>
                </c:pt>
                <c:pt idx="614">
                  <c:v>1147</c:v>
                </c:pt>
                <c:pt idx="615">
                  <c:v>1148</c:v>
                </c:pt>
                <c:pt idx="616">
                  <c:v>1149</c:v>
                </c:pt>
                <c:pt idx="617">
                  <c:v>1150</c:v>
                </c:pt>
                <c:pt idx="618">
                  <c:v>1151</c:v>
                </c:pt>
                <c:pt idx="619">
                  <c:v>1153</c:v>
                </c:pt>
                <c:pt idx="620">
                  <c:v>1154</c:v>
                </c:pt>
                <c:pt idx="621">
                  <c:v>1155</c:v>
                </c:pt>
                <c:pt idx="622">
                  <c:v>1156</c:v>
                </c:pt>
                <c:pt idx="623">
                  <c:v>1157</c:v>
                </c:pt>
                <c:pt idx="624">
                  <c:v>1158</c:v>
                </c:pt>
                <c:pt idx="625">
                  <c:v>1159</c:v>
                </c:pt>
                <c:pt idx="626">
                  <c:v>1160</c:v>
                </c:pt>
                <c:pt idx="627">
                  <c:v>1161</c:v>
                </c:pt>
                <c:pt idx="628">
                  <c:v>1162</c:v>
                </c:pt>
                <c:pt idx="629">
                  <c:v>1165</c:v>
                </c:pt>
                <c:pt idx="630">
                  <c:v>1166</c:v>
                </c:pt>
                <c:pt idx="631">
                  <c:v>1167</c:v>
                </c:pt>
                <c:pt idx="632">
                  <c:v>1168</c:v>
                </c:pt>
                <c:pt idx="633">
                  <c:v>1169</c:v>
                </c:pt>
                <c:pt idx="634">
                  <c:v>1170</c:v>
                </c:pt>
                <c:pt idx="635">
                  <c:v>1173</c:v>
                </c:pt>
                <c:pt idx="636">
                  <c:v>1174</c:v>
                </c:pt>
                <c:pt idx="637">
                  <c:v>1175</c:v>
                </c:pt>
                <c:pt idx="638">
                  <c:v>1180</c:v>
                </c:pt>
                <c:pt idx="639">
                  <c:v>1181</c:v>
                </c:pt>
                <c:pt idx="640">
                  <c:v>1182</c:v>
                </c:pt>
                <c:pt idx="641">
                  <c:v>1183</c:v>
                </c:pt>
                <c:pt idx="642">
                  <c:v>1184</c:v>
                </c:pt>
                <c:pt idx="643">
                  <c:v>1185</c:v>
                </c:pt>
                <c:pt idx="644">
                  <c:v>1186</c:v>
                </c:pt>
                <c:pt idx="645">
                  <c:v>1187</c:v>
                </c:pt>
                <c:pt idx="646">
                  <c:v>1188</c:v>
                </c:pt>
                <c:pt idx="647">
                  <c:v>1189</c:v>
                </c:pt>
                <c:pt idx="648">
                  <c:v>1190</c:v>
                </c:pt>
                <c:pt idx="649">
                  <c:v>1192</c:v>
                </c:pt>
                <c:pt idx="650">
                  <c:v>1193</c:v>
                </c:pt>
                <c:pt idx="651">
                  <c:v>1194</c:v>
                </c:pt>
                <c:pt idx="652">
                  <c:v>1195</c:v>
                </c:pt>
                <c:pt idx="653">
                  <c:v>1197</c:v>
                </c:pt>
                <c:pt idx="654">
                  <c:v>1198</c:v>
                </c:pt>
                <c:pt idx="655">
                  <c:v>1199</c:v>
                </c:pt>
                <c:pt idx="656">
                  <c:v>1200</c:v>
                </c:pt>
                <c:pt idx="657">
                  <c:v>1201</c:v>
                </c:pt>
                <c:pt idx="658">
                  <c:v>1203</c:v>
                </c:pt>
                <c:pt idx="659">
                  <c:v>1204</c:v>
                </c:pt>
                <c:pt idx="660">
                  <c:v>1205</c:v>
                </c:pt>
                <c:pt idx="661">
                  <c:v>1208</c:v>
                </c:pt>
                <c:pt idx="662">
                  <c:v>1209</c:v>
                </c:pt>
                <c:pt idx="663">
                  <c:v>1210</c:v>
                </c:pt>
                <c:pt idx="664">
                  <c:v>1214</c:v>
                </c:pt>
                <c:pt idx="665">
                  <c:v>1215</c:v>
                </c:pt>
                <c:pt idx="666">
                  <c:v>1216</c:v>
                </c:pt>
                <c:pt idx="667">
                  <c:v>1217</c:v>
                </c:pt>
                <c:pt idx="668">
                  <c:v>1220</c:v>
                </c:pt>
                <c:pt idx="669">
                  <c:v>1221</c:v>
                </c:pt>
                <c:pt idx="670">
                  <c:v>1225</c:v>
                </c:pt>
                <c:pt idx="671">
                  <c:v>1229</c:v>
                </c:pt>
                <c:pt idx="672">
                  <c:v>1231</c:v>
                </c:pt>
                <c:pt idx="673">
                  <c:v>1232</c:v>
                </c:pt>
                <c:pt idx="674">
                  <c:v>1242</c:v>
                </c:pt>
                <c:pt idx="675">
                  <c:v>1253</c:v>
                </c:pt>
                <c:pt idx="676">
                  <c:v>1255</c:v>
                </c:pt>
                <c:pt idx="677">
                  <c:v>1256</c:v>
                </c:pt>
                <c:pt idx="678">
                  <c:v>1258</c:v>
                </c:pt>
                <c:pt idx="679">
                  <c:v>1259</c:v>
                </c:pt>
                <c:pt idx="680">
                  <c:v>1260</c:v>
                </c:pt>
                <c:pt idx="681">
                  <c:v>1261</c:v>
                </c:pt>
                <c:pt idx="682">
                  <c:v>1262</c:v>
                </c:pt>
                <c:pt idx="683">
                  <c:v>1263</c:v>
                </c:pt>
                <c:pt idx="684">
                  <c:v>1264</c:v>
                </c:pt>
                <c:pt idx="685">
                  <c:v>1266</c:v>
                </c:pt>
                <c:pt idx="686">
                  <c:v>1269</c:v>
                </c:pt>
                <c:pt idx="687">
                  <c:v>1279</c:v>
                </c:pt>
                <c:pt idx="688">
                  <c:v>1280</c:v>
                </c:pt>
                <c:pt idx="689">
                  <c:v>1290</c:v>
                </c:pt>
                <c:pt idx="690">
                  <c:v>1291</c:v>
                </c:pt>
                <c:pt idx="691">
                  <c:v>1292</c:v>
                </c:pt>
                <c:pt idx="692">
                  <c:v>1293</c:v>
                </c:pt>
                <c:pt idx="693">
                  <c:v>1294</c:v>
                </c:pt>
                <c:pt idx="694">
                  <c:v>1295</c:v>
                </c:pt>
                <c:pt idx="695">
                  <c:v>1300</c:v>
                </c:pt>
                <c:pt idx="696">
                  <c:v>1301</c:v>
                </c:pt>
                <c:pt idx="697">
                  <c:v>1302</c:v>
                </c:pt>
                <c:pt idx="698">
                  <c:v>1303</c:v>
                </c:pt>
                <c:pt idx="699">
                  <c:v>1305</c:v>
                </c:pt>
                <c:pt idx="700">
                  <c:v>1306</c:v>
                </c:pt>
                <c:pt idx="701">
                  <c:v>1307</c:v>
                </c:pt>
                <c:pt idx="702">
                  <c:v>1308</c:v>
                </c:pt>
                <c:pt idx="703">
                  <c:v>1310</c:v>
                </c:pt>
                <c:pt idx="704">
                  <c:v>1311</c:v>
                </c:pt>
                <c:pt idx="705">
                  <c:v>1312</c:v>
                </c:pt>
                <c:pt idx="706">
                  <c:v>1313</c:v>
                </c:pt>
                <c:pt idx="707">
                  <c:v>1314</c:v>
                </c:pt>
                <c:pt idx="708">
                  <c:v>1315</c:v>
                </c:pt>
                <c:pt idx="709">
                  <c:v>1316</c:v>
                </c:pt>
                <c:pt idx="710">
                  <c:v>1317</c:v>
                </c:pt>
                <c:pt idx="711">
                  <c:v>1318</c:v>
                </c:pt>
                <c:pt idx="712">
                  <c:v>1319</c:v>
                </c:pt>
                <c:pt idx="713">
                  <c:v>1320</c:v>
                </c:pt>
                <c:pt idx="714">
                  <c:v>1322</c:v>
                </c:pt>
                <c:pt idx="715">
                  <c:v>1323</c:v>
                </c:pt>
                <c:pt idx="716">
                  <c:v>1324</c:v>
                </c:pt>
                <c:pt idx="717">
                  <c:v>1325</c:v>
                </c:pt>
                <c:pt idx="718">
                  <c:v>1326</c:v>
                </c:pt>
                <c:pt idx="719">
                  <c:v>1327</c:v>
                </c:pt>
                <c:pt idx="720">
                  <c:v>1328</c:v>
                </c:pt>
                <c:pt idx="721">
                  <c:v>1329</c:v>
                </c:pt>
                <c:pt idx="722">
                  <c:v>1331</c:v>
                </c:pt>
                <c:pt idx="723">
                  <c:v>1333</c:v>
                </c:pt>
                <c:pt idx="724">
                  <c:v>1337</c:v>
                </c:pt>
                <c:pt idx="725">
                  <c:v>1338</c:v>
                </c:pt>
                <c:pt idx="726">
                  <c:v>1339</c:v>
                </c:pt>
                <c:pt idx="727">
                  <c:v>1342</c:v>
                </c:pt>
                <c:pt idx="728">
                  <c:v>1343</c:v>
                </c:pt>
                <c:pt idx="729">
                  <c:v>1344</c:v>
                </c:pt>
                <c:pt idx="730">
                  <c:v>1345</c:v>
                </c:pt>
                <c:pt idx="731">
                  <c:v>1346</c:v>
                </c:pt>
                <c:pt idx="732">
                  <c:v>1348</c:v>
                </c:pt>
                <c:pt idx="733">
                  <c:v>1349</c:v>
                </c:pt>
                <c:pt idx="734">
                  <c:v>1353</c:v>
                </c:pt>
                <c:pt idx="735">
                  <c:v>1355</c:v>
                </c:pt>
                <c:pt idx="736">
                  <c:v>1360</c:v>
                </c:pt>
                <c:pt idx="737">
                  <c:v>1361</c:v>
                </c:pt>
                <c:pt idx="738">
                  <c:v>1363</c:v>
                </c:pt>
                <c:pt idx="739">
                  <c:v>1364</c:v>
                </c:pt>
                <c:pt idx="740">
                  <c:v>1365</c:v>
                </c:pt>
                <c:pt idx="741">
                  <c:v>1366</c:v>
                </c:pt>
                <c:pt idx="742">
                  <c:v>1367</c:v>
                </c:pt>
                <c:pt idx="743">
                  <c:v>1369</c:v>
                </c:pt>
                <c:pt idx="744">
                  <c:v>1372</c:v>
                </c:pt>
                <c:pt idx="745">
                  <c:v>1373</c:v>
                </c:pt>
                <c:pt idx="746">
                  <c:v>1374</c:v>
                </c:pt>
                <c:pt idx="747">
                  <c:v>1375</c:v>
                </c:pt>
                <c:pt idx="748">
                  <c:v>1376</c:v>
                </c:pt>
                <c:pt idx="749">
                  <c:v>1377</c:v>
                </c:pt>
                <c:pt idx="750">
                  <c:v>1378</c:v>
                </c:pt>
                <c:pt idx="751">
                  <c:v>1379</c:v>
                </c:pt>
                <c:pt idx="752">
                  <c:v>1380</c:v>
                </c:pt>
                <c:pt idx="753">
                  <c:v>1381</c:v>
                </c:pt>
                <c:pt idx="754">
                  <c:v>1383</c:v>
                </c:pt>
                <c:pt idx="755">
                  <c:v>1384</c:v>
                </c:pt>
                <c:pt idx="756">
                  <c:v>1385</c:v>
                </c:pt>
                <c:pt idx="757">
                  <c:v>1386</c:v>
                </c:pt>
                <c:pt idx="758">
                  <c:v>1390</c:v>
                </c:pt>
                <c:pt idx="759">
                  <c:v>1391</c:v>
                </c:pt>
                <c:pt idx="760">
                  <c:v>1392</c:v>
                </c:pt>
                <c:pt idx="761">
                  <c:v>1393</c:v>
                </c:pt>
                <c:pt idx="762">
                  <c:v>1394</c:v>
                </c:pt>
                <c:pt idx="763">
                  <c:v>1395</c:v>
                </c:pt>
                <c:pt idx="764">
                  <c:v>1396</c:v>
                </c:pt>
                <c:pt idx="765">
                  <c:v>1397</c:v>
                </c:pt>
                <c:pt idx="766">
                  <c:v>1398</c:v>
                </c:pt>
                <c:pt idx="767">
                  <c:v>1400</c:v>
                </c:pt>
                <c:pt idx="768">
                  <c:v>1401</c:v>
                </c:pt>
                <c:pt idx="769">
                  <c:v>1402</c:v>
                </c:pt>
                <c:pt idx="770">
                  <c:v>1403</c:v>
                </c:pt>
                <c:pt idx="771">
                  <c:v>1405</c:v>
                </c:pt>
                <c:pt idx="772">
                  <c:v>1407</c:v>
                </c:pt>
                <c:pt idx="773">
                  <c:v>1408</c:v>
                </c:pt>
                <c:pt idx="774">
                  <c:v>1410</c:v>
                </c:pt>
                <c:pt idx="775">
                  <c:v>1411</c:v>
                </c:pt>
                <c:pt idx="776">
                  <c:v>1412</c:v>
                </c:pt>
                <c:pt idx="777">
                  <c:v>1413</c:v>
                </c:pt>
                <c:pt idx="778">
                  <c:v>1414</c:v>
                </c:pt>
                <c:pt idx="779">
                  <c:v>1415</c:v>
                </c:pt>
                <c:pt idx="780">
                  <c:v>1416</c:v>
                </c:pt>
                <c:pt idx="781">
                  <c:v>1417</c:v>
                </c:pt>
                <c:pt idx="782">
                  <c:v>1418</c:v>
                </c:pt>
                <c:pt idx="783">
                  <c:v>1419</c:v>
                </c:pt>
                <c:pt idx="784">
                  <c:v>1420</c:v>
                </c:pt>
                <c:pt idx="785">
                  <c:v>1421</c:v>
                </c:pt>
                <c:pt idx="786">
                  <c:v>1423</c:v>
                </c:pt>
                <c:pt idx="787">
                  <c:v>1424</c:v>
                </c:pt>
                <c:pt idx="788">
                  <c:v>1425</c:v>
                </c:pt>
                <c:pt idx="789">
                  <c:v>1426</c:v>
                </c:pt>
                <c:pt idx="790">
                  <c:v>1427</c:v>
                </c:pt>
                <c:pt idx="791">
                  <c:v>1428</c:v>
                </c:pt>
                <c:pt idx="792">
                  <c:v>1429</c:v>
                </c:pt>
                <c:pt idx="793">
                  <c:v>1430</c:v>
                </c:pt>
                <c:pt idx="794">
                  <c:v>1432</c:v>
                </c:pt>
                <c:pt idx="795">
                  <c:v>1434</c:v>
                </c:pt>
                <c:pt idx="796">
                  <c:v>1435</c:v>
                </c:pt>
                <c:pt idx="797">
                  <c:v>1436</c:v>
                </c:pt>
                <c:pt idx="798">
                  <c:v>1437</c:v>
                </c:pt>
                <c:pt idx="799">
                  <c:v>1439</c:v>
                </c:pt>
                <c:pt idx="800">
                  <c:v>1440</c:v>
                </c:pt>
                <c:pt idx="801">
                  <c:v>1442</c:v>
                </c:pt>
                <c:pt idx="802">
                  <c:v>1443</c:v>
                </c:pt>
                <c:pt idx="803">
                  <c:v>1444</c:v>
                </c:pt>
                <c:pt idx="804">
                  <c:v>1445</c:v>
                </c:pt>
                <c:pt idx="805">
                  <c:v>1446</c:v>
                </c:pt>
                <c:pt idx="806">
                  <c:v>1447</c:v>
                </c:pt>
                <c:pt idx="807">
                  <c:v>1448</c:v>
                </c:pt>
                <c:pt idx="808">
                  <c:v>1449</c:v>
                </c:pt>
                <c:pt idx="809">
                  <c:v>1450</c:v>
                </c:pt>
                <c:pt idx="810">
                  <c:v>1451</c:v>
                </c:pt>
                <c:pt idx="811">
                  <c:v>1453</c:v>
                </c:pt>
                <c:pt idx="812">
                  <c:v>1454</c:v>
                </c:pt>
                <c:pt idx="813">
                  <c:v>1455</c:v>
                </c:pt>
                <c:pt idx="814">
                  <c:v>1456</c:v>
                </c:pt>
                <c:pt idx="815">
                  <c:v>1457</c:v>
                </c:pt>
                <c:pt idx="816">
                  <c:v>1458</c:v>
                </c:pt>
                <c:pt idx="817">
                  <c:v>1459</c:v>
                </c:pt>
                <c:pt idx="818">
                  <c:v>1460</c:v>
                </c:pt>
                <c:pt idx="819">
                  <c:v>1461</c:v>
                </c:pt>
                <c:pt idx="820">
                  <c:v>1462</c:v>
                </c:pt>
                <c:pt idx="821">
                  <c:v>1463</c:v>
                </c:pt>
                <c:pt idx="822">
                  <c:v>1464</c:v>
                </c:pt>
                <c:pt idx="823">
                  <c:v>1465</c:v>
                </c:pt>
                <c:pt idx="824">
                  <c:v>1466</c:v>
                </c:pt>
                <c:pt idx="825">
                  <c:v>1467</c:v>
                </c:pt>
                <c:pt idx="826">
                  <c:v>1468</c:v>
                </c:pt>
                <c:pt idx="827">
                  <c:v>1469</c:v>
                </c:pt>
                <c:pt idx="828">
                  <c:v>1470</c:v>
                </c:pt>
                <c:pt idx="829">
                  <c:v>1471</c:v>
                </c:pt>
                <c:pt idx="830">
                  <c:v>1472</c:v>
                </c:pt>
                <c:pt idx="831">
                  <c:v>1473</c:v>
                </c:pt>
                <c:pt idx="832">
                  <c:v>1474</c:v>
                </c:pt>
                <c:pt idx="833">
                  <c:v>1475</c:v>
                </c:pt>
                <c:pt idx="834">
                  <c:v>1476</c:v>
                </c:pt>
                <c:pt idx="835">
                  <c:v>1477</c:v>
                </c:pt>
                <c:pt idx="836">
                  <c:v>1478</c:v>
                </c:pt>
                <c:pt idx="837">
                  <c:v>1479</c:v>
                </c:pt>
                <c:pt idx="838">
                  <c:v>1480</c:v>
                </c:pt>
                <c:pt idx="839">
                  <c:v>1481</c:v>
                </c:pt>
                <c:pt idx="840">
                  <c:v>1482</c:v>
                </c:pt>
                <c:pt idx="841">
                  <c:v>1483</c:v>
                </c:pt>
                <c:pt idx="842">
                  <c:v>1484</c:v>
                </c:pt>
                <c:pt idx="843">
                  <c:v>1485</c:v>
                </c:pt>
                <c:pt idx="844">
                  <c:v>1486</c:v>
                </c:pt>
                <c:pt idx="845">
                  <c:v>1487</c:v>
                </c:pt>
                <c:pt idx="846">
                  <c:v>1488</c:v>
                </c:pt>
                <c:pt idx="847">
                  <c:v>1489</c:v>
                </c:pt>
                <c:pt idx="848">
                  <c:v>1490</c:v>
                </c:pt>
                <c:pt idx="849">
                  <c:v>1491</c:v>
                </c:pt>
                <c:pt idx="850">
                  <c:v>1492</c:v>
                </c:pt>
                <c:pt idx="851">
                  <c:v>1493</c:v>
                </c:pt>
                <c:pt idx="852">
                  <c:v>1494</c:v>
                </c:pt>
                <c:pt idx="853">
                  <c:v>1495</c:v>
                </c:pt>
                <c:pt idx="854">
                  <c:v>1496</c:v>
                </c:pt>
                <c:pt idx="855">
                  <c:v>1497</c:v>
                </c:pt>
                <c:pt idx="856">
                  <c:v>1498</c:v>
                </c:pt>
                <c:pt idx="857">
                  <c:v>1499</c:v>
                </c:pt>
                <c:pt idx="858">
                  <c:v>1500</c:v>
                </c:pt>
                <c:pt idx="859">
                  <c:v>1501</c:v>
                </c:pt>
                <c:pt idx="860">
                  <c:v>1502</c:v>
                </c:pt>
                <c:pt idx="861">
                  <c:v>1503</c:v>
                </c:pt>
                <c:pt idx="862">
                  <c:v>1504</c:v>
                </c:pt>
                <c:pt idx="863">
                  <c:v>1505</c:v>
                </c:pt>
                <c:pt idx="864">
                  <c:v>1506</c:v>
                </c:pt>
                <c:pt idx="865">
                  <c:v>1507</c:v>
                </c:pt>
                <c:pt idx="866">
                  <c:v>1509</c:v>
                </c:pt>
                <c:pt idx="867">
                  <c:v>1510</c:v>
                </c:pt>
                <c:pt idx="868">
                  <c:v>1511</c:v>
                </c:pt>
                <c:pt idx="869">
                  <c:v>1512</c:v>
                </c:pt>
                <c:pt idx="870">
                  <c:v>1514</c:v>
                </c:pt>
                <c:pt idx="871">
                  <c:v>1515</c:v>
                </c:pt>
                <c:pt idx="872">
                  <c:v>1516</c:v>
                </c:pt>
                <c:pt idx="873">
                  <c:v>1517</c:v>
                </c:pt>
                <c:pt idx="874">
                  <c:v>1518</c:v>
                </c:pt>
                <c:pt idx="875">
                  <c:v>1519</c:v>
                </c:pt>
                <c:pt idx="876">
                  <c:v>1520</c:v>
                </c:pt>
                <c:pt idx="877">
                  <c:v>1521</c:v>
                </c:pt>
                <c:pt idx="878">
                  <c:v>1522</c:v>
                </c:pt>
                <c:pt idx="879">
                  <c:v>1523</c:v>
                </c:pt>
                <c:pt idx="880">
                  <c:v>1524</c:v>
                </c:pt>
                <c:pt idx="881">
                  <c:v>1525</c:v>
                </c:pt>
                <c:pt idx="882">
                  <c:v>1526</c:v>
                </c:pt>
                <c:pt idx="883">
                  <c:v>1527</c:v>
                </c:pt>
                <c:pt idx="884">
                  <c:v>1528</c:v>
                </c:pt>
                <c:pt idx="885">
                  <c:v>1529</c:v>
                </c:pt>
                <c:pt idx="886">
                  <c:v>1530</c:v>
                </c:pt>
                <c:pt idx="887">
                  <c:v>1531</c:v>
                </c:pt>
                <c:pt idx="888">
                  <c:v>1532</c:v>
                </c:pt>
                <c:pt idx="889">
                  <c:v>1533</c:v>
                </c:pt>
                <c:pt idx="890">
                  <c:v>1534</c:v>
                </c:pt>
                <c:pt idx="891">
                  <c:v>1535</c:v>
                </c:pt>
                <c:pt idx="892">
                  <c:v>1536</c:v>
                </c:pt>
                <c:pt idx="893">
                  <c:v>1537</c:v>
                </c:pt>
                <c:pt idx="894">
                  <c:v>1538</c:v>
                </c:pt>
                <c:pt idx="895">
                  <c:v>1539</c:v>
                </c:pt>
                <c:pt idx="896">
                  <c:v>1540</c:v>
                </c:pt>
                <c:pt idx="897">
                  <c:v>1541</c:v>
                </c:pt>
                <c:pt idx="898">
                  <c:v>1542</c:v>
                </c:pt>
                <c:pt idx="899">
                  <c:v>1543</c:v>
                </c:pt>
                <c:pt idx="900">
                  <c:v>1544</c:v>
                </c:pt>
                <c:pt idx="901">
                  <c:v>1545</c:v>
                </c:pt>
                <c:pt idx="902">
                  <c:v>1546</c:v>
                </c:pt>
                <c:pt idx="903">
                  <c:v>1547</c:v>
                </c:pt>
                <c:pt idx="904">
                  <c:v>1548</c:v>
                </c:pt>
                <c:pt idx="905">
                  <c:v>1549</c:v>
                </c:pt>
                <c:pt idx="906">
                  <c:v>1550</c:v>
                </c:pt>
                <c:pt idx="907">
                  <c:v>1551</c:v>
                </c:pt>
                <c:pt idx="908">
                  <c:v>1552</c:v>
                </c:pt>
                <c:pt idx="909">
                  <c:v>1553</c:v>
                </c:pt>
                <c:pt idx="910">
                  <c:v>1554</c:v>
                </c:pt>
                <c:pt idx="911">
                  <c:v>1555</c:v>
                </c:pt>
                <c:pt idx="912">
                  <c:v>1556</c:v>
                </c:pt>
                <c:pt idx="913">
                  <c:v>1557</c:v>
                </c:pt>
                <c:pt idx="914">
                  <c:v>1558</c:v>
                </c:pt>
                <c:pt idx="915">
                  <c:v>1559</c:v>
                </c:pt>
                <c:pt idx="916">
                  <c:v>1560</c:v>
                </c:pt>
                <c:pt idx="917">
                  <c:v>1561</c:v>
                </c:pt>
                <c:pt idx="918">
                  <c:v>1562</c:v>
                </c:pt>
                <c:pt idx="919">
                  <c:v>1563</c:v>
                </c:pt>
                <c:pt idx="920">
                  <c:v>1564</c:v>
                </c:pt>
                <c:pt idx="921">
                  <c:v>1565</c:v>
                </c:pt>
                <c:pt idx="922">
                  <c:v>1566</c:v>
                </c:pt>
                <c:pt idx="923">
                  <c:v>1567</c:v>
                </c:pt>
                <c:pt idx="924">
                  <c:v>1568</c:v>
                </c:pt>
                <c:pt idx="925">
                  <c:v>1569</c:v>
                </c:pt>
                <c:pt idx="926">
                  <c:v>1570</c:v>
                </c:pt>
                <c:pt idx="927">
                  <c:v>1571</c:v>
                </c:pt>
                <c:pt idx="928">
                  <c:v>1572</c:v>
                </c:pt>
                <c:pt idx="929">
                  <c:v>1573</c:v>
                </c:pt>
                <c:pt idx="930">
                  <c:v>1574</c:v>
                </c:pt>
                <c:pt idx="931">
                  <c:v>1575</c:v>
                </c:pt>
                <c:pt idx="932">
                  <c:v>1576</c:v>
                </c:pt>
                <c:pt idx="933">
                  <c:v>1577</c:v>
                </c:pt>
                <c:pt idx="934">
                  <c:v>1578</c:v>
                </c:pt>
                <c:pt idx="935">
                  <c:v>1579</c:v>
                </c:pt>
                <c:pt idx="936">
                  <c:v>1580</c:v>
                </c:pt>
                <c:pt idx="937">
                  <c:v>1582</c:v>
                </c:pt>
                <c:pt idx="938">
                  <c:v>1583</c:v>
                </c:pt>
                <c:pt idx="939">
                  <c:v>1584</c:v>
                </c:pt>
                <c:pt idx="940">
                  <c:v>1585</c:v>
                </c:pt>
                <c:pt idx="941">
                  <c:v>1586</c:v>
                </c:pt>
                <c:pt idx="942">
                  <c:v>1587</c:v>
                </c:pt>
                <c:pt idx="943">
                  <c:v>1588</c:v>
                </c:pt>
                <c:pt idx="944">
                  <c:v>1589</c:v>
                </c:pt>
                <c:pt idx="945">
                  <c:v>1591</c:v>
                </c:pt>
                <c:pt idx="946">
                  <c:v>1592</c:v>
                </c:pt>
                <c:pt idx="947">
                  <c:v>1593</c:v>
                </c:pt>
                <c:pt idx="948">
                  <c:v>1594</c:v>
                </c:pt>
                <c:pt idx="949">
                  <c:v>1595</c:v>
                </c:pt>
                <c:pt idx="950">
                  <c:v>1596</c:v>
                </c:pt>
                <c:pt idx="951">
                  <c:v>1597</c:v>
                </c:pt>
                <c:pt idx="952">
                  <c:v>1598</c:v>
                </c:pt>
                <c:pt idx="953">
                  <c:v>1599</c:v>
                </c:pt>
                <c:pt idx="954">
                  <c:v>1600</c:v>
                </c:pt>
                <c:pt idx="955">
                  <c:v>1601</c:v>
                </c:pt>
                <c:pt idx="956">
                  <c:v>1602</c:v>
                </c:pt>
                <c:pt idx="957">
                  <c:v>1603</c:v>
                </c:pt>
                <c:pt idx="958">
                  <c:v>1604</c:v>
                </c:pt>
                <c:pt idx="959">
                  <c:v>1605</c:v>
                </c:pt>
                <c:pt idx="960">
                  <c:v>1606</c:v>
                </c:pt>
                <c:pt idx="961">
                  <c:v>1607</c:v>
                </c:pt>
                <c:pt idx="962">
                  <c:v>1608</c:v>
                </c:pt>
                <c:pt idx="963">
                  <c:v>1609</c:v>
                </c:pt>
                <c:pt idx="964">
                  <c:v>1610</c:v>
                </c:pt>
                <c:pt idx="965">
                  <c:v>1611</c:v>
                </c:pt>
                <c:pt idx="966">
                  <c:v>1612</c:v>
                </c:pt>
                <c:pt idx="967">
                  <c:v>1613</c:v>
                </c:pt>
                <c:pt idx="968">
                  <c:v>1614</c:v>
                </c:pt>
                <c:pt idx="969">
                  <c:v>1615</c:v>
                </c:pt>
                <c:pt idx="970">
                  <c:v>1616</c:v>
                </c:pt>
                <c:pt idx="971">
                  <c:v>1617</c:v>
                </c:pt>
                <c:pt idx="972">
                  <c:v>1618</c:v>
                </c:pt>
                <c:pt idx="973">
                  <c:v>1619</c:v>
                </c:pt>
                <c:pt idx="974">
                  <c:v>1620</c:v>
                </c:pt>
                <c:pt idx="975">
                  <c:v>1621</c:v>
                </c:pt>
                <c:pt idx="976">
                  <c:v>1622</c:v>
                </c:pt>
                <c:pt idx="977">
                  <c:v>1623</c:v>
                </c:pt>
                <c:pt idx="978">
                  <c:v>1624</c:v>
                </c:pt>
                <c:pt idx="979">
                  <c:v>1625</c:v>
                </c:pt>
                <c:pt idx="980">
                  <c:v>1626</c:v>
                </c:pt>
                <c:pt idx="981">
                  <c:v>1627</c:v>
                </c:pt>
                <c:pt idx="982">
                  <c:v>1628</c:v>
                </c:pt>
                <c:pt idx="983">
                  <c:v>1629</c:v>
                </c:pt>
                <c:pt idx="984">
                  <c:v>1630</c:v>
                </c:pt>
                <c:pt idx="985">
                  <c:v>1631</c:v>
                </c:pt>
                <c:pt idx="986">
                  <c:v>1632</c:v>
                </c:pt>
                <c:pt idx="987">
                  <c:v>1633</c:v>
                </c:pt>
                <c:pt idx="988">
                  <c:v>1634</c:v>
                </c:pt>
                <c:pt idx="989">
                  <c:v>1635</c:v>
                </c:pt>
                <c:pt idx="990">
                  <c:v>1636</c:v>
                </c:pt>
                <c:pt idx="991">
                  <c:v>1637</c:v>
                </c:pt>
                <c:pt idx="992">
                  <c:v>1638</c:v>
                </c:pt>
                <c:pt idx="993">
                  <c:v>1639</c:v>
                </c:pt>
                <c:pt idx="994">
                  <c:v>1640</c:v>
                </c:pt>
                <c:pt idx="995">
                  <c:v>1641</c:v>
                </c:pt>
                <c:pt idx="996">
                  <c:v>1642</c:v>
                </c:pt>
                <c:pt idx="997">
                  <c:v>1643</c:v>
                </c:pt>
                <c:pt idx="998">
                  <c:v>1644</c:v>
                </c:pt>
                <c:pt idx="999">
                  <c:v>1645</c:v>
                </c:pt>
                <c:pt idx="1000">
                  <c:v>1646</c:v>
                </c:pt>
                <c:pt idx="1001">
                  <c:v>1647</c:v>
                </c:pt>
                <c:pt idx="1002">
                  <c:v>1648</c:v>
                </c:pt>
                <c:pt idx="1003">
                  <c:v>1649</c:v>
                </c:pt>
                <c:pt idx="1004">
                  <c:v>1650</c:v>
                </c:pt>
                <c:pt idx="1005">
                  <c:v>1651</c:v>
                </c:pt>
                <c:pt idx="1006">
                  <c:v>1652</c:v>
                </c:pt>
                <c:pt idx="1007">
                  <c:v>1653</c:v>
                </c:pt>
                <c:pt idx="1008">
                  <c:v>1654</c:v>
                </c:pt>
                <c:pt idx="1009">
                  <c:v>1655</c:v>
                </c:pt>
                <c:pt idx="1010">
                  <c:v>1656</c:v>
                </c:pt>
                <c:pt idx="1011">
                  <c:v>1657</c:v>
                </c:pt>
                <c:pt idx="1012">
                  <c:v>1658</c:v>
                </c:pt>
                <c:pt idx="1013">
                  <c:v>1659</c:v>
                </c:pt>
                <c:pt idx="1014">
                  <c:v>1660</c:v>
                </c:pt>
                <c:pt idx="1015">
                  <c:v>1661</c:v>
                </c:pt>
                <c:pt idx="1016">
                  <c:v>1663</c:v>
                </c:pt>
                <c:pt idx="1017">
                  <c:v>1664</c:v>
                </c:pt>
                <c:pt idx="1018">
                  <c:v>1668</c:v>
                </c:pt>
                <c:pt idx="1019">
                  <c:v>1669</c:v>
                </c:pt>
                <c:pt idx="1020">
                  <c:v>1672</c:v>
                </c:pt>
                <c:pt idx="1021">
                  <c:v>1673</c:v>
                </c:pt>
                <c:pt idx="1022">
                  <c:v>1674</c:v>
                </c:pt>
                <c:pt idx="1023">
                  <c:v>1675</c:v>
                </c:pt>
                <c:pt idx="1024">
                  <c:v>1676</c:v>
                </c:pt>
                <c:pt idx="1025">
                  <c:v>1677</c:v>
                </c:pt>
                <c:pt idx="1026">
                  <c:v>1678</c:v>
                </c:pt>
                <c:pt idx="1027">
                  <c:v>1679</c:v>
                </c:pt>
                <c:pt idx="1028">
                  <c:v>1680</c:v>
                </c:pt>
                <c:pt idx="1029">
                  <c:v>1681</c:v>
                </c:pt>
                <c:pt idx="1030">
                  <c:v>1682</c:v>
                </c:pt>
                <c:pt idx="1031">
                  <c:v>1683</c:v>
                </c:pt>
                <c:pt idx="1032">
                  <c:v>1684</c:v>
                </c:pt>
                <c:pt idx="1033">
                  <c:v>1685</c:v>
                </c:pt>
                <c:pt idx="1034">
                  <c:v>1686</c:v>
                </c:pt>
                <c:pt idx="1035">
                  <c:v>1687</c:v>
                </c:pt>
                <c:pt idx="1036">
                  <c:v>1688</c:v>
                </c:pt>
                <c:pt idx="1037">
                  <c:v>1689</c:v>
                </c:pt>
                <c:pt idx="1038">
                  <c:v>1690</c:v>
                </c:pt>
                <c:pt idx="1039">
                  <c:v>1701</c:v>
                </c:pt>
                <c:pt idx="1040">
                  <c:v>1704</c:v>
                </c:pt>
                <c:pt idx="1041">
                  <c:v>1708</c:v>
                </c:pt>
                <c:pt idx="1042">
                  <c:v>1709</c:v>
                </c:pt>
                <c:pt idx="1043">
                  <c:v>1710</c:v>
                </c:pt>
                <c:pt idx="1044">
                  <c:v>1712</c:v>
                </c:pt>
                <c:pt idx="1045">
                  <c:v>1713</c:v>
                </c:pt>
                <c:pt idx="1046">
                  <c:v>1714</c:v>
                </c:pt>
                <c:pt idx="1047">
                  <c:v>1715</c:v>
                </c:pt>
                <c:pt idx="1048">
                  <c:v>1716</c:v>
                </c:pt>
                <c:pt idx="1049">
                  <c:v>1717</c:v>
                </c:pt>
                <c:pt idx="1050">
                  <c:v>1718</c:v>
                </c:pt>
                <c:pt idx="1051">
                  <c:v>1721</c:v>
                </c:pt>
                <c:pt idx="1052">
                  <c:v>1722</c:v>
                </c:pt>
                <c:pt idx="1053">
                  <c:v>1725</c:v>
                </c:pt>
                <c:pt idx="1054">
                  <c:v>1726</c:v>
                </c:pt>
                <c:pt idx="1055">
                  <c:v>1732</c:v>
                </c:pt>
                <c:pt idx="1056">
                  <c:v>1746</c:v>
                </c:pt>
                <c:pt idx="1057">
                  <c:v>1951</c:v>
                </c:pt>
              </c:numCache>
              <c:extLst xmlns:c15="http://schemas.microsoft.com/office/drawing/2012/chart"/>
            </c:numRef>
          </c:xVal>
          <c:yVal>
            <c:numRef>
              <c:f>'Brachy NFY'!$E$3:$E$1060</c:f>
              <c:numCache>
                <c:formatCode>General</c:formatCode>
                <c:ptCount val="1058"/>
                <c:pt idx="0">
                  <c:v>1</c:v>
                </c:pt>
                <c:pt idx="1">
                  <c:v>1</c:v>
                </c:pt>
                <c:pt idx="2">
                  <c:v>1</c:v>
                </c:pt>
                <c:pt idx="3">
                  <c:v>1</c:v>
                </c:pt>
                <c:pt idx="4">
                  <c:v>1</c:v>
                </c:pt>
                <c:pt idx="5">
                  <c:v>1</c:v>
                </c:pt>
                <c:pt idx="6">
                  <c:v>1</c:v>
                </c:pt>
                <c:pt idx="7">
                  <c:v>1</c:v>
                </c:pt>
                <c:pt idx="8">
                  <c:v>1</c:v>
                </c:pt>
                <c:pt idx="9">
                  <c:v>1</c:v>
                </c:pt>
                <c:pt idx="10">
                  <c:v>1</c:v>
                </c:pt>
                <c:pt idx="12">
                  <c:v>1</c:v>
                </c:pt>
                <c:pt idx="13">
                  <c:v>1</c:v>
                </c:pt>
                <c:pt idx="14">
                  <c:v>1</c:v>
                </c:pt>
                <c:pt idx="15">
                  <c:v>1</c:v>
                </c:pt>
                <c:pt idx="16">
                  <c:v>1</c:v>
                </c:pt>
                <c:pt idx="17">
                  <c:v>1</c:v>
                </c:pt>
                <c:pt idx="18">
                  <c:v>1</c:v>
                </c:pt>
                <c:pt idx="20">
                  <c:v>1</c:v>
                </c:pt>
                <c:pt idx="21">
                  <c:v>1</c:v>
                </c:pt>
                <c:pt idx="22">
                  <c:v>1</c:v>
                </c:pt>
                <c:pt idx="23">
                  <c:v>1</c:v>
                </c:pt>
                <c:pt idx="24">
                  <c:v>1</c:v>
                </c:pt>
                <c:pt idx="25">
                  <c:v>1</c:v>
                </c:pt>
                <c:pt idx="26">
                  <c:v>1</c:v>
                </c:pt>
                <c:pt idx="27">
                  <c:v>1</c:v>
                </c:pt>
                <c:pt idx="28">
                  <c:v>1</c:v>
                </c:pt>
                <c:pt idx="29">
                  <c:v>1</c:v>
                </c:pt>
                <c:pt idx="30">
                  <c:v>1</c:v>
                </c:pt>
                <c:pt idx="31">
                  <c:v>1</c:v>
                </c:pt>
                <c:pt idx="32">
                  <c:v>1</c:v>
                </c:pt>
                <c:pt idx="33">
                  <c:v>1</c:v>
                </c:pt>
                <c:pt idx="34">
                  <c:v>1</c:v>
                </c:pt>
                <c:pt idx="35">
                  <c:v>1</c:v>
                </c:pt>
                <c:pt idx="36">
                  <c:v>1</c:v>
                </c:pt>
                <c:pt idx="37">
                  <c:v>1</c:v>
                </c:pt>
                <c:pt idx="39">
                  <c:v>1</c:v>
                </c:pt>
                <c:pt idx="40">
                  <c:v>1</c:v>
                </c:pt>
                <c:pt idx="41">
                  <c:v>1</c:v>
                </c:pt>
                <c:pt idx="42">
                  <c:v>1</c:v>
                </c:pt>
                <c:pt idx="44">
                  <c:v>1</c:v>
                </c:pt>
                <c:pt idx="45">
                  <c:v>1</c:v>
                </c:pt>
                <c:pt idx="46">
                  <c:v>1</c:v>
                </c:pt>
                <c:pt idx="47">
                  <c:v>1</c:v>
                </c:pt>
                <c:pt idx="48">
                  <c:v>1</c:v>
                </c:pt>
                <c:pt idx="49">
                  <c:v>1</c:v>
                </c:pt>
                <c:pt idx="50">
                  <c:v>1</c:v>
                </c:pt>
                <c:pt idx="51">
                  <c:v>1</c:v>
                </c:pt>
                <c:pt idx="52">
                  <c:v>1</c:v>
                </c:pt>
                <c:pt idx="53">
                  <c:v>1</c:v>
                </c:pt>
                <c:pt idx="54">
                  <c:v>1</c:v>
                </c:pt>
                <c:pt idx="56">
                  <c:v>1</c:v>
                </c:pt>
                <c:pt idx="57">
                  <c:v>1</c:v>
                </c:pt>
                <c:pt idx="58">
                  <c:v>1</c:v>
                </c:pt>
                <c:pt idx="59">
                  <c:v>1</c:v>
                </c:pt>
                <c:pt idx="60">
                  <c:v>1</c:v>
                </c:pt>
                <c:pt idx="61">
                  <c:v>1</c:v>
                </c:pt>
                <c:pt idx="62">
                  <c:v>1</c:v>
                </c:pt>
                <c:pt idx="63">
                  <c:v>1</c:v>
                </c:pt>
                <c:pt idx="64">
                  <c:v>1</c:v>
                </c:pt>
                <c:pt idx="65">
                  <c:v>1</c:v>
                </c:pt>
                <c:pt idx="66">
                  <c:v>1</c:v>
                </c:pt>
                <c:pt idx="67">
                  <c:v>1</c:v>
                </c:pt>
                <c:pt idx="68">
                  <c:v>1</c:v>
                </c:pt>
                <c:pt idx="70">
                  <c:v>1</c:v>
                </c:pt>
                <c:pt idx="71">
                  <c:v>1</c:v>
                </c:pt>
                <c:pt idx="72">
                  <c:v>1</c:v>
                </c:pt>
                <c:pt idx="75">
                  <c:v>1</c:v>
                </c:pt>
                <c:pt idx="76">
                  <c:v>1</c:v>
                </c:pt>
                <c:pt idx="77">
                  <c:v>1</c:v>
                </c:pt>
                <c:pt idx="78">
                  <c:v>1</c:v>
                </c:pt>
                <c:pt idx="79">
                  <c:v>1</c:v>
                </c:pt>
                <c:pt idx="80">
                  <c:v>1</c:v>
                </c:pt>
                <c:pt idx="81">
                  <c:v>1</c:v>
                </c:pt>
                <c:pt idx="82">
                  <c:v>1</c:v>
                </c:pt>
                <c:pt idx="83">
                  <c:v>1</c:v>
                </c:pt>
                <c:pt idx="84">
                  <c:v>1</c:v>
                </c:pt>
                <c:pt idx="85">
                  <c:v>1</c:v>
                </c:pt>
                <c:pt idx="86">
                  <c:v>1</c:v>
                </c:pt>
                <c:pt idx="87">
                  <c:v>1</c:v>
                </c:pt>
                <c:pt idx="88">
                  <c:v>1</c:v>
                </c:pt>
                <c:pt idx="89">
                  <c:v>1</c:v>
                </c:pt>
                <c:pt idx="90">
                  <c:v>1</c:v>
                </c:pt>
                <c:pt idx="91">
                  <c:v>1</c:v>
                </c:pt>
                <c:pt idx="92">
                  <c:v>1</c:v>
                </c:pt>
                <c:pt idx="98">
                  <c:v>1</c:v>
                </c:pt>
                <c:pt idx="100">
                  <c:v>1</c:v>
                </c:pt>
                <c:pt idx="102">
                  <c:v>1</c:v>
                </c:pt>
                <c:pt idx="103">
                  <c:v>1</c:v>
                </c:pt>
                <c:pt idx="104">
                  <c:v>1</c:v>
                </c:pt>
                <c:pt idx="105">
                  <c:v>1</c:v>
                </c:pt>
                <c:pt idx="106">
                  <c:v>1</c:v>
                </c:pt>
                <c:pt idx="107">
                  <c:v>1</c:v>
                </c:pt>
                <c:pt idx="109">
                  <c:v>1</c:v>
                </c:pt>
                <c:pt idx="111">
                  <c:v>1</c:v>
                </c:pt>
                <c:pt idx="112">
                  <c:v>1</c:v>
                </c:pt>
                <c:pt idx="113">
                  <c:v>1</c:v>
                </c:pt>
                <c:pt idx="114">
                  <c:v>1</c:v>
                </c:pt>
                <c:pt idx="116">
                  <c:v>1</c:v>
                </c:pt>
                <c:pt idx="117">
                  <c:v>1</c:v>
                </c:pt>
                <c:pt idx="118">
                  <c:v>1</c:v>
                </c:pt>
                <c:pt idx="119">
                  <c:v>1</c:v>
                </c:pt>
                <c:pt idx="120">
                  <c:v>1</c:v>
                </c:pt>
                <c:pt idx="121">
                  <c:v>1</c:v>
                </c:pt>
                <c:pt idx="122">
                  <c:v>1</c:v>
                </c:pt>
                <c:pt idx="123">
                  <c:v>1</c:v>
                </c:pt>
                <c:pt idx="124">
                  <c:v>1</c:v>
                </c:pt>
                <c:pt idx="125">
                  <c:v>1</c:v>
                </c:pt>
                <c:pt idx="126">
                  <c:v>1</c:v>
                </c:pt>
                <c:pt idx="127">
                  <c:v>1</c:v>
                </c:pt>
                <c:pt idx="128">
                  <c:v>1</c:v>
                </c:pt>
                <c:pt idx="129">
                  <c:v>1</c:v>
                </c:pt>
                <c:pt idx="130">
                  <c:v>1</c:v>
                </c:pt>
                <c:pt idx="131">
                  <c:v>1</c:v>
                </c:pt>
                <c:pt idx="132">
                  <c:v>1</c:v>
                </c:pt>
                <c:pt idx="134">
                  <c:v>1</c:v>
                </c:pt>
                <c:pt idx="135">
                  <c:v>1</c:v>
                </c:pt>
                <c:pt idx="137">
                  <c:v>1</c:v>
                </c:pt>
                <c:pt idx="138">
                  <c:v>1</c:v>
                </c:pt>
                <c:pt idx="139">
                  <c:v>1</c:v>
                </c:pt>
                <c:pt idx="141">
                  <c:v>1</c:v>
                </c:pt>
                <c:pt idx="142">
                  <c:v>1</c:v>
                </c:pt>
                <c:pt idx="143">
                  <c:v>1</c:v>
                </c:pt>
                <c:pt idx="146">
                  <c:v>1</c:v>
                </c:pt>
                <c:pt idx="147">
                  <c:v>1</c:v>
                </c:pt>
                <c:pt idx="149">
                  <c:v>1</c:v>
                </c:pt>
                <c:pt idx="153">
                  <c:v>1</c:v>
                </c:pt>
                <c:pt idx="154">
                  <c:v>1</c:v>
                </c:pt>
                <c:pt idx="155">
                  <c:v>1</c:v>
                </c:pt>
                <c:pt idx="156">
                  <c:v>1</c:v>
                </c:pt>
                <c:pt idx="157">
                  <c:v>1</c:v>
                </c:pt>
                <c:pt idx="158">
                  <c:v>1</c:v>
                </c:pt>
                <c:pt idx="159">
                  <c:v>1</c:v>
                </c:pt>
                <c:pt idx="160">
                  <c:v>1</c:v>
                </c:pt>
                <c:pt idx="161">
                  <c:v>1</c:v>
                </c:pt>
                <c:pt idx="162">
                  <c:v>1</c:v>
                </c:pt>
                <c:pt idx="163">
                  <c:v>1</c:v>
                </c:pt>
                <c:pt idx="164">
                  <c:v>1</c:v>
                </c:pt>
                <c:pt idx="165">
                  <c:v>1</c:v>
                </c:pt>
                <c:pt idx="166">
                  <c:v>1</c:v>
                </c:pt>
                <c:pt idx="167">
                  <c:v>1</c:v>
                </c:pt>
                <c:pt idx="168">
                  <c:v>1</c:v>
                </c:pt>
                <c:pt idx="169">
                  <c:v>1</c:v>
                </c:pt>
                <c:pt idx="172">
                  <c:v>1</c:v>
                </c:pt>
                <c:pt idx="173">
                  <c:v>1</c:v>
                </c:pt>
                <c:pt idx="174">
                  <c:v>1</c:v>
                </c:pt>
                <c:pt idx="175">
                  <c:v>1</c:v>
                </c:pt>
                <c:pt idx="177">
                  <c:v>1</c:v>
                </c:pt>
                <c:pt idx="178">
                  <c:v>1</c:v>
                </c:pt>
                <c:pt idx="179">
                  <c:v>1</c:v>
                </c:pt>
                <c:pt idx="180">
                  <c:v>1</c:v>
                </c:pt>
                <c:pt idx="181">
                  <c:v>1</c:v>
                </c:pt>
                <c:pt idx="182">
                  <c:v>1</c:v>
                </c:pt>
                <c:pt idx="183">
                  <c:v>1</c:v>
                </c:pt>
                <c:pt idx="184">
                  <c:v>1</c:v>
                </c:pt>
                <c:pt idx="186">
                  <c:v>1</c:v>
                </c:pt>
                <c:pt idx="187">
                  <c:v>1</c:v>
                </c:pt>
                <c:pt idx="188">
                  <c:v>1</c:v>
                </c:pt>
                <c:pt idx="189">
                  <c:v>1</c:v>
                </c:pt>
                <c:pt idx="191">
                  <c:v>1</c:v>
                </c:pt>
                <c:pt idx="193">
                  <c:v>1</c:v>
                </c:pt>
                <c:pt idx="194">
                  <c:v>1</c:v>
                </c:pt>
                <c:pt idx="195">
                  <c:v>1</c:v>
                </c:pt>
                <c:pt idx="196">
                  <c:v>1</c:v>
                </c:pt>
                <c:pt idx="197">
                  <c:v>1</c:v>
                </c:pt>
                <c:pt idx="198">
                  <c:v>1</c:v>
                </c:pt>
                <c:pt idx="199">
                  <c:v>1</c:v>
                </c:pt>
                <c:pt idx="200">
                  <c:v>1</c:v>
                </c:pt>
                <c:pt idx="201">
                  <c:v>1</c:v>
                </c:pt>
                <c:pt idx="202">
                  <c:v>1</c:v>
                </c:pt>
                <c:pt idx="203">
                  <c:v>1</c:v>
                </c:pt>
                <c:pt idx="205">
                  <c:v>1</c:v>
                </c:pt>
                <c:pt idx="206">
                  <c:v>1</c:v>
                </c:pt>
                <c:pt idx="207">
                  <c:v>1</c:v>
                </c:pt>
                <c:pt idx="208">
                  <c:v>1</c:v>
                </c:pt>
                <c:pt idx="209">
                  <c:v>1</c:v>
                </c:pt>
                <c:pt idx="211">
                  <c:v>1</c:v>
                </c:pt>
                <c:pt idx="212">
                  <c:v>1</c:v>
                </c:pt>
                <c:pt idx="213">
                  <c:v>1</c:v>
                </c:pt>
                <c:pt idx="214">
                  <c:v>1</c:v>
                </c:pt>
                <c:pt idx="215">
                  <c:v>1</c:v>
                </c:pt>
                <c:pt idx="216">
                  <c:v>1</c:v>
                </c:pt>
                <c:pt idx="217">
                  <c:v>1</c:v>
                </c:pt>
                <c:pt idx="218">
                  <c:v>1</c:v>
                </c:pt>
                <c:pt idx="219">
                  <c:v>1</c:v>
                </c:pt>
                <c:pt idx="220">
                  <c:v>1</c:v>
                </c:pt>
                <c:pt idx="223">
                  <c:v>1</c:v>
                </c:pt>
                <c:pt idx="224">
                  <c:v>1</c:v>
                </c:pt>
                <c:pt idx="225">
                  <c:v>1</c:v>
                </c:pt>
                <c:pt idx="226">
                  <c:v>1</c:v>
                </c:pt>
                <c:pt idx="227">
                  <c:v>1</c:v>
                </c:pt>
                <c:pt idx="228">
                  <c:v>1</c:v>
                </c:pt>
                <c:pt idx="229">
                  <c:v>1</c:v>
                </c:pt>
                <c:pt idx="230">
                  <c:v>1</c:v>
                </c:pt>
                <c:pt idx="231">
                  <c:v>1</c:v>
                </c:pt>
                <c:pt idx="232">
                  <c:v>1</c:v>
                </c:pt>
                <c:pt idx="233">
                  <c:v>1</c:v>
                </c:pt>
                <c:pt idx="235">
                  <c:v>1</c:v>
                </c:pt>
                <c:pt idx="236">
                  <c:v>1</c:v>
                </c:pt>
                <c:pt idx="237">
                  <c:v>1</c:v>
                </c:pt>
                <c:pt idx="238">
                  <c:v>1</c:v>
                </c:pt>
                <c:pt idx="239">
                  <c:v>1</c:v>
                </c:pt>
                <c:pt idx="240">
                  <c:v>1</c:v>
                </c:pt>
                <c:pt idx="241">
                  <c:v>1</c:v>
                </c:pt>
                <c:pt idx="242">
                  <c:v>1</c:v>
                </c:pt>
                <c:pt idx="243">
                  <c:v>1</c:v>
                </c:pt>
                <c:pt idx="244">
                  <c:v>1</c:v>
                </c:pt>
                <c:pt idx="246">
                  <c:v>1</c:v>
                </c:pt>
                <c:pt idx="247">
                  <c:v>1</c:v>
                </c:pt>
                <c:pt idx="248">
                  <c:v>1</c:v>
                </c:pt>
                <c:pt idx="249">
                  <c:v>1</c:v>
                </c:pt>
                <c:pt idx="250">
                  <c:v>1</c:v>
                </c:pt>
                <c:pt idx="251">
                  <c:v>1</c:v>
                </c:pt>
                <c:pt idx="252">
                  <c:v>1</c:v>
                </c:pt>
                <c:pt idx="253">
                  <c:v>1</c:v>
                </c:pt>
                <c:pt idx="254">
                  <c:v>1</c:v>
                </c:pt>
                <c:pt idx="255">
                  <c:v>1</c:v>
                </c:pt>
                <c:pt idx="256">
                  <c:v>1</c:v>
                </c:pt>
                <c:pt idx="257">
                  <c:v>1</c:v>
                </c:pt>
                <c:pt idx="258">
                  <c:v>1</c:v>
                </c:pt>
                <c:pt idx="259">
                  <c:v>1</c:v>
                </c:pt>
                <c:pt idx="260">
                  <c:v>1</c:v>
                </c:pt>
                <c:pt idx="261">
                  <c:v>1</c:v>
                </c:pt>
                <c:pt idx="262">
                  <c:v>2</c:v>
                </c:pt>
                <c:pt idx="263">
                  <c:v>1</c:v>
                </c:pt>
                <c:pt idx="264">
                  <c:v>2</c:v>
                </c:pt>
                <c:pt idx="265">
                  <c:v>6</c:v>
                </c:pt>
                <c:pt idx="266">
                  <c:v>1</c:v>
                </c:pt>
                <c:pt idx="268">
                  <c:v>1</c:v>
                </c:pt>
                <c:pt idx="269">
                  <c:v>1</c:v>
                </c:pt>
                <c:pt idx="270">
                  <c:v>1</c:v>
                </c:pt>
                <c:pt idx="271">
                  <c:v>1</c:v>
                </c:pt>
                <c:pt idx="272">
                  <c:v>1</c:v>
                </c:pt>
                <c:pt idx="273">
                  <c:v>3</c:v>
                </c:pt>
                <c:pt idx="274">
                  <c:v>1</c:v>
                </c:pt>
                <c:pt idx="275">
                  <c:v>1</c:v>
                </c:pt>
                <c:pt idx="276">
                  <c:v>1</c:v>
                </c:pt>
                <c:pt idx="277">
                  <c:v>1</c:v>
                </c:pt>
                <c:pt idx="278">
                  <c:v>1</c:v>
                </c:pt>
                <c:pt idx="279">
                  <c:v>1</c:v>
                </c:pt>
                <c:pt idx="280">
                  <c:v>1</c:v>
                </c:pt>
                <c:pt idx="282">
                  <c:v>1</c:v>
                </c:pt>
                <c:pt idx="283">
                  <c:v>1</c:v>
                </c:pt>
                <c:pt idx="284">
                  <c:v>1</c:v>
                </c:pt>
                <c:pt idx="285">
                  <c:v>1</c:v>
                </c:pt>
                <c:pt idx="286">
                  <c:v>1</c:v>
                </c:pt>
                <c:pt idx="288">
                  <c:v>1</c:v>
                </c:pt>
                <c:pt idx="289">
                  <c:v>1</c:v>
                </c:pt>
                <c:pt idx="290">
                  <c:v>1</c:v>
                </c:pt>
                <c:pt idx="291">
                  <c:v>1</c:v>
                </c:pt>
                <c:pt idx="292">
                  <c:v>1</c:v>
                </c:pt>
                <c:pt idx="293">
                  <c:v>1</c:v>
                </c:pt>
                <c:pt idx="294">
                  <c:v>1</c:v>
                </c:pt>
                <c:pt idx="295">
                  <c:v>1</c:v>
                </c:pt>
                <c:pt idx="296">
                  <c:v>1</c:v>
                </c:pt>
                <c:pt idx="297">
                  <c:v>1</c:v>
                </c:pt>
                <c:pt idx="298">
                  <c:v>1</c:v>
                </c:pt>
                <c:pt idx="299">
                  <c:v>1</c:v>
                </c:pt>
                <c:pt idx="301">
                  <c:v>1</c:v>
                </c:pt>
                <c:pt idx="303">
                  <c:v>1</c:v>
                </c:pt>
                <c:pt idx="306">
                  <c:v>1</c:v>
                </c:pt>
                <c:pt idx="307">
                  <c:v>1</c:v>
                </c:pt>
                <c:pt idx="308">
                  <c:v>1</c:v>
                </c:pt>
                <c:pt idx="310">
                  <c:v>1</c:v>
                </c:pt>
                <c:pt idx="311">
                  <c:v>3</c:v>
                </c:pt>
                <c:pt idx="312">
                  <c:v>1</c:v>
                </c:pt>
                <c:pt idx="313">
                  <c:v>1</c:v>
                </c:pt>
                <c:pt idx="316">
                  <c:v>1</c:v>
                </c:pt>
                <c:pt idx="317">
                  <c:v>1</c:v>
                </c:pt>
                <c:pt idx="318">
                  <c:v>1</c:v>
                </c:pt>
                <c:pt idx="319">
                  <c:v>1</c:v>
                </c:pt>
                <c:pt idx="320">
                  <c:v>1</c:v>
                </c:pt>
                <c:pt idx="321">
                  <c:v>1</c:v>
                </c:pt>
                <c:pt idx="322">
                  <c:v>1</c:v>
                </c:pt>
                <c:pt idx="324">
                  <c:v>1</c:v>
                </c:pt>
                <c:pt idx="325">
                  <c:v>1</c:v>
                </c:pt>
                <c:pt idx="326">
                  <c:v>1</c:v>
                </c:pt>
                <c:pt idx="328">
                  <c:v>1</c:v>
                </c:pt>
                <c:pt idx="329">
                  <c:v>1</c:v>
                </c:pt>
                <c:pt idx="330">
                  <c:v>1</c:v>
                </c:pt>
                <c:pt idx="331">
                  <c:v>1</c:v>
                </c:pt>
                <c:pt idx="332">
                  <c:v>1</c:v>
                </c:pt>
                <c:pt idx="333">
                  <c:v>1</c:v>
                </c:pt>
                <c:pt idx="334">
                  <c:v>2</c:v>
                </c:pt>
                <c:pt idx="335">
                  <c:v>2</c:v>
                </c:pt>
                <c:pt idx="336">
                  <c:v>13</c:v>
                </c:pt>
                <c:pt idx="337">
                  <c:v>91</c:v>
                </c:pt>
                <c:pt idx="338">
                  <c:v>1</c:v>
                </c:pt>
                <c:pt idx="339">
                  <c:v>1</c:v>
                </c:pt>
                <c:pt idx="340">
                  <c:v>1</c:v>
                </c:pt>
                <c:pt idx="341">
                  <c:v>1</c:v>
                </c:pt>
                <c:pt idx="342">
                  <c:v>1</c:v>
                </c:pt>
                <c:pt idx="345">
                  <c:v>1</c:v>
                </c:pt>
                <c:pt idx="346">
                  <c:v>1</c:v>
                </c:pt>
                <c:pt idx="347">
                  <c:v>1</c:v>
                </c:pt>
                <c:pt idx="349">
                  <c:v>2</c:v>
                </c:pt>
                <c:pt idx="351">
                  <c:v>1</c:v>
                </c:pt>
                <c:pt idx="352">
                  <c:v>1</c:v>
                </c:pt>
                <c:pt idx="353">
                  <c:v>1</c:v>
                </c:pt>
                <c:pt idx="356">
                  <c:v>1</c:v>
                </c:pt>
                <c:pt idx="357">
                  <c:v>1</c:v>
                </c:pt>
                <c:pt idx="359">
                  <c:v>1</c:v>
                </c:pt>
                <c:pt idx="360">
                  <c:v>1</c:v>
                </c:pt>
                <c:pt idx="361">
                  <c:v>1</c:v>
                </c:pt>
                <c:pt idx="362">
                  <c:v>1</c:v>
                </c:pt>
                <c:pt idx="363">
                  <c:v>1</c:v>
                </c:pt>
                <c:pt idx="364">
                  <c:v>1</c:v>
                </c:pt>
                <c:pt idx="365">
                  <c:v>1</c:v>
                </c:pt>
                <c:pt idx="366">
                  <c:v>1</c:v>
                </c:pt>
                <c:pt idx="368">
                  <c:v>1</c:v>
                </c:pt>
                <c:pt idx="369">
                  <c:v>1</c:v>
                </c:pt>
                <c:pt idx="370">
                  <c:v>1</c:v>
                </c:pt>
                <c:pt idx="371">
                  <c:v>1</c:v>
                </c:pt>
                <c:pt idx="372">
                  <c:v>1</c:v>
                </c:pt>
                <c:pt idx="373">
                  <c:v>1</c:v>
                </c:pt>
                <c:pt idx="374">
                  <c:v>1</c:v>
                </c:pt>
                <c:pt idx="375">
                  <c:v>1</c:v>
                </c:pt>
                <c:pt idx="376">
                  <c:v>1</c:v>
                </c:pt>
                <c:pt idx="377">
                  <c:v>1</c:v>
                </c:pt>
                <c:pt idx="378">
                  <c:v>1</c:v>
                </c:pt>
                <c:pt idx="379">
                  <c:v>1</c:v>
                </c:pt>
                <c:pt idx="380">
                  <c:v>1</c:v>
                </c:pt>
                <c:pt idx="381">
                  <c:v>1</c:v>
                </c:pt>
                <c:pt idx="382">
                  <c:v>1</c:v>
                </c:pt>
                <c:pt idx="383">
                  <c:v>1</c:v>
                </c:pt>
                <c:pt idx="384">
                  <c:v>1</c:v>
                </c:pt>
                <c:pt idx="386">
                  <c:v>1</c:v>
                </c:pt>
                <c:pt idx="389">
                  <c:v>1</c:v>
                </c:pt>
                <c:pt idx="390">
                  <c:v>1</c:v>
                </c:pt>
                <c:pt idx="391">
                  <c:v>1</c:v>
                </c:pt>
                <c:pt idx="392">
                  <c:v>1</c:v>
                </c:pt>
                <c:pt idx="393">
                  <c:v>1</c:v>
                </c:pt>
                <c:pt idx="394">
                  <c:v>1</c:v>
                </c:pt>
                <c:pt idx="395">
                  <c:v>1</c:v>
                </c:pt>
                <c:pt idx="396">
                  <c:v>5</c:v>
                </c:pt>
                <c:pt idx="397">
                  <c:v>3</c:v>
                </c:pt>
                <c:pt idx="398">
                  <c:v>1</c:v>
                </c:pt>
                <c:pt idx="399">
                  <c:v>1</c:v>
                </c:pt>
                <c:pt idx="400">
                  <c:v>1</c:v>
                </c:pt>
                <c:pt idx="402">
                  <c:v>1</c:v>
                </c:pt>
                <c:pt idx="403">
                  <c:v>1</c:v>
                </c:pt>
                <c:pt idx="404">
                  <c:v>1</c:v>
                </c:pt>
                <c:pt idx="405">
                  <c:v>4</c:v>
                </c:pt>
                <c:pt idx="406">
                  <c:v>1</c:v>
                </c:pt>
                <c:pt idx="407">
                  <c:v>1</c:v>
                </c:pt>
                <c:pt idx="408">
                  <c:v>1</c:v>
                </c:pt>
                <c:pt idx="410">
                  <c:v>1</c:v>
                </c:pt>
                <c:pt idx="411">
                  <c:v>1</c:v>
                </c:pt>
                <c:pt idx="412">
                  <c:v>1</c:v>
                </c:pt>
                <c:pt idx="414">
                  <c:v>1</c:v>
                </c:pt>
                <c:pt idx="415">
                  <c:v>1</c:v>
                </c:pt>
                <c:pt idx="416">
                  <c:v>1</c:v>
                </c:pt>
                <c:pt idx="417">
                  <c:v>1</c:v>
                </c:pt>
                <c:pt idx="418">
                  <c:v>1</c:v>
                </c:pt>
                <c:pt idx="421">
                  <c:v>1</c:v>
                </c:pt>
                <c:pt idx="422">
                  <c:v>1</c:v>
                </c:pt>
                <c:pt idx="423">
                  <c:v>1</c:v>
                </c:pt>
                <c:pt idx="424">
                  <c:v>1</c:v>
                </c:pt>
                <c:pt idx="425">
                  <c:v>1</c:v>
                </c:pt>
                <c:pt idx="426">
                  <c:v>1</c:v>
                </c:pt>
                <c:pt idx="427">
                  <c:v>1</c:v>
                </c:pt>
                <c:pt idx="428">
                  <c:v>1</c:v>
                </c:pt>
                <c:pt idx="429">
                  <c:v>1</c:v>
                </c:pt>
                <c:pt idx="430">
                  <c:v>1</c:v>
                </c:pt>
                <c:pt idx="432">
                  <c:v>2</c:v>
                </c:pt>
                <c:pt idx="434">
                  <c:v>1</c:v>
                </c:pt>
                <c:pt idx="435">
                  <c:v>1</c:v>
                </c:pt>
                <c:pt idx="437">
                  <c:v>1</c:v>
                </c:pt>
                <c:pt idx="438">
                  <c:v>1</c:v>
                </c:pt>
                <c:pt idx="439">
                  <c:v>1</c:v>
                </c:pt>
                <c:pt idx="440">
                  <c:v>1</c:v>
                </c:pt>
                <c:pt idx="441">
                  <c:v>1</c:v>
                </c:pt>
                <c:pt idx="442">
                  <c:v>1</c:v>
                </c:pt>
                <c:pt idx="443">
                  <c:v>1</c:v>
                </c:pt>
                <c:pt idx="444">
                  <c:v>1</c:v>
                </c:pt>
                <c:pt idx="445">
                  <c:v>1</c:v>
                </c:pt>
                <c:pt idx="446">
                  <c:v>1</c:v>
                </c:pt>
                <c:pt idx="447">
                  <c:v>1</c:v>
                </c:pt>
                <c:pt idx="449">
                  <c:v>1</c:v>
                </c:pt>
                <c:pt idx="450">
                  <c:v>1</c:v>
                </c:pt>
                <c:pt idx="451">
                  <c:v>1</c:v>
                </c:pt>
                <c:pt idx="458">
                  <c:v>1</c:v>
                </c:pt>
                <c:pt idx="459">
                  <c:v>1</c:v>
                </c:pt>
                <c:pt idx="460">
                  <c:v>1</c:v>
                </c:pt>
                <c:pt idx="461">
                  <c:v>1</c:v>
                </c:pt>
                <c:pt idx="463">
                  <c:v>1</c:v>
                </c:pt>
                <c:pt idx="464">
                  <c:v>1</c:v>
                </c:pt>
                <c:pt idx="465">
                  <c:v>1</c:v>
                </c:pt>
                <c:pt idx="466">
                  <c:v>1</c:v>
                </c:pt>
                <c:pt idx="467">
                  <c:v>1</c:v>
                </c:pt>
                <c:pt idx="468">
                  <c:v>1</c:v>
                </c:pt>
                <c:pt idx="469">
                  <c:v>1</c:v>
                </c:pt>
                <c:pt idx="470">
                  <c:v>1</c:v>
                </c:pt>
                <c:pt idx="472">
                  <c:v>1</c:v>
                </c:pt>
                <c:pt idx="473">
                  <c:v>1</c:v>
                </c:pt>
                <c:pt idx="474">
                  <c:v>1</c:v>
                </c:pt>
                <c:pt idx="475">
                  <c:v>1</c:v>
                </c:pt>
                <c:pt idx="476">
                  <c:v>1</c:v>
                </c:pt>
                <c:pt idx="477">
                  <c:v>1</c:v>
                </c:pt>
                <c:pt idx="478">
                  <c:v>1</c:v>
                </c:pt>
                <c:pt idx="479">
                  <c:v>1</c:v>
                </c:pt>
                <c:pt idx="480">
                  <c:v>1</c:v>
                </c:pt>
                <c:pt idx="483">
                  <c:v>1</c:v>
                </c:pt>
                <c:pt idx="484">
                  <c:v>1</c:v>
                </c:pt>
                <c:pt idx="485">
                  <c:v>1</c:v>
                </c:pt>
                <c:pt idx="487">
                  <c:v>1</c:v>
                </c:pt>
                <c:pt idx="488">
                  <c:v>1</c:v>
                </c:pt>
                <c:pt idx="491">
                  <c:v>1</c:v>
                </c:pt>
                <c:pt idx="492">
                  <c:v>1</c:v>
                </c:pt>
                <c:pt idx="493">
                  <c:v>1</c:v>
                </c:pt>
                <c:pt idx="494">
                  <c:v>1</c:v>
                </c:pt>
                <c:pt idx="495">
                  <c:v>1</c:v>
                </c:pt>
                <c:pt idx="496">
                  <c:v>1</c:v>
                </c:pt>
                <c:pt idx="497">
                  <c:v>1</c:v>
                </c:pt>
                <c:pt idx="498">
                  <c:v>1</c:v>
                </c:pt>
                <c:pt idx="499">
                  <c:v>1</c:v>
                </c:pt>
                <c:pt idx="500">
                  <c:v>1</c:v>
                </c:pt>
                <c:pt idx="502">
                  <c:v>1</c:v>
                </c:pt>
                <c:pt idx="503">
                  <c:v>1</c:v>
                </c:pt>
                <c:pt idx="505">
                  <c:v>1</c:v>
                </c:pt>
                <c:pt idx="506">
                  <c:v>1</c:v>
                </c:pt>
                <c:pt idx="507">
                  <c:v>1</c:v>
                </c:pt>
                <c:pt idx="508">
                  <c:v>1</c:v>
                </c:pt>
                <c:pt idx="509">
                  <c:v>1</c:v>
                </c:pt>
                <c:pt idx="511">
                  <c:v>1</c:v>
                </c:pt>
                <c:pt idx="512">
                  <c:v>1</c:v>
                </c:pt>
                <c:pt idx="513">
                  <c:v>1</c:v>
                </c:pt>
                <c:pt idx="514">
                  <c:v>1</c:v>
                </c:pt>
                <c:pt idx="515">
                  <c:v>6</c:v>
                </c:pt>
                <c:pt idx="516">
                  <c:v>1</c:v>
                </c:pt>
                <c:pt idx="517">
                  <c:v>1</c:v>
                </c:pt>
                <c:pt idx="518">
                  <c:v>1</c:v>
                </c:pt>
                <c:pt idx="520">
                  <c:v>1</c:v>
                </c:pt>
                <c:pt idx="521">
                  <c:v>1</c:v>
                </c:pt>
                <c:pt idx="523">
                  <c:v>1</c:v>
                </c:pt>
                <c:pt idx="524">
                  <c:v>1</c:v>
                </c:pt>
                <c:pt idx="525">
                  <c:v>1</c:v>
                </c:pt>
                <c:pt idx="526">
                  <c:v>1</c:v>
                </c:pt>
                <c:pt idx="527">
                  <c:v>1</c:v>
                </c:pt>
                <c:pt idx="528">
                  <c:v>1</c:v>
                </c:pt>
                <c:pt idx="529">
                  <c:v>1</c:v>
                </c:pt>
                <c:pt idx="530">
                  <c:v>1</c:v>
                </c:pt>
                <c:pt idx="531">
                  <c:v>1</c:v>
                </c:pt>
                <c:pt idx="532">
                  <c:v>1</c:v>
                </c:pt>
                <c:pt idx="533">
                  <c:v>1</c:v>
                </c:pt>
                <c:pt idx="534">
                  <c:v>1</c:v>
                </c:pt>
                <c:pt idx="535">
                  <c:v>1</c:v>
                </c:pt>
                <c:pt idx="537">
                  <c:v>1</c:v>
                </c:pt>
                <c:pt idx="539">
                  <c:v>1</c:v>
                </c:pt>
                <c:pt idx="540">
                  <c:v>1</c:v>
                </c:pt>
                <c:pt idx="541">
                  <c:v>1</c:v>
                </c:pt>
                <c:pt idx="543">
                  <c:v>1</c:v>
                </c:pt>
                <c:pt idx="546">
                  <c:v>1</c:v>
                </c:pt>
                <c:pt idx="547">
                  <c:v>1</c:v>
                </c:pt>
                <c:pt idx="548">
                  <c:v>1</c:v>
                </c:pt>
                <c:pt idx="549">
                  <c:v>1</c:v>
                </c:pt>
                <c:pt idx="550">
                  <c:v>1</c:v>
                </c:pt>
                <c:pt idx="551">
                  <c:v>1</c:v>
                </c:pt>
                <c:pt idx="552">
                  <c:v>1</c:v>
                </c:pt>
                <c:pt idx="553">
                  <c:v>1</c:v>
                </c:pt>
                <c:pt idx="554">
                  <c:v>1</c:v>
                </c:pt>
                <c:pt idx="555">
                  <c:v>1</c:v>
                </c:pt>
                <c:pt idx="556">
                  <c:v>1</c:v>
                </c:pt>
                <c:pt idx="557">
                  <c:v>1</c:v>
                </c:pt>
                <c:pt idx="558">
                  <c:v>1</c:v>
                </c:pt>
                <c:pt idx="559">
                  <c:v>1</c:v>
                </c:pt>
                <c:pt idx="560">
                  <c:v>1</c:v>
                </c:pt>
                <c:pt idx="561">
                  <c:v>1</c:v>
                </c:pt>
                <c:pt idx="562">
                  <c:v>1</c:v>
                </c:pt>
                <c:pt idx="563">
                  <c:v>1</c:v>
                </c:pt>
                <c:pt idx="566">
                  <c:v>1</c:v>
                </c:pt>
                <c:pt idx="568">
                  <c:v>1</c:v>
                </c:pt>
                <c:pt idx="570">
                  <c:v>1</c:v>
                </c:pt>
                <c:pt idx="571">
                  <c:v>1</c:v>
                </c:pt>
                <c:pt idx="572">
                  <c:v>1</c:v>
                </c:pt>
                <c:pt idx="573">
                  <c:v>3</c:v>
                </c:pt>
                <c:pt idx="574">
                  <c:v>1</c:v>
                </c:pt>
                <c:pt idx="575">
                  <c:v>1</c:v>
                </c:pt>
                <c:pt idx="576">
                  <c:v>1</c:v>
                </c:pt>
                <c:pt idx="577">
                  <c:v>1</c:v>
                </c:pt>
                <c:pt idx="578">
                  <c:v>1</c:v>
                </c:pt>
                <c:pt idx="579">
                  <c:v>1</c:v>
                </c:pt>
                <c:pt idx="580">
                  <c:v>1</c:v>
                </c:pt>
                <c:pt idx="581">
                  <c:v>1</c:v>
                </c:pt>
                <c:pt idx="582">
                  <c:v>1</c:v>
                </c:pt>
                <c:pt idx="583">
                  <c:v>1</c:v>
                </c:pt>
                <c:pt idx="584">
                  <c:v>1</c:v>
                </c:pt>
                <c:pt idx="585">
                  <c:v>1</c:v>
                </c:pt>
                <c:pt idx="586">
                  <c:v>1</c:v>
                </c:pt>
                <c:pt idx="587">
                  <c:v>1</c:v>
                </c:pt>
                <c:pt idx="588">
                  <c:v>1</c:v>
                </c:pt>
                <c:pt idx="589">
                  <c:v>1</c:v>
                </c:pt>
                <c:pt idx="590">
                  <c:v>1</c:v>
                </c:pt>
                <c:pt idx="591">
                  <c:v>1</c:v>
                </c:pt>
                <c:pt idx="592">
                  <c:v>1</c:v>
                </c:pt>
                <c:pt idx="593">
                  <c:v>1</c:v>
                </c:pt>
                <c:pt idx="594">
                  <c:v>1</c:v>
                </c:pt>
                <c:pt idx="595">
                  <c:v>1</c:v>
                </c:pt>
                <c:pt idx="596">
                  <c:v>1</c:v>
                </c:pt>
                <c:pt idx="598">
                  <c:v>1</c:v>
                </c:pt>
                <c:pt idx="599">
                  <c:v>1</c:v>
                </c:pt>
                <c:pt idx="600">
                  <c:v>1</c:v>
                </c:pt>
                <c:pt idx="601">
                  <c:v>1</c:v>
                </c:pt>
                <c:pt idx="602">
                  <c:v>2</c:v>
                </c:pt>
                <c:pt idx="603">
                  <c:v>3</c:v>
                </c:pt>
                <c:pt idx="604">
                  <c:v>8</c:v>
                </c:pt>
                <c:pt idx="605">
                  <c:v>39</c:v>
                </c:pt>
                <c:pt idx="606">
                  <c:v>43</c:v>
                </c:pt>
                <c:pt idx="608">
                  <c:v>1</c:v>
                </c:pt>
                <c:pt idx="610">
                  <c:v>1</c:v>
                </c:pt>
                <c:pt idx="611">
                  <c:v>1</c:v>
                </c:pt>
                <c:pt idx="612">
                  <c:v>1</c:v>
                </c:pt>
                <c:pt idx="614">
                  <c:v>1</c:v>
                </c:pt>
                <c:pt idx="616">
                  <c:v>1</c:v>
                </c:pt>
                <c:pt idx="617">
                  <c:v>1</c:v>
                </c:pt>
                <c:pt idx="618">
                  <c:v>1</c:v>
                </c:pt>
                <c:pt idx="619">
                  <c:v>1</c:v>
                </c:pt>
                <c:pt idx="620">
                  <c:v>1</c:v>
                </c:pt>
                <c:pt idx="622">
                  <c:v>1</c:v>
                </c:pt>
                <c:pt idx="623">
                  <c:v>1</c:v>
                </c:pt>
                <c:pt idx="625">
                  <c:v>1</c:v>
                </c:pt>
                <c:pt idx="626">
                  <c:v>1</c:v>
                </c:pt>
                <c:pt idx="628">
                  <c:v>1</c:v>
                </c:pt>
                <c:pt idx="629">
                  <c:v>1</c:v>
                </c:pt>
                <c:pt idx="631">
                  <c:v>1</c:v>
                </c:pt>
                <c:pt idx="632">
                  <c:v>1</c:v>
                </c:pt>
                <c:pt idx="633">
                  <c:v>1</c:v>
                </c:pt>
                <c:pt idx="637">
                  <c:v>1</c:v>
                </c:pt>
                <c:pt idx="638">
                  <c:v>1</c:v>
                </c:pt>
                <c:pt idx="639">
                  <c:v>1</c:v>
                </c:pt>
                <c:pt idx="640">
                  <c:v>1</c:v>
                </c:pt>
                <c:pt idx="642">
                  <c:v>1</c:v>
                </c:pt>
                <c:pt idx="643">
                  <c:v>1</c:v>
                </c:pt>
                <c:pt idx="644">
                  <c:v>1</c:v>
                </c:pt>
                <c:pt idx="645">
                  <c:v>1</c:v>
                </c:pt>
                <c:pt idx="646">
                  <c:v>1</c:v>
                </c:pt>
                <c:pt idx="649">
                  <c:v>1</c:v>
                </c:pt>
                <c:pt idx="650">
                  <c:v>1</c:v>
                </c:pt>
                <c:pt idx="651">
                  <c:v>1</c:v>
                </c:pt>
                <c:pt idx="652">
                  <c:v>1</c:v>
                </c:pt>
                <c:pt idx="653">
                  <c:v>1</c:v>
                </c:pt>
                <c:pt idx="654">
                  <c:v>1</c:v>
                </c:pt>
                <c:pt idx="655">
                  <c:v>1</c:v>
                </c:pt>
                <c:pt idx="656">
                  <c:v>1</c:v>
                </c:pt>
                <c:pt idx="658">
                  <c:v>1</c:v>
                </c:pt>
                <c:pt idx="659">
                  <c:v>1</c:v>
                </c:pt>
                <c:pt idx="660">
                  <c:v>1</c:v>
                </c:pt>
                <c:pt idx="661">
                  <c:v>1</c:v>
                </c:pt>
                <c:pt idx="662">
                  <c:v>1</c:v>
                </c:pt>
                <c:pt idx="668">
                  <c:v>1</c:v>
                </c:pt>
                <c:pt idx="669">
                  <c:v>1</c:v>
                </c:pt>
                <c:pt idx="670">
                  <c:v>1</c:v>
                </c:pt>
                <c:pt idx="671">
                  <c:v>1</c:v>
                </c:pt>
                <c:pt idx="672">
                  <c:v>1</c:v>
                </c:pt>
                <c:pt idx="674">
                  <c:v>1</c:v>
                </c:pt>
                <c:pt idx="675">
                  <c:v>1</c:v>
                </c:pt>
                <c:pt idx="679">
                  <c:v>1</c:v>
                </c:pt>
                <c:pt idx="680">
                  <c:v>1</c:v>
                </c:pt>
                <c:pt idx="682">
                  <c:v>1</c:v>
                </c:pt>
                <c:pt idx="683">
                  <c:v>1</c:v>
                </c:pt>
                <c:pt idx="684">
                  <c:v>1</c:v>
                </c:pt>
                <c:pt idx="686">
                  <c:v>1</c:v>
                </c:pt>
                <c:pt idx="687">
                  <c:v>1</c:v>
                </c:pt>
                <c:pt idx="688">
                  <c:v>1</c:v>
                </c:pt>
                <c:pt idx="689">
                  <c:v>1</c:v>
                </c:pt>
                <c:pt idx="690">
                  <c:v>1</c:v>
                </c:pt>
                <c:pt idx="692">
                  <c:v>1</c:v>
                </c:pt>
                <c:pt idx="693">
                  <c:v>1</c:v>
                </c:pt>
                <c:pt idx="694">
                  <c:v>1</c:v>
                </c:pt>
                <c:pt idx="697">
                  <c:v>1</c:v>
                </c:pt>
                <c:pt idx="698">
                  <c:v>1</c:v>
                </c:pt>
                <c:pt idx="699">
                  <c:v>1</c:v>
                </c:pt>
                <c:pt idx="700">
                  <c:v>1</c:v>
                </c:pt>
                <c:pt idx="701">
                  <c:v>1</c:v>
                </c:pt>
                <c:pt idx="702">
                  <c:v>1</c:v>
                </c:pt>
                <c:pt idx="703">
                  <c:v>1</c:v>
                </c:pt>
                <c:pt idx="704">
                  <c:v>1</c:v>
                </c:pt>
                <c:pt idx="705">
                  <c:v>1</c:v>
                </c:pt>
                <c:pt idx="706">
                  <c:v>1</c:v>
                </c:pt>
                <c:pt idx="707">
                  <c:v>1</c:v>
                </c:pt>
                <c:pt idx="708">
                  <c:v>1</c:v>
                </c:pt>
                <c:pt idx="709">
                  <c:v>1</c:v>
                </c:pt>
                <c:pt idx="710">
                  <c:v>1</c:v>
                </c:pt>
                <c:pt idx="711">
                  <c:v>1</c:v>
                </c:pt>
                <c:pt idx="713">
                  <c:v>1</c:v>
                </c:pt>
                <c:pt idx="714">
                  <c:v>1</c:v>
                </c:pt>
                <c:pt idx="716">
                  <c:v>1</c:v>
                </c:pt>
                <c:pt idx="717">
                  <c:v>1</c:v>
                </c:pt>
                <c:pt idx="719">
                  <c:v>1</c:v>
                </c:pt>
                <c:pt idx="722">
                  <c:v>1</c:v>
                </c:pt>
                <c:pt idx="723">
                  <c:v>1</c:v>
                </c:pt>
                <c:pt idx="724">
                  <c:v>1</c:v>
                </c:pt>
                <c:pt idx="725">
                  <c:v>1</c:v>
                </c:pt>
                <c:pt idx="726">
                  <c:v>1</c:v>
                </c:pt>
                <c:pt idx="727">
                  <c:v>1</c:v>
                </c:pt>
                <c:pt idx="729">
                  <c:v>1</c:v>
                </c:pt>
                <c:pt idx="730">
                  <c:v>1</c:v>
                </c:pt>
                <c:pt idx="732">
                  <c:v>1</c:v>
                </c:pt>
                <c:pt idx="735">
                  <c:v>1</c:v>
                </c:pt>
                <c:pt idx="737">
                  <c:v>1</c:v>
                </c:pt>
                <c:pt idx="738">
                  <c:v>1</c:v>
                </c:pt>
                <c:pt idx="739">
                  <c:v>1</c:v>
                </c:pt>
                <c:pt idx="740">
                  <c:v>1</c:v>
                </c:pt>
                <c:pt idx="742">
                  <c:v>1</c:v>
                </c:pt>
                <c:pt idx="743">
                  <c:v>1</c:v>
                </c:pt>
                <c:pt idx="745">
                  <c:v>1</c:v>
                </c:pt>
                <c:pt idx="746">
                  <c:v>1</c:v>
                </c:pt>
                <c:pt idx="747">
                  <c:v>1</c:v>
                </c:pt>
                <c:pt idx="748">
                  <c:v>1</c:v>
                </c:pt>
                <c:pt idx="749">
                  <c:v>1</c:v>
                </c:pt>
                <c:pt idx="750">
                  <c:v>1</c:v>
                </c:pt>
                <c:pt idx="751">
                  <c:v>1</c:v>
                </c:pt>
                <c:pt idx="752">
                  <c:v>1</c:v>
                </c:pt>
                <c:pt idx="753">
                  <c:v>1</c:v>
                </c:pt>
                <c:pt idx="754">
                  <c:v>1</c:v>
                </c:pt>
                <c:pt idx="755">
                  <c:v>1</c:v>
                </c:pt>
                <c:pt idx="756">
                  <c:v>1</c:v>
                </c:pt>
                <c:pt idx="758">
                  <c:v>1</c:v>
                </c:pt>
                <c:pt idx="759">
                  <c:v>1</c:v>
                </c:pt>
                <c:pt idx="760">
                  <c:v>1</c:v>
                </c:pt>
                <c:pt idx="761">
                  <c:v>1</c:v>
                </c:pt>
                <c:pt idx="762">
                  <c:v>1</c:v>
                </c:pt>
                <c:pt idx="763">
                  <c:v>1</c:v>
                </c:pt>
                <c:pt idx="764">
                  <c:v>1</c:v>
                </c:pt>
                <c:pt idx="765">
                  <c:v>1</c:v>
                </c:pt>
                <c:pt idx="766">
                  <c:v>1</c:v>
                </c:pt>
                <c:pt idx="767">
                  <c:v>1</c:v>
                </c:pt>
                <c:pt idx="768">
                  <c:v>1</c:v>
                </c:pt>
                <c:pt idx="769">
                  <c:v>1</c:v>
                </c:pt>
                <c:pt idx="770">
                  <c:v>1</c:v>
                </c:pt>
                <c:pt idx="772">
                  <c:v>1</c:v>
                </c:pt>
                <c:pt idx="773">
                  <c:v>1</c:v>
                </c:pt>
                <c:pt idx="774">
                  <c:v>1</c:v>
                </c:pt>
                <c:pt idx="775">
                  <c:v>1</c:v>
                </c:pt>
                <c:pt idx="776">
                  <c:v>1</c:v>
                </c:pt>
                <c:pt idx="777">
                  <c:v>1</c:v>
                </c:pt>
                <c:pt idx="778">
                  <c:v>1</c:v>
                </c:pt>
                <c:pt idx="779">
                  <c:v>1</c:v>
                </c:pt>
                <c:pt idx="780">
                  <c:v>1</c:v>
                </c:pt>
                <c:pt idx="782">
                  <c:v>1</c:v>
                </c:pt>
                <c:pt idx="783">
                  <c:v>1</c:v>
                </c:pt>
                <c:pt idx="784">
                  <c:v>1</c:v>
                </c:pt>
                <c:pt idx="785">
                  <c:v>1</c:v>
                </c:pt>
                <c:pt idx="786">
                  <c:v>1</c:v>
                </c:pt>
                <c:pt idx="787">
                  <c:v>1</c:v>
                </c:pt>
                <c:pt idx="788">
                  <c:v>1</c:v>
                </c:pt>
                <c:pt idx="789">
                  <c:v>1</c:v>
                </c:pt>
                <c:pt idx="790">
                  <c:v>1</c:v>
                </c:pt>
                <c:pt idx="795">
                  <c:v>1</c:v>
                </c:pt>
                <c:pt idx="796">
                  <c:v>2</c:v>
                </c:pt>
                <c:pt idx="797">
                  <c:v>1</c:v>
                </c:pt>
                <c:pt idx="799">
                  <c:v>1</c:v>
                </c:pt>
                <c:pt idx="800">
                  <c:v>1</c:v>
                </c:pt>
                <c:pt idx="801">
                  <c:v>1</c:v>
                </c:pt>
                <c:pt idx="803">
                  <c:v>1</c:v>
                </c:pt>
                <c:pt idx="804">
                  <c:v>1</c:v>
                </c:pt>
                <c:pt idx="805">
                  <c:v>1</c:v>
                </c:pt>
                <c:pt idx="806">
                  <c:v>53</c:v>
                </c:pt>
                <c:pt idx="807">
                  <c:v>1</c:v>
                </c:pt>
                <c:pt idx="808">
                  <c:v>1</c:v>
                </c:pt>
                <c:pt idx="809">
                  <c:v>1</c:v>
                </c:pt>
                <c:pt idx="810">
                  <c:v>1</c:v>
                </c:pt>
                <c:pt idx="812">
                  <c:v>1</c:v>
                </c:pt>
                <c:pt idx="813">
                  <c:v>1</c:v>
                </c:pt>
                <c:pt idx="814">
                  <c:v>1</c:v>
                </c:pt>
                <c:pt idx="815">
                  <c:v>1</c:v>
                </c:pt>
                <c:pt idx="816">
                  <c:v>1</c:v>
                </c:pt>
                <c:pt idx="817">
                  <c:v>1</c:v>
                </c:pt>
                <c:pt idx="818">
                  <c:v>1</c:v>
                </c:pt>
                <c:pt idx="819">
                  <c:v>1</c:v>
                </c:pt>
                <c:pt idx="820">
                  <c:v>1</c:v>
                </c:pt>
                <c:pt idx="821">
                  <c:v>1</c:v>
                </c:pt>
                <c:pt idx="823">
                  <c:v>1</c:v>
                </c:pt>
                <c:pt idx="824">
                  <c:v>1</c:v>
                </c:pt>
                <c:pt idx="825">
                  <c:v>1</c:v>
                </c:pt>
                <c:pt idx="826">
                  <c:v>1</c:v>
                </c:pt>
                <c:pt idx="827">
                  <c:v>1</c:v>
                </c:pt>
                <c:pt idx="828">
                  <c:v>1</c:v>
                </c:pt>
                <c:pt idx="829">
                  <c:v>1</c:v>
                </c:pt>
                <c:pt idx="830">
                  <c:v>1</c:v>
                </c:pt>
                <c:pt idx="831">
                  <c:v>1</c:v>
                </c:pt>
                <c:pt idx="832">
                  <c:v>1</c:v>
                </c:pt>
                <c:pt idx="833">
                  <c:v>1</c:v>
                </c:pt>
                <c:pt idx="834">
                  <c:v>1</c:v>
                </c:pt>
                <c:pt idx="835">
                  <c:v>1</c:v>
                </c:pt>
                <c:pt idx="836">
                  <c:v>1</c:v>
                </c:pt>
                <c:pt idx="837">
                  <c:v>1</c:v>
                </c:pt>
                <c:pt idx="838">
                  <c:v>1</c:v>
                </c:pt>
                <c:pt idx="839">
                  <c:v>1</c:v>
                </c:pt>
                <c:pt idx="840">
                  <c:v>1</c:v>
                </c:pt>
                <c:pt idx="841">
                  <c:v>1</c:v>
                </c:pt>
                <c:pt idx="842">
                  <c:v>1</c:v>
                </c:pt>
                <c:pt idx="843">
                  <c:v>1</c:v>
                </c:pt>
                <c:pt idx="844">
                  <c:v>1</c:v>
                </c:pt>
                <c:pt idx="845">
                  <c:v>1</c:v>
                </c:pt>
                <c:pt idx="846">
                  <c:v>1</c:v>
                </c:pt>
                <c:pt idx="847">
                  <c:v>1</c:v>
                </c:pt>
                <c:pt idx="848">
                  <c:v>1</c:v>
                </c:pt>
                <c:pt idx="849">
                  <c:v>10</c:v>
                </c:pt>
                <c:pt idx="850">
                  <c:v>1</c:v>
                </c:pt>
                <c:pt idx="852">
                  <c:v>1</c:v>
                </c:pt>
                <c:pt idx="853">
                  <c:v>1</c:v>
                </c:pt>
                <c:pt idx="854">
                  <c:v>1</c:v>
                </c:pt>
                <c:pt idx="855">
                  <c:v>1</c:v>
                </c:pt>
                <c:pt idx="856">
                  <c:v>1</c:v>
                </c:pt>
                <c:pt idx="857">
                  <c:v>1</c:v>
                </c:pt>
                <c:pt idx="858">
                  <c:v>1</c:v>
                </c:pt>
                <c:pt idx="859">
                  <c:v>1</c:v>
                </c:pt>
                <c:pt idx="860">
                  <c:v>1</c:v>
                </c:pt>
                <c:pt idx="861">
                  <c:v>1</c:v>
                </c:pt>
                <c:pt idx="862">
                  <c:v>1</c:v>
                </c:pt>
                <c:pt idx="863">
                  <c:v>1</c:v>
                </c:pt>
                <c:pt idx="864">
                  <c:v>1</c:v>
                </c:pt>
                <c:pt idx="865">
                  <c:v>1</c:v>
                </c:pt>
                <c:pt idx="868">
                  <c:v>1</c:v>
                </c:pt>
                <c:pt idx="869">
                  <c:v>1</c:v>
                </c:pt>
                <c:pt idx="870">
                  <c:v>1</c:v>
                </c:pt>
                <c:pt idx="871">
                  <c:v>1</c:v>
                </c:pt>
                <c:pt idx="872">
                  <c:v>1</c:v>
                </c:pt>
                <c:pt idx="873">
                  <c:v>1</c:v>
                </c:pt>
                <c:pt idx="874">
                  <c:v>1</c:v>
                </c:pt>
                <c:pt idx="875">
                  <c:v>1</c:v>
                </c:pt>
                <c:pt idx="876">
                  <c:v>2</c:v>
                </c:pt>
                <c:pt idx="877">
                  <c:v>1</c:v>
                </c:pt>
                <c:pt idx="878">
                  <c:v>1</c:v>
                </c:pt>
                <c:pt idx="879">
                  <c:v>1</c:v>
                </c:pt>
                <c:pt idx="880">
                  <c:v>1</c:v>
                </c:pt>
                <c:pt idx="881">
                  <c:v>1</c:v>
                </c:pt>
                <c:pt idx="883">
                  <c:v>1</c:v>
                </c:pt>
                <c:pt idx="884">
                  <c:v>2</c:v>
                </c:pt>
                <c:pt idx="885">
                  <c:v>2</c:v>
                </c:pt>
                <c:pt idx="886">
                  <c:v>1</c:v>
                </c:pt>
                <c:pt idx="887">
                  <c:v>1</c:v>
                </c:pt>
                <c:pt idx="888">
                  <c:v>1</c:v>
                </c:pt>
                <c:pt idx="889">
                  <c:v>1</c:v>
                </c:pt>
                <c:pt idx="890">
                  <c:v>2</c:v>
                </c:pt>
                <c:pt idx="891">
                  <c:v>2</c:v>
                </c:pt>
                <c:pt idx="892">
                  <c:v>1</c:v>
                </c:pt>
                <c:pt idx="893">
                  <c:v>1</c:v>
                </c:pt>
                <c:pt idx="894">
                  <c:v>1</c:v>
                </c:pt>
                <c:pt idx="895">
                  <c:v>1</c:v>
                </c:pt>
                <c:pt idx="896">
                  <c:v>1</c:v>
                </c:pt>
                <c:pt idx="897">
                  <c:v>1</c:v>
                </c:pt>
                <c:pt idx="898">
                  <c:v>1</c:v>
                </c:pt>
                <c:pt idx="899">
                  <c:v>1</c:v>
                </c:pt>
                <c:pt idx="900">
                  <c:v>1</c:v>
                </c:pt>
                <c:pt idx="901">
                  <c:v>1</c:v>
                </c:pt>
                <c:pt idx="902">
                  <c:v>1</c:v>
                </c:pt>
                <c:pt idx="903">
                  <c:v>1</c:v>
                </c:pt>
                <c:pt idx="904">
                  <c:v>1</c:v>
                </c:pt>
                <c:pt idx="905">
                  <c:v>1</c:v>
                </c:pt>
                <c:pt idx="906">
                  <c:v>24</c:v>
                </c:pt>
                <c:pt idx="907">
                  <c:v>3</c:v>
                </c:pt>
                <c:pt idx="908">
                  <c:v>1</c:v>
                </c:pt>
                <c:pt idx="909">
                  <c:v>1</c:v>
                </c:pt>
                <c:pt idx="910">
                  <c:v>1</c:v>
                </c:pt>
                <c:pt idx="911">
                  <c:v>1</c:v>
                </c:pt>
                <c:pt idx="912">
                  <c:v>1</c:v>
                </c:pt>
                <c:pt idx="913">
                  <c:v>1</c:v>
                </c:pt>
                <c:pt idx="914">
                  <c:v>1</c:v>
                </c:pt>
                <c:pt idx="915">
                  <c:v>2</c:v>
                </c:pt>
                <c:pt idx="916">
                  <c:v>2</c:v>
                </c:pt>
                <c:pt idx="917">
                  <c:v>1</c:v>
                </c:pt>
                <c:pt idx="918">
                  <c:v>6</c:v>
                </c:pt>
                <c:pt idx="919">
                  <c:v>1</c:v>
                </c:pt>
                <c:pt idx="920">
                  <c:v>2</c:v>
                </c:pt>
                <c:pt idx="921">
                  <c:v>74</c:v>
                </c:pt>
                <c:pt idx="922">
                  <c:v>49</c:v>
                </c:pt>
                <c:pt idx="923">
                  <c:v>1</c:v>
                </c:pt>
                <c:pt idx="924">
                  <c:v>7</c:v>
                </c:pt>
                <c:pt idx="925">
                  <c:v>3</c:v>
                </c:pt>
                <c:pt idx="926">
                  <c:v>2</c:v>
                </c:pt>
                <c:pt idx="928">
                  <c:v>2</c:v>
                </c:pt>
                <c:pt idx="929">
                  <c:v>1</c:v>
                </c:pt>
                <c:pt idx="930">
                  <c:v>1</c:v>
                </c:pt>
                <c:pt idx="931">
                  <c:v>5</c:v>
                </c:pt>
                <c:pt idx="932">
                  <c:v>2</c:v>
                </c:pt>
                <c:pt idx="933">
                  <c:v>1</c:v>
                </c:pt>
                <c:pt idx="934">
                  <c:v>1</c:v>
                </c:pt>
                <c:pt idx="935">
                  <c:v>1</c:v>
                </c:pt>
                <c:pt idx="936">
                  <c:v>1</c:v>
                </c:pt>
                <c:pt idx="938">
                  <c:v>1</c:v>
                </c:pt>
                <c:pt idx="939">
                  <c:v>3</c:v>
                </c:pt>
                <c:pt idx="940">
                  <c:v>1</c:v>
                </c:pt>
                <c:pt idx="941">
                  <c:v>1</c:v>
                </c:pt>
                <c:pt idx="943">
                  <c:v>1</c:v>
                </c:pt>
                <c:pt idx="944">
                  <c:v>1</c:v>
                </c:pt>
                <c:pt idx="945">
                  <c:v>1</c:v>
                </c:pt>
                <c:pt idx="946">
                  <c:v>1</c:v>
                </c:pt>
                <c:pt idx="947">
                  <c:v>1</c:v>
                </c:pt>
                <c:pt idx="948">
                  <c:v>1</c:v>
                </c:pt>
                <c:pt idx="949">
                  <c:v>1</c:v>
                </c:pt>
                <c:pt idx="950">
                  <c:v>1</c:v>
                </c:pt>
                <c:pt idx="951">
                  <c:v>2</c:v>
                </c:pt>
                <c:pt idx="952">
                  <c:v>2</c:v>
                </c:pt>
                <c:pt idx="953">
                  <c:v>1</c:v>
                </c:pt>
                <c:pt idx="954">
                  <c:v>2</c:v>
                </c:pt>
                <c:pt idx="955">
                  <c:v>7</c:v>
                </c:pt>
                <c:pt idx="956">
                  <c:v>10</c:v>
                </c:pt>
                <c:pt idx="957">
                  <c:v>6</c:v>
                </c:pt>
                <c:pt idx="958">
                  <c:v>2</c:v>
                </c:pt>
                <c:pt idx="959">
                  <c:v>1</c:v>
                </c:pt>
                <c:pt idx="960">
                  <c:v>1</c:v>
                </c:pt>
                <c:pt idx="961">
                  <c:v>1</c:v>
                </c:pt>
                <c:pt idx="962">
                  <c:v>16</c:v>
                </c:pt>
                <c:pt idx="963">
                  <c:v>20</c:v>
                </c:pt>
                <c:pt idx="964">
                  <c:v>1</c:v>
                </c:pt>
                <c:pt idx="965">
                  <c:v>2</c:v>
                </c:pt>
                <c:pt idx="966">
                  <c:v>3</c:v>
                </c:pt>
                <c:pt idx="967">
                  <c:v>1</c:v>
                </c:pt>
                <c:pt idx="968">
                  <c:v>2</c:v>
                </c:pt>
                <c:pt idx="969">
                  <c:v>9</c:v>
                </c:pt>
                <c:pt idx="970">
                  <c:v>1</c:v>
                </c:pt>
                <c:pt idx="971">
                  <c:v>1</c:v>
                </c:pt>
                <c:pt idx="972">
                  <c:v>1</c:v>
                </c:pt>
                <c:pt idx="973">
                  <c:v>5</c:v>
                </c:pt>
                <c:pt idx="974">
                  <c:v>3</c:v>
                </c:pt>
                <c:pt idx="975">
                  <c:v>1</c:v>
                </c:pt>
                <c:pt idx="976">
                  <c:v>1</c:v>
                </c:pt>
                <c:pt idx="977">
                  <c:v>1</c:v>
                </c:pt>
                <c:pt idx="978">
                  <c:v>6</c:v>
                </c:pt>
                <c:pt idx="979">
                  <c:v>1</c:v>
                </c:pt>
                <c:pt idx="980">
                  <c:v>1</c:v>
                </c:pt>
                <c:pt idx="981">
                  <c:v>1</c:v>
                </c:pt>
                <c:pt idx="982">
                  <c:v>1</c:v>
                </c:pt>
                <c:pt idx="983">
                  <c:v>2</c:v>
                </c:pt>
                <c:pt idx="984">
                  <c:v>3</c:v>
                </c:pt>
                <c:pt idx="985">
                  <c:v>3</c:v>
                </c:pt>
                <c:pt idx="986">
                  <c:v>3</c:v>
                </c:pt>
                <c:pt idx="987">
                  <c:v>14</c:v>
                </c:pt>
                <c:pt idx="988">
                  <c:v>2</c:v>
                </c:pt>
                <c:pt idx="989">
                  <c:v>1</c:v>
                </c:pt>
                <c:pt idx="990">
                  <c:v>4</c:v>
                </c:pt>
                <c:pt idx="991">
                  <c:v>162</c:v>
                </c:pt>
                <c:pt idx="992">
                  <c:v>54</c:v>
                </c:pt>
                <c:pt idx="993">
                  <c:v>2</c:v>
                </c:pt>
                <c:pt idx="994">
                  <c:v>3</c:v>
                </c:pt>
                <c:pt idx="995">
                  <c:v>4</c:v>
                </c:pt>
                <c:pt idx="996">
                  <c:v>2</c:v>
                </c:pt>
                <c:pt idx="997">
                  <c:v>2</c:v>
                </c:pt>
                <c:pt idx="998">
                  <c:v>2</c:v>
                </c:pt>
                <c:pt idx="999">
                  <c:v>1</c:v>
                </c:pt>
                <c:pt idx="1000">
                  <c:v>8</c:v>
                </c:pt>
                <c:pt idx="1001">
                  <c:v>11</c:v>
                </c:pt>
                <c:pt idx="1002">
                  <c:v>1</c:v>
                </c:pt>
                <c:pt idx="1003">
                  <c:v>1</c:v>
                </c:pt>
                <c:pt idx="1004">
                  <c:v>1</c:v>
                </c:pt>
                <c:pt idx="1005">
                  <c:v>3</c:v>
                </c:pt>
                <c:pt idx="1006">
                  <c:v>2</c:v>
                </c:pt>
                <c:pt idx="1007">
                  <c:v>3</c:v>
                </c:pt>
                <c:pt idx="1008">
                  <c:v>1</c:v>
                </c:pt>
                <c:pt idx="1009">
                  <c:v>1</c:v>
                </c:pt>
                <c:pt idx="1010">
                  <c:v>1</c:v>
                </c:pt>
                <c:pt idx="1011">
                  <c:v>1</c:v>
                </c:pt>
                <c:pt idx="1012">
                  <c:v>1</c:v>
                </c:pt>
                <c:pt idx="1013">
                  <c:v>2</c:v>
                </c:pt>
                <c:pt idx="1014">
                  <c:v>1</c:v>
                </c:pt>
                <c:pt idx="1016">
                  <c:v>1</c:v>
                </c:pt>
                <c:pt idx="1017">
                  <c:v>1</c:v>
                </c:pt>
                <c:pt idx="1018">
                  <c:v>1</c:v>
                </c:pt>
                <c:pt idx="1019">
                  <c:v>1</c:v>
                </c:pt>
                <c:pt idx="1020">
                  <c:v>1</c:v>
                </c:pt>
                <c:pt idx="1023">
                  <c:v>1</c:v>
                </c:pt>
                <c:pt idx="1025">
                  <c:v>1</c:v>
                </c:pt>
                <c:pt idx="1026">
                  <c:v>7</c:v>
                </c:pt>
                <c:pt idx="1027">
                  <c:v>1</c:v>
                </c:pt>
                <c:pt idx="1028">
                  <c:v>1</c:v>
                </c:pt>
                <c:pt idx="1029">
                  <c:v>2</c:v>
                </c:pt>
                <c:pt idx="1030">
                  <c:v>1</c:v>
                </c:pt>
                <c:pt idx="1034">
                  <c:v>1</c:v>
                </c:pt>
                <c:pt idx="1035">
                  <c:v>1</c:v>
                </c:pt>
                <c:pt idx="1037">
                  <c:v>1</c:v>
                </c:pt>
                <c:pt idx="1038">
                  <c:v>1</c:v>
                </c:pt>
                <c:pt idx="1040">
                  <c:v>1</c:v>
                </c:pt>
                <c:pt idx="1041">
                  <c:v>1</c:v>
                </c:pt>
                <c:pt idx="1042">
                  <c:v>1</c:v>
                </c:pt>
                <c:pt idx="1044">
                  <c:v>1</c:v>
                </c:pt>
                <c:pt idx="1045">
                  <c:v>1</c:v>
                </c:pt>
                <c:pt idx="1046">
                  <c:v>1</c:v>
                </c:pt>
                <c:pt idx="1051">
                  <c:v>1</c:v>
                </c:pt>
                <c:pt idx="1053">
                  <c:v>1</c:v>
                </c:pt>
                <c:pt idx="1055">
                  <c:v>1</c:v>
                </c:pt>
              </c:numCache>
              <c:extLst xmlns:c15="http://schemas.microsoft.com/office/drawing/2012/chart"/>
            </c:numRef>
          </c:yVal>
          <c:smooth val="0"/>
        </c:ser>
        <c:dLbls>
          <c:showLegendKey val="0"/>
          <c:showVal val="0"/>
          <c:showCatName val="0"/>
          <c:showSerName val="0"/>
          <c:showPercent val="0"/>
          <c:showBubbleSize val="0"/>
        </c:dLbls>
        <c:axId val="419270080"/>
        <c:axId val="419270472"/>
        <c:extLst>
          <c:ext xmlns:c15="http://schemas.microsoft.com/office/drawing/2012/chart" uri="{02D57815-91ED-43cb-92C2-25804820EDAC}">
            <c15:filteredScatterSeries>
              <c15:ser>
                <c:idx val="0"/>
                <c:order val="0"/>
                <c:tx>
                  <c:strRef>
                    <c:extLst>
                      <c:ext uri="{02D57815-91ED-43cb-92C2-25804820EDAC}">
                        <c15:formulaRef>
                          <c15:sqref>'Brachy NFY'!$C$2</c15:sqref>
                        </c15:formulaRef>
                      </c:ext>
                    </c:extLst>
                    <c:strCache>
                      <c:ptCount val="1"/>
                      <c:pt idx="0">
                        <c:v>Control1</c:v>
                      </c:pt>
                    </c:strCache>
                  </c:strRef>
                </c:tx>
                <c:spPr>
                  <a:ln w="19050" cap="rnd">
                    <a:noFill/>
                    <a:round/>
                  </a:ln>
                  <a:effectLst/>
                </c:spPr>
                <c:marker>
                  <c:symbol val="circle"/>
                  <c:size val="5"/>
                  <c:spPr>
                    <a:solidFill>
                      <a:schemeClr val="tx1"/>
                    </a:solidFill>
                    <a:ln w="9525">
                      <a:solidFill>
                        <a:schemeClr val="tx1"/>
                      </a:solidFill>
                    </a:ln>
                    <a:effectLst/>
                  </c:spPr>
                </c:marker>
                <c:xVal>
                  <c:numRef>
                    <c:extLst>
                      <c:ext uri="{02D57815-91ED-43cb-92C2-25804820EDAC}">
                        <c15:formulaRef>
                          <c15:sqref>'Brachy NFY'!$B$3:$B$1060</c15:sqref>
                        </c15:formulaRef>
                      </c:ext>
                    </c:extLst>
                    <c:numCache>
                      <c:formatCode>General</c:formatCode>
                      <c:ptCount val="1058"/>
                      <c:pt idx="0">
                        <c:v>52</c:v>
                      </c:pt>
                      <c:pt idx="1">
                        <c:v>62</c:v>
                      </c:pt>
                      <c:pt idx="2">
                        <c:v>69</c:v>
                      </c:pt>
                      <c:pt idx="3">
                        <c:v>77</c:v>
                      </c:pt>
                      <c:pt idx="4">
                        <c:v>89</c:v>
                      </c:pt>
                      <c:pt idx="5">
                        <c:v>92</c:v>
                      </c:pt>
                      <c:pt idx="6">
                        <c:v>95</c:v>
                      </c:pt>
                      <c:pt idx="7">
                        <c:v>100</c:v>
                      </c:pt>
                      <c:pt idx="8">
                        <c:v>116</c:v>
                      </c:pt>
                      <c:pt idx="9">
                        <c:v>123</c:v>
                      </c:pt>
                      <c:pt idx="10">
                        <c:v>125</c:v>
                      </c:pt>
                      <c:pt idx="11">
                        <c:v>129</c:v>
                      </c:pt>
                      <c:pt idx="12">
                        <c:v>135</c:v>
                      </c:pt>
                      <c:pt idx="13">
                        <c:v>146</c:v>
                      </c:pt>
                      <c:pt idx="14">
                        <c:v>147</c:v>
                      </c:pt>
                      <c:pt idx="15">
                        <c:v>148</c:v>
                      </c:pt>
                      <c:pt idx="16">
                        <c:v>149</c:v>
                      </c:pt>
                      <c:pt idx="17">
                        <c:v>150</c:v>
                      </c:pt>
                      <c:pt idx="18">
                        <c:v>152</c:v>
                      </c:pt>
                      <c:pt idx="19">
                        <c:v>153</c:v>
                      </c:pt>
                      <c:pt idx="20">
                        <c:v>155</c:v>
                      </c:pt>
                      <c:pt idx="21">
                        <c:v>157</c:v>
                      </c:pt>
                      <c:pt idx="22">
                        <c:v>158</c:v>
                      </c:pt>
                      <c:pt idx="23">
                        <c:v>159</c:v>
                      </c:pt>
                      <c:pt idx="24">
                        <c:v>160</c:v>
                      </c:pt>
                      <c:pt idx="25">
                        <c:v>162</c:v>
                      </c:pt>
                      <c:pt idx="26">
                        <c:v>164</c:v>
                      </c:pt>
                      <c:pt idx="27">
                        <c:v>169</c:v>
                      </c:pt>
                      <c:pt idx="28">
                        <c:v>171</c:v>
                      </c:pt>
                      <c:pt idx="29">
                        <c:v>173</c:v>
                      </c:pt>
                      <c:pt idx="30">
                        <c:v>174</c:v>
                      </c:pt>
                      <c:pt idx="31">
                        <c:v>181</c:v>
                      </c:pt>
                      <c:pt idx="32">
                        <c:v>186</c:v>
                      </c:pt>
                      <c:pt idx="33">
                        <c:v>187</c:v>
                      </c:pt>
                      <c:pt idx="34">
                        <c:v>190</c:v>
                      </c:pt>
                      <c:pt idx="35">
                        <c:v>192</c:v>
                      </c:pt>
                      <c:pt idx="36">
                        <c:v>197</c:v>
                      </c:pt>
                      <c:pt idx="37">
                        <c:v>202</c:v>
                      </c:pt>
                      <c:pt idx="38">
                        <c:v>204</c:v>
                      </c:pt>
                      <c:pt idx="39">
                        <c:v>206</c:v>
                      </c:pt>
                      <c:pt idx="40">
                        <c:v>208</c:v>
                      </c:pt>
                      <c:pt idx="41">
                        <c:v>209</c:v>
                      </c:pt>
                      <c:pt idx="42">
                        <c:v>210</c:v>
                      </c:pt>
                      <c:pt idx="43">
                        <c:v>217</c:v>
                      </c:pt>
                      <c:pt idx="44">
                        <c:v>219</c:v>
                      </c:pt>
                      <c:pt idx="45">
                        <c:v>220</c:v>
                      </c:pt>
                      <c:pt idx="46">
                        <c:v>222</c:v>
                      </c:pt>
                      <c:pt idx="47">
                        <c:v>226</c:v>
                      </c:pt>
                      <c:pt idx="48">
                        <c:v>227</c:v>
                      </c:pt>
                      <c:pt idx="49">
                        <c:v>230</c:v>
                      </c:pt>
                      <c:pt idx="50">
                        <c:v>231</c:v>
                      </c:pt>
                      <c:pt idx="51">
                        <c:v>232</c:v>
                      </c:pt>
                      <c:pt idx="52">
                        <c:v>235</c:v>
                      </c:pt>
                      <c:pt idx="53">
                        <c:v>236</c:v>
                      </c:pt>
                      <c:pt idx="54">
                        <c:v>240</c:v>
                      </c:pt>
                      <c:pt idx="55">
                        <c:v>241</c:v>
                      </c:pt>
                      <c:pt idx="56">
                        <c:v>244</c:v>
                      </c:pt>
                      <c:pt idx="57">
                        <c:v>245</c:v>
                      </c:pt>
                      <c:pt idx="58">
                        <c:v>247</c:v>
                      </c:pt>
                      <c:pt idx="59">
                        <c:v>248</c:v>
                      </c:pt>
                      <c:pt idx="60">
                        <c:v>251</c:v>
                      </c:pt>
                      <c:pt idx="61">
                        <c:v>254</c:v>
                      </c:pt>
                      <c:pt idx="62">
                        <c:v>255</c:v>
                      </c:pt>
                      <c:pt idx="63">
                        <c:v>258</c:v>
                      </c:pt>
                      <c:pt idx="64">
                        <c:v>260</c:v>
                      </c:pt>
                      <c:pt idx="65">
                        <c:v>261</c:v>
                      </c:pt>
                      <c:pt idx="66">
                        <c:v>262</c:v>
                      </c:pt>
                      <c:pt idx="67">
                        <c:v>263</c:v>
                      </c:pt>
                      <c:pt idx="68">
                        <c:v>264</c:v>
                      </c:pt>
                      <c:pt idx="69">
                        <c:v>265</c:v>
                      </c:pt>
                      <c:pt idx="70">
                        <c:v>266</c:v>
                      </c:pt>
                      <c:pt idx="71">
                        <c:v>267</c:v>
                      </c:pt>
                      <c:pt idx="72">
                        <c:v>268</c:v>
                      </c:pt>
                      <c:pt idx="73">
                        <c:v>270</c:v>
                      </c:pt>
                      <c:pt idx="74">
                        <c:v>273</c:v>
                      </c:pt>
                      <c:pt idx="75">
                        <c:v>286</c:v>
                      </c:pt>
                      <c:pt idx="76">
                        <c:v>289</c:v>
                      </c:pt>
                      <c:pt idx="77">
                        <c:v>290</c:v>
                      </c:pt>
                      <c:pt idx="78">
                        <c:v>292</c:v>
                      </c:pt>
                      <c:pt idx="79">
                        <c:v>294</c:v>
                      </c:pt>
                      <c:pt idx="80">
                        <c:v>295</c:v>
                      </c:pt>
                      <c:pt idx="81">
                        <c:v>297</c:v>
                      </c:pt>
                      <c:pt idx="82">
                        <c:v>302</c:v>
                      </c:pt>
                      <c:pt idx="83">
                        <c:v>303</c:v>
                      </c:pt>
                      <c:pt idx="84">
                        <c:v>307</c:v>
                      </c:pt>
                      <c:pt idx="85">
                        <c:v>309</c:v>
                      </c:pt>
                      <c:pt idx="86">
                        <c:v>310</c:v>
                      </c:pt>
                      <c:pt idx="87">
                        <c:v>312</c:v>
                      </c:pt>
                      <c:pt idx="88">
                        <c:v>313</c:v>
                      </c:pt>
                      <c:pt idx="89">
                        <c:v>314</c:v>
                      </c:pt>
                      <c:pt idx="90">
                        <c:v>315</c:v>
                      </c:pt>
                      <c:pt idx="91">
                        <c:v>316</c:v>
                      </c:pt>
                      <c:pt idx="92">
                        <c:v>326</c:v>
                      </c:pt>
                      <c:pt idx="93">
                        <c:v>330</c:v>
                      </c:pt>
                      <c:pt idx="94">
                        <c:v>335</c:v>
                      </c:pt>
                      <c:pt idx="95">
                        <c:v>338</c:v>
                      </c:pt>
                      <c:pt idx="96">
                        <c:v>339</c:v>
                      </c:pt>
                      <c:pt idx="97">
                        <c:v>344</c:v>
                      </c:pt>
                      <c:pt idx="98">
                        <c:v>349</c:v>
                      </c:pt>
                      <c:pt idx="99">
                        <c:v>351</c:v>
                      </c:pt>
                      <c:pt idx="100">
                        <c:v>354</c:v>
                      </c:pt>
                      <c:pt idx="101">
                        <c:v>357</c:v>
                      </c:pt>
                      <c:pt idx="102">
                        <c:v>361</c:v>
                      </c:pt>
                      <c:pt idx="103">
                        <c:v>364</c:v>
                      </c:pt>
                      <c:pt idx="104">
                        <c:v>373</c:v>
                      </c:pt>
                      <c:pt idx="105">
                        <c:v>377</c:v>
                      </c:pt>
                      <c:pt idx="106">
                        <c:v>378</c:v>
                      </c:pt>
                      <c:pt idx="107">
                        <c:v>379</c:v>
                      </c:pt>
                      <c:pt idx="108">
                        <c:v>382</c:v>
                      </c:pt>
                      <c:pt idx="109">
                        <c:v>390</c:v>
                      </c:pt>
                      <c:pt idx="110">
                        <c:v>394</c:v>
                      </c:pt>
                      <c:pt idx="111">
                        <c:v>396</c:v>
                      </c:pt>
                      <c:pt idx="112">
                        <c:v>397</c:v>
                      </c:pt>
                      <c:pt idx="113">
                        <c:v>400</c:v>
                      </c:pt>
                      <c:pt idx="114">
                        <c:v>403</c:v>
                      </c:pt>
                      <c:pt idx="115">
                        <c:v>405</c:v>
                      </c:pt>
                      <c:pt idx="116">
                        <c:v>406</c:v>
                      </c:pt>
                      <c:pt idx="117">
                        <c:v>407</c:v>
                      </c:pt>
                      <c:pt idx="118">
                        <c:v>408</c:v>
                      </c:pt>
                      <c:pt idx="119">
                        <c:v>409</c:v>
                      </c:pt>
                      <c:pt idx="120">
                        <c:v>410</c:v>
                      </c:pt>
                      <c:pt idx="121">
                        <c:v>416</c:v>
                      </c:pt>
                      <c:pt idx="122">
                        <c:v>418</c:v>
                      </c:pt>
                      <c:pt idx="123">
                        <c:v>423</c:v>
                      </c:pt>
                      <c:pt idx="124">
                        <c:v>424</c:v>
                      </c:pt>
                      <c:pt idx="125">
                        <c:v>426</c:v>
                      </c:pt>
                      <c:pt idx="126">
                        <c:v>428</c:v>
                      </c:pt>
                      <c:pt idx="127">
                        <c:v>429</c:v>
                      </c:pt>
                      <c:pt idx="128">
                        <c:v>430</c:v>
                      </c:pt>
                      <c:pt idx="129">
                        <c:v>433</c:v>
                      </c:pt>
                      <c:pt idx="130">
                        <c:v>438</c:v>
                      </c:pt>
                      <c:pt idx="131">
                        <c:v>440</c:v>
                      </c:pt>
                      <c:pt idx="132">
                        <c:v>450</c:v>
                      </c:pt>
                      <c:pt idx="133">
                        <c:v>453</c:v>
                      </c:pt>
                      <c:pt idx="134">
                        <c:v>460</c:v>
                      </c:pt>
                      <c:pt idx="135">
                        <c:v>461</c:v>
                      </c:pt>
                      <c:pt idx="136">
                        <c:v>464</c:v>
                      </c:pt>
                      <c:pt idx="137">
                        <c:v>465</c:v>
                      </c:pt>
                      <c:pt idx="138">
                        <c:v>466</c:v>
                      </c:pt>
                      <c:pt idx="139">
                        <c:v>467</c:v>
                      </c:pt>
                      <c:pt idx="140">
                        <c:v>468</c:v>
                      </c:pt>
                      <c:pt idx="141">
                        <c:v>469</c:v>
                      </c:pt>
                      <c:pt idx="142">
                        <c:v>470</c:v>
                      </c:pt>
                      <c:pt idx="143">
                        <c:v>471</c:v>
                      </c:pt>
                      <c:pt idx="144">
                        <c:v>472</c:v>
                      </c:pt>
                      <c:pt idx="145">
                        <c:v>473</c:v>
                      </c:pt>
                      <c:pt idx="146">
                        <c:v>474</c:v>
                      </c:pt>
                      <c:pt idx="147">
                        <c:v>475</c:v>
                      </c:pt>
                      <c:pt idx="148">
                        <c:v>477</c:v>
                      </c:pt>
                      <c:pt idx="149">
                        <c:v>478</c:v>
                      </c:pt>
                      <c:pt idx="150">
                        <c:v>479</c:v>
                      </c:pt>
                      <c:pt idx="151">
                        <c:v>480</c:v>
                      </c:pt>
                      <c:pt idx="152">
                        <c:v>485</c:v>
                      </c:pt>
                      <c:pt idx="153">
                        <c:v>488</c:v>
                      </c:pt>
                      <c:pt idx="154">
                        <c:v>489</c:v>
                      </c:pt>
                      <c:pt idx="155">
                        <c:v>491</c:v>
                      </c:pt>
                      <c:pt idx="156">
                        <c:v>492</c:v>
                      </c:pt>
                      <c:pt idx="157">
                        <c:v>494</c:v>
                      </c:pt>
                      <c:pt idx="158">
                        <c:v>495</c:v>
                      </c:pt>
                      <c:pt idx="159">
                        <c:v>497</c:v>
                      </c:pt>
                      <c:pt idx="160">
                        <c:v>498</c:v>
                      </c:pt>
                      <c:pt idx="161">
                        <c:v>499</c:v>
                      </c:pt>
                      <c:pt idx="162">
                        <c:v>500</c:v>
                      </c:pt>
                      <c:pt idx="163">
                        <c:v>501</c:v>
                      </c:pt>
                      <c:pt idx="164">
                        <c:v>502</c:v>
                      </c:pt>
                      <c:pt idx="165">
                        <c:v>503</c:v>
                      </c:pt>
                      <c:pt idx="166">
                        <c:v>504</c:v>
                      </c:pt>
                      <c:pt idx="167">
                        <c:v>505</c:v>
                      </c:pt>
                      <c:pt idx="168">
                        <c:v>508</c:v>
                      </c:pt>
                      <c:pt idx="169">
                        <c:v>510</c:v>
                      </c:pt>
                      <c:pt idx="170">
                        <c:v>511</c:v>
                      </c:pt>
                      <c:pt idx="171">
                        <c:v>513</c:v>
                      </c:pt>
                      <c:pt idx="172">
                        <c:v>516</c:v>
                      </c:pt>
                      <c:pt idx="173">
                        <c:v>518</c:v>
                      </c:pt>
                      <c:pt idx="174">
                        <c:v>519</c:v>
                      </c:pt>
                      <c:pt idx="175">
                        <c:v>520</c:v>
                      </c:pt>
                      <c:pt idx="176">
                        <c:v>521</c:v>
                      </c:pt>
                      <c:pt idx="177">
                        <c:v>522</c:v>
                      </c:pt>
                      <c:pt idx="178">
                        <c:v>523</c:v>
                      </c:pt>
                      <c:pt idx="179">
                        <c:v>524</c:v>
                      </c:pt>
                      <c:pt idx="180">
                        <c:v>525</c:v>
                      </c:pt>
                      <c:pt idx="181">
                        <c:v>527</c:v>
                      </c:pt>
                      <c:pt idx="182">
                        <c:v>530</c:v>
                      </c:pt>
                      <c:pt idx="183">
                        <c:v>531</c:v>
                      </c:pt>
                      <c:pt idx="184">
                        <c:v>532</c:v>
                      </c:pt>
                      <c:pt idx="185">
                        <c:v>533</c:v>
                      </c:pt>
                      <c:pt idx="186">
                        <c:v>537</c:v>
                      </c:pt>
                      <c:pt idx="187">
                        <c:v>538</c:v>
                      </c:pt>
                      <c:pt idx="188">
                        <c:v>539</c:v>
                      </c:pt>
                      <c:pt idx="189">
                        <c:v>541</c:v>
                      </c:pt>
                      <c:pt idx="190">
                        <c:v>542</c:v>
                      </c:pt>
                      <c:pt idx="191">
                        <c:v>543</c:v>
                      </c:pt>
                      <c:pt idx="192">
                        <c:v>544</c:v>
                      </c:pt>
                      <c:pt idx="193">
                        <c:v>545</c:v>
                      </c:pt>
                      <c:pt idx="194">
                        <c:v>549</c:v>
                      </c:pt>
                      <c:pt idx="195">
                        <c:v>550</c:v>
                      </c:pt>
                      <c:pt idx="196">
                        <c:v>551</c:v>
                      </c:pt>
                      <c:pt idx="197">
                        <c:v>552</c:v>
                      </c:pt>
                      <c:pt idx="198">
                        <c:v>553</c:v>
                      </c:pt>
                      <c:pt idx="199">
                        <c:v>554</c:v>
                      </c:pt>
                      <c:pt idx="200">
                        <c:v>555</c:v>
                      </c:pt>
                      <c:pt idx="201">
                        <c:v>556</c:v>
                      </c:pt>
                      <c:pt idx="202">
                        <c:v>557</c:v>
                      </c:pt>
                      <c:pt idx="203">
                        <c:v>558</c:v>
                      </c:pt>
                      <c:pt idx="204">
                        <c:v>561</c:v>
                      </c:pt>
                      <c:pt idx="205">
                        <c:v>562</c:v>
                      </c:pt>
                      <c:pt idx="206">
                        <c:v>564</c:v>
                      </c:pt>
                      <c:pt idx="207">
                        <c:v>565</c:v>
                      </c:pt>
                      <c:pt idx="208">
                        <c:v>568</c:v>
                      </c:pt>
                      <c:pt idx="209">
                        <c:v>570</c:v>
                      </c:pt>
                      <c:pt idx="210">
                        <c:v>571</c:v>
                      </c:pt>
                      <c:pt idx="211">
                        <c:v>573</c:v>
                      </c:pt>
                      <c:pt idx="212">
                        <c:v>574</c:v>
                      </c:pt>
                      <c:pt idx="213">
                        <c:v>575</c:v>
                      </c:pt>
                      <c:pt idx="214">
                        <c:v>582</c:v>
                      </c:pt>
                      <c:pt idx="215">
                        <c:v>586</c:v>
                      </c:pt>
                      <c:pt idx="216">
                        <c:v>587</c:v>
                      </c:pt>
                      <c:pt idx="217">
                        <c:v>589</c:v>
                      </c:pt>
                      <c:pt idx="218">
                        <c:v>590</c:v>
                      </c:pt>
                      <c:pt idx="219">
                        <c:v>591</c:v>
                      </c:pt>
                      <c:pt idx="220">
                        <c:v>592</c:v>
                      </c:pt>
                      <c:pt idx="221">
                        <c:v>595</c:v>
                      </c:pt>
                      <c:pt idx="222">
                        <c:v>596</c:v>
                      </c:pt>
                      <c:pt idx="223">
                        <c:v>597</c:v>
                      </c:pt>
                      <c:pt idx="224">
                        <c:v>598</c:v>
                      </c:pt>
                      <c:pt idx="225">
                        <c:v>604</c:v>
                      </c:pt>
                      <c:pt idx="226">
                        <c:v>605</c:v>
                      </c:pt>
                      <c:pt idx="227">
                        <c:v>608</c:v>
                      </c:pt>
                      <c:pt idx="228">
                        <c:v>609</c:v>
                      </c:pt>
                      <c:pt idx="229">
                        <c:v>610</c:v>
                      </c:pt>
                      <c:pt idx="230">
                        <c:v>611</c:v>
                      </c:pt>
                      <c:pt idx="231">
                        <c:v>612</c:v>
                      </c:pt>
                      <c:pt idx="232">
                        <c:v>613</c:v>
                      </c:pt>
                      <c:pt idx="233">
                        <c:v>623</c:v>
                      </c:pt>
                      <c:pt idx="234">
                        <c:v>624</c:v>
                      </c:pt>
                      <c:pt idx="235">
                        <c:v>625</c:v>
                      </c:pt>
                      <c:pt idx="236">
                        <c:v>627</c:v>
                      </c:pt>
                      <c:pt idx="237">
                        <c:v>628</c:v>
                      </c:pt>
                      <c:pt idx="238">
                        <c:v>629</c:v>
                      </c:pt>
                      <c:pt idx="239">
                        <c:v>631</c:v>
                      </c:pt>
                      <c:pt idx="240">
                        <c:v>634</c:v>
                      </c:pt>
                      <c:pt idx="241">
                        <c:v>636</c:v>
                      </c:pt>
                      <c:pt idx="242">
                        <c:v>638</c:v>
                      </c:pt>
                      <c:pt idx="243">
                        <c:v>639</c:v>
                      </c:pt>
                      <c:pt idx="244">
                        <c:v>642</c:v>
                      </c:pt>
                      <c:pt idx="245">
                        <c:v>643</c:v>
                      </c:pt>
                      <c:pt idx="246">
                        <c:v>644</c:v>
                      </c:pt>
                      <c:pt idx="247">
                        <c:v>646</c:v>
                      </c:pt>
                      <c:pt idx="248">
                        <c:v>647</c:v>
                      </c:pt>
                      <c:pt idx="249">
                        <c:v>649</c:v>
                      </c:pt>
                      <c:pt idx="250">
                        <c:v>650</c:v>
                      </c:pt>
                      <c:pt idx="251">
                        <c:v>652</c:v>
                      </c:pt>
                      <c:pt idx="252">
                        <c:v>653</c:v>
                      </c:pt>
                      <c:pt idx="253">
                        <c:v>654</c:v>
                      </c:pt>
                      <c:pt idx="254">
                        <c:v>656</c:v>
                      </c:pt>
                      <c:pt idx="255">
                        <c:v>657</c:v>
                      </c:pt>
                      <c:pt idx="256">
                        <c:v>659</c:v>
                      </c:pt>
                      <c:pt idx="257">
                        <c:v>661</c:v>
                      </c:pt>
                      <c:pt idx="258">
                        <c:v>665</c:v>
                      </c:pt>
                      <c:pt idx="259">
                        <c:v>667</c:v>
                      </c:pt>
                      <c:pt idx="260">
                        <c:v>668</c:v>
                      </c:pt>
                      <c:pt idx="261">
                        <c:v>669</c:v>
                      </c:pt>
                      <c:pt idx="262">
                        <c:v>670</c:v>
                      </c:pt>
                      <c:pt idx="263">
                        <c:v>671</c:v>
                      </c:pt>
                      <c:pt idx="264">
                        <c:v>672</c:v>
                      </c:pt>
                      <c:pt idx="265">
                        <c:v>673</c:v>
                      </c:pt>
                      <c:pt idx="266">
                        <c:v>674</c:v>
                      </c:pt>
                      <c:pt idx="267">
                        <c:v>675</c:v>
                      </c:pt>
                      <c:pt idx="268">
                        <c:v>676</c:v>
                      </c:pt>
                      <c:pt idx="269">
                        <c:v>677</c:v>
                      </c:pt>
                      <c:pt idx="270">
                        <c:v>678</c:v>
                      </c:pt>
                      <c:pt idx="271">
                        <c:v>681</c:v>
                      </c:pt>
                      <c:pt idx="272">
                        <c:v>682</c:v>
                      </c:pt>
                      <c:pt idx="273">
                        <c:v>683</c:v>
                      </c:pt>
                      <c:pt idx="274">
                        <c:v>684</c:v>
                      </c:pt>
                      <c:pt idx="275">
                        <c:v>685</c:v>
                      </c:pt>
                      <c:pt idx="276">
                        <c:v>686</c:v>
                      </c:pt>
                      <c:pt idx="277">
                        <c:v>687</c:v>
                      </c:pt>
                      <c:pt idx="278">
                        <c:v>688</c:v>
                      </c:pt>
                      <c:pt idx="279">
                        <c:v>689</c:v>
                      </c:pt>
                      <c:pt idx="280">
                        <c:v>693</c:v>
                      </c:pt>
                      <c:pt idx="281">
                        <c:v>694</c:v>
                      </c:pt>
                      <c:pt idx="282">
                        <c:v>698</c:v>
                      </c:pt>
                      <c:pt idx="283">
                        <c:v>701</c:v>
                      </c:pt>
                      <c:pt idx="284">
                        <c:v>702</c:v>
                      </c:pt>
                      <c:pt idx="285">
                        <c:v>703</c:v>
                      </c:pt>
                      <c:pt idx="286">
                        <c:v>707</c:v>
                      </c:pt>
                      <c:pt idx="287">
                        <c:v>708</c:v>
                      </c:pt>
                      <c:pt idx="288">
                        <c:v>712</c:v>
                      </c:pt>
                      <c:pt idx="289">
                        <c:v>713</c:v>
                      </c:pt>
                      <c:pt idx="290">
                        <c:v>714</c:v>
                      </c:pt>
                      <c:pt idx="291">
                        <c:v>719</c:v>
                      </c:pt>
                      <c:pt idx="292">
                        <c:v>720</c:v>
                      </c:pt>
                      <c:pt idx="293">
                        <c:v>721</c:v>
                      </c:pt>
                      <c:pt idx="294">
                        <c:v>723</c:v>
                      </c:pt>
                      <c:pt idx="295">
                        <c:v>724</c:v>
                      </c:pt>
                      <c:pt idx="296">
                        <c:v>725</c:v>
                      </c:pt>
                      <c:pt idx="297">
                        <c:v>726</c:v>
                      </c:pt>
                      <c:pt idx="298">
                        <c:v>727</c:v>
                      </c:pt>
                      <c:pt idx="299">
                        <c:v>728</c:v>
                      </c:pt>
                      <c:pt idx="300">
                        <c:v>729</c:v>
                      </c:pt>
                      <c:pt idx="301">
                        <c:v>730</c:v>
                      </c:pt>
                      <c:pt idx="302">
                        <c:v>732</c:v>
                      </c:pt>
                      <c:pt idx="303">
                        <c:v>734</c:v>
                      </c:pt>
                      <c:pt idx="304">
                        <c:v>735</c:v>
                      </c:pt>
                      <c:pt idx="305">
                        <c:v>736</c:v>
                      </c:pt>
                      <c:pt idx="306">
                        <c:v>737</c:v>
                      </c:pt>
                      <c:pt idx="307">
                        <c:v>738</c:v>
                      </c:pt>
                      <c:pt idx="308">
                        <c:v>739</c:v>
                      </c:pt>
                      <c:pt idx="309">
                        <c:v>740</c:v>
                      </c:pt>
                      <c:pt idx="310">
                        <c:v>741</c:v>
                      </c:pt>
                      <c:pt idx="311">
                        <c:v>742</c:v>
                      </c:pt>
                      <c:pt idx="312">
                        <c:v>743</c:v>
                      </c:pt>
                      <c:pt idx="313">
                        <c:v>744</c:v>
                      </c:pt>
                      <c:pt idx="314">
                        <c:v>745</c:v>
                      </c:pt>
                      <c:pt idx="315">
                        <c:v>746</c:v>
                      </c:pt>
                      <c:pt idx="316">
                        <c:v>747</c:v>
                      </c:pt>
                      <c:pt idx="317">
                        <c:v>748</c:v>
                      </c:pt>
                      <c:pt idx="318">
                        <c:v>749</c:v>
                      </c:pt>
                      <c:pt idx="319">
                        <c:v>750</c:v>
                      </c:pt>
                      <c:pt idx="320">
                        <c:v>751</c:v>
                      </c:pt>
                      <c:pt idx="321">
                        <c:v>757</c:v>
                      </c:pt>
                      <c:pt idx="322">
                        <c:v>758</c:v>
                      </c:pt>
                      <c:pt idx="323">
                        <c:v>759</c:v>
                      </c:pt>
                      <c:pt idx="324">
                        <c:v>760</c:v>
                      </c:pt>
                      <c:pt idx="325">
                        <c:v>761</c:v>
                      </c:pt>
                      <c:pt idx="326">
                        <c:v>762</c:v>
                      </c:pt>
                      <c:pt idx="327">
                        <c:v>765</c:v>
                      </c:pt>
                      <c:pt idx="328">
                        <c:v>766</c:v>
                      </c:pt>
                      <c:pt idx="329">
                        <c:v>767</c:v>
                      </c:pt>
                      <c:pt idx="330">
                        <c:v>769</c:v>
                      </c:pt>
                      <c:pt idx="331">
                        <c:v>770</c:v>
                      </c:pt>
                      <c:pt idx="332">
                        <c:v>772</c:v>
                      </c:pt>
                      <c:pt idx="333">
                        <c:v>773</c:v>
                      </c:pt>
                      <c:pt idx="334">
                        <c:v>774</c:v>
                      </c:pt>
                      <c:pt idx="335">
                        <c:v>775</c:v>
                      </c:pt>
                      <c:pt idx="336">
                        <c:v>776</c:v>
                      </c:pt>
                      <c:pt idx="337">
                        <c:v>777</c:v>
                      </c:pt>
                      <c:pt idx="338">
                        <c:v>778</c:v>
                      </c:pt>
                      <c:pt idx="339">
                        <c:v>779</c:v>
                      </c:pt>
                      <c:pt idx="340">
                        <c:v>781</c:v>
                      </c:pt>
                      <c:pt idx="341">
                        <c:v>782</c:v>
                      </c:pt>
                      <c:pt idx="342">
                        <c:v>783</c:v>
                      </c:pt>
                      <c:pt idx="343">
                        <c:v>784</c:v>
                      </c:pt>
                      <c:pt idx="344">
                        <c:v>786</c:v>
                      </c:pt>
                      <c:pt idx="345">
                        <c:v>787</c:v>
                      </c:pt>
                      <c:pt idx="346">
                        <c:v>788</c:v>
                      </c:pt>
                      <c:pt idx="347">
                        <c:v>789</c:v>
                      </c:pt>
                      <c:pt idx="348">
                        <c:v>790</c:v>
                      </c:pt>
                      <c:pt idx="349">
                        <c:v>794</c:v>
                      </c:pt>
                      <c:pt idx="350">
                        <c:v>795</c:v>
                      </c:pt>
                      <c:pt idx="351">
                        <c:v>796</c:v>
                      </c:pt>
                      <c:pt idx="352">
                        <c:v>797</c:v>
                      </c:pt>
                      <c:pt idx="353">
                        <c:v>798</c:v>
                      </c:pt>
                      <c:pt idx="354">
                        <c:v>800</c:v>
                      </c:pt>
                      <c:pt idx="355">
                        <c:v>801</c:v>
                      </c:pt>
                      <c:pt idx="356">
                        <c:v>802</c:v>
                      </c:pt>
                      <c:pt idx="357">
                        <c:v>803</c:v>
                      </c:pt>
                      <c:pt idx="358">
                        <c:v>804</c:v>
                      </c:pt>
                      <c:pt idx="359">
                        <c:v>805</c:v>
                      </c:pt>
                      <c:pt idx="360">
                        <c:v>806</c:v>
                      </c:pt>
                      <c:pt idx="361">
                        <c:v>807</c:v>
                      </c:pt>
                      <c:pt idx="362">
                        <c:v>808</c:v>
                      </c:pt>
                      <c:pt idx="363">
                        <c:v>811</c:v>
                      </c:pt>
                      <c:pt idx="364">
                        <c:v>812</c:v>
                      </c:pt>
                      <c:pt idx="365">
                        <c:v>813</c:v>
                      </c:pt>
                      <c:pt idx="366">
                        <c:v>814</c:v>
                      </c:pt>
                      <c:pt idx="367">
                        <c:v>815</c:v>
                      </c:pt>
                      <c:pt idx="368">
                        <c:v>816</c:v>
                      </c:pt>
                      <c:pt idx="369">
                        <c:v>817</c:v>
                      </c:pt>
                      <c:pt idx="370">
                        <c:v>818</c:v>
                      </c:pt>
                      <c:pt idx="371">
                        <c:v>819</c:v>
                      </c:pt>
                      <c:pt idx="372">
                        <c:v>820</c:v>
                      </c:pt>
                      <c:pt idx="373">
                        <c:v>821</c:v>
                      </c:pt>
                      <c:pt idx="374">
                        <c:v>822</c:v>
                      </c:pt>
                      <c:pt idx="375">
                        <c:v>823</c:v>
                      </c:pt>
                      <c:pt idx="376">
                        <c:v>825</c:v>
                      </c:pt>
                      <c:pt idx="377">
                        <c:v>826</c:v>
                      </c:pt>
                      <c:pt idx="378">
                        <c:v>827</c:v>
                      </c:pt>
                      <c:pt idx="379">
                        <c:v>828</c:v>
                      </c:pt>
                      <c:pt idx="380">
                        <c:v>829</c:v>
                      </c:pt>
                      <c:pt idx="381">
                        <c:v>830</c:v>
                      </c:pt>
                      <c:pt idx="382">
                        <c:v>831</c:v>
                      </c:pt>
                      <c:pt idx="383">
                        <c:v>832</c:v>
                      </c:pt>
                      <c:pt idx="384">
                        <c:v>834</c:v>
                      </c:pt>
                      <c:pt idx="385">
                        <c:v>836</c:v>
                      </c:pt>
                      <c:pt idx="386">
                        <c:v>837</c:v>
                      </c:pt>
                      <c:pt idx="387">
                        <c:v>838</c:v>
                      </c:pt>
                      <c:pt idx="388">
                        <c:v>839</c:v>
                      </c:pt>
                      <c:pt idx="389">
                        <c:v>840</c:v>
                      </c:pt>
                      <c:pt idx="390">
                        <c:v>842</c:v>
                      </c:pt>
                      <c:pt idx="391">
                        <c:v>843</c:v>
                      </c:pt>
                      <c:pt idx="392">
                        <c:v>844</c:v>
                      </c:pt>
                      <c:pt idx="393">
                        <c:v>845</c:v>
                      </c:pt>
                      <c:pt idx="394">
                        <c:v>846</c:v>
                      </c:pt>
                      <c:pt idx="395">
                        <c:v>847</c:v>
                      </c:pt>
                      <c:pt idx="396">
                        <c:v>848</c:v>
                      </c:pt>
                      <c:pt idx="397">
                        <c:v>849</c:v>
                      </c:pt>
                      <c:pt idx="398">
                        <c:v>850</c:v>
                      </c:pt>
                      <c:pt idx="399">
                        <c:v>851</c:v>
                      </c:pt>
                      <c:pt idx="400">
                        <c:v>853</c:v>
                      </c:pt>
                      <c:pt idx="401">
                        <c:v>854</c:v>
                      </c:pt>
                      <c:pt idx="402">
                        <c:v>855</c:v>
                      </c:pt>
                      <c:pt idx="403">
                        <c:v>856</c:v>
                      </c:pt>
                      <c:pt idx="404">
                        <c:v>857</c:v>
                      </c:pt>
                      <c:pt idx="405">
                        <c:v>859</c:v>
                      </c:pt>
                      <c:pt idx="406">
                        <c:v>860</c:v>
                      </c:pt>
                      <c:pt idx="407">
                        <c:v>861</c:v>
                      </c:pt>
                      <c:pt idx="408">
                        <c:v>862</c:v>
                      </c:pt>
                      <c:pt idx="409">
                        <c:v>863</c:v>
                      </c:pt>
                      <c:pt idx="410">
                        <c:v>865</c:v>
                      </c:pt>
                      <c:pt idx="411">
                        <c:v>867</c:v>
                      </c:pt>
                      <c:pt idx="412">
                        <c:v>868</c:v>
                      </c:pt>
                      <c:pt idx="413">
                        <c:v>869</c:v>
                      </c:pt>
                      <c:pt idx="414">
                        <c:v>876</c:v>
                      </c:pt>
                      <c:pt idx="415">
                        <c:v>877</c:v>
                      </c:pt>
                      <c:pt idx="416">
                        <c:v>882</c:v>
                      </c:pt>
                      <c:pt idx="417">
                        <c:v>883</c:v>
                      </c:pt>
                      <c:pt idx="418">
                        <c:v>885</c:v>
                      </c:pt>
                      <c:pt idx="419">
                        <c:v>886</c:v>
                      </c:pt>
                      <c:pt idx="420">
                        <c:v>887</c:v>
                      </c:pt>
                      <c:pt idx="421">
                        <c:v>888</c:v>
                      </c:pt>
                      <c:pt idx="422">
                        <c:v>889</c:v>
                      </c:pt>
                      <c:pt idx="423">
                        <c:v>890</c:v>
                      </c:pt>
                      <c:pt idx="424">
                        <c:v>891</c:v>
                      </c:pt>
                      <c:pt idx="425">
                        <c:v>892</c:v>
                      </c:pt>
                      <c:pt idx="426">
                        <c:v>893</c:v>
                      </c:pt>
                      <c:pt idx="427">
                        <c:v>895</c:v>
                      </c:pt>
                      <c:pt idx="428">
                        <c:v>896</c:v>
                      </c:pt>
                      <c:pt idx="429">
                        <c:v>897</c:v>
                      </c:pt>
                      <c:pt idx="430">
                        <c:v>898</c:v>
                      </c:pt>
                      <c:pt idx="431">
                        <c:v>900</c:v>
                      </c:pt>
                      <c:pt idx="432">
                        <c:v>901</c:v>
                      </c:pt>
                      <c:pt idx="433">
                        <c:v>902</c:v>
                      </c:pt>
                      <c:pt idx="434">
                        <c:v>903</c:v>
                      </c:pt>
                      <c:pt idx="435">
                        <c:v>904</c:v>
                      </c:pt>
                      <c:pt idx="436">
                        <c:v>905</c:v>
                      </c:pt>
                      <c:pt idx="437">
                        <c:v>907</c:v>
                      </c:pt>
                      <c:pt idx="438">
                        <c:v>908</c:v>
                      </c:pt>
                      <c:pt idx="439">
                        <c:v>909</c:v>
                      </c:pt>
                      <c:pt idx="440">
                        <c:v>910</c:v>
                      </c:pt>
                      <c:pt idx="441">
                        <c:v>911</c:v>
                      </c:pt>
                      <c:pt idx="442">
                        <c:v>912</c:v>
                      </c:pt>
                      <c:pt idx="443">
                        <c:v>913</c:v>
                      </c:pt>
                      <c:pt idx="444">
                        <c:v>918</c:v>
                      </c:pt>
                      <c:pt idx="445">
                        <c:v>919</c:v>
                      </c:pt>
                      <c:pt idx="446">
                        <c:v>920</c:v>
                      </c:pt>
                      <c:pt idx="447">
                        <c:v>922</c:v>
                      </c:pt>
                      <c:pt idx="448">
                        <c:v>923</c:v>
                      </c:pt>
                      <c:pt idx="449">
                        <c:v>924</c:v>
                      </c:pt>
                      <c:pt idx="450">
                        <c:v>925</c:v>
                      </c:pt>
                      <c:pt idx="451">
                        <c:v>926</c:v>
                      </c:pt>
                      <c:pt idx="452">
                        <c:v>927</c:v>
                      </c:pt>
                      <c:pt idx="453">
                        <c:v>928</c:v>
                      </c:pt>
                      <c:pt idx="454">
                        <c:v>929</c:v>
                      </c:pt>
                      <c:pt idx="455">
                        <c:v>930</c:v>
                      </c:pt>
                      <c:pt idx="456">
                        <c:v>931</c:v>
                      </c:pt>
                      <c:pt idx="457">
                        <c:v>934</c:v>
                      </c:pt>
                      <c:pt idx="458">
                        <c:v>935</c:v>
                      </c:pt>
                      <c:pt idx="459">
                        <c:v>940</c:v>
                      </c:pt>
                      <c:pt idx="460">
                        <c:v>941</c:v>
                      </c:pt>
                      <c:pt idx="461">
                        <c:v>942</c:v>
                      </c:pt>
                      <c:pt idx="462">
                        <c:v>943</c:v>
                      </c:pt>
                      <c:pt idx="463">
                        <c:v>944</c:v>
                      </c:pt>
                      <c:pt idx="464">
                        <c:v>945</c:v>
                      </c:pt>
                      <c:pt idx="465">
                        <c:v>946</c:v>
                      </c:pt>
                      <c:pt idx="466">
                        <c:v>947</c:v>
                      </c:pt>
                      <c:pt idx="467">
                        <c:v>948</c:v>
                      </c:pt>
                      <c:pt idx="468">
                        <c:v>949</c:v>
                      </c:pt>
                      <c:pt idx="469">
                        <c:v>950</c:v>
                      </c:pt>
                      <c:pt idx="470">
                        <c:v>951</c:v>
                      </c:pt>
                      <c:pt idx="471">
                        <c:v>952</c:v>
                      </c:pt>
                      <c:pt idx="472">
                        <c:v>954</c:v>
                      </c:pt>
                      <c:pt idx="473">
                        <c:v>955</c:v>
                      </c:pt>
                      <c:pt idx="474">
                        <c:v>956</c:v>
                      </c:pt>
                      <c:pt idx="475">
                        <c:v>961</c:v>
                      </c:pt>
                      <c:pt idx="476">
                        <c:v>964</c:v>
                      </c:pt>
                      <c:pt idx="477">
                        <c:v>965</c:v>
                      </c:pt>
                      <c:pt idx="478">
                        <c:v>966</c:v>
                      </c:pt>
                      <c:pt idx="479">
                        <c:v>969</c:v>
                      </c:pt>
                      <c:pt idx="480">
                        <c:v>970</c:v>
                      </c:pt>
                      <c:pt idx="481">
                        <c:v>973</c:v>
                      </c:pt>
                      <c:pt idx="482">
                        <c:v>974</c:v>
                      </c:pt>
                      <c:pt idx="483">
                        <c:v>975</c:v>
                      </c:pt>
                      <c:pt idx="484">
                        <c:v>977</c:v>
                      </c:pt>
                      <c:pt idx="485">
                        <c:v>978</c:v>
                      </c:pt>
                      <c:pt idx="486">
                        <c:v>979</c:v>
                      </c:pt>
                      <c:pt idx="487">
                        <c:v>980</c:v>
                      </c:pt>
                      <c:pt idx="488">
                        <c:v>983</c:v>
                      </c:pt>
                      <c:pt idx="489">
                        <c:v>984</c:v>
                      </c:pt>
                      <c:pt idx="490">
                        <c:v>986</c:v>
                      </c:pt>
                      <c:pt idx="491">
                        <c:v>987</c:v>
                      </c:pt>
                      <c:pt idx="492">
                        <c:v>988</c:v>
                      </c:pt>
                      <c:pt idx="493">
                        <c:v>989</c:v>
                      </c:pt>
                      <c:pt idx="494">
                        <c:v>990</c:v>
                      </c:pt>
                      <c:pt idx="495">
                        <c:v>991</c:v>
                      </c:pt>
                      <c:pt idx="496">
                        <c:v>992</c:v>
                      </c:pt>
                      <c:pt idx="497">
                        <c:v>994</c:v>
                      </c:pt>
                      <c:pt idx="498">
                        <c:v>995</c:v>
                      </c:pt>
                      <c:pt idx="499">
                        <c:v>996</c:v>
                      </c:pt>
                      <c:pt idx="500">
                        <c:v>997</c:v>
                      </c:pt>
                      <c:pt idx="501">
                        <c:v>998</c:v>
                      </c:pt>
                      <c:pt idx="502">
                        <c:v>999</c:v>
                      </c:pt>
                      <c:pt idx="503">
                        <c:v>1000</c:v>
                      </c:pt>
                      <c:pt idx="504">
                        <c:v>1001</c:v>
                      </c:pt>
                      <c:pt idx="505">
                        <c:v>1002</c:v>
                      </c:pt>
                      <c:pt idx="506">
                        <c:v>1003</c:v>
                      </c:pt>
                      <c:pt idx="507">
                        <c:v>1004</c:v>
                      </c:pt>
                      <c:pt idx="508">
                        <c:v>1005</c:v>
                      </c:pt>
                      <c:pt idx="509">
                        <c:v>1006</c:v>
                      </c:pt>
                      <c:pt idx="510">
                        <c:v>1008</c:v>
                      </c:pt>
                      <c:pt idx="511">
                        <c:v>1009</c:v>
                      </c:pt>
                      <c:pt idx="512">
                        <c:v>1010</c:v>
                      </c:pt>
                      <c:pt idx="513">
                        <c:v>1011</c:v>
                      </c:pt>
                      <c:pt idx="514">
                        <c:v>1012</c:v>
                      </c:pt>
                      <c:pt idx="515">
                        <c:v>1013</c:v>
                      </c:pt>
                      <c:pt idx="516">
                        <c:v>1015</c:v>
                      </c:pt>
                      <c:pt idx="517">
                        <c:v>1020</c:v>
                      </c:pt>
                      <c:pt idx="518">
                        <c:v>1021</c:v>
                      </c:pt>
                      <c:pt idx="519">
                        <c:v>1022</c:v>
                      </c:pt>
                      <c:pt idx="520">
                        <c:v>1023</c:v>
                      </c:pt>
                      <c:pt idx="521">
                        <c:v>1024</c:v>
                      </c:pt>
                      <c:pt idx="522">
                        <c:v>1025</c:v>
                      </c:pt>
                      <c:pt idx="523">
                        <c:v>1027</c:v>
                      </c:pt>
                      <c:pt idx="524">
                        <c:v>1031</c:v>
                      </c:pt>
                      <c:pt idx="525">
                        <c:v>1032</c:v>
                      </c:pt>
                      <c:pt idx="526">
                        <c:v>1033</c:v>
                      </c:pt>
                      <c:pt idx="527">
                        <c:v>1034</c:v>
                      </c:pt>
                      <c:pt idx="528">
                        <c:v>1035</c:v>
                      </c:pt>
                      <c:pt idx="529">
                        <c:v>1037</c:v>
                      </c:pt>
                      <c:pt idx="530">
                        <c:v>1039</c:v>
                      </c:pt>
                      <c:pt idx="531">
                        <c:v>1040</c:v>
                      </c:pt>
                      <c:pt idx="532">
                        <c:v>1041</c:v>
                      </c:pt>
                      <c:pt idx="533">
                        <c:v>1043</c:v>
                      </c:pt>
                      <c:pt idx="534">
                        <c:v>1044</c:v>
                      </c:pt>
                      <c:pt idx="535">
                        <c:v>1045</c:v>
                      </c:pt>
                      <c:pt idx="536">
                        <c:v>1046</c:v>
                      </c:pt>
                      <c:pt idx="537">
                        <c:v>1047</c:v>
                      </c:pt>
                      <c:pt idx="538">
                        <c:v>1048</c:v>
                      </c:pt>
                      <c:pt idx="539">
                        <c:v>1049</c:v>
                      </c:pt>
                      <c:pt idx="540">
                        <c:v>1050</c:v>
                      </c:pt>
                      <c:pt idx="541">
                        <c:v>1051</c:v>
                      </c:pt>
                      <c:pt idx="542">
                        <c:v>1052</c:v>
                      </c:pt>
                      <c:pt idx="543">
                        <c:v>1053</c:v>
                      </c:pt>
                      <c:pt idx="544">
                        <c:v>1054</c:v>
                      </c:pt>
                      <c:pt idx="545">
                        <c:v>1055</c:v>
                      </c:pt>
                      <c:pt idx="546">
                        <c:v>1057</c:v>
                      </c:pt>
                      <c:pt idx="547">
                        <c:v>1059</c:v>
                      </c:pt>
                      <c:pt idx="548">
                        <c:v>1060</c:v>
                      </c:pt>
                      <c:pt idx="549">
                        <c:v>1061</c:v>
                      </c:pt>
                      <c:pt idx="550">
                        <c:v>1062</c:v>
                      </c:pt>
                      <c:pt idx="551">
                        <c:v>1063</c:v>
                      </c:pt>
                      <c:pt idx="552">
                        <c:v>1064</c:v>
                      </c:pt>
                      <c:pt idx="553">
                        <c:v>1065</c:v>
                      </c:pt>
                      <c:pt idx="554">
                        <c:v>1066</c:v>
                      </c:pt>
                      <c:pt idx="555">
                        <c:v>1067</c:v>
                      </c:pt>
                      <c:pt idx="556">
                        <c:v>1068</c:v>
                      </c:pt>
                      <c:pt idx="557">
                        <c:v>1069</c:v>
                      </c:pt>
                      <c:pt idx="558">
                        <c:v>1070</c:v>
                      </c:pt>
                      <c:pt idx="559">
                        <c:v>1072</c:v>
                      </c:pt>
                      <c:pt idx="560">
                        <c:v>1073</c:v>
                      </c:pt>
                      <c:pt idx="561">
                        <c:v>1074</c:v>
                      </c:pt>
                      <c:pt idx="562">
                        <c:v>1077</c:v>
                      </c:pt>
                      <c:pt idx="563">
                        <c:v>1080</c:v>
                      </c:pt>
                      <c:pt idx="564">
                        <c:v>1081</c:v>
                      </c:pt>
                      <c:pt idx="565">
                        <c:v>1082</c:v>
                      </c:pt>
                      <c:pt idx="566">
                        <c:v>1083</c:v>
                      </c:pt>
                      <c:pt idx="567">
                        <c:v>1084</c:v>
                      </c:pt>
                      <c:pt idx="568">
                        <c:v>1085</c:v>
                      </c:pt>
                      <c:pt idx="569">
                        <c:v>1090</c:v>
                      </c:pt>
                      <c:pt idx="570">
                        <c:v>1091</c:v>
                      </c:pt>
                      <c:pt idx="571">
                        <c:v>1092</c:v>
                      </c:pt>
                      <c:pt idx="572">
                        <c:v>1093</c:v>
                      </c:pt>
                      <c:pt idx="573">
                        <c:v>1094</c:v>
                      </c:pt>
                      <c:pt idx="574">
                        <c:v>1099</c:v>
                      </c:pt>
                      <c:pt idx="575">
                        <c:v>1100</c:v>
                      </c:pt>
                      <c:pt idx="576">
                        <c:v>1101</c:v>
                      </c:pt>
                      <c:pt idx="577">
                        <c:v>1102</c:v>
                      </c:pt>
                      <c:pt idx="578">
                        <c:v>1103</c:v>
                      </c:pt>
                      <c:pt idx="579">
                        <c:v>1104</c:v>
                      </c:pt>
                      <c:pt idx="580">
                        <c:v>1105</c:v>
                      </c:pt>
                      <c:pt idx="581">
                        <c:v>1106</c:v>
                      </c:pt>
                      <c:pt idx="582">
                        <c:v>1107</c:v>
                      </c:pt>
                      <c:pt idx="583">
                        <c:v>1108</c:v>
                      </c:pt>
                      <c:pt idx="584">
                        <c:v>1110</c:v>
                      </c:pt>
                      <c:pt idx="585">
                        <c:v>1111</c:v>
                      </c:pt>
                      <c:pt idx="586">
                        <c:v>1112</c:v>
                      </c:pt>
                      <c:pt idx="587">
                        <c:v>1113</c:v>
                      </c:pt>
                      <c:pt idx="588">
                        <c:v>1114</c:v>
                      </c:pt>
                      <c:pt idx="589">
                        <c:v>1115</c:v>
                      </c:pt>
                      <c:pt idx="590">
                        <c:v>1116</c:v>
                      </c:pt>
                      <c:pt idx="591">
                        <c:v>1118</c:v>
                      </c:pt>
                      <c:pt idx="592">
                        <c:v>1119</c:v>
                      </c:pt>
                      <c:pt idx="593">
                        <c:v>1120</c:v>
                      </c:pt>
                      <c:pt idx="594">
                        <c:v>1121</c:v>
                      </c:pt>
                      <c:pt idx="595">
                        <c:v>1122</c:v>
                      </c:pt>
                      <c:pt idx="596">
                        <c:v>1123</c:v>
                      </c:pt>
                      <c:pt idx="597">
                        <c:v>1124</c:v>
                      </c:pt>
                      <c:pt idx="598">
                        <c:v>1130</c:v>
                      </c:pt>
                      <c:pt idx="599">
                        <c:v>1131</c:v>
                      </c:pt>
                      <c:pt idx="600">
                        <c:v>1132</c:v>
                      </c:pt>
                      <c:pt idx="601">
                        <c:v>1133</c:v>
                      </c:pt>
                      <c:pt idx="602">
                        <c:v>1134</c:v>
                      </c:pt>
                      <c:pt idx="603">
                        <c:v>1135</c:v>
                      </c:pt>
                      <c:pt idx="604">
                        <c:v>1136</c:v>
                      </c:pt>
                      <c:pt idx="605">
                        <c:v>1137</c:v>
                      </c:pt>
                      <c:pt idx="606">
                        <c:v>1138</c:v>
                      </c:pt>
                      <c:pt idx="607">
                        <c:v>1139</c:v>
                      </c:pt>
                      <c:pt idx="608">
                        <c:v>1140</c:v>
                      </c:pt>
                      <c:pt idx="609">
                        <c:v>1141</c:v>
                      </c:pt>
                      <c:pt idx="610">
                        <c:v>1142</c:v>
                      </c:pt>
                      <c:pt idx="611">
                        <c:v>1143</c:v>
                      </c:pt>
                      <c:pt idx="612">
                        <c:v>1145</c:v>
                      </c:pt>
                      <c:pt idx="613">
                        <c:v>1146</c:v>
                      </c:pt>
                      <c:pt idx="614">
                        <c:v>1147</c:v>
                      </c:pt>
                      <c:pt idx="615">
                        <c:v>1148</c:v>
                      </c:pt>
                      <c:pt idx="616">
                        <c:v>1149</c:v>
                      </c:pt>
                      <c:pt idx="617">
                        <c:v>1150</c:v>
                      </c:pt>
                      <c:pt idx="618">
                        <c:v>1151</c:v>
                      </c:pt>
                      <c:pt idx="619">
                        <c:v>1153</c:v>
                      </c:pt>
                      <c:pt idx="620">
                        <c:v>1154</c:v>
                      </c:pt>
                      <c:pt idx="621">
                        <c:v>1155</c:v>
                      </c:pt>
                      <c:pt idx="622">
                        <c:v>1156</c:v>
                      </c:pt>
                      <c:pt idx="623">
                        <c:v>1157</c:v>
                      </c:pt>
                      <c:pt idx="624">
                        <c:v>1158</c:v>
                      </c:pt>
                      <c:pt idx="625">
                        <c:v>1159</c:v>
                      </c:pt>
                      <c:pt idx="626">
                        <c:v>1160</c:v>
                      </c:pt>
                      <c:pt idx="627">
                        <c:v>1161</c:v>
                      </c:pt>
                      <c:pt idx="628">
                        <c:v>1162</c:v>
                      </c:pt>
                      <c:pt idx="629">
                        <c:v>1165</c:v>
                      </c:pt>
                      <c:pt idx="630">
                        <c:v>1166</c:v>
                      </c:pt>
                      <c:pt idx="631">
                        <c:v>1167</c:v>
                      </c:pt>
                      <c:pt idx="632">
                        <c:v>1168</c:v>
                      </c:pt>
                      <c:pt idx="633">
                        <c:v>1169</c:v>
                      </c:pt>
                      <c:pt idx="634">
                        <c:v>1170</c:v>
                      </c:pt>
                      <c:pt idx="635">
                        <c:v>1173</c:v>
                      </c:pt>
                      <c:pt idx="636">
                        <c:v>1174</c:v>
                      </c:pt>
                      <c:pt idx="637">
                        <c:v>1175</c:v>
                      </c:pt>
                      <c:pt idx="638">
                        <c:v>1180</c:v>
                      </c:pt>
                      <c:pt idx="639">
                        <c:v>1181</c:v>
                      </c:pt>
                      <c:pt idx="640">
                        <c:v>1182</c:v>
                      </c:pt>
                      <c:pt idx="641">
                        <c:v>1183</c:v>
                      </c:pt>
                      <c:pt idx="642">
                        <c:v>1184</c:v>
                      </c:pt>
                      <c:pt idx="643">
                        <c:v>1185</c:v>
                      </c:pt>
                      <c:pt idx="644">
                        <c:v>1186</c:v>
                      </c:pt>
                      <c:pt idx="645">
                        <c:v>1187</c:v>
                      </c:pt>
                      <c:pt idx="646">
                        <c:v>1188</c:v>
                      </c:pt>
                      <c:pt idx="647">
                        <c:v>1189</c:v>
                      </c:pt>
                      <c:pt idx="648">
                        <c:v>1190</c:v>
                      </c:pt>
                      <c:pt idx="649">
                        <c:v>1192</c:v>
                      </c:pt>
                      <c:pt idx="650">
                        <c:v>1193</c:v>
                      </c:pt>
                      <c:pt idx="651">
                        <c:v>1194</c:v>
                      </c:pt>
                      <c:pt idx="652">
                        <c:v>1195</c:v>
                      </c:pt>
                      <c:pt idx="653">
                        <c:v>1197</c:v>
                      </c:pt>
                      <c:pt idx="654">
                        <c:v>1198</c:v>
                      </c:pt>
                      <c:pt idx="655">
                        <c:v>1199</c:v>
                      </c:pt>
                      <c:pt idx="656">
                        <c:v>1200</c:v>
                      </c:pt>
                      <c:pt idx="657">
                        <c:v>1201</c:v>
                      </c:pt>
                      <c:pt idx="658">
                        <c:v>1203</c:v>
                      </c:pt>
                      <c:pt idx="659">
                        <c:v>1204</c:v>
                      </c:pt>
                      <c:pt idx="660">
                        <c:v>1205</c:v>
                      </c:pt>
                      <c:pt idx="661">
                        <c:v>1208</c:v>
                      </c:pt>
                      <c:pt idx="662">
                        <c:v>1209</c:v>
                      </c:pt>
                      <c:pt idx="663">
                        <c:v>1210</c:v>
                      </c:pt>
                      <c:pt idx="664">
                        <c:v>1214</c:v>
                      </c:pt>
                      <c:pt idx="665">
                        <c:v>1215</c:v>
                      </c:pt>
                      <c:pt idx="666">
                        <c:v>1216</c:v>
                      </c:pt>
                      <c:pt idx="667">
                        <c:v>1217</c:v>
                      </c:pt>
                      <c:pt idx="668">
                        <c:v>1220</c:v>
                      </c:pt>
                      <c:pt idx="669">
                        <c:v>1221</c:v>
                      </c:pt>
                      <c:pt idx="670">
                        <c:v>1225</c:v>
                      </c:pt>
                      <c:pt idx="671">
                        <c:v>1229</c:v>
                      </c:pt>
                      <c:pt idx="672">
                        <c:v>1231</c:v>
                      </c:pt>
                      <c:pt idx="673">
                        <c:v>1232</c:v>
                      </c:pt>
                      <c:pt idx="674">
                        <c:v>1242</c:v>
                      </c:pt>
                      <c:pt idx="675">
                        <c:v>1253</c:v>
                      </c:pt>
                      <c:pt idx="676">
                        <c:v>1255</c:v>
                      </c:pt>
                      <c:pt idx="677">
                        <c:v>1256</c:v>
                      </c:pt>
                      <c:pt idx="678">
                        <c:v>1258</c:v>
                      </c:pt>
                      <c:pt idx="679">
                        <c:v>1259</c:v>
                      </c:pt>
                      <c:pt idx="680">
                        <c:v>1260</c:v>
                      </c:pt>
                      <c:pt idx="681">
                        <c:v>1261</c:v>
                      </c:pt>
                      <c:pt idx="682">
                        <c:v>1262</c:v>
                      </c:pt>
                      <c:pt idx="683">
                        <c:v>1263</c:v>
                      </c:pt>
                      <c:pt idx="684">
                        <c:v>1264</c:v>
                      </c:pt>
                      <c:pt idx="685">
                        <c:v>1266</c:v>
                      </c:pt>
                      <c:pt idx="686">
                        <c:v>1269</c:v>
                      </c:pt>
                      <c:pt idx="687">
                        <c:v>1279</c:v>
                      </c:pt>
                      <c:pt idx="688">
                        <c:v>1280</c:v>
                      </c:pt>
                      <c:pt idx="689">
                        <c:v>1290</c:v>
                      </c:pt>
                      <c:pt idx="690">
                        <c:v>1291</c:v>
                      </c:pt>
                      <c:pt idx="691">
                        <c:v>1292</c:v>
                      </c:pt>
                      <c:pt idx="692">
                        <c:v>1293</c:v>
                      </c:pt>
                      <c:pt idx="693">
                        <c:v>1294</c:v>
                      </c:pt>
                      <c:pt idx="694">
                        <c:v>1295</c:v>
                      </c:pt>
                      <c:pt idx="695">
                        <c:v>1300</c:v>
                      </c:pt>
                      <c:pt idx="696">
                        <c:v>1301</c:v>
                      </c:pt>
                      <c:pt idx="697">
                        <c:v>1302</c:v>
                      </c:pt>
                      <c:pt idx="698">
                        <c:v>1303</c:v>
                      </c:pt>
                      <c:pt idx="699">
                        <c:v>1305</c:v>
                      </c:pt>
                      <c:pt idx="700">
                        <c:v>1306</c:v>
                      </c:pt>
                      <c:pt idx="701">
                        <c:v>1307</c:v>
                      </c:pt>
                      <c:pt idx="702">
                        <c:v>1308</c:v>
                      </c:pt>
                      <c:pt idx="703">
                        <c:v>1310</c:v>
                      </c:pt>
                      <c:pt idx="704">
                        <c:v>1311</c:v>
                      </c:pt>
                      <c:pt idx="705">
                        <c:v>1312</c:v>
                      </c:pt>
                      <c:pt idx="706">
                        <c:v>1313</c:v>
                      </c:pt>
                      <c:pt idx="707">
                        <c:v>1314</c:v>
                      </c:pt>
                      <c:pt idx="708">
                        <c:v>1315</c:v>
                      </c:pt>
                      <c:pt idx="709">
                        <c:v>1316</c:v>
                      </c:pt>
                      <c:pt idx="710">
                        <c:v>1317</c:v>
                      </c:pt>
                      <c:pt idx="711">
                        <c:v>1318</c:v>
                      </c:pt>
                      <c:pt idx="712">
                        <c:v>1319</c:v>
                      </c:pt>
                      <c:pt idx="713">
                        <c:v>1320</c:v>
                      </c:pt>
                      <c:pt idx="714">
                        <c:v>1322</c:v>
                      </c:pt>
                      <c:pt idx="715">
                        <c:v>1323</c:v>
                      </c:pt>
                      <c:pt idx="716">
                        <c:v>1324</c:v>
                      </c:pt>
                      <c:pt idx="717">
                        <c:v>1325</c:v>
                      </c:pt>
                      <c:pt idx="718">
                        <c:v>1326</c:v>
                      </c:pt>
                      <c:pt idx="719">
                        <c:v>1327</c:v>
                      </c:pt>
                      <c:pt idx="720">
                        <c:v>1328</c:v>
                      </c:pt>
                      <c:pt idx="721">
                        <c:v>1329</c:v>
                      </c:pt>
                      <c:pt idx="722">
                        <c:v>1331</c:v>
                      </c:pt>
                      <c:pt idx="723">
                        <c:v>1333</c:v>
                      </c:pt>
                      <c:pt idx="724">
                        <c:v>1337</c:v>
                      </c:pt>
                      <c:pt idx="725">
                        <c:v>1338</c:v>
                      </c:pt>
                      <c:pt idx="726">
                        <c:v>1339</c:v>
                      </c:pt>
                      <c:pt idx="727">
                        <c:v>1342</c:v>
                      </c:pt>
                      <c:pt idx="728">
                        <c:v>1343</c:v>
                      </c:pt>
                      <c:pt idx="729">
                        <c:v>1344</c:v>
                      </c:pt>
                      <c:pt idx="730">
                        <c:v>1345</c:v>
                      </c:pt>
                      <c:pt idx="731">
                        <c:v>1346</c:v>
                      </c:pt>
                      <c:pt idx="732">
                        <c:v>1348</c:v>
                      </c:pt>
                      <c:pt idx="733">
                        <c:v>1349</c:v>
                      </c:pt>
                      <c:pt idx="734">
                        <c:v>1353</c:v>
                      </c:pt>
                      <c:pt idx="735">
                        <c:v>1355</c:v>
                      </c:pt>
                      <c:pt idx="736">
                        <c:v>1360</c:v>
                      </c:pt>
                      <c:pt idx="737">
                        <c:v>1361</c:v>
                      </c:pt>
                      <c:pt idx="738">
                        <c:v>1363</c:v>
                      </c:pt>
                      <c:pt idx="739">
                        <c:v>1364</c:v>
                      </c:pt>
                      <c:pt idx="740">
                        <c:v>1365</c:v>
                      </c:pt>
                      <c:pt idx="741">
                        <c:v>1366</c:v>
                      </c:pt>
                      <c:pt idx="742">
                        <c:v>1367</c:v>
                      </c:pt>
                      <c:pt idx="743">
                        <c:v>1369</c:v>
                      </c:pt>
                      <c:pt idx="744">
                        <c:v>1372</c:v>
                      </c:pt>
                      <c:pt idx="745">
                        <c:v>1373</c:v>
                      </c:pt>
                      <c:pt idx="746">
                        <c:v>1374</c:v>
                      </c:pt>
                      <c:pt idx="747">
                        <c:v>1375</c:v>
                      </c:pt>
                      <c:pt idx="748">
                        <c:v>1376</c:v>
                      </c:pt>
                      <c:pt idx="749">
                        <c:v>1377</c:v>
                      </c:pt>
                      <c:pt idx="750">
                        <c:v>1378</c:v>
                      </c:pt>
                      <c:pt idx="751">
                        <c:v>1379</c:v>
                      </c:pt>
                      <c:pt idx="752">
                        <c:v>1380</c:v>
                      </c:pt>
                      <c:pt idx="753">
                        <c:v>1381</c:v>
                      </c:pt>
                      <c:pt idx="754">
                        <c:v>1383</c:v>
                      </c:pt>
                      <c:pt idx="755">
                        <c:v>1384</c:v>
                      </c:pt>
                      <c:pt idx="756">
                        <c:v>1385</c:v>
                      </c:pt>
                      <c:pt idx="757">
                        <c:v>1386</c:v>
                      </c:pt>
                      <c:pt idx="758">
                        <c:v>1390</c:v>
                      </c:pt>
                      <c:pt idx="759">
                        <c:v>1391</c:v>
                      </c:pt>
                      <c:pt idx="760">
                        <c:v>1392</c:v>
                      </c:pt>
                      <c:pt idx="761">
                        <c:v>1393</c:v>
                      </c:pt>
                      <c:pt idx="762">
                        <c:v>1394</c:v>
                      </c:pt>
                      <c:pt idx="763">
                        <c:v>1395</c:v>
                      </c:pt>
                      <c:pt idx="764">
                        <c:v>1396</c:v>
                      </c:pt>
                      <c:pt idx="765">
                        <c:v>1397</c:v>
                      </c:pt>
                      <c:pt idx="766">
                        <c:v>1398</c:v>
                      </c:pt>
                      <c:pt idx="767">
                        <c:v>1400</c:v>
                      </c:pt>
                      <c:pt idx="768">
                        <c:v>1401</c:v>
                      </c:pt>
                      <c:pt idx="769">
                        <c:v>1402</c:v>
                      </c:pt>
                      <c:pt idx="770">
                        <c:v>1403</c:v>
                      </c:pt>
                      <c:pt idx="771">
                        <c:v>1405</c:v>
                      </c:pt>
                      <c:pt idx="772">
                        <c:v>1407</c:v>
                      </c:pt>
                      <c:pt idx="773">
                        <c:v>1408</c:v>
                      </c:pt>
                      <c:pt idx="774">
                        <c:v>1410</c:v>
                      </c:pt>
                      <c:pt idx="775">
                        <c:v>1411</c:v>
                      </c:pt>
                      <c:pt idx="776">
                        <c:v>1412</c:v>
                      </c:pt>
                      <c:pt idx="777">
                        <c:v>1413</c:v>
                      </c:pt>
                      <c:pt idx="778">
                        <c:v>1414</c:v>
                      </c:pt>
                      <c:pt idx="779">
                        <c:v>1415</c:v>
                      </c:pt>
                      <c:pt idx="780">
                        <c:v>1416</c:v>
                      </c:pt>
                      <c:pt idx="781">
                        <c:v>1417</c:v>
                      </c:pt>
                      <c:pt idx="782">
                        <c:v>1418</c:v>
                      </c:pt>
                      <c:pt idx="783">
                        <c:v>1419</c:v>
                      </c:pt>
                      <c:pt idx="784">
                        <c:v>1420</c:v>
                      </c:pt>
                      <c:pt idx="785">
                        <c:v>1421</c:v>
                      </c:pt>
                      <c:pt idx="786">
                        <c:v>1423</c:v>
                      </c:pt>
                      <c:pt idx="787">
                        <c:v>1424</c:v>
                      </c:pt>
                      <c:pt idx="788">
                        <c:v>1425</c:v>
                      </c:pt>
                      <c:pt idx="789">
                        <c:v>1426</c:v>
                      </c:pt>
                      <c:pt idx="790">
                        <c:v>1427</c:v>
                      </c:pt>
                      <c:pt idx="791">
                        <c:v>1428</c:v>
                      </c:pt>
                      <c:pt idx="792">
                        <c:v>1429</c:v>
                      </c:pt>
                      <c:pt idx="793">
                        <c:v>1430</c:v>
                      </c:pt>
                      <c:pt idx="794">
                        <c:v>1432</c:v>
                      </c:pt>
                      <c:pt idx="795">
                        <c:v>1434</c:v>
                      </c:pt>
                      <c:pt idx="796">
                        <c:v>1435</c:v>
                      </c:pt>
                      <c:pt idx="797">
                        <c:v>1436</c:v>
                      </c:pt>
                      <c:pt idx="798">
                        <c:v>1437</c:v>
                      </c:pt>
                      <c:pt idx="799">
                        <c:v>1439</c:v>
                      </c:pt>
                      <c:pt idx="800">
                        <c:v>1440</c:v>
                      </c:pt>
                      <c:pt idx="801">
                        <c:v>1442</c:v>
                      </c:pt>
                      <c:pt idx="802">
                        <c:v>1443</c:v>
                      </c:pt>
                      <c:pt idx="803">
                        <c:v>1444</c:v>
                      </c:pt>
                      <c:pt idx="804">
                        <c:v>1445</c:v>
                      </c:pt>
                      <c:pt idx="805">
                        <c:v>1446</c:v>
                      </c:pt>
                      <c:pt idx="806">
                        <c:v>1447</c:v>
                      </c:pt>
                      <c:pt idx="807">
                        <c:v>1448</c:v>
                      </c:pt>
                      <c:pt idx="808">
                        <c:v>1449</c:v>
                      </c:pt>
                      <c:pt idx="809">
                        <c:v>1450</c:v>
                      </c:pt>
                      <c:pt idx="810">
                        <c:v>1451</c:v>
                      </c:pt>
                      <c:pt idx="811">
                        <c:v>1453</c:v>
                      </c:pt>
                      <c:pt idx="812">
                        <c:v>1454</c:v>
                      </c:pt>
                      <c:pt idx="813">
                        <c:v>1455</c:v>
                      </c:pt>
                      <c:pt idx="814">
                        <c:v>1456</c:v>
                      </c:pt>
                      <c:pt idx="815">
                        <c:v>1457</c:v>
                      </c:pt>
                      <c:pt idx="816">
                        <c:v>1458</c:v>
                      </c:pt>
                      <c:pt idx="817">
                        <c:v>1459</c:v>
                      </c:pt>
                      <c:pt idx="818">
                        <c:v>1460</c:v>
                      </c:pt>
                      <c:pt idx="819">
                        <c:v>1461</c:v>
                      </c:pt>
                      <c:pt idx="820">
                        <c:v>1462</c:v>
                      </c:pt>
                      <c:pt idx="821">
                        <c:v>1463</c:v>
                      </c:pt>
                      <c:pt idx="822">
                        <c:v>1464</c:v>
                      </c:pt>
                      <c:pt idx="823">
                        <c:v>1465</c:v>
                      </c:pt>
                      <c:pt idx="824">
                        <c:v>1466</c:v>
                      </c:pt>
                      <c:pt idx="825">
                        <c:v>1467</c:v>
                      </c:pt>
                      <c:pt idx="826">
                        <c:v>1468</c:v>
                      </c:pt>
                      <c:pt idx="827">
                        <c:v>1469</c:v>
                      </c:pt>
                      <c:pt idx="828">
                        <c:v>1470</c:v>
                      </c:pt>
                      <c:pt idx="829">
                        <c:v>1471</c:v>
                      </c:pt>
                      <c:pt idx="830">
                        <c:v>1472</c:v>
                      </c:pt>
                      <c:pt idx="831">
                        <c:v>1473</c:v>
                      </c:pt>
                      <c:pt idx="832">
                        <c:v>1474</c:v>
                      </c:pt>
                      <c:pt idx="833">
                        <c:v>1475</c:v>
                      </c:pt>
                      <c:pt idx="834">
                        <c:v>1476</c:v>
                      </c:pt>
                      <c:pt idx="835">
                        <c:v>1477</c:v>
                      </c:pt>
                      <c:pt idx="836">
                        <c:v>1478</c:v>
                      </c:pt>
                      <c:pt idx="837">
                        <c:v>1479</c:v>
                      </c:pt>
                      <c:pt idx="838">
                        <c:v>1480</c:v>
                      </c:pt>
                      <c:pt idx="839">
                        <c:v>1481</c:v>
                      </c:pt>
                      <c:pt idx="840">
                        <c:v>1482</c:v>
                      </c:pt>
                      <c:pt idx="841">
                        <c:v>1483</c:v>
                      </c:pt>
                      <c:pt idx="842">
                        <c:v>1484</c:v>
                      </c:pt>
                      <c:pt idx="843">
                        <c:v>1485</c:v>
                      </c:pt>
                      <c:pt idx="844">
                        <c:v>1486</c:v>
                      </c:pt>
                      <c:pt idx="845">
                        <c:v>1487</c:v>
                      </c:pt>
                      <c:pt idx="846">
                        <c:v>1488</c:v>
                      </c:pt>
                      <c:pt idx="847">
                        <c:v>1489</c:v>
                      </c:pt>
                      <c:pt idx="848">
                        <c:v>1490</c:v>
                      </c:pt>
                      <c:pt idx="849">
                        <c:v>1491</c:v>
                      </c:pt>
                      <c:pt idx="850">
                        <c:v>1492</c:v>
                      </c:pt>
                      <c:pt idx="851">
                        <c:v>1493</c:v>
                      </c:pt>
                      <c:pt idx="852">
                        <c:v>1494</c:v>
                      </c:pt>
                      <c:pt idx="853">
                        <c:v>1495</c:v>
                      </c:pt>
                      <c:pt idx="854">
                        <c:v>1496</c:v>
                      </c:pt>
                      <c:pt idx="855">
                        <c:v>1497</c:v>
                      </c:pt>
                      <c:pt idx="856">
                        <c:v>1498</c:v>
                      </c:pt>
                      <c:pt idx="857">
                        <c:v>1499</c:v>
                      </c:pt>
                      <c:pt idx="858">
                        <c:v>1500</c:v>
                      </c:pt>
                      <c:pt idx="859">
                        <c:v>1501</c:v>
                      </c:pt>
                      <c:pt idx="860">
                        <c:v>1502</c:v>
                      </c:pt>
                      <c:pt idx="861">
                        <c:v>1503</c:v>
                      </c:pt>
                      <c:pt idx="862">
                        <c:v>1504</c:v>
                      </c:pt>
                      <c:pt idx="863">
                        <c:v>1505</c:v>
                      </c:pt>
                      <c:pt idx="864">
                        <c:v>1506</c:v>
                      </c:pt>
                      <c:pt idx="865">
                        <c:v>1507</c:v>
                      </c:pt>
                      <c:pt idx="866">
                        <c:v>1509</c:v>
                      </c:pt>
                      <c:pt idx="867">
                        <c:v>1510</c:v>
                      </c:pt>
                      <c:pt idx="868">
                        <c:v>1511</c:v>
                      </c:pt>
                      <c:pt idx="869">
                        <c:v>1512</c:v>
                      </c:pt>
                      <c:pt idx="870">
                        <c:v>1514</c:v>
                      </c:pt>
                      <c:pt idx="871">
                        <c:v>1515</c:v>
                      </c:pt>
                      <c:pt idx="872">
                        <c:v>1516</c:v>
                      </c:pt>
                      <c:pt idx="873">
                        <c:v>1517</c:v>
                      </c:pt>
                      <c:pt idx="874">
                        <c:v>1518</c:v>
                      </c:pt>
                      <c:pt idx="875">
                        <c:v>1519</c:v>
                      </c:pt>
                      <c:pt idx="876">
                        <c:v>1520</c:v>
                      </c:pt>
                      <c:pt idx="877">
                        <c:v>1521</c:v>
                      </c:pt>
                      <c:pt idx="878">
                        <c:v>1522</c:v>
                      </c:pt>
                      <c:pt idx="879">
                        <c:v>1523</c:v>
                      </c:pt>
                      <c:pt idx="880">
                        <c:v>1524</c:v>
                      </c:pt>
                      <c:pt idx="881">
                        <c:v>1525</c:v>
                      </c:pt>
                      <c:pt idx="882">
                        <c:v>1526</c:v>
                      </c:pt>
                      <c:pt idx="883">
                        <c:v>1527</c:v>
                      </c:pt>
                      <c:pt idx="884">
                        <c:v>1528</c:v>
                      </c:pt>
                      <c:pt idx="885">
                        <c:v>1529</c:v>
                      </c:pt>
                      <c:pt idx="886">
                        <c:v>1530</c:v>
                      </c:pt>
                      <c:pt idx="887">
                        <c:v>1531</c:v>
                      </c:pt>
                      <c:pt idx="888">
                        <c:v>1532</c:v>
                      </c:pt>
                      <c:pt idx="889">
                        <c:v>1533</c:v>
                      </c:pt>
                      <c:pt idx="890">
                        <c:v>1534</c:v>
                      </c:pt>
                      <c:pt idx="891">
                        <c:v>1535</c:v>
                      </c:pt>
                      <c:pt idx="892">
                        <c:v>1536</c:v>
                      </c:pt>
                      <c:pt idx="893">
                        <c:v>1537</c:v>
                      </c:pt>
                      <c:pt idx="894">
                        <c:v>1538</c:v>
                      </c:pt>
                      <c:pt idx="895">
                        <c:v>1539</c:v>
                      </c:pt>
                      <c:pt idx="896">
                        <c:v>1540</c:v>
                      </c:pt>
                      <c:pt idx="897">
                        <c:v>1541</c:v>
                      </c:pt>
                      <c:pt idx="898">
                        <c:v>1542</c:v>
                      </c:pt>
                      <c:pt idx="899">
                        <c:v>1543</c:v>
                      </c:pt>
                      <c:pt idx="900">
                        <c:v>1544</c:v>
                      </c:pt>
                      <c:pt idx="901">
                        <c:v>1545</c:v>
                      </c:pt>
                      <c:pt idx="902">
                        <c:v>1546</c:v>
                      </c:pt>
                      <c:pt idx="903">
                        <c:v>1547</c:v>
                      </c:pt>
                      <c:pt idx="904">
                        <c:v>1548</c:v>
                      </c:pt>
                      <c:pt idx="905">
                        <c:v>1549</c:v>
                      </c:pt>
                      <c:pt idx="906">
                        <c:v>1550</c:v>
                      </c:pt>
                      <c:pt idx="907">
                        <c:v>1551</c:v>
                      </c:pt>
                      <c:pt idx="908">
                        <c:v>1552</c:v>
                      </c:pt>
                      <c:pt idx="909">
                        <c:v>1553</c:v>
                      </c:pt>
                      <c:pt idx="910">
                        <c:v>1554</c:v>
                      </c:pt>
                      <c:pt idx="911">
                        <c:v>1555</c:v>
                      </c:pt>
                      <c:pt idx="912">
                        <c:v>1556</c:v>
                      </c:pt>
                      <c:pt idx="913">
                        <c:v>1557</c:v>
                      </c:pt>
                      <c:pt idx="914">
                        <c:v>1558</c:v>
                      </c:pt>
                      <c:pt idx="915">
                        <c:v>1559</c:v>
                      </c:pt>
                      <c:pt idx="916">
                        <c:v>1560</c:v>
                      </c:pt>
                      <c:pt idx="917">
                        <c:v>1561</c:v>
                      </c:pt>
                      <c:pt idx="918">
                        <c:v>1562</c:v>
                      </c:pt>
                      <c:pt idx="919">
                        <c:v>1563</c:v>
                      </c:pt>
                      <c:pt idx="920">
                        <c:v>1564</c:v>
                      </c:pt>
                      <c:pt idx="921">
                        <c:v>1565</c:v>
                      </c:pt>
                      <c:pt idx="922">
                        <c:v>1566</c:v>
                      </c:pt>
                      <c:pt idx="923">
                        <c:v>1567</c:v>
                      </c:pt>
                      <c:pt idx="924">
                        <c:v>1568</c:v>
                      </c:pt>
                      <c:pt idx="925">
                        <c:v>1569</c:v>
                      </c:pt>
                      <c:pt idx="926">
                        <c:v>1570</c:v>
                      </c:pt>
                      <c:pt idx="927">
                        <c:v>1571</c:v>
                      </c:pt>
                      <c:pt idx="928">
                        <c:v>1572</c:v>
                      </c:pt>
                      <c:pt idx="929">
                        <c:v>1573</c:v>
                      </c:pt>
                      <c:pt idx="930">
                        <c:v>1574</c:v>
                      </c:pt>
                      <c:pt idx="931">
                        <c:v>1575</c:v>
                      </c:pt>
                      <c:pt idx="932">
                        <c:v>1576</c:v>
                      </c:pt>
                      <c:pt idx="933">
                        <c:v>1577</c:v>
                      </c:pt>
                      <c:pt idx="934">
                        <c:v>1578</c:v>
                      </c:pt>
                      <c:pt idx="935">
                        <c:v>1579</c:v>
                      </c:pt>
                      <c:pt idx="936">
                        <c:v>1580</c:v>
                      </c:pt>
                      <c:pt idx="937">
                        <c:v>1582</c:v>
                      </c:pt>
                      <c:pt idx="938">
                        <c:v>1583</c:v>
                      </c:pt>
                      <c:pt idx="939">
                        <c:v>1584</c:v>
                      </c:pt>
                      <c:pt idx="940">
                        <c:v>1585</c:v>
                      </c:pt>
                      <c:pt idx="941">
                        <c:v>1586</c:v>
                      </c:pt>
                      <c:pt idx="942">
                        <c:v>1587</c:v>
                      </c:pt>
                      <c:pt idx="943">
                        <c:v>1588</c:v>
                      </c:pt>
                      <c:pt idx="944">
                        <c:v>1589</c:v>
                      </c:pt>
                      <c:pt idx="945">
                        <c:v>1591</c:v>
                      </c:pt>
                      <c:pt idx="946">
                        <c:v>1592</c:v>
                      </c:pt>
                      <c:pt idx="947">
                        <c:v>1593</c:v>
                      </c:pt>
                      <c:pt idx="948">
                        <c:v>1594</c:v>
                      </c:pt>
                      <c:pt idx="949">
                        <c:v>1595</c:v>
                      </c:pt>
                      <c:pt idx="950">
                        <c:v>1596</c:v>
                      </c:pt>
                      <c:pt idx="951">
                        <c:v>1597</c:v>
                      </c:pt>
                      <c:pt idx="952">
                        <c:v>1598</c:v>
                      </c:pt>
                      <c:pt idx="953">
                        <c:v>1599</c:v>
                      </c:pt>
                      <c:pt idx="954">
                        <c:v>1600</c:v>
                      </c:pt>
                      <c:pt idx="955">
                        <c:v>1601</c:v>
                      </c:pt>
                      <c:pt idx="956">
                        <c:v>1602</c:v>
                      </c:pt>
                      <c:pt idx="957">
                        <c:v>1603</c:v>
                      </c:pt>
                      <c:pt idx="958">
                        <c:v>1604</c:v>
                      </c:pt>
                      <c:pt idx="959">
                        <c:v>1605</c:v>
                      </c:pt>
                      <c:pt idx="960">
                        <c:v>1606</c:v>
                      </c:pt>
                      <c:pt idx="961">
                        <c:v>1607</c:v>
                      </c:pt>
                      <c:pt idx="962">
                        <c:v>1608</c:v>
                      </c:pt>
                      <c:pt idx="963">
                        <c:v>1609</c:v>
                      </c:pt>
                      <c:pt idx="964">
                        <c:v>1610</c:v>
                      </c:pt>
                      <c:pt idx="965">
                        <c:v>1611</c:v>
                      </c:pt>
                      <c:pt idx="966">
                        <c:v>1612</c:v>
                      </c:pt>
                      <c:pt idx="967">
                        <c:v>1613</c:v>
                      </c:pt>
                      <c:pt idx="968">
                        <c:v>1614</c:v>
                      </c:pt>
                      <c:pt idx="969">
                        <c:v>1615</c:v>
                      </c:pt>
                      <c:pt idx="970">
                        <c:v>1616</c:v>
                      </c:pt>
                      <c:pt idx="971">
                        <c:v>1617</c:v>
                      </c:pt>
                      <c:pt idx="972">
                        <c:v>1618</c:v>
                      </c:pt>
                      <c:pt idx="973">
                        <c:v>1619</c:v>
                      </c:pt>
                      <c:pt idx="974">
                        <c:v>1620</c:v>
                      </c:pt>
                      <c:pt idx="975">
                        <c:v>1621</c:v>
                      </c:pt>
                      <c:pt idx="976">
                        <c:v>1622</c:v>
                      </c:pt>
                      <c:pt idx="977">
                        <c:v>1623</c:v>
                      </c:pt>
                      <c:pt idx="978">
                        <c:v>1624</c:v>
                      </c:pt>
                      <c:pt idx="979">
                        <c:v>1625</c:v>
                      </c:pt>
                      <c:pt idx="980">
                        <c:v>1626</c:v>
                      </c:pt>
                      <c:pt idx="981">
                        <c:v>1627</c:v>
                      </c:pt>
                      <c:pt idx="982">
                        <c:v>1628</c:v>
                      </c:pt>
                      <c:pt idx="983">
                        <c:v>1629</c:v>
                      </c:pt>
                      <c:pt idx="984">
                        <c:v>1630</c:v>
                      </c:pt>
                      <c:pt idx="985">
                        <c:v>1631</c:v>
                      </c:pt>
                      <c:pt idx="986">
                        <c:v>1632</c:v>
                      </c:pt>
                      <c:pt idx="987">
                        <c:v>1633</c:v>
                      </c:pt>
                      <c:pt idx="988">
                        <c:v>1634</c:v>
                      </c:pt>
                      <c:pt idx="989">
                        <c:v>1635</c:v>
                      </c:pt>
                      <c:pt idx="990">
                        <c:v>1636</c:v>
                      </c:pt>
                      <c:pt idx="991">
                        <c:v>1637</c:v>
                      </c:pt>
                      <c:pt idx="992">
                        <c:v>1638</c:v>
                      </c:pt>
                      <c:pt idx="993">
                        <c:v>1639</c:v>
                      </c:pt>
                      <c:pt idx="994">
                        <c:v>1640</c:v>
                      </c:pt>
                      <c:pt idx="995">
                        <c:v>1641</c:v>
                      </c:pt>
                      <c:pt idx="996">
                        <c:v>1642</c:v>
                      </c:pt>
                      <c:pt idx="997">
                        <c:v>1643</c:v>
                      </c:pt>
                      <c:pt idx="998">
                        <c:v>1644</c:v>
                      </c:pt>
                      <c:pt idx="999">
                        <c:v>1645</c:v>
                      </c:pt>
                      <c:pt idx="1000">
                        <c:v>1646</c:v>
                      </c:pt>
                      <c:pt idx="1001">
                        <c:v>1647</c:v>
                      </c:pt>
                      <c:pt idx="1002">
                        <c:v>1648</c:v>
                      </c:pt>
                      <c:pt idx="1003">
                        <c:v>1649</c:v>
                      </c:pt>
                      <c:pt idx="1004">
                        <c:v>1650</c:v>
                      </c:pt>
                      <c:pt idx="1005">
                        <c:v>1651</c:v>
                      </c:pt>
                      <c:pt idx="1006">
                        <c:v>1652</c:v>
                      </c:pt>
                      <c:pt idx="1007">
                        <c:v>1653</c:v>
                      </c:pt>
                      <c:pt idx="1008">
                        <c:v>1654</c:v>
                      </c:pt>
                      <c:pt idx="1009">
                        <c:v>1655</c:v>
                      </c:pt>
                      <c:pt idx="1010">
                        <c:v>1656</c:v>
                      </c:pt>
                      <c:pt idx="1011">
                        <c:v>1657</c:v>
                      </c:pt>
                      <c:pt idx="1012">
                        <c:v>1658</c:v>
                      </c:pt>
                      <c:pt idx="1013">
                        <c:v>1659</c:v>
                      </c:pt>
                      <c:pt idx="1014">
                        <c:v>1660</c:v>
                      </c:pt>
                      <c:pt idx="1015">
                        <c:v>1661</c:v>
                      </c:pt>
                      <c:pt idx="1016">
                        <c:v>1663</c:v>
                      </c:pt>
                      <c:pt idx="1017">
                        <c:v>1664</c:v>
                      </c:pt>
                      <c:pt idx="1018">
                        <c:v>1668</c:v>
                      </c:pt>
                      <c:pt idx="1019">
                        <c:v>1669</c:v>
                      </c:pt>
                      <c:pt idx="1020">
                        <c:v>1672</c:v>
                      </c:pt>
                      <c:pt idx="1021">
                        <c:v>1673</c:v>
                      </c:pt>
                      <c:pt idx="1022">
                        <c:v>1674</c:v>
                      </c:pt>
                      <c:pt idx="1023">
                        <c:v>1675</c:v>
                      </c:pt>
                      <c:pt idx="1024">
                        <c:v>1676</c:v>
                      </c:pt>
                      <c:pt idx="1025">
                        <c:v>1677</c:v>
                      </c:pt>
                      <c:pt idx="1026">
                        <c:v>1678</c:v>
                      </c:pt>
                      <c:pt idx="1027">
                        <c:v>1679</c:v>
                      </c:pt>
                      <c:pt idx="1028">
                        <c:v>1680</c:v>
                      </c:pt>
                      <c:pt idx="1029">
                        <c:v>1681</c:v>
                      </c:pt>
                      <c:pt idx="1030">
                        <c:v>1682</c:v>
                      </c:pt>
                      <c:pt idx="1031">
                        <c:v>1683</c:v>
                      </c:pt>
                      <c:pt idx="1032">
                        <c:v>1684</c:v>
                      </c:pt>
                      <c:pt idx="1033">
                        <c:v>1685</c:v>
                      </c:pt>
                      <c:pt idx="1034">
                        <c:v>1686</c:v>
                      </c:pt>
                      <c:pt idx="1035">
                        <c:v>1687</c:v>
                      </c:pt>
                      <c:pt idx="1036">
                        <c:v>1688</c:v>
                      </c:pt>
                      <c:pt idx="1037">
                        <c:v>1689</c:v>
                      </c:pt>
                      <c:pt idx="1038">
                        <c:v>1690</c:v>
                      </c:pt>
                      <c:pt idx="1039">
                        <c:v>1701</c:v>
                      </c:pt>
                      <c:pt idx="1040">
                        <c:v>1704</c:v>
                      </c:pt>
                      <c:pt idx="1041">
                        <c:v>1708</c:v>
                      </c:pt>
                      <c:pt idx="1042">
                        <c:v>1709</c:v>
                      </c:pt>
                      <c:pt idx="1043">
                        <c:v>1710</c:v>
                      </c:pt>
                      <c:pt idx="1044">
                        <c:v>1712</c:v>
                      </c:pt>
                      <c:pt idx="1045">
                        <c:v>1713</c:v>
                      </c:pt>
                      <c:pt idx="1046">
                        <c:v>1714</c:v>
                      </c:pt>
                      <c:pt idx="1047">
                        <c:v>1715</c:v>
                      </c:pt>
                      <c:pt idx="1048">
                        <c:v>1716</c:v>
                      </c:pt>
                      <c:pt idx="1049">
                        <c:v>1717</c:v>
                      </c:pt>
                      <c:pt idx="1050">
                        <c:v>1718</c:v>
                      </c:pt>
                      <c:pt idx="1051">
                        <c:v>1721</c:v>
                      </c:pt>
                      <c:pt idx="1052">
                        <c:v>1722</c:v>
                      </c:pt>
                      <c:pt idx="1053">
                        <c:v>1725</c:v>
                      </c:pt>
                      <c:pt idx="1054">
                        <c:v>1726</c:v>
                      </c:pt>
                      <c:pt idx="1055">
                        <c:v>1732</c:v>
                      </c:pt>
                      <c:pt idx="1056">
                        <c:v>1746</c:v>
                      </c:pt>
                      <c:pt idx="1057">
                        <c:v>1951</c:v>
                      </c:pt>
                    </c:numCache>
                  </c:numRef>
                </c:xVal>
                <c:yVal>
                  <c:numRef>
                    <c:extLst>
                      <c:ext uri="{02D57815-91ED-43cb-92C2-25804820EDAC}">
                        <c15:formulaRef>
                          <c15:sqref>'Brachy NFY'!$C$3:$C$1060</c15:sqref>
                        </c15:formulaRef>
                      </c:ext>
                    </c:extLst>
                    <c:numCache>
                      <c:formatCode>General</c:formatCode>
                      <c:ptCount val="1058"/>
                      <c:pt idx="11">
                        <c:v>1</c:v>
                      </c:pt>
                      <c:pt idx="28">
                        <c:v>1</c:v>
                      </c:pt>
                      <c:pt idx="31">
                        <c:v>1</c:v>
                      </c:pt>
                      <c:pt idx="38">
                        <c:v>1</c:v>
                      </c:pt>
                      <c:pt idx="42">
                        <c:v>1</c:v>
                      </c:pt>
                      <c:pt idx="43">
                        <c:v>1</c:v>
                      </c:pt>
                      <c:pt idx="52">
                        <c:v>1</c:v>
                      </c:pt>
                      <c:pt idx="55">
                        <c:v>1</c:v>
                      </c:pt>
                      <c:pt idx="67">
                        <c:v>1</c:v>
                      </c:pt>
                      <c:pt idx="73">
                        <c:v>1</c:v>
                      </c:pt>
                      <c:pt idx="95">
                        <c:v>1</c:v>
                      </c:pt>
                      <c:pt idx="96">
                        <c:v>1</c:v>
                      </c:pt>
                      <c:pt idx="97">
                        <c:v>1</c:v>
                      </c:pt>
                      <c:pt idx="99">
                        <c:v>1</c:v>
                      </c:pt>
                      <c:pt idx="101">
                        <c:v>1</c:v>
                      </c:pt>
                      <c:pt idx="106">
                        <c:v>1</c:v>
                      </c:pt>
                      <c:pt idx="109">
                        <c:v>1</c:v>
                      </c:pt>
                      <c:pt idx="116">
                        <c:v>1</c:v>
                      </c:pt>
                      <c:pt idx="117">
                        <c:v>1</c:v>
                      </c:pt>
                      <c:pt idx="118">
                        <c:v>1</c:v>
                      </c:pt>
                      <c:pt idx="120">
                        <c:v>1</c:v>
                      </c:pt>
                      <c:pt idx="124">
                        <c:v>1</c:v>
                      </c:pt>
                      <c:pt idx="125">
                        <c:v>1</c:v>
                      </c:pt>
                      <c:pt idx="130">
                        <c:v>1</c:v>
                      </c:pt>
                      <c:pt idx="141">
                        <c:v>1</c:v>
                      </c:pt>
                      <c:pt idx="144">
                        <c:v>1</c:v>
                      </c:pt>
                      <c:pt idx="147">
                        <c:v>1</c:v>
                      </c:pt>
                      <c:pt idx="148">
                        <c:v>1</c:v>
                      </c:pt>
                      <c:pt idx="150">
                        <c:v>1</c:v>
                      </c:pt>
                      <c:pt idx="151">
                        <c:v>1</c:v>
                      </c:pt>
                      <c:pt idx="160">
                        <c:v>1</c:v>
                      </c:pt>
                      <c:pt idx="162">
                        <c:v>1</c:v>
                      </c:pt>
                      <c:pt idx="163">
                        <c:v>1</c:v>
                      </c:pt>
                      <c:pt idx="175">
                        <c:v>1</c:v>
                      </c:pt>
                      <c:pt idx="178">
                        <c:v>1</c:v>
                      </c:pt>
                      <c:pt idx="179">
                        <c:v>1</c:v>
                      </c:pt>
                      <c:pt idx="190">
                        <c:v>1</c:v>
                      </c:pt>
                      <c:pt idx="204">
                        <c:v>1</c:v>
                      </c:pt>
                      <c:pt idx="210">
                        <c:v>1</c:v>
                      </c:pt>
                      <c:pt idx="212">
                        <c:v>1</c:v>
                      </c:pt>
                      <c:pt idx="220">
                        <c:v>1</c:v>
                      </c:pt>
                      <c:pt idx="222">
                        <c:v>1</c:v>
                      </c:pt>
                      <c:pt idx="229">
                        <c:v>1</c:v>
                      </c:pt>
                      <c:pt idx="244">
                        <c:v>1</c:v>
                      </c:pt>
                      <c:pt idx="247">
                        <c:v>1</c:v>
                      </c:pt>
                      <c:pt idx="257">
                        <c:v>1</c:v>
                      </c:pt>
                      <c:pt idx="259">
                        <c:v>1</c:v>
                      </c:pt>
                      <c:pt idx="262">
                        <c:v>1</c:v>
                      </c:pt>
                      <c:pt idx="264">
                        <c:v>1</c:v>
                      </c:pt>
                      <c:pt idx="265">
                        <c:v>1</c:v>
                      </c:pt>
                      <c:pt idx="266">
                        <c:v>1</c:v>
                      </c:pt>
                      <c:pt idx="267">
                        <c:v>1</c:v>
                      </c:pt>
                      <c:pt idx="280">
                        <c:v>1</c:v>
                      </c:pt>
                      <c:pt idx="294">
                        <c:v>1</c:v>
                      </c:pt>
                      <c:pt idx="299">
                        <c:v>1</c:v>
                      </c:pt>
                      <c:pt idx="300">
                        <c:v>1</c:v>
                      </c:pt>
                      <c:pt idx="301">
                        <c:v>1</c:v>
                      </c:pt>
                      <c:pt idx="303">
                        <c:v>1</c:v>
                      </c:pt>
                      <c:pt idx="305">
                        <c:v>1</c:v>
                      </c:pt>
                      <c:pt idx="313">
                        <c:v>1</c:v>
                      </c:pt>
                      <c:pt idx="315">
                        <c:v>1</c:v>
                      </c:pt>
                      <c:pt idx="324">
                        <c:v>1</c:v>
                      </c:pt>
                      <c:pt idx="330">
                        <c:v>1</c:v>
                      </c:pt>
                      <c:pt idx="331">
                        <c:v>1</c:v>
                      </c:pt>
                      <c:pt idx="332">
                        <c:v>1</c:v>
                      </c:pt>
                      <c:pt idx="334">
                        <c:v>1</c:v>
                      </c:pt>
                      <c:pt idx="336">
                        <c:v>1</c:v>
                      </c:pt>
                      <c:pt idx="337">
                        <c:v>1</c:v>
                      </c:pt>
                      <c:pt idx="342">
                        <c:v>1</c:v>
                      </c:pt>
                      <c:pt idx="343">
                        <c:v>1</c:v>
                      </c:pt>
                      <c:pt idx="344">
                        <c:v>1</c:v>
                      </c:pt>
                      <c:pt idx="345">
                        <c:v>1</c:v>
                      </c:pt>
                      <c:pt idx="346">
                        <c:v>1</c:v>
                      </c:pt>
                      <c:pt idx="348">
                        <c:v>1</c:v>
                      </c:pt>
                      <c:pt idx="354">
                        <c:v>1</c:v>
                      </c:pt>
                      <c:pt idx="361">
                        <c:v>1</c:v>
                      </c:pt>
                      <c:pt idx="364">
                        <c:v>1</c:v>
                      </c:pt>
                      <c:pt idx="366">
                        <c:v>1</c:v>
                      </c:pt>
                      <c:pt idx="367">
                        <c:v>1</c:v>
                      </c:pt>
                      <c:pt idx="370">
                        <c:v>1</c:v>
                      </c:pt>
                      <c:pt idx="373">
                        <c:v>1</c:v>
                      </c:pt>
                      <c:pt idx="374">
                        <c:v>1</c:v>
                      </c:pt>
                      <c:pt idx="377">
                        <c:v>1</c:v>
                      </c:pt>
                      <c:pt idx="383">
                        <c:v>1</c:v>
                      </c:pt>
                      <c:pt idx="386">
                        <c:v>1</c:v>
                      </c:pt>
                      <c:pt idx="388">
                        <c:v>1</c:v>
                      </c:pt>
                      <c:pt idx="392">
                        <c:v>1</c:v>
                      </c:pt>
                      <c:pt idx="393">
                        <c:v>1</c:v>
                      </c:pt>
                      <c:pt idx="395">
                        <c:v>1</c:v>
                      </c:pt>
                      <c:pt idx="401">
                        <c:v>1</c:v>
                      </c:pt>
                      <c:pt idx="405">
                        <c:v>1</c:v>
                      </c:pt>
                      <c:pt idx="406">
                        <c:v>1</c:v>
                      </c:pt>
                      <c:pt idx="414">
                        <c:v>1</c:v>
                      </c:pt>
                      <c:pt idx="420">
                        <c:v>1</c:v>
                      </c:pt>
                      <c:pt idx="422">
                        <c:v>1</c:v>
                      </c:pt>
                      <c:pt idx="423">
                        <c:v>1</c:v>
                      </c:pt>
                      <c:pt idx="424">
                        <c:v>1</c:v>
                      </c:pt>
                      <c:pt idx="425">
                        <c:v>1</c:v>
                      </c:pt>
                      <c:pt idx="428">
                        <c:v>1</c:v>
                      </c:pt>
                      <c:pt idx="429">
                        <c:v>1</c:v>
                      </c:pt>
                      <c:pt idx="432">
                        <c:v>1</c:v>
                      </c:pt>
                      <c:pt idx="433">
                        <c:v>1</c:v>
                      </c:pt>
                      <c:pt idx="436">
                        <c:v>1</c:v>
                      </c:pt>
                      <c:pt idx="437">
                        <c:v>1</c:v>
                      </c:pt>
                      <c:pt idx="443">
                        <c:v>1</c:v>
                      </c:pt>
                      <c:pt idx="445">
                        <c:v>1</c:v>
                      </c:pt>
                      <c:pt idx="450">
                        <c:v>1</c:v>
                      </c:pt>
                      <c:pt idx="453">
                        <c:v>1</c:v>
                      </c:pt>
                      <c:pt idx="454">
                        <c:v>1</c:v>
                      </c:pt>
                      <c:pt idx="461">
                        <c:v>1</c:v>
                      </c:pt>
                      <c:pt idx="467">
                        <c:v>1</c:v>
                      </c:pt>
                      <c:pt idx="474">
                        <c:v>1</c:v>
                      </c:pt>
                      <c:pt idx="477">
                        <c:v>1</c:v>
                      </c:pt>
                      <c:pt idx="480">
                        <c:v>1</c:v>
                      </c:pt>
                      <c:pt idx="481">
                        <c:v>1</c:v>
                      </c:pt>
                      <c:pt idx="483">
                        <c:v>1</c:v>
                      </c:pt>
                      <c:pt idx="491">
                        <c:v>1</c:v>
                      </c:pt>
                      <c:pt idx="499">
                        <c:v>1</c:v>
                      </c:pt>
                      <c:pt idx="501">
                        <c:v>1</c:v>
                      </c:pt>
                      <c:pt idx="503">
                        <c:v>1</c:v>
                      </c:pt>
                      <c:pt idx="504">
                        <c:v>1</c:v>
                      </c:pt>
                      <c:pt idx="509">
                        <c:v>1</c:v>
                      </c:pt>
                      <c:pt idx="510">
                        <c:v>1</c:v>
                      </c:pt>
                      <c:pt idx="515">
                        <c:v>1</c:v>
                      </c:pt>
                      <c:pt idx="518">
                        <c:v>1</c:v>
                      </c:pt>
                      <c:pt idx="522">
                        <c:v>1</c:v>
                      </c:pt>
                      <c:pt idx="526">
                        <c:v>1</c:v>
                      </c:pt>
                      <c:pt idx="530">
                        <c:v>1</c:v>
                      </c:pt>
                      <c:pt idx="534">
                        <c:v>1</c:v>
                      </c:pt>
                      <c:pt idx="535">
                        <c:v>1</c:v>
                      </c:pt>
                      <c:pt idx="536">
                        <c:v>1</c:v>
                      </c:pt>
                      <c:pt idx="538">
                        <c:v>1</c:v>
                      </c:pt>
                      <c:pt idx="542">
                        <c:v>1</c:v>
                      </c:pt>
                      <c:pt idx="544">
                        <c:v>1</c:v>
                      </c:pt>
                      <c:pt idx="549">
                        <c:v>1</c:v>
                      </c:pt>
                      <c:pt idx="551">
                        <c:v>1</c:v>
                      </c:pt>
                      <c:pt idx="557">
                        <c:v>1</c:v>
                      </c:pt>
                      <c:pt idx="560">
                        <c:v>1</c:v>
                      </c:pt>
                      <c:pt idx="561">
                        <c:v>1</c:v>
                      </c:pt>
                      <c:pt idx="563">
                        <c:v>1</c:v>
                      </c:pt>
                      <c:pt idx="564">
                        <c:v>1</c:v>
                      </c:pt>
                      <c:pt idx="565">
                        <c:v>1</c:v>
                      </c:pt>
                      <c:pt idx="566">
                        <c:v>1</c:v>
                      </c:pt>
                      <c:pt idx="567">
                        <c:v>1</c:v>
                      </c:pt>
                      <c:pt idx="568">
                        <c:v>1</c:v>
                      </c:pt>
                      <c:pt idx="570">
                        <c:v>1</c:v>
                      </c:pt>
                      <c:pt idx="572">
                        <c:v>1</c:v>
                      </c:pt>
                      <c:pt idx="577">
                        <c:v>1</c:v>
                      </c:pt>
                      <c:pt idx="579">
                        <c:v>1</c:v>
                      </c:pt>
                      <c:pt idx="580">
                        <c:v>1</c:v>
                      </c:pt>
                      <c:pt idx="581">
                        <c:v>1</c:v>
                      </c:pt>
                      <c:pt idx="582">
                        <c:v>1</c:v>
                      </c:pt>
                      <c:pt idx="585">
                        <c:v>1</c:v>
                      </c:pt>
                      <c:pt idx="586">
                        <c:v>1</c:v>
                      </c:pt>
                      <c:pt idx="588">
                        <c:v>1</c:v>
                      </c:pt>
                      <c:pt idx="589">
                        <c:v>1</c:v>
                      </c:pt>
                      <c:pt idx="594">
                        <c:v>1</c:v>
                      </c:pt>
                      <c:pt idx="598">
                        <c:v>1</c:v>
                      </c:pt>
                      <c:pt idx="600">
                        <c:v>1</c:v>
                      </c:pt>
                      <c:pt idx="601">
                        <c:v>1</c:v>
                      </c:pt>
                      <c:pt idx="603">
                        <c:v>2</c:v>
                      </c:pt>
                      <c:pt idx="604">
                        <c:v>5</c:v>
                      </c:pt>
                      <c:pt idx="605">
                        <c:v>7</c:v>
                      </c:pt>
                      <c:pt idx="606">
                        <c:v>2</c:v>
                      </c:pt>
                      <c:pt idx="613">
                        <c:v>1</c:v>
                      </c:pt>
                      <c:pt idx="614">
                        <c:v>1</c:v>
                      </c:pt>
                      <c:pt idx="615">
                        <c:v>1</c:v>
                      </c:pt>
                      <c:pt idx="617">
                        <c:v>1</c:v>
                      </c:pt>
                      <c:pt idx="620">
                        <c:v>1</c:v>
                      </c:pt>
                      <c:pt idx="621">
                        <c:v>1</c:v>
                      </c:pt>
                      <c:pt idx="626">
                        <c:v>1</c:v>
                      </c:pt>
                      <c:pt idx="630">
                        <c:v>1</c:v>
                      </c:pt>
                      <c:pt idx="631">
                        <c:v>1</c:v>
                      </c:pt>
                      <c:pt idx="632">
                        <c:v>1</c:v>
                      </c:pt>
                      <c:pt idx="633">
                        <c:v>1</c:v>
                      </c:pt>
                      <c:pt idx="634">
                        <c:v>1</c:v>
                      </c:pt>
                      <c:pt idx="635">
                        <c:v>1</c:v>
                      </c:pt>
                      <c:pt idx="637">
                        <c:v>1</c:v>
                      </c:pt>
                      <c:pt idx="638">
                        <c:v>1</c:v>
                      </c:pt>
                      <c:pt idx="641">
                        <c:v>1</c:v>
                      </c:pt>
                      <c:pt idx="642">
                        <c:v>1</c:v>
                      </c:pt>
                      <c:pt idx="643">
                        <c:v>1</c:v>
                      </c:pt>
                      <c:pt idx="645">
                        <c:v>1</c:v>
                      </c:pt>
                      <c:pt idx="646">
                        <c:v>1</c:v>
                      </c:pt>
                      <c:pt idx="649">
                        <c:v>1</c:v>
                      </c:pt>
                      <c:pt idx="650">
                        <c:v>1</c:v>
                      </c:pt>
                      <c:pt idx="652">
                        <c:v>1</c:v>
                      </c:pt>
                      <c:pt idx="653">
                        <c:v>1</c:v>
                      </c:pt>
                      <c:pt idx="655">
                        <c:v>1</c:v>
                      </c:pt>
                      <c:pt idx="657">
                        <c:v>1</c:v>
                      </c:pt>
                      <c:pt idx="660">
                        <c:v>1</c:v>
                      </c:pt>
                      <c:pt idx="663">
                        <c:v>1</c:v>
                      </c:pt>
                      <c:pt idx="664">
                        <c:v>1</c:v>
                      </c:pt>
                      <c:pt idx="665">
                        <c:v>1</c:v>
                      </c:pt>
                      <c:pt idx="666">
                        <c:v>1</c:v>
                      </c:pt>
                      <c:pt idx="670">
                        <c:v>1</c:v>
                      </c:pt>
                      <c:pt idx="672">
                        <c:v>1</c:v>
                      </c:pt>
                      <c:pt idx="673">
                        <c:v>1</c:v>
                      </c:pt>
                      <c:pt idx="676">
                        <c:v>1</c:v>
                      </c:pt>
                      <c:pt idx="677">
                        <c:v>1</c:v>
                      </c:pt>
                      <c:pt idx="680">
                        <c:v>1</c:v>
                      </c:pt>
                      <c:pt idx="681">
                        <c:v>1</c:v>
                      </c:pt>
                      <c:pt idx="682">
                        <c:v>1</c:v>
                      </c:pt>
                      <c:pt idx="691">
                        <c:v>1</c:v>
                      </c:pt>
                      <c:pt idx="696">
                        <c:v>1</c:v>
                      </c:pt>
                      <c:pt idx="704">
                        <c:v>1</c:v>
                      </c:pt>
                      <c:pt idx="705">
                        <c:v>1</c:v>
                      </c:pt>
                      <c:pt idx="706">
                        <c:v>1</c:v>
                      </c:pt>
                      <c:pt idx="707">
                        <c:v>1</c:v>
                      </c:pt>
                      <c:pt idx="709">
                        <c:v>1</c:v>
                      </c:pt>
                      <c:pt idx="711">
                        <c:v>1</c:v>
                      </c:pt>
                      <c:pt idx="712">
                        <c:v>1</c:v>
                      </c:pt>
                      <c:pt idx="721">
                        <c:v>1</c:v>
                      </c:pt>
                      <c:pt idx="727">
                        <c:v>1</c:v>
                      </c:pt>
                      <c:pt idx="728">
                        <c:v>1</c:v>
                      </c:pt>
                      <c:pt idx="729">
                        <c:v>1</c:v>
                      </c:pt>
                      <c:pt idx="733">
                        <c:v>1</c:v>
                      </c:pt>
                      <c:pt idx="734">
                        <c:v>1</c:v>
                      </c:pt>
                      <c:pt idx="736">
                        <c:v>1</c:v>
                      </c:pt>
                      <c:pt idx="737">
                        <c:v>1</c:v>
                      </c:pt>
                      <c:pt idx="739">
                        <c:v>1</c:v>
                      </c:pt>
                      <c:pt idx="742">
                        <c:v>1</c:v>
                      </c:pt>
                      <c:pt idx="744">
                        <c:v>1</c:v>
                      </c:pt>
                      <c:pt idx="745">
                        <c:v>1</c:v>
                      </c:pt>
                      <c:pt idx="746">
                        <c:v>1</c:v>
                      </c:pt>
                      <c:pt idx="747">
                        <c:v>1</c:v>
                      </c:pt>
                      <c:pt idx="751">
                        <c:v>1</c:v>
                      </c:pt>
                      <c:pt idx="752">
                        <c:v>1</c:v>
                      </c:pt>
                      <c:pt idx="758">
                        <c:v>1</c:v>
                      </c:pt>
                      <c:pt idx="760">
                        <c:v>1</c:v>
                      </c:pt>
                      <c:pt idx="761">
                        <c:v>1</c:v>
                      </c:pt>
                      <c:pt idx="765">
                        <c:v>1</c:v>
                      </c:pt>
                      <c:pt idx="768">
                        <c:v>1</c:v>
                      </c:pt>
                      <c:pt idx="769">
                        <c:v>1</c:v>
                      </c:pt>
                      <c:pt idx="771">
                        <c:v>1</c:v>
                      </c:pt>
                      <c:pt idx="775">
                        <c:v>1</c:v>
                      </c:pt>
                      <c:pt idx="776">
                        <c:v>1</c:v>
                      </c:pt>
                      <c:pt idx="778">
                        <c:v>1</c:v>
                      </c:pt>
                      <c:pt idx="780">
                        <c:v>1</c:v>
                      </c:pt>
                      <c:pt idx="787">
                        <c:v>1</c:v>
                      </c:pt>
                      <c:pt idx="791">
                        <c:v>1</c:v>
                      </c:pt>
                      <c:pt idx="792">
                        <c:v>1</c:v>
                      </c:pt>
                      <c:pt idx="794">
                        <c:v>1</c:v>
                      </c:pt>
                      <c:pt idx="795">
                        <c:v>1</c:v>
                      </c:pt>
                      <c:pt idx="796">
                        <c:v>2</c:v>
                      </c:pt>
                      <c:pt idx="797">
                        <c:v>1</c:v>
                      </c:pt>
                      <c:pt idx="798">
                        <c:v>1</c:v>
                      </c:pt>
                      <c:pt idx="800">
                        <c:v>1</c:v>
                      </c:pt>
                      <c:pt idx="801">
                        <c:v>1</c:v>
                      </c:pt>
                      <c:pt idx="802">
                        <c:v>1</c:v>
                      </c:pt>
                      <c:pt idx="804">
                        <c:v>1</c:v>
                      </c:pt>
                      <c:pt idx="806">
                        <c:v>95</c:v>
                      </c:pt>
                      <c:pt idx="807">
                        <c:v>1</c:v>
                      </c:pt>
                      <c:pt idx="808">
                        <c:v>1</c:v>
                      </c:pt>
                      <c:pt idx="809">
                        <c:v>1</c:v>
                      </c:pt>
                      <c:pt idx="810">
                        <c:v>1</c:v>
                      </c:pt>
                      <c:pt idx="812">
                        <c:v>1</c:v>
                      </c:pt>
                      <c:pt idx="813">
                        <c:v>1</c:v>
                      </c:pt>
                      <c:pt idx="814">
                        <c:v>1</c:v>
                      </c:pt>
                      <c:pt idx="815">
                        <c:v>1</c:v>
                      </c:pt>
                      <c:pt idx="816">
                        <c:v>1</c:v>
                      </c:pt>
                      <c:pt idx="817">
                        <c:v>1</c:v>
                      </c:pt>
                      <c:pt idx="818">
                        <c:v>1</c:v>
                      </c:pt>
                      <c:pt idx="820">
                        <c:v>1</c:v>
                      </c:pt>
                      <c:pt idx="821">
                        <c:v>1</c:v>
                      </c:pt>
                      <c:pt idx="823">
                        <c:v>1</c:v>
                      </c:pt>
                      <c:pt idx="824">
                        <c:v>1</c:v>
                      </c:pt>
                      <c:pt idx="826">
                        <c:v>1</c:v>
                      </c:pt>
                      <c:pt idx="827">
                        <c:v>1</c:v>
                      </c:pt>
                      <c:pt idx="829">
                        <c:v>1</c:v>
                      </c:pt>
                      <c:pt idx="830">
                        <c:v>1</c:v>
                      </c:pt>
                      <c:pt idx="831">
                        <c:v>1</c:v>
                      </c:pt>
                      <c:pt idx="833">
                        <c:v>1</c:v>
                      </c:pt>
                      <c:pt idx="835">
                        <c:v>1</c:v>
                      </c:pt>
                      <c:pt idx="839">
                        <c:v>1</c:v>
                      </c:pt>
                      <c:pt idx="840">
                        <c:v>1</c:v>
                      </c:pt>
                      <c:pt idx="841">
                        <c:v>1</c:v>
                      </c:pt>
                      <c:pt idx="842">
                        <c:v>1</c:v>
                      </c:pt>
                      <c:pt idx="843">
                        <c:v>1</c:v>
                      </c:pt>
                      <c:pt idx="844">
                        <c:v>1</c:v>
                      </c:pt>
                      <c:pt idx="845">
                        <c:v>2</c:v>
                      </c:pt>
                      <c:pt idx="846">
                        <c:v>3</c:v>
                      </c:pt>
                      <c:pt idx="847">
                        <c:v>1</c:v>
                      </c:pt>
                      <c:pt idx="848">
                        <c:v>1</c:v>
                      </c:pt>
                      <c:pt idx="849">
                        <c:v>25</c:v>
                      </c:pt>
                      <c:pt idx="853">
                        <c:v>1</c:v>
                      </c:pt>
                      <c:pt idx="857">
                        <c:v>1</c:v>
                      </c:pt>
                      <c:pt idx="858">
                        <c:v>1</c:v>
                      </c:pt>
                      <c:pt idx="859">
                        <c:v>1</c:v>
                      </c:pt>
                      <c:pt idx="860">
                        <c:v>1</c:v>
                      </c:pt>
                      <c:pt idx="862">
                        <c:v>1</c:v>
                      </c:pt>
                      <c:pt idx="866">
                        <c:v>1</c:v>
                      </c:pt>
                      <c:pt idx="868">
                        <c:v>1</c:v>
                      </c:pt>
                      <c:pt idx="870">
                        <c:v>1</c:v>
                      </c:pt>
                      <c:pt idx="872">
                        <c:v>1</c:v>
                      </c:pt>
                      <c:pt idx="876">
                        <c:v>2</c:v>
                      </c:pt>
                      <c:pt idx="877">
                        <c:v>1</c:v>
                      </c:pt>
                      <c:pt idx="878">
                        <c:v>1</c:v>
                      </c:pt>
                      <c:pt idx="879">
                        <c:v>1</c:v>
                      </c:pt>
                      <c:pt idx="881">
                        <c:v>1</c:v>
                      </c:pt>
                      <c:pt idx="885">
                        <c:v>1</c:v>
                      </c:pt>
                      <c:pt idx="886">
                        <c:v>1</c:v>
                      </c:pt>
                      <c:pt idx="887">
                        <c:v>2</c:v>
                      </c:pt>
                      <c:pt idx="889">
                        <c:v>1</c:v>
                      </c:pt>
                      <c:pt idx="890">
                        <c:v>1</c:v>
                      </c:pt>
                      <c:pt idx="891">
                        <c:v>3</c:v>
                      </c:pt>
                      <c:pt idx="892">
                        <c:v>1</c:v>
                      </c:pt>
                      <c:pt idx="894">
                        <c:v>1</c:v>
                      </c:pt>
                      <c:pt idx="895">
                        <c:v>2</c:v>
                      </c:pt>
                      <c:pt idx="896">
                        <c:v>3</c:v>
                      </c:pt>
                      <c:pt idx="897">
                        <c:v>2</c:v>
                      </c:pt>
                      <c:pt idx="898">
                        <c:v>1</c:v>
                      </c:pt>
                      <c:pt idx="899">
                        <c:v>3</c:v>
                      </c:pt>
                      <c:pt idx="900">
                        <c:v>3</c:v>
                      </c:pt>
                      <c:pt idx="901">
                        <c:v>2</c:v>
                      </c:pt>
                      <c:pt idx="902">
                        <c:v>1</c:v>
                      </c:pt>
                      <c:pt idx="903">
                        <c:v>1</c:v>
                      </c:pt>
                      <c:pt idx="904">
                        <c:v>3</c:v>
                      </c:pt>
                      <c:pt idx="905">
                        <c:v>1</c:v>
                      </c:pt>
                      <c:pt idx="906">
                        <c:v>26</c:v>
                      </c:pt>
                      <c:pt idx="907">
                        <c:v>3</c:v>
                      </c:pt>
                      <c:pt idx="909">
                        <c:v>1</c:v>
                      </c:pt>
                      <c:pt idx="910">
                        <c:v>1</c:v>
                      </c:pt>
                      <c:pt idx="912">
                        <c:v>1</c:v>
                      </c:pt>
                      <c:pt idx="913">
                        <c:v>1</c:v>
                      </c:pt>
                      <c:pt idx="914">
                        <c:v>2</c:v>
                      </c:pt>
                      <c:pt idx="917">
                        <c:v>1</c:v>
                      </c:pt>
                      <c:pt idx="918">
                        <c:v>4</c:v>
                      </c:pt>
                      <c:pt idx="919">
                        <c:v>1</c:v>
                      </c:pt>
                      <c:pt idx="920">
                        <c:v>2</c:v>
                      </c:pt>
                      <c:pt idx="921">
                        <c:v>107</c:v>
                      </c:pt>
                      <c:pt idx="922">
                        <c:v>171</c:v>
                      </c:pt>
                      <c:pt idx="923">
                        <c:v>1</c:v>
                      </c:pt>
                      <c:pt idx="924">
                        <c:v>8</c:v>
                      </c:pt>
                      <c:pt idx="925">
                        <c:v>1</c:v>
                      </c:pt>
                      <c:pt idx="926">
                        <c:v>2</c:v>
                      </c:pt>
                      <c:pt idx="927">
                        <c:v>1</c:v>
                      </c:pt>
                      <c:pt idx="928">
                        <c:v>1</c:v>
                      </c:pt>
                      <c:pt idx="929">
                        <c:v>3</c:v>
                      </c:pt>
                      <c:pt idx="930">
                        <c:v>1</c:v>
                      </c:pt>
                      <c:pt idx="931">
                        <c:v>2</c:v>
                      </c:pt>
                      <c:pt idx="932">
                        <c:v>3</c:v>
                      </c:pt>
                      <c:pt idx="934">
                        <c:v>1</c:v>
                      </c:pt>
                      <c:pt idx="935">
                        <c:v>5</c:v>
                      </c:pt>
                      <c:pt idx="936">
                        <c:v>1</c:v>
                      </c:pt>
                      <c:pt idx="937">
                        <c:v>1</c:v>
                      </c:pt>
                      <c:pt idx="938">
                        <c:v>1</c:v>
                      </c:pt>
                      <c:pt idx="939">
                        <c:v>3</c:v>
                      </c:pt>
                      <c:pt idx="940">
                        <c:v>3</c:v>
                      </c:pt>
                      <c:pt idx="941">
                        <c:v>1</c:v>
                      </c:pt>
                      <c:pt idx="942">
                        <c:v>1</c:v>
                      </c:pt>
                      <c:pt idx="943">
                        <c:v>1</c:v>
                      </c:pt>
                      <c:pt idx="944">
                        <c:v>1</c:v>
                      </c:pt>
                      <c:pt idx="945">
                        <c:v>1</c:v>
                      </c:pt>
                      <c:pt idx="947">
                        <c:v>1</c:v>
                      </c:pt>
                      <c:pt idx="948">
                        <c:v>1</c:v>
                      </c:pt>
                      <c:pt idx="949">
                        <c:v>1</c:v>
                      </c:pt>
                      <c:pt idx="950">
                        <c:v>7</c:v>
                      </c:pt>
                      <c:pt idx="951">
                        <c:v>6</c:v>
                      </c:pt>
                      <c:pt idx="952">
                        <c:v>4</c:v>
                      </c:pt>
                      <c:pt idx="953">
                        <c:v>1</c:v>
                      </c:pt>
                      <c:pt idx="954">
                        <c:v>2</c:v>
                      </c:pt>
                      <c:pt idx="955">
                        <c:v>4</c:v>
                      </c:pt>
                      <c:pt idx="956">
                        <c:v>1</c:v>
                      </c:pt>
                      <c:pt idx="957">
                        <c:v>1</c:v>
                      </c:pt>
                      <c:pt idx="958">
                        <c:v>1</c:v>
                      </c:pt>
                      <c:pt idx="959">
                        <c:v>1</c:v>
                      </c:pt>
                      <c:pt idx="961">
                        <c:v>1</c:v>
                      </c:pt>
                      <c:pt idx="962">
                        <c:v>9</c:v>
                      </c:pt>
                      <c:pt idx="963">
                        <c:v>6</c:v>
                      </c:pt>
                      <c:pt idx="964">
                        <c:v>1</c:v>
                      </c:pt>
                      <c:pt idx="965">
                        <c:v>2</c:v>
                      </c:pt>
                      <c:pt idx="966">
                        <c:v>2</c:v>
                      </c:pt>
                      <c:pt idx="967">
                        <c:v>1</c:v>
                      </c:pt>
                      <c:pt idx="969">
                        <c:v>3</c:v>
                      </c:pt>
                      <c:pt idx="970">
                        <c:v>1</c:v>
                      </c:pt>
                      <c:pt idx="971">
                        <c:v>2</c:v>
                      </c:pt>
                      <c:pt idx="972">
                        <c:v>1</c:v>
                      </c:pt>
                      <c:pt idx="973">
                        <c:v>7</c:v>
                      </c:pt>
                      <c:pt idx="974">
                        <c:v>3</c:v>
                      </c:pt>
                      <c:pt idx="975">
                        <c:v>1</c:v>
                      </c:pt>
                      <c:pt idx="976">
                        <c:v>1</c:v>
                      </c:pt>
                      <c:pt idx="977">
                        <c:v>2</c:v>
                      </c:pt>
                      <c:pt idx="978">
                        <c:v>8</c:v>
                      </c:pt>
                      <c:pt idx="979">
                        <c:v>1</c:v>
                      </c:pt>
                      <c:pt idx="980">
                        <c:v>1</c:v>
                      </c:pt>
                      <c:pt idx="981">
                        <c:v>1</c:v>
                      </c:pt>
                      <c:pt idx="982">
                        <c:v>1</c:v>
                      </c:pt>
                      <c:pt idx="983">
                        <c:v>1</c:v>
                      </c:pt>
                      <c:pt idx="984">
                        <c:v>3</c:v>
                      </c:pt>
                      <c:pt idx="985">
                        <c:v>1</c:v>
                      </c:pt>
                      <c:pt idx="986">
                        <c:v>2</c:v>
                      </c:pt>
                      <c:pt idx="987">
                        <c:v>2</c:v>
                      </c:pt>
                      <c:pt idx="988">
                        <c:v>1</c:v>
                      </c:pt>
                      <c:pt idx="989">
                        <c:v>1</c:v>
                      </c:pt>
                      <c:pt idx="990">
                        <c:v>1</c:v>
                      </c:pt>
                      <c:pt idx="991">
                        <c:v>75</c:v>
                      </c:pt>
                      <c:pt idx="992">
                        <c:v>99</c:v>
                      </c:pt>
                      <c:pt idx="993">
                        <c:v>1</c:v>
                      </c:pt>
                      <c:pt idx="994">
                        <c:v>1</c:v>
                      </c:pt>
                      <c:pt idx="995">
                        <c:v>1</c:v>
                      </c:pt>
                      <c:pt idx="996">
                        <c:v>2</c:v>
                      </c:pt>
                      <c:pt idx="997">
                        <c:v>3</c:v>
                      </c:pt>
                      <c:pt idx="998">
                        <c:v>1</c:v>
                      </c:pt>
                      <c:pt idx="999">
                        <c:v>1</c:v>
                      </c:pt>
                      <c:pt idx="1000">
                        <c:v>2</c:v>
                      </c:pt>
                      <c:pt idx="1001">
                        <c:v>1</c:v>
                      </c:pt>
                      <c:pt idx="1002">
                        <c:v>3</c:v>
                      </c:pt>
                      <c:pt idx="1003">
                        <c:v>6</c:v>
                      </c:pt>
                      <c:pt idx="1004">
                        <c:v>3</c:v>
                      </c:pt>
                      <c:pt idx="1005">
                        <c:v>2</c:v>
                      </c:pt>
                      <c:pt idx="1006">
                        <c:v>1</c:v>
                      </c:pt>
                      <c:pt idx="1007">
                        <c:v>2</c:v>
                      </c:pt>
                      <c:pt idx="1008">
                        <c:v>2</c:v>
                      </c:pt>
                      <c:pt idx="1009">
                        <c:v>1</c:v>
                      </c:pt>
                      <c:pt idx="1010">
                        <c:v>2</c:v>
                      </c:pt>
                      <c:pt idx="1011">
                        <c:v>1</c:v>
                      </c:pt>
                      <c:pt idx="1012">
                        <c:v>1</c:v>
                      </c:pt>
                      <c:pt idx="1013">
                        <c:v>1</c:v>
                      </c:pt>
                      <c:pt idx="1016">
                        <c:v>1</c:v>
                      </c:pt>
                      <c:pt idx="1018">
                        <c:v>1</c:v>
                      </c:pt>
                      <c:pt idx="1019">
                        <c:v>1</c:v>
                      </c:pt>
                      <c:pt idx="1020">
                        <c:v>1</c:v>
                      </c:pt>
                      <c:pt idx="1024">
                        <c:v>1</c:v>
                      </c:pt>
                      <c:pt idx="1025">
                        <c:v>1</c:v>
                      </c:pt>
                      <c:pt idx="1026">
                        <c:v>4</c:v>
                      </c:pt>
                      <c:pt idx="1027">
                        <c:v>1</c:v>
                      </c:pt>
                      <c:pt idx="1028">
                        <c:v>1</c:v>
                      </c:pt>
                      <c:pt idx="1030">
                        <c:v>1</c:v>
                      </c:pt>
                      <c:pt idx="1031">
                        <c:v>1</c:v>
                      </c:pt>
                      <c:pt idx="1032">
                        <c:v>1</c:v>
                      </c:pt>
                      <c:pt idx="1033">
                        <c:v>1</c:v>
                      </c:pt>
                      <c:pt idx="1034">
                        <c:v>1</c:v>
                      </c:pt>
                      <c:pt idx="1036">
                        <c:v>1</c:v>
                      </c:pt>
                      <c:pt idx="1037">
                        <c:v>1</c:v>
                      </c:pt>
                      <c:pt idx="1042">
                        <c:v>1</c:v>
                      </c:pt>
                      <c:pt idx="1044">
                        <c:v>1</c:v>
                      </c:pt>
                      <c:pt idx="1045">
                        <c:v>1</c:v>
                      </c:pt>
                      <c:pt idx="1047">
                        <c:v>1</c:v>
                      </c:pt>
                      <c:pt idx="1049">
                        <c:v>1</c:v>
                      </c:pt>
                      <c:pt idx="1052">
                        <c:v>1</c:v>
                      </c:pt>
                      <c:pt idx="1053">
                        <c:v>1</c:v>
                      </c:pt>
                      <c:pt idx="1054">
                        <c:v>1</c:v>
                      </c:pt>
                      <c:pt idx="1057">
                        <c:v>1</c:v>
                      </c:pt>
                    </c:numCache>
                  </c:numRef>
                </c:yVal>
                <c:smooth val="0"/>
              </c15:ser>
            </c15:filteredScatterSeries>
            <c15:filteredScatterSeries>
              <c15:ser>
                <c:idx val="1"/>
                <c:order val="1"/>
                <c:tx>
                  <c:strRef>
                    <c:extLst xmlns:c15="http://schemas.microsoft.com/office/drawing/2012/chart">
                      <c:ext xmlns:c15="http://schemas.microsoft.com/office/drawing/2012/chart" uri="{02D57815-91ED-43cb-92C2-25804820EDAC}">
                        <c15:formulaRef>
                          <c15:sqref>'Brachy NFY'!$D$2</c15:sqref>
                        </c15:formulaRef>
                      </c:ext>
                    </c:extLst>
                    <c:strCache>
                      <c:ptCount val="1"/>
                      <c:pt idx="0">
                        <c:v>Control2</c:v>
                      </c:pt>
                    </c:strCache>
                  </c:strRef>
                </c:tx>
                <c:spPr>
                  <a:ln w="25400" cap="rnd">
                    <a:noFill/>
                    <a:round/>
                  </a:ln>
                  <a:effectLst/>
                </c:spPr>
                <c:marker>
                  <c:symbol val="circle"/>
                  <c:size val="5"/>
                  <c:spPr>
                    <a:solidFill>
                      <a:schemeClr val="tx1"/>
                    </a:solidFill>
                    <a:ln w="9525">
                      <a:solidFill>
                        <a:schemeClr val="tx1"/>
                      </a:solidFill>
                    </a:ln>
                    <a:effectLst/>
                  </c:spPr>
                </c:marker>
                <c:xVal>
                  <c:numRef>
                    <c:extLst xmlns:c15="http://schemas.microsoft.com/office/drawing/2012/chart">
                      <c:ext xmlns:c15="http://schemas.microsoft.com/office/drawing/2012/chart" uri="{02D57815-91ED-43cb-92C2-25804820EDAC}">
                        <c15:formulaRef>
                          <c15:sqref>'Brachy NFY'!$B$3:$B$1060</c15:sqref>
                        </c15:formulaRef>
                      </c:ext>
                    </c:extLst>
                    <c:numCache>
                      <c:formatCode>General</c:formatCode>
                      <c:ptCount val="1058"/>
                      <c:pt idx="0">
                        <c:v>52</c:v>
                      </c:pt>
                      <c:pt idx="1">
                        <c:v>62</c:v>
                      </c:pt>
                      <c:pt idx="2">
                        <c:v>69</c:v>
                      </c:pt>
                      <c:pt idx="3">
                        <c:v>77</c:v>
                      </c:pt>
                      <c:pt idx="4">
                        <c:v>89</c:v>
                      </c:pt>
                      <c:pt idx="5">
                        <c:v>92</c:v>
                      </c:pt>
                      <c:pt idx="6">
                        <c:v>95</c:v>
                      </c:pt>
                      <c:pt idx="7">
                        <c:v>100</c:v>
                      </c:pt>
                      <c:pt idx="8">
                        <c:v>116</c:v>
                      </c:pt>
                      <c:pt idx="9">
                        <c:v>123</c:v>
                      </c:pt>
                      <c:pt idx="10">
                        <c:v>125</c:v>
                      </c:pt>
                      <c:pt idx="11">
                        <c:v>129</c:v>
                      </c:pt>
                      <c:pt idx="12">
                        <c:v>135</c:v>
                      </c:pt>
                      <c:pt idx="13">
                        <c:v>146</c:v>
                      </c:pt>
                      <c:pt idx="14">
                        <c:v>147</c:v>
                      </c:pt>
                      <c:pt idx="15">
                        <c:v>148</c:v>
                      </c:pt>
                      <c:pt idx="16">
                        <c:v>149</c:v>
                      </c:pt>
                      <c:pt idx="17">
                        <c:v>150</c:v>
                      </c:pt>
                      <c:pt idx="18">
                        <c:v>152</c:v>
                      </c:pt>
                      <c:pt idx="19">
                        <c:v>153</c:v>
                      </c:pt>
                      <c:pt idx="20">
                        <c:v>155</c:v>
                      </c:pt>
                      <c:pt idx="21">
                        <c:v>157</c:v>
                      </c:pt>
                      <c:pt idx="22">
                        <c:v>158</c:v>
                      </c:pt>
                      <c:pt idx="23">
                        <c:v>159</c:v>
                      </c:pt>
                      <c:pt idx="24">
                        <c:v>160</c:v>
                      </c:pt>
                      <c:pt idx="25">
                        <c:v>162</c:v>
                      </c:pt>
                      <c:pt idx="26">
                        <c:v>164</c:v>
                      </c:pt>
                      <c:pt idx="27">
                        <c:v>169</c:v>
                      </c:pt>
                      <c:pt idx="28">
                        <c:v>171</c:v>
                      </c:pt>
                      <c:pt idx="29">
                        <c:v>173</c:v>
                      </c:pt>
                      <c:pt idx="30">
                        <c:v>174</c:v>
                      </c:pt>
                      <c:pt idx="31">
                        <c:v>181</c:v>
                      </c:pt>
                      <c:pt idx="32">
                        <c:v>186</c:v>
                      </c:pt>
                      <c:pt idx="33">
                        <c:v>187</c:v>
                      </c:pt>
                      <c:pt idx="34">
                        <c:v>190</c:v>
                      </c:pt>
                      <c:pt idx="35">
                        <c:v>192</c:v>
                      </c:pt>
                      <c:pt idx="36">
                        <c:v>197</c:v>
                      </c:pt>
                      <c:pt idx="37">
                        <c:v>202</c:v>
                      </c:pt>
                      <c:pt idx="38">
                        <c:v>204</c:v>
                      </c:pt>
                      <c:pt idx="39">
                        <c:v>206</c:v>
                      </c:pt>
                      <c:pt idx="40">
                        <c:v>208</c:v>
                      </c:pt>
                      <c:pt idx="41">
                        <c:v>209</c:v>
                      </c:pt>
                      <c:pt idx="42">
                        <c:v>210</c:v>
                      </c:pt>
                      <c:pt idx="43">
                        <c:v>217</c:v>
                      </c:pt>
                      <c:pt idx="44">
                        <c:v>219</c:v>
                      </c:pt>
                      <c:pt idx="45">
                        <c:v>220</c:v>
                      </c:pt>
                      <c:pt idx="46">
                        <c:v>222</c:v>
                      </c:pt>
                      <c:pt idx="47">
                        <c:v>226</c:v>
                      </c:pt>
                      <c:pt idx="48">
                        <c:v>227</c:v>
                      </c:pt>
                      <c:pt idx="49">
                        <c:v>230</c:v>
                      </c:pt>
                      <c:pt idx="50">
                        <c:v>231</c:v>
                      </c:pt>
                      <c:pt idx="51">
                        <c:v>232</c:v>
                      </c:pt>
                      <c:pt idx="52">
                        <c:v>235</c:v>
                      </c:pt>
                      <c:pt idx="53">
                        <c:v>236</c:v>
                      </c:pt>
                      <c:pt idx="54">
                        <c:v>240</c:v>
                      </c:pt>
                      <c:pt idx="55">
                        <c:v>241</c:v>
                      </c:pt>
                      <c:pt idx="56">
                        <c:v>244</c:v>
                      </c:pt>
                      <c:pt idx="57">
                        <c:v>245</c:v>
                      </c:pt>
                      <c:pt idx="58">
                        <c:v>247</c:v>
                      </c:pt>
                      <c:pt idx="59">
                        <c:v>248</c:v>
                      </c:pt>
                      <c:pt idx="60">
                        <c:v>251</c:v>
                      </c:pt>
                      <c:pt idx="61">
                        <c:v>254</c:v>
                      </c:pt>
                      <c:pt idx="62">
                        <c:v>255</c:v>
                      </c:pt>
                      <c:pt idx="63">
                        <c:v>258</c:v>
                      </c:pt>
                      <c:pt idx="64">
                        <c:v>260</c:v>
                      </c:pt>
                      <c:pt idx="65">
                        <c:v>261</c:v>
                      </c:pt>
                      <c:pt idx="66">
                        <c:v>262</c:v>
                      </c:pt>
                      <c:pt idx="67">
                        <c:v>263</c:v>
                      </c:pt>
                      <c:pt idx="68">
                        <c:v>264</c:v>
                      </c:pt>
                      <c:pt idx="69">
                        <c:v>265</c:v>
                      </c:pt>
                      <c:pt idx="70">
                        <c:v>266</c:v>
                      </c:pt>
                      <c:pt idx="71">
                        <c:v>267</c:v>
                      </c:pt>
                      <c:pt idx="72">
                        <c:v>268</c:v>
                      </c:pt>
                      <c:pt idx="73">
                        <c:v>270</c:v>
                      </c:pt>
                      <c:pt idx="74">
                        <c:v>273</c:v>
                      </c:pt>
                      <c:pt idx="75">
                        <c:v>286</c:v>
                      </c:pt>
                      <c:pt idx="76">
                        <c:v>289</c:v>
                      </c:pt>
                      <c:pt idx="77">
                        <c:v>290</c:v>
                      </c:pt>
                      <c:pt idx="78">
                        <c:v>292</c:v>
                      </c:pt>
                      <c:pt idx="79">
                        <c:v>294</c:v>
                      </c:pt>
                      <c:pt idx="80">
                        <c:v>295</c:v>
                      </c:pt>
                      <c:pt idx="81">
                        <c:v>297</c:v>
                      </c:pt>
                      <c:pt idx="82">
                        <c:v>302</c:v>
                      </c:pt>
                      <c:pt idx="83">
                        <c:v>303</c:v>
                      </c:pt>
                      <c:pt idx="84">
                        <c:v>307</c:v>
                      </c:pt>
                      <c:pt idx="85">
                        <c:v>309</c:v>
                      </c:pt>
                      <c:pt idx="86">
                        <c:v>310</c:v>
                      </c:pt>
                      <c:pt idx="87">
                        <c:v>312</c:v>
                      </c:pt>
                      <c:pt idx="88">
                        <c:v>313</c:v>
                      </c:pt>
                      <c:pt idx="89">
                        <c:v>314</c:v>
                      </c:pt>
                      <c:pt idx="90">
                        <c:v>315</c:v>
                      </c:pt>
                      <c:pt idx="91">
                        <c:v>316</c:v>
                      </c:pt>
                      <c:pt idx="92">
                        <c:v>326</c:v>
                      </c:pt>
                      <c:pt idx="93">
                        <c:v>330</c:v>
                      </c:pt>
                      <c:pt idx="94">
                        <c:v>335</c:v>
                      </c:pt>
                      <c:pt idx="95">
                        <c:v>338</c:v>
                      </c:pt>
                      <c:pt idx="96">
                        <c:v>339</c:v>
                      </c:pt>
                      <c:pt idx="97">
                        <c:v>344</c:v>
                      </c:pt>
                      <c:pt idx="98">
                        <c:v>349</c:v>
                      </c:pt>
                      <c:pt idx="99">
                        <c:v>351</c:v>
                      </c:pt>
                      <c:pt idx="100">
                        <c:v>354</c:v>
                      </c:pt>
                      <c:pt idx="101">
                        <c:v>357</c:v>
                      </c:pt>
                      <c:pt idx="102">
                        <c:v>361</c:v>
                      </c:pt>
                      <c:pt idx="103">
                        <c:v>364</c:v>
                      </c:pt>
                      <c:pt idx="104">
                        <c:v>373</c:v>
                      </c:pt>
                      <c:pt idx="105">
                        <c:v>377</c:v>
                      </c:pt>
                      <c:pt idx="106">
                        <c:v>378</c:v>
                      </c:pt>
                      <c:pt idx="107">
                        <c:v>379</c:v>
                      </c:pt>
                      <c:pt idx="108">
                        <c:v>382</c:v>
                      </c:pt>
                      <c:pt idx="109">
                        <c:v>390</c:v>
                      </c:pt>
                      <c:pt idx="110">
                        <c:v>394</c:v>
                      </c:pt>
                      <c:pt idx="111">
                        <c:v>396</c:v>
                      </c:pt>
                      <c:pt idx="112">
                        <c:v>397</c:v>
                      </c:pt>
                      <c:pt idx="113">
                        <c:v>400</c:v>
                      </c:pt>
                      <c:pt idx="114">
                        <c:v>403</c:v>
                      </c:pt>
                      <c:pt idx="115">
                        <c:v>405</c:v>
                      </c:pt>
                      <c:pt idx="116">
                        <c:v>406</c:v>
                      </c:pt>
                      <c:pt idx="117">
                        <c:v>407</c:v>
                      </c:pt>
                      <c:pt idx="118">
                        <c:v>408</c:v>
                      </c:pt>
                      <c:pt idx="119">
                        <c:v>409</c:v>
                      </c:pt>
                      <c:pt idx="120">
                        <c:v>410</c:v>
                      </c:pt>
                      <c:pt idx="121">
                        <c:v>416</c:v>
                      </c:pt>
                      <c:pt idx="122">
                        <c:v>418</c:v>
                      </c:pt>
                      <c:pt idx="123">
                        <c:v>423</c:v>
                      </c:pt>
                      <c:pt idx="124">
                        <c:v>424</c:v>
                      </c:pt>
                      <c:pt idx="125">
                        <c:v>426</c:v>
                      </c:pt>
                      <c:pt idx="126">
                        <c:v>428</c:v>
                      </c:pt>
                      <c:pt idx="127">
                        <c:v>429</c:v>
                      </c:pt>
                      <c:pt idx="128">
                        <c:v>430</c:v>
                      </c:pt>
                      <c:pt idx="129">
                        <c:v>433</c:v>
                      </c:pt>
                      <c:pt idx="130">
                        <c:v>438</c:v>
                      </c:pt>
                      <c:pt idx="131">
                        <c:v>440</c:v>
                      </c:pt>
                      <c:pt idx="132">
                        <c:v>450</c:v>
                      </c:pt>
                      <c:pt idx="133">
                        <c:v>453</c:v>
                      </c:pt>
                      <c:pt idx="134">
                        <c:v>460</c:v>
                      </c:pt>
                      <c:pt idx="135">
                        <c:v>461</c:v>
                      </c:pt>
                      <c:pt idx="136">
                        <c:v>464</c:v>
                      </c:pt>
                      <c:pt idx="137">
                        <c:v>465</c:v>
                      </c:pt>
                      <c:pt idx="138">
                        <c:v>466</c:v>
                      </c:pt>
                      <c:pt idx="139">
                        <c:v>467</c:v>
                      </c:pt>
                      <c:pt idx="140">
                        <c:v>468</c:v>
                      </c:pt>
                      <c:pt idx="141">
                        <c:v>469</c:v>
                      </c:pt>
                      <c:pt idx="142">
                        <c:v>470</c:v>
                      </c:pt>
                      <c:pt idx="143">
                        <c:v>471</c:v>
                      </c:pt>
                      <c:pt idx="144">
                        <c:v>472</c:v>
                      </c:pt>
                      <c:pt idx="145">
                        <c:v>473</c:v>
                      </c:pt>
                      <c:pt idx="146">
                        <c:v>474</c:v>
                      </c:pt>
                      <c:pt idx="147">
                        <c:v>475</c:v>
                      </c:pt>
                      <c:pt idx="148">
                        <c:v>477</c:v>
                      </c:pt>
                      <c:pt idx="149">
                        <c:v>478</c:v>
                      </c:pt>
                      <c:pt idx="150">
                        <c:v>479</c:v>
                      </c:pt>
                      <c:pt idx="151">
                        <c:v>480</c:v>
                      </c:pt>
                      <c:pt idx="152">
                        <c:v>485</c:v>
                      </c:pt>
                      <c:pt idx="153">
                        <c:v>488</c:v>
                      </c:pt>
                      <c:pt idx="154">
                        <c:v>489</c:v>
                      </c:pt>
                      <c:pt idx="155">
                        <c:v>491</c:v>
                      </c:pt>
                      <c:pt idx="156">
                        <c:v>492</c:v>
                      </c:pt>
                      <c:pt idx="157">
                        <c:v>494</c:v>
                      </c:pt>
                      <c:pt idx="158">
                        <c:v>495</c:v>
                      </c:pt>
                      <c:pt idx="159">
                        <c:v>497</c:v>
                      </c:pt>
                      <c:pt idx="160">
                        <c:v>498</c:v>
                      </c:pt>
                      <c:pt idx="161">
                        <c:v>499</c:v>
                      </c:pt>
                      <c:pt idx="162">
                        <c:v>500</c:v>
                      </c:pt>
                      <c:pt idx="163">
                        <c:v>501</c:v>
                      </c:pt>
                      <c:pt idx="164">
                        <c:v>502</c:v>
                      </c:pt>
                      <c:pt idx="165">
                        <c:v>503</c:v>
                      </c:pt>
                      <c:pt idx="166">
                        <c:v>504</c:v>
                      </c:pt>
                      <c:pt idx="167">
                        <c:v>505</c:v>
                      </c:pt>
                      <c:pt idx="168">
                        <c:v>508</c:v>
                      </c:pt>
                      <c:pt idx="169">
                        <c:v>510</c:v>
                      </c:pt>
                      <c:pt idx="170">
                        <c:v>511</c:v>
                      </c:pt>
                      <c:pt idx="171">
                        <c:v>513</c:v>
                      </c:pt>
                      <c:pt idx="172">
                        <c:v>516</c:v>
                      </c:pt>
                      <c:pt idx="173">
                        <c:v>518</c:v>
                      </c:pt>
                      <c:pt idx="174">
                        <c:v>519</c:v>
                      </c:pt>
                      <c:pt idx="175">
                        <c:v>520</c:v>
                      </c:pt>
                      <c:pt idx="176">
                        <c:v>521</c:v>
                      </c:pt>
                      <c:pt idx="177">
                        <c:v>522</c:v>
                      </c:pt>
                      <c:pt idx="178">
                        <c:v>523</c:v>
                      </c:pt>
                      <c:pt idx="179">
                        <c:v>524</c:v>
                      </c:pt>
                      <c:pt idx="180">
                        <c:v>525</c:v>
                      </c:pt>
                      <c:pt idx="181">
                        <c:v>527</c:v>
                      </c:pt>
                      <c:pt idx="182">
                        <c:v>530</c:v>
                      </c:pt>
                      <c:pt idx="183">
                        <c:v>531</c:v>
                      </c:pt>
                      <c:pt idx="184">
                        <c:v>532</c:v>
                      </c:pt>
                      <c:pt idx="185">
                        <c:v>533</c:v>
                      </c:pt>
                      <c:pt idx="186">
                        <c:v>537</c:v>
                      </c:pt>
                      <c:pt idx="187">
                        <c:v>538</c:v>
                      </c:pt>
                      <c:pt idx="188">
                        <c:v>539</c:v>
                      </c:pt>
                      <c:pt idx="189">
                        <c:v>541</c:v>
                      </c:pt>
                      <c:pt idx="190">
                        <c:v>542</c:v>
                      </c:pt>
                      <c:pt idx="191">
                        <c:v>543</c:v>
                      </c:pt>
                      <c:pt idx="192">
                        <c:v>544</c:v>
                      </c:pt>
                      <c:pt idx="193">
                        <c:v>545</c:v>
                      </c:pt>
                      <c:pt idx="194">
                        <c:v>549</c:v>
                      </c:pt>
                      <c:pt idx="195">
                        <c:v>550</c:v>
                      </c:pt>
                      <c:pt idx="196">
                        <c:v>551</c:v>
                      </c:pt>
                      <c:pt idx="197">
                        <c:v>552</c:v>
                      </c:pt>
                      <c:pt idx="198">
                        <c:v>553</c:v>
                      </c:pt>
                      <c:pt idx="199">
                        <c:v>554</c:v>
                      </c:pt>
                      <c:pt idx="200">
                        <c:v>555</c:v>
                      </c:pt>
                      <c:pt idx="201">
                        <c:v>556</c:v>
                      </c:pt>
                      <c:pt idx="202">
                        <c:v>557</c:v>
                      </c:pt>
                      <c:pt idx="203">
                        <c:v>558</c:v>
                      </c:pt>
                      <c:pt idx="204">
                        <c:v>561</c:v>
                      </c:pt>
                      <c:pt idx="205">
                        <c:v>562</c:v>
                      </c:pt>
                      <c:pt idx="206">
                        <c:v>564</c:v>
                      </c:pt>
                      <c:pt idx="207">
                        <c:v>565</c:v>
                      </c:pt>
                      <c:pt idx="208">
                        <c:v>568</c:v>
                      </c:pt>
                      <c:pt idx="209">
                        <c:v>570</c:v>
                      </c:pt>
                      <c:pt idx="210">
                        <c:v>571</c:v>
                      </c:pt>
                      <c:pt idx="211">
                        <c:v>573</c:v>
                      </c:pt>
                      <c:pt idx="212">
                        <c:v>574</c:v>
                      </c:pt>
                      <c:pt idx="213">
                        <c:v>575</c:v>
                      </c:pt>
                      <c:pt idx="214">
                        <c:v>582</c:v>
                      </c:pt>
                      <c:pt idx="215">
                        <c:v>586</c:v>
                      </c:pt>
                      <c:pt idx="216">
                        <c:v>587</c:v>
                      </c:pt>
                      <c:pt idx="217">
                        <c:v>589</c:v>
                      </c:pt>
                      <c:pt idx="218">
                        <c:v>590</c:v>
                      </c:pt>
                      <c:pt idx="219">
                        <c:v>591</c:v>
                      </c:pt>
                      <c:pt idx="220">
                        <c:v>592</c:v>
                      </c:pt>
                      <c:pt idx="221">
                        <c:v>595</c:v>
                      </c:pt>
                      <c:pt idx="222">
                        <c:v>596</c:v>
                      </c:pt>
                      <c:pt idx="223">
                        <c:v>597</c:v>
                      </c:pt>
                      <c:pt idx="224">
                        <c:v>598</c:v>
                      </c:pt>
                      <c:pt idx="225">
                        <c:v>604</c:v>
                      </c:pt>
                      <c:pt idx="226">
                        <c:v>605</c:v>
                      </c:pt>
                      <c:pt idx="227">
                        <c:v>608</c:v>
                      </c:pt>
                      <c:pt idx="228">
                        <c:v>609</c:v>
                      </c:pt>
                      <c:pt idx="229">
                        <c:v>610</c:v>
                      </c:pt>
                      <c:pt idx="230">
                        <c:v>611</c:v>
                      </c:pt>
                      <c:pt idx="231">
                        <c:v>612</c:v>
                      </c:pt>
                      <c:pt idx="232">
                        <c:v>613</c:v>
                      </c:pt>
                      <c:pt idx="233">
                        <c:v>623</c:v>
                      </c:pt>
                      <c:pt idx="234">
                        <c:v>624</c:v>
                      </c:pt>
                      <c:pt idx="235">
                        <c:v>625</c:v>
                      </c:pt>
                      <c:pt idx="236">
                        <c:v>627</c:v>
                      </c:pt>
                      <c:pt idx="237">
                        <c:v>628</c:v>
                      </c:pt>
                      <c:pt idx="238">
                        <c:v>629</c:v>
                      </c:pt>
                      <c:pt idx="239">
                        <c:v>631</c:v>
                      </c:pt>
                      <c:pt idx="240">
                        <c:v>634</c:v>
                      </c:pt>
                      <c:pt idx="241">
                        <c:v>636</c:v>
                      </c:pt>
                      <c:pt idx="242">
                        <c:v>638</c:v>
                      </c:pt>
                      <c:pt idx="243">
                        <c:v>639</c:v>
                      </c:pt>
                      <c:pt idx="244">
                        <c:v>642</c:v>
                      </c:pt>
                      <c:pt idx="245">
                        <c:v>643</c:v>
                      </c:pt>
                      <c:pt idx="246">
                        <c:v>644</c:v>
                      </c:pt>
                      <c:pt idx="247">
                        <c:v>646</c:v>
                      </c:pt>
                      <c:pt idx="248">
                        <c:v>647</c:v>
                      </c:pt>
                      <c:pt idx="249">
                        <c:v>649</c:v>
                      </c:pt>
                      <c:pt idx="250">
                        <c:v>650</c:v>
                      </c:pt>
                      <c:pt idx="251">
                        <c:v>652</c:v>
                      </c:pt>
                      <c:pt idx="252">
                        <c:v>653</c:v>
                      </c:pt>
                      <c:pt idx="253">
                        <c:v>654</c:v>
                      </c:pt>
                      <c:pt idx="254">
                        <c:v>656</c:v>
                      </c:pt>
                      <c:pt idx="255">
                        <c:v>657</c:v>
                      </c:pt>
                      <c:pt idx="256">
                        <c:v>659</c:v>
                      </c:pt>
                      <c:pt idx="257">
                        <c:v>661</c:v>
                      </c:pt>
                      <c:pt idx="258">
                        <c:v>665</c:v>
                      </c:pt>
                      <c:pt idx="259">
                        <c:v>667</c:v>
                      </c:pt>
                      <c:pt idx="260">
                        <c:v>668</c:v>
                      </c:pt>
                      <c:pt idx="261">
                        <c:v>669</c:v>
                      </c:pt>
                      <c:pt idx="262">
                        <c:v>670</c:v>
                      </c:pt>
                      <c:pt idx="263">
                        <c:v>671</c:v>
                      </c:pt>
                      <c:pt idx="264">
                        <c:v>672</c:v>
                      </c:pt>
                      <c:pt idx="265">
                        <c:v>673</c:v>
                      </c:pt>
                      <c:pt idx="266">
                        <c:v>674</c:v>
                      </c:pt>
                      <c:pt idx="267">
                        <c:v>675</c:v>
                      </c:pt>
                      <c:pt idx="268">
                        <c:v>676</c:v>
                      </c:pt>
                      <c:pt idx="269">
                        <c:v>677</c:v>
                      </c:pt>
                      <c:pt idx="270">
                        <c:v>678</c:v>
                      </c:pt>
                      <c:pt idx="271">
                        <c:v>681</c:v>
                      </c:pt>
                      <c:pt idx="272">
                        <c:v>682</c:v>
                      </c:pt>
                      <c:pt idx="273">
                        <c:v>683</c:v>
                      </c:pt>
                      <c:pt idx="274">
                        <c:v>684</c:v>
                      </c:pt>
                      <c:pt idx="275">
                        <c:v>685</c:v>
                      </c:pt>
                      <c:pt idx="276">
                        <c:v>686</c:v>
                      </c:pt>
                      <c:pt idx="277">
                        <c:v>687</c:v>
                      </c:pt>
                      <c:pt idx="278">
                        <c:v>688</c:v>
                      </c:pt>
                      <c:pt idx="279">
                        <c:v>689</c:v>
                      </c:pt>
                      <c:pt idx="280">
                        <c:v>693</c:v>
                      </c:pt>
                      <c:pt idx="281">
                        <c:v>694</c:v>
                      </c:pt>
                      <c:pt idx="282">
                        <c:v>698</c:v>
                      </c:pt>
                      <c:pt idx="283">
                        <c:v>701</c:v>
                      </c:pt>
                      <c:pt idx="284">
                        <c:v>702</c:v>
                      </c:pt>
                      <c:pt idx="285">
                        <c:v>703</c:v>
                      </c:pt>
                      <c:pt idx="286">
                        <c:v>707</c:v>
                      </c:pt>
                      <c:pt idx="287">
                        <c:v>708</c:v>
                      </c:pt>
                      <c:pt idx="288">
                        <c:v>712</c:v>
                      </c:pt>
                      <c:pt idx="289">
                        <c:v>713</c:v>
                      </c:pt>
                      <c:pt idx="290">
                        <c:v>714</c:v>
                      </c:pt>
                      <c:pt idx="291">
                        <c:v>719</c:v>
                      </c:pt>
                      <c:pt idx="292">
                        <c:v>720</c:v>
                      </c:pt>
                      <c:pt idx="293">
                        <c:v>721</c:v>
                      </c:pt>
                      <c:pt idx="294">
                        <c:v>723</c:v>
                      </c:pt>
                      <c:pt idx="295">
                        <c:v>724</c:v>
                      </c:pt>
                      <c:pt idx="296">
                        <c:v>725</c:v>
                      </c:pt>
                      <c:pt idx="297">
                        <c:v>726</c:v>
                      </c:pt>
                      <c:pt idx="298">
                        <c:v>727</c:v>
                      </c:pt>
                      <c:pt idx="299">
                        <c:v>728</c:v>
                      </c:pt>
                      <c:pt idx="300">
                        <c:v>729</c:v>
                      </c:pt>
                      <c:pt idx="301">
                        <c:v>730</c:v>
                      </c:pt>
                      <c:pt idx="302">
                        <c:v>732</c:v>
                      </c:pt>
                      <c:pt idx="303">
                        <c:v>734</c:v>
                      </c:pt>
                      <c:pt idx="304">
                        <c:v>735</c:v>
                      </c:pt>
                      <c:pt idx="305">
                        <c:v>736</c:v>
                      </c:pt>
                      <c:pt idx="306">
                        <c:v>737</c:v>
                      </c:pt>
                      <c:pt idx="307">
                        <c:v>738</c:v>
                      </c:pt>
                      <c:pt idx="308">
                        <c:v>739</c:v>
                      </c:pt>
                      <c:pt idx="309">
                        <c:v>740</c:v>
                      </c:pt>
                      <c:pt idx="310">
                        <c:v>741</c:v>
                      </c:pt>
                      <c:pt idx="311">
                        <c:v>742</c:v>
                      </c:pt>
                      <c:pt idx="312">
                        <c:v>743</c:v>
                      </c:pt>
                      <c:pt idx="313">
                        <c:v>744</c:v>
                      </c:pt>
                      <c:pt idx="314">
                        <c:v>745</c:v>
                      </c:pt>
                      <c:pt idx="315">
                        <c:v>746</c:v>
                      </c:pt>
                      <c:pt idx="316">
                        <c:v>747</c:v>
                      </c:pt>
                      <c:pt idx="317">
                        <c:v>748</c:v>
                      </c:pt>
                      <c:pt idx="318">
                        <c:v>749</c:v>
                      </c:pt>
                      <c:pt idx="319">
                        <c:v>750</c:v>
                      </c:pt>
                      <c:pt idx="320">
                        <c:v>751</c:v>
                      </c:pt>
                      <c:pt idx="321">
                        <c:v>757</c:v>
                      </c:pt>
                      <c:pt idx="322">
                        <c:v>758</c:v>
                      </c:pt>
                      <c:pt idx="323">
                        <c:v>759</c:v>
                      </c:pt>
                      <c:pt idx="324">
                        <c:v>760</c:v>
                      </c:pt>
                      <c:pt idx="325">
                        <c:v>761</c:v>
                      </c:pt>
                      <c:pt idx="326">
                        <c:v>762</c:v>
                      </c:pt>
                      <c:pt idx="327">
                        <c:v>765</c:v>
                      </c:pt>
                      <c:pt idx="328">
                        <c:v>766</c:v>
                      </c:pt>
                      <c:pt idx="329">
                        <c:v>767</c:v>
                      </c:pt>
                      <c:pt idx="330">
                        <c:v>769</c:v>
                      </c:pt>
                      <c:pt idx="331">
                        <c:v>770</c:v>
                      </c:pt>
                      <c:pt idx="332">
                        <c:v>772</c:v>
                      </c:pt>
                      <c:pt idx="333">
                        <c:v>773</c:v>
                      </c:pt>
                      <c:pt idx="334">
                        <c:v>774</c:v>
                      </c:pt>
                      <c:pt idx="335">
                        <c:v>775</c:v>
                      </c:pt>
                      <c:pt idx="336">
                        <c:v>776</c:v>
                      </c:pt>
                      <c:pt idx="337">
                        <c:v>777</c:v>
                      </c:pt>
                      <c:pt idx="338">
                        <c:v>778</c:v>
                      </c:pt>
                      <c:pt idx="339">
                        <c:v>779</c:v>
                      </c:pt>
                      <c:pt idx="340">
                        <c:v>781</c:v>
                      </c:pt>
                      <c:pt idx="341">
                        <c:v>782</c:v>
                      </c:pt>
                      <c:pt idx="342">
                        <c:v>783</c:v>
                      </c:pt>
                      <c:pt idx="343">
                        <c:v>784</c:v>
                      </c:pt>
                      <c:pt idx="344">
                        <c:v>786</c:v>
                      </c:pt>
                      <c:pt idx="345">
                        <c:v>787</c:v>
                      </c:pt>
                      <c:pt idx="346">
                        <c:v>788</c:v>
                      </c:pt>
                      <c:pt idx="347">
                        <c:v>789</c:v>
                      </c:pt>
                      <c:pt idx="348">
                        <c:v>790</c:v>
                      </c:pt>
                      <c:pt idx="349">
                        <c:v>794</c:v>
                      </c:pt>
                      <c:pt idx="350">
                        <c:v>795</c:v>
                      </c:pt>
                      <c:pt idx="351">
                        <c:v>796</c:v>
                      </c:pt>
                      <c:pt idx="352">
                        <c:v>797</c:v>
                      </c:pt>
                      <c:pt idx="353">
                        <c:v>798</c:v>
                      </c:pt>
                      <c:pt idx="354">
                        <c:v>800</c:v>
                      </c:pt>
                      <c:pt idx="355">
                        <c:v>801</c:v>
                      </c:pt>
                      <c:pt idx="356">
                        <c:v>802</c:v>
                      </c:pt>
                      <c:pt idx="357">
                        <c:v>803</c:v>
                      </c:pt>
                      <c:pt idx="358">
                        <c:v>804</c:v>
                      </c:pt>
                      <c:pt idx="359">
                        <c:v>805</c:v>
                      </c:pt>
                      <c:pt idx="360">
                        <c:v>806</c:v>
                      </c:pt>
                      <c:pt idx="361">
                        <c:v>807</c:v>
                      </c:pt>
                      <c:pt idx="362">
                        <c:v>808</c:v>
                      </c:pt>
                      <c:pt idx="363">
                        <c:v>811</c:v>
                      </c:pt>
                      <c:pt idx="364">
                        <c:v>812</c:v>
                      </c:pt>
                      <c:pt idx="365">
                        <c:v>813</c:v>
                      </c:pt>
                      <c:pt idx="366">
                        <c:v>814</c:v>
                      </c:pt>
                      <c:pt idx="367">
                        <c:v>815</c:v>
                      </c:pt>
                      <c:pt idx="368">
                        <c:v>816</c:v>
                      </c:pt>
                      <c:pt idx="369">
                        <c:v>817</c:v>
                      </c:pt>
                      <c:pt idx="370">
                        <c:v>818</c:v>
                      </c:pt>
                      <c:pt idx="371">
                        <c:v>819</c:v>
                      </c:pt>
                      <c:pt idx="372">
                        <c:v>820</c:v>
                      </c:pt>
                      <c:pt idx="373">
                        <c:v>821</c:v>
                      </c:pt>
                      <c:pt idx="374">
                        <c:v>822</c:v>
                      </c:pt>
                      <c:pt idx="375">
                        <c:v>823</c:v>
                      </c:pt>
                      <c:pt idx="376">
                        <c:v>825</c:v>
                      </c:pt>
                      <c:pt idx="377">
                        <c:v>826</c:v>
                      </c:pt>
                      <c:pt idx="378">
                        <c:v>827</c:v>
                      </c:pt>
                      <c:pt idx="379">
                        <c:v>828</c:v>
                      </c:pt>
                      <c:pt idx="380">
                        <c:v>829</c:v>
                      </c:pt>
                      <c:pt idx="381">
                        <c:v>830</c:v>
                      </c:pt>
                      <c:pt idx="382">
                        <c:v>831</c:v>
                      </c:pt>
                      <c:pt idx="383">
                        <c:v>832</c:v>
                      </c:pt>
                      <c:pt idx="384">
                        <c:v>834</c:v>
                      </c:pt>
                      <c:pt idx="385">
                        <c:v>836</c:v>
                      </c:pt>
                      <c:pt idx="386">
                        <c:v>837</c:v>
                      </c:pt>
                      <c:pt idx="387">
                        <c:v>838</c:v>
                      </c:pt>
                      <c:pt idx="388">
                        <c:v>839</c:v>
                      </c:pt>
                      <c:pt idx="389">
                        <c:v>840</c:v>
                      </c:pt>
                      <c:pt idx="390">
                        <c:v>842</c:v>
                      </c:pt>
                      <c:pt idx="391">
                        <c:v>843</c:v>
                      </c:pt>
                      <c:pt idx="392">
                        <c:v>844</c:v>
                      </c:pt>
                      <c:pt idx="393">
                        <c:v>845</c:v>
                      </c:pt>
                      <c:pt idx="394">
                        <c:v>846</c:v>
                      </c:pt>
                      <c:pt idx="395">
                        <c:v>847</c:v>
                      </c:pt>
                      <c:pt idx="396">
                        <c:v>848</c:v>
                      </c:pt>
                      <c:pt idx="397">
                        <c:v>849</c:v>
                      </c:pt>
                      <c:pt idx="398">
                        <c:v>850</c:v>
                      </c:pt>
                      <c:pt idx="399">
                        <c:v>851</c:v>
                      </c:pt>
                      <c:pt idx="400">
                        <c:v>853</c:v>
                      </c:pt>
                      <c:pt idx="401">
                        <c:v>854</c:v>
                      </c:pt>
                      <c:pt idx="402">
                        <c:v>855</c:v>
                      </c:pt>
                      <c:pt idx="403">
                        <c:v>856</c:v>
                      </c:pt>
                      <c:pt idx="404">
                        <c:v>857</c:v>
                      </c:pt>
                      <c:pt idx="405">
                        <c:v>859</c:v>
                      </c:pt>
                      <c:pt idx="406">
                        <c:v>860</c:v>
                      </c:pt>
                      <c:pt idx="407">
                        <c:v>861</c:v>
                      </c:pt>
                      <c:pt idx="408">
                        <c:v>862</c:v>
                      </c:pt>
                      <c:pt idx="409">
                        <c:v>863</c:v>
                      </c:pt>
                      <c:pt idx="410">
                        <c:v>865</c:v>
                      </c:pt>
                      <c:pt idx="411">
                        <c:v>867</c:v>
                      </c:pt>
                      <c:pt idx="412">
                        <c:v>868</c:v>
                      </c:pt>
                      <c:pt idx="413">
                        <c:v>869</c:v>
                      </c:pt>
                      <c:pt idx="414">
                        <c:v>876</c:v>
                      </c:pt>
                      <c:pt idx="415">
                        <c:v>877</c:v>
                      </c:pt>
                      <c:pt idx="416">
                        <c:v>882</c:v>
                      </c:pt>
                      <c:pt idx="417">
                        <c:v>883</c:v>
                      </c:pt>
                      <c:pt idx="418">
                        <c:v>885</c:v>
                      </c:pt>
                      <c:pt idx="419">
                        <c:v>886</c:v>
                      </c:pt>
                      <c:pt idx="420">
                        <c:v>887</c:v>
                      </c:pt>
                      <c:pt idx="421">
                        <c:v>888</c:v>
                      </c:pt>
                      <c:pt idx="422">
                        <c:v>889</c:v>
                      </c:pt>
                      <c:pt idx="423">
                        <c:v>890</c:v>
                      </c:pt>
                      <c:pt idx="424">
                        <c:v>891</c:v>
                      </c:pt>
                      <c:pt idx="425">
                        <c:v>892</c:v>
                      </c:pt>
                      <c:pt idx="426">
                        <c:v>893</c:v>
                      </c:pt>
                      <c:pt idx="427">
                        <c:v>895</c:v>
                      </c:pt>
                      <c:pt idx="428">
                        <c:v>896</c:v>
                      </c:pt>
                      <c:pt idx="429">
                        <c:v>897</c:v>
                      </c:pt>
                      <c:pt idx="430">
                        <c:v>898</c:v>
                      </c:pt>
                      <c:pt idx="431">
                        <c:v>900</c:v>
                      </c:pt>
                      <c:pt idx="432">
                        <c:v>901</c:v>
                      </c:pt>
                      <c:pt idx="433">
                        <c:v>902</c:v>
                      </c:pt>
                      <c:pt idx="434">
                        <c:v>903</c:v>
                      </c:pt>
                      <c:pt idx="435">
                        <c:v>904</c:v>
                      </c:pt>
                      <c:pt idx="436">
                        <c:v>905</c:v>
                      </c:pt>
                      <c:pt idx="437">
                        <c:v>907</c:v>
                      </c:pt>
                      <c:pt idx="438">
                        <c:v>908</c:v>
                      </c:pt>
                      <c:pt idx="439">
                        <c:v>909</c:v>
                      </c:pt>
                      <c:pt idx="440">
                        <c:v>910</c:v>
                      </c:pt>
                      <c:pt idx="441">
                        <c:v>911</c:v>
                      </c:pt>
                      <c:pt idx="442">
                        <c:v>912</c:v>
                      </c:pt>
                      <c:pt idx="443">
                        <c:v>913</c:v>
                      </c:pt>
                      <c:pt idx="444">
                        <c:v>918</c:v>
                      </c:pt>
                      <c:pt idx="445">
                        <c:v>919</c:v>
                      </c:pt>
                      <c:pt idx="446">
                        <c:v>920</c:v>
                      </c:pt>
                      <c:pt idx="447">
                        <c:v>922</c:v>
                      </c:pt>
                      <c:pt idx="448">
                        <c:v>923</c:v>
                      </c:pt>
                      <c:pt idx="449">
                        <c:v>924</c:v>
                      </c:pt>
                      <c:pt idx="450">
                        <c:v>925</c:v>
                      </c:pt>
                      <c:pt idx="451">
                        <c:v>926</c:v>
                      </c:pt>
                      <c:pt idx="452">
                        <c:v>927</c:v>
                      </c:pt>
                      <c:pt idx="453">
                        <c:v>928</c:v>
                      </c:pt>
                      <c:pt idx="454">
                        <c:v>929</c:v>
                      </c:pt>
                      <c:pt idx="455">
                        <c:v>930</c:v>
                      </c:pt>
                      <c:pt idx="456">
                        <c:v>931</c:v>
                      </c:pt>
                      <c:pt idx="457">
                        <c:v>934</c:v>
                      </c:pt>
                      <c:pt idx="458">
                        <c:v>935</c:v>
                      </c:pt>
                      <c:pt idx="459">
                        <c:v>940</c:v>
                      </c:pt>
                      <c:pt idx="460">
                        <c:v>941</c:v>
                      </c:pt>
                      <c:pt idx="461">
                        <c:v>942</c:v>
                      </c:pt>
                      <c:pt idx="462">
                        <c:v>943</c:v>
                      </c:pt>
                      <c:pt idx="463">
                        <c:v>944</c:v>
                      </c:pt>
                      <c:pt idx="464">
                        <c:v>945</c:v>
                      </c:pt>
                      <c:pt idx="465">
                        <c:v>946</c:v>
                      </c:pt>
                      <c:pt idx="466">
                        <c:v>947</c:v>
                      </c:pt>
                      <c:pt idx="467">
                        <c:v>948</c:v>
                      </c:pt>
                      <c:pt idx="468">
                        <c:v>949</c:v>
                      </c:pt>
                      <c:pt idx="469">
                        <c:v>950</c:v>
                      </c:pt>
                      <c:pt idx="470">
                        <c:v>951</c:v>
                      </c:pt>
                      <c:pt idx="471">
                        <c:v>952</c:v>
                      </c:pt>
                      <c:pt idx="472">
                        <c:v>954</c:v>
                      </c:pt>
                      <c:pt idx="473">
                        <c:v>955</c:v>
                      </c:pt>
                      <c:pt idx="474">
                        <c:v>956</c:v>
                      </c:pt>
                      <c:pt idx="475">
                        <c:v>961</c:v>
                      </c:pt>
                      <c:pt idx="476">
                        <c:v>964</c:v>
                      </c:pt>
                      <c:pt idx="477">
                        <c:v>965</c:v>
                      </c:pt>
                      <c:pt idx="478">
                        <c:v>966</c:v>
                      </c:pt>
                      <c:pt idx="479">
                        <c:v>969</c:v>
                      </c:pt>
                      <c:pt idx="480">
                        <c:v>970</c:v>
                      </c:pt>
                      <c:pt idx="481">
                        <c:v>973</c:v>
                      </c:pt>
                      <c:pt idx="482">
                        <c:v>974</c:v>
                      </c:pt>
                      <c:pt idx="483">
                        <c:v>975</c:v>
                      </c:pt>
                      <c:pt idx="484">
                        <c:v>977</c:v>
                      </c:pt>
                      <c:pt idx="485">
                        <c:v>978</c:v>
                      </c:pt>
                      <c:pt idx="486">
                        <c:v>979</c:v>
                      </c:pt>
                      <c:pt idx="487">
                        <c:v>980</c:v>
                      </c:pt>
                      <c:pt idx="488">
                        <c:v>983</c:v>
                      </c:pt>
                      <c:pt idx="489">
                        <c:v>984</c:v>
                      </c:pt>
                      <c:pt idx="490">
                        <c:v>986</c:v>
                      </c:pt>
                      <c:pt idx="491">
                        <c:v>987</c:v>
                      </c:pt>
                      <c:pt idx="492">
                        <c:v>988</c:v>
                      </c:pt>
                      <c:pt idx="493">
                        <c:v>989</c:v>
                      </c:pt>
                      <c:pt idx="494">
                        <c:v>990</c:v>
                      </c:pt>
                      <c:pt idx="495">
                        <c:v>991</c:v>
                      </c:pt>
                      <c:pt idx="496">
                        <c:v>992</c:v>
                      </c:pt>
                      <c:pt idx="497">
                        <c:v>994</c:v>
                      </c:pt>
                      <c:pt idx="498">
                        <c:v>995</c:v>
                      </c:pt>
                      <c:pt idx="499">
                        <c:v>996</c:v>
                      </c:pt>
                      <c:pt idx="500">
                        <c:v>997</c:v>
                      </c:pt>
                      <c:pt idx="501">
                        <c:v>998</c:v>
                      </c:pt>
                      <c:pt idx="502">
                        <c:v>999</c:v>
                      </c:pt>
                      <c:pt idx="503">
                        <c:v>1000</c:v>
                      </c:pt>
                      <c:pt idx="504">
                        <c:v>1001</c:v>
                      </c:pt>
                      <c:pt idx="505">
                        <c:v>1002</c:v>
                      </c:pt>
                      <c:pt idx="506">
                        <c:v>1003</c:v>
                      </c:pt>
                      <c:pt idx="507">
                        <c:v>1004</c:v>
                      </c:pt>
                      <c:pt idx="508">
                        <c:v>1005</c:v>
                      </c:pt>
                      <c:pt idx="509">
                        <c:v>1006</c:v>
                      </c:pt>
                      <c:pt idx="510">
                        <c:v>1008</c:v>
                      </c:pt>
                      <c:pt idx="511">
                        <c:v>1009</c:v>
                      </c:pt>
                      <c:pt idx="512">
                        <c:v>1010</c:v>
                      </c:pt>
                      <c:pt idx="513">
                        <c:v>1011</c:v>
                      </c:pt>
                      <c:pt idx="514">
                        <c:v>1012</c:v>
                      </c:pt>
                      <c:pt idx="515">
                        <c:v>1013</c:v>
                      </c:pt>
                      <c:pt idx="516">
                        <c:v>1015</c:v>
                      </c:pt>
                      <c:pt idx="517">
                        <c:v>1020</c:v>
                      </c:pt>
                      <c:pt idx="518">
                        <c:v>1021</c:v>
                      </c:pt>
                      <c:pt idx="519">
                        <c:v>1022</c:v>
                      </c:pt>
                      <c:pt idx="520">
                        <c:v>1023</c:v>
                      </c:pt>
                      <c:pt idx="521">
                        <c:v>1024</c:v>
                      </c:pt>
                      <c:pt idx="522">
                        <c:v>1025</c:v>
                      </c:pt>
                      <c:pt idx="523">
                        <c:v>1027</c:v>
                      </c:pt>
                      <c:pt idx="524">
                        <c:v>1031</c:v>
                      </c:pt>
                      <c:pt idx="525">
                        <c:v>1032</c:v>
                      </c:pt>
                      <c:pt idx="526">
                        <c:v>1033</c:v>
                      </c:pt>
                      <c:pt idx="527">
                        <c:v>1034</c:v>
                      </c:pt>
                      <c:pt idx="528">
                        <c:v>1035</c:v>
                      </c:pt>
                      <c:pt idx="529">
                        <c:v>1037</c:v>
                      </c:pt>
                      <c:pt idx="530">
                        <c:v>1039</c:v>
                      </c:pt>
                      <c:pt idx="531">
                        <c:v>1040</c:v>
                      </c:pt>
                      <c:pt idx="532">
                        <c:v>1041</c:v>
                      </c:pt>
                      <c:pt idx="533">
                        <c:v>1043</c:v>
                      </c:pt>
                      <c:pt idx="534">
                        <c:v>1044</c:v>
                      </c:pt>
                      <c:pt idx="535">
                        <c:v>1045</c:v>
                      </c:pt>
                      <c:pt idx="536">
                        <c:v>1046</c:v>
                      </c:pt>
                      <c:pt idx="537">
                        <c:v>1047</c:v>
                      </c:pt>
                      <c:pt idx="538">
                        <c:v>1048</c:v>
                      </c:pt>
                      <c:pt idx="539">
                        <c:v>1049</c:v>
                      </c:pt>
                      <c:pt idx="540">
                        <c:v>1050</c:v>
                      </c:pt>
                      <c:pt idx="541">
                        <c:v>1051</c:v>
                      </c:pt>
                      <c:pt idx="542">
                        <c:v>1052</c:v>
                      </c:pt>
                      <c:pt idx="543">
                        <c:v>1053</c:v>
                      </c:pt>
                      <c:pt idx="544">
                        <c:v>1054</c:v>
                      </c:pt>
                      <c:pt idx="545">
                        <c:v>1055</c:v>
                      </c:pt>
                      <c:pt idx="546">
                        <c:v>1057</c:v>
                      </c:pt>
                      <c:pt idx="547">
                        <c:v>1059</c:v>
                      </c:pt>
                      <c:pt idx="548">
                        <c:v>1060</c:v>
                      </c:pt>
                      <c:pt idx="549">
                        <c:v>1061</c:v>
                      </c:pt>
                      <c:pt idx="550">
                        <c:v>1062</c:v>
                      </c:pt>
                      <c:pt idx="551">
                        <c:v>1063</c:v>
                      </c:pt>
                      <c:pt idx="552">
                        <c:v>1064</c:v>
                      </c:pt>
                      <c:pt idx="553">
                        <c:v>1065</c:v>
                      </c:pt>
                      <c:pt idx="554">
                        <c:v>1066</c:v>
                      </c:pt>
                      <c:pt idx="555">
                        <c:v>1067</c:v>
                      </c:pt>
                      <c:pt idx="556">
                        <c:v>1068</c:v>
                      </c:pt>
                      <c:pt idx="557">
                        <c:v>1069</c:v>
                      </c:pt>
                      <c:pt idx="558">
                        <c:v>1070</c:v>
                      </c:pt>
                      <c:pt idx="559">
                        <c:v>1072</c:v>
                      </c:pt>
                      <c:pt idx="560">
                        <c:v>1073</c:v>
                      </c:pt>
                      <c:pt idx="561">
                        <c:v>1074</c:v>
                      </c:pt>
                      <c:pt idx="562">
                        <c:v>1077</c:v>
                      </c:pt>
                      <c:pt idx="563">
                        <c:v>1080</c:v>
                      </c:pt>
                      <c:pt idx="564">
                        <c:v>1081</c:v>
                      </c:pt>
                      <c:pt idx="565">
                        <c:v>1082</c:v>
                      </c:pt>
                      <c:pt idx="566">
                        <c:v>1083</c:v>
                      </c:pt>
                      <c:pt idx="567">
                        <c:v>1084</c:v>
                      </c:pt>
                      <c:pt idx="568">
                        <c:v>1085</c:v>
                      </c:pt>
                      <c:pt idx="569">
                        <c:v>1090</c:v>
                      </c:pt>
                      <c:pt idx="570">
                        <c:v>1091</c:v>
                      </c:pt>
                      <c:pt idx="571">
                        <c:v>1092</c:v>
                      </c:pt>
                      <c:pt idx="572">
                        <c:v>1093</c:v>
                      </c:pt>
                      <c:pt idx="573">
                        <c:v>1094</c:v>
                      </c:pt>
                      <c:pt idx="574">
                        <c:v>1099</c:v>
                      </c:pt>
                      <c:pt idx="575">
                        <c:v>1100</c:v>
                      </c:pt>
                      <c:pt idx="576">
                        <c:v>1101</c:v>
                      </c:pt>
                      <c:pt idx="577">
                        <c:v>1102</c:v>
                      </c:pt>
                      <c:pt idx="578">
                        <c:v>1103</c:v>
                      </c:pt>
                      <c:pt idx="579">
                        <c:v>1104</c:v>
                      </c:pt>
                      <c:pt idx="580">
                        <c:v>1105</c:v>
                      </c:pt>
                      <c:pt idx="581">
                        <c:v>1106</c:v>
                      </c:pt>
                      <c:pt idx="582">
                        <c:v>1107</c:v>
                      </c:pt>
                      <c:pt idx="583">
                        <c:v>1108</c:v>
                      </c:pt>
                      <c:pt idx="584">
                        <c:v>1110</c:v>
                      </c:pt>
                      <c:pt idx="585">
                        <c:v>1111</c:v>
                      </c:pt>
                      <c:pt idx="586">
                        <c:v>1112</c:v>
                      </c:pt>
                      <c:pt idx="587">
                        <c:v>1113</c:v>
                      </c:pt>
                      <c:pt idx="588">
                        <c:v>1114</c:v>
                      </c:pt>
                      <c:pt idx="589">
                        <c:v>1115</c:v>
                      </c:pt>
                      <c:pt idx="590">
                        <c:v>1116</c:v>
                      </c:pt>
                      <c:pt idx="591">
                        <c:v>1118</c:v>
                      </c:pt>
                      <c:pt idx="592">
                        <c:v>1119</c:v>
                      </c:pt>
                      <c:pt idx="593">
                        <c:v>1120</c:v>
                      </c:pt>
                      <c:pt idx="594">
                        <c:v>1121</c:v>
                      </c:pt>
                      <c:pt idx="595">
                        <c:v>1122</c:v>
                      </c:pt>
                      <c:pt idx="596">
                        <c:v>1123</c:v>
                      </c:pt>
                      <c:pt idx="597">
                        <c:v>1124</c:v>
                      </c:pt>
                      <c:pt idx="598">
                        <c:v>1130</c:v>
                      </c:pt>
                      <c:pt idx="599">
                        <c:v>1131</c:v>
                      </c:pt>
                      <c:pt idx="600">
                        <c:v>1132</c:v>
                      </c:pt>
                      <c:pt idx="601">
                        <c:v>1133</c:v>
                      </c:pt>
                      <c:pt idx="602">
                        <c:v>1134</c:v>
                      </c:pt>
                      <c:pt idx="603">
                        <c:v>1135</c:v>
                      </c:pt>
                      <c:pt idx="604">
                        <c:v>1136</c:v>
                      </c:pt>
                      <c:pt idx="605">
                        <c:v>1137</c:v>
                      </c:pt>
                      <c:pt idx="606">
                        <c:v>1138</c:v>
                      </c:pt>
                      <c:pt idx="607">
                        <c:v>1139</c:v>
                      </c:pt>
                      <c:pt idx="608">
                        <c:v>1140</c:v>
                      </c:pt>
                      <c:pt idx="609">
                        <c:v>1141</c:v>
                      </c:pt>
                      <c:pt idx="610">
                        <c:v>1142</c:v>
                      </c:pt>
                      <c:pt idx="611">
                        <c:v>1143</c:v>
                      </c:pt>
                      <c:pt idx="612">
                        <c:v>1145</c:v>
                      </c:pt>
                      <c:pt idx="613">
                        <c:v>1146</c:v>
                      </c:pt>
                      <c:pt idx="614">
                        <c:v>1147</c:v>
                      </c:pt>
                      <c:pt idx="615">
                        <c:v>1148</c:v>
                      </c:pt>
                      <c:pt idx="616">
                        <c:v>1149</c:v>
                      </c:pt>
                      <c:pt idx="617">
                        <c:v>1150</c:v>
                      </c:pt>
                      <c:pt idx="618">
                        <c:v>1151</c:v>
                      </c:pt>
                      <c:pt idx="619">
                        <c:v>1153</c:v>
                      </c:pt>
                      <c:pt idx="620">
                        <c:v>1154</c:v>
                      </c:pt>
                      <c:pt idx="621">
                        <c:v>1155</c:v>
                      </c:pt>
                      <c:pt idx="622">
                        <c:v>1156</c:v>
                      </c:pt>
                      <c:pt idx="623">
                        <c:v>1157</c:v>
                      </c:pt>
                      <c:pt idx="624">
                        <c:v>1158</c:v>
                      </c:pt>
                      <c:pt idx="625">
                        <c:v>1159</c:v>
                      </c:pt>
                      <c:pt idx="626">
                        <c:v>1160</c:v>
                      </c:pt>
                      <c:pt idx="627">
                        <c:v>1161</c:v>
                      </c:pt>
                      <c:pt idx="628">
                        <c:v>1162</c:v>
                      </c:pt>
                      <c:pt idx="629">
                        <c:v>1165</c:v>
                      </c:pt>
                      <c:pt idx="630">
                        <c:v>1166</c:v>
                      </c:pt>
                      <c:pt idx="631">
                        <c:v>1167</c:v>
                      </c:pt>
                      <c:pt idx="632">
                        <c:v>1168</c:v>
                      </c:pt>
                      <c:pt idx="633">
                        <c:v>1169</c:v>
                      </c:pt>
                      <c:pt idx="634">
                        <c:v>1170</c:v>
                      </c:pt>
                      <c:pt idx="635">
                        <c:v>1173</c:v>
                      </c:pt>
                      <c:pt idx="636">
                        <c:v>1174</c:v>
                      </c:pt>
                      <c:pt idx="637">
                        <c:v>1175</c:v>
                      </c:pt>
                      <c:pt idx="638">
                        <c:v>1180</c:v>
                      </c:pt>
                      <c:pt idx="639">
                        <c:v>1181</c:v>
                      </c:pt>
                      <c:pt idx="640">
                        <c:v>1182</c:v>
                      </c:pt>
                      <c:pt idx="641">
                        <c:v>1183</c:v>
                      </c:pt>
                      <c:pt idx="642">
                        <c:v>1184</c:v>
                      </c:pt>
                      <c:pt idx="643">
                        <c:v>1185</c:v>
                      </c:pt>
                      <c:pt idx="644">
                        <c:v>1186</c:v>
                      </c:pt>
                      <c:pt idx="645">
                        <c:v>1187</c:v>
                      </c:pt>
                      <c:pt idx="646">
                        <c:v>1188</c:v>
                      </c:pt>
                      <c:pt idx="647">
                        <c:v>1189</c:v>
                      </c:pt>
                      <c:pt idx="648">
                        <c:v>1190</c:v>
                      </c:pt>
                      <c:pt idx="649">
                        <c:v>1192</c:v>
                      </c:pt>
                      <c:pt idx="650">
                        <c:v>1193</c:v>
                      </c:pt>
                      <c:pt idx="651">
                        <c:v>1194</c:v>
                      </c:pt>
                      <c:pt idx="652">
                        <c:v>1195</c:v>
                      </c:pt>
                      <c:pt idx="653">
                        <c:v>1197</c:v>
                      </c:pt>
                      <c:pt idx="654">
                        <c:v>1198</c:v>
                      </c:pt>
                      <c:pt idx="655">
                        <c:v>1199</c:v>
                      </c:pt>
                      <c:pt idx="656">
                        <c:v>1200</c:v>
                      </c:pt>
                      <c:pt idx="657">
                        <c:v>1201</c:v>
                      </c:pt>
                      <c:pt idx="658">
                        <c:v>1203</c:v>
                      </c:pt>
                      <c:pt idx="659">
                        <c:v>1204</c:v>
                      </c:pt>
                      <c:pt idx="660">
                        <c:v>1205</c:v>
                      </c:pt>
                      <c:pt idx="661">
                        <c:v>1208</c:v>
                      </c:pt>
                      <c:pt idx="662">
                        <c:v>1209</c:v>
                      </c:pt>
                      <c:pt idx="663">
                        <c:v>1210</c:v>
                      </c:pt>
                      <c:pt idx="664">
                        <c:v>1214</c:v>
                      </c:pt>
                      <c:pt idx="665">
                        <c:v>1215</c:v>
                      </c:pt>
                      <c:pt idx="666">
                        <c:v>1216</c:v>
                      </c:pt>
                      <c:pt idx="667">
                        <c:v>1217</c:v>
                      </c:pt>
                      <c:pt idx="668">
                        <c:v>1220</c:v>
                      </c:pt>
                      <c:pt idx="669">
                        <c:v>1221</c:v>
                      </c:pt>
                      <c:pt idx="670">
                        <c:v>1225</c:v>
                      </c:pt>
                      <c:pt idx="671">
                        <c:v>1229</c:v>
                      </c:pt>
                      <c:pt idx="672">
                        <c:v>1231</c:v>
                      </c:pt>
                      <c:pt idx="673">
                        <c:v>1232</c:v>
                      </c:pt>
                      <c:pt idx="674">
                        <c:v>1242</c:v>
                      </c:pt>
                      <c:pt idx="675">
                        <c:v>1253</c:v>
                      </c:pt>
                      <c:pt idx="676">
                        <c:v>1255</c:v>
                      </c:pt>
                      <c:pt idx="677">
                        <c:v>1256</c:v>
                      </c:pt>
                      <c:pt idx="678">
                        <c:v>1258</c:v>
                      </c:pt>
                      <c:pt idx="679">
                        <c:v>1259</c:v>
                      </c:pt>
                      <c:pt idx="680">
                        <c:v>1260</c:v>
                      </c:pt>
                      <c:pt idx="681">
                        <c:v>1261</c:v>
                      </c:pt>
                      <c:pt idx="682">
                        <c:v>1262</c:v>
                      </c:pt>
                      <c:pt idx="683">
                        <c:v>1263</c:v>
                      </c:pt>
                      <c:pt idx="684">
                        <c:v>1264</c:v>
                      </c:pt>
                      <c:pt idx="685">
                        <c:v>1266</c:v>
                      </c:pt>
                      <c:pt idx="686">
                        <c:v>1269</c:v>
                      </c:pt>
                      <c:pt idx="687">
                        <c:v>1279</c:v>
                      </c:pt>
                      <c:pt idx="688">
                        <c:v>1280</c:v>
                      </c:pt>
                      <c:pt idx="689">
                        <c:v>1290</c:v>
                      </c:pt>
                      <c:pt idx="690">
                        <c:v>1291</c:v>
                      </c:pt>
                      <c:pt idx="691">
                        <c:v>1292</c:v>
                      </c:pt>
                      <c:pt idx="692">
                        <c:v>1293</c:v>
                      </c:pt>
                      <c:pt idx="693">
                        <c:v>1294</c:v>
                      </c:pt>
                      <c:pt idx="694">
                        <c:v>1295</c:v>
                      </c:pt>
                      <c:pt idx="695">
                        <c:v>1300</c:v>
                      </c:pt>
                      <c:pt idx="696">
                        <c:v>1301</c:v>
                      </c:pt>
                      <c:pt idx="697">
                        <c:v>1302</c:v>
                      </c:pt>
                      <c:pt idx="698">
                        <c:v>1303</c:v>
                      </c:pt>
                      <c:pt idx="699">
                        <c:v>1305</c:v>
                      </c:pt>
                      <c:pt idx="700">
                        <c:v>1306</c:v>
                      </c:pt>
                      <c:pt idx="701">
                        <c:v>1307</c:v>
                      </c:pt>
                      <c:pt idx="702">
                        <c:v>1308</c:v>
                      </c:pt>
                      <c:pt idx="703">
                        <c:v>1310</c:v>
                      </c:pt>
                      <c:pt idx="704">
                        <c:v>1311</c:v>
                      </c:pt>
                      <c:pt idx="705">
                        <c:v>1312</c:v>
                      </c:pt>
                      <c:pt idx="706">
                        <c:v>1313</c:v>
                      </c:pt>
                      <c:pt idx="707">
                        <c:v>1314</c:v>
                      </c:pt>
                      <c:pt idx="708">
                        <c:v>1315</c:v>
                      </c:pt>
                      <c:pt idx="709">
                        <c:v>1316</c:v>
                      </c:pt>
                      <c:pt idx="710">
                        <c:v>1317</c:v>
                      </c:pt>
                      <c:pt idx="711">
                        <c:v>1318</c:v>
                      </c:pt>
                      <c:pt idx="712">
                        <c:v>1319</c:v>
                      </c:pt>
                      <c:pt idx="713">
                        <c:v>1320</c:v>
                      </c:pt>
                      <c:pt idx="714">
                        <c:v>1322</c:v>
                      </c:pt>
                      <c:pt idx="715">
                        <c:v>1323</c:v>
                      </c:pt>
                      <c:pt idx="716">
                        <c:v>1324</c:v>
                      </c:pt>
                      <c:pt idx="717">
                        <c:v>1325</c:v>
                      </c:pt>
                      <c:pt idx="718">
                        <c:v>1326</c:v>
                      </c:pt>
                      <c:pt idx="719">
                        <c:v>1327</c:v>
                      </c:pt>
                      <c:pt idx="720">
                        <c:v>1328</c:v>
                      </c:pt>
                      <c:pt idx="721">
                        <c:v>1329</c:v>
                      </c:pt>
                      <c:pt idx="722">
                        <c:v>1331</c:v>
                      </c:pt>
                      <c:pt idx="723">
                        <c:v>1333</c:v>
                      </c:pt>
                      <c:pt idx="724">
                        <c:v>1337</c:v>
                      </c:pt>
                      <c:pt idx="725">
                        <c:v>1338</c:v>
                      </c:pt>
                      <c:pt idx="726">
                        <c:v>1339</c:v>
                      </c:pt>
                      <c:pt idx="727">
                        <c:v>1342</c:v>
                      </c:pt>
                      <c:pt idx="728">
                        <c:v>1343</c:v>
                      </c:pt>
                      <c:pt idx="729">
                        <c:v>1344</c:v>
                      </c:pt>
                      <c:pt idx="730">
                        <c:v>1345</c:v>
                      </c:pt>
                      <c:pt idx="731">
                        <c:v>1346</c:v>
                      </c:pt>
                      <c:pt idx="732">
                        <c:v>1348</c:v>
                      </c:pt>
                      <c:pt idx="733">
                        <c:v>1349</c:v>
                      </c:pt>
                      <c:pt idx="734">
                        <c:v>1353</c:v>
                      </c:pt>
                      <c:pt idx="735">
                        <c:v>1355</c:v>
                      </c:pt>
                      <c:pt idx="736">
                        <c:v>1360</c:v>
                      </c:pt>
                      <c:pt idx="737">
                        <c:v>1361</c:v>
                      </c:pt>
                      <c:pt idx="738">
                        <c:v>1363</c:v>
                      </c:pt>
                      <c:pt idx="739">
                        <c:v>1364</c:v>
                      </c:pt>
                      <c:pt idx="740">
                        <c:v>1365</c:v>
                      </c:pt>
                      <c:pt idx="741">
                        <c:v>1366</c:v>
                      </c:pt>
                      <c:pt idx="742">
                        <c:v>1367</c:v>
                      </c:pt>
                      <c:pt idx="743">
                        <c:v>1369</c:v>
                      </c:pt>
                      <c:pt idx="744">
                        <c:v>1372</c:v>
                      </c:pt>
                      <c:pt idx="745">
                        <c:v>1373</c:v>
                      </c:pt>
                      <c:pt idx="746">
                        <c:v>1374</c:v>
                      </c:pt>
                      <c:pt idx="747">
                        <c:v>1375</c:v>
                      </c:pt>
                      <c:pt idx="748">
                        <c:v>1376</c:v>
                      </c:pt>
                      <c:pt idx="749">
                        <c:v>1377</c:v>
                      </c:pt>
                      <c:pt idx="750">
                        <c:v>1378</c:v>
                      </c:pt>
                      <c:pt idx="751">
                        <c:v>1379</c:v>
                      </c:pt>
                      <c:pt idx="752">
                        <c:v>1380</c:v>
                      </c:pt>
                      <c:pt idx="753">
                        <c:v>1381</c:v>
                      </c:pt>
                      <c:pt idx="754">
                        <c:v>1383</c:v>
                      </c:pt>
                      <c:pt idx="755">
                        <c:v>1384</c:v>
                      </c:pt>
                      <c:pt idx="756">
                        <c:v>1385</c:v>
                      </c:pt>
                      <c:pt idx="757">
                        <c:v>1386</c:v>
                      </c:pt>
                      <c:pt idx="758">
                        <c:v>1390</c:v>
                      </c:pt>
                      <c:pt idx="759">
                        <c:v>1391</c:v>
                      </c:pt>
                      <c:pt idx="760">
                        <c:v>1392</c:v>
                      </c:pt>
                      <c:pt idx="761">
                        <c:v>1393</c:v>
                      </c:pt>
                      <c:pt idx="762">
                        <c:v>1394</c:v>
                      </c:pt>
                      <c:pt idx="763">
                        <c:v>1395</c:v>
                      </c:pt>
                      <c:pt idx="764">
                        <c:v>1396</c:v>
                      </c:pt>
                      <c:pt idx="765">
                        <c:v>1397</c:v>
                      </c:pt>
                      <c:pt idx="766">
                        <c:v>1398</c:v>
                      </c:pt>
                      <c:pt idx="767">
                        <c:v>1400</c:v>
                      </c:pt>
                      <c:pt idx="768">
                        <c:v>1401</c:v>
                      </c:pt>
                      <c:pt idx="769">
                        <c:v>1402</c:v>
                      </c:pt>
                      <c:pt idx="770">
                        <c:v>1403</c:v>
                      </c:pt>
                      <c:pt idx="771">
                        <c:v>1405</c:v>
                      </c:pt>
                      <c:pt idx="772">
                        <c:v>1407</c:v>
                      </c:pt>
                      <c:pt idx="773">
                        <c:v>1408</c:v>
                      </c:pt>
                      <c:pt idx="774">
                        <c:v>1410</c:v>
                      </c:pt>
                      <c:pt idx="775">
                        <c:v>1411</c:v>
                      </c:pt>
                      <c:pt idx="776">
                        <c:v>1412</c:v>
                      </c:pt>
                      <c:pt idx="777">
                        <c:v>1413</c:v>
                      </c:pt>
                      <c:pt idx="778">
                        <c:v>1414</c:v>
                      </c:pt>
                      <c:pt idx="779">
                        <c:v>1415</c:v>
                      </c:pt>
                      <c:pt idx="780">
                        <c:v>1416</c:v>
                      </c:pt>
                      <c:pt idx="781">
                        <c:v>1417</c:v>
                      </c:pt>
                      <c:pt idx="782">
                        <c:v>1418</c:v>
                      </c:pt>
                      <c:pt idx="783">
                        <c:v>1419</c:v>
                      </c:pt>
                      <c:pt idx="784">
                        <c:v>1420</c:v>
                      </c:pt>
                      <c:pt idx="785">
                        <c:v>1421</c:v>
                      </c:pt>
                      <c:pt idx="786">
                        <c:v>1423</c:v>
                      </c:pt>
                      <c:pt idx="787">
                        <c:v>1424</c:v>
                      </c:pt>
                      <c:pt idx="788">
                        <c:v>1425</c:v>
                      </c:pt>
                      <c:pt idx="789">
                        <c:v>1426</c:v>
                      </c:pt>
                      <c:pt idx="790">
                        <c:v>1427</c:v>
                      </c:pt>
                      <c:pt idx="791">
                        <c:v>1428</c:v>
                      </c:pt>
                      <c:pt idx="792">
                        <c:v>1429</c:v>
                      </c:pt>
                      <c:pt idx="793">
                        <c:v>1430</c:v>
                      </c:pt>
                      <c:pt idx="794">
                        <c:v>1432</c:v>
                      </c:pt>
                      <c:pt idx="795">
                        <c:v>1434</c:v>
                      </c:pt>
                      <c:pt idx="796">
                        <c:v>1435</c:v>
                      </c:pt>
                      <c:pt idx="797">
                        <c:v>1436</c:v>
                      </c:pt>
                      <c:pt idx="798">
                        <c:v>1437</c:v>
                      </c:pt>
                      <c:pt idx="799">
                        <c:v>1439</c:v>
                      </c:pt>
                      <c:pt idx="800">
                        <c:v>1440</c:v>
                      </c:pt>
                      <c:pt idx="801">
                        <c:v>1442</c:v>
                      </c:pt>
                      <c:pt idx="802">
                        <c:v>1443</c:v>
                      </c:pt>
                      <c:pt idx="803">
                        <c:v>1444</c:v>
                      </c:pt>
                      <c:pt idx="804">
                        <c:v>1445</c:v>
                      </c:pt>
                      <c:pt idx="805">
                        <c:v>1446</c:v>
                      </c:pt>
                      <c:pt idx="806">
                        <c:v>1447</c:v>
                      </c:pt>
                      <c:pt idx="807">
                        <c:v>1448</c:v>
                      </c:pt>
                      <c:pt idx="808">
                        <c:v>1449</c:v>
                      </c:pt>
                      <c:pt idx="809">
                        <c:v>1450</c:v>
                      </c:pt>
                      <c:pt idx="810">
                        <c:v>1451</c:v>
                      </c:pt>
                      <c:pt idx="811">
                        <c:v>1453</c:v>
                      </c:pt>
                      <c:pt idx="812">
                        <c:v>1454</c:v>
                      </c:pt>
                      <c:pt idx="813">
                        <c:v>1455</c:v>
                      </c:pt>
                      <c:pt idx="814">
                        <c:v>1456</c:v>
                      </c:pt>
                      <c:pt idx="815">
                        <c:v>1457</c:v>
                      </c:pt>
                      <c:pt idx="816">
                        <c:v>1458</c:v>
                      </c:pt>
                      <c:pt idx="817">
                        <c:v>1459</c:v>
                      </c:pt>
                      <c:pt idx="818">
                        <c:v>1460</c:v>
                      </c:pt>
                      <c:pt idx="819">
                        <c:v>1461</c:v>
                      </c:pt>
                      <c:pt idx="820">
                        <c:v>1462</c:v>
                      </c:pt>
                      <c:pt idx="821">
                        <c:v>1463</c:v>
                      </c:pt>
                      <c:pt idx="822">
                        <c:v>1464</c:v>
                      </c:pt>
                      <c:pt idx="823">
                        <c:v>1465</c:v>
                      </c:pt>
                      <c:pt idx="824">
                        <c:v>1466</c:v>
                      </c:pt>
                      <c:pt idx="825">
                        <c:v>1467</c:v>
                      </c:pt>
                      <c:pt idx="826">
                        <c:v>1468</c:v>
                      </c:pt>
                      <c:pt idx="827">
                        <c:v>1469</c:v>
                      </c:pt>
                      <c:pt idx="828">
                        <c:v>1470</c:v>
                      </c:pt>
                      <c:pt idx="829">
                        <c:v>1471</c:v>
                      </c:pt>
                      <c:pt idx="830">
                        <c:v>1472</c:v>
                      </c:pt>
                      <c:pt idx="831">
                        <c:v>1473</c:v>
                      </c:pt>
                      <c:pt idx="832">
                        <c:v>1474</c:v>
                      </c:pt>
                      <c:pt idx="833">
                        <c:v>1475</c:v>
                      </c:pt>
                      <c:pt idx="834">
                        <c:v>1476</c:v>
                      </c:pt>
                      <c:pt idx="835">
                        <c:v>1477</c:v>
                      </c:pt>
                      <c:pt idx="836">
                        <c:v>1478</c:v>
                      </c:pt>
                      <c:pt idx="837">
                        <c:v>1479</c:v>
                      </c:pt>
                      <c:pt idx="838">
                        <c:v>1480</c:v>
                      </c:pt>
                      <c:pt idx="839">
                        <c:v>1481</c:v>
                      </c:pt>
                      <c:pt idx="840">
                        <c:v>1482</c:v>
                      </c:pt>
                      <c:pt idx="841">
                        <c:v>1483</c:v>
                      </c:pt>
                      <c:pt idx="842">
                        <c:v>1484</c:v>
                      </c:pt>
                      <c:pt idx="843">
                        <c:v>1485</c:v>
                      </c:pt>
                      <c:pt idx="844">
                        <c:v>1486</c:v>
                      </c:pt>
                      <c:pt idx="845">
                        <c:v>1487</c:v>
                      </c:pt>
                      <c:pt idx="846">
                        <c:v>1488</c:v>
                      </c:pt>
                      <c:pt idx="847">
                        <c:v>1489</c:v>
                      </c:pt>
                      <c:pt idx="848">
                        <c:v>1490</c:v>
                      </c:pt>
                      <c:pt idx="849">
                        <c:v>1491</c:v>
                      </c:pt>
                      <c:pt idx="850">
                        <c:v>1492</c:v>
                      </c:pt>
                      <c:pt idx="851">
                        <c:v>1493</c:v>
                      </c:pt>
                      <c:pt idx="852">
                        <c:v>1494</c:v>
                      </c:pt>
                      <c:pt idx="853">
                        <c:v>1495</c:v>
                      </c:pt>
                      <c:pt idx="854">
                        <c:v>1496</c:v>
                      </c:pt>
                      <c:pt idx="855">
                        <c:v>1497</c:v>
                      </c:pt>
                      <c:pt idx="856">
                        <c:v>1498</c:v>
                      </c:pt>
                      <c:pt idx="857">
                        <c:v>1499</c:v>
                      </c:pt>
                      <c:pt idx="858">
                        <c:v>1500</c:v>
                      </c:pt>
                      <c:pt idx="859">
                        <c:v>1501</c:v>
                      </c:pt>
                      <c:pt idx="860">
                        <c:v>1502</c:v>
                      </c:pt>
                      <c:pt idx="861">
                        <c:v>1503</c:v>
                      </c:pt>
                      <c:pt idx="862">
                        <c:v>1504</c:v>
                      </c:pt>
                      <c:pt idx="863">
                        <c:v>1505</c:v>
                      </c:pt>
                      <c:pt idx="864">
                        <c:v>1506</c:v>
                      </c:pt>
                      <c:pt idx="865">
                        <c:v>1507</c:v>
                      </c:pt>
                      <c:pt idx="866">
                        <c:v>1509</c:v>
                      </c:pt>
                      <c:pt idx="867">
                        <c:v>1510</c:v>
                      </c:pt>
                      <c:pt idx="868">
                        <c:v>1511</c:v>
                      </c:pt>
                      <c:pt idx="869">
                        <c:v>1512</c:v>
                      </c:pt>
                      <c:pt idx="870">
                        <c:v>1514</c:v>
                      </c:pt>
                      <c:pt idx="871">
                        <c:v>1515</c:v>
                      </c:pt>
                      <c:pt idx="872">
                        <c:v>1516</c:v>
                      </c:pt>
                      <c:pt idx="873">
                        <c:v>1517</c:v>
                      </c:pt>
                      <c:pt idx="874">
                        <c:v>1518</c:v>
                      </c:pt>
                      <c:pt idx="875">
                        <c:v>1519</c:v>
                      </c:pt>
                      <c:pt idx="876">
                        <c:v>1520</c:v>
                      </c:pt>
                      <c:pt idx="877">
                        <c:v>1521</c:v>
                      </c:pt>
                      <c:pt idx="878">
                        <c:v>1522</c:v>
                      </c:pt>
                      <c:pt idx="879">
                        <c:v>1523</c:v>
                      </c:pt>
                      <c:pt idx="880">
                        <c:v>1524</c:v>
                      </c:pt>
                      <c:pt idx="881">
                        <c:v>1525</c:v>
                      </c:pt>
                      <c:pt idx="882">
                        <c:v>1526</c:v>
                      </c:pt>
                      <c:pt idx="883">
                        <c:v>1527</c:v>
                      </c:pt>
                      <c:pt idx="884">
                        <c:v>1528</c:v>
                      </c:pt>
                      <c:pt idx="885">
                        <c:v>1529</c:v>
                      </c:pt>
                      <c:pt idx="886">
                        <c:v>1530</c:v>
                      </c:pt>
                      <c:pt idx="887">
                        <c:v>1531</c:v>
                      </c:pt>
                      <c:pt idx="888">
                        <c:v>1532</c:v>
                      </c:pt>
                      <c:pt idx="889">
                        <c:v>1533</c:v>
                      </c:pt>
                      <c:pt idx="890">
                        <c:v>1534</c:v>
                      </c:pt>
                      <c:pt idx="891">
                        <c:v>1535</c:v>
                      </c:pt>
                      <c:pt idx="892">
                        <c:v>1536</c:v>
                      </c:pt>
                      <c:pt idx="893">
                        <c:v>1537</c:v>
                      </c:pt>
                      <c:pt idx="894">
                        <c:v>1538</c:v>
                      </c:pt>
                      <c:pt idx="895">
                        <c:v>1539</c:v>
                      </c:pt>
                      <c:pt idx="896">
                        <c:v>1540</c:v>
                      </c:pt>
                      <c:pt idx="897">
                        <c:v>1541</c:v>
                      </c:pt>
                      <c:pt idx="898">
                        <c:v>1542</c:v>
                      </c:pt>
                      <c:pt idx="899">
                        <c:v>1543</c:v>
                      </c:pt>
                      <c:pt idx="900">
                        <c:v>1544</c:v>
                      </c:pt>
                      <c:pt idx="901">
                        <c:v>1545</c:v>
                      </c:pt>
                      <c:pt idx="902">
                        <c:v>1546</c:v>
                      </c:pt>
                      <c:pt idx="903">
                        <c:v>1547</c:v>
                      </c:pt>
                      <c:pt idx="904">
                        <c:v>1548</c:v>
                      </c:pt>
                      <c:pt idx="905">
                        <c:v>1549</c:v>
                      </c:pt>
                      <c:pt idx="906">
                        <c:v>1550</c:v>
                      </c:pt>
                      <c:pt idx="907">
                        <c:v>1551</c:v>
                      </c:pt>
                      <c:pt idx="908">
                        <c:v>1552</c:v>
                      </c:pt>
                      <c:pt idx="909">
                        <c:v>1553</c:v>
                      </c:pt>
                      <c:pt idx="910">
                        <c:v>1554</c:v>
                      </c:pt>
                      <c:pt idx="911">
                        <c:v>1555</c:v>
                      </c:pt>
                      <c:pt idx="912">
                        <c:v>1556</c:v>
                      </c:pt>
                      <c:pt idx="913">
                        <c:v>1557</c:v>
                      </c:pt>
                      <c:pt idx="914">
                        <c:v>1558</c:v>
                      </c:pt>
                      <c:pt idx="915">
                        <c:v>1559</c:v>
                      </c:pt>
                      <c:pt idx="916">
                        <c:v>1560</c:v>
                      </c:pt>
                      <c:pt idx="917">
                        <c:v>1561</c:v>
                      </c:pt>
                      <c:pt idx="918">
                        <c:v>1562</c:v>
                      </c:pt>
                      <c:pt idx="919">
                        <c:v>1563</c:v>
                      </c:pt>
                      <c:pt idx="920">
                        <c:v>1564</c:v>
                      </c:pt>
                      <c:pt idx="921">
                        <c:v>1565</c:v>
                      </c:pt>
                      <c:pt idx="922">
                        <c:v>1566</c:v>
                      </c:pt>
                      <c:pt idx="923">
                        <c:v>1567</c:v>
                      </c:pt>
                      <c:pt idx="924">
                        <c:v>1568</c:v>
                      </c:pt>
                      <c:pt idx="925">
                        <c:v>1569</c:v>
                      </c:pt>
                      <c:pt idx="926">
                        <c:v>1570</c:v>
                      </c:pt>
                      <c:pt idx="927">
                        <c:v>1571</c:v>
                      </c:pt>
                      <c:pt idx="928">
                        <c:v>1572</c:v>
                      </c:pt>
                      <c:pt idx="929">
                        <c:v>1573</c:v>
                      </c:pt>
                      <c:pt idx="930">
                        <c:v>1574</c:v>
                      </c:pt>
                      <c:pt idx="931">
                        <c:v>1575</c:v>
                      </c:pt>
                      <c:pt idx="932">
                        <c:v>1576</c:v>
                      </c:pt>
                      <c:pt idx="933">
                        <c:v>1577</c:v>
                      </c:pt>
                      <c:pt idx="934">
                        <c:v>1578</c:v>
                      </c:pt>
                      <c:pt idx="935">
                        <c:v>1579</c:v>
                      </c:pt>
                      <c:pt idx="936">
                        <c:v>1580</c:v>
                      </c:pt>
                      <c:pt idx="937">
                        <c:v>1582</c:v>
                      </c:pt>
                      <c:pt idx="938">
                        <c:v>1583</c:v>
                      </c:pt>
                      <c:pt idx="939">
                        <c:v>1584</c:v>
                      </c:pt>
                      <c:pt idx="940">
                        <c:v>1585</c:v>
                      </c:pt>
                      <c:pt idx="941">
                        <c:v>1586</c:v>
                      </c:pt>
                      <c:pt idx="942">
                        <c:v>1587</c:v>
                      </c:pt>
                      <c:pt idx="943">
                        <c:v>1588</c:v>
                      </c:pt>
                      <c:pt idx="944">
                        <c:v>1589</c:v>
                      </c:pt>
                      <c:pt idx="945">
                        <c:v>1591</c:v>
                      </c:pt>
                      <c:pt idx="946">
                        <c:v>1592</c:v>
                      </c:pt>
                      <c:pt idx="947">
                        <c:v>1593</c:v>
                      </c:pt>
                      <c:pt idx="948">
                        <c:v>1594</c:v>
                      </c:pt>
                      <c:pt idx="949">
                        <c:v>1595</c:v>
                      </c:pt>
                      <c:pt idx="950">
                        <c:v>1596</c:v>
                      </c:pt>
                      <c:pt idx="951">
                        <c:v>1597</c:v>
                      </c:pt>
                      <c:pt idx="952">
                        <c:v>1598</c:v>
                      </c:pt>
                      <c:pt idx="953">
                        <c:v>1599</c:v>
                      </c:pt>
                      <c:pt idx="954">
                        <c:v>1600</c:v>
                      </c:pt>
                      <c:pt idx="955">
                        <c:v>1601</c:v>
                      </c:pt>
                      <c:pt idx="956">
                        <c:v>1602</c:v>
                      </c:pt>
                      <c:pt idx="957">
                        <c:v>1603</c:v>
                      </c:pt>
                      <c:pt idx="958">
                        <c:v>1604</c:v>
                      </c:pt>
                      <c:pt idx="959">
                        <c:v>1605</c:v>
                      </c:pt>
                      <c:pt idx="960">
                        <c:v>1606</c:v>
                      </c:pt>
                      <c:pt idx="961">
                        <c:v>1607</c:v>
                      </c:pt>
                      <c:pt idx="962">
                        <c:v>1608</c:v>
                      </c:pt>
                      <c:pt idx="963">
                        <c:v>1609</c:v>
                      </c:pt>
                      <c:pt idx="964">
                        <c:v>1610</c:v>
                      </c:pt>
                      <c:pt idx="965">
                        <c:v>1611</c:v>
                      </c:pt>
                      <c:pt idx="966">
                        <c:v>1612</c:v>
                      </c:pt>
                      <c:pt idx="967">
                        <c:v>1613</c:v>
                      </c:pt>
                      <c:pt idx="968">
                        <c:v>1614</c:v>
                      </c:pt>
                      <c:pt idx="969">
                        <c:v>1615</c:v>
                      </c:pt>
                      <c:pt idx="970">
                        <c:v>1616</c:v>
                      </c:pt>
                      <c:pt idx="971">
                        <c:v>1617</c:v>
                      </c:pt>
                      <c:pt idx="972">
                        <c:v>1618</c:v>
                      </c:pt>
                      <c:pt idx="973">
                        <c:v>1619</c:v>
                      </c:pt>
                      <c:pt idx="974">
                        <c:v>1620</c:v>
                      </c:pt>
                      <c:pt idx="975">
                        <c:v>1621</c:v>
                      </c:pt>
                      <c:pt idx="976">
                        <c:v>1622</c:v>
                      </c:pt>
                      <c:pt idx="977">
                        <c:v>1623</c:v>
                      </c:pt>
                      <c:pt idx="978">
                        <c:v>1624</c:v>
                      </c:pt>
                      <c:pt idx="979">
                        <c:v>1625</c:v>
                      </c:pt>
                      <c:pt idx="980">
                        <c:v>1626</c:v>
                      </c:pt>
                      <c:pt idx="981">
                        <c:v>1627</c:v>
                      </c:pt>
                      <c:pt idx="982">
                        <c:v>1628</c:v>
                      </c:pt>
                      <c:pt idx="983">
                        <c:v>1629</c:v>
                      </c:pt>
                      <c:pt idx="984">
                        <c:v>1630</c:v>
                      </c:pt>
                      <c:pt idx="985">
                        <c:v>1631</c:v>
                      </c:pt>
                      <c:pt idx="986">
                        <c:v>1632</c:v>
                      </c:pt>
                      <c:pt idx="987">
                        <c:v>1633</c:v>
                      </c:pt>
                      <c:pt idx="988">
                        <c:v>1634</c:v>
                      </c:pt>
                      <c:pt idx="989">
                        <c:v>1635</c:v>
                      </c:pt>
                      <c:pt idx="990">
                        <c:v>1636</c:v>
                      </c:pt>
                      <c:pt idx="991">
                        <c:v>1637</c:v>
                      </c:pt>
                      <c:pt idx="992">
                        <c:v>1638</c:v>
                      </c:pt>
                      <c:pt idx="993">
                        <c:v>1639</c:v>
                      </c:pt>
                      <c:pt idx="994">
                        <c:v>1640</c:v>
                      </c:pt>
                      <c:pt idx="995">
                        <c:v>1641</c:v>
                      </c:pt>
                      <c:pt idx="996">
                        <c:v>1642</c:v>
                      </c:pt>
                      <c:pt idx="997">
                        <c:v>1643</c:v>
                      </c:pt>
                      <c:pt idx="998">
                        <c:v>1644</c:v>
                      </c:pt>
                      <c:pt idx="999">
                        <c:v>1645</c:v>
                      </c:pt>
                      <c:pt idx="1000">
                        <c:v>1646</c:v>
                      </c:pt>
                      <c:pt idx="1001">
                        <c:v>1647</c:v>
                      </c:pt>
                      <c:pt idx="1002">
                        <c:v>1648</c:v>
                      </c:pt>
                      <c:pt idx="1003">
                        <c:v>1649</c:v>
                      </c:pt>
                      <c:pt idx="1004">
                        <c:v>1650</c:v>
                      </c:pt>
                      <c:pt idx="1005">
                        <c:v>1651</c:v>
                      </c:pt>
                      <c:pt idx="1006">
                        <c:v>1652</c:v>
                      </c:pt>
                      <c:pt idx="1007">
                        <c:v>1653</c:v>
                      </c:pt>
                      <c:pt idx="1008">
                        <c:v>1654</c:v>
                      </c:pt>
                      <c:pt idx="1009">
                        <c:v>1655</c:v>
                      </c:pt>
                      <c:pt idx="1010">
                        <c:v>1656</c:v>
                      </c:pt>
                      <c:pt idx="1011">
                        <c:v>1657</c:v>
                      </c:pt>
                      <c:pt idx="1012">
                        <c:v>1658</c:v>
                      </c:pt>
                      <c:pt idx="1013">
                        <c:v>1659</c:v>
                      </c:pt>
                      <c:pt idx="1014">
                        <c:v>1660</c:v>
                      </c:pt>
                      <c:pt idx="1015">
                        <c:v>1661</c:v>
                      </c:pt>
                      <c:pt idx="1016">
                        <c:v>1663</c:v>
                      </c:pt>
                      <c:pt idx="1017">
                        <c:v>1664</c:v>
                      </c:pt>
                      <c:pt idx="1018">
                        <c:v>1668</c:v>
                      </c:pt>
                      <c:pt idx="1019">
                        <c:v>1669</c:v>
                      </c:pt>
                      <c:pt idx="1020">
                        <c:v>1672</c:v>
                      </c:pt>
                      <c:pt idx="1021">
                        <c:v>1673</c:v>
                      </c:pt>
                      <c:pt idx="1022">
                        <c:v>1674</c:v>
                      </c:pt>
                      <c:pt idx="1023">
                        <c:v>1675</c:v>
                      </c:pt>
                      <c:pt idx="1024">
                        <c:v>1676</c:v>
                      </c:pt>
                      <c:pt idx="1025">
                        <c:v>1677</c:v>
                      </c:pt>
                      <c:pt idx="1026">
                        <c:v>1678</c:v>
                      </c:pt>
                      <c:pt idx="1027">
                        <c:v>1679</c:v>
                      </c:pt>
                      <c:pt idx="1028">
                        <c:v>1680</c:v>
                      </c:pt>
                      <c:pt idx="1029">
                        <c:v>1681</c:v>
                      </c:pt>
                      <c:pt idx="1030">
                        <c:v>1682</c:v>
                      </c:pt>
                      <c:pt idx="1031">
                        <c:v>1683</c:v>
                      </c:pt>
                      <c:pt idx="1032">
                        <c:v>1684</c:v>
                      </c:pt>
                      <c:pt idx="1033">
                        <c:v>1685</c:v>
                      </c:pt>
                      <c:pt idx="1034">
                        <c:v>1686</c:v>
                      </c:pt>
                      <c:pt idx="1035">
                        <c:v>1687</c:v>
                      </c:pt>
                      <c:pt idx="1036">
                        <c:v>1688</c:v>
                      </c:pt>
                      <c:pt idx="1037">
                        <c:v>1689</c:v>
                      </c:pt>
                      <c:pt idx="1038">
                        <c:v>1690</c:v>
                      </c:pt>
                      <c:pt idx="1039">
                        <c:v>1701</c:v>
                      </c:pt>
                      <c:pt idx="1040">
                        <c:v>1704</c:v>
                      </c:pt>
                      <c:pt idx="1041">
                        <c:v>1708</c:v>
                      </c:pt>
                      <c:pt idx="1042">
                        <c:v>1709</c:v>
                      </c:pt>
                      <c:pt idx="1043">
                        <c:v>1710</c:v>
                      </c:pt>
                      <c:pt idx="1044">
                        <c:v>1712</c:v>
                      </c:pt>
                      <c:pt idx="1045">
                        <c:v>1713</c:v>
                      </c:pt>
                      <c:pt idx="1046">
                        <c:v>1714</c:v>
                      </c:pt>
                      <c:pt idx="1047">
                        <c:v>1715</c:v>
                      </c:pt>
                      <c:pt idx="1048">
                        <c:v>1716</c:v>
                      </c:pt>
                      <c:pt idx="1049">
                        <c:v>1717</c:v>
                      </c:pt>
                      <c:pt idx="1050">
                        <c:v>1718</c:v>
                      </c:pt>
                      <c:pt idx="1051">
                        <c:v>1721</c:v>
                      </c:pt>
                      <c:pt idx="1052">
                        <c:v>1722</c:v>
                      </c:pt>
                      <c:pt idx="1053">
                        <c:v>1725</c:v>
                      </c:pt>
                      <c:pt idx="1054">
                        <c:v>1726</c:v>
                      </c:pt>
                      <c:pt idx="1055">
                        <c:v>1732</c:v>
                      </c:pt>
                      <c:pt idx="1056">
                        <c:v>1746</c:v>
                      </c:pt>
                      <c:pt idx="1057">
                        <c:v>1951</c:v>
                      </c:pt>
                    </c:numCache>
                  </c:numRef>
                </c:xVal>
                <c:yVal>
                  <c:numRef>
                    <c:extLst xmlns:c15="http://schemas.microsoft.com/office/drawing/2012/chart">
                      <c:ext xmlns:c15="http://schemas.microsoft.com/office/drawing/2012/chart" uri="{02D57815-91ED-43cb-92C2-25804820EDAC}">
                        <c15:formulaRef>
                          <c15:sqref>'Brachy NFY'!$D$3:$D$1060</c15:sqref>
                        </c15:formulaRef>
                      </c:ext>
                    </c:extLst>
                    <c:numCache>
                      <c:formatCode>General</c:formatCode>
                      <c:ptCount val="1058"/>
                      <c:pt idx="13">
                        <c:v>1</c:v>
                      </c:pt>
                      <c:pt idx="14">
                        <c:v>1</c:v>
                      </c:pt>
                      <c:pt idx="19">
                        <c:v>1</c:v>
                      </c:pt>
                      <c:pt idx="25">
                        <c:v>1</c:v>
                      </c:pt>
                      <c:pt idx="40">
                        <c:v>1</c:v>
                      </c:pt>
                      <c:pt idx="55">
                        <c:v>1</c:v>
                      </c:pt>
                      <c:pt idx="59">
                        <c:v>1</c:v>
                      </c:pt>
                      <c:pt idx="65">
                        <c:v>1</c:v>
                      </c:pt>
                      <c:pt idx="74">
                        <c:v>1</c:v>
                      </c:pt>
                      <c:pt idx="81">
                        <c:v>1</c:v>
                      </c:pt>
                      <c:pt idx="94">
                        <c:v>1</c:v>
                      </c:pt>
                      <c:pt idx="99">
                        <c:v>1</c:v>
                      </c:pt>
                      <c:pt idx="104">
                        <c:v>1</c:v>
                      </c:pt>
                      <c:pt idx="107">
                        <c:v>1</c:v>
                      </c:pt>
                      <c:pt idx="108">
                        <c:v>1</c:v>
                      </c:pt>
                      <c:pt idx="110">
                        <c:v>1</c:v>
                      </c:pt>
                      <c:pt idx="112">
                        <c:v>1</c:v>
                      </c:pt>
                      <c:pt idx="113">
                        <c:v>1</c:v>
                      </c:pt>
                      <c:pt idx="115">
                        <c:v>1</c:v>
                      </c:pt>
                      <c:pt idx="117">
                        <c:v>1</c:v>
                      </c:pt>
                      <c:pt idx="119">
                        <c:v>1</c:v>
                      </c:pt>
                      <c:pt idx="130">
                        <c:v>1</c:v>
                      </c:pt>
                      <c:pt idx="136">
                        <c:v>1</c:v>
                      </c:pt>
                      <c:pt idx="137">
                        <c:v>1</c:v>
                      </c:pt>
                      <c:pt idx="138">
                        <c:v>1</c:v>
                      </c:pt>
                      <c:pt idx="140">
                        <c:v>1</c:v>
                      </c:pt>
                      <c:pt idx="144">
                        <c:v>1</c:v>
                      </c:pt>
                      <c:pt idx="148">
                        <c:v>1</c:v>
                      </c:pt>
                      <c:pt idx="159">
                        <c:v>1</c:v>
                      </c:pt>
                      <c:pt idx="161">
                        <c:v>1</c:v>
                      </c:pt>
                      <c:pt idx="163">
                        <c:v>1</c:v>
                      </c:pt>
                      <c:pt idx="170">
                        <c:v>1</c:v>
                      </c:pt>
                      <c:pt idx="171">
                        <c:v>1</c:v>
                      </c:pt>
                      <c:pt idx="176">
                        <c:v>1</c:v>
                      </c:pt>
                      <c:pt idx="185">
                        <c:v>1</c:v>
                      </c:pt>
                      <c:pt idx="187">
                        <c:v>1</c:v>
                      </c:pt>
                      <c:pt idx="192">
                        <c:v>1</c:v>
                      </c:pt>
                      <c:pt idx="197">
                        <c:v>1</c:v>
                      </c:pt>
                      <c:pt idx="198">
                        <c:v>1</c:v>
                      </c:pt>
                      <c:pt idx="200">
                        <c:v>1</c:v>
                      </c:pt>
                      <c:pt idx="204">
                        <c:v>1</c:v>
                      </c:pt>
                      <c:pt idx="205">
                        <c:v>1</c:v>
                      </c:pt>
                      <c:pt idx="211">
                        <c:v>1</c:v>
                      </c:pt>
                      <c:pt idx="217">
                        <c:v>1</c:v>
                      </c:pt>
                      <c:pt idx="221">
                        <c:v>1</c:v>
                      </c:pt>
                      <c:pt idx="227">
                        <c:v>1</c:v>
                      </c:pt>
                      <c:pt idx="233">
                        <c:v>1</c:v>
                      </c:pt>
                      <c:pt idx="237">
                        <c:v>1</c:v>
                      </c:pt>
                      <c:pt idx="245">
                        <c:v>1</c:v>
                      </c:pt>
                      <c:pt idx="247">
                        <c:v>1</c:v>
                      </c:pt>
                      <c:pt idx="248">
                        <c:v>1</c:v>
                      </c:pt>
                      <c:pt idx="250">
                        <c:v>1</c:v>
                      </c:pt>
                      <c:pt idx="251">
                        <c:v>1</c:v>
                      </c:pt>
                      <c:pt idx="252">
                        <c:v>1</c:v>
                      </c:pt>
                      <c:pt idx="253">
                        <c:v>1</c:v>
                      </c:pt>
                      <c:pt idx="254">
                        <c:v>1</c:v>
                      </c:pt>
                      <c:pt idx="259">
                        <c:v>1</c:v>
                      </c:pt>
                      <c:pt idx="260">
                        <c:v>1</c:v>
                      </c:pt>
                      <c:pt idx="263">
                        <c:v>1</c:v>
                      </c:pt>
                      <c:pt idx="264">
                        <c:v>1</c:v>
                      </c:pt>
                      <c:pt idx="265">
                        <c:v>1</c:v>
                      </c:pt>
                      <c:pt idx="267">
                        <c:v>1</c:v>
                      </c:pt>
                      <c:pt idx="269">
                        <c:v>1</c:v>
                      </c:pt>
                      <c:pt idx="270">
                        <c:v>1</c:v>
                      </c:pt>
                      <c:pt idx="273">
                        <c:v>1</c:v>
                      </c:pt>
                      <c:pt idx="274">
                        <c:v>1</c:v>
                      </c:pt>
                      <c:pt idx="275">
                        <c:v>1</c:v>
                      </c:pt>
                      <c:pt idx="280">
                        <c:v>1</c:v>
                      </c:pt>
                      <c:pt idx="281">
                        <c:v>1</c:v>
                      </c:pt>
                      <c:pt idx="286">
                        <c:v>1</c:v>
                      </c:pt>
                      <c:pt idx="287">
                        <c:v>1</c:v>
                      </c:pt>
                      <c:pt idx="288">
                        <c:v>1</c:v>
                      </c:pt>
                      <c:pt idx="297">
                        <c:v>1</c:v>
                      </c:pt>
                      <c:pt idx="300">
                        <c:v>1</c:v>
                      </c:pt>
                      <c:pt idx="302">
                        <c:v>1</c:v>
                      </c:pt>
                      <c:pt idx="303">
                        <c:v>1</c:v>
                      </c:pt>
                      <c:pt idx="304">
                        <c:v>1</c:v>
                      </c:pt>
                      <c:pt idx="309">
                        <c:v>1</c:v>
                      </c:pt>
                      <c:pt idx="311">
                        <c:v>1</c:v>
                      </c:pt>
                      <c:pt idx="312">
                        <c:v>1</c:v>
                      </c:pt>
                      <c:pt idx="317">
                        <c:v>1</c:v>
                      </c:pt>
                      <c:pt idx="318">
                        <c:v>1</c:v>
                      </c:pt>
                      <c:pt idx="323">
                        <c:v>1</c:v>
                      </c:pt>
                      <c:pt idx="330">
                        <c:v>1</c:v>
                      </c:pt>
                      <c:pt idx="334">
                        <c:v>1</c:v>
                      </c:pt>
                      <c:pt idx="335">
                        <c:v>1</c:v>
                      </c:pt>
                      <c:pt idx="336">
                        <c:v>2</c:v>
                      </c:pt>
                      <c:pt idx="337">
                        <c:v>7</c:v>
                      </c:pt>
                      <c:pt idx="338">
                        <c:v>1</c:v>
                      </c:pt>
                      <c:pt idx="339">
                        <c:v>1</c:v>
                      </c:pt>
                      <c:pt idx="346">
                        <c:v>1</c:v>
                      </c:pt>
                      <c:pt idx="349">
                        <c:v>1</c:v>
                      </c:pt>
                      <c:pt idx="353">
                        <c:v>1</c:v>
                      </c:pt>
                      <c:pt idx="358">
                        <c:v>1</c:v>
                      </c:pt>
                      <c:pt idx="361">
                        <c:v>1</c:v>
                      </c:pt>
                      <c:pt idx="365">
                        <c:v>1</c:v>
                      </c:pt>
                      <c:pt idx="366">
                        <c:v>1</c:v>
                      </c:pt>
                      <c:pt idx="367">
                        <c:v>1</c:v>
                      </c:pt>
                      <c:pt idx="371">
                        <c:v>1</c:v>
                      </c:pt>
                      <c:pt idx="372">
                        <c:v>1</c:v>
                      </c:pt>
                      <c:pt idx="373">
                        <c:v>1</c:v>
                      </c:pt>
                      <c:pt idx="374">
                        <c:v>1</c:v>
                      </c:pt>
                      <c:pt idx="376">
                        <c:v>1</c:v>
                      </c:pt>
                      <c:pt idx="377">
                        <c:v>1</c:v>
                      </c:pt>
                      <c:pt idx="378">
                        <c:v>1</c:v>
                      </c:pt>
                      <c:pt idx="379">
                        <c:v>1</c:v>
                      </c:pt>
                      <c:pt idx="380">
                        <c:v>1</c:v>
                      </c:pt>
                      <c:pt idx="381">
                        <c:v>1</c:v>
                      </c:pt>
                      <c:pt idx="383">
                        <c:v>1</c:v>
                      </c:pt>
                      <c:pt idx="385">
                        <c:v>1</c:v>
                      </c:pt>
                      <c:pt idx="391">
                        <c:v>1</c:v>
                      </c:pt>
                      <c:pt idx="392">
                        <c:v>1</c:v>
                      </c:pt>
                      <c:pt idx="393">
                        <c:v>1</c:v>
                      </c:pt>
                      <c:pt idx="394">
                        <c:v>1</c:v>
                      </c:pt>
                      <c:pt idx="395">
                        <c:v>1</c:v>
                      </c:pt>
                      <c:pt idx="396">
                        <c:v>1</c:v>
                      </c:pt>
                      <c:pt idx="397">
                        <c:v>1</c:v>
                      </c:pt>
                      <c:pt idx="398">
                        <c:v>1</c:v>
                      </c:pt>
                      <c:pt idx="401">
                        <c:v>1</c:v>
                      </c:pt>
                      <c:pt idx="405">
                        <c:v>1</c:v>
                      </c:pt>
                      <c:pt idx="406">
                        <c:v>1</c:v>
                      </c:pt>
                      <c:pt idx="407">
                        <c:v>1</c:v>
                      </c:pt>
                      <c:pt idx="408">
                        <c:v>1</c:v>
                      </c:pt>
                      <c:pt idx="409">
                        <c:v>1</c:v>
                      </c:pt>
                      <c:pt idx="410">
                        <c:v>1</c:v>
                      </c:pt>
                      <c:pt idx="415">
                        <c:v>1</c:v>
                      </c:pt>
                      <c:pt idx="418">
                        <c:v>1</c:v>
                      </c:pt>
                      <c:pt idx="419">
                        <c:v>1</c:v>
                      </c:pt>
                      <c:pt idx="420">
                        <c:v>1</c:v>
                      </c:pt>
                      <c:pt idx="423">
                        <c:v>1</c:v>
                      </c:pt>
                      <c:pt idx="429">
                        <c:v>1</c:v>
                      </c:pt>
                      <c:pt idx="431">
                        <c:v>1</c:v>
                      </c:pt>
                      <c:pt idx="432">
                        <c:v>1</c:v>
                      </c:pt>
                      <c:pt idx="433">
                        <c:v>1</c:v>
                      </c:pt>
                      <c:pt idx="439">
                        <c:v>1</c:v>
                      </c:pt>
                      <c:pt idx="440">
                        <c:v>1</c:v>
                      </c:pt>
                      <c:pt idx="448">
                        <c:v>1</c:v>
                      </c:pt>
                      <c:pt idx="452">
                        <c:v>1</c:v>
                      </c:pt>
                      <c:pt idx="455">
                        <c:v>1</c:v>
                      </c:pt>
                      <c:pt idx="456">
                        <c:v>1</c:v>
                      </c:pt>
                      <c:pt idx="457">
                        <c:v>1</c:v>
                      </c:pt>
                      <c:pt idx="460">
                        <c:v>1</c:v>
                      </c:pt>
                      <c:pt idx="462">
                        <c:v>1</c:v>
                      </c:pt>
                      <c:pt idx="466">
                        <c:v>1</c:v>
                      </c:pt>
                      <c:pt idx="471">
                        <c:v>1</c:v>
                      </c:pt>
                      <c:pt idx="474">
                        <c:v>1</c:v>
                      </c:pt>
                      <c:pt idx="479">
                        <c:v>1</c:v>
                      </c:pt>
                      <c:pt idx="485">
                        <c:v>1</c:v>
                      </c:pt>
                      <c:pt idx="486">
                        <c:v>1</c:v>
                      </c:pt>
                      <c:pt idx="487">
                        <c:v>1</c:v>
                      </c:pt>
                      <c:pt idx="488">
                        <c:v>1</c:v>
                      </c:pt>
                      <c:pt idx="489">
                        <c:v>1</c:v>
                      </c:pt>
                      <c:pt idx="490">
                        <c:v>1</c:v>
                      </c:pt>
                      <c:pt idx="493">
                        <c:v>1</c:v>
                      </c:pt>
                      <c:pt idx="501">
                        <c:v>1</c:v>
                      </c:pt>
                      <c:pt idx="503">
                        <c:v>1</c:v>
                      </c:pt>
                      <c:pt idx="505">
                        <c:v>1</c:v>
                      </c:pt>
                      <c:pt idx="508">
                        <c:v>1</c:v>
                      </c:pt>
                      <c:pt idx="509">
                        <c:v>1</c:v>
                      </c:pt>
                      <c:pt idx="511">
                        <c:v>1</c:v>
                      </c:pt>
                      <c:pt idx="514">
                        <c:v>1</c:v>
                      </c:pt>
                      <c:pt idx="515">
                        <c:v>1</c:v>
                      </c:pt>
                      <c:pt idx="519">
                        <c:v>1</c:v>
                      </c:pt>
                      <c:pt idx="521">
                        <c:v>1</c:v>
                      </c:pt>
                      <c:pt idx="524">
                        <c:v>1</c:v>
                      </c:pt>
                      <c:pt idx="530">
                        <c:v>1</c:v>
                      </c:pt>
                      <c:pt idx="537">
                        <c:v>1</c:v>
                      </c:pt>
                      <c:pt idx="538">
                        <c:v>1</c:v>
                      </c:pt>
                      <c:pt idx="539">
                        <c:v>1</c:v>
                      </c:pt>
                      <c:pt idx="547">
                        <c:v>1</c:v>
                      </c:pt>
                      <c:pt idx="549">
                        <c:v>1</c:v>
                      </c:pt>
                      <c:pt idx="550">
                        <c:v>1</c:v>
                      </c:pt>
                      <c:pt idx="551">
                        <c:v>1</c:v>
                      </c:pt>
                      <c:pt idx="553">
                        <c:v>1</c:v>
                      </c:pt>
                      <c:pt idx="555">
                        <c:v>1</c:v>
                      </c:pt>
                      <c:pt idx="556">
                        <c:v>1</c:v>
                      </c:pt>
                      <c:pt idx="560">
                        <c:v>1</c:v>
                      </c:pt>
                      <c:pt idx="562">
                        <c:v>1</c:v>
                      </c:pt>
                      <c:pt idx="563">
                        <c:v>1</c:v>
                      </c:pt>
                      <c:pt idx="565">
                        <c:v>1</c:v>
                      </c:pt>
                      <c:pt idx="569">
                        <c:v>1</c:v>
                      </c:pt>
                      <c:pt idx="571">
                        <c:v>1</c:v>
                      </c:pt>
                      <c:pt idx="572">
                        <c:v>1</c:v>
                      </c:pt>
                      <c:pt idx="575">
                        <c:v>1</c:v>
                      </c:pt>
                      <c:pt idx="577">
                        <c:v>1</c:v>
                      </c:pt>
                      <c:pt idx="581">
                        <c:v>1</c:v>
                      </c:pt>
                      <c:pt idx="582">
                        <c:v>1</c:v>
                      </c:pt>
                      <c:pt idx="583">
                        <c:v>1</c:v>
                      </c:pt>
                      <c:pt idx="585">
                        <c:v>1</c:v>
                      </c:pt>
                      <c:pt idx="588">
                        <c:v>1</c:v>
                      </c:pt>
                      <c:pt idx="591">
                        <c:v>1</c:v>
                      </c:pt>
                      <c:pt idx="592">
                        <c:v>1</c:v>
                      </c:pt>
                      <c:pt idx="595">
                        <c:v>1</c:v>
                      </c:pt>
                      <c:pt idx="596">
                        <c:v>1</c:v>
                      </c:pt>
                      <c:pt idx="598">
                        <c:v>1</c:v>
                      </c:pt>
                      <c:pt idx="600">
                        <c:v>1</c:v>
                      </c:pt>
                      <c:pt idx="601">
                        <c:v>1</c:v>
                      </c:pt>
                      <c:pt idx="602">
                        <c:v>1</c:v>
                      </c:pt>
                      <c:pt idx="603">
                        <c:v>1</c:v>
                      </c:pt>
                      <c:pt idx="604">
                        <c:v>1</c:v>
                      </c:pt>
                      <c:pt idx="605">
                        <c:v>3</c:v>
                      </c:pt>
                      <c:pt idx="606">
                        <c:v>5</c:v>
                      </c:pt>
                      <c:pt idx="607">
                        <c:v>1</c:v>
                      </c:pt>
                      <c:pt idx="611">
                        <c:v>1</c:v>
                      </c:pt>
                      <c:pt idx="615">
                        <c:v>1</c:v>
                      </c:pt>
                      <c:pt idx="617">
                        <c:v>1</c:v>
                      </c:pt>
                      <c:pt idx="618">
                        <c:v>1</c:v>
                      </c:pt>
                      <c:pt idx="619">
                        <c:v>1</c:v>
                      </c:pt>
                      <c:pt idx="620">
                        <c:v>1</c:v>
                      </c:pt>
                      <c:pt idx="621">
                        <c:v>1</c:v>
                      </c:pt>
                      <c:pt idx="622">
                        <c:v>1</c:v>
                      </c:pt>
                      <c:pt idx="623">
                        <c:v>1</c:v>
                      </c:pt>
                      <c:pt idx="624">
                        <c:v>1</c:v>
                      </c:pt>
                      <c:pt idx="625">
                        <c:v>1</c:v>
                      </c:pt>
                      <c:pt idx="626">
                        <c:v>1</c:v>
                      </c:pt>
                      <c:pt idx="627">
                        <c:v>1</c:v>
                      </c:pt>
                      <c:pt idx="629">
                        <c:v>1</c:v>
                      </c:pt>
                      <c:pt idx="630">
                        <c:v>1</c:v>
                      </c:pt>
                      <c:pt idx="631">
                        <c:v>1</c:v>
                      </c:pt>
                      <c:pt idx="632">
                        <c:v>1</c:v>
                      </c:pt>
                      <c:pt idx="633">
                        <c:v>1</c:v>
                      </c:pt>
                      <c:pt idx="637">
                        <c:v>1</c:v>
                      </c:pt>
                      <c:pt idx="639">
                        <c:v>1</c:v>
                      </c:pt>
                      <c:pt idx="640">
                        <c:v>1</c:v>
                      </c:pt>
                      <c:pt idx="641">
                        <c:v>1</c:v>
                      </c:pt>
                      <c:pt idx="642">
                        <c:v>1</c:v>
                      </c:pt>
                      <c:pt idx="643">
                        <c:v>1</c:v>
                      </c:pt>
                      <c:pt idx="644">
                        <c:v>1</c:v>
                      </c:pt>
                      <c:pt idx="645">
                        <c:v>1</c:v>
                      </c:pt>
                      <c:pt idx="646">
                        <c:v>1</c:v>
                      </c:pt>
                      <c:pt idx="647">
                        <c:v>1</c:v>
                      </c:pt>
                      <c:pt idx="649">
                        <c:v>1</c:v>
                      </c:pt>
                      <c:pt idx="653">
                        <c:v>1</c:v>
                      </c:pt>
                      <c:pt idx="654">
                        <c:v>1</c:v>
                      </c:pt>
                      <c:pt idx="655">
                        <c:v>1</c:v>
                      </c:pt>
                      <c:pt idx="656">
                        <c:v>1</c:v>
                      </c:pt>
                      <c:pt idx="659">
                        <c:v>1</c:v>
                      </c:pt>
                      <c:pt idx="663">
                        <c:v>1</c:v>
                      </c:pt>
                      <c:pt idx="667">
                        <c:v>1</c:v>
                      </c:pt>
                      <c:pt idx="675">
                        <c:v>1</c:v>
                      </c:pt>
                      <c:pt idx="682">
                        <c:v>1</c:v>
                      </c:pt>
                      <c:pt idx="683">
                        <c:v>1</c:v>
                      </c:pt>
                      <c:pt idx="685">
                        <c:v>1</c:v>
                      </c:pt>
                      <c:pt idx="692">
                        <c:v>1</c:v>
                      </c:pt>
                      <c:pt idx="698">
                        <c:v>1</c:v>
                      </c:pt>
                      <c:pt idx="699">
                        <c:v>1</c:v>
                      </c:pt>
                      <c:pt idx="701">
                        <c:v>1</c:v>
                      </c:pt>
                      <c:pt idx="704">
                        <c:v>1</c:v>
                      </c:pt>
                      <c:pt idx="710">
                        <c:v>1</c:v>
                      </c:pt>
                      <c:pt idx="713">
                        <c:v>1</c:v>
                      </c:pt>
                      <c:pt idx="720">
                        <c:v>1</c:v>
                      </c:pt>
                      <c:pt idx="722">
                        <c:v>1</c:v>
                      </c:pt>
                      <c:pt idx="729">
                        <c:v>1</c:v>
                      </c:pt>
                      <c:pt idx="731">
                        <c:v>1</c:v>
                      </c:pt>
                      <c:pt idx="739">
                        <c:v>1</c:v>
                      </c:pt>
                      <c:pt idx="746">
                        <c:v>1</c:v>
                      </c:pt>
                      <c:pt idx="747">
                        <c:v>1</c:v>
                      </c:pt>
                      <c:pt idx="748">
                        <c:v>1</c:v>
                      </c:pt>
                      <c:pt idx="750">
                        <c:v>1</c:v>
                      </c:pt>
                      <c:pt idx="751">
                        <c:v>1</c:v>
                      </c:pt>
                      <c:pt idx="752">
                        <c:v>1</c:v>
                      </c:pt>
                      <c:pt idx="757">
                        <c:v>1</c:v>
                      </c:pt>
                      <c:pt idx="760">
                        <c:v>1</c:v>
                      </c:pt>
                      <c:pt idx="761">
                        <c:v>1</c:v>
                      </c:pt>
                      <c:pt idx="764">
                        <c:v>1</c:v>
                      </c:pt>
                      <c:pt idx="765">
                        <c:v>1</c:v>
                      </c:pt>
                      <c:pt idx="766">
                        <c:v>1</c:v>
                      </c:pt>
                      <c:pt idx="767">
                        <c:v>1</c:v>
                      </c:pt>
                      <c:pt idx="768">
                        <c:v>1</c:v>
                      </c:pt>
                      <c:pt idx="769">
                        <c:v>1</c:v>
                      </c:pt>
                      <c:pt idx="770">
                        <c:v>1</c:v>
                      </c:pt>
                      <c:pt idx="778">
                        <c:v>1</c:v>
                      </c:pt>
                      <c:pt idx="785">
                        <c:v>1</c:v>
                      </c:pt>
                      <c:pt idx="786">
                        <c:v>1</c:v>
                      </c:pt>
                      <c:pt idx="795">
                        <c:v>1</c:v>
                      </c:pt>
                      <c:pt idx="796">
                        <c:v>1</c:v>
                      </c:pt>
                      <c:pt idx="797">
                        <c:v>1</c:v>
                      </c:pt>
                      <c:pt idx="802">
                        <c:v>1</c:v>
                      </c:pt>
                      <c:pt idx="805">
                        <c:v>1</c:v>
                      </c:pt>
                      <c:pt idx="806">
                        <c:v>82</c:v>
                      </c:pt>
                      <c:pt idx="807">
                        <c:v>1</c:v>
                      </c:pt>
                      <c:pt idx="810">
                        <c:v>1</c:v>
                      </c:pt>
                      <c:pt idx="811">
                        <c:v>1</c:v>
                      </c:pt>
                      <c:pt idx="815">
                        <c:v>1</c:v>
                      </c:pt>
                      <c:pt idx="820">
                        <c:v>1</c:v>
                      </c:pt>
                      <c:pt idx="821">
                        <c:v>1</c:v>
                      </c:pt>
                      <c:pt idx="822">
                        <c:v>1</c:v>
                      </c:pt>
                      <c:pt idx="824">
                        <c:v>1</c:v>
                      </c:pt>
                      <c:pt idx="825">
                        <c:v>1</c:v>
                      </c:pt>
                      <c:pt idx="826">
                        <c:v>1</c:v>
                      </c:pt>
                      <c:pt idx="828">
                        <c:v>1</c:v>
                      </c:pt>
                      <c:pt idx="830">
                        <c:v>1</c:v>
                      </c:pt>
                      <c:pt idx="832">
                        <c:v>1</c:v>
                      </c:pt>
                      <c:pt idx="833">
                        <c:v>1</c:v>
                      </c:pt>
                      <c:pt idx="837">
                        <c:v>1</c:v>
                      </c:pt>
                      <c:pt idx="839">
                        <c:v>1</c:v>
                      </c:pt>
                      <c:pt idx="841">
                        <c:v>1</c:v>
                      </c:pt>
                      <c:pt idx="842">
                        <c:v>1</c:v>
                      </c:pt>
                      <c:pt idx="843">
                        <c:v>1</c:v>
                      </c:pt>
                      <c:pt idx="844">
                        <c:v>1</c:v>
                      </c:pt>
                      <c:pt idx="845">
                        <c:v>1</c:v>
                      </c:pt>
                      <c:pt idx="846">
                        <c:v>2</c:v>
                      </c:pt>
                      <c:pt idx="848">
                        <c:v>1</c:v>
                      </c:pt>
                      <c:pt idx="849">
                        <c:v>13</c:v>
                      </c:pt>
                      <c:pt idx="850">
                        <c:v>1</c:v>
                      </c:pt>
                      <c:pt idx="851">
                        <c:v>1</c:v>
                      </c:pt>
                      <c:pt idx="853">
                        <c:v>1</c:v>
                      </c:pt>
                      <c:pt idx="855">
                        <c:v>1</c:v>
                      </c:pt>
                      <c:pt idx="860">
                        <c:v>1</c:v>
                      </c:pt>
                      <c:pt idx="863">
                        <c:v>1</c:v>
                      </c:pt>
                      <c:pt idx="865">
                        <c:v>1</c:v>
                      </c:pt>
                      <c:pt idx="867">
                        <c:v>1</c:v>
                      </c:pt>
                      <c:pt idx="868">
                        <c:v>1</c:v>
                      </c:pt>
                      <c:pt idx="869">
                        <c:v>1</c:v>
                      </c:pt>
                      <c:pt idx="873">
                        <c:v>1</c:v>
                      </c:pt>
                      <c:pt idx="874">
                        <c:v>1</c:v>
                      </c:pt>
                      <c:pt idx="875">
                        <c:v>1</c:v>
                      </c:pt>
                      <c:pt idx="876">
                        <c:v>2</c:v>
                      </c:pt>
                      <c:pt idx="877">
                        <c:v>1</c:v>
                      </c:pt>
                      <c:pt idx="878">
                        <c:v>1</c:v>
                      </c:pt>
                      <c:pt idx="884">
                        <c:v>1</c:v>
                      </c:pt>
                      <c:pt idx="885">
                        <c:v>1</c:v>
                      </c:pt>
                      <c:pt idx="886">
                        <c:v>1</c:v>
                      </c:pt>
                      <c:pt idx="887">
                        <c:v>1</c:v>
                      </c:pt>
                      <c:pt idx="888">
                        <c:v>1</c:v>
                      </c:pt>
                      <c:pt idx="890">
                        <c:v>1</c:v>
                      </c:pt>
                      <c:pt idx="891">
                        <c:v>1</c:v>
                      </c:pt>
                      <c:pt idx="892">
                        <c:v>1</c:v>
                      </c:pt>
                      <c:pt idx="893">
                        <c:v>1</c:v>
                      </c:pt>
                      <c:pt idx="895">
                        <c:v>1</c:v>
                      </c:pt>
                      <c:pt idx="897">
                        <c:v>1</c:v>
                      </c:pt>
                      <c:pt idx="898">
                        <c:v>1</c:v>
                      </c:pt>
                      <c:pt idx="899">
                        <c:v>1</c:v>
                      </c:pt>
                      <c:pt idx="900">
                        <c:v>1</c:v>
                      </c:pt>
                      <c:pt idx="901">
                        <c:v>1</c:v>
                      </c:pt>
                      <c:pt idx="903">
                        <c:v>1</c:v>
                      </c:pt>
                      <c:pt idx="904">
                        <c:v>1</c:v>
                      </c:pt>
                      <c:pt idx="905">
                        <c:v>1</c:v>
                      </c:pt>
                      <c:pt idx="906">
                        <c:v>14</c:v>
                      </c:pt>
                      <c:pt idx="907">
                        <c:v>2</c:v>
                      </c:pt>
                      <c:pt idx="910">
                        <c:v>1</c:v>
                      </c:pt>
                      <c:pt idx="911">
                        <c:v>1</c:v>
                      </c:pt>
                      <c:pt idx="912">
                        <c:v>1</c:v>
                      </c:pt>
                      <c:pt idx="913">
                        <c:v>1</c:v>
                      </c:pt>
                      <c:pt idx="914">
                        <c:v>1</c:v>
                      </c:pt>
                      <c:pt idx="916">
                        <c:v>1</c:v>
                      </c:pt>
                      <c:pt idx="917">
                        <c:v>1</c:v>
                      </c:pt>
                      <c:pt idx="918">
                        <c:v>2</c:v>
                      </c:pt>
                      <c:pt idx="919">
                        <c:v>1</c:v>
                      </c:pt>
                      <c:pt idx="920">
                        <c:v>1</c:v>
                      </c:pt>
                      <c:pt idx="921">
                        <c:v>44</c:v>
                      </c:pt>
                      <c:pt idx="922">
                        <c:v>49</c:v>
                      </c:pt>
                      <c:pt idx="923">
                        <c:v>2</c:v>
                      </c:pt>
                      <c:pt idx="924">
                        <c:v>10</c:v>
                      </c:pt>
                      <c:pt idx="925">
                        <c:v>2</c:v>
                      </c:pt>
                      <c:pt idx="926">
                        <c:v>1</c:v>
                      </c:pt>
                      <c:pt idx="927">
                        <c:v>1</c:v>
                      </c:pt>
                      <c:pt idx="928">
                        <c:v>1</c:v>
                      </c:pt>
                      <c:pt idx="929">
                        <c:v>1</c:v>
                      </c:pt>
                      <c:pt idx="930">
                        <c:v>1</c:v>
                      </c:pt>
                      <c:pt idx="931">
                        <c:v>3</c:v>
                      </c:pt>
                      <c:pt idx="932">
                        <c:v>1</c:v>
                      </c:pt>
                      <c:pt idx="934">
                        <c:v>1</c:v>
                      </c:pt>
                      <c:pt idx="935">
                        <c:v>1</c:v>
                      </c:pt>
                      <c:pt idx="938">
                        <c:v>1</c:v>
                      </c:pt>
                      <c:pt idx="939">
                        <c:v>1</c:v>
                      </c:pt>
                      <c:pt idx="940">
                        <c:v>1</c:v>
                      </c:pt>
                      <c:pt idx="945">
                        <c:v>1</c:v>
                      </c:pt>
                      <c:pt idx="946">
                        <c:v>1</c:v>
                      </c:pt>
                      <c:pt idx="947">
                        <c:v>1</c:v>
                      </c:pt>
                      <c:pt idx="948">
                        <c:v>1</c:v>
                      </c:pt>
                      <c:pt idx="950">
                        <c:v>1</c:v>
                      </c:pt>
                      <c:pt idx="951">
                        <c:v>2</c:v>
                      </c:pt>
                      <c:pt idx="952">
                        <c:v>1</c:v>
                      </c:pt>
                      <c:pt idx="954">
                        <c:v>1</c:v>
                      </c:pt>
                      <c:pt idx="955">
                        <c:v>2</c:v>
                      </c:pt>
                      <c:pt idx="956">
                        <c:v>3</c:v>
                      </c:pt>
                      <c:pt idx="957">
                        <c:v>3</c:v>
                      </c:pt>
                      <c:pt idx="958">
                        <c:v>1</c:v>
                      </c:pt>
                      <c:pt idx="959">
                        <c:v>1</c:v>
                      </c:pt>
                      <c:pt idx="960">
                        <c:v>1</c:v>
                      </c:pt>
                      <c:pt idx="961">
                        <c:v>1</c:v>
                      </c:pt>
                      <c:pt idx="962">
                        <c:v>10</c:v>
                      </c:pt>
                      <c:pt idx="963">
                        <c:v>18</c:v>
                      </c:pt>
                      <c:pt idx="964">
                        <c:v>1</c:v>
                      </c:pt>
                      <c:pt idx="965">
                        <c:v>1</c:v>
                      </c:pt>
                      <c:pt idx="966">
                        <c:v>3</c:v>
                      </c:pt>
                      <c:pt idx="967">
                        <c:v>1</c:v>
                      </c:pt>
                      <c:pt idx="968">
                        <c:v>1</c:v>
                      </c:pt>
                      <c:pt idx="969">
                        <c:v>5</c:v>
                      </c:pt>
                      <c:pt idx="970">
                        <c:v>2</c:v>
                      </c:pt>
                      <c:pt idx="971">
                        <c:v>1</c:v>
                      </c:pt>
                      <c:pt idx="972">
                        <c:v>1</c:v>
                      </c:pt>
                      <c:pt idx="973">
                        <c:v>3</c:v>
                      </c:pt>
                      <c:pt idx="974">
                        <c:v>2</c:v>
                      </c:pt>
                      <c:pt idx="976">
                        <c:v>1</c:v>
                      </c:pt>
                      <c:pt idx="977">
                        <c:v>1</c:v>
                      </c:pt>
                      <c:pt idx="978">
                        <c:v>2</c:v>
                      </c:pt>
                      <c:pt idx="979">
                        <c:v>2</c:v>
                      </c:pt>
                      <c:pt idx="980">
                        <c:v>1</c:v>
                      </c:pt>
                      <c:pt idx="981">
                        <c:v>1</c:v>
                      </c:pt>
                      <c:pt idx="983">
                        <c:v>1</c:v>
                      </c:pt>
                      <c:pt idx="984">
                        <c:v>1</c:v>
                      </c:pt>
                      <c:pt idx="985">
                        <c:v>1</c:v>
                      </c:pt>
                      <c:pt idx="986">
                        <c:v>1</c:v>
                      </c:pt>
                      <c:pt idx="987">
                        <c:v>7</c:v>
                      </c:pt>
                      <c:pt idx="988">
                        <c:v>1</c:v>
                      </c:pt>
                      <c:pt idx="989">
                        <c:v>1</c:v>
                      </c:pt>
                      <c:pt idx="990">
                        <c:v>1</c:v>
                      </c:pt>
                      <c:pt idx="991">
                        <c:v>71</c:v>
                      </c:pt>
                      <c:pt idx="992">
                        <c:v>32</c:v>
                      </c:pt>
                      <c:pt idx="993">
                        <c:v>1</c:v>
                      </c:pt>
                      <c:pt idx="994">
                        <c:v>1</c:v>
                      </c:pt>
                      <c:pt idx="995">
                        <c:v>2</c:v>
                      </c:pt>
                      <c:pt idx="996">
                        <c:v>1</c:v>
                      </c:pt>
                      <c:pt idx="997">
                        <c:v>1</c:v>
                      </c:pt>
                      <c:pt idx="998">
                        <c:v>1</c:v>
                      </c:pt>
                      <c:pt idx="999">
                        <c:v>1</c:v>
                      </c:pt>
                      <c:pt idx="1000">
                        <c:v>1</c:v>
                      </c:pt>
                      <c:pt idx="1001">
                        <c:v>1</c:v>
                      </c:pt>
                      <c:pt idx="1002">
                        <c:v>1</c:v>
                      </c:pt>
                      <c:pt idx="1003">
                        <c:v>1</c:v>
                      </c:pt>
                      <c:pt idx="1004">
                        <c:v>1</c:v>
                      </c:pt>
                      <c:pt idx="1005">
                        <c:v>1</c:v>
                      </c:pt>
                      <c:pt idx="1006">
                        <c:v>1</c:v>
                      </c:pt>
                      <c:pt idx="1007">
                        <c:v>1</c:v>
                      </c:pt>
                      <c:pt idx="1008">
                        <c:v>1</c:v>
                      </c:pt>
                      <c:pt idx="1009">
                        <c:v>1</c:v>
                      </c:pt>
                      <c:pt idx="1011">
                        <c:v>1</c:v>
                      </c:pt>
                      <c:pt idx="1014">
                        <c:v>1</c:v>
                      </c:pt>
                      <c:pt idx="1015">
                        <c:v>1</c:v>
                      </c:pt>
                      <c:pt idx="1016">
                        <c:v>1</c:v>
                      </c:pt>
                      <c:pt idx="1018">
                        <c:v>1</c:v>
                      </c:pt>
                      <c:pt idx="1020">
                        <c:v>1</c:v>
                      </c:pt>
                      <c:pt idx="1021">
                        <c:v>1</c:v>
                      </c:pt>
                      <c:pt idx="1022">
                        <c:v>1</c:v>
                      </c:pt>
                      <c:pt idx="1025">
                        <c:v>1</c:v>
                      </c:pt>
                      <c:pt idx="1026">
                        <c:v>2</c:v>
                      </c:pt>
                      <c:pt idx="1028">
                        <c:v>1</c:v>
                      </c:pt>
                      <c:pt idx="1029">
                        <c:v>1</c:v>
                      </c:pt>
                      <c:pt idx="1030">
                        <c:v>1</c:v>
                      </c:pt>
                      <c:pt idx="1039">
                        <c:v>1</c:v>
                      </c:pt>
                      <c:pt idx="1043">
                        <c:v>1</c:v>
                      </c:pt>
                      <c:pt idx="1045">
                        <c:v>1</c:v>
                      </c:pt>
                      <c:pt idx="1046">
                        <c:v>1</c:v>
                      </c:pt>
                      <c:pt idx="1048">
                        <c:v>1</c:v>
                      </c:pt>
                      <c:pt idx="1053">
                        <c:v>1</c:v>
                      </c:pt>
                    </c:numCache>
                  </c:numRef>
                </c:yVal>
                <c:smooth val="0"/>
              </c15:ser>
            </c15:filteredScatterSeries>
            <c15:filteredScatterSeries>
              <c15:ser>
                <c:idx val="3"/>
                <c:order val="3"/>
                <c:tx>
                  <c:strRef>
                    <c:extLst xmlns:c15="http://schemas.microsoft.com/office/drawing/2012/chart">
                      <c:ext xmlns:c15="http://schemas.microsoft.com/office/drawing/2012/chart" uri="{02D57815-91ED-43cb-92C2-25804820EDAC}">
                        <c15:formulaRef>
                          <c15:sqref>'Brachy NFY'!$F$2</c15:sqref>
                        </c15:formulaRef>
                      </c:ext>
                    </c:extLst>
                    <c:strCache>
                      <c:ptCount val="1"/>
                      <c:pt idx="0">
                        <c:v>Cold2</c:v>
                      </c:pt>
                    </c:strCache>
                  </c:strRef>
                </c:tx>
                <c:spPr>
                  <a:ln w="25400" cap="rnd">
                    <a:noFill/>
                    <a:round/>
                  </a:ln>
                  <a:effectLst/>
                </c:spPr>
                <c:marker>
                  <c:symbol val="circle"/>
                  <c:size val="5"/>
                  <c:spPr>
                    <a:solidFill>
                      <a:schemeClr val="accent1">
                        <a:lumMod val="75000"/>
                      </a:schemeClr>
                    </a:solidFill>
                    <a:ln w="9525">
                      <a:solidFill>
                        <a:schemeClr val="accent1">
                          <a:lumMod val="75000"/>
                        </a:schemeClr>
                      </a:solidFill>
                    </a:ln>
                    <a:effectLst/>
                  </c:spPr>
                </c:marker>
                <c:xVal>
                  <c:numRef>
                    <c:extLst xmlns:c15="http://schemas.microsoft.com/office/drawing/2012/chart">
                      <c:ext xmlns:c15="http://schemas.microsoft.com/office/drawing/2012/chart" uri="{02D57815-91ED-43cb-92C2-25804820EDAC}">
                        <c15:formulaRef>
                          <c15:sqref>'Brachy NFY'!$B$3:$B$1060</c15:sqref>
                        </c15:formulaRef>
                      </c:ext>
                    </c:extLst>
                    <c:numCache>
                      <c:formatCode>General</c:formatCode>
                      <c:ptCount val="1058"/>
                      <c:pt idx="0">
                        <c:v>52</c:v>
                      </c:pt>
                      <c:pt idx="1">
                        <c:v>62</c:v>
                      </c:pt>
                      <c:pt idx="2">
                        <c:v>69</c:v>
                      </c:pt>
                      <c:pt idx="3">
                        <c:v>77</c:v>
                      </c:pt>
                      <c:pt idx="4">
                        <c:v>89</c:v>
                      </c:pt>
                      <c:pt idx="5">
                        <c:v>92</c:v>
                      </c:pt>
                      <c:pt idx="6">
                        <c:v>95</c:v>
                      </c:pt>
                      <c:pt idx="7">
                        <c:v>100</c:v>
                      </c:pt>
                      <c:pt idx="8">
                        <c:v>116</c:v>
                      </c:pt>
                      <c:pt idx="9">
                        <c:v>123</c:v>
                      </c:pt>
                      <c:pt idx="10">
                        <c:v>125</c:v>
                      </c:pt>
                      <c:pt idx="11">
                        <c:v>129</c:v>
                      </c:pt>
                      <c:pt idx="12">
                        <c:v>135</c:v>
                      </c:pt>
                      <c:pt idx="13">
                        <c:v>146</c:v>
                      </c:pt>
                      <c:pt idx="14">
                        <c:v>147</c:v>
                      </c:pt>
                      <c:pt idx="15">
                        <c:v>148</c:v>
                      </c:pt>
                      <c:pt idx="16">
                        <c:v>149</c:v>
                      </c:pt>
                      <c:pt idx="17">
                        <c:v>150</c:v>
                      </c:pt>
                      <c:pt idx="18">
                        <c:v>152</c:v>
                      </c:pt>
                      <c:pt idx="19">
                        <c:v>153</c:v>
                      </c:pt>
                      <c:pt idx="20">
                        <c:v>155</c:v>
                      </c:pt>
                      <c:pt idx="21">
                        <c:v>157</c:v>
                      </c:pt>
                      <c:pt idx="22">
                        <c:v>158</c:v>
                      </c:pt>
                      <c:pt idx="23">
                        <c:v>159</c:v>
                      </c:pt>
                      <c:pt idx="24">
                        <c:v>160</c:v>
                      </c:pt>
                      <c:pt idx="25">
                        <c:v>162</c:v>
                      </c:pt>
                      <c:pt idx="26">
                        <c:v>164</c:v>
                      </c:pt>
                      <c:pt idx="27">
                        <c:v>169</c:v>
                      </c:pt>
                      <c:pt idx="28">
                        <c:v>171</c:v>
                      </c:pt>
                      <c:pt idx="29">
                        <c:v>173</c:v>
                      </c:pt>
                      <c:pt idx="30">
                        <c:v>174</c:v>
                      </c:pt>
                      <c:pt idx="31">
                        <c:v>181</c:v>
                      </c:pt>
                      <c:pt idx="32">
                        <c:v>186</c:v>
                      </c:pt>
                      <c:pt idx="33">
                        <c:v>187</c:v>
                      </c:pt>
                      <c:pt idx="34">
                        <c:v>190</c:v>
                      </c:pt>
                      <c:pt idx="35">
                        <c:v>192</c:v>
                      </c:pt>
                      <c:pt idx="36">
                        <c:v>197</c:v>
                      </c:pt>
                      <c:pt idx="37">
                        <c:v>202</c:v>
                      </c:pt>
                      <c:pt idx="38">
                        <c:v>204</c:v>
                      </c:pt>
                      <c:pt idx="39">
                        <c:v>206</c:v>
                      </c:pt>
                      <c:pt idx="40">
                        <c:v>208</c:v>
                      </c:pt>
                      <c:pt idx="41">
                        <c:v>209</c:v>
                      </c:pt>
                      <c:pt idx="42">
                        <c:v>210</c:v>
                      </c:pt>
                      <c:pt idx="43">
                        <c:v>217</c:v>
                      </c:pt>
                      <c:pt idx="44">
                        <c:v>219</c:v>
                      </c:pt>
                      <c:pt idx="45">
                        <c:v>220</c:v>
                      </c:pt>
                      <c:pt idx="46">
                        <c:v>222</c:v>
                      </c:pt>
                      <c:pt idx="47">
                        <c:v>226</c:v>
                      </c:pt>
                      <c:pt idx="48">
                        <c:v>227</c:v>
                      </c:pt>
                      <c:pt idx="49">
                        <c:v>230</c:v>
                      </c:pt>
                      <c:pt idx="50">
                        <c:v>231</c:v>
                      </c:pt>
                      <c:pt idx="51">
                        <c:v>232</c:v>
                      </c:pt>
                      <c:pt idx="52">
                        <c:v>235</c:v>
                      </c:pt>
                      <c:pt idx="53">
                        <c:v>236</c:v>
                      </c:pt>
                      <c:pt idx="54">
                        <c:v>240</c:v>
                      </c:pt>
                      <c:pt idx="55">
                        <c:v>241</c:v>
                      </c:pt>
                      <c:pt idx="56">
                        <c:v>244</c:v>
                      </c:pt>
                      <c:pt idx="57">
                        <c:v>245</c:v>
                      </c:pt>
                      <c:pt idx="58">
                        <c:v>247</c:v>
                      </c:pt>
                      <c:pt idx="59">
                        <c:v>248</c:v>
                      </c:pt>
                      <c:pt idx="60">
                        <c:v>251</c:v>
                      </c:pt>
                      <c:pt idx="61">
                        <c:v>254</c:v>
                      </c:pt>
                      <c:pt idx="62">
                        <c:v>255</c:v>
                      </c:pt>
                      <c:pt idx="63">
                        <c:v>258</c:v>
                      </c:pt>
                      <c:pt idx="64">
                        <c:v>260</c:v>
                      </c:pt>
                      <c:pt idx="65">
                        <c:v>261</c:v>
                      </c:pt>
                      <c:pt idx="66">
                        <c:v>262</c:v>
                      </c:pt>
                      <c:pt idx="67">
                        <c:v>263</c:v>
                      </c:pt>
                      <c:pt idx="68">
                        <c:v>264</c:v>
                      </c:pt>
                      <c:pt idx="69">
                        <c:v>265</c:v>
                      </c:pt>
                      <c:pt idx="70">
                        <c:v>266</c:v>
                      </c:pt>
                      <c:pt idx="71">
                        <c:v>267</c:v>
                      </c:pt>
                      <c:pt idx="72">
                        <c:v>268</c:v>
                      </c:pt>
                      <c:pt idx="73">
                        <c:v>270</c:v>
                      </c:pt>
                      <c:pt idx="74">
                        <c:v>273</c:v>
                      </c:pt>
                      <c:pt idx="75">
                        <c:v>286</c:v>
                      </c:pt>
                      <c:pt idx="76">
                        <c:v>289</c:v>
                      </c:pt>
                      <c:pt idx="77">
                        <c:v>290</c:v>
                      </c:pt>
                      <c:pt idx="78">
                        <c:v>292</c:v>
                      </c:pt>
                      <c:pt idx="79">
                        <c:v>294</c:v>
                      </c:pt>
                      <c:pt idx="80">
                        <c:v>295</c:v>
                      </c:pt>
                      <c:pt idx="81">
                        <c:v>297</c:v>
                      </c:pt>
                      <c:pt idx="82">
                        <c:v>302</c:v>
                      </c:pt>
                      <c:pt idx="83">
                        <c:v>303</c:v>
                      </c:pt>
                      <c:pt idx="84">
                        <c:v>307</c:v>
                      </c:pt>
                      <c:pt idx="85">
                        <c:v>309</c:v>
                      </c:pt>
                      <c:pt idx="86">
                        <c:v>310</c:v>
                      </c:pt>
                      <c:pt idx="87">
                        <c:v>312</c:v>
                      </c:pt>
                      <c:pt idx="88">
                        <c:v>313</c:v>
                      </c:pt>
                      <c:pt idx="89">
                        <c:v>314</c:v>
                      </c:pt>
                      <c:pt idx="90">
                        <c:v>315</c:v>
                      </c:pt>
                      <c:pt idx="91">
                        <c:v>316</c:v>
                      </c:pt>
                      <c:pt idx="92">
                        <c:v>326</c:v>
                      </c:pt>
                      <c:pt idx="93">
                        <c:v>330</c:v>
                      </c:pt>
                      <c:pt idx="94">
                        <c:v>335</c:v>
                      </c:pt>
                      <c:pt idx="95">
                        <c:v>338</c:v>
                      </c:pt>
                      <c:pt idx="96">
                        <c:v>339</c:v>
                      </c:pt>
                      <c:pt idx="97">
                        <c:v>344</c:v>
                      </c:pt>
                      <c:pt idx="98">
                        <c:v>349</c:v>
                      </c:pt>
                      <c:pt idx="99">
                        <c:v>351</c:v>
                      </c:pt>
                      <c:pt idx="100">
                        <c:v>354</c:v>
                      </c:pt>
                      <c:pt idx="101">
                        <c:v>357</c:v>
                      </c:pt>
                      <c:pt idx="102">
                        <c:v>361</c:v>
                      </c:pt>
                      <c:pt idx="103">
                        <c:v>364</c:v>
                      </c:pt>
                      <c:pt idx="104">
                        <c:v>373</c:v>
                      </c:pt>
                      <c:pt idx="105">
                        <c:v>377</c:v>
                      </c:pt>
                      <c:pt idx="106">
                        <c:v>378</c:v>
                      </c:pt>
                      <c:pt idx="107">
                        <c:v>379</c:v>
                      </c:pt>
                      <c:pt idx="108">
                        <c:v>382</c:v>
                      </c:pt>
                      <c:pt idx="109">
                        <c:v>390</c:v>
                      </c:pt>
                      <c:pt idx="110">
                        <c:v>394</c:v>
                      </c:pt>
                      <c:pt idx="111">
                        <c:v>396</c:v>
                      </c:pt>
                      <c:pt idx="112">
                        <c:v>397</c:v>
                      </c:pt>
                      <c:pt idx="113">
                        <c:v>400</c:v>
                      </c:pt>
                      <c:pt idx="114">
                        <c:v>403</c:v>
                      </c:pt>
                      <c:pt idx="115">
                        <c:v>405</c:v>
                      </c:pt>
                      <c:pt idx="116">
                        <c:v>406</c:v>
                      </c:pt>
                      <c:pt idx="117">
                        <c:v>407</c:v>
                      </c:pt>
                      <c:pt idx="118">
                        <c:v>408</c:v>
                      </c:pt>
                      <c:pt idx="119">
                        <c:v>409</c:v>
                      </c:pt>
                      <c:pt idx="120">
                        <c:v>410</c:v>
                      </c:pt>
                      <c:pt idx="121">
                        <c:v>416</c:v>
                      </c:pt>
                      <c:pt idx="122">
                        <c:v>418</c:v>
                      </c:pt>
                      <c:pt idx="123">
                        <c:v>423</c:v>
                      </c:pt>
                      <c:pt idx="124">
                        <c:v>424</c:v>
                      </c:pt>
                      <c:pt idx="125">
                        <c:v>426</c:v>
                      </c:pt>
                      <c:pt idx="126">
                        <c:v>428</c:v>
                      </c:pt>
                      <c:pt idx="127">
                        <c:v>429</c:v>
                      </c:pt>
                      <c:pt idx="128">
                        <c:v>430</c:v>
                      </c:pt>
                      <c:pt idx="129">
                        <c:v>433</c:v>
                      </c:pt>
                      <c:pt idx="130">
                        <c:v>438</c:v>
                      </c:pt>
                      <c:pt idx="131">
                        <c:v>440</c:v>
                      </c:pt>
                      <c:pt idx="132">
                        <c:v>450</c:v>
                      </c:pt>
                      <c:pt idx="133">
                        <c:v>453</c:v>
                      </c:pt>
                      <c:pt idx="134">
                        <c:v>460</c:v>
                      </c:pt>
                      <c:pt idx="135">
                        <c:v>461</c:v>
                      </c:pt>
                      <c:pt idx="136">
                        <c:v>464</c:v>
                      </c:pt>
                      <c:pt idx="137">
                        <c:v>465</c:v>
                      </c:pt>
                      <c:pt idx="138">
                        <c:v>466</c:v>
                      </c:pt>
                      <c:pt idx="139">
                        <c:v>467</c:v>
                      </c:pt>
                      <c:pt idx="140">
                        <c:v>468</c:v>
                      </c:pt>
                      <c:pt idx="141">
                        <c:v>469</c:v>
                      </c:pt>
                      <c:pt idx="142">
                        <c:v>470</c:v>
                      </c:pt>
                      <c:pt idx="143">
                        <c:v>471</c:v>
                      </c:pt>
                      <c:pt idx="144">
                        <c:v>472</c:v>
                      </c:pt>
                      <c:pt idx="145">
                        <c:v>473</c:v>
                      </c:pt>
                      <c:pt idx="146">
                        <c:v>474</c:v>
                      </c:pt>
                      <c:pt idx="147">
                        <c:v>475</c:v>
                      </c:pt>
                      <c:pt idx="148">
                        <c:v>477</c:v>
                      </c:pt>
                      <c:pt idx="149">
                        <c:v>478</c:v>
                      </c:pt>
                      <c:pt idx="150">
                        <c:v>479</c:v>
                      </c:pt>
                      <c:pt idx="151">
                        <c:v>480</c:v>
                      </c:pt>
                      <c:pt idx="152">
                        <c:v>485</c:v>
                      </c:pt>
                      <c:pt idx="153">
                        <c:v>488</c:v>
                      </c:pt>
                      <c:pt idx="154">
                        <c:v>489</c:v>
                      </c:pt>
                      <c:pt idx="155">
                        <c:v>491</c:v>
                      </c:pt>
                      <c:pt idx="156">
                        <c:v>492</c:v>
                      </c:pt>
                      <c:pt idx="157">
                        <c:v>494</c:v>
                      </c:pt>
                      <c:pt idx="158">
                        <c:v>495</c:v>
                      </c:pt>
                      <c:pt idx="159">
                        <c:v>497</c:v>
                      </c:pt>
                      <c:pt idx="160">
                        <c:v>498</c:v>
                      </c:pt>
                      <c:pt idx="161">
                        <c:v>499</c:v>
                      </c:pt>
                      <c:pt idx="162">
                        <c:v>500</c:v>
                      </c:pt>
                      <c:pt idx="163">
                        <c:v>501</c:v>
                      </c:pt>
                      <c:pt idx="164">
                        <c:v>502</c:v>
                      </c:pt>
                      <c:pt idx="165">
                        <c:v>503</c:v>
                      </c:pt>
                      <c:pt idx="166">
                        <c:v>504</c:v>
                      </c:pt>
                      <c:pt idx="167">
                        <c:v>505</c:v>
                      </c:pt>
                      <c:pt idx="168">
                        <c:v>508</c:v>
                      </c:pt>
                      <c:pt idx="169">
                        <c:v>510</c:v>
                      </c:pt>
                      <c:pt idx="170">
                        <c:v>511</c:v>
                      </c:pt>
                      <c:pt idx="171">
                        <c:v>513</c:v>
                      </c:pt>
                      <c:pt idx="172">
                        <c:v>516</c:v>
                      </c:pt>
                      <c:pt idx="173">
                        <c:v>518</c:v>
                      </c:pt>
                      <c:pt idx="174">
                        <c:v>519</c:v>
                      </c:pt>
                      <c:pt idx="175">
                        <c:v>520</c:v>
                      </c:pt>
                      <c:pt idx="176">
                        <c:v>521</c:v>
                      </c:pt>
                      <c:pt idx="177">
                        <c:v>522</c:v>
                      </c:pt>
                      <c:pt idx="178">
                        <c:v>523</c:v>
                      </c:pt>
                      <c:pt idx="179">
                        <c:v>524</c:v>
                      </c:pt>
                      <c:pt idx="180">
                        <c:v>525</c:v>
                      </c:pt>
                      <c:pt idx="181">
                        <c:v>527</c:v>
                      </c:pt>
                      <c:pt idx="182">
                        <c:v>530</c:v>
                      </c:pt>
                      <c:pt idx="183">
                        <c:v>531</c:v>
                      </c:pt>
                      <c:pt idx="184">
                        <c:v>532</c:v>
                      </c:pt>
                      <c:pt idx="185">
                        <c:v>533</c:v>
                      </c:pt>
                      <c:pt idx="186">
                        <c:v>537</c:v>
                      </c:pt>
                      <c:pt idx="187">
                        <c:v>538</c:v>
                      </c:pt>
                      <c:pt idx="188">
                        <c:v>539</c:v>
                      </c:pt>
                      <c:pt idx="189">
                        <c:v>541</c:v>
                      </c:pt>
                      <c:pt idx="190">
                        <c:v>542</c:v>
                      </c:pt>
                      <c:pt idx="191">
                        <c:v>543</c:v>
                      </c:pt>
                      <c:pt idx="192">
                        <c:v>544</c:v>
                      </c:pt>
                      <c:pt idx="193">
                        <c:v>545</c:v>
                      </c:pt>
                      <c:pt idx="194">
                        <c:v>549</c:v>
                      </c:pt>
                      <c:pt idx="195">
                        <c:v>550</c:v>
                      </c:pt>
                      <c:pt idx="196">
                        <c:v>551</c:v>
                      </c:pt>
                      <c:pt idx="197">
                        <c:v>552</c:v>
                      </c:pt>
                      <c:pt idx="198">
                        <c:v>553</c:v>
                      </c:pt>
                      <c:pt idx="199">
                        <c:v>554</c:v>
                      </c:pt>
                      <c:pt idx="200">
                        <c:v>555</c:v>
                      </c:pt>
                      <c:pt idx="201">
                        <c:v>556</c:v>
                      </c:pt>
                      <c:pt idx="202">
                        <c:v>557</c:v>
                      </c:pt>
                      <c:pt idx="203">
                        <c:v>558</c:v>
                      </c:pt>
                      <c:pt idx="204">
                        <c:v>561</c:v>
                      </c:pt>
                      <c:pt idx="205">
                        <c:v>562</c:v>
                      </c:pt>
                      <c:pt idx="206">
                        <c:v>564</c:v>
                      </c:pt>
                      <c:pt idx="207">
                        <c:v>565</c:v>
                      </c:pt>
                      <c:pt idx="208">
                        <c:v>568</c:v>
                      </c:pt>
                      <c:pt idx="209">
                        <c:v>570</c:v>
                      </c:pt>
                      <c:pt idx="210">
                        <c:v>571</c:v>
                      </c:pt>
                      <c:pt idx="211">
                        <c:v>573</c:v>
                      </c:pt>
                      <c:pt idx="212">
                        <c:v>574</c:v>
                      </c:pt>
                      <c:pt idx="213">
                        <c:v>575</c:v>
                      </c:pt>
                      <c:pt idx="214">
                        <c:v>582</c:v>
                      </c:pt>
                      <c:pt idx="215">
                        <c:v>586</c:v>
                      </c:pt>
                      <c:pt idx="216">
                        <c:v>587</c:v>
                      </c:pt>
                      <c:pt idx="217">
                        <c:v>589</c:v>
                      </c:pt>
                      <c:pt idx="218">
                        <c:v>590</c:v>
                      </c:pt>
                      <c:pt idx="219">
                        <c:v>591</c:v>
                      </c:pt>
                      <c:pt idx="220">
                        <c:v>592</c:v>
                      </c:pt>
                      <c:pt idx="221">
                        <c:v>595</c:v>
                      </c:pt>
                      <c:pt idx="222">
                        <c:v>596</c:v>
                      </c:pt>
                      <c:pt idx="223">
                        <c:v>597</c:v>
                      </c:pt>
                      <c:pt idx="224">
                        <c:v>598</c:v>
                      </c:pt>
                      <c:pt idx="225">
                        <c:v>604</c:v>
                      </c:pt>
                      <c:pt idx="226">
                        <c:v>605</c:v>
                      </c:pt>
                      <c:pt idx="227">
                        <c:v>608</c:v>
                      </c:pt>
                      <c:pt idx="228">
                        <c:v>609</c:v>
                      </c:pt>
                      <c:pt idx="229">
                        <c:v>610</c:v>
                      </c:pt>
                      <c:pt idx="230">
                        <c:v>611</c:v>
                      </c:pt>
                      <c:pt idx="231">
                        <c:v>612</c:v>
                      </c:pt>
                      <c:pt idx="232">
                        <c:v>613</c:v>
                      </c:pt>
                      <c:pt idx="233">
                        <c:v>623</c:v>
                      </c:pt>
                      <c:pt idx="234">
                        <c:v>624</c:v>
                      </c:pt>
                      <c:pt idx="235">
                        <c:v>625</c:v>
                      </c:pt>
                      <c:pt idx="236">
                        <c:v>627</c:v>
                      </c:pt>
                      <c:pt idx="237">
                        <c:v>628</c:v>
                      </c:pt>
                      <c:pt idx="238">
                        <c:v>629</c:v>
                      </c:pt>
                      <c:pt idx="239">
                        <c:v>631</c:v>
                      </c:pt>
                      <c:pt idx="240">
                        <c:v>634</c:v>
                      </c:pt>
                      <c:pt idx="241">
                        <c:v>636</c:v>
                      </c:pt>
                      <c:pt idx="242">
                        <c:v>638</c:v>
                      </c:pt>
                      <c:pt idx="243">
                        <c:v>639</c:v>
                      </c:pt>
                      <c:pt idx="244">
                        <c:v>642</c:v>
                      </c:pt>
                      <c:pt idx="245">
                        <c:v>643</c:v>
                      </c:pt>
                      <c:pt idx="246">
                        <c:v>644</c:v>
                      </c:pt>
                      <c:pt idx="247">
                        <c:v>646</c:v>
                      </c:pt>
                      <c:pt idx="248">
                        <c:v>647</c:v>
                      </c:pt>
                      <c:pt idx="249">
                        <c:v>649</c:v>
                      </c:pt>
                      <c:pt idx="250">
                        <c:v>650</c:v>
                      </c:pt>
                      <c:pt idx="251">
                        <c:v>652</c:v>
                      </c:pt>
                      <c:pt idx="252">
                        <c:v>653</c:v>
                      </c:pt>
                      <c:pt idx="253">
                        <c:v>654</c:v>
                      </c:pt>
                      <c:pt idx="254">
                        <c:v>656</c:v>
                      </c:pt>
                      <c:pt idx="255">
                        <c:v>657</c:v>
                      </c:pt>
                      <c:pt idx="256">
                        <c:v>659</c:v>
                      </c:pt>
                      <c:pt idx="257">
                        <c:v>661</c:v>
                      </c:pt>
                      <c:pt idx="258">
                        <c:v>665</c:v>
                      </c:pt>
                      <c:pt idx="259">
                        <c:v>667</c:v>
                      </c:pt>
                      <c:pt idx="260">
                        <c:v>668</c:v>
                      </c:pt>
                      <c:pt idx="261">
                        <c:v>669</c:v>
                      </c:pt>
                      <c:pt idx="262">
                        <c:v>670</c:v>
                      </c:pt>
                      <c:pt idx="263">
                        <c:v>671</c:v>
                      </c:pt>
                      <c:pt idx="264">
                        <c:v>672</c:v>
                      </c:pt>
                      <c:pt idx="265">
                        <c:v>673</c:v>
                      </c:pt>
                      <c:pt idx="266">
                        <c:v>674</c:v>
                      </c:pt>
                      <c:pt idx="267">
                        <c:v>675</c:v>
                      </c:pt>
                      <c:pt idx="268">
                        <c:v>676</c:v>
                      </c:pt>
                      <c:pt idx="269">
                        <c:v>677</c:v>
                      </c:pt>
                      <c:pt idx="270">
                        <c:v>678</c:v>
                      </c:pt>
                      <c:pt idx="271">
                        <c:v>681</c:v>
                      </c:pt>
                      <c:pt idx="272">
                        <c:v>682</c:v>
                      </c:pt>
                      <c:pt idx="273">
                        <c:v>683</c:v>
                      </c:pt>
                      <c:pt idx="274">
                        <c:v>684</c:v>
                      </c:pt>
                      <c:pt idx="275">
                        <c:v>685</c:v>
                      </c:pt>
                      <c:pt idx="276">
                        <c:v>686</c:v>
                      </c:pt>
                      <c:pt idx="277">
                        <c:v>687</c:v>
                      </c:pt>
                      <c:pt idx="278">
                        <c:v>688</c:v>
                      </c:pt>
                      <c:pt idx="279">
                        <c:v>689</c:v>
                      </c:pt>
                      <c:pt idx="280">
                        <c:v>693</c:v>
                      </c:pt>
                      <c:pt idx="281">
                        <c:v>694</c:v>
                      </c:pt>
                      <c:pt idx="282">
                        <c:v>698</c:v>
                      </c:pt>
                      <c:pt idx="283">
                        <c:v>701</c:v>
                      </c:pt>
                      <c:pt idx="284">
                        <c:v>702</c:v>
                      </c:pt>
                      <c:pt idx="285">
                        <c:v>703</c:v>
                      </c:pt>
                      <c:pt idx="286">
                        <c:v>707</c:v>
                      </c:pt>
                      <c:pt idx="287">
                        <c:v>708</c:v>
                      </c:pt>
                      <c:pt idx="288">
                        <c:v>712</c:v>
                      </c:pt>
                      <c:pt idx="289">
                        <c:v>713</c:v>
                      </c:pt>
                      <c:pt idx="290">
                        <c:v>714</c:v>
                      </c:pt>
                      <c:pt idx="291">
                        <c:v>719</c:v>
                      </c:pt>
                      <c:pt idx="292">
                        <c:v>720</c:v>
                      </c:pt>
                      <c:pt idx="293">
                        <c:v>721</c:v>
                      </c:pt>
                      <c:pt idx="294">
                        <c:v>723</c:v>
                      </c:pt>
                      <c:pt idx="295">
                        <c:v>724</c:v>
                      </c:pt>
                      <c:pt idx="296">
                        <c:v>725</c:v>
                      </c:pt>
                      <c:pt idx="297">
                        <c:v>726</c:v>
                      </c:pt>
                      <c:pt idx="298">
                        <c:v>727</c:v>
                      </c:pt>
                      <c:pt idx="299">
                        <c:v>728</c:v>
                      </c:pt>
                      <c:pt idx="300">
                        <c:v>729</c:v>
                      </c:pt>
                      <c:pt idx="301">
                        <c:v>730</c:v>
                      </c:pt>
                      <c:pt idx="302">
                        <c:v>732</c:v>
                      </c:pt>
                      <c:pt idx="303">
                        <c:v>734</c:v>
                      </c:pt>
                      <c:pt idx="304">
                        <c:v>735</c:v>
                      </c:pt>
                      <c:pt idx="305">
                        <c:v>736</c:v>
                      </c:pt>
                      <c:pt idx="306">
                        <c:v>737</c:v>
                      </c:pt>
                      <c:pt idx="307">
                        <c:v>738</c:v>
                      </c:pt>
                      <c:pt idx="308">
                        <c:v>739</c:v>
                      </c:pt>
                      <c:pt idx="309">
                        <c:v>740</c:v>
                      </c:pt>
                      <c:pt idx="310">
                        <c:v>741</c:v>
                      </c:pt>
                      <c:pt idx="311">
                        <c:v>742</c:v>
                      </c:pt>
                      <c:pt idx="312">
                        <c:v>743</c:v>
                      </c:pt>
                      <c:pt idx="313">
                        <c:v>744</c:v>
                      </c:pt>
                      <c:pt idx="314">
                        <c:v>745</c:v>
                      </c:pt>
                      <c:pt idx="315">
                        <c:v>746</c:v>
                      </c:pt>
                      <c:pt idx="316">
                        <c:v>747</c:v>
                      </c:pt>
                      <c:pt idx="317">
                        <c:v>748</c:v>
                      </c:pt>
                      <c:pt idx="318">
                        <c:v>749</c:v>
                      </c:pt>
                      <c:pt idx="319">
                        <c:v>750</c:v>
                      </c:pt>
                      <c:pt idx="320">
                        <c:v>751</c:v>
                      </c:pt>
                      <c:pt idx="321">
                        <c:v>757</c:v>
                      </c:pt>
                      <c:pt idx="322">
                        <c:v>758</c:v>
                      </c:pt>
                      <c:pt idx="323">
                        <c:v>759</c:v>
                      </c:pt>
                      <c:pt idx="324">
                        <c:v>760</c:v>
                      </c:pt>
                      <c:pt idx="325">
                        <c:v>761</c:v>
                      </c:pt>
                      <c:pt idx="326">
                        <c:v>762</c:v>
                      </c:pt>
                      <c:pt idx="327">
                        <c:v>765</c:v>
                      </c:pt>
                      <c:pt idx="328">
                        <c:v>766</c:v>
                      </c:pt>
                      <c:pt idx="329">
                        <c:v>767</c:v>
                      </c:pt>
                      <c:pt idx="330">
                        <c:v>769</c:v>
                      </c:pt>
                      <c:pt idx="331">
                        <c:v>770</c:v>
                      </c:pt>
                      <c:pt idx="332">
                        <c:v>772</c:v>
                      </c:pt>
                      <c:pt idx="333">
                        <c:v>773</c:v>
                      </c:pt>
                      <c:pt idx="334">
                        <c:v>774</c:v>
                      </c:pt>
                      <c:pt idx="335">
                        <c:v>775</c:v>
                      </c:pt>
                      <c:pt idx="336">
                        <c:v>776</c:v>
                      </c:pt>
                      <c:pt idx="337">
                        <c:v>777</c:v>
                      </c:pt>
                      <c:pt idx="338">
                        <c:v>778</c:v>
                      </c:pt>
                      <c:pt idx="339">
                        <c:v>779</c:v>
                      </c:pt>
                      <c:pt idx="340">
                        <c:v>781</c:v>
                      </c:pt>
                      <c:pt idx="341">
                        <c:v>782</c:v>
                      </c:pt>
                      <c:pt idx="342">
                        <c:v>783</c:v>
                      </c:pt>
                      <c:pt idx="343">
                        <c:v>784</c:v>
                      </c:pt>
                      <c:pt idx="344">
                        <c:v>786</c:v>
                      </c:pt>
                      <c:pt idx="345">
                        <c:v>787</c:v>
                      </c:pt>
                      <c:pt idx="346">
                        <c:v>788</c:v>
                      </c:pt>
                      <c:pt idx="347">
                        <c:v>789</c:v>
                      </c:pt>
                      <c:pt idx="348">
                        <c:v>790</c:v>
                      </c:pt>
                      <c:pt idx="349">
                        <c:v>794</c:v>
                      </c:pt>
                      <c:pt idx="350">
                        <c:v>795</c:v>
                      </c:pt>
                      <c:pt idx="351">
                        <c:v>796</c:v>
                      </c:pt>
                      <c:pt idx="352">
                        <c:v>797</c:v>
                      </c:pt>
                      <c:pt idx="353">
                        <c:v>798</c:v>
                      </c:pt>
                      <c:pt idx="354">
                        <c:v>800</c:v>
                      </c:pt>
                      <c:pt idx="355">
                        <c:v>801</c:v>
                      </c:pt>
                      <c:pt idx="356">
                        <c:v>802</c:v>
                      </c:pt>
                      <c:pt idx="357">
                        <c:v>803</c:v>
                      </c:pt>
                      <c:pt idx="358">
                        <c:v>804</c:v>
                      </c:pt>
                      <c:pt idx="359">
                        <c:v>805</c:v>
                      </c:pt>
                      <c:pt idx="360">
                        <c:v>806</c:v>
                      </c:pt>
                      <c:pt idx="361">
                        <c:v>807</c:v>
                      </c:pt>
                      <c:pt idx="362">
                        <c:v>808</c:v>
                      </c:pt>
                      <c:pt idx="363">
                        <c:v>811</c:v>
                      </c:pt>
                      <c:pt idx="364">
                        <c:v>812</c:v>
                      </c:pt>
                      <c:pt idx="365">
                        <c:v>813</c:v>
                      </c:pt>
                      <c:pt idx="366">
                        <c:v>814</c:v>
                      </c:pt>
                      <c:pt idx="367">
                        <c:v>815</c:v>
                      </c:pt>
                      <c:pt idx="368">
                        <c:v>816</c:v>
                      </c:pt>
                      <c:pt idx="369">
                        <c:v>817</c:v>
                      </c:pt>
                      <c:pt idx="370">
                        <c:v>818</c:v>
                      </c:pt>
                      <c:pt idx="371">
                        <c:v>819</c:v>
                      </c:pt>
                      <c:pt idx="372">
                        <c:v>820</c:v>
                      </c:pt>
                      <c:pt idx="373">
                        <c:v>821</c:v>
                      </c:pt>
                      <c:pt idx="374">
                        <c:v>822</c:v>
                      </c:pt>
                      <c:pt idx="375">
                        <c:v>823</c:v>
                      </c:pt>
                      <c:pt idx="376">
                        <c:v>825</c:v>
                      </c:pt>
                      <c:pt idx="377">
                        <c:v>826</c:v>
                      </c:pt>
                      <c:pt idx="378">
                        <c:v>827</c:v>
                      </c:pt>
                      <c:pt idx="379">
                        <c:v>828</c:v>
                      </c:pt>
                      <c:pt idx="380">
                        <c:v>829</c:v>
                      </c:pt>
                      <c:pt idx="381">
                        <c:v>830</c:v>
                      </c:pt>
                      <c:pt idx="382">
                        <c:v>831</c:v>
                      </c:pt>
                      <c:pt idx="383">
                        <c:v>832</c:v>
                      </c:pt>
                      <c:pt idx="384">
                        <c:v>834</c:v>
                      </c:pt>
                      <c:pt idx="385">
                        <c:v>836</c:v>
                      </c:pt>
                      <c:pt idx="386">
                        <c:v>837</c:v>
                      </c:pt>
                      <c:pt idx="387">
                        <c:v>838</c:v>
                      </c:pt>
                      <c:pt idx="388">
                        <c:v>839</c:v>
                      </c:pt>
                      <c:pt idx="389">
                        <c:v>840</c:v>
                      </c:pt>
                      <c:pt idx="390">
                        <c:v>842</c:v>
                      </c:pt>
                      <c:pt idx="391">
                        <c:v>843</c:v>
                      </c:pt>
                      <c:pt idx="392">
                        <c:v>844</c:v>
                      </c:pt>
                      <c:pt idx="393">
                        <c:v>845</c:v>
                      </c:pt>
                      <c:pt idx="394">
                        <c:v>846</c:v>
                      </c:pt>
                      <c:pt idx="395">
                        <c:v>847</c:v>
                      </c:pt>
                      <c:pt idx="396">
                        <c:v>848</c:v>
                      </c:pt>
                      <c:pt idx="397">
                        <c:v>849</c:v>
                      </c:pt>
                      <c:pt idx="398">
                        <c:v>850</c:v>
                      </c:pt>
                      <c:pt idx="399">
                        <c:v>851</c:v>
                      </c:pt>
                      <c:pt idx="400">
                        <c:v>853</c:v>
                      </c:pt>
                      <c:pt idx="401">
                        <c:v>854</c:v>
                      </c:pt>
                      <c:pt idx="402">
                        <c:v>855</c:v>
                      </c:pt>
                      <c:pt idx="403">
                        <c:v>856</c:v>
                      </c:pt>
                      <c:pt idx="404">
                        <c:v>857</c:v>
                      </c:pt>
                      <c:pt idx="405">
                        <c:v>859</c:v>
                      </c:pt>
                      <c:pt idx="406">
                        <c:v>860</c:v>
                      </c:pt>
                      <c:pt idx="407">
                        <c:v>861</c:v>
                      </c:pt>
                      <c:pt idx="408">
                        <c:v>862</c:v>
                      </c:pt>
                      <c:pt idx="409">
                        <c:v>863</c:v>
                      </c:pt>
                      <c:pt idx="410">
                        <c:v>865</c:v>
                      </c:pt>
                      <c:pt idx="411">
                        <c:v>867</c:v>
                      </c:pt>
                      <c:pt idx="412">
                        <c:v>868</c:v>
                      </c:pt>
                      <c:pt idx="413">
                        <c:v>869</c:v>
                      </c:pt>
                      <c:pt idx="414">
                        <c:v>876</c:v>
                      </c:pt>
                      <c:pt idx="415">
                        <c:v>877</c:v>
                      </c:pt>
                      <c:pt idx="416">
                        <c:v>882</c:v>
                      </c:pt>
                      <c:pt idx="417">
                        <c:v>883</c:v>
                      </c:pt>
                      <c:pt idx="418">
                        <c:v>885</c:v>
                      </c:pt>
                      <c:pt idx="419">
                        <c:v>886</c:v>
                      </c:pt>
                      <c:pt idx="420">
                        <c:v>887</c:v>
                      </c:pt>
                      <c:pt idx="421">
                        <c:v>888</c:v>
                      </c:pt>
                      <c:pt idx="422">
                        <c:v>889</c:v>
                      </c:pt>
                      <c:pt idx="423">
                        <c:v>890</c:v>
                      </c:pt>
                      <c:pt idx="424">
                        <c:v>891</c:v>
                      </c:pt>
                      <c:pt idx="425">
                        <c:v>892</c:v>
                      </c:pt>
                      <c:pt idx="426">
                        <c:v>893</c:v>
                      </c:pt>
                      <c:pt idx="427">
                        <c:v>895</c:v>
                      </c:pt>
                      <c:pt idx="428">
                        <c:v>896</c:v>
                      </c:pt>
                      <c:pt idx="429">
                        <c:v>897</c:v>
                      </c:pt>
                      <c:pt idx="430">
                        <c:v>898</c:v>
                      </c:pt>
                      <c:pt idx="431">
                        <c:v>900</c:v>
                      </c:pt>
                      <c:pt idx="432">
                        <c:v>901</c:v>
                      </c:pt>
                      <c:pt idx="433">
                        <c:v>902</c:v>
                      </c:pt>
                      <c:pt idx="434">
                        <c:v>903</c:v>
                      </c:pt>
                      <c:pt idx="435">
                        <c:v>904</c:v>
                      </c:pt>
                      <c:pt idx="436">
                        <c:v>905</c:v>
                      </c:pt>
                      <c:pt idx="437">
                        <c:v>907</c:v>
                      </c:pt>
                      <c:pt idx="438">
                        <c:v>908</c:v>
                      </c:pt>
                      <c:pt idx="439">
                        <c:v>909</c:v>
                      </c:pt>
                      <c:pt idx="440">
                        <c:v>910</c:v>
                      </c:pt>
                      <c:pt idx="441">
                        <c:v>911</c:v>
                      </c:pt>
                      <c:pt idx="442">
                        <c:v>912</c:v>
                      </c:pt>
                      <c:pt idx="443">
                        <c:v>913</c:v>
                      </c:pt>
                      <c:pt idx="444">
                        <c:v>918</c:v>
                      </c:pt>
                      <c:pt idx="445">
                        <c:v>919</c:v>
                      </c:pt>
                      <c:pt idx="446">
                        <c:v>920</c:v>
                      </c:pt>
                      <c:pt idx="447">
                        <c:v>922</c:v>
                      </c:pt>
                      <c:pt idx="448">
                        <c:v>923</c:v>
                      </c:pt>
                      <c:pt idx="449">
                        <c:v>924</c:v>
                      </c:pt>
                      <c:pt idx="450">
                        <c:v>925</c:v>
                      </c:pt>
                      <c:pt idx="451">
                        <c:v>926</c:v>
                      </c:pt>
                      <c:pt idx="452">
                        <c:v>927</c:v>
                      </c:pt>
                      <c:pt idx="453">
                        <c:v>928</c:v>
                      </c:pt>
                      <c:pt idx="454">
                        <c:v>929</c:v>
                      </c:pt>
                      <c:pt idx="455">
                        <c:v>930</c:v>
                      </c:pt>
                      <c:pt idx="456">
                        <c:v>931</c:v>
                      </c:pt>
                      <c:pt idx="457">
                        <c:v>934</c:v>
                      </c:pt>
                      <c:pt idx="458">
                        <c:v>935</c:v>
                      </c:pt>
                      <c:pt idx="459">
                        <c:v>940</c:v>
                      </c:pt>
                      <c:pt idx="460">
                        <c:v>941</c:v>
                      </c:pt>
                      <c:pt idx="461">
                        <c:v>942</c:v>
                      </c:pt>
                      <c:pt idx="462">
                        <c:v>943</c:v>
                      </c:pt>
                      <c:pt idx="463">
                        <c:v>944</c:v>
                      </c:pt>
                      <c:pt idx="464">
                        <c:v>945</c:v>
                      </c:pt>
                      <c:pt idx="465">
                        <c:v>946</c:v>
                      </c:pt>
                      <c:pt idx="466">
                        <c:v>947</c:v>
                      </c:pt>
                      <c:pt idx="467">
                        <c:v>948</c:v>
                      </c:pt>
                      <c:pt idx="468">
                        <c:v>949</c:v>
                      </c:pt>
                      <c:pt idx="469">
                        <c:v>950</c:v>
                      </c:pt>
                      <c:pt idx="470">
                        <c:v>951</c:v>
                      </c:pt>
                      <c:pt idx="471">
                        <c:v>952</c:v>
                      </c:pt>
                      <c:pt idx="472">
                        <c:v>954</c:v>
                      </c:pt>
                      <c:pt idx="473">
                        <c:v>955</c:v>
                      </c:pt>
                      <c:pt idx="474">
                        <c:v>956</c:v>
                      </c:pt>
                      <c:pt idx="475">
                        <c:v>961</c:v>
                      </c:pt>
                      <c:pt idx="476">
                        <c:v>964</c:v>
                      </c:pt>
                      <c:pt idx="477">
                        <c:v>965</c:v>
                      </c:pt>
                      <c:pt idx="478">
                        <c:v>966</c:v>
                      </c:pt>
                      <c:pt idx="479">
                        <c:v>969</c:v>
                      </c:pt>
                      <c:pt idx="480">
                        <c:v>970</c:v>
                      </c:pt>
                      <c:pt idx="481">
                        <c:v>973</c:v>
                      </c:pt>
                      <c:pt idx="482">
                        <c:v>974</c:v>
                      </c:pt>
                      <c:pt idx="483">
                        <c:v>975</c:v>
                      </c:pt>
                      <c:pt idx="484">
                        <c:v>977</c:v>
                      </c:pt>
                      <c:pt idx="485">
                        <c:v>978</c:v>
                      </c:pt>
                      <c:pt idx="486">
                        <c:v>979</c:v>
                      </c:pt>
                      <c:pt idx="487">
                        <c:v>980</c:v>
                      </c:pt>
                      <c:pt idx="488">
                        <c:v>983</c:v>
                      </c:pt>
                      <c:pt idx="489">
                        <c:v>984</c:v>
                      </c:pt>
                      <c:pt idx="490">
                        <c:v>986</c:v>
                      </c:pt>
                      <c:pt idx="491">
                        <c:v>987</c:v>
                      </c:pt>
                      <c:pt idx="492">
                        <c:v>988</c:v>
                      </c:pt>
                      <c:pt idx="493">
                        <c:v>989</c:v>
                      </c:pt>
                      <c:pt idx="494">
                        <c:v>990</c:v>
                      </c:pt>
                      <c:pt idx="495">
                        <c:v>991</c:v>
                      </c:pt>
                      <c:pt idx="496">
                        <c:v>992</c:v>
                      </c:pt>
                      <c:pt idx="497">
                        <c:v>994</c:v>
                      </c:pt>
                      <c:pt idx="498">
                        <c:v>995</c:v>
                      </c:pt>
                      <c:pt idx="499">
                        <c:v>996</c:v>
                      </c:pt>
                      <c:pt idx="500">
                        <c:v>997</c:v>
                      </c:pt>
                      <c:pt idx="501">
                        <c:v>998</c:v>
                      </c:pt>
                      <c:pt idx="502">
                        <c:v>999</c:v>
                      </c:pt>
                      <c:pt idx="503">
                        <c:v>1000</c:v>
                      </c:pt>
                      <c:pt idx="504">
                        <c:v>1001</c:v>
                      </c:pt>
                      <c:pt idx="505">
                        <c:v>1002</c:v>
                      </c:pt>
                      <c:pt idx="506">
                        <c:v>1003</c:v>
                      </c:pt>
                      <c:pt idx="507">
                        <c:v>1004</c:v>
                      </c:pt>
                      <c:pt idx="508">
                        <c:v>1005</c:v>
                      </c:pt>
                      <c:pt idx="509">
                        <c:v>1006</c:v>
                      </c:pt>
                      <c:pt idx="510">
                        <c:v>1008</c:v>
                      </c:pt>
                      <c:pt idx="511">
                        <c:v>1009</c:v>
                      </c:pt>
                      <c:pt idx="512">
                        <c:v>1010</c:v>
                      </c:pt>
                      <c:pt idx="513">
                        <c:v>1011</c:v>
                      </c:pt>
                      <c:pt idx="514">
                        <c:v>1012</c:v>
                      </c:pt>
                      <c:pt idx="515">
                        <c:v>1013</c:v>
                      </c:pt>
                      <c:pt idx="516">
                        <c:v>1015</c:v>
                      </c:pt>
                      <c:pt idx="517">
                        <c:v>1020</c:v>
                      </c:pt>
                      <c:pt idx="518">
                        <c:v>1021</c:v>
                      </c:pt>
                      <c:pt idx="519">
                        <c:v>1022</c:v>
                      </c:pt>
                      <c:pt idx="520">
                        <c:v>1023</c:v>
                      </c:pt>
                      <c:pt idx="521">
                        <c:v>1024</c:v>
                      </c:pt>
                      <c:pt idx="522">
                        <c:v>1025</c:v>
                      </c:pt>
                      <c:pt idx="523">
                        <c:v>1027</c:v>
                      </c:pt>
                      <c:pt idx="524">
                        <c:v>1031</c:v>
                      </c:pt>
                      <c:pt idx="525">
                        <c:v>1032</c:v>
                      </c:pt>
                      <c:pt idx="526">
                        <c:v>1033</c:v>
                      </c:pt>
                      <c:pt idx="527">
                        <c:v>1034</c:v>
                      </c:pt>
                      <c:pt idx="528">
                        <c:v>1035</c:v>
                      </c:pt>
                      <c:pt idx="529">
                        <c:v>1037</c:v>
                      </c:pt>
                      <c:pt idx="530">
                        <c:v>1039</c:v>
                      </c:pt>
                      <c:pt idx="531">
                        <c:v>1040</c:v>
                      </c:pt>
                      <c:pt idx="532">
                        <c:v>1041</c:v>
                      </c:pt>
                      <c:pt idx="533">
                        <c:v>1043</c:v>
                      </c:pt>
                      <c:pt idx="534">
                        <c:v>1044</c:v>
                      </c:pt>
                      <c:pt idx="535">
                        <c:v>1045</c:v>
                      </c:pt>
                      <c:pt idx="536">
                        <c:v>1046</c:v>
                      </c:pt>
                      <c:pt idx="537">
                        <c:v>1047</c:v>
                      </c:pt>
                      <c:pt idx="538">
                        <c:v>1048</c:v>
                      </c:pt>
                      <c:pt idx="539">
                        <c:v>1049</c:v>
                      </c:pt>
                      <c:pt idx="540">
                        <c:v>1050</c:v>
                      </c:pt>
                      <c:pt idx="541">
                        <c:v>1051</c:v>
                      </c:pt>
                      <c:pt idx="542">
                        <c:v>1052</c:v>
                      </c:pt>
                      <c:pt idx="543">
                        <c:v>1053</c:v>
                      </c:pt>
                      <c:pt idx="544">
                        <c:v>1054</c:v>
                      </c:pt>
                      <c:pt idx="545">
                        <c:v>1055</c:v>
                      </c:pt>
                      <c:pt idx="546">
                        <c:v>1057</c:v>
                      </c:pt>
                      <c:pt idx="547">
                        <c:v>1059</c:v>
                      </c:pt>
                      <c:pt idx="548">
                        <c:v>1060</c:v>
                      </c:pt>
                      <c:pt idx="549">
                        <c:v>1061</c:v>
                      </c:pt>
                      <c:pt idx="550">
                        <c:v>1062</c:v>
                      </c:pt>
                      <c:pt idx="551">
                        <c:v>1063</c:v>
                      </c:pt>
                      <c:pt idx="552">
                        <c:v>1064</c:v>
                      </c:pt>
                      <c:pt idx="553">
                        <c:v>1065</c:v>
                      </c:pt>
                      <c:pt idx="554">
                        <c:v>1066</c:v>
                      </c:pt>
                      <c:pt idx="555">
                        <c:v>1067</c:v>
                      </c:pt>
                      <c:pt idx="556">
                        <c:v>1068</c:v>
                      </c:pt>
                      <c:pt idx="557">
                        <c:v>1069</c:v>
                      </c:pt>
                      <c:pt idx="558">
                        <c:v>1070</c:v>
                      </c:pt>
                      <c:pt idx="559">
                        <c:v>1072</c:v>
                      </c:pt>
                      <c:pt idx="560">
                        <c:v>1073</c:v>
                      </c:pt>
                      <c:pt idx="561">
                        <c:v>1074</c:v>
                      </c:pt>
                      <c:pt idx="562">
                        <c:v>1077</c:v>
                      </c:pt>
                      <c:pt idx="563">
                        <c:v>1080</c:v>
                      </c:pt>
                      <c:pt idx="564">
                        <c:v>1081</c:v>
                      </c:pt>
                      <c:pt idx="565">
                        <c:v>1082</c:v>
                      </c:pt>
                      <c:pt idx="566">
                        <c:v>1083</c:v>
                      </c:pt>
                      <c:pt idx="567">
                        <c:v>1084</c:v>
                      </c:pt>
                      <c:pt idx="568">
                        <c:v>1085</c:v>
                      </c:pt>
                      <c:pt idx="569">
                        <c:v>1090</c:v>
                      </c:pt>
                      <c:pt idx="570">
                        <c:v>1091</c:v>
                      </c:pt>
                      <c:pt idx="571">
                        <c:v>1092</c:v>
                      </c:pt>
                      <c:pt idx="572">
                        <c:v>1093</c:v>
                      </c:pt>
                      <c:pt idx="573">
                        <c:v>1094</c:v>
                      </c:pt>
                      <c:pt idx="574">
                        <c:v>1099</c:v>
                      </c:pt>
                      <c:pt idx="575">
                        <c:v>1100</c:v>
                      </c:pt>
                      <c:pt idx="576">
                        <c:v>1101</c:v>
                      </c:pt>
                      <c:pt idx="577">
                        <c:v>1102</c:v>
                      </c:pt>
                      <c:pt idx="578">
                        <c:v>1103</c:v>
                      </c:pt>
                      <c:pt idx="579">
                        <c:v>1104</c:v>
                      </c:pt>
                      <c:pt idx="580">
                        <c:v>1105</c:v>
                      </c:pt>
                      <c:pt idx="581">
                        <c:v>1106</c:v>
                      </c:pt>
                      <c:pt idx="582">
                        <c:v>1107</c:v>
                      </c:pt>
                      <c:pt idx="583">
                        <c:v>1108</c:v>
                      </c:pt>
                      <c:pt idx="584">
                        <c:v>1110</c:v>
                      </c:pt>
                      <c:pt idx="585">
                        <c:v>1111</c:v>
                      </c:pt>
                      <c:pt idx="586">
                        <c:v>1112</c:v>
                      </c:pt>
                      <c:pt idx="587">
                        <c:v>1113</c:v>
                      </c:pt>
                      <c:pt idx="588">
                        <c:v>1114</c:v>
                      </c:pt>
                      <c:pt idx="589">
                        <c:v>1115</c:v>
                      </c:pt>
                      <c:pt idx="590">
                        <c:v>1116</c:v>
                      </c:pt>
                      <c:pt idx="591">
                        <c:v>1118</c:v>
                      </c:pt>
                      <c:pt idx="592">
                        <c:v>1119</c:v>
                      </c:pt>
                      <c:pt idx="593">
                        <c:v>1120</c:v>
                      </c:pt>
                      <c:pt idx="594">
                        <c:v>1121</c:v>
                      </c:pt>
                      <c:pt idx="595">
                        <c:v>1122</c:v>
                      </c:pt>
                      <c:pt idx="596">
                        <c:v>1123</c:v>
                      </c:pt>
                      <c:pt idx="597">
                        <c:v>1124</c:v>
                      </c:pt>
                      <c:pt idx="598">
                        <c:v>1130</c:v>
                      </c:pt>
                      <c:pt idx="599">
                        <c:v>1131</c:v>
                      </c:pt>
                      <c:pt idx="600">
                        <c:v>1132</c:v>
                      </c:pt>
                      <c:pt idx="601">
                        <c:v>1133</c:v>
                      </c:pt>
                      <c:pt idx="602">
                        <c:v>1134</c:v>
                      </c:pt>
                      <c:pt idx="603">
                        <c:v>1135</c:v>
                      </c:pt>
                      <c:pt idx="604">
                        <c:v>1136</c:v>
                      </c:pt>
                      <c:pt idx="605">
                        <c:v>1137</c:v>
                      </c:pt>
                      <c:pt idx="606">
                        <c:v>1138</c:v>
                      </c:pt>
                      <c:pt idx="607">
                        <c:v>1139</c:v>
                      </c:pt>
                      <c:pt idx="608">
                        <c:v>1140</c:v>
                      </c:pt>
                      <c:pt idx="609">
                        <c:v>1141</c:v>
                      </c:pt>
                      <c:pt idx="610">
                        <c:v>1142</c:v>
                      </c:pt>
                      <c:pt idx="611">
                        <c:v>1143</c:v>
                      </c:pt>
                      <c:pt idx="612">
                        <c:v>1145</c:v>
                      </c:pt>
                      <c:pt idx="613">
                        <c:v>1146</c:v>
                      </c:pt>
                      <c:pt idx="614">
                        <c:v>1147</c:v>
                      </c:pt>
                      <c:pt idx="615">
                        <c:v>1148</c:v>
                      </c:pt>
                      <c:pt idx="616">
                        <c:v>1149</c:v>
                      </c:pt>
                      <c:pt idx="617">
                        <c:v>1150</c:v>
                      </c:pt>
                      <c:pt idx="618">
                        <c:v>1151</c:v>
                      </c:pt>
                      <c:pt idx="619">
                        <c:v>1153</c:v>
                      </c:pt>
                      <c:pt idx="620">
                        <c:v>1154</c:v>
                      </c:pt>
                      <c:pt idx="621">
                        <c:v>1155</c:v>
                      </c:pt>
                      <c:pt idx="622">
                        <c:v>1156</c:v>
                      </c:pt>
                      <c:pt idx="623">
                        <c:v>1157</c:v>
                      </c:pt>
                      <c:pt idx="624">
                        <c:v>1158</c:v>
                      </c:pt>
                      <c:pt idx="625">
                        <c:v>1159</c:v>
                      </c:pt>
                      <c:pt idx="626">
                        <c:v>1160</c:v>
                      </c:pt>
                      <c:pt idx="627">
                        <c:v>1161</c:v>
                      </c:pt>
                      <c:pt idx="628">
                        <c:v>1162</c:v>
                      </c:pt>
                      <c:pt idx="629">
                        <c:v>1165</c:v>
                      </c:pt>
                      <c:pt idx="630">
                        <c:v>1166</c:v>
                      </c:pt>
                      <c:pt idx="631">
                        <c:v>1167</c:v>
                      </c:pt>
                      <c:pt idx="632">
                        <c:v>1168</c:v>
                      </c:pt>
                      <c:pt idx="633">
                        <c:v>1169</c:v>
                      </c:pt>
                      <c:pt idx="634">
                        <c:v>1170</c:v>
                      </c:pt>
                      <c:pt idx="635">
                        <c:v>1173</c:v>
                      </c:pt>
                      <c:pt idx="636">
                        <c:v>1174</c:v>
                      </c:pt>
                      <c:pt idx="637">
                        <c:v>1175</c:v>
                      </c:pt>
                      <c:pt idx="638">
                        <c:v>1180</c:v>
                      </c:pt>
                      <c:pt idx="639">
                        <c:v>1181</c:v>
                      </c:pt>
                      <c:pt idx="640">
                        <c:v>1182</c:v>
                      </c:pt>
                      <c:pt idx="641">
                        <c:v>1183</c:v>
                      </c:pt>
                      <c:pt idx="642">
                        <c:v>1184</c:v>
                      </c:pt>
                      <c:pt idx="643">
                        <c:v>1185</c:v>
                      </c:pt>
                      <c:pt idx="644">
                        <c:v>1186</c:v>
                      </c:pt>
                      <c:pt idx="645">
                        <c:v>1187</c:v>
                      </c:pt>
                      <c:pt idx="646">
                        <c:v>1188</c:v>
                      </c:pt>
                      <c:pt idx="647">
                        <c:v>1189</c:v>
                      </c:pt>
                      <c:pt idx="648">
                        <c:v>1190</c:v>
                      </c:pt>
                      <c:pt idx="649">
                        <c:v>1192</c:v>
                      </c:pt>
                      <c:pt idx="650">
                        <c:v>1193</c:v>
                      </c:pt>
                      <c:pt idx="651">
                        <c:v>1194</c:v>
                      </c:pt>
                      <c:pt idx="652">
                        <c:v>1195</c:v>
                      </c:pt>
                      <c:pt idx="653">
                        <c:v>1197</c:v>
                      </c:pt>
                      <c:pt idx="654">
                        <c:v>1198</c:v>
                      </c:pt>
                      <c:pt idx="655">
                        <c:v>1199</c:v>
                      </c:pt>
                      <c:pt idx="656">
                        <c:v>1200</c:v>
                      </c:pt>
                      <c:pt idx="657">
                        <c:v>1201</c:v>
                      </c:pt>
                      <c:pt idx="658">
                        <c:v>1203</c:v>
                      </c:pt>
                      <c:pt idx="659">
                        <c:v>1204</c:v>
                      </c:pt>
                      <c:pt idx="660">
                        <c:v>1205</c:v>
                      </c:pt>
                      <c:pt idx="661">
                        <c:v>1208</c:v>
                      </c:pt>
                      <c:pt idx="662">
                        <c:v>1209</c:v>
                      </c:pt>
                      <c:pt idx="663">
                        <c:v>1210</c:v>
                      </c:pt>
                      <c:pt idx="664">
                        <c:v>1214</c:v>
                      </c:pt>
                      <c:pt idx="665">
                        <c:v>1215</c:v>
                      </c:pt>
                      <c:pt idx="666">
                        <c:v>1216</c:v>
                      </c:pt>
                      <c:pt idx="667">
                        <c:v>1217</c:v>
                      </c:pt>
                      <c:pt idx="668">
                        <c:v>1220</c:v>
                      </c:pt>
                      <c:pt idx="669">
                        <c:v>1221</c:v>
                      </c:pt>
                      <c:pt idx="670">
                        <c:v>1225</c:v>
                      </c:pt>
                      <c:pt idx="671">
                        <c:v>1229</c:v>
                      </c:pt>
                      <c:pt idx="672">
                        <c:v>1231</c:v>
                      </c:pt>
                      <c:pt idx="673">
                        <c:v>1232</c:v>
                      </c:pt>
                      <c:pt idx="674">
                        <c:v>1242</c:v>
                      </c:pt>
                      <c:pt idx="675">
                        <c:v>1253</c:v>
                      </c:pt>
                      <c:pt idx="676">
                        <c:v>1255</c:v>
                      </c:pt>
                      <c:pt idx="677">
                        <c:v>1256</c:v>
                      </c:pt>
                      <c:pt idx="678">
                        <c:v>1258</c:v>
                      </c:pt>
                      <c:pt idx="679">
                        <c:v>1259</c:v>
                      </c:pt>
                      <c:pt idx="680">
                        <c:v>1260</c:v>
                      </c:pt>
                      <c:pt idx="681">
                        <c:v>1261</c:v>
                      </c:pt>
                      <c:pt idx="682">
                        <c:v>1262</c:v>
                      </c:pt>
                      <c:pt idx="683">
                        <c:v>1263</c:v>
                      </c:pt>
                      <c:pt idx="684">
                        <c:v>1264</c:v>
                      </c:pt>
                      <c:pt idx="685">
                        <c:v>1266</c:v>
                      </c:pt>
                      <c:pt idx="686">
                        <c:v>1269</c:v>
                      </c:pt>
                      <c:pt idx="687">
                        <c:v>1279</c:v>
                      </c:pt>
                      <c:pt idx="688">
                        <c:v>1280</c:v>
                      </c:pt>
                      <c:pt idx="689">
                        <c:v>1290</c:v>
                      </c:pt>
                      <c:pt idx="690">
                        <c:v>1291</c:v>
                      </c:pt>
                      <c:pt idx="691">
                        <c:v>1292</c:v>
                      </c:pt>
                      <c:pt idx="692">
                        <c:v>1293</c:v>
                      </c:pt>
                      <c:pt idx="693">
                        <c:v>1294</c:v>
                      </c:pt>
                      <c:pt idx="694">
                        <c:v>1295</c:v>
                      </c:pt>
                      <c:pt idx="695">
                        <c:v>1300</c:v>
                      </c:pt>
                      <c:pt idx="696">
                        <c:v>1301</c:v>
                      </c:pt>
                      <c:pt idx="697">
                        <c:v>1302</c:v>
                      </c:pt>
                      <c:pt idx="698">
                        <c:v>1303</c:v>
                      </c:pt>
                      <c:pt idx="699">
                        <c:v>1305</c:v>
                      </c:pt>
                      <c:pt idx="700">
                        <c:v>1306</c:v>
                      </c:pt>
                      <c:pt idx="701">
                        <c:v>1307</c:v>
                      </c:pt>
                      <c:pt idx="702">
                        <c:v>1308</c:v>
                      </c:pt>
                      <c:pt idx="703">
                        <c:v>1310</c:v>
                      </c:pt>
                      <c:pt idx="704">
                        <c:v>1311</c:v>
                      </c:pt>
                      <c:pt idx="705">
                        <c:v>1312</c:v>
                      </c:pt>
                      <c:pt idx="706">
                        <c:v>1313</c:v>
                      </c:pt>
                      <c:pt idx="707">
                        <c:v>1314</c:v>
                      </c:pt>
                      <c:pt idx="708">
                        <c:v>1315</c:v>
                      </c:pt>
                      <c:pt idx="709">
                        <c:v>1316</c:v>
                      </c:pt>
                      <c:pt idx="710">
                        <c:v>1317</c:v>
                      </c:pt>
                      <c:pt idx="711">
                        <c:v>1318</c:v>
                      </c:pt>
                      <c:pt idx="712">
                        <c:v>1319</c:v>
                      </c:pt>
                      <c:pt idx="713">
                        <c:v>1320</c:v>
                      </c:pt>
                      <c:pt idx="714">
                        <c:v>1322</c:v>
                      </c:pt>
                      <c:pt idx="715">
                        <c:v>1323</c:v>
                      </c:pt>
                      <c:pt idx="716">
                        <c:v>1324</c:v>
                      </c:pt>
                      <c:pt idx="717">
                        <c:v>1325</c:v>
                      </c:pt>
                      <c:pt idx="718">
                        <c:v>1326</c:v>
                      </c:pt>
                      <c:pt idx="719">
                        <c:v>1327</c:v>
                      </c:pt>
                      <c:pt idx="720">
                        <c:v>1328</c:v>
                      </c:pt>
                      <c:pt idx="721">
                        <c:v>1329</c:v>
                      </c:pt>
                      <c:pt idx="722">
                        <c:v>1331</c:v>
                      </c:pt>
                      <c:pt idx="723">
                        <c:v>1333</c:v>
                      </c:pt>
                      <c:pt idx="724">
                        <c:v>1337</c:v>
                      </c:pt>
                      <c:pt idx="725">
                        <c:v>1338</c:v>
                      </c:pt>
                      <c:pt idx="726">
                        <c:v>1339</c:v>
                      </c:pt>
                      <c:pt idx="727">
                        <c:v>1342</c:v>
                      </c:pt>
                      <c:pt idx="728">
                        <c:v>1343</c:v>
                      </c:pt>
                      <c:pt idx="729">
                        <c:v>1344</c:v>
                      </c:pt>
                      <c:pt idx="730">
                        <c:v>1345</c:v>
                      </c:pt>
                      <c:pt idx="731">
                        <c:v>1346</c:v>
                      </c:pt>
                      <c:pt idx="732">
                        <c:v>1348</c:v>
                      </c:pt>
                      <c:pt idx="733">
                        <c:v>1349</c:v>
                      </c:pt>
                      <c:pt idx="734">
                        <c:v>1353</c:v>
                      </c:pt>
                      <c:pt idx="735">
                        <c:v>1355</c:v>
                      </c:pt>
                      <c:pt idx="736">
                        <c:v>1360</c:v>
                      </c:pt>
                      <c:pt idx="737">
                        <c:v>1361</c:v>
                      </c:pt>
                      <c:pt idx="738">
                        <c:v>1363</c:v>
                      </c:pt>
                      <c:pt idx="739">
                        <c:v>1364</c:v>
                      </c:pt>
                      <c:pt idx="740">
                        <c:v>1365</c:v>
                      </c:pt>
                      <c:pt idx="741">
                        <c:v>1366</c:v>
                      </c:pt>
                      <c:pt idx="742">
                        <c:v>1367</c:v>
                      </c:pt>
                      <c:pt idx="743">
                        <c:v>1369</c:v>
                      </c:pt>
                      <c:pt idx="744">
                        <c:v>1372</c:v>
                      </c:pt>
                      <c:pt idx="745">
                        <c:v>1373</c:v>
                      </c:pt>
                      <c:pt idx="746">
                        <c:v>1374</c:v>
                      </c:pt>
                      <c:pt idx="747">
                        <c:v>1375</c:v>
                      </c:pt>
                      <c:pt idx="748">
                        <c:v>1376</c:v>
                      </c:pt>
                      <c:pt idx="749">
                        <c:v>1377</c:v>
                      </c:pt>
                      <c:pt idx="750">
                        <c:v>1378</c:v>
                      </c:pt>
                      <c:pt idx="751">
                        <c:v>1379</c:v>
                      </c:pt>
                      <c:pt idx="752">
                        <c:v>1380</c:v>
                      </c:pt>
                      <c:pt idx="753">
                        <c:v>1381</c:v>
                      </c:pt>
                      <c:pt idx="754">
                        <c:v>1383</c:v>
                      </c:pt>
                      <c:pt idx="755">
                        <c:v>1384</c:v>
                      </c:pt>
                      <c:pt idx="756">
                        <c:v>1385</c:v>
                      </c:pt>
                      <c:pt idx="757">
                        <c:v>1386</c:v>
                      </c:pt>
                      <c:pt idx="758">
                        <c:v>1390</c:v>
                      </c:pt>
                      <c:pt idx="759">
                        <c:v>1391</c:v>
                      </c:pt>
                      <c:pt idx="760">
                        <c:v>1392</c:v>
                      </c:pt>
                      <c:pt idx="761">
                        <c:v>1393</c:v>
                      </c:pt>
                      <c:pt idx="762">
                        <c:v>1394</c:v>
                      </c:pt>
                      <c:pt idx="763">
                        <c:v>1395</c:v>
                      </c:pt>
                      <c:pt idx="764">
                        <c:v>1396</c:v>
                      </c:pt>
                      <c:pt idx="765">
                        <c:v>1397</c:v>
                      </c:pt>
                      <c:pt idx="766">
                        <c:v>1398</c:v>
                      </c:pt>
                      <c:pt idx="767">
                        <c:v>1400</c:v>
                      </c:pt>
                      <c:pt idx="768">
                        <c:v>1401</c:v>
                      </c:pt>
                      <c:pt idx="769">
                        <c:v>1402</c:v>
                      </c:pt>
                      <c:pt idx="770">
                        <c:v>1403</c:v>
                      </c:pt>
                      <c:pt idx="771">
                        <c:v>1405</c:v>
                      </c:pt>
                      <c:pt idx="772">
                        <c:v>1407</c:v>
                      </c:pt>
                      <c:pt idx="773">
                        <c:v>1408</c:v>
                      </c:pt>
                      <c:pt idx="774">
                        <c:v>1410</c:v>
                      </c:pt>
                      <c:pt idx="775">
                        <c:v>1411</c:v>
                      </c:pt>
                      <c:pt idx="776">
                        <c:v>1412</c:v>
                      </c:pt>
                      <c:pt idx="777">
                        <c:v>1413</c:v>
                      </c:pt>
                      <c:pt idx="778">
                        <c:v>1414</c:v>
                      </c:pt>
                      <c:pt idx="779">
                        <c:v>1415</c:v>
                      </c:pt>
                      <c:pt idx="780">
                        <c:v>1416</c:v>
                      </c:pt>
                      <c:pt idx="781">
                        <c:v>1417</c:v>
                      </c:pt>
                      <c:pt idx="782">
                        <c:v>1418</c:v>
                      </c:pt>
                      <c:pt idx="783">
                        <c:v>1419</c:v>
                      </c:pt>
                      <c:pt idx="784">
                        <c:v>1420</c:v>
                      </c:pt>
                      <c:pt idx="785">
                        <c:v>1421</c:v>
                      </c:pt>
                      <c:pt idx="786">
                        <c:v>1423</c:v>
                      </c:pt>
                      <c:pt idx="787">
                        <c:v>1424</c:v>
                      </c:pt>
                      <c:pt idx="788">
                        <c:v>1425</c:v>
                      </c:pt>
                      <c:pt idx="789">
                        <c:v>1426</c:v>
                      </c:pt>
                      <c:pt idx="790">
                        <c:v>1427</c:v>
                      </c:pt>
                      <c:pt idx="791">
                        <c:v>1428</c:v>
                      </c:pt>
                      <c:pt idx="792">
                        <c:v>1429</c:v>
                      </c:pt>
                      <c:pt idx="793">
                        <c:v>1430</c:v>
                      </c:pt>
                      <c:pt idx="794">
                        <c:v>1432</c:v>
                      </c:pt>
                      <c:pt idx="795">
                        <c:v>1434</c:v>
                      </c:pt>
                      <c:pt idx="796">
                        <c:v>1435</c:v>
                      </c:pt>
                      <c:pt idx="797">
                        <c:v>1436</c:v>
                      </c:pt>
                      <c:pt idx="798">
                        <c:v>1437</c:v>
                      </c:pt>
                      <c:pt idx="799">
                        <c:v>1439</c:v>
                      </c:pt>
                      <c:pt idx="800">
                        <c:v>1440</c:v>
                      </c:pt>
                      <c:pt idx="801">
                        <c:v>1442</c:v>
                      </c:pt>
                      <c:pt idx="802">
                        <c:v>1443</c:v>
                      </c:pt>
                      <c:pt idx="803">
                        <c:v>1444</c:v>
                      </c:pt>
                      <c:pt idx="804">
                        <c:v>1445</c:v>
                      </c:pt>
                      <c:pt idx="805">
                        <c:v>1446</c:v>
                      </c:pt>
                      <c:pt idx="806">
                        <c:v>1447</c:v>
                      </c:pt>
                      <c:pt idx="807">
                        <c:v>1448</c:v>
                      </c:pt>
                      <c:pt idx="808">
                        <c:v>1449</c:v>
                      </c:pt>
                      <c:pt idx="809">
                        <c:v>1450</c:v>
                      </c:pt>
                      <c:pt idx="810">
                        <c:v>1451</c:v>
                      </c:pt>
                      <c:pt idx="811">
                        <c:v>1453</c:v>
                      </c:pt>
                      <c:pt idx="812">
                        <c:v>1454</c:v>
                      </c:pt>
                      <c:pt idx="813">
                        <c:v>1455</c:v>
                      </c:pt>
                      <c:pt idx="814">
                        <c:v>1456</c:v>
                      </c:pt>
                      <c:pt idx="815">
                        <c:v>1457</c:v>
                      </c:pt>
                      <c:pt idx="816">
                        <c:v>1458</c:v>
                      </c:pt>
                      <c:pt idx="817">
                        <c:v>1459</c:v>
                      </c:pt>
                      <c:pt idx="818">
                        <c:v>1460</c:v>
                      </c:pt>
                      <c:pt idx="819">
                        <c:v>1461</c:v>
                      </c:pt>
                      <c:pt idx="820">
                        <c:v>1462</c:v>
                      </c:pt>
                      <c:pt idx="821">
                        <c:v>1463</c:v>
                      </c:pt>
                      <c:pt idx="822">
                        <c:v>1464</c:v>
                      </c:pt>
                      <c:pt idx="823">
                        <c:v>1465</c:v>
                      </c:pt>
                      <c:pt idx="824">
                        <c:v>1466</c:v>
                      </c:pt>
                      <c:pt idx="825">
                        <c:v>1467</c:v>
                      </c:pt>
                      <c:pt idx="826">
                        <c:v>1468</c:v>
                      </c:pt>
                      <c:pt idx="827">
                        <c:v>1469</c:v>
                      </c:pt>
                      <c:pt idx="828">
                        <c:v>1470</c:v>
                      </c:pt>
                      <c:pt idx="829">
                        <c:v>1471</c:v>
                      </c:pt>
                      <c:pt idx="830">
                        <c:v>1472</c:v>
                      </c:pt>
                      <c:pt idx="831">
                        <c:v>1473</c:v>
                      </c:pt>
                      <c:pt idx="832">
                        <c:v>1474</c:v>
                      </c:pt>
                      <c:pt idx="833">
                        <c:v>1475</c:v>
                      </c:pt>
                      <c:pt idx="834">
                        <c:v>1476</c:v>
                      </c:pt>
                      <c:pt idx="835">
                        <c:v>1477</c:v>
                      </c:pt>
                      <c:pt idx="836">
                        <c:v>1478</c:v>
                      </c:pt>
                      <c:pt idx="837">
                        <c:v>1479</c:v>
                      </c:pt>
                      <c:pt idx="838">
                        <c:v>1480</c:v>
                      </c:pt>
                      <c:pt idx="839">
                        <c:v>1481</c:v>
                      </c:pt>
                      <c:pt idx="840">
                        <c:v>1482</c:v>
                      </c:pt>
                      <c:pt idx="841">
                        <c:v>1483</c:v>
                      </c:pt>
                      <c:pt idx="842">
                        <c:v>1484</c:v>
                      </c:pt>
                      <c:pt idx="843">
                        <c:v>1485</c:v>
                      </c:pt>
                      <c:pt idx="844">
                        <c:v>1486</c:v>
                      </c:pt>
                      <c:pt idx="845">
                        <c:v>1487</c:v>
                      </c:pt>
                      <c:pt idx="846">
                        <c:v>1488</c:v>
                      </c:pt>
                      <c:pt idx="847">
                        <c:v>1489</c:v>
                      </c:pt>
                      <c:pt idx="848">
                        <c:v>1490</c:v>
                      </c:pt>
                      <c:pt idx="849">
                        <c:v>1491</c:v>
                      </c:pt>
                      <c:pt idx="850">
                        <c:v>1492</c:v>
                      </c:pt>
                      <c:pt idx="851">
                        <c:v>1493</c:v>
                      </c:pt>
                      <c:pt idx="852">
                        <c:v>1494</c:v>
                      </c:pt>
                      <c:pt idx="853">
                        <c:v>1495</c:v>
                      </c:pt>
                      <c:pt idx="854">
                        <c:v>1496</c:v>
                      </c:pt>
                      <c:pt idx="855">
                        <c:v>1497</c:v>
                      </c:pt>
                      <c:pt idx="856">
                        <c:v>1498</c:v>
                      </c:pt>
                      <c:pt idx="857">
                        <c:v>1499</c:v>
                      </c:pt>
                      <c:pt idx="858">
                        <c:v>1500</c:v>
                      </c:pt>
                      <c:pt idx="859">
                        <c:v>1501</c:v>
                      </c:pt>
                      <c:pt idx="860">
                        <c:v>1502</c:v>
                      </c:pt>
                      <c:pt idx="861">
                        <c:v>1503</c:v>
                      </c:pt>
                      <c:pt idx="862">
                        <c:v>1504</c:v>
                      </c:pt>
                      <c:pt idx="863">
                        <c:v>1505</c:v>
                      </c:pt>
                      <c:pt idx="864">
                        <c:v>1506</c:v>
                      </c:pt>
                      <c:pt idx="865">
                        <c:v>1507</c:v>
                      </c:pt>
                      <c:pt idx="866">
                        <c:v>1509</c:v>
                      </c:pt>
                      <c:pt idx="867">
                        <c:v>1510</c:v>
                      </c:pt>
                      <c:pt idx="868">
                        <c:v>1511</c:v>
                      </c:pt>
                      <c:pt idx="869">
                        <c:v>1512</c:v>
                      </c:pt>
                      <c:pt idx="870">
                        <c:v>1514</c:v>
                      </c:pt>
                      <c:pt idx="871">
                        <c:v>1515</c:v>
                      </c:pt>
                      <c:pt idx="872">
                        <c:v>1516</c:v>
                      </c:pt>
                      <c:pt idx="873">
                        <c:v>1517</c:v>
                      </c:pt>
                      <c:pt idx="874">
                        <c:v>1518</c:v>
                      </c:pt>
                      <c:pt idx="875">
                        <c:v>1519</c:v>
                      </c:pt>
                      <c:pt idx="876">
                        <c:v>1520</c:v>
                      </c:pt>
                      <c:pt idx="877">
                        <c:v>1521</c:v>
                      </c:pt>
                      <c:pt idx="878">
                        <c:v>1522</c:v>
                      </c:pt>
                      <c:pt idx="879">
                        <c:v>1523</c:v>
                      </c:pt>
                      <c:pt idx="880">
                        <c:v>1524</c:v>
                      </c:pt>
                      <c:pt idx="881">
                        <c:v>1525</c:v>
                      </c:pt>
                      <c:pt idx="882">
                        <c:v>1526</c:v>
                      </c:pt>
                      <c:pt idx="883">
                        <c:v>1527</c:v>
                      </c:pt>
                      <c:pt idx="884">
                        <c:v>1528</c:v>
                      </c:pt>
                      <c:pt idx="885">
                        <c:v>1529</c:v>
                      </c:pt>
                      <c:pt idx="886">
                        <c:v>1530</c:v>
                      </c:pt>
                      <c:pt idx="887">
                        <c:v>1531</c:v>
                      </c:pt>
                      <c:pt idx="888">
                        <c:v>1532</c:v>
                      </c:pt>
                      <c:pt idx="889">
                        <c:v>1533</c:v>
                      </c:pt>
                      <c:pt idx="890">
                        <c:v>1534</c:v>
                      </c:pt>
                      <c:pt idx="891">
                        <c:v>1535</c:v>
                      </c:pt>
                      <c:pt idx="892">
                        <c:v>1536</c:v>
                      </c:pt>
                      <c:pt idx="893">
                        <c:v>1537</c:v>
                      </c:pt>
                      <c:pt idx="894">
                        <c:v>1538</c:v>
                      </c:pt>
                      <c:pt idx="895">
                        <c:v>1539</c:v>
                      </c:pt>
                      <c:pt idx="896">
                        <c:v>1540</c:v>
                      </c:pt>
                      <c:pt idx="897">
                        <c:v>1541</c:v>
                      </c:pt>
                      <c:pt idx="898">
                        <c:v>1542</c:v>
                      </c:pt>
                      <c:pt idx="899">
                        <c:v>1543</c:v>
                      </c:pt>
                      <c:pt idx="900">
                        <c:v>1544</c:v>
                      </c:pt>
                      <c:pt idx="901">
                        <c:v>1545</c:v>
                      </c:pt>
                      <c:pt idx="902">
                        <c:v>1546</c:v>
                      </c:pt>
                      <c:pt idx="903">
                        <c:v>1547</c:v>
                      </c:pt>
                      <c:pt idx="904">
                        <c:v>1548</c:v>
                      </c:pt>
                      <c:pt idx="905">
                        <c:v>1549</c:v>
                      </c:pt>
                      <c:pt idx="906">
                        <c:v>1550</c:v>
                      </c:pt>
                      <c:pt idx="907">
                        <c:v>1551</c:v>
                      </c:pt>
                      <c:pt idx="908">
                        <c:v>1552</c:v>
                      </c:pt>
                      <c:pt idx="909">
                        <c:v>1553</c:v>
                      </c:pt>
                      <c:pt idx="910">
                        <c:v>1554</c:v>
                      </c:pt>
                      <c:pt idx="911">
                        <c:v>1555</c:v>
                      </c:pt>
                      <c:pt idx="912">
                        <c:v>1556</c:v>
                      </c:pt>
                      <c:pt idx="913">
                        <c:v>1557</c:v>
                      </c:pt>
                      <c:pt idx="914">
                        <c:v>1558</c:v>
                      </c:pt>
                      <c:pt idx="915">
                        <c:v>1559</c:v>
                      </c:pt>
                      <c:pt idx="916">
                        <c:v>1560</c:v>
                      </c:pt>
                      <c:pt idx="917">
                        <c:v>1561</c:v>
                      </c:pt>
                      <c:pt idx="918">
                        <c:v>1562</c:v>
                      </c:pt>
                      <c:pt idx="919">
                        <c:v>1563</c:v>
                      </c:pt>
                      <c:pt idx="920">
                        <c:v>1564</c:v>
                      </c:pt>
                      <c:pt idx="921">
                        <c:v>1565</c:v>
                      </c:pt>
                      <c:pt idx="922">
                        <c:v>1566</c:v>
                      </c:pt>
                      <c:pt idx="923">
                        <c:v>1567</c:v>
                      </c:pt>
                      <c:pt idx="924">
                        <c:v>1568</c:v>
                      </c:pt>
                      <c:pt idx="925">
                        <c:v>1569</c:v>
                      </c:pt>
                      <c:pt idx="926">
                        <c:v>1570</c:v>
                      </c:pt>
                      <c:pt idx="927">
                        <c:v>1571</c:v>
                      </c:pt>
                      <c:pt idx="928">
                        <c:v>1572</c:v>
                      </c:pt>
                      <c:pt idx="929">
                        <c:v>1573</c:v>
                      </c:pt>
                      <c:pt idx="930">
                        <c:v>1574</c:v>
                      </c:pt>
                      <c:pt idx="931">
                        <c:v>1575</c:v>
                      </c:pt>
                      <c:pt idx="932">
                        <c:v>1576</c:v>
                      </c:pt>
                      <c:pt idx="933">
                        <c:v>1577</c:v>
                      </c:pt>
                      <c:pt idx="934">
                        <c:v>1578</c:v>
                      </c:pt>
                      <c:pt idx="935">
                        <c:v>1579</c:v>
                      </c:pt>
                      <c:pt idx="936">
                        <c:v>1580</c:v>
                      </c:pt>
                      <c:pt idx="937">
                        <c:v>1582</c:v>
                      </c:pt>
                      <c:pt idx="938">
                        <c:v>1583</c:v>
                      </c:pt>
                      <c:pt idx="939">
                        <c:v>1584</c:v>
                      </c:pt>
                      <c:pt idx="940">
                        <c:v>1585</c:v>
                      </c:pt>
                      <c:pt idx="941">
                        <c:v>1586</c:v>
                      </c:pt>
                      <c:pt idx="942">
                        <c:v>1587</c:v>
                      </c:pt>
                      <c:pt idx="943">
                        <c:v>1588</c:v>
                      </c:pt>
                      <c:pt idx="944">
                        <c:v>1589</c:v>
                      </c:pt>
                      <c:pt idx="945">
                        <c:v>1591</c:v>
                      </c:pt>
                      <c:pt idx="946">
                        <c:v>1592</c:v>
                      </c:pt>
                      <c:pt idx="947">
                        <c:v>1593</c:v>
                      </c:pt>
                      <c:pt idx="948">
                        <c:v>1594</c:v>
                      </c:pt>
                      <c:pt idx="949">
                        <c:v>1595</c:v>
                      </c:pt>
                      <c:pt idx="950">
                        <c:v>1596</c:v>
                      </c:pt>
                      <c:pt idx="951">
                        <c:v>1597</c:v>
                      </c:pt>
                      <c:pt idx="952">
                        <c:v>1598</c:v>
                      </c:pt>
                      <c:pt idx="953">
                        <c:v>1599</c:v>
                      </c:pt>
                      <c:pt idx="954">
                        <c:v>1600</c:v>
                      </c:pt>
                      <c:pt idx="955">
                        <c:v>1601</c:v>
                      </c:pt>
                      <c:pt idx="956">
                        <c:v>1602</c:v>
                      </c:pt>
                      <c:pt idx="957">
                        <c:v>1603</c:v>
                      </c:pt>
                      <c:pt idx="958">
                        <c:v>1604</c:v>
                      </c:pt>
                      <c:pt idx="959">
                        <c:v>1605</c:v>
                      </c:pt>
                      <c:pt idx="960">
                        <c:v>1606</c:v>
                      </c:pt>
                      <c:pt idx="961">
                        <c:v>1607</c:v>
                      </c:pt>
                      <c:pt idx="962">
                        <c:v>1608</c:v>
                      </c:pt>
                      <c:pt idx="963">
                        <c:v>1609</c:v>
                      </c:pt>
                      <c:pt idx="964">
                        <c:v>1610</c:v>
                      </c:pt>
                      <c:pt idx="965">
                        <c:v>1611</c:v>
                      </c:pt>
                      <c:pt idx="966">
                        <c:v>1612</c:v>
                      </c:pt>
                      <c:pt idx="967">
                        <c:v>1613</c:v>
                      </c:pt>
                      <c:pt idx="968">
                        <c:v>1614</c:v>
                      </c:pt>
                      <c:pt idx="969">
                        <c:v>1615</c:v>
                      </c:pt>
                      <c:pt idx="970">
                        <c:v>1616</c:v>
                      </c:pt>
                      <c:pt idx="971">
                        <c:v>1617</c:v>
                      </c:pt>
                      <c:pt idx="972">
                        <c:v>1618</c:v>
                      </c:pt>
                      <c:pt idx="973">
                        <c:v>1619</c:v>
                      </c:pt>
                      <c:pt idx="974">
                        <c:v>1620</c:v>
                      </c:pt>
                      <c:pt idx="975">
                        <c:v>1621</c:v>
                      </c:pt>
                      <c:pt idx="976">
                        <c:v>1622</c:v>
                      </c:pt>
                      <c:pt idx="977">
                        <c:v>1623</c:v>
                      </c:pt>
                      <c:pt idx="978">
                        <c:v>1624</c:v>
                      </c:pt>
                      <c:pt idx="979">
                        <c:v>1625</c:v>
                      </c:pt>
                      <c:pt idx="980">
                        <c:v>1626</c:v>
                      </c:pt>
                      <c:pt idx="981">
                        <c:v>1627</c:v>
                      </c:pt>
                      <c:pt idx="982">
                        <c:v>1628</c:v>
                      </c:pt>
                      <c:pt idx="983">
                        <c:v>1629</c:v>
                      </c:pt>
                      <c:pt idx="984">
                        <c:v>1630</c:v>
                      </c:pt>
                      <c:pt idx="985">
                        <c:v>1631</c:v>
                      </c:pt>
                      <c:pt idx="986">
                        <c:v>1632</c:v>
                      </c:pt>
                      <c:pt idx="987">
                        <c:v>1633</c:v>
                      </c:pt>
                      <c:pt idx="988">
                        <c:v>1634</c:v>
                      </c:pt>
                      <c:pt idx="989">
                        <c:v>1635</c:v>
                      </c:pt>
                      <c:pt idx="990">
                        <c:v>1636</c:v>
                      </c:pt>
                      <c:pt idx="991">
                        <c:v>1637</c:v>
                      </c:pt>
                      <c:pt idx="992">
                        <c:v>1638</c:v>
                      </c:pt>
                      <c:pt idx="993">
                        <c:v>1639</c:v>
                      </c:pt>
                      <c:pt idx="994">
                        <c:v>1640</c:v>
                      </c:pt>
                      <c:pt idx="995">
                        <c:v>1641</c:v>
                      </c:pt>
                      <c:pt idx="996">
                        <c:v>1642</c:v>
                      </c:pt>
                      <c:pt idx="997">
                        <c:v>1643</c:v>
                      </c:pt>
                      <c:pt idx="998">
                        <c:v>1644</c:v>
                      </c:pt>
                      <c:pt idx="999">
                        <c:v>1645</c:v>
                      </c:pt>
                      <c:pt idx="1000">
                        <c:v>1646</c:v>
                      </c:pt>
                      <c:pt idx="1001">
                        <c:v>1647</c:v>
                      </c:pt>
                      <c:pt idx="1002">
                        <c:v>1648</c:v>
                      </c:pt>
                      <c:pt idx="1003">
                        <c:v>1649</c:v>
                      </c:pt>
                      <c:pt idx="1004">
                        <c:v>1650</c:v>
                      </c:pt>
                      <c:pt idx="1005">
                        <c:v>1651</c:v>
                      </c:pt>
                      <c:pt idx="1006">
                        <c:v>1652</c:v>
                      </c:pt>
                      <c:pt idx="1007">
                        <c:v>1653</c:v>
                      </c:pt>
                      <c:pt idx="1008">
                        <c:v>1654</c:v>
                      </c:pt>
                      <c:pt idx="1009">
                        <c:v>1655</c:v>
                      </c:pt>
                      <c:pt idx="1010">
                        <c:v>1656</c:v>
                      </c:pt>
                      <c:pt idx="1011">
                        <c:v>1657</c:v>
                      </c:pt>
                      <c:pt idx="1012">
                        <c:v>1658</c:v>
                      </c:pt>
                      <c:pt idx="1013">
                        <c:v>1659</c:v>
                      </c:pt>
                      <c:pt idx="1014">
                        <c:v>1660</c:v>
                      </c:pt>
                      <c:pt idx="1015">
                        <c:v>1661</c:v>
                      </c:pt>
                      <c:pt idx="1016">
                        <c:v>1663</c:v>
                      </c:pt>
                      <c:pt idx="1017">
                        <c:v>1664</c:v>
                      </c:pt>
                      <c:pt idx="1018">
                        <c:v>1668</c:v>
                      </c:pt>
                      <c:pt idx="1019">
                        <c:v>1669</c:v>
                      </c:pt>
                      <c:pt idx="1020">
                        <c:v>1672</c:v>
                      </c:pt>
                      <c:pt idx="1021">
                        <c:v>1673</c:v>
                      </c:pt>
                      <c:pt idx="1022">
                        <c:v>1674</c:v>
                      </c:pt>
                      <c:pt idx="1023">
                        <c:v>1675</c:v>
                      </c:pt>
                      <c:pt idx="1024">
                        <c:v>1676</c:v>
                      </c:pt>
                      <c:pt idx="1025">
                        <c:v>1677</c:v>
                      </c:pt>
                      <c:pt idx="1026">
                        <c:v>1678</c:v>
                      </c:pt>
                      <c:pt idx="1027">
                        <c:v>1679</c:v>
                      </c:pt>
                      <c:pt idx="1028">
                        <c:v>1680</c:v>
                      </c:pt>
                      <c:pt idx="1029">
                        <c:v>1681</c:v>
                      </c:pt>
                      <c:pt idx="1030">
                        <c:v>1682</c:v>
                      </c:pt>
                      <c:pt idx="1031">
                        <c:v>1683</c:v>
                      </c:pt>
                      <c:pt idx="1032">
                        <c:v>1684</c:v>
                      </c:pt>
                      <c:pt idx="1033">
                        <c:v>1685</c:v>
                      </c:pt>
                      <c:pt idx="1034">
                        <c:v>1686</c:v>
                      </c:pt>
                      <c:pt idx="1035">
                        <c:v>1687</c:v>
                      </c:pt>
                      <c:pt idx="1036">
                        <c:v>1688</c:v>
                      </c:pt>
                      <c:pt idx="1037">
                        <c:v>1689</c:v>
                      </c:pt>
                      <c:pt idx="1038">
                        <c:v>1690</c:v>
                      </c:pt>
                      <c:pt idx="1039">
                        <c:v>1701</c:v>
                      </c:pt>
                      <c:pt idx="1040">
                        <c:v>1704</c:v>
                      </c:pt>
                      <c:pt idx="1041">
                        <c:v>1708</c:v>
                      </c:pt>
                      <c:pt idx="1042">
                        <c:v>1709</c:v>
                      </c:pt>
                      <c:pt idx="1043">
                        <c:v>1710</c:v>
                      </c:pt>
                      <c:pt idx="1044">
                        <c:v>1712</c:v>
                      </c:pt>
                      <c:pt idx="1045">
                        <c:v>1713</c:v>
                      </c:pt>
                      <c:pt idx="1046">
                        <c:v>1714</c:v>
                      </c:pt>
                      <c:pt idx="1047">
                        <c:v>1715</c:v>
                      </c:pt>
                      <c:pt idx="1048">
                        <c:v>1716</c:v>
                      </c:pt>
                      <c:pt idx="1049">
                        <c:v>1717</c:v>
                      </c:pt>
                      <c:pt idx="1050">
                        <c:v>1718</c:v>
                      </c:pt>
                      <c:pt idx="1051">
                        <c:v>1721</c:v>
                      </c:pt>
                      <c:pt idx="1052">
                        <c:v>1722</c:v>
                      </c:pt>
                      <c:pt idx="1053">
                        <c:v>1725</c:v>
                      </c:pt>
                      <c:pt idx="1054">
                        <c:v>1726</c:v>
                      </c:pt>
                      <c:pt idx="1055">
                        <c:v>1732</c:v>
                      </c:pt>
                      <c:pt idx="1056">
                        <c:v>1746</c:v>
                      </c:pt>
                      <c:pt idx="1057">
                        <c:v>1951</c:v>
                      </c:pt>
                    </c:numCache>
                  </c:numRef>
                </c:xVal>
                <c:yVal>
                  <c:numRef>
                    <c:extLst xmlns:c15="http://schemas.microsoft.com/office/drawing/2012/chart">
                      <c:ext xmlns:c15="http://schemas.microsoft.com/office/drawing/2012/chart" uri="{02D57815-91ED-43cb-92C2-25804820EDAC}">
                        <c15:formulaRef>
                          <c15:sqref>'Brachy NFY'!$F$3:$F$1060</c15:sqref>
                        </c15:formulaRef>
                      </c:ext>
                    </c:extLst>
                    <c:numCache>
                      <c:formatCode>General</c:formatCode>
                      <c:ptCount val="1058"/>
                      <c:pt idx="26">
                        <c:v>1</c:v>
                      </c:pt>
                      <c:pt idx="69">
                        <c:v>1</c:v>
                      </c:pt>
                      <c:pt idx="82">
                        <c:v>1</c:v>
                      </c:pt>
                      <c:pt idx="93">
                        <c:v>1</c:v>
                      </c:pt>
                      <c:pt idx="111">
                        <c:v>1</c:v>
                      </c:pt>
                      <c:pt idx="133">
                        <c:v>1</c:v>
                      </c:pt>
                      <c:pt idx="138">
                        <c:v>1</c:v>
                      </c:pt>
                      <c:pt idx="145">
                        <c:v>1</c:v>
                      </c:pt>
                      <c:pt idx="152">
                        <c:v>1</c:v>
                      </c:pt>
                      <c:pt idx="160">
                        <c:v>1</c:v>
                      </c:pt>
                      <c:pt idx="164">
                        <c:v>1</c:v>
                      </c:pt>
                      <c:pt idx="189">
                        <c:v>1</c:v>
                      </c:pt>
                      <c:pt idx="197">
                        <c:v>1</c:v>
                      </c:pt>
                      <c:pt idx="198">
                        <c:v>1</c:v>
                      </c:pt>
                      <c:pt idx="200">
                        <c:v>1</c:v>
                      </c:pt>
                      <c:pt idx="205">
                        <c:v>1</c:v>
                      </c:pt>
                      <c:pt idx="228">
                        <c:v>1</c:v>
                      </c:pt>
                      <c:pt idx="232">
                        <c:v>1</c:v>
                      </c:pt>
                      <c:pt idx="234">
                        <c:v>1</c:v>
                      </c:pt>
                      <c:pt idx="235">
                        <c:v>1</c:v>
                      </c:pt>
                      <c:pt idx="248">
                        <c:v>1</c:v>
                      </c:pt>
                      <c:pt idx="258">
                        <c:v>1</c:v>
                      </c:pt>
                      <c:pt idx="259">
                        <c:v>1</c:v>
                      </c:pt>
                      <c:pt idx="263">
                        <c:v>1</c:v>
                      </c:pt>
                      <c:pt idx="273">
                        <c:v>1</c:v>
                      </c:pt>
                      <c:pt idx="275">
                        <c:v>1</c:v>
                      </c:pt>
                      <c:pt idx="283">
                        <c:v>1</c:v>
                      </c:pt>
                      <c:pt idx="286">
                        <c:v>1</c:v>
                      </c:pt>
                      <c:pt idx="290">
                        <c:v>1</c:v>
                      </c:pt>
                      <c:pt idx="298">
                        <c:v>1</c:v>
                      </c:pt>
                      <c:pt idx="310">
                        <c:v>1</c:v>
                      </c:pt>
                      <c:pt idx="311">
                        <c:v>1</c:v>
                      </c:pt>
                      <c:pt idx="314">
                        <c:v>1</c:v>
                      </c:pt>
                      <c:pt idx="317">
                        <c:v>1</c:v>
                      </c:pt>
                      <c:pt idx="327">
                        <c:v>1</c:v>
                      </c:pt>
                      <c:pt idx="335">
                        <c:v>1</c:v>
                      </c:pt>
                      <c:pt idx="337">
                        <c:v>4</c:v>
                      </c:pt>
                      <c:pt idx="338">
                        <c:v>1</c:v>
                      </c:pt>
                      <c:pt idx="342">
                        <c:v>1</c:v>
                      </c:pt>
                      <c:pt idx="350">
                        <c:v>1</c:v>
                      </c:pt>
                      <c:pt idx="352">
                        <c:v>1</c:v>
                      </c:pt>
                      <c:pt idx="355">
                        <c:v>1</c:v>
                      </c:pt>
                      <c:pt idx="368">
                        <c:v>1</c:v>
                      </c:pt>
                      <c:pt idx="381">
                        <c:v>1</c:v>
                      </c:pt>
                      <c:pt idx="387">
                        <c:v>1</c:v>
                      </c:pt>
                      <c:pt idx="389">
                        <c:v>1</c:v>
                      </c:pt>
                      <c:pt idx="391">
                        <c:v>1</c:v>
                      </c:pt>
                      <c:pt idx="396">
                        <c:v>1</c:v>
                      </c:pt>
                      <c:pt idx="397">
                        <c:v>1</c:v>
                      </c:pt>
                      <c:pt idx="404">
                        <c:v>1</c:v>
                      </c:pt>
                      <c:pt idx="405">
                        <c:v>1</c:v>
                      </c:pt>
                      <c:pt idx="413">
                        <c:v>1</c:v>
                      </c:pt>
                      <c:pt idx="414">
                        <c:v>1</c:v>
                      </c:pt>
                      <c:pt idx="419">
                        <c:v>1</c:v>
                      </c:pt>
                      <c:pt idx="423">
                        <c:v>1</c:v>
                      </c:pt>
                      <c:pt idx="424">
                        <c:v>1</c:v>
                      </c:pt>
                      <c:pt idx="427">
                        <c:v>1</c:v>
                      </c:pt>
                      <c:pt idx="432">
                        <c:v>1</c:v>
                      </c:pt>
                      <c:pt idx="433">
                        <c:v>1</c:v>
                      </c:pt>
                      <c:pt idx="434">
                        <c:v>1</c:v>
                      </c:pt>
                      <c:pt idx="438">
                        <c:v>1</c:v>
                      </c:pt>
                      <c:pt idx="440">
                        <c:v>1</c:v>
                      </c:pt>
                      <c:pt idx="441">
                        <c:v>1</c:v>
                      </c:pt>
                      <c:pt idx="455">
                        <c:v>1</c:v>
                      </c:pt>
                      <c:pt idx="460">
                        <c:v>1</c:v>
                      </c:pt>
                      <c:pt idx="470">
                        <c:v>1</c:v>
                      </c:pt>
                      <c:pt idx="479">
                        <c:v>1</c:v>
                      </c:pt>
                      <c:pt idx="480">
                        <c:v>1</c:v>
                      </c:pt>
                      <c:pt idx="482">
                        <c:v>1</c:v>
                      </c:pt>
                      <c:pt idx="483">
                        <c:v>1</c:v>
                      </c:pt>
                      <c:pt idx="484">
                        <c:v>1</c:v>
                      </c:pt>
                      <c:pt idx="488">
                        <c:v>1</c:v>
                      </c:pt>
                      <c:pt idx="493">
                        <c:v>1</c:v>
                      </c:pt>
                      <c:pt idx="506">
                        <c:v>1</c:v>
                      </c:pt>
                      <c:pt idx="513">
                        <c:v>1</c:v>
                      </c:pt>
                      <c:pt idx="514">
                        <c:v>1</c:v>
                      </c:pt>
                      <c:pt idx="515">
                        <c:v>1</c:v>
                      </c:pt>
                      <c:pt idx="538">
                        <c:v>1</c:v>
                      </c:pt>
                      <c:pt idx="539">
                        <c:v>1</c:v>
                      </c:pt>
                      <c:pt idx="545">
                        <c:v>1</c:v>
                      </c:pt>
                      <c:pt idx="547">
                        <c:v>1</c:v>
                      </c:pt>
                      <c:pt idx="549">
                        <c:v>1</c:v>
                      </c:pt>
                      <c:pt idx="551">
                        <c:v>1</c:v>
                      </c:pt>
                      <c:pt idx="561">
                        <c:v>1</c:v>
                      </c:pt>
                      <c:pt idx="563">
                        <c:v>1</c:v>
                      </c:pt>
                      <c:pt idx="570">
                        <c:v>1</c:v>
                      </c:pt>
                      <c:pt idx="574">
                        <c:v>1</c:v>
                      </c:pt>
                      <c:pt idx="575">
                        <c:v>1</c:v>
                      </c:pt>
                      <c:pt idx="578">
                        <c:v>1</c:v>
                      </c:pt>
                      <c:pt idx="597">
                        <c:v>1</c:v>
                      </c:pt>
                      <c:pt idx="602">
                        <c:v>1</c:v>
                      </c:pt>
                      <c:pt idx="603">
                        <c:v>4</c:v>
                      </c:pt>
                      <c:pt idx="604">
                        <c:v>4</c:v>
                      </c:pt>
                      <c:pt idx="605">
                        <c:v>7</c:v>
                      </c:pt>
                      <c:pt idx="606">
                        <c:v>3</c:v>
                      </c:pt>
                      <c:pt idx="608">
                        <c:v>1</c:v>
                      </c:pt>
                      <c:pt idx="609">
                        <c:v>1</c:v>
                      </c:pt>
                      <c:pt idx="615">
                        <c:v>1</c:v>
                      </c:pt>
                      <c:pt idx="621">
                        <c:v>1</c:v>
                      </c:pt>
                      <c:pt idx="632">
                        <c:v>1</c:v>
                      </c:pt>
                      <c:pt idx="633">
                        <c:v>1</c:v>
                      </c:pt>
                      <c:pt idx="634">
                        <c:v>1</c:v>
                      </c:pt>
                      <c:pt idx="636">
                        <c:v>1</c:v>
                      </c:pt>
                      <c:pt idx="644">
                        <c:v>1</c:v>
                      </c:pt>
                      <c:pt idx="648">
                        <c:v>1</c:v>
                      </c:pt>
                      <c:pt idx="666">
                        <c:v>1</c:v>
                      </c:pt>
                      <c:pt idx="678">
                        <c:v>1</c:v>
                      </c:pt>
                      <c:pt idx="680">
                        <c:v>1</c:v>
                      </c:pt>
                      <c:pt idx="684">
                        <c:v>1</c:v>
                      </c:pt>
                      <c:pt idx="687">
                        <c:v>1</c:v>
                      </c:pt>
                      <c:pt idx="695">
                        <c:v>1</c:v>
                      </c:pt>
                      <c:pt idx="700">
                        <c:v>1</c:v>
                      </c:pt>
                      <c:pt idx="704">
                        <c:v>1</c:v>
                      </c:pt>
                      <c:pt idx="705">
                        <c:v>1</c:v>
                      </c:pt>
                      <c:pt idx="706">
                        <c:v>1</c:v>
                      </c:pt>
                      <c:pt idx="715">
                        <c:v>1</c:v>
                      </c:pt>
                      <c:pt idx="718">
                        <c:v>1</c:v>
                      </c:pt>
                      <c:pt idx="733">
                        <c:v>1</c:v>
                      </c:pt>
                      <c:pt idx="741">
                        <c:v>1</c:v>
                      </c:pt>
                      <c:pt idx="745">
                        <c:v>1</c:v>
                      </c:pt>
                      <c:pt idx="748">
                        <c:v>1</c:v>
                      </c:pt>
                      <c:pt idx="758">
                        <c:v>1</c:v>
                      </c:pt>
                      <c:pt idx="762">
                        <c:v>1</c:v>
                      </c:pt>
                      <c:pt idx="764">
                        <c:v>1</c:v>
                      </c:pt>
                      <c:pt idx="769">
                        <c:v>1</c:v>
                      </c:pt>
                      <c:pt idx="776">
                        <c:v>1</c:v>
                      </c:pt>
                      <c:pt idx="780">
                        <c:v>1</c:v>
                      </c:pt>
                      <c:pt idx="781">
                        <c:v>1</c:v>
                      </c:pt>
                      <c:pt idx="783">
                        <c:v>1</c:v>
                      </c:pt>
                      <c:pt idx="789">
                        <c:v>1</c:v>
                      </c:pt>
                      <c:pt idx="790">
                        <c:v>1</c:v>
                      </c:pt>
                      <c:pt idx="793">
                        <c:v>1</c:v>
                      </c:pt>
                      <c:pt idx="795">
                        <c:v>1</c:v>
                      </c:pt>
                      <c:pt idx="796">
                        <c:v>1</c:v>
                      </c:pt>
                      <c:pt idx="797">
                        <c:v>1</c:v>
                      </c:pt>
                      <c:pt idx="798">
                        <c:v>1</c:v>
                      </c:pt>
                      <c:pt idx="800">
                        <c:v>1</c:v>
                      </c:pt>
                      <c:pt idx="801">
                        <c:v>1</c:v>
                      </c:pt>
                      <c:pt idx="806">
                        <c:v>34</c:v>
                      </c:pt>
                      <c:pt idx="808">
                        <c:v>1</c:v>
                      </c:pt>
                      <c:pt idx="814">
                        <c:v>1</c:v>
                      </c:pt>
                      <c:pt idx="819">
                        <c:v>1</c:v>
                      </c:pt>
                      <c:pt idx="822">
                        <c:v>1</c:v>
                      </c:pt>
                      <c:pt idx="824">
                        <c:v>1</c:v>
                      </c:pt>
                      <c:pt idx="826">
                        <c:v>2</c:v>
                      </c:pt>
                      <c:pt idx="827">
                        <c:v>1</c:v>
                      </c:pt>
                      <c:pt idx="829">
                        <c:v>1</c:v>
                      </c:pt>
                      <c:pt idx="830">
                        <c:v>1</c:v>
                      </c:pt>
                      <c:pt idx="832">
                        <c:v>1</c:v>
                      </c:pt>
                      <c:pt idx="833">
                        <c:v>1</c:v>
                      </c:pt>
                      <c:pt idx="834">
                        <c:v>1</c:v>
                      </c:pt>
                      <c:pt idx="835">
                        <c:v>1</c:v>
                      </c:pt>
                      <c:pt idx="837">
                        <c:v>1</c:v>
                      </c:pt>
                      <c:pt idx="838">
                        <c:v>1</c:v>
                      </c:pt>
                      <c:pt idx="839">
                        <c:v>1</c:v>
                      </c:pt>
                      <c:pt idx="841">
                        <c:v>1</c:v>
                      </c:pt>
                      <c:pt idx="843">
                        <c:v>1</c:v>
                      </c:pt>
                      <c:pt idx="844">
                        <c:v>1</c:v>
                      </c:pt>
                      <c:pt idx="845">
                        <c:v>1</c:v>
                      </c:pt>
                      <c:pt idx="846">
                        <c:v>1</c:v>
                      </c:pt>
                      <c:pt idx="849">
                        <c:v>8</c:v>
                      </c:pt>
                      <c:pt idx="851">
                        <c:v>1</c:v>
                      </c:pt>
                      <c:pt idx="853">
                        <c:v>1</c:v>
                      </c:pt>
                      <c:pt idx="854">
                        <c:v>1</c:v>
                      </c:pt>
                      <c:pt idx="857">
                        <c:v>1</c:v>
                      </c:pt>
                      <c:pt idx="858">
                        <c:v>1</c:v>
                      </c:pt>
                      <c:pt idx="859">
                        <c:v>1</c:v>
                      </c:pt>
                      <c:pt idx="860">
                        <c:v>1</c:v>
                      </c:pt>
                      <c:pt idx="864">
                        <c:v>1</c:v>
                      </c:pt>
                      <c:pt idx="865">
                        <c:v>1</c:v>
                      </c:pt>
                      <c:pt idx="868">
                        <c:v>1</c:v>
                      </c:pt>
                      <c:pt idx="869">
                        <c:v>1</c:v>
                      </c:pt>
                      <c:pt idx="873">
                        <c:v>1</c:v>
                      </c:pt>
                      <c:pt idx="875">
                        <c:v>1</c:v>
                      </c:pt>
                      <c:pt idx="876">
                        <c:v>3</c:v>
                      </c:pt>
                      <c:pt idx="877">
                        <c:v>1</c:v>
                      </c:pt>
                      <c:pt idx="878">
                        <c:v>1</c:v>
                      </c:pt>
                      <c:pt idx="880">
                        <c:v>1</c:v>
                      </c:pt>
                      <c:pt idx="882">
                        <c:v>1</c:v>
                      </c:pt>
                      <c:pt idx="884">
                        <c:v>1</c:v>
                      </c:pt>
                      <c:pt idx="885">
                        <c:v>3</c:v>
                      </c:pt>
                      <c:pt idx="886">
                        <c:v>1</c:v>
                      </c:pt>
                      <c:pt idx="887">
                        <c:v>1</c:v>
                      </c:pt>
                      <c:pt idx="888">
                        <c:v>1</c:v>
                      </c:pt>
                      <c:pt idx="889">
                        <c:v>1</c:v>
                      </c:pt>
                      <c:pt idx="891">
                        <c:v>1</c:v>
                      </c:pt>
                      <c:pt idx="892">
                        <c:v>1</c:v>
                      </c:pt>
                      <c:pt idx="893">
                        <c:v>1</c:v>
                      </c:pt>
                      <c:pt idx="894">
                        <c:v>1</c:v>
                      </c:pt>
                      <c:pt idx="895">
                        <c:v>1</c:v>
                      </c:pt>
                      <c:pt idx="896">
                        <c:v>1</c:v>
                      </c:pt>
                      <c:pt idx="897">
                        <c:v>2</c:v>
                      </c:pt>
                      <c:pt idx="898">
                        <c:v>1</c:v>
                      </c:pt>
                      <c:pt idx="899">
                        <c:v>1</c:v>
                      </c:pt>
                      <c:pt idx="901">
                        <c:v>1</c:v>
                      </c:pt>
                      <c:pt idx="902">
                        <c:v>1</c:v>
                      </c:pt>
                      <c:pt idx="903">
                        <c:v>1</c:v>
                      </c:pt>
                      <c:pt idx="904">
                        <c:v>1</c:v>
                      </c:pt>
                      <c:pt idx="905">
                        <c:v>1</c:v>
                      </c:pt>
                      <c:pt idx="906">
                        <c:v>21</c:v>
                      </c:pt>
                      <c:pt idx="907">
                        <c:v>2</c:v>
                      </c:pt>
                      <c:pt idx="910">
                        <c:v>2</c:v>
                      </c:pt>
                      <c:pt idx="911">
                        <c:v>2</c:v>
                      </c:pt>
                      <c:pt idx="913">
                        <c:v>1</c:v>
                      </c:pt>
                      <c:pt idx="914">
                        <c:v>1</c:v>
                      </c:pt>
                      <c:pt idx="915">
                        <c:v>1</c:v>
                      </c:pt>
                      <c:pt idx="916">
                        <c:v>3</c:v>
                      </c:pt>
                      <c:pt idx="917">
                        <c:v>1</c:v>
                      </c:pt>
                      <c:pt idx="918">
                        <c:v>7</c:v>
                      </c:pt>
                      <c:pt idx="919">
                        <c:v>1</c:v>
                      </c:pt>
                      <c:pt idx="920">
                        <c:v>1</c:v>
                      </c:pt>
                      <c:pt idx="921">
                        <c:v>57</c:v>
                      </c:pt>
                      <c:pt idx="922">
                        <c:v>36</c:v>
                      </c:pt>
                      <c:pt idx="923">
                        <c:v>1</c:v>
                      </c:pt>
                      <c:pt idx="924">
                        <c:v>7</c:v>
                      </c:pt>
                      <c:pt idx="925">
                        <c:v>3</c:v>
                      </c:pt>
                      <c:pt idx="926">
                        <c:v>1</c:v>
                      </c:pt>
                      <c:pt idx="927">
                        <c:v>1</c:v>
                      </c:pt>
                      <c:pt idx="928">
                        <c:v>1</c:v>
                      </c:pt>
                      <c:pt idx="929">
                        <c:v>1</c:v>
                      </c:pt>
                      <c:pt idx="930">
                        <c:v>3</c:v>
                      </c:pt>
                      <c:pt idx="931">
                        <c:v>5</c:v>
                      </c:pt>
                      <c:pt idx="932">
                        <c:v>3</c:v>
                      </c:pt>
                      <c:pt idx="933">
                        <c:v>1</c:v>
                      </c:pt>
                      <c:pt idx="935">
                        <c:v>1</c:v>
                      </c:pt>
                      <c:pt idx="938">
                        <c:v>1</c:v>
                      </c:pt>
                      <c:pt idx="939">
                        <c:v>4</c:v>
                      </c:pt>
                      <c:pt idx="946">
                        <c:v>1</c:v>
                      </c:pt>
                      <c:pt idx="947">
                        <c:v>1</c:v>
                      </c:pt>
                      <c:pt idx="948">
                        <c:v>1</c:v>
                      </c:pt>
                      <c:pt idx="950">
                        <c:v>1</c:v>
                      </c:pt>
                      <c:pt idx="951">
                        <c:v>1</c:v>
                      </c:pt>
                      <c:pt idx="952">
                        <c:v>1</c:v>
                      </c:pt>
                      <c:pt idx="953">
                        <c:v>1</c:v>
                      </c:pt>
                      <c:pt idx="954">
                        <c:v>1</c:v>
                      </c:pt>
                      <c:pt idx="955">
                        <c:v>3</c:v>
                      </c:pt>
                      <c:pt idx="956">
                        <c:v>5</c:v>
                      </c:pt>
                      <c:pt idx="957">
                        <c:v>5</c:v>
                      </c:pt>
                      <c:pt idx="958">
                        <c:v>1</c:v>
                      </c:pt>
                      <c:pt idx="959">
                        <c:v>1</c:v>
                      </c:pt>
                      <c:pt idx="960">
                        <c:v>1</c:v>
                      </c:pt>
                      <c:pt idx="962">
                        <c:v>10</c:v>
                      </c:pt>
                      <c:pt idx="963">
                        <c:v>17</c:v>
                      </c:pt>
                      <c:pt idx="964">
                        <c:v>1</c:v>
                      </c:pt>
                      <c:pt idx="965">
                        <c:v>1</c:v>
                      </c:pt>
                      <c:pt idx="966">
                        <c:v>1</c:v>
                      </c:pt>
                      <c:pt idx="967">
                        <c:v>1</c:v>
                      </c:pt>
                      <c:pt idx="968">
                        <c:v>1</c:v>
                      </c:pt>
                      <c:pt idx="969">
                        <c:v>7</c:v>
                      </c:pt>
                      <c:pt idx="970">
                        <c:v>2</c:v>
                      </c:pt>
                      <c:pt idx="972">
                        <c:v>1</c:v>
                      </c:pt>
                      <c:pt idx="973">
                        <c:v>3</c:v>
                      </c:pt>
                      <c:pt idx="974">
                        <c:v>1</c:v>
                      </c:pt>
                      <c:pt idx="976">
                        <c:v>1</c:v>
                      </c:pt>
                      <c:pt idx="978">
                        <c:v>5</c:v>
                      </c:pt>
                      <c:pt idx="979">
                        <c:v>1</c:v>
                      </c:pt>
                      <c:pt idx="980">
                        <c:v>1</c:v>
                      </c:pt>
                      <c:pt idx="982">
                        <c:v>1</c:v>
                      </c:pt>
                      <c:pt idx="983">
                        <c:v>1</c:v>
                      </c:pt>
                      <c:pt idx="984">
                        <c:v>1</c:v>
                      </c:pt>
                      <c:pt idx="985">
                        <c:v>1</c:v>
                      </c:pt>
                      <c:pt idx="986">
                        <c:v>5</c:v>
                      </c:pt>
                      <c:pt idx="987">
                        <c:v>11</c:v>
                      </c:pt>
                      <c:pt idx="988">
                        <c:v>1</c:v>
                      </c:pt>
                      <c:pt idx="989">
                        <c:v>1</c:v>
                      </c:pt>
                      <c:pt idx="990">
                        <c:v>4</c:v>
                      </c:pt>
                      <c:pt idx="991">
                        <c:v>126</c:v>
                      </c:pt>
                      <c:pt idx="992">
                        <c:v>35</c:v>
                      </c:pt>
                      <c:pt idx="994">
                        <c:v>2</c:v>
                      </c:pt>
                      <c:pt idx="995">
                        <c:v>6</c:v>
                      </c:pt>
                      <c:pt idx="996">
                        <c:v>4</c:v>
                      </c:pt>
                      <c:pt idx="997">
                        <c:v>3</c:v>
                      </c:pt>
                      <c:pt idx="998">
                        <c:v>3</c:v>
                      </c:pt>
                      <c:pt idx="999">
                        <c:v>1</c:v>
                      </c:pt>
                      <c:pt idx="1000">
                        <c:v>3</c:v>
                      </c:pt>
                      <c:pt idx="1001">
                        <c:v>1</c:v>
                      </c:pt>
                      <c:pt idx="1002">
                        <c:v>1</c:v>
                      </c:pt>
                      <c:pt idx="1003">
                        <c:v>2</c:v>
                      </c:pt>
                      <c:pt idx="1004">
                        <c:v>1</c:v>
                      </c:pt>
                      <c:pt idx="1005">
                        <c:v>1</c:v>
                      </c:pt>
                      <c:pt idx="1006">
                        <c:v>3</c:v>
                      </c:pt>
                      <c:pt idx="1007">
                        <c:v>4</c:v>
                      </c:pt>
                      <c:pt idx="1008">
                        <c:v>1</c:v>
                      </c:pt>
                      <c:pt idx="1009">
                        <c:v>3</c:v>
                      </c:pt>
                      <c:pt idx="1010">
                        <c:v>1</c:v>
                      </c:pt>
                      <c:pt idx="1011">
                        <c:v>3</c:v>
                      </c:pt>
                      <c:pt idx="1013">
                        <c:v>1</c:v>
                      </c:pt>
                      <c:pt idx="1018">
                        <c:v>1</c:v>
                      </c:pt>
                      <c:pt idx="1025">
                        <c:v>3</c:v>
                      </c:pt>
                      <c:pt idx="1026">
                        <c:v>3</c:v>
                      </c:pt>
                      <c:pt idx="1028">
                        <c:v>1</c:v>
                      </c:pt>
                      <c:pt idx="1029">
                        <c:v>3</c:v>
                      </c:pt>
                      <c:pt idx="1030">
                        <c:v>2</c:v>
                      </c:pt>
                      <c:pt idx="1045">
                        <c:v>1</c:v>
                      </c:pt>
                      <c:pt idx="1046">
                        <c:v>1</c:v>
                      </c:pt>
                      <c:pt idx="1047">
                        <c:v>1</c:v>
                      </c:pt>
                      <c:pt idx="1048">
                        <c:v>1</c:v>
                      </c:pt>
                      <c:pt idx="1050">
                        <c:v>1</c:v>
                      </c:pt>
                      <c:pt idx="1051">
                        <c:v>1</c:v>
                      </c:pt>
                      <c:pt idx="1052">
                        <c:v>1</c:v>
                      </c:pt>
                      <c:pt idx="1054">
                        <c:v>1</c:v>
                      </c:pt>
                      <c:pt idx="1055">
                        <c:v>1</c:v>
                      </c:pt>
                      <c:pt idx="1056">
                        <c:v>1</c:v>
                      </c:pt>
                    </c:numCache>
                  </c:numRef>
                </c:yVal>
                <c:smooth val="0"/>
              </c15:ser>
            </c15:filteredScatterSeries>
          </c:ext>
        </c:extLst>
      </c:scatterChart>
      <c:valAx>
        <c:axId val="419270080"/>
        <c:scaling>
          <c:orientation val="minMax"/>
          <c:max val="1800"/>
          <c:min val="0"/>
        </c:scaling>
        <c:delete val="0"/>
        <c:axPos val="b"/>
        <c:title>
          <c:tx>
            <c:rich>
              <a:bodyPr rot="0" spcFirstLastPara="1" vertOverflow="ellipsis" vert="horz" wrap="square" anchor="ctr" anchorCtr="1"/>
              <a:lstStyle/>
              <a:p>
                <a:pPr>
                  <a:defRPr sz="800" b="1" i="0" u="none" strike="noStrike" kern="1200" baseline="0">
                    <a:solidFill>
                      <a:schemeClr val="tx1"/>
                    </a:solidFill>
                    <a:latin typeface="+mn-lt"/>
                    <a:ea typeface="+mn-ea"/>
                    <a:cs typeface="+mn-cs"/>
                  </a:defRPr>
                </a:pPr>
                <a:r>
                  <a:rPr lang="en-US" sz="800" b="1">
                    <a:solidFill>
                      <a:schemeClr val="tx1"/>
                    </a:solidFill>
                  </a:rPr>
                  <a:t>cDNA Position</a:t>
                </a:r>
              </a:p>
            </c:rich>
          </c:tx>
          <c:layout/>
          <c:overlay val="0"/>
          <c:spPr>
            <a:noFill/>
            <a:ln>
              <a:noFill/>
            </a:ln>
            <a:effectLst/>
          </c:spPr>
          <c:txPr>
            <a:bodyPr rot="0" spcFirstLastPara="1" vertOverflow="ellipsis" vert="horz" wrap="square" anchor="ctr" anchorCtr="1"/>
            <a:lstStyle/>
            <a:p>
              <a:pPr>
                <a:defRPr sz="800" b="1" i="0" u="none" strike="noStrike" kern="1200" baseline="0">
                  <a:solidFill>
                    <a:schemeClr val="tx1"/>
                  </a:solidFill>
                  <a:latin typeface="+mn-lt"/>
                  <a:ea typeface="+mn-ea"/>
                  <a:cs typeface="+mn-cs"/>
                </a:defRPr>
              </a:pPr>
              <a:endParaRPr lang="en-US"/>
            </a:p>
          </c:txPr>
        </c:title>
        <c:numFmt formatCode="General"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800" b="0" i="0" u="none" strike="noStrike" kern="1200" baseline="0">
                <a:solidFill>
                  <a:schemeClr val="tx1"/>
                </a:solidFill>
                <a:latin typeface="+mn-lt"/>
                <a:ea typeface="+mn-ea"/>
                <a:cs typeface="+mn-cs"/>
              </a:defRPr>
            </a:pPr>
            <a:endParaRPr lang="en-US"/>
          </a:p>
        </c:txPr>
        <c:crossAx val="419270472"/>
        <c:crosses val="autoZero"/>
        <c:crossBetween val="midCat"/>
      </c:valAx>
      <c:valAx>
        <c:axId val="419270472"/>
        <c:scaling>
          <c:orientation val="minMax"/>
        </c:scaling>
        <c:delete val="0"/>
        <c:axPos val="l"/>
        <c:title>
          <c:tx>
            <c:rich>
              <a:bodyPr rot="-5400000" spcFirstLastPara="1" vertOverflow="ellipsis" vert="horz" wrap="square" anchor="ctr" anchorCtr="1"/>
              <a:lstStyle/>
              <a:p>
                <a:pPr>
                  <a:defRPr sz="800" b="1" i="0" u="none" strike="noStrike" kern="1200" baseline="0">
                    <a:solidFill>
                      <a:schemeClr val="tx1"/>
                    </a:solidFill>
                    <a:latin typeface="+mn-lt"/>
                    <a:ea typeface="+mn-ea"/>
                    <a:cs typeface="+mn-cs"/>
                  </a:defRPr>
                </a:pPr>
                <a:r>
                  <a:rPr lang="en-US" sz="800" b="1" dirty="0" smtClean="0">
                    <a:solidFill>
                      <a:schemeClr val="tx1"/>
                    </a:solidFill>
                  </a:rPr>
                  <a:t>PARE Abundance </a:t>
                </a:r>
                <a:r>
                  <a:rPr lang="en-US" sz="800" b="1" dirty="0">
                    <a:solidFill>
                      <a:schemeClr val="tx1"/>
                    </a:solidFill>
                  </a:rPr>
                  <a:t>(TP10M)</a:t>
                </a:r>
              </a:p>
            </c:rich>
          </c:tx>
          <c:layout/>
          <c:overlay val="0"/>
          <c:spPr>
            <a:noFill/>
            <a:ln>
              <a:noFill/>
            </a:ln>
            <a:effectLst/>
          </c:spPr>
          <c:txPr>
            <a:bodyPr rot="-5400000" spcFirstLastPara="1" vertOverflow="ellipsis" vert="horz" wrap="square" anchor="ctr" anchorCtr="1"/>
            <a:lstStyle/>
            <a:p>
              <a:pPr>
                <a:defRPr sz="800" b="1" i="0" u="none" strike="noStrike" kern="1200" baseline="0">
                  <a:solidFill>
                    <a:schemeClr val="tx1"/>
                  </a:solidFill>
                  <a:latin typeface="+mn-lt"/>
                  <a:ea typeface="+mn-ea"/>
                  <a:cs typeface="+mn-cs"/>
                </a:defRPr>
              </a:pPr>
              <a:endParaRPr lang="en-US"/>
            </a:p>
          </c:txPr>
        </c:title>
        <c:numFmt formatCode="General"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800" b="0" i="0" u="none" strike="noStrike" kern="1200" baseline="0">
                <a:solidFill>
                  <a:schemeClr val="tx1"/>
                </a:solidFill>
                <a:latin typeface="+mn-lt"/>
                <a:ea typeface="+mn-ea"/>
                <a:cs typeface="+mn-cs"/>
              </a:defRPr>
            </a:pPr>
            <a:endParaRPr lang="en-US"/>
          </a:p>
        </c:txPr>
        <c:crossAx val="419270080"/>
        <c:crosses val="autoZero"/>
        <c:crossBetween val="midCat"/>
      </c:valAx>
      <c:spPr>
        <a:noFill/>
        <a:ln>
          <a:noFill/>
        </a:ln>
        <a:effectLst/>
      </c:spPr>
    </c:plotArea>
    <c:plotVisOnly val="1"/>
    <c:dispBlanksAs val="gap"/>
    <c:showDLblsOverMax val="0"/>
  </c:chart>
  <c:spPr>
    <a:solidFill>
      <a:schemeClr val="bg1"/>
    </a:solidFill>
    <a:ln w="9525" cap="flat" cmpd="sng" algn="ctr">
      <a:solidFill>
        <a:schemeClr val="tx1"/>
      </a:solidFill>
      <a:round/>
    </a:ln>
    <a:effectLst/>
  </c:spPr>
  <c:txPr>
    <a:bodyPr/>
    <a:lstStyle/>
    <a:p>
      <a:pPr>
        <a:defRPr/>
      </a:pPr>
      <a:endParaRPr lang="en-U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sz="1200"/>
            </a:pPr>
            <a:r>
              <a:rPr lang="en-US" sz="1200" dirty="0" smtClean="0"/>
              <a:t>Control</a:t>
            </a:r>
            <a:endParaRPr lang="en-US" sz="1200" dirty="0"/>
          </a:p>
        </c:rich>
      </c:tx>
      <c:layout/>
      <c:overlay val="0"/>
    </c:title>
    <c:autoTitleDeleted val="0"/>
    <c:plotArea>
      <c:layout/>
      <c:scatterChart>
        <c:scatterStyle val="lineMarker"/>
        <c:varyColors val="0"/>
        <c:ser>
          <c:idx val="0"/>
          <c:order val="0"/>
          <c:tx>
            <c:v>Control1</c:v>
          </c:tx>
          <c:spPr>
            <a:ln w="28575">
              <a:noFill/>
            </a:ln>
          </c:spPr>
          <c:marker>
            <c:symbol val="circle"/>
            <c:size val="5"/>
            <c:spPr>
              <a:solidFill>
                <a:srgbClr val="000000"/>
              </a:solidFill>
              <a:ln w="9525">
                <a:solidFill>
                  <a:srgbClr val="000000"/>
                </a:solidFill>
              </a:ln>
            </c:spPr>
          </c:marker>
          <c:dPt>
            <c:idx val="853"/>
            <c:marker>
              <c:spPr>
                <a:solidFill>
                  <a:srgbClr val="FF0000"/>
                </a:solidFill>
                <a:ln w="9525">
                  <a:solidFill>
                    <a:srgbClr val="FF0000"/>
                  </a:solidFill>
                </a:ln>
              </c:spPr>
            </c:marker>
            <c:bubble3D val="0"/>
          </c:dPt>
          <c:xVal>
            <c:numRef>
              <c:f>'Brachy TIR1'!$B$4:$B$1395</c:f>
              <c:numCache>
                <c:formatCode>General</c:formatCode>
                <c:ptCount val="1392"/>
                <c:pt idx="0">
                  <c:v>1498</c:v>
                </c:pt>
                <c:pt idx="1">
                  <c:v>1908</c:v>
                </c:pt>
                <c:pt idx="2">
                  <c:v>1968</c:v>
                </c:pt>
                <c:pt idx="3">
                  <c:v>2214</c:v>
                </c:pt>
                <c:pt idx="4">
                  <c:v>1946</c:v>
                </c:pt>
                <c:pt idx="5">
                  <c:v>1202</c:v>
                </c:pt>
                <c:pt idx="6">
                  <c:v>2352</c:v>
                </c:pt>
                <c:pt idx="7">
                  <c:v>2393</c:v>
                </c:pt>
                <c:pt idx="8">
                  <c:v>1821</c:v>
                </c:pt>
                <c:pt idx="9">
                  <c:v>1956</c:v>
                </c:pt>
                <c:pt idx="10">
                  <c:v>1017</c:v>
                </c:pt>
                <c:pt idx="11">
                  <c:v>922</c:v>
                </c:pt>
                <c:pt idx="12">
                  <c:v>709</c:v>
                </c:pt>
                <c:pt idx="13">
                  <c:v>2254</c:v>
                </c:pt>
                <c:pt idx="14">
                  <c:v>2359</c:v>
                </c:pt>
                <c:pt idx="15">
                  <c:v>1700</c:v>
                </c:pt>
                <c:pt idx="16">
                  <c:v>1399</c:v>
                </c:pt>
                <c:pt idx="17">
                  <c:v>1200</c:v>
                </c:pt>
                <c:pt idx="18">
                  <c:v>1025</c:v>
                </c:pt>
                <c:pt idx="19">
                  <c:v>2159</c:v>
                </c:pt>
                <c:pt idx="20">
                  <c:v>749</c:v>
                </c:pt>
                <c:pt idx="21">
                  <c:v>2041</c:v>
                </c:pt>
                <c:pt idx="22">
                  <c:v>1500</c:v>
                </c:pt>
                <c:pt idx="23">
                  <c:v>1972</c:v>
                </c:pt>
                <c:pt idx="24">
                  <c:v>474</c:v>
                </c:pt>
                <c:pt idx="25">
                  <c:v>385</c:v>
                </c:pt>
                <c:pt idx="26">
                  <c:v>591</c:v>
                </c:pt>
                <c:pt idx="27">
                  <c:v>1259</c:v>
                </c:pt>
                <c:pt idx="28">
                  <c:v>649</c:v>
                </c:pt>
                <c:pt idx="29">
                  <c:v>2216</c:v>
                </c:pt>
                <c:pt idx="30">
                  <c:v>814</c:v>
                </c:pt>
                <c:pt idx="31">
                  <c:v>1386</c:v>
                </c:pt>
                <c:pt idx="32">
                  <c:v>2426</c:v>
                </c:pt>
                <c:pt idx="33">
                  <c:v>2149</c:v>
                </c:pt>
                <c:pt idx="34">
                  <c:v>1719</c:v>
                </c:pt>
                <c:pt idx="35">
                  <c:v>977</c:v>
                </c:pt>
                <c:pt idx="36">
                  <c:v>1095</c:v>
                </c:pt>
                <c:pt idx="37">
                  <c:v>711</c:v>
                </c:pt>
                <c:pt idx="38">
                  <c:v>619</c:v>
                </c:pt>
                <c:pt idx="39">
                  <c:v>1930</c:v>
                </c:pt>
                <c:pt idx="40">
                  <c:v>884</c:v>
                </c:pt>
                <c:pt idx="41">
                  <c:v>1668</c:v>
                </c:pt>
                <c:pt idx="42">
                  <c:v>1012</c:v>
                </c:pt>
                <c:pt idx="43">
                  <c:v>2143</c:v>
                </c:pt>
                <c:pt idx="44">
                  <c:v>1777</c:v>
                </c:pt>
                <c:pt idx="45">
                  <c:v>2412</c:v>
                </c:pt>
                <c:pt idx="46">
                  <c:v>2061</c:v>
                </c:pt>
                <c:pt idx="47">
                  <c:v>1828</c:v>
                </c:pt>
                <c:pt idx="48">
                  <c:v>141</c:v>
                </c:pt>
                <c:pt idx="49">
                  <c:v>2025</c:v>
                </c:pt>
                <c:pt idx="50">
                  <c:v>1122</c:v>
                </c:pt>
                <c:pt idx="51">
                  <c:v>2411</c:v>
                </c:pt>
                <c:pt idx="52">
                  <c:v>1703</c:v>
                </c:pt>
                <c:pt idx="53">
                  <c:v>2209</c:v>
                </c:pt>
                <c:pt idx="54">
                  <c:v>1796</c:v>
                </c:pt>
                <c:pt idx="55">
                  <c:v>2424</c:v>
                </c:pt>
                <c:pt idx="56">
                  <c:v>2379</c:v>
                </c:pt>
                <c:pt idx="57">
                  <c:v>2212</c:v>
                </c:pt>
                <c:pt idx="58">
                  <c:v>400</c:v>
                </c:pt>
                <c:pt idx="59">
                  <c:v>1529</c:v>
                </c:pt>
                <c:pt idx="60">
                  <c:v>2081</c:v>
                </c:pt>
                <c:pt idx="61">
                  <c:v>877</c:v>
                </c:pt>
                <c:pt idx="62">
                  <c:v>731</c:v>
                </c:pt>
                <c:pt idx="63">
                  <c:v>2324</c:v>
                </c:pt>
                <c:pt idx="64">
                  <c:v>2144</c:v>
                </c:pt>
                <c:pt idx="65">
                  <c:v>1897</c:v>
                </c:pt>
                <c:pt idx="66">
                  <c:v>2138</c:v>
                </c:pt>
                <c:pt idx="67">
                  <c:v>2240</c:v>
                </c:pt>
                <c:pt idx="68">
                  <c:v>865</c:v>
                </c:pt>
                <c:pt idx="69">
                  <c:v>1927</c:v>
                </c:pt>
                <c:pt idx="70">
                  <c:v>2047</c:v>
                </c:pt>
                <c:pt idx="71">
                  <c:v>953</c:v>
                </c:pt>
                <c:pt idx="72">
                  <c:v>771</c:v>
                </c:pt>
                <c:pt idx="73">
                  <c:v>1453</c:v>
                </c:pt>
                <c:pt idx="74">
                  <c:v>561</c:v>
                </c:pt>
                <c:pt idx="75">
                  <c:v>1073</c:v>
                </c:pt>
                <c:pt idx="76">
                  <c:v>1834</c:v>
                </c:pt>
                <c:pt idx="77">
                  <c:v>1165</c:v>
                </c:pt>
                <c:pt idx="78">
                  <c:v>495</c:v>
                </c:pt>
                <c:pt idx="79">
                  <c:v>2281</c:v>
                </c:pt>
                <c:pt idx="80">
                  <c:v>1869</c:v>
                </c:pt>
                <c:pt idx="81">
                  <c:v>713</c:v>
                </c:pt>
                <c:pt idx="82">
                  <c:v>1985</c:v>
                </c:pt>
                <c:pt idx="83">
                  <c:v>2333</c:v>
                </c:pt>
                <c:pt idx="84">
                  <c:v>1947</c:v>
                </c:pt>
                <c:pt idx="85">
                  <c:v>1707</c:v>
                </c:pt>
                <c:pt idx="86">
                  <c:v>1675</c:v>
                </c:pt>
                <c:pt idx="87">
                  <c:v>881</c:v>
                </c:pt>
                <c:pt idx="88">
                  <c:v>1092</c:v>
                </c:pt>
                <c:pt idx="89">
                  <c:v>955</c:v>
                </c:pt>
                <c:pt idx="90">
                  <c:v>1746</c:v>
                </c:pt>
                <c:pt idx="91">
                  <c:v>1647</c:v>
                </c:pt>
                <c:pt idx="92">
                  <c:v>989</c:v>
                </c:pt>
                <c:pt idx="93">
                  <c:v>1680</c:v>
                </c:pt>
                <c:pt idx="94">
                  <c:v>1123</c:v>
                </c:pt>
                <c:pt idx="95">
                  <c:v>1824</c:v>
                </c:pt>
                <c:pt idx="96">
                  <c:v>848</c:v>
                </c:pt>
                <c:pt idx="97">
                  <c:v>621</c:v>
                </c:pt>
                <c:pt idx="98">
                  <c:v>1815</c:v>
                </c:pt>
                <c:pt idx="99">
                  <c:v>2425</c:v>
                </c:pt>
                <c:pt idx="100">
                  <c:v>754</c:v>
                </c:pt>
                <c:pt idx="101">
                  <c:v>2268</c:v>
                </c:pt>
                <c:pt idx="102">
                  <c:v>2315</c:v>
                </c:pt>
                <c:pt idx="103">
                  <c:v>2391</c:v>
                </c:pt>
                <c:pt idx="104">
                  <c:v>1528</c:v>
                </c:pt>
                <c:pt idx="105">
                  <c:v>1893</c:v>
                </c:pt>
                <c:pt idx="106">
                  <c:v>1181</c:v>
                </c:pt>
                <c:pt idx="107">
                  <c:v>2084</c:v>
                </c:pt>
                <c:pt idx="108">
                  <c:v>958</c:v>
                </c:pt>
                <c:pt idx="109">
                  <c:v>2275</c:v>
                </c:pt>
                <c:pt idx="110">
                  <c:v>1806</c:v>
                </c:pt>
                <c:pt idx="111">
                  <c:v>2241</c:v>
                </c:pt>
                <c:pt idx="112">
                  <c:v>1431</c:v>
                </c:pt>
                <c:pt idx="113">
                  <c:v>1532</c:v>
                </c:pt>
                <c:pt idx="114">
                  <c:v>1918</c:v>
                </c:pt>
                <c:pt idx="115">
                  <c:v>2384</c:v>
                </c:pt>
                <c:pt idx="116">
                  <c:v>872</c:v>
                </c:pt>
                <c:pt idx="117">
                  <c:v>1957</c:v>
                </c:pt>
                <c:pt idx="118">
                  <c:v>1541</c:v>
                </c:pt>
                <c:pt idx="119">
                  <c:v>1104</c:v>
                </c:pt>
                <c:pt idx="120">
                  <c:v>2456</c:v>
                </c:pt>
                <c:pt idx="121">
                  <c:v>409</c:v>
                </c:pt>
                <c:pt idx="122">
                  <c:v>1755</c:v>
                </c:pt>
                <c:pt idx="123">
                  <c:v>2444</c:v>
                </c:pt>
                <c:pt idx="124">
                  <c:v>2312</c:v>
                </c:pt>
                <c:pt idx="125">
                  <c:v>891</c:v>
                </c:pt>
                <c:pt idx="126">
                  <c:v>2225</c:v>
                </c:pt>
                <c:pt idx="127">
                  <c:v>1558</c:v>
                </c:pt>
                <c:pt idx="128">
                  <c:v>1192</c:v>
                </c:pt>
                <c:pt idx="129">
                  <c:v>1757</c:v>
                </c:pt>
                <c:pt idx="130">
                  <c:v>684</c:v>
                </c:pt>
                <c:pt idx="131">
                  <c:v>2170</c:v>
                </c:pt>
                <c:pt idx="132">
                  <c:v>1283</c:v>
                </c:pt>
                <c:pt idx="133">
                  <c:v>2264</c:v>
                </c:pt>
                <c:pt idx="134">
                  <c:v>2450</c:v>
                </c:pt>
                <c:pt idx="135">
                  <c:v>680</c:v>
                </c:pt>
                <c:pt idx="136">
                  <c:v>612</c:v>
                </c:pt>
                <c:pt idx="137">
                  <c:v>2397</c:v>
                </c:pt>
                <c:pt idx="138">
                  <c:v>841</c:v>
                </c:pt>
                <c:pt idx="139">
                  <c:v>1971</c:v>
                </c:pt>
                <c:pt idx="140">
                  <c:v>790</c:v>
                </c:pt>
                <c:pt idx="141">
                  <c:v>1858</c:v>
                </c:pt>
                <c:pt idx="142">
                  <c:v>1706</c:v>
                </c:pt>
                <c:pt idx="143">
                  <c:v>1226</c:v>
                </c:pt>
                <c:pt idx="144">
                  <c:v>733</c:v>
                </c:pt>
                <c:pt idx="145">
                  <c:v>1663</c:v>
                </c:pt>
                <c:pt idx="146">
                  <c:v>2313</c:v>
                </c:pt>
                <c:pt idx="147">
                  <c:v>1855</c:v>
                </c:pt>
                <c:pt idx="148">
                  <c:v>807</c:v>
                </c:pt>
                <c:pt idx="149">
                  <c:v>1713</c:v>
                </c:pt>
                <c:pt idx="150">
                  <c:v>1650</c:v>
                </c:pt>
                <c:pt idx="151">
                  <c:v>1623</c:v>
                </c:pt>
                <c:pt idx="152">
                  <c:v>1207</c:v>
                </c:pt>
                <c:pt idx="153">
                  <c:v>669</c:v>
                </c:pt>
                <c:pt idx="154">
                  <c:v>1991</c:v>
                </c:pt>
                <c:pt idx="155">
                  <c:v>1353</c:v>
                </c:pt>
                <c:pt idx="156">
                  <c:v>696</c:v>
                </c:pt>
                <c:pt idx="157">
                  <c:v>815</c:v>
                </c:pt>
                <c:pt idx="158">
                  <c:v>2188</c:v>
                </c:pt>
                <c:pt idx="159">
                  <c:v>1810</c:v>
                </c:pt>
                <c:pt idx="160">
                  <c:v>914</c:v>
                </c:pt>
                <c:pt idx="161">
                  <c:v>1949</c:v>
                </c:pt>
                <c:pt idx="162">
                  <c:v>1546</c:v>
                </c:pt>
                <c:pt idx="163">
                  <c:v>2060</c:v>
                </c:pt>
                <c:pt idx="164">
                  <c:v>1115</c:v>
                </c:pt>
                <c:pt idx="165">
                  <c:v>788</c:v>
                </c:pt>
                <c:pt idx="166">
                  <c:v>699</c:v>
                </c:pt>
                <c:pt idx="167">
                  <c:v>1293</c:v>
                </c:pt>
                <c:pt idx="168">
                  <c:v>1549</c:v>
                </c:pt>
                <c:pt idx="169">
                  <c:v>964</c:v>
                </c:pt>
                <c:pt idx="170">
                  <c:v>742</c:v>
                </c:pt>
                <c:pt idx="171">
                  <c:v>1989</c:v>
                </c:pt>
                <c:pt idx="172">
                  <c:v>2189</c:v>
                </c:pt>
                <c:pt idx="173">
                  <c:v>1605</c:v>
                </c:pt>
                <c:pt idx="174">
                  <c:v>1687</c:v>
                </c:pt>
                <c:pt idx="175">
                  <c:v>2115</c:v>
                </c:pt>
                <c:pt idx="176">
                  <c:v>644</c:v>
                </c:pt>
                <c:pt idx="177">
                  <c:v>1009</c:v>
                </c:pt>
                <c:pt idx="178">
                  <c:v>1584</c:v>
                </c:pt>
                <c:pt idx="179">
                  <c:v>1729</c:v>
                </c:pt>
                <c:pt idx="180">
                  <c:v>1289</c:v>
                </c:pt>
                <c:pt idx="181">
                  <c:v>751</c:v>
                </c:pt>
                <c:pt idx="182">
                  <c:v>2364</c:v>
                </c:pt>
                <c:pt idx="183">
                  <c:v>743</c:v>
                </c:pt>
                <c:pt idx="184">
                  <c:v>875</c:v>
                </c:pt>
                <c:pt idx="185">
                  <c:v>1139</c:v>
                </c:pt>
                <c:pt idx="186">
                  <c:v>869</c:v>
                </c:pt>
                <c:pt idx="187">
                  <c:v>635</c:v>
                </c:pt>
                <c:pt idx="188">
                  <c:v>585</c:v>
                </c:pt>
                <c:pt idx="189">
                  <c:v>1781</c:v>
                </c:pt>
                <c:pt idx="190">
                  <c:v>908</c:v>
                </c:pt>
                <c:pt idx="191">
                  <c:v>1926</c:v>
                </c:pt>
                <c:pt idx="192">
                  <c:v>2113</c:v>
                </c:pt>
                <c:pt idx="193">
                  <c:v>1795</c:v>
                </c:pt>
                <c:pt idx="194">
                  <c:v>1847</c:v>
                </c:pt>
                <c:pt idx="195">
                  <c:v>2338</c:v>
                </c:pt>
                <c:pt idx="196">
                  <c:v>492</c:v>
                </c:pt>
                <c:pt idx="197">
                  <c:v>1677</c:v>
                </c:pt>
                <c:pt idx="198">
                  <c:v>2195</c:v>
                </c:pt>
                <c:pt idx="199">
                  <c:v>567</c:v>
                </c:pt>
                <c:pt idx="200">
                  <c:v>589</c:v>
                </c:pt>
                <c:pt idx="201">
                  <c:v>2156</c:v>
                </c:pt>
                <c:pt idx="202">
                  <c:v>976</c:v>
                </c:pt>
                <c:pt idx="203">
                  <c:v>889</c:v>
                </c:pt>
                <c:pt idx="204">
                  <c:v>1837</c:v>
                </c:pt>
                <c:pt idx="205">
                  <c:v>1588</c:v>
                </c:pt>
                <c:pt idx="206">
                  <c:v>2414</c:v>
                </c:pt>
                <c:pt idx="207">
                  <c:v>924</c:v>
                </c:pt>
                <c:pt idx="208">
                  <c:v>2227</c:v>
                </c:pt>
                <c:pt idx="209">
                  <c:v>1994</c:v>
                </c:pt>
                <c:pt idx="210">
                  <c:v>1888</c:v>
                </c:pt>
                <c:pt idx="211">
                  <c:v>2070</c:v>
                </c:pt>
                <c:pt idx="212">
                  <c:v>2369</c:v>
                </c:pt>
                <c:pt idx="213">
                  <c:v>753</c:v>
                </c:pt>
                <c:pt idx="214">
                  <c:v>2152</c:v>
                </c:pt>
                <c:pt idx="215">
                  <c:v>846</c:v>
                </c:pt>
                <c:pt idx="216">
                  <c:v>718</c:v>
                </c:pt>
                <c:pt idx="217">
                  <c:v>1159</c:v>
                </c:pt>
                <c:pt idx="218">
                  <c:v>1166</c:v>
                </c:pt>
                <c:pt idx="219">
                  <c:v>1688</c:v>
                </c:pt>
                <c:pt idx="220">
                  <c:v>1937</c:v>
                </c:pt>
                <c:pt idx="221">
                  <c:v>1909</c:v>
                </c:pt>
                <c:pt idx="222">
                  <c:v>911</c:v>
                </c:pt>
                <c:pt idx="223">
                  <c:v>2321</c:v>
                </c:pt>
                <c:pt idx="224">
                  <c:v>433</c:v>
                </c:pt>
                <c:pt idx="225">
                  <c:v>970</c:v>
                </c:pt>
                <c:pt idx="226">
                  <c:v>1448</c:v>
                </c:pt>
                <c:pt idx="227">
                  <c:v>1281</c:v>
                </c:pt>
                <c:pt idx="228">
                  <c:v>1664</c:v>
                </c:pt>
                <c:pt idx="229">
                  <c:v>2317</c:v>
                </c:pt>
                <c:pt idx="230">
                  <c:v>1393</c:v>
                </c:pt>
                <c:pt idx="231">
                  <c:v>1099</c:v>
                </c:pt>
                <c:pt idx="232">
                  <c:v>1862</c:v>
                </c:pt>
                <c:pt idx="233">
                  <c:v>2386</c:v>
                </c:pt>
                <c:pt idx="234">
                  <c:v>2173</c:v>
                </c:pt>
                <c:pt idx="235">
                  <c:v>1640</c:v>
                </c:pt>
                <c:pt idx="236">
                  <c:v>540</c:v>
                </c:pt>
                <c:pt idx="237">
                  <c:v>1011</c:v>
                </c:pt>
                <c:pt idx="238">
                  <c:v>1517</c:v>
                </c:pt>
                <c:pt idx="239">
                  <c:v>992</c:v>
                </c:pt>
                <c:pt idx="240">
                  <c:v>1132</c:v>
                </c:pt>
                <c:pt idx="241">
                  <c:v>1762</c:v>
                </c:pt>
                <c:pt idx="242">
                  <c:v>1227</c:v>
                </c:pt>
                <c:pt idx="243">
                  <c:v>1155</c:v>
                </c:pt>
                <c:pt idx="244">
                  <c:v>2204</c:v>
                </c:pt>
                <c:pt idx="245">
                  <c:v>662</c:v>
                </c:pt>
                <c:pt idx="246">
                  <c:v>690</c:v>
                </c:pt>
                <c:pt idx="247">
                  <c:v>1922</c:v>
                </c:pt>
                <c:pt idx="248">
                  <c:v>1485</c:v>
                </c:pt>
                <c:pt idx="249">
                  <c:v>702</c:v>
                </c:pt>
                <c:pt idx="250">
                  <c:v>873</c:v>
                </c:pt>
                <c:pt idx="251">
                  <c:v>827</c:v>
                </c:pt>
                <c:pt idx="252">
                  <c:v>1980</c:v>
                </c:pt>
                <c:pt idx="253">
                  <c:v>677</c:v>
                </c:pt>
                <c:pt idx="254">
                  <c:v>2339</c:v>
                </c:pt>
                <c:pt idx="255">
                  <c:v>2290</c:v>
                </c:pt>
                <c:pt idx="256">
                  <c:v>2246</c:v>
                </c:pt>
                <c:pt idx="257">
                  <c:v>1506</c:v>
                </c:pt>
                <c:pt idx="258">
                  <c:v>833</c:v>
                </c:pt>
                <c:pt idx="259">
                  <c:v>2345</c:v>
                </c:pt>
                <c:pt idx="260">
                  <c:v>1036</c:v>
                </c:pt>
                <c:pt idx="261">
                  <c:v>1902</c:v>
                </c:pt>
                <c:pt idx="262">
                  <c:v>1853</c:v>
                </c:pt>
                <c:pt idx="263">
                  <c:v>2126</c:v>
                </c:pt>
                <c:pt idx="264">
                  <c:v>68</c:v>
                </c:pt>
                <c:pt idx="265">
                  <c:v>736</c:v>
                </c:pt>
                <c:pt idx="266">
                  <c:v>2172</c:v>
                </c:pt>
                <c:pt idx="267">
                  <c:v>426</c:v>
                </c:pt>
                <c:pt idx="268">
                  <c:v>2153</c:v>
                </c:pt>
                <c:pt idx="269">
                  <c:v>2446</c:v>
                </c:pt>
                <c:pt idx="270">
                  <c:v>836</c:v>
                </c:pt>
                <c:pt idx="271">
                  <c:v>1794</c:v>
                </c:pt>
                <c:pt idx="272">
                  <c:v>2100</c:v>
                </c:pt>
                <c:pt idx="273">
                  <c:v>579</c:v>
                </c:pt>
                <c:pt idx="274">
                  <c:v>1468</c:v>
                </c:pt>
                <c:pt idx="275">
                  <c:v>1720</c:v>
                </c:pt>
                <c:pt idx="276">
                  <c:v>2200</c:v>
                </c:pt>
                <c:pt idx="277">
                  <c:v>965</c:v>
                </c:pt>
                <c:pt idx="278">
                  <c:v>1307</c:v>
                </c:pt>
                <c:pt idx="279">
                  <c:v>765</c:v>
                </c:pt>
                <c:pt idx="280">
                  <c:v>2420</c:v>
                </c:pt>
                <c:pt idx="281">
                  <c:v>1615</c:v>
                </c:pt>
                <c:pt idx="282">
                  <c:v>622</c:v>
                </c:pt>
                <c:pt idx="283">
                  <c:v>2094</c:v>
                </c:pt>
                <c:pt idx="284">
                  <c:v>2097</c:v>
                </c:pt>
                <c:pt idx="285">
                  <c:v>2236</c:v>
                </c:pt>
                <c:pt idx="286">
                  <c:v>1064</c:v>
                </c:pt>
                <c:pt idx="287">
                  <c:v>1896</c:v>
                </c:pt>
                <c:pt idx="288">
                  <c:v>1807</c:v>
                </c:pt>
                <c:pt idx="289">
                  <c:v>2415</c:v>
                </c:pt>
                <c:pt idx="290">
                  <c:v>2316</c:v>
                </c:pt>
                <c:pt idx="291">
                  <c:v>1313</c:v>
                </c:pt>
                <c:pt idx="292">
                  <c:v>1247</c:v>
                </c:pt>
                <c:pt idx="293">
                  <c:v>2179</c:v>
                </c:pt>
                <c:pt idx="294">
                  <c:v>862</c:v>
                </c:pt>
                <c:pt idx="295">
                  <c:v>1833</c:v>
                </c:pt>
                <c:pt idx="296">
                  <c:v>805</c:v>
                </c:pt>
                <c:pt idx="297">
                  <c:v>2297</c:v>
                </c:pt>
                <c:pt idx="298">
                  <c:v>424</c:v>
                </c:pt>
                <c:pt idx="299">
                  <c:v>1679</c:v>
                </c:pt>
                <c:pt idx="300">
                  <c:v>981</c:v>
                </c:pt>
                <c:pt idx="301">
                  <c:v>415</c:v>
                </c:pt>
                <c:pt idx="302">
                  <c:v>982</c:v>
                </c:pt>
                <c:pt idx="303">
                  <c:v>1811</c:v>
                </c:pt>
                <c:pt idx="304">
                  <c:v>2272</c:v>
                </c:pt>
                <c:pt idx="305">
                  <c:v>1716</c:v>
                </c:pt>
                <c:pt idx="306">
                  <c:v>2105</c:v>
                </c:pt>
                <c:pt idx="307">
                  <c:v>1499</c:v>
                </c:pt>
                <c:pt idx="308">
                  <c:v>2266</c:v>
                </c:pt>
                <c:pt idx="309">
                  <c:v>1157</c:v>
                </c:pt>
                <c:pt idx="310">
                  <c:v>1337</c:v>
                </c:pt>
                <c:pt idx="311">
                  <c:v>2184</c:v>
                </c:pt>
                <c:pt idx="312">
                  <c:v>1579</c:v>
                </c:pt>
                <c:pt idx="313">
                  <c:v>2341</c:v>
                </c:pt>
                <c:pt idx="314">
                  <c:v>1120</c:v>
                </c:pt>
                <c:pt idx="315">
                  <c:v>1315</c:v>
                </c:pt>
                <c:pt idx="316">
                  <c:v>1257</c:v>
                </c:pt>
                <c:pt idx="317">
                  <c:v>1548</c:v>
                </c:pt>
                <c:pt idx="318">
                  <c:v>1028</c:v>
                </c:pt>
                <c:pt idx="319">
                  <c:v>377</c:v>
                </c:pt>
                <c:pt idx="320">
                  <c:v>888</c:v>
                </c:pt>
                <c:pt idx="321">
                  <c:v>1371</c:v>
                </c:pt>
                <c:pt idx="322">
                  <c:v>979</c:v>
                </c:pt>
                <c:pt idx="323">
                  <c:v>2040</c:v>
                </c:pt>
                <c:pt idx="324">
                  <c:v>2076</c:v>
                </c:pt>
                <c:pt idx="325">
                  <c:v>2251</c:v>
                </c:pt>
                <c:pt idx="326">
                  <c:v>2322</c:v>
                </c:pt>
                <c:pt idx="327">
                  <c:v>1180</c:v>
                </c:pt>
                <c:pt idx="328">
                  <c:v>1648</c:v>
                </c:pt>
                <c:pt idx="329">
                  <c:v>764</c:v>
                </c:pt>
                <c:pt idx="330">
                  <c:v>2306</c:v>
                </c:pt>
                <c:pt idx="331">
                  <c:v>1715</c:v>
                </c:pt>
                <c:pt idx="332">
                  <c:v>648</c:v>
                </c:pt>
                <c:pt idx="333">
                  <c:v>1981</c:v>
                </c:pt>
                <c:pt idx="334">
                  <c:v>1620</c:v>
                </c:pt>
                <c:pt idx="335">
                  <c:v>1782</c:v>
                </c:pt>
                <c:pt idx="336">
                  <c:v>708</c:v>
                </c:pt>
                <c:pt idx="337">
                  <c:v>2074</c:v>
                </c:pt>
                <c:pt idx="338">
                  <c:v>575</c:v>
                </c:pt>
                <c:pt idx="339">
                  <c:v>2284</c:v>
                </c:pt>
                <c:pt idx="340">
                  <c:v>1019</c:v>
                </c:pt>
                <c:pt idx="341">
                  <c:v>1024</c:v>
                </c:pt>
                <c:pt idx="342">
                  <c:v>1429</c:v>
                </c:pt>
                <c:pt idx="343">
                  <c:v>1831</c:v>
                </c:pt>
                <c:pt idx="344">
                  <c:v>1471</c:v>
                </c:pt>
                <c:pt idx="345">
                  <c:v>2343</c:v>
                </c:pt>
                <c:pt idx="346">
                  <c:v>1632</c:v>
                </c:pt>
                <c:pt idx="347">
                  <c:v>766</c:v>
                </c:pt>
                <c:pt idx="348">
                  <c:v>642</c:v>
                </c:pt>
                <c:pt idx="349">
                  <c:v>651</c:v>
                </c:pt>
                <c:pt idx="350">
                  <c:v>1232</c:v>
                </c:pt>
                <c:pt idx="351">
                  <c:v>574</c:v>
                </c:pt>
                <c:pt idx="352">
                  <c:v>939</c:v>
                </c:pt>
                <c:pt idx="353">
                  <c:v>2080</c:v>
                </c:pt>
                <c:pt idx="354">
                  <c:v>1887</c:v>
                </c:pt>
                <c:pt idx="355">
                  <c:v>1778</c:v>
                </c:pt>
                <c:pt idx="356">
                  <c:v>1015</c:v>
                </c:pt>
                <c:pt idx="357">
                  <c:v>1182</c:v>
                </c:pt>
                <c:pt idx="358">
                  <c:v>2265</c:v>
                </c:pt>
                <c:pt idx="359">
                  <c:v>730</c:v>
                </c:pt>
                <c:pt idx="360">
                  <c:v>2367</c:v>
                </c:pt>
                <c:pt idx="361">
                  <c:v>483</c:v>
                </c:pt>
                <c:pt idx="362">
                  <c:v>1137</c:v>
                </c:pt>
                <c:pt idx="363">
                  <c:v>1661</c:v>
                </c:pt>
                <c:pt idx="364">
                  <c:v>1424</c:v>
                </c:pt>
                <c:pt idx="365">
                  <c:v>2229</c:v>
                </c:pt>
                <c:pt idx="366">
                  <c:v>950</c:v>
                </c:pt>
                <c:pt idx="367">
                  <c:v>1183</c:v>
                </c:pt>
                <c:pt idx="368">
                  <c:v>562</c:v>
                </c:pt>
                <c:pt idx="369">
                  <c:v>1951</c:v>
                </c:pt>
                <c:pt idx="370">
                  <c:v>630</c:v>
                </c:pt>
                <c:pt idx="371">
                  <c:v>2449</c:v>
                </c:pt>
                <c:pt idx="372">
                  <c:v>1243</c:v>
                </c:pt>
                <c:pt idx="373">
                  <c:v>1721</c:v>
                </c:pt>
                <c:pt idx="374">
                  <c:v>2440</c:v>
                </c:pt>
                <c:pt idx="375">
                  <c:v>2191</c:v>
                </c:pt>
                <c:pt idx="376">
                  <c:v>1596</c:v>
                </c:pt>
                <c:pt idx="377">
                  <c:v>2044</c:v>
                </c:pt>
                <c:pt idx="378">
                  <c:v>1984</c:v>
                </c:pt>
                <c:pt idx="379">
                  <c:v>2215</c:v>
                </c:pt>
                <c:pt idx="380">
                  <c:v>1140</c:v>
                </c:pt>
                <c:pt idx="381">
                  <c:v>1300</c:v>
                </c:pt>
                <c:pt idx="382">
                  <c:v>902</c:v>
                </c:pt>
                <c:pt idx="383">
                  <c:v>1409</c:v>
                </c:pt>
                <c:pt idx="384">
                  <c:v>2154</c:v>
                </c:pt>
                <c:pt idx="385">
                  <c:v>2107</c:v>
                </c:pt>
                <c:pt idx="386">
                  <c:v>568</c:v>
                </c:pt>
                <c:pt idx="387">
                  <c:v>2394</c:v>
                </c:pt>
                <c:pt idx="388">
                  <c:v>2178</c:v>
                </c:pt>
                <c:pt idx="389">
                  <c:v>2270</c:v>
                </c:pt>
                <c:pt idx="390">
                  <c:v>987</c:v>
                </c:pt>
                <c:pt idx="391">
                  <c:v>543</c:v>
                </c:pt>
                <c:pt idx="392">
                  <c:v>1903</c:v>
                </c:pt>
                <c:pt idx="393">
                  <c:v>1022</c:v>
                </c:pt>
                <c:pt idx="394">
                  <c:v>2447</c:v>
                </c:pt>
                <c:pt idx="395">
                  <c:v>855</c:v>
                </c:pt>
                <c:pt idx="396">
                  <c:v>2309</c:v>
                </c:pt>
                <c:pt idx="397">
                  <c:v>522</c:v>
                </c:pt>
                <c:pt idx="398">
                  <c:v>1051</c:v>
                </c:pt>
                <c:pt idx="399">
                  <c:v>1952</c:v>
                </c:pt>
                <c:pt idx="400">
                  <c:v>843</c:v>
                </c:pt>
                <c:pt idx="401">
                  <c:v>695</c:v>
                </c:pt>
                <c:pt idx="402">
                  <c:v>772</c:v>
                </c:pt>
                <c:pt idx="403">
                  <c:v>1163</c:v>
                </c:pt>
                <c:pt idx="404">
                  <c:v>2299</c:v>
                </c:pt>
                <c:pt idx="405">
                  <c:v>960</c:v>
                </c:pt>
                <c:pt idx="406">
                  <c:v>1449</c:v>
                </c:pt>
                <c:pt idx="407">
                  <c:v>1484</c:v>
                </c:pt>
                <c:pt idx="408">
                  <c:v>2134</c:v>
                </c:pt>
                <c:pt idx="409">
                  <c:v>1682</c:v>
                </c:pt>
                <c:pt idx="410">
                  <c:v>1235</c:v>
                </c:pt>
                <c:pt idx="411">
                  <c:v>1859</c:v>
                </c:pt>
                <c:pt idx="412">
                  <c:v>434</c:v>
                </c:pt>
                <c:pt idx="413">
                  <c:v>1966</c:v>
                </c:pt>
                <c:pt idx="414">
                  <c:v>1860</c:v>
                </c:pt>
                <c:pt idx="415">
                  <c:v>2161</c:v>
                </c:pt>
                <c:pt idx="416">
                  <c:v>2436</c:v>
                </c:pt>
                <c:pt idx="417">
                  <c:v>1763</c:v>
                </c:pt>
                <c:pt idx="418">
                  <c:v>1007</c:v>
                </c:pt>
                <c:pt idx="419">
                  <c:v>1136</c:v>
                </c:pt>
                <c:pt idx="420">
                  <c:v>1309</c:v>
                </c:pt>
                <c:pt idx="421">
                  <c:v>1236</c:v>
                </c:pt>
                <c:pt idx="422">
                  <c:v>2211</c:v>
                </c:pt>
                <c:pt idx="423">
                  <c:v>1153</c:v>
                </c:pt>
                <c:pt idx="424">
                  <c:v>813</c:v>
                </c:pt>
                <c:pt idx="425">
                  <c:v>1245</c:v>
                </c:pt>
                <c:pt idx="426">
                  <c:v>615</c:v>
                </c:pt>
                <c:pt idx="427">
                  <c:v>1962</c:v>
                </c:pt>
                <c:pt idx="428">
                  <c:v>2259</c:v>
                </c:pt>
                <c:pt idx="429">
                  <c:v>1920</c:v>
                </c:pt>
                <c:pt idx="430">
                  <c:v>1614</c:v>
                </c:pt>
                <c:pt idx="431">
                  <c:v>756</c:v>
                </c:pt>
                <c:pt idx="432">
                  <c:v>1002</c:v>
                </c:pt>
                <c:pt idx="433">
                  <c:v>683</c:v>
                </c:pt>
                <c:pt idx="434">
                  <c:v>2382</c:v>
                </c:pt>
                <c:pt idx="435">
                  <c:v>1037</c:v>
                </c:pt>
                <c:pt idx="436">
                  <c:v>1739</c:v>
                </c:pt>
                <c:pt idx="437">
                  <c:v>1255</c:v>
                </c:pt>
                <c:pt idx="438">
                  <c:v>1681</c:v>
                </c:pt>
                <c:pt idx="439">
                  <c:v>1852</c:v>
                </c:pt>
                <c:pt idx="440">
                  <c:v>2164</c:v>
                </c:pt>
                <c:pt idx="441">
                  <c:v>878</c:v>
                </c:pt>
                <c:pt idx="442">
                  <c:v>1557</c:v>
                </c:pt>
                <c:pt idx="443">
                  <c:v>2045</c:v>
                </c:pt>
                <c:pt idx="444">
                  <c:v>1000</c:v>
                </c:pt>
                <c:pt idx="445">
                  <c:v>2396</c:v>
                </c:pt>
                <c:pt idx="446">
                  <c:v>1045</c:v>
                </c:pt>
                <c:pt idx="447">
                  <c:v>717</c:v>
                </c:pt>
                <c:pt idx="448">
                  <c:v>2443</c:v>
                </c:pt>
                <c:pt idx="449">
                  <c:v>747</c:v>
                </c:pt>
                <c:pt idx="450">
                  <c:v>2078</c:v>
                </c:pt>
                <c:pt idx="451">
                  <c:v>1490</c:v>
                </c:pt>
                <c:pt idx="452">
                  <c:v>2402</c:v>
                </c:pt>
                <c:pt idx="453">
                  <c:v>2282</c:v>
                </c:pt>
                <c:pt idx="454">
                  <c:v>935</c:v>
                </c:pt>
                <c:pt idx="455">
                  <c:v>2305</c:v>
                </c:pt>
                <c:pt idx="456">
                  <c:v>1624</c:v>
                </c:pt>
                <c:pt idx="457">
                  <c:v>735</c:v>
                </c:pt>
                <c:pt idx="458">
                  <c:v>1868</c:v>
                </c:pt>
                <c:pt idx="459">
                  <c:v>2073</c:v>
                </c:pt>
                <c:pt idx="460">
                  <c:v>2072</c:v>
                </c:pt>
                <c:pt idx="461">
                  <c:v>1494</c:v>
                </c:pt>
                <c:pt idx="462">
                  <c:v>750</c:v>
                </c:pt>
                <c:pt idx="463">
                  <c:v>1665</c:v>
                </c:pt>
                <c:pt idx="464">
                  <c:v>1779</c:v>
                </c:pt>
                <c:pt idx="465">
                  <c:v>1925</c:v>
                </c:pt>
                <c:pt idx="466">
                  <c:v>1803</c:v>
                </c:pt>
                <c:pt idx="467">
                  <c:v>2293</c:v>
                </c:pt>
                <c:pt idx="468">
                  <c:v>2329</c:v>
                </c:pt>
                <c:pt idx="469">
                  <c:v>1161</c:v>
                </c:pt>
                <c:pt idx="470">
                  <c:v>1863</c:v>
                </c:pt>
                <c:pt idx="471">
                  <c:v>2261</c:v>
                </c:pt>
                <c:pt idx="472">
                  <c:v>666</c:v>
                </c:pt>
                <c:pt idx="473">
                  <c:v>1735</c:v>
                </c:pt>
                <c:pt idx="474">
                  <c:v>604</c:v>
                </c:pt>
                <c:pt idx="475">
                  <c:v>931</c:v>
                </c:pt>
                <c:pt idx="476">
                  <c:v>1753</c:v>
                </c:pt>
                <c:pt idx="477">
                  <c:v>1469</c:v>
                </c:pt>
                <c:pt idx="478">
                  <c:v>2064</c:v>
                </c:pt>
                <c:pt idx="479">
                  <c:v>971</c:v>
                </c:pt>
                <c:pt idx="480">
                  <c:v>1953</c:v>
                </c:pt>
                <c:pt idx="481">
                  <c:v>1270</c:v>
                </c:pt>
                <c:pt idx="482">
                  <c:v>734</c:v>
                </c:pt>
                <c:pt idx="483">
                  <c:v>1610</c:v>
                </c:pt>
                <c:pt idx="484">
                  <c:v>2365</c:v>
                </c:pt>
                <c:pt idx="485">
                  <c:v>1077</c:v>
                </c:pt>
                <c:pt idx="486">
                  <c:v>900</c:v>
                </c:pt>
                <c:pt idx="487">
                  <c:v>1109</c:v>
                </c:pt>
                <c:pt idx="488">
                  <c:v>1876</c:v>
                </c:pt>
                <c:pt idx="489">
                  <c:v>1861</c:v>
                </c:pt>
                <c:pt idx="490">
                  <c:v>720</c:v>
                </c:pt>
                <c:pt idx="491">
                  <c:v>2279</c:v>
                </c:pt>
                <c:pt idx="492">
                  <c:v>1671</c:v>
                </c:pt>
                <c:pt idx="493">
                  <c:v>1760</c:v>
                </c:pt>
                <c:pt idx="494">
                  <c:v>1986</c:v>
                </c:pt>
                <c:pt idx="495">
                  <c:v>1607</c:v>
                </c:pt>
                <c:pt idx="496">
                  <c:v>752</c:v>
                </c:pt>
                <c:pt idx="497">
                  <c:v>1818</c:v>
                </c:pt>
                <c:pt idx="498">
                  <c:v>1083</c:v>
                </c:pt>
                <c:pt idx="499">
                  <c:v>1135</c:v>
                </c:pt>
                <c:pt idx="500">
                  <c:v>2118</c:v>
                </c:pt>
                <c:pt idx="501">
                  <c:v>990</c:v>
                </c:pt>
                <c:pt idx="502">
                  <c:v>1827</c:v>
                </c:pt>
                <c:pt idx="503">
                  <c:v>1929</c:v>
                </c:pt>
                <c:pt idx="504">
                  <c:v>2192</c:v>
                </c:pt>
                <c:pt idx="505">
                  <c:v>2000</c:v>
                </c:pt>
                <c:pt idx="506">
                  <c:v>2111</c:v>
                </c:pt>
                <c:pt idx="507">
                  <c:v>1602</c:v>
                </c:pt>
                <c:pt idx="508">
                  <c:v>2400</c:v>
                </c:pt>
                <c:pt idx="509">
                  <c:v>1997</c:v>
                </c:pt>
                <c:pt idx="510">
                  <c:v>633</c:v>
                </c:pt>
                <c:pt idx="511">
                  <c:v>1578</c:v>
                </c:pt>
                <c:pt idx="512">
                  <c:v>91</c:v>
                </c:pt>
                <c:pt idx="513">
                  <c:v>1416</c:v>
                </c:pt>
                <c:pt idx="514">
                  <c:v>1151</c:v>
                </c:pt>
                <c:pt idx="515">
                  <c:v>1773</c:v>
                </c:pt>
                <c:pt idx="516">
                  <c:v>1723</c:v>
                </c:pt>
                <c:pt idx="517">
                  <c:v>1332</c:v>
                </c:pt>
                <c:pt idx="518">
                  <c:v>739</c:v>
                </c:pt>
                <c:pt idx="519">
                  <c:v>532</c:v>
                </c:pt>
                <c:pt idx="520">
                  <c:v>863</c:v>
                </c:pt>
                <c:pt idx="521">
                  <c:v>1776</c:v>
                </c:pt>
                <c:pt idx="522">
                  <c:v>2171</c:v>
                </c:pt>
                <c:pt idx="523">
                  <c:v>2403</c:v>
                </c:pt>
                <c:pt idx="524">
                  <c:v>916</c:v>
                </c:pt>
                <c:pt idx="525">
                  <c:v>1395</c:v>
                </c:pt>
                <c:pt idx="526">
                  <c:v>1547</c:v>
                </c:pt>
                <c:pt idx="527">
                  <c:v>986</c:v>
                </c:pt>
                <c:pt idx="528">
                  <c:v>2277</c:v>
                </c:pt>
                <c:pt idx="529">
                  <c:v>1826</c:v>
                </c:pt>
                <c:pt idx="530">
                  <c:v>961</c:v>
                </c:pt>
                <c:pt idx="531">
                  <c:v>1977</c:v>
                </c:pt>
                <c:pt idx="532">
                  <c:v>1561</c:v>
                </c:pt>
                <c:pt idx="533">
                  <c:v>1328</c:v>
                </c:pt>
                <c:pt idx="534">
                  <c:v>1822</c:v>
                </c:pt>
                <c:pt idx="535">
                  <c:v>838</c:v>
                </c:pt>
                <c:pt idx="536">
                  <c:v>610</c:v>
                </c:pt>
                <c:pt idx="537">
                  <c:v>2086</c:v>
                </c:pt>
                <c:pt idx="538">
                  <c:v>1088</c:v>
                </c:pt>
                <c:pt idx="539">
                  <c:v>1138</c:v>
                </c:pt>
                <c:pt idx="540">
                  <c:v>1992</c:v>
                </c:pt>
                <c:pt idx="541">
                  <c:v>1268</c:v>
                </c:pt>
                <c:pt idx="542">
                  <c:v>2387</c:v>
                </c:pt>
                <c:pt idx="543">
                  <c:v>2059</c:v>
                </c:pt>
                <c:pt idx="544">
                  <c:v>2334</c:v>
                </c:pt>
                <c:pt idx="545">
                  <c:v>1692</c:v>
                </c:pt>
                <c:pt idx="546">
                  <c:v>837</c:v>
                </c:pt>
                <c:pt idx="547">
                  <c:v>1747</c:v>
                </c:pt>
                <c:pt idx="548">
                  <c:v>893</c:v>
                </c:pt>
                <c:pt idx="549">
                  <c:v>692</c:v>
                </c:pt>
                <c:pt idx="550">
                  <c:v>1091</c:v>
                </c:pt>
                <c:pt idx="551">
                  <c:v>1057</c:v>
                </c:pt>
                <c:pt idx="552">
                  <c:v>2007</c:v>
                </c:pt>
                <c:pt idx="553">
                  <c:v>2009</c:v>
                </c:pt>
                <c:pt idx="554">
                  <c:v>566</c:v>
                </c:pt>
                <c:pt idx="555">
                  <c:v>2148</c:v>
                </c:pt>
                <c:pt idx="556">
                  <c:v>714</c:v>
                </c:pt>
                <c:pt idx="557">
                  <c:v>2055</c:v>
                </c:pt>
                <c:pt idx="558">
                  <c:v>1804</c:v>
                </c:pt>
                <c:pt idx="559">
                  <c:v>2308</c:v>
                </c:pt>
                <c:pt idx="560">
                  <c:v>806</c:v>
                </c:pt>
                <c:pt idx="561">
                  <c:v>2237</c:v>
                </c:pt>
                <c:pt idx="562">
                  <c:v>1204</c:v>
                </c:pt>
                <c:pt idx="563">
                  <c:v>1737</c:v>
                </c:pt>
                <c:pt idx="564">
                  <c:v>828</c:v>
                </c:pt>
                <c:pt idx="565">
                  <c:v>839</c:v>
                </c:pt>
                <c:pt idx="566">
                  <c:v>2123</c:v>
                </c:pt>
                <c:pt idx="567">
                  <c:v>732</c:v>
                </c:pt>
                <c:pt idx="568">
                  <c:v>698</c:v>
                </c:pt>
                <c:pt idx="569">
                  <c:v>1761</c:v>
                </c:pt>
                <c:pt idx="570">
                  <c:v>1178</c:v>
                </c:pt>
                <c:pt idx="571">
                  <c:v>1874</c:v>
                </c:pt>
                <c:pt idx="572">
                  <c:v>1001</c:v>
                </c:pt>
                <c:pt idx="573">
                  <c:v>1303</c:v>
                </c:pt>
                <c:pt idx="574">
                  <c:v>829</c:v>
                </c:pt>
                <c:pt idx="575">
                  <c:v>681</c:v>
                </c:pt>
                <c:pt idx="576">
                  <c:v>808</c:v>
                </c:pt>
                <c:pt idx="577">
                  <c:v>1790</c:v>
                </c:pt>
                <c:pt idx="578">
                  <c:v>825</c:v>
                </c:pt>
                <c:pt idx="579">
                  <c:v>1114</c:v>
                </c:pt>
                <c:pt idx="580">
                  <c:v>1892</c:v>
                </c:pt>
                <c:pt idx="581">
                  <c:v>675</c:v>
                </c:pt>
                <c:pt idx="582">
                  <c:v>1841</c:v>
                </c:pt>
                <c:pt idx="583">
                  <c:v>2066</c:v>
                </c:pt>
                <c:pt idx="584">
                  <c:v>1635</c:v>
                </c:pt>
                <c:pt idx="585">
                  <c:v>826</c:v>
                </c:pt>
                <c:pt idx="586">
                  <c:v>2346</c:v>
                </c:pt>
                <c:pt idx="587">
                  <c:v>2220</c:v>
                </c:pt>
                <c:pt idx="588">
                  <c:v>1504</c:v>
                </c:pt>
                <c:pt idx="589">
                  <c:v>2090</c:v>
                </c:pt>
                <c:pt idx="590">
                  <c:v>852</c:v>
                </c:pt>
                <c:pt idx="591">
                  <c:v>456</c:v>
                </c:pt>
                <c:pt idx="592">
                  <c:v>2098</c:v>
                </c:pt>
                <c:pt idx="593">
                  <c:v>2238</c:v>
                </c:pt>
                <c:pt idx="594">
                  <c:v>963</c:v>
                </c:pt>
                <c:pt idx="595">
                  <c:v>1856</c:v>
                </c:pt>
                <c:pt idx="596">
                  <c:v>1162</c:v>
                </c:pt>
                <c:pt idx="597">
                  <c:v>600</c:v>
                </c:pt>
                <c:pt idx="598">
                  <c:v>2110</c:v>
                </c:pt>
                <c:pt idx="599">
                  <c:v>1993</c:v>
                </c:pt>
                <c:pt idx="600">
                  <c:v>1443</c:v>
                </c:pt>
                <c:pt idx="601">
                  <c:v>1631</c:v>
                </c:pt>
                <c:pt idx="602">
                  <c:v>2177</c:v>
                </c:pt>
                <c:pt idx="603">
                  <c:v>1840</c:v>
                </c:pt>
                <c:pt idx="604">
                  <c:v>1008</c:v>
                </c:pt>
                <c:pt idx="605">
                  <c:v>2418</c:v>
                </c:pt>
                <c:pt idx="606">
                  <c:v>421</c:v>
                </c:pt>
                <c:pt idx="607">
                  <c:v>2079</c:v>
                </c:pt>
                <c:pt idx="608">
                  <c:v>1710</c:v>
                </c:pt>
                <c:pt idx="609">
                  <c:v>2083</c:v>
                </c:pt>
                <c:pt idx="610">
                  <c:v>623</c:v>
                </c:pt>
                <c:pt idx="611">
                  <c:v>2021</c:v>
                </c:pt>
                <c:pt idx="612">
                  <c:v>525</c:v>
                </c:pt>
                <c:pt idx="613">
                  <c:v>2361</c:v>
                </c:pt>
                <c:pt idx="614">
                  <c:v>1103</c:v>
                </c:pt>
                <c:pt idx="615">
                  <c:v>1916</c:v>
                </c:pt>
                <c:pt idx="616">
                  <c:v>2182</c:v>
                </c:pt>
                <c:pt idx="617">
                  <c:v>1041</c:v>
                </c:pt>
                <c:pt idx="618">
                  <c:v>654</c:v>
                </c:pt>
                <c:pt idx="619">
                  <c:v>1342</c:v>
                </c:pt>
                <c:pt idx="620">
                  <c:v>2092</c:v>
                </c:pt>
                <c:pt idx="621">
                  <c:v>1066</c:v>
                </c:pt>
                <c:pt idx="622">
                  <c:v>904</c:v>
                </c:pt>
                <c:pt idx="623">
                  <c:v>1141</c:v>
                </c:pt>
                <c:pt idx="624">
                  <c:v>2157</c:v>
                </c:pt>
                <c:pt idx="625">
                  <c:v>906</c:v>
                </c:pt>
                <c:pt idx="626">
                  <c:v>1983</c:v>
                </c:pt>
                <c:pt idx="627">
                  <c:v>999</c:v>
                </c:pt>
                <c:pt idx="628">
                  <c:v>2106</c:v>
                </c:pt>
                <c:pt idx="629">
                  <c:v>2454</c:v>
                </c:pt>
                <c:pt idx="630">
                  <c:v>1208</c:v>
                </c:pt>
                <c:pt idx="631">
                  <c:v>1539</c:v>
                </c:pt>
                <c:pt idx="632">
                  <c:v>1205</c:v>
                </c:pt>
                <c:pt idx="633">
                  <c:v>1190</c:v>
                </c:pt>
                <c:pt idx="634">
                  <c:v>501</c:v>
                </c:pt>
                <c:pt idx="635">
                  <c:v>2187</c:v>
                </c:pt>
                <c:pt idx="636">
                  <c:v>32</c:v>
                </c:pt>
                <c:pt idx="637">
                  <c:v>859</c:v>
                </c:pt>
                <c:pt idx="638">
                  <c:v>973</c:v>
                </c:pt>
                <c:pt idx="639">
                  <c:v>1142</c:v>
                </c:pt>
                <c:pt idx="640">
                  <c:v>974</c:v>
                </c:pt>
                <c:pt idx="641">
                  <c:v>1260</c:v>
                </c:pt>
                <c:pt idx="642">
                  <c:v>2427</c:v>
                </c:pt>
                <c:pt idx="643">
                  <c:v>1160</c:v>
                </c:pt>
                <c:pt idx="644">
                  <c:v>930</c:v>
                </c:pt>
                <c:pt idx="645">
                  <c:v>2202</c:v>
                </c:pt>
                <c:pt idx="646">
                  <c:v>687</c:v>
                </c:pt>
                <c:pt idx="647">
                  <c:v>1264</c:v>
                </c:pt>
                <c:pt idx="648">
                  <c:v>820</c:v>
                </c:pt>
                <c:pt idx="649">
                  <c:v>1895</c:v>
                </c:pt>
                <c:pt idx="650">
                  <c:v>330</c:v>
                </c:pt>
                <c:pt idx="651">
                  <c:v>583</c:v>
                </c:pt>
                <c:pt idx="652">
                  <c:v>966</c:v>
                </c:pt>
                <c:pt idx="653">
                  <c:v>1249</c:v>
                </c:pt>
                <c:pt idx="654">
                  <c:v>2125</c:v>
                </c:pt>
                <c:pt idx="655">
                  <c:v>784</c:v>
                </c:pt>
                <c:pt idx="656">
                  <c:v>842</c:v>
                </c:pt>
                <c:pt idx="657">
                  <c:v>1819</c:v>
                </c:pt>
                <c:pt idx="658">
                  <c:v>760</c:v>
                </c:pt>
                <c:pt idx="659">
                  <c:v>1974</c:v>
                </c:pt>
                <c:pt idx="660">
                  <c:v>678</c:v>
                </c:pt>
                <c:pt idx="661">
                  <c:v>991</c:v>
                </c:pt>
                <c:pt idx="662">
                  <c:v>834</c:v>
                </c:pt>
                <c:pt idx="663">
                  <c:v>1642</c:v>
                </c:pt>
                <c:pt idx="664">
                  <c:v>2168</c:v>
                </c:pt>
                <c:pt idx="665">
                  <c:v>1279</c:v>
                </c:pt>
                <c:pt idx="666">
                  <c:v>1411</c:v>
                </c:pt>
                <c:pt idx="667">
                  <c:v>1573</c:v>
                </c:pt>
                <c:pt idx="668">
                  <c:v>2366</c:v>
                </c:pt>
                <c:pt idx="669">
                  <c:v>2158</c:v>
                </c:pt>
                <c:pt idx="670">
                  <c:v>811</c:v>
                </c:pt>
                <c:pt idx="671">
                  <c:v>2380</c:v>
                </c:pt>
                <c:pt idx="672">
                  <c:v>1347</c:v>
                </c:pt>
                <c:pt idx="673">
                  <c:v>975</c:v>
                </c:pt>
                <c:pt idx="674">
                  <c:v>2002</c:v>
                </c:pt>
                <c:pt idx="675">
                  <c:v>2124</c:v>
                </c:pt>
                <c:pt idx="676">
                  <c:v>2208</c:v>
                </c:pt>
                <c:pt idx="677">
                  <c:v>932</c:v>
                </c:pt>
                <c:pt idx="678">
                  <c:v>2196</c:v>
                </c:pt>
                <c:pt idx="679">
                  <c:v>1792</c:v>
                </c:pt>
                <c:pt idx="680">
                  <c:v>1789</c:v>
                </c:pt>
                <c:pt idx="681">
                  <c:v>2337</c:v>
                </c:pt>
                <c:pt idx="682">
                  <c:v>2058</c:v>
                </c:pt>
                <c:pt idx="683">
                  <c:v>928</c:v>
                </c:pt>
                <c:pt idx="684">
                  <c:v>1890</c:v>
                </c:pt>
                <c:pt idx="685">
                  <c:v>980</c:v>
                </c:pt>
                <c:pt idx="686">
                  <c:v>1998</c:v>
                </c:pt>
                <c:pt idx="687">
                  <c:v>704</c:v>
                </c:pt>
                <c:pt idx="688">
                  <c:v>1195</c:v>
                </c:pt>
                <c:pt idx="689">
                  <c:v>1460</c:v>
                </c:pt>
                <c:pt idx="690">
                  <c:v>1201</c:v>
                </c:pt>
                <c:pt idx="691">
                  <c:v>1988</c:v>
                </c:pt>
                <c:pt idx="692">
                  <c:v>1764</c:v>
                </c:pt>
                <c:pt idx="693">
                  <c:v>2307</c:v>
                </c:pt>
                <c:pt idx="694">
                  <c:v>885</c:v>
                </c:pt>
                <c:pt idx="695">
                  <c:v>1275</c:v>
                </c:pt>
                <c:pt idx="696">
                  <c:v>689</c:v>
                </c:pt>
                <c:pt idx="697">
                  <c:v>1774</c:v>
                </c:pt>
                <c:pt idx="698">
                  <c:v>1805</c:v>
                </c:pt>
                <c:pt idx="699">
                  <c:v>1669</c:v>
                </c:pt>
                <c:pt idx="700">
                  <c:v>1432</c:v>
                </c:pt>
                <c:pt idx="701">
                  <c:v>1754</c:v>
                </c:pt>
                <c:pt idx="702">
                  <c:v>954</c:v>
                </c:pt>
                <c:pt idx="703">
                  <c:v>887</c:v>
                </c:pt>
                <c:pt idx="704">
                  <c:v>694</c:v>
                </c:pt>
                <c:pt idx="705">
                  <c:v>2353</c:v>
                </c:pt>
                <c:pt idx="706">
                  <c:v>956</c:v>
                </c:pt>
                <c:pt idx="707">
                  <c:v>488</c:v>
                </c:pt>
                <c:pt idx="708">
                  <c:v>912</c:v>
                </c:pt>
                <c:pt idx="709">
                  <c:v>2089</c:v>
                </c:pt>
                <c:pt idx="710">
                  <c:v>2163</c:v>
                </c:pt>
                <c:pt idx="711">
                  <c:v>897</c:v>
                </c:pt>
                <c:pt idx="712">
                  <c:v>2302</c:v>
                </c:pt>
                <c:pt idx="713">
                  <c:v>2036</c:v>
                </c:pt>
                <c:pt idx="714">
                  <c:v>1843</c:v>
                </c:pt>
                <c:pt idx="715">
                  <c:v>1428</c:v>
                </c:pt>
                <c:pt idx="716">
                  <c:v>2395</c:v>
                </c:pt>
                <c:pt idx="717">
                  <c:v>2077</c:v>
                </c:pt>
                <c:pt idx="718">
                  <c:v>2012</c:v>
                </c:pt>
                <c:pt idx="719">
                  <c:v>1058</c:v>
                </c:pt>
                <c:pt idx="720">
                  <c:v>1105</c:v>
                </c:pt>
                <c:pt idx="721">
                  <c:v>1383</c:v>
                </c:pt>
                <c:pt idx="722">
                  <c:v>1365</c:v>
                </c:pt>
                <c:pt idx="723">
                  <c:v>2169</c:v>
                </c:pt>
                <c:pt idx="724">
                  <c:v>1210</c:v>
                </c:pt>
                <c:pt idx="725">
                  <c:v>1456</c:v>
                </c:pt>
                <c:pt idx="726">
                  <c:v>2230</c:v>
                </c:pt>
                <c:pt idx="727">
                  <c:v>1133</c:v>
                </c:pt>
                <c:pt idx="728">
                  <c:v>2193</c:v>
                </c:pt>
                <c:pt idx="729">
                  <c:v>1344</c:v>
                </c:pt>
                <c:pt idx="730">
                  <c:v>2421</c:v>
                </c:pt>
                <c:pt idx="731">
                  <c:v>1939</c:v>
                </c:pt>
                <c:pt idx="732">
                  <c:v>1525</c:v>
                </c:pt>
                <c:pt idx="733">
                  <c:v>2455</c:v>
                </c:pt>
                <c:pt idx="734">
                  <c:v>1717</c:v>
                </c:pt>
                <c:pt idx="735">
                  <c:v>1373</c:v>
                </c:pt>
                <c:pt idx="736">
                  <c:v>700</c:v>
                </c:pt>
                <c:pt idx="737">
                  <c:v>1600</c:v>
                </c:pt>
                <c:pt idx="738">
                  <c:v>52</c:v>
                </c:pt>
                <c:pt idx="739">
                  <c:v>2197</c:v>
                </c:pt>
                <c:pt idx="740">
                  <c:v>822</c:v>
                </c:pt>
                <c:pt idx="741">
                  <c:v>1102</c:v>
                </c:pt>
                <c:pt idx="742">
                  <c:v>1976</c:v>
                </c:pt>
                <c:pt idx="743">
                  <c:v>1527</c:v>
                </c:pt>
                <c:pt idx="744">
                  <c:v>1112</c:v>
                </c:pt>
                <c:pt idx="745">
                  <c:v>816</c:v>
                </c:pt>
                <c:pt idx="746">
                  <c:v>2043</c:v>
                </c:pt>
                <c:pt idx="747">
                  <c:v>1052</c:v>
                </c:pt>
                <c:pt idx="748">
                  <c:v>1089</c:v>
                </c:pt>
                <c:pt idx="749">
                  <c:v>1727</c:v>
                </c:pt>
                <c:pt idx="750">
                  <c:v>1080</c:v>
                </c:pt>
                <c:pt idx="751">
                  <c:v>671</c:v>
                </c:pt>
                <c:pt idx="752">
                  <c:v>1213</c:v>
                </c:pt>
                <c:pt idx="753">
                  <c:v>2295</c:v>
                </c:pt>
                <c:pt idx="754">
                  <c:v>2258</c:v>
                </c:pt>
                <c:pt idx="755">
                  <c:v>867</c:v>
                </c:pt>
                <c:pt idx="756">
                  <c:v>348</c:v>
                </c:pt>
                <c:pt idx="757">
                  <c:v>818</c:v>
                </c:pt>
                <c:pt idx="758">
                  <c:v>1101</c:v>
                </c:pt>
                <c:pt idx="759">
                  <c:v>1107</c:v>
                </c:pt>
                <c:pt idx="760">
                  <c:v>2096</c:v>
                </c:pt>
                <c:pt idx="761">
                  <c:v>1967</c:v>
                </c:pt>
                <c:pt idx="762">
                  <c:v>1744</c:v>
                </c:pt>
                <c:pt idx="763">
                  <c:v>1873</c:v>
                </c:pt>
                <c:pt idx="764">
                  <c:v>2128</c:v>
                </c:pt>
                <c:pt idx="765">
                  <c:v>2419</c:v>
                </c:pt>
                <c:pt idx="766">
                  <c:v>719</c:v>
                </c:pt>
                <c:pt idx="767">
                  <c:v>1693</c:v>
                </c:pt>
                <c:pt idx="768">
                  <c:v>2020</c:v>
                </c:pt>
                <c:pt idx="769">
                  <c:v>907</c:v>
                </c:pt>
                <c:pt idx="770">
                  <c:v>2342</c:v>
                </c:pt>
                <c:pt idx="771">
                  <c:v>1026</c:v>
                </c:pt>
                <c:pt idx="772">
                  <c:v>1225</c:v>
                </c:pt>
                <c:pt idx="773">
                  <c:v>1147</c:v>
                </c:pt>
                <c:pt idx="774">
                  <c:v>360</c:v>
                </c:pt>
                <c:pt idx="775">
                  <c:v>1536</c:v>
                </c:pt>
                <c:pt idx="776">
                  <c:v>1748</c:v>
                </c:pt>
                <c:pt idx="777">
                  <c:v>594</c:v>
                </c:pt>
                <c:pt idx="778">
                  <c:v>2218</c:v>
                </c:pt>
                <c:pt idx="779">
                  <c:v>2263</c:v>
                </c:pt>
                <c:pt idx="780">
                  <c:v>1597</c:v>
                </c:pt>
                <c:pt idx="781">
                  <c:v>716</c:v>
                </c:pt>
                <c:pt idx="782">
                  <c:v>2174</c:v>
                </c:pt>
                <c:pt idx="783">
                  <c:v>1038</c:v>
                </c:pt>
                <c:pt idx="784">
                  <c:v>2175</c:v>
                </c:pt>
                <c:pt idx="785">
                  <c:v>949</c:v>
                </c:pt>
                <c:pt idx="786">
                  <c:v>925</c:v>
                </c:pt>
                <c:pt idx="787">
                  <c:v>2448</c:v>
                </c:pt>
                <c:pt idx="788">
                  <c:v>1537</c:v>
                </c:pt>
                <c:pt idx="789">
                  <c:v>2296</c:v>
                </c:pt>
                <c:pt idx="790">
                  <c:v>1248</c:v>
                </c:pt>
                <c:pt idx="791">
                  <c:v>186</c:v>
                </c:pt>
                <c:pt idx="792">
                  <c:v>569</c:v>
                </c:pt>
                <c:pt idx="793">
                  <c:v>1305</c:v>
                </c:pt>
                <c:pt idx="794">
                  <c:v>905</c:v>
                </c:pt>
                <c:pt idx="795">
                  <c:v>1905</c:v>
                </c:pt>
                <c:pt idx="796">
                  <c:v>2335</c:v>
                </c:pt>
                <c:pt idx="797">
                  <c:v>2147</c:v>
                </c:pt>
                <c:pt idx="798">
                  <c:v>2052</c:v>
                </c:pt>
                <c:pt idx="799">
                  <c:v>2372</c:v>
                </c:pt>
                <c:pt idx="800">
                  <c:v>1618</c:v>
                </c:pt>
                <c:pt idx="801">
                  <c:v>879</c:v>
                </c:pt>
                <c:pt idx="802">
                  <c:v>670</c:v>
                </c:pt>
                <c:pt idx="803">
                  <c:v>1334</c:v>
                </c:pt>
                <c:pt idx="804">
                  <c:v>2318</c:v>
                </c:pt>
                <c:pt idx="805">
                  <c:v>2016</c:v>
                </c:pt>
                <c:pt idx="806">
                  <c:v>2283</c:v>
                </c:pt>
                <c:pt idx="807">
                  <c:v>2136</c:v>
                </c:pt>
                <c:pt idx="808">
                  <c:v>947</c:v>
                </c:pt>
                <c:pt idx="809">
                  <c:v>1454</c:v>
                </c:pt>
                <c:pt idx="810">
                  <c:v>1302</c:v>
                </c:pt>
                <c:pt idx="811">
                  <c:v>535</c:v>
                </c:pt>
                <c:pt idx="812">
                  <c:v>1370</c:v>
                </c:pt>
                <c:pt idx="813">
                  <c:v>2438</c:v>
                </c:pt>
                <c:pt idx="814">
                  <c:v>824</c:v>
                </c:pt>
                <c:pt idx="815">
                  <c:v>1593</c:v>
                </c:pt>
                <c:pt idx="816">
                  <c:v>647</c:v>
                </c:pt>
                <c:pt idx="817">
                  <c:v>988</c:v>
                </c:pt>
                <c:pt idx="818">
                  <c:v>636</c:v>
                </c:pt>
                <c:pt idx="819">
                  <c:v>1975</c:v>
                </c:pt>
                <c:pt idx="820">
                  <c:v>1656</c:v>
                </c:pt>
                <c:pt idx="821">
                  <c:v>2183</c:v>
                </c:pt>
                <c:pt idx="822">
                  <c:v>1973</c:v>
                </c:pt>
                <c:pt idx="823">
                  <c:v>2101</c:v>
                </c:pt>
                <c:pt idx="824">
                  <c:v>1799</c:v>
                </c:pt>
                <c:pt idx="825">
                  <c:v>1969</c:v>
                </c:pt>
                <c:pt idx="826">
                  <c:v>2151</c:v>
                </c:pt>
                <c:pt idx="827">
                  <c:v>2135</c:v>
                </c:pt>
                <c:pt idx="828">
                  <c:v>1832</c:v>
                </c:pt>
                <c:pt idx="829">
                  <c:v>1486</c:v>
                </c:pt>
                <c:pt idx="830">
                  <c:v>1311</c:v>
                </c:pt>
                <c:pt idx="831">
                  <c:v>1251</c:v>
                </c:pt>
                <c:pt idx="832">
                  <c:v>1621</c:v>
                </c:pt>
                <c:pt idx="833">
                  <c:v>1292</c:v>
                </c:pt>
                <c:pt idx="834">
                  <c:v>2160</c:v>
                </c:pt>
                <c:pt idx="835">
                  <c:v>1263</c:v>
                </c:pt>
                <c:pt idx="836">
                  <c:v>2300</c:v>
                </c:pt>
                <c:pt idx="837">
                  <c:v>2383</c:v>
                </c:pt>
                <c:pt idx="838">
                  <c:v>847</c:v>
                </c:pt>
                <c:pt idx="839">
                  <c:v>1959</c:v>
                </c:pt>
                <c:pt idx="840">
                  <c:v>2253</c:v>
                </c:pt>
                <c:pt idx="841">
                  <c:v>2332</c:v>
                </c:pt>
                <c:pt idx="842">
                  <c:v>1254</c:v>
                </c:pt>
                <c:pt idx="843">
                  <c:v>608</c:v>
                </c:pt>
                <c:pt idx="844">
                  <c:v>1524</c:v>
                </c:pt>
                <c:pt idx="845">
                  <c:v>2354</c:v>
                </c:pt>
                <c:pt idx="846">
                  <c:v>657</c:v>
                </c:pt>
                <c:pt idx="847">
                  <c:v>2437</c:v>
                </c:pt>
                <c:pt idx="848">
                  <c:v>2249</c:v>
                </c:pt>
                <c:pt idx="849">
                  <c:v>2413</c:v>
                </c:pt>
                <c:pt idx="850">
                  <c:v>1825</c:v>
                </c:pt>
                <c:pt idx="851">
                  <c:v>2129</c:v>
                </c:pt>
                <c:pt idx="852">
                  <c:v>2331</c:v>
                </c:pt>
                <c:pt idx="853">
                  <c:v>1787</c:v>
                </c:pt>
                <c:pt idx="854">
                  <c:v>1676</c:v>
                </c:pt>
                <c:pt idx="855">
                  <c:v>2217</c:v>
                </c:pt>
                <c:pt idx="856">
                  <c:v>1276</c:v>
                </c:pt>
                <c:pt idx="857">
                  <c:v>946</c:v>
                </c:pt>
                <c:pt idx="858">
                  <c:v>2360</c:v>
                </c:pt>
                <c:pt idx="859">
                  <c:v>929</c:v>
                </c:pt>
                <c:pt idx="860">
                  <c:v>978</c:v>
                </c:pt>
                <c:pt idx="861">
                  <c:v>962</c:v>
                </c:pt>
                <c:pt idx="862">
                  <c:v>1412</c:v>
                </c:pt>
                <c:pt idx="863">
                  <c:v>578</c:v>
                </c:pt>
                <c:pt idx="864">
                  <c:v>1312</c:v>
                </c:pt>
                <c:pt idx="865">
                  <c:v>763</c:v>
                </c:pt>
                <c:pt idx="866">
                  <c:v>896</c:v>
                </c:pt>
                <c:pt idx="867">
                  <c:v>1594</c:v>
                </c:pt>
                <c:pt idx="868">
                  <c:v>1684</c:v>
                </c:pt>
                <c:pt idx="869">
                  <c:v>1100</c:v>
                </c:pt>
                <c:pt idx="870">
                  <c:v>1093</c:v>
                </c:pt>
                <c:pt idx="871">
                  <c:v>2141</c:v>
                </c:pt>
                <c:pt idx="872">
                  <c:v>2137</c:v>
                </c:pt>
                <c:pt idx="873">
                  <c:v>2451</c:v>
                </c:pt>
                <c:pt idx="874">
                  <c:v>1143</c:v>
                </c:pt>
                <c:pt idx="875">
                  <c:v>1686</c:v>
                </c:pt>
                <c:pt idx="876">
                  <c:v>1780</c:v>
                </c:pt>
                <c:pt idx="877">
                  <c:v>2226</c:v>
                </c:pt>
                <c:pt idx="878">
                  <c:v>2336</c:v>
                </c:pt>
                <c:pt idx="879">
                  <c:v>2326</c:v>
                </c:pt>
                <c:pt idx="880">
                  <c:v>1231</c:v>
                </c:pt>
                <c:pt idx="881">
                  <c:v>1830</c:v>
                </c:pt>
                <c:pt idx="882">
                  <c:v>2292</c:v>
                </c:pt>
                <c:pt idx="883">
                  <c:v>2067</c:v>
                </c:pt>
                <c:pt idx="884">
                  <c:v>1152</c:v>
                </c:pt>
                <c:pt idx="885">
                  <c:v>1964</c:v>
                </c:pt>
                <c:pt idx="886">
                  <c:v>2146</c:v>
                </c:pt>
                <c:pt idx="887">
                  <c:v>1595</c:v>
                </c:pt>
                <c:pt idx="888">
                  <c:v>2001</c:v>
                </c:pt>
                <c:pt idx="889">
                  <c:v>1702</c:v>
                </c:pt>
                <c:pt idx="890">
                  <c:v>1845</c:v>
                </c:pt>
                <c:pt idx="891">
                  <c:v>1505</c:v>
                </c:pt>
                <c:pt idx="892">
                  <c:v>2356</c:v>
                </c:pt>
                <c:pt idx="893">
                  <c:v>938</c:v>
                </c:pt>
                <c:pt idx="894">
                  <c:v>2210</c:v>
                </c:pt>
                <c:pt idx="895">
                  <c:v>609</c:v>
                </c:pt>
                <c:pt idx="896">
                  <c:v>2087</c:v>
                </c:pt>
                <c:pt idx="897">
                  <c:v>1944</c:v>
                </c:pt>
                <c:pt idx="898">
                  <c:v>2417</c:v>
                </c:pt>
                <c:pt idx="899">
                  <c:v>1613</c:v>
                </c:pt>
                <c:pt idx="900">
                  <c:v>626</c:v>
                </c:pt>
                <c:pt idx="901">
                  <c:v>1698</c:v>
                </c:pt>
                <c:pt idx="902">
                  <c:v>1534</c:v>
                </c:pt>
                <c:pt idx="903">
                  <c:v>1198</c:v>
                </c:pt>
                <c:pt idx="904">
                  <c:v>1788</c:v>
                </c:pt>
                <c:pt idx="905">
                  <c:v>2207</c:v>
                </c:pt>
                <c:pt idx="906">
                  <c:v>2286</c:v>
                </c:pt>
                <c:pt idx="907">
                  <c:v>1940</c:v>
                </c:pt>
                <c:pt idx="908">
                  <c:v>1696</c:v>
                </c:pt>
                <c:pt idx="909">
                  <c:v>2285</c:v>
                </c:pt>
                <c:pt idx="910">
                  <c:v>712</c:v>
                </c:pt>
                <c:pt idx="911">
                  <c:v>705</c:v>
                </c:pt>
                <c:pt idx="912">
                  <c:v>1864</c:v>
                </c:pt>
                <c:pt idx="913">
                  <c:v>727</c:v>
                </c:pt>
                <c:pt idx="914">
                  <c:v>1559</c:v>
                </c:pt>
                <c:pt idx="915">
                  <c:v>2127</c:v>
                </c:pt>
                <c:pt idx="916">
                  <c:v>2042</c:v>
                </c:pt>
                <c:pt idx="917">
                  <c:v>664</c:v>
                </c:pt>
                <c:pt idx="918">
                  <c:v>2057</c:v>
                </c:pt>
                <c:pt idx="919">
                  <c:v>1945</c:v>
                </c:pt>
                <c:pt idx="920">
                  <c:v>741</c:v>
                </c:pt>
                <c:pt idx="921">
                  <c:v>1269</c:v>
                </c:pt>
                <c:pt idx="922">
                  <c:v>613</c:v>
                </c:pt>
                <c:pt idx="923">
                  <c:v>2269</c:v>
                </c:pt>
                <c:pt idx="924">
                  <c:v>1689</c:v>
                </c:pt>
                <c:pt idx="925">
                  <c:v>2273</c:v>
                </c:pt>
                <c:pt idx="926">
                  <c:v>1320</c:v>
                </c:pt>
                <c:pt idx="927">
                  <c:v>942</c:v>
                </c:pt>
                <c:pt idx="928">
                  <c:v>2349</c:v>
                </c:pt>
                <c:pt idx="929">
                  <c:v>1639</c:v>
                </c:pt>
                <c:pt idx="930">
                  <c:v>2039</c:v>
                </c:pt>
                <c:pt idx="931">
                  <c:v>757</c:v>
                </c:pt>
                <c:pt idx="932">
                  <c:v>676</c:v>
                </c:pt>
                <c:pt idx="933">
                  <c:v>1545</c:v>
                </c:pt>
                <c:pt idx="934">
                  <c:v>2122</c:v>
                </c:pt>
                <c:pt idx="935">
                  <c:v>1948</c:v>
                </c:pt>
                <c:pt idx="936">
                  <c:v>1865</c:v>
                </c:pt>
                <c:pt idx="937">
                  <c:v>724</c:v>
                </c:pt>
                <c:pt idx="938">
                  <c:v>1463</c:v>
                </c:pt>
                <c:pt idx="939">
                  <c:v>1206</c:v>
                </c:pt>
                <c:pt idx="940">
                  <c:v>1278</c:v>
                </c:pt>
                <c:pt idx="941">
                  <c:v>1848</c:v>
                </c:pt>
                <c:pt idx="942">
                  <c:v>899</c:v>
                </c:pt>
                <c:pt idx="943">
                  <c:v>777</c:v>
                </c:pt>
                <c:pt idx="944">
                  <c:v>1851</c:v>
                </c:pt>
                <c:pt idx="945">
                  <c:v>2320</c:v>
                </c:pt>
                <c:pt idx="946">
                  <c:v>590</c:v>
                </c:pt>
                <c:pt idx="947">
                  <c:v>2085</c:v>
                </c:pt>
                <c:pt idx="948">
                  <c:v>2166</c:v>
                </c:pt>
                <c:pt idx="949">
                  <c:v>1839</c:v>
                </c:pt>
                <c:pt idx="950">
                  <c:v>913</c:v>
                </c:pt>
                <c:pt idx="951">
                  <c:v>1149</c:v>
                </c:pt>
                <c:pt idx="952">
                  <c:v>526</c:v>
                </c:pt>
                <c:pt idx="953">
                  <c:v>2381</c:v>
                </c:pt>
                <c:pt idx="954">
                  <c:v>1425</c:v>
                </c:pt>
                <c:pt idx="955">
                  <c:v>2102</c:v>
                </c:pt>
                <c:pt idx="956">
                  <c:v>2399</c:v>
                </c:pt>
                <c:pt idx="957">
                  <c:v>1148</c:v>
                </c:pt>
                <c:pt idx="958">
                  <c:v>1601</c:v>
                </c:pt>
                <c:pt idx="959">
                  <c:v>595</c:v>
                </c:pt>
                <c:pt idx="960">
                  <c:v>1406</c:v>
                </c:pt>
                <c:pt idx="961">
                  <c:v>1619</c:v>
                </c:pt>
                <c:pt idx="962">
                  <c:v>2186</c:v>
                </c:pt>
                <c:pt idx="963">
                  <c:v>1108</c:v>
                </c:pt>
                <c:pt idx="964">
                  <c:v>2327</c:v>
                </c:pt>
                <c:pt idx="965">
                  <c:v>1158</c:v>
                </c:pt>
                <c:pt idx="966">
                  <c:v>890</c:v>
                </c:pt>
                <c:pt idx="967">
                  <c:v>1872</c:v>
                </c:pt>
                <c:pt idx="968">
                  <c:v>1070</c:v>
                </c:pt>
                <c:pt idx="969">
                  <c:v>1772</c:v>
                </c:pt>
                <c:pt idx="970">
                  <c:v>632</c:v>
                </c:pt>
                <c:pt idx="971">
                  <c:v>564</c:v>
                </c:pt>
                <c:pt idx="972">
                  <c:v>1685</c:v>
                </c:pt>
                <c:pt idx="973">
                  <c:v>1301</c:v>
                </c:pt>
                <c:pt idx="974">
                  <c:v>2198</c:v>
                </c:pt>
                <c:pt idx="975">
                  <c:v>810</c:v>
                </c:pt>
                <c:pt idx="976">
                  <c:v>1990</c:v>
                </c:pt>
                <c:pt idx="977">
                  <c:v>2311</c:v>
                </c:pt>
                <c:pt idx="978">
                  <c:v>710</c:v>
                </c:pt>
                <c:pt idx="979">
                  <c:v>605</c:v>
                </c:pt>
                <c:pt idx="980">
                  <c:v>2180</c:v>
                </c:pt>
                <c:pt idx="981">
                  <c:v>1267</c:v>
                </c:pt>
                <c:pt idx="982">
                  <c:v>1435</c:v>
                </c:pt>
                <c:pt idx="983">
                  <c:v>1552</c:v>
                </c:pt>
                <c:pt idx="984">
                  <c:v>740</c:v>
                </c:pt>
                <c:pt idx="985">
                  <c:v>1466</c:v>
                </c:pt>
                <c:pt idx="986">
                  <c:v>1094</c:v>
                </c:pt>
                <c:pt idx="987">
                  <c:v>860</c:v>
                </c:pt>
                <c:pt idx="988">
                  <c:v>1447</c:v>
                </c:pt>
                <c:pt idx="989">
                  <c:v>2262</c:v>
                </c:pt>
                <c:pt idx="990">
                  <c:v>2340</c:v>
                </c:pt>
                <c:pt idx="991">
                  <c:v>1769</c:v>
                </c:pt>
                <c:pt idx="992">
                  <c:v>556</c:v>
                </c:pt>
                <c:pt idx="993">
                  <c:v>1743</c:v>
                </c:pt>
                <c:pt idx="994">
                  <c:v>1110</c:v>
                </c:pt>
                <c:pt idx="995">
                  <c:v>1995</c:v>
                </c:pt>
                <c:pt idx="996">
                  <c:v>1193</c:v>
                </c:pt>
                <c:pt idx="997">
                  <c:v>1350</c:v>
                </c:pt>
                <c:pt idx="998">
                  <c:v>2388</c:v>
                </c:pt>
                <c:pt idx="999">
                  <c:v>1330</c:v>
                </c:pt>
                <c:pt idx="1000">
                  <c:v>2213</c:v>
                </c:pt>
                <c:pt idx="1001">
                  <c:v>2010</c:v>
                </c:pt>
                <c:pt idx="1002">
                  <c:v>1465</c:v>
                </c:pt>
                <c:pt idx="1003">
                  <c:v>1238</c:v>
                </c:pt>
                <c:pt idx="1004">
                  <c:v>2280</c:v>
                </c:pt>
                <c:pt idx="1005">
                  <c:v>2205</c:v>
                </c:pt>
                <c:pt idx="1006">
                  <c:v>844</c:v>
                </c:pt>
                <c:pt idx="1007">
                  <c:v>995</c:v>
                </c:pt>
                <c:pt idx="1008">
                  <c:v>926</c:v>
                </c:pt>
                <c:pt idx="1009">
                  <c:v>2298</c:v>
                </c:pt>
                <c:pt idx="1010">
                  <c:v>762</c:v>
                </c:pt>
                <c:pt idx="1011">
                  <c:v>691</c:v>
                </c:pt>
                <c:pt idx="1012">
                  <c:v>2398</c:v>
                </c:pt>
                <c:pt idx="1013">
                  <c:v>1730</c:v>
                </c:pt>
                <c:pt idx="1014">
                  <c:v>1987</c:v>
                </c:pt>
                <c:pt idx="1015">
                  <c:v>2276</c:v>
                </c:pt>
                <c:pt idx="1016">
                  <c:v>607</c:v>
                </c:pt>
                <c:pt idx="1017">
                  <c:v>2278</c:v>
                </c:pt>
                <c:pt idx="1018">
                  <c:v>857</c:v>
                </c:pt>
                <c:pt idx="1019">
                  <c:v>2053</c:v>
                </c:pt>
                <c:pt idx="1020">
                  <c:v>2222</c:v>
                </c:pt>
                <c:pt idx="1021">
                  <c:v>616</c:v>
                </c:pt>
                <c:pt idx="1022">
                  <c:v>1793</c:v>
                </c:pt>
                <c:pt idx="1023">
                  <c:v>2232</c:v>
                </c:pt>
                <c:pt idx="1024">
                  <c:v>972</c:v>
                </c:pt>
                <c:pt idx="1025">
                  <c:v>994</c:v>
                </c:pt>
                <c:pt idx="1026">
                  <c:v>1752</c:v>
                </c:pt>
                <c:pt idx="1027">
                  <c:v>1511</c:v>
                </c:pt>
                <c:pt idx="1028">
                  <c:v>845</c:v>
                </c:pt>
                <c:pt idx="1029">
                  <c:v>2319</c:v>
                </c:pt>
                <c:pt idx="1030">
                  <c:v>703</c:v>
                </c:pt>
                <c:pt idx="1031">
                  <c:v>2190</c:v>
                </c:pt>
                <c:pt idx="1032">
                  <c:v>2114</c:v>
                </c:pt>
                <c:pt idx="1033">
                  <c:v>744</c:v>
                </c:pt>
                <c:pt idx="1034">
                  <c:v>2167</c:v>
                </c:pt>
                <c:pt idx="1035">
                  <c:v>1489</c:v>
                </c:pt>
                <c:pt idx="1036">
                  <c:v>2035</c:v>
                </c:pt>
                <c:pt idx="1037">
                  <c:v>2015</c:v>
                </c:pt>
                <c:pt idx="1038">
                  <c:v>706</c:v>
                </c:pt>
                <c:pt idx="1039">
                  <c:v>2048</c:v>
                </c:pt>
                <c:pt idx="1040">
                  <c:v>1622</c:v>
                </c:pt>
                <c:pt idx="1041">
                  <c:v>882</c:v>
                </c:pt>
                <c:pt idx="1042">
                  <c:v>614</c:v>
                </c:pt>
                <c:pt idx="1043">
                  <c:v>1023</c:v>
                </c:pt>
                <c:pt idx="1044">
                  <c:v>856</c:v>
                </c:pt>
                <c:pt idx="1045">
                  <c:v>1878</c:v>
                </c:pt>
                <c:pt idx="1046">
                  <c:v>663</c:v>
                </c:pt>
                <c:pt idx="1047">
                  <c:v>2024</c:v>
                </c:pt>
                <c:pt idx="1048">
                  <c:v>832</c:v>
                </c:pt>
                <c:pt idx="1049">
                  <c:v>1488</c:v>
                </c:pt>
                <c:pt idx="1050">
                  <c:v>2347</c:v>
                </c:pt>
                <c:pt idx="1051">
                  <c:v>2260</c:v>
                </c:pt>
                <c:pt idx="1052">
                  <c:v>432</c:v>
                </c:pt>
                <c:pt idx="1053">
                  <c:v>1582</c:v>
                </c:pt>
                <c:pt idx="1054">
                  <c:v>674</c:v>
                </c:pt>
                <c:pt idx="1055">
                  <c:v>2132</c:v>
                </c:pt>
                <c:pt idx="1056">
                  <c:v>688</c:v>
                </c:pt>
                <c:pt idx="1057">
                  <c:v>1237</c:v>
                </c:pt>
                <c:pt idx="1058">
                  <c:v>1042</c:v>
                </c:pt>
                <c:pt idx="1059">
                  <c:v>1362</c:v>
                </c:pt>
                <c:pt idx="1060">
                  <c:v>2368</c:v>
                </c:pt>
                <c:pt idx="1061">
                  <c:v>1194</c:v>
                </c:pt>
                <c:pt idx="1062">
                  <c:v>1857</c:v>
                </c:pt>
                <c:pt idx="1063">
                  <c:v>1705</c:v>
                </c:pt>
                <c:pt idx="1064">
                  <c:v>2112</c:v>
                </c:pt>
                <c:pt idx="1065">
                  <c:v>2206</c:v>
                </c:pt>
                <c:pt idx="1066">
                  <c:v>2392</c:v>
                </c:pt>
                <c:pt idx="1067">
                  <c:v>770</c:v>
                </c:pt>
                <c:pt idx="1068">
                  <c:v>2287</c:v>
                </c:pt>
                <c:pt idx="1069">
                  <c:v>894</c:v>
                </c:pt>
                <c:pt idx="1070">
                  <c:v>661</c:v>
                </c:pt>
                <c:pt idx="1071">
                  <c:v>941</c:v>
                </c:pt>
                <c:pt idx="1072">
                  <c:v>67</c:v>
                </c:pt>
                <c:pt idx="1073">
                  <c:v>895</c:v>
                </c:pt>
                <c:pt idx="1074">
                  <c:v>1938</c:v>
                </c:pt>
                <c:pt idx="1075">
                  <c:v>2328</c:v>
                </c:pt>
                <c:pt idx="1076">
                  <c:v>2233</c:v>
                </c:pt>
                <c:pt idx="1077">
                  <c:v>1915</c:v>
                </c:pt>
                <c:pt idx="1078">
                  <c:v>2323</c:v>
                </c:pt>
                <c:pt idx="1079">
                  <c:v>2017</c:v>
                </c:pt>
                <c:pt idx="1080">
                  <c:v>2219</c:v>
                </c:pt>
                <c:pt idx="1081">
                  <c:v>1290</c:v>
                </c:pt>
                <c:pt idx="1082">
                  <c:v>2003</c:v>
                </c:pt>
                <c:pt idx="1083">
                  <c:v>1791</c:v>
                </c:pt>
                <c:pt idx="1084">
                  <c:v>917</c:v>
                </c:pt>
                <c:pt idx="1085">
                  <c:v>1923</c:v>
                </c:pt>
                <c:pt idx="1086">
                  <c:v>2037</c:v>
                </c:pt>
                <c:pt idx="1087">
                  <c:v>1262</c:v>
                </c:pt>
                <c:pt idx="1088">
                  <c:v>1801</c:v>
                </c:pt>
                <c:pt idx="1089">
                  <c:v>2093</c:v>
                </c:pt>
                <c:pt idx="1090">
                  <c:v>2257</c:v>
                </c:pt>
                <c:pt idx="1091">
                  <c:v>1029</c:v>
                </c:pt>
                <c:pt idx="1092">
                  <c:v>2150</c:v>
                </c:pt>
                <c:pt idx="1093">
                  <c:v>1090</c:v>
                </c:pt>
                <c:pt idx="1094">
                  <c:v>2155</c:v>
                </c:pt>
                <c:pt idx="1095">
                  <c:v>685</c:v>
                </c:pt>
                <c:pt idx="1096">
                  <c:v>1808</c:v>
                </c:pt>
                <c:pt idx="1097">
                  <c:v>1750</c:v>
                </c:pt>
                <c:pt idx="1098">
                  <c:v>759</c:v>
                </c:pt>
                <c:pt idx="1099">
                  <c:v>1056</c:v>
                </c:pt>
                <c:pt idx="1100">
                  <c:v>1418</c:v>
                </c:pt>
                <c:pt idx="1101">
                  <c:v>499</c:v>
                </c:pt>
                <c:pt idx="1102">
                  <c:v>2142</c:v>
                </c:pt>
                <c:pt idx="1103">
                  <c:v>812</c:v>
                </c:pt>
                <c:pt idx="1104">
                  <c:v>2441</c:v>
                </c:pt>
                <c:pt idx="1105">
                  <c:v>1931</c:v>
                </c:pt>
                <c:pt idx="1106">
                  <c:v>868</c:v>
                </c:pt>
                <c:pt idx="1107">
                  <c:v>2453</c:v>
                </c:pt>
                <c:pt idx="1108">
                  <c:v>1906</c:v>
                </c:pt>
                <c:pt idx="1109">
                  <c:v>1032</c:v>
                </c:pt>
                <c:pt idx="1110">
                  <c:v>1738</c:v>
                </c:pt>
                <c:pt idx="1111">
                  <c:v>1074</c:v>
                </c:pt>
                <c:pt idx="1112">
                  <c:v>2348</c:v>
                </c:pt>
                <c:pt idx="1113">
                  <c:v>1156</c:v>
                </c:pt>
                <c:pt idx="1114">
                  <c:v>602</c:v>
                </c:pt>
                <c:pt idx="1115">
                  <c:v>1253</c:v>
                </c:pt>
                <c:pt idx="1116">
                  <c:v>1006</c:v>
                </c:pt>
                <c:pt idx="1117">
                  <c:v>1786</c:v>
                </c:pt>
                <c:pt idx="1118">
                  <c:v>2389</c:v>
                </c:pt>
                <c:pt idx="1119">
                  <c:v>1374</c:v>
                </c:pt>
                <c:pt idx="1120">
                  <c:v>1785</c:v>
                </c:pt>
                <c:pt idx="1121">
                  <c:v>2099</c:v>
                </c:pt>
                <c:pt idx="1122">
                  <c:v>737</c:v>
                </c:pt>
                <c:pt idx="1123">
                  <c:v>2185</c:v>
                </c:pt>
                <c:pt idx="1124">
                  <c:v>2071</c:v>
                </c:pt>
                <c:pt idx="1125">
                  <c:v>1724</c:v>
                </c:pt>
                <c:pt idx="1126">
                  <c:v>1171</c:v>
                </c:pt>
                <c:pt idx="1127">
                  <c:v>1875</c:v>
                </c:pt>
                <c:pt idx="1128">
                  <c:v>2314</c:v>
                </c:pt>
                <c:pt idx="1129">
                  <c:v>840</c:v>
                </c:pt>
                <c:pt idx="1130">
                  <c:v>559</c:v>
                </c:pt>
                <c:pt idx="1131">
                  <c:v>1256</c:v>
                </c:pt>
                <c:pt idx="1132">
                  <c:v>1391</c:v>
                </c:pt>
                <c:pt idx="1133">
                  <c:v>1121</c:v>
                </c:pt>
                <c:pt idx="1134">
                  <c:v>2221</c:v>
                </c:pt>
                <c:pt idx="1135">
                  <c:v>1087</c:v>
                </c:pt>
                <c:pt idx="1136">
                  <c:v>1215</c:v>
                </c:pt>
                <c:pt idx="1137">
                  <c:v>1013</c:v>
                </c:pt>
                <c:pt idx="1138">
                  <c:v>1921</c:v>
                </c:pt>
                <c:pt idx="1139">
                  <c:v>1846</c:v>
                </c:pt>
                <c:pt idx="1140">
                  <c:v>1098</c:v>
                </c:pt>
                <c:pt idx="1141">
                  <c:v>1079</c:v>
                </c:pt>
                <c:pt idx="1142">
                  <c:v>1394</c:v>
                </c:pt>
                <c:pt idx="1143">
                  <c:v>2344</c:v>
                </c:pt>
                <c:pt idx="1144">
                  <c:v>707</c:v>
                </c:pt>
                <c:pt idx="1145">
                  <c:v>28</c:v>
                </c:pt>
                <c:pt idx="1146">
                  <c:v>1598</c:v>
                </c:pt>
                <c:pt idx="1147">
                  <c:v>2310</c:v>
                </c:pt>
                <c:pt idx="1148">
                  <c:v>1346</c:v>
                </c:pt>
                <c:pt idx="1149">
                  <c:v>1836</c:v>
                </c:pt>
                <c:pt idx="1150">
                  <c:v>835</c:v>
                </c:pt>
                <c:pt idx="1151">
                  <c:v>923</c:v>
                </c:pt>
                <c:pt idx="1152">
                  <c:v>1214</c:v>
                </c:pt>
                <c:pt idx="1153">
                  <c:v>1211</c:v>
                </c:pt>
                <c:pt idx="1154">
                  <c:v>1333</c:v>
                </c:pt>
                <c:pt idx="1155">
                  <c:v>1884</c:v>
                </c:pt>
                <c:pt idx="1156">
                  <c:v>519</c:v>
                </c:pt>
                <c:pt idx="1157">
                  <c:v>1479</c:v>
                </c:pt>
                <c:pt idx="1158">
                  <c:v>1154</c:v>
                </c:pt>
                <c:pt idx="1159">
                  <c:v>2431</c:v>
                </c:pt>
                <c:pt idx="1160">
                  <c:v>2252</c:v>
                </c:pt>
                <c:pt idx="1161">
                  <c:v>1538</c:v>
                </c:pt>
                <c:pt idx="1162">
                  <c:v>937</c:v>
                </c:pt>
                <c:pt idx="1163">
                  <c:v>1031</c:v>
                </c:pt>
                <c:pt idx="1164">
                  <c:v>1854</c:v>
                </c:pt>
                <c:pt idx="1165">
                  <c:v>2165</c:v>
                </c:pt>
                <c:pt idx="1166">
                  <c:v>1542</c:v>
                </c:pt>
                <c:pt idx="1167">
                  <c:v>934</c:v>
                </c:pt>
                <c:pt idx="1168">
                  <c:v>985</c:v>
                </c:pt>
                <c:pt idx="1169">
                  <c:v>2407</c:v>
                </c:pt>
                <c:pt idx="1170">
                  <c:v>1850</c:v>
                </c:pt>
                <c:pt idx="1171">
                  <c:v>430</c:v>
                </c:pt>
                <c:pt idx="1172">
                  <c:v>659</c:v>
                </c:pt>
                <c:pt idx="1173">
                  <c:v>1389</c:v>
                </c:pt>
                <c:pt idx="1174">
                  <c:v>959</c:v>
                </c:pt>
                <c:pt idx="1175">
                  <c:v>801</c:v>
                </c:pt>
                <c:pt idx="1176">
                  <c:v>1164</c:v>
                </c:pt>
                <c:pt idx="1177">
                  <c:v>2145</c:v>
                </c:pt>
                <c:pt idx="1178">
                  <c:v>2130</c:v>
                </c:pt>
                <c:pt idx="1179">
                  <c:v>2032</c:v>
                </c:pt>
                <c:pt idx="1180">
                  <c:v>1562</c:v>
                </c:pt>
                <c:pt idx="1181">
                  <c:v>951</c:v>
                </c:pt>
                <c:pt idx="1182">
                  <c:v>1459</c:v>
                </c:pt>
                <c:pt idx="1183">
                  <c:v>1919</c:v>
                </c:pt>
                <c:pt idx="1184">
                  <c:v>596</c:v>
                </c:pt>
                <c:pt idx="1185">
                  <c:v>1736</c:v>
                </c:pt>
                <c:pt idx="1186">
                  <c:v>791</c:v>
                </c:pt>
                <c:pt idx="1187">
                  <c:v>2006</c:v>
                </c:pt>
                <c:pt idx="1188">
                  <c:v>1699</c:v>
                </c:pt>
                <c:pt idx="1189">
                  <c:v>1515</c:v>
                </c:pt>
                <c:pt idx="1190">
                  <c:v>1212</c:v>
                </c:pt>
                <c:pt idx="1191">
                  <c:v>1329</c:v>
                </c:pt>
                <c:pt idx="1192">
                  <c:v>2050</c:v>
                </c:pt>
                <c:pt idx="1193">
                  <c:v>936</c:v>
                </c:pt>
                <c:pt idx="1194">
                  <c:v>1695</c:v>
                </c:pt>
                <c:pt idx="1195">
                  <c:v>1216</c:v>
                </c:pt>
                <c:pt idx="1196">
                  <c:v>2082</c:v>
                </c:pt>
                <c:pt idx="1197">
                  <c:v>2406</c:v>
                </c:pt>
                <c:pt idx="1198">
                  <c:v>969</c:v>
                </c:pt>
                <c:pt idx="1199">
                  <c:v>918</c:v>
                </c:pt>
                <c:pt idx="1200">
                  <c:v>1867</c:v>
                </c:pt>
                <c:pt idx="1201">
                  <c:v>2422</c:v>
                </c:pt>
                <c:pt idx="1202">
                  <c:v>1116</c:v>
                </c:pt>
                <c:pt idx="1203">
                  <c:v>1871</c:v>
                </c:pt>
                <c:pt idx="1204">
                  <c:v>781</c:v>
                </c:pt>
                <c:pt idx="1205">
                  <c:v>968</c:v>
                </c:pt>
                <c:pt idx="1206">
                  <c:v>1273</c:v>
                </c:pt>
                <c:pt idx="1207">
                  <c:v>1885</c:v>
                </c:pt>
                <c:pt idx="1208">
                  <c:v>2358</c:v>
                </c:pt>
                <c:pt idx="1209">
                  <c:v>945</c:v>
                </c:pt>
                <c:pt idx="1210">
                  <c:v>658</c:v>
                </c:pt>
                <c:pt idx="1211">
                  <c:v>1172</c:v>
                </c:pt>
                <c:pt idx="1212">
                  <c:v>1899</c:v>
                </c:pt>
                <c:pt idx="1213">
                  <c:v>1501</c:v>
                </c:pt>
                <c:pt idx="1214">
                  <c:v>2267</c:v>
                </c:pt>
                <c:pt idx="1215">
                  <c:v>2291</c:v>
                </c:pt>
                <c:pt idx="1216">
                  <c:v>2008</c:v>
                </c:pt>
                <c:pt idx="1217">
                  <c:v>2430</c:v>
                </c:pt>
                <c:pt idx="1218">
                  <c:v>2303</c:v>
                </c:pt>
                <c:pt idx="1219">
                  <c:v>2371</c:v>
                </c:pt>
                <c:pt idx="1220">
                  <c:v>1904</c:v>
                </c:pt>
                <c:pt idx="1221">
                  <c:v>1535</c:v>
                </c:pt>
                <c:pt idx="1222">
                  <c:v>715</c:v>
                </c:pt>
                <c:pt idx="1223">
                  <c:v>748</c:v>
                </c:pt>
                <c:pt idx="1224">
                  <c:v>782</c:v>
                </c:pt>
                <c:pt idx="1225">
                  <c:v>2034</c:v>
                </c:pt>
                <c:pt idx="1226">
                  <c:v>2289</c:v>
                </c:pt>
                <c:pt idx="1227">
                  <c:v>967</c:v>
                </c:pt>
                <c:pt idx="1228">
                  <c:v>2363</c:v>
                </c:pt>
                <c:pt idx="1229">
                  <c:v>643</c:v>
                </c:pt>
                <c:pt idx="1230">
                  <c:v>2301</c:v>
                </c:pt>
                <c:pt idx="1231">
                  <c:v>726</c:v>
                </c:pt>
                <c:pt idx="1232">
                  <c:v>1280</c:v>
                </c:pt>
                <c:pt idx="1233">
                  <c:v>2131</c:v>
                </c:pt>
                <c:pt idx="1234">
                  <c:v>576</c:v>
                </c:pt>
                <c:pt idx="1235">
                  <c:v>2457</c:v>
                </c:pt>
                <c:pt idx="1236">
                  <c:v>792</c:v>
                </c:pt>
                <c:pt idx="1237">
                  <c:v>1054</c:v>
                </c:pt>
                <c:pt idx="1238">
                  <c:v>665</c:v>
                </c:pt>
                <c:pt idx="1239">
                  <c:v>2069</c:v>
                </c:pt>
                <c:pt idx="1240">
                  <c:v>725</c:v>
                </c:pt>
                <c:pt idx="1241">
                  <c:v>2373</c:v>
                </c:pt>
                <c:pt idx="1242">
                  <c:v>1462</c:v>
                </c:pt>
                <c:pt idx="1243">
                  <c:v>1050</c:v>
                </c:pt>
                <c:pt idx="1244">
                  <c:v>1310</c:v>
                </c:pt>
                <c:pt idx="1245">
                  <c:v>997</c:v>
                </c:pt>
                <c:pt idx="1246">
                  <c:v>2390</c:v>
                </c:pt>
                <c:pt idx="1247">
                  <c:v>1217</c:v>
                </c:pt>
                <c:pt idx="1248">
                  <c:v>1522</c:v>
                </c:pt>
                <c:pt idx="1249">
                  <c:v>2355</c:v>
                </c:pt>
                <c:pt idx="1250">
                  <c:v>1734</c:v>
                </c:pt>
                <c:pt idx="1251">
                  <c:v>660</c:v>
                </c:pt>
                <c:pt idx="1252">
                  <c:v>1599</c:v>
                </c:pt>
                <c:pt idx="1253">
                  <c:v>667</c:v>
                </c:pt>
                <c:pt idx="1254">
                  <c:v>1809</c:v>
                </c:pt>
                <c:pt idx="1255">
                  <c:v>2224</c:v>
                </c:pt>
                <c:pt idx="1256">
                  <c:v>831</c:v>
                </c:pt>
                <c:pt idx="1257">
                  <c:v>774</c:v>
                </c:pt>
                <c:pt idx="1258">
                  <c:v>1866</c:v>
                </c:pt>
                <c:pt idx="1259">
                  <c:v>2011</c:v>
                </c:pt>
                <c:pt idx="1260">
                  <c:v>2432</c:v>
                </c:pt>
                <c:pt idx="1261">
                  <c:v>1591</c:v>
                </c:pt>
                <c:pt idx="1262">
                  <c:v>407</c:v>
                </c:pt>
                <c:pt idx="1263">
                  <c:v>1427</c:v>
                </c:pt>
                <c:pt idx="1264">
                  <c:v>1401</c:v>
                </c:pt>
                <c:pt idx="1265">
                  <c:v>2065</c:v>
                </c:pt>
                <c:pt idx="1266">
                  <c:v>1258</c:v>
                </c:pt>
                <c:pt idx="1267">
                  <c:v>624</c:v>
                </c:pt>
                <c:pt idx="1268">
                  <c:v>2405</c:v>
                </c:pt>
                <c:pt idx="1269">
                  <c:v>1829</c:v>
                </c:pt>
                <c:pt idx="1270">
                  <c:v>1849</c:v>
                </c:pt>
                <c:pt idx="1271">
                  <c:v>1555</c:v>
                </c:pt>
                <c:pt idx="1272">
                  <c:v>2075</c:v>
                </c:pt>
                <c:pt idx="1273">
                  <c:v>2103</c:v>
                </c:pt>
                <c:pt idx="1274">
                  <c:v>1704</c:v>
                </c:pt>
                <c:pt idx="1275">
                  <c:v>804</c:v>
                </c:pt>
                <c:pt idx="1276">
                  <c:v>1732</c:v>
                </c:pt>
                <c:pt idx="1277">
                  <c:v>1961</c:v>
                </c:pt>
                <c:pt idx="1278">
                  <c:v>1979</c:v>
                </c:pt>
                <c:pt idx="1279">
                  <c:v>2434</c:v>
                </c:pt>
                <c:pt idx="1280">
                  <c:v>1043</c:v>
                </c:pt>
                <c:pt idx="1281">
                  <c:v>502</c:v>
                </c:pt>
                <c:pt idx="1282">
                  <c:v>1767</c:v>
                </c:pt>
                <c:pt idx="1283">
                  <c:v>2022</c:v>
                </c:pt>
                <c:pt idx="1284">
                  <c:v>2199</c:v>
                </c:pt>
                <c:pt idx="1285">
                  <c:v>1814</c:v>
                </c:pt>
                <c:pt idx="1286">
                  <c:v>1444</c:v>
                </c:pt>
                <c:pt idx="1287">
                  <c:v>1907</c:v>
                </c:pt>
                <c:pt idx="1288">
                  <c:v>2030</c:v>
                </c:pt>
                <c:pt idx="1289">
                  <c:v>1509</c:v>
                </c:pt>
                <c:pt idx="1290">
                  <c:v>1081</c:v>
                </c:pt>
                <c:pt idx="1291">
                  <c:v>1901</c:v>
                </c:pt>
                <c:pt idx="1292">
                  <c:v>1898</c:v>
                </c:pt>
                <c:pt idx="1293">
                  <c:v>2433</c:v>
                </c:pt>
                <c:pt idx="1294">
                  <c:v>1608</c:v>
                </c:pt>
                <c:pt idx="1295">
                  <c:v>1004</c:v>
                </c:pt>
                <c:pt idx="1296">
                  <c:v>861</c:v>
                </c:pt>
                <c:pt idx="1297">
                  <c:v>618</c:v>
                </c:pt>
                <c:pt idx="1298">
                  <c:v>2095</c:v>
                </c:pt>
                <c:pt idx="1299">
                  <c:v>729</c:v>
                </c:pt>
                <c:pt idx="1300">
                  <c:v>758</c:v>
                </c:pt>
                <c:pt idx="1301">
                  <c:v>1503</c:v>
                </c:pt>
                <c:pt idx="1302">
                  <c:v>1728</c:v>
                </c:pt>
                <c:pt idx="1303">
                  <c:v>1396</c:v>
                </c:pt>
                <c:pt idx="1304">
                  <c:v>1390</c:v>
                </c:pt>
                <c:pt idx="1305">
                  <c:v>2385</c:v>
                </c:pt>
                <c:pt idx="1306">
                  <c:v>898</c:v>
                </c:pt>
                <c:pt idx="1307">
                  <c:v>1458</c:v>
                </c:pt>
                <c:pt idx="1308">
                  <c:v>2409</c:v>
                </c:pt>
                <c:pt idx="1309">
                  <c:v>2014</c:v>
                </c:pt>
                <c:pt idx="1310">
                  <c:v>915</c:v>
                </c:pt>
                <c:pt idx="1311">
                  <c:v>2330</c:v>
                </c:pt>
                <c:pt idx="1312">
                  <c:v>2325</c:v>
                </c:pt>
                <c:pt idx="1313">
                  <c:v>1291</c:v>
                </c:pt>
                <c:pt idx="1314">
                  <c:v>1844</c:v>
                </c:pt>
                <c:pt idx="1315">
                  <c:v>1134</c:v>
                </c:pt>
                <c:pt idx="1316">
                  <c:v>592</c:v>
                </c:pt>
                <c:pt idx="1317">
                  <c:v>2201</c:v>
                </c:pt>
                <c:pt idx="1318">
                  <c:v>558</c:v>
                </c:pt>
                <c:pt idx="1319">
                  <c:v>921</c:v>
                </c:pt>
                <c:pt idx="1320">
                  <c:v>1759</c:v>
                </c:pt>
                <c:pt idx="1321">
                  <c:v>1069</c:v>
                </c:pt>
                <c:pt idx="1322">
                  <c:v>2370</c:v>
                </c:pt>
                <c:pt idx="1323">
                  <c:v>2194</c:v>
                </c:pt>
                <c:pt idx="1324">
                  <c:v>1186</c:v>
                </c:pt>
                <c:pt idx="1325">
                  <c:v>2256</c:v>
                </c:pt>
                <c:pt idx="1326">
                  <c:v>1612</c:v>
                </c:pt>
                <c:pt idx="1327">
                  <c:v>2176</c:v>
                </c:pt>
                <c:pt idx="1328">
                  <c:v>1478</c:v>
                </c:pt>
                <c:pt idx="1329">
                  <c:v>2274</c:v>
                </c:pt>
                <c:pt idx="1330">
                  <c:v>1749</c:v>
                </c:pt>
                <c:pt idx="1331">
                  <c:v>1224</c:v>
                </c:pt>
                <c:pt idx="1332">
                  <c:v>2250</c:v>
                </c:pt>
                <c:pt idx="1333">
                  <c:v>1690</c:v>
                </c:pt>
                <c:pt idx="1334">
                  <c:v>2304</c:v>
                </c:pt>
                <c:pt idx="1335">
                  <c:v>1646</c:v>
                </c:pt>
                <c:pt idx="1336">
                  <c:v>1314</c:v>
                </c:pt>
                <c:pt idx="1337">
                  <c:v>1617</c:v>
                </c:pt>
                <c:pt idx="1338">
                  <c:v>668</c:v>
                </c:pt>
                <c:pt idx="1339">
                  <c:v>943</c:v>
                </c:pt>
                <c:pt idx="1340">
                  <c:v>2091</c:v>
                </c:pt>
                <c:pt idx="1341">
                  <c:v>776</c:v>
                </c:pt>
                <c:pt idx="1342">
                  <c:v>1059</c:v>
                </c:pt>
                <c:pt idx="1343">
                  <c:v>2116</c:v>
                </c:pt>
                <c:pt idx="1344">
                  <c:v>853</c:v>
                </c:pt>
                <c:pt idx="1345">
                  <c:v>2271</c:v>
                </c:pt>
                <c:pt idx="1346">
                  <c:v>2049</c:v>
                </c:pt>
                <c:pt idx="1347">
                  <c:v>1299</c:v>
                </c:pt>
                <c:pt idx="1348">
                  <c:v>1626</c:v>
                </c:pt>
                <c:pt idx="1349">
                  <c:v>1016</c:v>
                </c:pt>
                <c:pt idx="1350">
                  <c:v>2408</c:v>
                </c:pt>
                <c:pt idx="1351">
                  <c:v>1199</c:v>
                </c:pt>
                <c:pt idx="1352">
                  <c:v>2401</c:v>
                </c:pt>
                <c:pt idx="1353">
                  <c:v>1816</c:v>
                </c:pt>
                <c:pt idx="1354">
                  <c:v>2139</c:v>
                </c:pt>
                <c:pt idx="1355">
                  <c:v>817</c:v>
                </c:pt>
                <c:pt idx="1356">
                  <c:v>1913</c:v>
                </c:pt>
                <c:pt idx="1357">
                  <c:v>1891</c:v>
                </c:pt>
                <c:pt idx="1358">
                  <c:v>1722</c:v>
                </c:pt>
                <c:pt idx="1359">
                  <c:v>1835</c:v>
                </c:pt>
                <c:pt idx="1360">
                  <c:v>427</c:v>
                </c:pt>
                <c:pt idx="1361">
                  <c:v>1244</c:v>
                </c:pt>
                <c:pt idx="1362">
                  <c:v>910</c:v>
                </c:pt>
                <c:pt idx="1363">
                  <c:v>1014</c:v>
                </c:pt>
                <c:pt idx="1364">
                  <c:v>1606</c:v>
                </c:pt>
                <c:pt idx="1365">
                  <c:v>952</c:v>
                </c:pt>
                <c:pt idx="1366">
                  <c:v>628</c:v>
                </c:pt>
                <c:pt idx="1367">
                  <c:v>2452</c:v>
                </c:pt>
                <c:pt idx="1368">
                  <c:v>793</c:v>
                </c:pt>
                <c:pt idx="1369">
                  <c:v>1173</c:v>
                </c:pt>
                <c:pt idx="1370">
                  <c:v>2288</c:v>
                </c:pt>
                <c:pt idx="1371">
                  <c:v>584</c:v>
                </c:pt>
                <c:pt idx="1372">
                  <c:v>1033</c:v>
                </c:pt>
                <c:pt idx="1373">
                  <c:v>1097</c:v>
                </c:pt>
                <c:pt idx="1374">
                  <c:v>819</c:v>
                </c:pt>
                <c:pt idx="1375">
                  <c:v>1583</c:v>
                </c:pt>
                <c:pt idx="1376">
                  <c:v>2362</c:v>
                </c:pt>
                <c:pt idx="1377">
                  <c:v>773</c:v>
                </c:pt>
                <c:pt idx="1378">
                  <c:v>2088</c:v>
                </c:pt>
                <c:pt idx="1379">
                  <c:v>1936</c:v>
                </c:pt>
                <c:pt idx="1380">
                  <c:v>1361</c:v>
                </c:pt>
                <c:pt idx="1381">
                  <c:v>920</c:v>
                </c:pt>
                <c:pt idx="1382">
                  <c:v>2255</c:v>
                </c:pt>
                <c:pt idx="1383">
                  <c:v>1203</c:v>
                </c:pt>
                <c:pt idx="1384">
                  <c:v>2140</c:v>
                </c:pt>
                <c:pt idx="1385">
                  <c:v>1691</c:v>
                </c:pt>
                <c:pt idx="1386">
                  <c:v>1697</c:v>
                </c:pt>
                <c:pt idx="1387">
                  <c:v>455</c:v>
                </c:pt>
                <c:pt idx="1388">
                  <c:v>1838</c:v>
                </c:pt>
                <c:pt idx="1389">
                  <c:v>870</c:v>
                </c:pt>
                <c:pt idx="1390">
                  <c:v>580</c:v>
                </c:pt>
                <c:pt idx="1391">
                  <c:v>2294</c:v>
                </c:pt>
              </c:numCache>
            </c:numRef>
          </c:xVal>
          <c:yVal>
            <c:numRef>
              <c:f>'Brachy TIR1'!$C$4:$C$1395</c:f>
              <c:numCache>
                <c:formatCode>General</c:formatCode>
                <c:ptCount val="1392"/>
                <c:pt idx="1">
                  <c:v>1</c:v>
                </c:pt>
                <c:pt idx="2">
                  <c:v>1</c:v>
                </c:pt>
                <c:pt idx="3">
                  <c:v>1</c:v>
                </c:pt>
                <c:pt idx="6">
                  <c:v>1</c:v>
                </c:pt>
                <c:pt idx="7">
                  <c:v>2</c:v>
                </c:pt>
                <c:pt idx="9">
                  <c:v>1</c:v>
                </c:pt>
                <c:pt idx="12">
                  <c:v>1</c:v>
                </c:pt>
                <c:pt idx="13">
                  <c:v>1</c:v>
                </c:pt>
                <c:pt idx="14">
                  <c:v>1</c:v>
                </c:pt>
                <c:pt idx="15">
                  <c:v>1</c:v>
                </c:pt>
                <c:pt idx="19">
                  <c:v>1</c:v>
                </c:pt>
                <c:pt idx="21">
                  <c:v>1</c:v>
                </c:pt>
                <c:pt idx="23">
                  <c:v>1</c:v>
                </c:pt>
                <c:pt idx="31">
                  <c:v>1</c:v>
                </c:pt>
                <c:pt idx="33">
                  <c:v>3</c:v>
                </c:pt>
                <c:pt idx="34">
                  <c:v>1</c:v>
                </c:pt>
                <c:pt idx="36">
                  <c:v>1</c:v>
                </c:pt>
                <c:pt idx="37">
                  <c:v>1</c:v>
                </c:pt>
                <c:pt idx="38">
                  <c:v>1</c:v>
                </c:pt>
                <c:pt idx="39">
                  <c:v>1</c:v>
                </c:pt>
                <c:pt idx="41">
                  <c:v>1</c:v>
                </c:pt>
                <c:pt idx="43">
                  <c:v>1</c:v>
                </c:pt>
                <c:pt idx="45">
                  <c:v>1</c:v>
                </c:pt>
                <c:pt idx="46">
                  <c:v>1</c:v>
                </c:pt>
                <c:pt idx="47">
                  <c:v>1</c:v>
                </c:pt>
                <c:pt idx="48">
                  <c:v>1</c:v>
                </c:pt>
                <c:pt idx="49">
                  <c:v>1</c:v>
                </c:pt>
                <c:pt idx="50">
                  <c:v>1</c:v>
                </c:pt>
                <c:pt idx="51">
                  <c:v>1</c:v>
                </c:pt>
                <c:pt idx="52">
                  <c:v>1</c:v>
                </c:pt>
                <c:pt idx="53">
                  <c:v>1</c:v>
                </c:pt>
                <c:pt idx="54">
                  <c:v>1</c:v>
                </c:pt>
                <c:pt idx="55">
                  <c:v>1</c:v>
                </c:pt>
                <c:pt idx="57">
                  <c:v>1</c:v>
                </c:pt>
                <c:pt idx="59">
                  <c:v>1</c:v>
                </c:pt>
                <c:pt idx="62">
                  <c:v>1</c:v>
                </c:pt>
                <c:pt idx="63">
                  <c:v>28</c:v>
                </c:pt>
                <c:pt idx="64">
                  <c:v>1</c:v>
                </c:pt>
                <c:pt idx="66">
                  <c:v>1</c:v>
                </c:pt>
                <c:pt idx="67">
                  <c:v>1</c:v>
                </c:pt>
                <c:pt idx="69">
                  <c:v>1</c:v>
                </c:pt>
                <c:pt idx="71">
                  <c:v>1</c:v>
                </c:pt>
                <c:pt idx="72">
                  <c:v>1</c:v>
                </c:pt>
                <c:pt idx="73">
                  <c:v>1</c:v>
                </c:pt>
                <c:pt idx="75">
                  <c:v>1</c:v>
                </c:pt>
                <c:pt idx="76">
                  <c:v>1</c:v>
                </c:pt>
                <c:pt idx="77">
                  <c:v>1</c:v>
                </c:pt>
                <c:pt idx="78">
                  <c:v>1</c:v>
                </c:pt>
                <c:pt idx="79">
                  <c:v>1</c:v>
                </c:pt>
                <c:pt idx="80">
                  <c:v>1</c:v>
                </c:pt>
                <c:pt idx="82">
                  <c:v>1</c:v>
                </c:pt>
                <c:pt idx="83">
                  <c:v>2</c:v>
                </c:pt>
                <c:pt idx="88">
                  <c:v>1</c:v>
                </c:pt>
                <c:pt idx="89">
                  <c:v>1</c:v>
                </c:pt>
                <c:pt idx="90">
                  <c:v>1</c:v>
                </c:pt>
                <c:pt idx="91">
                  <c:v>1</c:v>
                </c:pt>
                <c:pt idx="93">
                  <c:v>1</c:v>
                </c:pt>
                <c:pt idx="95">
                  <c:v>1</c:v>
                </c:pt>
                <c:pt idx="99">
                  <c:v>1</c:v>
                </c:pt>
                <c:pt idx="101">
                  <c:v>1</c:v>
                </c:pt>
                <c:pt idx="102">
                  <c:v>5</c:v>
                </c:pt>
                <c:pt idx="103">
                  <c:v>1</c:v>
                </c:pt>
                <c:pt idx="104">
                  <c:v>1</c:v>
                </c:pt>
                <c:pt idx="106">
                  <c:v>1</c:v>
                </c:pt>
                <c:pt idx="107">
                  <c:v>1</c:v>
                </c:pt>
                <c:pt idx="108">
                  <c:v>1</c:v>
                </c:pt>
                <c:pt idx="110">
                  <c:v>1</c:v>
                </c:pt>
                <c:pt idx="112">
                  <c:v>1</c:v>
                </c:pt>
                <c:pt idx="113">
                  <c:v>1</c:v>
                </c:pt>
                <c:pt idx="115">
                  <c:v>1</c:v>
                </c:pt>
                <c:pt idx="117">
                  <c:v>1</c:v>
                </c:pt>
                <c:pt idx="118">
                  <c:v>1</c:v>
                </c:pt>
                <c:pt idx="120">
                  <c:v>1</c:v>
                </c:pt>
                <c:pt idx="122">
                  <c:v>1</c:v>
                </c:pt>
                <c:pt idx="123">
                  <c:v>1</c:v>
                </c:pt>
                <c:pt idx="124">
                  <c:v>1</c:v>
                </c:pt>
                <c:pt idx="125">
                  <c:v>1</c:v>
                </c:pt>
                <c:pt idx="127">
                  <c:v>1</c:v>
                </c:pt>
                <c:pt idx="128">
                  <c:v>1</c:v>
                </c:pt>
                <c:pt idx="129">
                  <c:v>1</c:v>
                </c:pt>
                <c:pt idx="131">
                  <c:v>1</c:v>
                </c:pt>
                <c:pt idx="133">
                  <c:v>3</c:v>
                </c:pt>
                <c:pt idx="134">
                  <c:v>1</c:v>
                </c:pt>
                <c:pt idx="135">
                  <c:v>1</c:v>
                </c:pt>
                <c:pt idx="136">
                  <c:v>1</c:v>
                </c:pt>
                <c:pt idx="137">
                  <c:v>1</c:v>
                </c:pt>
                <c:pt idx="139">
                  <c:v>1</c:v>
                </c:pt>
                <c:pt idx="141">
                  <c:v>1</c:v>
                </c:pt>
                <c:pt idx="144">
                  <c:v>1</c:v>
                </c:pt>
                <c:pt idx="146">
                  <c:v>5</c:v>
                </c:pt>
                <c:pt idx="147">
                  <c:v>1</c:v>
                </c:pt>
                <c:pt idx="151">
                  <c:v>1</c:v>
                </c:pt>
                <c:pt idx="152">
                  <c:v>1</c:v>
                </c:pt>
                <c:pt idx="154">
                  <c:v>1</c:v>
                </c:pt>
                <c:pt idx="156">
                  <c:v>1</c:v>
                </c:pt>
                <c:pt idx="157">
                  <c:v>1</c:v>
                </c:pt>
                <c:pt idx="158">
                  <c:v>2</c:v>
                </c:pt>
                <c:pt idx="159">
                  <c:v>1</c:v>
                </c:pt>
                <c:pt idx="160">
                  <c:v>1</c:v>
                </c:pt>
                <c:pt idx="161">
                  <c:v>1</c:v>
                </c:pt>
                <c:pt idx="162">
                  <c:v>1</c:v>
                </c:pt>
                <c:pt idx="163">
                  <c:v>1</c:v>
                </c:pt>
                <c:pt idx="164">
                  <c:v>1</c:v>
                </c:pt>
                <c:pt idx="166">
                  <c:v>1</c:v>
                </c:pt>
                <c:pt idx="168">
                  <c:v>1</c:v>
                </c:pt>
                <c:pt idx="170">
                  <c:v>1</c:v>
                </c:pt>
                <c:pt idx="171">
                  <c:v>1</c:v>
                </c:pt>
                <c:pt idx="172">
                  <c:v>10</c:v>
                </c:pt>
                <c:pt idx="173">
                  <c:v>1</c:v>
                </c:pt>
                <c:pt idx="174">
                  <c:v>1</c:v>
                </c:pt>
                <c:pt idx="175">
                  <c:v>1</c:v>
                </c:pt>
                <c:pt idx="179">
                  <c:v>1</c:v>
                </c:pt>
                <c:pt idx="180">
                  <c:v>1</c:v>
                </c:pt>
                <c:pt idx="182">
                  <c:v>1</c:v>
                </c:pt>
                <c:pt idx="183">
                  <c:v>1</c:v>
                </c:pt>
                <c:pt idx="185">
                  <c:v>1</c:v>
                </c:pt>
                <c:pt idx="186">
                  <c:v>1</c:v>
                </c:pt>
                <c:pt idx="189">
                  <c:v>1</c:v>
                </c:pt>
                <c:pt idx="190">
                  <c:v>1</c:v>
                </c:pt>
                <c:pt idx="191">
                  <c:v>1</c:v>
                </c:pt>
                <c:pt idx="194">
                  <c:v>1</c:v>
                </c:pt>
                <c:pt idx="195">
                  <c:v>12</c:v>
                </c:pt>
                <c:pt idx="196">
                  <c:v>1</c:v>
                </c:pt>
                <c:pt idx="197">
                  <c:v>1</c:v>
                </c:pt>
                <c:pt idx="199">
                  <c:v>1</c:v>
                </c:pt>
                <c:pt idx="201">
                  <c:v>1</c:v>
                </c:pt>
                <c:pt idx="204">
                  <c:v>1</c:v>
                </c:pt>
                <c:pt idx="206">
                  <c:v>1</c:v>
                </c:pt>
                <c:pt idx="207">
                  <c:v>1</c:v>
                </c:pt>
                <c:pt idx="208">
                  <c:v>1</c:v>
                </c:pt>
                <c:pt idx="209">
                  <c:v>1</c:v>
                </c:pt>
                <c:pt idx="212">
                  <c:v>1</c:v>
                </c:pt>
                <c:pt idx="214">
                  <c:v>3</c:v>
                </c:pt>
                <c:pt idx="217">
                  <c:v>1</c:v>
                </c:pt>
                <c:pt idx="219">
                  <c:v>1</c:v>
                </c:pt>
                <c:pt idx="220">
                  <c:v>1</c:v>
                </c:pt>
                <c:pt idx="223">
                  <c:v>75</c:v>
                </c:pt>
                <c:pt idx="225">
                  <c:v>1</c:v>
                </c:pt>
                <c:pt idx="226">
                  <c:v>1</c:v>
                </c:pt>
                <c:pt idx="229">
                  <c:v>4</c:v>
                </c:pt>
                <c:pt idx="232">
                  <c:v>1</c:v>
                </c:pt>
                <c:pt idx="233">
                  <c:v>1</c:v>
                </c:pt>
                <c:pt idx="235">
                  <c:v>1</c:v>
                </c:pt>
                <c:pt idx="238">
                  <c:v>1</c:v>
                </c:pt>
                <c:pt idx="243">
                  <c:v>1</c:v>
                </c:pt>
                <c:pt idx="247">
                  <c:v>1</c:v>
                </c:pt>
                <c:pt idx="248">
                  <c:v>1</c:v>
                </c:pt>
                <c:pt idx="251">
                  <c:v>1</c:v>
                </c:pt>
                <c:pt idx="252">
                  <c:v>1</c:v>
                </c:pt>
                <c:pt idx="254">
                  <c:v>12</c:v>
                </c:pt>
                <c:pt idx="255">
                  <c:v>3</c:v>
                </c:pt>
                <c:pt idx="256">
                  <c:v>1</c:v>
                </c:pt>
                <c:pt idx="258">
                  <c:v>1</c:v>
                </c:pt>
                <c:pt idx="259">
                  <c:v>1</c:v>
                </c:pt>
                <c:pt idx="261">
                  <c:v>1</c:v>
                </c:pt>
                <c:pt idx="262">
                  <c:v>1</c:v>
                </c:pt>
                <c:pt idx="263">
                  <c:v>1</c:v>
                </c:pt>
                <c:pt idx="264">
                  <c:v>1</c:v>
                </c:pt>
                <c:pt idx="266">
                  <c:v>1</c:v>
                </c:pt>
                <c:pt idx="267">
                  <c:v>1</c:v>
                </c:pt>
                <c:pt idx="268">
                  <c:v>6</c:v>
                </c:pt>
                <c:pt idx="269">
                  <c:v>2</c:v>
                </c:pt>
                <c:pt idx="272">
                  <c:v>2</c:v>
                </c:pt>
                <c:pt idx="275">
                  <c:v>1</c:v>
                </c:pt>
                <c:pt idx="277">
                  <c:v>1</c:v>
                </c:pt>
                <c:pt idx="280">
                  <c:v>1</c:v>
                </c:pt>
                <c:pt idx="282">
                  <c:v>1</c:v>
                </c:pt>
                <c:pt idx="284">
                  <c:v>1</c:v>
                </c:pt>
                <c:pt idx="285">
                  <c:v>1</c:v>
                </c:pt>
                <c:pt idx="287">
                  <c:v>1</c:v>
                </c:pt>
                <c:pt idx="288">
                  <c:v>1</c:v>
                </c:pt>
                <c:pt idx="289">
                  <c:v>1</c:v>
                </c:pt>
                <c:pt idx="290">
                  <c:v>6</c:v>
                </c:pt>
                <c:pt idx="291">
                  <c:v>1</c:v>
                </c:pt>
                <c:pt idx="293">
                  <c:v>1</c:v>
                </c:pt>
                <c:pt idx="295">
                  <c:v>1</c:v>
                </c:pt>
                <c:pt idx="296">
                  <c:v>1</c:v>
                </c:pt>
                <c:pt idx="297">
                  <c:v>1</c:v>
                </c:pt>
                <c:pt idx="298">
                  <c:v>1</c:v>
                </c:pt>
                <c:pt idx="299">
                  <c:v>1</c:v>
                </c:pt>
                <c:pt idx="302">
                  <c:v>1</c:v>
                </c:pt>
                <c:pt idx="304">
                  <c:v>1</c:v>
                </c:pt>
                <c:pt idx="306">
                  <c:v>1</c:v>
                </c:pt>
                <c:pt idx="307">
                  <c:v>1</c:v>
                </c:pt>
                <c:pt idx="308">
                  <c:v>2</c:v>
                </c:pt>
                <c:pt idx="310">
                  <c:v>1</c:v>
                </c:pt>
                <c:pt idx="313">
                  <c:v>16</c:v>
                </c:pt>
                <c:pt idx="314">
                  <c:v>1</c:v>
                </c:pt>
                <c:pt idx="315">
                  <c:v>1</c:v>
                </c:pt>
                <c:pt idx="316">
                  <c:v>1</c:v>
                </c:pt>
                <c:pt idx="317">
                  <c:v>1</c:v>
                </c:pt>
                <c:pt idx="320">
                  <c:v>1</c:v>
                </c:pt>
                <c:pt idx="322">
                  <c:v>1</c:v>
                </c:pt>
                <c:pt idx="323">
                  <c:v>1</c:v>
                </c:pt>
                <c:pt idx="324">
                  <c:v>1</c:v>
                </c:pt>
                <c:pt idx="325">
                  <c:v>1</c:v>
                </c:pt>
                <c:pt idx="326">
                  <c:v>70</c:v>
                </c:pt>
                <c:pt idx="327">
                  <c:v>1</c:v>
                </c:pt>
                <c:pt idx="330">
                  <c:v>2</c:v>
                </c:pt>
                <c:pt idx="331">
                  <c:v>1</c:v>
                </c:pt>
                <c:pt idx="333">
                  <c:v>1</c:v>
                </c:pt>
                <c:pt idx="334">
                  <c:v>1</c:v>
                </c:pt>
                <c:pt idx="335">
                  <c:v>1</c:v>
                </c:pt>
                <c:pt idx="336">
                  <c:v>1</c:v>
                </c:pt>
                <c:pt idx="337">
                  <c:v>1</c:v>
                </c:pt>
                <c:pt idx="338">
                  <c:v>1</c:v>
                </c:pt>
                <c:pt idx="339">
                  <c:v>1</c:v>
                </c:pt>
                <c:pt idx="342">
                  <c:v>1</c:v>
                </c:pt>
                <c:pt idx="343">
                  <c:v>1</c:v>
                </c:pt>
                <c:pt idx="345">
                  <c:v>132</c:v>
                </c:pt>
                <c:pt idx="346">
                  <c:v>1</c:v>
                </c:pt>
                <c:pt idx="347">
                  <c:v>1</c:v>
                </c:pt>
                <c:pt idx="349">
                  <c:v>1</c:v>
                </c:pt>
                <c:pt idx="350">
                  <c:v>1</c:v>
                </c:pt>
                <c:pt idx="352">
                  <c:v>1</c:v>
                </c:pt>
                <c:pt idx="353">
                  <c:v>1</c:v>
                </c:pt>
                <c:pt idx="355">
                  <c:v>1</c:v>
                </c:pt>
                <c:pt idx="358">
                  <c:v>1</c:v>
                </c:pt>
                <c:pt idx="359">
                  <c:v>1</c:v>
                </c:pt>
                <c:pt idx="360">
                  <c:v>2</c:v>
                </c:pt>
                <c:pt idx="368">
                  <c:v>1</c:v>
                </c:pt>
                <c:pt idx="375">
                  <c:v>4</c:v>
                </c:pt>
                <c:pt idx="376">
                  <c:v>1</c:v>
                </c:pt>
                <c:pt idx="377">
                  <c:v>1</c:v>
                </c:pt>
                <c:pt idx="378">
                  <c:v>1</c:v>
                </c:pt>
                <c:pt idx="379">
                  <c:v>1</c:v>
                </c:pt>
                <c:pt idx="380">
                  <c:v>1</c:v>
                </c:pt>
                <c:pt idx="381">
                  <c:v>1</c:v>
                </c:pt>
                <c:pt idx="382">
                  <c:v>1</c:v>
                </c:pt>
                <c:pt idx="383">
                  <c:v>1</c:v>
                </c:pt>
                <c:pt idx="384">
                  <c:v>1</c:v>
                </c:pt>
                <c:pt idx="385">
                  <c:v>1</c:v>
                </c:pt>
                <c:pt idx="387">
                  <c:v>1</c:v>
                </c:pt>
                <c:pt idx="389">
                  <c:v>1</c:v>
                </c:pt>
                <c:pt idx="390">
                  <c:v>1</c:v>
                </c:pt>
                <c:pt idx="392">
                  <c:v>2</c:v>
                </c:pt>
                <c:pt idx="394">
                  <c:v>1</c:v>
                </c:pt>
                <c:pt idx="396">
                  <c:v>3</c:v>
                </c:pt>
                <c:pt idx="398">
                  <c:v>1</c:v>
                </c:pt>
                <c:pt idx="400">
                  <c:v>1</c:v>
                </c:pt>
                <c:pt idx="403">
                  <c:v>1</c:v>
                </c:pt>
                <c:pt idx="404">
                  <c:v>1</c:v>
                </c:pt>
                <c:pt idx="409">
                  <c:v>1</c:v>
                </c:pt>
                <c:pt idx="411">
                  <c:v>1</c:v>
                </c:pt>
                <c:pt idx="412">
                  <c:v>1</c:v>
                </c:pt>
                <c:pt idx="413">
                  <c:v>1</c:v>
                </c:pt>
                <c:pt idx="414">
                  <c:v>1</c:v>
                </c:pt>
                <c:pt idx="415">
                  <c:v>1</c:v>
                </c:pt>
                <c:pt idx="416">
                  <c:v>1</c:v>
                </c:pt>
                <c:pt idx="418">
                  <c:v>1</c:v>
                </c:pt>
                <c:pt idx="419">
                  <c:v>1</c:v>
                </c:pt>
                <c:pt idx="421">
                  <c:v>1</c:v>
                </c:pt>
                <c:pt idx="423">
                  <c:v>1</c:v>
                </c:pt>
                <c:pt idx="424">
                  <c:v>1</c:v>
                </c:pt>
                <c:pt idx="427">
                  <c:v>1</c:v>
                </c:pt>
                <c:pt idx="429">
                  <c:v>1</c:v>
                </c:pt>
                <c:pt idx="430">
                  <c:v>1</c:v>
                </c:pt>
                <c:pt idx="431">
                  <c:v>1</c:v>
                </c:pt>
                <c:pt idx="432">
                  <c:v>1</c:v>
                </c:pt>
                <c:pt idx="434">
                  <c:v>1</c:v>
                </c:pt>
                <c:pt idx="436">
                  <c:v>1</c:v>
                </c:pt>
                <c:pt idx="439">
                  <c:v>1</c:v>
                </c:pt>
                <c:pt idx="441">
                  <c:v>1</c:v>
                </c:pt>
                <c:pt idx="442">
                  <c:v>1</c:v>
                </c:pt>
                <c:pt idx="445">
                  <c:v>1</c:v>
                </c:pt>
                <c:pt idx="446">
                  <c:v>1</c:v>
                </c:pt>
                <c:pt idx="448">
                  <c:v>1</c:v>
                </c:pt>
                <c:pt idx="452">
                  <c:v>1</c:v>
                </c:pt>
                <c:pt idx="453">
                  <c:v>1</c:v>
                </c:pt>
                <c:pt idx="454">
                  <c:v>1</c:v>
                </c:pt>
                <c:pt idx="455">
                  <c:v>3</c:v>
                </c:pt>
                <c:pt idx="456">
                  <c:v>1</c:v>
                </c:pt>
                <c:pt idx="459">
                  <c:v>1</c:v>
                </c:pt>
                <c:pt idx="460">
                  <c:v>1</c:v>
                </c:pt>
                <c:pt idx="463">
                  <c:v>1</c:v>
                </c:pt>
                <c:pt idx="464">
                  <c:v>1</c:v>
                </c:pt>
                <c:pt idx="465">
                  <c:v>1</c:v>
                </c:pt>
                <c:pt idx="466">
                  <c:v>1</c:v>
                </c:pt>
                <c:pt idx="467">
                  <c:v>1</c:v>
                </c:pt>
                <c:pt idx="468">
                  <c:v>38</c:v>
                </c:pt>
                <c:pt idx="470">
                  <c:v>1</c:v>
                </c:pt>
                <c:pt idx="471">
                  <c:v>1</c:v>
                </c:pt>
                <c:pt idx="473">
                  <c:v>1</c:v>
                </c:pt>
                <c:pt idx="475">
                  <c:v>1</c:v>
                </c:pt>
                <c:pt idx="476">
                  <c:v>1</c:v>
                </c:pt>
                <c:pt idx="477">
                  <c:v>1</c:v>
                </c:pt>
                <c:pt idx="478">
                  <c:v>1</c:v>
                </c:pt>
                <c:pt idx="481">
                  <c:v>1</c:v>
                </c:pt>
                <c:pt idx="482">
                  <c:v>1</c:v>
                </c:pt>
                <c:pt idx="483">
                  <c:v>1</c:v>
                </c:pt>
                <c:pt idx="484">
                  <c:v>1</c:v>
                </c:pt>
                <c:pt idx="486">
                  <c:v>1</c:v>
                </c:pt>
                <c:pt idx="488">
                  <c:v>1</c:v>
                </c:pt>
                <c:pt idx="489">
                  <c:v>1</c:v>
                </c:pt>
                <c:pt idx="491">
                  <c:v>1</c:v>
                </c:pt>
                <c:pt idx="492">
                  <c:v>1</c:v>
                </c:pt>
                <c:pt idx="494">
                  <c:v>2</c:v>
                </c:pt>
                <c:pt idx="495">
                  <c:v>1</c:v>
                </c:pt>
                <c:pt idx="496">
                  <c:v>1</c:v>
                </c:pt>
                <c:pt idx="497">
                  <c:v>1</c:v>
                </c:pt>
                <c:pt idx="499">
                  <c:v>1</c:v>
                </c:pt>
                <c:pt idx="500">
                  <c:v>1</c:v>
                </c:pt>
                <c:pt idx="504">
                  <c:v>1</c:v>
                </c:pt>
                <c:pt idx="506">
                  <c:v>1</c:v>
                </c:pt>
                <c:pt idx="507">
                  <c:v>1</c:v>
                </c:pt>
                <c:pt idx="508">
                  <c:v>1</c:v>
                </c:pt>
                <c:pt idx="513">
                  <c:v>1</c:v>
                </c:pt>
                <c:pt idx="514">
                  <c:v>1</c:v>
                </c:pt>
                <c:pt idx="515">
                  <c:v>1</c:v>
                </c:pt>
                <c:pt idx="516">
                  <c:v>1</c:v>
                </c:pt>
                <c:pt idx="517">
                  <c:v>1</c:v>
                </c:pt>
                <c:pt idx="521">
                  <c:v>1</c:v>
                </c:pt>
                <c:pt idx="522">
                  <c:v>1</c:v>
                </c:pt>
                <c:pt idx="524">
                  <c:v>1</c:v>
                </c:pt>
                <c:pt idx="526">
                  <c:v>1</c:v>
                </c:pt>
                <c:pt idx="531">
                  <c:v>1</c:v>
                </c:pt>
                <c:pt idx="532">
                  <c:v>1</c:v>
                </c:pt>
                <c:pt idx="533">
                  <c:v>1</c:v>
                </c:pt>
                <c:pt idx="535">
                  <c:v>1</c:v>
                </c:pt>
                <c:pt idx="539">
                  <c:v>1</c:v>
                </c:pt>
                <c:pt idx="540">
                  <c:v>1</c:v>
                </c:pt>
                <c:pt idx="542">
                  <c:v>1</c:v>
                </c:pt>
                <c:pt idx="543">
                  <c:v>1</c:v>
                </c:pt>
                <c:pt idx="544">
                  <c:v>63</c:v>
                </c:pt>
                <c:pt idx="549">
                  <c:v>1</c:v>
                </c:pt>
                <c:pt idx="550">
                  <c:v>1</c:v>
                </c:pt>
                <c:pt idx="551">
                  <c:v>1</c:v>
                </c:pt>
                <c:pt idx="552">
                  <c:v>1</c:v>
                </c:pt>
                <c:pt idx="553">
                  <c:v>1</c:v>
                </c:pt>
                <c:pt idx="555">
                  <c:v>1</c:v>
                </c:pt>
                <c:pt idx="556">
                  <c:v>1</c:v>
                </c:pt>
                <c:pt idx="558">
                  <c:v>1</c:v>
                </c:pt>
                <c:pt idx="559">
                  <c:v>2</c:v>
                </c:pt>
                <c:pt idx="561">
                  <c:v>1</c:v>
                </c:pt>
                <c:pt idx="563">
                  <c:v>1</c:v>
                </c:pt>
                <c:pt idx="564">
                  <c:v>1</c:v>
                </c:pt>
                <c:pt idx="566">
                  <c:v>1</c:v>
                </c:pt>
                <c:pt idx="567">
                  <c:v>1</c:v>
                </c:pt>
                <c:pt idx="573">
                  <c:v>1</c:v>
                </c:pt>
                <c:pt idx="576">
                  <c:v>1</c:v>
                </c:pt>
                <c:pt idx="577">
                  <c:v>1</c:v>
                </c:pt>
                <c:pt idx="580">
                  <c:v>1</c:v>
                </c:pt>
                <c:pt idx="581">
                  <c:v>1</c:v>
                </c:pt>
                <c:pt idx="582">
                  <c:v>1</c:v>
                </c:pt>
                <c:pt idx="583">
                  <c:v>1</c:v>
                </c:pt>
                <c:pt idx="584">
                  <c:v>1</c:v>
                </c:pt>
                <c:pt idx="586">
                  <c:v>1</c:v>
                </c:pt>
                <c:pt idx="587">
                  <c:v>1</c:v>
                </c:pt>
                <c:pt idx="588">
                  <c:v>1</c:v>
                </c:pt>
                <c:pt idx="590">
                  <c:v>1</c:v>
                </c:pt>
                <c:pt idx="592">
                  <c:v>1</c:v>
                </c:pt>
                <c:pt idx="593">
                  <c:v>1</c:v>
                </c:pt>
                <c:pt idx="594">
                  <c:v>1</c:v>
                </c:pt>
                <c:pt idx="595">
                  <c:v>1</c:v>
                </c:pt>
                <c:pt idx="596">
                  <c:v>1</c:v>
                </c:pt>
                <c:pt idx="597">
                  <c:v>1</c:v>
                </c:pt>
                <c:pt idx="599">
                  <c:v>1</c:v>
                </c:pt>
                <c:pt idx="603">
                  <c:v>1</c:v>
                </c:pt>
                <c:pt idx="605">
                  <c:v>1</c:v>
                </c:pt>
                <c:pt idx="607">
                  <c:v>1</c:v>
                </c:pt>
                <c:pt idx="608">
                  <c:v>1</c:v>
                </c:pt>
                <c:pt idx="609">
                  <c:v>1</c:v>
                </c:pt>
                <c:pt idx="611">
                  <c:v>1</c:v>
                </c:pt>
                <c:pt idx="612">
                  <c:v>1</c:v>
                </c:pt>
                <c:pt idx="613">
                  <c:v>15</c:v>
                </c:pt>
                <c:pt idx="614">
                  <c:v>1</c:v>
                </c:pt>
                <c:pt idx="615">
                  <c:v>1</c:v>
                </c:pt>
                <c:pt idx="616">
                  <c:v>1</c:v>
                </c:pt>
                <c:pt idx="619">
                  <c:v>1</c:v>
                </c:pt>
                <c:pt idx="622">
                  <c:v>1</c:v>
                </c:pt>
                <c:pt idx="623">
                  <c:v>1</c:v>
                </c:pt>
                <c:pt idx="624">
                  <c:v>10</c:v>
                </c:pt>
                <c:pt idx="626">
                  <c:v>1</c:v>
                </c:pt>
                <c:pt idx="627">
                  <c:v>1</c:v>
                </c:pt>
                <c:pt idx="631">
                  <c:v>1</c:v>
                </c:pt>
                <c:pt idx="632">
                  <c:v>1</c:v>
                </c:pt>
                <c:pt idx="633">
                  <c:v>1</c:v>
                </c:pt>
                <c:pt idx="636">
                  <c:v>1</c:v>
                </c:pt>
                <c:pt idx="638">
                  <c:v>1</c:v>
                </c:pt>
                <c:pt idx="639">
                  <c:v>1</c:v>
                </c:pt>
                <c:pt idx="643">
                  <c:v>1</c:v>
                </c:pt>
                <c:pt idx="649">
                  <c:v>1</c:v>
                </c:pt>
                <c:pt idx="656">
                  <c:v>1</c:v>
                </c:pt>
                <c:pt idx="659">
                  <c:v>1</c:v>
                </c:pt>
                <c:pt idx="660">
                  <c:v>1</c:v>
                </c:pt>
                <c:pt idx="662">
                  <c:v>1</c:v>
                </c:pt>
                <c:pt idx="663">
                  <c:v>1</c:v>
                </c:pt>
                <c:pt idx="665">
                  <c:v>1</c:v>
                </c:pt>
                <c:pt idx="666">
                  <c:v>1</c:v>
                </c:pt>
                <c:pt idx="668">
                  <c:v>1</c:v>
                </c:pt>
                <c:pt idx="669">
                  <c:v>3</c:v>
                </c:pt>
                <c:pt idx="671">
                  <c:v>1</c:v>
                </c:pt>
                <c:pt idx="672">
                  <c:v>1</c:v>
                </c:pt>
                <c:pt idx="673">
                  <c:v>1</c:v>
                </c:pt>
                <c:pt idx="674">
                  <c:v>1</c:v>
                </c:pt>
                <c:pt idx="676">
                  <c:v>1</c:v>
                </c:pt>
                <c:pt idx="677">
                  <c:v>1</c:v>
                </c:pt>
                <c:pt idx="678">
                  <c:v>1</c:v>
                </c:pt>
                <c:pt idx="679">
                  <c:v>1</c:v>
                </c:pt>
                <c:pt idx="680">
                  <c:v>1</c:v>
                </c:pt>
                <c:pt idx="681">
                  <c:v>1</c:v>
                </c:pt>
                <c:pt idx="682">
                  <c:v>1</c:v>
                </c:pt>
                <c:pt idx="683">
                  <c:v>1</c:v>
                </c:pt>
                <c:pt idx="684">
                  <c:v>1</c:v>
                </c:pt>
                <c:pt idx="685">
                  <c:v>1</c:v>
                </c:pt>
                <c:pt idx="686">
                  <c:v>1</c:v>
                </c:pt>
                <c:pt idx="688">
                  <c:v>1</c:v>
                </c:pt>
                <c:pt idx="689">
                  <c:v>1</c:v>
                </c:pt>
                <c:pt idx="691">
                  <c:v>1</c:v>
                </c:pt>
                <c:pt idx="693">
                  <c:v>1</c:v>
                </c:pt>
                <c:pt idx="695">
                  <c:v>1</c:v>
                </c:pt>
                <c:pt idx="696">
                  <c:v>1</c:v>
                </c:pt>
                <c:pt idx="697">
                  <c:v>1</c:v>
                </c:pt>
                <c:pt idx="699">
                  <c:v>1</c:v>
                </c:pt>
                <c:pt idx="701">
                  <c:v>1</c:v>
                </c:pt>
                <c:pt idx="705">
                  <c:v>1</c:v>
                </c:pt>
                <c:pt idx="706">
                  <c:v>1</c:v>
                </c:pt>
                <c:pt idx="708">
                  <c:v>1</c:v>
                </c:pt>
                <c:pt idx="709">
                  <c:v>1</c:v>
                </c:pt>
                <c:pt idx="710">
                  <c:v>1</c:v>
                </c:pt>
                <c:pt idx="712">
                  <c:v>5</c:v>
                </c:pt>
                <c:pt idx="713">
                  <c:v>1</c:v>
                </c:pt>
                <c:pt idx="715">
                  <c:v>1</c:v>
                </c:pt>
                <c:pt idx="716">
                  <c:v>2</c:v>
                </c:pt>
                <c:pt idx="717">
                  <c:v>1</c:v>
                </c:pt>
                <c:pt idx="718">
                  <c:v>1</c:v>
                </c:pt>
                <c:pt idx="722">
                  <c:v>1</c:v>
                </c:pt>
                <c:pt idx="723">
                  <c:v>1</c:v>
                </c:pt>
                <c:pt idx="726">
                  <c:v>1</c:v>
                </c:pt>
                <c:pt idx="727">
                  <c:v>1</c:v>
                </c:pt>
                <c:pt idx="728">
                  <c:v>2</c:v>
                </c:pt>
                <c:pt idx="730">
                  <c:v>1</c:v>
                </c:pt>
                <c:pt idx="733">
                  <c:v>1</c:v>
                </c:pt>
                <c:pt idx="739">
                  <c:v>2</c:v>
                </c:pt>
                <c:pt idx="740">
                  <c:v>1</c:v>
                </c:pt>
                <c:pt idx="742">
                  <c:v>1</c:v>
                </c:pt>
                <c:pt idx="743">
                  <c:v>1</c:v>
                </c:pt>
                <c:pt idx="744">
                  <c:v>1</c:v>
                </c:pt>
                <c:pt idx="745">
                  <c:v>1</c:v>
                </c:pt>
                <c:pt idx="746">
                  <c:v>1</c:v>
                </c:pt>
                <c:pt idx="751">
                  <c:v>1</c:v>
                </c:pt>
                <c:pt idx="753">
                  <c:v>1</c:v>
                </c:pt>
                <c:pt idx="754">
                  <c:v>1</c:v>
                </c:pt>
                <c:pt idx="755">
                  <c:v>1</c:v>
                </c:pt>
                <c:pt idx="756">
                  <c:v>-1</c:v>
                </c:pt>
                <c:pt idx="757">
                  <c:v>1</c:v>
                </c:pt>
                <c:pt idx="758">
                  <c:v>1</c:v>
                </c:pt>
                <c:pt idx="759">
                  <c:v>1</c:v>
                </c:pt>
                <c:pt idx="760">
                  <c:v>1</c:v>
                </c:pt>
                <c:pt idx="761">
                  <c:v>1</c:v>
                </c:pt>
                <c:pt idx="762">
                  <c:v>1</c:v>
                </c:pt>
                <c:pt idx="765">
                  <c:v>1</c:v>
                </c:pt>
                <c:pt idx="768">
                  <c:v>1</c:v>
                </c:pt>
                <c:pt idx="770">
                  <c:v>13</c:v>
                </c:pt>
                <c:pt idx="771">
                  <c:v>1</c:v>
                </c:pt>
                <c:pt idx="773">
                  <c:v>1</c:v>
                </c:pt>
                <c:pt idx="776">
                  <c:v>1</c:v>
                </c:pt>
                <c:pt idx="778">
                  <c:v>1</c:v>
                </c:pt>
                <c:pt idx="779">
                  <c:v>2</c:v>
                </c:pt>
                <c:pt idx="780">
                  <c:v>1</c:v>
                </c:pt>
                <c:pt idx="785">
                  <c:v>1</c:v>
                </c:pt>
                <c:pt idx="789">
                  <c:v>1</c:v>
                </c:pt>
                <c:pt idx="791">
                  <c:v>1</c:v>
                </c:pt>
                <c:pt idx="795">
                  <c:v>1</c:v>
                </c:pt>
                <c:pt idx="796">
                  <c:v>230</c:v>
                </c:pt>
                <c:pt idx="797">
                  <c:v>1</c:v>
                </c:pt>
                <c:pt idx="798">
                  <c:v>1</c:v>
                </c:pt>
                <c:pt idx="802">
                  <c:v>1</c:v>
                </c:pt>
                <c:pt idx="803">
                  <c:v>1</c:v>
                </c:pt>
                <c:pt idx="804">
                  <c:v>5</c:v>
                </c:pt>
                <c:pt idx="805">
                  <c:v>1</c:v>
                </c:pt>
                <c:pt idx="806">
                  <c:v>1</c:v>
                </c:pt>
                <c:pt idx="809">
                  <c:v>1</c:v>
                </c:pt>
                <c:pt idx="813">
                  <c:v>1</c:v>
                </c:pt>
                <c:pt idx="815">
                  <c:v>1</c:v>
                </c:pt>
                <c:pt idx="816">
                  <c:v>1</c:v>
                </c:pt>
                <c:pt idx="817">
                  <c:v>1</c:v>
                </c:pt>
                <c:pt idx="820">
                  <c:v>1</c:v>
                </c:pt>
                <c:pt idx="822">
                  <c:v>1</c:v>
                </c:pt>
                <c:pt idx="823">
                  <c:v>1</c:v>
                </c:pt>
                <c:pt idx="826">
                  <c:v>5</c:v>
                </c:pt>
                <c:pt idx="828">
                  <c:v>1</c:v>
                </c:pt>
                <c:pt idx="830">
                  <c:v>1</c:v>
                </c:pt>
                <c:pt idx="831">
                  <c:v>1</c:v>
                </c:pt>
                <c:pt idx="832">
                  <c:v>1</c:v>
                </c:pt>
                <c:pt idx="833">
                  <c:v>1</c:v>
                </c:pt>
                <c:pt idx="834">
                  <c:v>1</c:v>
                </c:pt>
                <c:pt idx="836">
                  <c:v>156</c:v>
                </c:pt>
                <c:pt idx="837">
                  <c:v>1</c:v>
                </c:pt>
                <c:pt idx="840">
                  <c:v>1</c:v>
                </c:pt>
                <c:pt idx="841">
                  <c:v>1</c:v>
                </c:pt>
                <c:pt idx="842">
                  <c:v>1</c:v>
                </c:pt>
                <c:pt idx="844">
                  <c:v>1</c:v>
                </c:pt>
                <c:pt idx="845">
                  <c:v>1</c:v>
                </c:pt>
                <c:pt idx="847">
                  <c:v>1</c:v>
                </c:pt>
                <c:pt idx="848">
                  <c:v>1</c:v>
                </c:pt>
                <c:pt idx="849">
                  <c:v>2</c:v>
                </c:pt>
                <c:pt idx="852">
                  <c:v>5</c:v>
                </c:pt>
                <c:pt idx="853">
                  <c:v>52</c:v>
                </c:pt>
                <c:pt idx="855">
                  <c:v>1</c:v>
                </c:pt>
                <c:pt idx="856">
                  <c:v>1</c:v>
                </c:pt>
                <c:pt idx="858">
                  <c:v>1</c:v>
                </c:pt>
                <c:pt idx="859">
                  <c:v>1</c:v>
                </c:pt>
                <c:pt idx="860">
                  <c:v>1</c:v>
                </c:pt>
                <c:pt idx="861">
                  <c:v>1</c:v>
                </c:pt>
                <c:pt idx="862">
                  <c:v>1</c:v>
                </c:pt>
                <c:pt idx="863">
                  <c:v>1</c:v>
                </c:pt>
                <c:pt idx="864">
                  <c:v>1</c:v>
                </c:pt>
                <c:pt idx="866">
                  <c:v>1</c:v>
                </c:pt>
                <c:pt idx="874">
                  <c:v>1</c:v>
                </c:pt>
                <c:pt idx="875">
                  <c:v>1</c:v>
                </c:pt>
                <c:pt idx="876">
                  <c:v>1</c:v>
                </c:pt>
                <c:pt idx="877">
                  <c:v>2</c:v>
                </c:pt>
                <c:pt idx="878">
                  <c:v>1</c:v>
                </c:pt>
                <c:pt idx="879">
                  <c:v>9</c:v>
                </c:pt>
                <c:pt idx="880">
                  <c:v>1</c:v>
                </c:pt>
                <c:pt idx="881">
                  <c:v>1</c:v>
                </c:pt>
                <c:pt idx="882">
                  <c:v>1</c:v>
                </c:pt>
                <c:pt idx="884">
                  <c:v>1</c:v>
                </c:pt>
                <c:pt idx="886">
                  <c:v>1</c:v>
                </c:pt>
                <c:pt idx="889">
                  <c:v>1</c:v>
                </c:pt>
                <c:pt idx="890">
                  <c:v>1</c:v>
                </c:pt>
                <c:pt idx="891">
                  <c:v>1</c:v>
                </c:pt>
                <c:pt idx="893">
                  <c:v>1</c:v>
                </c:pt>
                <c:pt idx="894">
                  <c:v>1</c:v>
                </c:pt>
                <c:pt idx="896">
                  <c:v>1</c:v>
                </c:pt>
                <c:pt idx="898">
                  <c:v>1</c:v>
                </c:pt>
                <c:pt idx="902">
                  <c:v>1</c:v>
                </c:pt>
                <c:pt idx="903">
                  <c:v>1</c:v>
                </c:pt>
                <c:pt idx="904">
                  <c:v>13</c:v>
                </c:pt>
                <c:pt idx="906">
                  <c:v>13</c:v>
                </c:pt>
                <c:pt idx="907">
                  <c:v>1</c:v>
                </c:pt>
                <c:pt idx="908">
                  <c:v>1</c:v>
                </c:pt>
                <c:pt idx="909">
                  <c:v>13</c:v>
                </c:pt>
                <c:pt idx="910">
                  <c:v>1</c:v>
                </c:pt>
                <c:pt idx="911">
                  <c:v>1</c:v>
                </c:pt>
                <c:pt idx="912">
                  <c:v>1</c:v>
                </c:pt>
                <c:pt idx="914">
                  <c:v>1</c:v>
                </c:pt>
                <c:pt idx="915">
                  <c:v>1</c:v>
                </c:pt>
                <c:pt idx="916">
                  <c:v>1</c:v>
                </c:pt>
                <c:pt idx="921">
                  <c:v>1</c:v>
                </c:pt>
                <c:pt idx="922">
                  <c:v>1</c:v>
                </c:pt>
                <c:pt idx="923">
                  <c:v>1</c:v>
                </c:pt>
                <c:pt idx="925">
                  <c:v>1</c:v>
                </c:pt>
                <c:pt idx="926">
                  <c:v>1</c:v>
                </c:pt>
                <c:pt idx="928">
                  <c:v>1</c:v>
                </c:pt>
                <c:pt idx="929">
                  <c:v>1</c:v>
                </c:pt>
                <c:pt idx="930">
                  <c:v>1</c:v>
                </c:pt>
                <c:pt idx="933">
                  <c:v>1</c:v>
                </c:pt>
                <c:pt idx="935">
                  <c:v>1</c:v>
                </c:pt>
                <c:pt idx="939">
                  <c:v>1</c:v>
                </c:pt>
                <c:pt idx="941">
                  <c:v>1</c:v>
                </c:pt>
                <c:pt idx="944">
                  <c:v>1</c:v>
                </c:pt>
                <c:pt idx="945">
                  <c:v>7</c:v>
                </c:pt>
                <c:pt idx="949">
                  <c:v>1</c:v>
                </c:pt>
                <c:pt idx="952">
                  <c:v>1</c:v>
                </c:pt>
                <c:pt idx="954">
                  <c:v>1</c:v>
                </c:pt>
                <c:pt idx="955">
                  <c:v>1</c:v>
                </c:pt>
                <c:pt idx="959">
                  <c:v>1</c:v>
                </c:pt>
                <c:pt idx="961">
                  <c:v>1</c:v>
                </c:pt>
                <c:pt idx="962">
                  <c:v>1</c:v>
                </c:pt>
                <c:pt idx="963">
                  <c:v>1</c:v>
                </c:pt>
                <c:pt idx="964">
                  <c:v>27</c:v>
                </c:pt>
                <c:pt idx="965">
                  <c:v>1</c:v>
                </c:pt>
                <c:pt idx="966">
                  <c:v>1</c:v>
                </c:pt>
                <c:pt idx="967">
                  <c:v>1</c:v>
                </c:pt>
                <c:pt idx="968">
                  <c:v>1</c:v>
                </c:pt>
                <c:pt idx="969">
                  <c:v>1</c:v>
                </c:pt>
                <c:pt idx="972">
                  <c:v>1</c:v>
                </c:pt>
                <c:pt idx="974">
                  <c:v>1</c:v>
                </c:pt>
                <c:pt idx="976">
                  <c:v>1</c:v>
                </c:pt>
                <c:pt idx="977">
                  <c:v>3</c:v>
                </c:pt>
                <c:pt idx="980">
                  <c:v>1</c:v>
                </c:pt>
                <c:pt idx="983">
                  <c:v>1</c:v>
                </c:pt>
                <c:pt idx="989">
                  <c:v>2</c:v>
                </c:pt>
                <c:pt idx="990">
                  <c:v>1</c:v>
                </c:pt>
                <c:pt idx="994">
                  <c:v>1</c:v>
                </c:pt>
                <c:pt idx="996">
                  <c:v>1</c:v>
                </c:pt>
                <c:pt idx="998">
                  <c:v>1</c:v>
                </c:pt>
                <c:pt idx="999">
                  <c:v>1</c:v>
                </c:pt>
                <c:pt idx="1000">
                  <c:v>1</c:v>
                </c:pt>
                <c:pt idx="1001">
                  <c:v>2</c:v>
                </c:pt>
                <c:pt idx="1004">
                  <c:v>1</c:v>
                </c:pt>
                <c:pt idx="1008">
                  <c:v>1</c:v>
                </c:pt>
                <c:pt idx="1009">
                  <c:v>1</c:v>
                </c:pt>
                <c:pt idx="1013">
                  <c:v>1</c:v>
                </c:pt>
                <c:pt idx="1014">
                  <c:v>1</c:v>
                </c:pt>
                <c:pt idx="1016">
                  <c:v>1</c:v>
                </c:pt>
                <c:pt idx="1018">
                  <c:v>1</c:v>
                </c:pt>
                <c:pt idx="1019">
                  <c:v>1</c:v>
                </c:pt>
                <c:pt idx="1021">
                  <c:v>1</c:v>
                </c:pt>
                <c:pt idx="1022">
                  <c:v>1</c:v>
                </c:pt>
                <c:pt idx="1023">
                  <c:v>1</c:v>
                </c:pt>
                <c:pt idx="1024">
                  <c:v>1</c:v>
                </c:pt>
                <c:pt idx="1027">
                  <c:v>1</c:v>
                </c:pt>
                <c:pt idx="1029">
                  <c:v>12</c:v>
                </c:pt>
                <c:pt idx="1031">
                  <c:v>20</c:v>
                </c:pt>
                <c:pt idx="1032">
                  <c:v>1</c:v>
                </c:pt>
                <c:pt idx="1033">
                  <c:v>1</c:v>
                </c:pt>
                <c:pt idx="1035">
                  <c:v>1</c:v>
                </c:pt>
                <c:pt idx="1037">
                  <c:v>1</c:v>
                </c:pt>
                <c:pt idx="1039">
                  <c:v>1</c:v>
                </c:pt>
                <c:pt idx="1040">
                  <c:v>1</c:v>
                </c:pt>
                <c:pt idx="1044">
                  <c:v>1</c:v>
                </c:pt>
                <c:pt idx="1046">
                  <c:v>1</c:v>
                </c:pt>
                <c:pt idx="1050">
                  <c:v>1</c:v>
                </c:pt>
                <c:pt idx="1051">
                  <c:v>1</c:v>
                </c:pt>
                <c:pt idx="1054">
                  <c:v>1</c:v>
                </c:pt>
                <c:pt idx="1057">
                  <c:v>1</c:v>
                </c:pt>
                <c:pt idx="1060">
                  <c:v>2</c:v>
                </c:pt>
                <c:pt idx="1062">
                  <c:v>1</c:v>
                </c:pt>
                <c:pt idx="1063">
                  <c:v>1</c:v>
                </c:pt>
                <c:pt idx="1066">
                  <c:v>1</c:v>
                </c:pt>
                <c:pt idx="1068">
                  <c:v>3</c:v>
                </c:pt>
                <c:pt idx="1073">
                  <c:v>1</c:v>
                </c:pt>
                <c:pt idx="1074">
                  <c:v>1</c:v>
                </c:pt>
                <c:pt idx="1075">
                  <c:v>3</c:v>
                </c:pt>
                <c:pt idx="1076">
                  <c:v>1</c:v>
                </c:pt>
                <c:pt idx="1077">
                  <c:v>1</c:v>
                </c:pt>
                <c:pt idx="1078">
                  <c:v>4</c:v>
                </c:pt>
                <c:pt idx="1079">
                  <c:v>1</c:v>
                </c:pt>
                <c:pt idx="1080">
                  <c:v>1</c:v>
                </c:pt>
                <c:pt idx="1082">
                  <c:v>1</c:v>
                </c:pt>
                <c:pt idx="1083">
                  <c:v>1</c:v>
                </c:pt>
                <c:pt idx="1085">
                  <c:v>1</c:v>
                </c:pt>
                <c:pt idx="1086">
                  <c:v>1</c:v>
                </c:pt>
                <c:pt idx="1090">
                  <c:v>1</c:v>
                </c:pt>
                <c:pt idx="1091">
                  <c:v>1</c:v>
                </c:pt>
                <c:pt idx="1092">
                  <c:v>1</c:v>
                </c:pt>
                <c:pt idx="1093">
                  <c:v>1</c:v>
                </c:pt>
                <c:pt idx="1094">
                  <c:v>1</c:v>
                </c:pt>
                <c:pt idx="1096">
                  <c:v>1</c:v>
                </c:pt>
                <c:pt idx="1098">
                  <c:v>1</c:v>
                </c:pt>
                <c:pt idx="1102">
                  <c:v>1</c:v>
                </c:pt>
                <c:pt idx="1104">
                  <c:v>1</c:v>
                </c:pt>
                <c:pt idx="1107">
                  <c:v>1</c:v>
                </c:pt>
                <c:pt idx="1108">
                  <c:v>2</c:v>
                </c:pt>
                <c:pt idx="1109">
                  <c:v>1</c:v>
                </c:pt>
                <c:pt idx="1112">
                  <c:v>1</c:v>
                </c:pt>
                <c:pt idx="1114">
                  <c:v>1</c:v>
                </c:pt>
                <c:pt idx="1115">
                  <c:v>1</c:v>
                </c:pt>
                <c:pt idx="1116">
                  <c:v>1</c:v>
                </c:pt>
                <c:pt idx="1117">
                  <c:v>1</c:v>
                </c:pt>
                <c:pt idx="1118">
                  <c:v>1</c:v>
                </c:pt>
                <c:pt idx="1119">
                  <c:v>1</c:v>
                </c:pt>
                <c:pt idx="1121">
                  <c:v>1</c:v>
                </c:pt>
                <c:pt idx="1123">
                  <c:v>1</c:v>
                </c:pt>
                <c:pt idx="1125">
                  <c:v>1</c:v>
                </c:pt>
                <c:pt idx="1126">
                  <c:v>1</c:v>
                </c:pt>
                <c:pt idx="1127">
                  <c:v>1</c:v>
                </c:pt>
                <c:pt idx="1128">
                  <c:v>5</c:v>
                </c:pt>
                <c:pt idx="1131">
                  <c:v>1</c:v>
                </c:pt>
                <c:pt idx="1132">
                  <c:v>1</c:v>
                </c:pt>
                <c:pt idx="1134">
                  <c:v>1</c:v>
                </c:pt>
                <c:pt idx="1138">
                  <c:v>1</c:v>
                </c:pt>
                <c:pt idx="1140">
                  <c:v>1</c:v>
                </c:pt>
                <c:pt idx="1141">
                  <c:v>1</c:v>
                </c:pt>
                <c:pt idx="1143">
                  <c:v>56</c:v>
                </c:pt>
                <c:pt idx="1144">
                  <c:v>1</c:v>
                </c:pt>
                <c:pt idx="1146">
                  <c:v>1</c:v>
                </c:pt>
                <c:pt idx="1147">
                  <c:v>3</c:v>
                </c:pt>
                <c:pt idx="1149">
                  <c:v>1</c:v>
                </c:pt>
                <c:pt idx="1152">
                  <c:v>1</c:v>
                </c:pt>
                <c:pt idx="1153">
                  <c:v>1</c:v>
                </c:pt>
                <c:pt idx="1154">
                  <c:v>1</c:v>
                </c:pt>
                <c:pt idx="1155">
                  <c:v>1</c:v>
                </c:pt>
                <c:pt idx="1157">
                  <c:v>1</c:v>
                </c:pt>
                <c:pt idx="1158">
                  <c:v>1</c:v>
                </c:pt>
                <c:pt idx="1159">
                  <c:v>1</c:v>
                </c:pt>
                <c:pt idx="1160">
                  <c:v>1</c:v>
                </c:pt>
                <c:pt idx="1161">
                  <c:v>1</c:v>
                </c:pt>
                <c:pt idx="1163">
                  <c:v>1</c:v>
                </c:pt>
                <c:pt idx="1164">
                  <c:v>2</c:v>
                </c:pt>
                <c:pt idx="1165">
                  <c:v>1</c:v>
                </c:pt>
                <c:pt idx="1166">
                  <c:v>1</c:v>
                </c:pt>
                <c:pt idx="1167">
                  <c:v>1</c:v>
                </c:pt>
                <c:pt idx="1168">
                  <c:v>1</c:v>
                </c:pt>
                <c:pt idx="1169">
                  <c:v>4</c:v>
                </c:pt>
                <c:pt idx="1170">
                  <c:v>2</c:v>
                </c:pt>
                <c:pt idx="1172">
                  <c:v>1</c:v>
                </c:pt>
                <c:pt idx="1177">
                  <c:v>1</c:v>
                </c:pt>
                <c:pt idx="1178">
                  <c:v>1</c:v>
                </c:pt>
                <c:pt idx="1179">
                  <c:v>1</c:v>
                </c:pt>
                <c:pt idx="1183">
                  <c:v>1</c:v>
                </c:pt>
                <c:pt idx="1185">
                  <c:v>1</c:v>
                </c:pt>
                <c:pt idx="1187">
                  <c:v>1</c:v>
                </c:pt>
                <c:pt idx="1190">
                  <c:v>1</c:v>
                </c:pt>
                <c:pt idx="1191">
                  <c:v>1</c:v>
                </c:pt>
                <c:pt idx="1193">
                  <c:v>1</c:v>
                </c:pt>
                <c:pt idx="1194">
                  <c:v>1</c:v>
                </c:pt>
                <c:pt idx="1197">
                  <c:v>1</c:v>
                </c:pt>
                <c:pt idx="1198">
                  <c:v>1</c:v>
                </c:pt>
                <c:pt idx="1200">
                  <c:v>1</c:v>
                </c:pt>
                <c:pt idx="1201">
                  <c:v>1</c:v>
                </c:pt>
                <c:pt idx="1203">
                  <c:v>1</c:v>
                </c:pt>
                <c:pt idx="1205">
                  <c:v>1</c:v>
                </c:pt>
                <c:pt idx="1208">
                  <c:v>1</c:v>
                </c:pt>
                <c:pt idx="1209">
                  <c:v>1</c:v>
                </c:pt>
                <c:pt idx="1213">
                  <c:v>1</c:v>
                </c:pt>
                <c:pt idx="1214">
                  <c:v>1</c:v>
                </c:pt>
                <c:pt idx="1215">
                  <c:v>1</c:v>
                </c:pt>
                <c:pt idx="1216">
                  <c:v>1</c:v>
                </c:pt>
                <c:pt idx="1217">
                  <c:v>1</c:v>
                </c:pt>
                <c:pt idx="1218">
                  <c:v>21</c:v>
                </c:pt>
                <c:pt idx="1219">
                  <c:v>1</c:v>
                </c:pt>
                <c:pt idx="1220">
                  <c:v>1</c:v>
                </c:pt>
                <c:pt idx="1224">
                  <c:v>1</c:v>
                </c:pt>
                <c:pt idx="1225">
                  <c:v>1</c:v>
                </c:pt>
                <c:pt idx="1226">
                  <c:v>1</c:v>
                </c:pt>
                <c:pt idx="1227">
                  <c:v>1</c:v>
                </c:pt>
                <c:pt idx="1228">
                  <c:v>1</c:v>
                </c:pt>
                <c:pt idx="1230">
                  <c:v>3</c:v>
                </c:pt>
                <c:pt idx="1235">
                  <c:v>1</c:v>
                </c:pt>
                <c:pt idx="1237">
                  <c:v>1</c:v>
                </c:pt>
                <c:pt idx="1238">
                  <c:v>1</c:v>
                </c:pt>
                <c:pt idx="1241">
                  <c:v>1</c:v>
                </c:pt>
                <c:pt idx="1243">
                  <c:v>1</c:v>
                </c:pt>
                <c:pt idx="1246">
                  <c:v>1</c:v>
                </c:pt>
                <c:pt idx="1248">
                  <c:v>1</c:v>
                </c:pt>
                <c:pt idx="1249">
                  <c:v>1</c:v>
                </c:pt>
                <c:pt idx="1250">
                  <c:v>1</c:v>
                </c:pt>
                <c:pt idx="1251">
                  <c:v>1</c:v>
                </c:pt>
                <c:pt idx="1254">
                  <c:v>1</c:v>
                </c:pt>
                <c:pt idx="1258">
                  <c:v>1</c:v>
                </c:pt>
                <c:pt idx="1259">
                  <c:v>1</c:v>
                </c:pt>
                <c:pt idx="1260">
                  <c:v>1</c:v>
                </c:pt>
                <c:pt idx="1263">
                  <c:v>1</c:v>
                </c:pt>
                <c:pt idx="1266">
                  <c:v>1</c:v>
                </c:pt>
                <c:pt idx="1268">
                  <c:v>1</c:v>
                </c:pt>
                <c:pt idx="1269">
                  <c:v>1</c:v>
                </c:pt>
                <c:pt idx="1270">
                  <c:v>2</c:v>
                </c:pt>
                <c:pt idx="1272">
                  <c:v>1</c:v>
                </c:pt>
                <c:pt idx="1273">
                  <c:v>1</c:v>
                </c:pt>
                <c:pt idx="1275">
                  <c:v>1</c:v>
                </c:pt>
                <c:pt idx="1276">
                  <c:v>1</c:v>
                </c:pt>
                <c:pt idx="1279">
                  <c:v>1</c:v>
                </c:pt>
                <c:pt idx="1282">
                  <c:v>1</c:v>
                </c:pt>
                <c:pt idx="1284">
                  <c:v>1</c:v>
                </c:pt>
                <c:pt idx="1287">
                  <c:v>1</c:v>
                </c:pt>
                <c:pt idx="1288">
                  <c:v>1</c:v>
                </c:pt>
                <c:pt idx="1292">
                  <c:v>1</c:v>
                </c:pt>
                <c:pt idx="1293">
                  <c:v>1</c:v>
                </c:pt>
                <c:pt idx="1294">
                  <c:v>1</c:v>
                </c:pt>
                <c:pt idx="1295">
                  <c:v>1</c:v>
                </c:pt>
                <c:pt idx="1296">
                  <c:v>1</c:v>
                </c:pt>
                <c:pt idx="1298">
                  <c:v>1</c:v>
                </c:pt>
                <c:pt idx="1299">
                  <c:v>1</c:v>
                </c:pt>
                <c:pt idx="1300">
                  <c:v>1</c:v>
                </c:pt>
                <c:pt idx="1301">
                  <c:v>1</c:v>
                </c:pt>
                <c:pt idx="1305">
                  <c:v>1</c:v>
                </c:pt>
                <c:pt idx="1307">
                  <c:v>1</c:v>
                </c:pt>
                <c:pt idx="1309">
                  <c:v>1</c:v>
                </c:pt>
                <c:pt idx="1310">
                  <c:v>1</c:v>
                </c:pt>
                <c:pt idx="1311">
                  <c:v>46</c:v>
                </c:pt>
                <c:pt idx="1312">
                  <c:v>8</c:v>
                </c:pt>
                <c:pt idx="1313">
                  <c:v>1</c:v>
                </c:pt>
                <c:pt idx="1314">
                  <c:v>1</c:v>
                </c:pt>
                <c:pt idx="1315">
                  <c:v>1</c:v>
                </c:pt>
                <c:pt idx="1318">
                  <c:v>1</c:v>
                </c:pt>
                <c:pt idx="1321">
                  <c:v>1</c:v>
                </c:pt>
                <c:pt idx="1322">
                  <c:v>1</c:v>
                </c:pt>
                <c:pt idx="1323">
                  <c:v>2</c:v>
                </c:pt>
                <c:pt idx="1325">
                  <c:v>1</c:v>
                </c:pt>
                <c:pt idx="1327">
                  <c:v>1</c:v>
                </c:pt>
                <c:pt idx="1329">
                  <c:v>1</c:v>
                </c:pt>
                <c:pt idx="1330">
                  <c:v>1</c:v>
                </c:pt>
                <c:pt idx="1332">
                  <c:v>1</c:v>
                </c:pt>
                <c:pt idx="1333">
                  <c:v>1</c:v>
                </c:pt>
                <c:pt idx="1334">
                  <c:v>9</c:v>
                </c:pt>
                <c:pt idx="1340">
                  <c:v>1</c:v>
                </c:pt>
                <c:pt idx="1343">
                  <c:v>1</c:v>
                </c:pt>
                <c:pt idx="1345">
                  <c:v>1</c:v>
                </c:pt>
                <c:pt idx="1346">
                  <c:v>1</c:v>
                </c:pt>
                <c:pt idx="1347">
                  <c:v>1</c:v>
                </c:pt>
                <c:pt idx="1348">
                  <c:v>1</c:v>
                </c:pt>
                <c:pt idx="1349">
                  <c:v>1</c:v>
                </c:pt>
                <c:pt idx="1350">
                  <c:v>30</c:v>
                </c:pt>
                <c:pt idx="1351">
                  <c:v>1</c:v>
                </c:pt>
                <c:pt idx="1352">
                  <c:v>1</c:v>
                </c:pt>
                <c:pt idx="1353">
                  <c:v>1</c:v>
                </c:pt>
                <c:pt idx="1354">
                  <c:v>1</c:v>
                </c:pt>
                <c:pt idx="1355">
                  <c:v>1</c:v>
                </c:pt>
                <c:pt idx="1357">
                  <c:v>1</c:v>
                </c:pt>
                <c:pt idx="1359">
                  <c:v>1</c:v>
                </c:pt>
                <c:pt idx="1362">
                  <c:v>1</c:v>
                </c:pt>
                <c:pt idx="1363">
                  <c:v>1</c:v>
                </c:pt>
                <c:pt idx="1364">
                  <c:v>1</c:v>
                </c:pt>
                <c:pt idx="1365">
                  <c:v>1</c:v>
                </c:pt>
                <c:pt idx="1367">
                  <c:v>1</c:v>
                </c:pt>
                <c:pt idx="1369">
                  <c:v>1</c:v>
                </c:pt>
                <c:pt idx="1370">
                  <c:v>1</c:v>
                </c:pt>
                <c:pt idx="1372">
                  <c:v>1</c:v>
                </c:pt>
                <c:pt idx="1373">
                  <c:v>1</c:v>
                </c:pt>
                <c:pt idx="1374">
                  <c:v>1</c:v>
                </c:pt>
                <c:pt idx="1376">
                  <c:v>1</c:v>
                </c:pt>
                <c:pt idx="1378">
                  <c:v>1</c:v>
                </c:pt>
                <c:pt idx="1379">
                  <c:v>1</c:v>
                </c:pt>
                <c:pt idx="1380">
                  <c:v>1</c:v>
                </c:pt>
                <c:pt idx="1382">
                  <c:v>1</c:v>
                </c:pt>
                <c:pt idx="1384">
                  <c:v>1</c:v>
                </c:pt>
                <c:pt idx="1386">
                  <c:v>1</c:v>
                </c:pt>
                <c:pt idx="1387">
                  <c:v>1</c:v>
                </c:pt>
                <c:pt idx="1388">
                  <c:v>1</c:v>
                </c:pt>
                <c:pt idx="1389">
                  <c:v>1</c:v>
                </c:pt>
                <c:pt idx="1391">
                  <c:v>1</c:v>
                </c:pt>
              </c:numCache>
            </c:numRef>
          </c:yVal>
          <c:smooth val="0"/>
        </c:ser>
        <c:dLbls>
          <c:showLegendKey val="0"/>
          <c:showVal val="0"/>
          <c:showCatName val="0"/>
          <c:showSerName val="0"/>
          <c:showPercent val="0"/>
          <c:showBubbleSize val="0"/>
        </c:dLbls>
        <c:axId val="419271256"/>
        <c:axId val="419271648"/>
      </c:scatterChart>
      <c:valAx>
        <c:axId val="419271256"/>
        <c:scaling>
          <c:orientation val="minMax"/>
          <c:max val="2500"/>
        </c:scaling>
        <c:delete val="0"/>
        <c:axPos val="b"/>
        <c:title>
          <c:tx>
            <c:rich>
              <a:bodyPr/>
              <a:lstStyle/>
              <a:p>
                <a:pPr>
                  <a:defRPr sz="800"/>
                </a:pPr>
                <a:r>
                  <a:rPr lang="en-US" sz="800"/>
                  <a:t>cDNA Position</a:t>
                </a:r>
              </a:p>
            </c:rich>
          </c:tx>
          <c:layout/>
          <c:overlay val="0"/>
        </c:title>
        <c:numFmt formatCode="General" sourceLinked="1"/>
        <c:majorTickMark val="out"/>
        <c:minorTickMark val="none"/>
        <c:tickLblPos val="nextTo"/>
        <c:spPr>
          <a:ln>
            <a:solidFill>
              <a:schemeClr val="tx1"/>
            </a:solidFill>
          </a:ln>
        </c:spPr>
        <c:txPr>
          <a:bodyPr/>
          <a:lstStyle/>
          <a:p>
            <a:pPr>
              <a:defRPr sz="800"/>
            </a:pPr>
            <a:endParaRPr lang="en-US"/>
          </a:p>
        </c:txPr>
        <c:crossAx val="419271648"/>
        <c:crosses val="autoZero"/>
        <c:crossBetween val="midCat"/>
      </c:valAx>
      <c:valAx>
        <c:axId val="419271648"/>
        <c:scaling>
          <c:orientation val="minMax"/>
          <c:max val="240"/>
          <c:min val="0"/>
        </c:scaling>
        <c:delete val="0"/>
        <c:axPos val="l"/>
        <c:title>
          <c:tx>
            <c:rich>
              <a:bodyPr rot="-5400000" vert="horz"/>
              <a:lstStyle/>
              <a:p>
                <a:pPr>
                  <a:defRPr sz="800"/>
                </a:pPr>
                <a:r>
                  <a:rPr lang="en-US" sz="800"/>
                  <a:t>PARE Abundance (TP10M)</a:t>
                </a:r>
              </a:p>
            </c:rich>
          </c:tx>
          <c:layout/>
          <c:overlay val="0"/>
        </c:title>
        <c:numFmt formatCode="General" sourceLinked="1"/>
        <c:majorTickMark val="out"/>
        <c:minorTickMark val="none"/>
        <c:tickLblPos val="nextTo"/>
        <c:spPr>
          <a:ln>
            <a:solidFill>
              <a:schemeClr val="tx1"/>
            </a:solidFill>
          </a:ln>
        </c:spPr>
        <c:txPr>
          <a:bodyPr/>
          <a:lstStyle/>
          <a:p>
            <a:pPr>
              <a:defRPr sz="800"/>
            </a:pPr>
            <a:endParaRPr lang="en-US"/>
          </a:p>
        </c:txPr>
        <c:crossAx val="419271256"/>
        <c:crosses val="autoZero"/>
        <c:crossBetween val="midCat"/>
        <c:majorUnit val="30"/>
      </c:valAx>
    </c:plotArea>
    <c:plotVisOnly val="1"/>
    <c:dispBlanksAs val="gap"/>
    <c:showDLblsOverMax val="0"/>
  </c:chart>
  <c:spPr>
    <a:ln>
      <a:solidFill>
        <a:schemeClr val="tx1"/>
      </a:solidFill>
    </a:ln>
  </c:spPr>
  <c:externalData r:id="rId1">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sz="1200"/>
            </a:pPr>
            <a:r>
              <a:rPr lang="en-US" sz="1200" dirty="0" smtClean="0"/>
              <a:t>Cold</a:t>
            </a:r>
            <a:endParaRPr lang="en-US" sz="1200" dirty="0"/>
          </a:p>
        </c:rich>
      </c:tx>
      <c:layout/>
      <c:overlay val="0"/>
    </c:title>
    <c:autoTitleDeleted val="0"/>
    <c:plotArea>
      <c:layout/>
      <c:scatterChart>
        <c:scatterStyle val="lineMarker"/>
        <c:varyColors val="0"/>
        <c:ser>
          <c:idx val="0"/>
          <c:order val="0"/>
          <c:tx>
            <c:v>Cold1</c:v>
          </c:tx>
          <c:spPr>
            <a:ln w="28575">
              <a:noFill/>
            </a:ln>
          </c:spPr>
          <c:marker>
            <c:symbol val="circle"/>
            <c:size val="5"/>
            <c:spPr>
              <a:solidFill>
                <a:srgbClr val="000000"/>
              </a:solidFill>
              <a:ln w="9525">
                <a:solidFill>
                  <a:srgbClr val="000000"/>
                </a:solidFill>
              </a:ln>
            </c:spPr>
          </c:marker>
          <c:dPt>
            <c:idx val="853"/>
            <c:marker>
              <c:spPr>
                <a:solidFill>
                  <a:srgbClr val="FF0000"/>
                </a:solidFill>
                <a:ln w="9525">
                  <a:solidFill>
                    <a:srgbClr val="FF0000"/>
                  </a:solidFill>
                </a:ln>
              </c:spPr>
            </c:marker>
            <c:bubble3D val="0"/>
          </c:dPt>
          <c:xVal>
            <c:numRef>
              <c:f>'Brachy TIR1'!$B$4:$B$1395</c:f>
              <c:numCache>
                <c:formatCode>General</c:formatCode>
                <c:ptCount val="1392"/>
                <c:pt idx="0">
                  <c:v>1498</c:v>
                </c:pt>
                <c:pt idx="1">
                  <c:v>1908</c:v>
                </c:pt>
                <c:pt idx="2">
                  <c:v>1968</c:v>
                </c:pt>
                <c:pt idx="3">
                  <c:v>2214</c:v>
                </c:pt>
                <c:pt idx="4">
                  <c:v>1946</c:v>
                </c:pt>
                <c:pt idx="5">
                  <c:v>1202</c:v>
                </c:pt>
                <c:pt idx="6">
                  <c:v>2352</c:v>
                </c:pt>
                <c:pt idx="7">
                  <c:v>2393</c:v>
                </c:pt>
                <c:pt idx="8">
                  <c:v>1821</c:v>
                </c:pt>
                <c:pt idx="9">
                  <c:v>1956</c:v>
                </c:pt>
                <c:pt idx="10">
                  <c:v>1017</c:v>
                </c:pt>
                <c:pt idx="11">
                  <c:v>922</c:v>
                </c:pt>
                <c:pt idx="12">
                  <c:v>709</c:v>
                </c:pt>
                <c:pt idx="13">
                  <c:v>2254</c:v>
                </c:pt>
                <c:pt idx="14">
                  <c:v>2359</c:v>
                </c:pt>
                <c:pt idx="15">
                  <c:v>1700</c:v>
                </c:pt>
                <c:pt idx="16">
                  <c:v>1399</c:v>
                </c:pt>
                <c:pt idx="17">
                  <c:v>1200</c:v>
                </c:pt>
                <c:pt idx="18">
                  <c:v>1025</c:v>
                </c:pt>
                <c:pt idx="19">
                  <c:v>2159</c:v>
                </c:pt>
                <c:pt idx="20">
                  <c:v>749</c:v>
                </c:pt>
                <c:pt idx="21">
                  <c:v>2041</c:v>
                </c:pt>
                <c:pt idx="22">
                  <c:v>1500</c:v>
                </c:pt>
                <c:pt idx="23">
                  <c:v>1972</c:v>
                </c:pt>
                <c:pt idx="24">
                  <c:v>474</c:v>
                </c:pt>
                <c:pt idx="25">
                  <c:v>385</c:v>
                </c:pt>
                <c:pt idx="26">
                  <c:v>591</c:v>
                </c:pt>
                <c:pt idx="27">
                  <c:v>1259</c:v>
                </c:pt>
                <c:pt idx="28">
                  <c:v>649</c:v>
                </c:pt>
                <c:pt idx="29">
                  <c:v>2216</c:v>
                </c:pt>
                <c:pt idx="30">
                  <c:v>814</c:v>
                </c:pt>
                <c:pt idx="31">
                  <c:v>1386</c:v>
                </c:pt>
                <c:pt idx="32">
                  <c:v>2426</c:v>
                </c:pt>
                <c:pt idx="33">
                  <c:v>2149</c:v>
                </c:pt>
                <c:pt idx="34">
                  <c:v>1719</c:v>
                </c:pt>
                <c:pt idx="35">
                  <c:v>977</c:v>
                </c:pt>
                <c:pt idx="36">
                  <c:v>1095</c:v>
                </c:pt>
                <c:pt idx="37">
                  <c:v>711</c:v>
                </c:pt>
                <c:pt idx="38">
                  <c:v>619</c:v>
                </c:pt>
                <c:pt idx="39">
                  <c:v>1930</c:v>
                </c:pt>
                <c:pt idx="40">
                  <c:v>884</c:v>
                </c:pt>
                <c:pt idx="41">
                  <c:v>1668</c:v>
                </c:pt>
                <c:pt idx="42">
                  <c:v>1012</c:v>
                </c:pt>
                <c:pt idx="43">
                  <c:v>2143</c:v>
                </c:pt>
                <c:pt idx="44">
                  <c:v>1777</c:v>
                </c:pt>
                <c:pt idx="45">
                  <c:v>2412</c:v>
                </c:pt>
                <c:pt idx="46">
                  <c:v>2061</c:v>
                </c:pt>
                <c:pt idx="47">
                  <c:v>1828</c:v>
                </c:pt>
                <c:pt idx="48">
                  <c:v>141</c:v>
                </c:pt>
                <c:pt idx="49">
                  <c:v>2025</c:v>
                </c:pt>
                <c:pt idx="50">
                  <c:v>1122</c:v>
                </c:pt>
                <c:pt idx="51">
                  <c:v>2411</c:v>
                </c:pt>
                <c:pt idx="52">
                  <c:v>1703</c:v>
                </c:pt>
                <c:pt idx="53">
                  <c:v>2209</c:v>
                </c:pt>
                <c:pt idx="54">
                  <c:v>1796</c:v>
                </c:pt>
                <c:pt idx="55">
                  <c:v>2424</c:v>
                </c:pt>
                <c:pt idx="56">
                  <c:v>2379</c:v>
                </c:pt>
                <c:pt idx="57">
                  <c:v>2212</c:v>
                </c:pt>
                <c:pt idx="58">
                  <c:v>400</c:v>
                </c:pt>
                <c:pt idx="59">
                  <c:v>1529</c:v>
                </c:pt>
                <c:pt idx="60">
                  <c:v>2081</c:v>
                </c:pt>
                <c:pt idx="61">
                  <c:v>877</c:v>
                </c:pt>
                <c:pt idx="62">
                  <c:v>731</c:v>
                </c:pt>
                <c:pt idx="63">
                  <c:v>2324</c:v>
                </c:pt>
                <c:pt idx="64">
                  <c:v>2144</c:v>
                </c:pt>
                <c:pt idx="65">
                  <c:v>1897</c:v>
                </c:pt>
                <c:pt idx="66">
                  <c:v>2138</c:v>
                </c:pt>
                <c:pt idx="67">
                  <c:v>2240</c:v>
                </c:pt>
                <c:pt idx="68">
                  <c:v>865</c:v>
                </c:pt>
                <c:pt idx="69">
                  <c:v>1927</c:v>
                </c:pt>
                <c:pt idx="70">
                  <c:v>2047</c:v>
                </c:pt>
                <c:pt idx="71">
                  <c:v>953</c:v>
                </c:pt>
                <c:pt idx="72">
                  <c:v>771</c:v>
                </c:pt>
                <c:pt idx="73">
                  <c:v>1453</c:v>
                </c:pt>
                <c:pt idx="74">
                  <c:v>561</c:v>
                </c:pt>
                <c:pt idx="75">
                  <c:v>1073</c:v>
                </c:pt>
                <c:pt idx="76">
                  <c:v>1834</c:v>
                </c:pt>
                <c:pt idx="77">
                  <c:v>1165</c:v>
                </c:pt>
                <c:pt idx="78">
                  <c:v>495</c:v>
                </c:pt>
                <c:pt idx="79">
                  <c:v>2281</c:v>
                </c:pt>
                <c:pt idx="80">
                  <c:v>1869</c:v>
                </c:pt>
                <c:pt idx="81">
                  <c:v>713</c:v>
                </c:pt>
                <c:pt idx="82">
                  <c:v>1985</c:v>
                </c:pt>
                <c:pt idx="83">
                  <c:v>2333</c:v>
                </c:pt>
                <c:pt idx="84">
                  <c:v>1947</c:v>
                </c:pt>
                <c:pt idx="85">
                  <c:v>1707</c:v>
                </c:pt>
                <c:pt idx="86">
                  <c:v>1675</c:v>
                </c:pt>
                <c:pt idx="87">
                  <c:v>881</c:v>
                </c:pt>
                <c:pt idx="88">
                  <c:v>1092</c:v>
                </c:pt>
                <c:pt idx="89">
                  <c:v>955</c:v>
                </c:pt>
                <c:pt idx="90">
                  <c:v>1746</c:v>
                </c:pt>
                <c:pt idx="91">
                  <c:v>1647</c:v>
                </c:pt>
                <c:pt idx="92">
                  <c:v>989</c:v>
                </c:pt>
                <c:pt idx="93">
                  <c:v>1680</c:v>
                </c:pt>
                <c:pt idx="94">
                  <c:v>1123</c:v>
                </c:pt>
                <c:pt idx="95">
                  <c:v>1824</c:v>
                </c:pt>
                <c:pt idx="96">
                  <c:v>848</c:v>
                </c:pt>
                <c:pt idx="97">
                  <c:v>621</c:v>
                </c:pt>
                <c:pt idx="98">
                  <c:v>1815</c:v>
                </c:pt>
                <c:pt idx="99">
                  <c:v>2425</c:v>
                </c:pt>
                <c:pt idx="100">
                  <c:v>754</c:v>
                </c:pt>
                <c:pt idx="101">
                  <c:v>2268</c:v>
                </c:pt>
                <c:pt idx="102">
                  <c:v>2315</c:v>
                </c:pt>
                <c:pt idx="103">
                  <c:v>2391</c:v>
                </c:pt>
                <c:pt idx="104">
                  <c:v>1528</c:v>
                </c:pt>
                <c:pt idx="105">
                  <c:v>1893</c:v>
                </c:pt>
                <c:pt idx="106">
                  <c:v>1181</c:v>
                </c:pt>
                <c:pt idx="107">
                  <c:v>2084</c:v>
                </c:pt>
                <c:pt idx="108">
                  <c:v>958</c:v>
                </c:pt>
                <c:pt idx="109">
                  <c:v>2275</c:v>
                </c:pt>
                <c:pt idx="110">
                  <c:v>1806</c:v>
                </c:pt>
                <c:pt idx="111">
                  <c:v>2241</c:v>
                </c:pt>
                <c:pt idx="112">
                  <c:v>1431</c:v>
                </c:pt>
                <c:pt idx="113">
                  <c:v>1532</c:v>
                </c:pt>
                <c:pt idx="114">
                  <c:v>1918</c:v>
                </c:pt>
                <c:pt idx="115">
                  <c:v>2384</c:v>
                </c:pt>
                <c:pt idx="116">
                  <c:v>872</c:v>
                </c:pt>
                <c:pt idx="117">
                  <c:v>1957</c:v>
                </c:pt>
                <c:pt idx="118">
                  <c:v>1541</c:v>
                </c:pt>
                <c:pt idx="119">
                  <c:v>1104</c:v>
                </c:pt>
                <c:pt idx="120">
                  <c:v>2456</c:v>
                </c:pt>
                <c:pt idx="121">
                  <c:v>409</c:v>
                </c:pt>
                <c:pt idx="122">
                  <c:v>1755</c:v>
                </c:pt>
                <c:pt idx="123">
                  <c:v>2444</c:v>
                </c:pt>
                <c:pt idx="124">
                  <c:v>2312</c:v>
                </c:pt>
                <c:pt idx="125">
                  <c:v>891</c:v>
                </c:pt>
                <c:pt idx="126">
                  <c:v>2225</c:v>
                </c:pt>
                <c:pt idx="127">
                  <c:v>1558</c:v>
                </c:pt>
                <c:pt idx="128">
                  <c:v>1192</c:v>
                </c:pt>
                <c:pt idx="129">
                  <c:v>1757</c:v>
                </c:pt>
                <c:pt idx="130">
                  <c:v>684</c:v>
                </c:pt>
                <c:pt idx="131">
                  <c:v>2170</c:v>
                </c:pt>
                <c:pt idx="132">
                  <c:v>1283</c:v>
                </c:pt>
                <c:pt idx="133">
                  <c:v>2264</c:v>
                </c:pt>
                <c:pt idx="134">
                  <c:v>2450</c:v>
                </c:pt>
                <c:pt idx="135">
                  <c:v>680</c:v>
                </c:pt>
                <c:pt idx="136">
                  <c:v>612</c:v>
                </c:pt>
                <c:pt idx="137">
                  <c:v>2397</c:v>
                </c:pt>
                <c:pt idx="138">
                  <c:v>841</c:v>
                </c:pt>
                <c:pt idx="139">
                  <c:v>1971</c:v>
                </c:pt>
                <c:pt idx="140">
                  <c:v>790</c:v>
                </c:pt>
                <c:pt idx="141">
                  <c:v>1858</c:v>
                </c:pt>
                <c:pt idx="142">
                  <c:v>1706</c:v>
                </c:pt>
                <c:pt idx="143">
                  <c:v>1226</c:v>
                </c:pt>
                <c:pt idx="144">
                  <c:v>733</c:v>
                </c:pt>
                <c:pt idx="145">
                  <c:v>1663</c:v>
                </c:pt>
                <c:pt idx="146">
                  <c:v>2313</c:v>
                </c:pt>
                <c:pt idx="147">
                  <c:v>1855</c:v>
                </c:pt>
                <c:pt idx="148">
                  <c:v>807</c:v>
                </c:pt>
                <c:pt idx="149">
                  <c:v>1713</c:v>
                </c:pt>
                <c:pt idx="150">
                  <c:v>1650</c:v>
                </c:pt>
                <c:pt idx="151">
                  <c:v>1623</c:v>
                </c:pt>
                <c:pt idx="152">
                  <c:v>1207</c:v>
                </c:pt>
                <c:pt idx="153">
                  <c:v>669</c:v>
                </c:pt>
                <c:pt idx="154">
                  <c:v>1991</c:v>
                </c:pt>
                <c:pt idx="155">
                  <c:v>1353</c:v>
                </c:pt>
                <c:pt idx="156">
                  <c:v>696</c:v>
                </c:pt>
                <c:pt idx="157">
                  <c:v>815</c:v>
                </c:pt>
                <c:pt idx="158">
                  <c:v>2188</c:v>
                </c:pt>
                <c:pt idx="159">
                  <c:v>1810</c:v>
                </c:pt>
                <c:pt idx="160">
                  <c:v>914</c:v>
                </c:pt>
                <c:pt idx="161">
                  <c:v>1949</c:v>
                </c:pt>
                <c:pt idx="162">
                  <c:v>1546</c:v>
                </c:pt>
                <c:pt idx="163">
                  <c:v>2060</c:v>
                </c:pt>
                <c:pt idx="164">
                  <c:v>1115</c:v>
                </c:pt>
                <c:pt idx="165">
                  <c:v>788</c:v>
                </c:pt>
                <c:pt idx="166">
                  <c:v>699</c:v>
                </c:pt>
                <c:pt idx="167">
                  <c:v>1293</c:v>
                </c:pt>
                <c:pt idx="168">
                  <c:v>1549</c:v>
                </c:pt>
                <c:pt idx="169">
                  <c:v>964</c:v>
                </c:pt>
                <c:pt idx="170">
                  <c:v>742</c:v>
                </c:pt>
                <c:pt idx="171">
                  <c:v>1989</c:v>
                </c:pt>
                <c:pt idx="172">
                  <c:v>2189</c:v>
                </c:pt>
                <c:pt idx="173">
                  <c:v>1605</c:v>
                </c:pt>
                <c:pt idx="174">
                  <c:v>1687</c:v>
                </c:pt>
                <c:pt idx="175">
                  <c:v>2115</c:v>
                </c:pt>
                <c:pt idx="176">
                  <c:v>644</c:v>
                </c:pt>
                <c:pt idx="177">
                  <c:v>1009</c:v>
                </c:pt>
                <c:pt idx="178">
                  <c:v>1584</c:v>
                </c:pt>
                <c:pt idx="179">
                  <c:v>1729</c:v>
                </c:pt>
                <c:pt idx="180">
                  <c:v>1289</c:v>
                </c:pt>
                <c:pt idx="181">
                  <c:v>751</c:v>
                </c:pt>
                <c:pt idx="182">
                  <c:v>2364</c:v>
                </c:pt>
                <c:pt idx="183">
                  <c:v>743</c:v>
                </c:pt>
                <c:pt idx="184">
                  <c:v>875</c:v>
                </c:pt>
                <c:pt idx="185">
                  <c:v>1139</c:v>
                </c:pt>
                <c:pt idx="186">
                  <c:v>869</c:v>
                </c:pt>
                <c:pt idx="187">
                  <c:v>635</c:v>
                </c:pt>
                <c:pt idx="188">
                  <c:v>585</c:v>
                </c:pt>
                <c:pt idx="189">
                  <c:v>1781</c:v>
                </c:pt>
                <c:pt idx="190">
                  <c:v>908</c:v>
                </c:pt>
                <c:pt idx="191">
                  <c:v>1926</c:v>
                </c:pt>
                <c:pt idx="192">
                  <c:v>2113</c:v>
                </c:pt>
                <c:pt idx="193">
                  <c:v>1795</c:v>
                </c:pt>
                <c:pt idx="194">
                  <c:v>1847</c:v>
                </c:pt>
                <c:pt idx="195">
                  <c:v>2338</c:v>
                </c:pt>
                <c:pt idx="196">
                  <c:v>492</c:v>
                </c:pt>
                <c:pt idx="197">
                  <c:v>1677</c:v>
                </c:pt>
                <c:pt idx="198">
                  <c:v>2195</c:v>
                </c:pt>
                <c:pt idx="199">
                  <c:v>567</c:v>
                </c:pt>
                <c:pt idx="200">
                  <c:v>589</c:v>
                </c:pt>
                <c:pt idx="201">
                  <c:v>2156</c:v>
                </c:pt>
                <c:pt idx="202">
                  <c:v>976</c:v>
                </c:pt>
                <c:pt idx="203">
                  <c:v>889</c:v>
                </c:pt>
                <c:pt idx="204">
                  <c:v>1837</c:v>
                </c:pt>
                <c:pt idx="205">
                  <c:v>1588</c:v>
                </c:pt>
                <c:pt idx="206">
                  <c:v>2414</c:v>
                </c:pt>
                <c:pt idx="207">
                  <c:v>924</c:v>
                </c:pt>
                <c:pt idx="208">
                  <c:v>2227</c:v>
                </c:pt>
                <c:pt idx="209">
                  <c:v>1994</c:v>
                </c:pt>
                <c:pt idx="210">
                  <c:v>1888</c:v>
                </c:pt>
                <c:pt idx="211">
                  <c:v>2070</c:v>
                </c:pt>
                <c:pt idx="212">
                  <c:v>2369</c:v>
                </c:pt>
                <c:pt idx="213">
                  <c:v>753</c:v>
                </c:pt>
                <c:pt idx="214">
                  <c:v>2152</c:v>
                </c:pt>
                <c:pt idx="215">
                  <c:v>846</c:v>
                </c:pt>
                <c:pt idx="216">
                  <c:v>718</c:v>
                </c:pt>
                <c:pt idx="217">
                  <c:v>1159</c:v>
                </c:pt>
                <c:pt idx="218">
                  <c:v>1166</c:v>
                </c:pt>
                <c:pt idx="219">
                  <c:v>1688</c:v>
                </c:pt>
                <c:pt idx="220">
                  <c:v>1937</c:v>
                </c:pt>
                <c:pt idx="221">
                  <c:v>1909</c:v>
                </c:pt>
                <c:pt idx="222">
                  <c:v>911</c:v>
                </c:pt>
                <c:pt idx="223">
                  <c:v>2321</c:v>
                </c:pt>
                <c:pt idx="224">
                  <c:v>433</c:v>
                </c:pt>
                <c:pt idx="225">
                  <c:v>970</c:v>
                </c:pt>
                <c:pt idx="226">
                  <c:v>1448</c:v>
                </c:pt>
                <c:pt idx="227">
                  <c:v>1281</c:v>
                </c:pt>
                <c:pt idx="228">
                  <c:v>1664</c:v>
                </c:pt>
                <c:pt idx="229">
                  <c:v>2317</c:v>
                </c:pt>
                <c:pt idx="230">
                  <c:v>1393</c:v>
                </c:pt>
                <c:pt idx="231">
                  <c:v>1099</c:v>
                </c:pt>
                <c:pt idx="232">
                  <c:v>1862</c:v>
                </c:pt>
                <c:pt idx="233">
                  <c:v>2386</c:v>
                </c:pt>
                <c:pt idx="234">
                  <c:v>2173</c:v>
                </c:pt>
                <c:pt idx="235">
                  <c:v>1640</c:v>
                </c:pt>
                <c:pt idx="236">
                  <c:v>540</c:v>
                </c:pt>
                <c:pt idx="237">
                  <c:v>1011</c:v>
                </c:pt>
                <c:pt idx="238">
                  <c:v>1517</c:v>
                </c:pt>
                <c:pt idx="239">
                  <c:v>992</c:v>
                </c:pt>
                <c:pt idx="240">
                  <c:v>1132</c:v>
                </c:pt>
                <c:pt idx="241">
                  <c:v>1762</c:v>
                </c:pt>
                <c:pt idx="242">
                  <c:v>1227</c:v>
                </c:pt>
                <c:pt idx="243">
                  <c:v>1155</c:v>
                </c:pt>
                <c:pt idx="244">
                  <c:v>2204</c:v>
                </c:pt>
                <c:pt idx="245">
                  <c:v>662</c:v>
                </c:pt>
                <c:pt idx="246">
                  <c:v>690</c:v>
                </c:pt>
                <c:pt idx="247">
                  <c:v>1922</c:v>
                </c:pt>
                <c:pt idx="248">
                  <c:v>1485</c:v>
                </c:pt>
                <c:pt idx="249">
                  <c:v>702</c:v>
                </c:pt>
                <c:pt idx="250">
                  <c:v>873</c:v>
                </c:pt>
                <c:pt idx="251">
                  <c:v>827</c:v>
                </c:pt>
                <c:pt idx="252">
                  <c:v>1980</c:v>
                </c:pt>
                <c:pt idx="253">
                  <c:v>677</c:v>
                </c:pt>
                <c:pt idx="254">
                  <c:v>2339</c:v>
                </c:pt>
                <c:pt idx="255">
                  <c:v>2290</c:v>
                </c:pt>
                <c:pt idx="256">
                  <c:v>2246</c:v>
                </c:pt>
                <c:pt idx="257">
                  <c:v>1506</c:v>
                </c:pt>
                <c:pt idx="258">
                  <c:v>833</c:v>
                </c:pt>
                <c:pt idx="259">
                  <c:v>2345</c:v>
                </c:pt>
                <c:pt idx="260">
                  <c:v>1036</c:v>
                </c:pt>
                <c:pt idx="261">
                  <c:v>1902</c:v>
                </c:pt>
                <c:pt idx="262">
                  <c:v>1853</c:v>
                </c:pt>
                <c:pt idx="263">
                  <c:v>2126</c:v>
                </c:pt>
                <c:pt idx="264">
                  <c:v>68</c:v>
                </c:pt>
                <c:pt idx="265">
                  <c:v>736</c:v>
                </c:pt>
                <c:pt idx="266">
                  <c:v>2172</c:v>
                </c:pt>
                <c:pt idx="267">
                  <c:v>426</c:v>
                </c:pt>
                <c:pt idx="268">
                  <c:v>2153</c:v>
                </c:pt>
                <c:pt idx="269">
                  <c:v>2446</c:v>
                </c:pt>
                <c:pt idx="270">
                  <c:v>836</c:v>
                </c:pt>
                <c:pt idx="271">
                  <c:v>1794</c:v>
                </c:pt>
                <c:pt idx="272">
                  <c:v>2100</c:v>
                </c:pt>
                <c:pt idx="273">
                  <c:v>579</c:v>
                </c:pt>
                <c:pt idx="274">
                  <c:v>1468</c:v>
                </c:pt>
                <c:pt idx="275">
                  <c:v>1720</c:v>
                </c:pt>
                <c:pt idx="276">
                  <c:v>2200</c:v>
                </c:pt>
                <c:pt idx="277">
                  <c:v>965</c:v>
                </c:pt>
                <c:pt idx="278">
                  <c:v>1307</c:v>
                </c:pt>
                <c:pt idx="279">
                  <c:v>765</c:v>
                </c:pt>
                <c:pt idx="280">
                  <c:v>2420</c:v>
                </c:pt>
                <c:pt idx="281">
                  <c:v>1615</c:v>
                </c:pt>
                <c:pt idx="282">
                  <c:v>622</c:v>
                </c:pt>
                <c:pt idx="283">
                  <c:v>2094</c:v>
                </c:pt>
                <c:pt idx="284">
                  <c:v>2097</c:v>
                </c:pt>
                <c:pt idx="285">
                  <c:v>2236</c:v>
                </c:pt>
                <c:pt idx="286">
                  <c:v>1064</c:v>
                </c:pt>
                <c:pt idx="287">
                  <c:v>1896</c:v>
                </c:pt>
                <c:pt idx="288">
                  <c:v>1807</c:v>
                </c:pt>
                <c:pt idx="289">
                  <c:v>2415</c:v>
                </c:pt>
                <c:pt idx="290">
                  <c:v>2316</c:v>
                </c:pt>
                <c:pt idx="291">
                  <c:v>1313</c:v>
                </c:pt>
                <c:pt idx="292">
                  <c:v>1247</c:v>
                </c:pt>
                <c:pt idx="293">
                  <c:v>2179</c:v>
                </c:pt>
                <c:pt idx="294">
                  <c:v>862</c:v>
                </c:pt>
                <c:pt idx="295">
                  <c:v>1833</c:v>
                </c:pt>
                <c:pt idx="296">
                  <c:v>805</c:v>
                </c:pt>
                <c:pt idx="297">
                  <c:v>2297</c:v>
                </c:pt>
                <c:pt idx="298">
                  <c:v>424</c:v>
                </c:pt>
                <c:pt idx="299">
                  <c:v>1679</c:v>
                </c:pt>
                <c:pt idx="300">
                  <c:v>981</c:v>
                </c:pt>
                <c:pt idx="301">
                  <c:v>415</c:v>
                </c:pt>
                <c:pt idx="302">
                  <c:v>982</c:v>
                </c:pt>
                <c:pt idx="303">
                  <c:v>1811</c:v>
                </c:pt>
                <c:pt idx="304">
                  <c:v>2272</c:v>
                </c:pt>
                <c:pt idx="305">
                  <c:v>1716</c:v>
                </c:pt>
                <c:pt idx="306">
                  <c:v>2105</c:v>
                </c:pt>
                <c:pt idx="307">
                  <c:v>1499</c:v>
                </c:pt>
                <c:pt idx="308">
                  <c:v>2266</c:v>
                </c:pt>
                <c:pt idx="309">
                  <c:v>1157</c:v>
                </c:pt>
                <c:pt idx="310">
                  <c:v>1337</c:v>
                </c:pt>
                <c:pt idx="311">
                  <c:v>2184</c:v>
                </c:pt>
                <c:pt idx="312">
                  <c:v>1579</c:v>
                </c:pt>
                <c:pt idx="313">
                  <c:v>2341</c:v>
                </c:pt>
                <c:pt idx="314">
                  <c:v>1120</c:v>
                </c:pt>
                <c:pt idx="315">
                  <c:v>1315</c:v>
                </c:pt>
                <c:pt idx="316">
                  <c:v>1257</c:v>
                </c:pt>
                <c:pt idx="317">
                  <c:v>1548</c:v>
                </c:pt>
                <c:pt idx="318">
                  <c:v>1028</c:v>
                </c:pt>
                <c:pt idx="319">
                  <c:v>377</c:v>
                </c:pt>
                <c:pt idx="320">
                  <c:v>888</c:v>
                </c:pt>
                <c:pt idx="321">
                  <c:v>1371</c:v>
                </c:pt>
                <c:pt idx="322">
                  <c:v>979</c:v>
                </c:pt>
                <c:pt idx="323">
                  <c:v>2040</c:v>
                </c:pt>
                <c:pt idx="324">
                  <c:v>2076</c:v>
                </c:pt>
                <c:pt idx="325">
                  <c:v>2251</c:v>
                </c:pt>
                <c:pt idx="326">
                  <c:v>2322</c:v>
                </c:pt>
                <c:pt idx="327">
                  <c:v>1180</c:v>
                </c:pt>
                <c:pt idx="328">
                  <c:v>1648</c:v>
                </c:pt>
                <c:pt idx="329">
                  <c:v>764</c:v>
                </c:pt>
                <c:pt idx="330">
                  <c:v>2306</c:v>
                </c:pt>
                <c:pt idx="331">
                  <c:v>1715</c:v>
                </c:pt>
                <c:pt idx="332">
                  <c:v>648</c:v>
                </c:pt>
                <c:pt idx="333">
                  <c:v>1981</c:v>
                </c:pt>
                <c:pt idx="334">
                  <c:v>1620</c:v>
                </c:pt>
                <c:pt idx="335">
                  <c:v>1782</c:v>
                </c:pt>
                <c:pt idx="336">
                  <c:v>708</c:v>
                </c:pt>
                <c:pt idx="337">
                  <c:v>2074</c:v>
                </c:pt>
                <c:pt idx="338">
                  <c:v>575</c:v>
                </c:pt>
                <c:pt idx="339">
                  <c:v>2284</c:v>
                </c:pt>
                <c:pt idx="340">
                  <c:v>1019</c:v>
                </c:pt>
                <c:pt idx="341">
                  <c:v>1024</c:v>
                </c:pt>
                <c:pt idx="342">
                  <c:v>1429</c:v>
                </c:pt>
                <c:pt idx="343">
                  <c:v>1831</c:v>
                </c:pt>
                <c:pt idx="344">
                  <c:v>1471</c:v>
                </c:pt>
                <c:pt idx="345">
                  <c:v>2343</c:v>
                </c:pt>
                <c:pt idx="346">
                  <c:v>1632</c:v>
                </c:pt>
                <c:pt idx="347">
                  <c:v>766</c:v>
                </c:pt>
                <c:pt idx="348">
                  <c:v>642</c:v>
                </c:pt>
                <c:pt idx="349">
                  <c:v>651</c:v>
                </c:pt>
                <c:pt idx="350">
                  <c:v>1232</c:v>
                </c:pt>
                <c:pt idx="351">
                  <c:v>574</c:v>
                </c:pt>
                <c:pt idx="352">
                  <c:v>939</c:v>
                </c:pt>
                <c:pt idx="353">
                  <c:v>2080</c:v>
                </c:pt>
                <c:pt idx="354">
                  <c:v>1887</c:v>
                </c:pt>
                <c:pt idx="355">
                  <c:v>1778</c:v>
                </c:pt>
                <c:pt idx="356">
                  <c:v>1015</c:v>
                </c:pt>
                <c:pt idx="357">
                  <c:v>1182</c:v>
                </c:pt>
                <c:pt idx="358">
                  <c:v>2265</c:v>
                </c:pt>
                <c:pt idx="359">
                  <c:v>730</c:v>
                </c:pt>
                <c:pt idx="360">
                  <c:v>2367</c:v>
                </c:pt>
                <c:pt idx="361">
                  <c:v>483</c:v>
                </c:pt>
                <c:pt idx="362">
                  <c:v>1137</c:v>
                </c:pt>
                <c:pt idx="363">
                  <c:v>1661</c:v>
                </c:pt>
                <c:pt idx="364">
                  <c:v>1424</c:v>
                </c:pt>
                <c:pt idx="365">
                  <c:v>2229</c:v>
                </c:pt>
                <c:pt idx="366">
                  <c:v>950</c:v>
                </c:pt>
                <c:pt idx="367">
                  <c:v>1183</c:v>
                </c:pt>
                <c:pt idx="368">
                  <c:v>562</c:v>
                </c:pt>
                <c:pt idx="369">
                  <c:v>1951</c:v>
                </c:pt>
                <c:pt idx="370">
                  <c:v>630</c:v>
                </c:pt>
                <c:pt idx="371">
                  <c:v>2449</c:v>
                </c:pt>
                <c:pt idx="372">
                  <c:v>1243</c:v>
                </c:pt>
                <c:pt idx="373">
                  <c:v>1721</c:v>
                </c:pt>
                <c:pt idx="374">
                  <c:v>2440</c:v>
                </c:pt>
                <c:pt idx="375">
                  <c:v>2191</c:v>
                </c:pt>
                <c:pt idx="376">
                  <c:v>1596</c:v>
                </c:pt>
                <c:pt idx="377">
                  <c:v>2044</c:v>
                </c:pt>
                <c:pt idx="378">
                  <c:v>1984</c:v>
                </c:pt>
                <c:pt idx="379">
                  <c:v>2215</c:v>
                </c:pt>
                <c:pt idx="380">
                  <c:v>1140</c:v>
                </c:pt>
                <c:pt idx="381">
                  <c:v>1300</c:v>
                </c:pt>
                <c:pt idx="382">
                  <c:v>902</c:v>
                </c:pt>
                <c:pt idx="383">
                  <c:v>1409</c:v>
                </c:pt>
                <c:pt idx="384">
                  <c:v>2154</c:v>
                </c:pt>
                <c:pt idx="385">
                  <c:v>2107</c:v>
                </c:pt>
                <c:pt idx="386">
                  <c:v>568</c:v>
                </c:pt>
                <c:pt idx="387">
                  <c:v>2394</c:v>
                </c:pt>
                <c:pt idx="388">
                  <c:v>2178</c:v>
                </c:pt>
                <c:pt idx="389">
                  <c:v>2270</c:v>
                </c:pt>
                <c:pt idx="390">
                  <c:v>987</c:v>
                </c:pt>
                <c:pt idx="391">
                  <c:v>543</c:v>
                </c:pt>
                <c:pt idx="392">
                  <c:v>1903</c:v>
                </c:pt>
                <c:pt idx="393">
                  <c:v>1022</c:v>
                </c:pt>
                <c:pt idx="394">
                  <c:v>2447</c:v>
                </c:pt>
                <c:pt idx="395">
                  <c:v>855</c:v>
                </c:pt>
                <c:pt idx="396">
                  <c:v>2309</c:v>
                </c:pt>
                <c:pt idx="397">
                  <c:v>522</c:v>
                </c:pt>
                <c:pt idx="398">
                  <c:v>1051</c:v>
                </c:pt>
                <c:pt idx="399">
                  <c:v>1952</c:v>
                </c:pt>
                <c:pt idx="400">
                  <c:v>843</c:v>
                </c:pt>
                <c:pt idx="401">
                  <c:v>695</c:v>
                </c:pt>
                <c:pt idx="402">
                  <c:v>772</c:v>
                </c:pt>
                <c:pt idx="403">
                  <c:v>1163</c:v>
                </c:pt>
                <c:pt idx="404">
                  <c:v>2299</c:v>
                </c:pt>
                <c:pt idx="405">
                  <c:v>960</c:v>
                </c:pt>
                <c:pt idx="406">
                  <c:v>1449</c:v>
                </c:pt>
                <c:pt idx="407">
                  <c:v>1484</c:v>
                </c:pt>
                <c:pt idx="408">
                  <c:v>2134</c:v>
                </c:pt>
                <c:pt idx="409">
                  <c:v>1682</c:v>
                </c:pt>
                <c:pt idx="410">
                  <c:v>1235</c:v>
                </c:pt>
                <c:pt idx="411">
                  <c:v>1859</c:v>
                </c:pt>
                <c:pt idx="412">
                  <c:v>434</c:v>
                </c:pt>
                <c:pt idx="413">
                  <c:v>1966</c:v>
                </c:pt>
                <c:pt idx="414">
                  <c:v>1860</c:v>
                </c:pt>
                <c:pt idx="415">
                  <c:v>2161</c:v>
                </c:pt>
                <c:pt idx="416">
                  <c:v>2436</c:v>
                </c:pt>
                <c:pt idx="417">
                  <c:v>1763</c:v>
                </c:pt>
                <c:pt idx="418">
                  <c:v>1007</c:v>
                </c:pt>
                <c:pt idx="419">
                  <c:v>1136</c:v>
                </c:pt>
                <c:pt idx="420">
                  <c:v>1309</c:v>
                </c:pt>
                <c:pt idx="421">
                  <c:v>1236</c:v>
                </c:pt>
                <c:pt idx="422">
                  <c:v>2211</c:v>
                </c:pt>
                <c:pt idx="423">
                  <c:v>1153</c:v>
                </c:pt>
                <c:pt idx="424">
                  <c:v>813</c:v>
                </c:pt>
                <c:pt idx="425">
                  <c:v>1245</c:v>
                </c:pt>
                <c:pt idx="426">
                  <c:v>615</c:v>
                </c:pt>
                <c:pt idx="427">
                  <c:v>1962</c:v>
                </c:pt>
                <c:pt idx="428">
                  <c:v>2259</c:v>
                </c:pt>
                <c:pt idx="429">
                  <c:v>1920</c:v>
                </c:pt>
                <c:pt idx="430">
                  <c:v>1614</c:v>
                </c:pt>
                <c:pt idx="431">
                  <c:v>756</c:v>
                </c:pt>
                <c:pt idx="432">
                  <c:v>1002</c:v>
                </c:pt>
                <c:pt idx="433">
                  <c:v>683</c:v>
                </c:pt>
                <c:pt idx="434">
                  <c:v>2382</c:v>
                </c:pt>
                <c:pt idx="435">
                  <c:v>1037</c:v>
                </c:pt>
                <c:pt idx="436">
                  <c:v>1739</c:v>
                </c:pt>
                <c:pt idx="437">
                  <c:v>1255</c:v>
                </c:pt>
                <c:pt idx="438">
                  <c:v>1681</c:v>
                </c:pt>
                <c:pt idx="439">
                  <c:v>1852</c:v>
                </c:pt>
                <c:pt idx="440">
                  <c:v>2164</c:v>
                </c:pt>
                <c:pt idx="441">
                  <c:v>878</c:v>
                </c:pt>
                <c:pt idx="442">
                  <c:v>1557</c:v>
                </c:pt>
                <c:pt idx="443">
                  <c:v>2045</c:v>
                </c:pt>
                <c:pt idx="444">
                  <c:v>1000</c:v>
                </c:pt>
                <c:pt idx="445">
                  <c:v>2396</c:v>
                </c:pt>
                <c:pt idx="446">
                  <c:v>1045</c:v>
                </c:pt>
                <c:pt idx="447">
                  <c:v>717</c:v>
                </c:pt>
                <c:pt idx="448">
                  <c:v>2443</c:v>
                </c:pt>
                <c:pt idx="449">
                  <c:v>747</c:v>
                </c:pt>
                <c:pt idx="450">
                  <c:v>2078</c:v>
                </c:pt>
                <c:pt idx="451">
                  <c:v>1490</c:v>
                </c:pt>
                <c:pt idx="452">
                  <c:v>2402</c:v>
                </c:pt>
                <c:pt idx="453">
                  <c:v>2282</c:v>
                </c:pt>
                <c:pt idx="454">
                  <c:v>935</c:v>
                </c:pt>
                <c:pt idx="455">
                  <c:v>2305</c:v>
                </c:pt>
                <c:pt idx="456">
                  <c:v>1624</c:v>
                </c:pt>
                <c:pt idx="457">
                  <c:v>735</c:v>
                </c:pt>
                <c:pt idx="458">
                  <c:v>1868</c:v>
                </c:pt>
                <c:pt idx="459">
                  <c:v>2073</c:v>
                </c:pt>
                <c:pt idx="460">
                  <c:v>2072</c:v>
                </c:pt>
                <c:pt idx="461">
                  <c:v>1494</c:v>
                </c:pt>
                <c:pt idx="462">
                  <c:v>750</c:v>
                </c:pt>
                <c:pt idx="463">
                  <c:v>1665</c:v>
                </c:pt>
                <c:pt idx="464">
                  <c:v>1779</c:v>
                </c:pt>
                <c:pt idx="465">
                  <c:v>1925</c:v>
                </c:pt>
                <c:pt idx="466">
                  <c:v>1803</c:v>
                </c:pt>
                <c:pt idx="467">
                  <c:v>2293</c:v>
                </c:pt>
                <c:pt idx="468">
                  <c:v>2329</c:v>
                </c:pt>
                <c:pt idx="469">
                  <c:v>1161</c:v>
                </c:pt>
                <c:pt idx="470">
                  <c:v>1863</c:v>
                </c:pt>
                <c:pt idx="471">
                  <c:v>2261</c:v>
                </c:pt>
                <c:pt idx="472">
                  <c:v>666</c:v>
                </c:pt>
                <c:pt idx="473">
                  <c:v>1735</c:v>
                </c:pt>
                <c:pt idx="474">
                  <c:v>604</c:v>
                </c:pt>
                <c:pt idx="475">
                  <c:v>931</c:v>
                </c:pt>
                <c:pt idx="476">
                  <c:v>1753</c:v>
                </c:pt>
                <c:pt idx="477">
                  <c:v>1469</c:v>
                </c:pt>
                <c:pt idx="478">
                  <c:v>2064</c:v>
                </c:pt>
                <c:pt idx="479">
                  <c:v>971</c:v>
                </c:pt>
                <c:pt idx="480">
                  <c:v>1953</c:v>
                </c:pt>
                <c:pt idx="481">
                  <c:v>1270</c:v>
                </c:pt>
                <c:pt idx="482">
                  <c:v>734</c:v>
                </c:pt>
                <c:pt idx="483">
                  <c:v>1610</c:v>
                </c:pt>
                <c:pt idx="484">
                  <c:v>2365</c:v>
                </c:pt>
                <c:pt idx="485">
                  <c:v>1077</c:v>
                </c:pt>
                <c:pt idx="486">
                  <c:v>900</c:v>
                </c:pt>
                <c:pt idx="487">
                  <c:v>1109</c:v>
                </c:pt>
                <c:pt idx="488">
                  <c:v>1876</c:v>
                </c:pt>
                <c:pt idx="489">
                  <c:v>1861</c:v>
                </c:pt>
                <c:pt idx="490">
                  <c:v>720</c:v>
                </c:pt>
                <c:pt idx="491">
                  <c:v>2279</c:v>
                </c:pt>
                <c:pt idx="492">
                  <c:v>1671</c:v>
                </c:pt>
                <c:pt idx="493">
                  <c:v>1760</c:v>
                </c:pt>
                <c:pt idx="494">
                  <c:v>1986</c:v>
                </c:pt>
                <c:pt idx="495">
                  <c:v>1607</c:v>
                </c:pt>
                <c:pt idx="496">
                  <c:v>752</c:v>
                </c:pt>
                <c:pt idx="497">
                  <c:v>1818</c:v>
                </c:pt>
                <c:pt idx="498">
                  <c:v>1083</c:v>
                </c:pt>
                <c:pt idx="499">
                  <c:v>1135</c:v>
                </c:pt>
                <c:pt idx="500">
                  <c:v>2118</c:v>
                </c:pt>
                <c:pt idx="501">
                  <c:v>990</c:v>
                </c:pt>
                <c:pt idx="502">
                  <c:v>1827</c:v>
                </c:pt>
                <c:pt idx="503">
                  <c:v>1929</c:v>
                </c:pt>
                <c:pt idx="504">
                  <c:v>2192</c:v>
                </c:pt>
                <c:pt idx="505">
                  <c:v>2000</c:v>
                </c:pt>
                <c:pt idx="506">
                  <c:v>2111</c:v>
                </c:pt>
                <c:pt idx="507">
                  <c:v>1602</c:v>
                </c:pt>
                <c:pt idx="508">
                  <c:v>2400</c:v>
                </c:pt>
                <c:pt idx="509">
                  <c:v>1997</c:v>
                </c:pt>
                <c:pt idx="510">
                  <c:v>633</c:v>
                </c:pt>
                <c:pt idx="511">
                  <c:v>1578</c:v>
                </c:pt>
                <c:pt idx="512">
                  <c:v>91</c:v>
                </c:pt>
                <c:pt idx="513">
                  <c:v>1416</c:v>
                </c:pt>
                <c:pt idx="514">
                  <c:v>1151</c:v>
                </c:pt>
                <c:pt idx="515">
                  <c:v>1773</c:v>
                </c:pt>
                <c:pt idx="516">
                  <c:v>1723</c:v>
                </c:pt>
                <c:pt idx="517">
                  <c:v>1332</c:v>
                </c:pt>
                <c:pt idx="518">
                  <c:v>739</c:v>
                </c:pt>
                <c:pt idx="519">
                  <c:v>532</c:v>
                </c:pt>
                <c:pt idx="520">
                  <c:v>863</c:v>
                </c:pt>
                <c:pt idx="521">
                  <c:v>1776</c:v>
                </c:pt>
                <c:pt idx="522">
                  <c:v>2171</c:v>
                </c:pt>
                <c:pt idx="523">
                  <c:v>2403</c:v>
                </c:pt>
                <c:pt idx="524">
                  <c:v>916</c:v>
                </c:pt>
                <c:pt idx="525">
                  <c:v>1395</c:v>
                </c:pt>
                <c:pt idx="526">
                  <c:v>1547</c:v>
                </c:pt>
                <c:pt idx="527">
                  <c:v>986</c:v>
                </c:pt>
                <c:pt idx="528">
                  <c:v>2277</c:v>
                </c:pt>
                <c:pt idx="529">
                  <c:v>1826</c:v>
                </c:pt>
                <c:pt idx="530">
                  <c:v>961</c:v>
                </c:pt>
                <c:pt idx="531">
                  <c:v>1977</c:v>
                </c:pt>
                <c:pt idx="532">
                  <c:v>1561</c:v>
                </c:pt>
                <c:pt idx="533">
                  <c:v>1328</c:v>
                </c:pt>
                <c:pt idx="534">
                  <c:v>1822</c:v>
                </c:pt>
                <c:pt idx="535">
                  <c:v>838</c:v>
                </c:pt>
                <c:pt idx="536">
                  <c:v>610</c:v>
                </c:pt>
                <c:pt idx="537">
                  <c:v>2086</c:v>
                </c:pt>
                <c:pt idx="538">
                  <c:v>1088</c:v>
                </c:pt>
                <c:pt idx="539">
                  <c:v>1138</c:v>
                </c:pt>
                <c:pt idx="540">
                  <c:v>1992</c:v>
                </c:pt>
                <c:pt idx="541">
                  <c:v>1268</c:v>
                </c:pt>
                <c:pt idx="542">
                  <c:v>2387</c:v>
                </c:pt>
                <c:pt idx="543">
                  <c:v>2059</c:v>
                </c:pt>
                <c:pt idx="544">
                  <c:v>2334</c:v>
                </c:pt>
                <c:pt idx="545">
                  <c:v>1692</c:v>
                </c:pt>
                <c:pt idx="546">
                  <c:v>837</c:v>
                </c:pt>
                <c:pt idx="547">
                  <c:v>1747</c:v>
                </c:pt>
                <c:pt idx="548">
                  <c:v>893</c:v>
                </c:pt>
                <c:pt idx="549">
                  <c:v>692</c:v>
                </c:pt>
                <c:pt idx="550">
                  <c:v>1091</c:v>
                </c:pt>
                <c:pt idx="551">
                  <c:v>1057</c:v>
                </c:pt>
                <c:pt idx="552">
                  <c:v>2007</c:v>
                </c:pt>
                <c:pt idx="553">
                  <c:v>2009</c:v>
                </c:pt>
                <c:pt idx="554">
                  <c:v>566</c:v>
                </c:pt>
                <c:pt idx="555">
                  <c:v>2148</c:v>
                </c:pt>
                <c:pt idx="556">
                  <c:v>714</c:v>
                </c:pt>
                <c:pt idx="557">
                  <c:v>2055</c:v>
                </c:pt>
                <c:pt idx="558">
                  <c:v>1804</c:v>
                </c:pt>
                <c:pt idx="559">
                  <c:v>2308</c:v>
                </c:pt>
                <c:pt idx="560">
                  <c:v>806</c:v>
                </c:pt>
                <c:pt idx="561">
                  <c:v>2237</c:v>
                </c:pt>
                <c:pt idx="562">
                  <c:v>1204</c:v>
                </c:pt>
                <c:pt idx="563">
                  <c:v>1737</c:v>
                </c:pt>
                <c:pt idx="564">
                  <c:v>828</c:v>
                </c:pt>
                <c:pt idx="565">
                  <c:v>839</c:v>
                </c:pt>
                <c:pt idx="566">
                  <c:v>2123</c:v>
                </c:pt>
                <c:pt idx="567">
                  <c:v>732</c:v>
                </c:pt>
                <c:pt idx="568">
                  <c:v>698</c:v>
                </c:pt>
                <c:pt idx="569">
                  <c:v>1761</c:v>
                </c:pt>
                <c:pt idx="570">
                  <c:v>1178</c:v>
                </c:pt>
                <c:pt idx="571">
                  <c:v>1874</c:v>
                </c:pt>
                <c:pt idx="572">
                  <c:v>1001</c:v>
                </c:pt>
                <c:pt idx="573">
                  <c:v>1303</c:v>
                </c:pt>
                <c:pt idx="574">
                  <c:v>829</c:v>
                </c:pt>
                <c:pt idx="575">
                  <c:v>681</c:v>
                </c:pt>
                <c:pt idx="576">
                  <c:v>808</c:v>
                </c:pt>
                <c:pt idx="577">
                  <c:v>1790</c:v>
                </c:pt>
                <c:pt idx="578">
                  <c:v>825</c:v>
                </c:pt>
                <c:pt idx="579">
                  <c:v>1114</c:v>
                </c:pt>
                <c:pt idx="580">
                  <c:v>1892</c:v>
                </c:pt>
                <c:pt idx="581">
                  <c:v>675</c:v>
                </c:pt>
                <c:pt idx="582">
                  <c:v>1841</c:v>
                </c:pt>
                <c:pt idx="583">
                  <c:v>2066</c:v>
                </c:pt>
                <c:pt idx="584">
                  <c:v>1635</c:v>
                </c:pt>
                <c:pt idx="585">
                  <c:v>826</c:v>
                </c:pt>
                <c:pt idx="586">
                  <c:v>2346</c:v>
                </c:pt>
                <c:pt idx="587">
                  <c:v>2220</c:v>
                </c:pt>
                <c:pt idx="588">
                  <c:v>1504</c:v>
                </c:pt>
                <c:pt idx="589">
                  <c:v>2090</c:v>
                </c:pt>
                <c:pt idx="590">
                  <c:v>852</c:v>
                </c:pt>
                <c:pt idx="591">
                  <c:v>456</c:v>
                </c:pt>
                <c:pt idx="592">
                  <c:v>2098</c:v>
                </c:pt>
                <c:pt idx="593">
                  <c:v>2238</c:v>
                </c:pt>
                <c:pt idx="594">
                  <c:v>963</c:v>
                </c:pt>
                <c:pt idx="595">
                  <c:v>1856</c:v>
                </c:pt>
                <c:pt idx="596">
                  <c:v>1162</c:v>
                </c:pt>
                <c:pt idx="597">
                  <c:v>600</c:v>
                </c:pt>
                <c:pt idx="598">
                  <c:v>2110</c:v>
                </c:pt>
                <c:pt idx="599">
                  <c:v>1993</c:v>
                </c:pt>
                <c:pt idx="600">
                  <c:v>1443</c:v>
                </c:pt>
                <c:pt idx="601">
                  <c:v>1631</c:v>
                </c:pt>
                <c:pt idx="602">
                  <c:v>2177</c:v>
                </c:pt>
                <c:pt idx="603">
                  <c:v>1840</c:v>
                </c:pt>
                <c:pt idx="604">
                  <c:v>1008</c:v>
                </c:pt>
                <c:pt idx="605">
                  <c:v>2418</c:v>
                </c:pt>
                <c:pt idx="606">
                  <c:v>421</c:v>
                </c:pt>
                <c:pt idx="607">
                  <c:v>2079</c:v>
                </c:pt>
                <c:pt idx="608">
                  <c:v>1710</c:v>
                </c:pt>
                <c:pt idx="609">
                  <c:v>2083</c:v>
                </c:pt>
                <c:pt idx="610">
                  <c:v>623</c:v>
                </c:pt>
                <c:pt idx="611">
                  <c:v>2021</c:v>
                </c:pt>
                <c:pt idx="612">
                  <c:v>525</c:v>
                </c:pt>
                <c:pt idx="613">
                  <c:v>2361</c:v>
                </c:pt>
                <c:pt idx="614">
                  <c:v>1103</c:v>
                </c:pt>
                <c:pt idx="615">
                  <c:v>1916</c:v>
                </c:pt>
                <c:pt idx="616">
                  <c:v>2182</c:v>
                </c:pt>
                <c:pt idx="617">
                  <c:v>1041</c:v>
                </c:pt>
                <c:pt idx="618">
                  <c:v>654</c:v>
                </c:pt>
                <c:pt idx="619">
                  <c:v>1342</c:v>
                </c:pt>
                <c:pt idx="620">
                  <c:v>2092</c:v>
                </c:pt>
                <c:pt idx="621">
                  <c:v>1066</c:v>
                </c:pt>
                <c:pt idx="622">
                  <c:v>904</c:v>
                </c:pt>
                <c:pt idx="623">
                  <c:v>1141</c:v>
                </c:pt>
                <c:pt idx="624">
                  <c:v>2157</c:v>
                </c:pt>
                <c:pt idx="625">
                  <c:v>906</c:v>
                </c:pt>
                <c:pt idx="626">
                  <c:v>1983</c:v>
                </c:pt>
                <c:pt idx="627">
                  <c:v>999</c:v>
                </c:pt>
                <c:pt idx="628">
                  <c:v>2106</c:v>
                </c:pt>
                <c:pt idx="629">
                  <c:v>2454</c:v>
                </c:pt>
                <c:pt idx="630">
                  <c:v>1208</c:v>
                </c:pt>
                <c:pt idx="631">
                  <c:v>1539</c:v>
                </c:pt>
                <c:pt idx="632">
                  <c:v>1205</c:v>
                </c:pt>
                <c:pt idx="633">
                  <c:v>1190</c:v>
                </c:pt>
                <c:pt idx="634">
                  <c:v>501</c:v>
                </c:pt>
                <c:pt idx="635">
                  <c:v>2187</c:v>
                </c:pt>
                <c:pt idx="636">
                  <c:v>32</c:v>
                </c:pt>
                <c:pt idx="637">
                  <c:v>859</c:v>
                </c:pt>
                <c:pt idx="638">
                  <c:v>973</c:v>
                </c:pt>
                <c:pt idx="639">
                  <c:v>1142</c:v>
                </c:pt>
                <c:pt idx="640">
                  <c:v>974</c:v>
                </c:pt>
                <c:pt idx="641">
                  <c:v>1260</c:v>
                </c:pt>
                <c:pt idx="642">
                  <c:v>2427</c:v>
                </c:pt>
                <c:pt idx="643">
                  <c:v>1160</c:v>
                </c:pt>
                <c:pt idx="644">
                  <c:v>930</c:v>
                </c:pt>
                <c:pt idx="645">
                  <c:v>2202</c:v>
                </c:pt>
                <c:pt idx="646">
                  <c:v>687</c:v>
                </c:pt>
                <c:pt idx="647">
                  <c:v>1264</c:v>
                </c:pt>
                <c:pt idx="648">
                  <c:v>820</c:v>
                </c:pt>
                <c:pt idx="649">
                  <c:v>1895</c:v>
                </c:pt>
                <c:pt idx="650">
                  <c:v>330</c:v>
                </c:pt>
                <c:pt idx="651">
                  <c:v>583</c:v>
                </c:pt>
                <c:pt idx="652">
                  <c:v>966</c:v>
                </c:pt>
                <c:pt idx="653">
                  <c:v>1249</c:v>
                </c:pt>
                <c:pt idx="654">
                  <c:v>2125</c:v>
                </c:pt>
                <c:pt idx="655">
                  <c:v>784</c:v>
                </c:pt>
                <c:pt idx="656">
                  <c:v>842</c:v>
                </c:pt>
                <c:pt idx="657">
                  <c:v>1819</c:v>
                </c:pt>
                <c:pt idx="658">
                  <c:v>760</c:v>
                </c:pt>
                <c:pt idx="659">
                  <c:v>1974</c:v>
                </c:pt>
                <c:pt idx="660">
                  <c:v>678</c:v>
                </c:pt>
                <c:pt idx="661">
                  <c:v>991</c:v>
                </c:pt>
                <c:pt idx="662">
                  <c:v>834</c:v>
                </c:pt>
                <c:pt idx="663">
                  <c:v>1642</c:v>
                </c:pt>
                <c:pt idx="664">
                  <c:v>2168</c:v>
                </c:pt>
                <c:pt idx="665">
                  <c:v>1279</c:v>
                </c:pt>
                <c:pt idx="666">
                  <c:v>1411</c:v>
                </c:pt>
                <c:pt idx="667">
                  <c:v>1573</c:v>
                </c:pt>
                <c:pt idx="668">
                  <c:v>2366</c:v>
                </c:pt>
                <c:pt idx="669">
                  <c:v>2158</c:v>
                </c:pt>
                <c:pt idx="670">
                  <c:v>811</c:v>
                </c:pt>
                <c:pt idx="671">
                  <c:v>2380</c:v>
                </c:pt>
                <c:pt idx="672">
                  <c:v>1347</c:v>
                </c:pt>
                <c:pt idx="673">
                  <c:v>975</c:v>
                </c:pt>
                <c:pt idx="674">
                  <c:v>2002</c:v>
                </c:pt>
                <c:pt idx="675">
                  <c:v>2124</c:v>
                </c:pt>
                <c:pt idx="676">
                  <c:v>2208</c:v>
                </c:pt>
                <c:pt idx="677">
                  <c:v>932</c:v>
                </c:pt>
                <c:pt idx="678">
                  <c:v>2196</c:v>
                </c:pt>
                <c:pt idx="679">
                  <c:v>1792</c:v>
                </c:pt>
                <c:pt idx="680">
                  <c:v>1789</c:v>
                </c:pt>
                <c:pt idx="681">
                  <c:v>2337</c:v>
                </c:pt>
                <c:pt idx="682">
                  <c:v>2058</c:v>
                </c:pt>
                <c:pt idx="683">
                  <c:v>928</c:v>
                </c:pt>
                <c:pt idx="684">
                  <c:v>1890</c:v>
                </c:pt>
                <c:pt idx="685">
                  <c:v>980</c:v>
                </c:pt>
                <c:pt idx="686">
                  <c:v>1998</c:v>
                </c:pt>
                <c:pt idx="687">
                  <c:v>704</c:v>
                </c:pt>
                <c:pt idx="688">
                  <c:v>1195</c:v>
                </c:pt>
                <c:pt idx="689">
                  <c:v>1460</c:v>
                </c:pt>
                <c:pt idx="690">
                  <c:v>1201</c:v>
                </c:pt>
                <c:pt idx="691">
                  <c:v>1988</c:v>
                </c:pt>
                <c:pt idx="692">
                  <c:v>1764</c:v>
                </c:pt>
                <c:pt idx="693">
                  <c:v>2307</c:v>
                </c:pt>
                <c:pt idx="694">
                  <c:v>885</c:v>
                </c:pt>
                <c:pt idx="695">
                  <c:v>1275</c:v>
                </c:pt>
                <c:pt idx="696">
                  <c:v>689</c:v>
                </c:pt>
                <c:pt idx="697">
                  <c:v>1774</c:v>
                </c:pt>
                <c:pt idx="698">
                  <c:v>1805</c:v>
                </c:pt>
                <c:pt idx="699">
                  <c:v>1669</c:v>
                </c:pt>
                <c:pt idx="700">
                  <c:v>1432</c:v>
                </c:pt>
                <c:pt idx="701">
                  <c:v>1754</c:v>
                </c:pt>
                <c:pt idx="702">
                  <c:v>954</c:v>
                </c:pt>
                <c:pt idx="703">
                  <c:v>887</c:v>
                </c:pt>
                <c:pt idx="704">
                  <c:v>694</c:v>
                </c:pt>
                <c:pt idx="705">
                  <c:v>2353</c:v>
                </c:pt>
                <c:pt idx="706">
                  <c:v>956</c:v>
                </c:pt>
                <c:pt idx="707">
                  <c:v>488</c:v>
                </c:pt>
                <c:pt idx="708">
                  <c:v>912</c:v>
                </c:pt>
                <c:pt idx="709">
                  <c:v>2089</c:v>
                </c:pt>
                <c:pt idx="710">
                  <c:v>2163</c:v>
                </c:pt>
                <c:pt idx="711">
                  <c:v>897</c:v>
                </c:pt>
                <c:pt idx="712">
                  <c:v>2302</c:v>
                </c:pt>
                <c:pt idx="713">
                  <c:v>2036</c:v>
                </c:pt>
                <c:pt idx="714">
                  <c:v>1843</c:v>
                </c:pt>
                <c:pt idx="715">
                  <c:v>1428</c:v>
                </c:pt>
                <c:pt idx="716">
                  <c:v>2395</c:v>
                </c:pt>
                <c:pt idx="717">
                  <c:v>2077</c:v>
                </c:pt>
                <c:pt idx="718">
                  <c:v>2012</c:v>
                </c:pt>
                <c:pt idx="719">
                  <c:v>1058</c:v>
                </c:pt>
                <c:pt idx="720">
                  <c:v>1105</c:v>
                </c:pt>
                <c:pt idx="721">
                  <c:v>1383</c:v>
                </c:pt>
                <c:pt idx="722">
                  <c:v>1365</c:v>
                </c:pt>
                <c:pt idx="723">
                  <c:v>2169</c:v>
                </c:pt>
                <c:pt idx="724">
                  <c:v>1210</c:v>
                </c:pt>
                <c:pt idx="725">
                  <c:v>1456</c:v>
                </c:pt>
                <c:pt idx="726">
                  <c:v>2230</c:v>
                </c:pt>
                <c:pt idx="727">
                  <c:v>1133</c:v>
                </c:pt>
                <c:pt idx="728">
                  <c:v>2193</c:v>
                </c:pt>
                <c:pt idx="729">
                  <c:v>1344</c:v>
                </c:pt>
                <c:pt idx="730">
                  <c:v>2421</c:v>
                </c:pt>
                <c:pt idx="731">
                  <c:v>1939</c:v>
                </c:pt>
                <c:pt idx="732">
                  <c:v>1525</c:v>
                </c:pt>
                <c:pt idx="733">
                  <c:v>2455</c:v>
                </c:pt>
                <c:pt idx="734">
                  <c:v>1717</c:v>
                </c:pt>
                <c:pt idx="735">
                  <c:v>1373</c:v>
                </c:pt>
                <c:pt idx="736">
                  <c:v>700</c:v>
                </c:pt>
                <c:pt idx="737">
                  <c:v>1600</c:v>
                </c:pt>
                <c:pt idx="738">
                  <c:v>52</c:v>
                </c:pt>
                <c:pt idx="739">
                  <c:v>2197</c:v>
                </c:pt>
                <c:pt idx="740">
                  <c:v>822</c:v>
                </c:pt>
                <c:pt idx="741">
                  <c:v>1102</c:v>
                </c:pt>
                <c:pt idx="742">
                  <c:v>1976</c:v>
                </c:pt>
                <c:pt idx="743">
                  <c:v>1527</c:v>
                </c:pt>
                <c:pt idx="744">
                  <c:v>1112</c:v>
                </c:pt>
                <c:pt idx="745">
                  <c:v>816</c:v>
                </c:pt>
                <c:pt idx="746">
                  <c:v>2043</c:v>
                </c:pt>
                <c:pt idx="747">
                  <c:v>1052</c:v>
                </c:pt>
                <c:pt idx="748">
                  <c:v>1089</c:v>
                </c:pt>
                <c:pt idx="749">
                  <c:v>1727</c:v>
                </c:pt>
                <c:pt idx="750">
                  <c:v>1080</c:v>
                </c:pt>
                <c:pt idx="751">
                  <c:v>671</c:v>
                </c:pt>
                <c:pt idx="752">
                  <c:v>1213</c:v>
                </c:pt>
                <c:pt idx="753">
                  <c:v>2295</c:v>
                </c:pt>
                <c:pt idx="754">
                  <c:v>2258</c:v>
                </c:pt>
                <c:pt idx="755">
                  <c:v>867</c:v>
                </c:pt>
                <c:pt idx="756">
                  <c:v>348</c:v>
                </c:pt>
                <c:pt idx="757">
                  <c:v>818</c:v>
                </c:pt>
                <c:pt idx="758">
                  <c:v>1101</c:v>
                </c:pt>
                <c:pt idx="759">
                  <c:v>1107</c:v>
                </c:pt>
                <c:pt idx="760">
                  <c:v>2096</c:v>
                </c:pt>
                <c:pt idx="761">
                  <c:v>1967</c:v>
                </c:pt>
                <c:pt idx="762">
                  <c:v>1744</c:v>
                </c:pt>
                <c:pt idx="763">
                  <c:v>1873</c:v>
                </c:pt>
                <c:pt idx="764">
                  <c:v>2128</c:v>
                </c:pt>
                <c:pt idx="765">
                  <c:v>2419</c:v>
                </c:pt>
                <c:pt idx="766">
                  <c:v>719</c:v>
                </c:pt>
                <c:pt idx="767">
                  <c:v>1693</c:v>
                </c:pt>
                <c:pt idx="768">
                  <c:v>2020</c:v>
                </c:pt>
                <c:pt idx="769">
                  <c:v>907</c:v>
                </c:pt>
                <c:pt idx="770">
                  <c:v>2342</c:v>
                </c:pt>
                <c:pt idx="771">
                  <c:v>1026</c:v>
                </c:pt>
                <c:pt idx="772">
                  <c:v>1225</c:v>
                </c:pt>
                <c:pt idx="773">
                  <c:v>1147</c:v>
                </c:pt>
                <c:pt idx="774">
                  <c:v>360</c:v>
                </c:pt>
                <c:pt idx="775">
                  <c:v>1536</c:v>
                </c:pt>
                <c:pt idx="776">
                  <c:v>1748</c:v>
                </c:pt>
                <c:pt idx="777">
                  <c:v>594</c:v>
                </c:pt>
                <c:pt idx="778">
                  <c:v>2218</c:v>
                </c:pt>
                <c:pt idx="779">
                  <c:v>2263</c:v>
                </c:pt>
                <c:pt idx="780">
                  <c:v>1597</c:v>
                </c:pt>
                <c:pt idx="781">
                  <c:v>716</c:v>
                </c:pt>
                <c:pt idx="782">
                  <c:v>2174</c:v>
                </c:pt>
                <c:pt idx="783">
                  <c:v>1038</c:v>
                </c:pt>
                <c:pt idx="784">
                  <c:v>2175</c:v>
                </c:pt>
                <c:pt idx="785">
                  <c:v>949</c:v>
                </c:pt>
                <c:pt idx="786">
                  <c:v>925</c:v>
                </c:pt>
                <c:pt idx="787">
                  <c:v>2448</c:v>
                </c:pt>
                <c:pt idx="788">
                  <c:v>1537</c:v>
                </c:pt>
                <c:pt idx="789">
                  <c:v>2296</c:v>
                </c:pt>
                <c:pt idx="790">
                  <c:v>1248</c:v>
                </c:pt>
                <c:pt idx="791">
                  <c:v>186</c:v>
                </c:pt>
                <c:pt idx="792">
                  <c:v>569</c:v>
                </c:pt>
                <c:pt idx="793">
                  <c:v>1305</c:v>
                </c:pt>
                <c:pt idx="794">
                  <c:v>905</c:v>
                </c:pt>
                <c:pt idx="795">
                  <c:v>1905</c:v>
                </c:pt>
                <c:pt idx="796">
                  <c:v>2335</c:v>
                </c:pt>
                <c:pt idx="797">
                  <c:v>2147</c:v>
                </c:pt>
                <c:pt idx="798">
                  <c:v>2052</c:v>
                </c:pt>
                <c:pt idx="799">
                  <c:v>2372</c:v>
                </c:pt>
                <c:pt idx="800">
                  <c:v>1618</c:v>
                </c:pt>
                <c:pt idx="801">
                  <c:v>879</c:v>
                </c:pt>
                <c:pt idx="802">
                  <c:v>670</c:v>
                </c:pt>
                <c:pt idx="803">
                  <c:v>1334</c:v>
                </c:pt>
                <c:pt idx="804">
                  <c:v>2318</c:v>
                </c:pt>
                <c:pt idx="805">
                  <c:v>2016</c:v>
                </c:pt>
                <c:pt idx="806">
                  <c:v>2283</c:v>
                </c:pt>
                <c:pt idx="807">
                  <c:v>2136</c:v>
                </c:pt>
                <c:pt idx="808">
                  <c:v>947</c:v>
                </c:pt>
                <c:pt idx="809">
                  <c:v>1454</c:v>
                </c:pt>
                <c:pt idx="810">
                  <c:v>1302</c:v>
                </c:pt>
                <c:pt idx="811">
                  <c:v>535</c:v>
                </c:pt>
                <c:pt idx="812">
                  <c:v>1370</c:v>
                </c:pt>
                <c:pt idx="813">
                  <c:v>2438</c:v>
                </c:pt>
                <c:pt idx="814">
                  <c:v>824</c:v>
                </c:pt>
                <c:pt idx="815">
                  <c:v>1593</c:v>
                </c:pt>
                <c:pt idx="816">
                  <c:v>647</c:v>
                </c:pt>
                <c:pt idx="817">
                  <c:v>988</c:v>
                </c:pt>
                <c:pt idx="818">
                  <c:v>636</c:v>
                </c:pt>
                <c:pt idx="819">
                  <c:v>1975</c:v>
                </c:pt>
                <c:pt idx="820">
                  <c:v>1656</c:v>
                </c:pt>
                <c:pt idx="821">
                  <c:v>2183</c:v>
                </c:pt>
                <c:pt idx="822">
                  <c:v>1973</c:v>
                </c:pt>
                <c:pt idx="823">
                  <c:v>2101</c:v>
                </c:pt>
                <c:pt idx="824">
                  <c:v>1799</c:v>
                </c:pt>
                <c:pt idx="825">
                  <c:v>1969</c:v>
                </c:pt>
                <c:pt idx="826">
                  <c:v>2151</c:v>
                </c:pt>
                <c:pt idx="827">
                  <c:v>2135</c:v>
                </c:pt>
                <c:pt idx="828">
                  <c:v>1832</c:v>
                </c:pt>
                <c:pt idx="829">
                  <c:v>1486</c:v>
                </c:pt>
                <c:pt idx="830">
                  <c:v>1311</c:v>
                </c:pt>
                <c:pt idx="831">
                  <c:v>1251</c:v>
                </c:pt>
                <c:pt idx="832">
                  <c:v>1621</c:v>
                </c:pt>
                <c:pt idx="833">
                  <c:v>1292</c:v>
                </c:pt>
                <c:pt idx="834">
                  <c:v>2160</c:v>
                </c:pt>
                <c:pt idx="835">
                  <c:v>1263</c:v>
                </c:pt>
                <c:pt idx="836">
                  <c:v>2300</c:v>
                </c:pt>
                <c:pt idx="837">
                  <c:v>2383</c:v>
                </c:pt>
                <c:pt idx="838">
                  <c:v>847</c:v>
                </c:pt>
                <c:pt idx="839">
                  <c:v>1959</c:v>
                </c:pt>
                <c:pt idx="840">
                  <c:v>2253</c:v>
                </c:pt>
                <c:pt idx="841">
                  <c:v>2332</c:v>
                </c:pt>
                <c:pt idx="842">
                  <c:v>1254</c:v>
                </c:pt>
                <c:pt idx="843">
                  <c:v>608</c:v>
                </c:pt>
                <c:pt idx="844">
                  <c:v>1524</c:v>
                </c:pt>
                <c:pt idx="845">
                  <c:v>2354</c:v>
                </c:pt>
                <c:pt idx="846">
                  <c:v>657</c:v>
                </c:pt>
                <c:pt idx="847">
                  <c:v>2437</c:v>
                </c:pt>
                <c:pt idx="848">
                  <c:v>2249</c:v>
                </c:pt>
                <c:pt idx="849">
                  <c:v>2413</c:v>
                </c:pt>
                <c:pt idx="850">
                  <c:v>1825</c:v>
                </c:pt>
                <c:pt idx="851">
                  <c:v>2129</c:v>
                </c:pt>
                <c:pt idx="852">
                  <c:v>2331</c:v>
                </c:pt>
                <c:pt idx="853">
                  <c:v>1787</c:v>
                </c:pt>
                <c:pt idx="854">
                  <c:v>1676</c:v>
                </c:pt>
                <c:pt idx="855">
                  <c:v>2217</c:v>
                </c:pt>
                <c:pt idx="856">
                  <c:v>1276</c:v>
                </c:pt>
                <c:pt idx="857">
                  <c:v>946</c:v>
                </c:pt>
                <c:pt idx="858">
                  <c:v>2360</c:v>
                </c:pt>
                <c:pt idx="859">
                  <c:v>929</c:v>
                </c:pt>
                <c:pt idx="860">
                  <c:v>978</c:v>
                </c:pt>
                <c:pt idx="861">
                  <c:v>962</c:v>
                </c:pt>
                <c:pt idx="862">
                  <c:v>1412</c:v>
                </c:pt>
                <c:pt idx="863">
                  <c:v>578</c:v>
                </c:pt>
                <c:pt idx="864">
                  <c:v>1312</c:v>
                </c:pt>
                <c:pt idx="865">
                  <c:v>763</c:v>
                </c:pt>
                <c:pt idx="866">
                  <c:v>896</c:v>
                </c:pt>
                <c:pt idx="867">
                  <c:v>1594</c:v>
                </c:pt>
                <c:pt idx="868">
                  <c:v>1684</c:v>
                </c:pt>
                <c:pt idx="869">
                  <c:v>1100</c:v>
                </c:pt>
                <c:pt idx="870">
                  <c:v>1093</c:v>
                </c:pt>
                <c:pt idx="871">
                  <c:v>2141</c:v>
                </c:pt>
                <c:pt idx="872">
                  <c:v>2137</c:v>
                </c:pt>
                <c:pt idx="873">
                  <c:v>2451</c:v>
                </c:pt>
                <c:pt idx="874">
                  <c:v>1143</c:v>
                </c:pt>
                <c:pt idx="875">
                  <c:v>1686</c:v>
                </c:pt>
                <c:pt idx="876">
                  <c:v>1780</c:v>
                </c:pt>
                <c:pt idx="877">
                  <c:v>2226</c:v>
                </c:pt>
                <c:pt idx="878">
                  <c:v>2336</c:v>
                </c:pt>
                <c:pt idx="879">
                  <c:v>2326</c:v>
                </c:pt>
                <c:pt idx="880">
                  <c:v>1231</c:v>
                </c:pt>
                <c:pt idx="881">
                  <c:v>1830</c:v>
                </c:pt>
                <c:pt idx="882">
                  <c:v>2292</c:v>
                </c:pt>
                <c:pt idx="883">
                  <c:v>2067</c:v>
                </c:pt>
                <c:pt idx="884">
                  <c:v>1152</c:v>
                </c:pt>
                <c:pt idx="885">
                  <c:v>1964</c:v>
                </c:pt>
                <c:pt idx="886">
                  <c:v>2146</c:v>
                </c:pt>
                <c:pt idx="887">
                  <c:v>1595</c:v>
                </c:pt>
                <c:pt idx="888">
                  <c:v>2001</c:v>
                </c:pt>
                <c:pt idx="889">
                  <c:v>1702</c:v>
                </c:pt>
                <c:pt idx="890">
                  <c:v>1845</c:v>
                </c:pt>
                <c:pt idx="891">
                  <c:v>1505</c:v>
                </c:pt>
                <c:pt idx="892">
                  <c:v>2356</c:v>
                </c:pt>
                <c:pt idx="893">
                  <c:v>938</c:v>
                </c:pt>
                <c:pt idx="894">
                  <c:v>2210</c:v>
                </c:pt>
                <c:pt idx="895">
                  <c:v>609</c:v>
                </c:pt>
                <c:pt idx="896">
                  <c:v>2087</c:v>
                </c:pt>
                <c:pt idx="897">
                  <c:v>1944</c:v>
                </c:pt>
                <c:pt idx="898">
                  <c:v>2417</c:v>
                </c:pt>
                <c:pt idx="899">
                  <c:v>1613</c:v>
                </c:pt>
                <c:pt idx="900">
                  <c:v>626</c:v>
                </c:pt>
                <c:pt idx="901">
                  <c:v>1698</c:v>
                </c:pt>
                <c:pt idx="902">
                  <c:v>1534</c:v>
                </c:pt>
                <c:pt idx="903">
                  <c:v>1198</c:v>
                </c:pt>
                <c:pt idx="904">
                  <c:v>1788</c:v>
                </c:pt>
                <c:pt idx="905">
                  <c:v>2207</c:v>
                </c:pt>
                <c:pt idx="906">
                  <c:v>2286</c:v>
                </c:pt>
                <c:pt idx="907">
                  <c:v>1940</c:v>
                </c:pt>
                <c:pt idx="908">
                  <c:v>1696</c:v>
                </c:pt>
                <c:pt idx="909">
                  <c:v>2285</c:v>
                </c:pt>
                <c:pt idx="910">
                  <c:v>712</c:v>
                </c:pt>
                <c:pt idx="911">
                  <c:v>705</c:v>
                </c:pt>
                <c:pt idx="912">
                  <c:v>1864</c:v>
                </c:pt>
                <c:pt idx="913">
                  <c:v>727</c:v>
                </c:pt>
                <c:pt idx="914">
                  <c:v>1559</c:v>
                </c:pt>
                <c:pt idx="915">
                  <c:v>2127</c:v>
                </c:pt>
                <c:pt idx="916">
                  <c:v>2042</c:v>
                </c:pt>
                <c:pt idx="917">
                  <c:v>664</c:v>
                </c:pt>
                <c:pt idx="918">
                  <c:v>2057</c:v>
                </c:pt>
                <c:pt idx="919">
                  <c:v>1945</c:v>
                </c:pt>
                <c:pt idx="920">
                  <c:v>741</c:v>
                </c:pt>
                <c:pt idx="921">
                  <c:v>1269</c:v>
                </c:pt>
                <c:pt idx="922">
                  <c:v>613</c:v>
                </c:pt>
                <c:pt idx="923">
                  <c:v>2269</c:v>
                </c:pt>
                <c:pt idx="924">
                  <c:v>1689</c:v>
                </c:pt>
                <c:pt idx="925">
                  <c:v>2273</c:v>
                </c:pt>
                <c:pt idx="926">
                  <c:v>1320</c:v>
                </c:pt>
                <c:pt idx="927">
                  <c:v>942</c:v>
                </c:pt>
                <c:pt idx="928">
                  <c:v>2349</c:v>
                </c:pt>
                <c:pt idx="929">
                  <c:v>1639</c:v>
                </c:pt>
                <c:pt idx="930">
                  <c:v>2039</c:v>
                </c:pt>
                <c:pt idx="931">
                  <c:v>757</c:v>
                </c:pt>
                <c:pt idx="932">
                  <c:v>676</c:v>
                </c:pt>
                <c:pt idx="933">
                  <c:v>1545</c:v>
                </c:pt>
                <c:pt idx="934">
                  <c:v>2122</c:v>
                </c:pt>
                <c:pt idx="935">
                  <c:v>1948</c:v>
                </c:pt>
                <c:pt idx="936">
                  <c:v>1865</c:v>
                </c:pt>
                <c:pt idx="937">
                  <c:v>724</c:v>
                </c:pt>
                <c:pt idx="938">
                  <c:v>1463</c:v>
                </c:pt>
                <c:pt idx="939">
                  <c:v>1206</c:v>
                </c:pt>
                <c:pt idx="940">
                  <c:v>1278</c:v>
                </c:pt>
                <c:pt idx="941">
                  <c:v>1848</c:v>
                </c:pt>
                <c:pt idx="942">
                  <c:v>899</c:v>
                </c:pt>
                <c:pt idx="943">
                  <c:v>777</c:v>
                </c:pt>
                <c:pt idx="944">
                  <c:v>1851</c:v>
                </c:pt>
                <c:pt idx="945">
                  <c:v>2320</c:v>
                </c:pt>
                <c:pt idx="946">
                  <c:v>590</c:v>
                </c:pt>
                <c:pt idx="947">
                  <c:v>2085</c:v>
                </c:pt>
                <c:pt idx="948">
                  <c:v>2166</c:v>
                </c:pt>
                <c:pt idx="949">
                  <c:v>1839</c:v>
                </c:pt>
                <c:pt idx="950">
                  <c:v>913</c:v>
                </c:pt>
                <c:pt idx="951">
                  <c:v>1149</c:v>
                </c:pt>
                <c:pt idx="952">
                  <c:v>526</c:v>
                </c:pt>
                <c:pt idx="953">
                  <c:v>2381</c:v>
                </c:pt>
                <c:pt idx="954">
                  <c:v>1425</c:v>
                </c:pt>
                <c:pt idx="955">
                  <c:v>2102</c:v>
                </c:pt>
                <c:pt idx="956">
                  <c:v>2399</c:v>
                </c:pt>
                <c:pt idx="957">
                  <c:v>1148</c:v>
                </c:pt>
                <c:pt idx="958">
                  <c:v>1601</c:v>
                </c:pt>
                <c:pt idx="959">
                  <c:v>595</c:v>
                </c:pt>
                <c:pt idx="960">
                  <c:v>1406</c:v>
                </c:pt>
                <c:pt idx="961">
                  <c:v>1619</c:v>
                </c:pt>
                <c:pt idx="962">
                  <c:v>2186</c:v>
                </c:pt>
                <c:pt idx="963">
                  <c:v>1108</c:v>
                </c:pt>
                <c:pt idx="964">
                  <c:v>2327</c:v>
                </c:pt>
                <c:pt idx="965">
                  <c:v>1158</c:v>
                </c:pt>
                <c:pt idx="966">
                  <c:v>890</c:v>
                </c:pt>
                <c:pt idx="967">
                  <c:v>1872</c:v>
                </c:pt>
                <c:pt idx="968">
                  <c:v>1070</c:v>
                </c:pt>
                <c:pt idx="969">
                  <c:v>1772</c:v>
                </c:pt>
                <c:pt idx="970">
                  <c:v>632</c:v>
                </c:pt>
                <c:pt idx="971">
                  <c:v>564</c:v>
                </c:pt>
                <c:pt idx="972">
                  <c:v>1685</c:v>
                </c:pt>
                <c:pt idx="973">
                  <c:v>1301</c:v>
                </c:pt>
                <c:pt idx="974">
                  <c:v>2198</c:v>
                </c:pt>
                <c:pt idx="975">
                  <c:v>810</c:v>
                </c:pt>
                <c:pt idx="976">
                  <c:v>1990</c:v>
                </c:pt>
                <c:pt idx="977">
                  <c:v>2311</c:v>
                </c:pt>
                <c:pt idx="978">
                  <c:v>710</c:v>
                </c:pt>
                <c:pt idx="979">
                  <c:v>605</c:v>
                </c:pt>
                <c:pt idx="980">
                  <c:v>2180</c:v>
                </c:pt>
                <c:pt idx="981">
                  <c:v>1267</c:v>
                </c:pt>
                <c:pt idx="982">
                  <c:v>1435</c:v>
                </c:pt>
                <c:pt idx="983">
                  <c:v>1552</c:v>
                </c:pt>
                <c:pt idx="984">
                  <c:v>740</c:v>
                </c:pt>
                <c:pt idx="985">
                  <c:v>1466</c:v>
                </c:pt>
                <c:pt idx="986">
                  <c:v>1094</c:v>
                </c:pt>
                <c:pt idx="987">
                  <c:v>860</c:v>
                </c:pt>
                <c:pt idx="988">
                  <c:v>1447</c:v>
                </c:pt>
                <c:pt idx="989">
                  <c:v>2262</c:v>
                </c:pt>
                <c:pt idx="990">
                  <c:v>2340</c:v>
                </c:pt>
                <c:pt idx="991">
                  <c:v>1769</c:v>
                </c:pt>
                <c:pt idx="992">
                  <c:v>556</c:v>
                </c:pt>
                <c:pt idx="993">
                  <c:v>1743</c:v>
                </c:pt>
                <c:pt idx="994">
                  <c:v>1110</c:v>
                </c:pt>
                <c:pt idx="995">
                  <c:v>1995</c:v>
                </c:pt>
                <c:pt idx="996">
                  <c:v>1193</c:v>
                </c:pt>
                <c:pt idx="997">
                  <c:v>1350</c:v>
                </c:pt>
                <c:pt idx="998">
                  <c:v>2388</c:v>
                </c:pt>
                <c:pt idx="999">
                  <c:v>1330</c:v>
                </c:pt>
                <c:pt idx="1000">
                  <c:v>2213</c:v>
                </c:pt>
                <c:pt idx="1001">
                  <c:v>2010</c:v>
                </c:pt>
                <c:pt idx="1002">
                  <c:v>1465</c:v>
                </c:pt>
                <c:pt idx="1003">
                  <c:v>1238</c:v>
                </c:pt>
                <c:pt idx="1004">
                  <c:v>2280</c:v>
                </c:pt>
                <c:pt idx="1005">
                  <c:v>2205</c:v>
                </c:pt>
                <c:pt idx="1006">
                  <c:v>844</c:v>
                </c:pt>
                <c:pt idx="1007">
                  <c:v>995</c:v>
                </c:pt>
                <c:pt idx="1008">
                  <c:v>926</c:v>
                </c:pt>
                <c:pt idx="1009">
                  <c:v>2298</c:v>
                </c:pt>
                <c:pt idx="1010">
                  <c:v>762</c:v>
                </c:pt>
                <c:pt idx="1011">
                  <c:v>691</c:v>
                </c:pt>
                <c:pt idx="1012">
                  <c:v>2398</c:v>
                </c:pt>
                <c:pt idx="1013">
                  <c:v>1730</c:v>
                </c:pt>
                <c:pt idx="1014">
                  <c:v>1987</c:v>
                </c:pt>
                <c:pt idx="1015">
                  <c:v>2276</c:v>
                </c:pt>
                <c:pt idx="1016">
                  <c:v>607</c:v>
                </c:pt>
                <c:pt idx="1017">
                  <c:v>2278</c:v>
                </c:pt>
                <c:pt idx="1018">
                  <c:v>857</c:v>
                </c:pt>
                <c:pt idx="1019">
                  <c:v>2053</c:v>
                </c:pt>
                <c:pt idx="1020">
                  <c:v>2222</c:v>
                </c:pt>
                <c:pt idx="1021">
                  <c:v>616</c:v>
                </c:pt>
                <c:pt idx="1022">
                  <c:v>1793</c:v>
                </c:pt>
                <c:pt idx="1023">
                  <c:v>2232</c:v>
                </c:pt>
                <c:pt idx="1024">
                  <c:v>972</c:v>
                </c:pt>
                <c:pt idx="1025">
                  <c:v>994</c:v>
                </c:pt>
                <c:pt idx="1026">
                  <c:v>1752</c:v>
                </c:pt>
                <c:pt idx="1027">
                  <c:v>1511</c:v>
                </c:pt>
                <c:pt idx="1028">
                  <c:v>845</c:v>
                </c:pt>
                <c:pt idx="1029">
                  <c:v>2319</c:v>
                </c:pt>
                <c:pt idx="1030">
                  <c:v>703</c:v>
                </c:pt>
                <c:pt idx="1031">
                  <c:v>2190</c:v>
                </c:pt>
                <c:pt idx="1032">
                  <c:v>2114</c:v>
                </c:pt>
                <c:pt idx="1033">
                  <c:v>744</c:v>
                </c:pt>
                <c:pt idx="1034">
                  <c:v>2167</c:v>
                </c:pt>
                <c:pt idx="1035">
                  <c:v>1489</c:v>
                </c:pt>
                <c:pt idx="1036">
                  <c:v>2035</c:v>
                </c:pt>
                <c:pt idx="1037">
                  <c:v>2015</c:v>
                </c:pt>
                <c:pt idx="1038">
                  <c:v>706</c:v>
                </c:pt>
                <c:pt idx="1039">
                  <c:v>2048</c:v>
                </c:pt>
                <c:pt idx="1040">
                  <c:v>1622</c:v>
                </c:pt>
                <c:pt idx="1041">
                  <c:v>882</c:v>
                </c:pt>
                <c:pt idx="1042">
                  <c:v>614</c:v>
                </c:pt>
                <c:pt idx="1043">
                  <c:v>1023</c:v>
                </c:pt>
                <c:pt idx="1044">
                  <c:v>856</c:v>
                </c:pt>
                <c:pt idx="1045">
                  <c:v>1878</c:v>
                </c:pt>
                <c:pt idx="1046">
                  <c:v>663</c:v>
                </c:pt>
                <c:pt idx="1047">
                  <c:v>2024</c:v>
                </c:pt>
                <c:pt idx="1048">
                  <c:v>832</c:v>
                </c:pt>
                <c:pt idx="1049">
                  <c:v>1488</c:v>
                </c:pt>
                <c:pt idx="1050">
                  <c:v>2347</c:v>
                </c:pt>
                <c:pt idx="1051">
                  <c:v>2260</c:v>
                </c:pt>
                <c:pt idx="1052">
                  <c:v>432</c:v>
                </c:pt>
                <c:pt idx="1053">
                  <c:v>1582</c:v>
                </c:pt>
                <c:pt idx="1054">
                  <c:v>674</c:v>
                </c:pt>
                <c:pt idx="1055">
                  <c:v>2132</c:v>
                </c:pt>
                <c:pt idx="1056">
                  <c:v>688</c:v>
                </c:pt>
                <c:pt idx="1057">
                  <c:v>1237</c:v>
                </c:pt>
                <c:pt idx="1058">
                  <c:v>1042</c:v>
                </c:pt>
                <c:pt idx="1059">
                  <c:v>1362</c:v>
                </c:pt>
                <c:pt idx="1060">
                  <c:v>2368</c:v>
                </c:pt>
                <c:pt idx="1061">
                  <c:v>1194</c:v>
                </c:pt>
                <c:pt idx="1062">
                  <c:v>1857</c:v>
                </c:pt>
                <c:pt idx="1063">
                  <c:v>1705</c:v>
                </c:pt>
                <c:pt idx="1064">
                  <c:v>2112</c:v>
                </c:pt>
                <c:pt idx="1065">
                  <c:v>2206</c:v>
                </c:pt>
                <c:pt idx="1066">
                  <c:v>2392</c:v>
                </c:pt>
                <c:pt idx="1067">
                  <c:v>770</c:v>
                </c:pt>
                <c:pt idx="1068">
                  <c:v>2287</c:v>
                </c:pt>
                <c:pt idx="1069">
                  <c:v>894</c:v>
                </c:pt>
                <c:pt idx="1070">
                  <c:v>661</c:v>
                </c:pt>
                <c:pt idx="1071">
                  <c:v>941</c:v>
                </c:pt>
                <c:pt idx="1072">
                  <c:v>67</c:v>
                </c:pt>
                <c:pt idx="1073">
                  <c:v>895</c:v>
                </c:pt>
                <c:pt idx="1074">
                  <c:v>1938</c:v>
                </c:pt>
                <c:pt idx="1075">
                  <c:v>2328</c:v>
                </c:pt>
                <c:pt idx="1076">
                  <c:v>2233</c:v>
                </c:pt>
                <c:pt idx="1077">
                  <c:v>1915</c:v>
                </c:pt>
                <c:pt idx="1078">
                  <c:v>2323</c:v>
                </c:pt>
                <c:pt idx="1079">
                  <c:v>2017</c:v>
                </c:pt>
                <c:pt idx="1080">
                  <c:v>2219</c:v>
                </c:pt>
                <c:pt idx="1081">
                  <c:v>1290</c:v>
                </c:pt>
                <c:pt idx="1082">
                  <c:v>2003</c:v>
                </c:pt>
                <c:pt idx="1083">
                  <c:v>1791</c:v>
                </c:pt>
                <c:pt idx="1084">
                  <c:v>917</c:v>
                </c:pt>
                <c:pt idx="1085">
                  <c:v>1923</c:v>
                </c:pt>
                <c:pt idx="1086">
                  <c:v>2037</c:v>
                </c:pt>
                <c:pt idx="1087">
                  <c:v>1262</c:v>
                </c:pt>
                <c:pt idx="1088">
                  <c:v>1801</c:v>
                </c:pt>
                <c:pt idx="1089">
                  <c:v>2093</c:v>
                </c:pt>
                <c:pt idx="1090">
                  <c:v>2257</c:v>
                </c:pt>
                <c:pt idx="1091">
                  <c:v>1029</c:v>
                </c:pt>
                <c:pt idx="1092">
                  <c:v>2150</c:v>
                </c:pt>
                <c:pt idx="1093">
                  <c:v>1090</c:v>
                </c:pt>
                <c:pt idx="1094">
                  <c:v>2155</c:v>
                </c:pt>
                <c:pt idx="1095">
                  <c:v>685</c:v>
                </c:pt>
                <c:pt idx="1096">
                  <c:v>1808</c:v>
                </c:pt>
                <c:pt idx="1097">
                  <c:v>1750</c:v>
                </c:pt>
                <c:pt idx="1098">
                  <c:v>759</c:v>
                </c:pt>
                <c:pt idx="1099">
                  <c:v>1056</c:v>
                </c:pt>
                <c:pt idx="1100">
                  <c:v>1418</c:v>
                </c:pt>
                <c:pt idx="1101">
                  <c:v>499</c:v>
                </c:pt>
                <c:pt idx="1102">
                  <c:v>2142</c:v>
                </c:pt>
                <c:pt idx="1103">
                  <c:v>812</c:v>
                </c:pt>
                <c:pt idx="1104">
                  <c:v>2441</c:v>
                </c:pt>
                <c:pt idx="1105">
                  <c:v>1931</c:v>
                </c:pt>
                <c:pt idx="1106">
                  <c:v>868</c:v>
                </c:pt>
                <c:pt idx="1107">
                  <c:v>2453</c:v>
                </c:pt>
                <c:pt idx="1108">
                  <c:v>1906</c:v>
                </c:pt>
                <c:pt idx="1109">
                  <c:v>1032</c:v>
                </c:pt>
                <c:pt idx="1110">
                  <c:v>1738</c:v>
                </c:pt>
                <c:pt idx="1111">
                  <c:v>1074</c:v>
                </c:pt>
                <c:pt idx="1112">
                  <c:v>2348</c:v>
                </c:pt>
                <c:pt idx="1113">
                  <c:v>1156</c:v>
                </c:pt>
                <c:pt idx="1114">
                  <c:v>602</c:v>
                </c:pt>
                <c:pt idx="1115">
                  <c:v>1253</c:v>
                </c:pt>
                <c:pt idx="1116">
                  <c:v>1006</c:v>
                </c:pt>
                <c:pt idx="1117">
                  <c:v>1786</c:v>
                </c:pt>
                <c:pt idx="1118">
                  <c:v>2389</c:v>
                </c:pt>
                <c:pt idx="1119">
                  <c:v>1374</c:v>
                </c:pt>
                <c:pt idx="1120">
                  <c:v>1785</c:v>
                </c:pt>
                <c:pt idx="1121">
                  <c:v>2099</c:v>
                </c:pt>
                <c:pt idx="1122">
                  <c:v>737</c:v>
                </c:pt>
                <c:pt idx="1123">
                  <c:v>2185</c:v>
                </c:pt>
                <c:pt idx="1124">
                  <c:v>2071</c:v>
                </c:pt>
                <c:pt idx="1125">
                  <c:v>1724</c:v>
                </c:pt>
                <c:pt idx="1126">
                  <c:v>1171</c:v>
                </c:pt>
                <c:pt idx="1127">
                  <c:v>1875</c:v>
                </c:pt>
                <c:pt idx="1128">
                  <c:v>2314</c:v>
                </c:pt>
                <c:pt idx="1129">
                  <c:v>840</c:v>
                </c:pt>
                <c:pt idx="1130">
                  <c:v>559</c:v>
                </c:pt>
                <c:pt idx="1131">
                  <c:v>1256</c:v>
                </c:pt>
                <c:pt idx="1132">
                  <c:v>1391</c:v>
                </c:pt>
                <c:pt idx="1133">
                  <c:v>1121</c:v>
                </c:pt>
                <c:pt idx="1134">
                  <c:v>2221</c:v>
                </c:pt>
                <c:pt idx="1135">
                  <c:v>1087</c:v>
                </c:pt>
                <c:pt idx="1136">
                  <c:v>1215</c:v>
                </c:pt>
                <c:pt idx="1137">
                  <c:v>1013</c:v>
                </c:pt>
                <c:pt idx="1138">
                  <c:v>1921</c:v>
                </c:pt>
                <c:pt idx="1139">
                  <c:v>1846</c:v>
                </c:pt>
                <c:pt idx="1140">
                  <c:v>1098</c:v>
                </c:pt>
                <c:pt idx="1141">
                  <c:v>1079</c:v>
                </c:pt>
                <c:pt idx="1142">
                  <c:v>1394</c:v>
                </c:pt>
                <c:pt idx="1143">
                  <c:v>2344</c:v>
                </c:pt>
                <c:pt idx="1144">
                  <c:v>707</c:v>
                </c:pt>
                <c:pt idx="1145">
                  <c:v>28</c:v>
                </c:pt>
                <c:pt idx="1146">
                  <c:v>1598</c:v>
                </c:pt>
                <c:pt idx="1147">
                  <c:v>2310</c:v>
                </c:pt>
                <c:pt idx="1148">
                  <c:v>1346</c:v>
                </c:pt>
                <c:pt idx="1149">
                  <c:v>1836</c:v>
                </c:pt>
                <c:pt idx="1150">
                  <c:v>835</c:v>
                </c:pt>
                <c:pt idx="1151">
                  <c:v>923</c:v>
                </c:pt>
                <c:pt idx="1152">
                  <c:v>1214</c:v>
                </c:pt>
                <c:pt idx="1153">
                  <c:v>1211</c:v>
                </c:pt>
                <c:pt idx="1154">
                  <c:v>1333</c:v>
                </c:pt>
                <c:pt idx="1155">
                  <c:v>1884</c:v>
                </c:pt>
                <c:pt idx="1156">
                  <c:v>519</c:v>
                </c:pt>
                <c:pt idx="1157">
                  <c:v>1479</c:v>
                </c:pt>
                <c:pt idx="1158">
                  <c:v>1154</c:v>
                </c:pt>
                <c:pt idx="1159">
                  <c:v>2431</c:v>
                </c:pt>
                <c:pt idx="1160">
                  <c:v>2252</c:v>
                </c:pt>
                <c:pt idx="1161">
                  <c:v>1538</c:v>
                </c:pt>
                <c:pt idx="1162">
                  <c:v>937</c:v>
                </c:pt>
                <c:pt idx="1163">
                  <c:v>1031</c:v>
                </c:pt>
                <c:pt idx="1164">
                  <c:v>1854</c:v>
                </c:pt>
                <c:pt idx="1165">
                  <c:v>2165</c:v>
                </c:pt>
                <c:pt idx="1166">
                  <c:v>1542</c:v>
                </c:pt>
                <c:pt idx="1167">
                  <c:v>934</c:v>
                </c:pt>
                <c:pt idx="1168">
                  <c:v>985</c:v>
                </c:pt>
                <c:pt idx="1169">
                  <c:v>2407</c:v>
                </c:pt>
                <c:pt idx="1170">
                  <c:v>1850</c:v>
                </c:pt>
                <c:pt idx="1171">
                  <c:v>430</c:v>
                </c:pt>
                <c:pt idx="1172">
                  <c:v>659</c:v>
                </c:pt>
                <c:pt idx="1173">
                  <c:v>1389</c:v>
                </c:pt>
                <c:pt idx="1174">
                  <c:v>959</c:v>
                </c:pt>
                <c:pt idx="1175">
                  <c:v>801</c:v>
                </c:pt>
                <c:pt idx="1176">
                  <c:v>1164</c:v>
                </c:pt>
                <c:pt idx="1177">
                  <c:v>2145</c:v>
                </c:pt>
                <c:pt idx="1178">
                  <c:v>2130</c:v>
                </c:pt>
                <c:pt idx="1179">
                  <c:v>2032</c:v>
                </c:pt>
                <c:pt idx="1180">
                  <c:v>1562</c:v>
                </c:pt>
                <c:pt idx="1181">
                  <c:v>951</c:v>
                </c:pt>
                <c:pt idx="1182">
                  <c:v>1459</c:v>
                </c:pt>
                <c:pt idx="1183">
                  <c:v>1919</c:v>
                </c:pt>
                <c:pt idx="1184">
                  <c:v>596</c:v>
                </c:pt>
                <c:pt idx="1185">
                  <c:v>1736</c:v>
                </c:pt>
                <c:pt idx="1186">
                  <c:v>791</c:v>
                </c:pt>
                <c:pt idx="1187">
                  <c:v>2006</c:v>
                </c:pt>
                <c:pt idx="1188">
                  <c:v>1699</c:v>
                </c:pt>
                <c:pt idx="1189">
                  <c:v>1515</c:v>
                </c:pt>
                <c:pt idx="1190">
                  <c:v>1212</c:v>
                </c:pt>
                <c:pt idx="1191">
                  <c:v>1329</c:v>
                </c:pt>
                <c:pt idx="1192">
                  <c:v>2050</c:v>
                </c:pt>
                <c:pt idx="1193">
                  <c:v>936</c:v>
                </c:pt>
                <c:pt idx="1194">
                  <c:v>1695</c:v>
                </c:pt>
                <c:pt idx="1195">
                  <c:v>1216</c:v>
                </c:pt>
                <c:pt idx="1196">
                  <c:v>2082</c:v>
                </c:pt>
                <c:pt idx="1197">
                  <c:v>2406</c:v>
                </c:pt>
                <c:pt idx="1198">
                  <c:v>969</c:v>
                </c:pt>
                <c:pt idx="1199">
                  <c:v>918</c:v>
                </c:pt>
                <c:pt idx="1200">
                  <c:v>1867</c:v>
                </c:pt>
                <c:pt idx="1201">
                  <c:v>2422</c:v>
                </c:pt>
                <c:pt idx="1202">
                  <c:v>1116</c:v>
                </c:pt>
                <c:pt idx="1203">
                  <c:v>1871</c:v>
                </c:pt>
                <c:pt idx="1204">
                  <c:v>781</c:v>
                </c:pt>
                <c:pt idx="1205">
                  <c:v>968</c:v>
                </c:pt>
                <c:pt idx="1206">
                  <c:v>1273</c:v>
                </c:pt>
                <c:pt idx="1207">
                  <c:v>1885</c:v>
                </c:pt>
                <c:pt idx="1208">
                  <c:v>2358</c:v>
                </c:pt>
                <c:pt idx="1209">
                  <c:v>945</c:v>
                </c:pt>
                <c:pt idx="1210">
                  <c:v>658</c:v>
                </c:pt>
                <c:pt idx="1211">
                  <c:v>1172</c:v>
                </c:pt>
                <c:pt idx="1212">
                  <c:v>1899</c:v>
                </c:pt>
                <c:pt idx="1213">
                  <c:v>1501</c:v>
                </c:pt>
                <c:pt idx="1214">
                  <c:v>2267</c:v>
                </c:pt>
                <c:pt idx="1215">
                  <c:v>2291</c:v>
                </c:pt>
                <c:pt idx="1216">
                  <c:v>2008</c:v>
                </c:pt>
                <c:pt idx="1217">
                  <c:v>2430</c:v>
                </c:pt>
                <c:pt idx="1218">
                  <c:v>2303</c:v>
                </c:pt>
                <c:pt idx="1219">
                  <c:v>2371</c:v>
                </c:pt>
                <c:pt idx="1220">
                  <c:v>1904</c:v>
                </c:pt>
                <c:pt idx="1221">
                  <c:v>1535</c:v>
                </c:pt>
                <c:pt idx="1222">
                  <c:v>715</c:v>
                </c:pt>
                <c:pt idx="1223">
                  <c:v>748</c:v>
                </c:pt>
                <c:pt idx="1224">
                  <c:v>782</c:v>
                </c:pt>
                <c:pt idx="1225">
                  <c:v>2034</c:v>
                </c:pt>
                <c:pt idx="1226">
                  <c:v>2289</c:v>
                </c:pt>
                <c:pt idx="1227">
                  <c:v>967</c:v>
                </c:pt>
                <c:pt idx="1228">
                  <c:v>2363</c:v>
                </c:pt>
                <c:pt idx="1229">
                  <c:v>643</c:v>
                </c:pt>
                <c:pt idx="1230">
                  <c:v>2301</c:v>
                </c:pt>
                <c:pt idx="1231">
                  <c:v>726</c:v>
                </c:pt>
                <c:pt idx="1232">
                  <c:v>1280</c:v>
                </c:pt>
                <c:pt idx="1233">
                  <c:v>2131</c:v>
                </c:pt>
                <c:pt idx="1234">
                  <c:v>576</c:v>
                </c:pt>
                <c:pt idx="1235">
                  <c:v>2457</c:v>
                </c:pt>
                <c:pt idx="1236">
                  <c:v>792</c:v>
                </c:pt>
                <c:pt idx="1237">
                  <c:v>1054</c:v>
                </c:pt>
                <c:pt idx="1238">
                  <c:v>665</c:v>
                </c:pt>
                <c:pt idx="1239">
                  <c:v>2069</c:v>
                </c:pt>
                <c:pt idx="1240">
                  <c:v>725</c:v>
                </c:pt>
                <c:pt idx="1241">
                  <c:v>2373</c:v>
                </c:pt>
                <c:pt idx="1242">
                  <c:v>1462</c:v>
                </c:pt>
                <c:pt idx="1243">
                  <c:v>1050</c:v>
                </c:pt>
                <c:pt idx="1244">
                  <c:v>1310</c:v>
                </c:pt>
                <c:pt idx="1245">
                  <c:v>997</c:v>
                </c:pt>
                <c:pt idx="1246">
                  <c:v>2390</c:v>
                </c:pt>
                <c:pt idx="1247">
                  <c:v>1217</c:v>
                </c:pt>
                <c:pt idx="1248">
                  <c:v>1522</c:v>
                </c:pt>
                <c:pt idx="1249">
                  <c:v>2355</c:v>
                </c:pt>
                <c:pt idx="1250">
                  <c:v>1734</c:v>
                </c:pt>
                <c:pt idx="1251">
                  <c:v>660</c:v>
                </c:pt>
                <c:pt idx="1252">
                  <c:v>1599</c:v>
                </c:pt>
                <c:pt idx="1253">
                  <c:v>667</c:v>
                </c:pt>
                <c:pt idx="1254">
                  <c:v>1809</c:v>
                </c:pt>
                <c:pt idx="1255">
                  <c:v>2224</c:v>
                </c:pt>
                <c:pt idx="1256">
                  <c:v>831</c:v>
                </c:pt>
                <c:pt idx="1257">
                  <c:v>774</c:v>
                </c:pt>
                <c:pt idx="1258">
                  <c:v>1866</c:v>
                </c:pt>
                <c:pt idx="1259">
                  <c:v>2011</c:v>
                </c:pt>
                <c:pt idx="1260">
                  <c:v>2432</c:v>
                </c:pt>
                <c:pt idx="1261">
                  <c:v>1591</c:v>
                </c:pt>
                <c:pt idx="1262">
                  <c:v>407</c:v>
                </c:pt>
                <c:pt idx="1263">
                  <c:v>1427</c:v>
                </c:pt>
                <c:pt idx="1264">
                  <c:v>1401</c:v>
                </c:pt>
                <c:pt idx="1265">
                  <c:v>2065</c:v>
                </c:pt>
                <c:pt idx="1266">
                  <c:v>1258</c:v>
                </c:pt>
                <c:pt idx="1267">
                  <c:v>624</c:v>
                </c:pt>
                <c:pt idx="1268">
                  <c:v>2405</c:v>
                </c:pt>
                <c:pt idx="1269">
                  <c:v>1829</c:v>
                </c:pt>
                <c:pt idx="1270">
                  <c:v>1849</c:v>
                </c:pt>
                <c:pt idx="1271">
                  <c:v>1555</c:v>
                </c:pt>
                <c:pt idx="1272">
                  <c:v>2075</c:v>
                </c:pt>
                <c:pt idx="1273">
                  <c:v>2103</c:v>
                </c:pt>
                <c:pt idx="1274">
                  <c:v>1704</c:v>
                </c:pt>
                <c:pt idx="1275">
                  <c:v>804</c:v>
                </c:pt>
                <c:pt idx="1276">
                  <c:v>1732</c:v>
                </c:pt>
                <c:pt idx="1277">
                  <c:v>1961</c:v>
                </c:pt>
                <c:pt idx="1278">
                  <c:v>1979</c:v>
                </c:pt>
                <c:pt idx="1279">
                  <c:v>2434</c:v>
                </c:pt>
                <c:pt idx="1280">
                  <c:v>1043</c:v>
                </c:pt>
                <c:pt idx="1281">
                  <c:v>502</c:v>
                </c:pt>
                <c:pt idx="1282">
                  <c:v>1767</c:v>
                </c:pt>
                <c:pt idx="1283">
                  <c:v>2022</c:v>
                </c:pt>
                <c:pt idx="1284">
                  <c:v>2199</c:v>
                </c:pt>
                <c:pt idx="1285">
                  <c:v>1814</c:v>
                </c:pt>
                <c:pt idx="1286">
                  <c:v>1444</c:v>
                </c:pt>
                <c:pt idx="1287">
                  <c:v>1907</c:v>
                </c:pt>
                <c:pt idx="1288">
                  <c:v>2030</c:v>
                </c:pt>
                <c:pt idx="1289">
                  <c:v>1509</c:v>
                </c:pt>
                <c:pt idx="1290">
                  <c:v>1081</c:v>
                </c:pt>
                <c:pt idx="1291">
                  <c:v>1901</c:v>
                </c:pt>
                <c:pt idx="1292">
                  <c:v>1898</c:v>
                </c:pt>
                <c:pt idx="1293">
                  <c:v>2433</c:v>
                </c:pt>
                <c:pt idx="1294">
                  <c:v>1608</c:v>
                </c:pt>
                <c:pt idx="1295">
                  <c:v>1004</c:v>
                </c:pt>
                <c:pt idx="1296">
                  <c:v>861</c:v>
                </c:pt>
                <c:pt idx="1297">
                  <c:v>618</c:v>
                </c:pt>
                <c:pt idx="1298">
                  <c:v>2095</c:v>
                </c:pt>
                <c:pt idx="1299">
                  <c:v>729</c:v>
                </c:pt>
                <c:pt idx="1300">
                  <c:v>758</c:v>
                </c:pt>
                <c:pt idx="1301">
                  <c:v>1503</c:v>
                </c:pt>
                <c:pt idx="1302">
                  <c:v>1728</c:v>
                </c:pt>
                <c:pt idx="1303">
                  <c:v>1396</c:v>
                </c:pt>
                <c:pt idx="1304">
                  <c:v>1390</c:v>
                </c:pt>
                <c:pt idx="1305">
                  <c:v>2385</c:v>
                </c:pt>
                <c:pt idx="1306">
                  <c:v>898</c:v>
                </c:pt>
                <c:pt idx="1307">
                  <c:v>1458</c:v>
                </c:pt>
                <c:pt idx="1308">
                  <c:v>2409</c:v>
                </c:pt>
                <c:pt idx="1309">
                  <c:v>2014</c:v>
                </c:pt>
                <c:pt idx="1310">
                  <c:v>915</c:v>
                </c:pt>
                <c:pt idx="1311">
                  <c:v>2330</c:v>
                </c:pt>
                <c:pt idx="1312">
                  <c:v>2325</c:v>
                </c:pt>
                <c:pt idx="1313">
                  <c:v>1291</c:v>
                </c:pt>
                <c:pt idx="1314">
                  <c:v>1844</c:v>
                </c:pt>
                <c:pt idx="1315">
                  <c:v>1134</c:v>
                </c:pt>
                <c:pt idx="1316">
                  <c:v>592</c:v>
                </c:pt>
                <c:pt idx="1317">
                  <c:v>2201</c:v>
                </c:pt>
                <c:pt idx="1318">
                  <c:v>558</c:v>
                </c:pt>
                <c:pt idx="1319">
                  <c:v>921</c:v>
                </c:pt>
                <c:pt idx="1320">
                  <c:v>1759</c:v>
                </c:pt>
                <c:pt idx="1321">
                  <c:v>1069</c:v>
                </c:pt>
                <c:pt idx="1322">
                  <c:v>2370</c:v>
                </c:pt>
                <c:pt idx="1323">
                  <c:v>2194</c:v>
                </c:pt>
                <c:pt idx="1324">
                  <c:v>1186</c:v>
                </c:pt>
                <c:pt idx="1325">
                  <c:v>2256</c:v>
                </c:pt>
                <c:pt idx="1326">
                  <c:v>1612</c:v>
                </c:pt>
                <c:pt idx="1327">
                  <c:v>2176</c:v>
                </c:pt>
                <c:pt idx="1328">
                  <c:v>1478</c:v>
                </c:pt>
                <c:pt idx="1329">
                  <c:v>2274</c:v>
                </c:pt>
                <c:pt idx="1330">
                  <c:v>1749</c:v>
                </c:pt>
                <c:pt idx="1331">
                  <c:v>1224</c:v>
                </c:pt>
                <c:pt idx="1332">
                  <c:v>2250</c:v>
                </c:pt>
                <c:pt idx="1333">
                  <c:v>1690</c:v>
                </c:pt>
                <c:pt idx="1334">
                  <c:v>2304</c:v>
                </c:pt>
                <c:pt idx="1335">
                  <c:v>1646</c:v>
                </c:pt>
                <c:pt idx="1336">
                  <c:v>1314</c:v>
                </c:pt>
                <c:pt idx="1337">
                  <c:v>1617</c:v>
                </c:pt>
                <c:pt idx="1338">
                  <c:v>668</c:v>
                </c:pt>
                <c:pt idx="1339">
                  <c:v>943</c:v>
                </c:pt>
                <c:pt idx="1340">
                  <c:v>2091</c:v>
                </c:pt>
                <c:pt idx="1341">
                  <c:v>776</c:v>
                </c:pt>
                <c:pt idx="1342">
                  <c:v>1059</c:v>
                </c:pt>
                <c:pt idx="1343">
                  <c:v>2116</c:v>
                </c:pt>
                <c:pt idx="1344">
                  <c:v>853</c:v>
                </c:pt>
                <c:pt idx="1345">
                  <c:v>2271</c:v>
                </c:pt>
                <c:pt idx="1346">
                  <c:v>2049</c:v>
                </c:pt>
                <c:pt idx="1347">
                  <c:v>1299</c:v>
                </c:pt>
                <c:pt idx="1348">
                  <c:v>1626</c:v>
                </c:pt>
                <c:pt idx="1349">
                  <c:v>1016</c:v>
                </c:pt>
                <c:pt idx="1350">
                  <c:v>2408</c:v>
                </c:pt>
                <c:pt idx="1351">
                  <c:v>1199</c:v>
                </c:pt>
                <c:pt idx="1352">
                  <c:v>2401</c:v>
                </c:pt>
                <c:pt idx="1353">
                  <c:v>1816</c:v>
                </c:pt>
                <c:pt idx="1354">
                  <c:v>2139</c:v>
                </c:pt>
                <c:pt idx="1355">
                  <c:v>817</c:v>
                </c:pt>
                <c:pt idx="1356">
                  <c:v>1913</c:v>
                </c:pt>
                <c:pt idx="1357">
                  <c:v>1891</c:v>
                </c:pt>
                <c:pt idx="1358">
                  <c:v>1722</c:v>
                </c:pt>
                <c:pt idx="1359">
                  <c:v>1835</c:v>
                </c:pt>
                <c:pt idx="1360">
                  <c:v>427</c:v>
                </c:pt>
                <c:pt idx="1361">
                  <c:v>1244</c:v>
                </c:pt>
                <c:pt idx="1362">
                  <c:v>910</c:v>
                </c:pt>
                <c:pt idx="1363">
                  <c:v>1014</c:v>
                </c:pt>
                <c:pt idx="1364">
                  <c:v>1606</c:v>
                </c:pt>
                <c:pt idx="1365">
                  <c:v>952</c:v>
                </c:pt>
                <c:pt idx="1366">
                  <c:v>628</c:v>
                </c:pt>
                <c:pt idx="1367">
                  <c:v>2452</c:v>
                </c:pt>
                <c:pt idx="1368">
                  <c:v>793</c:v>
                </c:pt>
                <c:pt idx="1369">
                  <c:v>1173</c:v>
                </c:pt>
                <c:pt idx="1370">
                  <c:v>2288</c:v>
                </c:pt>
                <c:pt idx="1371">
                  <c:v>584</c:v>
                </c:pt>
                <c:pt idx="1372">
                  <c:v>1033</c:v>
                </c:pt>
                <c:pt idx="1373">
                  <c:v>1097</c:v>
                </c:pt>
                <c:pt idx="1374">
                  <c:v>819</c:v>
                </c:pt>
                <c:pt idx="1375">
                  <c:v>1583</c:v>
                </c:pt>
                <c:pt idx="1376">
                  <c:v>2362</c:v>
                </c:pt>
                <c:pt idx="1377">
                  <c:v>773</c:v>
                </c:pt>
                <c:pt idx="1378">
                  <c:v>2088</c:v>
                </c:pt>
                <c:pt idx="1379">
                  <c:v>1936</c:v>
                </c:pt>
                <c:pt idx="1380">
                  <c:v>1361</c:v>
                </c:pt>
                <c:pt idx="1381">
                  <c:v>920</c:v>
                </c:pt>
                <c:pt idx="1382">
                  <c:v>2255</c:v>
                </c:pt>
                <c:pt idx="1383">
                  <c:v>1203</c:v>
                </c:pt>
                <c:pt idx="1384">
                  <c:v>2140</c:v>
                </c:pt>
                <c:pt idx="1385">
                  <c:v>1691</c:v>
                </c:pt>
                <c:pt idx="1386">
                  <c:v>1697</c:v>
                </c:pt>
                <c:pt idx="1387">
                  <c:v>455</c:v>
                </c:pt>
                <c:pt idx="1388">
                  <c:v>1838</c:v>
                </c:pt>
                <c:pt idx="1389">
                  <c:v>870</c:v>
                </c:pt>
                <c:pt idx="1390">
                  <c:v>580</c:v>
                </c:pt>
                <c:pt idx="1391">
                  <c:v>2294</c:v>
                </c:pt>
              </c:numCache>
            </c:numRef>
          </c:xVal>
          <c:yVal>
            <c:numRef>
              <c:f>'Brachy TIR1'!$E$4:$E$1395</c:f>
              <c:numCache>
                <c:formatCode>General</c:formatCode>
                <c:ptCount val="1392"/>
                <c:pt idx="0">
                  <c:v>1</c:v>
                </c:pt>
                <c:pt idx="3">
                  <c:v>1</c:v>
                </c:pt>
                <c:pt idx="4">
                  <c:v>1</c:v>
                </c:pt>
                <c:pt idx="5">
                  <c:v>1</c:v>
                </c:pt>
                <c:pt idx="6">
                  <c:v>1</c:v>
                </c:pt>
                <c:pt idx="7">
                  <c:v>1</c:v>
                </c:pt>
                <c:pt idx="8">
                  <c:v>1</c:v>
                </c:pt>
                <c:pt idx="10">
                  <c:v>1</c:v>
                </c:pt>
                <c:pt idx="11">
                  <c:v>1</c:v>
                </c:pt>
                <c:pt idx="12">
                  <c:v>1</c:v>
                </c:pt>
                <c:pt idx="15">
                  <c:v>1</c:v>
                </c:pt>
                <c:pt idx="16">
                  <c:v>1</c:v>
                </c:pt>
                <c:pt idx="17">
                  <c:v>1</c:v>
                </c:pt>
                <c:pt idx="20">
                  <c:v>1</c:v>
                </c:pt>
                <c:pt idx="22">
                  <c:v>1</c:v>
                </c:pt>
                <c:pt idx="26">
                  <c:v>1</c:v>
                </c:pt>
                <c:pt idx="27">
                  <c:v>1</c:v>
                </c:pt>
                <c:pt idx="28">
                  <c:v>1</c:v>
                </c:pt>
                <c:pt idx="30">
                  <c:v>1</c:v>
                </c:pt>
                <c:pt idx="32">
                  <c:v>1</c:v>
                </c:pt>
                <c:pt idx="33">
                  <c:v>2</c:v>
                </c:pt>
                <c:pt idx="37">
                  <c:v>1</c:v>
                </c:pt>
                <c:pt idx="38">
                  <c:v>1</c:v>
                </c:pt>
                <c:pt idx="39">
                  <c:v>1</c:v>
                </c:pt>
                <c:pt idx="40">
                  <c:v>1</c:v>
                </c:pt>
                <c:pt idx="42">
                  <c:v>1</c:v>
                </c:pt>
                <c:pt idx="43">
                  <c:v>1</c:v>
                </c:pt>
                <c:pt idx="44">
                  <c:v>1</c:v>
                </c:pt>
                <c:pt idx="46">
                  <c:v>1</c:v>
                </c:pt>
                <c:pt idx="47">
                  <c:v>1</c:v>
                </c:pt>
                <c:pt idx="49">
                  <c:v>1</c:v>
                </c:pt>
                <c:pt idx="50">
                  <c:v>1</c:v>
                </c:pt>
                <c:pt idx="51">
                  <c:v>1</c:v>
                </c:pt>
                <c:pt idx="53">
                  <c:v>1</c:v>
                </c:pt>
                <c:pt idx="55">
                  <c:v>1</c:v>
                </c:pt>
                <c:pt idx="56">
                  <c:v>1</c:v>
                </c:pt>
                <c:pt idx="57">
                  <c:v>1</c:v>
                </c:pt>
                <c:pt idx="59">
                  <c:v>1</c:v>
                </c:pt>
                <c:pt idx="60">
                  <c:v>1</c:v>
                </c:pt>
                <c:pt idx="61">
                  <c:v>1</c:v>
                </c:pt>
                <c:pt idx="62">
                  <c:v>1</c:v>
                </c:pt>
                <c:pt idx="63">
                  <c:v>5</c:v>
                </c:pt>
                <c:pt idx="64">
                  <c:v>1</c:v>
                </c:pt>
                <c:pt idx="66">
                  <c:v>1</c:v>
                </c:pt>
                <c:pt idx="67">
                  <c:v>1</c:v>
                </c:pt>
                <c:pt idx="68">
                  <c:v>1</c:v>
                </c:pt>
                <c:pt idx="69">
                  <c:v>1</c:v>
                </c:pt>
                <c:pt idx="70">
                  <c:v>1</c:v>
                </c:pt>
                <c:pt idx="71">
                  <c:v>1</c:v>
                </c:pt>
                <c:pt idx="74">
                  <c:v>1</c:v>
                </c:pt>
                <c:pt idx="79">
                  <c:v>1</c:v>
                </c:pt>
                <c:pt idx="80">
                  <c:v>1</c:v>
                </c:pt>
                <c:pt idx="81">
                  <c:v>1</c:v>
                </c:pt>
                <c:pt idx="82">
                  <c:v>1</c:v>
                </c:pt>
                <c:pt idx="83">
                  <c:v>2</c:v>
                </c:pt>
                <c:pt idx="85">
                  <c:v>1</c:v>
                </c:pt>
                <c:pt idx="86">
                  <c:v>1</c:v>
                </c:pt>
                <c:pt idx="88">
                  <c:v>1</c:v>
                </c:pt>
                <c:pt idx="89">
                  <c:v>1</c:v>
                </c:pt>
                <c:pt idx="90">
                  <c:v>1</c:v>
                </c:pt>
                <c:pt idx="92">
                  <c:v>1</c:v>
                </c:pt>
                <c:pt idx="94">
                  <c:v>1</c:v>
                </c:pt>
                <c:pt idx="96">
                  <c:v>1</c:v>
                </c:pt>
                <c:pt idx="100">
                  <c:v>1</c:v>
                </c:pt>
                <c:pt idx="101">
                  <c:v>1</c:v>
                </c:pt>
                <c:pt idx="102">
                  <c:v>2</c:v>
                </c:pt>
                <c:pt idx="106">
                  <c:v>1</c:v>
                </c:pt>
                <c:pt idx="107">
                  <c:v>1</c:v>
                </c:pt>
                <c:pt idx="109">
                  <c:v>1</c:v>
                </c:pt>
                <c:pt idx="112">
                  <c:v>1</c:v>
                </c:pt>
                <c:pt idx="114">
                  <c:v>1</c:v>
                </c:pt>
                <c:pt idx="115">
                  <c:v>1</c:v>
                </c:pt>
                <c:pt idx="116">
                  <c:v>1</c:v>
                </c:pt>
                <c:pt idx="119">
                  <c:v>1</c:v>
                </c:pt>
                <c:pt idx="121">
                  <c:v>1</c:v>
                </c:pt>
                <c:pt idx="122">
                  <c:v>1</c:v>
                </c:pt>
                <c:pt idx="125">
                  <c:v>1</c:v>
                </c:pt>
                <c:pt idx="126">
                  <c:v>1</c:v>
                </c:pt>
                <c:pt idx="130">
                  <c:v>1</c:v>
                </c:pt>
                <c:pt idx="132">
                  <c:v>1</c:v>
                </c:pt>
                <c:pt idx="133">
                  <c:v>1</c:v>
                </c:pt>
                <c:pt idx="137">
                  <c:v>1</c:v>
                </c:pt>
                <c:pt idx="138">
                  <c:v>1</c:v>
                </c:pt>
                <c:pt idx="139">
                  <c:v>1</c:v>
                </c:pt>
                <c:pt idx="140">
                  <c:v>1</c:v>
                </c:pt>
                <c:pt idx="141">
                  <c:v>5</c:v>
                </c:pt>
                <c:pt idx="142">
                  <c:v>1</c:v>
                </c:pt>
                <c:pt idx="143">
                  <c:v>1</c:v>
                </c:pt>
                <c:pt idx="145">
                  <c:v>1</c:v>
                </c:pt>
                <c:pt idx="146">
                  <c:v>2</c:v>
                </c:pt>
                <c:pt idx="147">
                  <c:v>1</c:v>
                </c:pt>
                <c:pt idx="148">
                  <c:v>1</c:v>
                </c:pt>
                <c:pt idx="153">
                  <c:v>1</c:v>
                </c:pt>
                <c:pt idx="154">
                  <c:v>1</c:v>
                </c:pt>
                <c:pt idx="156">
                  <c:v>1</c:v>
                </c:pt>
                <c:pt idx="158">
                  <c:v>1</c:v>
                </c:pt>
                <c:pt idx="161">
                  <c:v>1</c:v>
                </c:pt>
                <c:pt idx="165">
                  <c:v>1</c:v>
                </c:pt>
                <c:pt idx="166">
                  <c:v>1</c:v>
                </c:pt>
                <c:pt idx="167">
                  <c:v>1</c:v>
                </c:pt>
                <c:pt idx="169">
                  <c:v>1</c:v>
                </c:pt>
                <c:pt idx="170">
                  <c:v>1</c:v>
                </c:pt>
                <c:pt idx="172">
                  <c:v>1</c:v>
                </c:pt>
                <c:pt idx="174">
                  <c:v>1</c:v>
                </c:pt>
                <c:pt idx="175">
                  <c:v>1</c:v>
                </c:pt>
                <c:pt idx="176">
                  <c:v>1</c:v>
                </c:pt>
                <c:pt idx="177">
                  <c:v>1</c:v>
                </c:pt>
                <c:pt idx="178">
                  <c:v>1</c:v>
                </c:pt>
                <c:pt idx="179">
                  <c:v>1</c:v>
                </c:pt>
                <c:pt idx="180">
                  <c:v>1</c:v>
                </c:pt>
                <c:pt idx="181">
                  <c:v>1</c:v>
                </c:pt>
                <c:pt idx="183">
                  <c:v>1</c:v>
                </c:pt>
                <c:pt idx="184">
                  <c:v>1</c:v>
                </c:pt>
                <c:pt idx="185">
                  <c:v>1</c:v>
                </c:pt>
                <c:pt idx="186">
                  <c:v>1</c:v>
                </c:pt>
                <c:pt idx="187">
                  <c:v>1</c:v>
                </c:pt>
                <c:pt idx="188">
                  <c:v>1</c:v>
                </c:pt>
                <c:pt idx="190">
                  <c:v>1</c:v>
                </c:pt>
                <c:pt idx="192">
                  <c:v>1</c:v>
                </c:pt>
                <c:pt idx="193">
                  <c:v>1</c:v>
                </c:pt>
                <c:pt idx="194">
                  <c:v>1</c:v>
                </c:pt>
                <c:pt idx="195">
                  <c:v>16</c:v>
                </c:pt>
                <c:pt idx="198">
                  <c:v>1</c:v>
                </c:pt>
                <c:pt idx="200">
                  <c:v>1</c:v>
                </c:pt>
                <c:pt idx="201">
                  <c:v>1</c:v>
                </c:pt>
                <c:pt idx="202">
                  <c:v>1</c:v>
                </c:pt>
                <c:pt idx="203">
                  <c:v>1</c:v>
                </c:pt>
                <c:pt idx="204">
                  <c:v>1</c:v>
                </c:pt>
                <c:pt idx="206">
                  <c:v>1</c:v>
                </c:pt>
                <c:pt idx="208">
                  <c:v>1</c:v>
                </c:pt>
                <c:pt idx="210">
                  <c:v>1</c:v>
                </c:pt>
                <c:pt idx="212">
                  <c:v>1</c:v>
                </c:pt>
                <c:pt idx="213">
                  <c:v>1</c:v>
                </c:pt>
                <c:pt idx="214">
                  <c:v>1</c:v>
                </c:pt>
                <c:pt idx="215">
                  <c:v>1</c:v>
                </c:pt>
                <c:pt idx="216">
                  <c:v>1</c:v>
                </c:pt>
                <c:pt idx="217">
                  <c:v>1</c:v>
                </c:pt>
                <c:pt idx="218">
                  <c:v>1</c:v>
                </c:pt>
                <c:pt idx="221">
                  <c:v>1</c:v>
                </c:pt>
                <c:pt idx="223">
                  <c:v>49</c:v>
                </c:pt>
                <c:pt idx="225">
                  <c:v>1</c:v>
                </c:pt>
                <c:pt idx="226">
                  <c:v>1</c:v>
                </c:pt>
                <c:pt idx="228">
                  <c:v>1</c:v>
                </c:pt>
                <c:pt idx="229">
                  <c:v>3</c:v>
                </c:pt>
                <c:pt idx="230">
                  <c:v>1</c:v>
                </c:pt>
                <c:pt idx="231">
                  <c:v>1</c:v>
                </c:pt>
                <c:pt idx="234">
                  <c:v>1</c:v>
                </c:pt>
                <c:pt idx="239">
                  <c:v>1</c:v>
                </c:pt>
                <c:pt idx="240">
                  <c:v>1</c:v>
                </c:pt>
                <c:pt idx="241">
                  <c:v>1</c:v>
                </c:pt>
                <c:pt idx="242">
                  <c:v>1</c:v>
                </c:pt>
                <c:pt idx="243">
                  <c:v>1</c:v>
                </c:pt>
                <c:pt idx="244">
                  <c:v>1</c:v>
                </c:pt>
                <c:pt idx="245">
                  <c:v>1</c:v>
                </c:pt>
                <c:pt idx="249">
                  <c:v>1</c:v>
                </c:pt>
                <c:pt idx="250">
                  <c:v>1</c:v>
                </c:pt>
                <c:pt idx="251">
                  <c:v>1</c:v>
                </c:pt>
                <c:pt idx="253">
                  <c:v>1</c:v>
                </c:pt>
                <c:pt idx="254">
                  <c:v>3</c:v>
                </c:pt>
                <c:pt idx="255">
                  <c:v>1</c:v>
                </c:pt>
                <c:pt idx="258">
                  <c:v>1</c:v>
                </c:pt>
                <c:pt idx="259">
                  <c:v>1</c:v>
                </c:pt>
                <c:pt idx="261">
                  <c:v>1</c:v>
                </c:pt>
                <c:pt idx="262">
                  <c:v>1</c:v>
                </c:pt>
                <c:pt idx="263">
                  <c:v>1</c:v>
                </c:pt>
                <c:pt idx="265">
                  <c:v>1</c:v>
                </c:pt>
                <c:pt idx="268">
                  <c:v>1</c:v>
                </c:pt>
                <c:pt idx="272">
                  <c:v>1</c:v>
                </c:pt>
                <c:pt idx="274">
                  <c:v>1</c:v>
                </c:pt>
                <c:pt idx="277">
                  <c:v>1</c:v>
                </c:pt>
                <c:pt idx="278">
                  <c:v>1</c:v>
                </c:pt>
                <c:pt idx="280">
                  <c:v>1</c:v>
                </c:pt>
                <c:pt idx="283">
                  <c:v>1</c:v>
                </c:pt>
                <c:pt idx="284">
                  <c:v>1</c:v>
                </c:pt>
                <c:pt idx="286">
                  <c:v>1</c:v>
                </c:pt>
                <c:pt idx="289">
                  <c:v>1</c:v>
                </c:pt>
                <c:pt idx="290">
                  <c:v>1</c:v>
                </c:pt>
                <c:pt idx="291">
                  <c:v>1</c:v>
                </c:pt>
                <c:pt idx="292">
                  <c:v>1</c:v>
                </c:pt>
                <c:pt idx="294">
                  <c:v>1</c:v>
                </c:pt>
                <c:pt idx="296">
                  <c:v>1</c:v>
                </c:pt>
                <c:pt idx="297">
                  <c:v>1</c:v>
                </c:pt>
                <c:pt idx="299">
                  <c:v>1</c:v>
                </c:pt>
                <c:pt idx="300">
                  <c:v>1</c:v>
                </c:pt>
                <c:pt idx="301">
                  <c:v>1</c:v>
                </c:pt>
                <c:pt idx="302">
                  <c:v>1</c:v>
                </c:pt>
                <c:pt idx="304">
                  <c:v>1</c:v>
                </c:pt>
                <c:pt idx="308">
                  <c:v>1</c:v>
                </c:pt>
                <c:pt idx="309">
                  <c:v>1</c:v>
                </c:pt>
                <c:pt idx="310">
                  <c:v>1</c:v>
                </c:pt>
                <c:pt idx="311">
                  <c:v>1</c:v>
                </c:pt>
                <c:pt idx="312">
                  <c:v>1</c:v>
                </c:pt>
                <c:pt idx="313">
                  <c:v>1</c:v>
                </c:pt>
                <c:pt idx="314">
                  <c:v>1</c:v>
                </c:pt>
                <c:pt idx="316">
                  <c:v>1</c:v>
                </c:pt>
                <c:pt idx="317">
                  <c:v>1</c:v>
                </c:pt>
                <c:pt idx="318">
                  <c:v>1</c:v>
                </c:pt>
                <c:pt idx="322">
                  <c:v>1</c:v>
                </c:pt>
                <c:pt idx="323">
                  <c:v>1</c:v>
                </c:pt>
                <c:pt idx="325">
                  <c:v>1</c:v>
                </c:pt>
                <c:pt idx="326">
                  <c:v>44</c:v>
                </c:pt>
                <c:pt idx="327">
                  <c:v>1</c:v>
                </c:pt>
                <c:pt idx="329">
                  <c:v>1</c:v>
                </c:pt>
                <c:pt idx="330">
                  <c:v>1</c:v>
                </c:pt>
                <c:pt idx="331">
                  <c:v>1</c:v>
                </c:pt>
                <c:pt idx="333">
                  <c:v>1</c:v>
                </c:pt>
                <c:pt idx="336">
                  <c:v>1</c:v>
                </c:pt>
                <c:pt idx="337">
                  <c:v>1</c:v>
                </c:pt>
                <c:pt idx="338">
                  <c:v>1</c:v>
                </c:pt>
                <c:pt idx="339">
                  <c:v>1</c:v>
                </c:pt>
                <c:pt idx="340">
                  <c:v>1</c:v>
                </c:pt>
                <c:pt idx="341">
                  <c:v>1</c:v>
                </c:pt>
                <c:pt idx="343">
                  <c:v>1</c:v>
                </c:pt>
                <c:pt idx="344">
                  <c:v>1</c:v>
                </c:pt>
                <c:pt idx="345">
                  <c:v>32</c:v>
                </c:pt>
                <c:pt idx="349">
                  <c:v>1</c:v>
                </c:pt>
                <c:pt idx="351">
                  <c:v>1</c:v>
                </c:pt>
                <c:pt idx="354">
                  <c:v>1</c:v>
                </c:pt>
                <c:pt idx="355">
                  <c:v>1</c:v>
                </c:pt>
                <c:pt idx="357">
                  <c:v>1</c:v>
                </c:pt>
                <c:pt idx="358">
                  <c:v>1</c:v>
                </c:pt>
                <c:pt idx="359">
                  <c:v>1</c:v>
                </c:pt>
                <c:pt idx="360">
                  <c:v>1</c:v>
                </c:pt>
                <c:pt idx="362">
                  <c:v>1</c:v>
                </c:pt>
                <c:pt idx="364">
                  <c:v>1</c:v>
                </c:pt>
                <c:pt idx="365">
                  <c:v>1</c:v>
                </c:pt>
                <c:pt idx="366">
                  <c:v>1</c:v>
                </c:pt>
                <c:pt idx="367">
                  <c:v>1</c:v>
                </c:pt>
                <c:pt idx="369">
                  <c:v>1</c:v>
                </c:pt>
                <c:pt idx="371">
                  <c:v>1</c:v>
                </c:pt>
                <c:pt idx="373">
                  <c:v>1</c:v>
                </c:pt>
                <c:pt idx="375">
                  <c:v>1</c:v>
                </c:pt>
                <c:pt idx="376">
                  <c:v>1</c:v>
                </c:pt>
                <c:pt idx="379">
                  <c:v>1</c:v>
                </c:pt>
                <c:pt idx="380">
                  <c:v>1</c:v>
                </c:pt>
                <c:pt idx="383">
                  <c:v>1</c:v>
                </c:pt>
                <c:pt idx="384">
                  <c:v>1</c:v>
                </c:pt>
                <c:pt idx="385">
                  <c:v>1</c:v>
                </c:pt>
                <c:pt idx="386">
                  <c:v>1</c:v>
                </c:pt>
                <c:pt idx="389">
                  <c:v>1</c:v>
                </c:pt>
                <c:pt idx="390">
                  <c:v>1</c:v>
                </c:pt>
                <c:pt idx="392">
                  <c:v>1</c:v>
                </c:pt>
                <c:pt idx="395">
                  <c:v>1</c:v>
                </c:pt>
                <c:pt idx="396">
                  <c:v>1</c:v>
                </c:pt>
                <c:pt idx="397">
                  <c:v>1</c:v>
                </c:pt>
                <c:pt idx="398">
                  <c:v>1</c:v>
                </c:pt>
                <c:pt idx="399">
                  <c:v>1</c:v>
                </c:pt>
                <c:pt idx="404">
                  <c:v>1</c:v>
                </c:pt>
                <c:pt idx="405">
                  <c:v>1</c:v>
                </c:pt>
                <c:pt idx="406">
                  <c:v>1</c:v>
                </c:pt>
                <c:pt idx="407">
                  <c:v>1</c:v>
                </c:pt>
                <c:pt idx="410">
                  <c:v>1</c:v>
                </c:pt>
                <c:pt idx="411">
                  <c:v>3</c:v>
                </c:pt>
                <c:pt idx="414">
                  <c:v>1</c:v>
                </c:pt>
                <c:pt idx="415">
                  <c:v>1</c:v>
                </c:pt>
                <c:pt idx="418">
                  <c:v>1</c:v>
                </c:pt>
                <c:pt idx="419">
                  <c:v>1</c:v>
                </c:pt>
                <c:pt idx="422">
                  <c:v>1</c:v>
                </c:pt>
                <c:pt idx="423">
                  <c:v>1</c:v>
                </c:pt>
                <c:pt idx="424">
                  <c:v>1</c:v>
                </c:pt>
                <c:pt idx="428">
                  <c:v>1</c:v>
                </c:pt>
                <c:pt idx="429">
                  <c:v>1</c:v>
                </c:pt>
                <c:pt idx="431">
                  <c:v>1</c:v>
                </c:pt>
                <c:pt idx="432">
                  <c:v>1</c:v>
                </c:pt>
                <c:pt idx="434">
                  <c:v>1</c:v>
                </c:pt>
                <c:pt idx="435">
                  <c:v>1</c:v>
                </c:pt>
                <c:pt idx="436">
                  <c:v>1</c:v>
                </c:pt>
                <c:pt idx="437">
                  <c:v>1</c:v>
                </c:pt>
                <c:pt idx="438">
                  <c:v>1</c:v>
                </c:pt>
                <c:pt idx="439">
                  <c:v>1</c:v>
                </c:pt>
                <c:pt idx="440">
                  <c:v>1</c:v>
                </c:pt>
                <c:pt idx="442">
                  <c:v>1</c:v>
                </c:pt>
                <c:pt idx="444">
                  <c:v>1</c:v>
                </c:pt>
                <c:pt idx="445">
                  <c:v>1</c:v>
                </c:pt>
                <c:pt idx="449">
                  <c:v>1</c:v>
                </c:pt>
                <c:pt idx="450">
                  <c:v>1</c:v>
                </c:pt>
                <c:pt idx="451">
                  <c:v>1</c:v>
                </c:pt>
                <c:pt idx="452">
                  <c:v>1</c:v>
                </c:pt>
                <c:pt idx="453">
                  <c:v>1</c:v>
                </c:pt>
                <c:pt idx="455">
                  <c:v>1</c:v>
                </c:pt>
                <c:pt idx="458">
                  <c:v>1</c:v>
                </c:pt>
                <c:pt idx="459">
                  <c:v>1</c:v>
                </c:pt>
                <c:pt idx="461">
                  <c:v>1</c:v>
                </c:pt>
                <c:pt idx="462">
                  <c:v>1</c:v>
                </c:pt>
                <c:pt idx="467">
                  <c:v>1</c:v>
                </c:pt>
                <c:pt idx="468">
                  <c:v>36</c:v>
                </c:pt>
                <c:pt idx="469">
                  <c:v>1</c:v>
                </c:pt>
                <c:pt idx="470">
                  <c:v>1</c:v>
                </c:pt>
                <c:pt idx="471">
                  <c:v>1</c:v>
                </c:pt>
                <c:pt idx="472">
                  <c:v>1</c:v>
                </c:pt>
                <c:pt idx="474">
                  <c:v>1</c:v>
                </c:pt>
                <c:pt idx="478">
                  <c:v>1</c:v>
                </c:pt>
                <c:pt idx="479">
                  <c:v>1</c:v>
                </c:pt>
                <c:pt idx="480">
                  <c:v>1</c:v>
                </c:pt>
                <c:pt idx="484">
                  <c:v>1</c:v>
                </c:pt>
                <c:pt idx="485">
                  <c:v>1</c:v>
                </c:pt>
                <c:pt idx="486">
                  <c:v>1</c:v>
                </c:pt>
                <c:pt idx="487">
                  <c:v>1</c:v>
                </c:pt>
                <c:pt idx="490">
                  <c:v>1</c:v>
                </c:pt>
                <c:pt idx="491">
                  <c:v>1</c:v>
                </c:pt>
                <c:pt idx="493">
                  <c:v>1</c:v>
                </c:pt>
                <c:pt idx="494">
                  <c:v>1</c:v>
                </c:pt>
                <c:pt idx="498">
                  <c:v>1</c:v>
                </c:pt>
                <c:pt idx="500">
                  <c:v>1</c:v>
                </c:pt>
                <c:pt idx="501">
                  <c:v>1</c:v>
                </c:pt>
                <c:pt idx="502">
                  <c:v>1</c:v>
                </c:pt>
                <c:pt idx="504">
                  <c:v>1</c:v>
                </c:pt>
                <c:pt idx="505">
                  <c:v>1</c:v>
                </c:pt>
                <c:pt idx="508">
                  <c:v>1</c:v>
                </c:pt>
                <c:pt idx="510">
                  <c:v>1</c:v>
                </c:pt>
                <c:pt idx="511">
                  <c:v>1</c:v>
                </c:pt>
                <c:pt idx="512">
                  <c:v>-1</c:v>
                </c:pt>
                <c:pt idx="514">
                  <c:v>1</c:v>
                </c:pt>
                <c:pt idx="519">
                  <c:v>1</c:v>
                </c:pt>
                <c:pt idx="520">
                  <c:v>1</c:v>
                </c:pt>
                <c:pt idx="521">
                  <c:v>1</c:v>
                </c:pt>
                <c:pt idx="522">
                  <c:v>1</c:v>
                </c:pt>
                <c:pt idx="524">
                  <c:v>1</c:v>
                </c:pt>
                <c:pt idx="528">
                  <c:v>1</c:v>
                </c:pt>
                <c:pt idx="530">
                  <c:v>1</c:v>
                </c:pt>
                <c:pt idx="535">
                  <c:v>1</c:v>
                </c:pt>
                <c:pt idx="536">
                  <c:v>1</c:v>
                </c:pt>
                <c:pt idx="537">
                  <c:v>1</c:v>
                </c:pt>
                <c:pt idx="539">
                  <c:v>1</c:v>
                </c:pt>
                <c:pt idx="540">
                  <c:v>1</c:v>
                </c:pt>
                <c:pt idx="541">
                  <c:v>1</c:v>
                </c:pt>
                <c:pt idx="542">
                  <c:v>1</c:v>
                </c:pt>
                <c:pt idx="544">
                  <c:v>30</c:v>
                </c:pt>
                <c:pt idx="545">
                  <c:v>1</c:v>
                </c:pt>
                <c:pt idx="546">
                  <c:v>1</c:v>
                </c:pt>
                <c:pt idx="548">
                  <c:v>1</c:v>
                </c:pt>
                <c:pt idx="550">
                  <c:v>1</c:v>
                </c:pt>
                <c:pt idx="555">
                  <c:v>1</c:v>
                </c:pt>
                <c:pt idx="557">
                  <c:v>1</c:v>
                </c:pt>
                <c:pt idx="560">
                  <c:v>1</c:v>
                </c:pt>
                <c:pt idx="561">
                  <c:v>1</c:v>
                </c:pt>
                <c:pt idx="563">
                  <c:v>1</c:v>
                </c:pt>
                <c:pt idx="565">
                  <c:v>1</c:v>
                </c:pt>
                <c:pt idx="566">
                  <c:v>1</c:v>
                </c:pt>
                <c:pt idx="567">
                  <c:v>1</c:v>
                </c:pt>
                <c:pt idx="568">
                  <c:v>1</c:v>
                </c:pt>
                <c:pt idx="569">
                  <c:v>1</c:v>
                </c:pt>
                <c:pt idx="572">
                  <c:v>1</c:v>
                </c:pt>
                <c:pt idx="574">
                  <c:v>1</c:v>
                </c:pt>
                <c:pt idx="575">
                  <c:v>1</c:v>
                </c:pt>
                <c:pt idx="577">
                  <c:v>1</c:v>
                </c:pt>
                <c:pt idx="578">
                  <c:v>1</c:v>
                </c:pt>
                <c:pt idx="579">
                  <c:v>1</c:v>
                </c:pt>
                <c:pt idx="581">
                  <c:v>1</c:v>
                </c:pt>
                <c:pt idx="583">
                  <c:v>1</c:v>
                </c:pt>
                <c:pt idx="585">
                  <c:v>1</c:v>
                </c:pt>
                <c:pt idx="586">
                  <c:v>1</c:v>
                </c:pt>
                <c:pt idx="590">
                  <c:v>1</c:v>
                </c:pt>
                <c:pt idx="591">
                  <c:v>1</c:v>
                </c:pt>
                <c:pt idx="595">
                  <c:v>1</c:v>
                </c:pt>
                <c:pt idx="599">
                  <c:v>1</c:v>
                </c:pt>
                <c:pt idx="600">
                  <c:v>1</c:v>
                </c:pt>
                <c:pt idx="602">
                  <c:v>1</c:v>
                </c:pt>
                <c:pt idx="603">
                  <c:v>1</c:v>
                </c:pt>
                <c:pt idx="604">
                  <c:v>1</c:v>
                </c:pt>
                <c:pt idx="607">
                  <c:v>1</c:v>
                </c:pt>
                <c:pt idx="610">
                  <c:v>1</c:v>
                </c:pt>
                <c:pt idx="613">
                  <c:v>5</c:v>
                </c:pt>
                <c:pt idx="618">
                  <c:v>1</c:v>
                </c:pt>
                <c:pt idx="621">
                  <c:v>1</c:v>
                </c:pt>
                <c:pt idx="622">
                  <c:v>1</c:v>
                </c:pt>
                <c:pt idx="623">
                  <c:v>1</c:v>
                </c:pt>
                <c:pt idx="624">
                  <c:v>1</c:v>
                </c:pt>
                <c:pt idx="625">
                  <c:v>1</c:v>
                </c:pt>
                <c:pt idx="626">
                  <c:v>1</c:v>
                </c:pt>
                <c:pt idx="627">
                  <c:v>1</c:v>
                </c:pt>
                <c:pt idx="629">
                  <c:v>1</c:v>
                </c:pt>
                <c:pt idx="630">
                  <c:v>1</c:v>
                </c:pt>
                <c:pt idx="631">
                  <c:v>1</c:v>
                </c:pt>
                <c:pt idx="632">
                  <c:v>1</c:v>
                </c:pt>
                <c:pt idx="635">
                  <c:v>1</c:v>
                </c:pt>
                <c:pt idx="637">
                  <c:v>1</c:v>
                </c:pt>
                <c:pt idx="638">
                  <c:v>1</c:v>
                </c:pt>
                <c:pt idx="639">
                  <c:v>1</c:v>
                </c:pt>
                <c:pt idx="640">
                  <c:v>1</c:v>
                </c:pt>
                <c:pt idx="641">
                  <c:v>1</c:v>
                </c:pt>
                <c:pt idx="643">
                  <c:v>1</c:v>
                </c:pt>
                <c:pt idx="644">
                  <c:v>1</c:v>
                </c:pt>
                <c:pt idx="645">
                  <c:v>1</c:v>
                </c:pt>
                <c:pt idx="646">
                  <c:v>1</c:v>
                </c:pt>
                <c:pt idx="647">
                  <c:v>1</c:v>
                </c:pt>
                <c:pt idx="650">
                  <c:v>1</c:v>
                </c:pt>
                <c:pt idx="651">
                  <c:v>1</c:v>
                </c:pt>
                <c:pt idx="652">
                  <c:v>1</c:v>
                </c:pt>
                <c:pt idx="653">
                  <c:v>1</c:v>
                </c:pt>
                <c:pt idx="654">
                  <c:v>1</c:v>
                </c:pt>
                <c:pt idx="656">
                  <c:v>1</c:v>
                </c:pt>
                <c:pt idx="657">
                  <c:v>1</c:v>
                </c:pt>
                <c:pt idx="661">
                  <c:v>1</c:v>
                </c:pt>
                <c:pt idx="662">
                  <c:v>1</c:v>
                </c:pt>
                <c:pt idx="667">
                  <c:v>1</c:v>
                </c:pt>
                <c:pt idx="668">
                  <c:v>1</c:v>
                </c:pt>
                <c:pt idx="669">
                  <c:v>1</c:v>
                </c:pt>
                <c:pt idx="670">
                  <c:v>1</c:v>
                </c:pt>
                <c:pt idx="671">
                  <c:v>1</c:v>
                </c:pt>
                <c:pt idx="672">
                  <c:v>1</c:v>
                </c:pt>
                <c:pt idx="673">
                  <c:v>1</c:v>
                </c:pt>
                <c:pt idx="674">
                  <c:v>1</c:v>
                </c:pt>
                <c:pt idx="675">
                  <c:v>1</c:v>
                </c:pt>
                <c:pt idx="676">
                  <c:v>1</c:v>
                </c:pt>
                <c:pt idx="677">
                  <c:v>1</c:v>
                </c:pt>
                <c:pt idx="678">
                  <c:v>1</c:v>
                </c:pt>
                <c:pt idx="680">
                  <c:v>1</c:v>
                </c:pt>
                <c:pt idx="681">
                  <c:v>2</c:v>
                </c:pt>
                <c:pt idx="683">
                  <c:v>1</c:v>
                </c:pt>
                <c:pt idx="685">
                  <c:v>1</c:v>
                </c:pt>
                <c:pt idx="686">
                  <c:v>1</c:v>
                </c:pt>
                <c:pt idx="687">
                  <c:v>1</c:v>
                </c:pt>
                <c:pt idx="688">
                  <c:v>2</c:v>
                </c:pt>
                <c:pt idx="692">
                  <c:v>1</c:v>
                </c:pt>
                <c:pt idx="693">
                  <c:v>1</c:v>
                </c:pt>
                <c:pt idx="701">
                  <c:v>1</c:v>
                </c:pt>
                <c:pt idx="702">
                  <c:v>1</c:v>
                </c:pt>
                <c:pt idx="703">
                  <c:v>1</c:v>
                </c:pt>
                <c:pt idx="705">
                  <c:v>1</c:v>
                </c:pt>
                <c:pt idx="706">
                  <c:v>1</c:v>
                </c:pt>
                <c:pt idx="707">
                  <c:v>1</c:v>
                </c:pt>
                <c:pt idx="710">
                  <c:v>1</c:v>
                </c:pt>
                <c:pt idx="711">
                  <c:v>1</c:v>
                </c:pt>
                <c:pt idx="712">
                  <c:v>4</c:v>
                </c:pt>
                <c:pt idx="714">
                  <c:v>1</c:v>
                </c:pt>
                <c:pt idx="716">
                  <c:v>1</c:v>
                </c:pt>
                <c:pt idx="720">
                  <c:v>1</c:v>
                </c:pt>
                <c:pt idx="721">
                  <c:v>1</c:v>
                </c:pt>
                <c:pt idx="725">
                  <c:v>1</c:v>
                </c:pt>
                <c:pt idx="726">
                  <c:v>1</c:v>
                </c:pt>
                <c:pt idx="728">
                  <c:v>1</c:v>
                </c:pt>
                <c:pt idx="729">
                  <c:v>1</c:v>
                </c:pt>
                <c:pt idx="732">
                  <c:v>1</c:v>
                </c:pt>
                <c:pt idx="734">
                  <c:v>1</c:v>
                </c:pt>
                <c:pt idx="735">
                  <c:v>1</c:v>
                </c:pt>
                <c:pt idx="737">
                  <c:v>1</c:v>
                </c:pt>
                <c:pt idx="738">
                  <c:v>1</c:v>
                </c:pt>
                <c:pt idx="739">
                  <c:v>1</c:v>
                </c:pt>
                <c:pt idx="741">
                  <c:v>1</c:v>
                </c:pt>
                <c:pt idx="742">
                  <c:v>1</c:v>
                </c:pt>
                <c:pt idx="743">
                  <c:v>1</c:v>
                </c:pt>
                <c:pt idx="744">
                  <c:v>1</c:v>
                </c:pt>
                <c:pt idx="746">
                  <c:v>1</c:v>
                </c:pt>
                <c:pt idx="747">
                  <c:v>1</c:v>
                </c:pt>
                <c:pt idx="748">
                  <c:v>1</c:v>
                </c:pt>
                <c:pt idx="749">
                  <c:v>1</c:v>
                </c:pt>
                <c:pt idx="751">
                  <c:v>1</c:v>
                </c:pt>
                <c:pt idx="753">
                  <c:v>1</c:v>
                </c:pt>
                <c:pt idx="754">
                  <c:v>1</c:v>
                </c:pt>
                <c:pt idx="758">
                  <c:v>1</c:v>
                </c:pt>
                <c:pt idx="759">
                  <c:v>1</c:v>
                </c:pt>
                <c:pt idx="762">
                  <c:v>1</c:v>
                </c:pt>
                <c:pt idx="767">
                  <c:v>1</c:v>
                </c:pt>
                <c:pt idx="769">
                  <c:v>1</c:v>
                </c:pt>
                <c:pt idx="770">
                  <c:v>4</c:v>
                </c:pt>
                <c:pt idx="772">
                  <c:v>1</c:v>
                </c:pt>
                <c:pt idx="774">
                  <c:v>1</c:v>
                </c:pt>
                <c:pt idx="775">
                  <c:v>1</c:v>
                </c:pt>
                <c:pt idx="776">
                  <c:v>2</c:v>
                </c:pt>
                <c:pt idx="777">
                  <c:v>1</c:v>
                </c:pt>
                <c:pt idx="778">
                  <c:v>1</c:v>
                </c:pt>
                <c:pt idx="779">
                  <c:v>1</c:v>
                </c:pt>
                <c:pt idx="781">
                  <c:v>1</c:v>
                </c:pt>
                <c:pt idx="782">
                  <c:v>1</c:v>
                </c:pt>
                <c:pt idx="784">
                  <c:v>1</c:v>
                </c:pt>
                <c:pt idx="785">
                  <c:v>1</c:v>
                </c:pt>
                <c:pt idx="786">
                  <c:v>1</c:v>
                </c:pt>
                <c:pt idx="787">
                  <c:v>1</c:v>
                </c:pt>
                <c:pt idx="788">
                  <c:v>1</c:v>
                </c:pt>
                <c:pt idx="790">
                  <c:v>1</c:v>
                </c:pt>
                <c:pt idx="794">
                  <c:v>1</c:v>
                </c:pt>
                <c:pt idx="795">
                  <c:v>1</c:v>
                </c:pt>
                <c:pt idx="796">
                  <c:v>26</c:v>
                </c:pt>
                <c:pt idx="797">
                  <c:v>1</c:v>
                </c:pt>
                <c:pt idx="798">
                  <c:v>1</c:v>
                </c:pt>
                <c:pt idx="800">
                  <c:v>1</c:v>
                </c:pt>
                <c:pt idx="804">
                  <c:v>3</c:v>
                </c:pt>
                <c:pt idx="805">
                  <c:v>1</c:v>
                </c:pt>
                <c:pt idx="806">
                  <c:v>1</c:v>
                </c:pt>
                <c:pt idx="807">
                  <c:v>1</c:v>
                </c:pt>
                <c:pt idx="808">
                  <c:v>1</c:v>
                </c:pt>
                <c:pt idx="809">
                  <c:v>1</c:v>
                </c:pt>
                <c:pt idx="811">
                  <c:v>1</c:v>
                </c:pt>
                <c:pt idx="812">
                  <c:v>1</c:v>
                </c:pt>
                <c:pt idx="818">
                  <c:v>1</c:v>
                </c:pt>
                <c:pt idx="819">
                  <c:v>1</c:v>
                </c:pt>
                <c:pt idx="821">
                  <c:v>1</c:v>
                </c:pt>
                <c:pt idx="823">
                  <c:v>1</c:v>
                </c:pt>
                <c:pt idx="824">
                  <c:v>1</c:v>
                </c:pt>
                <c:pt idx="826">
                  <c:v>1</c:v>
                </c:pt>
                <c:pt idx="829">
                  <c:v>1</c:v>
                </c:pt>
                <c:pt idx="830">
                  <c:v>1</c:v>
                </c:pt>
                <c:pt idx="832">
                  <c:v>1</c:v>
                </c:pt>
                <c:pt idx="834">
                  <c:v>1</c:v>
                </c:pt>
                <c:pt idx="835">
                  <c:v>1</c:v>
                </c:pt>
                <c:pt idx="836">
                  <c:v>46</c:v>
                </c:pt>
                <c:pt idx="837">
                  <c:v>1</c:v>
                </c:pt>
                <c:pt idx="838">
                  <c:v>1</c:v>
                </c:pt>
                <c:pt idx="839">
                  <c:v>1</c:v>
                </c:pt>
                <c:pt idx="840">
                  <c:v>1</c:v>
                </c:pt>
                <c:pt idx="841">
                  <c:v>2</c:v>
                </c:pt>
                <c:pt idx="845">
                  <c:v>1</c:v>
                </c:pt>
                <c:pt idx="846">
                  <c:v>1</c:v>
                </c:pt>
                <c:pt idx="847">
                  <c:v>1</c:v>
                </c:pt>
                <c:pt idx="849">
                  <c:v>1</c:v>
                </c:pt>
                <c:pt idx="850">
                  <c:v>1</c:v>
                </c:pt>
                <c:pt idx="851">
                  <c:v>1</c:v>
                </c:pt>
                <c:pt idx="852">
                  <c:v>3</c:v>
                </c:pt>
                <c:pt idx="853">
                  <c:v>21</c:v>
                </c:pt>
                <c:pt idx="857">
                  <c:v>1</c:v>
                </c:pt>
                <c:pt idx="858">
                  <c:v>1</c:v>
                </c:pt>
                <c:pt idx="859">
                  <c:v>1</c:v>
                </c:pt>
                <c:pt idx="860">
                  <c:v>1</c:v>
                </c:pt>
                <c:pt idx="861">
                  <c:v>1</c:v>
                </c:pt>
                <c:pt idx="862">
                  <c:v>1</c:v>
                </c:pt>
                <c:pt idx="863">
                  <c:v>1</c:v>
                </c:pt>
                <c:pt idx="864">
                  <c:v>1</c:v>
                </c:pt>
                <c:pt idx="865">
                  <c:v>1</c:v>
                </c:pt>
                <c:pt idx="868">
                  <c:v>1</c:v>
                </c:pt>
                <c:pt idx="869">
                  <c:v>1</c:v>
                </c:pt>
                <c:pt idx="872">
                  <c:v>1</c:v>
                </c:pt>
                <c:pt idx="873">
                  <c:v>1</c:v>
                </c:pt>
                <c:pt idx="875">
                  <c:v>1</c:v>
                </c:pt>
                <c:pt idx="877">
                  <c:v>1</c:v>
                </c:pt>
                <c:pt idx="878">
                  <c:v>2</c:v>
                </c:pt>
                <c:pt idx="879">
                  <c:v>2</c:v>
                </c:pt>
                <c:pt idx="882">
                  <c:v>1</c:v>
                </c:pt>
                <c:pt idx="886">
                  <c:v>1</c:v>
                </c:pt>
                <c:pt idx="887">
                  <c:v>1</c:v>
                </c:pt>
                <c:pt idx="888">
                  <c:v>1</c:v>
                </c:pt>
                <c:pt idx="894">
                  <c:v>1</c:v>
                </c:pt>
                <c:pt idx="895">
                  <c:v>1</c:v>
                </c:pt>
                <c:pt idx="896">
                  <c:v>1</c:v>
                </c:pt>
                <c:pt idx="898">
                  <c:v>1</c:v>
                </c:pt>
                <c:pt idx="899">
                  <c:v>1</c:v>
                </c:pt>
                <c:pt idx="900">
                  <c:v>1</c:v>
                </c:pt>
                <c:pt idx="904">
                  <c:v>6</c:v>
                </c:pt>
                <c:pt idx="905">
                  <c:v>1</c:v>
                </c:pt>
                <c:pt idx="906">
                  <c:v>9</c:v>
                </c:pt>
                <c:pt idx="907">
                  <c:v>1</c:v>
                </c:pt>
                <c:pt idx="909">
                  <c:v>8</c:v>
                </c:pt>
                <c:pt idx="910">
                  <c:v>1</c:v>
                </c:pt>
                <c:pt idx="911">
                  <c:v>1</c:v>
                </c:pt>
                <c:pt idx="915">
                  <c:v>1</c:v>
                </c:pt>
                <c:pt idx="917">
                  <c:v>1</c:v>
                </c:pt>
                <c:pt idx="920">
                  <c:v>1</c:v>
                </c:pt>
                <c:pt idx="921">
                  <c:v>1</c:v>
                </c:pt>
                <c:pt idx="922">
                  <c:v>1</c:v>
                </c:pt>
                <c:pt idx="923">
                  <c:v>1</c:v>
                </c:pt>
                <c:pt idx="924">
                  <c:v>1</c:v>
                </c:pt>
                <c:pt idx="925">
                  <c:v>1</c:v>
                </c:pt>
                <c:pt idx="927">
                  <c:v>1</c:v>
                </c:pt>
                <c:pt idx="928">
                  <c:v>1</c:v>
                </c:pt>
                <c:pt idx="929">
                  <c:v>1</c:v>
                </c:pt>
                <c:pt idx="931">
                  <c:v>1</c:v>
                </c:pt>
                <c:pt idx="932">
                  <c:v>1</c:v>
                </c:pt>
                <c:pt idx="934">
                  <c:v>1</c:v>
                </c:pt>
                <c:pt idx="937">
                  <c:v>1</c:v>
                </c:pt>
                <c:pt idx="940">
                  <c:v>1</c:v>
                </c:pt>
                <c:pt idx="941">
                  <c:v>1</c:v>
                </c:pt>
                <c:pt idx="942">
                  <c:v>1</c:v>
                </c:pt>
                <c:pt idx="944">
                  <c:v>1</c:v>
                </c:pt>
                <c:pt idx="945">
                  <c:v>1</c:v>
                </c:pt>
                <c:pt idx="946">
                  <c:v>1</c:v>
                </c:pt>
                <c:pt idx="947">
                  <c:v>1</c:v>
                </c:pt>
                <c:pt idx="948">
                  <c:v>1</c:v>
                </c:pt>
                <c:pt idx="950">
                  <c:v>1</c:v>
                </c:pt>
                <c:pt idx="953">
                  <c:v>1</c:v>
                </c:pt>
                <c:pt idx="955">
                  <c:v>1</c:v>
                </c:pt>
                <c:pt idx="956">
                  <c:v>1</c:v>
                </c:pt>
                <c:pt idx="957">
                  <c:v>1</c:v>
                </c:pt>
                <c:pt idx="959">
                  <c:v>1</c:v>
                </c:pt>
                <c:pt idx="960">
                  <c:v>1</c:v>
                </c:pt>
                <c:pt idx="961">
                  <c:v>1</c:v>
                </c:pt>
                <c:pt idx="962">
                  <c:v>1</c:v>
                </c:pt>
                <c:pt idx="963">
                  <c:v>1</c:v>
                </c:pt>
                <c:pt idx="964">
                  <c:v>4</c:v>
                </c:pt>
                <c:pt idx="965">
                  <c:v>1</c:v>
                </c:pt>
                <c:pt idx="968">
                  <c:v>1</c:v>
                </c:pt>
                <c:pt idx="970">
                  <c:v>1</c:v>
                </c:pt>
                <c:pt idx="973">
                  <c:v>1</c:v>
                </c:pt>
                <c:pt idx="974">
                  <c:v>1</c:v>
                </c:pt>
                <c:pt idx="975">
                  <c:v>1</c:v>
                </c:pt>
                <c:pt idx="976">
                  <c:v>1</c:v>
                </c:pt>
                <c:pt idx="977">
                  <c:v>1</c:v>
                </c:pt>
                <c:pt idx="979">
                  <c:v>1</c:v>
                </c:pt>
                <c:pt idx="986">
                  <c:v>1</c:v>
                </c:pt>
                <c:pt idx="989">
                  <c:v>1</c:v>
                </c:pt>
                <c:pt idx="990">
                  <c:v>1</c:v>
                </c:pt>
                <c:pt idx="991">
                  <c:v>1</c:v>
                </c:pt>
                <c:pt idx="992">
                  <c:v>1</c:v>
                </c:pt>
                <c:pt idx="993">
                  <c:v>1</c:v>
                </c:pt>
                <c:pt idx="994">
                  <c:v>1</c:v>
                </c:pt>
                <c:pt idx="995">
                  <c:v>1</c:v>
                </c:pt>
                <c:pt idx="1000">
                  <c:v>1</c:v>
                </c:pt>
                <c:pt idx="1001">
                  <c:v>1</c:v>
                </c:pt>
                <c:pt idx="1002">
                  <c:v>1</c:v>
                </c:pt>
                <c:pt idx="1004">
                  <c:v>1</c:v>
                </c:pt>
                <c:pt idx="1005">
                  <c:v>1</c:v>
                </c:pt>
                <c:pt idx="1007">
                  <c:v>1</c:v>
                </c:pt>
                <c:pt idx="1008">
                  <c:v>1</c:v>
                </c:pt>
                <c:pt idx="1009">
                  <c:v>1</c:v>
                </c:pt>
                <c:pt idx="1010">
                  <c:v>1</c:v>
                </c:pt>
                <c:pt idx="1011">
                  <c:v>1</c:v>
                </c:pt>
                <c:pt idx="1013">
                  <c:v>1</c:v>
                </c:pt>
                <c:pt idx="1014">
                  <c:v>1</c:v>
                </c:pt>
                <c:pt idx="1015">
                  <c:v>1</c:v>
                </c:pt>
                <c:pt idx="1017">
                  <c:v>1</c:v>
                </c:pt>
                <c:pt idx="1018">
                  <c:v>1</c:v>
                </c:pt>
                <c:pt idx="1022">
                  <c:v>1</c:v>
                </c:pt>
                <c:pt idx="1024">
                  <c:v>1</c:v>
                </c:pt>
                <c:pt idx="1025">
                  <c:v>1</c:v>
                </c:pt>
                <c:pt idx="1026">
                  <c:v>1</c:v>
                </c:pt>
                <c:pt idx="1028">
                  <c:v>1</c:v>
                </c:pt>
                <c:pt idx="1029">
                  <c:v>2</c:v>
                </c:pt>
                <c:pt idx="1030">
                  <c:v>1</c:v>
                </c:pt>
                <c:pt idx="1031">
                  <c:v>2</c:v>
                </c:pt>
                <c:pt idx="1032">
                  <c:v>1</c:v>
                </c:pt>
                <c:pt idx="1033">
                  <c:v>1</c:v>
                </c:pt>
                <c:pt idx="1034">
                  <c:v>1</c:v>
                </c:pt>
                <c:pt idx="1036">
                  <c:v>1</c:v>
                </c:pt>
                <c:pt idx="1038">
                  <c:v>1</c:v>
                </c:pt>
                <c:pt idx="1040">
                  <c:v>1</c:v>
                </c:pt>
                <c:pt idx="1042">
                  <c:v>1</c:v>
                </c:pt>
                <c:pt idx="1043">
                  <c:v>1</c:v>
                </c:pt>
                <c:pt idx="1045">
                  <c:v>1</c:v>
                </c:pt>
                <c:pt idx="1046">
                  <c:v>1</c:v>
                </c:pt>
                <c:pt idx="1047">
                  <c:v>1</c:v>
                </c:pt>
                <c:pt idx="1049">
                  <c:v>1</c:v>
                </c:pt>
                <c:pt idx="1050">
                  <c:v>1</c:v>
                </c:pt>
                <c:pt idx="1053">
                  <c:v>1</c:v>
                </c:pt>
                <c:pt idx="1054">
                  <c:v>1</c:v>
                </c:pt>
                <c:pt idx="1055">
                  <c:v>1</c:v>
                </c:pt>
                <c:pt idx="1058">
                  <c:v>1</c:v>
                </c:pt>
                <c:pt idx="1060">
                  <c:v>1</c:v>
                </c:pt>
                <c:pt idx="1061">
                  <c:v>1</c:v>
                </c:pt>
                <c:pt idx="1065">
                  <c:v>1</c:v>
                </c:pt>
                <c:pt idx="1066">
                  <c:v>1</c:v>
                </c:pt>
                <c:pt idx="1067">
                  <c:v>1</c:v>
                </c:pt>
                <c:pt idx="1068">
                  <c:v>1</c:v>
                </c:pt>
                <c:pt idx="1070">
                  <c:v>1</c:v>
                </c:pt>
                <c:pt idx="1071">
                  <c:v>1</c:v>
                </c:pt>
                <c:pt idx="1072">
                  <c:v>1</c:v>
                </c:pt>
                <c:pt idx="1074">
                  <c:v>1</c:v>
                </c:pt>
                <c:pt idx="1075">
                  <c:v>2</c:v>
                </c:pt>
                <c:pt idx="1076">
                  <c:v>1</c:v>
                </c:pt>
                <c:pt idx="1078">
                  <c:v>4</c:v>
                </c:pt>
                <c:pt idx="1080">
                  <c:v>1</c:v>
                </c:pt>
                <c:pt idx="1081">
                  <c:v>1</c:v>
                </c:pt>
                <c:pt idx="1084">
                  <c:v>1</c:v>
                </c:pt>
                <c:pt idx="1089">
                  <c:v>1</c:v>
                </c:pt>
                <c:pt idx="1090">
                  <c:v>1</c:v>
                </c:pt>
                <c:pt idx="1091">
                  <c:v>1</c:v>
                </c:pt>
                <c:pt idx="1092">
                  <c:v>1</c:v>
                </c:pt>
                <c:pt idx="1093">
                  <c:v>1</c:v>
                </c:pt>
                <c:pt idx="1094">
                  <c:v>1</c:v>
                </c:pt>
                <c:pt idx="1095">
                  <c:v>1</c:v>
                </c:pt>
                <c:pt idx="1098">
                  <c:v>1</c:v>
                </c:pt>
                <c:pt idx="1099">
                  <c:v>1</c:v>
                </c:pt>
                <c:pt idx="1100">
                  <c:v>1</c:v>
                </c:pt>
                <c:pt idx="1101">
                  <c:v>1</c:v>
                </c:pt>
                <c:pt idx="1102">
                  <c:v>1</c:v>
                </c:pt>
                <c:pt idx="1103">
                  <c:v>1</c:v>
                </c:pt>
                <c:pt idx="1106">
                  <c:v>1</c:v>
                </c:pt>
                <c:pt idx="1108">
                  <c:v>1</c:v>
                </c:pt>
                <c:pt idx="1109">
                  <c:v>1</c:v>
                </c:pt>
                <c:pt idx="1110">
                  <c:v>1</c:v>
                </c:pt>
                <c:pt idx="1111">
                  <c:v>1</c:v>
                </c:pt>
                <c:pt idx="1113">
                  <c:v>1</c:v>
                </c:pt>
                <c:pt idx="1116">
                  <c:v>1</c:v>
                </c:pt>
                <c:pt idx="1117">
                  <c:v>1</c:v>
                </c:pt>
                <c:pt idx="1118">
                  <c:v>1</c:v>
                </c:pt>
                <c:pt idx="1120">
                  <c:v>1</c:v>
                </c:pt>
                <c:pt idx="1121">
                  <c:v>1</c:v>
                </c:pt>
                <c:pt idx="1123">
                  <c:v>1</c:v>
                </c:pt>
                <c:pt idx="1124">
                  <c:v>1</c:v>
                </c:pt>
                <c:pt idx="1127">
                  <c:v>1</c:v>
                </c:pt>
                <c:pt idx="1128">
                  <c:v>3</c:v>
                </c:pt>
                <c:pt idx="1130">
                  <c:v>1</c:v>
                </c:pt>
                <c:pt idx="1132">
                  <c:v>1</c:v>
                </c:pt>
                <c:pt idx="1133">
                  <c:v>1</c:v>
                </c:pt>
                <c:pt idx="1134">
                  <c:v>1</c:v>
                </c:pt>
                <c:pt idx="1136">
                  <c:v>1</c:v>
                </c:pt>
                <c:pt idx="1140">
                  <c:v>1</c:v>
                </c:pt>
                <c:pt idx="1141">
                  <c:v>1</c:v>
                </c:pt>
                <c:pt idx="1142">
                  <c:v>1</c:v>
                </c:pt>
                <c:pt idx="1143">
                  <c:v>7</c:v>
                </c:pt>
                <c:pt idx="1144">
                  <c:v>1</c:v>
                </c:pt>
                <c:pt idx="1145">
                  <c:v>1</c:v>
                </c:pt>
                <c:pt idx="1147">
                  <c:v>1</c:v>
                </c:pt>
                <c:pt idx="1150">
                  <c:v>1</c:v>
                </c:pt>
                <c:pt idx="1151">
                  <c:v>1</c:v>
                </c:pt>
                <c:pt idx="1154">
                  <c:v>1</c:v>
                </c:pt>
                <c:pt idx="1155">
                  <c:v>1</c:v>
                </c:pt>
                <c:pt idx="1156">
                  <c:v>1</c:v>
                </c:pt>
                <c:pt idx="1160">
                  <c:v>1</c:v>
                </c:pt>
                <c:pt idx="1162">
                  <c:v>1</c:v>
                </c:pt>
                <c:pt idx="1163">
                  <c:v>1</c:v>
                </c:pt>
                <c:pt idx="1164">
                  <c:v>1</c:v>
                </c:pt>
                <c:pt idx="1165">
                  <c:v>1</c:v>
                </c:pt>
                <c:pt idx="1167">
                  <c:v>1</c:v>
                </c:pt>
                <c:pt idx="1169">
                  <c:v>10</c:v>
                </c:pt>
                <c:pt idx="1170">
                  <c:v>1</c:v>
                </c:pt>
                <c:pt idx="1173">
                  <c:v>1</c:v>
                </c:pt>
                <c:pt idx="1174">
                  <c:v>1</c:v>
                </c:pt>
                <c:pt idx="1175">
                  <c:v>1</c:v>
                </c:pt>
                <c:pt idx="1176">
                  <c:v>1</c:v>
                </c:pt>
                <c:pt idx="1177">
                  <c:v>1</c:v>
                </c:pt>
                <c:pt idx="1178">
                  <c:v>1</c:v>
                </c:pt>
                <c:pt idx="1181">
                  <c:v>1</c:v>
                </c:pt>
                <c:pt idx="1182">
                  <c:v>1</c:v>
                </c:pt>
                <c:pt idx="1184">
                  <c:v>1</c:v>
                </c:pt>
                <c:pt idx="1188">
                  <c:v>1</c:v>
                </c:pt>
                <c:pt idx="1190">
                  <c:v>1</c:v>
                </c:pt>
                <c:pt idx="1194">
                  <c:v>1</c:v>
                </c:pt>
                <c:pt idx="1196">
                  <c:v>1</c:v>
                </c:pt>
                <c:pt idx="1197">
                  <c:v>1</c:v>
                </c:pt>
                <c:pt idx="1198">
                  <c:v>8</c:v>
                </c:pt>
                <c:pt idx="1199">
                  <c:v>1</c:v>
                </c:pt>
                <c:pt idx="1200">
                  <c:v>1</c:v>
                </c:pt>
                <c:pt idx="1205">
                  <c:v>1</c:v>
                </c:pt>
                <c:pt idx="1206">
                  <c:v>1</c:v>
                </c:pt>
                <c:pt idx="1207">
                  <c:v>1</c:v>
                </c:pt>
                <c:pt idx="1209">
                  <c:v>1</c:v>
                </c:pt>
                <c:pt idx="1210">
                  <c:v>1</c:v>
                </c:pt>
                <c:pt idx="1211">
                  <c:v>1</c:v>
                </c:pt>
                <c:pt idx="1212">
                  <c:v>1</c:v>
                </c:pt>
                <c:pt idx="1213">
                  <c:v>1</c:v>
                </c:pt>
                <c:pt idx="1214">
                  <c:v>1</c:v>
                </c:pt>
                <c:pt idx="1215">
                  <c:v>1</c:v>
                </c:pt>
                <c:pt idx="1217">
                  <c:v>1</c:v>
                </c:pt>
                <c:pt idx="1218">
                  <c:v>5</c:v>
                </c:pt>
                <c:pt idx="1219">
                  <c:v>1</c:v>
                </c:pt>
                <c:pt idx="1220">
                  <c:v>1</c:v>
                </c:pt>
                <c:pt idx="1222">
                  <c:v>1</c:v>
                </c:pt>
                <c:pt idx="1223">
                  <c:v>1</c:v>
                </c:pt>
                <c:pt idx="1224">
                  <c:v>1</c:v>
                </c:pt>
                <c:pt idx="1226">
                  <c:v>1</c:v>
                </c:pt>
                <c:pt idx="1227">
                  <c:v>2</c:v>
                </c:pt>
                <c:pt idx="1228">
                  <c:v>1</c:v>
                </c:pt>
                <c:pt idx="1229">
                  <c:v>1</c:v>
                </c:pt>
                <c:pt idx="1230">
                  <c:v>4</c:v>
                </c:pt>
                <c:pt idx="1231">
                  <c:v>1</c:v>
                </c:pt>
                <c:pt idx="1232">
                  <c:v>1</c:v>
                </c:pt>
                <c:pt idx="1233">
                  <c:v>1</c:v>
                </c:pt>
                <c:pt idx="1236">
                  <c:v>1</c:v>
                </c:pt>
                <c:pt idx="1237">
                  <c:v>1</c:v>
                </c:pt>
                <c:pt idx="1239">
                  <c:v>1</c:v>
                </c:pt>
                <c:pt idx="1244">
                  <c:v>1</c:v>
                </c:pt>
                <c:pt idx="1245">
                  <c:v>1</c:v>
                </c:pt>
                <c:pt idx="1246">
                  <c:v>1</c:v>
                </c:pt>
                <c:pt idx="1251">
                  <c:v>1</c:v>
                </c:pt>
                <c:pt idx="1253">
                  <c:v>1</c:v>
                </c:pt>
                <c:pt idx="1254">
                  <c:v>1</c:v>
                </c:pt>
                <c:pt idx="1256">
                  <c:v>1</c:v>
                </c:pt>
                <c:pt idx="1257">
                  <c:v>1</c:v>
                </c:pt>
                <c:pt idx="1259">
                  <c:v>1</c:v>
                </c:pt>
                <c:pt idx="1261">
                  <c:v>1</c:v>
                </c:pt>
                <c:pt idx="1264">
                  <c:v>1</c:v>
                </c:pt>
                <c:pt idx="1267">
                  <c:v>1</c:v>
                </c:pt>
                <c:pt idx="1268">
                  <c:v>1</c:v>
                </c:pt>
                <c:pt idx="1270">
                  <c:v>1</c:v>
                </c:pt>
                <c:pt idx="1272">
                  <c:v>1</c:v>
                </c:pt>
                <c:pt idx="1273">
                  <c:v>1</c:v>
                </c:pt>
                <c:pt idx="1274">
                  <c:v>1</c:v>
                </c:pt>
                <c:pt idx="1277">
                  <c:v>1</c:v>
                </c:pt>
                <c:pt idx="1278">
                  <c:v>1</c:v>
                </c:pt>
                <c:pt idx="1281">
                  <c:v>1</c:v>
                </c:pt>
                <c:pt idx="1283">
                  <c:v>1</c:v>
                </c:pt>
                <c:pt idx="1287">
                  <c:v>1</c:v>
                </c:pt>
                <c:pt idx="1290">
                  <c:v>1</c:v>
                </c:pt>
                <c:pt idx="1292">
                  <c:v>1</c:v>
                </c:pt>
                <c:pt idx="1293">
                  <c:v>1</c:v>
                </c:pt>
                <c:pt idx="1297">
                  <c:v>1</c:v>
                </c:pt>
                <c:pt idx="1298">
                  <c:v>1</c:v>
                </c:pt>
                <c:pt idx="1300">
                  <c:v>1</c:v>
                </c:pt>
                <c:pt idx="1302">
                  <c:v>1</c:v>
                </c:pt>
                <c:pt idx="1304">
                  <c:v>1</c:v>
                </c:pt>
                <c:pt idx="1306">
                  <c:v>1</c:v>
                </c:pt>
                <c:pt idx="1308">
                  <c:v>1</c:v>
                </c:pt>
                <c:pt idx="1311">
                  <c:v>26</c:v>
                </c:pt>
                <c:pt idx="1312">
                  <c:v>3</c:v>
                </c:pt>
                <c:pt idx="1313">
                  <c:v>1</c:v>
                </c:pt>
                <c:pt idx="1316">
                  <c:v>1</c:v>
                </c:pt>
                <c:pt idx="1317">
                  <c:v>1</c:v>
                </c:pt>
                <c:pt idx="1318">
                  <c:v>1</c:v>
                </c:pt>
                <c:pt idx="1319">
                  <c:v>1</c:v>
                </c:pt>
                <c:pt idx="1321">
                  <c:v>1</c:v>
                </c:pt>
                <c:pt idx="1322">
                  <c:v>1</c:v>
                </c:pt>
                <c:pt idx="1323">
                  <c:v>1</c:v>
                </c:pt>
                <c:pt idx="1326">
                  <c:v>1</c:v>
                </c:pt>
                <c:pt idx="1327">
                  <c:v>1</c:v>
                </c:pt>
                <c:pt idx="1329">
                  <c:v>1</c:v>
                </c:pt>
                <c:pt idx="1330">
                  <c:v>1</c:v>
                </c:pt>
                <c:pt idx="1331">
                  <c:v>1</c:v>
                </c:pt>
                <c:pt idx="1333">
                  <c:v>1</c:v>
                </c:pt>
                <c:pt idx="1334">
                  <c:v>3</c:v>
                </c:pt>
                <c:pt idx="1335">
                  <c:v>1</c:v>
                </c:pt>
                <c:pt idx="1338">
                  <c:v>1</c:v>
                </c:pt>
                <c:pt idx="1339">
                  <c:v>1</c:v>
                </c:pt>
                <c:pt idx="1340">
                  <c:v>1</c:v>
                </c:pt>
                <c:pt idx="1341">
                  <c:v>1</c:v>
                </c:pt>
                <c:pt idx="1342">
                  <c:v>1</c:v>
                </c:pt>
                <c:pt idx="1344">
                  <c:v>1</c:v>
                </c:pt>
                <c:pt idx="1346">
                  <c:v>1</c:v>
                </c:pt>
                <c:pt idx="1348">
                  <c:v>1</c:v>
                </c:pt>
                <c:pt idx="1349">
                  <c:v>1</c:v>
                </c:pt>
                <c:pt idx="1350">
                  <c:v>13</c:v>
                </c:pt>
                <c:pt idx="1352">
                  <c:v>1</c:v>
                </c:pt>
                <c:pt idx="1353">
                  <c:v>1</c:v>
                </c:pt>
                <c:pt idx="1355">
                  <c:v>1</c:v>
                </c:pt>
                <c:pt idx="1356">
                  <c:v>1</c:v>
                </c:pt>
                <c:pt idx="1359">
                  <c:v>1</c:v>
                </c:pt>
                <c:pt idx="1360">
                  <c:v>1</c:v>
                </c:pt>
                <c:pt idx="1362">
                  <c:v>1</c:v>
                </c:pt>
                <c:pt idx="1363">
                  <c:v>1</c:v>
                </c:pt>
                <c:pt idx="1364">
                  <c:v>1</c:v>
                </c:pt>
                <c:pt idx="1365">
                  <c:v>2</c:v>
                </c:pt>
                <c:pt idx="1367">
                  <c:v>1</c:v>
                </c:pt>
                <c:pt idx="1368">
                  <c:v>1</c:v>
                </c:pt>
                <c:pt idx="1370">
                  <c:v>1</c:v>
                </c:pt>
                <c:pt idx="1373">
                  <c:v>1</c:v>
                </c:pt>
                <c:pt idx="1375">
                  <c:v>1</c:v>
                </c:pt>
                <c:pt idx="1376">
                  <c:v>1</c:v>
                </c:pt>
                <c:pt idx="1377">
                  <c:v>1</c:v>
                </c:pt>
                <c:pt idx="1378">
                  <c:v>1</c:v>
                </c:pt>
                <c:pt idx="1381">
                  <c:v>1</c:v>
                </c:pt>
                <c:pt idx="1382">
                  <c:v>1</c:v>
                </c:pt>
                <c:pt idx="1383">
                  <c:v>1</c:v>
                </c:pt>
                <c:pt idx="1384">
                  <c:v>1</c:v>
                </c:pt>
                <c:pt idx="1385">
                  <c:v>1</c:v>
                </c:pt>
                <c:pt idx="1391">
                  <c:v>1</c:v>
                </c:pt>
              </c:numCache>
            </c:numRef>
          </c:yVal>
          <c:smooth val="0"/>
        </c:ser>
        <c:dLbls>
          <c:showLegendKey val="0"/>
          <c:showVal val="0"/>
          <c:showCatName val="0"/>
          <c:showSerName val="0"/>
          <c:showPercent val="0"/>
          <c:showBubbleSize val="0"/>
        </c:dLbls>
        <c:axId val="419272432"/>
        <c:axId val="419272824"/>
      </c:scatterChart>
      <c:valAx>
        <c:axId val="419272432"/>
        <c:scaling>
          <c:orientation val="minMax"/>
          <c:max val="2500"/>
        </c:scaling>
        <c:delete val="0"/>
        <c:axPos val="b"/>
        <c:title>
          <c:tx>
            <c:rich>
              <a:bodyPr/>
              <a:lstStyle/>
              <a:p>
                <a:pPr>
                  <a:defRPr sz="800"/>
                </a:pPr>
                <a:r>
                  <a:rPr lang="en-US" sz="800"/>
                  <a:t>cDNA Position</a:t>
                </a:r>
              </a:p>
            </c:rich>
          </c:tx>
          <c:layout/>
          <c:overlay val="0"/>
        </c:title>
        <c:numFmt formatCode="General" sourceLinked="1"/>
        <c:majorTickMark val="out"/>
        <c:minorTickMark val="none"/>
        <c:tickLblPos val="nextTo"/>
        <c:spPr>
          <a:ln>
            <a:solidFill>
              <a:schemeClr val="tx1"/>
            </a:solidFill>
          </a:ln>
        </c:spPr>
        <c:txPr>
          <a:bodyPr/>
          <a:lstStyle/>
          <a:p>
            <a:pPr>
              <a:defRPr sz="800"/>
            </a:pPr>
            <a:endParaRPr lang="en-US"/>
          </a:p>
        </c:txPr>
        <c:crossAx val="419272824"/>
        <c:crosses val="autoZero"/>
        <c:crossBetween val="midCat"/>
      </c:valAx>
      <c:valAx>
        <c:axId val="419272824"/>
        <c:scaling>
          <c:orientation val="minMax"/>
          <c:max val="240"/>
          <c:min val="0"/>
        </c:scaling>
        <c:delete val="0"/>
        <c:axPos val="l"/>
        <c:title>
          <c:tx>
            <c:rich>
              <a:bodyPr rot="-5400000" vert="horz"/>
              <a:lstStyle/>
              <a:p>
                <a:pPr>
                  <a:defRPr sz="800"/>
                </a:pPr>
                <a:r>
                  <a:rPr lang="en-US" sz="800"/>
                  <a:t>PARE Abundance (TP10M)</a:t>
                </a:r>
              </a:p>
            </c:rich>
          </c:tx>
          <c:layout/>
          <c:overlay val="0"/>
        </c:title>
        <c:numFmt formatCode="General" sourceLinked="1"/>
        <c:majorTickMark val="out"/>
        <c:minorTickMark val="none"/>
        <c:tickLblPos val="nextTo"/>
        <c:spPr>
          <a:ln>
            <a:solidFill>
              <a:schemeClr val="tx1"/>
            </a:solidFill>
          </a:ln>
        </c:spPr>
        <c:txPr>
          <a:bodyPr/>
          <a:lstStyle/>
          <a:p>
            <a:pPr>
              <a:defRPr sz="800"/>
            </a:pPr>
            <a:endParaRPr lang="en-US"/>
          </a:p>
        </c:txPr>
        <c:crossAx val="419272432"/>
        <c:crosses val="autoZero"/>
        <c:crossBetween val="midCat"/>
        <c:majorUnit val="30"/>
      </c:valAx>
    </c:plotArea>
    <c:plotVisOnly val="1"/>
    <c:dispBlanksAs val="gap"/>
    <c:showDLblsOverMax val="0"/>
  </c:chart>
  <c:spPr>
    <a:ln>
      <a:solidFill>
        <a:schemeClr val="tx1"/>
      </a:solidFill>
    </a:ln>
  </c:spPr>
  <c:externalData r:id="rId1">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sz="1200"/>
            </a:pPr>
            <a:r>
              <a:rPr lang="en-US" dirty="0" smtClean="0"/>
              <a:t>Control</a:t>
            </a:r>
            <a:endParaRPr lang="en-US" dirty="0"/>
          </a:p>
        </c:rich>
      </c:tx>
      <c:layout/>
      <c:overlay val="0"/>
    </c:title>
    <c:autoTitleDeleted val="0"/>
    <c:plotArea>
      <c:layout/>
      <c:scatterChart>
        <c:scatterStyle val="lineMarker"/>
        <c:varyColors val="0"/>
        <c:ser>
          <c:idx val="0"/>
          <c:order val="0"/>
          <c:tx>
            <c:v>Control1</c:v>
          </c:tx>
          <c:spPr>
            <a:ln w="28575">
              <a:noFill/>
            </a:ln>
          </c:spPr>
          <c:marker>
            <c:symbol val="circle"/>
            <c:size val="5"/>
            <c:spPr>
              <a:solidFill>
                <a:srgbClr val="000000"/>
              </a:solidFill>
              <a:ln w="9525">
                <a:solidFill>
                  <a:srgbClr val="000000"/>
                </a:solidFill>
              </a:ln>
            </c:spPr>
          </c:marker>
          <c:dPt>
            <c:idx val="425"/>
            <c:marker>
              <c:spPr>
                <a:solidFill>
                  <a:srgbClr val="FF0000"/>
                </a:solidFill>
                <a:ln w="9525">
                  <a:solidFill>
                    <a:srgbClr val="FF0000"/>
                  </a:solidFill>
                </a:ln>
              </c:spPr>
            </c:marker>
            <c:bubble3D val="0"/>
          </c:dPt>
          <c:xVal>
            <c:numRef>
              <c:f>'Brachy LCR'!$B$4:$B$872</c:f>
              <c:numCache>
                <c:formatCode>General</c:formatCode>
                <c:ptCount val="869"/>
                <c:pt idx="0">
                  <c:v>1562</c:v>
                </c:pt>
                <c:pt idx="1">
                  <c:v>1348</c:v>
                </c:pt>
                <c:pt idx="2">
                  <c:v>1899</c:v>
                </c:pt>
                <c:pt idx="3">
                  <c:v>519</c:v>
                </c:pt>
                <c:pt idx="4">
                  <c:v>1707</c:v>
                </c:pt>
                <c:pt idx="5">
                  <c:v>1883</c:v>
                </c:pt>
                <c:pt idx="6">
                  <c:v>2047</c:v>
                </c:pt>
                <c:pt idx="7">
                  <c:v>1789</c:v>
                </c:pt>
                <c:pt idx="8">
                  <c:v>1963</c:v>
                </c:pt>
                <c:pt idx="9">
                  <c:v>1962</c:v>
                </c:pt>
                <c:pt idx="10">
                  <c:v>1909</c:v>
                </c:pt>
                <c:pt idx="11">
                  <c:v>648</c:v>
                </c:pt>
                <c:pt idx="12">
                  <c:v>1105</c:v>
                </c:pt>
                <c:pt idx="13">
                  <c:v>517</c:v>
                </c:pt>
                <c:pt idx="14">
                  <c:v>1469</c:v>
                </c:pt>
                <c:pt idx="15">
                  <c:v>2075</c:v>
                </c:pt>
                <c:pt idx="16">
                  <c:v>1484</c:v>
                </c:pt>
                <c:pt idx="17">
                  <c:v>727</c:v>
                </c:pt>
                <c:pt idx="18">
                  <c:v>1167</c:v>
                </c:pt>
                <c:pt idx="19">
                  <c:v>1184</c:v>
                </c:pt>
                <c:pt idx="20">
                  <c:v>1269</c:v>
                </c:pt>
                <c:pt idx="21">
                  <c:v>1613</c:v>
                </c:pt>
                <c:pt idx="22">
                  <c:v>2014</c:v>
                </c:pt>
                <c:pt idx="23">
                  <c:v>415</c:v>
                </c:pt>
                <c:pt idx="24">
                  <c:v>407</c:v>
                </c:pt>
                <c:pt idx="25">
                  <c:v>1512</c:v>
                </c:pt>
                <c:pt idx="26">
                  <c:v>1701</c:v>
                </c:pt>
                <c:pt idx="27">
                  <c:v>459</c:v>
                </c:pt>
                <c:pt idx="28">
                  <c:v>1100</c:v>
                </c:pt>
                <c:pt idx="29">
                  <c:v>584</c:v>
                </c:pt>
                <c:pt idx="30">
                  <c:v>1692</c:v>
                </c:pt>
                <c:pt idx="31">
                  <c:v>794</c:v>
                </c:pt>
                <c:pt idx="32">
                  <c:v>2001</c:v>
                </c:pt>
                <c:pt idx="33">
                  <c:v>1720</c:v>
                </c:pt>
                <c:pt idx="34">
                  <c:v>1690</c:v>
                </c:pt>
                <c:pt idx="35">
                  <c:v>867</c:v>
                </c:pt>
                <c:pt idx="36">
                  <c:v>1991</c:v>
                </c:pt>
                <c:pt idx="37">
                  <c:v>2004</c:v>
                </c:pt>
                <c:pt idx="38">
                  <c:v>1738</c:v>
                </c:pt>
                <c:pt idx="39">
                  <c:v>2039</c:v>
                </c:pt>
                <c:pt idx="40">
                  <c:v>1345</c:v>
                </c:pt>
                <c:pt idx="41">
                  <c:v>1083</c:v>
                </c:pt>
                <c:pt idx="42">
                  <c:v>2017</c:v>
                </c:pt>
                <c:pt idx="43">
                  <c:v>2073</c:v>
                </c:pt>
                <c:pt idx="44">
                  <c:v>2015</c:v>
                </c:pt>
                <c:pt idx="45">
                  <c:v>1736</c:v>
                </c:pt>
                <c:pt idx="46">
                  <c:v>1144</c:v>
                </c:pt>
                <c:pt idx="47">
                  <c:v>1992</c:v>
                </c:pt>
                <c:pt idx="48">
                  <c:v>1146</c:v>
                </c:pt>
                <c:pt idx="49">
                  <c:v>1365</c:v>
                </c:pt>
                <c:pt idx="50">
                  <c:v>1997</c:v>
                </c:pt>
                <c:pt idx="51">
                  <c:v>1844</c:v>
                </c:pt>
                <c:pt idx="52">
                  <c:v>428</c:v>
                </c:pt>
                <c:pt idx="53">
                  <c:v>1837</c:v>
                </c:pt>
                <c:pt idx="54">
                  <c:v>894</c:v>
                </c:pt>
                <c:pt idx="55">
                  <c:v>1966</c:v>
                </c:pt>
                <c:pt idx="56">
                  <c:v>1391</c:v>
                </c:pt>
                <c:pt idx="57">
                  <c:v>2026</c:v>
                </c:pt>
                <c:pt idx="58">
                  <c:v>789</c:v>
                </c:pt>
                <c:pt idx="59">
                  <c:v>1829</c:v>
                </c:pt>
                <c:pt idx="60">
                  <c:v>1723</c:v>
                </c:pt>
                <c:pt idx="61">
                  <c:v>1867</c:v>
                </c:pt>
                <c:pt idx="62">
                  <c:v>1119</c:v>
                </c:pt>
                <c:pt idx="63">
                  <c:v>2002</c:v>
                </c:pt>
                <c:pt idx="64">
                  <c:v>1499</c:v>
                </c:pt>
                <c:pt idx="65">
                  <c:v>2169</c:v>
                </c:pt>
                <c:pt idx="66">
                  <c:v>1548</c:v>
                </c:pt>
                <c:pt idx="67">
                  <c:v>1807</c:v>
                </c:pt>
                <c:pt idx="68">
                  <c:v>2164</c:v>
                </c:pt>
                <c:pt idx="69">
                  <c:v>1715</c:v>
                </c:pt>
                <c:pt idx="70">
                  <c:v>2083</c:v>
                </c:pt>
                <c:pt idx="71">
                  <c:v>1773</c:v>
                </c:pt>
                <c:pt idx="72">
                  <c:v>1767</c:v>
                </c:pt>
                <c:pt idx="73">
                  <c:v>1061</c:v>
                </c:pt>
                <c:pt idx="74">
                  <c:v>1802</c:v>
                </c:pt>
                <c:pt idx="75">
                  <c:v>2016</c:v>
                </c:pt>
                <c:pt idx="76">
                  <c:v>1442</c:v>
                </c:pt>
                <c:pt idx="77">
                  <c:v>1694</c:v>
                </c:pt>
                <c:pt idx="78">
                  <c:v>1454</c:v>
                </c:pt>
                <c:pt idx="79">
                  <c:v>1599</c:v>
                </c:pt>
                <c:pt idx="80">
                  <c:v>960</c:v>
                </c:pt>
                <c:pt idx="81">
                  <c:v>483</c:v>
                </c:pt>
                <c:pt idx="82">
                  <c:v>1849</c:v>
                </c:pt>
                <c:pt idx="83">
                  <c:v>926</c:v>
                </c:pt>
                <c:pt idx="84">
                  <c:v>1631</c:v>
                </c:pt>
                <c:pt idx="85">
                  <c:v>1434</c:v>
                </c:pt>
                <c:pt idx="86">
                  <c:v>566</c:v>
                </c:pt>
                <c:pt idx="87">
                  <c:v>2040</c:v>
                </c:pt>
                <c:pt idx="88">
                  <c:v>1142</c:v>
                </c:pt>
                <c:pt idx="89">
                  <c:v>1446</c:v>
                </c:pt>
                <c:pt idx="90">
                  <c:v>1988</c:v>
                </c:pt>
                <c:pt idx="91">
                  <c:v>484</c:v>
                </c:pt>
                <c:pt idx="92">
                  <c:v>1709</c:v>
                </c:pt>
                <c:pt idx="93">
                  <c:v>1460</c:v>
                </c:pt>
                <c:pt idx="94">
                  <c:v>1818</c:v>
                </c:pt>
                <c:pt idx="95">
                  <c:v>1557</c:v>
                </c:pt>
                <c:pt idx="96">
                  <c:v>1075</c:v>
                </c:pt>
                <c:pt idx="97">
                  <c:v>1685</c:v>
                </c:pt>
                <c:pt idx="98">
                  <c:v>1067</c:v>
                </c:pt>
                <c:pt idx="99">
                  <c:v>1864</c:v>
                </c:pt>
                <c:pt idx="100">
                  <c:v>615</c:v>
                </c:pt>
                <c:pt idx="101">
                  <c:v>824</c:v>
                </c:pt>
                <c:pt idx="102">
                  <c:v>1684</c:v>
                </c:pt>
                <c:pt idx="103">
                  <c:v>1702</c:v>
                </c:pt>
                <c:pt idx="104">
                  <c:v>1919</c:v>
                </c:pt>
                <c:pt idx="105">
                  <c:v>2112</c:v>
                </c:pt>
                <c:pt idx="106">
                  <c:v>1882</c:v>
                </c:pt>
                <c:pt idx="107">
                  <c:v>779</c:v>
                </c:pt>
                <c:pt idx="108">
                  <c:v>1213</c:v>
                </c:pt>
                <c:pt idx="109">
                  <c:v>1000</c:v>
                </c:pt>
                <c:pt idx="110">
                  <c:v>1689</c:v>
                </c:pt>
                <c:pt idx="111">
                  <c:v>986</c:v>
                </c:pt>
                <c:pt idx="112">
                  <c:v>2053</c:v>
                </c:pt>
                <c:pt idx="113">
                  <c:v>2077</c:v>
                </c:pt>
                <c:pt idx="114">
                  <c:v>1972</c:v>
                </c:pt>
                <c:pt idx="115">
                  <c:v>757</c:v>
                </c:pt>
                <c:pt idx="116">
                  <c:v>1491</c:v>
                </c:pt>
                <c:pt idx="117">
                  <c:v>1711</c:v>
                </c:pt>
                <c:pt idx="118">
                  <c:v>1155</c:v>
                </c:pt>
                <c:pt idx="119">
                  <c:v>2136</c:v>
                </c:pt>
                <c:pt idx="120">
                  <c:v>1959</c:v>
                </c:pt>
                <c:pt idx="121">
                  <c:v>1514</c:v>
                </c:pt>
                <c:pt idx="122">
                  <c:v>705</c:v>
                </c:pt>
                <c:pt idx="123">
                  <c:v>2021</c:v>
                </c:pt>
                <c:pt idx="124">
                  <c:v>1670</c:v>
                </c:pt>
                <c:pt idx="125">
                  <c:v>900</c:v>
                </c:pt>
                <c:pt idx="126">
                  <c:v>582</c:v>
                </c:pt>
                <c:pt idx="127">
                  <c:v>367</c:v>
                </c:pt>
                <c:pt idx="128">
                  <c:v>905</c:v>
                </c:pt>
                <c:pt idx="129">
                  <c:v>1748</c:v>
                </c:pt>
                <c:pt idx="130">
                  <c:v>1401</c:v>
                </c:pt>
                <c:pt idx="131">
                  <c:v>1376</c:v>
                </c:pt>
                <c:pt idx="132">
                  <c:v>1890</c:v>
                </c:pt>
                <c:pt idx="133">
                  <c:v>1915</c:v>
                </c:pt>
                <c:pt idx="134">
                  <c:v>1077</c:v>
                </c:pt>
                <c:pt idx="135">
                  <c:v>1444</c:v>
                </c:pt>
                <c:pt idx="136">
                  <c:v>1916</c:v>
                </c:pt>
                <c:pt idx="137">
                  <c:v>383</c:v>
                </c:pt>
                <c:pt idx="138">
                  <c:v>1340</c:v>
                </c:pt>
                <c:pt idx="139">
                  <c:v>1872</c:v>
                </c:pt>
                <c:pt idx="140">
                  <c:v>506</c:v>
                </c:pt>
                <c:pt idx="141">
                  <c:v>1354</c:v>
                </c:pt>
                <c:pt idx="142">
                  <c:v>1302</c:v>
                </c:pt>
                <c:pt idx="143">
                  <c:v>1440</c:v>
                </c:pt>
                <c:pt idx="144">
                  <c:v>1014</c:v>
                </c:pt>
                <c:pt idx="145">
                  <c:v>1381</c:v>
                </c:pt>
                <c:pt idx="146">
                  <c:v>1073</c:v>
                </c:pt>
                <c:pt idx="147">
                  <c:v>632</c:v>
                </c:pt>
                <c:pt idx="148">
                  <c:v>1726</c:v>
                </c:pt>
                <c:pt idx="149">
                  <c:v>1934</c:v>
                </c:pt>
                <c:pt idx="150">
                  <c:v>832</c:v>
                </c:pt>
                <c:pt idx="151">
                  <c:v>1629</c:v>
                </c:pt>
                <c:pt idx="152">
                  <c:v>1911</c:v>
                </c:pt>
                <c:pt idx="153">
                  <c:v>418</c:v>
                </c:pt>
                <c:pt idx="154">
                  <c:v>782</c:v>
                </c:pt>
                <c:pt idx="155">
                  <c:v>1138</c:v>
                </c:pt>
                <c:pt idx="156">
                  <c:v>1546</c:v>
                </c:pt>
                <c:pt idx="157">
                  <c:v>717</c:v>
                </c:pt>
                <c:pt idx="158">
                  <c:v>550</c:v>
                </c:pt>
                <c:pt idx="159">
                  <c:v>1467</c:v>
                </c:pt>
                <c:pt idx="160">
                  <c:v>372</c:v>
                </c:pt>
                <c:pt idx="161">
                  <c:v>1570</c:v>
                </c:pt>
                <c:pt idx="162">
                  <c:v>1825</c:v>
                </c:pt>
                <c:pt idx="163">
                  <c:v>535</c:v>
                </c:pt>
                <c:pt idx="164">
                  <c:v>1930</c:v>
                </c:pt>
                <c:pt idx="165">
                  <c:v>1258</c:v>
                </c:pt>
                <c:pt idx="166">
                  <c:v>1850</c:v>
                </c:pt>
                <c:pt idx="167">
                  <c:v>836</c:v>
                </c:pt>
                <c:pt idx="168">
                  <c:v>1618</c:v>
                </c:pt>
                <c:pt idx="169">
                  <c:v>2191</c:v>
                </c:pt>
                <c:pt idx="170">
                  <c:v>2005</c:v>
                </c:pt>
                <c:pt idx="171">
                  <c:v>1761</c:v>
                </c:pt>
                <c:pt idx="172">
                  <c:v>2122</c:v>
                </c:pt>
                <c:pt idx="173">
                  <c:v>2102</c:v>
                </c:pt>
                <c:pt idx="174">
                  <c:v>2000</c:v>
                </c:pt>
                <c:pt idx="175">
                  <c:v>2032</c:v>
                </c:pt>
                <c:pt idx="176">
                  <c:v>2006</c:v>
                </c:pt>
                <c:pt idx="177">
                  <c:v>1334</c:v>
                </c:pt>
                <c:pt idx="178">
                  <c:v>2127</c:v>
                </c:pt>
                <c:pt idx="179">
                  <c:v>2110</c:v>
                </c:pt>
                <c:pt idx="180">
                  <c:v>401</c:v>
                </c:pt>
                <c:pt idx="181">
                  <c:v>1881</c:v>
                </c:pt>
                <c:pt idx="182">
                  <c:v>1096</c:v>
                </c:pt>
                <c:pt idx="183">
                  <c:v>1332</c:v>
                </c:pt>
                <c:pt idx="184">
                  <c:v>2111</c:v>
                </c:pt>
                <c:pt idx="185">
                  <c:v>1921</c:v>
                </c:pt>
                <c:pt idx="186">
                  <c:v>2028</c:v>
                </c:pt>
                <c:pt idx="187">
                  <c:v>855</c:v>
                </c:pt>
                <c:pt idx="188">
                  <c:v>574</c:v>
                </c:pt>
                <c:pt idx="189">
                  <c:v>964</c:v>
                </c:pt>
                <c:pt idx="190">
                  <c:v>1745</c:v>
                </c:pt>
                <c:pt idx="191">
                  <c:v>1649</c:v>
                </c:pt>
                <c:pt idx="192">
                  <c:v>983</c:v>
                </c:pt>
                <c:pt idx="193">
                  <c:v>1700</c:v>
                </c:pt>
                <c:pt idx="194">
                  <c:v>1686</c:v>
                </c:pt>
                <c:pt idx="195">
                  <c:v>2141</c:v>
                </c:pt>
                <c:pt idx="196">
                  <c:v>1197</c:v>
                </c:pt>
                <c:pt idx="197">
                  <c:v>1796</c:v>
                </c:pt>
                <c:pt idx="198">
                  <c:v>743</c:v>
                </c:pt>
                <c:pt idx="199">
                  <c:v>1216</c:v>
                </c:pt>
                <c:pt idx="200">
                  <c:v>1947</c:v>
                </c:pt>
                <c:pt idx="201">
                  <c:v>1894</c:v>
                </c:pt>
                <c:pt idx="202">
                  <c:v>702</c:v>
                </c:pt>
                <c:pt idx="203">
                  <c:v>1721</c:v>
                </c:pt>
                <c:pt idx="204">
                  <c:v>1751</c:v>
                </c:pt>
                <c:pt idx="205">
                  <c:v>1559</c:v>
                </c:pt>
                <c:pt idx="206">
                  <c:v>2174</c:v>
                </c:pt>
                <c:pt idx="207">
                  <c:v>1695</c:v>
                </c:pt>
                <c:pt idx="208">
                  <c:v>2050</c:v>
                </c:pt>
                <c:pt idx="209">
                  <c:v>1363</c:v>
                </c:pt>
                <c:pt idx="210">
                  <c:v>1404</c:v>
                </c:pt>
                <c:pt idx="211">
                  <c:v>2022</c:v>
                </c:pt>
                <c:pt idx="212">
                  <c:v>1165</c:v>
                </c:pt>
                <c:pt idx="213">
                  <c:v>886</c:v>
                </c:pt>
                <c:pt idx="214">
                  <c:v>1904</c:v>
                </c:pt>
                <c:pt idx="215">
                  <c:v>1524</c:v>
                </c:pt>
                <c:pt idx="216">
                  <c:v>1983</c:v>
                </c:pt>
                <c:pt idx="217">
                  <c:v>1812</c:v>
                </c:pt>
                <c:pt idx="218">
                  <c:v>1928</c:v>
                </c:pt>
                <c:pt idx="219">
                  <c:v>1584</c:v>
                </c:pt>
                <c:pt idx="220">
                  <c:v>1729</c:v>
                </c:pt>
                <c:pt idx="221">
                  <c:v>1569</c:v>
                </c:pt>
                <c:pt idx="222">
                  <c:v>689</c:v>
                </c:pt>
                <c:pt idx="223">
                  <c:v>721</c:v>
                </c:pt>
                <c:pt idx="224">
                  <c:v>1776</c:v>
                </c:pt>
                <c:pt idx="225">
                  <c:v>588</c:v>
                </c:pt>
                <c:pt idx="226">
                  <c:v>1536</c:v>
                </c:pt>
                <c:pt idx="227">
                  <c:v>1810</c:v>
                </c:pt>
                <c:pt idx="228">
                  <c:v>1614</c:v>
                </c:pt>
                <c:pt idx="229">
                  <c:v>1698</c:v>
                </c:pt>
                <c:pt idx="230">
                  <c:v>1360</c:v>
                </c:pt>
                <c:pt idx="231">
                  <c:v>1704</c:v>
                </c:pt>
                <c:pt idx="232">
                  <c:v>904</c:v>
                </c:pt>
                <c:pt idx="233">
                  <c:v>1800</c:v>
                </c:pt>
                <c:pt idx="234">
                  <c:v>1706</c:v>
                </c:pt>
                <c:pt idx="235">
                  <c:v>797</c:v>
                </c:pt>
                <c:pt idx="236">
                  <c:v>1838</c:v>
                </c:pt>
                <c:pt idx="237">
                  <c:v>1968</c:v>
                </c:pt>
                <c:pt idx="238">
                  <c:v>2095</c:v>
                </c:pt>
                <c:pt idx="239">
                  <c:v>1341</c:v>
                </c:pt>
                <c:pt idx="240">
                  <c:v>934</c:v>
                </c:pt>
                <c:pt idx="241">
                  <c:v>1766</c:v>
                </c:pt>
                <c:pt idx="242">
                  <c:v>1935</c:v>
                </c:pt>
                <c:pt idx="243">
                  <c:v>2059</c:v>
                </c:pt>
                <c:pt idx="244">
                  <c:v>2097</c:v>
                </c:pt>
                <c:pt idx="245">
                  <c:v>534</c:v>
                </c:pt>
                <c:pt idx="246">
                  <c:v>1912</c:v>
                </c:pt>
                <c:pt idx="247">
                  <c:v>2010</c:v>
                </c:pt>
                <c:pt idx="248">
                  <c:v>1532</c:v>
                </c:pt>
                <c:pt idx="249">
                  <c:v>1175</c:v>
                </c:pt>
                <c:pt idx="250">
                  <c:v>2134</c:v>
                </c:pt>
                <c:pt idx="251">
                  <c:v>2181</c:v>
                </c:pt>
                <c:pt idx="252">
                  <c:v>1728</c:v>
                </c:pt>
                <c:pt idx="253">
                  <c:v>1876</c:v>
                </c:pt>
                <c:pt idx="254">
                  <c:v>2142</c:v>
                </c:pt>
                <c:pt idx="255">
                  <c:v>1663</c:v>
                </c:pt>
                <c:pt idx="256">
                  <c:v>1758</c:v>
                </c:pt>
                <c:pt idx="257">
                  <c:v>382</c:v>
                </c:pt>
                <c:pt idx="258">
                  <c:v>1859</c:v>
                </c:pt>
                <c:pt idx="259">
                  <c:v>1489</c:v>
                </c:pt>
                <c:pt idx="260">
                  <c:v>488</c:v>
                </c:pt>
                <c:pt idx="261">
                  <c:v>1806</c:v>
                </c:pt>
                <c:pt idx="262">
                  <c:v>1639</c:v>
                </c:pt>
                <c:pt idx="263">
                  <c:v>1984</c:v>
                </c:pt>
                <c:pt idx="264">
                  <c:v>1183</c:v>
                </c:pt>
                <c:pt idx="265">
                  <c:v>1831</c:v>
                </c:pt>
                <c:pt idx="266">
                  <c:v>1852</c:v>
                </c:pt>
                <c:pt idx="267">
                  <c:v>1389</c:v>
                </c:pt>
                <c:pt idx="268">
                  <c:v>1878</c:v>
                </c:pt>
                <c:pt idx="269">
                  <c:v>1753</c:v>
                </c:pt>
                <c:pt idx="270">
                  <c:v>1116</c:v>
                </c:pt>
                <c:pt idx="271">
                  <c:v>1820</c:v>
                </c:pt>
                <c:pt idx="272">
                  <c:v>1998</c:v>
                </c:pt>
                <c:pt idx="273">
                  <c:v>1927</c:v>
                </c:pt>
                <c:pt idx="274">
                  <c:v>1535</c:v>
                </c:pt>
                <c:pt idx="275">
                  <c:v>664</c:v>
                </c:pt>
                <c:pt idx="276">
                  <c:v>1762</c:v>
                </c:pt>
                <c:pt idx="277">
                  <c:v>1574</c:v>
                </c:pt>
                <c:pt idx="278">
                  <c:v>1480</c:v>
                </c:pt>
                <c:pt idx="279">
                  <c:v>1771</c:v>
                </c:pt>
                <c:pt idx="280">
                  <c:v>240</c:v>
                </c:pt>
                <c:pt idx="281">
                  <c:v>1240</c:v>
                </c:pt>
                <c:pt idx="282">
                  <c:v>1020</c:v>
                </c:pt>
                <c:pt idx="283">
                  <c:v>1801</c:v>
                </c:pt>
                <c:pt idx="284">
                  <c:v>1355</c:v>
                </c:pt>
                <c:pt idx="285">
                  <c:v>2046</c:v>
                </c:pt>
                <c:pt idx="286">
                  <c:v>1973</c:v>
                </c:pt>
                <c:pt idx="287">
                  <c:v>1630</c:v>
                </c:pt>
                <c:pt idx="288">
                  <c:v>403</c:v>
                </c:pt>
                <c:pt idx="289">
                  <c:v>1862</c:v>
                </c:pt>
                <c:pt idx="290">
                  <c:v>1936</c:v>
                </c:pt>
                <c:pt idx="291">
                  <c:v>1785</c:v>
                </c:pt>
                <c:pt idx="292">
                  <c:v>890</c:v>
                </c:pt>
                <c:pt idx="293">
                  <c:v>1990</c:v>
                </c:pt>
                <c:pt idx="294">
                  <c:v>1162</c:v>
                </c:pt>
                <c:pt idx="295">
                  <c:v>1520</c:v>
                </c:pt>
                <c:pt idx="296">
                  <c:v>2013</c:v>
                </c:pt>
                <c:pt idx="297">
                  <c:v>2079</c:v>
                </c:pt>
                <c:pt idx="298">
                  <c:v>675</c:v>
                </c:pt>
                <c:pt idx="299">
                  <c:v>1343</c:v>
                </c:pt>
                <c:pt idx="300">
                  <c:v>400</c:v>
                </c:pt>
                <c:pt idx="301">
                  <c:v>1079</c:v>
                </c:pt>
                <c:pt idx="302">
                  <c:v>1898</c:v>
                </c:pt>
                <c:pt idx="303">
                  <c:v>1438</c:v>
                </c:pt>
                <c:pt idx="304">
                  <c:v>579</c:v>
                </c:pt>
                <c:pt idx="305">
                  <c:v>2158</c:v>
                </c:pt>
                <c:pt idx="306">
                  <c:v>1160</c:v>
                </c:pt>
                <c:pt idx="307">
                  <c:v>1775</c:v>
                </c:pt>
                <c:pt idx="308">
                  <c:v>1939</c:v>
                </c:pt>
                <c:pt idx="309">
                  <c:v>1498</c:v>
                </c:pt>
                <c:pt idx="310">
                  <c:v>2171</c:v>
                </c:pt>
                <c:pt idx="311">
                  <c:v>1875</c:v>
                </c:pt>
                <c:pt idx="312">
                  <c:v>1929</c:v>
                </c:pt>
                <c:pt idx="313">
                  <c:v>1933</c:v>
                </c:pt>
                <c:pt idx="314">
                  <c:v>1823</c:v>
                </c:pt>
                <c:pt idx="315">
                  <c:v>1581</c:v>
                </c:pt>
                <c:pt idx="316">
                  <c:v>1070</c:v>
                </c:pt>
                <c:pt idx="317">
                  <c:v>1571</c:v>
                </c:pt>
                <c:pt idx="318">
                  <c:v>1153</c:v>
                </c:pt>
                <c:pt idx="319">
                  <c:v>565</c:v>
                </c:pt>
                <c:pt idx="320">
                  <c:v>1718</c:v>
                </c:pt>
                <c:pt idx="321">
                  <c:v>1803</c:v>
                </c:pt>
                <c:pt idx="322">
                  <c:v>1576</c:v>
                </c:pt>
                <c:pt idx="323">
                  <c:v>1855</c:v>
                </c:pt>
                <c:pt idx="324">
                  <c:v>2030</c:v>
                </c:pt>
                <c:pt idx="325">
                  <c:v>1961</c:v>
                </c:pt>
                <c:pt idx="326">
                  <c:v>1975</c:v>
                </c:pt>
                <c:pt idx="327">
                  <c:v>1741</c:v>
                </c:pt>
                <c:pt idx="328">
                  <c:v>1482</c:v>
                </c:pt>
                <c:pt idx="329">
                  <c:v>1443</c:v>
                </c:pt>
                <c:pt idx="330">
                  <c:v>1774</c:v>
                </c:pt>
                <c:pt idx="331">
                  <c:v>514</c:v>
                </c:pt>
                <c:pt idx="332">
                  <c:v>1449</c:v>
                </c:pt>
                <c:pt idx="333">
                  <c:v>1521</c:v>
                </c:pt>
                <c:pt idx="334">
                  <c:v>1873</c:v>
                </c:pt>
                <c:pt idx="335">
                  <c:v>1817</c:v>
                </c:pt>
                <c:pt idx="336">
                  <c:v>1682</c:v>
                </c:pt>
                <c:pt idx="337">
                  <c:v>1481</c:v>
                </c:pt>
                <c:pt idx="338">
                  <c:v>2163</c:v>
                </c:pt>
                <c:pt idx="339">
                  <c:v>1573</c:v>
                </c:pt>
                <c:pt idx="340">
                  <c:v>1887</c:v>
                </c:pt>
                <c:pt idx="341">
                  <c:v>1958</c:v>
                </c:pt>
                <c:pt idx="342">
                  <c:v>2058</c:v>
                </c:pt>
                <c:pt idx="343">
                  <c:v>2196</c:v>
                </c:pt>
                <c:pt idx="344">
                  <c:v>586</c:v>
                </c:pt>
                <c:pt idx="345">
                  <c:v>1903</c:v>
                </c:pt>
                <c:pt idx="346">
                  <c:v>1418</c:v>
                </c:pt>
                <c:pt idx="347">
                  <c:v>1874</c:v>
                </c:pt>
                <c:pt idx="348">
                  <c:v>1211</c:v>
                </c:pt>
                <c:pt idx="349">
                  <c:v>1608</c:v>
                </c:pt>
                <c:pt idx="350">
                  <c:v>387</c:v>
                </c:pt>
                <c:pt idx="351">
                  <c:v>1497</c:v>
                </c:pt>
                <c:pt idx="352">
                  <c:v>1032</c:v>
                </c:pt>
                <c:pt idx="353">
                  <c:v>1906</c:v>
                </c:pt>
                <c:pt idx="354">
                  <c:v>2070</c:v>
                </c:pt>
                <c:pt idx="355">
                  <c:v>1666</c:v>
                </c:pt>
                <c:pt idx="356">
                  <c:v>1097</c:v>
                </c:pt>
                <c:pt idx="357">
                  <c:v>1582</c:v>
                </c:pt>
                <c:pt idx="358">
                  <c:v>1664</c:v>
                </c:pt>
                <c:pt idx="359">
                  <c:v>1157</c:v>
                </c:pt>
                <c:pt idx="360">
                  <c:v>1476</c:v>
                </c:pt>
                <c:pt idx="361">
                  <c:v>2056</c:v>
                </c:pt>
                <c:pt idx="362">
                  <c:v>1246</c:v>
                </c:pt>
                <c:pt idx="363">
                  <c:v>583</c:v>
                </c:pt>
                <c:pt idx="364">
                  <c:v>1953</c:v>
                </c:pt>
                <c:pt idx="365">
                  <c:v>1139</c:v>
                </c:pt>
                <c:pt idx="366">
                  <c:v>485</c:v>
                </c:pt>
                <c:pt idx="367">
                  <c:v>1949</c:v>
                </c:pt>
                <c:pt idx="368">
                  <c:v>807</c:v>
                </c:pt>
                <c:pt idx="369">
                  <c:v>1869</c:v>
                </c:pt>
                <c:pt idx="370">
                  <c:v>1596</c:v>
                </c:pt>
                <c:pt idx="371">
                  <c:v>1683</c:v>
                </c:pt>
                <c:pt idx="372">
                  <c:v>404</c:v>
                </c:pt>
                <c:pt idx="373">
                  <c:v>2092</c:v>
                </c:pt>
                <c:pt idx="374">
                  <c:v>1913</c:v>
                </c:pt>
                <c:pt idx="375">
                  <c:v>1892</c:v>
                </c:pt>
                <c:pt idx="376">
                  <c:v>1359</c:v>
                </c:pt>
                <c:pt idx="377">
                  <c:v>1834</c:v>
                </c:pt>
                <c:pt idx="378">
                  <c:v>1841</c:v>
                </c:pt>
                <c:pt idx="379">
                  <c:v>1485</c:v>
                </c:pt>
                <c:pt idx="380">
                  <c:v>2071</c:v>
                </c:pt>
                <c:pt idx="381">
                  <c:v>1150</c:v>
                </c:pt>
                <c:pt idx="382">
                  <c:v>1351</c:v>
                </c:pt>
                <c:pt idx="383">
                  <c:v>1815</c:v>
                </c:pt>
                <c:pt idx="384">
                  <c:v>1799</c:v>
                </c:pt>
                <c:pt idx="385">
                  <c:v>1848</c:v>
                </c:pt>
                <c:pt idx="386">
                  <c:v>1125</c:v>
                </c:pt>
                <c:pt idx="387">
                  <c:v>1626</c:v>
                </c:pt>
                <c:pt idx="388">
                  <c:v>1385</c:v>
                </c:pt>
                <c:pt idx="389">
                  <c:v>1781</c:v>
                </c:pt>
                <c:pt idx="390">
                  <c:v>1946</c:v>
                </c:pt>
                <c:pt idx="391">
                  <c:v>1996</c:v>
                </c:pt>
                <c:pt idx="392">
                  <c:v>1145</c:v>
                </c:pt>
                <c:pt idx="393">
                  <c:v>1114</c:v>
                </c:pt>
                <c:pt idx="394">
                  <c:v>930</c:v>
                </c:pt>
                <c:pt idx="395">
                  <c:v>1942</c:v>
                </c:pt>
                <c:pt idx="396">
                  <c:v>2065</c:v>
                </c:pt>
                <c:pt idx="397">
                  <c:v>968</c:v>
                </c:pt>
                <c:pt idx="398">
                  <c:v>1062</c:v>
                </c:pt>
                <c:pt idx="399">
                  <c:v>1814</c:v>
                </c:pt>
                <c:pt idx="400">
                  <c:v>372</c:v>
                </c:pt>
                <c:pt idx="401">
                  <c:v>1681</c:v>
                </c:pt>
                <c:pt idx="402">
                  <c:v>1349</c:v>
                </c:pt>
                <c:pt idx="403">
                  <c:v>546</c:v>
                </c:pt>
                <c:pt idx="404">
                  <c:v>2033</c:v>
                </c:pt>
                <c:pt idx="405">
                  <c:v>1198</c:v>
                </c:pt>
                <c:pt idx="406">
                  <c:v>2125</c:v>
                </c:pt>
                <c:pt idx="407">
                  <c:v>1954</c:v>
                </c:pt>
                <c:pt idx="408">
                  <c:v>2080</c:v>
                </c:pt>
                <c:pt idx="409">
                  <c:v>619</c:v>
                </c:pt>
                <c:pt idx="410">
                  <c:v>1564</c:v>
                </c:pt>
                <c:pt idx="411">
                  <c:v>1790</c:v>
                </c:pt>
                <c:pt idx="412">
                  <c:v>1891</c:v>
                </c:pt>
                <c:pt idx="413">
                  <c:v>1977</c:v>
                </c:pt>
                <c:pt idx="414">
                  <c:v>1423</c:v>
                </c:pt>
                <c:pt idx="415">
                  <c:v>1163</c:v>
                </c:pt>
                <c:pt idx="416">
                  <c:v>2081</c:v>
                </c:pt>
                <c:pt idx="417">
                  <c:v>847</c:v>
                </c:pt>
                <c:pt idx="418">
                  <c:v>1739</c:v>
                </c:pt>
                <c:pt idx="419">
                  <c:v>2157</c:v>
                </c:pt>
                <c:pt idx="420">
                  <c:v>1137</c:v>
                </c:pt>
                <c:pt idx="421">
                  <c:v>1688</c:v>
                </c:pt>
                <c:pt idx="422">
                  <c:v>1133</c:v>
                </c:pt>
                <c:pt idx="423">
                  <c:v>1937</c:v>
                </c:pt>
                <c:pt idx="424">
                  <c:v>1042</c:v>
                </c:pt>
                <c:pt idx="425">
                  <c:v>1479</c:v>
                </c:pt>
                <c:pt idx="426">
                  <c:v>369</c:v>
                </c:pt>
                <c:pt idx="427">
                  <c:v>1871</c:v>
                </c:pt>
                <c:pt idx="428">
                  <c:v>1076</c:v>
                </c:pt>
                <c:pt idx="429">
                  <c:v>1338</c:v>
                </c:pt>
                <c:pt idx="430">
                  <c:v>2018</c:v>
                </c:pt>
                <c:pt idx="431">
                  <c:v>1040</c:v>
                </c:pt>
                <c:pt idx="432">
                  <c:v>2072</c:v>
                </c:pt>
                <c:pt idx="433">
                  <c:v>1561</c:v>
                </c:pt>
                <c:pt idx="434">
                  <c:v>896</c:v>
                </c:pt>
                <c:pt idx="435">
                  <c:v>1655</c:v>
                </c:pt>
                <c:pt idx="436">
                  <c:v>1786</c:v>
                </c:pt>
                <c:pt idx="437">
                  <c:v>1836</c:v>
                </c:pt>
                <c:pt idx="438">
                  <c:v>1601</c:v>
                </c:pt>
                <c:pt idx="439">
                  <c:v>1956</c:v>
                </c:pt>
                <c:pt idx="440">
                  <c:v>884</c:v>
                </c:pt>
                <c:pt idx="441">
                  <c:v>1784</c:v>
                </c:pt>
                <c:pt idx="442">
                  <c:v>1754</c:v>
                </c:pt>
                <c:pt idx="443">
                  <c:v>2066</c:v>
                </c:pt>
                <c:pt idx="444">
                  <c:v>504</c:v>
                </c:pt>
                <c:pt idx="445">
                  <c:v>2023</c:v>
                </c:pt>
                <c:pt idx="446">
                  <c:v>2173</c:v>
                </c:pt>
                <c:pt idx="447">
                  <c:v>2113</c:v>
                </c:pt>
                <c:pt idx="448">
                  <c:v>1744</c:v>
                </c:pt>
                <c:pt idx="449">
                  <c:v>2041</c:v>
                </c:pt>
                <c:pt idx="450">
                  <c:v>2034</c:v>
                </c:pt>
                <c:pt idx="451">
                  <c:v>912</c:v>
                </c:pt>
                <c:pt idx="452">
                  <c:v>988</c:v>
                </c:pt>
                <c:pt idx="453">
                  <c:v>1367</c:v>
                </c:pt>
                <c:pt idx="454">
                  <c:v>1788</c:v>
                </c:pt>
                <c:pt idx="455">
                  <c:v>1858</c:v>
                </c:pt>
                <c:pt idx="456">
                  <c:v>1902</c:v>
                </c:pt>
                <c:pt idx="457">
                  <c:v>1508</c:v>
                </c:pt>
                <c:pt idx="458">
                  <c:v>1315</c:v>
                </c:pt>
                <c:pt idx="459">
                  <c:v>2048</c:v>
                </c:pt>
                <c:pt idx="460">
                  <c:v>480</c:v>
                </c:pt>
                <c:pt idx="461">
                  <c:v>791</c:v>
                </c:pt>
                <c:pt idx="462">
                  <c:v>2140</c:v>
                </c:pt>
                <c:pt idx="463">
                  <c:v>1965</c:v>
                </c:pt>
                <c:pt idx="464">
                  <c:v>1592</c:v>
                </c:pt>
                <c:pt idx="465">
                  <c:v>1244</c:v>
                </c:pt>
                <c:pt idx="466">
                  <c:v>370</c:v>
                </c:pt>
                <c:pt idx="467">
                  <c:v>1118</c:v>
                </c:pt>
                <c:pt idx="468">
                  <c:v>1696</c:v>
                </c:pt>
                <c:pt idx="469">
                  <c:v>1925</c:v>
                </c:pt>
                <c:pt idx="470">
                  <c:v>1730</c:v>
                </c:pt>
                <c:pt idx="471">
                  <c:v>1678</c:v>
                </c:pt>
                <c:pt idx="472">
                  <c:v>1511</c:v>
                </c:pt>
                <c:pt idx="473">
                  <c:v>1589</c:v>
                </c:pt>
                <c:pt idx="474">
                  <c:v>1826</c:v>
                </c:pt>
                <c:pt idx="475">
                  <c:v>1980</c:v>
                </c:pt>
                <c:pt idx="476">
                  <c:v>1746</c:v>
                </c:pt>
                <c:pt idx="477">
                  <c:v>461</c:v>
                </c:pt>
                <c:pt idx="478">
                  <c:v>1896</c:v>
                </c:pt>
                <c:pt idx="479">
                  <c:v>1462</c:v>
                </c:pt>
                <c:pt idx="480">
                  <c:v>2035</c:v>
                </c:pt>
                <c:pt idx="481">
                  <c:v>2074</c:v>
                </c:pt>
                <c:pt idx="482">
                  <c:v>2012</c:v>
                </c:pt>
                <c:pt idx="483">
                  <c:v>1687</c:v>
                </c:pt>
                <c:pt idx="484">
                  <c:v>1113</c:v>
                </c:pt>
                <c:pt idx="485">
                  <c:v>2098</c:v>
                </c:pt>
                <c:pt idx="486">
                  <c:v>1507</c:v>
                </c:pt>
                <c:pt idx="487">
                  <c:v>599</c:v>
                </c:pt>
                <c:pt idx="488">
                  <c:v>1861</c:v>
                </c:pt>
                <c:pt idx="489">
                  <c:v>1235</c:v>
                </c:pt>
                <c:pt idx="490">
                  <c:v>1050</c:v>
                </c:pt>
                <c:pt idx="491">
                  <c:v>1057</c:v>
                </c:pt>
                <c:pt idx="492">
                  <c:v>1148</c:v>
                </c:pt>
                <c:pt idx="493">
                  <c:v>1910</c:v>
                </c:pt>
                <c:pt idx="494">
                  <c:v>2101</c:v>
                </c:pt>
                <c:pt idx="495">
                  <c:v>1839</c:v>
                </c:pt>
                <c:pt idx="496">
                  <c:v>883</c:v>
                </c:pt>
                <c:pt idx="497">
                  <c:v>1059</c:v>
                </c:pt>
                <c:pt idx="498">
                  <c:v>2076</c:v>
                </c:pt>
                <c:pt idx="499">
                  <c:v>2085</c:v>
                </c:pt>
                <c:pt idx="500">
                  <c:v>1463</c:v>
                </c:pt>
                <c:pt idx="501">
                  <c:v>1433</c:v>
                </c:pt>
                <c:pt idx="502">
                  <c:v>1342</c:v>
                </c:pt>
                <c:pt idx="503">
                  <c:v>2115</c:v>
                </c:pt>
                <c:pt idx="504">
                  <c:v>1747</c:v>
                </c:pt>
                <c:pt idx="505">
                  <c:v>1344</c:v>
                </c:pt>
                <c:pt idx="506">
                  <c:v>394</c:v>
                </c:pt>
                <c:pt idx="507">
                  <c:v>2020</c:v>
                </c:pt>
                <c:pt idx="508">
                  <c:v>1407</c:v>
                </c:pt>
                <c:pt idx="509">
                  <c:v>646</c:v>
                </c:pt>
                <c:pt idx="510">
                  <c:v>1245</c:v>
                </c:pt>
                <c:pt idx="511">
                  <c:v>457</c:v>
                </c:pt>
                <c:pt idx="512">
                  <c:v>1058</c:v>
                </c:pt>
                <c:pt idx="513">
                  <c:v>1379</c:v>
                </c:pt>
                <c:pt idx="514">
                  <c:v>1156</c:v>
                </c:pt>
                <c:pt idx="515">
                  <c:v>1986</c:v>
                </c:pt>
                <c:pt idx="516">
                  <c:v>2036</c:v>
                </c:pt>
                <c:pt idx="517">
                  <c:v>679</c:v>
                </c:pt>
                <c:pt idx="518">
                  <c:v>1147</c:v>
                </c:pt>
                <c:pt idx="519">
                  <c:v>1768</c:v>
                </c:pt>
                <c:pt idx="520">
                  <c:v>1161</c:v>
                </c:pt>
                <c:pt idx="521">
                  <c:v>1932</c:v>
                </c:pt>
                <c:pt idx="522">
                  <c:v>1620</c:v>
                </c:pt>
                <c:pt idx="523">
                  <c:v>481</c:v>
                </c:pt>
                <c:pt idx="524">
                  <c:v>1905</c:v>
                </c:pt>
                <c:pt idx="525">
                  <c:v>1846</c:v>
                </c:pt>
                <c:pt idx="526">
                  <c:v>2084</c:v>
                </c:pt>
                <c:pt idx="527">
                  <c:v>1140</c:v>
                </c:pt>
                <c:pt idx="528">
                  <c:v>2044</c:v>
                </c:pt>
                <c:pt idx="529">
                  <c:v>1554</c:v>
                </c:pt>
                <c:pt idx="530">
                  <c:v>1602</c:v>
                </c:pt>
                <c:pt idx="531">
                  <c:v>1186</c:v>
                </c:pt>
                <c:pt idx="532">
                  <c:v>2172</c:v>
                </c:pt>
                <c:pt idx="533">
                  <c:v>1900</c:v>
                </c:pt>
                <c:pt idx="534">
                  <c:v>1917</c:v>
                </c:pt>
                <c:pt idx="535">
                  <c:v>1347</c:v>
                </c:pt>
                <c:pt idx="536">
                  <c:v>1610</c:v>
                </c:pt>
                <c:pt idx="537">
                  <c:v>1671</c:v>
                </c:pt>
                <c:pt idx="538">
                  <c:v>2091</c:v>
                </c:pt>
                <c:pt idx="539">
                  <c:v>487</c:v>
                </c:pt>
                <c:pt idx="540">
                  <c:v>1827</c:v>
                </c:pt>
                <c:pt idx="541">
                  <c:v>489</c:v>
                </c:pt>
                <c:pt idx="542">
                  <c:v>756</c:v>
                </c:pt>
                <c:pt idx="543">
                  <c:v>1732</c:v>
                </c:pt>
                <c:pt idx="544">
                  <c:v>1339</c:v>
                </c:pt>
                <c:pt idx="545">
                  <c:v>2042</c:v>
                </c:pt>
                <c:pt idx="546">
                  <c:v>1292</c:v>
                </c:pt>
                <c:pt idx="547">
                  <c:v>1483</c:v>
                </c:pt>
                <c:pt idx="548">
                  <c:v>2197</c:v>
                </c:pt>
                <c:pt idx="549">
                  <c:v>1926</c:v>
                </c:pt>
                <c:pt idx="550">
                  <c:v>1501</c:v>
                </c:pt>
                <c:pt idx="551">
                  <c:v>1124</c:v>
                </c:pt>
                <c:pt idx="552">
                  <c:v>1597</c:v>
                </c:pt>
                <c:pt idx="553">
                  <c:v>1955</c:v>
                </c:pt>
                <c:pt idx="554">
                  <c:v>739</c:v>
                </c:pt>
                <c:pt idx="555">
                  <c:v>1436</c:v>
                </c:pt>
                <c:pt idx="556">
                  <c:v>805</c:v>
                </c:pt>
                <c:pt idx="557">
                  <c:v>1527</c:v>
                </c:pt>
                <c:pt idx="558">
                  <c:v>859</c:v>
                </c:pt>
                <c:pt idx="559">
                  <c:v>1591</c:v>
                </c:pt>
                <c:pt idx="560">
                  <c:v>1337</c:v>
                </c:pt>
                <c:pt idx="561">
                  <c:v>2009</c:v>
                </c:pt>
                <c:pt idx="562">
                  <c:v>1492</c:v>
                </c:pt>
                <c:pt idx="563">
                  <c:v>2165</c:v>
                </c:pt>
                <c:pt idx="564">
                  <c:v>486</c:v>
                </c:pt>
                <c:pt idx="565">
                  <c:v>1417</c:v>
                </c:pt>
                <c:pt idx="566">
                  <c:v>737</c:v>
                </c:pt>
                <c:pt idx="567">
                  <c:v>910</c:v>
                </c:pt>
                <c:pt idx="568">
                  <c:v>2051</c:v>
                </c:pt>
                <c:pt idx="569">
                  <c:v>1435</c:v>
                </c:pt>
                <c:pt idx="570">
                  <c:v>420</c:v>
                </c:pt>
                <c:pt idx="571">
                  <c:v>1364</c:v>
                </c:pt>
                <c:pt idx="572">
                  <c:v>1727</c:v>
                </c:pt>
                <c:pt idx="573">
                  <c:v>1868</c:v>
                </c:pt>
                <c:pt idx="574">
                  <c:v>906</c:v>
                </c:pt>
                <c:pt idx="575">
                  <c:v>440</c:v>
                </c:pt>
                <c:pt idx="576">
                  <c:v>1673</c:v>
                </c:pt>
                <c:pt idx="577">
                  <c:v>371</c:v>
                </c:pt>
                <c:pt idx="578">
                  <c:v>2107</c:v>
                </c:pt>
                <c:pt idx="579">
                  <c:v>1588</c:v>
                </c:pt>
                <c:pt idx="580">
                  <c:v>1811</c:v>
                </c:pt>
                <c:pt idx="581">
                  <c:v>1893</c:v>
                </c:pt>
                <c:pt idx="582">
                  <c:v>1159</c:v>
                </c:pt>
                <c:pt idx="583">
                  <c:v>1609</c:v>
                </c:pt>
                <c:pt idx="584">
                  <c:v>1971</c:v>
                </c:pt>
                <c:pt idx="585">
                  <c:v>1539</c:v>
                </c:pt>
                <c:pt idx="586">
                  <c:v>1847</c:v>
                </c:pt>
                <c:pt idx="587">
                  <c:v>1987</c:v>
                </c:pt>
                <c:pt idx="588">
                  <c:v>1531</c:v>
                </c:pt>
                <c:pt idx="589">
                  <c:v>567</c:v>
                </c:pt>
                <c:pt idx="590">
                  <c:v>1288</c:v>
                </c:pt>
                <c:pt idx="591">
                  <c:v>2045</c:v>
                </c:pt>
                <c:pt idx="592">
                  <c:v>1403</c:v>
                </c:pt>
                <c:pt idx="593">
                  <c:v>1013</c:v>
                </c:pt>
                <c:pt idx="594">
                  <c:v>2167</c:v>
                </c:pt>
                <c:pt idx="595">
                  <c:v>984</c:v>
                </c:pt>
                <c:pt idx="596">
                  <c:v>1779</c:v>
                </c:pt>
                <c:pt idx="597">
                  <c:v>1369</c:v>
                </c:pt>
                <c:pt idx="598">
                  <c:v>587</c:v>
                </c:pt>
                <c:pt idx="599">
                  <c:v>1672</c:v>
                </c:pt>
                <c:pt idx="600">
                  <c:v>562</c:v>
                </c:pt>
                <c:pt idx="601">
                  <c:v>1510</c:v>
                </c:pt>
                <c:pt idx="602">
                  <c:v>1254</c:v>
                </c:pt>
                <c:pt idx="603">
                  <c:v>2067</c:v>
                </c:pt>
                <c:pt idx="604">
                  <c:v>1691</c:v>
                </c:pt>
                <c:pt idx="605">
                  <c:v>686</c:v>
                </c:pt>
                <c:pt idx="606">
                  <c:v>1034</c:v>
                </c:pt>
                <c:pt idx="607">
                  <c:v>379</c:v>
                </c:pt>
                <c:pt idx="608">
                  <c:v>1999</c:v>
                </c:pt>
                <c:pt idx="609">
                  <c:v>1035</c:v>
                </c:pt>
                <c:pt idx="610">
                  <c:v>1128</c:v>
                </c:pt>
                <c:pt idx="611">
                  <c:v>1509</c:v>
                </c:pt>
                <c:pt idx="612">
                  <c:v>2019</c:v>
                </c:pt>
                <c:pt idx="613">
                  <c:v>2089</c:v>
                </c:pt>
                <c:pt idx="614">
                  <c:v>2031</c:v>
                </c:pt>
                <c:pt idx="615">
                  <c:v>1519</c:v>
                </c:pt>
                <c:pt idx="616">
                  <c:v>497</c:v>
                </c:pt>
                <c:pt idx="617">
                  <c:v>1452</c:v>
                </c:pt>
                <c:pt idx="618">
                  <c:v>795</c:v>
                </c:pt>
                <c:pt idx="619">
                  <c:v>2078</c:v>
                </c:pt>
                <c:pt idx="620">
                  <c:v>1734</c:v>
                </c:pt>
                <c:pt idx="621">
                  <c:v>1528</c:v>
                </c:pt>
                <c:pt idx="622">
                  <c:v>578</c:v>
                </c:pt>
                <c:pt idx="623">
                  <c:v>1072</c:v>
                </c:pt>
                <c:pt idx="624">
                  <c:v>1132</c:v>
                </c:pt>
                <c:pt idx="625">
                  <c:v>1813</c:v>
                </c:pt>
                <c:pt idx="626">
                  <c:v>373</c:v>
                </c:pt>
                <c:pt idx="627">
                  <c:v>1920</c:v>
                </c:pt>
                <c:pt idx="628">
                  <c:v>1390</c:v>
                </c:pt>
                <c:pt idx="629">
                  <c:v>1405</c:v>
                </c:pt>
                <c:pt idx="630">
                  <c:v>1122</c:v>
                </c:pt>
                <c:pt idx="631">
                  <c:v>1865</c:v>
                </c:pt>
                <c:pt idx="632">
                  <c:v>1432</c:v>
                </c:pt>
                <c:pt idx="633">
                  <c:v>1593</c:v>
                </c:pt>
                <c:pt idx="634">
                  <c:v>544</c:v>
                </c:pt>
                <c:pt idx="635">
                  <c:v>1787</c:v>
                </c:pt>
                <c:pt idx="636">
                  <c:v>2166</c:v>
                </c:pt>
                <c:pt idx="637">
                  <c:v>1409</c:v>
                </c:pt>
                <c:pt idx="638">
                  <c:v>1500</c:v>
                </c:pt>
                <c:pt idx="639">
                  <c:v>452</c:v>
                </c:pt>
                <c:pt idx="640">
                  <c:v>1358</c:v>
                </c:pt>
                <c:pt idx="641">
                  <c:v>2007</c:v>
                </c:pt>
                <c:pt idx="642">
                  <c:v>736</c:v>
                </c:pt>
                <c:pt idx="643">
                  <c:v>540</c:v>
                </c:pt>
                <c:pt idx="644">
                  <c:v>902</c:v>
                </c:pt>
                <c:pt idx="645">
                  <c:v>542</c:v>
                </c:pt>
                <c:pt idx="646">
                  <c:v>1387</c:v>
                </c:pt>
                <c:pt idx="647">
                  <c:v>761</c:v>
                </c:pt>
                <c:pt idx="648">
                  <c:v>1866</c:v>
                </c:pt>
                <c:pt idx="649">
                  <c:v>1797</c:v>
                </c:pt>
                <c:pt idx="650">
                  <c:v>1565</c:v>
                </c:pt>
                <c:pt idx="651">
                  <c:v>1791</c:v>
                </c:pt>
                <c:pt idx="652">
                  <c:v>1944</c:v>
                </c:pt>
                <c:pt idx="653">
                  <c:v>856</c:v>
                </c:pt>
                <c:pt idx="654">
                  <c:v>2049</c:v>
                </c:pt>
                <c:pt idx="655">
                  <c:v>1769</c:v>
                </c:pt>
                <c:pt idx="656">
                  <c:v>1856</c:v>
                </c:pt>
                <c:pt idx="657">
                  <c:v>1117</c:v>
                </c:pt>
                <c:pt idx="658">
                  <c:v>1121</c:v>
                </c:pt>
                <c:pt idx="659">
                  <c:v>1970</c:v>
                </c:pt>
                <c:pt idx="660">
                  <c:v>2025</c:v>
                </c:pt>
                <c:pt idx="661">
                  <c:v>1312</c:v>
                </c:pt>
                <c:pt idx="662">
                  <c:v>2069</c:v>
                </c:pt>
                <c:pt idx="663">
                  <c:v>1068</c:v>
                </c:pt>
                <c:pt idx="664">
                  <c:v>2062</c:v>
                </c:pt>
                <c:pt idx="665">
                  <c:v>1400</c:v>
                </c:pt>
                <c:pt idx="666">
                  <c:v>2162</c:v>
                </c:pt>
                <c:pt idx="667">
                  <c:v>820</c:v>
                </c:pt>
                <c:pt idx="668">
                  <c:v>1214</c:v>
                </c:pt>
                <c:pt idx="669">
                  <c:v>1357</c:v>
                </c:pt>
                <c:pt idx="670">
                  <c:v>792</c:v>
                </c:pt>
                <c:pt idx="671">
                  <c:v>2093</c:v>
                </c:pt>
                <c:pt idx="672">
                  <c:v>2124</c:v>
                </c:pt>
                <c:pt idx="673">
                  <c:v>1822</c:v>
                </c:pt>
                <c:pt idx="674">
                  <c:v>1264</c:v>
                </c:pt>
                <c:pt idx="675">
                  <c:v>1234</c:v>
                </c:pt>
                <c:pt idx="676">
                  <c:v>1907</c:v>
                </c:pt>
                <c:pt idx="677">
                  <c:v>1710</c:v>
                </c:pt>
                <c:pt idx="678">
                  <c:v>1170</c:v>
                </c:pt>
                <c:pt idx="679">
                  <c:v>1603</c:v>
                </c:pt>
                <c:pt idx="680">
                  <c:v>1335</c:v>
                </c:pt>
                <c:pt idx="681">
                  <c:v>1722</c:v>
                </c:pt>
                <c:pt idx="682">
                  <c:v>1080</c:v>
                </c:pt>
                <c:pt idx="683">
                  <c:v>759</c:v>
                </c:pt>
                <c:pt idx="684">
                  <c:v>1931</c:v>
                </c:pt>
                <c:pt idx="685">
                  <c:v>1008</c:v>
                </c:pt>
                <c:pt idx="686">
                  <c:v>774</c:v>
                </c:pt>
                <c:pt idx="687">
                  <c:v>1857</c:v>
                </c:pt>
                <c:pt idx="688">
                  <c:v>1653</c:v>
                </c:pt>
                <c:pt idx="689">
                  <c:v>1675</c:v>
                </c:pt>
                <c:pt idx="690">
                  <c:v>1945</c:v>
                </c:pt>
                <c:pt idx="691">
                  <c:v>1870</c:v>
                </c:pt>
                <c:pt idx="692">
                  <c:v>1466</c:v>
                </c:pt>
                <c:pt idx="693">
                  <c:v>956</c:v>
                </c:pt>
                <c:pt idx="694">
                  <c:v>2180</c:v>
                </c:pt>
                <c:pt idx="695">
                  <c:v>1703</c:v>
                </c:pt>
                <c:pt idx="696">
                  <c:v>1325</c:v>
                </c:pt>
                <c:pt idx="697">
                  <c:v>1755</c:v>
                </c:pt>
                <c:pt idx="698">
                  <c:v>1792</c:v>
                </c:pt>
                <c:pt idx="699">
                  <c:v>901</c:v>
                </c:pt>
                <c:pt idx="700">
                  <c:v>2024</c:v>
                </c:pt>
                <c:pt idx="701">
                  <c:v>2086</c:v>
                </c:pt>
                <c:pt idx="702">
                  <c:v>882</c:v>
                </c:pt>
                <c:pt idx="703">
                  <c:v>959</c:v>
                </c:pt>
                <c:pt idx="704">
                  <c:v>857</c:v>
                </c:pt>
                <c:pt idx="705">
                  <c:v>1066</c:v>
                </c:pt>
                <c:pt idx="706">
                  <c:v>1143</c:v>
                </c:pt>
                <c:pt idx="707">
                  <c:v>1585</c:v>
                </c:pt>
                <c:pt idx="708">
                  <c:v>898</c:v>
                </c:pt>
                <c:pt idx="709">
                  <c:v>1808</c:v>
                </c:pt>
                <c:pt idx="710">
                  <c:v>1832</c:v>
                </c:pt>
                <c:pt idx="711">
                  <c:v>1742</c:v>
                </c:pt>
                <c:pt idx="712">
                  <c:v>2094</c:v>
                </c:pt>
                <c:pt idx="713">
                  <c:v>1888</c:v>
                </c:pt>
                <c:pt idx="714">
                  <c:v>453</c:v>
                </c:pt>
                <c:pt idx="715">
                  <c:v>2090</c:v>
                </c:pt>
                <c:pt idx="716">
                  <c:v>2003</c:v>
                </c:pt>
                <c:pt idx="717">
                  <c:v>969</c:v>
                </c:pt>
                <c:pt idx="718">
                  <c:v>1189</c:v>
                </c:pt>
                <c:pt idx="719">
                  <c:v>631</c:v>
                </c:pt>
                <c:pt idx="720">
                  <c:v>1074</c:v>
                </c:pt>
                <c:pt idx="721">
                  <c:v>2011</c:v>
                </c:pt>
                <c:pt idx="722">
                  <c:v>994</c:v>
                </c:pt>
                <c:pt idx="723">
                  <c:v>1295</c:v>
                </c:pt>
                <c:pt idx="724">
                  <c:v>1368</c:v>
                </c:pt>
                <c:pt idx="725">
                  <c:v>1895</c:v>
                </c:pt>
                <c:pt idx="726">
                  <c:v>1488</c:v>
                </c:pt>
                <c:pt idx="727">
                  <c:v>783</c:v>
                </c:pt>
                <c:pt idx="728">
                  <c:v>1749</c:v>
                </c:pt>
                <c:pt idx="729">
                  <c:v>2043</c:v>
                </c:pt>
                <c:pt idx="730">
                  <c:v>723</c:v>
                </c:pt>
                <c:pt idx="731">
                  <c:v>1777</c:v>
                </c:pt>
                <c:pt idx="732">
                  <c:v>510</c:v>
                </c:pt>
                <c:pt idx="733">
                  <c:v>2088</c:v>
                </c:pt>
                <c:pt idx="734">
                  <c:v>1346</c:v>
                </c:pt>
                <c:pt idx="735">
                  <c:v>822</c:v>
                </c:pt>
                <c:pt idx="736">
                  <c:v>1304</c:v>
                </c:pt>
                <c:pt idx="737">
                  <c:v>563</c:v>
                </c:pt>
                <c:pt idx="738">
                  <c:v>1078</c:v>
                </c:pt>
                <c:pt idx="739">
                  <c:v>1995</c:v>
                </c:pt>
                <c:pt idx="740">
                  <c:v>1636</c:v>
                </c:pt>
                <c:pt idx="741">
                  <c:v>936</c:v>
                </c:pt>
                <c:pt idx="742">
                  <c:v>2063</c:v>
                </c:pt>
                <c:pt idx="743">
                  <c:v>1770</c:v>
                </c:pt>
                <c:pt idx="744">
                  <c:v>1556</c:v>
                </c:pt>
                <c:pt idx="745">
                  <c:v>2064</c:v>
                </c:pt>
                <c:pt idx="746">
                  <c:v>1989</c:v>
                </c:pt>
                <c:pt idx="747">
                  <c:v>1604</c:v>
                </c:pt>
                <c:pt idx="748">
                  <c:v>1236</c:v>
                </c:pt>
                <c:pt idx="749">
                  <c:v>518</c:v>
                </c:pt>
                <c:pt idx="750">
                  <c:v>2132</c:v>
                </c:pt>
                <c:pt idx="751">
                  <c:v>839</c:v>
                </c:pt>
                <c:pt idx="752">
                  <c:v>2137</c:v>
                </c:pt>
                <c:pt idx="753">
                  <c:v>1697</c:v>
                </c:pt>
                <c:pt idx="754">
                  <c:v>1580</c:v>
                </c:pt>
                <c:pt idx="755">
                  <c:v>1578</c:v>
                </c:pt>
                <c:pt idx="756">
                  <c:v>2082</c:v>
                </c:pt>
                <c:pt idx="757">
                  <c:v>1853</c:v>
                </c:pt>
                <c:pt idx="758">
                  <c:v>1064</c:v>
                </c:pt>
                <c:pt idx="759">
                  <c:v>1994</c:v>
                </c:pt>
                <c:pt idx="760">
                  <c:v>2168</c:v>
                </c:pt>
                <c:pt idx="761">
                  <c:v>2057</c:v>
                </c:pt>
                <c:pt idx="762">
                  <c:v>1854</c:v>
                </c:pt>
                <c:pt idx="763">
                  <c:v>1104</c:v>
                </c:pt>
                <c:pt idx="764">
                  <c:v>785</c:v>
                </c:pt>
                <c:pt idx="765">
                  <c:v>1719</c:v>
                </c:pt>
                <c:pt idx="766">
                  <c:v>1708</c:v>
                </c:pt>
                <c:pt idx="767">
                  <c:v>1600</c:v>
                </c:pt>
                <c:pt idx="768">
                  <c:v>2037</c:v>
                </c:pt>
                <c:pt idx="769">
                  <c:v>1840</c:v>
                </c:pt>
                <c:pt idx="770">
                  <c:v>963</c:v>
                </c:pt>
                <c:pt idx="771">
                  <c:v>891</c:v>
                </c:pt>
                <c:pt idx="772">
                  <c:v>1149</c:v>
                </c:pt>
                <c:pt idx="773">
                  <c:v>1375</c:v>
                </c:pt>
                <c:pt idx="774">
                  <c:v>1993</c:v>
                </c:pt>
                <c:pt idx="775">
                  <c:v>1506</c:v>
                </c:pt>
                <c:pt idx="776">
                  <c:v>1886</c:v>
                </c:pt>
                <c:pt idx="777">
                  <c:v>1373</c:v>
                </c:pt>
                <c:pt idx="778">
                  <c:v>865</c:v>
                </c:pt>
                <c:pt idx="779">
                  <c:v>1023</c:v>
                </c:pt>
                <c:pt idx="780">
                  <c:v>1819</c:v>
                </c:pt>
                <c:pt idx="781">
                  <c:v>987</c:v>
                </c:pt>
                <c:pt idx="782">
                  <c:v>1253</c:v>
                </c:pt>
                <c:pt idx="783">
                  <c:v>1545</c:v>
                </c:pt>
                <c:pt idx="784">
                  <c:v>1577</c:v>
                </c:pt>
                <c:pt idx="785">
                  <c:v>1863</c:v>
                </c:pt>
                <c:pt idx="786">
                  <c:v>1731</c:v>
                </c:pt>
                <c:pt idx="787">
                  <c:v>1331</c:v>
                </c:pt>
                <c:pt idx="788">
                  <c:v>1752</c:v>
                </c:pt>
                <c:pt idx="789">
                  <c:v>1572</c:v>
                </c:pt>
                <c:pt idx="790">
                  <c:v>1851</c:v>
                </c:pt>
                <c:pt idx="791">
                  <c:v>1560</c:v>
                </c:pt>
                <c:pt idx="792">
                  <c:v>1725</c:v>
                </c:pt>
                <c:pt idx="793">
                  <c:v>1833</c:v>
                </c:pt>
                <c:pt idx="794">
                  <c:v>2159</c:v>
                </c:pt>
                <c:pt idx="795">
                  <c:v>2038</c:v>
                </c:pt>
                <c:pt idx="796">
                  <c:v>1978</c:v>
                </c:pt>
                <c:pt idx="797">
                  <c:v>305</c:v>
                </c:pt>
                <c:pt idx="798">
                  <c:v>1134</c:v>
                </c:pt>
                <c:pt idx="799">
                  <c:v>1960</c:v>
                </c:pt>
                <c:pt idx="800">
                  <c:v>1017</c:v>
                </c:pt>
                <c:pt idx="801">
                  <c:v>1951</c:v>
                </c:pt>
                <c:pt idx="802">
                  <c:v>2054</c:v>
                </c:pt>
                <c:pt idx="803">
                  <c:v>1547</c:v>
                </c:pt>
                <c:pt idx="804">
                  <c:v>1805</c:v>
                </c:pt>
                <c:pt idx="805">
                  <c:v>539</c:v>
                </c:pt>
                <c:pt idx="806">
                  <c:v>1477</c:v>
                </c:pt>
                <c:pt idx="807">
                  <c:v>1323</c:v>
                </c:pt>
                <c:pt idx="808">
                  <c:v>1413</c:v>
                </c:pt>
                <c:pt idx="809">
                  <c:v>1804</c:v>
                </c:pt>
                <c:pt idx="810">
                  <c:v>1316</c:v>
                </c:pt>
                <c:pt idx="811">
                  <c:v>1563</c:v>
                </c:pt>
                <c:pt idx="812">
                  <c:v>1835</c:v>
                </c:pt>
                <c:pt idx="813">
                  <c:v>1901</c:v>
                </c:pt>
                <c:pt idx="814">
                  <c:v>1845</c:v>
                </c:pt>
                <c:pt idx="815">
                  <c:v>1828</c:v>
                </c:pt>
                <c:pt idx="816">
                  <c:v>1579</c:v>
                </c:pt>
                <c:pt idx="817">
                  <c:v>1486</c:v>
                </c:pt>
                <c:pt idx="818">
                  <c:v>2170</c:v>
                </c:pt>
                <c:pt idx="819">
                  <c:v>2055</c:v>
                </c:pt>
                <c:pt idx="820">
                  <c:v>1809</c:v>
                </c:pt>
                <c:pt idx="821">
                  <c:v>1029</c:v>
                </c:pt>
                <c:pt idx="822">
                  <c:v>1967</c:v>
                </c:pt>
                <c:pt idx="823">
                  <c:v>1897</c:v>
                </c:pt>
                <c:pt idx="824">
                  <c:v>1750</c:v>
                </c:pt>
                <c:pt idx="825">
                  <c:v>585</c:v>
                </c:pt>
                <c:pt idx="826">
                  <c:v>1676</c:v>
                </c:pt>
                <c:pt idx="827">
                  <c:v>770</c:v>
                </c:pt>
                <c:pt idx="828">
                  <c:v>1952</c:v>
                </c:pt>
                <c:pt idx="829">
                  <c:v>1772</c:v>
                </c:pt>
                <c:pt idx="830">
                  <c:v>1154</c:v>
                </c:pt>
                <c:pt idx="831">
                  <c:v>374</c:v>
                </c:pt>
                <c:pt idx="832">
                  <c:v>478</c:v>
                </c:pt>
                <c:pt idx="833">
                  <c:v>571</c:v>
                </c:pt>
                <c:pt idx="834">
                  <c:v>1036</c:v>
                </c:pt>
                <c:pt idx="835">
                  <c:v>2179</c:v>
                </c:pt>
                <c:pt idx="836">
                  <c:v>1366</c:v>
                </c:pt>
                <c:pt idx="837">
                  <c:v>1794</c:v>
                </c:pt>
                <c:pt idx="838">
                  <c:v>1884</c:v>
                </c:pt>
                <c:pt idx="839">
                  <c:v>1382</c:v>
                </c:pt>
                <c:pt idx="840">
                  <c:v>1598</c:v>
                </c:pt>
                <c:pt idx="841">
                  <c:v>819</c:v>
                </c:pt>
                <c:pt idx="842">
                  <c:v>1918</c:v>
                </c:pt>
                <c:pt idx="843">
                  <c:v>2068</c:v>
                </c:pt>
                <c:pt idx="844">
                  <c:v>1141</c:v>
                </c:pt>
                <c:pt idx="845">
                  <c:v>1830</c:v>
                </c:pt>
                <c:pt idx="846">
                  <c:v>2029</c:v>
                </c:pt>
                <c:pt idx="847">
                  <c:v>1628</c:v>
                </c:pt>
                <c:pt idx="848">
                  <c:v>1530</c:v>
                </c:pt>
                <c:pt idx="849">
                  <c:v>1699</c:v>
                </c:pt>
                <c:pt idx="850">
                  <c:v>1558</c:v>
                </c:pt>
                <c:pt idx="851">
                  <c:v>1860</c:v>
                </c:pt>
                <c:pt idx="852">
                  <c:v>1516</c:v>
                </c:pt>
                <c:pt idx="853">
                  <c:v>2087</c:v>
                </c:pt>
                <c:pt idx="854">
                  <c:v>1151</c:v>
                </c:pt>
                <c:pt idx="855">
                  <c:v>1259</c:v>
                </c:pt>
                <c:pt idx="856">
                  <c:v>2052</c:v>
                </c:pt>
                <c:pt idx="857">
                  <c:v>2096</c:v>
                </c:pt>
                <c:pt idx="858">
                  <c:v>1879</c:v>
                </c:pt>
                <c:pt idx="859">
                  <c:v>1350</c:v>
                </c:pt>
                <c:pt idx="860">
                  <c:v>2027</c:v>
                </c:pt>
                <c:pt idx="861">
                  <c:v>455</c:v>
                </c:pt>
                <c:pt idx="862">
                  <c:v>1914</c:v>
                </c:pt>
                <c:pt idx="863">
                  <c:v>594</c:v>
                </c:pt>
                <c:pt idx="864">
                  <c:v>2143</c:v>
                </c:pt>
                <c:pt idx="865">
                  <c:v>1069</c:v>
                </c:pt>
                <c:pt idx="866">
                  <c:v>1938</c:v>
                </c:pt>
                <c:pt idx="867">
                  <c:v>1969</c:v>
                </c:pt>
                <c:pt idx="868">
                  <c:v>1974</c:v>
                </c:pt>
              </c:numCache>
            </c:numRef>
          </c:xVal>
          <c:yVal>
            <c:numRef>
              <c:f>'Brachy LCR'!$C$4:$C$872</c:f>
              <c:numCache>
                <c:formatCode>General</c:formatCode>
                <c:ptCount val="869"/>
                <c:pt idx="0">
                  <c:v>1</c:v>
                </c:pt>
                <c:pt idx="1">
                  <c:v>1</c:v>
                </c:pt>
                <c:pt idx="2">
                  <c:v>1</c:v>
                </c:pt>
                <c:pt idx="4">
                  <c:v>1</c:v>
                </c:pt>
                <c:pt idx="5">
                  <c:v>1</c:v>
                </c:pt>
                <c:pt idx="6">
                  <c:v>1</c:v>
                </c:pt>
                <c:pt idx="7">
                  <c:v>1</c:v>
                </c:pt>
                <c:pt idx="8">
                  <c:v>1</c:v>
                </c:pt>
                <c:pt idx="9">
                  <c:v>1</c:v>
                </c:pt>
                <c:pt idx="10">
                  <c:v>1</c:v>
                </c:pt>
                <c:pt idx="13">
                  <c:v>1</c:v>
                </c:pt>
                <c:pt idx="15">
                  <c:v>13</c:v>
                </c:pt>
                <c:pt idx="16">
                  <c:v>1</c:v>
                </c:pt>
                <c:pt idx="17">
                  <c:v>1</c:v>
                </c:pt>
                <c:pt idx="20">
                  <c:v>1</c:v>
                </c:pt>
                <c:pt idx="21">
                  <c:v>1</c:v>
                </c:pt>
                <c:pt idx="22">
                  <c:v>1</c:v>
                </c:pt>
                <c:pt idx="26">
                  <c:v>1</c:v>
                </c:pt>
                <c:pt idx="27">
                  <c:v>1</c:v>
                </c:pt>
                <c:pt idx="30">
                  <c:v>1</c:v>
                </c:pt>
                <c:pt idx="32">
                  <c:v>2</c:v>
                </c:pt>
                <c:pt idx="34">
                  <c:v>1</c:v>
                </c:pt>
                <c:pt idx="36">
                  <c:v>1</c:v>
                </c:pt>
                <c:pt idx="37">
                  <c:v>4</c:v>
                </c:pt>
                <c:pt idx="38">
                  <c:v>1</c:v>
                </c:pt>
                <c:pt idx="39">
                  <c:v>1</c:v>
                </c:pt>
                <c:pt idx="41">
                  <c:v>1</c:v>
                </c:pt>
                <c:pt idx="42">
                  <c:v>1</c:v>
                </c:pt>
                <c:pt idx="43">
                  <c:v>1</c:v>
                </c:pt>
                <c:pt idx="46">
                  <c:v>1</c:v>
                </c:pt>
                <c:pt idx="47">
                  <c:v>1</c:v>
                </c:pt>
                <c:pt idx="48">
                  <c:v>1</c:v>
                </c:pt>
                <c:pt idx="50">
                  <c:v>1</c:v>
                </c:pt>
                <c:pt idx="51">
                  <c:v>1</c:v>
                </c:pt>
                <c:pt idx="52">
                  <c:v>1</c:v>
                </c:pt>
                <c:pt idx="53">
                  <c:v>1</c:v>
                </c:pt>
                <c:pt idx="55">
                  <c:v>1</c:v>
                </c:pt>
                <c:pt idx="57">
                  <c:v>1</c:v>
                </c:pt>
                <c:pt idx="59">
                  <c:v>1</c:v>
                </c:pt>
                <c:pt idx="60">
                  <c:v>1</c:v>
                </c:pt>
                <c:pt idx="61">
                  <c:v>1</c:v>
                </c:pt>
                <c:pt idx="62">
                  <c:v>1</c:v>
                </c:pt>
                <c:pt idx="63">
                  <c:v>1</c:v>
                </c:pt>
                <c:pt idx="64">
                  <c:v>1</c:v>
                </c:pt>
                <c:pt idx="65">
                  <c:v>1</c:v>
                </c:pt>
                <c:pt idx="66">
                  <c:v>1</c:v>
                </c:pt>
                <c:pt idx="67">
                  <c:v>1</c:v>
                </c:pt>
                <c:pt idx="69">
                  <c:v>1</c:v>
                </c:pt>
                <c:pt idx="70">
                  <c:v>4</c:v>
                </c:pt>
                <c:pt idx="71">
                  <c:v>1</c:v>
                </c:pt>
                <c:pt idx="73">
                  <c:v>1</c:v>
                </c:pt>
                <c:pt idx="74">
                  <c:v>1</c:v>
                </c:pt>
                <c:pt idx="75">
                  <c:v>1</c:v>
                </c:pt>
                <c:pt idx="77">
                  <c:v>1</c:v>
                </c:pt>
                <c:pt idx="78">
                  <c:v>1</c:v>
                </c:pt>
                <c:pt idx="80">
                  <c:v>1</c:v>
                </c:pt>
                <c:pt idx="82">
                  <c:v>1</c:v>
                </c:pt>
                <c:pt idx="83">
                  <c:v>1</c:v>
                </c:pt>
                <c:pt idx="84">
                  <c:v>1</c:v>
                </c:pt>
                <c:pt idx="85">
                  <c:v>1</c:v>
                </c:pt>
                <c:pt idx="86">
                  <c:v>1</c:v>
                </c:pt>
                <c:pt idx="87">
                  <c:v>2</c:v>
                </c:pt>
                <c:pt idx="94">
                  <c:v>1</c:v>
                </c:pt>
                <c:pt idx="95">
                  <c:v>1</c:v>
                </c:pt>
                <c:pt idx="96">
                  <c:v>1</c:v>
                </c:pt>
                <c:pt idx="97">
                  <c:v>1</c:v>
                </c:pt>
                <c:pt idx="100">
                  <c:v>1</c:v>
                </c:pt>
                <c:pt idx="102">
                  <c:v>1</c:v>
                </c:pt>
                <c:pt idx="103">
                  <c:v>1</c:v>
                </c:pt>
                <c:pt idx="104">
                  <c:v>1</c:v>
                </c:pt>
                <c:pt idx="105">
                  <c:v>1</c:v>
                </c:pt>
                <c:pt idx="106">
                  <c:v>1</c:v>
                </c:pt>
                <c:pt idx="107">
                  <c:v>1</c:v>
                </c:pt>
                <c:pt idx="108">
                  <c:v>1</c:v>
                </c:pt>
                <c:pt idx="110">
                  <c:v>1</c:v>
                </c:pt>
                <c:pt idx="111">
                  <c:v>1</c:v>
                </c:pt>
                <c:pt idx="112">
                  <c:v>1</c:v>
                </c:pt>
                <c:pt idx="113">
                  <c:v>1</c:v>
                </c:pt>
                <c:pt idx="114">
                  <c:v>1</c:v>
                </c:pt>
                <c:pt idx="116">
                  <c:v>1</c:v>
                </c:pt>
                <c:pt idx="119">
                  <c:v>1</c:v>
                </c:pt>
                <c:pt idx="121">
                  <c:v>1</c:v>
                </c:pt>
                <c:pt idx="123">
                  <c:v>2</c:v>
                </c:pt>
                <c:pt idx="124">
                  <c:v>1</c:v>
                </c:pt>
                <c:pt idx="126">
                  <c:v>1</c:v>
                </c:pt>
                <c:pt idx="127">
                  <c:v>-1</c:v>
                </c:pt>
                <c:pt idx="130">
                  <c:v>1</c:v>
                </c:pt>
                <c:pt idx="131">
                  <c:v>1</c:v>
                </c:pt>
                <c:pt idx="132">
                  <c:v>1</c:v>
                </c:pt>
                <c:pt idx="133">
                  <c:v>1</c:v>
                </c:pt>
                <c:pt idx="134">
                  <c:v>1</c:v>
                </c:pt>
                <c:pt idx="135">
                  <c:v>1</c:v>
                </c:pt>
                <c:pt idx="136">
                  <c:v>1</c:v>
                </c:pt>
                <c:pt idx="139">
                  <c:v>1</c:v>
                </c:pt>
                <c:pt idx="140">
                  <c:v>1</c:v>
                </c:pt>
                <c:pt idx="141">
                  <c:v>1</c:v>
                </c:pt>
                <c:pt idx="142">
                  <c:v>1</c:v>
                </c:pt>
                <c:pt idx="143">
                  <c:v>1</c:v>
                </c:pt>
                <c:pt idx="145">
                  <c:v>1</c:v>
                </c:pt>
                <c:pt idx="148">
                  <c:v>1</c:v>
                </c:pt>
                <c:pt idx="150">
                  <c:v>1</c:v>
                </c:pt>
                <c:pt idx="151">
                  <c:v>1</c:v>
                </c:pt>
                <c:pt idx="152">
                  <c:v>1</c:v>
                </c:pt>
                <c:pt idx="155">
                  <c:v>1</c:v>
                </c:pt>
                <c:pt idx="157">
                  <c:v>1</c:v>
                </c:pt>
                <c:pt idx="158">
                  <c:v>1</c:v>
                </c:pt>
                <c:pt idx="159">
                  <c:v>1</c:v>
                </c:pt>
                <c:pt idx="160">
                  <c:v>-1</c:v>
                </c:pt>
                <c:pt idx="163">
                  <c:v>1</c:v>
                </c:pt>
                <c:pt idx="166">
                  <c:v>1</c:v>
                </c:pt>
                <c:pt idx="169">
                  <c:v>1</c:v>
                </c:pt>
                <c:pt idx="170">
                  <c:v>1</c:v>
                </c:pt>
                <c:pt idx="172">
                  <c:v>1</c:v>
                </c:pt>
                <c:pt idx="173">
                  <c:v>1</c:v>
                </c:pt>
                <c:pt idx="174">
                  <c:v>1</c:v>
                </c:pt>
                <c:pt idx="176">
                  <c:v>1</c:v>
                </c:pt>
                <c:pt idx="178">
                  <c:v>1</c:v>
                </c:pt>
                <c:pt idx="179">
                  <c:v>1</c:v>
                </c:pt>
                <c:pt idx="181">
                  <c:v>1</c:v>
                </c:pt>
                <c:pt idx="183">
                  <c:v>1</c:v>
                </c:pt>
                <c:pt idx="184">
                  <c:v>1</c:v>
                </c:pt>
                <c:pt idx="186">
                  <c:v>1</c:v>
                </c:pt>
                <c:pt idx="190">
                  <c:v>1</c:v>
                </c:pt>
                <c:pt idx="192">
                  <c:v>1</c:v>
                </c:pt>
                <c:pt idx="193">
                  <c:v>2</c:v>
                </c:pt>
                <c:pt idx="194">
                  <c:v>1</c:v>
                </c:pt>
                <c:pt idx="196">
                  <c:v>1</c:v>
                </c:pt>
                <c:pt idx="199">
                  <c:v>1</c:v>
                </c:pt>
                <c:pt idx="200">
                  <c:v>1</c:v>
                </c:pt>
                <c:pt idx="201">
                  <c:v>1</c:v>
                </c:pt>
                <c:pt idx="202">
                  <c:v>1</c:v>
                </c:pt>
                <c:pt idx="204">
                  <c:v>1</c:v>
                </c:pt>
                <c:pt idx="205">
                  <c:v>1</c:v>
                </c:pt>
                <c:pt idx="206">
                  <c:v>1</c:v>
                </c:pt>
                <c:pt idx="207">
                  <c:v>1</c:v>
                </c:pt>
                <c:pt idx="208">
                  <c:v>1</c:v>
                </c:pt>
                <c:pt idx="211">
                  <c:v>1</c:v>
                </c:pt>
                <c:pt idx="212">
                  <c:v>1</c:v>
                </c:pt>
                <c:pt idx="214">
                  <c:v>1</c:v>
                </c:pt>
                <c:pt idx="215">
                  <c:v>1</c:v>
                </c:pt>
                <c:pt idx="216">
                  <c:v>1</c:v>
                </c:pt>
                <c:pt idx="217">
                  <c:v>1</c:v>
                </c:pt>
                <c:pt idx="220">
                  <c:v>1</c:v>
                </c:pt>
                <c:pt idx="221">
                  <c:v>1</c:v>
                </c:pt>
                <c:pt idx="224">
                  <c:v>1</c:v>
                </c:pt>
                <c:pt idx="227">
                  <c:v>1</c:v>
                </c:pt>
                <c:pt idx="228">
                  <c:v>1</c:v>
                </c:pt>
                <c:pt idx="229">
                  <c:v>1</c:v>
                </c:pt>
                <c:pt idx="230">
                  <c:v>1</c:v>
                </c:pt>
                <c:pt idx="231">
                  <c:v>1</c:v>
                </c:pt>
                <c:pt idx="233">
                  <c:v>1</c:v>
                </c:pt>
                <c:pt idx="234">
                  <c:v>1</c:v>
                </c:pt>
                <c:pt idx="236">
                  <c:v>1</c:v>
                </c:pt>
                <c:pt idx="237">
                  <c:v>1</c:v>
                </c:pt>
                <c:pt idx="238">
                  <c:v>1</c:v>
                </c:pt>
                <c:pt idx="239">
                  <c:v>1</c:v>
                </c:pt>
                <c:pt idx="241">
                  <c:v>1</c:v>
                </c:pt>
                <c:pt idx="242">
                  <c:v>1</c:v>
                </c:pt>
                <c:pt idx="244">
                  <c:v>11</c:v>
                </c:pt>
                <c:pt idx="246">
                  <c:v>2</c:v>
                </c:pt>
                <c:pt idx="247">
                  <c:v>1</c:v>
                </c:pt>
                <c:pt idx="249">
                  <c:v>1</c:v>
                </c:pt>
                <c:pt idx="250">
                  <c:v>1</c:v>
                </c:pt>
                <c:pt idx="253">
                  <c:v>1</c:v>
                </c:pt>
                <c:pt idx="255">
                  <c:v>1</c:v>
                </c:pt>
                <c:pt idx="256">
                  <c:v>1</c:v>
                </c:pt>
                <c:pt idx="258">
                  <c:v>1</c:v>
                </c:pt>
                <c:pt idx="259">
                  <c:v>1</c:v>
                </c:pt>
                <c:pt idx="261">
                  <c:v>1</c:v>
                </c:pt>
                <c:pt idx="263">
                  <c:v>1</c:v>
                </c:pt>
                <c:pt idx="264">
                  <c:v>1</c:v>
                </c:pt>
                <c:pt idx="265">
                  <c:v>1</c:v>
                </c:pt>
                <c:pt idx="266">
                  <c:v>1</c:v>
                </c:pt>
                <c:pt idx="268">
                  <c:v>1</c:v>
                </c:pt>
                <c:pt idx="269">
                  <c:v>1</c:v>
                </c:pt>
                <c:pt idx="270">
                  <c:v>1</c:v>
                </c:pt>
                <c:pt idx="272">
                  <c:v>2</c:v>
                </c:pt>
                <c:pt idx="273">
                  <c:v>1</c:v>
                </c:pt>
                <c:pt idx="274">
                  <c:v>1</c:v>
                </c:pt>
                <c:pt idx="275">
                  <c:v>1</c:v>
                </c:pt>
                <c:pt idx="276">
                  <c:v>1</c:v>
                </c:pt>
                <c:pt idx="277">
                  <c:v>1</c:v>
                </c:pt>
                <c:pt idx="278">
                  <c:v>1</c:v>
                </c:pt>
                <c:pt idx="283">
                  <c:v>1</c:v>
                </c:pt>
                <c:pt idx="285">
                  <c:v>1</c:v>
                </c:pt>
                <c:pt idx="287">
                  <c:v>1</c:v>
                </c:pt>
                <c:pt idx="288">
                  <c:v>1</c:v>
                </c:pt>
                <c:pt idx="289">
                  <c:v>1</c:v>
                </c:pt>
                <c:pt idx="290">
                  <c:v>1</c:v>
                </c:pt>
                <c:pt idx="295">
                  <c:v>1</c:v>
                </c:pt>
                <c:pt idx="296">
                  <c:v>1</c:v>
                </c:pt>
                <c:pt idx="297">
                  <c:v>1</c:v>
                </c:pt>
                <c:pt idx="298">
                  <c:v>1</c:v>
                </c:pt>
                <c:pt idx="299">
                  <c:v>1</c:v>
                </c:pt>
                <c:pt idx="301">
                  <c:v>1</c:v>
                </c:pt>
                <c:pt idx="302">
                  <c:v>1</c:v>
                </c:pt>
                <c:pt idx="305">
                  <c:v>1</c:v>
                </c:pt>
                <c:pt idx="309">
                  <c:v>1</c:v>
                </c:pt>
                <c:pt idx="311">
                  <c:v>1</c:v>
                </c:pt>
                <c:pt idx="312">
                  <c:v>2</c:v>
                </c:pt>
                <c:pt idx="313">
                  <c:v>1</c:v>
                </c:pt>
                <c:pt idx="314">
                  <c:v>1</c:v>
                </c:pt>
                <c:pt idx="317">
                  <c:v>1</c:v>
                </c:pt>
                <c:pt idx="321">
                  <c:v>1</c:v>
                </c:pt>
                <c:pt idx="324">
                  <c:v>1</c:v>
                </c:pt>
                <c:pt idx="325">
                  <c:v>1</c:v>
                </c:pt>
                <c:pt idx="326">
                  <c:v>1</c:v>
                </c:pt>
                <c:pt idx="327">
                  <c:v>1</c:v>
                </c:pt>
                <c:pt idx="328">
                  <c:v>1</c:v>
                </c:pt>
                <c:pt idx="329">
                  <c:v>1</c:v>
                </c:pt>
                <c:pt idx="330">
                  <c:v>1</c:v>
                </c:pt>
                <c:pt idx="333">
                  <c:v>1</c:v>
                </c:pt>
                <c:pt idx="334">
                  <c:v>1</c:v>
                </c:pt>
                <c:pt idx="335">
                  <c:v>1</c:v>
                </c:pt>
                <c:pt idx="336">
                  <c:v>1</c:v>
                </c:pt>
                <c:pt idx="337">
                  <c:v>1</c:v>
                </c:pt>
                <c:pt idx="338">
                  <c:v>1</c:v>
                </c:pt>
                <c:pt idx="339">
                  <c:v>1</c:v>
                </c:pt>
                <c:pt idx="340">
                  <c:v>3</c:v>
                </c:pt>
                <c:pt idx="343">
                  <c:v>1</c:v>
                </c:pt>
                <c:pt idx="345">
                  <c:v>1</c:v>
                </c:pt>
                <c:pt idx="346">
                  <c:v>1</c:v>
                </c:pt>
                <c:pt idx="348">
                  <c:v>1</c:v>
                </c:pt>
                <c:pt idx="351">
                  <c:v>1</c:v>
                </c:pt>
                <c:pt idx="353">
                  <c:v>1</c:v>
                </c:pt>
                <c:pt idx="354">
                  <c:v>1</c:v>
                </c:pt>
                <c:pt idx="359">
                  <c:v>1</c:v>
                </c:pt>
                <c:pt idx="360">
                  <c:v>1</c:v>
                </c:pt>
                <c:pt idx="361">
                  <c:v>8</c:v>
                </c:pt>
                <c:pt idx="364">
                  <c:v>1</c:v>
                </c:pt>
                <c:pt idx="365">
                  <c:v>1</c:v>
                </c:pt>
                <c:pt idx="366">
                  <c:v>1</c:v>
                </c:pt>
                <c:pt idx="367">
                  <c:v>1</c:v>
                </c:pt>
                <c:pt idx="369">
                  <c:v>1</c:v>
                </c:pt>
                <c:pt idx="371">
                  <c:v>1</c:v>
                </c:pt>
                <c:pt idx="372">
                  <c:v>1</c:v>
                </c:pt>
                <c:pt idx="373">
                  <c:v>2</c:v>
                </c:pt>
                <c:pt idx="374">
                  <c:v>3</c:v>
                </c:pt>
                <c:pt idx="375">
                  <c:v>1</c:v>
                </c:pt>
                <c:pt idx="377">
                  <c:v>1</c:v>
                </c:pt>
                <c:pt idx="378">
                  <c:v>1</c:v>
                </c:pt>
                <c:pt idx="379">
                  <c:v>1</c:v>
                </c:pt>
                <c:pt idx="380">
                  <c:v>2</c:v>
                </c:pt>
                <c:pt idx="382">
                  <c:v>1</c:v>
                </c:pt>
                <c:pt idx="383">
                  <c:v>1</c:v>
                </c:pt>
                <c:pt idx="384">
                  <c:v>1</c:v>
                </c:pt>
                <c:pt idx="385">
                  <c:v>1</c:v>
                </c:pt>
                <c:pt idx="386">
                  <c:v>1</c:v>
                </c:pt>
                <c:pt idx="387">
                  <c:v>1</c:v>
                </c:pt>
                <c:pt idx="388">
                  <c:v>1</c:v>
                </c:pt>
                <c:pt idx="389">
                  <c:v>1</c:v>
                </c:pt>
                <c:pt idx="391">
                  <c:v>1</c:v>
                </c:pt>
                <c:pt idx="393">
                  <c:v>1</c:v>
                </c:pt>
                <c:pt idx="399">
                  <c:v>1</c:v>
                </c:pt>
                <c:pt idx="402">
                  <c:v>1</c:v>
                </c:pt>
                <c:pt idx="404">
                  <c:v>1</c:v>
                </c:pt>
                <c:pt idx="407">
                  <c:v>1</c:v>
                </c:pt>
                <c:pt idx="408">
                  <c:v>1</c:v>
                </c:pt>
                <c:pt idx="409">
                  <c:v>1</c:v>
                </c:pt>
                <c:pt idx="410">
                  <c:v>1</c:v>
                </c:pt>
                <c:pt idx="411">
                  <c:v>1</c:v>
                </c:pt>
                <c:pt idx="412">
                  <c:v>2</c:v>
                </c:pt>
                <c:pt idx="414">
                  <c:v>2</c:v>
                </c:pt>
                <c:pt idx="415">
                  <c:v>1</c:v>
                </c:pt>
                <c:pt idx="416">
                  <c:v>1</c:v>
                </c:pt>
                <c:pt idx="417">
                  <c:v>1</c:v>
                </c:pt>
                <c:pt idx="418">
                  <c:v>1</c:v>
                </c:pt>
                <c:pt idx="419">
                  <c:v>1</c:v>
                </c:pt>
                <c:pt idx="420">
                  <c:v>1</c:v>
                </c:pt>
                <c:pt idx="421">
                  <c:v>1</c:v>
                </c:pt>
                <c:pt idx="425">
                  <c:v>196</c:v>
                </c:pt>
                <c:pt idx="428">
                  <c:v>1</c:v>
                </c:pt>
                <c:pt idx="429">
                  <c:v>1</c:v>
                </c:pt>
                <c:pt idx="430">
                  <c:v>1</c:v>
                </c:pt>
                <c:pt idx="432">
                  <c:v>4</c:v>
                </c:pt>
                <c:pt idx="434">
                  <c:v>1</c:v>
                </c:pt>
                <c:pt idx="435">
                  <c:v>1</c:v>
                </c:pt>
                <c:pt idx="437">
                  <c:v>1</c:v>
                </c:pt>
                <c:pt idx="438">
                  <c:v>1</c:v>
                </c:pt>
                <c:pt idx="439">
                  <c:v>1</c:v>
                </c:pt>
                <c:pt idx="440">
                  <c:v>1</c:v>
                </c:pt>
                <c:pt idx="441">
                  <c:v>1</c:v>
                </c:pt>
                <c:pt idx="442">
                  <c:v>1</c:v>
                </c:pt>
                <c:pt idx="443">
                  <c:v>1</c:v>
                </c:pt>
                <c:pt idx="444">
                  <c:v>1</c:v>
                </c:pt>
                <c:pt idx="447">
                  <c:v>1</c:v>
                </c:pt>
                <c:pt idx="448">
                  <c:v>1</c:v>
                </c:pt>
                <c:pt idx="449">
                  <c:v>3</c:v>
                </c:pt>
                <c:pt idx="450">
                  <c:v>1</c:v>
                </c:pt>
                <c:pt idx="451">
                  <c:v>1</c:v>
                </c:pt>
                <c:pt idx="452">
                  <c:v>1</c:v>
                </c:pt>
                <c:pt idx="455">
                  <c:v>1</c:v>
                </c:pt>
                <c:pt idx="456">
                  <c:v>1</c:v>
                </c:pt>
                <c:pt idx="457">
                  <c:v>1</c:v>
                </c:pt>
                <c:pt idx="462">
                  <c:v>1</c:v>
                </c:pt>
                <c:pt idx="463">
                  <c:v>1</c:v>
                </c:pt>
                <c:pt idx="466">
                  <c:v>-1</c:v>
                </c:pt>
                <c:pt idx="467">
                  <c:v>1</c:v>
                </c:pt>
                <c:pt idx="468">
                  <c:v>1</c:v>
                </c:pt>
                <c:pt idx="470">
                  <c:v>1</c:v>
                </c:pt>
                <c:pt idx="471">
                  <c:v>1</c:v>
                </c:pt>
                <c:pt idx="472">
                  <c:v>1</c:v>
                </c:pt>
                <c:pt idx="475">
                  <c:v>1</c:v>
                </c:pt>
                <c:pt idx="477">
                  <c:v>1</c:v>
                </c:pt>
                <c:pt idx="480">
                  <c:v>1</c:v>
                </c:pt>
                <c:pt idx="481">
                  <c:v>1</c:v>
                </c:pt>
                <c:pt idx="482">
                  <c:v>1</c:v>
                </c:pt>
                <c:pt idx="483">
                  <c:v>1</c:v>
                </c:pt>
                <c:pt idx="484">
                  <c:v>1</c:v>
                </c:pt>
                <c:pt idx="485">
                  <c:v>4</c:v>
                </c:pt>
                <c:pt idx="488">
                  <c:v>1</c:v>
                </c:pt>
                <c:pt idx="489">
                  <c:v>1</c:v>
                </c:pt>
                <c:pt idx="490">
                  <c:v>1</c:v>
                </c:pt>
                <c:pt idx="492">
                  <c:v>1</c:v>
                </c:pt>
                <c:pt idx="493">
                  <c:v>1</c:v>
                </c:pt>
                <c:pt idx="495">
                  <c:v>1</c:v>
                </c:pt>
                <c:pt idx="497">
                  <c:v>1</c:v>
                </c:pt>
                <c:pt idx="498">
                  <c:v>1</c:v>
                </c:pt>
                <c:pt idx="499">
                  <c:v>7</c:v>
                </c:pt>
                <c:pt idx="501">
                  <c:v>1</c:v>
                </c:pt>
                <c:pt idx="507">
                  <c:v>2</c:v>
                </c:pt>
                <c:pt idx="509">
                  <c:v>1</c:v>
                </c:pt>
                <c:pt idx="510">
                  <c:v>1</c:v>
                </c:pt>
                <c:pt idx="511">
                  <c:v>1</c:v>
                </c:pt>
                <c:pt idx="512">
                  <c:v>1</c:v>
                </c:pt>
                <c:pt idx="516">
                  <c:v>1</c:v>
                </c:pt>
                <c:pt idx="520">
                  <c:v>1</c:v>
                </c:pt>
                <c:pt idx="523">
                  <c:v>1</c:v>
                </c:pt>
                <c:pt idx="525">
                  <c:v>1</c:v>
                </c:pt>
                <c:pt idx="526">
                  <c:v>6</c:v>
                </c:pt>
                <c:pt idx="527">
                  <c:v>1</c:v>
                </c:pt>
                <c:pt idx="528">
                  <c:v>3</c:v>
                </c:pt>
                <c:pt idx="529">
                  <c:v>1</c:v>
                </c:pt>
                <c:pt idx="531">
                  <c:v>1</c:v>
                </c:pt>
                <c:pt idx="533">
                  <c:v>1</c:v>
                </c:pt>
                <c:pt idx="534">
                  <c:v>1</c:v>
                </c:pt>
                <c:pt idx="538">
                  <c:v>1</c:v>
                </c:pt>
                <c:pt idx="539">
                  <c:v>1</c:v>
                </c:pt>
                <c:pt idx="540">
                  <c:v>1</c:v>
                </c:pt>
                <c:pt idx="543">
                  <c:v>1</c:v>
                </c:pt>
                <c:pt idx="544">
                  <c:v>1</c:v>
                </c:pt>
                <c:pt idx="545">
                  <c:v>2</c:v>
                </c:pt>
                <c:pt idx="549">
                  <c:v>1</c:v>
                </c:pt>
                <c:pt idx="550">
                  <c:v>1</c:v>
                </c:pt>
                <c:pt idx="555">
                  <c:v>1</c:v>
                </c:pt>
                <c:pt idx="557">
                  <c:v>1</c:v>
                </c:pt>
                <c:pt idx="558">
                  <c:v>1</c:v>
                </c:pt>
                <c:pt idx="561">
                  <c:v>1</c:v>
                </c:pt>
                <c:pt idx="562">
                  <c:v>1</c:v>
                </c:pt>
                <c:pt idx="564">
                  <c:v>1</c:v>
                </c:pt>
                <c:pt idx="565">
                  <c:v>1</c:v>
                </c:pt>
                <c:pt idx="566">
                  <c:v>1</c:v>
                </c:pt>
                <c:pt idx="567">
                  <c:v>1</c:v>
                </c:pt>
                <c:pt idx="568">
                  <c:v>1</c:v>
                </c:pt>
                <c:pt idx="570">
                  <c:v>1</c:v>
                </c:pt>
                <c:pt idx="572">
                  <c:v>1</c:v>
                </c:pt>
                <c:pt idx="573">
                  <c:v>1</c:v>
                </c:pt>
                <c:pt idx="575">
                  <c:v>1</c:v>
                </c:pt>
                <c:pt idx="578">
                  <c:v>1</c:v>
                </c:pt>
                <c:pt idx="579">
                  <c:v>1</c:v>
                </c:pt>
                <c:pt idx="580">
                  <c:v>8</c:v>
                </c:pt>
                <c:pt idx="581">
                  <c:v>1</c:v>
                </c:pt>
                <c:pt idx="584">
                  <c:v>1</c:v>
                </c:pt>
                <c:pt idx="586">
                  <c:v>1</c:v>
                </c:pt>
                <c:pt idx="591">
                  <c:v>2</c:v>
                </c:pt>
                <c:pt idx="593">
                  <c:v>1</c:v>
                </c:pt>
                <c:pt idx="594">
                  <c:v>1</c:v>
                </c:pt>
                <c:pt idx="596">
                  <c:v>1</c:v>
                </c:pt>
                <c:pt idx="597">
                  <c:v>1</c:v>
                </c:pt>
                <c:pt idx="599">
                  <c:v>1</c:v>
                </c:pt>
                <c:pt idx="601">
                  <c:v>1</c:v>
                </c:pt>
                <c:pt idx="603">
                  <c:v>1</c:v>
                </c:pt>
                <c:pt idx="608">
                  <c:v>1</c:v>
                </c:pt>
                <c:pt idx="610">
                  <c:v>1</c:v>
                </c:pt>
                <c:pt idx="611">
                  <c:v>1</c:v>
                </c:pt>
                <c:pt idx="612">
                  <c:v>1</c:v>
                </c:pt>
                <c:pt idx="613">
                  <c:v>10</c:v>
                </c:pt>
                <c:pt idx="614">
                  <c:v>1</c:v>
                </c:pt>
                <c:pt idx="615">
                  <c:v>1</c:v>
                </c:pt>
                <c:pt idx="618">
                  <c:v>1</c:v>
                </c:pt>
                <c:pt idx="619">
                  <c:v>1</c:v>
                </c:pt>
                <c:pt idx="620">
                  <c:v>1</c:v>
                </c:pt>
                <c:pt idx="621">
                  <c:v>1</c:v>
                </c:pt>
                <c:pt idx="622">
                  <c:v>1</c:v>
                </c:pt>
                <c:pt idx="625">
                  <c:v>1</c:v>
                </c:pt>
                <c:pt idx="630">
                  <c:v>1</c:v>
                </c:pt>
                <c:pt idx="631">
                  <c:v>1</c:v>
                </c:pt>
                <c:pt idx="632">
                  <c:v>1</c:v>
                </c:pt>
                <c:pt idx="633">
                  <c:v>1</c:v>
                </c:pt>
                <c:pt idx="634">
                  <c:v>1</c:v>
                </c:pt>
                <c:pt idx="635">
                  <c:v>1</c:v>
                </c:pt>
                <c:pt idx="636">
                  <c:v>1</c:v>
                </c:pt>
                <c:pt idx="637">
                  <c:v>1</c:v>
                </c:pt>
                <c:pt idx="638">
                  <c:v>1</c:v>
                </c:pt>
                <c:pt idx="640">
                  <c:v>1</c:v>
                </c:pt>
                <c:pt idx="641">
                  <c:v>1</c:v>
                </c:pt>
                <c:pt idx="642">
                  <c:v>1</c:v>
                </c:pt>
                <c:pt idx="643">
                  <c:v>1</c:v>
                </c:pt>
                <c:pt idx="645">
                  <c:v>1</c:v>
                </c:pt>
                <c:pt idx="646">
                  <c:v>1</c:v>
                </c:pt>
                <c:pt idx="649">
                  <c:v>1</c:v>
                </c:pt>
                <c:pt idx="651">
                  <c:v>1</c:v>
                </c:pt>
                <c:pt idx="652">
                  <c:v>1</c:v>
                </c:pt>
                <c:pt idx="654">
                  <c:v>1</c:v>
                </c:pt>
                <c:pt idx="655">
                  <c:v>1</c:v>
                </c:pt>
                <c:pt idx="656">
                  <c:v>1</c:v>
                </c:pt>
                <c:pt idx="657">
                  <c:v>1</c:v>
                </c:pt>
                <c:pt idx="658">
                  <c:v>1</c:v>
                </c:pt>
                <c:pt idx="659">
                  <c:v>1</c:v>
                </c:pt>
                <c:pt idx="660">
                  <c:v>1</c:v>
                </c:pt>
                <c:pt idx="662">
                  <c:v>2</c:v>
                </c:pt>
                <c:pt idx="664">
                  <c:v>1</c:v>
                </c:pt>
                <c:pt idx="665">
                  <c:v>1</c:v>
                </c:pt>
                <c:pt idx="666">
                  <c:v>1</c:v>
                </c:pt>
                <c:pt idx="669">
                  <c:v>1</c:v>
                </c:pt>
                <c:pt idx="671">
                  <c:v>1</c:v>
                </c:pt>
                <c:pt idx="672">
                  <c:v>1</c:v>
                </c:pt>
                <c:pt idx="673">
                  <c:v>1</c:v>
                </c:pt>
                <c:pt idx="676">
                  <c:v>1</c:v>
                </c:pt>
                <c:pt idx="678">
                  <c:v>1</c:v>
                </c:pt>
                <c:pt idx="682">
                  <c:v>1</c:v>
                </c:pt>
                <c:pt idx="683">
                  <c:v>1</c:v>
                </c:pt>
                <c:pt idx="684">
                  <c:v>1</c:v>
                </c:pt>
                <c:pt idx="686">
                  <c:v>1</c:v>
                </c:pt>
                <c:pt idx="687">
                  <c:v>1</c:v>
                </c:pt>
                <c:pt idx="689">
                  <c:v>1</c:v>
                </c:pt>
                <c:pt idx="692">
                  <c:v>1</c:v>
                </c:pt>
                <c:pt idx="695">
                  <c:v>1</c:v>
                </c:pt>
                <c:pt idx="697">
                  <c:v>1</c:v>
                </c:pt>
                <c:pt idx="698">
                  <c:v>1</c:v>
                </c:pt>
                <c:pt idx="700">
                  <c:v>1</c:v>
                </c:pt>
                <c:pt idx="701">
                  <c:v>17</c:v>
                </c:pt>
                <c:pt idx="704">
                  <c:v>1</c:v>
                </c:pt>
                <c:pt idx="705">
                  <c:v>1</c:v>
                </c:pt>
                <c:pt idx="709">
                  <c:v>1</c:v>
                </c:pt>
                <c:pt idx="710">
                  <c:v>1</c:v>
                </c:pt>
                <c:pt idx="712">
                  <c:v>1</c:v>
                </c:pt>
                <c:pt idx="713">
                  <c:v>1</c:v>
                </c:pt>
                <c:pt idx="715">
                  <c:v>4</c:v>
                </c:pt>
                <c:pt idx="716">
                  <c:v>1</c:v>
                </c:pt>
                <c:pt idx="720">
                  <c:v>1</c:v>
                </c:pt>
                <c:pt idx="721">
                  <c:v>1</c:v>
                </c:pt>
                <c:pt idx="725">
                  <c:v>1</c:v>
                </c:pt>
                <c:pt idx="726">
                  <c:v>-2</c:v>
                </c:pt>
                <c:pt idx="727">
                  <c:v>1</c:v>
                </c:pt>
                <c:pt idx="728">
                  <c:v>1</c:v>
                </c:pt>
                <c:pt idx="729">
                  <c:v>2</c:v>
                </c:pt>
                <c:pt idx="730">
                  <c:v>1</c:v>
                </c:pt>
                <c:pt idx="732">
                  <c:v>1</c:v>
                </c:pt>
                <c:pt idx="733">
                  <c:v>9</c:v>
                </c:pt>
                <c:pt idx="737">
                  <c:v>1</c:v>
                </c:pt>
                <c:pt idx="738">
                  <c:v>1</c:v>
                </c:pt>
                <c:pt idx="739">
                  <c:v>2</c:v>
                </c:pt>
                <c:pt idx="740">
                  <c:v>1</c:v>
                </c:pt>
                <c:pt idx="741">
                  <c:v>1</c:v>
                </c:pt>
                <c:pt idx="743">
                  <c:v>1</c:v>
                </c:pt>
                <c:pt idx="745">
                  <c:v>1</c:v>
                </c:pt>
                <c:pt idx="747">
                  <c:v>1</c:v>
                </c:pt>
                <c:pt idx="753">
                  <c:v>1</c:v>
                </c:pt>
                <c:pt idx="754">
                  <c:v>1</c:v>
                </c:pt>
                <c:pt idx="755">
                  <c:v>1</c:v>
                </c:pt>
                <c:pt idx="756">
                  <c:v>1</c:v>
                </c:pt>
                <c:pt idx="757">
                  <c:v>1</c:v>
                </c:pt>
                <c:pt idx="758">
                  <c:v>1</c:v>
                </c:pt>
                <c:pt idx="759">
                  <c:v>1</c:v>
                </c:pt>
                <c:pt idx="760">
                  <c:v>1</c:v>
                </c:pt>
                <c:pt idx="761">
                  <c:v>1</c:v>
                </c:pt>
                <c:pt idx="763">
                  <c:v>1</c:v>
                </c:pt>
                <c:pt idx="767">
                  <c:v>1</c:v>
                </c:pt>
                <c:pt idx="768">
                  <c:v>2</c:v>
                </c:pt>
                <c:pt idx="770">
                  <c:v>1</c:v>
                </c:pt>
                <c:pt idx="773">
                  <c:v>1</c:v>
                </c:pt>
                <c:pt idx="774">
                  <c:v>1</c:v>
                </c:pt>
                <c:pt idx="775">
                  <c:v>1</c:v>
                </c:pt>
                <c:pt idx="776">
                  <c:v>1</c:v>
                </c:pt>
                <c:pt idx="777">
                  <c:v>1</c:v>
                </c:pt>
                <c:pt idx="781">
                  <c:v>1</c:v>
                </c:pt>
                <c:pt idx="782">
                  <c:v>1</c:v>
                </c:pt>
                <c:pt idx="784">
                  <c:v>1</c:v>
                </c:pt>
                <c:pt idx="786">
                  <c:v>1</c:v>
                </c:pt>
                <c:pt idx="788">
                  <c:v>1</c:v>
                </c:pt>
                <c:pt idx="789">
                  <c:v>1</c:v>
                </c:pt>
                <c:pt idx="790">
                  <c:v>1</c:v>
                </c:pt>
                <c:pt idx="791">
                  <c:v>1</c:v>
                </c:pt>
                <c:pt idx="794">
                  <c:v>1</c:v>
                </c:pt>
                <c:pt idx="795">
                  <c:v>1</c:v>
                </c:pt>
                <c:pt idx="796">
                  <c:v>1</c:v>
                </c:pt>
                <c:pt idx="799">
                  <c:v>1</c:v>
                </c:pt>
                <c:pt idx="800">
                  <c:v>1</c:v>
                </c:pt>
                <c:pt idx="801">
                  <c:v>1</c:v>
                </c:pt>
                <c:pt idx="802">
                  <c:v>1</c:v>
                </c:pt>
                <c:pt idx="803">
                  <c:v>1</c:v>
                </c:pt>
                <c:pt idx="806">
                  <c:v>1</c:v>
                </c:pt>
                <c:pt idx="809">
                  <c:v>1</c:v>
                </c:pt>
                <c:pt idx="810">
                  <c:v>1</c:v>
                </c:pt>
                <c:pt idx="812">
                  <c:v>1</c:v>
                </c:pt>
                <c:pt idx="813">
                  <c:v>1</c:v>
                </c:pt>
                <c:pt idx="814">
                  <c:v>1</c:v>
                </c:pt>
                <c:pt idx="815">
                  <c:v>1</c:v>
                </c:pt>
                <c:pt idx="818">
                  <c:v>1</c:v>
                </c:pt>
                <c:pt idx="819">
                  <c:v>3</c:v>
                </c:pt>
                <c:pt idx="820">
                  <c:v>1</c:v>
                </c:pt>
                <c:pt idx="822">
                  <c:v>1</c:v>
                </c:pt>
                <c:pt idx="823">
                  <c:v>1</c:v>
                </c:pt>
                <c:pt idx="825">
                  <c:v>1</c:v>
                </c:pt>
                <c:pt idx="826">
                  <c:v>1</c:v>
                </c:pt>
                <c:pt idx="827">
                  <c:v>1</c:v>
                </c:pt>
                <c:pt idx="828">
                  <c:v>1</c:v>
                </c:pt>
                <c:pt idx="830">
                  <c:v>1</c:v>
                </c:pt>
                <c:pt idx="840">
                  <c:v>1</c:v>
                </c:pt>
                <c:pt idx="841">
                  <c:v>1</c:v>
                </c:pt>
                <c:pt idx="842">
                  <c:v>1</c:v>
                </c:pt>
                <c:pt idx="843">
                  <c:v>2</c:v>
                </c:pt>
                <c:pt idx="844">
                  <c:v>1</c:v>
                </c:pt>
                <c:pt idx="845">
                  <c:v>1</c:v>
                </c:pt>
                <c:pt idx="849">
                  <c:v>1</c:v>
                </c:pt>
                <c:pt idx="850">
                  <c:v>1</c:v>
                </c:pt>
                <c:pt idx="851">
                  <c:v>2</c:v>
                </c:pt>
                <c:pt idx="852">
                  <c:v>1</c:v>
                </c:pt>
                <c:pt idx="853">
                  <c:v>6</c:v>
                </c:pt>
                <c:pt idx="854">
                  <c:v>1</c:v>
                </c:pt>
                <c:pt idx="856">
                  <c:v>1</c:v>
                </c:pt>
                <c:pt idx="857">
                  <c:v>1</c:v>
                </c:pt>
                <c:pt idx="858">
                  <c:v>1</c:v>
                </c:pt>
                <c:pt idx="859">
                  <c:v>1</c:v>
                </c:pt>
                <c:pt idx="860">
                  <c:v>1</c:v>
                </c:pt>
                <c:pt idx="862">
                  <c:v>3</c:v>
                </c:pt>
                <c:pt idx="866">
                  <c:v>1</c:v>
                </c:pt>
                <c:pt idx="867">
                  <c:v>1</c:v>
                </c:pt>
              </c:numCache>
            </c:numRef>
          </c:yVal>
          <c:smooth val="0"/>
        </c:ser>
        <c:dLbls>
          <c:showLegendKey val="0"/>
          <c:showVal val="0"/>
          <c:showCatName val="0"/>
          <c:showSerName val="0"/>
          <c:showPercent val="0"/>
          <c:showBubbleSize val="0"/>
        </c:dLbls>
        <c:axId val="476426464"/>
        <c:axId val="476426856"/>
      </c:scatterChart>
      <c:valAx>
        <c:axId val="476426464"/>
        <c:scaling>
          <c:orientation val="minMax"/>
          <c:max val="2300"/>
          <c:min val="0"/>
        </c:scaling>
        <c:delete val="0"/>
        <c:axPos val="b"/>
        <c:title>
          <c:tx>
            <c:rich>
              <a:bodyPr/>
              <a:lstStyle/>
              <a:p>
                <a:pPr>
                  <a:defRPr sz="800"/>
                </a:pPr>
                <a:r>
                  <a:rPr lang="en-US" sz="800"/>
                  <a:t>cDNA Position</a:t>
                </a:r>
              </a:p>
            </c:rich>
          </c:tx>
          <c:layout/>
          <c:overlay val="0"/>
        </c:title>
        <c:numFmt formatCode="General" sourceLinked="1"/>
        <c:majorTickMark val="out"/>
        <c:minorTickMark val="none"/>
        <c:tickLblPos val="nextTo"/>
        <c:spPr>
          <a:ln>
            <a:solidFill>
              <a:schemeClr val="tx1"/>
            </a:solidFill>
          </a:ln>
        </c:spPr>
        <c:txPr>
          <a:bodyPr/>
          <a:lstStyle/>
          <a:p>
            <a:pPr>
              <a:defRPr sz="800"/>
            </a:pPr>
            <a:endParaRPr lang="en-US"/>
          </a:p>
        </c:txPr>
        <c:crossAx val="476426856"/>
        <c:crosses val="autoZero"/>
        <c:crossBetween val="midCat"/>
      </c:valAx>
      <c:valAx>
        <c:axId val="476426856"/>
        <c:scaling>
          <c:orientation val="minMax"/>
          <c:max val="250"/>
          <c:min val="0"/>
        </c:scaling>
        <c:delete val="0"/>
        <c:axPos val="l"/>
        <c:title>
          <c:tx>
            <c:rich>
              <a:bodyPr rot="-5400000" vert="horz"/>
              <a:lstStyle/>
              <a:p>
                <a:pPr>
                  <a:defRPr sz="800"/>
                </a:pPr>
                <a:r>
                  <a:rPr lang="en-US" sz="800"/>
                  <a:t>PARE Abundance (TP10M)</a:t>
                </a:r>
              </a:p>
            </c:rich>
          </c:tx>
          <c:layout/>
          <c:overlay val="0"/>
        </c:title>
        <c:numFmt formatCode="General" sourceLinked="1"/>
        <c:majorTickMark val="out"/>
        <c:minorTickMark val="none"/>
        <c:tickLblPos val="nextTo"/>
        <c:spPr>
          <a:ln>
            <a:solidFill>
              <a:schemeClr val="tx1"/>
            </a:solidFill>
          </a:ln>
        </c:spPr>
        <c:txPr>
          <a:bodyPr/>
          <a:lstStyle/>
          <a:p>
            <a:pPr>
              <a:defRPr sz="800"/>
            </a:pPr>
            <a:endParaRPr lang="en-US"/>
          </a:p>
        </c:txPr>
        <c:crossAx val="476426464"/>
        <c:crosses val="autoZero"/>
        <c:crossBetween val="midCat"/>
        <c:majorUnit val="30"/>
      </c:valAx>
    </c:plotArea>
    <c:plotVisOnly val="1"/>
    <c:dispBlanksAs val="gap"/>
    <c:showDLblsOverMax val="0"/>
  </c:chart>
  <c:spPr>
    <a:ln>
      <a:solidFill>
        <a:schemeClr val="tx1"/>
      </a:solidFill>
    </a:ln>
  </c:spPr>
  <c:externalData r:id="rId1">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layout/>
      <c:overlay val="0"/>
      <c:txPr>
        <a:bodyPr/>
        <a:lstStyle/>
        <a:p>
          <a:pPr>
            <a:defRPr sz="1200"/>
          </a:pPr>
          <a:endParaRPr lang="en-US"/>
        </a:p>
      </c:txPr>
    </c:title>
    <c:autoTitleDeleted val="0"/>
    <c:plotArea>
      <c:layout/>
      <c:scatterChart>
        <c:scatterStyle val="lineMarker"/>
        <c:varyColors val="0"/>
        <c:ser>
          <c:idx val="0"/>
          <c:order val="0"/>
          <c:tx>
            <c:v>Cold1</c:v>
          </c:tx>
          <c:spPr>
            <a:ln w="28575">
              <a:noFill/>
            </a:ln>
          </c:spPr>
          <c:marker>
            <c:symbol val="circle"/>
            <c:size val="5"/>
            <c:spPr>
              <a:solidFill>
                <a:srgbClr val="000000"/>
              </a:solidFill>
              <a:ln w="9525">
                <a:solidFill>
                  <a:srgbClr val="000000"/>
                </a:solidFill>
              </a:ln>
            </c:spPr>
          </c:marker>
          <c:dPt>
            <c:idx val="425"/>
            <c:marker>
              <c:spPr>
                <a:solidFill>
                  <a:srgbClr val="FF0000"/>
                </a:solidFill>
                <a:ln w="9525">
                  <a:solidFill>
                    <a:srgbClr val="FF0000"/>
                  </a:solidFill>
                </a:ln>
              </c:spPr>
            </c:marker>
            <c:bubble3D val="0"/>
          </c:dPt>
          <c:xVal>
            <c:numRef>
              <c:f>'Brachy LCR'!$B$4:$B$872</c:f>
              <c:numCache>
                <c:formatCode>General</c:formatCode>
                <c:ptCount val="869"/>
                <c:pt idx="0">
                  <c:v>1562</c:v>
                </c:pt>
                <c:pt idx="1">
                  <c:v>1348</c:v>
                </c:pt>
                <c:pt idx="2">
                  <c:v>1899</c:v>
                </c:pt>
                <c:pt idx="3">
                  <c:v>519</c:v>
                </c:pt>
                <c:pt idx="4">
                  <c:v>1707</c:v>
                </c:pt>
                <c:pt idx="5">
                  <c:v>1883</c:v>
                </c:pt>
                <c:pt idx="6">
                  <c:v>2047</c:v>
                </c:pt>
                <c:pt idx="7">
                  <c:v>1789</c:v>
                </c:pt>
                <c:pt idx="8">
                  <c:v>1963</c:v>
                </c:pt>
                <c:pt idx="9">
                  <c:v>1962</c:v>
                </c:pt>
                <c:pt idx="10">
                  <c:v>1909</c:v>
                </c:pt>
                <c:pt idx="11">
                  <c:v>648</c:v>
                </c:pt>
                <c:pt idx="12">
                  <c:v>1105</c:v>
                </c:pt>
                <c:pt idx="13">
                  <c:v>517</c:v>
                </c:pt>
                <c:pt idx="14">
                  <c:v>1469</c:v>
                </c:pt>
                <c:pt idx="15">
                  <c:v>2075</c:v>
                </c:pt>
                <c:pt idx="16">
                  <c:v>1484</c:v>
                </c:pt>
                <c:pt idx="17">
                  <c:v>727</c:v>
                </c:pt>
                <c:pt idx="18">
                  <c:v>1167</c:v>
                </c:pt>
                <c:pt idx="19">
                  <c:v>1184</c:v>
                </c:pt>
                <c:pt idx="20">
                  <c:v>1269</c:v>
                </c:pt>
                <c:pt idx="21">
                  <c:v>1613</c:v>
                </c:pt>
                <c:pt idx="22">
                  <c:v>2014</c:v>
                </c:pt>
                <c:pt idx="23">
                  <c:v>415</c:v>
                </c:pt>
                <c:pt idx="24">
                  <c:v>407</c:v>
                </c:pt>
                <c:pt idx="25">
                  <c:v>1512</c:v>
                </c:pt>
                <c:pt idx="26">
                  <c:v>1701</c:v>
                </c:pt>
                <c:pt idx="27">
                  <c:v>459</c:v>
                </c:pt>
                <c:pt idx="28">
                  <c:v>1100</c:v>
                </c:pt>
                <c:pt idx="29">
                  <c:v>584</c:v>
                </c:pt>
                <c:pt idx="30">
                  <c:v>1692</c:v>
                </c:pt>
                <c:pt idx="31">
                  <c:v>794</c:v>
                </c:pt>
                <c:pt idx="32">
                  <c:v>2001</c:v>
                </c:pt>
                <c:pt idx="33">
                  <c:v>1720</c:v>
                </c:pt>
                <c:pt idx="34">
                  <c:v>1690</c:v>
                </c:pt>
                <c:pt idx="35">
                  <c:v>867</c:v>
                </c:pt>
                <c:pt idx="36">
                  <c:v>1991</c:v>
                </c:pt>
                <c:pt idx="37">
                  <c:v>2004</c:v>
                </c:pt>
                <c:pt idx="38">
                  <c:v>1738</c:v>
                </c:pt>
                <c:pt idx="39">
                  <c:v>2039</c:v>
                </c:pt>
                <c:pt idx="40">
                  <c:v>1345</c:v>
                </c:pt>
                <c:pt idx="41">
                  <c:v>1083</c:v>
                </c:pt>
                <c:pt idx="42">
                  <c:v>2017</c:v>
                </c:pt>
                <c:pt idx="43">
                  <c:v>2073</c:v>
                </c:pt>
                <c:pt idx="44">
                  <c:v>2015</c:v>
                </c:pt>
                <c:pt idx="45">
                  <c:v>1736</c:v>
                </c:pt>
                <c:pt idx="46">
                  <c:v>1144</c:v>
                </c:pt>
                <c:pt idx="47">
                  <c:v>1992</c:v>
                </c:pt>
                <c:pt idx="48">
                  <c:v>1146</c:v>
                </c:pt>
                <c:pt idx="49">
                  <c:v>1365</c:v>
                </c:pt>
                <c:pt idx="50">
                  <c:v>1997</c:v>
                </c:pt>
                <c:pt idx="51">
                  <c:v>1844</c:v>
                </c:pt>
                <c:pt idx="52">
                  <c:v>428</c:v>
                </c:pt>
                <c:pt idx="53">
                  <c:v>1837</c:v>
                </c:pt>
                <c:pt idx="54">
                  <c:v>894</c:v>
                </c:pt>
                <c:pt idx="55">
                  <c:v>1966</c:v>
                </c:pt>
                <c:pt idx="56">
                  <c:v>1391</c:v>
                </c:pt>
                <c:pt idx="57">
                  <c:v>2026</c:v>
                </c:pt>
                <c:pt idx="58">
                  <c:v>789</c:v>
                </c:pt>
                <c:pt idx="59">
                  <c:v>1829</c:v>
                </c:pt>
                <c:pt idx="60">
                  <c:v>1723</c:v>
                </c:pt>
                <c:pt idx="61">
                  <c:v>1867</c:v>
                </c:pt>
                <c:pt idx="62">
                  <c:v>1119</c:v>
                </c:pt>
                <c:pt idx="63">
                  <c:v>2002</c:v>
                </c:pt>
                <c:pt idx="64">
                  <c:v>1499</c:v>
                </c:pt>
                <c:pt idx="65">
                  <c:v>2169</c:v>
                </c:pt>
                <c:pt idx="66">
                  <c:v>1548</c:v>
                </c:pt>
                <c:pt idx="67">
                  <c:v>1807</c:v>
                </c:pt>
                <c:pt idx="68">
                  <c:v>2164</c:v>
                </c:pt>
                <c:pt idx="69">
                  <c:v>1715</c:v>
                </c:pt>
                <c:pt idx="70">
                  <c:v>2083</c:v>
                </c:pt>
                <c:pt idx="71">
                  <c:v>1773</c:v>
                </c:pt>
                <c:pt idx="72">
                  <c:v>1767</c:v>
                </c:pt>
                <c:pt idx="73">
                  <c:v>1061</c:v>
                </c:pt>
                <c:pt idx="74">
                  <c:v>1802</c:v>
                </c:pt>
                <c:pt idx="75">
                  <c:v>2016</c:v>
                </c:pt>
                <c:pt idx="76">
                  <c:v>1442</c:v>
                </c:pt>
                <c:pt idx="77">
                  <c:v>1694</c:v>
                </c:pt>
                <c:pt idx="78">
                  <c:v>1454</c:v>
                </c:pt>
                <c:pt idx="79">
                  <c:v>1599</c:v>
                </c:pt>
                <c:pt idx="80">
                  <c:v>960</c:v>
                </c:pt>
                <c:pt idx="81">
                  <c:v>483</c:v>
                </c:pt>
                <c:pt idx="82">
                  <c:v>1849</c:v>
                </c:pt>
                <c:pt idx="83">
                  <c:v>926</c:v>
                </c:pt>
                <c:pt idx="84">
                  <c:v>1631</c:v>
                </c:pt>
                <c:pt idx="85">
                  <c:v>1434</c:v>
                </c:pt>
                <c:pt idx="86">
                  <c:v>566</c:v>
                </c:pt>
                <c:pt idx="87">
                  <c:v>2040</c:v>
                </c:pt>
                <c:pt idx="88">
                  <c:v>1142</c:v>
                </c:pt>
                <c:pt idx="89">
                  <c:v>1446</c:v>
                </c:pt>
                <c:pt idx="90">
                  <c:v>1988</c:v>
                </c:pt>
                <c:pt idx="91">
                  <c:v>484</c:v>
                </c:pt>
                <c:pt idx="92">
                  <c:v>1709</c:v>
                </c:pt>
                <c:pt idx="93">
                  <c:v>1460</c:v>
                </c:pt>
                <c:pt idx="94">
                  <c:v>1818</c:v>
                </c:pt>
                <c:pt idx="95">
                  <c:v>1557</c:v>
                </c:pt>
                <c:pt idx="96">
                  <c:v>1075</c:v>
                </c:pt>
                <c:pt idx="97">
                  <c:v>1685</c:v>
                </c:pt>
                <c:pt idx="98">
                  <c:v>1067</c:v>
                </c:pt>
                <c:pt idx="99">
                  <c:v>1864</c:v>
                </c:pt>
                <c:pt idx="100">
                  <c:v>615</c:v>
                </c:pt>
                <c:pt idx="101">
                  <c:v>824</c:v>
                </c:pt>
                <c:pt idx="102">
                  <c:v>1684</c:v>
                </c:pt>
                <c:pt idx="103">
                  <c:v>1702</c:v>
                </c:pt>
                <c:pt idx="104">
                  <c:v>1919</c:v>
                </c:pt>
                <c:pt idx="105">
                  <c:v>2112</c:v>
                </c:pt>
                <c:pt idx="106">
                  <c:v>1882</c:v>
                </c:pt>
                <c:pt idx="107">
                  <c:v>779</c:v>
                </c:pt>
                <c:pt idx="108">
                  <c:v>1213</c:v>
                </c:pt>
                <c:pt idx="109">
                  <c:v>1000</c:v>
                </c:pt>
                <c:pt idx="110">
                  <c:v>1689</c:v>
                </c:pt>
                <c:pt idx="111">
                  <c:v>986</c:v>
                </c:pt>
                <c:pt idx="112">
                  <c:v>2053</c:v>
                </c:pt>
                <c:pt idx="113">
                  <c:v>2077</c:v>
                </c:pt>
                <c:pt idx="114">
                  <c:v>1972</c:v>
                </c:pt>
                <c:pt idx="115">
                  <c:v>757</c:v>
                </c:pt>
                <c:pt idx="116">
                  <c:v>1491</c:v>
                </c:pt>
                <c:pt idx="117">
                  <c:v>1711</c:v>
                </c:pt>
                <c:pt idx="118">
                  <c:v>1155</c:v>
                </c:pt>
                <c:pt idx="119">
                  <c:v>2136</c:v>
                </c:pt>
                <c:pt idx="120">
                  <c:v>1959</c:v>
                </c:pt>
                <c:pt idx="121">
                  <c:v>1514</c:v>
                </c:pt>
                <c:pt idx="122">
                  <c:v>705</c:v>
                </c:pt>
                <c:pt idx="123">
                  <c:v>2021</c:v>
                </c:pt>
                <c:pt idx="124">
                  <c:v>1670</c:v>
                </c:pt>
                <c:pt idx="125">
                  <c:v>900</c:v>
                </c:pt>
                <c:pt idx="126">
                  <c:v>582</c:v>
                </c:pt>
                <c:pt idx="127">
                  <c:v>367</c:v>
                </c:pt>
                <c:pt idx="128">
                  <c:v>905</c:v>
                </c:pt>
                <c:pt idx="129">
                  <c:v>1748</c:v>
                </c:pt>
                <c:pt idx="130">
                  <c:v>1401</c:v>
                </c:pt>
                <c:pt idx="131">
                  <c:v>1376</c:v>
                </c:pt>
                <c:pt idx="132">
                  <c:v>1890</c:v>
                </c:pt>
                <c:pt idx="133">
                  <c:v>1915</c:v>
                </c:pt>
                <c:pt idx="134">
                  <c:v>1077</c:v>
                </c:pt>
                <c:pt idx="135">
                  <c:v>1444</c:v>
                </c:pt>
                <c:pt idx="136">
                  <c:v>1916</c:v>
                </c:pt>
                <c:pt idx="137">
                  <c:v>383</c:v>
                </c:pt>
                <c:pt idx="138">
                  <c:v>1340</c:v>
                </c:pt>
                <c:pt idx="139">
                  <c:v>1872</c:v>
                </c:pt>
                <c:pt idx="140">
                  <c:v>506</c:v>
                </c:pt>
                <c:pt idx="141">
                  <c:v>1354</c:v>
                </c:pt>
                <c:pt idx="142">
                  <c:v>1302</c:v>
                </c:pt>
                <c:pt idx="143">
                  <c:v>1440</c:v>
                </c:pt>
                <c:pt idx="144">
                  <c:v>1014</c:v>
                </c:pt>
                <c:pt idx="145">
                  <c:v>1381</c:v>
                </c:pt>
                <c:pt idx="146">
                  <c:v>1073</c:v>
                </c:pt>
                <c:pt idx="147">
                  <c:v>632</c:v>
                </c:pt>
                <c:pt idx="148">
                  <c:v>1726</c:v>
                </c:pt>
                <c:pt idx="149">
                  <c:v>1934</c:v>
                </c:pt>
                <c:pt idx="150">
                  <c:v>832</c:v>
                </c:pt>
                <c:pt idx="151">
                  <c:v>1629</c:v>
                </c:pt>
                <c:pt idx="152">
                  <c:v>1911</c:v>
                </c:pt>
                <c:pt idx="153">
                  <c:v>418</c:v>
                </c:pt>
                <c:pt idx="154">
                  <c:v>782</c:v>
                </c:pt>
                <c:pt idx="155">
                  <c:v>1138</c:v>
                </c:pt>
                <c:pt idx="156">
                  <c:v>1546</c:v>
                </c:pt>
                <c:pt idx="157">
                  <c:v>717</c:v>
                </c:pt>
                <c:pt idx="158">
                  <c:v>550</c:v>
                </c:pt>
                <c:pt idx="159">
                  <c:v>1467</c:v>
                </c:pt>
                <c:pt idx="160">
                  <c:v>372</c:v>
                </c:pt>
                <c:pt idx="161">
                  <c:v>1570</c:v>
                </c:pt>
                <c:pt idx="162">
                  <c:v>1825</c:v>
                </c:pt>
                <c:pt idx="163">
                  <c:v>535</c:v>
                </c:pt>
                <c:pt idx="164">
                  <c:v>1930</c:v>
                </c:pt>
                <c:pt idx="165">
                  <c:v>1258</c:v>
                </c:pt>
                <c:pt idx="166">
                  <c:v>1850</c:v>
                </c:pt>
                <c:pt idx="167">
                  <c:v>836</c:v>
                </c:pt>
                <c:pt idx="168">
                  <c:v>1618</c:v>
                </c:pt>
                <c:pt idx="169">
                  <c:v>2191</c:v>
                </c:pt>
                <c:pt idx="170">
                  <c:v>2005</c:v>
                </c:pt>
                <c:pt idx="171">
                  <c:v>1761</c:v>
                </c:pt>
                <c:pt idx="172">
                  <c:v>2122</c:v>
                </c:pt>
                <c:pt idx="173">
                  <c:v>2102</c:v>
                </c:pt>
                <c:pt idx="174">
                  <c:v>2000</c:v>
                </c:pt>
                <c:pt idx="175">
                  <c:v>2032</c:v>
                </c:pt>
                <c:pt idx="176">
                  <c:v>2006</c:v>
                </c:pt>
                <c:pt idx="177">
                  <c:v>1334</c:v>
                </c:pt>
                <c:pt idx="178">
                  <c:v>2127</c:v>
                </c:pt>
                <c:pt idx="179">
                  <c:v>2110</c:v>
                </c:pt>
                <c:pt idx="180">
                  <c:v>401</c:v>
                </c:pt>
                <c:pt idx="181">
                  <c:v>1881</c:v>
                </c:pt>
                <c:pt idx="182">
                  <c:v>1096</c:v>
                </c:pt>
                <c:pt idx="183">
                  <c:v>1332</c:v>
                </c:pt>
                <c:pt idx="184">
                  <c:v>2111</c:v>
                </c:pt>
                <c:pt idx="185">
                  <c:v>1921</c:v>
                </c:pt>
                <c:pt idx="186">
                  <c:v>2028</c:v>
                </c:pt>
                <c:pt idx="187">
                  <c:v>855</c:v>
                </c:pt>
                <c:pt idx="188">
                  <c:v>574</c:v>
                </c:pt>
                <c:pt idx="189">
                  <c:v>964</c:v>
                </c:pt>
                <c:pt idx="190">
                  <c:v>1745</c:v>
                </c:pt>
                <c:pt idx="191">
                  <c:v>1649</c:v>
                </c:pt>
                <c:pt idx="192">
                  <c:v>983</c:v>
                </c:pt>
                <c:pt idx="193">
                  <c:v>1700</c:v>
                </c:pt>
                <c:pt idx="194">
                  <c:v>1686</c:v>
                </c:pt>
                <c:pt idx="195">
                  <c:v>2141</c:v>
                </c:pt>
                <c:pt idx="196">
                  <c:v>1197</c:v>
                </c:pt>
                <c:pt idx="197">
                  <c:v>1796</c:v>
                </c:pt>
                <c:pt idx="198">
                  <c:v>743</c:v>
                </c:pt>
                <c:pt idx="199">
                  <c:v>1216</c:v>
                </c:pt>
                <c:pt idx="200">
                  <c:v>1947</c:v>
                </c:pt>
                <c:pt idx="201">
                  <c:v>1894</c:v>
                </c:pt>
                <c:pt idx="202">
                  <c:v>702</c:v>
                </c:pt>
                <c:pt idx="203">
                  <c:v>1721</c:v>
                </c:pt>
                <c:pt idx="204">
                  <c:v>1751</c:v>
                </c:pt>
                <c:pt idx="205">
                  <c:v>1559</c:v>
                </c:pt>
                <c:pt idx="206">
                  <c:v>2174</c:v>
                </c:pt>
                <c:pt idx="207">
                  <c:v>1695</c:v>
                </c:pt>
                <c:pt idx="208">
                  <c:v>2050</c:v>
                </c:pt>
                <c:pt idx="209">
                  <c:v>1363</c:v>
                </c:pt>
                <c:pt idx="210">
                  <c:v>1404</c:v>
                </c:pt>
                <c:pt idx="211">
                  <c:v>2022</c:v>
                </c:pt>
                <c:pt idx="212">
                  <c:v>1165</c:v>
                </c:pt>
                <c:pt idx="213">
                  <c:v>886</c:v>
                </c:pt>
                <c:pt idx="214">
                  <c:v>1904</c:v>
                </c:pt>
                <c:pt idx="215">
                  <c:v>1524</c:v>
                </c:pt>
                <c:pt idx="216">
                  <c:v>1983</c:v>
                </c:pt>
                <c:pt idx="217">
                  <c:v>1812</c:v>
                </c:pt>
                <c:pt idx="218">
                  <c:v>1928</c:v>
                </c:pt>
                <c:pt idx="219">
                  <c:v>1584</c:v>
                </c:pt>
                <c:pt idx="220">
                  <c:v>1729</c:v>
                </c:pt>
                <c:pt idx="221">
                  <c:v>1569</c:v>
                </c:pt>
                <c:pt idx="222">
                  <c:v>689</c:v>
                </c:pt>
                <c:pt idx="223">
                  <c:v>721</c:v>
                </c:pt>
                <c:pt idx="224">
                  <c:v>1776</c:v>
                </c:pt>
                <c:pt idx="225">
                  <c:v>588</c:v>
                </c:pt>
                <c:pt idx="226">
                  <c:v>1536</c:v>
                </c:pt>
                <c:pt idx="227">
                  <c:v>1810</c:v>
                </c:pt>
                <c:pt idx="228">
                  <c:v>1614</c:v>
                </c:pt>
                <c:pt idx="229">
                  <c:v>1698</c:v>
                </c:pt>
                <c:pt idx="230">
                  <c:v>1360</c:v>
                </c:pt>
                <c:pt idx="231">
                  <c:v>1704</c:v>
                </c:pt>
                <c:pt idx="232">
                  <c:v>904</c:v>
                </c:pt>
                <c:pt idx="233">
                  <c:v>1800</c:v>
                </c:pt>
                <c:pt idx="234">
                  <c:v>1706</c:v>
                </c:pt>
                <c:pt idx="235">
                  <c:v>797</c:v>
                </c:pt>
                <c:pt idx="236">
                  <c:v>1838</c:v>
                </c:pt>
                <c:pt idx="237">
                  <c:v>1968</c:v>
                </c:pt>
                <c:pt idx="238">
                  <c:v>2095</c:v>
                </c:pt>
                <c:pt idx="239">
                  <c:v>1341</c:v>
                </c:pt>
                <c:pt idx="240">
                  <c:v>934</c:v>
                </c:pt>
                <c:pt idx="241">
                  <c:v>1766</c:v>
                </c:pt>
                <c:pt idx="242">
                  <c:v>1935</c:v>
                </c:pt>
                <c:pt idx="243">
                  <c:v>2059</c:v>
                </c:pt>
                <c:pt idx="244">
                  <c:v>2097</c:v>
                </c:pt>
                <c:pt idx="245">
                  <c:v>534</c:v>
                </c:pt>
                <c:pt idx="246">
                  <c:v>1912</c:v>
                </c:pt>
                <c:pt idx="247">
                  <c:v>2010</c:v>
                </c:pt>
                <c:pt idx="248">
                  <c:v>1532</c:v>
                </c:pt>
                <c:pt idx="249">
                  <c:v>1175</c:v>
                </c:pt>
                <c:pt idx="250">
                  <c:v>2134</c:v>
                </c:pt>
                <c:pt idx="251">
                  <c:v>2181</c:v>
                </c:pt>
                <c:pt idx="252">
                  <c:v>1728</c:v>
                </c:pt>
                <c:pt idx="253">
                  <c:v>1876</c:v>
                </c:pt>
                <c:pt idx="254">
                  <c:v>2142</c:v>
                </c:pt>
                <c:pt idx="255">
                  <c:v>1663</c:v>
                </c:pt>
                <c:pt idx="256">
                  <c:v>1758</c:v>
                </c:pt>
                <c:pt idx="257">
                  <c:v>382</c:v>
                </c:pt>
                <c:pt idx="258">
                  <c:v>1859</c:v>
                </c:pt>
                <c:pt idx="259">
                  <c:v>1489</c:v>
                </c:pt>
                <c:pt idx="260">
                  <c:v>488</c:v>
                </c:pt>
                <c:pt idx="261">
                  <c:v>1806</c:v>
                </c:pt>
                <c:pt idx="262">
                  <c:v>1639</c:v>
                </c:pt>
                <c:pt idx="263">
                  <c:v>1984</c:v>
                </c:pt>
                <c:pt idx="264">
                  <c:v>1183</c:v>
                </c:pt>
                <c:pt idx="265">
                  <c:v>1831</c:v>
                </c:pt>
                <c:pt idx="266">
                  <c:v>1852</c:v>
                </c:pt>
                <c:pt idx="267">
                  <c:v>1389</c:v>
                </c:pt>
                <c:pt idx="268">
                  <c:v>1878</c:v>
                </c:pt>
                <c:pt idx="269">
                  <c:v>1753</c:v>
                </c:pt>
                <c:pt idx="270">
                  <c:v>1116</c:v>
                </c:pt>
                <c:pt idx="271">
                  <c:v>1820</c:v>
                </c:pt>
                <c:pt idx="272">
                  <c:v>1998</c:v>
                </c:pt>
                <c:pt idx="273">
                  <c:v>1927</c:v>
                </c:pt>
                <c:pt idx="274">
                  <c:v>1535</c:v>
                </c:pt>
                <c:pt idx="275">
                  <c:v>664</c:v>
                </c:pt>
                <c:pt idx="276">
                  <c:v>1762</c:v>
                </c:pt>
                <c:pt idx="277">
                  <c:v>1574</c:v>
                </c:pt>
                <c:pt idx="278">
                  <c:v>1480</c:v>
                </c:pt>
                <c:pt idx="279">
                  <c:v>1771</c:v>
                </c:pt>
                <c:pt idx="280">
                  <c:v>240</c:v>
                </c:pt>
                <c:pt idx="281">
                  <c:v>1240</c:v>
                </c:pt>
                <c:pt idx="282">
                  <c:v>1020</c:v>
                </c:pt>
                <c:pt idx="283">
                  <c:v>1801</c:v>
                </c:pt>
                <c:pt idx="284">
                  <c:v>1355</c:v>
                </c:pt>
                <c:pt idx="285">
                  <c:v>2046</c:v>
                </c:pt>
                <c:pt idx="286">
                  <c:v>1973</c:v>
                </c:pt>
                <c:pt idx="287">
                  <c:v>1630</c:v>
                </c:pt>
                <c:pt idx="288">
                  <c:v>403</c:v>
                </c:pt>
                <c:pt idx="289">
                  <c:v>1862</c:v>
                </c:pt>
                <c:pt idx="290">
                  <c:v>1936</c:v>
                </c:pt>
                <c:pt idx="291">
                  <c:v>1785</c:v>
                </c:pt>
                <c:pt idx="292">
                  <c:v>890</c:v>
                </c:pt>
                <c:pt idx="293">
                  <c:v>1990</c:v>
                </c:pt>
                <c:pt idx="294">
                  <c:v>1162</c:v>
                </c:pt>
                <c:pt idx="295">
                  <c:v>1520</c:v>
                </c:pt>
                <c:pt idx="296">
                  <c:v>2013</c:v>
                </c:pt>
                <c:pt idx="297">
                  <c:v>2079</c:v>
                </c:pt>
                <c:pt idx="298">
                  <c:v>675</c:v>
                </c:pt>
                <c:pt idx="299">
                  <c:v>1343</c:v>
                </c:pt>
                <c:pt idx="300">
                  <c:v>400</c:v>
                </c:pt>
                <c:pt idx="301">
                  <c:v>1079</c:v>
                </c:pt>
                <c:pt idx="302">
                  <c:v>1898</c:v>
                </c:pt>
                <c:pt idx="303">
                  <c:v>1438</c:v>
                </c:pt>
                <c:pt idx="304">
                  <c:v>579</c:v>
                </c:pt>
                <c:pt idx="305">
                  <c:v>2158</c:v>
                </c:pt>
                <c:pt idx="306">
                  <c:v>1160</c:v>
                </c:pt>
                <c:pt idx="307">
                  <c:v>1775</c:v>
                </c:pt>
                <c:pt idx="308">
                  <c:v>1939</c:v>
                </c:pt>
                <c:pt idx="309">
                  <c:v>1498</c:v>
                </c:pt>
                <c:pt idx="310">
                  <c:v>2171</c:v>
                </c:pt>
                <c:pt idx="311">
                  <c:v>1875</c:v>
                </c:pt>
                <c:pt idx="312">
                  <c:v>1929</c:v>
                </c:pt>
                <c:pt idx="313">
                  <c:v>1933</c:v>
                </c:pt>
                <c:pt idx="314">
                  <c:v>1823</c:v>
                </c:pt>
                <c:pt idx="315">
                  <c:v>1581</c:v>
                </c:pt>
                <c:pt idx="316">
                  <c:v>1070</c:v>
                </c:pt>
                <c:pt idx="317">
                  <c:v>1571</c:v>
                </c:pt>
                <c:pt idx="318">
                  <c:v>1153</c:v>
                </c:pt>
                <c:pt idx="319">
                  <c:v>565</c:v>
                </c:pt>
                <c:pt idx="320">
                  <c:v>1718</c:v>
                </c:pt>
                <c:pt idx="321">
                  <c:v>1803</c:v>
                </c:pt>
                <c:pt idx="322">
                  <c:v>1576</c:v>
                </c:pt>
                <c:pt idx="323">
                  <c:v>1855</c:v>
                </c:pt>
                <c:pt idx="324">
                  <c:v>2030</c:v>
                </c:pt>
                <c:pt idx="325">
                  <c:v>1961</c:v>
                </c:pt>
                <c:pt idx="326">
                  <c:v>1975</c:v>
                </c:pt>
                <c:pt idx="327">
                  <c:v>1741</c:v>
                </c:pt>
                <c:pt idx="328">
                  <c:v>1482</c:v>
                </c:pt>
                <c:pt idx="329">
                  <c:v>1443</c:v>
                </c:pt>
                <c:pt idx="330">
                  <c:v>1774</c:v>
                </c:pt>
                <c:pt idx="331">
                  <c:v>514</c:v>
                </c:pt>
                <c:pt idx="332">
                  <c:v>1449</c:v>
                </c:pt>
                <c:pt idx="333">
                  <c:v>1521</c:v>
                </c:pt>
                <c:pt idx="334">
                  <c:v>1873</c:v>
                </c:pt>
                <c:pt idx="335">
                  <c:v>1817</c:v>
                </c:pt>
                <c:pt idx="336">
                  <c:v>1682</c:v>
                </c:pt>
                <c:pt idx="337">
                  <c:v>1481</c:v>
                </c:pt>
                <c:pt idx="338">
                  <c:v>2163</c:v>
                </c:pt>
                <c:pt idx="339">
                  <c:v>1573</c:v>
                </c:pt>
                <c:pt idx="340">
                  <c:v>1887</c:v>
                </c:pt>
                <c:pt idx="341">
                  <c:v>1958</c:v>
                </c:pt>
                <c:pt idx="342">
                  <c:v>2058</c:v>
                </c:pt>
                <c:pt idx="343">
                  <c:v>2196</c:v>
                </c:pt>
                <c:pt idx="344">
                  <c:v>586</c:v>
                </c:pt>
                <c:pt idx="345">
                  <c:v>1903</c:v>
                </c:pt>
                <c:pt idx="346">
                  <c:v>1418</c:v>
                </c:pt>
                <c:pt idx="347">
                  <c:v>1874</c:v>
                </c:pt>
                <c:pt idx="348">
                  <c:v>1211</c:v>
                </c:pt>
                <c:pt idx="349">
                  <c:v>1608</c:v>
                </c:pt>
                <c:pt idx="350">
                  <c:v>387</c:v>
                </c:pt>
                <c:pt idx="351">
                  <c:v>1497</c:v>
                </c:pt>
                <c:pt idx="352">
                  <c:v>1032</c:v>
                </c:pt>
                <c:pt idx="353">
                  <c:v>1906</c:v>
                </c:pt>
                <c:pt idx="354">
                  <c:v>2070</c:v>
                </c:pt>
                <c:pt idx="355">
                  <c:v>1666</c:v>
                </c:pt>
                <c:pt idx="356">
                  <c:v>1097</c:v>
                </c:pt>
                <c:pt idx="357">
                  <c:v>1582</c:v>
                </c:pt>
                <c:pt idx="358">
                  <c:v>1664</c:v>
                </c:pt>
                <c:pt idx="359">
                  <c:v>1157</c:v>
                </c:pt>
                <c:pt idx="360">
                  <c:v>1476</c:v>
                </c:pt>
                <c:pt idx="361">
                  <c:v>2056</c:v>
                </c:pt>
                <c:pt idx="362">
                  <c:v>1246</c:v>
                </c:pt>
                <c:pt idx="363">
                  <c:v>583</c:v>
                </c:pt>
                <c:pt idx="364">
                  <c:v>1953</c:v>
                </c:pt>
                <c:pt idx="365">
                  <c:v>1139</c:v>
                </c:pt>
                <c:pt idx="366">
                  <c:v>485</c:v>
                </c:pt>
                <c:pt idx="367">
                  <c:v>1949</c:v>
                </c:pt>
                <c:pt idx="368">
                  <c:v>807</c:v>
                </c:pt>
                <c:pt idx="369">
                  <c:v>1869</c:v>
                </c:pt>
                <c:pt idx="370">
                  <c:v>1596</c:v>
                </c:pt>
                <c:pt idx="371">
                  <c:v>1683</c:v>
                </c:pt>
                <c:pt idx="372">
                  <c:v>404</c:v>
                </c:pt>
                <c:pt idx="373">
                  <c:v>2092</c:v>
                </c:pt>
                <c:pt idx="374">
                  <c:v>1913</c:v>
                </c:pt>
                <c:pt idx="375">
                  <c:v>1892</c:v>
                </c:pt>
                <c:pt idx="376">
                  <c:v>1359</c:v>
                </c:pt>
                <c:pt idx="377">
                  <c:v>1834</c:v>
                </c:pt>
                <c:pt idx="378">
                  <c:v>1841</c:v>
                </c:pt>
                <c:pt idx="379">
                  <c:v>1485</c:v>
                </c:pt>
                <c:pt idx="380">
                  <c:v>2071</c:v>
                </c:pt>
                <c:pt idx="381">
                  <c:v>1150</c:v>
                </c:pt>
                <c:pt idx="382">
                  <c:v>1351</c:v>
                </c:pt>
                <c:pt idx="383">
                  <c:v>1815</c:v>
                </c:pt>
                <c:pt idx="384">
                  <c:v>1799</c:v>
                </c:pt>
                <c:pt idx="385">
                  <c:v>1848</c:v>
                </c:pt>
                <c:pt idx="386">
                  <c:v>1125</c:v>
                </c:pt>
                <c:pt idx="387">
                  <c:v>1626</c:v>
                </c:pt>
                <c:pt idx="388">
                  <c:v>1385</c:v>
                </c:pt>
                <c:pt idx="389">
                  <c:v>1781</c:v>
                </c:pt>
                <c:pt idx="390">
                  <c:v>1946</c:v>
                </c:pt>
                <c:pt idx="391">
                  <c:v>1996</c:v>
                </c:pt>
                <c:pt idx="392">
                  <c:v>1145</c:v>
                </c:pt>
                <c:pt idx="393">
                  <c:v>1114</c:v>
                </c:pt>
                <c:pt idx="394">
                  <c:v>930</c:v>
                </c:pt>
                <c:pt idx="395">
                  <c:v>1942</c:v>
                </c:pt>
                <c:pt idx="396">
                  <c:v>2065</c:v>
                </c:pt>
                <c:pt idx="397">
                  <c:v>968</c:v>
                </c:pt>
                <c:pt idx="398">
                  <c:v>1062</c:v>
                </c:pt>
                <c:pt idx="399">
                  <c:v>1814</c:v>
                </c:pt>
                <c:pt idx="400">
                  <c:v>372</c:v>
                </c:pt>
                <c:pt idx="401">
                  <c:v>1681</c:v>
                </c:pt>
                <c:pt idx="402">
                  <c:v>1349</c:v>
                </c:pt>
                <c:pt idx="403">
                  <c:v>546</c:v>
                </c:pt>
                <c:pt idx="404">
                  <c:v>2033</c:v>
                </c:pt>
                <c:pt idx="405">
                  <c:v>1198</c:v>
                </c:pt>
                <c:pt idx="406">
                  <c:v>2125</c:v>
                </c:pt>
                <c:pt idx="407">
                  <c:v>1954</c:v>
                </c:pt>
                <c:pt idx="408">
                  <c:v>2080</c:v>
                </c:pt>
                <c:pt idx="409">
                  <c:v>619</c:v>
                </c:pt>
                <c:pt idx="410">
                  <c:v>1564</c:v>
                </c:pt>
                <c:pt idx="411">
                  <c:v>1790</c:v>
                </c:pt>
                <c:pt idx="412">
                  <c:v>1891</c:v>
                </c:pt>
                <c:pt idx="413">
                  <c:v>1977</c:v>
                </c:pt>
                <c:pt idx="414">
                  <c:v>1423</c:v>
                </c:pt>
                <c:pt idx="415">
                  <c:v>1163</c:v>
                </c:pt>
                <c:pt idx="416">
                  <c:v>2081</c:v>
                </c:pt>
                <c:pt idx="417">
                  <c:v>847</c:v>
                </c:pt>
                <c:pt idx="418">
                  <c:v>1739</c:v>
                </c:pt>
                <c:pt idx="419">
                  <c:v>2157</c:v>
                </c:pt>
                <c:pt idx="420">
                  <c:v>1137</c:v>
                </c:pt>
                <c:pt idx="421">
                  <c:v>1688</c:v>
                </c:pt>
                <c:pt idx="422">
                  <c:v>1133</c:v>
                </c:pt>
                <c:pt idx="423">
                  <c:v>1937</c:v>
                </c:pt>
                <c:pt idx="424">
                  <c:v>1042</c:v>
                </c:pt>
                <c:pt idx="425">
                  <c:v>1479</c:v>
                </c:pt>
                <c:pt idx="426">
                  <c:v>369</c:v>
                </c:pt>
                <c:pt idx="427">
                  <c:v>1871</c:v>
                </c:pt>
                <c:pt idx="428">
                  <c:v>1076</c:v>
                </c:pt>
                <c:pt idx="429">
                  <c:v>1338</c:v>
                </c:pt>
                <c:pt idx="430">
                  <c:v>2018</c:v>
                </c:pt>
                <c:pt idx="431">
                  <c:v>1040</c:v>
                </c:pt>
                <c:pt idx="432">
                  <c:v>2072</c:v>
                </c:pt>
                <c:pt idx="433">
                  <c:v>1561</c:v>
                </c:pt>
                <c:pt idx="434">
                  <c:v>896</c:v>
                </c:pt>
                <c:pt idx="435">
                  <c:v>1655</c:v>
                </c:pt>
                <c:pt idx="436">
                  <c:v>1786</c:v>
                </c:pt>
                <c:pt idx="437">
                  <c:v>1836</c:v>
                </c:pt>
                <c:pt idx="438">
                  <c:v>1601</c:v>
                </c:pt>
                <c:pt idx="439">
                  <c:v>1956</c:v>
                </c:pt>
                <c:pt idx="440">
                  <c:v>884</c:v>
                </c:pt>
                <c:pt idx="441">
                  <c:v>1784</c:v>
                </c:pt>
                <c:pt idx="442">
                  <c:v>1754</c:v>
                </c:pt>
                <c:pt idx="443">
                  <c:v>2066</c:v>
                </c:pt>
                <c:pt idx="444">
                  <c:v>504</c:v>
                </c:pt>
                <c:pt idx="445">
                  <c:v>2023</c:v>
                </c:pt>
                <c:pt idx="446">
                  <c:v>2173</c:v>
                </c:pt>
                <c:pt idx="447">
                  <c:v>2113</c:v>
                </c:pt>
                <c:pt idx="448">
                  <c:v>1744</c:v>
                </c:pt>
                <c:pt idx="449">
                  <c:v>2041</c:v>
                </c:pt>
                <c:pt idx="450">
                  <c:v>2034</c:v>
                </c:pt>
                <c:pt idx="451">
                  <c:v>912</c:v>
                </c:pt>
                <c:pt idx="452">
                  <c:v>988</c:v>
                </c:pt>
                <c:pt idx="453">
                  <c:v>1367</c:v>
                </c:pt>
                <c:pt idx="454">
                  <c:v>1788</c:v>
                </c:pt>
                <c:pt idx="455">
                  <c:v>1858</c:v>
                </c:pt>
                <c:pt idx="456">
                  <c:v>1902</c:v>
                </c:pt>
                <c:pt idx="457">
                  <c:v>1508</c:v>
                </c:pt>
                <c:pt idx="458">
                  <c:v>1315</c:v>
                </c:pt>
                <c:pt idx="459">
                  <c:v>2048</c:v>
                </c:pt>
                <c:pt idx="460">
                  <c:v>480</c:v>
                </c:pt>
                <c:pt idx="461">
                  <c:v>791</c:v>
                </c:pt>
                <c:pt idx="462">
                  <c:v>2140</c:v>
                </c:pt>
                <c:pt idx="463">
                  <c:v>1965</c:v>
                </c:pt>
                <c:pt idx="464">
                  <c:v>1592</c:v>
                </c:pt>
                <c:pt idx="465">
                  <c:v>1244</c:v>
                </c:pt>
                <c:pt idx="466">
                  <c:v>370</c:v>
                </c:pt>
                <c:pt idx="467">
                  <c:v>1118</c:v>
                </c:pt>
                <c:pt idx="468">
                  <c:v>1696</c:v>
                </c:pt>
                <c:pt idx="469">
                  <c:v>1925</c:v>
                </c:pt>
                <c:pt idx="470">
                  <c:v>1730</c:v>
                </c:pt>
                <c:pt idx="471">
                  <c:v>1678</c:v>
                </c:pt>
                <c:pt idx="472">
                  <c:v>1511</c:v>
                </c:pt>
                <c:pt idx="473">
                  <c:v>1589</c:v>
                </c:pt>
                <c:pt idx="474">
                  <c:v>1826</c:v>
                </c:pt>
                <c:pt idx="475">
                  <c:v>1980</c:v>
                </c:pt>
                <c:pt idx="476">
                  <c:v>1746</c:v>
                </c:pt>
                <c:pt idx="477">
                  <c:v>461</c:v>
                </c:pt>
                <c:pt idx="478">
                  <c:v>1896</c:v>
                </c:pt>
                <c:pt idx="479">
                  <c:v>1462</c:v>
                </c:pt>
                <c:pt idx="480">
                  <c:v>2035</c:v>
                </c:pt>
                <c:pt idx="481">
                  <c:v>2074</c:v>
                </c:pt>
                <c:pt idx="482">
                  <c:v>2012</c:v>
                </c:pt>
                <c:pt idx="483">
                  <c:v>1687</c:v>
                </c:pt>
                <c:pt idx="484">
                  <c:v>1113</c:v>
                </c:pt>
                <c:pt idx="485">
                  <c:v>2098</c:v>
                </c:pt>
                <c:pt idx="486">
                  <c:v>1507</c:v>
                </c:pt>
                <c:pt idx="487">
                  <c:v>599</c:v>
                </c:pt>
                <c:pt idx="488">
                  <c:v>1861</c:v>
                </c:pt>
                <c:pt idx="489">
                  <c:v>1235</c:v>
                </c:pt>
                <c:pt idx="490">
                  <c:v>1050</c:v>
                </c:pt>
                <c:pt idx="491">
                  <c:v>1057</c:v>
                </c:pt>
                <c:pt idx="492">
                  <c:v>1148</c:v>
                </c:pt>
                <c:pt idx="493">
                  <c:v>1910</c:v>
                </c:pt>
                <c:pt idx="494">
                  <c:v>2101</c:v>
                </c:pt>
                <c:pt idx="495">
                  <c:v>1839</c:v>
                </c:pt>
                <c:pt idx="496">
                  <c:v>883</c:v>
                </c:pt>
                <c:pt idx="497">
                  <c:v>1059</c:v>
                </c:pt>
                <c:pt idx="498">
                  <c:v>2076</c:v>
                </c:pt>
                <c:pt idx="499">
                  <c:v>2085</c:v>
                </c:pt>
                <c:pt idx="500">
                  <c:v>1463</c:v>
                </c:pt>
                <c:pt idx="501">
                  <c:v>1433</c:v>
                </c:pt>
                <c:pt idx="502">
                  <c:v>1342</c:v>
                </c:pt>
                <c:pt idx="503">
                  <c:v>2115</c:v>
                </c:pt>
                <c:pt idx="504">
                  <c:v>1747</c:v>
                </c:pt>
                <c:pt idx="505">
                  <c:v>1344</c:v>
                </c:pt>
                <c:pt idx="506">
                  <c:v>394</c:v>
                </c:pt>
                <c:pt idx="507">
                  <c:v>2020</c:v>
                </c:pt>
                <c:pt idx="508">
                  <c:v>1407</c:v>
                </c:pt>
                <c:pt idx="509">
                  <c:v>646</c:v>
                </c:pt>
                <c:pt idx="510">
                  <c:v>1245</c:v>
                </c:pt>
                <c:pt idx="511">
                  <c:v>457</c:v>
                </c:pt>
                <c:pt idx="512">
                  <c:v>1058</c:v>
                </c:pt>
                <c:pt idx="513">
                  <c:v>1379</c:v>
                </c:pt>
                <c:pt idx="514">
                  <c:v>1156</c:v>
                </c:pt>
                <c:pt idx="515">
                  <c:v>1986</c:v>
                </c:pt>
                <c:pt idx="516">
                  <c:v>2036</c:v>
                </c:pt>
                <c:pt idx="517">
                  <c:v>679</c:v>
                </c:pt>
                <c:pt idx="518">
                  <c:v>1147</c:v>
                </c:pt>
                <c:pt idx="519">
                  <c:v>1768</c:v>
                </c:pt>
                <c:pt idx="520">
                  <c:v>1161</c:v>
                </c:pt>
                <c:pt idx="521">
                  <c:v>1932</c:v>
                </c:pt>
                <c:pt idx="522">
                  <c:v>1620</c:v>
                </c:pt>
                <c:pt idx="523">
                  <c:v>481</c:v>
                </c:pt>
                <c:pt idx="524">
                  <c:v>1905</c:v>
                </c:pt>
                <c:pt idx="525">
                  <c:v>1846</c:v>
                </c:pt>
                <c:pt idx="526">
                  <c:v>2084</c:v>
                </c:pt>
                <c:pt idx="527">
                  <c:v>1140</c:v>
                </c:pt>
                <c:pt idx="528">
                  <c:v>2044</c:v>
                </c:pt>
                <c:pt idx="529">
                  <c:v>1554</c:v>
                </c:pt>
                <c:pt idx="530">
                  <c:v>1602</c:v>
                </c:pt>
                <c:pt idx="531">
                  <c:v>1186</c:v>
                </c:pt>
                <c:pt idx="532">
                  <c:v>2172</c:v>
                </c:pt>
                <c:pt idx="533">
                  <c:v>1900</c:v>
                </c:pt>
                <c:pt idx="534">
                  <c:v>1917</c:v>
                </c:pt>
                <c:pt idx="535">
                  <c:v>1347</c:v>
                </c:pt>
                <c:pt idx="536">
                  <c:v>1610</c:v>
                </c:pt>
                <c:pt idx="537">
                  <c:v>1671</c:v>
                </c:pt>
                <c:pt idx="538">
                  <c:v>2091</c:v>
                </c:pt>
                <c:pt idx="539">
                  <c:v>487</c:v>
                </c:pt>
                <c:pt idx="540">
                  <c:v>1827</c:v>
                </c:pt>
                <c:pt idx="541">
                  <c:v>489</c:v>
                </c:pt>
                <c:pt idx="542">
                  <c:v>756</c:v>
                </c:pt>
                <c:pt idx="543">
                  <c:v>1732</c:v>
                </c:pt>
                <c:pt idx="544">
                  <c:v>1339</c:v>
                </c:pt>
                <c:pt idx="545">
                  <c:v>2042</c:v>
                </c:pt>
                <c:pt idx="546">
                  <c:v>1292</c:v>
                </c:pt>
                <c:pt idx="547">
                  <c:v>1483</c:v>
                </c:pt>
                <c:pt idx="548">
                  <c:v>2197</c:v>
                </c:pt>
                <c:pt idx="549">
                  <c:v>1926</c:v>
                </c:pt>
                <c:pt idx="550">
                  <c:v>1501</c:v>
                </c:pt>
                <c:pt idx="551">
                  <c:v>1124</c:v>
                </c:pt>
                <c:pt idx="552">
                  <c:v>1597</c:v>
                </c:pt>
                <c:pt idx="553">
                  <c:v>1955</c:v>
                </c:pt>
                <c:pt idx="554">
                  <c:v>739</c:v>
                </c:pt>
                <c:pt idx="555">
                  <c:v>1436</c:v>
                </c:pt>
                <c:pt idx="556">
                  <c:v>805</c:v>
                </c:pt>
                <c:pt idx="557">
                  <c:v>1527</c:v>
                </c:pt>
                <c:pt idx="558">
                  <c:v>859</c:v>
                </c:pt>
                <c:pt idx="559">
                  <c:v>1591</c:v>
                </c:pt>
                <c:pt idx="560">
                  <c:v>1337</c:v>
                </c:pt>
                <c:pt idx="561">
                  <c:v>2009</c:v>
                </c:pt>
                <c:pt idx="562">
                  <c:v>1492</c:v>
                </c:pt>
                <c:pt idx="563">
                  <c:v>2165</c:v>
                </c:pt>
                <c:pt idx="564">
                  <c:v>486</c:v>
                </c:pt>
                <c:pt idx="565">
                  <c:v>1417</c:v>
                </c:pt>
                <c:pt idx="566">
                  <c:v>737</c:v>
                </c:pt>
                <c:pt idx="567">
                  <c:v>910</c:v>
                </c:pt>
                <c:pt idx="568">
                  <c:v>2051</c:v>
                </c:pt>
                <c:pt idx="569">
                  <c:v>1435</c:v>
                </c:pt>
                <c:pt idx="570">
                  <c:v>420</c:v>
                </c:pt>
                <c:pt idx="571">
                  <c:v>1364</c:v>
                </c:pt>
                <c:pt idx="572">
                  <c:v>1727</c:v>
                </c:pt>
                <c:pt idx="573">
                  <c:v>1868</c:v>
                </c:pt>
                <c:pt idx="574">
                  <c:v>906</c:v>
                </c:pt>
                <c:pt idx="575">
                  <c:v>440</c:v>
                </c:pt>
                <c:pt idx="576">
                  <c:v>1673</c:v>
                </c:pt>
                <c:pt idx="577">
                  <c:v>371</c:v>
                </c:pt>
                <c:pt idx="578">
                  <c:v>2107</c:v>
                </c:pt>
                <c:pt idx="579">
                  <c:v>1588</c:v>
                </c:pt>
                <c:pt idx="580">
                  <c:v>1811</c:v>
                </c:pt>
                <c:pt idx="581">
                  <c:v>1893</c:v>
                </c:pt>
                <c:pt idx="582">
                  <c:v>1159</c:v>
                </c:pt>
                <c:pt idx="583">
                  <c:v>1609</c:v>
                </c:pt>
                <c:pt idx="584">
                  <c:v>1971</c:v>
                </c:pt>
                <c:pt idx="585">
                  <c:v>1539</c:v>
                </c:pt>
                <c:pt idx="586">
                  <c:v>1847</c:v>
                </c:pt>
                <c:pt idx="587">
                  <c:v>1987</c:v>
                </c:pt>
                <c:pt idx="588">
                  <c:v>1531</c:v>
                </c:pt>
                <c:pt idx="589">
                  <c:v>567</c:v>
                </c:pt>
                <c:pt idx="590">
                  <c:v>1288</c:v>
                </c:pt>
                <c:pt idx="591">
                  <c:v>2045</c:v>
                </c:pt>
                <c:pt idx="592">
                  <c:v>1403</c:v>
                </c:pt>
                <c:pt idx="593">
                  <c:v>1013</c:v>
                </c:pt>
                <c:pt idx="594">
                  <c:v>2167</c:v>
                </c:pt>
                <c:pt idx="595">
                  <c:v>984</c:v>
                </c:pt>
                <c:pt idx="596">
                  <c:v>1779</c:v>
                </c:pt>
                <c:pt idx="597">
                  <c:v>1369</c:v>
                </c:pt>
                <c:pt idx="598">
                  <c:v>587</c:v>
                </c:pt>
                <c:pt idx="599">
                  <c:v>1672</c:v>
                </c:pt>
                <c:pt idx="600">
                  <c:v>562</c:v>
                </c:pt>
                <c:pt idx="601">
                  <c:v>1510</c:v>
                </c:pt>
                <c:pt idx="602">
                  <c:v>1254</c:v>
                </c:pt>
                <c:pt idx="603">
                  <c:v>2067</c:v>
                </c:pt>
                <c:pt idx="604">
                  <c:v>1691</c:v>
                </c:pt>
                <c:pt idx="605">
                  <c:v>686</c:v>
                </c:pt>
                <c:pt idx="606">
                  <c:v>1034</c:v>
                </c:pt>
                <c:pt idx="607">
                  <c:v>379</c:v>
                </c:pt>
                <c:pt idx="608">
                  <c:v>1999</c:v>
                </c:pt>
                <c:pt idx="609">
                  <c:v>1035</c:v>
                </c:pt>
                <c:pt idx="610">
                  <c:v>1128</c:v>
                </c:pt>
                <c:pt idx="611">
                  <c:v>1509</c:v>
                </c:pt>
                <c:pt idx="612">
                  <c:v>2019</c:v>
                </c:pt>
                <c:pt idx="613">
                  <c:v>2089</c:v>
                </c:pt>
                <c:pt idx="614">
                  <c:v>2031</c:v>
                </c:pt>
                <c:pt idx="615">
                  <c:v>1519</c:v>
                </c:pt>
                <c:pt idx="616">
                  <c:v>497</c:v>
                </c:pt>
                <c:pt idx="617">
                  <c:v>1452</c:v>
                </c:pt>
                <c:pt idx="618">
                  <c:v>795</c:v>
                </c:pt>
                <c:pt idx="619">
                  <c:v>2078</c:v>
                </c:pt>
                <c:pt idx="620">
                  <c:v>1734</c:v>
                </c:pt>
                <c:pt idx="621">
                  <c:v>1528</c:v>
                </c:pt>
                <c:pt idx="622">
                  <c:v>578</c:v>
                </c:pt>
                <c:pt idx="623">
                  <c:v>1072</c:v>
                </c:pt>
                <c:pt idx="624">
                  <c:v>1132</c:v>
                </c:pt>
                <c:pt idx="625">
                  <c:v>1813</c:v>
                </c:pt>
                <c:pt idx="626">
                  <c:v>373</c:v>
                </c:pt>
                <c:pt idx="627">
                  <c:v>1920</c:v>
                </c:pt>
                <c:pt idx="628">
                  <c:v>1390</c:v>
                </c:pt>
                <c:pt idx="629">
                  <c:v>1405</c:v>
                </c:pt>
                <c:pt idx="630">
                  <c:v>1122</c:v>
                </c:pt>
                <c:pt idx="631">
                  <c:v>1865</c:v>
                </c:pt>
                <c:pt idx="632">
                  <c:v>1432</c:v>
                </c:pt>
                <c:pt idx="633">
                  <c:v>1593</c:v>
                </c:pt>
                <c:pt idx="634">
                  <c:v>544</c:v>
                </c:pt>
                <c:pt idx="635">
                  <c:v>1787</c:v>
                </c:pt>
                <c:pt idx="636">
                  <c:v>2166</c:v>
                </c:pt>
                <c:pt idx="637">
                  <c:v>1409</c:v>
                </c:pt>
                <c:pt idx="638">
                  <c:v>1500</c:v>
                </c:pt>
                <c:pt idx="639">
                  <c:v>452</c:v>
                </c:pt>
                <c:pt idx="640">
                  <c:v>1358</c:v>
                </c:pt>
                <c:pt idx="641">
                  <c:v>2007</c:v>
                </c:pt>
                <c:pt idx="642">
                  <c:v>736</c:v>
                </c:pt>
                <c:pt idx="643">
                  <c:v>540</c:v>
                </c:pt>
                <c:pt idx="644">
                  <c:v>902</c:v>
                </c:pt>
                <c:pt idx="645">
                  <c:v>542</c:v>
                </c:pt>
                <c:pt idx="646">
                  <c:v>1387</c:v>
                </c:pt>
                <c:pt idx="647">
                  <c:v>761</c:v>
                </c:pt>
                <c:pt idx="648">
                  <c:v>1866</c:v>
                </c:pt>
                <c:pt idx="649">
                  <c:v>1797</c:v>
                </c:pt>
                <c:pt idx="650">
                  <c:v>1565</c:v>
                </c:pt>
                <c:pt idx="651">
                  <c:v>1791</c:v>
                </c:pt>
                <c:pt idx="652">
                  <c:v>1944</c:v>
                </c:pt>
                <c:pt idx="653">
                  <c:v>856</c:v>
                </c:pt>
                <c:pt idx="654">
                  <c:v>2049</c:v>
                </c:pt>
                <c:pt idx="655">
                  <c:v>1769</c:v>
                </c:pt>
                <c:pt idx="656">
                  <c:v>1856</c:v>
                </c:pt>
                <c:pt idx="657">
                  <c:v>1117</c:v>
                </c:pt>
                <c:pt idx="658">
                  <c:v>1121</c:v>
                </c:pt>
                <c:pt idx="659">
                  <c:v>1970</c:v>
                </c:pt>
                <c:pt idx="660">
                  <c:v>2025</c:v>
                </c:pt>
                <c:pt idx="661">
                  <c:v>1312</c:v>
                </c:pt>
                <c:pt idx="662">
                  <c:v>2069</c:v>
                </c:pt>
                <c:pt idx="663">
                  <c:v>1068</c:v>
                </c:pt>
                <c:pt idx="664">
                  <c:v>2062</c:v>
                </c:pt>
                <c:pt idx="665">
                  <c:v>1400</c:v>
                </c:pt>
                <c:pt idx="666">
                  <c:v>2162</c:v>
                </c:pt>
                <c:pt idx="667">
                  <c:v>820</c:v>
                </c:pt>
                <c:pt idx="668">
                  <c:v>1214</c:v>
                </c:pt>
                <c:pt idx="669">
                  <c:v>1357</c:v>
                </c:pt>
                <c:pt idx="670">
                  <c:v>792</c:v>
                </c:pt>
                <c:pt idx="671">
                  <c:v>2093</c:v>
                </c:pt>
                <c:pt idx="672">
                  <c:v>2124</c:v>
                </c:pt>
                <c:pt idx="673">
                  <c:v>1822</c:v>
                </c:pt>
                <c:pt idx="674">
                  <c:v>1264</c:v>
                </c:pt>
                <c:pt idx="675">
                  <c:v>1234</c:v>
                </c:pt>
                <c:pt idx="676">
                  <c:v>1907</c:v>
                </c:pt>
                <c:pt idx="677">
                  <c:v>1710</c:v>
                </c:pt>
                <c:pt idx="678">
                  <c:v>1170</c:v>
                </c:pt>
                <c:pt idx="679">
                  <c:v>1603</c:v>
                </c:pt>
                <c:pt idx="680">
                  <c:v>1335</c:v>
                </c:pt>
                <c:pt idx="681">
                  <c:v>1722</c:v>
                </c:pt>
                <c:pt idx="682">
                  <c:v>1080</c:v>
                </c:pt>
                <c:pt idx="683">
                  <c:v>759</c:v>
                </c:pt>
                <c:pt idx="684">
                  <c:v>1931</c:v>
                </c:pt>
                <c:pt idx="685">
                  <c:v>1008</c:v>
                </c:pt>
                <c:pt idx="686">
                  <c:v>774</c:v>
                </c:pt>
                <c:pt idx="687">
                  <c:v>1857</c:v>
                </c:pt>
                <c:pt idx="688">
                  <c:v>1653</c:v>
                </c:pt>
                <c:pt idx="689">
                  <c:v>1675</c:v>
                </c:pt>
                <c:pt idx="690">
                  <c:v>1945</c:v>
                </c:pt>
                <c:pt idx="691">
                  <c:v>1870</c:v>
                </c:pt>
                <c:pt idx="692">
                  <c:v>1466</c:v>
                </c:pt>
                <c:pt idx="693">
                  <c:v>956</c:v>
                </c:pt>
                <c:pt idx="694">
                  <c:v>2180</c:v>
                </c:pt>
                <c:pt idx="695">
                  <c:v>1703</c:v>
                </c:pt>
                <c:pt idx="696">
                  <c:v>1325</c:v>
                </c:pt>
                <c:pt idx="697">
                  <c:v>1755</c:v>
                </c:pt>
                <c:pt idx="698">
                  <c:v>1792</c:v>
                </c:pt>
                <c:pt idx="699">
                  <c:v>901</c:v>
                </c:pt>
                <c:pt idx="700">
                  <c:v>2024</c:v>
                </c:pt>
                <c:pt idx="701">
                  <c:v>2086</c:v>
                </c:pt>
                <c:pt idx="702">
                  <c:v>882</c:v>
                </c:pt>
                <c:pt idx="703">
                  <c:v>959</c:v>
                </c:pt>
                <c:pt idx="704">
                  <c:v>857</c:v>
                </c:pt>
                <c:pt idx="705">
                  <c:v>1066</c:v>
                </c:pt>
                <c:pt idx="706">
                  <c:v>1143</c:v>
                </c:pt>
                <c:pt idx="707">
                  <c:v>1585</c:v>
                </c:pt>
                <c:pt idx="708">
                  <c:v>898</c:v>
                </c:pt>
                <c:pt idx="709">
                  <c:v>1808</c:v>
                </c:pt>
                <c:pt idx="710">
                  <c:v>1832</c:v>
                </c:pt>
                <c:pt idx="711">
                  <c:v>1742</c:v>
                </c:pt>
                <c:pt idx="712">
                  <c:v>2094</c:v>
                </c:pt>
                <c:pt idx="713">
                  <c:v>1888</c:v>
                </c:pt>
                <c:pt idx="714">
                  <c:v>453</c:v>
                </c:pt>
                <c:pt idx="715">
                  <c:v>2090</c:v>
                </c:pt>
                <c:pt idx="716">
                  <c:v>2003</c:v>
                </c:pt>
                <c:pt idx="717">
                  <c:v>969</c:v>
                </c:pt>
                <c:pt idx="718">
                  <c:v>1189</c:v>
                </c:pt>
                <c:pt idx="719">
                  <c:v>631</c:v>
                </c:pt>
                <c:pt idx="720">
                  <c:v>1074</c:v>
                </c:pt>
                <c:pt idx="721">
                  <c:v>2011</c:v>
                </c:pt>
                <c:pt idx="722">
                  <c:v>994</c:v>
                </c:pt>
                <c:pt idx="723">
                  <c:v>1295</c:v>
                </c:pt>
                <c:pt idx="724">
                  <c:v>1368</c:v>
                </c:pt>
                <c:pt idx="725">
                  <c:v>1895</c:v>
                </c:pt>
                <c:pt idx="726">
                  <c:v>1488</c:v>
                </c:pt>
                <c:pt idx="727">
                  <c:v>783</c:v>
                </c:pt>
                <c:pt idx="728">
                  <c:v>1749</c:v>
                </c:pt>
                <c:pt idx="729">
                  <c:v>2043</c:v>
                </c:pt>
                <c:pt idx="730">
                  <c:v>723</c:v>
                </c:pt>
                <c:pt idx="731">
                  <c:v>1777</c:v>
                </c:pt>
                <c:pt idx="732">
                  <c:v>510</c:v>
                </c:pt>
                <c:pt idx="733">
                  <c:v>2088</c:v>
                </c:pt>
                <c:pt idx="734">
                  <c:v>1346</c:v>
                </c:pt>
                <c:pt idx="735">
                  <c:v>822</c:v>
                </c:pt>
                <c:pt idx="736">
                  <c:v>1304</c:v>
                </c:pt>
                <c:pt idx="737">
                  <c:v>563</c:v>
                </c:pt>
                <c:pt idx="738">
                  <c:v>1078</c:v>
                </c:pt>
                <c:pt idx="739">
                  <c:v>1995</c:v>
                </c:pt>
                <c:pt idx="740">
                  <c:v>1636</c:v>
                </c:pt>
                <c:pt idx="741">
                  <c:v>936</c:v>
                </c:pt>
                <c:pt idx="742">
                  <c:v>2063</c:v>
                </c:pt>
                <c:pt idx="743">
                  <c:v>1770</c:v>
                </c:pt>
                <c:pt idx="744">
                  <c:v>1556</c:v>
                </c:pt>
                <c:pt idx="745">
                  <c:v>2064</c:v>
                </c:pt>
                <c:pt idx="746">
                  <c:v>1989</c:v>
                </c:pt>
                <c:pt idx="747">
                  <c:v>1604</c:v>
                </c:pt>
                <c:pt idx="748">
                  <c:v>1236</c:v>
                </c:pt>
                <c:pt idx="749">
                  <c:v>518</c:v>
                </c:pt>
                <c:pt idx="750">
                  <c:v>2132</c:v>
                </c:pt>
                <c:pt idx="751">
                  <c:v>839</c:v>
                </c:pt>
                <c:pt idx="752">
                  <c:v>2137</c:v>
                </c:pt>
                <c:pt idx="753">
                  <c:v>1697</c:v>
                </c:pt>
                <c:pt idx="754">
                  <c:v>1580</c:v>
                </c:pt>
                <c:pt idx="755">
                  <c:v>1578</c:v>
                </c:pt>
                <c:pt idx="756">
                  <c:v>2082</c:v>
                </c:pt>
                <c:pt idx="757">
                  <c:v>1853</c:v>
                </c:pt>
                <c:pt idx="758">
                  <c:v>1064</c:v>
                </c:pt>
                <c:pt idx="759">
                  <c:v>1994</c:v>
                </c:pt>
                <c:pt idx="760">
                  <c:v>2168</c:v>
                </c:pt>
                <c:pt idx="761">
                  <c:v>2057</c:v>
                </c:pt>
                <c:pt idx="762">
                  <c:v>1854</c:v>
                </c:pt>
                <c:pt idx="763">
                  <c:v>1104</c:v>
                </c:pt>
                <c:pt idx="764">
                  <c:v>785</c:v>
                </c:pt>
                <c:pt idx="765">
                  <c:v>1719</c:v>
                </c:pt>
                <c:pt idx="766">
                  <c:v>1708</c:v>
                </c:pt>
                <c:pt idx="767">
                  <c:v>1600</c:v>
                </c:pt>
                <c:pt idx="768">
                  <c:v>2037</c:v>
                </c:pt>
                <c:pt idx="769">
                  <c:v>1840</c:v>
                </c:pt>
                <c:pt idx="770">
                  <c:v>963</c:v>
                </c:pt>
                <c:pt idx="771">
                  <c:v>891</c:v>
                </c:pt>
                <c:pt idx="772">
                  <c:v>1149</c:v>
                </c:pt>
                <c:pt idx="773">
                  <c:v>1375</c:v>
                </c:pt>
                <c:pt idx="774">
                  <c:v>1993</c:v>
                </c:pt>
                <c:pt idx="775">
                  <c:v>1506</c:v>
                </c:pt>
                <c:pt idx="776">
                  <c:v>1886</c:v>
                </c:pt>
                <c:pt idx="777">
                  <c:v>1373</c:v>
                </c:pt>
                <c:pt idx="778">
                  <c:v>865</c:v>
                </c:pt>
                <c:pt idx="779">
                  <c:v>1023</c:v>
                </c:pt>
                <c:pt idx="780">
                  <c:v>1819</c:v>
                </c:pt>
                <c:pt idx="781">
                  <c:v>987</c:v>
                </c:pt>
                <c:pt idx="782">
                  <c:v>1253</c:v>
                </c:pt>
                <c:pt idx="783">
                  <c:v>1545</c:v>
                </c:pt>
                <c:pt idx="784">
                  <c:v>1577</c:v>
                </c:pt>
                <c:pt idx="785">
                  <c:v>1863</c:v>
                </c:pt>
                <c:pt idx="786">
                  <c:v>1731</c:v>
                </c:pt>
                <c:pt idx="787">
                  <c:v>1331</c:v>
                </c:pt>
                <c:pt idx="788">
                  <c:v>1752</c:v>
                </c:pt>
                <c:pt idx="789">
                  <c:v>1572</c:v>
                </c:pt>
                <c:pt idx="790">
                  <c:v>1851</c:v>
                </c:pt>
                <c:pt idx="791">
                  <c:v>1560</c:v>
                </c:pt>
                <c:pt idx="792">
                  <c:v>1725</c:v>
                </c:pt>
                <c:pt idx="793">
                  <c:v>1833</c:v>
                </c:pt>
                <c:pt idx="794">
                  <c:v>2159</c:v>
                </c:pt>
                <c:pt idx="795">
                  <c:v>2038</c:v>
                </c:pt>
                <c:pt idx="796">
                  <c:v>1978</c:v>
                </c:pt>
                <c:pt idx="797">
                  <c:v>305</c:v>
                </c:pt>
                <c:pt idx="798">
                  <c:v>1134</c:v>
                </c:pt>
                <c:pt idx="799">
                  <c:v>1960</c:v>
                </c:pt>
                <c:pt idx="800">
                  <c:v>1017</c:v>
                </c:pt>
                <c:pt idx="801">
                  <c:v>1951</c:v>
                </c:pt>
                <c:pt idx="802">
                  <c:v>2054</c:v>
                </c:pt>
                <c:pt idx="803">
                  <c:v>1547</c:v>
                </c:pt>
                <c:pt idx="804">
                  <c:v>1805</c:v>
                </c:pt>
                <c:pt idx="805">
                  <c:v>539</c:v>
                </c:pt>
                <c:pt idx="806">
                  <c:v>1477</c:v>
                </c:pt>
                <c:pt idx="807">
                  <c:v>1323</c:v>
                </c:pt>
                <c:pt idx="808">
                  <c:v>1413</c:v>
                </c:pt>
                <c:pt idx="809">
                  <c:v>1804</c:v>
                </c:pt>
                <c:pt idx="810">
                  <c:v>1316</c:v>
                </c:pt>
                <c:pt idx="811">
                  <c:v>1563</c:v>
                </c:pt>
                <c:pt idx="812">
                  <c:v>1835</c:v>
                </c:pt>
                <c:pt idx="813">
                  <c:v>1901</c:v>
                </c:pt>
                <c:pt idx="814">
                  <c:v>1845</c:v>
                </c:pt>
                <c:pt idx="815">
                  <c:v>1828</c:v>
                </c:pt>
                <c:pt idx="816">
                  <c:v>1579</c:v>
                </c:pt>
                <c:pt idx="817">
                  <c:v>1486</c:v>
                </c:pt>
                <c:pt idx="818">
                  <c:v>2170</c:v>
                </c:pt>
                <c:pt idx="819">
                  <c:v>2055</c:v>
                </c:pt>
                <c:pt idx="820">
                  <c:v>1809</c:v>
                </c:pt>
                <c:pt idx="821">
                  <c:v>1029</c:v>
                </c:pt>
                <c:pt idx="822">
                  <c:v>1967</c:v>
                </c:pt>
                <c:pt idx="823">
                  <c:v>1897</c:v>
                </c:pt>
                <c:pt idx="824">
                  <c:v>1750</c:v>
                </c:pt>
                <c:pt idx="825">
                  <c:v>585</c:v>
                </c:pt>
                <c:pt idx="826">
                  <c:v>1676</c:v>
                </c:pt>
                <c:pt idx="827">
                  <c:v>770</c:v>
                </c:pt>
                <c:pt idx="828">
                  <c:v>1952</c:v>
                </c:pt>
                <c:pt idx="829">
                  <c:v>1772</c:v>
                </c:pt>
                <c:pt idx="830">
                  <c:v>1154</c:v>
                </c:pt>
                <c:pt idx="831">
                  <c:v>374</c:v>
                </c:pt>
                <c:pt idx="832">
                  <c:v>478</c:v>
                </c:pt>
                <c:pt idx="833">
                  <c:v>571</c:v>
                </c:pt>
                <c:pt idx="834">
                  <c:v>1036</c:v>
                </c:pt>
                <c:pt idx="835">
                  <c:v>2179</c:v>
                </c:pt>
                <c:pt idx="836">
                  <c:v>1366</c:v>
                </c:pt>
                <c:pt idx="837">
                  <c:v>1794</c:v>
                </c:pt>
                <c:pt idx="838">
                  <c:v>1884</c:v>
                </c:pt>
                <c:pt idx="839">
                  <c:v>1382</c:v>
                </c:pt>
                <c:pt idx="840">
                  <c:v>1598</c:v>
                </c:pt>
                <c:pt idx="841">
                  <c:v>819</c:v>
                </c:pt>
                <c:pt idx="842">
                  <c:v>1918</c:v>
                </c:pt>
                <c:pt idx="843">
                  <c:v>2068</c:v>
                </c:pt>
                <c:pt idx="844">
                  <c:v>1141</c:v>
                </c:pt>
                <c:pt idx="845">
                  <c:v>1830</c:v>
                </c:pt>
                <c:pt idx="846">
                  <c:v>2029</c:v>
                </c:pt>
                <c:pt idx="847">
                  <c:v>1628</c:v>
                </c:pt>
                <c:pt idx="848">
                  <c:v>1530</c:v>
                </c:pt>
                <c:pt idx="849">
                  <c:v>1699</c:v>
                </c:pt>
                <c:pt idx="850">
                  <c:v>1558</c:v>
                </c:pt>
                <c:pt idx="851">
                  <c:v>1860</c:v>
                </c:pt>
                <c:pt idx="852">
                  <c:v>1516</c:v>
                </c:pt>
                <c:pt idx="853">
                  <c:v>2087</c:v>
                </c:pt>
                <c:pt idx="854">
                  <c:v>1151</c:v>
                </c:pt>
                <c:pt idx="855">
                  <c:v>1259</c:v>
                </c:pt>
                <c:pt idx="856">
                  <c:v>2052</c:v>
                </c:pt>
                <c:pt idx="857">
                  <c:v>2096</c:v>
                </c:pt>
                <c:pt idx="858">
                  <c:v>1879</c:v>
                </c:pt>
                <c:pt idx="859">
                  <c:v>1350</c:v>
                </c:pt>
                <c:pt idx="860">
                  <c:v>2027</c:v>
                </c:pt>
                <c:pt idx="861">
                  <c:v>455</c:v>
                </c:pt>
                <c:pt idx="862">
                  <c:v>1914</c:v>
                </c:pt>
                <c:pt idx="863">
                  <c:v>594</c:v>
                </c:pt>
                <c:pt idx="864">
                  <c:v>2143</c:v>
                </c:pt>
                <c:pt idx="865">
                  <c:v>1069</c:v>
                </c:pt>
                <c:pt idx="866">
                  <c:v>1938</c:v>
                </c:pt>
                <c:pt idx="867">
                  <c:v>1969</c:v>
                </c:pt>
                <c:pt idx="868">
                  <c:v>1974</c:v>
                </c:pt>
              </c:numCache>
            </c:numRef>
          </c:xVal>
          <c:yVal>
            <c:numRef>
              <c:f>'Brachy LCR'!$E$4:$E$872</c:f>
              <c:numCache>
                <c:formatCode>General</c:formatCode>
                <c:ptCount val="869"/>
                <c:pt idx="2">
                  <c:v>1</c:v>
                </c:pt>
                <c:pt idx="5">
                  <c:v>1</c:v>
                </c:pt>
                <c:pt idx="6">
                  <c:v>1</c:v>
                </c:pt>
                <c:pt idx="9">
                  <c:v>1</c:v>
                </c:pt>
                <c:pt idx="12">
                  <c:v>1</c:v>
                </c:pt>
                <c:pt idx="15">
                  <c:v>3</c:v>
                </c:pt>
                <c:pt idx="22">
                  <c:v>1</c:v>
                </c:pt>
                <c:pt idx="26">
                  <c:v>1</c:v>
                </c:pt>
                <c:pt idx="28">
                  <c:v>1</c:v>
                </c:pt>
                <c:pt idx="30">
                  <c:v>1</c:v>
                </c:pt>
                <c:pt idx="31">
                  <c:v>1</c:v>
                </c:pt>
                <c:pt idx="32">
                  <c:v>1</c:v>
                </c:pt>
                <c:pt idx="33">
                  <c:v>1</c:v>
                </c:pt>
                <c:pt idx="37">
                  <c:v>1</c:v>
                </c:pt>
                <c:pt idx="38">
                  <c:v>1</c:v>
                </c:pt>
                <c:pt idx="39">
                  <c:v>1</c:v>
                </c:pt>
                <c:pt idx="40">
                  <c:v>1</c:v>
                </c:pt>
                <c:pt idx="41">
                  <c:v>1</c:v>
                </c:pt>
                <c:pt idx="42">
                  <c:v>1</c:v>
                </c:pt>
                <c:pt idx="43">
                  <c:v>1</c:v>
                </c:pt>
                <c:pt idx="44">
                  <c:v>1</c:v>
                </c:pt>
                <c:pt idx="45">
                  <c:v>1</c:v>
                </c:pt>
                <c:pt idx="49">
                  <c:v>1</c:v>
                </c:pt>
                <c:pt idx="50">
                  <c:v>1</c:v>
                </c:pt>
                <c:pt idx="54">
                  <c:v>1</c:v>
                </c:pt>
                <c:pt idx="55">
                  <c:v>1</c:v>
                </c:pt>
                <c:pt idx="61">
                  <c:v>1</c:v>
                </c:pt>
                <c:pt idx="63">
                  <c:v>1</c:v>
                </c:pt>
                <c:pt idx="64">
                  <c:v>1</c:v>
                </c:pt>
                <c:pt idx="67">
                  <c:v>1</c:v>
                </c:pt>
                <c:pt idx="68">
                  <c:v>1</c:v>
                </c:pt>
                <c:pt idx="70">
                  <c:v>1</c:v>
                </c:pt>
                <c:pt idx="71">
                  <c:v>1</c:v>
                </c:pt>
                <c:pt idx="72">
                  <c:v>1</c:v>
                </c:pt>
                <c:pt idx="73">
                  <c:v>1</c:v>
                </c:pt>
                <c:pt idx="74">
                  <c:v>1</c:v>
                </c:pt>
                <c:pt idx="75">
                  <c:v>1</c:v>
                </c:pt>
                <c:pt idx="76">
                  <c:v>1</c:v>
                </c:pt>
                <c:pt idx="78">
                  <c:v>1</c:v>
                </c:pt>
                <c:pt idx="81">
                  <c:v>1</c:v>
                </c:pt>
                <c:pt idx="87">
                  <c:v>1</c:v>
                </c:pt>
                <c:pt idx="88">
                  <c:v>1</c:v>
                </c:pt>
                <c:pt idx="89">
                  <c:v>1</c:v>
                </c:pt>
                <c:pt idx="90">
                  <c:v>1</c:v>
                </c:pt>
                <c:pt idx="93">
                  <c:v>2</c:v>
                </c:pt>
                <c:pt idx="97">
                  <c:v>1</c:v>
                </c:pt>
                <c:pt idx="98">
                  <c:v>1</c:v>
                </c:pt>
                <c:pt idx="99">
                  <c:v>1</c:v>
                </c:pt>
                <c:pt idx="101">
                  <c:v>1</c:v>
                </c:pt>
                <c:pt idx="103">
                  <c:v>1</c:v>
                </c:pt>
                <c:pt idx="104">
                  <c:v>1</c:v>
                </c:pt>
                <c:pt idx="105">
                  <c:v>1</c:v>
                </c:pt>
                <c:pt idx="108">
                  <c:v>1</c:v>
                </c:pt>
                <c:pt idx="109">
                  <c:v>1</c:v>
                </c:pt>
                <c:pt idx="112">
                  <c:v>1</c:v>
                </c:pt>
                <c:pt idx="114">
                  <c:v>1</c:v>
                </c:pt>
                <c:pt idx="115">
                  <c:v>1</c:v>
                </c:pt>
                <c:pt idx="116">
                  <c:v>1</c:v>
                </c:pt>
                <c:pt idx="117">
                  <c:v>1</c:v>
                </c:pt>
                <c:pt idx="118">
                  <c:v>1</c:v>
                </c:pt>
                <c:pt idx="123">
                  <c:v>1</c:v>
                </c:pt>
                <c:pt idx="126">
                  <c:v>1</c:v>
                </c:pt>
                <c:pt idx="128">
                  <c:v>1</c:v>
                </c:pt>
                <c:pt idx="129">
                  <c:v>1</c:v>
                </c:pt>
                <c:pt idx="130">
                  <c:v>1</c:v>
                </c:pt>
                <c:pt idx="132">
                  <c:v>1</c:v>
                </c:pt>
                <c:pt idx="133">
                  <c:v>1</c:v>
                </c:pt>
                <c:pt idx="136">
                  <c:v>1</c:v>
                </c:pt>
                <c:pt idx="139">
                  <c:v>1</c:v>
                </c:pt>
                <c:pt idx="145">
                  <c:v>1</c:v>
                </c:pt>
                <c:pt idx="148">
                  <c:v>1</c:v>
                </c:pt>
                <c:pt idx="149">
                  <c:v>1</c:v>
                </c:pt>
                <c:pt idx="153">
                  <c:v>1</c:v>
                </c:pt>
                <c:pt idx="154">
                  <c:v>1</c:v>
                </c:pt>
                <c:pt idx="159">
                  <c:v>1</c:v>
                </c:pt>
                <c:pt idx="160">
                  <c:v>-1</c:v>
                </c:pt>
                <c:pt idx="162">
                  <c:v>1</c:v>
                </c:pt>
                <c:pt idx="163">
                  <c:v>1</c:v>
                </c:pt>
                <c:pt idx="164">
                  <c:v>1</c:v>
                </c:pt>
                <c:pt idx="170">
                  <c:v>1</c:v>
                </c:pt>
                <c:pt idx="171">
                  <c:v>1</c:v>
                </c:pt>
                <c:pt idx="175">
                  <c:v>1</c:v>
                </c:pt>
                <c:pt idx="177">
                  <c:v>1</c:v>
                </c:pt>
                <c:pt idx="180">
                  <c:v>1</c:v>
                </c:pt>
                <c:pt idx="182">
                  <c:v>1</c:v>
                </c:pt>
                <c:pt idx="187">
                  <c:v>1</c:v>
                </c:pt>
                <c:pt idx="188">
                  <c:v>1</c:v>
                </c:pt>
                <c:pt idx="189">
                  <c:v>1</c:v>
                </c:pt>
                <c:pt idx="193">
                  <c:v>1</c:v>
                </c:pt>
                <c:pt idx="194">
                  <c:v>1</c:v>
                </c:pt>
                <c:pt idx="197">
                  <c:v>1</c:v>
                </c:pt>
                <c:pt idx="198">
                  <c:v>1</c:v>
                </c:pt>
                <c:pt idx="200">
                  <c:v>1</c:v>
                </c:pt>
                <c:pt idx="206">
                  <c:v>1</c:v>
                </c:pt>
                <c:pt idx="208">
                  <c:v>1</c:v>
                </c:pt>
                <c:pt idx="210">
                  <c:v>1</c:v>
                </c:pt>
                <c:pt idx="211">
                  <c:v>1</c:v>
                </c:pt>
                <c:pt idx="213">
                  <c:v>1</c:v>
                </c:pt>
                <c:pt idx="215">
                  <c:v>1</c:v>
                </c:pt>
                <c:pt idx="217">
                  <c:v>1</c:v>
                </c:pt>
                <c:pt idx="219">
                  <c:v>1</c:v>
                </c:pt>
                <c:pt idx="220">
                  <c:v>1</c:v>
                </c:pt>
                <c:pt idx="228">
                  <c:v>1</c:v>
                </c:pt>
                <c:pt idx="229">
                  <c:v>1</c:v>
                </c:pt>
                <c:pt idx="232">
                  <c:v>1</c:v>
                </c:pt>
                <c:pt idx="233">
                  <c:v>1</c:v>
                </c:pt>
                <c:pt idx="236">
                  <c:v>1</c:v>
                </c:pt>
                <c:pt idx="237">
                  <c:v>1</c:v>
                </c:pt>
                <c:pt idx="239">
                  <c:v>1</c:v>
                </c:pt>
                <c:pt idx="242">
                  <c:v>2</c:v>
                </c:pt>
                <c:pt idx="244">
                  <c:v>5</c:v>
                </c:pt>
                <c:pt idx="245">
                  <c:v>1</c:v>
                </c:pt>
                <c:pt idx="246">
                  <c:v>1</c:v>
                </c:pt>
                <c:pt idx="252">
                  <c:v>1</c:v>
                </c:pt>
                <c:pt idx="253">
                  <c:v>1</c:v>
                </c:pt>
                <c:pt idx="261">
                  <c:v>1</c:v>
                </c:pt>
                <c:pt idx="262">
                  <c:v>1</c:v>
                </c:pt>
                <c:pt idx="266">
                  <c:v>1</c:v>
                </c:pt>
                <c:pt idx="268">
                  <c:v>1</c:v>
                </c:pt>
                <c:pt idx="271">
                  <c:v>1</c:v>
                </c:pt>
                <c:pt idx="276">
                  <c:v>1</c:v>
                </c:pt>
                <c:pt idx="279">
                  <c:v>1</c:v>
                </c:pt>
                <c:pt idx="281">
                  <c:v>1</c:v>
                </c:pt>
                <c:pt idx="283">
                  <c:v>1</c:v>
                </c:pt>
                <c:pt idx="285">
                  <c:v>1</c:v>
                </c:pt>
                <c:pt idx="286">
                  <c:v>1</c:v>
                </c:pt>
                <c:pt idx="287">
                  <c:v>1</c:v>
                </c:pt>
                <c:pt idx="289">
                  <c:v>1</c:v>
                </c:pt>
                <c:pt idx="290">
                  <c:v>1</c:v>
                </c:pt>
                <c:pt idx="291">
                  <c:v>1</c:v>
                </c:pt>
                <c:pt idx="292">
                  <c:v>1</c:v>
                </c:pt>
                <c:pt idx="297">
                  <c:v>2</c:v>
                </c:pt>
                <c:pt idx="299">
                  <c:v>1</c:v>
                </c:pt>
                <c:pt idx="302">
                  <c:v>1</c:v>
                </c:pt>
                <c:pt idx="305">
                  <c:v>1</c:v>
                </c:pt>
                <c:pt idx="307">
                  <c:v>1</c:v>
                </c:pt>
                <c:pt idx="308">
                  <c:v>1</c:v>
                </c:pt>
                <c:pt idx="309">
                  <c:v>1</c:v>
                </c:pt>
                <c:pt idx="310">
                  <c:v>1</c:v>
                </c:pt>
                <c:pt idx="311">
                  <c:v>1</c:v>
                </c:pt>
                <c:pt idx="313">
                  <c:v>1</c:v>
                </c:pt>
                <c:pt idx="314">
                  <c:v>1</c:v>
                </c:pt>
                <c:pt idx="315">
                  <c:v>1</c:v>
                </c:pt>
                <c:pt idx="319">
                  <c:v>1</c:v>
                </c:pt>
                <c:pt idx="320">
                  <c:v>1</c:v>
                </c:pt>
                <c:pt idx="323">
                  <c:v>1</c:v>
                </c:pt>
                <c:pt idx="324">
                  <c:v>1</c:v>
                </c:pt>
                <c:pt idx="325">
                  <c:v>1</c:v>
                </c:pt>
                <c:pt idx="327">
                  <c:v>1</c:v>
                </c:pt>
                <c:pt idx="334">
                  <c:v>1</c:v>
                </c:pt>
                <c:pt idx="335">
                  <c:v>1</c:v>
                </c:pt>
                <c:pt idx="336">
                  <c:v>1</c:v>
                </c:pt>
                <c:pt idx="337">
                  <c:v>1</c:v>
                </c:pt>
                <c:pt idx="340">
                  <c:v>1</c:v>
                </c:pt>
                <c:pt idx="341">
                  <c:v>1</c:v>
                </c:pt>
                <c:pt idx="342">
                  <c:v>1</c:v>
                </c:pt>
                <c:pt idx="343">
                  <c:v>1</c:v>
                </c:pt>
                <c:pt idx="345">
                  <c:v>1</c:v>
                </c:pt>
                <c:pt idx="347">
                  <c:v>3</c:v>
                </c:pt>
                <c:pt idx="352">
                  <c:v>1</c:v>
                </c:pt>
                <c:pt idx="353">
                  <c:v>1</c:v>
                </c:pt>
                <c:pt idx="354">
                  <c:v>1</c:v>
                </c:pt>
                <c:pt idx="355">
                  <c:v>1</c:v>
                </c:pt>
                <c:pt idx="358">
                  <c:v>1</c:v>
                </c:pt>
                <c:pt idx="361">
                  <c:v>1</c:v>
                </c:pt>
                <c:pt idx="368">
                  <c:v>1</c:v>
                </c:pt>
                <c:pt idx="369">
                  <c:v>1</c:v>
                </c:pt>
                <c:pt idx="370">
                  <c:v>1</c:v>
                </c:pt>
                <c:pt idx="371">
                  <c:v>1</c:v>
                </c:pt>
                <c:pt idx="373">
                  <c:v>1</c:v>
                </c:pt>
                <c:pt idx="374">
                  <c:v>1</c:v>
                </c:pt>
                <c:pt idx="377">
                  <c:v>1</c:v>
                </c:pt>
                <c:pt idx="378">
                  <c:v>1</c:v>
                </c:pt>
                <c:pt idx="379">
                  <c:v>1</c:v>
                </c:pt>
                <c:pt idx="380">
                  <c:v>1</c:v>
                </c:pt>
                <c:pt idx="381">
                  <c:v>1</c:v>
                </c:pt>
                <c:pt idx="384">
                  <c:v>1</c:v>
                </c:pt>
                <c:pt idx="391">
                  <c:v>1</c:v>
                </c:pt>
                <c:pt idx="392">
                  <c:v>1</c:v>
                </c:pt>
                <c:pt idx="394">
                  <c:v>1</c:v>
                </c:pt>
                <c:pt idx="395">
                  <c:v>1</c:v>
                </c:pt>
                <c:pt idx="399">
                  <c:v>1</c:v>
                </c:pt>
                <c:pt idx="401">
                  <c:v>1</c:v>
                </c:pt>
                <c:pt idx="404">
                  <c:v>1</c:v>
                </c:pt>
                <c:pt idx="405">
                  <c:v>1</c:v>
                </c:pt>
                <c:pt idx="407">
                  <c:v>1</c:v>
                </c:pt>
                <c:pt idx="408">
                  <c:v>1</c:v>
                </c:pt>
                <c:pt idx="412">
                  <c:v>1</c:v>
                </c:pt>
                <c:pt idx="416">
                  <c:v>1</c:v>
                </c:pt>
                <c:pt idx="418">
                  <c:v>1</c:v>
                </c:pt>
                <c:pt idx="422">
                  <c:v>1</c:v>
                </c:pt>
                <c:pt idx="423">
                  <c:v>1</c:v>
                </c:pt>
                <c:pt idx="424">
                  <c:v>1</c:v>
                </c:pt>
                <c:pt idx="425">
                  <c:v>47</c:v>
                </c:pt>
                <c:pt idx="427">
                  <c:v>1</c:v>
                </c:pt>
                <c:pt idx="431">
                  <c:v>1</c:v>
                </c:pt>
                <c:pt idx="432">
                  <c:v>1</c:v>
                </c:pt>
                <c:pt idx="436">
                  <c:v>1</c:v>
                </c:pt>
                <c:pt idx="437">
                  <c:v>1</c:v>
                </c:pt>
                <c:pt idx="439">
                  <c:v>1</c:v>
                </c:pt>
                <c:pt idx="441">
                  <c:v>1</c:v>
                </c:pt>
                <c:pt idx="442">
                  <c:v>1</c:v>
                </c:pt>
                <c:pt idx="445">
                  <c:v>1</c:v>
                </c:pt>
                <c:pt idx="446">
                  <c:v>1</c:v>
                </c:pt>
                <c:pt idx="448">
                  <c:v>1</c:v>
                </c:pt>
                <c:pt idx="449">
                  <c:v>2</c:v>
                </c:pt>
                <c:pt idx="450">
                  <c:v>1</c:v>
                </c:pt>
                <c:pt idx="453">
                  <c:v>1</c:v>
                </c:pt>
                <c:pt idx="454">
                  <c:v>1</c:v>
                </c:pt>
                <c:pt idx="455">
                  <c:v>1</c:v>
                </c:pt>
                <c:pt idx="459">
                  <c:v>1</c:v>
                </c:pt>
                <c:pt idx="460">
                  <c:v>1</c:v>
                </c:pt>
                <c:pt idx="467">
                  <c:v>1</c:v>
                </c:pt>
                <c:pt idx="468">
                  <c:v>1</c:v>
                </c:pt>
                <c:pt idx="470">
                  <c:v>1</c:v>
                </c:pt>
                <c:pt idx="474">
                  <c:v>1</c:v>
                </c:pt>
                <c:pt idx="475">
                  <c:v>1</c:v>
                </c:pt>
                <c:pt idx="478">
                  <c:v>1</c:v>
                </c:pt>
                <c:pt idx="479">
                  <c:v>1</c:v>
                </c:pt>
                <c:pt idx="480">
                  <c:v>1</c:v>
                </c:pt>
                <c:pt idx="481">
                  <c:v>1</c:v>
                </c:pt>
                <c:pt idx="482">
                  <c:v>1</c:v>
                </c:pt>
                <c:pt idx="485">
                  <c:v>1</c:v>
                </c:pt>
                <c:pt idx="493">
                  <c:v>1</c:v>
                </c:pt>
                <c:pt idx="494">
                  <c:v>1</c:v>
                </c:pt>
                <c:pt idx="495">
                  <c:v>1</c:v>
                </c:pt>
                <c:pt idx="498">
                  <c:v>1</c:v>
                </c:pt>
                <c:pt idx="499">
                  <c:v>1</c:v>
                </c:pt>
                <c:pt idx="502">
                  <c:v>1</c:v>
                </c:pt>
                <c:pt idx="504">
                  <c:v>1</c:v>
                </c:pt>
                <c:pt idx="506">
                  <c:v>1</c:v>
                </c:pt>
                <c:pt idx="507">
                  <c:v>1</c:v>
                </c:pt>
                <c:pt idx="508">
                  <c:v>1</c:v>
                </c:pt>
                <c:pt idx="514">
                  <c:v>1</c:v>
                </c:pt>
                <c:pt idx="515">
                  <c:v>1</c:v>
                </c:pt>
                <c:pt idx="516">
                  <c:v>1</c:v>
                </c:pt>
                <c:pt idx="518">
                  <c:v>1</c:v>
                </c:pt>
                <c:pt idx="521">
                  <c:v>1</c:v>
                </c:pt>
                <c:pt idx="523">
                  <c:v>1</c:v>
                </c:pt>
                <c:pt idx="524">
                  <c:v>1</c:v>
                </c:pt>
                <c:pt idx="525">
                  <c:v>1</c:v>
                </c:pt>
                <c:pt idx="526">
                  <c:v>1</c:v>
                </c:pt>
                <c:pt idx="528">
                  <c:v>1</c:v>
                </c:pt>
                <c:pt idx="529">
                  <c:v>1</c:v>
                </c:pt>
                <c:pt idx="531">
                  <c:v>1</c:v>
                </c:pt>
                <c:pt idx="533">
                  <c:v>1</c:v>
                </c:pt>
                <c:pt idx="534">
                  <c:v>1</c:v>
                </c:pt>
                <c:pt idx="535">
                  <c:v>1</c:v>
                </c:pt>
                <c:pt idx="537">
                  <c:v>1</c:v>
                </c:pt>
                <c:pt idx="538">
                  <c:v>1</c:v>
                </c:pt>
                <c:pt idx="539">
                  <c:v>1</c:v>
                </c:pt>
                <c:pt idx="541">
                  <c:v>1</c:v>
                </c:pt>
                <c:pt idx="545">
                  <c:v>1</c:v>
                </c:pt>
                <c:pt idx="547">
                  <c:v>1</c:v>
                </c:pt>
                <c:pt idx="548">
                  <c:v>1</c:v>
                </c:pt>
                <c:pt idx="551">
                  <c:v>1</c:v>
                </c:pt>
                <c:pt idx="559">
                  <c:v>1</c:v>
                </c:pt>
                <c:pt idx="561">
                  <c:v>1</c:v>
                </c:pt>
                <c:pt idx="564">
                  <c:v>1</c:v>
                </c:pt>
                <c:pt idx="572">
                  <c:v>1</c:v>
                </c:pt>
                <c:pt idx="573">
                  <c:v>1</c:v>
                </c:pt>
                <c:pt idx="574">
                  <c:v>1</c:v>
                </c:pt>
                <c:pt idx="577">
                  <c:v>-1</c:v>
                </c:pt>
                <c:pt idx="579">
                  <c:v>1</c:v>
                </c:pt>
                <c:pt idx="580">
                  <c:v>1</c:v>
                </c:pt>
                <c:pt idx="582">
                  <c:v>1</c:v>
                </c:pt>
                <c:pt idx="583">
                  <c:v>1</c:v>
                </c:pt>
                <c:pt idx="584">
                  <c:v>1</c:v>
                </c:pt>
                <c:pt idx="587">
                  <c:v>1</c:v>
                </c:pt>
                <c:pt idx="588">
                  <c:v>1</c:v>
                </c:pt>
                <c:pt idx="590">
                  <c:v>1</c:v>
                </c:pt>
                <c:pt idx="591">
                  <c:v>1</c:v>
                </c:pt>
                <c:pt idx="592">
                  <c:v>1</c:v>
                </c:pt>
                <c:pt idx="595">
                  <c:v>1</c:v>
                </c:pt>
                <c:pt idx="596">
                  <c:v>1</c:v>
                </c:pt>
                <c:pt idx="599">
                  <c:v>1</c:v>
                </c:pt>
                <c:pt idx="601">
                  <c:v>1</c:v>
                </c:pt>
                <c:pt idx="603">
                  <c:v>1</c:v>
                </c:pt>
                <c:pt idx="605">
                  <c:v>1</c:v>
                </c:pt>
                <c:pt idx="608">
                  <c:v>1</c:v>
                </c:pt>
                <c:pt idx="611">
                  <c:v>1</c:v>
                </c:pt>
                <c:pt idx="612">
                  <c:v>1</c:v>
                </c:pt>
                <c:pt idx="613">
                  <c:v>2</c:v>
                </c:pt>
                <c:pt idx="614">
                  <c:v>1</c:v>
                </c:pt>
                <c:pt idx="615">
                  <c:v>1</c:v>
                </c:pt>
                <c:pt idx="616">
                  <c:v>1</c:v>
                </c:pt>
                <c:pt idx="617">
                  <c:v>1</c:v>
                </c:pt>
                <c:pt idx="619">
                  <c:v>1</c:v>
                </c:pt>
                <c:pt idx="620">
                  <c:v>1</c:v>
                </c:pt>
                <c:pt idx="623">
                  <c:v>1</c:v>
                </c:pt>
                <c:pt idx="624">
                  <c:v>1</c:v>
                </c:pt>
                <c:pt idx="625">
                  <c:v>1</c:v>
                </c:pt>
                <c:pt idx="626">
                  <c:v>-1</c:v>
                </c:pt>
                <c:pt idx="627">
                  <c:v>1</c:v>
                </c:pt>
                <c:pt idx="631">
                  <c:v>1</c:v>
                </c:pt>
                <c:pt idx="639">
                  <c:v>1</c:v>
                </c:pt>
                <c:pt idx="640">
                  <c:v>1</c:v>
                </c:pt>
                <c:pt idx="641">
                  <c:v>1</c:v>
                </c:pt>
                <c:pt idx="644">
                  <c:v>1</c:v>
                </c:pt>
                <c:pt idx="648">
                  <c:v>1</c:v>
                </c:pt>
                <c:pt idx="650">
                  <c:v>1</c:v>
                </c:pt>
                <c:pt idx="652">
                  <c:v>1</c:v>
                </c:pt>
                <c:pt idx="653">
                  <c:v>1</c:v>
                </c:pt>
                <c:pt idx="656">
                  <c:v>1</c:v>
                </c:pt>
                <c:pt idx="662">
                  <c:v>1</c:v>
                </c:pt>
                <c:pt idx="668">
                  <c:v>1</c:v>
                </c:pt>
                <c:pt idx="670">
                  <c:v>1</c:v>
                </c:pt>
                <c:pt idx="672">
                  <c:v>1</c:v>
                </c:pt>
                <c:pt idx="674">
                  <c:v>1</c:v>
                </c:pt>
                <c:pt idx="676">
                  <c:v>1</c:v>
                </c:pt>
                <c:pt idx="677">
                  <c:v>1</c:v>
                </c:pt>
                <c:pt idx="679">
                  <c:v>1</c:v>
                </c:pt>
                <c:pt idx="681">
                  <c:v>1</c:v>
                </c:pt>
                <c:pt idx="685">
                  <c:v>1</c:v>
                </c:pt>
                <c:pt idx="687">
                  <c:v>1</c:v>
                </c:pt>
                <c:pt idx="688">
                  <c:v>1</c:v>
                </c:pt>
                <c:pt idx="689">
                  <c:v>1</c:v>
                </c:pt>
                <c:pt idx="691">
                  <c:v>1</c:v>
                </c:pt>
                <c:pt idx="694">
                  <c:v>1</c:v>
                </c:pt>
                <c:pt idx="695">
                  <c:v>1</c:v>
                </c:pt>
                <c:pt idx="701">
                  <c:v>1</c:v>
                </c:pt>
                <c:pt idx="703">
                  <c:v>1</c:v>
                </c:pt>
                <c:pt idx="708">
                  <c:v>1</c:v>
                </c:pt>
                <c:pt idx="709">
                  <c:v>1</c:v>
                </c:pt>
                <c:pt idx="710">
                  <c:v>1</c:v>
                </c:pt>
                <c:pt idx="711">
                  <c:v>1</c:v>
                </c:pt>
                <c:pt idx="712">
                  <c:v>1</c:v>
                </c:pt>
                <c:pt idx="713">
                  <c:v>1</c:v>
                </c:pt>
                <c:pt idx="715">
                  <c:v>1</c:v>
                </c:pt>
                <c:pt idx="716">
                  <c:v>1</c:v>
                </c:pt>
                <c:pt idx="717">
                  <c:v>1</c:v>
                </c:pt>
                <c:pt idx="720">
                  <c:v>1</c:v>
                </c:pt>
                <c:pt idx="722">
                  <c:v>1</c:v>
                </c:pt>
                <c:pt idx="726">
                  <c:v>-2</c:v>
                </c:pt>
                <c:pt idx="729">
                  <c:v>1</c:v>
                </c:pt>
                <c:pt idx="731">
                  <c:v>1</c:v>
                </c:pt>
                <c:pt idx="733">
                  <c:v>1</c:v>
                </c:pt>
                <c:pt idx="736">
                  <c:v>1</c:v>
                </c:pt>
                <c:pt idx="739">
                  <c:v>1</c:v>
                </c:pt>
                <c:pt idx="745">
                  <c:v>1</c:v>
                </c:pt>
                <c:pt idx="747">
                  <c:v>1</c:v>
                </c:pt>
                <c:pt idx="750">
                  <c:v>1</c:v>
                </c:pt>
                <c:pt idx="751">
                  <c:v>1</c:v>
                </c:pt>
                <c:pt idx="756">
                  <c:v>1</c:v>
                </c:pt>
                <c:pt idx="759">
                  <c:v>1</c:v>
                </c:pt>
                <c:pt idx="760">
                  <c:v>1</c:v>
                </c:pt>
                <c:pt idx="761">
                  <c:v>1</c:v>
                </c:pt>
                <c:pt idx="762">
                  <c:v>1</c:v>
                </c:pt>
                <c:pt idx="767">
                  <c:v>1</c:v>
                </c:pt>
                <c:pt idx="768">
                  <c:v>1</c:v>
                </c:pt>
                <c:pt idx="771">
                  <c:v>1</c:v>
                </c:pt>
                <c:pt idx="772">
                  <c:v>1</c:v>
                </c:pt>
                <c:pt idx="776">
                  <c:v>1</c:v>
                </c:pt>
                <c:pt idx="778">
                  <c:v>1</c:v>
                </c:pt>
                <c:pt idx="780">
                  <c:v>1</c:v>
                </c:pt>
                <c:pt idx="783">
                  <c:v>1</c:v>
                </c:pt>
                <c:pt idx="785">
                  <c:v>1</c:v>
                </c:pt>
                <c:pt idx="786">
                  <c:v>1</c:v>
                </c:pt>
                <c:pt idx="789">
                  <c:v>1</c:v>
                </c:pt>
                <c:pt idx="790">
                  <c:v>1</c:v>
                </c:pt>
                <c:pt idx="792">
                  <c:v>1</c:v>
                </c:pt>
                <c:pt idx="793">
                  <c:v>1</c:v>
                </c:pt>
                <c:pt idx="794">
                  <c:v>1</c:v>
                </c:pt>
                <c:pt idx="795">
                  <c:v>1</c:v>
                </c:pt>
                <c:pt idx="796">
                  <c:v>1</c:v>
                </c:pt>
                <c:pt idx="799">
                  <c:v>1</c:v>
                </c:pt>
                <c:pt idx="802">
                  <c:v>1</c:v>
                </c:pt>
                <c:pt idx="804">
                  <c:v>1</c:v>
                </c:pt>
                <c:pt idx="809">
                  <c:v>1</c:v>
                </c:pt>
                <c:pt idx="811">
                  <c:v>1</c:v>
                </c:pt>
                <c:pt idx="812">
                  <c:v>1</c:v>
                </c:pt>
                <c:pt idx="814">
                  <c:v>1</c:v>
                </c:pt>
                <c:pt idx="816">
                  <c:v>1</c:v>
                </c:pt>
                <c:pt idx="818">
                  <c:v>1</c:v>
                </c:pt>
                <c:pt idx="819">
                  <c:v>1</c:v>
                </c:pt>
                <c:pt idx="822">
                  <c:v>1</c:v>
                </c:pt>
                <c:pt idx="823">
                  <c:v>1</c:v>
                </c:pt>
                <c:pt idx="824">
                  <c:v>1</c:v>
                </c:pt>
                <c:pt idx="826">
                  <c:v>1</c:v>
                </c:pt>
                <c:pt idx="829">
                  <c:v>1</c:v>
                </c:pt>
                <c:pt idx="831">
                  <c:v>-1</c:v>
                </c:pt>
                <c:pt idx="832">
                  <c:v>1</c:v>
                </c:pt>
                <c:pt idx="835">
                  <c:v>1</c:v>
                </c:pt>
                <c:pt idx="836">
                  <c:v>1</c:v>
                </c:pt>
                <c:pt idx="837">
                  <c:v>1</c:v>
                </c:pt>
                <c:pt idx="839">
                  <c:v>1</c:v>
                </c:pt>
                <c:pt idx="841">
                  <c:v>1</c:v>
                </c:pt>
                <c:pt idx="843">
                  <c:v>1</c:v>
                </c:pt>
                <c:pt idx="847">
                  <c:v>1</c:v>
                </c:pt>
                <c:pt idx="848">
                  <c:v>1</c:v>
                </c:pt>
                <c:pt idx="849">
                  <c:v>1</c:v>
                </c:pt>
                <c:pt idx="851">
                  <c:v>1</c:v>
                </c:pt>
                <c:pt idx="853">
                  <c:v>1</c:v>
                </c:pt>
                <c:pt idx="855">
                  <c:v>1</c:v>
                </c:pt>
                <c:pt idx="857">
                  <c:v>1</c:v>
                </c:pt>
                <c:pt idx="858">
                  <c:v>1</c:v>
                </c:pt>
                <c:pt idx="862">
                  <c:v>1</c:v>
                </c:pt>
                <c:pt idx="864">
                  <c:v>1</c:v>
                </c:pt>
                <c:pt idx="866">
                  <c:v>1</c:v>
                </c:pt>
                <c:pt idx="867">
                  <c:v>1</c:v>
                </c:pt>
                <c:pt idx="868">
                  <c:v>1</c:v>
                </c:pt>
              </c:numCache>
            </c:numRef>
          </c:yVal>
          <c:smooth val="0"/>
        </c:ser>
        <c:dLbls>
          <c:showLegendKey val="0"/>
          <c:showVal val="0"/>
          <c:showCatName val="0"/>
          <c:showSerName val="0"/>
          <c:showPercent val="0"/>
          <c:showBubbleSize val="0"/>
        </c:dLbls>
        <c:axId val="476427640"/>
        <c:axId val="476428032"/>
      </c:scatterChart>
      <c:valAx>
        <c:axId val="476427640"/>
        <c:scaling>
          <c:orientation val="minMax"/>
          <c:max val="2300"/>
          <c:min val="0"/>
        </c:scaling>
        <c:delete val="0"/>
        <c:axPos val="b"/>
        <c:title>
          <c:tx>
            <c:rich>
              <a:bodyPr/>
              <a:lstStyle/>
              <a:p>
                <a:pPr>
                  <a:defRPr sz="800"/>
                </a:pPr>
                <a:r>
                  <a:rPr lang="en-US" sz="800"/>
                  <a:t>cDNA Position</a:t>
                </a:r>
              </a:p>
            </c:rich>
          </c:tx>
          <c:layout/>
          <c:overlay val="0"/>
        </c:title>
        <c:numFmt formatCode="General" sourceLinked="1"/>
        <c:majorTickMark val="out"/>
        <c:minorTickMark val="none"/>
        <c:tickLblPos val="nextTo"/>
        <c:spPr>
          <a:ln>
            <a:solidFill>
              <a:schemeClr val="tx1"/>
            </a:solidFill>
          </a:ln>
        </c:spPr>
        <c:txPr>
          <a:bodyPr/>
          <a:lstStyle/>
          <a:p>
            <a:pPr>
              <a:defRPr sz="800"/>
            </a:pPr>
            <a:endParaRPr lang="en-US"/>
          </a:p>
        </c:txPr>
        <c:crossAx val="476428032"/>
        <c:crosses val="autoZero"/>
        <c:crossBetween val="midCat"/>
      </c:valAx>
      <c:valAx>
        <c:axId val="476428032"/>
        <c:scaling>
          <c:orientation val="minMax"/>
          <c:max val="250"/>
          <c:min val="0"/>
        </c:scaling>
        <c:delete val="0"/>
        <c:axPos val="l"/>
        <c:title>
          <c:tx>
            <c:rich>
              <a:bodyPr rot="-5400000" vert="horz"/>
              <a:lstStyle/>
              <a:p>
                <a:pPr>
                  <a:defRPr sz="800"/>
                </a:pPr>
                <a:r>
                  <a:rPr lang="en-US" sz="800"/>
                  <a:t>PARE Abundance (TP10M)</a:t>
                </a:r>
              </a:p>
            </c:rich>
          </c:tx>
          <c:layout/>
          <c:overlay val="0"/>
        </c:title>
        <c:numFmt formatCode="General" sourceLinked="1"/>
        <c:majorTickMark val="out"/>
        <c:minorTickMark val="none"/>
        <c:tickLblPos val="nextTo"/>
        <c:spPr>
          <a:ln>
            <a:solidFill>
              <a:schemeClr val="tx1"/>
            </a:solidFill>
          </a:ln>
        </c:spPr>
        <c:txPr>
          <a:bodyPr/>
          <a:lstStyle/>
          <a:p>
            <a:pPr>
              <a:defRPr sz="800"/>
            </a:pPr>
            <a:endParaRPr lang="en-US"/>
          </a:p>
        </c:txPr>
        <c:crossAx val="476427640"/>
        <c:crosses val="autoZero"/>
        <c:crossBetween val="midCat"/>
        <c:majorUnit val="30"/>
      </c:valAx>
    </c:plotArea>
    <c:plotVisOnly val="1"/>
    <c:dispBlanksAs val="gap"/>
    <c:showDLblsOverMax val="0"/>
  </c:chart>
  <c:spPr>
    <a:ln>
      <a:solidFill>
        <a:schemeClr val="tx1"/>
      </a:solidFill>
    </a:ln>
  </c:spPr>
  <c:externalData r:id="rId1">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sz="1400" b="0" i="0" u="none" strike="noStrike" baseline="0">
                <a:effectLst/>
              </a:rPr>
              <a:t>Bradi1g11800.5 Biorep 2</a:t>
            </a:r>
            <a:endParaRPr lang="en-US"/>
          </a:p>
        </c:rich>
      </c:tx>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barChart>
        <c:barDir val="col"/>
        <c:grouping val="clustered"/>
        <c:varyColors val="0"/>
        <c:ser>
          <c:idx val="0"/>
          <c:order val="0"/>
          <c:spPr>
            <a:solidFill>
              <a:schemeClr val="accent1"/>
            </a:solidFill>
            <a:ln>
              <a:noFill/>
            </a:ln>
            <a:effectLst/>
          </c:spPr>
          <c:invertIfNegative val="0"/>
          <c:errBars>
            <c:errBarType val="both"/>
            <c:errValType val="cust"/>
            <c:noEndCap val="0"/>
            <c:plus>
              <c:numRef>
                <c:f>'0 (2)'!$U$2:$U$16</c:f>
                <c:numCache>
                  <c:formatCode>General</c:formatCode>
                  <c:ptCount val="15"/>
                  <c:pt idx="0">
                    <c:v>8.5289895029553295E-2</c:v>
                  </c:pt>
                  <c:pt idx="1">
                    <c:v>0.11089935799073</c:v>
                  </c:pt>
                  <c:pt idx="2">
                    <c:v>5.7385793938738203E-2</c:v>
                  </c:pt>
                  <c:pt idx="3">
                    <c:v>1.08003276369853E-2</c:v>
                  </c:pt>
                  <c:pt idx="4">
                    <c:v>2.9586039005203998E-2</c:v>
                  </c:pt>
                  <c:pt idx="5">
                    <c:v>3.445840214748E-2</c:v>
                  </c:pt>
                  <c:pt idx="6">
                    <c:v>0.186893792822175</c:v>
                  </c:pt>
                  <c:pt idx="7">
                    <c:v>3.8356366739560298E-2</c:v>
                  </c:pt>
                  <c:pt idx="8">
                    <c:v>6.5097378906965597E-2</c:v>
                  </c:pt>
                  <c:pt idx="9">
                    <c:v>4.2033718728488899E-2</c:v>
                  </c:pt>
                  <c:pt idx="10">
                    <c:v>0.110932983598899</c:v>
                  </c:pt>
                  <c:pt idx="11">
                    <c:v>9.3213936801158803E-2</c:v>
                  </c:pt>
                  <c:pt idx="12">
                    <c:v>0.132481971387376</c:v>
                  </c:pt>
                  <c:pt idx="13">
                    <c:v>9.9302211934192197E-2</c:v>
                  </c:pt>
                  <c:pt idx="14">
                    <c:v>0.109612217457441</c:v>
                  </c:pt>
                </c:numCache>
              </c:numRef>
            </c:plus>
            <c:minus>
              <c:numRef>
                <c:f>'0 (2)'!$U$2:$U$16</c:f>
                <c:numCache>
                  <c:formatCode>General</c:formatCode>
                  <c:ptCount val="15"/>
                  <c:pt idx="0">
                    <c:v>8.5289895029553295E-2</c:v>
                  </c:pt>
                  <c:pt idx="1">
                    <c:v>0.11089935799073</c:v>
                  </c:pt>
                  <c:pt idx="2">
                    <c:v>5.7385793938738203E-2</c:v>
                  </c:pt>
                  <c:pt idx="3">
                    <c:v>1.08003276369853E-2</c:v>
                  </c:pt>
                  <c:pt idx="4">
                    <c:v>2.9586039005203998E-2</c:v>
                  </c:pt>
                  <c:pt idx="5">
                    <c:v>3.445840214748E-2</c:v>
                  </c:pt>
                  <c:pt idx="6">
                    <c:v>0.186893792822175</c:v>
                  </c:pt>
                  <c:pt idx="7">
                    <c:v>3.8356366739560298E-2</c:v>
                  </c:pt>
                  <c:pt idx="8">
                    <c:v>6.5097378906965597E-2</c:v>
                  </c:pt>
                  <c:pt idx="9">
                    <c:v>4.2033718728488899E-2</c:v>
                  </c:pt>
                  <c:pt idx="10">
                    <c:v>0.110932983598899</c:v>
                  </c:pt>
                  <c:pt idx="11">
                    <c:v>9.3213936801158803E-2</c:v>
                  </c:pt>
                  <c:pt idx="12">
                    <c:v>0.132481971387376</c:v>
                  </c:pt>
                  <c:pt idx="13">
                    <c:v>9.9302211934192197E-2</c:v>
                  </c:pt>
                  <c:pt idx="14">
                    <c:v>0.109612217457441</c:v>
                  </c:pt>
                </c:numCache>
              </c:numRef>
            </c:minus>
            <c:spPr>
              <a:noFill/>
              <a:ln w="9525" cap="flat" cmpd="sng" algn="ctr">
                <a:solidFill>
                  <a:schemeClr val="tx1">
                    <a:lumMod val="65000"/>
                    <a:lumOff val="35000"/>
                  </a:schemeClr>
                </a:solidFill>
                <a:round/>
              </a:ln>
              <a:effectLst/>
            </c:spPr>
          </c:errBars>
          <c:cat>
            <c:multiLvlStrRef>
              <c:f>'0 (2)'!$P$2:$Q$16</c:f>
              <c:multiLvlStrCache>
                <c:ptCount val="15"/>
                <c:lvl>
                  <c:pt idx="0">
                    <c:v>0</c:v>
                  </c:pt>
                  <c:pt idx="1">
                    <c:v>1</c:v>
                  </c:pt>
                  <c:pt idx="2">
                    <c:v>2</c:v>
                  </c:pt>
                  <c:pt idx="3">
                    <c:v>3</c:v>
                  </c:pt>
                  <c:pt idx="4">
                    <c:v>6</c:v>
                  </c:pt>
                  <c:pt idx="5">
                    <c:v>12</c:v>
                  </c:pt>
                  <c:pt idx="6">
                    <c:v>24</c:v>
                  </c:pt>
                  <c:pt idx="7">
                    <c:v>36</c:v>
                  </c:pt>
                  <c:pt idx="8">
                    <c:v>1</c:v>
                  </c:pt>
                  <c:pt idx="9">
                    <c:v>2</c:v>
                  </c:pt>
                  <c:pt idx="10">
                    <c:v>3</c:v>
                  </c:pt>
                  <c:pt idx="11">
                    <c:v>6</c:v>
                  </c:pt>
                  <c:pt idx="12">
                    <c:v>12</c:v>
                  </c:pt>
                  <c:pt idx="13">
                    <c:v>24</c:v>
                  </c:pt>
                  <c:pt idx="14">
                    <c:v>36</c:v>
                  </c:pt>
                </c:lvl>
                <c:lvl>
                  <c:pt idx="0">
                    <c:v>Control - Hours</c:v>
                  </c:pt>
                  <c:pt idx="8">
                    <c:v>Cold - Hours</c:v>
                  </c:pt>
                </c:lvl>
              </c:multiLvlStrCache>
            </c:multiLvlStrRef>
          </c:cat>
          <c:val>
            <c:numRef>
              <c:f>'0 (2)'!$R$2:$R$16</c:f>
              <c:numCache>
                <c:formatCode>###0.00000;\-###0.00000</c:formatCode>
                <c:ptCount val="15"/>
                <c:pt idx="0">
                  <c:v>1</c:v>
                </c:pt>
                <c:pt idx="1">
                  <c:v>0.78781209260056795</c:v>
                </c:pt>
                <c:pt idx="2">
                  <c:v>0.73413044019984197</c:v>
                </c:pt>
                <c:pt idx="3">
                  <c:v>0.59436720779138597</c:v>
                </c:pt>
                <c:pt idx="4">
                  <c:v>0.58668592913086604</c:v>
                </c:pt>
                <c:pt idx="5">
                  <c:v>0.77083883250964702</c:v>
                </c:pt>
                <c:pt idx="6">
                  <c:v>0.72023098029710397</c:v>
                </c:pt>
                <c:pt idx="7">
                  <c:v>0.57084123709928603</c:v>
                </c:pt>
                <c:pt idx="8">
                  <c:v>0.72334172636362903</c:v>
                </c:pt>
                <c:pt idx="9">
                  <c:v>0.88759094768894797</c:v>
                </c:pt>
                <c:pt idx="10">
                  <c:v>1.6121081119052101</c:v>
                </c:pt>
                <c:pt idx="11">
                  <c:v>1.7750123320923901</c:v>
                </c:pt>
                <c:pt idx="12">
                  <c:v>1.93482958380337</c:v>
                </c:pt>
                <c:pt idx="13">
                  <c:v>1.4498044238804899</c:v>
                </c:pt>
                <c:pt idx="14">
                  <c:v>1.27301833862949</c:v>
                </c:pt>
              </c:numCache>
            </c:numRef>
          </c:val>
        </c:ser>
        <c:dLbls>
          <c:showLegendKey val="0"/>
          <c:showVal val="0"/>
          <c:showCatName val="0"/>
          <c:showSerName val="0"/>
          <c:showPercent val="0"/>
          <c:showBubbleSize val="0"/>
        </c:dLbls>
        <c:gapWidth val="219"/>
        <c:overlap val="-27"/>
        <c:axId val="426009024"/>
        <c:axId val="426009416"/>
      </c:barChart>
      <c:catAx>
        <c:axId val="426009024"/>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426009416"/>
        <c:crosses val="autoZero"/>
        <c:auto val="1"/>
        <c:lblAlgn val="ctr"/>
        <c:lblOffset val="100"/>
        <c:noMultiLvlLbl val="0"/>
      </c:catAx>
      <c:valAx>
        <c:axId val="426009416"/>
        <c:scaling>
          <c:orientation val="minMax"/>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t>Relative Expression</a:t>
                </a:r>
              </a:p>
            </c:rich>
          </c:tx>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 sourceLinked="0"/>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426009024"/>
        <c:crosses val="autoZero"/>
        <c:crossBetween val="between"/>
      </c:valAx>
      <c:spPr>
        <a:noFill/>
        <a:ln>
          <a:noFill/>
        </a:ln>
        <a:effectLst/>
      </c:spPr>
    </c:plotArea>
    <c:plotVisOnly val="1"/>
    <c:dispBlanksAs val="gap"/>
    <c:showDLblsOverMax val="0"/>
  </c:chart>
  <c:spPr>
    <a:noFill/>
    <a:ln>
      <a:solidFill>
        <a:schemeClr val="tx1"/>
      </a:solidFill>
    </a:ln>
    <a:effectLst/>
  </c:spPr>
  <c:txPr>
    <a:bodyPr/>
    <a:lstStyle/>
    <a:p>
      <a:pPr>
        <a:defRPr/>
      </a:pPr>
      <a:endParaRPr lang="en-US"/>
    </a:p>
  </c:txPr>
  <c:externalData r:id="rId3">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sz="1400" b="0" i="0" u="none" strike="noStrike" baseline="0">
                <a:effectLst/>
              </a:rPr>
              <a:t>Bradi2g35720.1 Biorep 2 </a:t>
            </a:r>
            <a:endParaRPr lang="en-US"/>
          </a:p>
        </c:rich>
      </c:tx>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barChart>
        <c:barDir val="col"/>
        <c:grouping val="clustered"/>
        <c:varyColors val="0"/>
        <c:ser>
          <c:idx val="0"/>
          <c:order val="0"/>
          <c:spPr>
            <a:solidFill>
              <a:schemeClr val="accent1"/>
            </a:solidFill>
            <a:ln>
              <a:noFill/>
            </a:ln>
            <a:effectLst/>
          </c:spPr>
          <c:invertIfNegative val="0"/>
          <c:errBars>
            <c:errBarType val="both"/>
            <c:errValType val="cust"/>
            <c:noEndCap val="0"/>
            <c:plus>
              <c:numRef>
                <c:f>'0 (2)'!$J$2:$J$16</c:f>
                <c:numCache>
                  <c:formatCode>General</c:formatCode>
                  <c:ptCount val="15"/>
                  <c:pt idx="0">
                    <c:v>8.2187359915667099E-2</c:v>
                  </c:pt>
                  <c:pt idx="1">
                    <c:v>0.157455774645129</c:v>
                  </c:pt>
                  <c:pt idx="2">
                    <c:v>8.2869402882686197E-2</c:v>
                  </c:pt>
                  <c:pt idx="3">
                    <c:v>2.5525642418157E-2</c:v>
                  </c:pt>
                  <c:pt idx="4">
                    <c:v>5.9885072594761397E-2</c:v>
                  </c:pt>
                  <c:pt idx="5">
                    <c:v>4.5041682146507202E-2</c:v>
                  </c:pt>
                  <c:pt idx="6">
                    <c:v>6.5234323978651296E-2</c:v>
                  </c:pt>
                  <c:pt idx="7">
                    <c:v>2.4037830197390302E-2</c:v>
                  </c:pt>
                  <c:pt idx="8">
                    <c:v>8.9698380111636403E-2</c:v>
                  </c:pt>
                  <c:pt idx="9">
                    <c:v>7.0021356127670506E-2</c:v>
                  </c:pt>
                  <c:pt idx="10">
                    <c:v>9.2461505860127094E-2</c:v>
                  </c:pt>
                  <c:pt idx="11">
                    <c:v>7.9692943209177206E-2</c:v>
                  </c:pt>
                  <c:pt idx="12">
                    <c:v>0.113327448148638</c:v>
                  </c:pt>
                  <c:pt idx="13">
                    <c:v>9.3304830286595405E-2</c:v>
                  </c:pt>
                  <c:pt idx="14">
                    <c:v>0.112992464556886</c:v>
                  </c:pt>
                </c:numCache>
              </c:numRef>
            </c:plus>
            <c:minus>
              <c:numRef>
                <c:f>'0 (2)'!$J$2:$J$16</c:f>
                <c:numCache>
                  <c:formatCode>General</c:formatCode>
                  <c:ptCount val="15"/>
                  <c:pt idx="0">
                    <c:v>8.2187359915667099E-2</c:v>
                  </c:pt>
                  <c:pt idx="1">
                    <c:v>0.157455774645129</c:v>
                  </c:pt>
                  <c:pt idx="2">
                    <c:v>8.2869402882686197E-2</c:v>
                  </c:pt>
                  <c:pt idx="3">
                    <c:v>2.5525642418157E-2</c:v>
                  </c:pt>
                  <c:pt idx="4">
                    <c:v>5.9885072594761397E-2</c:v>
                  </c:pt>
                  <c:pt idx="5">
                    <c:v>4.5041682146507202E-2</c:v>
                  </c:pt>
                  <c:pt idx="6">
                    <c:v>6.5234323978651296E-2</c:v>
                  </c:pt>
                  <c:pt idx="7">
                    <c:v>2.4037830197390302E-2</c:v>
                  </c:pt>
                  <c:pt idx="8">
                    <c:v>8.9698380111636403E-2</c:v>
                  </c:pt>
                  <c:pt idx="9">
                    <c:v>7.0021356127670506E-2</c:v>
                  </c:pt>
                  <c:pt idx="10">
                    <c:v>9.2461505860127094E-2</c:v>
                  </c:pt>
                  <c:pt idx="11">
                    <c:v>7.9692943209177206E-2</c:v>
                  </c:pt>
                  <c:pt idx="12">
                    <c:v>0.113327448148638</c:v>
                  </c:pt>
                  <c:pt idx="13">
                    <c:v>9.3304830286595405E-2</c:v>
                  </c:pt>
                  <c:pt idx="14">
                    <c:v>0.112992464556886</c:v>
                  </c:pt>
                </c:numCache>
              </c:numRef>
            </c:minus>
            <c:spPr>
              <a:noFill/>
              <a:ln w="9525" cap="flat" cmpd="sng" algn="ctr">
                <a:solidFill>
                  <a:schemeClr val="tx1">
                    <a:lumMod val="65000"/>
                    <a:lumOff val="35000"/>
                  </a:schemeClr>
                </a:solidFill>
                <a:round/>
              </a:ln>
              <a:effectLst/>
            </c:spPr>
          </c:errBars>
          <c:cat>
            <c:multiLvlStrRef>
              <c:f>'0 (2)'!$E$2:$F$16</c:f>
              <c:multiLvlStrCache>
                <c:ptCount val="15"/>
                <c:lvl>
                  <c:pt idx="0">
                    <c:v>0</c:v>
                  </c:pt>
                  <c:pt idx="1">
                    <c:v>1</c:v>
                  </c:pt>
                  <c:pt idx="2">
                    <c:v>2</c:v>
                  </c:pt>
                  <c:pt idx="3">
                    <c:v>3</c:v>
                  </c:pt>
                  <c:pt idx="4">
                    <c:v>6</c:v>
                  </c:pt>
                  <c:pt idx="5">
                    <c:v>12</c:v>
                  </c:pt>
                  <c:pt idx="6">
                    <c:v>24</c:v>
                  </c:pt>
                  <c:pt idx="7">
                    <c:v>36</c:v>
                  </c:pt>
                  <c:pt idx="8">
                    <c:v>1</c:v>
                  </c:pt>
                  <c:pt idx="9">
                    <c:v>2</c:v>
                  </c:pt>
                  <c:pt idx="10">
                    <c:v>3</c:v>
                  </c:pt>
                  <c:pt idx="11">
                    <c:v>6</c:v>
                  </c:pt>
                  <c:pt idx="12">
                    <c:v>12</c:v>
                  </c:pt>
                  <c:pt idx="13">
                    <c:v>24</c:v>
                  </c:pt>
                  <c:pt idx="14">
                    <c:v>36</c:v>
                  </c:pt>
                </c:lvl>
                <c:lvl>
                  <c:pt idx="0">
                    <c:v>Control - Hours</c:v>
                  </c:pt>
                  <c:pt idx="8">
                    <c:v>Cold - Hours</c:v>
                  </c:pt>
                </c:lvl>
              </c:multiLvlStrCache>
            </c:multiLvlStrRef>
          </c:cat>
          <c:val>
            <c:numRef>
              <c:f>'0 (2)'!$G$2:$G$16</c:f>
              <c:numCache>
                <c:formatCode>###0.00000;\-###0.00000</c:formatCode>
                <c:ptCount val="15"/>
                <c:pt idx="0">
                  <c:v>1</c:v>
                </c:pt>
                <c:pt idx="1">
                  <c:v>1.0697278519506399</c:v>
                </c:pt>
                <c:pt idx="2">
                  <c:v>1.5725460716411901</c:v>
                </c:pt>
                <c:pt idx="3">
                  <c:v>1.1792648564361199</c:v>
                </c:pt>
                <c:pt idx="4">
                  <c:v>0.96493646526778698</c:v>
                </c:pt>
                <c:pt idx="5">
                  <c:v>1.2954198518909401</c:v>
                </c:pt>
                <c:pt idx="6">
                  <c:v>1.48853170877504</c:v>
                </c:pt>
                <c:pt idx="7">
                  <c:v>1.0813852741462799</c:v>
                </c:pt>
                <c:pt idx="8">
                  <c:v>0.91994772862304397</c:v>
                </c:pt>
                <c:pt idx="9">
                  <c:v>1.80616770574838</c:v>
                </c:pt>
                <c:pt idx="10">
                  <c:v>1.78626043216381</c:v>
                </c:pt>
                <c:pt idx="11">
                  <c:v>3.3286080842249599</c:v>
                </c:pt>
                <c:pt idx="12">
                  <c:v>3.2463568988664901</c:v>
                </c:pt>
                <c:pt idx="13">
                  <c:v>1.59848121760808</c:v>
                </c:pt>
                <c:pt idx="14">
                  <c:v>2.97570059995572</c:v>
                </c:pt>
              </c:numCache>
            </c:numRef>
          </c:val>
        </c:ser>
        <c:dLbls>
          <c:showLegendKey val="0"/>
          <c:showVal val="0"/>
          <c:showCatName val="0"/>
          <c:showSerName val="0"/>
          <c:showPercent val="0"/>
          <c:showBubbleSize val="0"/>
        </c:dLbls>
        <c:gapWidth val="219"/>
        <c:overlap val="-27"/>
        <c:axId val="426010200"/>
        <c:axId val="426010592"/>
      </c:barChart>
      <c:catAx>
        <c:axId val="426010200"/>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426010592"/>
        <c:crosses val="autoZero"/>
        <c:auto val="1"/>
        <c:lblAlgn val="ctr"/>
        <c:lblOffset val="100"/>
        <c:noMultiLvlLbl val="0"/>
      </c:catAx>
      <c:valAx>
        <c:axId val="426010592"/>
        <c:scaling>
          <c:orientation val="minMax"/>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t>Relative Expression</a:t>
                </a:r>
              </a:p>
            </c:rich>
          </c:tx>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 sourceLinked="0"/>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426010200"/>
        <c:crosses val="autoZero"/>
        <c:crossBetween val="between"/>
      </c:valAx>
      <c:spPr>
        <a:noFill/>
        <a:ln>
          <a:noFill/>
        </a:ln>
        <a:effectLst/>
      </c:spPr>
    </c:plotArea>
    <c:plotVisOnly val="1"/>
    <c:dispBlanksAs val="gap"/>
    <c:showDLblsOverMax val="0"/>
  </c:chart>
  <c:spPr>
    <a:noFill/>
    <a:ln>
      <a:solidFill>
        <a:schemeClr val="tx1"/>
      </a:solidFill>
    </a:ln>
    <a:effectLst/>
  </c:spPr>
  <c:txPr>
    <a:bodyPr/>
    <a:lstStyle/>
    <a:p>
      <a:pPr>
        <a:defRPr/>
      </a:pPr>
      <a:endParaRPr lang="en-US"/>
    </a:p>
  </c:txPr>
  <c:externalData r:id="rId3">
    <c:autoUpdate val="0"/>
  </c:externalData>
</c:chartSpace>
</file>

<file path=ppt/charts/chart9.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sz="1400" b="0" i="0" u="none" strike="noStrike" baseline="0">
                <a:effectLst/>
              </a:rPr>
              <a:t>Bradi2g59200.1 Biorep 2 </a:t>
            </a:r>
            <a:endParaRPr lang="en-US"/>
          </a:p>
        </c:rich>
      </c:tx>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barChart>
        <c:barDir val="col"/>
        <c:grouping val="clustered"/>
        <c:varyColors val="0"/>
        <c:ser>
          <c:idx val="0"/>
          <c:order val="0"/>
          <c:spPr>
            <a:solidFill>
              <a:schemeClr val="accent1"/>
            </a:solidFill>
            <a:ln>
              <a:noFill/>
            </a:ln>
            <a:effectLst/>
          </c:spPr>
          <c:invertIfNegative val="0"/>
          <c:errBars>
            <c:errBarType val="both"/>
            <c:errValType val="cust"/>
            <c:noEndCap val="0"/>
            <c:plus>
              <c:numRef>
                <c:f>'0 (2)'!$J$2:$J$16</c:f>
                <c:numCache>
                  <c:formatCode>General</c:formatCode>
                  <c:ptCount val="15"/>
                  <c:pt idx="0">
                    <c:v>9.54160585065114E-2</c:v>
                  </c:pt>
                  <c:pt idx="1">
                    <c:v>0.20677330498673199</c:v>
                  </c:pt>
                  <c:pt idx="2">
                    <c:v>9.57830928925264E-2</c:v>
                  </c:pt>
                  <c:pt idx="3">
                    <c:v>0.17991143731429199</c:v>
                  </c:pt>
                  <c:pt idx="4">
                    <c:v>0.11698223351385401</c:v>
                  </c:pt>
                  <c:pt idx="5">
                    <c:v>0.13517426304215699</c:v>
                  </c:pt>
                  <c:pt idx="6">
                    <c:v>0.15925009380633501</c:v>
                  </c:pt>
                  <c:pt idx="7">
                    <c:v>0.16972331725961901</c:v>
                  </c:pt>
                  <c:pt idx="8">
                    <c:v>0.17985401787379501</c:v>
                  </c:pt>
                  <c:pt idx="9">
                    <c:v>0.18821028211444499</c:v>
                  </c:pt>
                  <c:pt idx="10">
                    <c:v>0.39148138901242502</c:v>
                  </c:pt>
                  <c:pt idx="11">
                    <c:v>0.34123835353484</c:v>
                  </c:pt>
                  <c:pt idx="12">
                    <c:v>0.59895961369401995</c:v>
                  </c:pt>
                  <c:pt idx="13">
                    <c:v>0.32531198071242201</c:v>
                  </c:pt>
                  <c:pt idx="14">
                    <c:v>0.199136031920817</c:v>
                  </c:pt>
                </c:numCache>
              </c:numRef>
            </c:plus>
            <c:minus>
              <c:numRef>
                <c:f>'0 (2)'!$J$2:$J$16</c:f>
                <c:numCache>
                  <c:formatCode>General</c:formatCode>
                  <c:ptCount val="15"/>
                  <c:pt idx="0">
                    <c:v>9.54160585065114E-2</c:v>
                  </c:pt>
                  <c:pt idx="1">
                    <c:v>0.20677330498673199</c:v>
                  </c:pt>
                  <c:pt idx="2">
                    <c:v>9.57830928925264E-2</c:v>
                  </c:pt>
                  <c:pt idx="3">
                    <c:v>0.17991143731429199</c:v>
                  </c:pt>
                  <c:pt idx="4">
                    <c:v>0.11698223351385401</c:v>
                  </c:pt>
                  <c:pt idx="5">
                    <c:v>0.13517426304215699</c:v>
                  </c:pt>
                  <c:pt idx="6">
                    <c:v>0.15925009380633501</c:v>
                  </c:pt>
                  <c:pt idx="7">
                    <c:v>0.16972331725961901</c:v>
                  </c:pt>
                  <c:pt idx="8">
                    <c:v>0.17985401787379501</c:v>
                  </c:pt>
                  <c:pt idx="9">
                    <c:v>0.18821028211444499</c:v>
                  </c:pt>
                  <c:pt idx="10">
                    <c:v>0.39148138901242502</c:v>
                  </c:pt>
                  <c:pt idx="11">
                    <c:v>0.34123835353484</c:v>
                  </c:pt>
                  <c:pt idx="12">
                    <c:v>0.59895961369401995</c:v>
                  </c:pt>
                  <c:pt idx="13">
                    <c:v>0.32531198071242201</c:v>
                  </c:pt>
                  <c:pt idx="14">
                    <c:v>0.199136031920817</c:v>
                  </c:pt>
                </c:numCache>
              </c:numRef>
            </c:minus>
            <c:spPr>
              <a:noFill/>
              <a:ln w="9525" cap="flat" cmpd="sng" algn="ctr">
                <a:solidFill>
                  <a:schemeClr val="tx1">
                    <a:lumMod val="65000"/>
                    <a:lumOff val="35000"/>
                  </a:schemeClr>
                </a:solidFill>
                <a:round/>
              </a:ln>
              <a:effectLst/>
            </c:spPr>
          </c:errBars>
          <c:cat>
            <c:multiLvlStrRef>
              <c:f>'0 (2)'!$E$2:$F$16</c:f>
              <c:multiLvlStrCache>
                <c:ptCount val="15"/>
                <c:lvl>
                  <c:pt idx="0">
                    <c:v>0</c:v>
                  </c:pt>
                  <c:pt idx="1">
                    <c:v>1</c:v>
                  </c:pt>
                  <c:pt idx="2">
                    <c:v>2</c:v>
                  </c:pt>
                  <c:pt idx="3">
                    <c:v>3</c:v>
                  </c:pt>
                  <c:pt idx="4">
                    <c:v>6</c:v>
                  </c:pt>
                  <c:pt idx="5">
                    <c:v>12</c:v>
                  </c:pt>
                  <c:pt idx="6">
                    <c:v>24</c:v>
                  </c:pt>
                  <c:pt idx="7">
                    <c:v>36</c:v>
                  </c:pt>
                  <c:pt idx="8">
                    <c:v>1</c:v>
                  </c:pt>
                  <c:pt idx="9">
                    <c:v>2</c:v>
                  </c:pt>
                  <c:pt idx="10">
                    <c:v>3</c:v>
                  </c:pt>
                  <c:pt idx="11">
                    <c:v>6</c:v>
                  </c:pt>
                  <c:pt idx="12">
                    <c:v>12</c:v>
                  </c:pt>
                  <c:pt idx="13">
                    <c:v>24</c:v>
                  </c:pt>
                  <c:pt idx="14">
                    <c:v>36</c:v>
                  </c:pt>
                </c:lvl>
                <c:lvl>
                  <c:pt idx="0">
                    <c:v>Control - Hours</c:v>
                  </c:pt>
                  <c:pt idx="8">
                    <c:v>Cold - Hours</c:v>
                  </c:pt>
                </c:lvl>
              </c:multiLvlStrCache>
            </c:multiLvlStrRef>
          </c:cat>
          <c:val>
            <c:numRef>
              <c:f>'0 (2)'!$G$2:$G$16</c:f>
              <c:numCache>
                <c:formatCode>###0.00000;\-###0.00000</c:formatCode>
                <c:ptCount val="15"/>
                <c:pt idx="0">
                  <c:v>1</c:v>
                </c:pt>
                <c:pt idx="1">
                  <c:v>1.15625925281442</c:v>
                </c:pt>
                <c:pt idx="2">
                  <c:v>1.25686962477325</c:v>
                </c:pt>
                <c:pt idx="3">
                  <c:v>1.0399199767057901</c:v>
                </c:pt>
                <c:pt idx="4">
                  <c:v>0.84909150878516004</c:v>
                </c:pt>
                <c:pt idx="5">
                  <c:v>0.994078276159445</c:v>
                </c:pt>
                <c:pt idx="6">
                  <c:v>1.1349407121036801</c:v>
                </c:pt>
                <c:pt idx="7">
                  <c:v>0.87131768048824898</c:v>
                </c:pt>
                <c:pt idx="8">
                  <c:v>0.90428012866603602</c:v>
                </c:pt>
                <c:pt idx="9">
                  <c:v>1.0395504301073</c:v>
                </c:pt>
                <c:pt idx="10">
                  <c:v>2.1429851620816698</c:v>
                </c:pt>
                <c:pt idx="11">
                  <c:v>2.5221746504751699</c:v>
                </c:pt>
                <c:pt idx="12">
                  <c:v>2.84560582282421</c:v>
                </c:pt>
                <c:pt idx="13">
                  <c:v>2.1981466013620601</c:v>
                </c:pt>
                <c:pt idx="14">
                  <c:v>2.1398522981577601</c:v>
                </c:pt>
              </c:numCache>
            </c:numRef>
          </c:val>
        </c:ser>
        <c:dLbls>
          <c:showLegendKey val="0"/>
          <c:showVal val="0"/>
          <c:showCatName val="0"/>
          <c:showSerName val="0"/>
          <c:showPercent val="0"/>
          <c:showBubbleSize val="0"/>
        </c:dLbls>
        <c:gapWidth val="219"/>
        <c:overlap val="-27"/>
        <c:axId val="426011376"/>
        <c:axId val="426011768"/>
      </c:barChart>
      <c:catAx>
        <c:axId val="426011376"/>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426011768"/>
        <c:crosses val="autoZero"/>
        <c:auto val="1"/>
        <c:lblAlgn val="ctr"/>
        <c:lblOffset val="100"/>
        <c:noMultiLvlLbl val="0"/>
      </c:catAx>
      <c:valAx>
        <c:axId val="426011768"/>
        <c:scaling>
          <c:orientation val="minMax"/>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t>Relative Expression</a:t>
                </a:r>
              </a:p>
            </c:rich>
          </c:tx>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 sourceLinked="0"/>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426011376"/>
        <c:crosses val="autoZero"/>
        <c:crossBetween val="between"/>
      </c:valAx>
      <c:spPr>
        <a:noFill/>
        <a:ln>
          <a:noFill/>
        </a:ln>
        <a:effectLst/>
      </c:spPr>
    </c:plotArea>
    <c:plotVisOnly val="1"/>
    <c:dispBlanksAs val="gap"/>
    <c:showDLblsOverMax val="0"/>
  </c:chart>
  <c:spPr>
    <a:noFill/>
    <a:ln>
      <a:solidFill>
        <a:schemeClr val="tx1"/>
      </a:solid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6.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82930" y="3124625"/>
            <a:ext cx="6606540" cy="2156037"/>
          </a:xfrm>
        </p:spPr>
        <p:txBody>
          <a:bodyPr/>
          <a:lstStyle/>
          <a:p>
            <a:r>
              <a:rPr lang="en-US" smtClean="0"/>
              <a:t>Click to edit Master title style</a:t>
            </a:r>
            <a:endParaRPr lang="en-US"/>
          </a:p>
        </p:txBody>
      </p:sp>
      <p:sp>
        <p:nvSpPr>
          <p:cNvPr id="3" name="Subtitle 2"/>
          <p:cNvSpPr>
            <a:spLocks noGrp="1"/>
          </p:cNvSpPr>
          <p:nvPr>
            <p:ph type="subTitle" idx="1"/>
          </p:nvPr>
        </p:nvSpPr>
        <p:spPr>
          <a:xfrm>
            <a:off x="1165860" y="5699760"/>
            <a:ext cx="5440680" cy="2570480"/>
          </a:xfrm>
        </p:spPr>
        <p:txBody>
          <a:bodyPr/>
          <a:lstStyle>
            <a:lvl1pPr marL="0" indent="0" algn="ctr">
              <a:buNone/>
              <a:defRPr>
                <a:solidFill>
                  <a:schemeClr val="tx1">
                    <a:tint val="75000"/>
                  </a:schemeClr>
                </a:solidFill>
              </a:defRPr>
            </a:lvl1pPr>
            <a:lvl2pPr marL="569989" indent="0" algn="ctr">
              <a:buNone/>
              <a:defRPr>
                <a:solidFill>
                  <a:schemeClr val="tx1">
                    <a:tint val="75000"/>
                  </a:schemeClr>
                </a:solidFill>
              </a:defRPr>
            </a:lvl2pPr>
            <a:lvl3pPr marL="1139978" indent="0" algn="ctr">
              <a:buNone/>
              <a:defRPr>
                <a:solidFill>
                  <a:schemeClr val="tx1">
                    <a:tint val="75000"/>
                  </a:schemeClr>
                </a:solidFill>
              </a:defRPr>
            </a:lvl3pPr>
            <a:lvl4pPr marL="1709967" indent="0" algn="ctr">
              <a:buNone/>
              <a:defRPr>
                <a:solidFill>
                  <a:schemeClr val="tx1">
                    <a:tint val="75000"/>
                  </a:schemeClr>
                </a:solidFill>
              </a:defRPr>
            </a:lvl4pPr>
            <a:lvl5pPr marL="2279956" indent="0" algn="ctr">
              <a:buNone/>
              <a:defRPr>
                <a:solidFill>
                  <a:schemeClr val="tx1">
                    <a:tint val="75000"/>
                  </a:schemeClr>
                </a:solidFill>
              </a:defRPr>
            </a:lvl5pPr>
            <a:lvl6pPr marL="2849945" indent="0" algn="ctr">
              <a:buNone/>
              <a:defRPr>
                <a:solidFill>
                  <a:schemeClr val="tx1">
                    <a:tint val="75000"/>
                  </a:schemeClr>
                </a:solidFill>
              </a:defRPr>
            </a:lvl6pPr>
            <a:lvl7pPr marL="3419934" indent="0" algn="ctr">
              <a:buNone/>
              <a:defRPr>
                <a:solidFill>
                  <a:schemeClr val="tx1">
                    <a:tint val="75000"/>
                  </a:schemeClr>
                </a:solidFill>
              </a:defRPr>
            </a:lvl7pPr>
            <a:lvl8pPr marL="3989923" indent="0" algn="ctr">
              <a:buNone/>
              <a:defRPr>
                <a:solidFill>
                  <a:schemeClr val="tx1">
                    <a:tint val="75000"/>
                  </a:schemeClr>
                </a:solidFill>
              </a:defRPr>
            </a:lvl8pPr>
            <a:lvl9pPr marL="4559912"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3/30/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3/30/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634990" y="402804"/>
            <a:ext cx="1748790" cy="8582237"/>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388620" y="402804"/>
            <a:ext cx="5116830" cy="8582237"/>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3/30/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3/30/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13966" y="6463456"/>
            <a:ext cx="6606540" cy="1997710"/>
          </a:xfrm>
        </p:spPr>
        <p:txBody>
          <a:bodyPr anchor="t"/>
          <a:lstStyle>
            <a:lvl1pPr algn="l">
              <a:defRPr sz="4987" b="1" cap="all"/>
            </a:lvl1pPr>
          </a:lstStyle>
          <a:p>
            <a:r>
              <a:rPr lang="en-US" smtClean="0"/>
              <a:t>Click to edit Master title style</a:t>
            </a:r>
            <a:endParaRPr lang="en-US"/>
          </a:p>
        </p:txBody>
      </p:sp>
      <p:sp>
        <p:nvSpPr>
          <p:cNvPr id="3" name="Text Placeholder 2"/>
          <p:cNvSpPr>
            <a:spLocks noGrp="1"/>
          </p:cNvSpPr>
          <p:nvPr>
            <p:ph type="body" idx="1"/>
          </p:nvPr>
        </p:nvSpPr>
        <p:spPr>
          <a:xfrm>
            <a:off x="613966" y="4263180"/>
            <a:ext cx="6606540" cy="2200274"/>
          </a:xfrm>
        </p:spPr>
        <p:txBody>
          <a:bodyPr anchor="b"/>
          <a:lstStyle>
            <a:lvl1pPr marL="0" indent="0">
              <a:buNone/>
              <a:defRPr sz="2493">
                <a:solidFill>
                  <a:schemeClr val="tx1">
                    <a:tint val="75000"/>
                  </a:schemeClr>
                </a:solidFill>
              </a:defRPr>
            </a:lvl1pPr>
            <a:lvl2pPr marL="569989" indent="0">
              <a:buNone/>
              <a:defRPr sz="2244">
                <a:solidFill>
                  <a:schemeClr val="tx1">
                    <a:tint val="75000"/>
                  </a:schemeClr>
                </a:solidFill>
              </a:defRPr>
            </a:lvl2pPr>
            <a:lvl3pPr marL="1139978" indent="0">
              <a:buNone/>
              <a:defRPr sz="1995">
                <a:solidFill>
                  <a:schemeClr val="tx1">
                    <a:tint val="75000"/>
                  </a:schemeClr>
                </a:solidFill>
              </a:defRPr>
            </a:lvl3pPr>
            <a:lvl4pPr marL="1709967" indent="0">
              <a:buNone/>
              <a:defRPr sz="1745">
                <a:solidFill>
                  <a:schemeClr val="tx1">
                    <a:tint val="75000"/>
                  </a:schemeClr>
                </a:solidFill>
              </a:defRPr>
            </a:lvl4pPr>
            <a:lvl5pPr marL="2279956" indent="0">
              <a:buNone/>
              <a:defRPr sz="1745">
                <a:solidFill>
                  <a:schemeClr val="tx1">
                    <a:tint val="75000"/>
                  </a:schemeClr>
                </a:solidFill>
              </a:defRPr>
            </a:lvl5pPr>
            <a:lvl6pPr marL="2849945" indent="0">
              <a:buNone/>
              <a:defRPr sz="1745">
                <a:solidFill>
                  <a:schemeClr val="tx1">
                    <a:tint val="75000"/>
                  </a:schemeClr>
                </a:solidFill>
              </a:defRPr>
            </a:lvl6pPr>
            <a:lvl7pPr marL="3419934" indent="0">
              <a:buNone/>
              <a:defRPr sz="1745">
                <a:solidFill>
                  <a:schemeClr val="tx1">
                    <a:tint val="75000"/>
                  </a:schemeClr>
                </a:solidFill>
              </a:defRPr>
            </a:lvl7pPr>
            <a:lvl8pPr marL="3989923" indent="0">
              <a:buNone/>
              <a:defRPr sz="1745">
                <a:solidFill>
                  <a:schemeClr val="tx1">
                    <a:tint val="75000"/>
                  </a:schemeClr>
                </a:solidFill>
              </a:defRPr>
            </a:lvl8pPr>
            <a:lvl9pPr marL="4559912" indent="0">
              <a:buNone/>
              <a:defRPr sz="1745">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1D8BD707-D9CF-40AE-B4C6-C98DA3205C09}" type="datetimeFigureOut">
              <a:rPr lang="en-US" smtClean="0"/>
              <a:pPr/>
              <a:t>3/30/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388620" y="2346962"/>
            <a:ext cx="3432810" cy="6638079"/>
          </a:xfrm>
        </p:spPr>
        <p:txBody>
          <a:bodyPr/>
          <a:lstStyle>
            <a:lvl1pPr>
              <a:defRPr sz="3491"/>
            </a:lvl1pPr>
            <a:lvl2pPr>
              <a:defRPr sz="2992"/>
            </a:lvl2pPr>
            <a:lvl3pPr>
              <a:defRPr sz="2493"/>
            </a:lvl3pPr>
            <a:lvl4pPr>
              <a:defRPr sz="2244"/>
            </a:lvl4pPr>
            <a:lvl5pPr>
              <a:defRPr sz="2244"/>
            </a:lvl5pPr>
            <a:lvl6pPr>
              <a:defRPr sz="2244"/>
            </a:lvl6pPr>
            <a:lvl7pPr>
              <a:defRPr sz="2244"/>
            </a:lvl7pPr>
            <a:lvl8pPr>
              <a:defRPr sz="2244"/>
            </a:lvl8pPr>
            <a:lvl9pPr>
              <a:defRPr sz="2244"/>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3950970" y="2346962"/>
            <a:ext cx="3432810" cy="6638079"/>
          </a:xfrm>
        </p:spPr>
        <p:txBody>
          <a:bodyPr/>
          <a:lstStyle>
            <a:lvl1pPr>
              <a:defRPr sz="3491"/>
            </a:lvl1pPr>
            <a:lvl2pPr>
              <a:defRPr sz="2992"/>
            </a:lvl2pPr>
            <a:lvl3pPr>
              <a:defRPr sz="2493"/>
            </a:lvl3pPr>
            <a:lvl4pPr>
              <a:defRPr sz="2244"/>
            </a:lvl4pPr>
            <a:lvl5pPr>
              <a:defRPr sz="2244"/>
            </a:lvl5pPr>
            <a:lvl6pPr>
              <a:defRPr sz="2244"/>
            </a:lvl6pPr>
            <a:lvl7pPr>
              <a:defRPr sz="2244"/>
            </a:lvl7pPr>
            <a:lvl8pPr>
              <a:defRPr sz="2244"/>
            </a:lvl8pPr>
            <a:lvl9pPr>
              <a:defRPr sz="2244"/>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1D8BD707-D9CF-40AE-B4C6-C98DA3205C09}" type="datetimeFigureOut">
              <a:rPr lang="en-US" smtClean="0"/>
              <a:pPr/>
              <a:t>3/30/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388620" y="2251499"/>
            <a:ext cx="3434160" cy="938318"/>
          </a:xfrm>
        </p:spPr>
        <p:txBody>
          <a:bodyPr anchor="b"/>
          <a:lstStyle>
            <a:lvl1pPr marL="0" indent="0">
              <a:buNone/>
              <a:defRPr sz="2992" b="1"/>
            </a:lvl1pPr>
            <a:lvl2pPr marL="569989" indent="0">
              <a:buNone/>
              <a:defRPr sz="2493" b="1"/>
            </a:lvl2pPr>
            <a:lvl3pPr marL="1139978" indent="0">
              <a:buNone/>
              <a:defRPr sz="2244" b="1"/>
            </a:lvl3pPr>
            <a:lvl4pPr marL="1709967" indent="0">
              <a:buNone/>
              <a:defRPr sz="1995" b="1"/>
            </a:lvl4pPr>
            <a:lvl5pPr marL="2279956" indent="0">
              <a:buNone/>
              <a:defRPr sz="1995" b="1"/>
            </a:lvl5pPr>
            <a:lvl6pPr marL="2849945" indent="0">
              <a:buNone/>
              <a:defRPr sz="1995" b="1"/>
            </a:lvl6pPr>
            <a:lvl7pPr marL="3419934" indent="0">
              <a:buNone/>
              <a:defRPr sz="1995" b="1"/>
            </a:lvl7pPr>
            <a:lvl8pPr marL="3989923" indent="0">
              <a:buNone/>
              <a:defRPr sz="1995" b="1"/>
            </a:lvl8pPr>
            <a:lvl9pPr marL="4559912" indent="0">
              <a:buNone/>
              <a:defRPr sz="1995" b="1"/>
            </a:lvl9pPr>
          </a:lstStyle>
          <a:p>
            <a:pPr lvl="0"/>
            <a:r>
              <a:rPr lang="en-US" smtClean="0"/>
              <a:t>Click to edit Master text styles</a:t>
            </a:r>
          </a:p>
        </p:txBody>
      </p:sp>
      <p:sp>
        <p:nvSpPr>
          <p:cNvPr id="4" name="Content Placeholder 3"/>
          <p:cNvSpPr>
            <a:spLocks noGrp="1"/>
          </p:cNvSpPr>
          <p:nvPr>
            <p:ph sz="half" idx="2"/>
          </p:nvPr>
        </p:nvSpPr>
        <p:spPr>
          <a:xfrm>
            <a:off x="388620" y="3189817"/>
            <a:ext cx="3434160" cy="5795222"/>
          </a:xfrm>
        </p:spPr>
        <p:txBody>
          <a:bodyPr/>
          <a:lstStyle>
            <a:lvl1pPr>
              <a:defRPr sz="2992"/>
            </a:lvl1pPr>
            <a:lvl2pPr>
              <a:defRPr sz="2493"/>
            </a:lvl2pPr>
            <a:lvl3pPr>
              <a:defRPr sz="2244"/>
            </a:lvl3pPr>
            <a:lvl4pPr>
              <a:defRPr sz="1995"/>
            </a:lvl4pPr>
            <a:lvl5pPr>
              <a:defRPr sz="1995"/>
            </a:lvl5pPr>
            <a:lvl6pPr>
              <a:defRPr sz="1995"/>
            </a:lvl6pPr>
            <a:lvl7pPr>
              <a:defRPr sz="1995"/>
            </a:lvl7pPr>
            <a:lvl8pPr>
              <a:defRPr sz="1995"/>
            </a:lvl8pPr>
            <a:lvl9pPr>
              <a:defRPr sz="1995"/>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3948273" y="2251499"/>
            <a:ext cx="3435509" cy="938318"/>
          </a:xfrm>
        </p:spPr>
        <p:txBody>
          <a:bodyPr anchor="b"/>
          <a:lstStyle>
            <a:lvl1pPr marL="0" indent="0">
              <a:buNone/>
              <a:defRPr sz="2992" b="1"/>
            </a:lvl1pPr>
            <a:lvl2pPr marL="569989" indent="0">
              <a:buNone/>
              <a:defRPr sz="2493" b="1"/>
            </a:lvl2pPr>
            <a:lvl3pPr marL="1139978" indent="0">
              <a:buNone/>
              <a:defRPr sz="2244" b="1"/>
            </a:lvl3pPr>
            <a:lvl4pPr marL="1709967" indent="0">
              <a:buNone/>
              <a:defRPr sz="1995" b="1"/>
            </a:lvl4pPr>
            <a:lvl5pPr marL="2279956" indent="0">
              <a:buNone/>
              <a:defRPr sz="1995" b="1"/>
            </a:lvl5pPr>
            <a:lvl6pPr marL="2849945" indent="0">
              <a:buNone/>
              <a:defRPr sz="1995" b="1"/>
            </a:lvl6pPr>
            <a:lvl7pPr marL="3419934" indent="0">
              <a:buNone/>
              <a:defRPr sz="1995" b="1"/>
            </a:lvl7pPr>
            <a:lvl8pPr marL="3989923" indent="0">
              <a:buNone/>
              <a:defRPr sz="1995" b="1"/>
            </a:lvl8pPr>
            <a:lvl9pPr marL="4559912" indent="0">
              <a:buNone/>
              <a:defRPr sz="1995" b="1"/>
            </a:lvl9pPr>
          </a:lstStyle>
          <a:p>
            <a:pPr lvl="0"/>
            <a:r>
              <a:rPr lang="en-US" smtClean="0"/>
              <a:t>Click to edit Master text styles</a:t>
            </a:r>
          </a:p>
        </p:txBody>
      </p:sp>
      <p:sp>
        <p:nvSpPr>
          <p:cNvPr id="6" name="Content Placeholder 5"/>
          <p:cNvSpPr>
            <a:spLocks noGrp="1"/>
          </p:cNvSpPr>
          <p:nvPr>
            <p:ph sz="quarter" idx="4"/>
          </p:nvPr>
        </p:nvSpPr>
        <p:spPr>
          <a:xfrm>
            <a:off x="3948273" y="3189817"/>
            <a:ext cx="3435509" cy="5795222"/>
          </a:xfrm>
        </p:spPr>
        <p:txBody>
          <a:bodyPr/>
          <a:lstStyle>
            <a:lvl1pPr>
              <a:defRPr sz="2992"/>
            </a:lvl1pPr>
            <a:lvl2pPr>
              <a:defRPr sz="2493"/>
            </a:lvl2pPr>
            <a:lvl3pPr>
              <a:defRPr sz="2244"/>
            </a:lvl3pPr>
            <a:lvl4pPr>
              <a:defRPr sz="1995"/>
            </a:lvl4pPr>
            <a:lvl5pPr>
              <a:defRPr sz="1995"/>
            </a:lvl5pPr>
            <a:lvl6pPr>
              <a:defRPr sz="1995"/>
            </a:lvl6pPr>
            <a:lvl7pPr>
              <a:defRPr sz="1995"/>
            </a:lvl7pPr>
            <a:lvl8pPr>
              <a:defRPr sz="1995"/>
            </a:lvl8pPr>
            <a:lvl9pPr>
              <a:defRPr sz="1995"/>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1D8BD707-D9CF-40AE-B4C6-C98DA3205C09}" type="datetimeFigureOut">
              <a:rPr lang="en-US" smtClean="0"/>
              <a:pPr/>
              <a:t>3/30/2018</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1D8BD707-D9CF-40AE-B4C6-C98DA3205C09}" type="datetimeFigureOut">
              <a:rPr lang="en-US" smtClean="0"/>
              <a:pPr/>
              <a:t>3/30/2018</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D8BD707-D9CF-40AE-B4C6-C98DA3205C09}" type="datetimeFigureOut">
              <a:rPr lang="en-US" smtClean="0"/>
              <a:pPr/>
              <a:t>3/30/2018</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88620" y="400473"/>
            <a:ext cx="2557066" cy="1704340"/>
          </a:xfrm>
        </p:spPr>
        <p:txBody>
          <a:bodyPr anchor="b"/>
          <a:lstStyle>
            <a:lvl1pPr algn="l">
              <a:defRPr sz="2493" b="1"/>
            </a:lvl1pPr>
          </a:lstStyle>
          <a:p>
            <a:r>
              <a:rPr lang="en-US" smtClean="0"/>
              <a:t>Click to edit Master title style</a:t>
            </a:r>
            <a:endParaRPr lang="en-US"/>
          </a:p>
        </p:txBody>
      </p:sp>
      <p:sp>
        <p:nvSpPr>
          <p:cNvPr id="3" name="Content Placeholder 2"/>
          <p:cNvSpPr>
            <a:spLocks noGrp="1"/>
          </p:cNvSpPr>
          <p:nvPr>
            <p:ph idx="1"/>
          </p:nvPr>
        </p:nvSpPr>
        <p:spPr>
          <a:xfrm>
            <a:off x="3038792" y="400475"/>
            <a:ext cx="4344988" cy="8584566"/>
          </a:xfrm>
        </p:spPr>
        <p:txBody>
          <a:bodyPr/>
          <a:lstStyle>
            <a:lvl1pPr>
              <a:defRPr sz="3989"/>
            </a:lvl1pPr>
            <a:lvl2pPr>
              <a:defRPr sz="3491"/>
            </a:lvl2pPr>
            <a:lvl3pPr>
              <a:defRPr sz="2992"/>
            </a:lvl3pPr>
            <a:lvl4pPr>
              <a:defRPr sz="2493"/>
            </a:lvl4pPr>
            <a:lvl5pPr>
              <a:defRPr sz="2493"/>
            </a:lvl5pPr>
            <a:lvl6pPr>
              <a:defRPr sz="2493"/>
            </a:lvl6pPr>
            <a:lvl7pPr>
              <a:defRPr sz="2493"/>
            </a:lvl7pPr>
            <a:lvl8pPr>
              <a:defRPr sz="2493"/>
            </a:lvl8pPr>
            <a:lvl9pPr>
              <a:defRPr sz="2493"/>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388620" y="2104815"/>
            <a:ext cx="2557066" cy="6880226"/>
          </a:xfrm>
        </p:spPr>
        <p:txBody>
          <a:bodyPr/>
          <a:lstStyle>
            <a:lvl1pPr marL="0" indent="0">
              <a:buNone/>
              <a:defRPr sz="1745"/>
            </a:lvl1pPr>
            <a:lvl2pPr marL="569989" indent="0">
              <a:buNone/>
              <a:defRPr sz="1496"/>
            </a:lvl2pPr>
            <a:lvl3pPr marL="1139978" indent="0">
              <a:buNone/>
              <a:defRPr sz="1247"/>
            </a:lvl3pPr>
            <a:lvl4pPr marL="1709967" indent="0">
              <a:buNone/>
              <a:defRPr sz="1122"/>
            </a:lvl4pPr>
            <a:lvl5pPr marL="2279956" indent="0">
              <a:buNone/>
              <a:defRPr sz="1122"/>
            </a:lvl5pPr>
            <a:lvl6pPr marL="2849945" indent="0">
              <a:buNone/>
              <a:defRPr sz="1122"/>
            </a:lvl6pPr>
            <a:lvl7pPr marL="3419934" indent="0">
              <a:buNone/>
              <a:defRPr sz="1122"/>
            </a:lvl7pPr>
            <a:lvl8pPr marL="3989923" indent="0">
              <a:buNone/>
              <a:defRPr sz="1122"/>
            </a:lvl8pPr>
            <a:lvl9pPr marL="4559912" indent="0">
              <a:buNone/>
              <a:defRPr sz="1122"/>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3/30/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523445" y="7040880"/>
            <a:ext cx="4663440" cy="831216"/>
          </a:xfrm>
        </p:spPr>
        <p:txBody>
          <a:bodyPr anchor="b"/>
          <a:lstStyle>
            <a:lvl1pPr algn="l">
              <a:defRPr sz="2493" b="1"/>
            </a:lvl1pPr>
          </a:lstStyle>
          <a:p>
            <a:r>
              <a:rPr lang="en-US" smtClean="0"/>
              <a:t>Click to edit Master title style</a:t>
            </a:r>
            <a:endParaRPr lang="en-US"/>
          </a:p>
        </p:txBody>
      </p:sp>
      <p:sp>
        <p:nvSpPr>
          <p:cNvPr id="3" name="Picture Placeholder 2"/>
          <p:cNvSpPr>
            <a:spLocks noGrp="1"/>
          </p:cNvSpPr>
          <p:nvPr>
            <p:ph type="pic" idx="1"/>
          </p:nvPr>
        </p:nvSpPr>
        <p:spPr>
          <a:xfrm>
            <a:off x="1523445" y="898737"/>
            <a:ext cx="4663440" cy="6035040"/>
          </a:xfrm>
        </p:spPr>
        <p:txBody>
          <a:bodyPr/>
          <a:lstStyle>
            <a:lvl1pPr marL="0" indent="0">
              <a:buNone/>
              <a:defRPr sz="3989"/>
            </a:lvl1pPr>
            <a:lvl2pPr marL="569989" indent="0">
              <a:buNone/>
              <a:defRPr sz="3491"/>
            </a:lvl2pPr>
            <a:lvl3pPr marL="1139978" indent="0">
              <a:buNone/>
              <a:defRPr sz="2992"/>
            </a:lvl3pPr>
            <a:lvl4pPr marL="1709967" indent="0">
              <a:buNone/>
              <a:defRPr sz="2493"/>
            </a:lvl4pPr>
            <a:lvl5pPr marL="2279956" indent="0">
              <a:buNone/>
              <a:defRPr sz="2493"/>
            </a:lvl5pPr>
            <a:lvl6pPr marL="2849945" indent="0">
              <a:buNone/>
              <a:defRPr sz="2493"/>
            </a:lvl6pPr>
            <a:lvl7pPr marL="3419934" indent="0">
              <a:buNone/>
              <a:defRPr sz="2493"/>
            </a:lvl7pPr>
            <a:lvl8pPr marL="3989923" indent="0">
              <a:buNone/>
              <a:defRPr sz="2493"/>
            </a:lvl8pPr>
            <a:lvl9pPr marL="4559912" indent="0">
              <a:buNone/>
              <a:defRPr sz="2493"/>
            </a:lvl9pPr>
          </a:lstStyle>
          <a:p>
            <a:endParaRPr lang="en-US"/>
          </a:p>
        </p:txBody>
      </p:sp>
      <p:sp>
        <p:nvSpPr>
          <p:cNvPr id="4" name="Text Placeholder 3"/>
          <p:cNvSpPr>
            <a:spLocks noGrp="1"/>
          </p:cNvSpPr>
          <p:nvPr>
            <p:ph type="body" sz="half" idx="2"/>
          </p:nvPr>
        </p:nvSpPr>
        <p:spPr>
          <a:xfrm>
            <a:off x="1523445" y="7872096"/>
            <a:ext cx="4663440" cy="1180464"/>
          </a:xfrm>
        </p:spPr>
        <p:txBody>
          <a:bodyPr/>
          <a:lstStyle>
            <a:lvl1pPr marL="0" indent="0">
              <a:buNone/>
              <a:defRPr sz="1745"/>
            </a:lvl1pPr>
            <a:lvl2pPr marL="569989" indent="0">
              <a:buNone/>
              <a:defRPr sz="1496"/>
            </a:lvl2pPr>
            <a:lvl3pPr marL="1139978" indent="0">
              <a:buNone/>
              <a:defRPr sz="1247"/>
            </a:lvl3pPr>
            <a:lvl4pPr marL="1709967" indent="0">
              <a:buNone/>
              <a:defRPr sz="1122"/>
            </a:lvl4pPr>
            <a:lvl5pPr marL="2279956" indent="0">
              <a:buNone/>
              <a:defRPr sz="1122"/>
            </a:lvl5pPr>
            <a:lvl6pPr marL="2849945" indent="0">
              <a:buNone/>
              <a:defRPr sz="1122"/>
            </a:lvl6pPr>
            <a:lvl7pPr marL="3419934" indent="0">
              <a:buNone/>
              <a:defRPr sz="1122"/>
            </a:lvl7pPr>
            <a:lvl8pPr marL="3989923" indent="0">
              <a:buNone/>
              <a:defRPr sz="1122"/>
            </a:lvl8pPr>
            <a:lvl9pPr marL="4559912" indent="0">
              <a:buNone/>
              <a:defRPr sz="1122"/>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3/30/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88620" y="402802"/>
            <a:ext cx="6995160" cy="16764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388620" y="2346962"/>
            <a:ext cx="6995160" cy="6638079"/>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388620" y="9322649"/>
            <a:ext cx="1813560" cy="535517"/>
          </a:xfrm>
          <a:prstGeom prst="rect">
            <a:avLst/>
          </a:prstGeom>
        </p:spPr>
        <p:txBody>
          <a:bodyPr vert="horz" lIns="91440" tIns="45720" rIns="91440" bIns="45720" rtlCol="0" anchor="ctr"/>
          <a:lstStyle>
            <a:lvl1pPr algn="l">
              <a:defRPr sz="1496">
                <a:solidFill>
                  <a:schemeClr val="tx1">
                    <a:tint val="75000"/>
                  </a:schemeClr>
                </a:solidFill>
              </a:defRPr>
            </a:lvl1pPr>
          </a:lstStyle>
          <a:p>
            <a:fld id="{1D8BD707-D9CF-40AE-B4C6-C98DA3205C09}" type="datetimeFigureOut">
              <a:rPr lang="en-US" smtClean="0"/>
              <a:pPr/>
              <a:t>3/30/2018</a:t>
            </a:fld>
            <a:endParaRPr lang="en-US"/>
          </a:p>
        </p:txBody>
      </p:sp>
      <p:sp>
        <p:nvSpPr>
          <p:cNvPr id="5" name="Footer Placeholder 4"/>
          <p:cNvSpPr>
            <a:spLocks noGrp="1"/>
          </p:cNvSpPr>
          <p:nvPr>
            <p:ph type="ftr" sz="quarter" idx="3"/>
          </p:nvPr>
        </p:nvSpPr>
        <p:spPr>
          <a:xfrm>
            <a:off x="2655570" y="9322649"/>
            <a:ext cx="2461260" cy="535517"/>
          </a:xfrm>
          <a:prstGeom prst="rect">
            <a:avLst/>
          </a:prstGeom>
        </p:spPr>
        <p:txBody>
          <a:bodyPr vert="horz" lIns="91440" tIns="45720" rIns="91440" bIns="45720" rtlCol="0" anchor="ctr"/>
          <a:lstStyle>
            <a:lvl1pPr algn="ctr">
              <a:defRPr sz="1496">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5570220" y="9322649"/>
            <a:ext cx="1813560" cy="535517"/>
          </a:xfrm>
          <a:prstGeom prst="rect">
            <a:avLst/>
          </a:prstGeom>
        </p:spPr>
        <p:txBody>
          <a:bodyPr vert="horz" lIns="91440" tIns="45720" rIns="91440" bIns="45720" rtlCol="0" anchor="ctr"/>
          <a:lstStyle>
            <a:lvl1pPr algn="r">
              <a:defRPr sz="1496">
                <a:solidFill>
                  <a:schemeClr val="tx1">
                    <a:tint val="75000"/>
                  </a:schemeClr>
                </a:solidFill>
              </a:defRPr>
            </a:lvl1pPr>
          </a:lstStyle>
          <a:p>
            <a:fld id="{B6F15528-21DE-4FAA-801E-634DDDAF4B2B}"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1139978" rtl="0" eaLnBrk="1" latinLnBrk="0" hangingPunct="1">
        <a:spcBef>
          <a:spcPct val="0"/>
        </a:spcBef>
        <a:buNone/>
        <a:defRPr sz="5485" kern="1200">
          <a:solidFill>
            <a:schemeClr val="tx1"/>
          </a:solidFill>
          <a:latin typeface="+mj-lt"/>
          <a:ea typeface="+mj-ea"/>
          <a:cs typeface="+mj-cs"/>
        </a:defRPr>
      </a:lvl1pPr>
    </p:titleStyle>
    <p:bodyStyle>
      <a:lvl1pPr marL="427492" indent="-427492" algn="l" defTabSz="1139978" rtl="0" eaLnBrk="1" latinLnBrk="0" hangingPunct="1">
        <a:spcBef>
          <a:spcPct val="20000"/>
        </a:spcBef>
        <a:buFont typeface="Arial" pitchFamily="34" charset="0"/>
        <a:buChar char="•"/>
        <a:defRPr sz="3989" kern="1200">
          <a:solidFill>
            <a:schemeClr val="tx1"/>
          </a:solidFill>
          <a:latin typeface="+mn-lt"/>
          <a:ea typeface="+mn-ea"/>
          <a:cs typeface="+mn-cs"/>
        </a:defRPr>
      </a:lvl1pPr>
      <a:lvl2pPr marL="926233" indent="-356244" algn="l" defTabSz="1139978" rtl="0" eaLnBrk="1" latinLnBrk="0" hangingPunct="1">
        <a:spcBef>
          <a:spcPct val="20000"/>
        </a:spcBef>
        <a:buFont typeface="Arial" pitchFamily="34" charset="0"/>
        <a:buChar char="–"/>
        <a:defRPr sz="3491" kern="1200">
          <a:solidFill>
            <a:schemeClr val="tx1"/>
          </a:solidFill>
          <a:latin typeface="+mn-lt"/>
          <a:ea typeface="+mn-ea"/>
          <a:cs typeface="+mn-cs"/>
        </a:defRPr>
      </a:lvl2pPr>
      <a:lvl3pPr marL="1424972" indent="-284994" algn="l" defTabSz="1139978" rtl="0" eaLnBrk="1" latinLnBrk="0" hangingPunct="1">
        <a:spcBef>
          <a:spcPct val="20000"/>
        </a:spcBef>
        <a:buFont typeface="Arial" pitchFamily="34" charset="0"/>
        <a:buChar char="•"/>
        <a:defRPr sz="2992" kern="1200">
          <a:solidFill>
            <a:schemeClr val="tx1"/>
          </a:solidFill>
          <a:latin typeface="+mn-lt"/>
          <a:ea typeface="+mn-ea"/>
          <a:cs typeface="+mn-cs"/>
        </a:defRPr>
      </a:lvl3pPr>
      <a:lvl4pPr marL="1994961" indent="-284994" algn="l" defTabSz="1139978" rtl="0" eaLnBrk="1" latinLnBrk="0" hangingPunct="1">
        <a:spcBef>
          <a:spcPct val="20000"/>
        </a:spcBef>
        <a:buFont typeface="Arial" pitchFamily="34" charset="0"/>
        <a:buChar char="–"/>
        <a:defRPr sz="2493" kern="1200">
          <a:solidFill>
            <a:schemeClr val="tx1"/>
          </a:solidFill>
          <a:latin typeface="+mn-lt"/>
          <a:ea typeface="+mn-ea"/>
          <a:cs typeface="+mn-cs"/>
        </a:defRPr>
      </a:lvl4pPr>
      <a:lvl5pPr marL="2564950" indent="-284994" algn="l" defTabSz="1139978" rtl="0" eaLnBrk="1" latinLnBrk="0" hangingPunct="1">
        <a:spcBef>
          <a:spcPct val="20000"/>
        </a:spcBef>
        <a:buFont typeface="Arial" pitchFamily="34" charset="0"/>
        <a:buChar char="»"/>
        <a:defRPr sz="2493" kern="1200">
          <a:solidFill>
            <a:schemeClr val="tx1"/>
          </a:solidFill>
          <a:latin typeface="+mn-lt"/>
          <a:ea typeface="+mn-ea"/>
          <a:cs typeface="+mn-cs"/>
        </a:defRPr>
      </a:lvl5pPr>
      <a:lvl6pPr marL="3134939" indent="-284994" algn="l" defTabSz="1139978" rtl="0" eaLnBrk="1" latinLnBrk="0" hangingPunct="1">
        <a:spcBef>
          <a:spcPct val="20000"/>
        </a:spcBef>
        <a:buFont typeface="Arial" pitchFamily="34" charset="0"/>
        <a:buChar char="•"/>
        <a:defRPr sz="2493" kern="1200">
          <a:solidFill>
            <a:schemeClr val="tx1"/>
          </a:solidFill>
          <a:latin typeface="+mn-lt"/>
          <a:ea typeface="+mn-ea"/>
          <a:cs typeface="+mn-cs"/>
        </a:defRPr>
      </a:lvl6pPr>
      <a:lvl7pPr marL="3704928" indent="-284994" algn="l" defTabSz="1139978" rtl="0" eaLnBrk="1" latinLnBrk="0" hangingPunct="1">
        <a:spcBef>
          <a:spcPct val="20000"/>
        </a:spcBef>
        <a:buFont typeface="Arial" pitchFamily="34" charset="0"/>
        <a:buChar char="•"/>
        <a:defRPr sz="2493" kern="1200">
          <a:solidFill>
            <a:schemeClr val="tx1"/>
          </a:solidFill>
          <a:latin typeface="+mn-lt"/>
          <a:ea typeface="+mn-ea"/>
          <a:cs typeface="+mn-cs"/>
        </a:defRPr>
      </a:lvl7pPr>
      <a:lvl8pPr marL="4274917" indent="-284994" algn="l" defTabSz="1139978" rtl="0" eaLnBrk="1" latinLnBrk="0" hangingPunct="1">
        <a:spcBef>
          <a:spcPct val="20000"/>
        </a:spcBef>
        <a:buFont typeface="Arial" pitchFamily="34" charset="0"/>
        <a:buChar char="•"/>
        <a:defRPr sz="2493" kern="1200">
          <a:solidFill>
            <a:schemeClr val="tx1"/>
          </a:solidFill>
          <a:latin typeface="+mn-lt"/>
          <a:ea typeface="+mn-ea"/>
          <a:cs typeface="+mn-cs"/>
        </a:defRPr>
      </a:lvl8pPr>
      <a:lvl9pPr marL="4844906" indent="-284994" algn="l" defTabSz="1139978" rtl="0" eaLnBrk="1" latinLnBrk="0" hangingPunct="1">
        <a:spcBef>
          <a:spcPct val="20000"/>
        </a:spcBef>
        <a:buFont typeface="Arial" pitchFamily="34" charset="0"/>
        <a:buChar char="•"/>
        <a:defRPr sz="2493" kern="1200">
          <a:solidFill>
            <a:schemeClr val="tx1"/>
          </a:solidFill>
          <a:latin typeface="+mn-lt"/>
          <a:ea typeface="+mn-ea"/>
          <a:cs typeface="+mn-cs"/>
        </a:defRPr>
      </a:lvl9pPr>
    </p:bodyStyle>
    <p:otherStyle>
      <a:defPPr>
        <a:defRPr lang="en-US"/>
      </a:defPPr>
      <a:lvl1pPr marL="0" algn="l" defTabSz="1139978" rtl="0" eaLnBrk="1" latinLnBrk="0" hangingPunct="1">
        <a:defRPr sz="2244" kern="1200">
          <a:solidFill>
            <a:schemeClr val="tx1"/>
          </a:solidFill>
          <a:latin typeface="+mn-lt"/>
          <a:ea typeface="+mn-ea"/>
          <a:cs typeface="+mn-cs"/>
        </a:defRPr>
      </a:lvl1pPr>
      <a:lvl2pPr marL="569989" algn="l" defTabSz="1139978" rtl="0" eaLnBrk="1" latinLnBrk="0" hangingPunct="1">
        <a:defRPr sz="2244" kern="1200">
          <a:solidFill>
            <a:schemeClr val="tx1"/>
          </a:solidFill>
          <a:latin typeface="+mn-lt"/>
          <a:ea typeface="+mn-ea"/>
          <a:cs typeface="+mn-cs"/>
        </a:defRPr>
      </a:lvl2pPr>
      <a:lvl3pPr marL="1139978" algn="l" defTabSz="1139978" rtl="0" eaLnBrk="1" latinLnBrk="0" hangingPunct="1">
        <a:defRPr sz="2244" kern="1200">
          <a:solidFill>
            <a:schemeClr val="tx1"/>
          </a:solidFill>
          <a:latin typeface="+mn-lt"/>
          <a:ea typeface="+mn-ea"/>
          <a:cs typeface="+mn-cs"/>
        </a:defRPr>
      </a:lvl3pPr>
      <a:lvl4pPr marL="1709967" algn="l" defTabSz="1139978" rtl="0" eaLnBrk="1" latinLnBrk="0" hangingPunct="1">
        <a:defRPr sz="2244" kern="1200">
          <a:solidFill>
            <a:schemeClr val="tx1"/>
          </a:solidFill>
          <a:latin typeface="+mn-lt"/>
          <a:ea typeface="+mn-ea"/>
          <a:cs typeface="+mn-cs"/>
        </a:defRPr>
      </a:lvl4pPr>
      <a:lvl5pPr marL="2279956" algn="l" defTabSz="1139978" rtl="0" eaLnBrk="1" latinLnBrk="0" hangingPunct="1">
        <a:defRPr sz="2244" kern="1200">
          <a:solidFill>
            <a:schemeClr val="tx1"/>
          </a:solidFill>
          <a:latin typeface="+mn-lt"/>
          <a:ea typeface="+mn-ea"/>
          <a:cs typeface="+mn-cs"/>
        </a:defRPr>
      </a:lvl5pPr>
      <a:lvl6pPr marL="2849945" algn="l" defTabSz="1139978" rtl="0" eaLnBrk="1" latinLnBrk="0" hangingPunct="1">
        <a:defRPr sz="2244" kern="1200">
          <a:solidFill>
            <a:schemeClr val="tx1"/>
          </a:solidFill>
          <a:latin typeface="+mn-lt"/>
          <a:ea typeface="+mn-ea"/>
          <a:cs typeface="+mn-cs"/>
        </a:defRPr>
      </a:lvl6pPr>
      <a:lvl7pPr marL="3419934" algn="l" defTabSz="1139978" rtl="0" eaLnBrk="1" latinLnBrk="0" hangingPunct="1">
        <a:defRPr sz="2244" kern="1200">
          <a:solidFill>
            <a:schemeClr val="tx1"/>
          </a:solidFill>
          <a:latin typeface="+mn-lt"/>
          <a:ea typeface="+mn-ea"/>
          <a:cs typeface="+mn-cs"/>
        </a:defRPr>
      </a:lvl7pPr>
      <a:lvl8pPr marL="3989923" algn="l" defTabSz="1139978" rtl="0" eaLnBrk="1" latinLnBrk="0" hangingPunct="1">
        <a:defRPr sz="2244" kern="1200">
          <a:solidFill>
            <a:schemeClr val="tx1"/>
          </a:solidFill>
          <a:latin typeface="+mn-lt"/>
          <a:ea typeface="+mn-ea"/>
          <a:cs typeface="+mn-cs"/>
        </a:defRPr>
      </a:lvl8pPr>
      <a:lvl9pPr marL="4559912" algn="l" defTabSz="1139978" rtl="0" eaLnBrk="1" latinLnBrk="0" hangingPunct="1">
        <a:defRPr sz="2244"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2.xml"/><Relationship Id="rId7" Type="http://schemas.openxmlformats.org/officeDocument/2006/relationships/chart" Target="../charts/chart6.xml"/><Relationship Id="rId2" Type="http://schemas.openxmlformats.org/officeDocument/2006/relationships/chart" Target="../charts/chart1.xml"/><Relationship Id="rId1" Type="http://schemas.openxmlformats.org/officeDocument/2006/relationships/slideLayout" Target="../slideLayouts/slideLayout1.xml"/><Relationship Id="rId6" Type="http://schemas.openxmlformats.org/officeDocument/2006/relationships/chart" Target="../charts/chart5.xml"/><Relationship Id="rId5" Type="http://schemas.openxmlformats.org/officeDocument/2006/relationships/chart" Target="../charts/chart4.xml"/><Relationship Id="rId4" Type="http://schemas.openxmlformats.org/officeDocument/2006/relationships/chart" Target="../charts/chart3.xml"/></Relationships>
</file>

<file path=ppt/slides/_rels/slide2.xml.rels><?xml version="1.0" encoding="UTF-8" standalone="yes"?>
<Relationships xmlns="http://schemas.openxmlformats.org/package/2006/relationships"><Relationship Id="rId8" Type="http://schemas.microsoft.com/office/2007/relationships/hdphoto" Target="../media/hdphoto2.wdp"/><Relationship Id="rId3" Type="http://schemas.microsoft.com/office/2007/relationships/hdphoto" Target="../media/hdphoto1.wdp"/><Relationship Id="rId7" Type="http://schemas.openxmlformats.org/officeDocument/2006/relationships/image" Target="../media/image5.png"/><Relationship Id="rId12" Type="http://schemas.openxmlformats.org/officeDocument/2006/relationships/chart" Target="../charts/chart9.xml"/><Relationship Id="rId2" Type="http://schemas.openxmlformats.org/officeDocument/2006/relationships/image" Target="../media/image1.png"/><Relationship Id="rId1" Type="http://schemas.openxmlformats.org/officeDocument/2006/relationships/slideLayout" Target="../slideLayouts/slideLayout2.xml"/><Relationship Id="rId6" Type="http://schemas.openxmlformats.org/officeDocument/2006/relationships/image" Target="../media/image4.png"/><Relationship Id="rId11" Type="http://schemas.openxmlformats.org/officeDocument/2006/relationships/chart" Target="../charts/chart8.xml"/><Relationship Id="rId5" Type="http://schemas.openxmlformats.org/officeDocument/2006/relationships/image" Target="../media/image3.png"/><Relationship Id="rId10" Type="http://schemas.openxmlformats.org/officeDocument/2006/relationships/chart" Target="../charts/chart7.xml"/><Relationship Id="rId4" Type="http://schemas.openxmlformats.org/officeDocument/2006/relationships/image" Target="../media/image2.png"/><Relationship Id="rId9" Type="http://schemas.openxmlformats.org/officeDocument/2006/relationships/image" Target="../media/image6.png"/></Relationships>
</file>

<file path=ppt/slides/_rels/slide3.xml.rels><?xml version="1.0" encoding="UTF-8" standalone="yes"?>
<Relationships xmlns="http://schemas.openxmlformats.org/package/2006/relationships"><Relationship Id="rId2" Type="http://schemas.openxmlformats.org/officeDocument/2006/relationships/chart" Target="../charts/chart10.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hape 949"/>
          <p:cNvSpPr/>
          <p:nvPr/>
        </p:nvSpPr>
        <p:spPr>
          <a:xfrm>
            <a:off x="911911" y="260121"/>
            <a:ext cx="3429001" cy="307800"/>
          </a:xfrm>
          <a:prstGeom prst="rect">
            <a:avLst/>
          </a:prstGeom>
          <a:noFill/>
          <a:ln>
            <a:noFill/>
          </a:ln>
        </p:spPr>
        <p:txBody>
          <a:bodyPr lIns="91425" tIns="45700" rIns="91425" bIns="45700" anchor="t" anchorCtr="0">
            <a:noAutofit/>
          </a:bodyPr>
          <a:lstStyle/>
          <a:p>
            <a:pPr>
              <a:buSzPct val="25000"/>
            </a:pPr>
            <a:r>
              <a:rPr lang="en-US" sz="1400" dirty="0" smtClean="0">
                <a:solidFill>
                  <a:schemeClr val="dk1"/>
                </a:solidFill>
                <a:latin typeface="Calibri"/>
                <a:ea typeface="Calibri"/>
                <a:cs typeface="Calibri"/>
                <a:sym typeface="Calibri"/>
              </a:rPr>
              <a:t>miR394ab </a:t>
            </a:r>
            <a:r>
              <a:rPr lang="en-US" sz="1400" dirty="0">
                <a:solidFill>
                  <a:schemeClr val="dk1"/>
                </a:solidFill>
                <a:latin typeface="Calibri"/>
                <a:ea typeface="Calibri"/>
                <a:cs typeface="Calibri"/>
                <a:sym typeface="Calibri"/>
              </a:rPr>
              <a:t>targeting Bradi2g59200.1</a:t>
            </a:r>
          </a:p>
        </p:txBody>
      </p:sp>
      <p:sp>
        <p:nvSpPr>
          <p:cNvPr id="3" name="TextBox 2"/>
          <p:cNvSpPr txBox="1"/>
          <p:nvPr/>
        </p:nvSpPr>
        <p:spPr>
          <a:xfrm>
            <a:off x="629641" y="223230"/>
            <a:ext cx="376770" cy="369332"/>
          </a:xfrm>
          <a:prstGeom prst="rect">
            <a:avLst/>
          </a:prstGeom>
          <a:noFill/>
        </p:spPr>
        <p:txBody>
          <a:bodyPr wrap="none" rtlCol="0">
            <a:spAutoFit/>
          </a:bodyPr>
          <a:lstStyle/>
          <a:p>
            <a:r>
              <a:rPr lang="en-US" dirty="0" smtClean="0"/>
              <a:t>A.</a:t>
            </a:r>
            <a:endParaRPr lang="en-US" dirty="0"/>
          </a:p>
        </p:txBody>
      </p:sp>
      <p:sp>
        <p:nvSpPr>
          <p:cNvPr id="4" name="TextBox 3"/>
          <p:cNvSpPr txBox="1"/>
          <p:nvPr/>
        </p:nvSpPr>
        <p:spPr>
          <a:xfrm>
            <a:off x="540355" y="2925887"/>
            <a:ext cx="379656" cy="369332"/>
          </a:xfrm>
          <a:prstGeom prst="rect">
            <a:avLst/>
          </a:prstGeom>
          <a:noFill/>
        </p:spPr>
        <p:txBody>
          <a:bodyPr wrap="none" rtlCol="0">
            <a:spAutoFit/>
          </a:bodyPr>
          <a:lstStyle/>
          <a:p>
            <a:r>
              <a:rPr lang="en-US" dirty="0" smtClean="0"/>
              <a:t>B.</a:t>
            </a:r>
            <a:endParaRPr lang="en-US" dirty="0"/>
          </a:p>
        </p:txBody>
      </p:sp>
      <p:sp>
        <p:nvSpPr>
          <p:cNvPr id="5" name="Shape 949"/>
          <p:cNvSpPr/>
          <p:nvPr/>
        </p:nvSpPr>
        <p:spPr>
          <a:xfrm>
            <a:off x="835968" y="2957513"/>
            <a:ext cx="3238739" cy="420426"/>
          </a:xfrm>
          <a:prstGeom prst="rect">
            <a:avLst/>
          </a:prstGeom>
          <a:noFill/>
          <a:ln>
            <a:noFill/>
          </a:ln>
        </p:spPr>
        <p:txBody>
          <a:bodyPr lIns="91425" tIns="45700" rIns="91425" bIns="45700" anchor="t" anchorCtr="0">
            <a:noAutofit/>
          </a:bodyPr>
          <a:lstStyle/>
          <a:p>
            <a:pPr lvl="0">
              <a:buSzPct val="25000"/>
            </a:pPr>
            <a:r>
              <a:rPr lang="en-US" sz="1400" dirty="0" smtClean="0">
                <a:solidFill>
                  <a:schemeClr val="dk1"/>
                </a:solidFill>
                <a:latin typeface="Calibri"/>
                <a:ea typeface="Calibri"/>
                <a:cs typeface="Calibri"/>
                <a:sym typeface="Calibri"/>
              </a:rPr>
              <a:t>miR169 </a:t>
            </a:r>
            <a:r>
              <a:rPr lang="en-US" sz="1400" dirty="0">
                <a:solidFill>
                  <a:schemeClr val="dk1"/>
                </a:solidFill>
                <a:latin typeface="Calibri"/>
                <a:ea typeface="Calibri"/>
                <a:cs typeface="Calibri"/>
                <a:sym typeface="Calibri"/>
              </a:rPr>
              <a:t>targeting </a:t>
            </a:r>
            <a:r>
              <a:rPr lang="en-US" sz="1400" dirty="0" smtClean="0">
                <a:solidFill>
                  <a:schemeClr val="dk1"/>
                </a:solidFill>
                <a:latin typeface="Calibri"/>
                <a:ea typeface="Calibri"/>
                <a:cs typeface="Calibri"/>
                <a:sym typeface="Calibri"/>
              </a:rPr>
              <a:t>Bradi1g11800.5</a:t>
            </a:r>
            <a:endParaRPr lang="en-US" sz="1400" dirty="0">
              <a:solidFill>
                <a:schemeClr val="dk1"/>
              </a:solidFill>
              <a:latin typeface="Calibri"/>
              <a:ea typeface="Calibri"/>
              <a:cs typeface="Calibri"/>
              <a:sym typeface="Calibri"/>
            </a:endParaRPr>
          </a:p>
        </p:txBody>
      </p:sp>
      <p:graphicFrame>
        <p:nvGraphicFramePr>
          <p:cNvPr id="6" name="Chart 5"/>
          <p:cNvGraphicFramePr>
            <a:graphicFrameLocks/>
          </p:cNvGraphicFramePr>
          <p:nvPr>
            <p:extLst>
              <p:ext uri="{D42A27DB-BD31-4B8C-83A1-F6EECF244321}">
                <p14:modId xmlns:p14="http://schemas.microsoft.com/office/powerpoint/2010/main" val="1328458881"/>
              </p:ext>
            </p:extLst>
          </p:nvPr>
        </p:nvGraphicFramePr>
        <p:xfrm>
          <a:off x="642969" y="3276600"/>
          <a:ext cx="3240000" cy="228600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7" name="Chart 6"/>
          <p:cNvGraphicFramePr>
            <a:graphicFrameLocks/>
          </p:cNvGraphicFramePr>
          <p:nvPr>
            <p:extLst>
              <p:ext uri="{D42A27DB-BD31-4B8C-83A1-F6EECF244321}">
                <p14:modId xmlns:p14="http://schemas.microsoft.com/office/powerpoint/2010/main" val="1464538053"/>
              </p:ext>
            </p:extLst>
          </p:nvPr>
        </p:nvGraphicFramePr>
        <p:xfrm>
          <a:off x="3886200" y="3276600"/>
          <a:ext cx="3240000" cy="228600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8" name="Chart 7"/>
          <p:cNvGraphicFramePr>
            <a:graphicFrameLocks/>
          </p:cNvGraphicFramePr>
          <p:nvPr>
            <p:extLst>
              <p:ext uri="{D42A27DB-BD31-4B8C-83A1-F6EECF244321}">
                <p14:modId xmlns:p14="http://schemas.microsoft.com/office/powerpoint/2010/main" val="416460846"/>
              </p:ext>
            </p:extLst>
          </p:nvPr>
        </p:nvGraphicFramePr>
        <p:xfrm>
          <a:off x="642969" y="5979636"/>
          <a:ext cx="3240000" cy="2286000"/>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9" name="Chart 8"/>
          <p:cNvGraphicFramePr>
            <a:graphicFrameLocks/>
          </p:cNvGraphicFramePr>
          <p:nvPr>
            <p:extLst>
              <p:ext uri="{D42A27DB-BD31-4B8C-83A1-F6EECF244321}">
                <p14:modId xmlns:p14="http://schemas.microsoft.com/office/powerpoint/2010/main" val="478111652"/>
              </p:ext>
            </p:extLst>
          </p:nvPr>
        </p:nvGraphicFramePr>
        <p:xfrm>
          <a:off x="3886200" y="5979636"/>
          <a:ext cx="3240000" cy="2286000"/>
        </p:xfrm>
        <a:graphic>
          <a:graphicData uri="http://schemas.openxmlformats.org/drawingml/2006/chart">
            <c:chart xmlns:c="http://schemas.openxmlformats.org/drawingml/2006/chart" xmlns:r="http://schemas.openxmlformats.org/officeDocument/2006/relationships" r:id="rId5"/>
          </a:graphicData>
        </a:graphic>
      </p:graphicFrame>
      <p:sp>
        <p:nvSpPr>
          <p:cNvPr id="10" name="TextBox 9"/>
          <p:cNvSpPr txBox="1"/>
          <p:nvPr/>
        </p:nvSpPr>
        <p:spPr>
          <a:xfrm>
            <a:off x="554205" y="5610304"/>
            <a:ext cx="365806" cy="369332"/>
          </a:xfrm>
          <a:prstGeom prst="rect">
            <a:avLst/>
          </a:prstGeom>
          <a:noFill/>
        </p:spPr>
        <p:txBody>
          <a:bodyPr wrap="none" rtlCol="0">
            <a:spAutoFit/>
          </a:bodyPr>
          <a:lstStyle/>
          <a:p>
            <a:r>
              <a:rPr lang="en-US" dirty="0"/>
              <a:t>C</a:t>
            </a:r>
            <a:r>
              <a:rPr lang="en-US" dirty="0" smtClean="0"/>
              <a:t>.</a:t>
            </a:r>
            <a:endParaRPr lang="en-US" dirty="0"/>
          </a:p>
        </p:txBody>
      </p:sp>
      <p:sp>
        <p:nvSpPr>
          <p:cNvPr id="11" name="Shape 949"/>
          <p:cNvSpPr/>
          <p:nvPr/>
        </p:nvSpPr>
        <p:spPr>
          <a:xfrm>
            <a:off x="835968" y="5628544"/>
            <a:ext cx="3238739" cy="420426"/>
          </a:xfrm>
          <a:prstGeom prst="rect">
            <a:avLst/>
          </a:prstGeom>
          <a:noFill/>
          <a:ln>
            <a:noFill/>
          </a:ln>
        </p:spPr>
        <p:txBody>
          <a:bodyPr lIns="91425" tIns="45700" rIns="91425" bIns="45700" anchor="t" anchorCtr="0">
            <a:noAutofit/>
          </a:bodyPr>
          <a:lstStyle/>
          <a:p>
            <a:pPr lvl="0">
              <a:buSzPct val="25000"/>
            </a:pPr>
            <a:r>
              <a:rPr lang="en-US" sz="1400" dirty="0" smtClean="0">
                <a:solidFill>
                  <a:schemeClr val="dk1"/>
                </a:solidFill>
                <a:latin typeface="Calibri"/>
                <a:ea typeface="Calibri"/>
                <a:cs typeface="Calibri"/>
                <a:sym typeface="Calibri"/>
              </a:rPr>
              <a:t>miR393ab </a:t>
            </a:r>
            <a:r>
              <a:rPr lang="en-US" sz="1400" dirty="0">
                <a:solidFill>
                  <a:schemeClr val="dk1"/>
                </a:solidFill>
                <a:latin typeface="Calibri"/>
                <a:ea typeface="Calibri"/>
                <a:cs typeface="Calibri"/>
                <a:sym typeface="Calibri"/>
              </a:rPr>
              <a:t>targeting </a:t>
            </a:r>
            <a:r>
              <a:rPr lang="en-US" sz="1400" dirty="0">
                <a:solidFill>
                  <a:schemeClr val="dk1"/>
                </a:solidFill>
                <a:ea typeface="Calibri"/>
                <a:cs typeface="Calibri"/>
                <a:sym typeface="Calibri"/>
              </a:rPr>
              <a:t>Bradi2g35720.1</a:t>
            </a:r>
            <a:endParaRPr lang="en-US" sz="1400" dirty="0">
              <a:solidFill>
                <a:schemeClr val="dk1"/>
              </a:solidFill>
              <a:latin typeface="Calibri"/>
              <a:ea typeface="Calibri"/>
              <a:cs typeface="Calibri"/>
              <a:sym typeface="Calibri"/>
            </a:endParaRPr>
          </a:p>
        </p:txBody>
      </p:sp>
      <p:graphicFrame>
        <p:nvGraphicFramePr>
          <p:cNvPr id="12" name="Chart 11"/>
          <p:cNvGraphicFramePr>
            <a:graphicFrameLocks/>
          </p:cNvGraphicFramePr>
          <p:nvPr>
            <p:extLst>
              <p:ext uri="{D42A27DB-BD31-4B8C-83A1-F6EECF244321}">
                <p14:modId xmlns:p14="http://schemas.microsoft.com/office/powerpoint/2010/main" val="151616586"/>
              </p:ext>
            </p:extLst>
          </p:nvPr>
        </p:nvGraphicFramePr>
        <p:xfrm>
          <a:off x="642969" y="624188"/>
          <a:ext cx="3240000" cy="2286000"/>
        </p:xfrm>
        <a:graphic>
          <a:graphicData uri="http://schemas.openxmlformats.org/drawingml/2006/chart">
            <c:chart xmlns:c="http://schemas.openxmlformats.org/drawingml/2006/chart" xmlns:r="http://schemas.openxmlformats.org/officeDocument/2006/relationships" r:id="rId6"/>
          </a:graphicData>
        </a:graphic>
      </p:graphicFrame>
      <p:graphicFrame>
        <p:nvGraphicFramePr>
          <p:cNvPr id="13" name="Chart 12"/>
          <p:cNvGraphicFramePr>
            <a:graphicFrameLocks/>
          </p:cNvGraphicFramePr>
          <p:nvPr>
            <p:extLst>
              <p:ext uri="{D42A27DB-BD31-4B8C-83A1-F6EECF244321}">
                <p14:modId xmlns:p14="http://schemas.microsoft.com/office/powerpoint/2010/main" val="391064641"/>
              </p:ext>
            </p:extLst>
          </p:nvPr>
        </p:nvGraphicFramePr>
        <p:xfrm>
          <a:off x="3882969" y="623809"/>
          <a:ext cx="3240000" cy="2286000"/>
        </p:xfrm>
        <a:graphic>
          <a:graphicData uri="http://schemas.openxmlformats.org/drawingml/2006/chart">
            <c:chart xmlns:c="http://schemas.openxmlformats.org/drawingml/2006/chart" xmlns:r="http://schemas.openxmlformats.org/officeDocument/2006/relationships" r:id="rId7"/>
          </a:graphicData>
        </a:graphic>
      </p:graphicFrame>
      <p:sp>
        <p:nvSpPr>
          <p:cNvPr id="14" name="Shape 884"/>
          <p:cNvSpPr txBox="1"/>
          <p:nvPr/>
        </p:nvSpPr>
        <p:spPr>
          <a:xfrm>
            <a:off x="598326" y="8294721"/>
            <a:ext cx="6569286" cy="795973"/>
          </a:xfrm>
          <a:prstGeom prst="rect">
            <a:avLst/>
          </a:prstGeom>
          <a:noFill/>
          <a:ln>
            <a:noFill/>
          </a:ln>
        </p:spPr>
        <p:txBody>
          <a:bodyPr lIns="91425" tIns="45700" rIns="91425" bIns="45700" anchor="t" anchorCtr="0">
            <a:noAutofit/>
          </a:bodyPr>
          <a:lstStyle/>
          <a:p>
            <a:pPr>
              <a:buSzPct val="25000"/>
            </a:pPr>
            <a:r>
              <a:rPr lang="en-US" sz="1200" b="1" dirty="0" smtClean="0">
                <a:solidFill>
                  <a:schemeClr val="dk1"/>
                </a:solidFill>
                <a:latin typeface="Calibri"/>
                <a:ea typeface="Calibri"/>
                <a:cs typeface="Calibri"/>
                <a:sym typeface="Calibri"/>
              </a:rPr>
              <a:t>Figure S1 D-Plots of the </a:t>
            </a:r>
            <a:r>
              <a:rPr lang="en-US" sz="1200" b="1" dirty="0">
                <a:solidFill>
                  <a:schemeClr val="dk1"/>
                </a:solidFill>
                <a:ea typeface="Calibri"/>
                <a:cs typeface="Calibri"/>
                <a:sym typeface="Calibri"/>
              </a:rPr>
              <a:t>cold regulated inverse group miRNA targets</a:t>
            </a:r>
            <a:r>
              <a:rPr lang="en-US" sz="1200" b="1" dirty="0" smtClean="0">
                <a:solidFill>
                  <a:schemeClr val="dk1"/>
                </a:solidFill>
                <a:latin typeface="Calibri"/>
                <a:ea typeface="Calibri"/>
                <a:cs typeface="Calibri"/>
                <a:sym typeface="Calibri"/>
              </a:rPr>
              <a:t>. </a:t>
            </a:r>
            <a:r>
              <a:rPr lang="en-US" sz="1200" dirty="0" smtClean="0">
                <a:solidFill>
                  <a:schemeClr val="dk1"/>
                </a:solidFill>
                <a:latin typeface="Calibri"/>
                <a:ea typeface="Calibri"/>
                <a:cs typeface="Calibri"/>
                <a:sym typeface="Calibri"/>
              </a:rPr>
              <a:t>PARE data showing evidence for cold regulation of the miRNA guided cleavages of (A) Bradi2g59200.1, (B) Bradi1g11800.5, and (C) Bradi2g35720.1.  An additional biological replicate of what is shown in Figure 6. </a:t>
            </a:r>
            <a:r>
              <a:rPr lang="en-US" sz="1200" dirty="0"/>
              <a:t>Red dots indicate the PARE sequences mapping to predicted target sites.</a:t>
            </a:r>
            <a:endParaRPr lang="en-US" sz="1200" b="1" dirty="0">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223758780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1547016" y="2667000"/>
            <a:ext cx="367408" cy="369332"/>
          </a:xfrm>
          <a:prstGeom prst="rect">
            <a:avLst/>
          </a:prstGeom>
          <a:noFill/>
        </p:spPr>
        <p:txBody>
          <a:bodyPr wrap="none" rtlCol="0">
            <a:spAutoFit/>
          </a:bodyPr>
          <a:lstStyle/>
          <a:p>
            <a:r>
              <a:rPr lang="en-US" dirty="0" smtClean="0"/>
              <a:t>B.</a:t>
            </a:r>
            <a:endParaRPr lang="en-US" dirty="0"/>
          </a:p>
        </p:txBody>
      </p:sp>
      <p:sp>
        <p:nvSpPr>
          <p:cNvPr id="5" name="TextBox 4"/>
          <p:cNvSpPr txBox="1"/>
          <p:nvPr/>
        </p:nvSpPr>
        <p:spPr>
          <a:xfrm>
            <a:off x="1552329" y="117124"/>
            <a:ext cx="376770" cy="369332"/>
          </a:xfrm>
          <a:prstGeom prst="rect">
            <a:avLst/>
          </a:prstGeom>
          <a:noFill/>
        </p:spPr>
        <p:txBody>
          <a:bodyPr wrap="none" rtlCol="0">
            <a:spAutoFit/>
          </a:bodyPr>
          <a:lstStyle/>
          <a:p>
            <a:r>
              <a:rPr lang="en-US" dirty="0" smtClean="0"/>
              <a:t>A.</a:t>
            </a:r>
            <a:endParaRPr lang="en-US" dirty="0"/>
          </a:p>
        </p:txBody>
      </p:sp>
      <p:sp>
        <p:nvSpPr>
          <p:cNvPr id="6" name="Shape 937"/>
          <p:cNvSpPr txBox="1"/>
          <p:nvPr/>
        </p:nvSpPr>
        <p:spPr>
          <a:xfrm>
            <a:off x="1520550" y="790058"/>
            <a:ext cx="769938" cy="296568"/>
          </a:xfrm>
          <a:prstGeom prst="rect">
            <a:avLst/>
          </a:prstGeom>
          <a:noFill/>
          <a:ln>
            <a:noFill/>
          </a:ln>
        </p:spPr>
        <p:txBody>
          <a:bodyPr lIns="91425" tIns="45700" rIns="91425" bIns="45700" anchor="ctr" anchorCtr="0">
            <a:noAutofit/>
          </a:bodyPr>
          <a:lstStyle/>
          <a:p>
            <a:pPr algn="r">
              <a:buSzPct val="25000"/>
            </a:pPr>
            <a:r>
              <a:rPr lang="en-US" sz="1000" dirty="0">
                <a:solidFill>
                  <a:schemeClr val="dk1"/>
                </a:solidFill>
                <a:latin typeface="Calibri"/>
                <a:ea typeface="Calibri"/>
                <a:cs typeface="Calibri"/>
                <a:sym typeface="Calibri"/>
              </a:rPr>
              <a:t>miR394ab</a:t>
            </a:r>
          </a:p>
        </p:txBody>
      </p:sp>
      <p:sp>
        <p:nvSpPr>
          <p:cNvPr id="7" name="Shape 936"/>
          <p:cNvSpPr txBox="1"/>
          <p:nvPr/>
        </p:nvSpPr>
        <p:spPr>
          <a:xfrm>
            <a:off x="2290488" y="502172"/>
            <a:ext cx="1800000" cy="287886"/>
          </a:xfrm>
          <a:prstGeom prst="rect">
            <a:avLst/>
          </a:prstGeom>
          <a:noFill/>
          <a:ln>
            <a:noFill/>
          </a:ln>
        </p:spPr>
        <p:txBody>
          <a:bodyPr lIns="91425" tIns="45700" rIns="91425" bIns="45700" anchor="t" anchorCtr="0">
            <a:noAutofit/>
          </a:bodyPr>
          <a:lstStyle/>
          <a:p>
            <a:pPr>
              <a:buSzPct val="25000"/>
            </a:pPr>
            <a:r>
              <a:rPr lang="en-US" sz="1000" dirty="0">
                <a:solidFill>
                  <a:schemeClr val="dk1"/>
                </a:solidFill>
                <a:ea typeface="Arial"/>
                <a:cs typeface="Arial"/>
                <a:sym typeface="Arial"/>
              </a:rPr>
              <a:t> </a:t>
            </a:r>
            <a:r>
              <a:rPr lang="en-US" sz="1000" dirty="0" smtClean="0">
                <a:solidFill>
                  <a:schemeClr val="dk1"/>
                </a:solidFill>
                <a:ea typeface="Arial"/>
                <a:cs typeface="Arial"/>
                <a:sym typeface="Arial"/>
              </a:rPr>
              <a:t>0     1     </a:t>
            </a:r>
            <a:r>
              <a:rPr lang="en-US" sz="1000" dirty="0">
                <a:solidFill>
                  <a:schemeClr val="dk1"/>
                </a:solidFill>
                <a:ea typeface="Arial"/>
                <a:cs typeface="Arial"/>
                <a:sym typeface="Arial"/>
              </a:rPr>
              <a:t>2     </a:t>
            </a:r>
            <a:r>
              <a:rPr lang="en-US" sz="1000" dirty="0" smtClean="0">
                <a:solidFill>
                  <a:schemeClr val="dk1"/>
                </a:solidFill>
                <a:ea typeface="Arial"/>
                <a:cs typeface="Arial"/>
                <a:sym typeface="Arial"/>
              </a:rPr>
              <a:t> 3     6    12  24   36</a:t>
            </a:r>
            <a:endParaRPr lang="en-US" sz="1000" dirty="0">
              <a:solidFill>
                <a:schemeClr val="dk1"/>
              </a:solidFill>
              <a:ea typeface="Arial"/>
              <a:cs typeface="Arial"/>
              <a:sym typeface="Arial"/>
            </a:endParaRPr>
          </a:p>
        </p:txBody>
      </p:sp>
      <p:cxnSp>
        <p:nvCxnSpPr>
          <p:cNvPr id="8" name="Shape 932"/>
          <p:cNvCxnSpPr/>
          <p:nvPr/>
        </p:nvCxnSpPr>
        <p:spPr>
          <a:xfrm flipV="1">
            <a:off x="2290488" y="457757"/>
            <a:ext cx="1800000" cy="0"/>
          </a:xfrm>
          <a:prstGeom prst="straightConnector1">
            <a:avLst/>
          </a:prstGeom>
          <a:noFill/>
          <a:ln w="28575" cap="flat">
            <a:solidFill>
              <a:schemeClr val="dk1"/>
            </a:solidFill>
            <a:prstDash val="solid"/>
            <a:miter/>
            <a:headEnd type="none" w="med" len="med"/>
            <a:tailEnd type="none" w="med" len="med"/>
          </a:ln>
        </p:spPr>
      </p:cxnSp>
      <p:sp>
        <p:nvSpPr>
          <p:cNvPr id="9" name="Shape 933"/>
          <p:cNvSpPr txBox="1"/>
          <p:nvPr/>
        </p:nvSpPr>
        <p:spPr>
          <a:xfrm>
            <a:off x="2805762" y="195486"/>
            <a:ext cx="769452" cy="276998"/>
          </a:xfrm>
          <a:prstGeom prst="rect">
            <a:avLst/>
          </a:prstGeom>
          <a:noFill/>
          <a:ln>
            <a:noFill/>
          </a:ln>
        </p:spPr>
        <p:txBody>
          <a:bodyPr lIns="91425" tIns="45700" rIns="91425" bIns="45700" anchor="t" anchorCtr="0">
            <a:noAutofit/>
          </a:bodyPr>
          <a:lstStyle/>
          <a:p>
            <a:pPr algn="ctr">
              <a:buSzPct val="25000"/>
            </a:pPr>
            <a:r>
              <a:rPr lang="en-US" sz="1200" b="1" dirty="0">
                <a:solidFill>
                  <a:schemeClr val="dk1"/>
                </a:solidFill>
                <a:ea typeface="Arial"/>
                <a:cs typeface="Arial"/>
                <a:sym typeface="Arial"/>
              </a:rPr>
              <a:t>Control</a:t>
            </a:r>
          </a:p>
        </p:txBody>
      </p:sp>
      <p:sp>
        <p:nvSpPr>
          <p:cNvPr id="10" name="Shape 935"/>
          <p:cNvSpPr txBox="1"/>
          <p:nvPr/>
        </p:nvSpPr>
        <p:spPr>
          <a:xfrm>
            <a:off x="4813266" y="195473"/>
            <a:ext cx="769452" cy="276998"/>
          </a:xfrm>
          <a:prstGeom prst="rect">
            <a:avLst/>
          </a:prstGeom>
          <a:noFill/>
          <a:ln>
            <a:noFill/>
          </a:ln>
        </p:spPr>
        <p:txBody>
          <a:bodyPr lIns="91425" tIns="45700" rIns="91425" bIns="45700" anchor="t" anchorCtr="0">
            <a:noAutofit/>
          </a:bodyPr>
          <a:lstStyle/>
          <a:p>
            <a:pPr algn="ctr">
              <a:buSzPct val="25000"/>
            </a:pPr>
            <a:r>
              <a:rPr lang="en-US" sz="1200" b="1" dirty="0">
                <a:solidFill>
                  <a:schemeClr val="dk1"/>
                </a:solidFill>
                <a:ea typeface="Arial"/>
                <a:cs typeface="Arial"/>
                <a:sym typeface="Arial"/>
              </a:rPr>
              <a:t>Cold</a:t>
            </a:r>
          </a:p>
        </p:txBody>
      </p:sp>
      <p:cxnSp>
        <p:nvCxnSpPr>
          <p:cNvPr id="11" name="Shape 932"/>
          <p:cNvCxnSpPr/>
          <p:nvPr/>
        </p:nvCxnSpPr>
        <p:spPr>
          <a:xfrm>
            <a:off x="4297992" y="457757"/>
            <a:ext cx="1800000" cy="0"/>
          </a:xfrm>
          <a:prstGeom prst="straightConnector1">
            <a:avLst/>
          </a:prstGeom>
          <a:noFill/>
          <a:ln w="28575" cap="flat">
            <a:solidFill>
              <a:schemeClr val="dk1"/>
            </a:solidFill>
            <a:prstDash val="solid"/>
            <a:miter/>
            <a:headEnd type="none" w="med" len="med"/>
            <a:tailEnd type="none" w="med" len="med"/>
          </a:ln>
        </p:spPr>
      </p:cxnSp>
      <p:sp>
        <p:nvSpPr>
          <p:cNvPr id="12" name="Shape 937"/>
          <p:cNvSpPr txBox="1"/>
          <p:nvPr/>
        </p:nvSpPr>
        <p:spPr>
          <a:xfrm>
            <a:off x="1515237" y="510918"/>
            <a:ext cx="775251" cy="276998"/>
          </a:xfrm>
          <a:prstGeom prst="rect">
            <a:avLst/>
          </a:prstGeom>
          <a:noFill/>
          <a:ln>
            <a:noFill/>
          </a:ln>
        </p:spPr>
        <p:txBody>
          <a:bodyPr lIns="91425" tIns="45700" rIns="91425" bIns="45700" anchor="t" anchorCtr="0">
            <a:noAutofit/>
          </a:bodyPr>
          <a:lstStyle/>
          <a:p>
            <a:pPr algn="r">
              <a:buSzPct val="25000"/>
            </a:pPr>
            <a:r>
              <a:rPr lang="en-US" sz="1100" b="1" dirty="0">
                <a:solidFill>
                  <a:schemeClr val="dk1"/>
                </a:solidFill>
                <a:latin typeface="Calibri"/>
                <a:ea typeface="Calibri"/>
                <a:cs typeface="Calibri"/>
                <a:sym typeface="Calibri"/>
              </a:rPr>
              <a:t>Time in </a:t>
            </a:r>
            <a:r>
              <a:rPr lang="en-US" sz="1100" b="1" dirty="0" err="1">
                <a:solidFill>
                  <a:schemeClr val="dk1"/>
                </a:solidFill>
                <a:latin typeface="Calibri"/>
                <a:ea typeface="Calibri"/>
                <a:cs typeface="Calibri"/>
                <a:sym typeface="Calibri"/>
              </a:rPr>
              <a:t>hr</a:t>
            </a:r>
            <a:endParaRPr lang="en-US" sz="1100" b="1" dirty="0">
              <a:solidFill>
                <a:schemeClr val="dk1"/>
              </a:solidFill>
              <a:latin typeface="Calibri"/>
              <a:ea typeface="Calibri"/>
              <a:cs typeface="Calibri"/>
              <a:sym typeface="Calibri"/>
            </a:endParaRPr>
          </a:p>
        </p:txBody>
      </p:sp>
      <p:sp>
        <p:nvSpPr>
          <p:cNvPr id="13" name="Shape 937"/>
          <p:cNvSpPr txBox="1"/>
          <p:nvPr/>
        </p:nvSpPr>
        <p:spPr>
          <a:xfrm>
            <a:off x="1520551" y="2501019"/>
            <a:ext cx="756224" cy="279229"/>
          </a:xfrm>
          <a:prstGeom prst="rect">
            <a:avLst/>
          </a:prstGeom>
          <a:noFill/>
          <a:ln>
            <a:noFill/>
          </a:ln>
        </p:spPr>
        <p:txBody>
          <a:bodyPr lIns="91425" tIns="45700" rIns="91425" bIns="45700" anchor="ctr" anchorCtr="0">
            <a:noAutofit/>
          </a:bodyPr>
          <a:lstStyle/>
          <a:p>
            <a:pPr algn="r">
              <a:buSzPct val="25000"/>
            </a:pPr>
            <a:r>
              <a:rPr lang="en-US" sz="1000" dirty="0">
                <a:solidFill>
                  <a:schemeClr val="dk1"/>
                </a:solidFill>
                <a:latin typeface="Calibri"/>
                <a:ea typeface="Calibri"/>
                <a:cs typeface="Calibri"/>
                <a:sym typeface="Calibri"/>
              </a:rPr>
              <a:t>miR168</a:t>
            </a:r>
          </a:p>
        </p:txBody>
      </p:sp>
      <p:sp>
        <p:nvSpPr>
          <p:cNvPr id="14" name="Shape 937"/>
          <p:cNvSpPr txBox="1"/>
          <p:nvPr/>
        </p:nvSpPr>
        <p:spPr>
          <a:xfrm>
            <a:off x="1591067" y="1357096"/>
            <a:ext cx="699421" cy="300148"/>
          </a:xfrm>
          <a:prstGeom prst="rect">
            <a:avLst/>
          </a:prstGeom>
          <a:noFill/>
          <a:ln>
            <a:noFill/>
          </a:ln>
        </p:spPr>
        <p:txBody>
          <a:bodyPr lIns="91425" tIns="45700" rIns="91425" bIns="45700" anchor="ctr" anchorCtr="0">
            <a:noAutofit/>
          </a:bodyPr>
          <a:lstStyle/>
          <a:p>
            <a:pPr algn="r">
              <a:buSzPct val="25000"/>
            </a:pPr>
            <a:r>
              <a:rPr lang="en-US" sz="1000" dirty="0">
                <a:solidFill>
                  <a:schemeClr val="dk1"/>
                </a:solidFill>
                <a:latin typeface="Calibri"/>
                <a:ea typeface="Calibri"/>
                <a:cs typeface="Calibri"/>
                <a:sym typeface="Calibri"/>
              </a:rPr>
              <a:t>miR169a</a:t>
            </a:r>
            <a:endParaRPr lang="en-US" sz="1050" dirty="0">
              <a:solidFill>
                <a:schemeClr val="dk1"/>
              </a:solidFill>
              <a:latin typeface="Calibri"/>
              <a:ea typeface="Calibri"/>
              <a:cs typeface="Calibri"/>
              <a:sym typeface="Calibri"/>
            </a:endParaRPr>
          </a:p>
        </p:txBody>
      </p:sp>
      <p:sp>
        <p:nvSpPr>
          <p:cNvPr id="15" name="Shape 937"/>
          <p:cNvSpPr txBox="1"/>
          <p:nvPr/>
        </p:nvSpPr>
        <p:spPr>
          <a:xfrm>
            <a:off x="1520551" y="1937678"/>
            <a:ext cx="769938" cy="282907"/>
          </a:xfrm>
          <a:prstGeom prst="rect">
            <a:avLst/>
          </a:prstGeom>
          <a:noFill/>
          <a:ln>
            <a:noFill/>
          </a:ln>
        </p:spPr>
        <p:txBody>
          <a:bodyPr lIns="91425" tIns="45700" rIns="91425" bIns="45700" anchor="ctr" anchorCtr="0">
            <a:noAutofit/>
          </a:bodyPr>
          <a:lstStyle/>
          <a:p>
            <a:pPr algn="r">
              <a:buSzPct val="25000"/>
            </a:pPr>
            <a:r>
              <a:rPr lang="en-US" sz="1000" dirty="0" smtClean="0">
                <a:solidFill>
                  <a:schemeClr val="dk1"/>
                </a:solidFill>
                <a:latin typeface="Calibri"/>
                <a:ea typeface="Calibri"/>
                <a:cs typeface="Calibri"/>
                <a:sym typeface="Calibri"/>
              </a:rPr>
              <a:t>miR393ab</a:t>
            </a:r>
            <a:endParaRPr lang="en-US" sz="1000" dirty="0">
              <a:solidFill>
                <a:schemeClr val="dk1"/>
              </a:solidFill>
              <a:latin typeface="Calibri"/>
              <a:ea typeface="Calibri"/>
              <a:cs typeface="Calibri"/>
              <a:sym typeface="Calibri"/>
            </a:endParaRPr>
          </a:p>
        </p:txBody>
      </p:sp>
      <p:sp>
        <p:nvSpPr>
          <p:cNvPr id="16" name="Shape 936"/>
          <p:cNvSpPr txBox="1"/>
          <p:nvPr/>
        </p:nvSpPr>
        <p:spPr>
          <a:xfrm>
            <a:off x="4297993" y="496617"/>
            <a:ext cx="1800000" cy="287886"/>
          </a:xfrm>
          <a:prstGeom prst="rect">
            <a:avLst/>
          </a:prstGeom>
          <a:noFill/>
          <a:ln>
            <a:noFill/>
          </a:ln>
        </p:spPr>
        <p:txBody>
          <a:bodyPr lIns="91425" tIns="45700" rIns="91425" bIns="45700" anchor="t" anchorCtr="0">
            <a:noAutofit/>
          </a:bodyPr>
          <a:lstStyle/>
          <a:p>
            <a:pPr>
              <a:buSzPct val="25000"/>
            </a:pPr>
            <a:r>
              <a:rPr lang="en-US" sz="1000" dirty="0">
                <a:solidFill>
                  <a:schemeClr val="dk1"/>
                </a:solidFill>
                <a:ea typeface="Arial"/>
                <a:cs typeface="Arial"/>
                <a:sym typeface="Arial"/>
              </a:rPr>
              <a:t> </a:t>
            </a:r>
            <a:r>
              <a:rPr lang="en-US" sz="1000" dirty="0" smtClean="0">
                <a:solidFill>
                  <a:schemeClr val="dk1"/>
                </a:solidFill>
                <a:ea typeface="Arial"/>
                <a:cs typeface="Arial"/>
                <a:sym typeface="Arial"/>
              </a:rPr>
              <a:t>1       2      </a:t>
            </a:r>
            <a:r>
              <a:rPr lang="en-US" sz="1000" dirty="0">
                <a:solidFill>
                  <a:schemeClr val="dk1"/>
                </a:solidFill>
                <a:ea typeface="Arial"/>
                <a:cs typeface="Arial"/>
                <a:sym typeface="Arial"/>
              </a:rPr>
              <a:t>3   </a:t>
            </a:r>
            <a:r>
              <a:rPr lang="en-US" sz="1000" dirty="0" smtClean="0">
                <a:solidFill>
                  <a:schemeClr val="dk1"/>
                </a:solidFill>
                <a:ea typeface="Arial"/>
                <a:cs typeface="Arial"/>
                <a:sym typeface="Arial"/>
              </a:rPr>
              <a:t>    6     12    </a:t>
            </a:r>
            <a:r>
              <a:rPr lang="en-US" sz="1000" dirty="0">
                <a:solidFill>
                  <a:schemeClr val="dk1"/>
                </a:solidFill>
                <a:ea typeface="Arial"/>
                <a:cs typeface="Arial"/>
                <a:sym typeface="Arial"/>
              </a:rPr>
              <a:t>24 </a:t>
            </a:r>
            <a:r>
              <a:rPr lang="en-US" sz="1000" dirty="0" smtClean="0">
                <a:solidFill>
                  <a:schemeClr val="dk1"/>
                </a:solidFill>
                <a:ea typeface="Arial"/>
                <a:cs typeface="Arial"/>
                <a:sym typeface="Arial"/>
              </a:rPr>
              <a:t>  36</a:t>
            </a:r>
            <a:endParaRPr lang="en-US" sz="1000" dirty="0">
              <a:solidFill>
                <a:schemeClr val="dk1"/>
              </a:solidFill>
              <a:ea typeface="Arial"/>
              <a:cs typeface="Arial"/>
              <a:sym typeface="Arial"/>
            </a:endParaRPr>
          </a:p>
        </p:txBody>
      </p:sp>
      <p:pic>
        <p:nvPicPr>
          <p:cNvPr id="17" name="Picture 16"/>
          <p:cNvPicPr>
            <a:picLocks noChangeAspect="1"/>
          </p:cNvPicPr>
          <p:nvPr/>
        </p:nvPicPr>
        <p:blipFill rotWithShape="1">
          <a:blip r:embed="rId2" cstate="print">
            <a:extLst>
              <a:ext uri="{BEBA8EAE-BF5A-486C-A8C5-ECC9F3942E4B}">
                <a14:imgProps xmlns:a14="http://schemas.microsoft.com/office/drawing/2010/main">
                  <a14:imgLayer r:embed="rId3">
                    <a14:imgEffect>
                      <a14:brightnessContrast bright="20000" contrast="20000"/>
                    </a14:imgEffect>
                  </a14:imgLayer>
                </a14:imgProps>
              </a:ext>
              <a:ext uri="{28A0092B-C50C-407E-A947-70E740481C1C}">
                <a14:useLocalDpi xmlns:a14="http://schemas.microsoft.com/office/drawing/2010/main" val="0"/>
              </a:ext>
            </a:extLst>
          </a:blip>
          <a:srcRect l="55110" t="29086" r="13757" b="51864"/>
          <a:stretch/>
        </p:blipFill>
        <p:spPr>
          <a:xfrm>
            <a:off x="4297992" y="1366428"/>
            <a:ext cx="1800000" cy="275334"/>
          </a:xfrm>
          <a:prstGeom prst="rect">
            <a:avLst/>
          </a:prstGeom>
          <a:ln>
            <a:solidFill>
              <a:schemeClr val="tx1"/>
            </a:solidFill>
          </a:ln>
        </p:spPr>
      </p:pic>
      <p:pic>
        <p:nvPicPr>
          <p:cNvPr id="18" name="Picture 17"/>
          <p:cNvPicPr>
            <a:picLocks noChangeAspect="1"/>
          </p:cNvPicPr>
          <p:nvPr/>
        </p:nvPicPr>
        <p:blipFill rotWithShape="1">
          <a:blip r:embed="rId4" cstate="print">
            <a:extLst>
              <a:ext uri="{BEBA8EAE-BF5A-486C-A8C5-ECC9F3942E4B}">
                <a14:imgProps xmlns:a14="http://schemas.microsoft.com/office/drawing/2010/main">
                  <a14:imgLayer r:embed="rId3">
                    <a14:imgEffect>
                      <a14:brightnessContrast bright="20000" contrast="20000"/>
                    </a14:imgEffect>
                  </a14:imgLayer>
                </a14:imgProps>
              </a:ext>
              <a:ext uri="{28A0092B-C50C-407E-A947-70E740481C1C}">
                <a14:useLocalDpi xmlns:a14="http://schemas.microsoft.com/office/drawing/2010/main" val="0"/>
              </a:ext>
            </a:extLst>
          </a:blip>
          <a:srcRect l="20113" t="24394" r="44055" b="53760"/>
          <a:stretch/>
        </p:blipFill>
        <p:spPr>
          <a:xfrm>
            <a:off x="2290488" y="1371307"/>
            <a:ext cx="1800000" cy="274349"/>
          </a:xfrm>
          <a:prstGeom prst="rect">
            <a:avLst/>
          </a:prstGeom>
          <a:ln>
            <a:solidFill>
              <a:schemeClr val="tx1"/>
            </a:solidFill>
          </a:ln>
        </p:spPr>
      </p:pic>
      <p:pic>
        <p:nvPicPr>
          <p:cNvPr id="19" name="Picture 18"/>
          <p:cNvPicPr>
            <a:picLocks noChangeAspect="1"/>
          </p:cNvPicPr>
          <p:nvPr/>
        </p:nvPicPr>
        <p:blipFill rotWithShape="1">
          <a:blip r:embed="rId5"/>
          <a:srcRect l="22836" t="58199" r="43126" b="35132"/>
          <a:stretch/>
        </p:blipFill>
        <p:spPr>
          <a:xfrm>
            <a:off x="2299924" y="2499925"/>
            <a:ext cx="1800000" cy="271462"/>
          </a:xfrm>
          <a:prstGeom prst="rect">
            <a:avLst/>
          </a:prstGeom>
          <a:ln>
            <a:solidFill>
              <a:schemeClr val="tx1"/>
            </a:solidFill>
          </a:ln>
        </p:spPr>
      </p:pic>
      <p:pic>
        <p:nvPicPr>
          <p:cNvPr id="20" name="Picture 19"/>
          <p:cNvPicPr>
            <a:picLocks noChangeAspect="1"/>
          </p:cNvPicPr>
          <p:nvPr/>
        </p:nvPicPr>
        <p:blipFill rotWithShape="1">
          <a:blip r:embed="rId6"/>
          <a:srcRect t="37187" r="46660" b="28054"/>
          <a:stretch/>
        </p:blipFill>
        <p:spPr>
          <a:xfrm>
            <a:off x="2299924" y="807822"/>
            <a:ext cx="1800000" cy="271463"/>
          </a:xfrm>
          <a:prstGeom prst="rect">
            <a:avLst/>
          </a:prstGeom>
          <a:ln>
            <a:solidFill>
              <a:schemeClr val="tx1"/>
            </a:solidFill>
          </a:ln>
        </p:spPr>
      </p:pic>
      <p:pic>
        <p:nvPicPr>
          <p:cNvPr id="21" name="Picture 20"/>
          <p:cNvPicPr>
            <a:picLocks noChangeAspect="1"/>
          </p:cNvPicPr>
          <p:nvPr/>
        </p:nvPicPr>
        <p:blipFill rotWithShape="1">
          <a:blip r:embed="rId6"/>
          <a:srcRect l="52276" t="42758" r="2196" b="28197"/>
          <a:stretch/>
        </p:blipFill>
        <p:spPr>
          <a:xfrm>
            <a:off x="4297992" y="803685"/>
            <a:ext cx="1800000" cy="265762"/>
          </a:xfrm>
          <a:prstGeom prst="rect">
            <a:avLst/>
          </a:prstGeom>
          <a:ln>
            <a:solidFill>
              <a:schemeClr val="tx1"/>
            </a:solidFill>
          </a:ln>
        </p:spPr>
      </p:pic>
      <p:pic>
        <p:nvPicPr>
          <p:cNvPr id="22" name="Picture 21"/>
          <p:cNvPicPr>
            <a:picLocks noChangeAspect="1"/>
          </p:cNvPicPr>
          <p:nvPr/>
        </p:nvPicPr>
        <p:blipFill rotWithShape="1">
          <a:blip r:embed="rId7" cstate="print">
            <a:extLst>
              <a:ext uri="{BEBA8EAE-BF5A-486C-A8C5-ECC9F3942E4B}">
                <a14:imgProps xmlns:a14="http://schemas.microsoft.com/office/drawing/2010/main">
                  <a14:imgLayer r:embed="rId8">
                    <a14:imgEffect>
                      <a14:brightnessContrast bright="40000" contrast="40000"/>
                    </a14:imgEffect>
                  </a14:imgLayer>
                </a14:imgProps>
              </a:ext>
              <a:ext uri="{28A0092B-C50C-407E-A947-70E740481C1C}">
                <a14:useLocalDpi xmlns:a14="http://schemas.microsoft.com/office/drawing/2010/main" val="0"/>
              </a:ext>
            </a:extLst>
          </a:blip>
          <a:srcRect l="14973" t="63903" r="49758" b="27294"/>
          <a:stretch/>
        </p:blipFill>
        <p:spPr>
          <a:xfrm>
            <a:off x="2290488" y="1929840"/>
            <a:ext cx="1800000" cy="280764"/>
          </a:xfrm>
          <a:prstGeom prst="rect">
            <a:avLst/>
          </a:prstGeom>
          <a:ln>
            <a:solidFill>
              <a:schemeClr val="tx1"/>
            </a:solidFill>
          </a:ln>
        </p:spPr>
      </p:pic>
      <p:pic>
        <p:nvPicPr>
          <p:cNvPr id="23" name="Picture 22"/>
          <p:cNvPicPr>
            <a:picLocks noChangeAspect="1"/>
          </p:cNvPicPr>
          <p:nvPr/>
        </p:nvPicPr>
        <p:blipFill rotWithShape="1">
          <a:blip r:embed="rId9" cstate="print">
            <a:extLst>
              <a:ext uri="{BEBA8EAE-BF5A-486C-A8C5-ECC9F3942E4B}">
                <a14:imgProps xmlns:a14="http://schemas.microsoft.com/office/drawing/2010/main">
                  <a14:imgLayer r:embed="rId8">
                    <a14:imgEffect>
                      <a14:brightnessContrast bright="40000" contrast="40000"/>
                    </a14:imgEffect>
                  </a14:imgLayer>
                </a14:imgProps>
              </a:ext>
              <a:ext uri="{28A0092B-C50C-407E-A947-70E740481C1C}">
                <a14:useLocalDpi xmlns:a14="http://schemas.microsoft.com/office/drawing/2010/main" val="0"/>
              </a:ext>
            </a:extLst>
          </a:blip>
          <a:srcRect l="54412" t="63367" r="14984" b="29506"/>
          <a:stretch/>
        </p:blipFill>
        <p:spPr>
          <a:xfrm>
            <a:off x="4297992" y="1939253"/>
            <a:ext cx="1800000" cy="261938"/>
          </a:xfrm>
          <a:prstGeom prst="rect">
            <a:avLst/>
          </a:prstGeom>
          <a:ln>
            <a:solidFill>
              <a:schemeClr val="tx1"/>
            </a:solidFill>
          </a:ln>
        </p:spPr>
      </p:pic>
      <p:pic>
        <p:nvPicPr>
          <p:cNvPr id="24" name="Picture 23"/>
          <p:cNvPicPr>
            <a:picLocks noChangeAspect="1"/>
          </p:cNvPicPr>
          <p:nvPr/>
        </p:nvPicPr>
        <p:blipFill rotWithShape="1">
          <a:blip r:embed="rId5"/>
          <a:srcRect l="56091" t="59466" r="14302" b="34862"/>
          <a:stretch/>
        </p:blipFill>
        <p:spPr>
          <a:xfrm>
            <a:off x="4297992" y="2500502"/>
            <a:ext cx="1800000" cy="265425"/>
          </a:xfrm>
          <a:prstGeom prst="rect">
            <a:avLst/>
          </a:prstGeom>
          <a:ln>
            <a:solidFill>
              <a:schemeClr val="tx1"/>
            </a:solidFill>
          </a:ln>
        </p:spPr>
      </p:pic>
      <p:graphicFrame>
        <p:nvGraphicFramePr>
          <p:cNvPr id="25" name="Chart 24"/>
          <p:cNvGraphicFramePr>
            <a:graphicFrameLocks/>
          </p:cNvGraphicFramePr>
          <p:nvPr>
            <p:extLst>
              <p:ext uri="{D42A27DB-BD31-4B8C-83A1-F6EECF244321}">
                <p14:modId xmlns:p14="http://schemas.microsoft.com/office/powerpoint/2010/main" val="1483770598"/>
              </p:ext>
            </p:extLst>
          </p:nvPr>
        </p:nvGraphicFramePr>
        <p:xfrm>
          <a:off x="1726200" y="5168894"/>
          <a:ext cx="4320000" cy="2160000"/>
        </p:xfrm>
        <a:graphic>
          <a:graphicData uri="http://schemas.openxmlformats.org/drawingml/2006/chart">
            <c:chart xmlns:c="http://schemas.openxmlformats.org/drawingml/2006/chart" xmlns:r="http://schemas.openxmlformats.org/officeDocument/2006/relationships" r:id="rId10"/>
          </a:graphicData>
        </a:graphic>
      </p:graphicFrame>
      <p:graphicFrame>
        <p:nvGraphicFramePr>
          <p:cNvPr id="26" name="Chart 25"/>
          <p:cNvGraphicFramePr>
            <a:graphicFrameLocks/>
          </p:cNvGraphicFramePr>
          <p:nvPr>
            <p:extLst>
              <p:ext uri="{D42A27DB-BD31-4B8C-83A1-F6EECF244321}">
                <p14:modId xmlns:p14="http://schemas.microsoft.com/office/powerpoint/2010/main" val="280471205"/>
              </p:ext>
            </p:extLst>
          </p:nvPr>
        </p:nvGraphicFramePr>
        <p:xfrm>
          <a:off x="1725231" y="7328893"/>
          <a:ext cx="4320000" cy="2160000"/>
        </p:xfrm>
        <a:graphic>
          <a:graphicData uri="http://schemas.openxmlformats.org/drawingml/2006/chart">
            <c:chart xmlns:c="http://schemas.openxmlformats.org/drawingml/2006/chart" xmlns:r="http://schemas.openxmlformats.org/officeDocument/2006/relationships" r:id="rId11"/>
          </a:graphicData>
        </a:graphic>
      </p:graphicFrame>
      <p:graphicFrame>
        <p:nvGraphicFramePr>
          <p:cNvPr id="27" name="Chart 26"/>
          <p:cNvGraphicFramePr>
            <a:graphicFrameLocks/>
          </p:cNvGraphicFramePr>
          <p:nvPr>
            <p:extLst>
              <p:ext uri="{D42A27DB-BD31-4B8C-83A1-F6EECF244321}">
                <p14:modId xmlns:p14="http://schemas.microsoft.com/office/powerpoint/2010/main" val="2637175986"/>
              </p:ext>
            </p:extLst>
          </p:nvPr>
        </p:nvGraphicFramePr>
        <p:xfrm>
          <a:off x="1727169" y="3008894"/>
          <a:ext cx="4320000" cy="2160000"/>
        </p:xfrm>
        <a:graphic>
          <a:graphicData uri="http://schemas.openxmlformats.org/drawingml/2006/chart">
            <c:chart xmlns:c="http://schemas.openxmlformats.org/drawingml/2006/chart" xmlns:r="http://schemas.openxmlformats.org/officeDocument/2006/relationships" r:id="rId12"/>
          </a:graphicData>
        </a:graphic>
      </p:graphicFrame>
      <p:sp>
        <p:nvSpPr>
          <p:cNvPr id="28" name="Shape 884"/>
          <p:cNvSpPr txBox="1"/>
          <p:nvPr/>
        </p:nvSpPr>
        <p:spPr>
          <a:xfrm>
            <a:off x="1777991" y="9448800"/>
            <a:ext cx="4320001" cy="794018"/>
          </a:xfrm>
          <a:prstGeom prst="rect">
            <a:avLst/>
          </a:prstGeom>
          <a:noFill/>
          <a:ln>
            <a:noFill/>
          </a:ln>
        </p:spPr>
        <p:txBody>
          <a:bodyPr lIns="91425" tIns="45700" rIns="91425" bIns="45700" anchor="t" anchorCtr="0">
            <a:noAutofit/>
          </a:bodyPr>
          <a:lstStyle/>
          <a:p>
            <a:pPr>
              <a:buSzPct val="25000"/>
            </a:pPr>
            <a:r>
              <a:rPr lang="en-US" sz="1200" b="1" dirty="0" smtClean="0">
                <a:solidFill>
                  <a:schemeClr val="dk1"/>
                </a:solidFill>
                <a:latin typeface="Calibri"/>
                <a:ea typeface="Calibri"/>
                <a:cs typeface="Calibri"/>
                <a:sym typeface="Calibri"/>
              </a:rPr>
              <a:t>Figure S2 </a:t>
            </a:r>
            <a:r>
              <a:rPr lang="en-US" sz="1200" b="1" dirty="0">
                <a:solidFill>
                  <a:schemeClr val="dk1"/>
                </a:solidFill>
                <a:ea typeface="Calibri"/>
                <a:cs typeface="Calibri"/>
                <a:sym typeface="Calibri"/>
              </a:rPr>
              <a:t>Characterization of cold regulated miRNAs and mRNA </a:t>
            </a:r>
            <a:r>
              <a:rPr lang="en-US" sz="1200" b="1" dirty="0" smtClean="0">
                <a:solidFill>
                  <a:schemeClr val="dk1"/>
                </a:solidFill>
                <a:ea typeface="Calibri"/>
                <a:cs typeface="Calibri"/>
                <a:sym typeface="Calibri"/>
              </a:rPr>
              <a:t>targets in </a:t>
            </a:r>
            <a:r>
              <a:rPr lang="en-US" sz="1200" b="1" dirty="0" err="1" smtClean="0">
                <a:solidFill>
                  <a:schemeClr val="dk1"/>
                </a:solidFill>
                <a:ea typeface="Calibri"/>
                <a:cs typeface="Calibri"/>
                <a:sym typeface="Calibri"/>
              </a:rPr>
              <a:t>Biorep</a:t>
            </a:r>
            <a:r>
              <a:rPr lang="en-US" sz="1200" b="1" dirty="0" smtClean="0">
                <a:solidFill>
                  <a:schemeClr val="dk1"/>
                </a:solidFill>
                <a:ea typeface="Calibri"/>
                <a:cs typeface="Calibri"/>
                <a:sym typeface="Calibri"/>
              </a:rPr>
              <a:t> #2.  </a:t>
            </a:r>
            <a:r>
              <a:rPr lang="en-US" sz="1200" dirty="0" smtClean="0">
                <a:solidFill>
                  <a:schemeClr val="dk1"/>
                </a:solidFill>
                <a:latin typeface="Calibri"/>
                <a:ea typeface="Calibri"/>
                <a:cs typeface="Calibri"/>
                <a:sym typeface="Calibri"/>
              </a:rPr>
              <a:t>Complementary to Figure 8.</a:t>
            </a:r>
            <a:endParaRPr lang="en-US" sz="1200" b="1" dirty="0">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355259478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Shape 884"/>
          <p:cNvSpPr txBox="1"/>
          <p:nvPr/>
        </p:nvSpPr>
        <p:spPr>
          <a:xfrm>
            <a:off x="1633538" y="5572674"/>
            <a:ext cx="4435982" cy="845711"/>
          </a:xfrm>
          <a:prstGeom prst="rect">
            <a:avLst/>
          </a:prstGeom>
          <a:noFill/>
          <a:ln>
            <a:noFill/>
          </a:ln>
        </p:spPr>
        <p:txBody>
          <a:bodyPr lIns="91425" tIns="45700" rIns="91425" bIns="45700" anchor="t" anchorCtr="0">
            <a:noAutofit/>
          </a:bodyPr>
          <a:lstStyle/>
          <a:p>
            <a:pPr algn="just">
              <a:buSzPct val="25000"/>
            </a:pPr>
            <a:r>
              <a:rPr lang="en-US" sz="1200" b="1" dirty="0" smtClean="0">
                <a:solidFill>
                  <a:schemeClr val="dk1"/>
                </a:solidFill>
                <a:latin typeface="Calibri"/>
                <a:ea typeface="Calibri"/>
                <a:cs typeface="Calibri"/>
                <a:sym typeface="Calibri"/>
              </a:rPr>
              <a:t>Figure S3 Bdi-miR168 Targeting </a:t>
            </a:r>
            <a:r>
              <a:rPr lang="en-US" sz="1200" b="1" dirty="0" smtClean="0">
                <a:solidFill>
                  <a:schemeClr val="dk1"/>
                </a:solidFill>
                <a:latin typeface="Calibri"/>
                <a:ea typeface="Calibri"/>
                <a:cs typeface="Calibri"/>
                <a:sym typeface="Calibri"/>
              </a:rPr>
              <a:t>AGO1a.  </a:t>
            </a:r>
            <a:r>
              <a:rPr lang="en-US" sz="1200" dirty="0" smtClean="0">
                <a:solidFill>
                  <a:schemeClr val="dk1"/>
                </a:solidFill>
                <a:latin typeface="Calibri"/>
                <a:ea typeface="Calibri"/>
                <a:cs typeface="Calibri"/>
                <a:sym typeface="Calibri"/>
              </a:rPr>
              <a:t>D-Plot of PARE data showing evidence for cleavage of the </a:t>
            </a:r>
            <a:r>
              <a:rPr lang="en-US" sz="1200" dirty="0">
                <a:solidFill>
                  <a:schemeClr val="dk1"/>
                </a:solidFill>
                <a:ea typeface="Calibri"/>
                <a:cs typeface="Calibri"/>
                <a:sym typeface="Calibri"/>
              </a:rPr>
              <a:t>AGO1a transcript (</a:t>
            </a:r>
            <a:r>
              <a:rPr lang="en-US" sz="1200" dirty="0" smtClean="0">
                <a:solidFill>
                  <a:schemeClr val="dk1"/>
                </a:solidFill>
                <a:ea typeface="Calibri"/>
                <a:cs typeface="Calibri"/>
                <a:sym typeface="Calibri"/>
              </a:rPr>
              <a:t>Bradi3g51077.3)</a:t>
            </a:r>
            <a:r>
              <a:rPr lang="en-US" sz="1200" dirty="0" smtClean="0">
                <a:solidFill>
                  <a:schemeClr val="dk1"/>
                </a:solidFill>
                <a:latin typeface="Calibri"/>
                <a:ea typeface="Calibri"/>
                <a:cs typeface="Calibri"/>
                <a:sym typeface="Calibri"/>
              </a:rPr>
              <a:t> </a:t>
            </a:r>
            <a:r>
              <a:rPr lang="en-US" sz="1200" dirty="0" smtClean="0">
                <a:solidFill>
                  <a:schemeClr val="dk1"/>
                </a:solidFill>
                <a:latin typeface="Calibri"/>
                <a:ea typeface="Calibri"/>
                <a:cs typeface="Calibri"/>
                <a:sym typeface="Calibri"/>
              </a:rPr>
              <a:t>via miR168. Despite this cleavage event being highly conserved it is only Level 1 prominence. </a:t>
            </a:r>
            <a:r>
              <a:rPr lang="en-US" sz="1200" dirty="0"/>
              <a:t>Red </a:t>
            </a:r>
            <a:r>
              <a:rPr lang="en-US" sz="1200" dirty="0" smtClean="0"/>
              <a:t>dot indicates </a:t>
            </a:r>
            <a:r>
              <a:rPr lang="en-US" sz="1200" dirty="0"/>
              <a:t>the PARE </a:t>
            </a:r>
            <a:r>
              <a:rPr lang="en-US" sz="1200" dirty="0" smtClean="0"/>
              <a:t>sequence which mapped </a:t>
            </a:r>
            <a:r>
              <a:rPr lang="en-US" sz="1200" dirty="0"/>
              <a:t>to </a:t>
            </a:r>
            <a:r>
              <a:rPr lang="en-US" sz="1200" dirty="0" smtClean="0"/>
              <a:t>the miR168 target site.</a:t>
            </a:r>
            <a:endParaRPr lang="en-US" sz="1200" b="1" dirty="0">
              <a:solidFill>
                <a:schemeClr val="dk1"/>
              </a:solidFill>
              <a:latin typeface="Calibri"/>
              <a:ea typeface="Calibri"/>
              <a:cs typeface="Calibri"/>
              <a:sym typeface="Calibri"/>
            </a:endParaRPr>
          </a:p>
        </p:txBody>
      </p:sp>
      <p:graphicFrame>
        <p:nvGraphicFramePr>
          <p:cNvPr id="7" name="Chart 6"/>
          <p:cNvGraphicFramePr>
            <a:graphicFrameLocks/>
          </p:cNvGraphicFramePr>
          <p:nvPr>
            <p:extLst>
              <p:ext uri="{D42A27DB-BD31-4B8C-83A1-F6EECF244321}">
                <p14:modId xmlns:p14="http://schemas.microsoft.com/office/powerpoint/2010/main" val="2941649470"/>
              </p:ext>
            </p:extLst>
          </p:nvPr>
        </p:nvGraphicFramePr>
        <p:xfrm>
          <a:off x="1597929" y="1663450"/>
          <a:ext cx="4507200" cy="3902400"/>
        </p:xfrm>
        <a:graphic>
          <a:graphicData uri="http://schemas.openxmlformats.org/drawingml/2006/chart">
            <c:chart xmlns:c="http://schemas.openxmlformats.org/drawingml/2006/chart" xmlns:r="http://schemas.openxmlformats.org/officeDocument/2006/relationships" r:id="rId2"/>
          </a:graphicData>
        </a:graphic>
      </p:graphicFrame>
    </p:spTree>
    <p:extLst>
      <p:ext uri="{BB962C8B-B14F-4D97-AF65-F5344CB8AC3E}">
        <p14:creationId xmlns:p14="http://schemas.microsoft.com/office/powerpoint/2010/main" val="165944257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84</TotalTime>
  <Words>255</Words>
  <Application>Microsoft Office PowerPoint</Application>
  <PresentationFormat>Custom</PresentationFormat>
  <Paragraphs>47</Paragraphs>
  <Slides>3</Slides>
  <Notes>0</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3</vt:i4>
      </vt:variant>
    </vt:vector>
  </HeadingPairs>
  <TitlesOfParts>
    <vt:vector size="6" baseType="lpstr">
      <vt:lpstr>Arial</vt:lpstr>
      <vt:lpstr>Calibri</vt:lpstr>
      <vt:lpstr>Office Theme</vt:lpstr>
      <vt:lpstr>PowerPoint Presentation</vt:lpstr>
      <vt:lpstr>PowerPoint Presentation</vt:lpstr>
      <vt:lpstr>PowerPoint Presentation</vt:lpstr>
    </vt:vector>
  </TitlesOfParts>
  <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Karl</dc:creator>
  <cp:lastModifiedBy>Karl Franke</cp:lastModifiedBy>
  <cp:revision>5</cp:revision>
  <dcterms:created xsi:type="dcterms:W3CDTF">2006-08-16T00:00:00Z</dcterms:created>
  <dcterms:modified xsi:type="dcterms:W3CDTF">2018-03-30T18:53:18Z</dcterms:modified>
</cp:coreProperties>
</file>